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p:sldMasterIdLst>
    <p:sldMasterId id="2147483660" r:id="rId1"/>
  </p:sldMasterIdLst>
  <p:notesMasterIdLst>
    <p:notesMasterId r:id="rId53"/>
  </p:notesMasterIdLst>
  <p:sldIdLst>
    <p:sldId id="256" r:id="rId2"/>
    <p:sldId id="257" r:id="rId3"/>
    <p:sldId id="258" r:id="rId4"/>
    <p:sldId id="301" r:id="rId5"/>
    <p:sldId id="302" r:id="rId6"/>
    <p:sldId id="303" r:id="rId7"/>
    <p:sldId id="304" r:id="rId8"/>
    <p:sldId id="305" r:id="rId9"/>
    <p:sldId id="320" r:id="rId10"/>
    <p:sldId id="321" r:id="rId11"/>
    <p:sldId id="272" r:id="rId12"/>
    <p:sldId id="259" r:id="rId13"/>
    <p:sldId id="275" r:id="rId14"/>
    <p:sldId id="276" r:id="rId15"/>
    <p:sldId id="277" r:id="rId16"/>
    <p:sldId id="287" r:id="rId17"/>
    <p:sldId id="278" r:id="rId18"/>
    <p:sldId id="289" r:id="rId19"/>
    <p:sldId id="273" r:id="rId20"/>
    <p:sldId id="323" r:id="rId21"/>
    <p:sldId id="263" r:id="rId22"/>
    <p:sldId id="279" r:id="rId23"/>
    <p:sldId id="280" r:id="rId24"/>
    <p:sldId id="281" r:id="rId25"/>
    <p:sldId id="282" r:id="rId26"/>
    <p:sldId id="291" r:id="rId27"/>
    <p:sldId id="283" r:id="rId28"/>
    <p:sldId id="284" r:id="rId29"/>
    <p:sldId id="290" r:id="rId30"/>
    <p:sldId id="266" r:id="rId31"/>
    <p:sldId id="265" r:id="rId32"/>
    <p:sldId id="264" r:id="rId33"/>
    <p:sldId id="274" r:id="rId34"/>
    <p:sldId id="324" r:id="rId35"/>
    <p:sldId id="307" r:id="rId36"/>
    <p:sldId id="308" r:id="rId37"/>
    <p:sldId id="309" r:id="rId38"/>
    <p:sldId id="310" r:id="rId39"/>
    <p:sldId id="325" r:id="rId40"/>
    <p:sldId id="311" r:id="rId41"/>
    <p:sldId id="312" r:id="rId42"/>
    <p:sldId id="313" r:id="rId43"/>
    <p:sldId id="314" r:id="rId44"/>
    <p:sldId id="315" r:id="rId45"/>
    <p:sldId id="316" r:id="rId46"/>
    <p:sldId id="317" r:id="rId47"/>
    <p:sldId id="318" r:id="rId48"/>
    <p:sldId id="271" r:id="rId49"/>
    <p:sldId id="322" r:id="rId50"/>
    <p:sldId id="270" r:id="rId51"/>
    <p:sldId id="269" r:id="rId5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Introduction" id="{7C028330-C34F-4366-850D-AFF0D3D00344}">
          <p14:sldIdLst>
            <p14:sldId id="256"/>
            <p14:sldId id="257"/>
            <p14:sldId id="258"/>
          </p14:sldIdLst>
        </p14:section>
        <p14:section name="Cognitive Load Theory" id="{5F241FA6-EC2B-4922-A221-F9CAF4F861AF}">
          <p14:sldIdLst>
            <p14:sldId id="301"/>
            <p14:sldId id="302"/>
            <p14:sldId id="303"/>
            <p14:sldId id="304"/>
            <p14:sldId id="305"/>
            <p14:sldId id="320"/>
            <p14:sldId id="321"/>
          </p14:sldIdLst>
        </p14:section>
        <p14:section name="General Principles" id="{A609DDBD-2B84-4274-84A8-6E305E4D20FB}">
          <p14:sldIdLst>
            <p14:sldId id="272"/>
            <p14:sldId id="259"/>
            <p14:sldId id="275"/>
            <p14:sldId id="276"/>
            <p14:sldId id="277"/>
            <p14:sldId id="287"/>
            <p14:sldId id="278"/>
            <p14:sldId id="289"/>
          </p14:sldIdLst>
        </p14:section>
        <p14:section name="Standardized Framework" id="{5DC8FCA3-E381-4235-BC60-FD4527164232}">
          <p14:sldIdLst>
            <p14:sldId id="273"/>
            <p14:sldId id="323"/>
            <p14:sldId id="263"/>
            <p14:sldId id="279"/>
            <p14:sldId id="280"/>
            <p14:sldId id="281"/>
            <p14:sldId id="282"/>
            <p14:sldId id="291"/>
            <p14:sldId id="283"/>
            <p14:sldId id="284"/>
            <p14:sldId id="290"/>
          </p14:sldIdLst>
        </p14:section>
        <p14:section name="Conclusion" id="{8AF58E42-8C04-44BA-A9D3-18C380859241}">
          <p14:sldIdLst>
            <p14:sldId id="266"/>
            <p14:sldId id="265"/>
            <p14:sldId id="264"/>
          </p14:sldIdLst>
        </p14:section>
        <p14:section name="Microskills" id="{4D8B3768-5767-4119-B53A-61010BA690AB}">
          <p14:sldIdLst>
            <p14:sldId id="274"/>
            <p14:sldId id="324"/>
            <p14:sldId id="307"/>
            <p14:sldId id="308"/>
            <p14:sldId id="309"/>
            <p14:sldId id="310"/>
            <p14:sldId id="325"/>
            <p14:sldId id="311"/>
            <p14:sldId id="312"/>
            <p14:sldId id="313"/>
            <p14:sldId id="314"/>
            <p14:sldId id="315"/>
            <p14:sldId id="316"/>
            <p14:sldId id="317"/>
            <p14:sldId id="318"/>
            <p14:sldId id="271"/>
            <p14:sldId id="322"/>
            <p14:sldId id="270"/>
            <p14:sldId id="269"/>
          </p14:sldIdLst>
        </p14:section>
      </p14:section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74472" autoAdjust="0"/>
  </p:normalViewPr>
  <p:slideViewPr>
    <p:cSldViewPr>
      <p:cViewPr varScale="1">
        <p:scale>
          <a:sx n="98" d="100"/>
          <a:sy n="98" d="100"/>
        </p:scale>
        <p:origin x="-2004" y="-108"/>
      </p:cViewPr>
      <p:guideLst>
        <p:guide orient="horz" pos="432"/>
        <p:guide orient="horz" pos="3888"/>
        <p:guide orient="horz" pos="3456"/>
        <p:guide orient="horz" pos="864"/>
        <p:guide orient="horz" pos="1728"/>
        <p:guide orient="horz" pos="2592"/>
        <p:guide pos="416"/>
        <p:guide pos="5344"/>
        <p:guide pos="4939"/>
        <p:guide pos="826"/>
        <p:guide pos="1648"/>
        <p:guide pos="4112"/>
        <p:guide pos="3296"/>
        <p:guide pos="2464"/>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54"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theme" Target="theme/theme1.xml"/><Relationship Id="rId8" Type="http://schemas.openxmlformats.org/officeDocument/2006/relationships/slide" Target="slides/slide7.xml"/><Relationship Id="rId51" Type="http://schemas.openxmlformats.org/officeDocument/2006/relationships/slide" Target="slides/slide50.xml"/><Relationship Id="rId3"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0A17E374-0FC4-4CE8-A59E-DEE9310DD04D}" type="datetimeFigureOut">
              <a:rPr lang="en-US" smtClean="0"/>
              <a:t>10/28/20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D784820F-0CE4-462B-BAD9-E3B4A35DBCAB}" type="slidenum">
              <a:rPr lang="en-US" smtClean="0"/>
              <a:t>‹#›</a:t>
            </a:fld>
            <a:endParaRPr lang="en-US"/>
          </a:p>
        </p:txBody>
      </p:sp>
    </p:spTree>
    <p:extLst>
      <p:ext uri="{BB962C8B-B14F-4D97-AF65-F5344CB8AC3E}">
        <p14:creationId xmlns:p14="http://schemas.microsoft.com/office/powerpoint/2010/main" val="97185422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3" Type="http://schemas.openxmlformats.org/officeDocument/2006/relationships/hyperlink" Target="https://en.wikipedia.org/wiki/Automaticity" TargetMode="External"/><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0" i="1" dirty="0" smtClean="0"/>
              <a:t>(Notes to presenter: The small group sessions are designed to be open book. During small group sessions, residents</a:t>
            </a:r>
            <a:r>
              <a:rPr lang="en-US" b="0" i="1" baseline="0" dirty="0" smtClean="0"/>
              <a:t> should be encouraged to refer to the primer document and make full use of the internet/smart devices to help answer the questions. </a:t>
            </a:r>
            <a:r>
              <a:rPr lang="en-US" i="1" baseline="0" dirty="0" smtClean="0"/>
              <a:t>The examples provided in the speaker notes throughout this presentation are geared towards teaching new CA-1 residents. However, the concepts still apply for teaching medical students and other learners. Examples involving medical students may be used instead if desired</a:t>
            </a:r>
            <a:r>
              <a:rPr lang="en-US" b="0" i="1" baseline="0" dirty="0" smtClean="0"/>
              <a:t>)</a:t>
            </a:r>
            <a:endParaRPr lang="en-US" b="0" i="1" dirty="0" smtClean="0"/>
          </a:p>
          <a:p>
            <a:pPr marL="0" marR="0" indent="0" algn="l" defTabSz="914400" rtl="0" eaLnBrk="1" fontAlgn="auto" latinLnBrk="0" hangingPunct="1">
              <a:lnSpc>
                <a:spcPct val="100000"/>
              </a:lnSpc>
              <a:spcBef>
                <a:spcPts val="0"/>
              </a:spcBef>
              <a:spcAft>
                <a:spcPts val="0"/>
              </a:spcAft>
              <a:buClrTx/>
              <a:buSzTx/>
              <a:buFontTx/>
              <a:buNone/>
              <a:tabLst/>
              <a:defRPr/>
            </a:pPr>
            <a:endParaRPr lang="en-US" b="1"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1" dirty="0" smtClean="0"/>
              <a:t>[Make</a:t>
            </a:r>
            <a:r>
              <a:rPr lang="en-US" b="1" baseline="0" dirty="0" smtClean="0"/>
              <a:t> sure residents are seated in such a way that they will be able to break into small groups of 2-3 residents throughout this talk</a:t>
            </a:r>
            <a:r>
              <a:rPr lang="en-US" b="1" dirty="0" smtClean="0"/>
              <a:t>]</a:t>
            </a:r>
          </a:p>
          <a:p>
            <a:endParaRPr lang="en-US" dirty="0" smtClean="0"/>
          </a:p>
          <a:p>
            <a:r>
              <a:rPr lang="en-US" dirty="0" smtClean="0"/>
              <a:t>Welcome everyone.</a:t>
            </a:r>
          </a:p>
          <a:p>
            <a:pPr marL="0" marR="0" indent="0" algn="l" defTabSz="914400" rtl="0" eaLnBrk="1" fontAlgn="auto" latinLnBrk="0" hangingPunct="1">
              <a:lnSpc>
                <a:spcPct val="100000"/>
              </a:lnSpc>
              <a:spcBef>
                <a:spcPts val="0"/>
              </a:spcBef>
              <a:spcAft>
                <a:spcPts val="0"/>
              </a:spcAft>
              <a:buClrTx/>
              <a:buSzTx/>
              <a:buFontTx/>
              <a:buNone/>
              <a:tabLst/>
              <a:defRPr/>
            </a:pPr>
            <a:r>
              <a:rPr lang="en-US" b="1" dirty="0" smtClean="0"/>
              <a:t>[Introduce</a:t>
            </a:r>
            <a:r>
              <a:rPr lang="en-US" b="1" baseline="0" dirty="0" smtClean="0"/>
              <a:t> self]</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During this workshop,</a:t>
            </a:r>
            <a:r>
              <a:rPr lang="en-US" baseline="0" dirty="0" smtClean="0"/>
              <a:t> we </a:t>
            </a:r>
            <a:r>
              <a:rPr lang="en-US" dirty="0" smtClean="0"/>
              <a:t>will cover various</a:t>
            </a:r>
            <a:r>
              <a:rPr lang="en-US" baseline="0" dirty="0" smtClean="0"/>
              <a:t> concepts from learning theory to help make you a more effective trainer.</a:t>
            </a:r>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Think back to when you were a medical student rotating on the wards. There were times when you were learning a lot and it felt great. And there were also experiences that were less good.</a:t>
            </a:r>
            <a:endParaRPr lang="en-US" dirty="0" smtClean="0"/>
          </a:p>
        </p:txBody>
      </p:sp>
      <p:sp>
        <p:nvSpPr>
          <p:cNvPr id="4" name="Slide Number Placeholder 3"/>
          <p:cNvSpPr>
            <a:spLocks noGrp="1"/>
          </p:cNvSpPr>
          <p:nvPr>
            <p:ph type="sldNum" sz="quarter" idx="10"/>
          </p:nvPr>
        </p:nvSpPr>
        <p:spPr/>
        <p:txBody>
          <a:bodyPr/>
          <a:lstStyle/>
          <a:p>
            <a:fld id="{D784820F-0CE4-462B-BAD9-E3B4A35DBCAB}" type="slidenum">
              <a:rPr lang="en-US" smtClean="0"/>
              <a:t>1</a:t>
            </a:fld>
            <a:endParaRPr lang="en-US"/>
          </a:p>
        </p:txBody>
      </p:sp>
    </p:spTree>
    <p:extLst>
      <p:ext uri="{BB962C8B-B14F-4D97-AF65-F5344CB8AC3E}">
        <p14:creationId xmlns:p14="http://schemas.microsoft.com/office/powerpoint/2010/main" val="253287293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D784820F-0CE4-462B-BAD9-E3B4A35DBCAB}" type="slidenum">
              <a:rPr lang="en-US" smtClean="0"/>
              <a:t>10</a:t>
            </a:fld>
            <a:endParaRPr lang="en-US"/>
          </a:p>
        </p:txBody>
      </p:sp>
    </p:spTree>
    <p:extLst>
      <p:ext uri="{BB962C8B-B14F-4D97-AF65-F5344CB8AC3E}">
        <p14:creationId xmlns:p14="http://schemas.microsoft.com/office/powerpoint/2010/main" val="354285127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Next we will</a:t>
            </a:r>
            <a:r>
              <a:rPr lang="en-US" baseline="0" dirty="0" smtClean="0"/>
              <a:t> cover general principles of effective teaching.</a:t>
            </a:r>
            <a:endParaRPr lang="en-US" dirty="0"/>
          </a:p>
        </p:txBody>
      </p:sp>
      <p:sp>
        <p:nvSpPr>
          <p:cNvPr id="4" name="Slide Number Placeholder 3"/>
          <p:cNvSpPr>
            <a:spLocks noGrp="1"/>
          </p:cNvSpPr>
          <p:nvPr>
            <p:ph type="sldNum" sz="quarter" idx="10"/>
          </p:nvPr>
        </p:nvSpPr>
        <p:spPr/>
        <p:txBody>
          <a:bodyPr/>
          <a:lstStyle/>
          <a:p>
            <a:fld id="{D784820F-0CE4-462B-BAD9-E3B4A35DBCAB}" type="slidenum">
              <a:rPr lang="en-US" smtClean="0"/>
              <a:t>11</a:t>
            </a:fld>
            <a:endParaRPr lang="en-US"/>
          </a:p>
        </p:txBody>
      </p:sp>
    </p:spTree>
    <p:extLst>
      <p:ext uri="{BB962C8B-B14F-4D97-AF65-F5344CB8AC3E}">
        <p14:creationId xmlns:p14="http://schemas.microsoft.com/office/powerpoint/2010/main" val="277125394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hese are the 3 principles that we will discuss: Allow sufficient time, Let them figure it out, and Encourage autonomy.</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D784820F-0CE4-462B-BAD9-E3B4A35DBCAB}" type="slidenum">
              <a:rPr lang="en-US" smtClean="0"/>
              <a:t>12</a:t>
            </a:fld>
            <a:endParaRPr lang="en-US"/>
          </a:p>
        </p:txBody>
      </p:sp>
    </p:spTree>
    <p:extLst>
      <p:ext uri="{BB962C8B-B14F-4D97-AF65-F5344CB8AC3E}">
        <p14:creationId xmlns:p14="http://schemas.microsoft.com/office/powerpoint/2010/main" val="99079667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As we progress through training, a lot of tasks become second-nature (think muscle memory). This can complicate teaching because something seems obvious and simple, but the trainee is still processing a lot of information and forming mental connections. This takes time. Remember what we talked</a:t>
            </a:r>
            <a:r>
              <a:rPr lang="en-US" sz="1200" kern="1200" baseline="0" dirty="0" smtClean="0">
                <a:solidFill>
                  <a:schemeClr val="tx1"/>
                </a:solidFill>
                <a:effectLst/>
                <a:latin typeface="+mn-lt"/>
                <a:ea typeface="+mn-ea"/>
                <a:cs typeface="+mn-cs"/>
              </a:rPr>
              <a:t> about earlier with automaticity. Preparing a bag of IV fluids is easy for you, but it is a lot more cognitively challenging for your new CA-1.</a:t>
            </a:r>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 </a:t>
            </a:r>
          </a:p>
          <a:p>
            <a:r>
              <a:rPr lang="en-US" sz="1200" kern="1200" dirty="0" smtClean="0">
                <a:solidFill>
                  <a:schemeClr val="tx1"/>
                </a:solidFill>
                <a:effectLst/>
                <a:latin typeface="+mn-lt"/>
                <a:ea typeface="+mn-ea"/>
                <a:cs typeface="+mn-cs"/>
              </a:rPr>
              <a:t>Finish one thing at a time before moving on to the next item. For example, if you asked your trainee to give a bolus of medication, let your trainee finish giving the medication before you continue talking again.</a:t>
            </a:r>
          </a:p>
          <a:p>
            <a:endParaRPr lang="en-US"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sz="1200" i="1" kern="1200" dirty="0" smtClean="0">
                <a:solidFill>
                  <a:schemeClr val="tx1"/>
                </a:solidFill>
                <a:effectLst/>
                <a:latin typeface="+mn-lt"/>
                <a:ea typeface="+mn-ea"/>
                <a:cs typeface="+mn-cs"/>
              </a:rPr>
              <a:t>Image by Michael Jeffrey, retrieved from: https://unsplash.com/photos/lgCb_XiLgp8 on 5/16/2020. Image is in the public domain.</a:t>
            </a:r>
          </a:p>
        </p:txBody>
      </p:sp>
      <p:sp>
        <p:nvSpPr>
          <p:cNvPr id="4" name="Slide Number Placeholder 3"/>
          <p:cNvSpPr>
            <a:spLocks noGrp="1"/>
          </p:cNvSpPr>
          <p:nvPr>
            <p:ph type="sldNum" sz="quarter" idx="10"/>
          </p:nvPr>
        </p:nvSpPr>
        <p:spPr/>
        <p:txBody>
          <a:bodyPr/>
          <a:lstStyle/>
          <a:p>
            <a:fld id="{D784820F-0CE4-462B-BAD9-E3B4A35DBCAB}" type="slidenum">
              <a:rPr lang="en-US" smtClean="0"/>
              <a:t>13</a:t>
            </a:fld>
            <a:endParaRPr lang="en-US"/>
          </a:p>
        </p:txBody>
      </p:sp>
    </p:spTree>
    <p:extLst>
      <p:ext uri="{BB962C8B-B14F-4D97-AF65-F5344CB8AC3E}">
        <p14:creationId xmlns:p14="http://schemas.microsoft.com/office/powerpoint/2010/main" val="137344859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Instead of telling your tr</a:t>
            </a:r>
            <a:r>
              <a:rPr lang="en-US" sz="1200" b="0" kern="1200" dirty="0" smtClean="0">
                <a:solidFill>
                  <a:schemeClr val="tx1"/>
                </a:solidFill>
                <a:effectLst/>
                <a:latin typeface="+mn-lt"/>
                <a:ea typeface="+mn-ea"/>
                <a:cs typeface="+mn-cs"/>
              </a:rPr>
              <a:t>ainee the answer, use questions and prompts to help guide them to the correct answer.</a:t>
            </a:r>
            <a:r>
              <a:rPr lang="en-US" sz="1200" b="0" kern="1200" baseline="0" dirty="0" smtClean="0">
                <a:solidFill>
                  <a:schemeClr val="tx1"/>
                </a:solidFill>
                <a:effectLst/>
                <a:latin typeface="+mn-lt"/>
                <a:ea typeface="+mn-ea"/>
                <a:cs typeface="+mn-cs"/>
              </a:rPr>
              <a:t> There is a famous quote “</a:t>
            </a:r>
            <a:r>
              <a:rPr lang="en-US" sz="1200" b="0" i="0" kern="1200" dirty="0" smtClean="0">
                <a:solidFill>
                  <a:schemeClr val="tx1"/>
                </a:solidFill>
                <a:effectLst/>
                <a:latin typeface="+mn-lt"/>
                <a:ea typeface="+mn-ea"/>
                <a:cs typeface="+mn-cs"/>
              </a:rPr>
              <a:t>Give a man a fish and you feed him for a day; teach a man to fish and you feed him for a lifetime.”</a:t>
            </a:r>
            <a:endParaRPr lang="en-US" sz="1200" b="0" kern="1200" dirty="0" smtClean="0">
              <a:solidFill>
                <a:schemeClr val="tx1"/>
              </a:solidFill>
              <a:effectLst/>
              <a:latin typeface="+mn-lt"/>
              <a:ea typeface="+mn-ea"/>
              <a:cs typeface="+mn-cs"/>
            </a:endParaRPr>
          </a:p>
          <a:p>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By making your trainee work a little bit for the answer, you will help form more long-lasting mental connections.</a:t>
            </a:r>
          </a:p>
          <a:p>
            <a:endParaRPr lang="en-US" dirty="0" smtClean="0"/>
          </a:p>
          <a:p>
            <a:r>
              <a:rPr lang="en-US" i="1" dirty="0" smtClean="0"/>
              <a:t>Image by </a:t>
            </a:r>
            <a:r>
              <a:rPr lang="en-US" i="1" dirty="0" err="1" smtClean="0"/>
              <a:t>Pixabay</a:t>
            </a:r>
            <a:r>
              <a:rPr lang="en-US" i="1" dirty="0" smtClean="0"/>
              <a:t>, retrieved from: https://www.pexels.com/photo/analysis-blackboard-board-bubble-355952/ on 5/16/2020. Image is in the public domain.</a:t>
            </a:r>
            <a:endParaRPr lang="en-US" i="1" dirty="0"/>
          </a:p>
        </p:txBody>
      </p:sp>
      <p:sp>
        <p:nvSpPr>
          <p:cNvPr id="4" name="Slide Number Placeholder 3"/>
          <p:cNvSpPr>
            <a:spLocks noGrp="1"/>
          </p:cNvSpPr>
          <p:nvPr>
            <p:ph type="sldNum" sz="quarter" idx="10"/>
          </p:nvPr>
        </p:nvSpPr>
        <p:spPr/>
        <p:txBody>
          <a:bodyPr/>
          <a:lstStyle/>
          <a:p>
            <a:fld id="{D784820F-0CE4-462B-BAD9-E3B4A35DBCAB}" type="slidenum">
              <a:rPr lang="en-US" smtClean="0"/>
              <a:t>14</a:t>
            </a:fld>
            <a:endParaRPr lang="en-US"/>
          </a:p>
        </p:txBody>
      </p:sp>
    </p:spTree>
    <p:extLst>
      <p:ext uri="{BB962C8B-B14F-4D97-AF65-F5344CB8AC3E}">
        <p14:creationId xmlns:p14="http://schemas.microsoft.com/office/powerpoint/2010/main" val="96079610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hink for a moment: why does encouraging autonomy lead to better learning?</a:t>
            </a:r>
          </a:p>
          <a:p>
            <a:r>
              <a:rPr lang="en-US" sz="1200" b="1" kern="1200" dirty="0" smtClean="0">
                <a:solidFill>
                  <a:schemeClr val="tx1"/>
                </a:solidFill>
                <a:effectLst/>
                <a:latin typeface="+mn-lt"/>
                <a:ea typeface="+mn-ea"/>
                <a:cs typeface="+mn-cs"/>
              </a:rPr>
              <a:t>[Audience response] (answer: autonomy is a key part of self-determination theory, aka what motivates people to do stuff on their own)</a:t>
            </a:r>
            <a:endParaRPr lang="en-US" sz="1200" kern="1200" dirty="0" smtClean="0">
              <a:solidFill>
                <a:schemeClr val="tx1"/>
              </a:solidFill>
              <a:effectLst/>
              <a:latin typeface="+mn-lt"/>
              <a:ea typeface="+mn-ea"/>
              <a:cs typeface="+mn-cs"/>
            </a:endParaRPr>
          </a:p>
          <a:p>
            <a:r>
              <a:rPr lang="en-US" sz="1200" b="1" kern="1200" dirty="0" smtClean="0">
                <a:solidFill>
                  <a:schemeClr val="tx1"/>
                </a:solidFill>
                <a:effectLst/>
                <a:latin typeface="+mn-lt"/>
                <a:ea typeface="+mn-ea"/>
                <a:cs typeface="+mn-cs"/>
              </a:rPr>
              <a:t>[Small group sessions – question #3 – components of self-determination theory] </a:t>
            </a:r>
            <a:r>
              <a:rPr lang="en-US" sz="1200" b="1" i="1" kern="1200" dirty="0" smtClean="0">
                <a:solidFill>
                  <a:schemeClr val="tx1"/>
                </a:solidFill>
                <a:effectLst/>
                <a:latin typeface="+mn-lt"/>
                <a:ea typeface="+mn-ea"/>
                <a:cs typeface="+mn-cs"/>
              </a:rPr>
              <a:t>(ask residents to work together to complete question #3 on the handout)</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D784820F-0CE4-462B-BAD9-E3B4A35DBCAB}" type="slidenum">
              <a:rPr lang="en-US" smtClean="0"/>
              <a:t>15</a:t>
            </a:fld>
            <a:endParaRPr lang="en-US"/>
          </a:p>
        </p:txBody>
      </p:sp>
    </p:spTree>
    <p:extLst>
      <p:ext uri="{BB962C8B-B14F-4D97-AF65-F5344CB8AC3E}">
        <p14:creationId xmlns:p14="http://schemas.microsoft.com/office/powerpoint/2010/main" val="25831359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What motivates people to want to learn? One answer is self-determination theory which breaks down into these</a:t>
            </a:r>
            <a:r>
              <a:rPr lang="en-US" sz="1200" kern="1200" baseline="0" dirty="0" smtClean="0">
                <a:solidFill>
                  <a:schemeClr val="tx1"/>
                </a:solidFill>
                <a:effectLst/>
                <a:latin typeface="+mn-lt"/>
                <a:ea typeface="+mn-ea"/>
                <a:cs typeface="+mn-cs"/>
              </a:rPr>
              <a:t> 3 </a:t>
            </a:r>
            <a:r>
              <a:rPr lang="en-US" sz="1200" kern="1200" dirty="0" smtClean="0">
                <a:solidFill>
                  <a:schemeClr val="tx1"/>
                </a:solidFill>
                <a:effectLst/>
                <a:latin typeface="+mn-lt"/>
                <a:ea typeface="+mn-ea"/>
                <a:cs typeface="+mn-cs"/>
              </a:rPr>
              <a:t>components: relatedness, competence, autonomy.</a:t>
            </a:r>
          </a:p>
          <a:p>
            <a:r>
              <a:rPr lang="en-US" sz="1200" kern="1200" dirty="0" smtClean="0">
                <a:solidFill>
                  <a:schemeClr val="tx1"/>
                </a:solidFill>
                <a:effectLst/>
                <a:latin typeface="+mn-lt"/>
                <a:ea typeface="+mn-ea"/>
                <a:cs typeface="+mn-cs"/>
              </a:rPr>
              <a:t> </a:t>
            </a:r>
          </a:p>
          <a:p>
            <a:r>
              <a:rPr lang="en-US" sz="1200" kern="1200" dirty="0" smtClean="0">
                <a:solidFill>
                  <a:schemeClr val="tx1"/>
                </a:solidFill>
                <a:effectLst/>
                <a:latin typeface="+mn-lt"/>
                <a:ea typeface="+mn-ea"/>
                <a:cs typeface="+mn-cs"/>
              </a:rPr>
              <a:t>Relatedness and competence typically come along naturally from being a resident:</a:t>
            </a:r>
          </a:p>
          <a:p>
            <a:r>
              <a:rPr lang="en-US" sz="1200" kern="1200" dirty="0" smtClean="0">
                <a:solidFill>
                  <a:schemeClr val="tx1"/>
                </a:solidFill>
                <a:effectLst/>
                <a:latin typeface="+mn-lt"/>
                <a:ea typeface="+mn-ea"/>
                <a:cs typeface="+mn-cs"/>
              </a:rPr>
              <a:t>Relatedness: a sense of community – knowing there are other people in the same boat as you. You are part of a group.</a:t>
            </a:r>
          </a:p>
          <a:p>
            <a:r>
              <a:rPr lang="en-US" sz="1200" kern="1200" dirty="0" smtClean="0">
                <a:solidFill>
                  <a:schemeClr val="tx1"/>
                </a:solidFill>
                <a:effectLst/>
                <a:latin typeface="+mn-lt"/>
                <a:ea typeface="+mn-ea"/>
                <a:cs typeface="+mn-cs"/>
              </a:rPr>
              <a:t>Competence: you want to become</a:t>
            </a:r>
            <a:r>
              <a:rPr lang="en-US" sz="1200" kern="1200" baseline="0" dirty="0" smtClean="0">
                <a:solidFill>
                  <a:schemeClr val="tx1"/>
                </a:solidFill>
                <a:effectLst/>
                <a:latin typeface="+mn-lt"/>
                <a:ea typeface="+mn-ea"/>
                <a:cs typeface="+mn-cs"/>
              </a:rPr>
              <a:t> competent at something.</a:t>
            </a:r>
            <a:endParaRPr lang="en-US" sz="1200" kern="1200" dirty="0" smtClean="0">
              <a:solidFill>
                <a:schemeClr val="tx1"/>
              </a:solidFill>
              <a:effectLst/>
              <a:latin typeface="+mn-lt"/>
              <a:ea typeface="+mn-ea"/>
              <a:cs typeface="+mn-cs"/>
            </a:endParaRPr>
          </a:p>
          <a:p>
            <a:endParaRPr lang="en-US" sz="1200" kern="1200" dirty="0" smtClean="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As a trainer, you can impact all three of these components up here. Most people will naturally</a:t>
            </a:r>
            <a:r>
              <a:rPr lang="en-US" sz="1200" kern="1200" baseline="0" dirty="0" smtClean="0">
                <a:solidFill>
                  <a:schemeClr val="tx1"/>
                </a:solidFill>
                <a:effectLst/>
                <a:latin typeface="+mn-lt"/>
                <a:ea typeface="+mn-ea"/>
                <a:cs typeface="+mn-cs"/>
              </a:rPr>
              <a:t> satisfy the first two components of relatedness and competence. But we can sometimes accidentally overlook autonomy.</a:t>
            </a:r>
            <a:endParaRPr lang="en-US" sz="1200" kern="1200" dirty="0" smtClean="0">
              <a:solidFill>
                <a:schemeClr val="tx1"/>
              </a:solidFill>
              <a:effectLst/>
              <a:latin typeface="+mn-lt"/>
              <a:ea typeface="+mn-ea"/>
              <a:cs typeface="+mn-cs"/>
            </a:endParaRPr>
          </a:p>
          <a:p>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Think back</a:t>
            </a:r>
            <a:r>
              <a:rPr lang="en-US" sz="1200" kern="1200" baseline="0" dirty="0" smtClean="0">
                <a:solidFill>
                  <a:schemeClr val="tx1"/>
                </a:solidFill>
                <a:effectLst/>
                <a:latin typeface="+mn-lt"/>
                <a:ea typeface="+mn-ea"/>
                <a:cs typeface="+mn-cs"/>
              </a:rPr>
              <a:t> to the last time you were in the operating room and somebody took over a procedure that you had started because you were too slow.</a:t>
            </a:r>
            <a:endParaRPr lang="en-US" sz="1200" kern="1200" dirty="0" smtClean="0">
              <a:solidFill>
                <a:schemeClr val="tx1"/>
              </a:solidFill>
              <a:effectLst/>
              <a:latin typeface="+mn-lt"/>
              <a:ea typeface="+mn-ea"/>
              <a:cs typeface="+mn-cs"/>
            </a:endParaRPr>
          </a:p>
          <a:p>
            <a:r>
              <a:rPr lang="en-US" sz="1200" b="1" kern="1200" dirty="0" smtClean="0">
                <a:solidFill>
                  <a:schemeClr val="tx1"/>
                </a:solidFill>
                <a:effectLst/>
                <a:latin typeface="+mn-lt"/>
                <a:ea typeface="+mn-ea"/>
                <a:cs typeface="+mn-cs"/>
              </a:rPr>
              <a:t>(Pause to think)</a:t>
            </a:r>
          </a:p>
          <a:p>
            <a:endParaRPr lang="en-US" sz="1200" b="1" kern="1200" dirty="0" smtClean="0">
              <a:solidFill>
                <a:schemeClr val="tx1"/>
              </a:solidFill>
              <a:effectLst/>
              <a:latin typeface="+mn-lt"/>
              <a:ea typeface="+mn-ea"/>
              <a:cs typeface="+mn-cs"/>
            </a:endParaRPr>
          </a:p>
          <a:p>
            <a:r>
              <a:rPr lang="en-US" sz="1200" b="0" kern="1200" dirty="0" smtClean="0">
                <a:solidFill>
                  <a:schemeClr val="tx1"/>
                </a:solidFill>
                <a:effectLst/>
                <a:latin typeface="+mn-lt"/>
                <a:ea typeface="+mn-ea"/>
                <a:cs typeface="+mn-cs"/>
              </a:rPr>
              <a:t>Think of the last time your attending rejected your plan without a good explanation</a:t>
            </a:r>
            <a:r>
              <a:rPr lang="en-US" sz="1200" b="0" kern="1200" baseline="0" dirty="0" smtClean="0">
                <a:solidFill>
                  <a:schemeClr val="tx1"/>
                </a:solidFill>
                <a:effectLst/>
                <a:latin typeface="+mn-lt"/>
                <a:ea typeface="+mn-ea"/>
                <a:cs typeface="+mn-cs"/>
              </a:rPr>
              <a:t> why (“We’re going to do it this way, no arguments”).</a:t>
            </a:r>
            <a:endParaRPr lang="en-US" sz="1200" b="0" kern="1200" dirty="0" smtClean="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b="1" kern="1200" dirty="0" smtClean="0">
                <a:solidFill>
                  <a:schemeClr val="tx1"/>
                </a:solidFill>
                <a:effectLst/>
                <a:latin typeface="+mn-lt"/>
                <a:ea typeface="+mn-ea"/>
                <a:cs typeface="+mn-cs"/>
              </a:rPr>
              <a:t>(Pause to think)</a:t>
            </a:r>
          </a:p>
          <a:p>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One of the hardest parts of being a trainer is learning to be hands off. It’s been ingrained in us to help out. To solve this, once your trainee</a:t>
            </a:r>
            <a:r>
              <a:rPr lang="en-US" sz="1200" kern="1200" baseline="0" dirty="0" smtClean="0">
                <a:solidFill>
                  <a:schemeClr val="tx1"/>
                </a:solidFill>
                <a:effectLst/>
                <a:latin typeface="+mn-lt"/>
                <a:ea typeface="+mn-ea"/>
                <a:cs typeface="+mn-cs"/>
              </a:rPr>
              <a:t> has achieved some basic competence, </a:t>
            </a:r>
            <a:r>
              <a:rPr lang="en-US" sz="1200" kern="1200" dirty="0" smtClean="0">
                <a:solidFill>
                  <a:schemeClr val="tx1"/>
                </a:solidFill>
                <a:effectLst/>
                <a:latin typeface="+mn-lt"/>
                <a:ea typeface="+mn-ea"/>
                <a:cs typeface="+mn-cs"/>
              </a:rPr>
              <a:t>step back and keep your arms folded. This will help you fight the urge to jump in immediately when something happens. If you must, stand in the corner of the room so that you are far away. Try to let your trainee solve problems on their own if it is safe for the patient (Y</a:t>
            </a:r>
            <a:r>
              <a:rPr lang="en-US" sz="1200" kern="1200" baseline="0" dirty="0" smtClean="0">
                <a:solidFill>
                  <a:schemeClr val="tx1"/>
                </a:solidFill>
                <a:effectLst/>
                <a:latin typeface="+mn-lt"/>
                <a:ea typeface="+mn-ea"/>
                <a:cs typeface="+mn-cs"/>
              </a:rPr>
              <a:t>ou should still step in if there is something critical happening that can’t wait, but even in those circumstances, when you debrief and discuss afterwards you can ask them what they would have done and why</a:t>
            </a:r>
            <a:r>
              <a:rPr lang="en-US" sz="1200" kern="1200" dirty="0" smtClean="0">
                <a:solidFill>
                  <a:schemeClr val="tx1"/>
                </a:solidFill>
                <a:effectLst/>
                <a:latin typeface="+mn-lt"/>
                <a:ea typeface="+mn-ea"/>
                <a:cs typeface="+mn-cs"/>
              </a:rPr>
              <a:t>).</a:t>
            </a:r>
          </a:p>
          <a:p>
            <a:endParaRPr lang="en-US" sz="1200" kern="1200" dirty="0" smtClean="0">
              <a:solidFill>
                <a:schemeClr val="tx1"/>
              </a:solidFill>
              <a:effectLst/>
              <a:latin typeface="+mn-lt"/>
              <a:ea typeface="+mn-ea"/>
              <a:cs typeface="+mn-cs"/>
            </a:endParaRPr>
          </a:p>
          <a:p>
            <a:r>
              <a:rPr lang="en-US" sz="1200" i="1" kern="1200" dirty="0" smtClean="0">
                <a:solidFill>
                  <a:schemeClr val="tx1"/>
                </a:solidFill>
                <a:effectLst/>
                <a:latin typeface="+mn-lt"/>
                <a:ea typeface="+mn-ea"/>
                <a:cs typeface="+mn-cs"/>
              </a:rPr>
              <a:t>Image by Lisa </a:t>
            </a:r>
            <a:r>
              <a:rPr lang="en-US" sz="1200" i="1" kern="1200" dirty="0" err="1" smtClean="0">
                <a:solidFill>
                  <a:schemeClr val="tx1"/>
                </a:solidFill>
                <a:effectLst/>
                <a:latin typeface="+mn-lt"/>
                <a:ea typeface="+mn-ea"/>
                <a:cs typeface="+mn-cs"/>
              </a:rPr>
              <a:t>Fotios</a:t>
            </a:r>
            <a:r>
              <a:rPr lang="en-US" sz="1200" i="1" kern="1200" dirty="0" smtClean="0">
                <a:solidFill>
                  <a:schemeClr val="tx1"/>
                </a:solidFill>
                <a:effectLst/>
                <a:latin typeface="+mn-lt"/>
                <a:ea typeface="+mn-ea"/>
                <a:cs typeface="+mn-cs"/>
              </a:rPr>
              <a:t>, retrieved from: https://www.pexels.com/photo/person-reading-book-while-sitting-1472841/ on 5/16/2020. Image is in the public domain.</a:t>
            </a:r>
          </a:p>
        </p:txBody>
      </p:sp>
      <p:sp>
        <p:nvSpPr>
          <p:cNvPr id="4" name="Slide Number Placeholder 3"/>
          <p:cNvSpPr>
            <a:spLocks noGrp="1"/>
          </p:cNvSpPr>
          <p:nvPr>
            <p:ph type="sldNum" sz="quarter" idx="10"/>
          </p:nvPr>
        </p:nvSpPr>
        <p:spPr/>
        <p:txBody>
          <a:bodyPr/>
          <a:lstStyle/>
          <a:p>
            <a:fld id="{D784820F-0CE4-462B-BAD9-E3B4A35DBCAB}" type="slidenum">
              <a:rPr lang="en-US" smtClean="0"/>
              <a:t>16</a:t>
            </a:fld>
            <a:endParaRPr lang="en-US"/>
          </a:p>
        </p:txBody>
      </p:sp>
    </p:spTree>
    <p:extLst>
      <p:ext uri="{BB962C8B-B14F-4D97-AF65-F5344CB8AC3E}">
        <p14:creationId xmlns:p14="http://schemas.microsoft.com/office/powerpoint/2010/main" val="200153816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D784820F-0CE4-462B-BAD9-E3B4A35DBCAB}" type="slidenum">
              <a:rPr lang="en-US" smtClean="0"/>
              <a:t>17</a:t>
            </a:fld>
            <a:endParaRPr lang="en-US"/>
          </a:p>
        </p:txBody>
      </p:sp>
    </p:spTree>
    <p:extLst>
      <p:ext uri="{BB962C8B-B14F-4D97-AF65-F5344CB8AC3E}">
        <p14:creationId xmlns:p14="http://schemas.microsoft.com/office/powerpoint/2010/main" val="319217355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D784820F-0CE4-462B-BAD9-E3B4A35DBCAB}" type="slidenum">
              <a:rPr lang="en-US" smtClean="0"/>
              <a:t>18</a:t>
            </a:fld>
            <a:endParaRPr lang="en-US"/>
          </a:p>
        </p:txBody>
      </p:sp>
    </p:spTree>
    <p:extLst>
      <p:ext uri="{BB962C8B-B14F-4D97-AF65-F5344CB8AC3E}">
        <p14:creationId xmlns:p14="http://schemas.microsoft.com/office/powerpoint/2010/main" val="58882939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Our</a:t>
            </a:r>
            <a:r>
              <a:rPr lang="en-US" baseline="0" dirty="0" smtClean="0"/>
              <a:t> last topic during this first hour will be a framework for figuring out if you are delivering high-quality education.</a:t>
            </a:r>
            <a:endParaRPr lang="en-US" dirty="0"/>
          </a:p>
        </p:txBody>
      </p:sp>
      <p:sp>
        <p:nvSpPr>
          <p:cNvPr id="4" name="Slide Number Placeholder 3"/>
          <p:cNvSpPr>
            <a:spLocks noGrp="1"/>
          </p:cNvSpPr>
          <p:nvPr>
            <p:ph type="sldNum" sz="quarter" idx="10"/>
          </p:nvPr>
        </p:nvSpPr>
        <p:spPr/>
        <p:txBody>
          <a:bodyPr/>
          <a:lstStyle/>
          <a:p>
            <a:fld id="{D784820F-0CE4-462B-BAD9-E3B4A35DBCAB}" type="slidenum">
              <a:rPr lang="en-US" smtClean="0"/>
              <a:t>19</a:t>
            </a:fld>
            <a:endParaRPr lang="en-US"/>
          </a:p>
        </p:txBody>
      </p:sp>
    </p:spTree>
    <p:extLst>
      <p:ext uri="{BB962C8B-B14F-4D97-AF65-F5344CB8AC3E}">
        <p14:creationId xmlns:p14="http://schemas.microsoft.com/office/powerpoint/2010/main" val="315131467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The </a:t>
            </a:r>
            <a:r>
              <a:rPr lang="en-US" baseline="0" dirty="0" smtClean="0"/>
              <a:t>goal is that by the end of this workshop, you will acquire the knowledge and the skills so that you too can brighten someone’s day. And remember, quality teaching benefits both the student and the teacher. You may have heard of the phrase “See one, do one, teach one.” Teaching is a fantastic way to solidify concepts in your head. And it’s a great way to see how far you yourself have come and maybe even identify areas of improvement for yourself.</a:t>
            </a:r>
          </a:p>
        </p:txBody>
      </p:sp>
      <p:sp>
        <p:nvSpPr>
          <p:cNvPr id="4" name="Slide Number Placeholder 3"/>
          <p:cNvSpPr>
            <a:spLocks noGrp="1"/>
          </p:cNvSpPr>
          <p:nvPr>
            <p:ph type="sldNum" sz="quarter" idx="10"/>
          </p:nvPr>
        </p:nvSpPr>
        <p:spPr/>
        <p:txBody>
          <a:bodyPr/>
          <a:lstStyle/>
          <a:p>
            <a:fld id="{D784820F-0CE4-462B-BAD9-E3B4A35DBCAB}" type="slidenum">
              <a:rPr lang="en-US" smtClean="0"/>
              <a:t>2</a:t>
            </a:fld>
            <a:endParaRPr lang="en-US"/>
          </a:p>
        </p:txBody>
      </p:sp>
    </p:spTree>
    <p:extLst>
      <p:ext uri="{BB962C8B-B14F-4D97-AF65-F5344CB8AC3E}">
        <p14:creationId xmlns:p14="http://schemas.microsoft.com/office/powerpoint/2010/main" val="12908631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 would like</a:t>
            </a:r>
            <a:r>
              <a:rPr lang="en-US" baseline="0" dirty="0" smtClean="0"/>
              <a:t> you all to think back to a time during your medical education (medical school or residency) when you had a great learning experience. Please fill out question #4 and then discuss with your neighbor.</a:t>
            </a:r>
          </a:p>
          <a:p>
            <a:r>
              <a:rPr lang="en-US" b="1" baseline="0" dirty="0" smtClean="0"/>
              <a:t>[Small group session – question #4 – personal experience with learning. Please note that there are 4 parts to the question]</a:t>
            </a:r>
            <a:endParaRPr lang="en-US" b="1" dirty="0" smtClean="0"/>
          </a:p>
          <a:p>
            <a:endParaRPr lang="en-US" dirty="0" smtClean="0"/>
          </a:p>
          <a:p>
            <a:r>
              <a:rPr lang="en-US" dirty="0" smtClean="0"/>
              <a:t>Would anyone like to share their experiences</a:t>
            </a:r>
            <a:r>
              <a:rPr lang="en-US" baseline="0" dirty="0" smtClean="0"/>
              <a:t> with the group?</a:t>
            </a:r>
          </a:p>
          <a:p>
            <a:r>
              <a:rPr lang="en-US" b="1" baseline="0" dirty="0" smtClean="0"/>
              <a:t>(Discuss answers to question #4)</a:t>
            </a:r>
          </a:p>
          <a:p>
            <a:endParaRPr lang="en-US" dirty="0" smtClean="0"/>
          </a:p>
          <a:p>
            <a:r>
              <a:rPr lang="en-US" b="1" dirty="0" smtClean="0"/>
              <a:t>[Small group session – question #5A – what are the 5 steps to evaluating</a:t>
            </a:r>
            <a:r>
              <a:rPr lang="en-US" b="1" baseline="0" dirty="0" smtClean="0"/>
              <a:t> the quality of teaching</a:t>
            </a:r>
            <a:r>
              <a:rPr lang="en-US" b="1" dirty="0" smtClean="0"/>
              <a:t>]</a:t>
            </a:r>
            <a:endParaRPr lang="en-US" b="1" baseline="0" dirty="0" smtClean="0"/>
          </a:p>
          <a:p>
            <a:r>
              <a:rPr lang="en-US" i="1" dirty="0" smtClean="0"/>
              <a:t>(Residents should work together</a:t>
            </a:r>
            <a:r>
              <a:rPr lang="en-US" i="1" baseline="0" dirty="0" smtClean="0"/>
              <a:t> as a group to </a:t>
            </a:r>
            <a:r>
              <a:rPr lang="en-US" i="1" dirty="0" smtClean="0"/>
              <a:t>answer the question and write down </a:t>
            </a:r>
            <a:r>
              <a:rPr lang="en-US" i="1" dirty="0" smtClean="0"/>
              <a:t>the 5 </a:t>
            </a:r>
            <a:r>
              <a:rPr lang="en-US" i="1" dirty="0" smtClean="0"/>
              <a:t>steps)</a:t>
            </a:r>
            <a:endParaRPr lang="en-US" i="1" dirty="0" smtClean="0"/>
          </a:p>
          <a:p>
            <a:endParaRPr lang="en-US" dirty="0" smtClean="0"/>
          </a:p>
          <a:p>
            <a:r>
              <a:rPr lang="en-US" i="1" dirty="0" smtClean="0"/>
              <a:t>Image by </a:t>
            </a:r>
            <a:r>
              <a:rPr lang="en-US" i="1" dirty="0" err="1" smtClean="0"/>
              <a:t>Pixabay</a:t>
            </a:r>
            <a:r>
              <a:rPr lang="en-US" i="1" dirty="0" smtClean="0"/>
              <a:t>, retrieved from: https://www.pexels.com/photo/ask-blackboard-chalk-board-chalkboard-356079/ on 5/16/2020. Image is in the public domain.</a:t>
            </a:r>
            <a:endParaRPr lang="en-US" i="1" dirty="0"/>
          </a:p>
        </p:txBody>
      </p:sp>
      <p:sp>
        <p:nvSpPr>
          <p:cNvPr id="4" name="Slide Number Placeholder 3"/>
          <p:cNvSpPr>
            <a:spLocks noGrp="1"/>
          </p:cNvSpPr>
          <p:nvPr>
            <p:ph type="sldNum" sz="quarter" idx="10"/>
          </p:nvPr>
        </p:nvSpPr>
        <p:spPr/>
        <p:txBody>
          <a:bodyPr/>
          <a:lstStyle/>
          <a:p>
            <a:fld id="{D784820F-0CE4-462B-BAD9-E3B4A35DBCAB}" type="slidenum">
              <a:rPr lang="en-US" smtClean="0"/>
              <a:t>20</a:t>
            </a:fld>
            <a:endParaRPr lang="en-US"/>
          </a:p>
        </p:txBody>
      </p:sp>
    </p:spTree>
    <p:extLst>
      <p:ext uri="{BB962C8B-B14F-4D97-AF65-F5344CB8AC3E}">
        <p14:creationId xmlns:p14="http://schemas.microsoft.com/office/powerpoint/2010/main" val="160475309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i="0" dirty="0" smtClean="0"/>
              <a:t>[Small</a:t>
            </a:r>
            <a:r>
              <a:rPr lang="en-US" b="1" i="0" baseline="0" dirty="0" smtClean="0"/>
              <a:t> group session – question #5B - </a:t>
            </a:r>
            <a:r>
              <a:rPr lang="en-US" b="1" i="0" dirty="0" smtClean="0"/>
              <a:t> Explain the significance</a:t>
            </a:r>
            <a:r>
              <a:rPr lang="en-US" b="1" i="0" baseline="0" dirty="0" smtClean="0"/>
              <a:t> of each step]</a:t>
            </a:r>
            <a:endParaRPr lang="en-US" b="0" i="0" baseline="0" dirty="0" smtClean="0"/>
          </a:p>
          <a:p>
            <a:r>
              <a:rPr lang="en-US" sz="1200" i="1" kern="1200" dirty="0" smtClean="0">
                <a:solidFill>
                  <a:schemeClr val="tx1"/>
                </a:solidFill>
                <a:effectLst/>
                <a:latin typeface="+mn-lt"/>
                <a:ea typeface="+mn-ea"/>
                <a:cs typeface="+mn-cs"/>
              </a:rPr>
              <a:t>(Allow residents to discuss question #5B with each other, then proceed through the following 5 slides for each step)</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D784820F-0CE4-462B-BAD9-E3B4A35DBCAB}" type="slidenum">
              <a:rPr lang="en-US" smtClean="0"/>
              <a:t>21</a:t>
            </a:fld>
            <a:endParaRPr lang="en-US"/>
          </a:p>
        </p:txBody>
      </p:sp>
    </p:spTree>
    <p:extLst>
      <p:ext uri="{BB962C8B-B14F-4D97-AF65-F5344CB8AC3E}">
        <p14:creationId xmlns:p14="http://schemas.microsoft.com/office/powerpoint/2010/main" val="454426149"/>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Think back to the last time someone yelled at you in the OR. Your learning was probably impaired after the event. For ACLS training</a:t>
            </a:r>
            <a:r>
              <a:rPr lang="en-US" sz="1200" kern="1200" baseline="0" dirty="0" smtClean="0">
                <a:solidFill>
                  <a:schemeClr val="tx1"/>
                </a:solidFill>
                <a:effectLst/>
                <a:latin typeface="+mn-lt"/>
                <a:ea typeface="+mn-ea"/>
                <a:cs typeface="+mn-cs"/>
              </a:rPr>
              <a:t> nowadays, they emphasize a collaborative environment where people who are lower on the totem pole can still feel safe making suggestions or pointing out errors. This is very similar in teaching. </a:t>
            </a:r>
            <a:r>
              <a:rPr lang="en-US" sz="1200" kern="1200" dirty="0" smtClean="0">
                <a:solidFill>
                  <a:schemeClr val="tx1"/>
                </a:solidFill>
                <a:effectLst/>
                <a:latin typeface="+mn-lt"/>
                <a:ea typeface="+mn-ea"/>
                <a:cs typeface="+mn-cs"/>
              </a:rPr>
              <a:t>For maximum learning, it is important to provide psychological safety and establish a non-punitive climate. Let your trainee know that it is okay to admit when they don’t know the answer. Validate that it is okay that they don’t know the answer and that this is expected as a learner. Be warm and welcoming. Don’t punish them for mistakes – they</a:t>
            </a:r>
            <a:r>
              <a:rPr lang="en-US" sz="1200" kern="1200" baseline="0" dirty="0" smtClean="0">
                <a:solidFill>
                  <a:schemeClr val="tx1"/>
                </a:solidFill>
                <a:effectLst/>
                <a:latin typeface="+mn-lt"/>
                <a:ea typeface="+mn-ea"/>
                <a:cs typeface="+mn-cs"/>
              </a:rPr>
              <a:t> are here to learn</a:t>
            </a:r>
            <a:r>
              <a:rPr lang="en-US" sz="1200" kern="1200" dirty="0" smtClean="0">
                <a:solidFill>
                  <a:schemeClr val="tx1"/>
                </a:solidFill>
                <a:effectLst/>
                <a:latin typeface="+mn-lt"/>
                <a:ea typeface="+mn-ea"/>
                <a:cs typeface="+mn-cs"/>
              </a:rPr>
              <a:t>.</a:t>
            </a: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kern="1200" dirty="0" smtClean="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i="1" kern="1200" dirty="0" smtClean="0">
                <a:solidFill>
                  <a:schemeClr val="tx1"/>
                </a:solidFill>
                <a:effectLst/>
                <a:latin typeface="+mn-lt"/>
                <a:ea typeface="+mn-ea"/>
                <a:cs typeface="+mn-cs"/>
              </a:rPr>
              <a:t>Image by Mohamed Mahmoud Hassan, retrieved from: https://www.publicdomainpictures.net/pictures/270000/velka/course-classroom.jpg on 5/16/2020. Image is in the public domain.</a:t>
            </a:r>
          </a:p>
        </p:txBody>
      </p:sp>
      <p:sp>
        <p:nvSpPr>
          <p:cNvPr id="4" name="Slide Number Placeholder 3"/>
          <p:cNvSpPr>
            <a:spLocks noGrp="1"/>
          </p:cNvSpPr>
          <p:nvPr>
            <p:ph type="sldNum" sz="quarter" idx="10"/>
          </p:nvPr>
        </p:nvSpPr>
        <p:spPr/>
        <p:txBody>
          <a:bodyPr/>
          <a:lstStyle/>
          <a:p>
            <a:fld id="{D784820F-0CE4-462B-BAD9-E3B4A35DBCAB}" type="slidenum">
              <a:rPr lang="en-US" smtClean="0"/>
              <a:t>22</a:t>
            </a:fld>
            <a:endParaRPr lang="en-US"/>
          </a:p>
        </p:txBody>
      </p:sp>
    </p:spTree>
    <p:extLst>
      <p:ext uri="{BB962C8B-B14F-4D97-AF65-F5344CB8AC3E}">
        <p14:creationId xmlns:p14="http://schemas.microsoft.com/office/powerpoint/2010/main" val="1911096453"/>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It is easier for your trainee to follow along if you start out by letting them know what you are about to cover and what you want them to get out of it. For example, “Let’s talk about how to place an arterial line” or “Let’s discuss </a:t>
            </a:r>
            <a:r>
              <a:rPr lang="en-US" sz="1200" kern="1200" dirty="0" err="1" smtClean="0">
                <a:solidFill>
                  <a:schemeClr val="tx1"/>
                </a:solidFill>
                <a:effectLst/>
                <a:latin typeface="+mn-lt"/>
                <a:ea typeface="+mn-ea"/>
                <a:cs typeface="+mn-cs"/>
              </a:rPr>
              <a:t>pressors</a:t>
            </a:r>
            <a:r>
              <a:rPr lang="en-US" sz="1200" kern="1200" dirty="0" smtClean="0">
                <a:solidFill>
                  <a:schemeClr val="tx1"/>
                </a:solidFill>
                <a:effectLst/>
                <a:latin typeface="+mn-lt"/>
                <a:ea typeface="+mn-ea"/>
                <a:cs typeface="+mn-cs"/>
              </a:rPr>
              <a:t>, specifically phenylephrine and ephedrine”</a:t>
            </a: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kern="1200" dirty="0" smtClean="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i="1" kern="1200" dirty="0" smtClean="0">
                <a:solidFill>
                  <a:schemeClr val="tx1"/>
                </a:solidFill>
                <a:effectLst/>
                <a:latin typeface="+mn-lt"/>
                <a:ea typeface="+mn-ea"/>
                <a:cs typeface="+mn-cs"/>
              </a:rPr>
              <a:t>Image by Suzy Hazelwood, retrieved from: https://www.pexels.com/photo/notebook-1226398/ on 5/16/2020. Image is in the public domain.</a:t>
            </a:r>
          </a:p>
        </p:txBody>
      </p:sp>
      <p:sp>
        <p:nvSpPr>
          <p:cNvPr id="4" name="Slide Number Placeholder 3"/>
          <p:cNvSpPr>
            <a:spLocks noGrp="1"/>
          </p:cNvSpPr>
          <p:nvPr>
            <p:ph type="sldNum" sz="quarter" idx="10"/>
          </p:nvPr>
        </p:nvSpPr>
        <p:spPr/>
        <p:txBody>
          <a:bodyPr/>
          <a:lstStyle/>
          <a:p>
            <a:fld id="{D784820F-0CE4-462B-BAD9-E3B4A35DBCAB}" type="slidenum">
              <a:rPr lang="en-US" smtClean="0"/>
              <a:t>23</a:t>
            </a:fld>
            <a:endParaRPr lang="en-US"/>
          </a:p>
        </p:txBody>
      </p:sp>
    </p:spTree>
    <p:extLst>
      <p:ext uri="{BB962C8B-B14F-4D97-AF65-F5344CB8AC3E}">
        <p14:creationId xmlns:p14="http://schemas.microsoft.com/office/powerpoint/2010/main" val="414769191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Adult learning theory differs from child learning theory. Children have no basis for comparison and accept information a priori (i.e. “This is the color red”). On the other hand, adults learn by relating information back to what they already know. As a teacher, you can promote understanding by </a:t>
            </a:r>
            <a:r>
              <a:rPr lang="en-US" sz="1200" b="1" kern="1200" dirty="0" smtClean="0">
                <a:solidFill>
                  <a:schemeClr val="tx1"/>
                </a:solidFill>
                <a:effectLst/>
                <a:latin typeface="+mn-lt"/>
                <a:ea typeface="+mn-ea"/>
                <a:cs typeface="+mn-cs"/>
              </a:rPr>
              <a:t>activating prior knowledge</a:t>
            </a:r>
            <a:r>
              <a:rPr lang="en-US" sz="1200" kern="1200" dirty="0" smtClean="0">
                <a:solidFill>
                  <a:schemeClr val="tx1"/>
                </a:solidFill>
                <a:effectLst/>
                <a:latin typeface="+mn-lt"/>
                <a:ea typeface="+mn-ea"/>
                <a:cs typeface="+mn-cs"/>
              </a:rPr>
              <a:t>. For example, when talking about atelectasis and lung compliance, ask learners to think about the difficulty of inflating a balloon. The more you can tie a new concept back to something they already know, the better it will stick. Be careful to </a:t>
            </a:r>
            <a:r>
              <a:rPr lang="en-US" sz="1200" b="1" kern="1200" dirty="0" smtClean="0">
                <a:solidFill>
                  <a:schemeClr val="tx1"/>
                </a:solidFill>
                <a:effectLst/>
                <a:latin typeface="+mn-lt"/>
                <a:ea typeface="+mn-ea"/>
                <a:cs typeface="+mn-cs"/>
              </a:rPr>
              <a:t>avoid information overload</a:t>
            </a:r>
            <a:r>
              <a:rPr lang="en-US" sz="1200" kern="1200" dirty="0" smtClean="0">
                <a:solidFill>
                  <a:schemeClr val="tx1"/>
                </a:solidFill>
                <a:effectLst/>
                <a:latin typeface="+mn-lt"/>
                <a:ea typeface="+mn-ea"/>
                <a:cs typeface="+mn-cs"/>
              </a:rPr>
              <a:t>, as discussed above.</a:t>
            </a: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kern="1200" dirty="0" smtClean="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i="1" kern="1200" dirty="0" smtClean="0">
                <a:solidFill>
                  <a:schemeClr val="tx1"/>
                </a:solidFill>
                <a:effectLst/>
                <a:latin typeface="+mn-lt"/>
                <a:ea typeface="+mn-ea"/>
                <a:cs typeface="+mn-cs"/>
              </a:rPr>
              <a:t>Image by Michael Jeffrey, retrieved from: https://unsplash.com/photos/lgCb_XiLgp8 on 5/16/2020. Image is in the public domain.</a:t>
            </a:r>
          </a:p>
        </p:txBody>
      </p:sp>
      <p:sp>
        <p:nvSpPr>
          <p:cNvPr id="4" name="Slide Number Placeholder 3"/>
          <p:cNvSpPr>
            <a:spLocks noGrp="1"/>
          </p:cNvSpPr>
          <p:nvPr>
            <p:ph type="sldNum" sz="quarter" idx="10"/>
          </p:nvPr>
        </p:nvSpPr>
        <p:spPr/>
        <p:txBody>
          <a:bodyPr/>
          <a:lstStyle/>
          <a:p>
            <a:fld id="{D784820F-0CE4-462B-BAD9-E3B4A35DBCAB}" type="slidenum">
              <a:rPr lang="en-US" smtClean="0"/>
              <a:t>24</a:t>
            </a:fld>
            <a:endParaRPr lang="en-US"/>
          </a:p>
        </p:txBody>
      </p:sp>
    </p:spTree>
    <p:extLst>
      <p:ext uri="{BB962C8B-B14F-4D97-AF65-F5344CB8AC3E}">
        <p14:creationId xmlns:p14="http://schemas.microsoft.com/office/powerpoint/2010/main" val="2353533704"/>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i="0" kern="1200" dirty="0" smtClean="0">
                <a:solidFill>
                  <a:schemeClr val="tx1"/>
                </a:solidFill>
                <a:effectLst/>
                <a:latin typeface="+mn-lt"/>
                <a:ea typeface="+mn-ea"/>
                <a:cs typeface="+mn-cs"/>
              </a:rPr>
              <a:t>The types of questions that you ask</a:t>
            </a:r>
            <a:r>
              <a:rPr lang="en-US" sz="1200" i="0" kern="1200" baseline="0" dirty="0" smtClean="0">
                <a:solidFill>
                  <a:schemeClr val="tx1"/>
                </a:solidFill>
                <a:effectLst/>
                <a:latin typeface="+mn-lt"/>
                <a:ea typeface="+mn-ea"/>
                <a:cs typeface="+mn-cs"/>
              </a:rPr>
              <a:t> can be important too.</a:t>
            </a:r>
            <a:endParaRPr lang="en-US" sz="1200" i="0" kern="1200" dirty="0" smtClean="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i="1" kern="1200" dirty="0" smtClean="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i="1" kern="1200" dirty="0" smtClean="0">
                <a:solidFill>
                  <a:schemeClr val="tx1"/>
                </a:solidFill>
                <a:effectLst/>
                <a:latin typeface="+mn-lt"/>
                <a:ea typeface="+mn-ea"/>
                <a:cs typeface="+mn-cs"/>
              </a:rPr>
              <a:t>Image by </a:t>
            </a:r>
            <a:r>
              <a:rPr lang="en-US" sz="1200" i="1" kern="1200" dirty="0" err="1" smtClean="0">
                <a:solidFill>
                  <a:schemeClr val="tx1"/>
                </a:solidFill>
                <a:effectLst/>
                <a:latin typeface="+mn-lt"/>
                <a:ea typeface="+mn-ea"/>
                <a:cs typeface="+mn-cs"/>
              </a:rPr>
              <a:t>Gerd</a:t>
            </a:r>
            <a:r>
              <a:rPr lang="en-US" sz="1200" i="1" kern="1200" dirty="0" smtClean="0">
                <a:solidFill>
                  <a:schemeClr val="tx1"/>
                </a:solidFill>
                <a:effectLst/>
                <a:latin typeface="+mn-lt"/>
                <a:ea typeface="+mn-ea"/>
                <a:cs typeface="+mn-cs"/>
              </a:rPr>
              <a:t> </a:t>
            </a:r>
            <a:r>
              <a:rPr lang="en-US" sz="1200" i="1" kern="1200" dirty="0" err="1" smtClean="0">
                <a:solidFill>
                  <a:schemeClr val="tx1"/>
                </a:solidFill>
                <a:effectLst/>
                <a:latin typeface="+mn-lt"/>
                <a:ea typeface="+mn-ea"/>
                <a:cs typeface="+mn-cs"/>
              </a:rPr>
              <a:t>Altmann</a:t>
            </a:r>
            <a:r>
              <a:rPr lang="en-US" sz="1200" i="1" kern="1200" dirty="0" smtClean="0">
                <a:solidFill>
                  <a:schemeClr val="tx1"/>
                </a:solidFill>
                <a:effectLst/>
                <a:latin typeface="+mn-lt"/>
                <a:ea typeface="+mn-ea"/>
                <a:cs typeface="+mn-cs"/>
              </a:rPr>
              <a:t>, retrieved from: https://www.publicdomainpictures.net/pictures/230000/velka/feedback-1499060362Jgy.jpg on 5/16/2020. Image is in the public domain.</a:t>
            </a:r>
          </a:p>
        </p:txBody>
      </p:sp>
      <p:sp>
        <p:nvSpPr>
          <p:cNvPr id="4" name="Slide Number Placeholder 3"/>
          <p:cNvSpPr>
            <a:spLocks noGrp="1"/>
          </p:cNvSpPr>
          <p:nvPr>
            <p:ph type="sldNum" sz="quarter" idx="10"/>
          </p:nvPr>
        </p:nvSpPr>
        <p:spPr/>
        <p:txBody>
          <a:bodyPr/>
          <a:lstStyle/>
          <a:p>
            <a:fld id="{D784820F-0CE4-462B-BAD9-E3B4A35DBCAB}" type="slidenum">
              <a:rPr lang="en-US" smtClean="0"/>
              <a:t>25</a:t>
            </a:fld>
            <a:endParaRPr lang="en-US"/>
          </a:p>
        </p:txBody>
      </p:sp>
    </p:spTree>
    <p:extLst>
      <p:ext uri="{BB962C8B-B14F-4D97-AF65-F5344CB8AC3E}">
        <p14:creationId xmlns:p14="http://schemas.microsoft.com/office/powerpoint/2010/main" val="2139965912"/>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here are various types of questions you can ask.</a:t>
            </a:r>
          </a:p>
          <a:p>
            <a:r>
              <a:rPr lang="en-US" sz="1200" b="1" kern="1200" dirty="0" smtClean="0">
                <a:solidFill>
                  <a:schemeClr val="tx1"/>
                </a:solidFill>
                <a:effectLst/>
                <a:latin typeface="+mn-lt"/>
                <a:ea typeface="+mn-ea"/>
                <a:cs typeface="+mn-cs"/>
              </a:rPr>
              <a:t>[Small group session – question #6 – types of questions. Ask the audience to explain and provide examples of each type of question (Recall, Synthesis, Application)]</a:t>
            </a:r>
            <a:endParaRPr lang="en-US" sz="1200" kern="1200" dirty="0" smtClean="0">
              <a:solidFill>
                <a:schemeClr val="tx1"/>
              </a:solidFill>
              <a:effectLst/>
              <a:latin typeface="+mn-lt"/>
              <a:ea typeface="+mn-ea"/>
              <a:cs typeface="+mn-cs"/>
            </a:endParaRPr>
          </a:p>
          <a:p>
            <a:r>
              <a:rPr lang="en-US" sz="1200" i="1" kern="1200" dirty="0" smtClean="0">
                <a:solidFill>
                  <a:schemeClr val="tx1"/>
                </a:solidFill>
                <a:effectLst/>
                <a:latin typeface="+mn-lt"/>
                <a:ea typeface="+mn-ea"/>
                <a:cs typeface="+mn-cs"/>
              </a:rPr>
              <a:t>Suggested</a:t>
            </a:r>
            <a:r>
              <a:rPr lang="en-US" sz="1200" i="1" kern="1200" baseline="0" dirty="0" smtClean="0">
                <a:solidFill>
                  <a:schemeClr val="tx1"/>
                </a:solidFill>
                <a:effectLst/>
                <a:latin typeface="+mn-lt"/>
                <a:ea typeface="+mn-ea"/>
                <a:cs typeface="+mn-cs"/>
              </a:rPr>
              <a:t> </a:t>
            </a:r>
            <a:r>
              <a:rPr lang="en-US" sz="1200" i="1" kern="1200" baseline="0" dirty="0" smtClean="0">
                <a:solidFill>
                  <a:schemeClr val="tx1"/>
                </a:solidFill>
                <a:effectLst/>
                <a:latin typeface="+mn-lt"/>
                <a:ea typeface="+mn-ea"/>
                <a:cs typeface="+mn-cs"/>
              </a:rPr>
              <a:t>examples:</a:t>
            </a:r>
            <a:endParaRPr lang="en-US" sz="1200" i="1" kern="1200" dirty="0" smtClean="0">
              <a:solidFill>
                <a:schemeClr val="tx1"/>
              </a:solidFill>
              <a:effectLst/>
              <a:latin typeface="+mn-lt"/>
              <a:ea typeface="+mn-ea"/>
              <a:cs typeface="+mn-cs"/>
            </a:endParaRPr>
          </a:p>
          <a:p>
            <a:pPr lvl="0"/>
            <a:r>
              <a:rPr lang="en-US" sz="1200" b="1" i="1" kern="1200" dirty="0" smtClean="0">
                <a:solidFill>
                  <a:schemeClr val="tx1"/>
                </a:solidFill>
                <a:effectLst/>
                <a:latin typeface="+mn-lt"/>
                <a:ea typeface="+mn-ea"/>
                <a:cs typeface="+mn-cs"/>
              </a:rPr>
              <a:t>Recall</a:t>
            </a:r>
            <a:r>
              <a:rPr lang="en-US" sz="1200" i="1" kern="1200" dirty="0" smtClean="0">
                <a:solidFill>
                  <a:schemeClr val="tx1"/>
                </a:solidFill>
                <a:effectLst/>
                <a:latin typeface="+mn-lt"/>
                <a:ea typeface="+mn-ea"/>
                <a:cs typeface="+mn-cs"/>
              </a:rPr>
              <a:t>: “What are the criteria for severe aortic stenosis?”</a:t>
            </a:r>
          </a:p>
          <a:p>
            <a:pPr lvl="0"/>
            <a:r>
              <a:rPr lang="en-US" sz="1200" b="1" i="1" kern="1200" dirty="0" smtClean="0">
                <a:solidFill>
                  <a:schemeClr val="tx1"/>
                </a:solidFill>
                <a:effectLst/>
                <a:latin typeface="+mn-lt"/>
                <a:ea typeface="+mn-ea"/>
                <a:cs typeface="+mn-cs"/>
              </a:rPr>
              <a:t>Synthesis</a:t>
            </a:r>
            <a:r>
              <a:rPr lang="en-US" sz="1200" i="1" kern="1200" dirty="0" smtClean="0">
                <a:solidFill>
                  <a:schemeClr val="tx1"/>
                </a:solidFill>
                <a:effectLst/>
                <a:latin typeface="+mn-lt"/>
                <a:ea typeface="+mn-ea"/>
                <a:cs typeface="+mn-cs"/>
              </a:rPr>
              <a:t>: “What will happen to the left ventricle</a:t>
            </a:r>
            <a:r>
              <a:rPr lang="en-US" sz="1200" i="1" kern="1200" baseline="0" dirty="0" smtClean="0">
                <a:solidFill>
                  <a:schemeClr val="tx1"/>
                </a:solidFill>
                <a:effectLst/>
                <a:latin typeface="+mn-lt"/>
                <a:ea typeface="+mn-ea"/>
                <a:cs typeface="+mn-cs"/>
              </a:rPr>
              <a:t> with longstanding severe aortic stenosis</a:t>
            </a:r>
            <a:r>
              <a:rPr lang="en-US" sz="1200" i="1" kern="1200" dirty="0" smtClean="0">
                <a:solidFill>
                  <a:schemeClr val="tx1"/>
                </a:solidFill>
                <a:effectLst/>
                <a:latin typeface="+mn-lt"/>
                <a:ea typeface="+mn-ea"/>
                <a:cs typeface="+mn-cs"/>
              </a:rPr>
              <a:t>?”</a:t>
            </a:r>
          </a:p>
          <a:p>
            <a:pPr lvl="0"/>
            <a:r>
              <a:rPr lang="en-US" sz="1200" b="1" i="1" kern="1200" dirty="0" smtClean="0">
                <a:solidFill>
                  <a:schemeClr val="tx1"/>
                </a:solidFill>
                <a:effectLst/>
                <a:latin typeface="+mn-lt"/>
                <a:ea typeface="+mn-ea"/>
                <a:cs typeface="+mn-cs"/>
              </a:rPr>
              <a:t>Application</a:t>
            </a:r>
            <a:r>
              <a:rPr lang="en-US" sz="1200" i="1" kern="1200" dirty="0" smtClean="0">
                <a:solidFill>
                  <a:schemeClr val="tx1"/>
                </a:solidFill>
                <a:effectLst/>
                <a:latin typeface="+mn-lt"/>
                <a:ea typeface="+mn-ea"/>
                <a:cs typeface="+mn-cs"/>
              </a:rPr>
              <a:t>: “What are your hemodynamic goals for a patient with severe aortic stenosis?”</a:t>
            </a:r>
          </a:p>
          <a:p>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Recall questions are the easiest ones to ask since they are essentially fact regurgitation.</a:t>
            </a:r>
          </a:p>
          <a:p>
            <a:r>
              <a:rPr lang="en-US" sz="1200" kern="1200" dirty="0" smtClean="0">
                <a:solidFill>
                  <a:schemeClr val="tx1"/>
                </a:solidFill>
                <a:effectLst/>
                <a:latin typeface="+mn-lt"/>
                <a:ea typeface="+mn-ea"/>
                <a:cs typeface="+mn-cs"/>
              </a:rPr>
              <a:t>Effective teachers will attempt to use higher-order Synthesis and Application questions to challenge learners to think more deeply and form those mental connections.</a:t>
            </a:r>
          </a:p>
          <a:p>
            <a:endParaRPr lang="en-US" sz="1200" kern="1200" dirty="0" smtClean="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i="1" dirty="0" smtClean="0"/>
              <a:t>Image by </a:t>
            </a:r>
            <a:r>
              <a:rPr lang="en-US" i="1" dirty="0" err="1" smtClean="0"/>
              <a:t>Pixabay</a:t>
            </a:r>
            <a:r>
              <a:rPr lang="en-US" i="1" dirty="0" smtClean="0"/>
              <a:t>, retrieved from: https://www.pexels.com/photo/analysis-blackboard-board-bubble-355952/ on 5/16/2020. Image is in the public domain.</a:t>
            </a:r>
          </a:p>
        </p:txBody>
      </p:sp>
      <p:sp>
        <p:nvSpPr>
          <p:cNvPr id="4" name="Slide Number Placeholder 3"/>
          <p:cNvSpPr>
            <a:spLocks noGrp="1"/>
          </p:cNvSpPr>
          <p:nvPr>
            <p:ph type="sldNum" sz="quarter" idx="10"/>
          </p:nvPr>
        </p:nvSpPr>
        <p:spPr/>
        <p:txBody>
          <a:bodyPr/>
          <a:lstStyle/>
          <a:p>
            <a:fld id="{D784820F-0CE4-462B-BAD9-E3B4A35DBCAB}" type="slidenum">
              <a:rPr lang="en-US" smtClean="0"/>
              <a:t>26</a:t>
            </a:fld>
            <a:endParaRPr lang="en-US"/>
          </a:p>
        </p:txBody>
      </p:sp>
    </p:spTree>
    <p:extLst>
      <p:ext uri="{BB962C8B-B14F-4D97-AF65-F5344CB8AC3E}">
        <p14:creationId xmlns:p14="http://schemas.microsoft.com/office/powerpoint/2010/main" val="3887009214"/>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Ensure that there is two-way communication so that you and your trainee remain on the same page. Did that make sense? Am I moving too quickly? Is this too simple?</a:t>
            </a: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kern="1200" dirty="0" smtClean="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i="1" kern="1200" dirty="0" smtClean="0">
                <a:solidFill>
                  <a:schemeClr val="tx1"/>
                </a:solidFill>
                <a:effectLst/>
                <a:latin typeface="+mn-lt"/>
                <a:ea typeface="+mn-ea"/>
                <a:cs typeface="+mn-cs"/>
              </a:rPr>
              <a:t>Image by Mohamed Mahmoud Hassan, retrieved from: https://www.publicdomainpictures.net/pictures/280000/velka/customer-satisfaction-survey.jpg on 5/16/2020. Image is in the public domain.</a:t>
            </a:r>
          </a:p>
        </p:txBody>
      </p:sp>
      <p:sp>
        <p:nvSpPr>
          <p:cNvPr id="4" name="Slide Number Placeholder 3"/>
          <p:cNvSpPr>
            <a:spLocks noGrp="1"/>
          </p:cNvSpPr>
          <p:nvPr>
            <p:ph type="sldNum" sz="quarter" idx="10"/>
          </p:nvPr>
        </p:nvSpPr>
        <p:spPr/>
        <p:txBody>
          <a:bodyPr/>
          <a:lstStyle/>
          <a:p>
            <a:fld id="{D784820F-0CE4-462B-BAD9-E3B4A35DBCAB}" type="slidenum">
              <a:rPr lang="en-US" smtClean="0"/>
              <a:t>27</a:t>
            </a:fld>
            <a:endParaRPr lang="en-US"/>
          </a:p>
        </p:txBody>
      </p:sp>
    </p:spTree>
    <p:extLst>
      <p:ext uri="{BB962C8B-B14F-4D97-AF65-F5344CB8AC3E}">
        <p14:creationId xmlns:p14="http://schemas.microsoft.com/office/powerpoint/2010/main" val="1251750953"/>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smtClean="0"/>
              <a:t>[Small</a:t>
            </a:r>
            <a:r>
              <a:rPr lang="en-US" b="1" baseline="0" dirty="0" smtClean="0"/>
              <a:t> group session – question #7 – microteaching</a:t>
            </a:r>
            <a:r>
              <a:rPr lang="en-US" b="1" dirty="0" smtClean="0"/>
              <a:t>]</a:t>
            </a:r>
            <a:endParaRPr lang="en-US" b="0" dirty="0" smtClean="0"/>
          </a:p>
          <a:p>
            <a:r>
              <a:rPr lang="en-US" sz="1200" i="1" kern="1200" dirty="0" smtClean="0">
                <a:solidFill>
                  <a:schemeClr val="tx1"/>
                </a:solidFill>
                <a:effectLst/>
                <a:latin typeface="+mn-lt"/>
                <a:ea typeface="+mn-ea"/>
                <a:cs typeface="+mn-cs"/>
              </a:rPr>
              <a:t>(Allow residents a few minutes to individually write down a topic for question #7. Ask residents to break into pairs. Each person will practice microteaching for 5 minutes to their partner and then their partner will provide feedback (2 minutes) using the above framework. The preceptor should notify residents when the 5 minutes are up and then ask residents to provide feedback for 2 minutes. Then ask residents to switch roles and repeat.)</a:t>
            </a:r>
            <a:endParaRPr lang="en-US" sz="1200" kern="1200" dirty="0" smtClean="0">
              <a:solidFill>
                <a:schemeClr val="tx1"/>
              </a:solidFill>
              <a:effectLst/>
              <a:latin typeface="+mn-lt"/>
              <a:ea typeface="+mn-ea"/>
              <a:cs typeface="+mn-cs"/>
            </a:endParaRPr>
          </a:p>
          <a:p>
            <a:endParaRPr lang="en-US" b="0" i="0" dirty="0" smtClean="0"/>
          </a:p>
          <a:p>
            <a:r>
              <a:rPr lang="en-US" b="0" i="0" dirty="0" smtClean="0"/>
              <a:t>How did that feel</a:t>
            </a:r>
            <a:r>
              <a:rPr lang="en-US" b="0" i="0" dirty="0" smtClean="0"/>
              <a:t>?</a:t>
            </a:r>
          </a:p>
          <a:p>
            <a:pPr marL="0" marR="0" indent="0" algn="l" defTabSz="914400" rtl="0" eaLnBrk="1" fontAlgn="auto" latinLnBrk="0" hangingPunct="1">
              <a:lnSpc>
                <a:spcPct val="100000"/>
              </a:lnSpc>
              <a:spcBef>
                <a:spcPts val="0"/>
              </a:spcBef>
              <a:spcAft>
                <a:spcPts val="0"/>
              </a:spcAft>
              <a:buClrTx/>
              <a:buSzTx/>
              <a:buFontTx/>
              <a:buNone/>
              <a:tabLst/>
              <a:defRPr/>
            </a:pPr>
            <a:r>
              <a:rPr lang="en-US" sz="1200" i="1" kern="1200" dirty="0" smtClean="0">
                <a:solidFill>
                  <a:schemeClr val="tx1"/>
                </a:solidFill>
                <a:effectLst/>
                <a:latin typeface="+mn-lt"/>
                <a:ea typeface="+mn-ea"/>
                <a:cs typeface="+mn-cs"/>
              </a:rPr>
              <a:t>(Solicit feedback from residents</a:t>
            </a:r>
            <a:r>
              <a:rPr lang="en-US" sz="1200" b="0" i="1" kern="1200" dirty="0" smtClean="0">
                <a:solidFill>
                  <a:schemeClr val="tx1"/>
                </a:solidFill>
                <a:effectLst/>
                <a:latin typeface="+mn-lt"/>
                <a:ea typeface="+mn-ea"/>
                <a:cs typeface="+mn-cs"/>
              </a:rPr>
              <a:t>)</a:t>
            </a:r>
            <a:endParaRPr lang="en-US" sz="1200" i="1" kern="1200" dirty="0" smtClean="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D784820F-0CE4-462B-BAD9-E3B4A35DBCAB}" type="slidenum">
              <a:rPr lang="en-US" smtClean="0"/>
              <a:t>28</a:t>
            </a:fld>
            <a:endParaRPr lang="en-US"/>
          </a:p>
        </p:txBody>
      </p:sp>
    </p:spTree>
    <p:extLst>
      <p:ext uri="{BB962C8B-B14F-4D97-AF65-F5344CB8AC3E}">
        <p14:creationId xmlns:p14="http://schemas.microsoft.com/office/powerpoint/2010/main" val="2624220287"/>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smtClean="0"/>
              <a:t>(Offer to take a break before the second hour)</a:t>
            </a:r>
            <a:endParaRPr lang="en-US" i="1" dirty="0"/>
          </a:p>
        </p:txBody>
      </p:sp>
      <p:sp>
        <p:nvSpPr>
          <p:cNvPr id="4" name="Slide Number Placeholder 3"/>
          <p:cNvSpPr>
            <a:spLocks noGrp="1"/>
          </p:cNvSpPr>
          <p:nvPr>
            <p:ph type="sldNum" sz="quarter" idx="10"/>
          </p:nvPr>
        </p:nvSpPr>
        <p:spPr/>
        <p:txBody>
          <a:bodyPr/>
          <a:lstStyle/>
          <a:p>
            <a:fld id="{D784820F-0CE4-462B-BAD9-E3B4A35DBCAB}" type="slidenum">
              <a:rPr lang="en-US" smtClean="0"/>
              <a:t>31</a:t>
            </a:fld>
            <a:endParaRPr lang="en-US"/>
          </a:p>
        </p:txBody>
      </p:sp>
    </p:spTree>
    <p:extLst>
      <p:ext uri="{BB962C8B-B14F-4D97-AF65-F5344CB8AC3E}">
        <p14:creationId xmlns:p14="http://schemas.microsoft.com/office/powerpoint/2010/main" val="236308798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During</a:t>
            </a:r>
            <a:r>
              <a:rPr lang="en-US" baseline="0" dirty="0" smtClean="0"/>
              <a:t> the first hour, we will focus on the first three items here: cognitive load theory, general principles of effective teaching, and a framework for evaluating the quality of teaching. During the second hour, we will discuss and practice </a:t>
            </a:r>
            <a:r>
              <a:rPr lang="en-US" baseline="0" dirty="0" err="1" smtClean="0"/>
              <a:t>microskills</a:t>
            </a:r>
            <a:r>
              <a:rPr lang="en-US" baseline="0" dirty="0" smtClean="0"/>
              <a:t>.</a:t>
            </a:r>
            <a:endParaRPr lang="en-US" dirty="0"/>
          </a:p>
        </p:txBody>
      </p:sp>
      <p:sp>
        <p:nvSpPr>
          <p:cNvPr id="4" name="Slide Number Placeholder 3"/>
          <p:cNvSpPr>
            <a:spLocks noGrp="1"/>
          </p:cNvSpPr>
          <p:nvPr>
            <p:ph type="sldNum" sz="quarter" idx="10"/>
          </p:nvPr>
        </p:nvSpPr>
        <p:spPr/>
        <p:txBody>
          <a:bodyPr/>
          <a:lstStyle/>
          <a:p>
            <a:fld id="{D784820F-0CE4-462B-BAD9-E3B4A35DBCAB}" type="slidenum">
              <a:rPr lang="en-US" smtClean="0"/>
              <a:t>3</a:t>
            </a:fld>
            <a:endParaRPr lang="en-US"/>
          </a:p>
        </p:txBody>
      </p:sp>
    </p:spTree>
    <p:extLst>
      <p:ext uri="{BB962C8B-B14F-4D97-AF65-F5344CB8AC3E}">
        <p14:creationId xmlns:p14="http://schemas.microsoft.com/office/powerpoint/2010/main" val="3816877832"/>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or</a:t>
            </a:r>
            <a:r>
              <a:rPr lang="en-US" baseline="0" dirty="0" smtClean="0"/>
              <a:t> this second hour we are going to focus on </a:t>
            </a:r>
            <a:r>
              <a:rPr lang="en-US" baseline="0" dirty="0" err="1" smtClean="0"/>
              <a:t>microskills</a:t>
            </a:r>
            <a:r>
              <a:rPr lang="en-US" baseline="0" dirty="0" smtClean="0"/>
              <a:t>, otherwise known as the one-minute preceptor. Other frameworks for teaching exist; we have decided to focus on </a:t>
            </a:r>
            <a:r>
              <a:rPr lang="en-US" baseline="0" dirty="0" err="1" smtClean="0"/>
              <a:t>microskills</a:t>
            </a:r>
            <a:r>
              <a:rPr lang="en-US" baseline="0" dirty="0" smtClean="0"/>
              <a:t> in particular as it has been well-studied with plenty of literature to show its effectiveness in the clinical setting.</a:t>
            </a:r>
            <a:endParaRPr lang="en-US" dirty="0"/>
          </a:p>
        </p:txBody>
      </p:sp>
      <p:sp>
        <p:nvSpPr>
          <p:cNvPr id="4" name="Slide Number Placeholder 3"/>
          <p:cNvSpPr>
            <a:spLocks noGrp="1"/>
          </p:cNvSpPr>
          <p:nvPr>
            <p:ph type="sldNum" sz="quarter" idx="10"/>
          </p:nvPr>
        </p:nvSpPr>
        <p:spPr/>
        <p:txBody>
          <a:bodyPr/>
          <a:lstStyle/>
          <a:p>
            <a:fld id="{D784820F-0CE4-462B-BAD9-E3B4A35DBCAB}" type="slidenum">
              <a:rPr lang="en-US" smtClean="0"/>
              <a:t>33</a:t>
            </a:fld>
            <a:endParaRPr lang="en-US"/>
          </a:p>
        </p:txBody>
      </p:sp>
    </p:spTree>
    <p:extLst>
      <p:ext uri="{BB962C8B-B14F-4D97-AF65-F5344CB8AC3E}">
        <p14:creationId xmlns:p14="http://schemas.microsoft.com/office/powerpoint/2010/main" val="2953014099"/>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nk</a:t>
            </a:r>
            <a:r>
              <a:rPr lang="en-US" baseline="0" dirty="0" smtClean="0"/>
              <a:t> </a:t>
            </a:r>
            <a:r>
              <a:rPr lang="en-US" baseline="0" dirty="0"/>
              <a:t>of this as another tool for your toolbox – it may not be the best way to teach every single </a:t>
            </a:r>
            <a:r>
              <a:rPr lang="en-US" baseline="0" dirty="0" smtClean="0"/>
              <a:t>topic, </a:t>
            </a:r>
            <a:r>
              <a:rPr lang="en-US" baseline="0" dirty="0"/>
              <a:t>but it fills a useful niche</a:t>
            </a:r>
            <a:r>
              <a:rPr lang="en-US" baseline="0" dirty="0" smtClean="0"/>
              <a:t>.</a:t>
            </a:r>
          </a:p>
          <a:p>
            <a:endParaRPr lang="en-US" baseline="0" dirty="0" smtClean="0"/>
          </a:p>
          <a:p>
            <a:r>
              <a:rPr lang="en-US" i="1" dirty="0" smtClean="0"/>
              <a:t>Image by </a:t>
            </a:r>
            <a:r>
              <a:rPr lang="en-US" i="1" dirty="0" err="1" smtClean="0"/>
              <a:t>Tekton</a:t>
            </a:r>
            <a:r>
              <a:rPr lang="en-US" i="1" dirty="0" smtClean="0"/>
              <a:t>, retrieved from: https://unsplash.com/photos/EcE9dFfXwwE on 5/16/2020. Image is in the public domain.</a:t>
            </a:r>
            <a:endParaRPr lang="en-US" i="1" dirty="0"/>
          </a:p>
        </p:txBody>
      </p:sp>
      <p:sp>
        <p:nvSpPr>
          <p:cNvPr id="4" name="Slide Number Placeholder 3"/>
          <p:cNvSpPr>
            <a:spLocks noGrp="1"/>
          </p:cNvSpPr>
          <p:nvPr>
            <p:ph type="sldNum" sz="quarter" idx="10"/>
          </p:nvPr>
        </p:nvSpPr>
        <p:spPr/>
        <p:txBody>
          <a:bodyPr/>
          <a:lstStyle/>
          <a:p>
            <a:fld id="{D784820F-0CE4-462B-BAD9-E3B4A35DBCAB}" type="slidenum">
              <a:rPr lang="en-US" smtClean="0"/>
              <a:t>35</a:t>
            </a:fld>
            <a:endParaRPr lang="en-US"/>
          </a:p>
        </p:txBody>
      </p:sp>
    </p:spTree>
    <p:extLst>
      <p:ext uri="{BB962C8B-B14F-4D97-AF65-F5344CB8AC3E}">
        <p14:creationId xmlns:p14="http://schemas.microsoft.com/office/powerpoint/2010/main" val="2565135984"/>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b="0" kern="1200" dirty="0" smtClean="0">
                <a:solidFill>
                  <a:schemeClr val="tx1"/>
                </a:solidFill>
                <a:effectLst/>
                <a:latin typeface="+mn-lt"/>
                <a:ea typeface="+mn-ea"/>
                <a:cs typeface="+mn-cs"/>
              </a:rPr>
              <a:t>There are papers from multiple specialties and disciplines showing that </a:t>
            </a:r>
            <a:r>
              <a:rPr lang="en-US" sz="1200" b="0" kern="1200" dirty="0" err="1" smtClean="0">
                <a:solidFill>
                  <a:schemeClr val="tx1"/>
                </a:solidFill>
                <a:effectLst/>
                <a:latin typeface="+mn-lt"/>
                <a:ea typeface="+mn-ea"/>
                <a:cs typeface="+mn-cs"/>
              </a:rPr>
              <a:t>microskills</a:t>
            </a:r>
            <a:r>
              <a:rPr lang="en-US" sz="1200" b="0" kern="1200" baseline="0" dirty="0" smtClean="0">
                <a:solidFill>
                  <a:schemeClr val="tx1"/>
                </a:solidFill>
                <a:effectLst/>
                <a:latin typeface="+mn-lt"/>
                <a:ea typeface="+mn-ea"/>
                <a:cs typeface="+mn-cs"/>
              </a:rPr>
              <a:t> has wide applicability.</a:t>
            </a:r>
            <a:endParaRPr lang="en-US" sz="1200" b="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D784820F-0CE4-462B-BAD9-E3B4A35DBCAB}" type="slidenum">
              <a:rPr lang="en-US" smtClean="0"/>
              <a:t>36</a:t>
            </a:fld>
            <a:endParaRPr lang="en-US"/>
          </a:p>
        </p:txBody>
      </p:sp>
    </p:spTree>
    <p:extLst>
      <p:ext uri="{BB962C8B-B14F-4D97-AF65-F5344CB8AC3E}">
        <p14:creationId xmlns:p14="http://schemas.microsoft.com/office/powerpoint/2010/main" val="3049169993"/>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b="0" kern="1200" dirty="0" smtClean="0">
                <a:solidFill>
                  <a:schemeClr val="tx1"/>
                </a:solidFill>
                <a:effectLst/>
                <a:latin typeface="+mn-lt"/>
                <a:ea typeface="+mn-ea"/>
                <a:cs typeface="+mn-cs"/>
              </a:rPr>
              <a:t>We</a:t>
            </a:r>
            <a:r>
              <a:rPr lang="en-US" sz="1200" b="0" kern="1200" baseline="0" dirty="0" smtClean="0">
                <a:solidFill>
                  <a:schemeClr val="tx1"/>
                </a:solidFill>
                <a:effectLst/>
                <a:latin typeface="+mn-lt"/>
                <a:ea typeface="+mn-ea"/>
                <a:cs typeface="+mn-cs"/>
              </a:rPr>
              <a:t> also have evidence to show that the students learn better and have a better experience when their preceptors use </a:t>
            </a:r>
            <a:r>
              <a:rPr lang="en-US" sz="1200" b="0" kern="1200" baseline="0" dirty="0" err="1" smtClean="0">
                <a:solidFill>
                  <a:schemeClr val="tx1"/>
                </a:solidFill>
                <a:effectLst/>
                <a:latin typeface="+mn-lt"/>
                <a:ea typeface="+mn-ea"/>
                <a:cs typeface="+mn-cs"/>
              </a:rPr>
              <a:t>microskills</a:t>
            </a:r>
            <a:r>
              <a:rPr lang="en-US" sz="1200" b="0" kern="1200" baseline="0" dirty="0" smtClean="0">
                <a:solidFill>
                  <a:schemeClr val="tx1"/>
                </a:solidFill>
                <a:effectLst/>
                <a:latin typeface="+mn-lt"/>
                <a:ea typeface="+mn-ea"/>
                <a:cs typeface="+mn-cs"/>
              </a:rPr>
              <a:t>.</a:t>
            </a:r>
            <a:endParaRPr lang="en-US" sz="1200" b="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D784820F-0CE4-462B-BAD9-E3B4A35DBCAB}" type="slidenum">
              <a:rPr lang="en-US" smtClean="0"/>
              <a:t>37</a:t>
            </a:fld>
            <a:endParaRPr lang="en-US"/>
          </a:p>
        </p:txBody>
      </p:sp>
    </p:spTree>
    <p:extLst>
      <p:ext uri="{BB962C8B-B14F-4D97-AF65-F5344CB8AC3E}">
        <p14:creationId xmlns:p14="http://schemas.microsoft.com/office/powerpoint/2010/main" val="3522402990"/>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b="0" kern="1200" dirty="0" err="1" smtClean="0">
                <a:solidFill>
                  <a:schemeClr val="tx1"/>
                </a:solidFill>
                <a:effectLst/>
                <a:latin typeface="+mn-lt"/>
                <a:ea typeface="+mn-ea"/>
                <a:cs typeface="+mn-cs"/>
              </a:rPr>
              <a:t>Microskills</a:t>
            </a:r>
            <a:r>
              <a:rPr lang="en-US" sz="1200" b="0" kern="1200" baseline="0" dirty="0" smtClean="0">
                <a:solidFill>
                  <a:schemeClr val="tx1"/>
                </a:solidFill>
                <a:effectLst/>
                <a:latin typeface="+mn-lt"/>
                <a:ea typeface="+mn-ea"/>
                <a:cs typeface="+mn-cs"/>
              </a:rPr>
              <a:t> have been shown to improve resident teaching.</a:t>
            </a:r>
            <a:endParaRPr lang="en-US" sz="1200" b="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D784820F-0CE4-462B-BAD9-E3B4A35DBCAB}" type="slidenum">
              <a:rPr lang="en-US" smtClean="0"/>
              <a:t>38</a:t>
            </a:fld>
            <a:endParaRPr lang="en-US"/>
          </a:p>
        </p:txBody>
      </p:sp>
    </p:spTree>
    <p:extLst>
      <p:ext uri="{BB962C8B-B14F-4D97-AF65-F5344CB8AC3E}">
        <p14:creationId xmlns:p14="http://schemas.microsoft.com/office/powerpoint/2010/main" val="1796198679"/>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smtClean="0"/>
          </a:p>
        </p:txBody>
      </p:sp>
      <p:sp>
        <p:nvSpPr>
          <p:cNvPr id="4" name="Slide Number Placeholder 3"/>
          <p:cNvSpPr>
            <a:spLocks noGrp="1"/>
          </p:cNvSpPr>
          <p:nvPr>
            <p:ph type="sldNum" sz="quarter" idx="10"/>
          </p:nvPr>
        </p:nvSpPr>
        <p:spPr/>
        <p:txBody>
          <a:bodyPr/>
          <a:lstStyle/>
          <a:p>
            <a:fld id="{D784820F-0CE4-462B-BAD9-E3B4A35DBCAB}" type="slidenum">
              <a:rPr lang="en-US" smtClean="0"/>
              <a:t>39</a:t>
            </a:fld>
            <a:endParaRPr lang="en-US"/>
          </a:p>
        </p:txBody>
      </p:sp>
    </p:spTree>
    <p:extLst>
      <p:ext uri="{BB962C8B-B14F-4D97-AF65-F5344CB8AC3E}">
        <p14:creationId xmlns:p14="http://schemas.microsoft.com/office/powerpoint/2010/main" val="322032526"/>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Here are the five steps.</a:t>
            </a:r>
            <a:endParaRPr lang="en-US" dirty="0"/>
          </a:p>
        </p:txBody>
      </p:sp>
      <p:sp>
        <p:nvSpPr>
          <p:cNvPr id="4" name="Slide Number Placeholder 3"/>
          <p:cNvSpPr>
            <a:spLocks noGrp="1"/>
          </p:cNvSpPr>
          <p:nvPr>
            <p:ph type="sldNum" sz="quarter" idx="10"/>
          </p:nvPr>
        </p:nvSpPr>
        <p:spPr/>
        <p:txBody>
          <a:bodyPr/>
          <a:lstStyle/>
          <a:p>
            <a:fld id="{D784820F-0CE4-462B-BAD9-E3B4A35DBCAB}" type="slidenum">
              <a:rPr lang="en-US" smtClean="0"/>
              <a:t>40</a:t>
            </a:fld>
            <a:endParaRPr lang="en-US"/>
          </a:p>
        </p:txBody>
      </p:sp>
    </p:spTree>
    <p:extLst>
      <p:ext uri="{BB962C8B-B14F-4D97-AF65-F5344CB8AC3E}">
        <p14:creationId xmlns:p14="http://schemas.microsoft.com/office/powerpoint/2010/main" val="2516441789"/>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Let’s</a:t>
            </a:r>
            <a:r>
              <a:rPr lang="en-US" baseline="0" dirty="0" smtClean="0"/>
              <a:t> use an example as we explain these 5 steps.</a:t>
            </a:r>
            <a:endParaRPr lang="en-US" dirty="0"/>
          </a:p>
        </p:txBody>
      </p:sp>
      <p:sp>
        <p:nvSpPr>
          <p:cNvPr id="4" name="Slide Number Placeholder 3"/>
          <p:cNvSpPr>
            <a:spLocks noGrp="1"/>
          </p:cNvSpPr>
          <p:nvPr>
            <p:ph type="sldNum" sz="quarter" idx="10"/>
          </p:nvPr>
        </p:nvSpPr>
        <p:spPr/>
        <p:txBody>
          <a:bodyPr/>
          <a:lstStyle/>
          <a:p>
            <a:fld id="{D784820F-0CE4-462B-BAD9-E3B4A35DBCAB}" type="slidenum">
              <a:rPr lang="en-US" smtClean="0"/>
              <a:t>41</a:t>
            </a:fld>
            <a:endParaRPr lang="en-US"/>
          </a:p>
        </p:txBody>
      </p:sp>
    </p:spTree>
    <p:extLst>
      <p:ext uri="{BB962C8B-B14F-4D97-AF65-F5344CB8AC3E}">
        <p14:creationId xmlns:p14="http://schemas.microsoft.com/office/powerpoint/2010/main" val="3722592728"/>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sk your trainee to </a:t>
            </a:r>
            <a:r>
              <a:rPr lang="en-US" sz="1200" kern="1200" dirty="0" smtClean="0">
                <a:solidFill>
                  <a:schemeClr val="tx1"/>
                </a:solidFill>
                <a:effectLst/>
                <a:latin typeface="+mn-lt"/>
                <a:ea typeface="+mn-ea"/>
                <a:cs typeface="+mn-cs"/>
              </a:rPr>
              <a:t>commit to a </a:t>
            </a:r>
            <a:r>
              <a:rPr lang="en-US" sz="1200" kern="1200" dirty="0">
                <a:solidFill>
                  <a:schemeClr val="tx1"/>
                </a:solidFill>
                <a:effectLst/>
                <a:latin typeface="+mn-lt"/>
                <a:ea typeface="+mn-ea"/>
                <a:cs typeface="+mn-cs"/>
              </a:rPr>
              <a:t>possible explanation. It’s okay if it turns out that they are incorrect</a:t>
            </a:r>
            <a:r>
              <a:rPr lang="en-US" sz="1200" kern="1200" dirty="0" smtClean="0">
                <a:solidFill>
                  <a:schemeClr val="tx1"/>
                </a:solidFill>
                <a:effectLst/>
                <a:latin typeface="+mn-lt"/>
                <a:ea typeface="+mn-ea"/>
                <a:cs typeface="+mn-cs"/>
              </a:rPr>
              <a:t>. In fact, it</a:t>
            </a:r>
            <a:r>
              <a:rPr lang="en-US" sz="1200" kern="1200" baseline="0" dirty="0" smtClean="0">
                <a:solidFill>
                  <a:schemeClr val="tx1"/>
                </a:solidFill>
                <a:effectLst/>
                <a:latin typeface="+mn-lt"/>
                <a:ea typeface="+mn-ea"/>
                <a:cs typeface="+mn-cs"/>
              </a:rPr>
              <a:t> works even better if they are incorrect.</a:t>
            </a:r>
            <a:r>
              <a:rPr lang="en-US" sz="1200" kern="1200" dirty="0" smtClean="0">
                <a:solidFill>
                  <a:schemeClr val="tx1"/>
                </a:solidFill>
                <a:effectLst/>
                <a:latin typeface="+mn-lt"/>
                <a:ea typeface="+mn-ea"/>
                <a:cs typeface="+mn-cs"/>
              </a:rPr>
              <a:t> </a:t>
            </a:r>
            <a:r>
              <a:rPr lang="en-US" sz="1200" kern="1200" dirty="0">
                <a:solidFill>
                  <a:schemeClr val="tx1"/>
                </a:solidFill>
                <a:effectLst/>
                <a:latin typeface="+mn-lt"/>
                <a:ea typeface="+mn-ea"/>
                <a:cs typeface="+mn-cs"/>
              </a:rPr>
              <a:t>The purpose of the exercise is to develop their critical thinking skills.</a:t>
            </a:r>
          </a:p>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What do you think is going on with this patient?"</a:t>
            </a:r>
          </a:p>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What do you think the main problem is here?"</a:t>
            </a:r>
          </a:p>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What complaint is the most important to focus on during this visit?"</a:t>
            </a:r>
          </a:p>
        </p:txBody>
      </p:sp>
      <p:sp>
        <p:nvSpPr>
          <p:cNvPr id="4" name="Slide Number Placeholder 3"/>
          <p:cNvSpPr>
            <a:spLocks noGrp="1"/>
          </p:cNvSpPr>
          <p:nvPr>
            <p:ph type="sldNum" sz="quarter" idx="10"/>
          </p:nvPr>
        </p:nvSpPr>
        <p:spPr/>
        <p:txBody>
          <a:bodyPr/>
          <a:lstStyle/>
          <a:p>
            <a:fld id="{D784820F-0CE4-462B-BAD9-E3B4A35DBCAB}" type="slidenum">
              <a:rPr lang="en-US" smtClean="0"/>
              <a:t>42</a:t>
            </a:fld>
            <a:endParaRPr lang="en-US"/>
          </a:p>
        </p:txBody>
      </p:sp>
    </p:spTree>
    <p:extLst>
      <p:ext uri="{BB962C8B-B14F-4D97-AF65-F5344CB8AC3E}">
        <p14:creationId xmlns:p14="http://schemas.microsoft.com/office/powerpoint/2010/main" val="1315211352"/>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sk your trainee to look for clinical evidence that supports or argues against their hypothesis. Remember, this is still the fact-gathering stage – do not confirm or deny </a:t>
            </a:r>
            <a:r>
              <a:rPr lang="en-US" sz="1200" kern="1200" dirty="0" smtClean="0">
                <a:solidFill>
                  <a:schemeClr val="tx1"/>
                </a:solidFill>
                <a:effectLst/>
                <a:latin typeface="+mn-lt"/>
                <a:ea typeface="+mn-ea"/>
                <a:cs typeface="+mn-cs"/>
              </a:rPr>
              <a:t>his/her hypothesis </a:t>
            </a:r>
            <a:r>
              <a:rPr lang="en-US" sz="1200" kern="1200" dirty="0">
                <a:solidFill>
                  <a:schemeClr val="tx1"/>
                </a:solidFill>
                <a:effectLst/>
                <a:latin typeface="+mn-lt"/>
                <a:ea typeface="+mn-ea"/>
                <a:cs typeface="+mn-cs"/>
              </a:rPr>
              <a:t>yet.</a:t>
            </a:r>
          </a:p>
        </p:txBody>
      </p:sp>
      <p:sp>
        <p:nvSpPr>
          <p:cNvPr id="4" name="Slide Number Placeholder 3"/>
          <p:cNvSpPr>
            <a:spLocks noGrp="1"/>
          </p:cNvSpPr>
          <p:nvPr>
            <p:ph type="sldNum" sz="quarter" idx="10"/>
          </p:nvPr>
        </p:nvSpPr>
        <p:spPr/>
        <p:txBody>
          <a:bodyPr/>
          <a:lstStyle/>
          <a:p>
            <a:fld id="{D784820F-0CE4-462B-BAD9-E3B4A35DBCAB}" type="slidenum">
              <a:rPr lang="en-US" smtClean="0"/>
              <a:t>43</a:t>
            </a:fld>
            <a:endParaRPr lang="en-US"/>
          </a:p>
        </p:txBody>
      </p:sp>
    </p:spTree>
    <p:extLst>
      <p:ext uri="{BB962C8B-B14F-4D97-AF65-F5344CB8AC3E}">
        <p14:creationId xmlns:p14="http://schemas.microsoft.com/office/powerpoint/2010/main" val="361540785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i="0" kern="1200" dirty="0" smtClean="0">
                <a:solidFill>
                  <a:schemeClr val="tx1"/>
                </a:solidFill>
                <a:effectLst/>
                <a:latin typeface="+mn-lt"/>
                <a:ea typeface="+mn-ea"/>
                <a:cs typeface="+mn-cs"/>
              </a:rPr>
              <a:t>We’ll start with cognitive load theory</a:t>
            </a:r>
            <a:r>
              <a:rPr lang="en-US" sz="1200" i="0" kern="1200" baseline="0" dirty="0" smtClean="0">
                <a:solidFill>
                  <a:schemeClr val="tx1"/>
                </a:solidFill>
                <a:effectLst/>
                <a:latin typeface="+mn-lt"/>
                <a:ea typeface="+mn-ea"/>
                <a:cs typeface="+mn-cs"/>
              </a:rPr>
              <a:t> – how to avoid drowning your learner with too much information at once.</a:t>
            </a:r>
            <a:endParaRPr lang="en-US" sz="1200" i="0" kern="1200" dirty="0" smtClean="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i="0" kern="1200" dirty="0" smtClean="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i="1" kern="1200" dirty="0" smtClean="0">
                <a:solidFill>
                  <a:schemeClr val="tx1"/>
                </a:solidFill>
                <a:effectLst/>
                <a:latin typeface="+mn-lt"/>
                <a:ea typeface="+mn-ea"/>
                <a:cs typeface="+mn-cs"/>
              </a:rPr>
              <a:t>Image by Michael Jeffrey, retrieved from: https://unsplash.com/photos/lgCb_XiLgp8 on 5/16/2020. Image is in the public domain.</a:t>
            </a:r>
          </a:p>
        </p:txBody>
      </p:sp>
      <p:sp>
        <p:nvSpPr>
          <p:cNvPr id="4" name="Slide Number Placeholder 3"/>
          <p:cNvSpPr>
            <a:spLocks noGrp="1"/>
          </p:cNvSpPr>
          <p:nvPr>
            <p:ph type="sldNum" sz="quarter" idx="10"/>
          </p:nvPr>
        </p:nvSpPr>
        <p:spPr/>
        <p:txBody>
          <a:bodyPr/>
          <a:lstStyle/>
          <a:p>
            <a:fld id="{D784820F-0CE4-462B-BAD9-E3B4A35DBCAB}" type="slidenum">
              <a:rPr lang="en-US" smtClean="0"/>
              <a:t>4</a:t>
            </a:fld>
            <a:endParaRPr lang="en-US"/>
          </a:p>
        </p:txBody>
      </p:sp>
    </p:spTree>
    <p:extLst>
      <p:ext uri="{BB962C8B-B14F-4D97-AF65-F5344CB8AC3E}">
        <p14:creationId xmlns:p14="http://schemas.microsoft.com/office/powerpoint/2010/main" val="3423095246"/>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Explain how you would approach a similar situation. What are the most common explanations for this scenario? What critical issues do you need to rule out?</a:t>
            </a:r>
          </a:p>
        </p:txBody>
      </p:sp>
      <p:sp>
        <p:nvSpPr>
          <p:cNvPr id="4" name="Slide Number Placeholder 3"/>
          <p:cNvSpPr>
            <a:spLocks noGrp="1"/>
          </p:cNvSpPr>
          <p:nvPr>
            <p:ph type="sldNum" sz="quarter" idx="10"/>
          </p:nvPr>
        </p:nvSpPr>
        <p:spPr/>
        <p:txBody>
          <a:bodyPr/>
          <a:lstStyle/>
          <a:p>
            <a:fld id="{D784820F-0CE4-462B-BAD9-E3B4A35DBCAB}" type="slidenum">
              <a:rPr lang="en-US" smtClean="0"/>
              <a:t>44</a:t>
            </a:fld>
            <a:endParaRPr lang="en-US"/>
          </a:p>
        </p:txBody>
      </p:sp>
    </p:spTree>
    <p:extLst>
      <p:ext uri="{BB962C8B-B14F-4D97-AF65-F5344CB8AC3E}">
        <p14:creationId xmlns:p14="http://schemas.microsoft.com/office/powerpoint/2010/main" val="2937391198"/>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Now for the feedback: start by highlighting the things they did well.</a:t>
            </a:r>
          </a:p>
        </p:txBody>
      </p:sp>
      <p:sp>
        <p:nvSpPr>
          <p:cNvPr id="4" name="Slide Number Placeholder 3"/>
          <p:cNvSpPr>
            <a:spLocks noGrp="1"/>
          </p:cNvSpPr>
          <p:nvPr>
            <p:ph type="sldNum" sz="quarter" idx="10"/>
          </p:nvPr>
        </p:nvSpPr>
        <p:spPr/>
        <p:txBody>
          <a:bodyPr/>
          <a:lstStyle/>
          <a:p>
            <a:fld id="{D784820F-0CE4-462B-BAD9-E3B4A35DBCAB}" type="slidenum">
              <a:rPr lang="en-US" smtClean="0"/>
              <a:t>45</a:t>
            </a:fld>
            <a:endParaRPr lang="en-US"/>
          </a:p>
        </p:txBody>
      </p:sp>
    </p:spTree>
    <p:extLst>
      <p:ext uri="{BB962C8B-B14F-4D97-AF65-F5344CB8AC3E}">
        <p14:creationId xmlns:p14="http://schemas.microsoft.com/office/powerpoint/2010/main" val="2025999071"/>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nd finally, explain any errors that they made and how to correct them.</a:t>
            </a:r>
          </a:p>
        </p:txBody>
      </p:sp>
      <p:sp>
        <p:nvSpPr>
          <p:cNvPr id="4" name="Slide Number Placeholder 3"/>
          <p:cNvSpPr>
            <a:spLocks noGrp="1"/>
          </p:cNvSpPr>
          <p:nvPr>
            <p:ph type="sldNum" sz="quarter" idx="10"/>
          </p:nvPr>
        </p:nvSpPr>
        <p:spPr/>
        <p:txBody>
          <a:bodyPr/>
          <a:lstStyle/>
          <a:p>
            <a:fld id="{D784820F-0CE4-462B-BAD9-E3B4A35DBCAB}" type="slidenum">
              <a:rPr lang="en-US" smtClean="0"/>
              <a:t>46</a:t>
            </a:fld>
            <a:endParaRPr lang="en-US"/>
          </a:p>
        </p:txBody>
      </p:sp>
    </p:spTree>
    <p:extLst>
      <p:ext uri="{BB962C8B-B14F-4D97-AF65-F5344CB8AC3E}">
        <p14:creationId xmlns:p14="http://schemas.microsoft.com/office/powerpoint/2010/main" val="3207183151"/>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smtClean="0"/>
              <a:t>Image by </a:t>
            </a:r>
            <a:r>
              <a:rPr lang="en-US" i="1" dirty="0" err="1" smtClean="0"/>
              <a:t>Gerd</a:t>
            </a:r>
            <a:r>
              <a:rPr lang="en-US" i="1" dirty="0" smtClean="0"/>
              <a:t> </a:t>
            </a:r>
            <a:r>
              <a:rPr lang="en-US" i="1" dirty="0" err="1" smtClean="0"/>
              <a:t>Altmann</a:t>
            </a:r>
            <a:r>
              <a:rPr lang="en-US" i="1" dirty="0" smtClean="0"/>
              <a:t>, retrieved from: https://www.publicdomainpictures.net/pictures/230000/velka/feedback-1499060450DyA.jpg on 5/16/2020. Image is in the public domain.</a:t>
            </a:r>
            <a:endParaRPr lang="en-US" i="1" dirty="0"/>
          </a:p>
        </p:txBody>
      </p:sp>
      <p:sp>
        <p:nvSpPr>
          <p:cNvPr id="4" name="Slide Number Placeholder 3"/>
          <p:cNvSpPr>
            <a:spLocks noGrp="1"/>
          </p:cNvSpPr>
          <p:nvPr>
            <p:ph type="sldNum" sz="quarter" idx="10"/>
          </p:nvPr>
        </p:nvSpPr>
        <p:spPr/>
        <p:txBody>
          <a:bodyPr/>
          <a:lstStyle/>
          <a:p>
            <a:fld id="{D784820F-0CE4-462B-BAD9-E3B4A35DBCAB}" type="slidenum">
              <a:rPr lang="en-US" smtClean="0"/>
              <a:t>47</a:t>
            </a:fld>
            <a:endParaRPr lang="en-US"/>
          </a:p>
        </p:txBody>
      </p:sp>
    </p:spTree>
    <p:extLst>
      <p:ext uri="{BB962C8B-B14F-4D97-AF65-F5344CB8AC3E}">
        <p14:creationId xmlns:p14="http://schemas.microsoft.com/office/powerpoint/2010/main" val="3629247640"/>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D784820F-0CE4-462B-BAD9-E3B4A35DBCAB}" type="slidenum">
              <a:rPr lang="en-US" smtClean="0"/>
              <a:t>48</a:t>
            </a:fld>
            <a:endParaRPr lang="en-US"/>
          </a:p>
        </p:txBody>
      </p:sp>
    </p:spTree>
    <p:extLst>
      <p:ext uri="{BB962C8B-B14F-4D97-AF65-F5344CB8AC3E}">
        <p14:creationId xmlns:p14="http://schemas.microsoft.com/office/powerpoint/2010/main" val="83274978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Cognitive</a:t>
            </a:r>
            <a:r>
              <a:rPr lang="en-US" baseline="0" dirty="0" smtClean="0"/>
              <a:t> load theory has been around for several decades. One of the key works was </a:t>
            </a:r>
            <a:r>
              <a:rPr lang="en-US" dirty="0" smtClean="0"/>
              <a:t>Chase and Simon in 1973 who discussed the idea of schema construction</a:t>
            </a:r>
            <a:r>
              <a:rPr lang="en-US" baseline="0" dirty="0" smtClean="0"/>
              <a:t> in the setting of the board game chess. Whereas beginners in chess perceive the board as individual pieces (pawn, knight, rook, </a:t>
            </a:r>
            <a:r>
              <a:rPr lang="en-US" baseline="0" dirty="0" err="1" smtClean="0"/>
              <a:t>etc</a:t>
            </a:r>
            <a:r>
              <a:rPr lang="en-US" baseline="0" dirty="0" smtClean="0"/>
              <a:t>), masters recognize various formations of multiple pieces in a particular configuration as a single unit – a schema or chunk if you will. This allows them to process the state of the game board at a higher level.</a:t>
            </a:r>
            <a:endParaRPr lang="en-US" dirty="0" smtClean="0"/>
          </a:p>
          <a:p>
            <a:endParaRPr lang="en-US" dirty="0" smtClean="0"/>
          </a:p>
          <a:p>
            <a:r>
              <a:rPr lang="en-US" i="1" dirty="0" smtClean="0"/>
              <a:t>Image by Jon Tyson, retrieved from: https://unsplash.com/photos/SlntP-SLi0Q on 5/16/2020. Image is in the public domain.</a:t>
            </a:r>
          </a:p>
        </p:txBody>
      </p:sp>
      <p:sp>
        <p:nvSpPr>
          <p:cNvPr id="4" name="Slide Number Placeholder 3"/>
          <p:cNvSpPr>
            <a:spLocks noGrp="1"/>
          </p:cNvSpPr>
          <p:nvPr>
            <p:ph type="sldNum" sz="quarter" idx="10"/>
          </p:nvPr>
        </p:nvSpPr>
        <p:spPr/>
        <p:txBody>
          <a:bodyPr/>
          <a:lstStyle/>
          <a:p>
            <a:fld id="{D784820F-0CE4-462B-BAD9-E3B4A35DBCAB}" type="slidenum">
              <a:rPr lang="en-US" smtClean="0"/>
              <a:t>5</a:t>
            </a:fld>
            <a:endParaRPr lang="en-US"/>
          </a:p>
        </p:txBody>
      </p:sp>
    </p:spTree>
    <p:extLst>
      <p:ext uri="{BB962C8B-B14F-4D97-AF65-F5344CB8AC3E}">
        <p14:creationId xmlns:p14="http://schemas.microsoft.com/office/powerpoint/2010/main" val="118631698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Schema construction applies to physical actions too. In other</a:t>
            </a:r>
            <a:r>
              <a:rPr lang="en-US" sz="1200" kern="1200" baseline="0" dirty="0" smtClean="0">
                <a:solidFill>
                  <a:schemeClr val="tx1"/>
                </a:solidFill>
                <a:effectLst/>
                <a:latin typeface="+mn-lt"/>
                <a:ea typeface="+mn-ea"/>
                <a:cs typeface="+mn-cs"/>
              </a:rPr>
              <a:t> words, muscle memory.</a:t>
            </a:r>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From Wikipedia (</a:t>
            </a:r>
            <a:r>
              <a:rPr lang="en-US" dirty="0" smtClean="0">
                <a:hlinkClick r:id="rId3"/>
              </a:rPr>
              <a:t>https://en.wikipedia.org/wiki/Automaticity</a:t>
            </a:r>
            <a:r>
              <a:rPr lang="en-US" dirty="0" smtClean="0"/>
              <a:t>)</a:t>
            </a:r>
            <a:r>
              <a:rPr lang="en-US" sz="1200" kern="1200" dirty="0" smtClean="0">
                <a:solidFill>
                  <a:schemeClr val="tx1"/>
                </a:solidFill>
                <a:effectLst/>
                <a:latin typeface="+mn-lt"/>
                <a:ea typeface="+mn-ea"/>
                <a:cs typeface="+mn-cs"/>
              </a:rPr>
              <a:t>: “The ability to do things without occupying the mind with the low-level details”</a:t>
            </a:r>
          </a:p>
          <a:p>
            <a:endParaRPr lang="en-US" sz="1200" kern="1200" dirty="0" smtClean="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b="1" kern="1200" baseline="0" dirty="0" smtClean="0">
                <a:solidFill>
                  <a:schemeClr val="tx1"/>
                </a:solidFill>
                <a:effectLst/>
                <a:latin typeface="+mn-lt"/>
                <a:ea typeface="+mn-ea"/>
                <a:cs typeface="+mn-cs"/>
              </a:rPr>
              <a:t>[Audience response: w</a:t>
            </a:r>
            <a:r>
              <a:rPr lang="en-US" sz="1200" b="1" kern="1200" dirty="0" smtClean="0">
                <a:solidFill>
                  <a:schemeClr val="tx1"/>
                </a:solidFill>
                <a:effectLst/>
                <a:latin typeface="+mn-lt"/>
                <a:ea typeface="+mn-ea"/>
                <a:cs typeface="+mn-cs"/>
              </a:rPr>
              <a:t>hat are</a:t>
            </a:r>
            <a:r>
              <a:rPr lang="en-US" sz="1200" b="1" kern="1200" baseline="0" dirty="0" smtClean="0">
                <a:solidFill>
                  <a:schemeClr val="tx1"/>
                </a:solidFill>
                <a:effectLst/>
                <a:latin typeface="+mn-lt"/>
                <a:ea typeface="+mn-ea"/>
                <a:cs typeface="+mn-cs"/>
              </a:rPr>
              <a:t> some examples of automaticity in anesthesia?]</a:t>
            </a:r>
            <a:endParaRPr lang="en-US" sz="1200" b="1" kern="1200" dirty="0" smtClean="0">
              <a:solidFill>
                <a:schemeClr val="tx1"/>
              </a:solidFill>
              <a:effectLst/>
              <a:latin typeface="+mn-lt"/>
              <a:ea typeface="+mn-ea"/>
              <a:cs typeface="+mn-cs"/>
            </a:endParaRPr>
          </a:p>
          <a:p>
            <a:r>
              <a:rPr lang="en-US" sz="1200" i="1" kern="1200" dirty="0" smtClean="0">
                <a:solidFill>
                  <a:schemeClr val="tx1"/>
                </a:solidFill>
                <a:effectLst/>
                <a:latin typeface="+mn-lt"/>
                <a:ea typeface="+mn-ea"/>
                <a:cs typeface="+mn-cs"/>
              </a:rPr>
              <a:t>Suggested</a:t>
            </a:r>
            <a:r>
              <a:rPr lang="en-US" sz="1200" i="1" kern="1200" baseline="0" dirty="0" smtClean="0">
                <a:solidFill>
                  <a:schemeClr val="tx1"/>
                </a:solidFill>
                <a:effectLst/>
                <a:latin typeface="+mn-lt"/>
                <a:ea typeface="+mn-ea"/>
                <a:cs typeface="+mn-cs"/>
              </a:rPr>
              <a:t> e</a:t>
            </a:r>
            <a:r>
              <a:rPr lang="en-US" sz="1200" i="1" kern="1200" dirty="0" smtClean="0">
                <a:solidFill>
                  <a:schemeClr val="tx1"/>
                </a:solidFill>
                <a:effectLst/>
                <a:latin typeface="+mn-lt"/>
                <a:ea typeface="+mn-ea"/>
                <a:cs typeface="+mn-cs"/>
              </a:rPr>
              <a:t>xamples: bag mask ventilation, administering IV drugs, direct laryngoscopy</a:t>
            </a:r>
          </a:p>
          <a:p>
            <a:r>
              <a:rPr lang="en-US" sz="1200" kern="1200" dirty="0" smtClean="0">
                <a:solidFill>
                  <a:schemeClr val="tx1"/>
                </a:solidFill>
                <a:effectLst/>
                <a:latin typeface="+mn-lt"/>
                <a:ea typeface="+mn-ea"/>
                <a:cs typeface="+mn-cs"/>
              </a:rPr>
              <a:t>For example, let’s talk about bag mask ventilation. When you were brand new CA-1s, your</a:t>
            </a:r>
            <a:r>
              <a:rPr lang="en-US" sz="1200" kern="1200" baseline="0" dirty="0" smtClean="0">
                <a:solidFill>
                  <a:schemeClr val="tx1"/>
                </a:solidFill>
                <a:effectLst/>
                <a:latin typeface="+mn-lt"/>
                <a:ea typeface="+mn-ea"/>
                <a:cs typeface="+mn-cs"/>
              </a:rPr>
              <a:t> brain had to manually consider the position of each finger of your left hand. Now that you are all experienced anesthesia providers, for a typical patient you can simply think, I need to mask ventilate and your left hand positions the mask automatically with minimal thought required. This frees up mental capacity so that instead you can do things like watch for chest rise, check the tidal volumes, look at the end tidal CO2 tracing, etc.</a:t>
            </a:r>
          </a:p>
          <a:p>
            <a:endParaRPr lang="en-US" sz="1200" kern="1200" baseline="0" dirty="0" smtClean="0">
              <a:solidFill>
                <a:schemeClr val="tx1"/>
              </a:solidFill>
              <a:effectLst/>
              <a:latin typeface="+mn-lt"/>
              <a:ea typeface="+mn-ea"/>
              <a:cs typeface="+mn-cs"/>
            </a:endParaRPr>
          </a:p>
          <a:p>
            <a:r>
              <a:rPr lang="en-US" sz="1200" b="1" kern="1200" baseline="0" dirty="0" smtClean="0">
                <a:solidFill>
                  <a:schemeClr val="tx1"/>
                </a:solidFill>
                <a:effectLst/>
                <a:latin typeface="+mn-lt"/>
                <a:ea typeface="+mn-ea"/>
                <a:cs typeface="+mn-cs"/>
              </a:rPr>
              <a:t>[Audience response: what are some of the dangers of automaticity when it comes to teaching a new trainee?]</a:t>
            </a:r>
          </a:p>
          <a:p>
            <a:r>
              <a:rPr lang="en-US" sz="1200" kern="1200" baseline="0" dirty="0" smtClean="0">
                <a:solidFill>
                  <a:schemeClr val="tx1"/>
                </a:solidFill>
                <a:effectLst/>
                <a:latin typeface="+mn-lt"/>
                <a:ea typeface="+mn-ea"/>
                <a:cs typeface="+mn-cs"/>
              </a:rPr>
              <a:t>Often times, the tasks we perform are so automated that we don’t even think about the individual steps. This can make it challenging to transmit the information from you to your trainee. Or we may forget what it was like as a brand-new CA-1 and </a:t>
            </a:r>
            <a:r>
              <a:rPr lang="en-US" sz="1200" kern="1200" baseline="0" dirty="0" smtClean="0">
                <a:solidFill>
                  <a:schemeClr val="tx1"/>
                </a:solidFill>
                <a:effectLst/>
                <a:latin typeface="+mn-lt"/>
                <a:ea typeface="+mn-ea"/>
                <a:cs typeface="+mn-cs"/>
              </a:rPr>
              <a:t>overwhelm the CA-1 with too much information at once.</a:t>
            </a:r>
            <a:endParaRPr lang="en-US" sz="1200" kern="1200" baseline="0" dirty="0" smtClean="0">
              <a:solidFill>
                <a:schemeClr val="tx1"/>
              </a:solidFill>
              <a:effectLst/>
              <a:latin typeface="+mn-lt"/>
              <a:ea typeface="+mn-ea"/>
              <a:cs typeface="+mn-cs"/>
            </a:endParaRPr>
          </a:p>
          <a:p>
            <a:endParaRPr lang="en-US" sz="1200" kern="1200" baseline="0" dirty="0" smtClean="0">
              <a:solidFill>
                <a:schemeClr val="tx1"/>
              </a:solidFill>
              <a:effectLst/>
              <a:latin typeface="+mn-lt"/>
              <a:ea typeface="+mn-ea"/>
              <a:cs typeface="+mn-cs"/>
            </a:endParaRPr>
          </a:p>
          <a:p>
            <a:r>
              <a:rPr lang="en-US" sz="1200" kern="1200" baseline="0" dirty="0" smtClean="0">
                <a:solidFill>
                  <a:schemeClr val="tx1"/>
                </a:solidFill>
                <a:effectLst/>
                <a:latin typeface="+mn-lt"/>
                <a:ea typeface="+mn-ea"/>
                <a:cs typeface="+mn-cs"/>
              </a:rPr>
              <a:t>Now before we go to the next slide, I want you to turn to your neighbor and </a:t>
            </a:r>
            <a:r>
              <a:rPr lang="en-US" sz="1200" kern="1200" baseline="0" dirty="0" smtClean="0">
                <a:solidFill>
                  <a:schemeClr val="tx1"/>
                </a:solidFill>
                <a:effectLst/>
                <a:latin typeface="+mn-lt"/>
                <a:ea typeface="+mn-ea"/>
                <a:cs typeface="+mn-cs"/>
              </a:rPr>
              <a:t>work through </a:t>
            </a:r>
            <a:r>
              <a:rPr lang="en-US" sz="1200" kern="1200" baseline="0" dirty="0" smtClean="0">
                <a:solidFill>
                  <a:schemeClr val="tx1"/>
                </a:solidFill>
                <a:effectLst/>
                <a:latin typeface="+mn-lt"/>
                <a:ea typeface="+mn-ea"/>
                <a:cs typeface="+mn-cs"/>
              </a:rPr>
              <a:t>question #1 on your handout together. </a:t>
            </a:r>
          </a:p>
          <a:p>
            <a:r>
              <a:rPr lang="en-US" sz="1200" b="1" kern="1200" dirty="0" smtClean="0">
                <a:solidFill>
                  <a:schemeClr val="tx1"/>
                </a:solidFill>
                <a:effectLst/>
                <a:latin typeface="+mn-lt"/>
                <a:ea typeface="+mn-ea"/>
                <a:cs typeface="+mn-cs"/>
              </a:rPr>
              <a:t>[Small group session – question #1 – </a:t>
            </a:r>
            <a:r>
              <a:rPr lang="en-US" sz="1200" b="1" i="1" kern="1200" dirty="0" smtClean="0">
                <a:solidFill>
                  <a:schemeClr val="tx1"/>
                </a:solidFill>
                <a:effectLst/>
                <a:latin typeface="+mn-lt"/>
                <a:ea typeface="+mn-ea"/>
                <a:cs typeface="+mn-cs"/>
              </a:rPr>
              <a:t>ask residents to name and explain each of the 3 types of cognitive load (intrinsic load, extraneous load, and germane load). After each explanation, ask for an example related to anesthesia (can call on a different resident if desired)</a:t>
            </a:r>
            <a:r>
              <a:rPr lang="en-US" sz="1200" b="1" kern="1200" dirty="0" smtClean="0">
                <a:solidFill>
                  <a:schemeClr val="tx1"/>
                </a:solidFill>
                <a:effectLst/>
                <a:latin typeface="+mn-lt"/>
                <a:ea typeface="+mn-ea"/>
                <a:cs typeface="+mn-cs"/>
              </a:rPr>
              <a:t>]</a:t>
            </a:r>
            <a:endParaRPr lang="en-US" sz="1200" kern="1200" dirty="0" smtClean="0">
              <a:solidFill>
                <a:schemeClr val="tx1"/>
              </a:solidFill>
              <a:effectLst/>
              <a:latin typeface="+mn-lt"/>
              <a:ea typeface="+mn-ea"/>
              <a:cs typeface="+mn-cs"/>
            </a:endParaRPr>
          </a:p>
          <a:p>
            <a:r>
              <a:rPr lang="en-US" sz="1200" i="1" kern="1200" dirty="0" smtClean="0">
                <a:solidFill>
                  <a:schemeClr val="tx1"/>
                </a:solidFill>
                <a:effectLst/>
                <a:latin typeface="+mn-lt"/>
                <a:ea typeface="+mn-ea"/>
                <a:cs typeface="+mn-cs"/>
              </a:rPr>
              <a:t>Suggested </a:t>
            </a:r>
            <a:r>
              <a:rPr lang="en-US" sz="1200" i="1" kern="1200" dirty="0" smtClean="0">
                <a:solidFill>
                  <a:schemeClr val="tx1"/>
                </a:solidFill>
                <a:effectLst/>
                <a:latin typeface="+mn-lt"/>
                <a:ea typeface="+mn-ea"/>
                <a:cs typeface="+mn-cs"/>
              </a:rPr>
              <a:t>examples:</a:t>
            </a:r>
          </a:p>
          <a:p>
            <a:r>
              <a:rPr lang="en-US" sz="1200" i="1" kern="1200" dirty="0" smtClean="0">
                <a:solidFill>
                  <a:schemeClr val="tx1"/>
                </a:solidFill>
                <a:effectLst/>
                <a:latin typeface="+mn-lt"/>
                <a:ea typeface="+mn-ea"/>
                <a:cs typeface="+mn-cs"/>
              </a:rPr>
              <a:t>Intrinsic</a:t>
            </a:r>
            <a:r>
              <a:rPr lang="en-US" sz="1200" i="1" kern="1200" baseline="0" dirty="0" smtClean="0">
                <a:solidFill>
                  <a:schemeClr val="tx1"/>
                </a:solidFill>
                <a:effectLst/>
                <a:latin typeface="+mn-lt"/>
                <a:ea typeface="+mn-ea"/>
                <a:cs typeface="+mn-cs"/>
              </a:rPr>
              <a:t> load: placing a central line is intrinsically more cognitively challenging than placing a peripheral IV.</a:t>
            </a:r>
          </a:p>
          <a:p>
            <a:r>
              <a:rPr lang="en-US" sz="1200" i="1" kern="1200" baseline="0" dirty="0" smtClean="0">
                <a:solidFill>
                  <a:schemeClr val="tx1"/>
                </a:solidFill>
                <a:effectLst/>
                <a:latin typeface="+mn-lt"/>
                <a:ea typeface="+mn-ea"/>
                <a:cs typeface="+mn-cs"/>
              </a:rPr>
              <a:t>Extraneous load: holding a casual conversation with your trainee while they are trying to concentrate on charting.</a:t>
            </a:r>
            <a:endParaRPr lang="en-US" sz="1200" i="1" kern="1200" dirty="0" smtClean="0">
              <a:solidFill>
                <a:schemeClr val="tx1"/>
              </a:solidFill>
              <a:effectLst/>
              <a:latin typeface="+mn-lt"/>
              <a:ea typeface="+mn-ea"/>
              <a:cs typeface="+mn-cs"/>
            </a:endParaRPr>
          </a:p>
          <a:p>
            <a:r>
              <a:rPr lang="en-US" sz="1200" i="1" kern="1200" dirty="0" smtClean="0">
                <a:solidFill>
                  <a:schemeClr val="tx1"/>
                </a:solidFill>
                <a:effectLst/>
                <a:latin typeface="+mn-lt"/>
                <a:ea typeface="+mn-ea"/>
                <a:cs typeface="+mn-cs"/>
              </a:rPr>
              <a:t>Germane load: this is the</a:t>
            </a:r>
            <a:r>
              <a:rPr lang="en-US" sz="1200" i="1" kern="1200" baseline="0" dirty="0" smtClean="0">
                <a:solidFill>
                  <a:schemeClr val="tx1"/>
                </a:solidFill>
                <a:effectLst/>
                <a:latin typeface="+mn-lt"/>
                <a:ea typeface="+mn-ea"/>
                <a:cs typeface="+mn-cs"/>
              </a:rPr>
              <a:t> cognitive work that your trainee’s brain is doing when they learn how to bag mask.</a:t>
            </a:r>
            <a:endParaRPr lang="en-US" sz="1200" i="1" kern="1200" dirty="0" smtClean="0">
              <a:solidFill>
                <a:schemeClr val="tx1"/>
              </a:solidFill>
              <a:effectLst/>
              <a:latin typeface="+mn-lt"/>
              <a:ea typeface="+mn-ea"/>
              <a:cs typeface="+mn-cs"/>
            </a:endParaRPr>
          </a:p>
          <a:p>
            <a:endParaRPr lang="en-US" sz="1200" kern="1200" dirty="0" smtClean="0">
              <a:solidFill>
                <a:schemeClr val="tx1"/>
              </a:solidFill>
              <a:effectLst/>
              <a:latin typeface="+mn-lt"/>
              <a:ea typeface="+mn-ea"/>
              <a:cs typeface="+mn-cs"/>
            </a:endParaRPr>
          </a:p>
          <a:p>
            <a:r>
              <a:rPr lang="en-US" sz="1200" i="1" kern="1200" dirty="0" smtClean="0">
                <a:solidFill>
                  <a:schemeClr val="tx1"/>
                </a:solidFill>
                <a:effectLst/>
                <a:latin typeface="+mn-lt"/>
                <a:ea typeface="+mn-ea"/>
                <a:cs typeface="+mn-cs"/>
              </a:rPr>
              <a:t>Image by Tim Foster, retrieved from: https://unsplash.com/photos/TW-rxLXqJUs on 5/16/2020. Image is in the public domain.</a:t>
            </a:r>
          </a:p>
        </p:txBody>
      </p:sp>
      <p:sp>
        <p:nvSpPr>
          <p:cNvPr id="4" name="Slide Number Placeholder 3"/>
          <p:cNvSpPr>
            <a:spLocks noGrp="1"/>
          </p:cNvSpPr>
          <p:nvPr>
            <p:ph type="sldNum" sz="quarter" idx="10"/>
          </p:nvPr>
        </p:nvSpPr>
        <p:spPr/>
        <p:txBody>
          <a:bodyPr/>
          <a:lstStyle/>
          <a:p>
            <a:fld id="{D784820F-0CE4-462B-BAD9-E3B4A35DBCAB}" type="slidenum">
              <a:rPr lang="en-US" smtClean="0"/>
              <a:t>6</a:t>
            </a:fld>
            <a:endParaRPr lang="en-US"/>
          </a:p>
        </p:txBody>
      </p:sp>
    </p:spTree>
    <p:extLst>
      <p:ext uri="{BB962C8B-B14F-4D97-AF65-F5344CB8AC3E}">
        <p14:creationId xmlns:p14="http://schemas.microsoft.com/office/powerpoint/2010/main" val="171551706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i="0" dirty="0" smtClean="0"/>
              <a:t>[</a:t>
            </a:r>
            <a:r>
              <a:rPr lang="en-US" b="1" i="0" dirty="0" smtClean="0"/>
              <a:t>Small</a:t>
            </a:r>
            <a:r>
              <a:rPr lang="en-US" b="1" i="0" baseline="0" dirty="0" smtClean="0"/>
              <a:t> group session – question #2 – let’s say it is July and you are the one in charge of a brand new CA1. How can you minimize extraneous cognitive load so that they can focus on learning the necessary material?] </a:t>
            </a:r>
            <a:r>
              <a:rPr lang="en-US" b="1" i="1" baseline="0" dirty="0" smtClean="0"/>
              <a:t>(ask residents to work with their partner again. Have them identify each item on the next slide and ask for an example in anesthesia. See primer document for detailed explanations and references)</a:t>
            </a:r>
            <a:endParaRPr lang="en-US" b="0" i="1" baseline="0" dirty="0" smtClean="0"/>
          </a:p>
          <a:p>
            <a:r>
              <a:rPr lang="en-US" b="0" i="1" dirty="0" smtClean="0"/>
              <a:t>Suggested examples:</a:t>
            </a:r>
          </a:p>
          <a:p>
            <a:r>
              <a:rPr lang="en-US" b="0" i="1" dirty="0" smtClean="0"/>
              <a:t>Minimize distractions: Delegate and</a:t>
            </a:r>
            <a:r>
              <a:rPr lang="en-US" b="0" i="1" baseline="0" dirty="0" smtClean="0"/>
              <a:t> simplify tasks. For example, if they are learning how to bag mask, tell them to focus on the mask ventilation and that you will take care of the patient’s blood pressure.</a:t>
            </a:r>
          </a:p>
          <a:p>
            <a:r>
              <a:rPr lang="en-US" b="0" i="1" baseline="0" dirty="0" smtClean="0"/>
              <a:t>Scaffolding: Gradually withdraw assistance over time. For example, for morning OR setup during the first few days with your trainee you can help make IV fluids and draw up medications, then over the next several days you stop helping with each of these tasks.</a:t>
            </a:r>
          </a:p>
          <a:p>
            <a:r>
              <a:rPr lang="en-US" b="0" i="1" baseline="0" dirty="0" smtClean="0"/>
              <a:t>Worked examples: Step-by-step breakdown of a task. For example for peripheral IV placement, you can divide the process into identifying landmarks, getting the flash, and threading the catheter. This makes it easier to troubleshoot when something doesn’t go smoothly.</a:t>
            </a:r>
          </a:p>
          <a:p>
            <a:r>
              <a:rPr lang="en-US" b="0" i="1" baseline="0" dirty="0" smtClean="0"/>
              <a:t>Integration: Use multiple modalities in a synergistic fashion. For example chalk talks (actively drawing diagrams/figures on a paper while explaining a concept).</a:t>
            </a:r>
          </a:p>
          <a:p>
            <a:r>
              <a:rPr lang="en-US" b="0" i="1" baseline="0" dirty="0" smtClean="0"/>
              <a:t>Split-attention effect: Avoid competing stimuli. When your trainee is using a MAC 3 blade for the first time, resist to urge to start elaborating about the Miller 2 blade and the relative advantages/disadvantages. Let them get the basic concept down first before moving </a:t>
            </a:r>
            <a:r>
              <a:rPr lang="en-US" b="0" i="1" baseline="0" dirty="0" smtClean="0"/>
              <a:t>on.</a:t>
            </a:r>
            <a:endParaRPr lang="en-US" b="0" i="1" dirty="0"/>
          </a:p>
        </p:txBody>
      </p:sp>
      <p:sp>
        <p:nvSpPr>
          <p:cNvPr id="4" name="Slide Number Placeholder 3"/>
          <p:cNvSpPr>
            <a:spLocks noGrp="1"/>
          </p:cNvSpPr>
          <p:nvPr>
            <p:ph type="sldNum" sz="quarter" idx="10"/>
          </p:nvPr>
        </p:nvSpPr>
        <p:spPr/>
        <p:txBody>
          <a:bodyPr/>
          <a:lstStyle/>
          <a:p>
            <a:fld id="{D784820F-0CE4-462B-BAD9-E3B4A35DBCAB}" type="slidenum">
              <a:rPr lang="en-US" smtClean="0"/>
              <a:t>7</a:t>
            </a:fld>
            <a:endParaRPr lang="en-US"/>
          </a:p>
        </p:txBody>
      </p:sp>
    </p:spTree>
    <p:extLst>
      <p:ext uri="{BB962C8B-B14F-4D97-AF65-F5344CB8AC3E}">
        <p14:creationId xmlns:p14="http://schemas.microsoft.com/office/powerpoint/2010/main" val="244861356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endParaRPr lang="en-US" i="0" dirty="0" smtClean="0"/>
          </a:p>
        </p:txBody>
      </p:sp>
      <p:sp>
        <p:nvSpPr>
          <p:cNvPr id="4" name="Slide Number Placeholder 3"/>
          <p:cNvSpPr>
            <a:spLocks noGrp="1"/>
          </p:cNvSpPr>
          <p:nvPr>
            <p:ph type="sldNum" sz="quarter" idx="10"/>
          </p:nvPr>
        </p:nvSpPr>
        <p:spPr/>
        <p:txBody>
          <a:bodyPr/>
          <a:lstStyle/>
          <a:p>
            <a:fld id="{D784820F-0CE4-462B-BAD9-E3B4A35DBCAB}" type="slidenum">
              <a:rPr lang="en-US" smtClean="0"/>
              <a:t>8</a:t>
            </a:fld>
            <a:endParaRPr lang="en-US"/>
          </a:p>
        </p:txBody>
      </p:sp>
    </p:spTree>
    <p:extLst>
      <p:ext uri="{BB962C8B-B14F-4D97-AF65-F5344CB8AC3E}">
        <p14:creationId xmlns:p14="http://schemas.microsoft.com/office/powerpoint/2010/main" val="173830420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i="0" dirty="0"/>
          </a:p>
        </p:txBody>
      </p:sp>
      <p:sp>
        <p:nvSpPr>
          <p:cNvPr id="4" name="Slide Number Placeholder 3"/>
          <p:cNvSpPr>
            <a:spLocks noGrp="1"/>
          </p:cNvSpPr>
          <p:nvPr>
            <p:ph type="sldNum" sz="quarter" idx="10"/>
          </p:nvPr>
        </p:nvSpPr>
        <p:spPr/>
        <p:txBody>
          <a:bodyPr/>
          <a:lstStyle/>
          <a:p>
            <a:fld id="{D784820F-0CE4-462B-BAD9-E3B4A35DBCAB}" type="slidenum">
              <a:rPr lang="en-US" smtClean="0"/>
              <a:t>9</a:t>
            </a:fld>
            <a:endParaRPr lang="en-US"/>
          </a:p>
        </p:txBody>
      </p:sp>
    </p:spTree>
    <p:extLst>
      <p:ext uri="{BB962C8B-B14F-4D97-AF65-F5344CB8AC3E}">
        <p14:creationId xmlns:p14="http://schemas.microsoft.com/office/powerpoint/2010/main" val="86692620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58368" y="2743200"/>
            <a:ext cx="7827264" cy="1371600"/>
          </a:xfrm>
        </p:spPr>
        <p:txBody>
          <a:bodyPr lIns="0" rIns="0" anchor="b" anchorCtr="0">
            <a:noAutofit/>
          </a:bodyPr>
          <a:lstStyle>
            <a:lvl1pPr algn="l">
              <a:defRPr sz="3600">
                <a:solidFill>
                  <a:schemeClr val="tx2"/>
                </a:solidFill>
              </a:defRPr>
            </a:lvl1pPr>
          </a:lstStyle>
          <a:p>
            <a:r>
              <a:rPr lang="en-US" smtClean="0"/>
              <a:t>Click to edit Master title style</a:t>
            </a:r>
            <a:endParaRPr lang="en-US" dirty="0"/>
          </a:p>
        </p:txBody>
      </p:sp>
      <p:sp>
        <p:nvSpPr>
          <p:cNvPr id="3" name="Subtitle 2"/>
          <p:cNvSpPr>
            <a:spLocks noGrp="1"/>
          </p:cNvSpPr>
          <p:nvPr>
            <p:ph type="subTitle" idx="1"/>
          </p:nvPr>
        </p:nvSpPr>
        <p:spPr>
          <a:xfrm>
            <a:off x="658368" y="4114800"/>
            <a:ext cx="7827264" cy="685800"/>
          </a:xfrm>
        </p:spPr>
        <p:txBody>
          <a:bodyPr lIns="0" tIns="228600" rIns="0">
            <a:noAutofit/>
          </a:bodyPr>
          <a:lstStyle>
            <a:lvl1pPr marL="0" indent="0" algn="l">
              <a:spcBef>
                <a:spcPts val="0"/>
              </a:spcBef>
              <a:buNone/>
              <a:defRPr sz="2200">
                <a:solidFill>
                  <a:schemeClr val="tx1"/>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dirty="0" smtClean="0"/>
          </a:p>
        </p:txBody>
      </p:sp>
      <p:sp>
        <p:nvSpPr>
          <p:cNvPr id="4" name="Date Placeholder 3"/>
          <p:cNvSpPr>
            <a:spLocks noGrp="1"/>
          </p:cNvSpPr>
          <p:nvPr>
            <p:ph type="dt" sz="half" idx="10"/>
          </p:nvPr>
        </p:nvSpPr>
        <p:spPr/>
        <p:txBody>
          <a:bodyPr/>
          <a:lstStyle/>
          <a:p>
            <a:fld id="{3B8E2A78-FB6E-4298-BF2F-1DA12D46150D}" type="datetime1">
              <a:rPr lang="en-US" smtClean="0"/>
              <a:t>10/2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C53FA5-AE81-45E0-8206-920AA27813B4}" type="slidenum">
              <a:rPr lang="en-US" smtClean="0"/>
              <a:t>‹#›</a:t>
            </a:fld>
            <a:endParaRPr lang="en-US"/>
          </a:p>
        </p:txBody>
      </p:sp>
      <p:grpSp>
        <p:nvGrpSpPr>
          <p:cNvPr id="20" name="Group 19"/>
          <p:cNvGrpSpPr/>
          <p:nvPr userDrawn="1"/>
        </p:nvGrpSpPr>
        <p:grpSpPr>
          <a:xfrm>
            <a:off x="657225" y="681038"/>
            <a:ext cx="1266825" cy="1381125"/>
            <a:chOff x="657225" y="681038"/>
            <a:chExt cx="1266825" cy="1381125"/>
          </a:xfrm>
          <a:solidFill>
            <a:srgbClr val="FFFFFF"/>
          </a:solidFill>
        </p:grpSpPr>
        <p:sp>
          <p:nvSpPr>
            <p:cNvPr id="21" name="Freeform 5"/>
            <p:cNvSpPr>
              <a:spLocks noEditPoints="1"/>
            </p:cNvSpPr>
            <p:nvPr userDrawn="1"/>
          </p:nvSpPr>
          <p:spPr bwMode="auto">
            <a:xfrm>
              <a:off x="846138" y="1354138"/>
              <a:ext cx="887413" cy="708025"/>
            </a:xfrm>
            <a:custGeom>
              <a:avLst/>
              <a:gdLst>
                <a:gd name="T0" fmla="*/ 2203 w 2794"/>
                <a:gd name="T1" fmla="*/ 0 h 2229"/>
                <a:gd name="T2" fmla="*/ 1613 w 2794"/>
                <a:gd name="T3" fmla="*/ 0 h 2229"/>
                <a:gd name="T4" fmla="*/ 1613 w 2794"/>
                <a:gd name="T5" fmla="*/ 665 h 2229"/>
                <a:gd name="T6" fmla="*/ 1904 w 2794"/>
                <a:gd name="T7" fmla="*/ 1330 h 2229"/>
                <a:gd name="T8" fmla="*/ 1904 w 2794"/>
                <a:gd name="T9" fmla="*/ 1237 h 2229"/>
                <a:gd name="T10" fmla="*/ 1749 w 2794"/>
                <a:gd name="T11" fmla="*/ 747 h 2229"/>
                <a:gd name="T12" fmla="*/ 1749 w 2794"/>
                <a:gd name="T13" fmla="*/ 573 h 2229"/>
                <a:gd name="T14" fmla="*/ 1972 w 2794"/>
                <a:gd name="T15" fmla="*/ 573 h 2229"/>
                <a:gd name="T16" fmla="*/ 1972 w 2794"/>
                <a:gd name="T17" fmla="*/ 1332 h 2229"/>
                <a:gd name="T18" fmla="*/ 1401 w 2794"/>
                <a:gd name="T19" fmla="*/ 2182 h 2229"/>
                <a:gd name="T20" fmla="*/ 829 w 2794"/>
                <a:gd name="T21" fmla="*/ 1374 h 2229"/>
                <a:gd name="T22" fmla="*/ 1180 w 2794"/>
                <a:gd name="T23" fmla="*/ 665 h 2229"/>
                <a:gd name="T24" fmla="*/ 1180 w 2794"/>
                <a:gd name="T25" fmla="*/ 573 h 2229"/>
                <a:gd name="T26" fmla="*/ 1401 w 2794"/>
                <a:gd name="T27" fmla="*/ 573 h 2229"/>
                <a:gd name="T28" fmla="*/ 1542 w 2794"/>
                <a:gd name="T29" fmla="*/ 573 h 2229"/>
                <a:gd name="T30" fmla="*/ 1542 w 2794"/>
                <a:gd name="T31" fmla="*/ 436 h 2229"/>
                <a:gd name="T32" fmla="*/ 1401 w 2794"/>
                <a:gd name="T33" fmla="*/ 436 h 2229"/>
                <a:gd name="T34" fmla="*/ 1180 w 2794"/>
                <a:gd name="T35" fmla="*/ 436 h 2229"/>
                <a:gd name="T36" fmla="*/ 1180 w 2794"/>
                <a:gd name="T37" fmla="*/ 436 h 2229"/>
                <a:gd name="T38" fmla="*/ 1044 w 2794"/>
                <a:gd name="T39" fmla="*/ 436 h 2229"/>
                <a:gd name="T40" fmla="*/ 1044 w 2794"/>
                <a:gd name="T41" fmla="*/ 436 h 2229"/>
                <a:gd name="T42" fmla="*/ 692 w 2794"/>
                <a:gd name="T43" fmla="*/ 436 h 2229"/>
                <a:gd name="T44" fmla="*/ 692 w 2794"/>
                <a:gd name="T45" fmla="*/ 1234 h 2229"/>
                <a:gd name="T46" fmla="*/ 695 w 2794"/>
                <a:gd name="T47" fmla="*/ 1315 h 2229"/>
                <a:gd name="T48" fmla="*/ 695 w 2794"/>
                <a:gd name="T49" fmla="*/ 1315 h 2229"/>
                <a:gd name="T50" fmla="*/ 829 w 2794"/>
                <a:gd name="T51" fmla="*/ 1205 h 2229"/>
                <a:gd name="T52" fmla="*/ 829 w 2794"/>
                <a:gd name="T53" fmla="*/ 1205 h 2229"/>
                <a:gd name="T54" fmla="*/ 829 w 2794"/>
                <a:gd name="T55" fmla="*/ 573 h 2229"/>
                <a:gd name="T56" fmla="*/ 1044 w 2794"/>
                <a:gd name="T57" fmla="*/ 573 h 2229"/>
                <a:gd name="T58" fmla="*/ 1044 w 2794"/>
                <a:gd name="T59" fmla="*/ 573 h 2229"/>
                <a:gd name="T60" fmla="*/ 1044 w 2794"/>
                <a:gd name="T61" fmla="*/ 747 h 2229"/>
                <a:gd name="T62" fmla="*/ 590 w 2794"/>
                <a:gd name="T63" fmla="*/ 1447 h 2229"/>
                <a:gd name="T64" fmla="*/ 135 w 2794"/>
                <a:gd name="T65" fmla="*/ 747 h 2229"/>
                <a:gd name="T66" fmla="*/ 135 w 2794"/>
                <a:gd name="T67" fmla="*/ 136 h 2229"/>
                <a:gd name="T68" fmla="*/ 590 w 2794"/>
                <a:gd name="T69" fmla="*/ 136 h 2229"/>
                <a:gd name="T70" fmla="*/ 1044 w 2794"/>
                <a:gd name="T71" fmla="*/ 136 h 2229"/>
                <a:gd name="T72" fmla="*/ 1044 w 2794"/>
                <a:gd name="T73" fmla="*/ 370 h 2229"/>
                <a:gd name="T74" fmla="*/ 1180 w 2794"/>
                <a:gd name="T75" fmla="*/ 370 h 2229"/>
                <a:gd name="T76" fmla="*/ 1180 w 2794"/>
                <a:gd name="T77" fmla="*/ 0 h 2229"/>
                <a:gd name="T78" fmla="*/ 590 w 2794"/>
                <a:gd name="T79" fmla="*/ 0 h 2229"/>
                <a:gd name="T80" fmla="*/ 0 w 2794"/>
                <a:gd name="T81" fmla="*/ 0 h 2229"/>
                <a:gd name="T82" fmla="*/ 0 w 2794"/>
                <a:gd name="T83" fmla="*/ 665 h 2229"/>
                <a:gd name="T84" fmla="*/ 590 w 2794"/>
                <a:gd name="T85" fmla="*/ 1495 h 2229"/>
                <a:gd name="T86" fmla="*/ 708 w 2794"/>
                <a:gd name="T87" fmla="*/ 1444 h 2229"/>
                <a:gd name="T88" fmla="*/ 1401 w 2794"/>
                <a:gd name="T89" fmla="*/ 2229 h 2229"/>
                <a:gd name="T90" fmla="*/ 2093 w 2794"/>
                <a:gd name="T91" fmla="*/ 1447 h 2229"/>
                <a:gd name="T92" fmla="*/ 2203 w 2794"/>
                <a:gd name="T93" fmla="*/ 1495 h 2229"/>
                <a:gd name="T94" fmla="*/ 2794 w 2794"/>
                <a:gd name="T95" fmla="*/ 665 h 2229"/>
                <a:gd name="T96" fmla="*/ 2794 w 2794"/>
                <a:gd name="T97" fmla="*/ 0 h 2229"/>
                <a:gd name="T98" fmla="*/ 2203 w 2794"/>
                <a:gd name="T99" fmla="*/ 0 h 2229"/>
                <a:gd name="T100" fmla="*/ 2658 w 2794"/>
                <a:gd name="T101" fmla="*/ 747 h 2229"/>
                <a:gd name="T102" fmla="*/ 2203 w 2794"/>
                <a:gd name="T103" fmla="*/ 1447 h 2229"/>
                <a:gd name="T104" fmla="*/ 2100 w 2794"/>
                <a:gd name="T105" fmla="*/ 1395 h 2229"/>
                <a:gd name="T106" fmla="*/ 2109 w 2794"/>
                <a:gd name="T107" fmla="*/ 1234 h 2229"/>
                <a:gd name="T108" fmla="*/ 2109 w 2794"/>
                <a:gd name="T109" fmla="*/ 436 h 2229"/>
                <a:gd name="T110" fmla="*/ 1749 w 2794"/>
                <a:gd name="T111" fmla="*/ 436 h 2229"/>
                <a:gd name="T112" fmla="*/ 1749 w 2794"/>
                <a:gd name="T113" fmla="*/ 136 h 2229"/>
                <a:gd name="T114" fmla="*/ 2203 w 2794"/>
                <a:gd name="T115" fmla="*/ 136 h 2229"/>
                <a:gd name="T116" fmla="*/ 2658 w 2794"/>
                <a:gd name="T117" fmla="*/ 136 h 2229"/>
                <a:gd name="T118" fmla="*/ 2658 w 2794"/>
                <a:gd name="T119" fmla="*/ 747 h 222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 ang="0">
                  <a:pos x="T118" y="T119"/>
                </a:cxn>
              </a:cxnLst>
              <a:rect l="0" t="0" r="r" b="b"/>
              <a:pathLst>
                <a:path w="2794" h="2229">
                  <a:moveTo>
                    <a:pt x="2203" y="0"/>
                  </a:moveTo>
                  <a:cubicBezTo>
                    <a:pt x="1613" y="0"/>
                    <a:pt x="1613" y="0"/>
                    <a:pt x="1613" y="0"/>
                  </a:cubicBezTo>
                  <a:cubicBezTo>
                    <a:pt x="1613" y="665"/>
                    <a:pt x="1613" y="665"/>
                    <a:pt x="1613" y="665"/>
                  </a:cubicBezTo>
                  <a:cubicBezTo>
                    <a:pt x="1613" y="970"/>
                    <a:pt x="1719" y="1183"/>
                    <a:pt x="1904" y="1330"/>
                  </a:cubicBezTo>
                  <a:cubicBezTo>
                    <a:pt x="1904" y="1237"/>
                    <a:pt x="1904" y="1237"/>
                    <a:pt x="1904" y="1237"/>
                  </a:cubicBezTo>
                  <a:cubicBezTo>
                    <a:pt x="1769" y="1081"/>
                    <a:pt x="1749" y="901"/>
                    <a:pt x="1749" y="747"/>
                  </a:cubicBezTo>
                  <a:cubicBezTo>
                    <a:pt x="1749" y="573"/>
                    <a:pt x="1749" y="573"/>
                    <a:pt x="1749" y="573"/>
                  </a:cubicBezTo>
                  <a:cubicBezTo>
                    <a:pt x="1972" y="573"/>
                    <a:pt x="1972" y="573"/>
                    <a:pt x="1972" y="573"/>
                  </a:cubicBezTo>
                  <a:cubicBezTo>
                    <a:pt x="1972" y="1332"/>
                    <a:pt x="1972" y="1332"/>
                    <a:pt x="1972" y="1332"/>
                  </a:cubicBezTo>
                  <a:cubicBezTo>
                    <a:pt x="1972" y="1609"/>
                    <a:pt x="1895" y="1961"/>
                    <a:pt x="1401" y="2182"/>
                  </a:cubicBezTo>
                  <a:cubicBezTo>
                    <a:pt x="931" y="1972"/>
                    <a:pt x="838" y="1643"/>
                    <a:pt x="829" y="1374"/>
                  </a:cubicBezTo>
                  <a:cubicBezTo>
                    <a:pt x="1051" y="1225"/>
                    <a:pt x="1180" y="1001"/>
                    <a:pt x="1180" y="665"/>
                  </a:cubicBezTo>
                  <a:cubicBezTo>
                    <a:pt x="1180" y="573"/>
                    <a:pt x="1180" y="573"/>
                    <a:pt x="1180" y="573"/>
                  </a:cubicBezTo>
                  <a:cubicBezTo>
                    <a:pt x="1401" y="573"/>
                    <a:pt x="1401" y="573"/>
                    <a:pt x="1401" y="573"/>
                  </a:cubicBezTo>
                  <a:cubicBezTo>
                    <a:pt x="1542" y="573"/>
                    <a:pt x="1542" y="573"/>
                    <a:pt x="1542" y="573"/>
                  </a:cubicBezTo>
                  <a:cubicBezTo>
                    <a:pt x="1542" y="436"/>
                    <a:pt x="1542" y="436"/>
                    <a:pt x="1542" y="436"/>
                  </a:cubicBezTo>
                  <a:cubicBezTo>
                    <a:pt x="1401" y="436"/>
                    <a:pt x="1401" y="436"/>
                    <a:pt x="1401" y="436"/>
                  </a:cubicBezTo>
                  <a:cubicBezTo>
                    <a:pt x="1180" y="436"/>
                    <a:pt x="1180" y="436"/>
                    <a:pt x="1180" y="436"/>
                  </a:cubicBezTo>
                  <a:cubicBezTo>
                    <a:pt x="1180" y="436"/>
                    <a:pt x="1180" y="436"/>
                    <a:pt x="1180" y="436"/>
                  </a:cubicBezTo>
                  <a:cubicBezTo>
                    <a:pt x="1044" y="436"/>
                    <a:pt x="1044" y="436"/>
                    <a:pt x="1044" y="436"/>
                  </a:cubicBezTo>
                  <a:cubicBezTo>
                    <a:pt x="1044" y="436"/>
                    <a:pt x="1044" y="436"/>
                    <a:pt x="1044" y="436"/>
                  </a:cubicBezTo>
                  <a:cubicBezTo>
                    <a:pt x="692" y="436"/>
                    <a:pt x="692" y="436"/>
                    <a:pt x="692" y="436"/>
                  </a:cubicBezTo>
                  <a:cubicBezTo>
                    <a:pt x="692" y="1234"/>
                    <a:pt x="692" y="1234"/>
                    <a:pt x="692" y="1234"/>
                  </a:cubicBezTo>
                  <a:cubicBezTo>
                    <a:pt x="692" y="1262"/>
                    <a:pt x="693" y="1289"/>
                    <a:pt x="695" y="1315"/>
                  </a:cubicBezTo>
                  <a:cubicBezTo>
                    <a:pt x="695" y="1315"/>
                    <a:pt x="695" y="1315"/>
                    <a:pt x="695" y="1315"/>
                  </a:cubicBezTo>
                  <a:cubicBezTo>
                    <a:pt x="748" y="1280"/>
                    <a:pt x="792" y="1244"/>
                    <a:pt x="829" y="1205"/>
                  </a:cubicBezTo>
                  <a:cubicBezTo>
                    <a:pt x="829" y="1205"/>
                    <a:pt x="829" y="1205"/>
                    <a:pt x="829" y="1205"/>
                  </a:cubicBezTo>
                  <a:cubicBezTo>
                    <a:pt x="829" y="573"/>
                    <a:pt x="829" y="573"/>
                    <a:pt x="829" y="573"/>
                  </a:cubicBezTo>
                  <a:cubicBezTo>
                    <a:pt x="1044" y="573"/>
                    <a:pt x="1044" y="573"/>
                    <a:pt x="1044" y="573"/>
                  </a:cubicBezTo>
                  <a:cubicBezTo>
                    <a:pt x="1044" y="573"/>
                    <a:pt x="1044" y="573"/>
                    <a:pt x="1044" y="573"/>
                  </a:cubicBezTo>
                  <a:cubicBezTo>
                    <a:pt x="1044" y="747"/>
                    <a:pt x="1044" y="747"/>
                    <a:pt x="1044" y="747"/>
                  </a:cubicBezTo>
                  <a:cubicBezTo>
                    <a:pt x="1044" y="978"/>
                    <a:pt x="1001" y="1263"/>
                    <a:pt x="590" y="1447"/>
                  </a:cubicBezTo>
                  <a:cubicBezTo>
                    <a:pt x="178" y="1263"/>
                    <a:pt x="135" y="978"/>
                    <a:pt x="135" y="747"/>
                  </a:cubicBezTo>
                  <a:cubicBezTo>
                    <a:pt x="135" y="136"/>
                    <a:pt x="135" y="136"/>
                    <a:pt x="135" y="136"/>
                  </a:cubicBezTo>
                  <a:cubicBezTo>
                    <a:pt x="590" y="136"/>
                    <a:pt x="590" y="136"/>
                    <a:pt x="590" y="136"/>
                  </a:cubicBezTo>
                  <a:cubicBezTo>
                    <a:pt x="1044" y="136"/>
                    <a:pt x="1044" y="136"/>
                    <a:pt x="1044" y="136"/>
                  </a:cubicBezTo>
                  <a:cubicBezTo>
                    <a:pt x="1044" y="370"/>
                    <a:pt x="1044" y="370"/>
                    <a:pt x="1044" y="370"/>
                  </a:cubicBezTo>
                  <a:cubicBezTo>
                    <a:pt x="1180" y="370"/>
                    <a:pt x="1180" y="370"/>
                    <a:pt x="1180" y="370"/>
                  </a:cubicBezTo>
                  <a:cubicBezTo>
                    <a:pt x="1180" y="0"/>
                    <a:pt x="1180" y="0"/>
                    <a:pt x="1180" y="0"/>
                  </a:cubicBezTo>
                  <a:cubicBezTo>
                    <a:pt x="590" y="0"/>
                    <a:pt x="590" y="0"/>
                    <a:pt x="590" y="0"/>
                  </a:cubicBezTo>
                  <a:cubicBezTo>
                    <a:pt x="0" y="0"/>
                    <a:pt x="0" y="0"/>
                    <a:pt x="0" y="0"/>
                  </a:cubicBezTo>
                  <a:cubicBezTo>
                    <a:pt x="0" y="665"/>
                    <a:pt x="0" y="665"/>
                    <a:pt x="0" y="665"/>
                  </a:cubicBezTo>
                  <a:cubicBezTo>
                    <a:pt x="0" y="1109"/>
                    <a:pt x="224" y="1357"/>
                    <a:pt x="590" y="1495"/>
                  </a:cubicBezTo>
                  <a:cubicBezTo>
                    <a:pt x="631" y="1479"/>
                    <a:pt x="670" y="1462"/>
                    <a:pt x="708" y="1444"/>
                  </a:cubicBezTo>
                  <a:cubicBezTo>
                    <a:pt x="771" y="1847"/>
                    <a:pt x="1023" y="2087"/>
                    <a:pt x="1401" y="2229"/>
                  </a:cubicBezTo>
                  <a:cubicBezTo>
                    <a:pt x="1777" y="2087"/>
                    <a:pt x="2029" y="1848"/>
                    <a:pt x="2093" y="1447"/>
                  </a:cubicBezTo>
                  <a:cubicBezTo>
                    <a:pt x="2128" y="1464"/>
                    <a:pt x="2165" y="1480"/>
                    <a:pt x="2203" y="1495"/>
                  </a:cubicBezTo>
                  <a:cubicBezTo>
                    <a:pt x="2569" y="1357"/>
                    <a:pt x="2794" y="1109"/>
                    <a:pt x="2794" y="665"/>
                  </a:cubicBezTo>
                  <a:cubicBezTo>
                    <a:pt x="2794" y="0"/>
                    <a:pt x="2794" y="0"/>
                    <a:pt x="2794" y="0"/>
                  </a:cubicBezTo>
                  <a:lnTo>
                    <a:pt x="2203" y="0"/>
                  </a:lnTo>
                  <a:close/>
                  <a:moveTo>
                    <a:pt x="2658" y="747"/>
                  </a:moveTo>
                  <a:cubicBezTo>
                    <a:pt x="2658" y="978"/>
                    <a:pt x="2615" y="1263"/>
                    <a:pt x="2203" y="1447"/>
                  </a:cubicBezTo>
                  <a:cubicBezTo>
                    <a:pt x="2166" y="1431"/>
                    <a:pt x="2131" y="1413"/>
                    <a:pt x="2100" y="1395"/>
                  </a:cubicBezTo>
                  <a:cubicBezTo>
                    <a:pt x="2106" y="1344"/>
                    <a:pt x="2109" y="1290"/>
                    <a:pt x="2109" y="1234"/>
                  </a:cubicBezTo>
                  <a:cubicBezTo>
                    <a:pt x="2109" y="436"/>
                    <a:pt x="2109" y="436"/>
                    <a:pt x="2109" y="436"/>
                  </a:cubicBezTo>
                  <a:cubicBezTo>
                    <a:pt x="1749" y="436"/>
                    <a:pt x="1749" y="436"/>
                    <a:pt x="1749" y="436"/>
                  </a:cubicBezTo>
                  <a:cubicBezTo>
                    <a:pt x="1749" y="136"/>
                    <a:pt x="1749" y="136"/>
                    <a:pt x="1749" y="136"/>
                  </a:cubicBezTo>
                  <a:cubicBezTo>
                    <a:pt x="2203" y="136"/>
                    <a:pt x="2203" y="136"/>
                    <a:pt x="2203" y="136"/>
                  </a:cubicBezTo>
                  <a:cubicBezTo>
                    <a:pt x="2658" y="136"/>
                    <a:pt x="2658" y="136"/>
                    <a:pt x="2658" y="136"/>
                  </a:cubicBezTo>
                  <a:lnTo>
                    <a:pt x="2658" y="74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2" name="Freeform 6"/>
            <p:cNvSpPr>
              <a:spLocks/>
            </p:cNvSpPr>
            <p:nvPr userDrawn="1"/>
          </p:nvSpPr>
          <p:spPr bwMode="auto">
            <a:xfrm>
              <a:off x="915988" y="1003301"/>
              <a:ext cx="188913" cy="236538"/>
            </a:xfrm>
            <a:custGeom>
              <a:avLst/>
              <a:gdLst>
                <a:gd name="T0" fmla="*/ 49 w 596"/>
                <a:gd name="T1" fmla="*/ 747 h 747"/>
                <a:gd name="T2" fmla="*/ 49 w 596"/>
                <a:gd name="T3" fmla="*/ 721 h 747"/>
                <a:gd name="T4" fmla="*/ 91 w 596"/>
                <a:gd name="T5" fmla="*/ 696 h 747"/>
                <a:gd name="T6" fmla="*/ 99 w 596"/>
                <a:gd name="T7" fmla="*/ 684 h 747"/>
                <a:gd name="T8" fmla="*/ 105 w 596"/>
                <a:gd name="T9" fmla="*/ 621 h 747"/>
                <a:gd name="T10" fmla="*/ 109 w 596"/>
                <a:gd name="T11" fmla="*/ 535 h 747"/>
                <a:gd name="T12" fmla="*/ 109 w 596"/>
                <a:gd name="T13" fmla="*/ 252 h 747"/>
                <a:gd name="T14" fmla="*/ 105 w 596"/>
                <a:gd name="T15" fmla="*/ 112 h 747"/>
                <a:gd name="T16" fmla="*/ 98 w 596"/>
                <a:gd name="T17" fmla="*/ 52 h 747"/>
                <a:gd name="T18" fmla="*/ 78 w 596"/>
                <a:gd name="T19" fmla="*/ 39 h 747"/>
                <a:gd name="T20" fmla="*/ 0 w 596"/>
                <a:gd name="T21" fmla="*/ 33 h 747"/>
                <a:gd name="T22" fmla="*/ 0 w 596"/>
                <a:gd name="T23" fmla="*/ 0 h 747"/>
                <a:gd name="T24" fmla="*/ 165 w 596"/>
                <a:gd name="T25" fmla="*/ 3 h 747"/>
                <a:gd name="T26" fmla="*/ 323 w 596"/>
                <a:gd name="T27" fmla="*/ 0 h 747"/>
                <a:gd name="T28" fmla="*/ 323 w 596"/>
                <a:gd name="T29" fmla="*/ 33 h 747"/>
                <a:gd name="T30" fmla="*/ 243 w 596"/>
                <a:gd name="T31" fmla="*/ 39 h 747"/>
                <a:gd name="T32" fmla="*/ 224 w 596"/>
                <a:gd name="T33" fmla="*/ 51 h 747"/>
                <a:gd name="T34" fmla="*/ 216 w 596"/>
                <a:gd name="T35" fmla="*/ 102 h 747"/>
                <a:gd name="T36" fmla="*/ 213 w 596"/>
                <a:gd name="T37" fmla="*/ 252 h 747"/>
                <a:gd name="T38" fmla="*/ 213 w 596"/>
                <a:gd name="T39" fmla="*/ 606 h 747"/>
                <a:gd name="T40" fmla="*/ 216 w 596"/>
                <a:gd name="T41" fmla="*/ 696 h 747"/>
                <a:gd name="T42" fmla="*/ 303 w 596"/>
                <a:gd name="T43" fmla="*/ 700 h 747"/>
                <a:gd name="T44" fmla="*/ 525 w 596"/>
                <a:gd name="T45" fmla="*/ 681 h 747"/>
                <a:gd name="T46" fmla="*/ 538 w 596"/>
                <a:gd name="T47" fmla="*/ 644 h 747"/>
                <a:gd name="T48" fmla="*/ 560 w 596"/>
                <a:gd name="T49" fmla="*/ 557 h 747"/>
                <a:gd name="T50" fmla="*/ 596 w 596"/>
                <a:gd name="T51" fmla="*/ 557 h 747"/>
                <a:gd name="T52" fmla="*/ 573 w 596"/>
                <a:gd name="T53" fmla="*/ 741 h 747"/>
                <a:gd name="T54" fmla="*/ 537 w 596"/>
                <a:gd name="T55" fmla="*/ 746 h 747"/>
                <a:gd name="T56" fmla="*/ 449 w 596"/>
                <a:gd name="T57" fmla="*/ 747 h 747"/>
                <a:gd name="T58" fmla="*/ 156 w 596"/>
                <a:gd name="T59" fmla="*/ 744 h 747"/>
                <a:gd name="T60" fmla="*/ 49 w 596"/>
                <a:gd name="T61" fmla="*/ 747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Lst>
              <a:rect l="0" t="0" r="r" b="b"/>
              <a:pathLst>
                <a:path w="596" h="747">
                  <a:moveTo>
                    <a:pt x="49" y="747"/>
                  </a:moveTo>
                  <a:cubicBezTo>
                    <a:pt x="49" y="721"/>
                    <a:pt x="49" y="721"/>
                    <a:pt x="49" y="721"/>
                  </a:cubicBezTo>
                  <a:cubicBezTo>
                    <a:pt x="71" y="710"/>
                    <a:pt x="85" y="702"/>
                    <a:pt x="91" y="696"/>
                  </a:cubicBezTo>
                  <a:cubicBezTo>
                    <a:pt x="95" y="693"/>
                    <a:pt x="98" y="689"/>
                    <a:pt x="99" y="684"/>
                  </a:cubicBezTo>
                  <a:cubicBezTo>
                    <a:pt x="102" y="675"/>
                    <a:pt x="104" y="654"/>
                    <a:pt x="105" y="621"/>
                  </a:cubicBezTo>
                  <a:cubicBezTo>
                    <a:pt x="108" y="573"/>
                    <a:pt x="109" y="545"/>
                    <a:pt x="109" y="535"/>
                  </a:cubicBezTo>
                  <a:cubicBezTo>
                    <a:pt x="109" y="252"/>
                    <a:pt x="109" y="252"/>
                    <a:pt x="109" y="252"/>
                  </a:cubicBezTo>
                  <a:cubicBezTo>
                    <a:pt x="109" y="204"/>
                    <a:pt x="108" y="157"/>
                    <a:pt x="105" y="112"/>
                  </a:cubicBezTo>
                  <a:cubicBezTo>
                    <a:pt x="104" y="78"/>
                    <a:pt x="102" y="59"/>
                    <a:pt x="98" y="52"/>
                  </a:cubicBezTo>
                  <a:cubicBezTo>
                    <a:pt x="93" y="46"/>
                    <a:pt x="87" y="42"/>
                    <a:pt x="78" y="39"/>
                  </a:cubicBezTo>
                  <a:cubicBezTo>
                    <a:pt x="69" y="36"/>
                    <a:pt x="43" y="34"/>
                    <a:pt x="0" y="33"/>
                  </a:cubicBezTo>
                  <a:cubicBezTo>
                    <a:pt x="0" y="0"/>
                    <a:pt x="0" y="0"/>
                    <a:pt x="0" y="0"/>
                  </a:cubicBezTo>
                  <a:cubicBezTo>
                    <a:pt x="89" y="2"/>
                    <a:pt x="144" y="3"/>
                    <a:pt x="165" y="3"/>
                  </a:cubicBezTo>
                  <a:cubicBezTo>
                    <a:pt x="189" y="3"/>
                    <a:pt x="241" y="2"/>
                    <a:pt x="323" y="0"/>
                  </a:cubicBezTo>
                  <a:cubicBezTo>
                    <a:pt x="323" y="33"/>
                    <a:pt x="323" y="33"/>
                    <a:pt x="323" y="33"/>
                  </a:cubicBezTo>
                  <a:cubicBezTo>
                    <a:pt x="279" y="34"/>
                    <a:pt x="253" y="36"/>
                    <a:pt x="243" y="39"/>
                  </a:cubicBezTo>
                  <a:cubicBezTo>
                    <a:pt x="234" y="42"/>
                    <a:pt x="228" y="46"/>
                    <a:pt x="224" y="51"/>
                  </a:cubicBezTo>
                  <a:cubicBezTo>
                    <a:pt x="220" y="58"/>
                    <a:pt x="217" y="75"/>
                    <a:pt x="216" y="102"/>
                  </a:cubicBezTo>
                  <a:cubicBezTo>
                    <a:pt x="215" y="109"/>
                    <a:pt x="214" y="159"/>
                    <a:pt x="213" y="252"/>
                  </a:cubicBezTo>
                  <a:cubicBezTo>
                    <a:pt x="213" y="606"/>
                    <a:pt x="213" y="606"/>
                    <a:pt x="213" y="606"/>
                  </a:cubicBezTo>
                  <a:cubicBezTo>
                    <a:pt x="213" y="643"/>
                    <a:pt x="214" y="673"/>
                    <a:pt x="216" y="696"/>
                  </a:cubicBezTo>
                  <a:cubicBezTo>
                    <a:pt x="257" y="699"/>
                    <a:pt x="262" y="700"/>
                    <a:pt x="303" y="700"/>
                  </a:cubicBezTo>
                  <a:cubicBezTo>
                    <a:pt x="407" y="700"/>
                    <a:pt x="484" y="693"/>
                    <a:pt x="525" y="681"/>
                  </a:cubicBezTo>
                  <a:cubicBezTo>
                    <a:pt x="530" y="670"/>
                    <a:pt x="534" y="658"/>
                    <a:pt x="538" y="644"/>
                  </a:cubicBezTo>
                  <a:cubicBezTo>
                    <a:pt x="560" y="557"/>
                    <a:pt x="560" y="557"/>
                    <a:pt x="560" y="557"/>
                  </a:cubicBezTo>
                  <a:cubicBezTo>
                    <a:pt x="596" y="557"/>
                    <a:pt x="596" y="557"/>
                    <a:pt x="596" y="557"/>
                  </a:cubicBezTo>
                  <a:cubicBezTo>
                    <a:pt x="588" y="609"/>
                    <a:pt x="580" y="671"/>
                    <a:pt x="573" y="741"/>
                  </a:cubicBezTo>
                  <a:cubicBezTo>
                    <a:pt x="558" y="744"/>
                    <a:pt x="546" y="745"/>
                    <a:pt x="537" y="746"/>
                  </a:cubicBezTo>
                  <a:cubicBezTo>
                    <a:pt x="518" y="747"/>
                    <a:pt x="488" y="747"/>
                    <a:pt x="449" y="747"/>
                  </a:cubicBezTo>
                  <a:cubicBezTo>
                    <a:pt x="156" y="744"/>
                    <a:pt x="156" y="744"/>
                    <a:pt x="156" y="744"/>
                  </a:cubicBezTo>
                  <a:cubicBezTo>
                    <a:pt x="121" y="744"/>
                    <a:pt x="85" y="745"/>
                    <a:pt x="49"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3" name="Freeform 7"/>
            <p:cNvSpPr>
              <a:spLocks/>
            </p:cNvSpPr>
            <p:nvPr userDrawn="1"/>
          </p:nvSpPr>
          <p:spPr bwMode="auto">
            <a:xfrm>
              <a:off x="1127125" y="1003301"/>
              <a:ext cx="103188" cy="236538"/>
            </a:xfrm>
            <a:custGeom>
              <a:avLst/>
              <a:gdLst>
                <a:gd name="T0" fmla="*/ 321 w 321"/>
                <a:gd name="T1" fmla="*/ 714 h 747"/>
                <a:gd name="T2" fmla="*/ 321 w 321"/>
                <a:gd name="T3" fmla="*/ 747 h 747"/>
                <a:gd name="T4" fmla="*/ 168 w 321"/>
                <a:gd name="T5" fmla="*/ 744 h 747"/>
                <a:gd name="T6" fmla="*/ 0 w 321"/>
                <a:gd name="T7" fmla="*/ 747 h 747"/>
                <a:gd name="T8" fmla="*/ 0 w 321"/>
                <a:gd name="T9" fmla="*/ 714 h 747"/>
                <a:gd name="T10" fmla="*/ 77 w 321"/>
                <a:gd name="T11" fmla="*/ 708 h 747"/>
                <a:gd name="T12" fmla="*/ 97 w 321"/>
                <a:gd name="T13" fmla="*/ 696 h 747"/>
                <a:gd name="T14" fmla="*/ 105 w 321"/>
                <a:gd name="T15" fmla="*/ 645 h 747"/>
                <a:gd name="T16" fmla="*/ 108 w 321"/>
                <a:gd name="T17" fmla="*/ 495 h 747"/>
                <a:gd name="T18" fmla="*/ 108 w 321"/>
                <a:gd name="T19" fmla="*/ 251 h 747"/>
                <a:gd name="T20" fmla="*/ 105 w 321"/>
                <a:gd name="T21" fmla="*/ 111 h 747"/>
                <a:gd name="T22" fmla="*/ 97 w 321"/>
                <a:gd name="T23" fmla="*/ 52 h 747"/>
                <a:gd name="T24" fmla="*/ 77 w 321"/>
                <a:gd name="T25" fmla="*/ 39 h 747"/>
                <a:gd name="T26" fmla="*/ 0 w 321"/>
                <a:gd name="T27" fmla="*/ 33 h 747"/>
                <a:gd name="T28" fmla="*/ 0 w 321"/>
                <a:gd name="T29" fmla="*/ 0 h 747"/>
                <a:gd name="T30" fmla="*/ 161 w 321"/>
                <a:gd name="T31" fmla="*/ 3 h 747"/>
                <a:gd name="T32" fmla="*/ 321 w 321"/>
                <a:gd name="T33" fmla="*/ 0 h 747"/>
                <a:gd name="T34" fmla="*/ 321 w 321"/>
                <a:gd name="T35" fmla="*/ 33 h 747"/>
                <a:gd name="T36" fmla="*/ 243 w 321"/>
                <a:gd name="T37" fmla="*/ 39 h 747"/>
                <a:gd name="T38" fmla="*/ 224 w 321"/>
                <a:gd name="T39" fmla="*/ 51 h 747"/>
                <a:gd name="T40" fmla="*/ 216 w 321"/>
                <a:gd name="T41" fmla="*/ 102 h 747"/>
                <a:gd name="T42" fmla="*/ 212 w 321"/>
                <a:gd name="T43" fmla="*/ 251 h 747"/>
                <a:gd name="T44" fmla="*/ 212 w 321"/>
                <a:gd name="T45" fmla="*/ 495 h 747"/>
                <a:gd name="T46" fmla="*/ 214 w 321"/>
                <a:gd name="T47" fmla="*/ 635 h 747"/>
                <a:gd name="T48" fmla="*/ 222 w 321"/>
                <a:gd name="T49" fmla="*/ 694 h 747"/>
                <a:gd name="T50" fmla="*/ 242 w 321"/>
                <a:gd name="T51" fmla="*/ 708 h 747"/>
                <a:gd name="T52" fmla="*/ 321 w 321"/>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1" h="747">
                  <a:moveTo>
                    <a:pt x="321" y="714"/>
                  </a:moveTo>
                  <a:cubicBezTo>
                    <a:pt x="321" y="747"/>
                    <a:pt x="321" y="747"/>
                    <a:pt x="321" y="747"/>
                  </a:cubicBezTo>
                  <a:cubicBezTo>
                    <a:pt x="244" y="745"/>
                    <a:pt x="193" y="744"/>
                    <a:pt x="168" y="744"/>
                  </a:cubicBezTo>
                  <a:cubicBezTo>
                    <a:pt x="0" y="747"/>
                    <a:pt x="0" y="747"/>
                    <a:pt x="0" y="747"/>
                  </a:cubicBezTo>
                  <a:cubicBezTo>
                    <a:pt x="0" y="714"/>
                    <a:pt x="0" y="714"/>
                    <a:pt x="0" y="714"/>
                  </a:cubicBezTo>
                  <a:cubicBezTo>
                    <a:pt x="42" y="713"/>
                    <a:pt x="68" y="711"/>
                    <a:pt x="77" y="708"/>
                  </a:cubicBezTo>
                  <a:cubicBezTo>
                    <a:pt x="87" y="705"/>
                    <a:pt x="93" y="701"/>
                    <a:pt x="97" y="696"/>
                  </a:cubicBezTo>
                  <a:cubicBezTo>
                    <a:pt x="101" y="689"/>
                    <a:pt x="104" y="672"/>
                    <a:pt x="105" y="645"/>
                  </a:cubicBezTo>
                  <a:cubicBezTo>
                    <a:pt x="106" y="637"/>
                    <a:pt x="107" y="587"/>
                    <a:pt x="108" y="495"/>
                  </a:cubicBezTo>
                  <a:cubicBezTo>
                    <a:pt x="108" y="251"/>
                    <a:pt x="108" y="251"/>
                    <a:pt x="108" y="251"/>
                  </a:cubicBezTo>
                  <a:cubicBezTo>
                    <a:pt x="108" y="204"/>
                    <a:pt x="107" y="157"/>
                    <a:pt x="105" y="111"/>
                  </a:cubicBezTo>
                  <a:cubicBezTo>
                    <a:pt x="104" y="78"/>
                    <a:pt x="102" y="59"/>
                    <a:pt x="97" y="52"/>
                  </a:cubicBezTo>
                  <a:cubicBezTo>
                    <a:pt x="93" y="46"/>
                    <a:pt x="87" y="41"/>
                    <a:pt x="77" y="39"/>
                  </a:cubicBezTo>
                  <a:cubicBezTo>
                    <a:pt x="68" y="36"/>
                    <a:pt x="42" y="34"/>
                    <a:pt x="0" y="33"/>
                  </a:cubicBezTo>
                  <a:cubicBezTo>
                    <a:pt x="0" y="0"/>
                    <a:pt x="0" y="0"/>
                    <a:pt x="0" y="0"/>
                  </a:cubicBezTo>
                  <a:cubicBezTo>
                    <a:pt x="69" y="2"/>
                    <a:pt x="123" y="3"/>
                    <a:pt x="161" y="3"/>
                  </a:cubicBezTo>
                  <a:cubicBezTo>
                    <a:pt x="197" y="3"/>
                    <a:pt x="250" y="2"/>
                    <a:pt x="321" y="0"/>
                  </a:cubicBezTo>
                  <a:cubicBezTo>
                    <a:pt x="321" y="33"/>
                    <a:pt x="321" y="33"/>
                    <a:pt x="321" y="33"/>
                  </a:cubicBezTo>
                  <a:cubicBezTo>
                    <a:pt x="278" y="34"/>
                    <a:pt x="252" y="36"/>
                    <a:pt x="243" y="39"/>
                  </a:cubicBezTo>
                  <a:cubicBezTo>
                    <a:pt x="234" y="41"/>
                    <a:pt x="227" y="46"/>
                    <a:pt x="224" y="51"/>
                  </a:cubicBezTo>
                  <a:cubicBezTo>
                    <a:pt x="219" y="58"/>
                    <a:pt x="217" y="75"/>
                    <a:pt x="216" y="102"/>
                  </a:cubicBezTo>
                  <a:cubicBezTo>
                    <a:pt x="215" y="109"/>
                    <a:pt x="214" y="159"/>
                    <a:pt x="212" y="251"/>
                  </a:cubicBezTo>
                  <a:cubicBezTo>
                    <a:pt x="212" y="495"/>
                    <a:pt x="212" y="495"/>
                    <a:pt x="212" y="495"/>
                  </a:cubicBezTo>
                  <a:cubicBezTo>
                    <a:pt x="212" y="543"/>
                    <a:pt x="213" y="589"/>
                    <a:pt x="214" y="635"/>
                  </a:cubicBezTo>
                  <a:cubicBezTo>
                    <a:pt x="215" y="668"/>
                    <a:pt x="218" y="688"/>
                    <a:pt x="222" y="694"/>
                  </a:cubicBezTo>
                  <a:cubicBezTo>
                    <a:pt x="226" y="700"/>
                    <a:pt x="233" y="705"/>
                    <a:pt x="242" y="708"/>
                  </a:cubicBezTo>
                  <a:cubicBezTo>
                    <a:pt x="251" y="711"/>
                    <a:pt x="278" y="713"/>
                    <a:pt x="321"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4" name="Freeform 8"/>
            <p:cNvSpPr>
              <a:spLocks/>
            </p:cNvSpPr>
            <p:nvPr userDrawn="1"/>
          </p:nvSpPr>
          <p:spPr bwMode="auto">
            <a:xfrm>
              <a:off x="1266825" y="1003301"/>
              <a:ext cx="276225" cy="242888"/>
            </a:xfrm>
            <a:custGeom>
              <a:avLst/>
              <a:gdLst>
                <a:gd name="T0" fmla="*/ 5 w 869"/>
                <a:gd name="T1" fmla="*/ 747 h 766"/>
                <a:gd name="T2" fmla="*/ 5 w 869"/>
                <a:gd name="T3" fmla="*/ 714 h 766"/>
                <a:gd name="T4" fmla="*/ 80 w 869"/>
                <a:gd name="T5" fmla="*/ 705 h 766"/>
                <a:gd name="T6" fmla="*/ 91 w 869"/>
                <a:gd name="T7" fmla="*/ 695 h 766"/>
                <a:gd name="T8" fmla="*/ 99 w 869"/>
                <a:gd name="T9" fmla="*/ 640 h 766"/>
                <a:gd name="T10" fmla="*/ 102 w 869"/>
                <a:gd name="T11" fmla="*/ 520 h 766"/>
                <a:gd name="T12" fmla="*/ 102 w 869"/>
                <a:gd name="T13" fmla="*/ 92 h 766"/>
                <a:gd name="T14" fmla="*/ 100 w 869"/>
                <a:gd name="T15" fmla="*/ 69 h 766"/>
                <a:gd name="T16" fmla="*/ 80 w 869"/>
                <a:gd name="T17" fmla="*/ 47 h 766"/>
                <a:gd name="T18" fmla="*/ 57 w 869"/>
                <a:gd name="T19" fmla="*/ 36 h 766"/>
                <a:gd name="T20" fmla="*/ 0 w 869"/>
                <a:gd name="T21" fmla="*/ 33 h 766"/>
                <a:gd name="T22" fmla="*/ 0 w 869"/>
                <a:gd name="T23" fmla="*/ 0 h 766"/>
                <a:gd name="T24" fmla="*/ 119 w 869"/>
                <a:gd name="T25" fmla="*/ 3 h 766"/>
                <a:gd name="T26" fmla="*/ 202 w 869"/>
                <a:gd name="T27" fmla="*/ 0 h 766"/>
                <a:gd name="T28" fmla="*/ 269 w 869"/>
                <a:gd name="T29" fmla="*/ 86 h 766"/>
                <a:gd name="T30" fmla="*/ 381 w 869"/>
                <a:gd name="T31" fmla="*/ 220 h 766"/>
                <a:gd name="T32" fmla="*/ 545 w 869"/>
                <a:gd name="T33" fmla="*/ 411 h 766"/>
                <a:gd name="T34" fmla="*/ 671 w 869"/>
                <a:gd name="T35" fmla="*/ 554 h 766"/>
                <a:gd name="T36" fmla="*/ 721 w 869"/>
                <a:gd name="T37" fmla="*/ 609 h 766"/>
                <a:gd name="T38" fmla="*/ 721 w 869"/>
                <a:gd name="T39" fmla="*/ 226 h 766"/>
                <a:gd name="T40" fmla="*/ 718 w 869"/>
                <a:gd name="T41" fmla="*/ 105 h 766"/>
                <a:gd name="T42" fmla="*/ 711 w 869"/>
                <a:gd name="T43" fmla="*/ 51 h 766"/>
                <a:gd name="T44" fmla="*/ 699 w 869"/>
                <a:gd name="T45" fmla="*/ 41 h 766"/>
                <a:gd name="T46" fmla="*/ 624 w 869"/>
                <a:gd name="T47" fmla="*/ 33 h 766"/>
                <a:gd name="T48" fmla="*/ 624 w 869"/>
                <a:gd name="T49" fmla="*/ 0 h 766"/>
                <a:gd name="T50" fmla="*/ 756 w 869"/>
                <a:gd name="T51" fmla="*/ 3 h 766"/>
                <a:gd name="T52" fmla="*/ 869 w 869"/>
                <a:gd name="T53" fmla="*/ 0 h 766"/>
                <a:gd name="T54" fmla="*/ 869 w 869"/>
                <a:gd name="T55" fmla="*/ 33 h 766"/>
                <a:gd name="T56" fmla="*/ 794 w 869"/>
                <a:gd name="T57" fmla="*/ 41 h 766"/>
                <a:gd name="T58" fmla="*/ 783 w 869"/>
                <a:gd name="T59" fmla="*/ 52 h 766"/>
                <a:gd name="T60" fmla="*/ 775 w 869"/>
                <a:gd name="T61" fmla="*/ 107 h 766"/>
                <a:gd name="T62" fmla="*/ 772 w 869"/>
                <a:gd name="T63" fmla="*/ 226 h 766"/>
                <a:gd name="T64" fmla="*/ 772 w 869"/>
                <a:gd name="T65" fmla="*/ 479 h 766"/>
                <a:gd name="T66" fmla="*/ 775 w 869"/>
                <a:gd name="T67" fmla="*/ 766 h 766"/>
                <a:gd name="T68" fmla="*/ 721 w 869"/>
                <a:gd name="T69" fmla="*/ 766 h 766"/>
                <a:gd name="T70" fmla="*/ 707 w 869"/>
                <a:gd name="T71" fmla="*/ 752 h 766"/>
                <a:gd name="T72" fmla="*/ 698 w 869"/>
                <a:gd name="T73" fmla="*/ 744 h 766"/>
                <a:gd name="T74" fmla="*/ 678 w 869"/>
                <a:gd name="T75" fmla="*/ 723 h 766"/>
                <a:gd name="T76" fmla="*/ 611 w 869"/>
                <a:gd name="T77" fmla="*/ 647 h 766"/>
                <a:gd name="T78" fmla="*/ 540 w 869"/>
                <a:gd name="T79" fmla="*/ 560 h 766"/>
                <a:gd name="T80" fmla="*/ 151 w 869"/>
                <a:gd name="T81" fmla="*/ 110 h 766"/>
                <a:gd name="T82" fmla="*/ 151 w 869"/>
                <a:gd name="T83" fmla="*/ 518 h 766"/>
                <a:gd name="T84" fmla="*/ 154 w 869"/>
                <a:gd name="T85" fmla="*/ 641 h 766"/>
                <a:gd name="T86" fmla="*/ 161 w 869"/>
                <a:gd name="T87" fmla="*/ 695 h 766"/>
                <a:gd name="T88" fmla="*/ 173 w 869"/>
                <a:gd name="T89" fmla="*/ 705 h 766"/>
                <a:gd name="T90" fmla="*/ 249 w 869"/>
                <a:gd name="T91" fmla="*/ 714 h 766"/>
                <a:gd name="T92" fmla="*/ 249 w 869"/>
                <a:gd name="T93" fmla="*/ 747 h 766"/>
                <a:gd name="T94" fmla="*/ 143 w 869"/>
                <a:gd name="T95" fmla="*/ 744 h 766"/>
                <a:gd name="T96" fmla="*/ 5 w 869"/>
                <a:gd name="T97" fmla="*/ 747 h 76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869" h="766">
                  <a:moveTo>
                    <a:pt x="5" y="747"/>
                  </a:moveTo>
                  <a:cubicBezTo>
                    <a:pt x="5" y="714"/>
                    <a:pt x="5" y="714"/>
                    <a:pt x="5" y="714"/>
                  </a:cubicBezTo>
                  <a:cubicBezTo>
                    <a:pt x="43" y="714"/>
                    <a:pt x="68" y="711"/>
                    <a:pt x="80" y="705"/>
                  </a:cubicBezTo>
                  <a:cubicBezTo>
                    <a:pt x="86" y="703"/>
                    <a:pt x="89" y="700"/>
                    <a:pt x="91" y="695"/>
                  </a:cubicBezTo>
                  <a:cubicBezTo>
                    <a:pt x="95" y="688"/>
                    <a:pt x="98" y="670"/>
                    <a:pt x="99" y="640"/>
                  </a:cubicBezTo>
                  <a:cubicBezTo>
                    <a:pt x="101" y="594"/>
                    <a:pt x="102" y="554"/>
                    <a:pt x="102" y="520"/>
                  </a:cubicBezTo>
                  <a:cubicBezTo>
                    <a:pt x="102" y="92"/>
                    <a:pt x="102" y="92"/>
                    <a:pt x="102" y="92"/>
                  </a:cubicBezTo>
                  <a:cubicBezTo>
                    <a:pt x="102" y="80"/>
                    <a:pt x="102" y="73"/>
                    <a:pt x="100" y="69"/>
                  </a:cubicBezTo>
                  <a:cubicBezTo>
                    <a:pt x="97" y="63"/>
                    <a:pt x="91" y="56"/>
                    <a:pt x="80" y="47"/>
                  </a:cubicBezTo>
                  <a:cubicBezTo>
                    <a:pt x="74" y="41"/>
                    <a:pt x="66" y="38"/>
                    <a:pt x="57" y="36"/>
                  </a:cubicBezTo>
                  <a:cubicBezTo>
                    <a:pt x="49" y="34"/>
                    <a:pt x="30" y="33"/>
                    <a:pt x="0" y="33"/>
                  </a:cubicBezTo>
                  <a:cubicBezTo>
                    <a:pt x="0" y="0"/>
                    <a:pt x="0" y="0"/>
                    <a:pt x="0" y="0"/>
                  </a:cubicBezTo>
                  <a:cubicBezTo>
                    <a:pt x="63" y="2"/>
                    <a:pt x="103" y="3"/>
                    <a:pt x="119" y="3"/>
                  </a:cubicBezTo>
                  <a:cubicBezTo>
                    <a:pt x="147" y="3"/>
                    <a:pt x="174" y="2"/>
                    <a:pt x="202" y="0"/>
                  </a:cubicBezTo>
                  <a:cubicBezTo>
                    <a:pt x="232" y="39"/>
                    <a:pt x="255" y="67"/>
                    <a:pt x="269" y="86"/>
                  </a:cubicBezTo>
                  <a:cubicBezTo>
                    <a:pt x="381" y="220"/>
                    <a:pt x="381" y="220"/>
                    <a:pt x="381" y="220"/>
                  </a:cubicBezTo>
                  <a:cubicBezTo>
                    <a:pt x="545" y="411"/>
                    <a:pt x="545" y="411"/>
                    <a:pt x="545" y="411"/>
                  </a:cubicBezTo>
                  <a:cubicBezTo>
                    <a:pt x="597" y="472"/>
                    <a:pt x="639" y="520"/>
                    <a:pt x="671" y="554"/>
                  </a:cubicBezTo>
                  <a:cubicBezTo>
                    <a:pt x="691" y="578"/>
                    <a:pt x="708" y="596"/>
                    <a:pt x="721" y="609"/>
                  </a:cubicBezTo>
                  <a:cubicBezTo>
                    <a:pt x="721" y="226"/>
                    <a:pt x="721" y="226"/>
                    <a:pt x="721" y="226"/>
                  </a:cubicBezTo>
                  <a:cubicBezTo>
                    <a:pt x="721" y="191"/>
                    <a:pt x="720" y="151"/>
                    <a:pt x="718" y="105"/>
                  </a:cubicBezTo>
                  <a:cubicBezTo>
                    <a:pt x="717" y="76"/>
                    <a:pt x="714" y="58"/>
                    <a:pt x="711" y="51"/>
                  </a:cubicBezTo>
                  <a:cubicBezTo>
                    <a:pt x="708" y="46"/>
                    <a:pt x="705" y="43"/>
                    <a:pt x="699" y="41"/>
                  </a:cubicBezTo>
                  <a:cubicBezTo>
                    <a:pt x="687" y="36"/>
                    <a:pt x="662" y="33"/>
                    <a:pt x="624" y="33"/>
                  </a:cubicBezTo>
                  <a:cubicBezTo>
                    <a:pt x="624" y="0"/>
                    <a:pt x="624" y="0"/>
                    <a:pt x="624" y="0"/>
                  </a:cubicBezTo>
                  <a:cubicBezTo>
                    <a:pt x="667" y="2"/>
                    <a:pt x="711" y="3"/>
                    <a:pt x="756" y="3"/>
                  </a:cubicBezTo>
                  <a:cubicBezTo>
                    <a:pt x="797" y="3"/>
                    <a:pt x="835" y="2"/>
                    <a:pt x="869" y="0"/>
                  </a:cubicBezTo>
                  <a:cubicBezTo>
                    <a:pt x="869" y="33"/>
                    <a:pt x="869" y="33"/>
                    <a:pt x="869" y="33"/>
                  </a:cubicBezTo>
                  <a:cubicBezTo>
                    <a:pt x="831" y="33"/>
                    <a:pt x="806" y="36"/>
                    <a:pt x="794" y="41"/>
                  </a:cubicBezTo>
                  <a:cubicBezTo>
                    <a:pt x="789" y="43"/>
                    <a:pt x="785" y="47"/>
                    <a:pt x="783" y="52"/>
                  </a:cubicBezTo>
                  <a:cubicBezTo>
                    <a:pt x="779" y="58"/>
                    <a:pt x="776" y="77"/>
                    <a:pt x="775" y="107"/>
                  </a:cubicBezTo>
                  <a:cubicBezTo>
                    <a:pt x="773" y="153"/>
                    <a:pt x="772" y="193"/>
                    <a:pt x="772" y="226"/>
                  </a:cubicBezTo>
                  <a:cubicBezTo>
                    <a:pt x="772" y="479"/>
                    <a:pt x="772" y="479"/>
                    <a:pt x="772" y="479"/>
                  </a:cubicBezTo>
                  <a:cubicBezTo>
                    <a:pt x="772" y="531"/>
                    <a:pt x="773" y="626"/>
                    <a:pt x="775" y="766"/>
                  </a:cubicBezTo>
                  <a:cubicBezTo>
                    <a:pt x="721" y="766"/>
                    <a:pt x="721" y="766"/>
                    <a:pt x="721" y="766"/>
                  </a:cubicBezTo>
                  <a:cubicBezTo>
                    <a:pt x="707" y="752"/>
                    <a:pt x="707" y="752"/>
                    <a:pt x="707" y="752"/>
                  </a:cubicBezTo>
                  <a:cubicBezTo>
                    <a:pt x="705" y="751"/>
                    <a:pt x="700" y="746"/>
                    <a:pt x="698" y="744"/>
                  </a:cubicBezTo>
                  <a:cubicBezTo>
                    <a:pt x="696" y="742"/>
                    <a:pt x="689" y="735"/>
                    <a:pt x="678" y="723"/>
                  </a:cubicBezTo>
                  <a:cubicBezTo>
                    <a:pt x="647" y="689"/>
                    <a:pt x="625" y="664"/>
                    <a:pt x="611" y="647"/>
                  </a:cubicBezTo>
                  <a:cubicBezTo>
                    <a:pt x="540" y="560"/>
                    <a:pt x="540" y="560"/>
                    <a:pt x="540" y="560"/>
                  </a:cubicBezTo>
                  <a:cubicBezTo>
                    <a:pt x="151" y="110"/>
                    <a:pt x="151" y="110"/>
                    <a:pt x="151" y="110"/>
                  </a:cubicBezTo>
                  <a:cubicBezTo>
                    <a:pt x="151" y="518"/>
                    <a:pt x="151" y="518"/>
                    <a:pt x="151" y="518"/>
                  </a:cubicBezTo>
                  <a:cubicBezTo>
                    <a:pt x="151" y="552"/>
                    <a:pt x="152" y="593"/>
                    <a:pt x="154" y="641"/>
                  </a:cubicBezTo>
                  <a:cubicBezTo>
                    <a:pt x="156" y="670"/>
                    <a:pt x="158" y="688"/>
                    <a:pt x="161" y="695"/>
                  </a:cubicBezTo>
                  <a:cubicBezTo>
                    <a:pt x="164" y="700"/>
                    <a:pt x="168" y="704"/>
                    <a:pt x="173" y="705"/>
                  </a:cubicBezTo>
                  <a:cubicBezTo>
                    <a:pt x="185" y="711"/>
                    <a:pt x="210" y="714"/>
                    <a:pt x="249" y="714"/>
                  </a:cubicBezTo>
                  <a:cubicBezTo>
                    <a:pt x="249" y="747"/>
                    <a:pt x="249" y="747"/>
                    <a:pt x="249" y="747"/>
                  </a:cubicBezTo>
                  <a:cubicBezTo>
                    <a:pt x="217" y="745"/>
                    <a:pt x="181" y="744"/>
                    <a:pt x="143" y="744"/>
                  </a:cubicBezTo>
                  <a:cubicBezTo>
                    <a:pt x="100" y="744"/>
                    <a:pt x="54" y="745"/>
                    <a:pt x="5"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5" name="Freeform 9"/>
            <p:cNvSpPr>
              <a:spLocks/>
            </p:cNvSpPr>
            <p:nvPr userDrawn="1"/>
          </p:nvSpPr>
          <p:spPr bwMode="auto">
            <a:xfrm>
              <a:off x="1573213" y="1003301"/>
              <a:ext cx="101600" cy="236538"/>
            </a:xfrm>
            <a:custGeom>
              <a:avLst/>
              <a:gdLst>
                <a:gd name="T0" fmla="*/ 322 w 322"/>
                <a:gd name="T1" fmla="*/ 714 h 747"/>
                <a:gd name="T2" fmla="*/ 322 w 322"/>
                <a:gd name="T3" fmla="*/ 747 h 747"/>
                <a:gd name="T4" fmla="*/ 169 w 322"/>
                <a:gd name="T5" fmla="*/ 744 h 747"/>
                <a:gd name="T6" fmla="*/ 0 w 322"/>
                <a:gd name="T7" fmla="*/ 747 h 747"/>
                <a:gd name="T8" fmla="*/ 0 w 322"/>
                <a:gd name="T9" fmla="*/ 714 h 747"/>
                <a:gd name="T10" fmla="*/ 79 w 322"/>
                <a:gd name="T11" fmla="*/ 708 h 747"/>
                <a:gd name="T12" fmla="*/ 98 w 322"/>
                <a:gd name="T13" fmla="*/ 696 h 747"/>
                <a:gd name="T14" fmla="*/ 106 w 322"/>
                <a:gd name="T15" fmla="*/ 645 h 747"/>
                <a:gd name="T16" fmla="*/ 109 w 322"/>
                <a:gd name="T17" fmla="*/ 495 h 747"/>
                <a:gd name="T18" fmla="*/ 109 w 322"/>
                <a:gd name="T19" fmla="*/ 251 h 747"/>
                <a:gd name="T20" fmla="*/ 106 w 322"/>
                <a:gd name="T21" fmla="*/ 111 h 747"/>
                <a:gd name="T22" fmla="*/ 98 w 322"/>
                <a:gd name="T23" fmla="*/ 52 h 747"/>
                <a:gd name="T24" fmla="*/ 78 w 322"/>
                <a:gd name="T25" fmla="*/ 39 h 747"/>
                <a:gd name="T26" fmla="*/ 0 w 322"/>
                <a:gd name="T27" fmla="*/ 33 h 747"/>
                <a:gd name="T28" fmla="*/ 0 w 322"/>
                <a:gd name="T29" fmla="*/ 0 h 747"/>
                <a:gd name="T30" fmla="*/ 161 w 322"/>
                <a:gd name="T31" fmla="*/ 3 h 747"/>
                <a:gd name="T32" fmla="*/ 322 w 322"/>
                <a:gd name="T33" fmla="*/ 0 h 747"/>
                <a:gd name="T34" fmla="*/ 322 w 322"/>
                <a:gd name="T35" fmla="*/ 33 h 747"/>
                <a:gd name="T36" fmla="*/ 244 w 322"/>
                <a:gd name="T37" fmla="*/ 39 h 747"/>
                <a:gd name="T38" fmla="*/ 224 w 322"/>
                <a:gd name="T39" fmla="*/ 51 h 747"/>
                <a:gd name="T40" fmla="*/ 216 w 322"/>
                <a:gd name="T41" fmla="*/ 102 h 747"/>
                <a:gd name="T42" fmla="*/ 213 w 322"/>
                <a:gd name="T43" fmla="*/ 251 h 747"/>
                <a:gd name="T44" fmla="*/ 213 w 322"/>
                <a:gd name="T45" fmla="*/ 495 h 747"/>
                <a:gd name="T46" fmla="*/ 215 w 322"/>
                <a:gd name="T47" fmla="*/ 635 h 747"/>
                <a:gd name="T48" fmla="*/ 223 w 322"/>
                <a:gd name="T49" fmla="*/ 694 h 747"/>
                <a:gd name="T50" fmla="*/ 243 w 322"/>
                <a:gd name="T51" fmla="*/ 708 h 747"/>
                <a:gd name="T52" fmla="*/ 322 w 322"/>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2" h="747">
                  <a:moveTo>
                    <a:pt x="322" y="714"/>
                  </a:moveTo>
                  <a:cubicBezTo>
                    <a:pt x="322" y="747"/>
                    <a:pt x="322" y="747"/>
                    <a:pt x="322" y="747"/>
                  </a:cubicBezTo>
                  <a:cubicBezTo>
                    <a:pt x="244" y="745"/>
                    <a:pt x="193" y="744"/>
                    <a:pt x="169" y="744"/>
                  </a:cubicBezTo>
                  <a:cubicBezTo>
                    <a:pt x="0" y="747"/>
                    <a:pt x="0" y="747"/>
                    <a:pt x="0" y="747"/>
                  </a:cubicBezTo>
                  <a:cubicBezTo>
                    <a:pt x="0" y="714"/>
                    <a:pt x="0" y="714"/>
                    <a:pt x="0" y="714"/>
                  </a:cubicBezTo>
                  <a:cubicBezTo>
                    <a:pt x="43" y="713"/>
                    <a:pt x="69" y="711"/>
                    <a:pt x="79" y="708"/>
                  </a:cubicBezTo>
                  <a:cubicBezTo>
                    <a:pt x="88" y="705"/>
                    <a:pt x="94" y="701"/>
                    <a:pt x="98" y="696"/>
                  </a:cubicBezTo>
                  <a:cubicBezTo>
                    <a:pt x="102" y="689"/>
                    <a:pt x="105" y="672"/>
                    <a:pt x="106" y="645"/>
                  </a:cubicBezTo>
                  <a:cubicBezTo>
                    <a:pt x="107" y="637"/>
                    <a:pt x="108" y="587"/>
                    <a:pt x="109" y="495"/>
                  </a:cubicBezTo>
                  <a:cubicBezTo>
                    <a:pt x="109" y="251"/>
                    <a:pt x="109" y="251"/>
                    <a:pt x="109" y="251"/>
                  </a:cubicBezTo>
                  <a:cubicBezTo>
                    <a:pt x="109" y="204"/>
                    <a:pt x="108" y="157"/>
                    <a:pt x="106" y="111"/>
                  </a:cubicBezTo>
                  <a:cubicBezTo>
                    <a:pt x="105" y="78"/>
                    <a:pt x="102" y="59"/>
                    <a:pt x="98" y="52"/>
                  </a:cubicBezTo>
                  <a:cubicBezTo>
                    <a:pt x="94" y="46"/>
                    <a:pt x="88" y="41"/>
                    <a:pt x="78" y="39"/>
                  </a:cubicBezTo>
                  <a:cubicBezTo>
                    <a:pt x="69" y="36"/>
                    <a:pt x="43" y="34"/>
                    <a:pt x="0" y="33"/>
                  </a:cubicBezTo>
                  <a:cubicBezTo>
                    <a:pt x="0" y="0"/>
                    <a:pt x="0" y="0"/>
                    <a:pt x="0" y="0"/>
                  </a:cubicBezTo>
                  <a:cubicBezTo>
                    <a:pt x="70" y="2"/>
                    <a:pt x="124" y="3"/>
                    <a:pt x="161" y="3"/>
                  </a:cubicBezTo>
                  <a:cubicBezTo>
                    <a:pt x="198" y="3"/>
                    <a:pt x="251" y="2"/>
                    <a:pt x="322" y="0"/>
                  </a:cubicBezTo>
                  <a:cubicBezTo>
                    <a:pt x="322" y="33"/>
                    <a:pt x="322" y="33"/>
                    <a:pt x="322" y="33"/>
                  </a:cubicBezTo>
                  <a:cubicBezTo>
                    <a:pt x="279" y="34"/>
                    <a:pt x="253" y="36"/>
                    <a:pt x="244" y="39"/>
                  </a:cubicBezTo>
                  <a:cubicBezTo>
                    <a:pt x="234" y="41"/>
                    <a:pt x="228" y="46"/>
                    <a:pt x="224" y="51"/>
                  </a:cubicBezTo>
                  <a:cubicBezTo>
                    <a:pt x="220" y="58"/>
                    <a:pt x="217" y="75"/>
                    <a:pt x="216" y="102"/>
                  </a:cubicBezTo>
                  <a:cubicBezTo>
                    <a:pt x="216" y="109"/>
                    <a:pt x="215" y="159"/>
                    <a:pt x="213" y="251"/>
                  </a:cubicBezTo>
                  <a:cubicBezTo>
                    <a:pt x="213" y="495"/>
                    <a:pt x="213" y="495"/>
                    <a:pt x="213" y="495"/>
                  </a:cubicBezTo>
                  <a:cubicBezTo>
                    <a:pt x="213" y="543"/>
                    <a:pt x="214" y="589"/>
                    <a:pt x="215" y="635"/>
                  </a:cubicBezTo>
                  <a:cubicBezTo>
                    <a:pt x="216" y="668"/>
                    <a:pt x="219" y="688"/>
                    <a:pt x="223" y="694"/>
                  </a:cubicBezTo>
                  <a:cubicBezTo>
                    <a:pt x="227" y="700"/>
                    <a:pt x="234" y="705"/>
                    <a:pt x="243" y="708"/>
                  </a:cubicBezTo>
                  <a:cubicBezTo>
                    <a:pt x="252" y="711"/>
                    <a:pt x="278" y="713"/>
                    <a:pt x="322"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6" name="Freeform 10"/>
            <p:cNvSpPr>
              <a:spLocks/>
            </p:cNvSpPr>
            <p:nvPr userDrawn="1"/>
          </p:nvSpPr>
          <p:spPr bwMode="auto">
            <a:xfrm>
              <a:off x="1692275" y="998538"/>
              <a:ext cx="231775" cy="246063"/>
            </a:xfrm>
            <a:custGeom>
              <a:avLst/>
              <a:gdLst>
                <a:gd name="T0" fmla="*/ 728 w 728"/>
                <a:gd name="T1" fmla="*/ 667 h 774"/>
                <a:gd name="T2" fmla="*/ 707 w 728"/>
                <a:gd name="T3" fmla="*/ 716 h 774"/>
                <a:gd name="T4" fmla="*/ 581 w 728"/>
                <a:gd name="T5" fmla="*/ 761 h 774"/>
                <a:gd name="T6" fmla="*/ 447 w 728"/>
                <a:gd name="T7" fmla="*/ 774 h 774"/>
                <a:gd name="T8" fmla="*/ 288 w 728"/>
                <a:gd name="T9" fmla="*/ 754 h 774"/>
                <a:gd name="T10" fmla="*/ 161 w 728"/>
                <a:gd name="T11" fmla="*/ 696 h 774"/>
                <a:gd name="T12" fmla="*/ 71 w 728"/>
                <a:gd name="T13" fmla="*/ 610 h 774"/>
                <a:gd name="T14" fmla="*/ 18 w 728"/>
                <a:gd name="T15" fmla="*/ 508 h 774"/>
                <a:gd name="T16" fmla="*/ 0 w 728"/>
                <a:gd name="T17" fmla="*/ 386 h 774"/>
                <a:gd name="T18" fmla="*/ 123 w 728"/>
                <a:gd name="T19" fmla="*/ 110 h 774"/>
                <a:gd name="T20" fmla="*/ 457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5 w 728"/>
                <a:gd name="T35" fmla="*/ 143 h 774"/>
                <a:gd name="T36" fmla="*/ 605 w 728"/>
                <a:gd name="T37" fmla="*/ 66 h 774"/>
                <a:gd name="T38" fmla="*/ 446 w 728"/>
                <a:gd name="T39" fmla="*/ 41 h 774"/>
                <a:gd name="T40" fmla="*/ 313 w 728"/>
                <a:gd name="T41" fmla="*/ 60 h 774"/>
                <a:gd name="T42" fmla="*/ 217 w 728"/>
                <a:gd name="T43" fmla="*/ 117 h 774"/>
                <a:gd name="T44" fmla="*/ 149 w 728"/>
                <a:gd name="T45" fmla="*/ 216 h 774"/>
                <a:gd name="T46" fmla="*/ 122 w 728"/>
                <a:gd name="T47" fmla="*/ 366 h 774"/>
                <a:gd name="T48" fmla="*/ 223 w 728"/>
                <a:gd name="T49" fmla="*/ 621 h 774"/>
                <a:gd name="T50" fmla="*/ 492 w 728"/>
                <a:gd name="T51" fmla="*/ 717 h 774"/>
                <a:gd name="T52" fmla="*/ 632 w 728"/>
                <a:gd name="T53" fmla="*/ 698 h 774"/>
                <a:gd name="T54" fmla="*/ 719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7" y="716"/>
                    <a:pt x="707" y="716"/>
                    <a:pt x="707" y="716"/>
                  </a:cubicBezTo>
                  <a:cubicBezTo>
                    <a:pt x="664" y="736"/>
                    <a:pt x="622" y="751"/>
                    <a:pt x="581" y="761"/>
                  </a:cubicBezTo>
                  <a:cubicBezTo>
                    <a:pt x="540" y="770"/>
                    <a:pt x="495" y="774"/>
                    <a:pt x="447" y="774"/>
                  </a:cubicBezTo>
                  <a:cubicBezTo>
                    <a:pt x="390" y="774"/>
                    <a:pt x="337" y="768"/>
                    <a:pt x="288" y="754"/>
                  </a:cubicBezTo>
                  <a:cubicBezTo>
                    <a:pt x="240" y="740"/>
                    <a:pt x="197" y="721"/>
                    <a:pt x="161" y="696"/>
                  </a:cubicBezTo>
                  <a:cubicBezTo>
                    <a:pt x="124" y="670"/>
                    <a:pt x="94" y="642"/>
                    <a:pt x="71" y="610"/>
                  </a:cubicBezTo>
                  <a:cubicBezTo>
                    <a:pt x="48" y="579"/>
                    <a:pt x="31" y="545"/>
                    <a:pt x="18" y="508"/>
                  </a:cubicBezTo>
                  <a:cubicBezTo>
                    <a:pt x="6" y="471"/>
                    <a:pt x="0" y="430"/>
                    <a:pt x="0" y="386"/>
                  </a:cubicBezTo>
                  <a:cubicBezTo>
                    <a:pt x="0" y="275"/>
                    <a:pt x="41" y="183"/>
                    <a:pt x="123" y="110"/>
                  </a:cubicBezTo>
                  <a:cubicBezTo>
                    <a:pt x="204" y="37"/>
                    <a:pt x="316" y="0"/>
                    <a:pt x="457" y="0"/>
                  </a:cubicBezTo>
                  <a:cubicBezTo>
                    <a:pt x="490" y="0"/>
                    <a:pt x="521" y="2"/>
                    <a:pt x="549" y="6"/>
                  </a:cubicBezTo>
                  <a:cubicBezTo>
                    <a:pt x="578"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5" y="143"/>
                    <a:pt x="665" y="143"/>
                    <a:pt x="665" y="143"/>
                  </a:cubicBezTo>
                  <a:cubicBezTo>
                    <a:pt x="661" y="109"/>
                    <a:pt x="641" y="83"/>
                    <a:pt x="605" y="66"/>
                  </a:cubicBezTo>
                  <a:cubicBezTo>
                    <a:pt x="569" y="50"/>
                    <a:pt x="516" y="41"/>
                    <a:pt x="446" y="41"/>
                  </a:cubicBezTo>
                  <a:cubicBezTo>
                    <a:pt x="393" y="42"/>
                    <a:pt x="349" y="48"/>
                    <a:pt x="313" y="60"/>
                  </a:cubicBezTo>
                  <a:cubicBezTo>
                    <a:pt x="277" y="72"/>
                    <a:pt x="245" y="91"/>
                    <a:pt x="217" y="117"/>
                  </a:cubicBezTo>
                  <a:cubicBezTo>
                    <a:pt x="189" y="143"/>
                    <a:pt x="166" y="176"/>
                    <a:pt x="149" y="216"/>
                  </a:cubicBezTo>
                  <a:cubicBezTo>
                    <a:pt x="131" y="256"/>
                    <a:pt x="122" y="306"/>
                    <a:pt x="122" y="366"/>
                  </a:cubicBezTo>
                  <a:cubicBezTo>
                    <a:pt x="122" y="472"/>
                    <a:pt x="155" y="557"/>
                    <a:pt x="223" y="621"/>
                  </a:cubicBezTo>
                  <a:cubicBezTo>
                    <a:pt x="291" y="685"/>
                    <a:pt x="380" y="717"/>
                    <a:pt x="492" y="717"/>
                  </a:cubicBezTo>
                  <a:cubicBezTo>
                    <a:pt x="542" y="717"/>
                    <a:pt x="589" y="711"/>
                    <a:pt x="632" y="698"/>
                  </a:cubicBezTo>
                  <a:cubicBezTo>
                    <a:pt x="661" y="689"/>
                    <a:pt x="690" y="675"/>
                    <a:pt x="719"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7" name="Freeform 11"/>
            <p:cNvSpPr>
              <a:spLocks/>
            </p:cNvSpPr>
            <p:nvPr userDrawn="1"/>
          </p:nvSpPr>
          <p:spPr bwMode="auto">
            <a:xfrm>
              <a:off x="657225" y="998538"/>
              <a:ext cx="231775" cy="246063"/>
            </a:xfrm>
            <a:custGeom>
              <a:avLst/>
              <a:gdLst>
                <a:gd name="T0" fmla="*/ 728 w 728"/>
                <a:gd name="T1" fmla="*/ 667 h 774"/>
                <a:gd name="T2" fmla="*/ 706 w 728"/>
                <a:gd name="T3" fmla="*/ 716 h 774"/>
                <a:gd name="T4" fmla="*/ 580 w 728"/>
                <a:gd name="T5" fmla="*/ 761 h 774"/>
                <a:gd name="T6" fmla="*/ 446 w 728"/>
                <a:gd name="T7" fmla="*/ 774 h 774"/>
                <a:gd name="T8" fmla="*/ 288 w 728"/>
                <a:gd name="T9" fmla="*/ 754 h 774"/>
                <a:gd name="T10" fmla="*/ 160 w 728"/>
                <a:gd name="T11" fmla="*/ 696 h 774"/>
                <a:gd name="T12" fmla="*/ 71 w 728"/>
                <a:gd name="T13" fmla="*/ 610 h 774"/>
                <a:gd name="T14" fmla="*/ 18 w 728"/>
                <a:gd name="T15" fmla="*/ 508 h 774"/>
                <a:gd name="T16" fmla="*/ 0 w 728"/>
                <a:gd name="T17" fmla="*/ 386 h 774"/>
                <a:gd name="T18" fmla="*/ 122 w 728"/>
                <a:gd name="T19" fmla="*/ 110 h 774"/>
                <a:gd name="T20" fmla="*/ 456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4 w 728"/>
                <a:gd name="T35" fmla="*/ 143 h 774"/>
                <a:gd name="T36" fmla="*/ 604 w 728"/>
                <a:gd name="T37" fmla="*/ 66 h 774"/>
                <a:gd name="T38" fmla="*/ 445 w 728"/>
                <a:gd name="T39" fmla="*/ 41 h 774"/>
                <a:gd name="T40" fmla="*/ 313 w 728"/>
                <a:gd name="T41" fmla="*/ 60 h 774"/>
                <a:gd name="T42" fmla="*/ 216 w 728"/>
                <a:gd name="T43" fmla="*/ 117 h 774"/>
                <a:gd name="T44" fmla="*/ 148 w 728"/>
                <a:gd name="T45" fmla="*/ 216 h 774"/>
                <a:gd name="T46" fmla="*/ 121 w 728"/>
                <a:gd name="T47" fmla="*/ 366 h 774"/>
                <a:gd name="T48" fmla="*/ 223 w 728"/>
                <a:gd name="T49" fmla="*/ 621 h 774"/>
                <a:gd name="T50" fmla="*/ 492 w 728"/>
                <a:gd name="T51" fmla="*/ 717 h 774"/>
                <a:gd name="T52" fmla="*/ 631 w 728"/>
                <a:gd name="T53" fmla="*/ 698 h 774"/>
                <a:gd name="T54" fmla="*/ 718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6" y="716"/>
                    <a:pt x="706" y="716"/>
                    <a:pt x="706" y="716"/>
                  </a:cubicBezTo>
                  <a:cubicBezTo>
                    <a:pt x="663" y="736"/>
                    <a:pt x="621" y="751"/>
                    <a:pt x="580" y="761"/>
                  </a:cubicBezTo>
                  <a:cubicBezTo>
                    <a:pt x="539" y="770"/>
                    <a:pt x="495" y="774"/>
                    <a:pt x="446" y="774"/>
                  </a:cubicBezTo>
                  <a:cubicBezTo>
                    <a:pt x="389" y="774"/>
                    <a:pt x="337" y="768"/>
                    <a:pt x="288" y="754"/>
                  </a:cubicBezTo>
                  <a:cubicBezTo>
                    <a:pt x="239" y="740"/>
                    <a:pt x="197" y="721"/>
                    <a:pt x="160" y="696"/>
                  </a:cubicBezTo>
                  <a:cubicBezTo>
                    <a:pt x="124" y="670"/>
                    <a:pt x="94" y="642"/>
                    <a:pt x="71" y="610"/>
                  </a:cubicBezTo>
                  <a:cubicBezTo>
                    <a:pt x="48" y="579"/>
                    <a:pt x="30" y="545"/>
                    <a:pt x="18" y="508"/>
                  </a:cubicBezTo>
                  <a:cubicBezTo>
                    <a:pt x="6" y="471"/>
                    <a:pt x="0" y="430"/>
                    <a:pt x="0" y="386"/>
                  </a:cubicBezTo>
                  <a:cubicBezTo>
                    <a:pt x="0" y="275"/>
                    <a:pt x="41" y="183"/>
                    <a:pt x="122" y="110"/>
                  </a:cubicBezTo>
                  <a:cubicBezTo>
                    <a:pt x="204" y="37"/>
                    <a:pt x="315" y="0"/>
                    <a:pt x="456" y="0"/>
                  </a:cubicBezTo>
                  <a:cubicBezTo>
                    <a:pt x="490" y="0"/>
                    <a:pt x="520" y="2"/>
                    <a:pt x="549" y="6"/>
                  </a:cubicBezTo>
                  <a:cubicBezTo>
                    <a:pt x="577"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4" y="143"/>
                    <a:pt x="664" y="143"/>
                    <a:pt x="664" y="143"/>
                  </a:cubicBezTo>
                  <a:cubicBezTo>
                    <a:pt x="661" y="109"/>
                    <a:pt x="641" y="83"/>
                    <a:pt x="604" y="66"/>
                  </a:cubicBezTo>
                  <a:cubicBezTo>
                    <a:pt x="568" y="50"/>
                    <a:pt x="515" y="41"/>
                    <a:pt x="445" y="41"/>
                  </a:cubicBezTo>
                  <a:cubicBezTo>
                    <a:pt x="393" y="42"/>
                    <a:pt x="349" y="48"/>
                    <a:pt x="313" y="60"/>
                  </a:cubicBezTo>
                  <a:cubicBezTo>
                    <a:pt x="276" y="72"/>
                    <a:pt x="244" y="91"/>
                    <a:pt x="216" y="117"/>
                  </a:cubicBezTo>
                  <a:cubicBezTo>
                    <a:pt x="189" y="143"/>
                    <a:pt x="166" y="176"/>
                    <a:pt x="148" y="216"/>
                  </a:cubicBezTo>
                  <a:cubicBezTo>
                    <a:pt x="131" y="256"/>
                    <a:pt x="122" y="306"/>
                    <a:pt x="121" y="366"/>
                  </a:cubicBezTo>
                  <a:cubicBezTo>
                    <a:pt x="121" y="472"/>
                    <a:pt x="155" y="557"/>
                    <a:pt x="223" y="621"/>
                  </a:cubicBezTo>
                  <a:cubicBezTo>
                    <a:pt x="290" y="685"/>
                    <a:pt x="380" y="717"/>
                    <a:pt x="492" y="717"/>
                  </a:cubicBezTo>
                  <a:cubicBezTo>
                    <a:pt x="542" y="717"/>
                    <a:pt x="588" y="711"/>
                    <a:pt x="631" y="698"/>
                  </a:cubicBezTo>
                  <a:cubicBezTo>
                    <a:pt x="660" y="689"/>
                    <a:pt x="689" y="675"/>
                    <a:pt x="718"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8" name="Freeform 12"/>
            <p:cNvSpPr>
              <a:spLocks/>
            </p:cNvSpPr>
            <p:nvPr userDrawn="1"/>
          </p:nvSpPr>
          <p:spPr bwMode="auto">
            <a:xfrm>
              <a:off x="757238" y="687388"/>
              <a:ext cx="323850" cy="239713"/>
            </a:xfrm>
            <a:custGeom>
              <a:avLst/>
              <a:gdLst>
                <a:gd name="T0" fmla="*/ 0 w 1017"/>
                <a:gd name="T1" fmla="*/ 35 h 754"/>
                <a:gd name="T2" fmla="*/ 0 w 1017"/>
                <a:gd name="T3" fmla="*/ 0 h 754"/>
                <a:gd name="T4" fmla="*/ 110 w 1017"/>
                <a:gd name="T5" fmla="*/ 4 h 754"/>
                <a:gd name="T6" fmla="*/ 212 w 1017"/>
                <a:gd name="T7" fmla="*/ 0 h 754"/>
                <a:gd name="T8" fmla="*/ 300 w 1017"/>
                <a:gd name="T9" fmla="*/ 183 h 754"/>
                <a:gd name="T10" fmla="*/ 509 w 1017"/>
                <a:gd name="T11" fmla="*/ 592 h 754"/>
                <a:gd name="T12" fmla="*/ 697 w 1017"/>
                <a:gd name="T13" fmla="*/ 218 h 754"/>
                <a:gd name="T14" fmla="*/ 800 w 1017"/>
                <a:gd name="T15" fmla="*/ 0 h 754"/>
                <a:gd name="T16" fmla="*/ 898 w 1017"/>
                <a:gd name="T17" fmla="*/ 4 h 754"/>
                <a:gd name="T18" fmla="*/ 1017 w 1017"/>
                <a:gd name="T19" fmla="*/ 0 h 754"/>
                <a:gd name="T20" fmla="*/ 1017 w 1017"/>
                <a:gd name="T21" fmla="*/ 35 h 754"/>
                <a:gd name="T22" fmla="*/ 938 w 1017"/>
                <a:gd name="T23" fmla="*/ 40 h 754"/>
                <a:gd name="T24" fmla="*/ 918 w 1017"/>
                <a:gd name="T25" fmla="*/ 53 h 754"/>
                <a:gd name="T26" fmla="*/ 910 w 1017"/>
                <a:gd name="T27" fmla="*/ 103 h 754"/>
                <a:gd name="T28" fmla="*/ 907 w 1017"/>
                <a:gd name="T29" fmla="*/ 251 h 754"/>
                <a:gd name="T30" fmla="*/ 907 w 1017"/>
                <a:gd name="T31" fmla="*/ 492 h 754"/>
                <a:gd name="T32" fmla="*/ 910 w 1017"/>
                <a:gd name="T33" fmla="*/ 631 h 754"/>
                <a:gd name="T34" fmla="*/ 918 w 1017"/>
                <a:gd name="T35" fmla="*/ 690 h 754"/>
                <a:gd name="T36" fmla="*/ 938 w 1017"/>
                <a:gd name="T37" fmla="*/ 704 h 754"/>
                <a:gd name="T38" fmla="*/ 1017 w 1017"/>
                <a:gd name="T39" fmla="*/ 709 h 754"/>
                <a:gd name="T40" fmla="*/ 1017 w 1017"/>
                <a:gd name="T41" fmla="*/ 743 h 754"/>
                <a:gd name="T42" fmla="*/ 861 w 1017"/>
                <a:gd name="T43" fmla="*/ 739 h 754"/>
                <a:gd name="T44" fmla="*/ 699 w 1017"/>
                <a:gd name="T45" fmla="*/ 743 h 754"/>
                <a:gd name="T46" fmla="*/ 699 w 1017"/>
                <a:gd name="T47" fmla="*/ 709 h 754"/>
                <a:gd name="T48" fmla="*/ 778 w 1017"/>
                <a:gd name="T49" fmla="*/ 704 h 754"/>
                <a:gd name="T50" fmla="*/ 797 w 1017"/>
                <a:gd name="T51" fmla="*/ 691 h 754"/>
                <a:gd name="T52" fmla="*/ 806 w 1017"/>
                <a:gd name="T53" fmla="*/ 641 h 754"/>
                <a:gd name="T54" fmla="*/ 808 w 1017"/>
                <a:gd name="T55" fmla="*/ 492 h 754"/>
                <a:gd name="T56" fmla="*/ 808 w 1017"/>
                <a:gd name="T57" fmla="*/ 108 h 754"/>
                <a:gd name="T58" fmla="*/ 619 w 1017"/>
                <a:gd name="T59" fmla="*/ 486 h 754"/>
                <a:gd name="T60" fmla="*/ 549 w 1017"/>
                <a:gd name="T61" fmla="*/ 629 h 754"/>
                <a:gd name="T62" fmla="*/ 494 w 1017"/>
                <a:gd name="T63" fmla="*/ 754 h 754"/>
                <a:gd name="T64" fmla="*/ 472 w 1017"/>
                <a:gd name="T65" fmla="*/ 754 h 754"/>
                <a:gd name="T66" fmla="*/ 459 w 1017"/>
                <a:gd name="T67" fmla="*/ 722 h 754"/>
                <a:gd name="T68" fmla="*/ 422 w 1017"/>
                <a:gd name="T69" fmla="*/ 645 h 754"/>
                <a:gd name="T70" fmla="*/ 159 w 1017"/>
                <a:gd name="T71" fmla="*/ 126 h 754"/>
                <a:gd name="T72" fmla="*/ 159 w 1017"/>
                <a:gd name="T73" fmla="*/ 492 h 754"/>
                <a:gd name="T74" fmla="*/ 163 w 1017"/>
                <a:gd name="T75" fmla="*/ 631 h 754"/>
                <a:gd name="T76" fmla="*/ 171 w 1017"/>
                <a:gd name="T77" fmla="*/ 690 h 754"/>
                <a:gd name="T78" fmla="*/ 191 w 1017"/>
                <a:gd name="T79" fmla="*/ 704 h 754"/>
                <a:gd name="T80" fmla="*/ 271 w 1017"/>
                <a:gd name="T81" fmla="*/ 709 h 754"/>
                <a:gd name="T82" fmla="*/ 271 w 1017"/>
                <a:gd name="T83" fmla="*/ 743 h 754"/>
                <a:gd name="T84" fmla="*/ 138 w 1017"/>
                <a:gd name="T85" fmla="*/ 739 h 754"/>
                <a:gd name="T86" fmla="*/ 0 w 1017"/>
                <a:gd name="T87" fmla="*/ 743 h 754"/>
                <a:gd name="T88" fmla="*/ 0 w 1017"/>
                <a:gd name="T89" fmla="*/ 709 h 754"/>
                <a:gd name="T90" fmla="*/ 79 w 1017"/>
                <a:gd name="T91" fmla="*/ 704 h 754"/>
                <a:gd name="T92" fmla="*/ 98 w 1017"/>
                <a:gd name="T93" fmla="*/ 691 h 754"/>
                <a:gd name="T94" fmla="*/ 107 w 1017"/>
                <a:gd name="T95" fmla="*/ 641 h 754"/>
                <a:gd name="T96" fmla="*/ 109 w 1017"/>
                <a:gd name="T97" fmla="*/ 492 h 754"/>
                <a:gd name="T98" fmla="*/ 109 w 1017"/>
                <a:gd name="T99" fmla="*/ 251 h 754"/>
                <a:gd name="T100" fmla="*/ 107 w 1017"/>
                <a:gd name="T101" fmla="*/ 112 h 754"/>
                <a:gd name="T102" fmla="*/ 99 w 1017"/>
                <a:gd name="T103" fmla="*/ 54 h 754"/>
                <a:gd name="T104" fmla="*/ 78 w 1017"/>
                <a:gd name="T105" fmla="*/ 40 h 754"/>
                <a:gd name="T106" fmla="*/ 0 w 1017"/>
                <a:gd name="T107" fmla="*/ 35 h 75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Lst>
              <a:rect l="0" t="0" r="r" b="b"/>
              <a:pathLst>
                <a:path w="1017" h="754">
                  <a:moveTo>
                    <a:pt x="0" y="35"/>
                  </a:moveTo>
                  <a:cubicBezTo>
                    <a:pt x="0" y="0"/>
                    <a:pt x="0" y="0"/>
                    <a:pt x="0" y="0"/>
                  </a:cubicBezTo>
                  <a:cubicBezTo>
                    <a:pt x="38" y="2"/>
                    <a:pt x="75" y="4"/>
                    <a:pt x="110" y="4"/>
                  </a:cubicBezTo>
                  <a:cubicBezTo>
                    <a:pt x="145" y="4"/>
                    <a:pt x="179" y="2"/>
                    <a:pt x="212" y="0"/>
                  </a:cubicBezTo>
                  <a:cubicBezTo>
                    <a:pt x="244" y="70"/>
                    <a:pt x="274" y="131"/>
                    <a:pt x="300" y="183"/>
                  </a:cubicBezTo>
                  <a:cubicBezTo>
                    <a:pt x="509" y="592"/>
                    <a:pt x="509" y="592"/>
                    <a:pt x="509" y="592"/>
                  </a:cubicBezTo>
                  <a:cubicBezTo>
                    <a:pt x="697" y="218"/>
                    <a:pt x="697" y="218"/>
                    <a:pt x="697" y="218"/>
                  </a:cubicBezTo>
                  <a:cubicBezTo>
                    <a:pt x="749" y="116"/>
                    <a:pt x="783" y="43"/>
                    <a:pt x="800" y="0"/>
                  </a:cubicBezTo>
                  <a:cubicBezTo>
                    <a:pt x="839" y="2"/>
                    <a:pt x="872" y="4"/>
                    <a:pt x="898" y="4"/>
                  </a:cubicBezTo>
                  <a:cubicBezTo>
                    <a:pt x="923" y="4"/>
                    <a:pt x="962" y="2"/>
                    <a:pt x="1017" y="0"/>
                  </a:cubicBezTo>
                  <a:cubicBezTo>
                    <a:pt x="1017" y="35"/>
                    <a:pt x="1017" y="35"/>
                    <a:pt x="1017" y="35"/>
                  </a:cubicBezTo>
                  <a:cubicBezTo>
                    <a:pt x="974" y="35"/>
                    <a:pt x="947" y="37"/>
                    <a:pt x="938" y="40"/>
                  </a:cubicBezTo>
                  <a:cubicBezTo>
                    <a:pt x="928" y="43"/>
                    <a:pt x="922" y="47"/>
                    <a:pt x="918" y="53"/>
                  </a:cubicBezTo>
                  <a:cubicBezTo>
                    <a:pt x="914" y="60"/>
                    <a:pt x="911" y="76"/>
                    <a:pt x="910" y="103"/>
                  </a:cubicBezTo>
                  <a:cubicBezTo>
                    <a:pt x="910" y="110"/>
                    <a:pt x="909" y="159"/>
                    <a:pt x="907" y="251"/>
                  </a:cubicBezTo>
                  <a:cubicBezTo>
                    <a:pt x="907" y="492"/>
                    <a:pt x="907" y="492"/>
                    <a:pt x="907" y="492"/>
                  </a:cubicBezTo>
                  <a:cubicBezTo>
                    <a:pt x="907" y="540"/>
                    <a:pt x="908" y="586"/>
                    <a:pt x="910" y="631"/>
                  </a:cubicBezTo>
                  <a:cubicBezTo>
                    <a:pt x="911" y="664"/>
                    <a:pt x="914" y="684"/>
                    <a:pt x="918" y="690"/>
                  </a:cubicBezTo>
                  <a:cubicBezTo>
                    <a:pt x="922" y="696"/>
                    <a:pt x="929" y="701"/>
                    <a:pt x="938" y="704"/>
                  </a:cubicBezTo>
                  <a:cubicBezTo>
                    <a:pt x="948" y="707"/>
                    <a:pt x="974" y="709"/>
                    <a:pt x="1017" y="709"/>
                  </a:cubicBezTo>
                  <a:cubicBezTo>
                    <a:pt x="1017" y="743"/>
                    <a:pt x="1017" y="743"/>
                    <a:pt x="1017" y="743"/>
                  </a:cubicBezTo>
                  <a:cubicBezTo>
                    <a:pt x="943" y="740"/>
                    <a:pt x="891" y="739"/>
                    <a:pt x="861" y="739"/>
                  </a:cubicBezTo>
                  <a:cubicBezTo>
                    <a:pt x="837" y="739"/>
                    <a:pt x="782" y="740"/>
                    <a:pt x="699" y="743"/>
                  </a:cubicBezTo>
                  <a:cubicBezTo>
                    <a:pt x="699" y="709"/>
                    <a:pt x="699" y="709"/>
                    <a:pt x="699" y="709"/>
                  </a:cubicBezTo>
                  <a:cubicBezTo>
                    <a:pt x="742" y="709"/>
                    <a:pt x="768" y="707"/>
                    <a:pt x="778" y="704"/>
                  </a:cubicBezTo>
                  <a:cubicBezTo>
                    <a:pt x="788" y="701"/>
                    <a:pt x="794" y="697"/>
                    <a:pt x="797" y="691"/>
                  </a:cubicBezTo>
                  <a:cubicBezTo>
                    <a:pt x="802" y="684"/>
                    <a:pt x="805" y="668"/>
                    <a:pt x="806" y="641"/>
                  </a:cubicBezTo>
                  <a:cubicBezTo>
                    <a:pt x="806" y="633"/>
                    <a:pt x="807" y="584"/>
                    <a:pt x="808" y="492"/>
                  </a:cubicBezTo>
                  <a:cubicBezTo>
                    <a:pt x="808" y="108"/>
                    <a:pt x="808" y="108"/>
                    <a:pt x="808" y="108"/>
                  </a:cubicBezTo>
                  <a:cubicBezTo>
                    <a:pt x="619" y="486"/>
                    <a:pt x="619" y="486"/>
                    <a:pt x="619" y="486"/>
                  </a:cubicBezTo>
                  <a:cubicBezTo>
                    <a:pt x="589" y="545"/>
                    <a:pt x="566" y="593"/>
                    <a:pt x="549" y="629"/>
                  </a:cubicBezTo>
                  <a:cubicBezTo>
                    <a:pt x="537" y="655"/>
                    <a:pt x="518" y="696"/>
                    <a:pt x="494" y="754"/>
                  </a:cubicBezTo>
                  <a:cubicBezTo>
                    <a:pt x="472" y="754"/>
                    <a:pt x="472" y="754"/>
                    <a:pt x="472" y="754"/>
                  </a:cubicBezTo>
                  <a:cubicBezTo>
                    <a:pt x="468" y="740"/>
                    <a:pt x="463" y="729"/>
                    <a:pt x="459" y="722"/>
                  </a:cubicBezTo>
                  <a:cubicBezTo>
                    <a:pt x="422" y="645"/>
                    <a:pt x="422" y="645"/>
                    <a:pt x="422" y="645"/>
                  </a:cubicBezTo>
                  <a:cubicBezTo>
                    <a:pt x="159" y="126"/>
                    <a:pt x="159" y="126"/>
                    <a:pt x="159" y="126"/>
                  </a:cubicBezTo>
                  <a:cubicBezTo>
                    <a:pt x="159" y="492"/>
                    <a:pt x="159" y="492"/>
                    <a:pt x="159" y="492"/>
                  </a:cubicBezTo>
                  <a:cubicBezTo>
                    <a:pt x="159" y="540"/>
                    <a:pt x="160" y="586"/>
                    <a:pt x="163" y="631"/>
                  </a:cubicBezTo>
                  <a:cubicBezTo>
                    <a:pt x="164" y="664"/>
                    <a:pt x="167" y="683"/>
                    <a:pt x="171" y="690"/>
                  </a:cubicBezTo>
                  <a:cubicBezTo>
                    <a:pt x="175" y="696"/>
                    <a:pt x="182" y="701"/>
                    <a:pt x="191" y="704"/>
                  </a:cubicBezTo>
                  <a:cubicBezTo>
                    <a:pt x="200" y="707"/>
                    <a:pt x="227" y="709"/>
                    <a:pt x="271" y="709"/>
                  </a:cubicBezTo>
                  <a:cubicBezTo>
                    <a:pt x="271" y="743"/>
                    <a:pt x="271" y="743"/>
                    <a:pt x="271" y="743"/>
                  </a:cubicBezTo>
                  <a:cubicBezTo>
                    <a:pt x="138" y="739"/>
                    <a:pt x="138" y="739"/>
                    <a:pt x="138" y="739"/>
                  </a:cubicBezTo>
                  <a:cubicBezTo>
                    <a:pt x="0" y="743"/>
                    <a:pt x="0" y="743"/>
                    <a:pt x="0" y="743"/>
                  </a:cubicBezTo>
                  <a:cubicBezTo>
                    <a:pt x="0" y="709"/>
                    <a:pt x="0" y="709"/>
                    <a:pt x="0" y="709"/>
                  </a:cubicBezTo>
                  <a:cubicBezTo>
                    <a:pt x="43" y="709"/>
                    <a:pt x="69" y="707"/>
                    <a:pt x="79" y="704"/>
                  </a:cubicBezTo>
                  <a:cubicBezTo>
                    <a:pt x="88" y="701"/>
                    <a:pt x="95" y="697"/>
                    <a:pt x="98" y="691"/>
                  </a:cubicBezTo>
                  <a:cubicBezTo>
                    <a:pt x="103" y="684"/>
                    <a:pt x="105" y="668"/>
                    <a:pt x="107" y="641"/>
                  </a:cubicBezTo>
                  <a:cubicBezTo>
                    <a:pt x="107" y="634"/>
                    <a:pt x="108" y="584"/>
                    <a:pt x="109" y="492"/>
                  </a:cubicBezTo>
                  <a:cubicBezTo>
                    <a:pt x="109" y="251"/>
                    <a:pt x="109" y="251"/>
                    <a:pt x="109" y="251"/>
                  </a:cubicBezTo>
                  <a:cubicBezTo>
                    <a:pt x="109" y="204"/>
                    <a:pt x="108" y="158"/>
                    <a:pt x="107" y="112"/>
                  </a:cubicBezTo>
                  <a:cubicBezTo>
                    <a:pt x="105" y="79"/>
                    <a:pt x="103" y="60"/>
                    <a:pt x="99" y="54"/>
                  </a:cubicBezTo>
                  <a:cubicBezTo>
                    <a:pt x="94" y="48"/>
                    <a:pt x="88" y="43"/>
                    <a:pt x="78" y="40"/>
                  </a:cubicBezTo>
                  <a:cubicBezTo>
                    <a:pt x="69" y="37"/>
                    <a:pt x="43" y="35"/>
                    <a:pt x="0" y="35"/>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9" name="Freeform 13"/>
            <p:cNvSpPr>
              <a:spLocks noEditPoints="1"/>
            </p:cNvSpPr>
            <p:nvPr userDrawn="1"/>
          </p:nvSpPr>
          <p:spPr bwMode="auto">
            <a:xfrm>
              <a:off x="1092200" y="684213"/>
              <a:ext cx="263525" cy="238125"/>
            </a:xfrm>
            <a:custGeom>
              <a:avLst/>
              <a:gdLst>
                <a:gd name="T0" fmla="*/ 117 w 832"/>
                <a:gd name="T1" fmla="*/ 747 h 750"/>
                <a:gd name="T2" fmla="*/ 257 w 832"/>
                <a:gd name="T3" fmla="*/ 750 h 750"/>
                <a:gd name="T4" fmla="*/ 257 w 832"/>
                <a:gd name="T5" fmla="*/ 717 h 750"/>
                <a:gd name="T6" fmla="*/ 185 w 832"/>
                <a:gd name="T7" fmla="*/ 712 h 750"/>
                <a:gd name="T8" fmla="*/ 166 w 832"/>
                <a:gd name="T9" fmla="*/ 702 h 750"/>
                <a:gd name="T10" fmla="*/ 162 w 832"/>
                <a:gd name="T11" fmla="*/ 690 h 750"/>
                <a:gd name="T12" fmla="*/ 178 w 832"/>
                <a:gd name="T13" fmla="*/ 637 h 750"/>
                <a:gd name="T14" fmla="*/ 237 w 832"/>
                <a:gd name="T15" fmla="*/ 503 h 750"/>
                <a:gd name="T16" fmla="*/ 556 w 832"/>
                <a:gd name="T17" fmla="*/ 503 h 750"/>
                <a:gd name="T18" fmla="*/ 624 w 832"/>
                <a:gd name="T19" fmla="*/ 663 h 750"/>
                <a:gd name="T20" fmla="*/ 632 w 832"/>
                <a:gd name="T21" fmla="*/ 693 h 750"/>
                <a:gd name="T22" fmla="*/ 627 w 832"/>
                <a:gd name="T23" fmla="*/ 705 h 750"/>
                <a:gd name="T24" fmla="*/ 609 w 832"/>
                <a:gd name="T25" fmla="*/ 713 h 750"/>
                <a:gd name="T26" fmla="*/ 535 w 832"/>
                <a:gd name="T27" fmla="*/ 717 h 750"/>
                <a:gd name="T28" fmla="*/ 535 w 832"/>
                <a:gd name="T29" fmla="*/ 750 h 750"/>
                <a:gd name="T30" fmla="*/ 712 w 832"/>
                <a:gd name="T31" fmla="*/ 747 h 750"/>
                <a:gd name="T32" fmla="*/ 832 w 832"/>
                <a:gd name="T33" fmla="*/ 750 h 750"/>
                <a:gd name="T34" fmla="*/ 832 w 832"/>
                <a:gd name="T35" fmla="*/ 717 h 750"/>
                <a:gd name="T36" fmla="*/ 776 w 832"/>
                <a:gd name="T37" fmla="*/ 710 h 750"/>
                <a:gd name="T38" fmla="*/ 753 w 832"/>
                <a:gd name="T39" fmla="*/ 687 h 750"/>
                <a:gd name="T40" fmla="*/ 677 w 832"/>
                <a:gd name="T41" fmla="*/ 526 h 750"/>
                <a:gd name="T42" fmla="*/ 441 w 832"/>
                <a:gd name="T43" fmla="*/ 0 h 750"/>
                <a:gd name="T44" fmla="*/ 406 w 832"/>
                <a:gd name="T45" fmla="*/ 0 h 750"/>
                <a:gd name="T46" fmla="*/ 310 w 832"/>
                <a:gd name="T47" fmla="*/ 217 h 750"/>
                <a:gd name="T48" fmla="*/ 172 w 832"/>
                <a:gd name="T49" fmla="*/ 512 h 750"/>
                <a:gd name="T50" fmla="*/ 100 w 832"/>
                <a:gd name="T51" fmla="*/ 660 h 750"/>
                <a:gd name="T52" fmla="*/ 74 w 832"/>
                <a:gd name="T53" fmla="*/ 702 h 750"/>
                <a:gd name="T54" fmla="*/ 54 w 832"/>
                <a:gd name="T55" fmla="*/ 713 h 750"/>
                <a:gd name="T56" fmla="*/ 0 w 832"/>
                <a:gd name="T57" fmla="*/ 717 h 750"/>
                <a:gd name="T58" fmla="*/ 0 w 832"/>
                <a:gd name="T59" fmla="*/ 750 h 750"/>
                <a:gd name="T60" fmla="*/ 117 w 832"/>
                <a:gd name="T61" fmla="*/ 747 h 750"/>
                <a:gd name="T62" fmla="*/ 396 w 832"/>
                <a:gd name="T63" fmla="*/ 143 h 750"/>
                <a:gd name="T64" fmla="*/ 534 w 832"/>
                <a:gd name="T65" fmla="*/ 458 h 750"/>
                <a:gd name="T66" fmla="*/ 256 w 832"/>
                <a:gd name="T67" fmla="*/ 458 h 750"/>
                <a:gd name="T68" fmla="*/ 396 w 832"/>
                <a:gd name="T69" fmla="*/ 143 h 75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Lst>
              <a:rect l="0" t="0" r="r" b="b"/>
              <a:pathLst>
                <a:path w="832" h="750">
                  <a:moveTo>
                    <a:pt x="117" y="747"/>
                  </a:moveTo>
                  <a:cubicBezTo>
                    <a:pt x="148" y="747"/>
                    <a:pt x="195" y="748"/>
                    <a:pt x="257" y="750"/>
                  </a:cubicBezTo>
                  <a:cubicBezTo>
                    <a:pt x="257" y="717"/>
                    <a:pt x="257" y="717"/>
                    <a:pt x="257" y="717"/>
                  </a:cubicBezTo>
                  <a:cubicBezTo>
                    <a:pt x="222" y="716"/>
                    <a:pt x="199" y="715"/>
                    <a:pt x="185" y="712"/>
                  </a:cubicBezTo>
                  <a:cubicBezTo>
                    <a:pt x="177" y="710"/>
                    <a:pt x="170" y="707"/>
                    <a:pt x="166" y="702"/>
                  </a:cubicBezTo>
                  <a:cubicBezTo>
                    <a:pt x="163" y="699"/>
                    <a:pt x="162" y="695"/>
                    <a:pt x="162" y="690"/>
                  </a:cubicBezTo>
                  <a:cubicBezTo>
                    <a:pt x="162" y="679"/>
                    <a:pt x="167" y="662"/>
                    <a:pt x="178" y="637"/>
                  </a:cubicBezTo>
                  <a:cubicBezTo>
                    <a:pt x="237" y="503"/>
                    <a:pt x="237" y="503"/>
                    <a:pt x="237" y="503"/>
                  </a:cubicBezTo>
                  <a:cubicBezTo>
                    <a:pt x="556" y="503"/>
                    <a:pt x="556" y="503"/>
                    <a:pt x="556" y="503"/>
                  </a:cubicBezTo>
                  <a:cubicBezTo>
                    <a:pt x="624" y="663"/>
                    <a:pt x="624" y="663"/>
                    <a:pt x="624" y="663"/>
                  </a:cubicBezTo>
                  <a:cubicBezTo>
                    <a:pt x="629" y="675"/>
                    <a:pt x="632" y="685"/>
                    <a:pt x="632" y="693"/>
                  </a:cubicBezTo>
                  <a:cubicBezTo>
                    <a:pt x="632" y="698"/>
                    <a:pt x="630" y="702"/>
                    <a:pt x="627" y="705"/>
                  </a:cubicBezTo>
                  <a:cubicBezTo>
                    <a:pt x="624" y="708"/>
                    <a:pt x="618" y="711"/>
                    <a:pt x="609" y="713"/>
                  </a:cubicBezTo>
                  <a:cubicBezTo>
                    <a:pt x="601" y="715"/>
                    <a:pt x="576" y="716"/>
                    <a:pt x="535" y="717"/>
                  </a:cubicBezTo>
                  <a:cubicBezTo>
                    <a:pt x="535" y="750"/>
                    <a:pt x="535" y="750"/>
                    <a:pt x="535" y="750"/>
                  </a:cubicBezTo>
                  <a:cubicBezTo>
                    <a:pt x="712" y="747"/>
                    <a:pt x="712" y="747"/>
                    <a:pt x="712" y="747"/>
                  </a:cubicBezTo>
                  <a:cubicBezTo>
                    <a:pt x="734" y="747"/>
                    <a:pt x="775" y="748"/>
                    <a:pt x="832" y="750"/>
                  </a:cubicBezTo>
                  <a:cubicBezTo>
                    <a:pt x="832" y="717"/>
                    <a:pt x="832" y="717"/>
                    <a:pt x="832" y="717"/>
                  </a:cubicBezTo>
                  <a:cubicBezTo>
                    <a:pt x="803" y="716"/>
                    <a:pt x="784" y="714"/>
                    <a:pt x="776" y="710"/>
                  </a:cubicBezTo>
                  <a:cubicBezTo>
                    <a:pt x="767" y="707"/>
                    <a:pt x="760" y="699"/>
                    <a:pt x="753" y="687"/>
                  </a:cubicBezTo>
                  <a:cubicBezTo>
                    <a:pt x="740" y="664"/>
                    <a:pt x="715" y="611"/>
                    <a:pt x="677" y="526"/>
                  </a:cubicBezTo>
                  <a:cubicBezTo>
                    <a:pt x="441" y="0"/>
                    <a:pt x="441" y="0"/>
                    <a:pt x="441" y="0"/>
                  </a:cubicBezTo>
                  <a:cubicBezTo>
                    <a:pt x="406" y="0"/>
                    <a:pt x="406" y="0"/>
                    <a:pt x="406" y="0"/>
                  </a:cubicBezTo>
                  <a:cubicBezTo>
                    <a:pt x="357" y="112"/>
                    <a:pt x="325" y="185"/>
                    <a:pt x="310" y="217"/>
                  </a:cubicBezTo>
                  <a:cubicBezTo>
                    <a:pt x="172" y="512"/>
                    <a:pt x="172" y="512"/>
                    <a:pt x="172" y="512"/>
                  </a:cubicBezTo>
                  <a:cubicBezTo>
                    <a:pt x="131" y="598"/>
                    <a:pt x="107" y="647"/>
                    <a:pt x="100" y="660"/>
                  </a:cubicBezTo>
                  <a:cubicBezTo>
                    <a:pt x="89" y="683"/>
                    <a:pt x="80" y="697"/>
                    <a:pt x="74" y="702"/>
                  </a:cubicBezTo>
                  <a:cubicBezTo>
                    <a:pt x="68" y="708"/>
                    <a:pt x="61" y="711"/>
                    <a:pt x="54" y="713"/>
                  </a:cubicBezTo>
                  <a:cubicBezTo>
                    <a:pt x="47" y="715"/>
                    <a:pt x="29" y="716"/>
                    <a:pt x="0" y="717"/>
                  </a:cubicBezTo>
                  <a:cubicBezTo>
                    <a:pt x="0" y="750"/>
                    <a:pt x="0" y="750"/>
                    <a:pt x="0" y="750"/>
                  </a:cubicBezTo>
                  <a:cubicBezTo>
                    <a:pt x="42" y="748"/>
                    <a:pt x="81" y="747"/>
                    <a:pt x="117" y="747"/>
                  </a:cubicBezTo>
                  <a:close/>
                  <a:moveTo>
                    <a:pt x="396" y="143"/>
                  </a:moveTo>
                  <a:cubicBezTo>
                    <a:pt x="534" y="458"/>
                    <a:pt x="534" y="458"/>
                    <a:pt x="534" y="458"/>
                  </a:cubicBezTo>
                  <a:cubicBezTo>
                    <a:pt x="256" y="458"/>
                    <a:pt x="256" y="458"/>
                    <a:pt x="256" y="458"/>
                  </a:cubicBezTo>
                  <a:lnTo>
                    <a:pt x="396" y="143"/>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0" name="Freeform 14"/>
            <p:cNvSpPr>
              <a:spLocks/>
            </p:cNvSpPr>
            <p:nvPr userDrawn="1"/>
          </p:nvSpPr>
          <p:spPr bwMode="auto">
            <a:xfrm>
              <a:off x="1309688" y="687388"/>
              <a:ext cx="260350" cy="234950"/>
            </a:xfrm>
            <a:custGeom>
              <a:avLst/>
              <a:gdLst>
                <a:gd name="T0" fmla="*/ 601 w 817"/>
                <a:gd name="T1" fmla="*/ 111 h 743"/>
                <a:gd name="T2" fmla="*/ 634 w 817"/>
                <a:gd name="T3" fmla="*/ 52 h 743"/>
                <a:gd name="T4" fmla="*/ 624 w 817"/>
                <a:gd name="T5" fmla="*/ 39 h 743"/>
                <a:gd name="T6" fmla="*/ 543 w 817"/>
                <a:gd name="T7" fmla="*/ 33 h 743"/>
                <a:gd name="T8" fmla="*/ 543 w 817"/>
                <a:gd name="T9" fmla="*/ 0 h 743"/>
                <a:gd name="T10" fmla="*/ 688 w 817"/>
                <a:gd name="T11" fmla="*/ 3 h 743"/>
                <a:gd name="T12" fmla="*/ 817 w 817"/>
                <a:gd name="T13" fmla="*/ 0 h 743"/>
                <a:gd name="T14" fmla="*/ 817 w 817"/>
                <a:gd name="T15" fmla="*/ 33 h 743"/>
                <a:gd name="T16" fmla="*/ 746 w 817"/>
                <a:gd name="T17" fmla="*/ 39 h 743"/>
                <a:gd name="T18" fmla="*/ 718 w 817"/>
                <a:gd name="T19" fmla="*/ 51 h 743"/>
                <a:gd name="T20" fmla="*/ 675 w 817"/>
                <a:gd name="T21" fmla="*/ 102 h 743"/>
                <a:gd name="T22" fmla="*/ 514 w 817"/>
                <a:gd name="T23" fmla="*/ 333 h 743"/>
                <a:gd name="T24" fmla="*/ 461 w 817"/>
                <a:gd name="T25" fmla="*/ 422 h 743"/>
                <a:gd name="T26" fmla="*/ 455 w 817"/>
                <a:gd name="T27" fmla="*/ 453 h 743"/>
                <a:gd name="T28" fmla="*/ 455 w 817"/>
                <a:gd name="T29" fmla="*/ 493 h 743"/>
                <a:gd name="T30" fmla="*/ 459 w 817"/>
                <a:gd name="T31" fmla="*/ 631 h 743"/>
                <a:gd name="T32" fmla="*/ 466 w 817"/>
                <a:gd name="T33" fmla="*/ 690 h 743"/>
                <a:gd name="T34" fmla="*/ 486 w 817"/>
                <a:gd name="T35" fmla="*/ 704 h 743"/>
                <a:gd name="T36" fmla="*/ 564 w 817"/>
                <a:gd name="T37" fmla="*/ 710 h 743"/>
                <a:gd name="T38" fmla="*/ 564 w 817"/>
                <a:gd name="T39" fmla="*/ 743 h 743"/>
                <a:gd name="T40" fmla="*/ 410 w 817"/>
                <a:gd name="T41" fmla="*/ 740 h 743"/>
                <a:gd name="T42" fmla="*/ 244 w 817"/>
                <a:gd name="T43" fmla="*/ 743 h 743"/>
                <a:gd name="T44" fmla="*/ 244 w 817"/>
                <a:gd name="T45" fmla="*/ 710 h 743"/>
                <a:gd name="T46" fmla="*/ 322 w 817"/>
                <a:gd name="T47" fmla="*/ 704 h 743"/>
                <a:gd name="T48" fmla="*/ 341 w 817"/>
                <a:gd name="T49" fmla="*/ 692 h 743"/>
                <a:gd name="T50" fmla="*/ 350 w 817"/>
                <a:gd name="T51" fmla="*/ 641 h 743"/>
                <a:gd name="T52" fmla="*/ 353 w 817"/>
                <a:gd name="T53" fmla="*/ 493 h 743"/>
                <a:gd name="T54" fmla="*/ 353 w 817"/>
                <a:gd name="T55" fmla="*/ 432 h 743"/>
                <a:gd name="T56" fmla="*/ 331 w 817"/>
                <a:gd name="T57" fmla="*/ 390 h 743"/>
                <a:gd name="T58" fmla="*/ 275 w 817"/>
                <a:gd name="T59" fmla="*/ 300 h 743"/>
                <a:gd name="T60" fmla="*/ 135 w 817"/>
                <a:gd name="T61" fmla="*/ 102 h 743"/>
                <a:gd name="T62" fmla="*/ 96 w 817"/>
                <a:gd name="T63" fmla="*/ 51 h 743"/>
                <a:gd name="T64" fmla="*/ 69 w 817"/>
                <a:gd name="T65" fmla="*/ 39 h 743"/>
                <a:gd name="T66" fmla="*/ 0 w 817"/>
                <a:gd name="T67" fmla="*/ 33 h 743"/>
                <a:gd name="T68" fmla="*/ 0 w 817"/>
                <a:gd name="T69" fmla="*/ 0 h 743"/>
                <a:gd name="T70" fmla="*/ 130 w 817"/>
                <a:gd name="T71" fmla="*/ 3 h 743"/>
                <a:gd name="T72" fmla="*/ 333 w 817"/>
                <a:gd name="T73" fmla="*/ 0 h 743"/>
                <a:gd name="T74" fmla="*/ 333 w 817"/>
                <a:gd name="T75" fmla="*/ 33 h 743"/>
                <a:gd name="T76" fmla="*/ 246 w 817"/>
                <a:gd name="T77" fmla="*/ 39 h 743"/>
                <a:gd name="T78" fmla="*/ 234 w 817"/>
                <a:gd name="T79" fmla="*/ 52 h 743"/>
                <a:gd name="T80" fmla="*/ 262 w 817"/>
                <a:gd name="T81" fmla="*/ 111 h 743"/>
                <a:gd name="T82" fmla="*/ 426 w 817"/>
                <a:gd name="T83" fmla="*/ 376 h 743"/>
                <a:gd name="T84" fmla="*/ 601 w 817"/>
                <a:gd name="T85" fmla="*/ 111 h 74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Lst>
              <a:rect l="0" t="0" r="r" b="b"/>
              <a:pathLst>
                <a:path w="817" h="743">
                  <a:moveTo>
                    <a:pt x="601" y="111"/>
                  </a:moveTo>
                  <a:cubicBezTo>
                    <a:pt x="623" y="78"/>
                    <a:pt x="634" y="59"/>
                    <a:pt x="634" y="52"/>
                  </a:cubicBezTo>
                  <a:cubicBezTo>
                    <a:pt x="634" y="46"/>
                    <a:pt x="631" y="41"/>
                    <a:pt x="624" y="39"/>
                  </a:cubicBezTo>
                  <a:cubicBezTo>
                    <a:pt x="616" y="36"/>
                    <a:pt x="585" y="34"/>
                    <a:pt x="543" y="33"/>
                  </a:cubicBezTo>
                  <a:cubicBezTo>
                    <a:pt x="543" y="0"/>
                    <a:pt x="543" y="0"/>
                    <a:pt x="543" y="0"/>
                  </a:cubicBezTo>
                  <a:cubicBezTo>
                    <a:pt x="610" y="2"/>
                    <a:pt x="650" y="3"/>
                    <a:pt x="688" y="3"/>
                  </a:cubicBezTo>
                  <a:cubicBezTo>
                    <a:pt x="725" y="3"/>
                    <a:pt x="745" y="2"/>
                    <a:pt x="817" y="0"/>
                  </a:cubicBezTo>
                  <a:cubicBezTo>
                    <a:pt x="817" y="33"/>
                    <a:pt x="817" y="33"/>
                    <a:pt x="817" y="33"/>
                  </a:cubicBezTo>
                  <a:cubicBezTo>
                    <a:pt x="773" y="34"/>
                    <a:pt x="757" y="36"/>
                    <a:pt x="746" y="39"/>
                  </a:cubicBezTo>
                  <a:cubicBezTo>
                    <a:pt x="735" y="41"/>
                    <a:pt x="725" y="46"/>
                    <a:pt x="718" y="51"/>
                  </a:cubicBezTo>
                  <a:cubicBezTo>
                    <a:pt x="709" y="58"/>
                    <a:pt x="695" y="75"/>
                    <a:pt x="675" y="102"/>
                  </a:cubicBezTo>
                  <a:cubicBezTo>
                    <a:pt x="514" y="333"/>
                    <a:pt x="514" y="333"/>
                    <a:pt x="514" y="333"/>
                  </a:cubicBezTo>
                  <a:cubicBezTo>
                    <a:pt x="483" y="381"/>
                    <a:pt x="465" y="411"/>
                    <a:pt x="461" y="422"/>
                  </a:cubicBezTo>
                  <a:cubicBezTo>
                    <a:pt x="457" y="433"/>
                    <a:pt x="455" y="443"/>
                    <a:pt x="455" y="453"/>
                  </a:cubicBezTo>
                  <a:cubicBezTo>
                    <a:pt x="455" y="493"/>
                    <a:pt x="455" y="493"/>
                    <a:pt x="455" y="493"/>
                  </a:cubicBezTo>
                  <a:cubicBezTo>
                    <a:pt x="455" y="541"/>
                    <a:pt x="456" y="587"/>
                    <a:pt x="459" y="631"/>
                  </a:cubicBezTo>
                  <a:cubicBezTo>
                    <a:pt x="460" y="665"/>
                    <a:pt x="462" y="684"/>
                    <a:pt x="466" y="690"/>
                  </a:cubicBezTo>
                  <a:cubicBezTo>
                    <a:pt x="470" y="696"/>
                    <a:pt x="477" y="701"/>
                    <a:pt x="486" y="704"/>
                  </a:cubicBezTo>
                  <a:cubicBezTo>
                    <a:pt x="495" y="707"/>
                    <a:pt x="521" y="709"/>
                    <a:pt x="564" y="710"/>
                  </a:cubicBezTo>
                  <a:cubicBezTo>
                    <a:pt x="564" y="743"/>
                    <a:pt x="564" y="743"/>
                    <a:pt x="564" y="743"/>
                  </a:cubicBezTo>
                  <a:cubicBezTo>
                    <a:pt x="505" y="741"/>
                    <a:pt x="453" y="740"/>
                    <a:pt x="410" y="740"/>
                  </a:cubicBezTo>
                  <a:cubicBezTo>
                    <a:pt x="368" y="740"/>
                    <a:pt x="313" y="741"/>
                    <a:pt x="244" y="743"/>
                  </a:cubicBezTo>
                  <a:cubicBezTo>
                    <a:pt x="244" y="710"/>
                    <a:pt x="244" y="710"/>
                    <a:pt x="244" y="710"/>
                  </a:cubicBezTo>
                  <a:cubicBezTo>
                    <a:pt x="287" y="709"/>
                    <a:pt x="313" y="707"/>
                    <a:pt x="322" y="704"/>
                  </a:cubicBezTo>
                  <a:cubicBezTo>
                    <a:pt x="332" y="701"/>
                    <a:pt x="338" y="697"/>
                    <a:pt x="341" y="692"/>
                  </a:cubicBezTo>
                  <a:cubicBezTo>
                    <a:pt x="346" y="685"/>
                    <a:pt x="349" y="668"/>
                    <a:pt x="350" y="641"/>
                  </a:cubicBezTo>
                  <a:cubicBezTo>
                    <a:pt x="350" y="634"/>
                    <a:pt x="351" y="585"/>
                    <a:pt x="353" y="493"/>
                  </a:cubicBezTo>
                  <a:cubicBezTo>
                    <a:pt x="353" y="432"/>
                    <a:pt x="353" y="432"/>
                    <a:pt x="353" y="432"/>
                  </a:cubicBezTo>
                  <a:cubicBezTo>
                    <a:pt x="345" y="417"/>
                    <a:pt x="338" y="403"/>
                    <a:pt x="331" y="390"/>
                  </a:cubicBezTo>
                  <a:cubicBezTo>
                    <a:pt x="325" y="382"/>
                    <a:pt x="307" y="352"/>
                    <a:pt x="275" y="300"/>
                  </a:cubicBezTo>
                  <a:cubicBezTo>
                    <a:pt x="135" y="102"/>
                    <a:pt x="135" y="102"/>
                    <a:pt x="135" y="102"/>
                  </a:cubicBezTo>
                  <a:cubicBezTo>
                    <a:pt x="118" y="75"/>
                    <a:pt x="105" y="58"/>
                    <a:pt x="96" y="51"/>
                  </a:cubicBezTo>
                  <a:cubicBezTo>
                    <a:pt x="89" y="46"/>
                    <a:pt x="80" y="41"/>
                    <a:pt x="69" y="39"/>
                  </a:cubicBezTo>
                  <a:cubicBezTo>
                    <a:pt x="58" y="36"/>
                    <a:pt x="44" y="34"/>
                    <a:pt x="0" y="33"/>
                  </a:cubicBezTo>
                  <a:cubicBezTo>
                    <a:pt x="0" y="0"/>
                    <a:pt x="0" y="0"/>
                    <a:pt x="0" y="0"/>
                  </a:cubicBezTo>
                  <a:cubicBezTo>
                    <a:pt x="72" y="2"/>
                    <a:pt x="94" y="3"/>
                    <a:pt x="130" y="3"/>
                  </a:cubicBezTo>
                  <a:cubicBezTo>
                    <a:pt x="168" y="3"/>
                    <a:pt x="265" y="2"/>
                    <a:pt x="333" y="0"/>
                  </a:cubicBezTo>
                  <a:cubicBezTo>
                    <a:pt x="333" y="33"/>
                    <a:pt x="333" y="33"/>
                    <a:pt x="333" y="33"/>
                  </a:cubicBezTo>
                  <a:cubicBezTo>
                    <a:pt x="291" y="34"/>
                    <a:pt x="254" y="36"/>
                    <a:pt x="246" y="39"/>
                  </a:cubicBezTo>
                  <a:cubicBezTo>
                    <a:pt x="239" y="41"/>
                    <a:pt x="235" y="46"/>
                    <a:pt x="234" y="52"/>
                  </a:cubicBezTo>
                  <a:cubicBezTo>
                    <a:pt x="234" y="59"/>
                    <a:pt x="243" y="78"/>
                    <a:pt x="262" y="111"/>
                  </a:cubicBezTo>
                  <a:cubicBezTo>
                    <a:pt x="426" y="376"/>
                    <a:pt x="426" y="376"/>
                    <a:pt x="426" y="376"/>
                  </a:cubicBezTo>
                  <a:lnTo>
                    <a:pt x="601" y="111"/>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1" name="Freeform 15"/>
            <p:cNvSpPr>
              <a:spLocks noEditPoints="1"/>
            </p:cNvSpPr>
            <p:nvPr userDrawn="1"/>
          </p:nvSpPr>
          <p:spPr bwMode="auto">
            <a:xfrm>
              <a:off x="1558925" y="681038"/>
              <a:ext cx="263525" cy="246063"/>
            </a:xfrm>
            <a:custGeom>
              <a:avLst/>
              <a:gdLst>
                <a:gd name="T0" fmla="*/ 148 w 830"/>
                <a:gd name="T1" fmla="*/ 190 h 775"/>
                <a:gd name="T2" fmla="*/ 247 w 830"/>
                <a:gd name="T3" fmla="*/ 82 h 775"/>
                <a:gd name="T4" fmla="*/ 399 w 830"/>
                <a:gd name="T5" fmla="*/ 45 h 775"/>
                <a:gd name="T6" fmla="*/ 512 w 830"/>
                <a:gd name="T7" fmla="*/ 62 h 775"/>
                <a:gd name="T8" fmla="*/ 596 w 830"/>
                <a:gd name="T9" fmla="*/ 106 h 775"/>
                <a:gd name="T10" fmla="*/ 652 w 830"/>
                <a:gd name="T11" fmla="*/ 167 h 775"/>
                <a:gd name="T12" fmla="*/ 690 w 830"/>
                <a:gd name="T13" fmla="*/ 245 h 775"/>
                <a:gd name="T14" fmla="*/ 713 w 830"/>
                <a:gd name="T15" fmla="*/ 398 h 775"/>
                <a:gd name="T16" fmla="*/ 681 w 830"/>
                <a:gd name="T17" fmla="*/ 571 h 775"/>
                <a:gd name="T18" fmla="*/ 584 w 830"/>
                <a:gd name="T19" fmla="*/ 686 h 775"/>
                <a:gd name="T20" fmla="*/ 431 w 830"/>
                <a:gd name="T21" fmla="*/ 727 h 775"/>
                <a:gd name="T22" fmla="*/ 315 w 830"/>
                <a:gd name="T23" fmla="*/ 707 h 775"/>
                <a:gd name="T24" fmla="*/ 220 w 830"/>
                <a:gd name="T25" fmla="*/ 644 h 775"/>
                <a:gd name="T26" fmla="*/ 151 w 830"/>
                <a:gd name="T27" fmla="*/ 539 h 775"/>
                <a:gd name="T28" fmla="*/ 125 w 830"/>
                <a:gd name="T29" fmla="*/ 450 h 775"/>
                <a:gd name="T30" fmla="*/ 115 w 830"/>
                <a:gd name="T31" fmla="*/ 349 h 775"/>
                <a:gd name="T32" fmla="*/ 148 w 830"/>
                <a:gd name="T33" fmla="*/ 190 h 775"/>
                <a:gd name="T34" fmla="*/ 26 w 830"/>
                <a:gd name="T35" fmla="*/ 541 h 775"/>
                <a:gd name="T36" fmla="*/ 105 w 830"/>
                <a:gd name="T37" fmla="*/ 669 h 775"/>
                <a:gd name="T38" fmla="*/ 231 w 830"/>
                <a:gd name="T39" fmla="*/ 748 h 775"/>
                <a:gd name="T40" fmla="*/ 392 w 830"/>
                <a:gd name="T41" fmla="*/ 775 h 775"/>
                <a:gd name="T42" fmla="*/ 706 w 830"/>
                <a:gd name="T43" fmla="*/ 657 h 775"/>
                <a:gd name="T44" fmla="*/ 830 w 830"/>
                <a:gd name="T45" fmla="*/ 364 h 775"/>
                <a:gd name="T46" fmla="*/ 817 w 830"/>
                <a:gd name="T47" fmla="*/ 261 h 775"/>
                <a:gd name="T48" fmla="*/ 784 w 830"/>
                <a:gd name="T49" fmla="*/ 177 h 775"/>
                <a:gd name="T50" fmla="*/ 709 w 830"/>
                <a:gd name="T51" fmla="*/ 89 h 775"/>
                <a:gd name="T52" fmla="*/ 588 w 830"/>
                <a:gd name="T53" fmla="*/ 25 h 775"/>
                <a:gd name="T54" fmla="*/ 423 w 830"/>
                <a:gd name="T55" fmla="*/ 0 h 775"/>
                <a:gd name="T56" fmla="*/ 249 w 830"/>
                <a:gd name="T57" fmla="*/ 29 h 775"/>
                <a:gd name="T58" fmla="*/ 112 w 830"/>
                <a:gd name="T59" fmla="*/ 113 h 775"/>
                <a:gd name="T60" fmla="*/ 26 w 830"/>
                <a:gd name="T61" fmla="*/ 239 h 775"/>
                <a:gd name="T62" fmla="*/ 0 w 830"/>
                <a:gd name="T63" fmla="*/ 393 h 775"/>
                <a:gd name="T64" fmla="*/ 26 w 830"/>
                <a:gd name="T65" fmla="*/ 541 h 77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Lst>
              <a:rect l="0" t="0" r="r" b="b"/>
              <a:pathLst>
                <a:path w="830" h="775">
                  <a:moveTo>
                    <a:pt x="148" y="190"/>
                  </a:moveTo>
                  <a:cubicBezTo>
                    <a:pt x="170" y="143"/>
                    <a:pt x="203" y="107"/>
                    <a:pt x="247" y="82"/>
                  </a:cubicBezTo>
                  <a:cubicBezTo>
                    <a:pt x="290" y="57"/>
                    <a:pt x="341" y="45"/>
                    <a:pt x="399" y="45"/>
                  </a:cubicBezTo>
                  <a:cubicBezTo>
                    <a:pt x="440" y="45"/>
                    <a:pt x="477" y="51"/>
                    <a:pt x="512" y="62"/>
                  </a:cubicBezTo>
                  <a:cubicBezTo>
                    <a:pt x="546" y="74"/>
                    <a:pt x="575" y="89"/>
                    <a:pt x="596" y="106"/>
                  </a:cubicBezTo>
                  <a:cubicBezTo>
                    <a:pt x="618" y="124"/>
                    <a:pt x="637" y="144"/>
                    <a:pt x="652" y="167"/>
                  </a:cubicBezTo>
                  <a:cubicBezTo>
                    <a:pt x="668" y="190"/>
                    <a:pt x="681" y="216"/>
                    <a:pt x="690" y="245"/>
                  </a:cubicBezTo>
                  <a:cubicBezTo>
                    <a:pt x="706" y="292"/>
                    <a:pt x="713" y="343"/>
                    <a:pt x="713" y="398"/>
                  </a:cubicBezTo>
                  <a:cubicBezTo>
                    <a:pt x="713" y="463"/>
                    <a:pt x="703" y="521"/>
                    <a:pt x="681" y="571"/>
                  </a:cubicBezTo>
                  <a:cubicBezTo>
                    <a:pt x="660" y="620"/>
                    <a:pt x="627" y="659"/>
                    <a:pt x="584" y="686"/>
                  </a:cubicBezTo>
                  <a:cubicBezTo>
                    <a:pt x="541" y="714"/>
                    <a:pt x="490" y="727"/>
                    <a:pt x="431" y="727"/>
                  </a:cubicBezTo>
                  <a:cubicBezTo>
                    <a:pt x="388" y="727"/>
                    <a:pt x="350" y="721"/>
                    <a:pt x="315" y="707"/>
                  </a:cubicBezTo>
                  <a:cubicBezTo>
                    <a:pt x="280" y="694"/>
                    <a:pt x="248" y="673"/>
                    <a:pt x="220" y="644"/>
                  </a:cubicBezTo>
                  <a:cubicBezTo>
                    <a:pt x="192" y="616"/>
                    <a:pt x="169" y="581"/>
                    <a:pt x="151" y="539"/>
                  </a:cubicBezTo>
                  <a:cubicBezTo>
                    <a:pt x="141" y="514"/>
                    <a:pt x="132" y="484"/>
                    <a:pt x="125" y="450"/>
                  </a:cubicBezTo>
                  <a:cubicBezTo>
                    <a:pt x="118" y="416"/>
                    <a:pt x="115" y="382"/>
                    <a:pt x="115" y="349"/>
                  </a:cubicBezTo>
                  <a:cubicBezTo>
                    <a:pt x="115" y="290"/>
                    <a:pt x="126" y="236"/>
                    <a:pt x="148" y="190"/>
                  </a:cubicBezTo>
                  <a:close/>
                  <a:moveTo>
                    <a:pt x="26" y="541"/>
                  </a:moveTo>
                  <a:cubicBezTo>
                    <a:pt x="44" y="591"/>
                    <a:pt x="70" y="634"/>
                    <a:pt x="105" y="669"/>
                  </a:cubicBezTo>
                  <a:cubicBezTo>
                    <a:pt x="139" y="704"/>
                    <a:pt x="181" y="730"/>
                    <a:pt x="231" y="748"/>
                  </a:cubicBezTo>
                  <a:cubicBezTo>
                    <a:pt x="281" y="765"/>
                    <a:pt x="335" y="775"/>
                    <a:pt x="392" y="775"/>
                  </a:cubicBezTo>
                  <a:cubicBezTo>
                    <a:pt x="518" y="775"/>
                    <a:pt x="623" y="736"/>
                    <a:pt x="706" y="657"/>
                  </a:cubicBezTo>
                  <a:cubicBezTo>
                    <a:pt x="788" y="579"/>
                    <a:pt x="830" y="481"/>
                    <a:pt x="830" y="364"/>
                  </a:cubicBezTo>
                  <a:cubicBezTo>
                    <a:pt x="830" y="327"/>
                    <a:pt x="826" y="293"/>
                    <a:pt x="817" y="261"/>
                  </a:cubicBezTo>
                  <a:cubicBezTo>
                    <a:pt x="809" y="228"/>
                    <a:pt x="798" y="200"/>
                    <a:pt x="784" y="177"/>
                  </a:cubicBezTo>
                  <a:cubicBezTo>
                    <a:pt x="766" y="145"/>
                    <a:pt x="741" y="116"/>
                    <a:pt x="709" y="89"/>
                  </a:cubicBezTo>
                  <a:cubicBezTo>
                    <a:pt x="678" y="62"/>
                    <a:pt x="637" y="41"/>
                    <a:pt x="588" y="25"/>
                  </a:cubicBezTo>
                  <a:cubicBezTo>
                    <a:pt x="538" y="8"/>
                    <a:pt x="484" y="0"/>
                    <a:pt x="423" y="0"/>
                  </a:cubicBezTo>
                  <a:cubicBezTo>
                    <a:pt x="358" y="0"/>
                    <a:pt x="300" y="10"/>
                    <a:pt x="249" y="29"/>
                  </a:cubicBezTo>
                  <a:cubicBezTo>
                    <a:pt x="198" y="48"/>
                    <a:pt x="152" y="76"/>
                    <a:pt x="112" y="113"/>
                  </a:cubicBezTo>
                  <a:cubicBezTo>
                    <a:pt x="72" y="151"/>
                    <a:pt x="43" y="193"/>
                    <a:pt x="26" y="239"/>
                  </a:cubicBezTo>
                  <a:cubicBezTo>
                    <a:pt x="8" y="286"/>
                    <a:pt x="0" y="337"/>
                    <a:pt x="0" y="393"/>
                  </a:cubicBezTo>
                  <a:cubicBezTo>
                    <a:pt x="0" y="441"/>
                    <a:pt x="9" y="491"/>
                    <a:pt x="26" y="541"/>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spTree>
    <p:extLst>
      <p:ext uri="{BB962C8B-B14F-4D97-AF65-F5344CB8AC3E}">
        <p14:creationId xmlns:p14="http://schemas.microsoft.com/office/powerpoint/2010/main" val="2900270017"/>
      </p:ext>
    </p:extLst>
  </p:cSld>
  <p:clrMapOvr>
    <a:masterClrMapping/>
  </p:clrMapOvr>
  <p:timing>
    <p:tnLst>
      <p:par>
        <p:cTn id="1" dur="indefinite" restart="never" nodeType="tmRoot"/>
      </p:par>
    </p:tn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58368" y="0"/>
            <a:ext cx="7827264" cy="1371600"/>
          </a:xfrm>
        </p:spPr>
        <p:txBody>
          <a:bodyPr anchor="b"/>
          <a:lstStyle>
            <a:lvl1pPr algn="l">
              <a:defRPr sz="3200" b="0"/>
            </a:lvl1pPr>
          </a:lstStyle>
          <a:p>
            <a:r>
              <a:rPr lang="en-US" smtClean="0"/>
              <a:t>Click to edit Master title style</a:t>
            </a:r>
            <a:endParaRPr lang="en-US" dirty="0"/>
          </a:p>
        </p:txBody>
      </p:sp>
      <p:sp>
        <p:nvSpPr>
          <p:cNvPr id="3" name="Picture Placeholder 2"/>
          <p:cNvSpPr>
            <a:spLocks noGrp="1"/>
          </p:cNvSpPr>
          <p:nvPr>
            <p:ph type="pic" idx="1"/>
          </p:nvPr>
        </p:nvSpPr>
        <p:spPr>
          <a:xfrm>
            <a:off x="658368" y="1444752"/>
            <a:ext cx="7827264" cy="4270248"/>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Click icon to add picture</a:t>
            </a:r>
            <a:endParaRPr lang="en-US" dirty="0"/>
          </a:p>
        </p:txBody>
      </p:sp>
      <p:sp>
        <p:nvSpPr>
          <p:cNvPr id="4" name="Text Placeholder 3"/>
          <p:cNvSpPr>
            <a:spLocks noGrp="1"/>
          </p:cNvSpPr>
          <p:nvPr>
            <p:ph type="body" sz="half" idx="2"/>
          </p:nvPr>
        </p:nvSpPr>
        <p:spPr>
          <a:xfrm>
            <a:off x="658368" y="5788152"/>
            <a:ext cx="7827264" cy="384048"/>
          </a:xfrm>
        </p:spPr>
        <p:txBody>
          <a:bodyPr tIns="45720" anchor="ctr" anchorCtr="0"/>
          <a:lstStyle>
            <a:lvl1pPr marL="0" indent="0">
              <a:spcBef>
                <a:spcPts val="0"/>
              </a:spcBef>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3FC8540-FD45-4545-82D8-C7EFE950ED53}" type="datetime1">
              <a:rPr lang="en-US" smtClean="0"/>
              <a:t>10/2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DC53FA5-AE81-45E0-8206-920AA27813B4}" type="slidenum">
              <a:rPr lang="en-US" smtClean="0"/>
              <a:t>‹#›</a:t>
            </a:fld>
            <a:endParaRPr lang="en-US"/>
          </a:p>
        </p:txBody>
      </p:sp>
      <p:grpSp>
        <p:nvGrpSpPr>
          <p:cNvPr id="21" name="Group 20"/>
          <p:cNvGrpSpPr/>
          <p:nvPr userDrawn="1"/>
        </p:nvGrpSpPr>
        <p:grpSpPr>
          <a:xfrm>
            <a:off x="120650" y="6299343"/>
            <a:ext cx="420688" cy="458645"/>
            <a:chOff x="657225" y="681038"/>
            <a:chExt cx="1266825" cy="1381125"/>
          </a:xfrm>
          <a:solidFill>
            <a:srgbClr val="FFFFFF"/>
          </a:solidFill>
        </p:grpSpPr>
        <p:sp>
          <p:nvSpPr>
            <p:cNvPr id="22" name="Freeform 5"/>
            <p:cNvSpPr>
              <a:spLocks noEditPoints="1"/>
            </p:cNvSpPr>
            <p:nvPr userDrawn="1"/>
          </p:nvSpPr>
          <p:spPr bwMode="auto">
            <a:xfrm>
              <a:off x="846138" y="1354138"/>
              <a:ext cx="887413" cy="708025"/>
            </a:xfrm>
            <a:custGeom>
              <a:avLst/>
              <a:gdLst>
                <a:gd name="T0" fmla="*/ 2203 w 2794"/>
                <a:gd name="T1" fmla="*/ 0 h 2229"/>
                <a:gd name="T2" fmla="*/ 1613 w 2794"/>
                <a:gd name="T3" fmla="*/ 0 h 2229"/>
                <a:gd name="T4" fmla="*/ 1613 w 2794"/>
                <a:gd name="T5" fmla="*/ 665 h 2229"/>
                <a:gd name="T6" fmla="*/ 1904 w 2794"/>
                <a:gd name="T7" fmla="*/ 1330 h 2229"/>
                <a:gd name="T8" fmla="*/ 1904 w 2794"/>
                <a:gd name="T9" fmla="*/ 1237 h 2229"/>
                <a:gd name="T10" fmla="*/ 1749 w 2794"/>
                <a:gd name="T11" fmla="*/ 747 h 2229"/>
                <a:gd name="T12" fmla="*/ 1749 w 2794"/>
                <a:gd name="T13" fmla="*/ 573 h 2229"/>
                <a:gd name="T14" fmla="*/ 1972 w 2794"/>
                <a:gd name="T15" fmla="*/ 573 h 2229"/>
                <a:gd name="T16" fmla="*/ 1972 w 2794"/>
                <a:gd name="T17" fmla="*/ 1332 h 2229"/>
                <a:gd name="T18" fmla="*/ 1401 w 2794"/>
                <a:gd name="T19" fmla="*/ 2182 h 2229"/>
                <a:gd name="T20" fmla="*/ 829 w 2794"/>
                <a:gd name="T21" fmla="*/ 1374 h 2229"/>
                <a:gd name="T22" fmla="*/ 1180 w 2794"/>
                <a:gd name="T23" fmla="*/ 665 h 2229"/>
                <a:gd name="T24" fmla="*/ 1180 w 2794"/>
                <a:gd name="T25" fmla="*/ 573 h 2229"/>
                <a:gd name="T26" fmla="*/ 1401 w 2794"/>
                <a:gd name="T27" fmla="*/ 573 h 2229"/>
                <a:gd name="T28" fmla="*/ 1542 w 2794"/>
                <a:gd name="T29" fmla="*/ 573 h 2229"/>
                <a:gd name="T30" fmla="*/ 1542 w 2794"/>
                <a:gd name="T31" fmla="*/ 436 h 2229"/>
                <a:gd name="T32" fmla="*/ 1401 w 2794"/>
                <a:gd name="T33" fmla="*/ 436 h 2229"/>
                <a:gd name="T34" fmla="*/ 1180 w 2794"/>
                <a:gd name="T35" fmla="*/ 436 h 2229"/>
                <a:gd name="T36" fmla="*/ 1180 w 2794"/>
                <a:gd name="T37" fmla="*/ 436 h 2229"/>
                <a:gd name="T38" fmla="*/ 1044 w 2794"/>
                <a:gd name="T39" fmla="*/ 436 h 2229"/>
                <a:gd name="T40" fmla="*/ 1044 w 2794"/>
                <a:gd name="T41" fmla="*/ 436 h 2229"/>
                <a:gd name="T42" fmla="*/ 692 w 2794"/>
                <a:gd name="T43" fmla="*/ 436 h 2229"/>
                <a:gd name="T44" fmla="*/ 692 w 2794"/>
                <a:gd name="T45" fmla="*/ 1234 h 2229"/>
                <a:gd name="T46" fmla="*/ 695 w 2794"/>
                <a:gd name="T47" fmla="*/ 1315 h 2229"/>
                <a:gd name="T48" fmla="*/ 695 w 2794"/>
                <a:gd name="T49" fmla="*/ 1315 h 2229"/>
                <a:gd name="T50" fmla="*/ 829 w 2794"/>
                <a:gd name="T51" fmla="*/ 1205 h 2229"/>
                <a:gd name="T52" fmla="*/ 829 w 2794"/>
                <a:gd name="T53" fmla="*/ 1205 h 2229"/>
                <a:gd name="T54" fmla="*/ 829 w 2794"/>
                <a:gd name="T55" fmla="*/ 573 h 2229"/>
                <a:gd name="T56" fmla="*/ 1044 w 2794"/>
                <a:gd name="T57" fmla="*/ 573 h 2229"/>
                <a:gd name="T58" fmla="*/ 1044 w 2794"/>
                <a:gd name="T59" fmla="*/ 573 h 2229"/>
                <a:gd name="T60" fmla="*/ 1044 w 2794"/>
                <a:gd name="T61" fmla="*/ 747 h 2229"/>
                <a:gd name="T62" fmla="*/ 590 w 2794"/>
                <a:gd name="T63" fmla="*/ 1447 h 2229"/>
                <a:gd name="T64" fmla="*/ 135 w 2794"/>
                <a:gd name="T65" fmla="*/ 747 h 2229"/>
                <a:gd name="T66" fmla="*/ 135 w 2794"/>
                <a:gd name="T67" fmla="*/ 136 h 2229"/>
                <a:gd name="T68" fmla="*/ 590 w 2794"/>
                <a:gd name="T69" fmla="*/ 136 h 2229"/>
                <a:gd name="T70" fmla="*/ 1044 w 2794"/>
                <a:gd name="T71" fmla="*/ 136 h 2229"/>
                <a:gd name="T72" fmla="*/ 1044 w 2794"/>
                <a:gd name="T73" fmla="*/ 370 h 2229"/>
                <a:gd name="T74" fmla="*/ 1180 w 2794"/>
                <a:gd name="T75" fmla="*/ 370 h 2229"/>
                <a:gd name="T76" fmla="*/ 1180 w 2794"/>
                <a:gd name="T77" fmla="*/ 0 h 2229"/>
                <a:gd name="T78" fmla="*/ 590 w 2794"/>
                <a:gd name="T79" fmla="*/ 0 h 2229"/>
                <a:gd name="T80" fmla="*/ 0 w 2794"/>
                <a:gd name="T81" fmla="*/ 0 h 2229"/>
                <a:gd name="T82" fmla="*/ 0 w 2794"/>
                <a:gd name="T83" fmla="*/ 665 h 2229"/>
                <a:gd name="T84" fmla="*/ 590 w 2794"/>
                <a:gd name="T85" fmla="*/ 1495 h 2229"/>
                <a:gd name="T86" fmla="*/ 708 w 2794"/>
                <a:gd name="T87" fmla="*/ 1444 h 2229"/>
                <a:gd name="T88" fmla="*/ 1401 w 2794"/>
                <a:gd name="T89" fmla="*/ 2229 h 2229"/>
                <a:gd name="T90" fmla="*/ 2093 w 2794"/>
                <a:gd name="T91" fmla="*/ 1447 h 2229"/>
                <a:gd name="T92" fmla="*/ 2203 w 2794"/>
                <a:gd name="T93" fmla="*/ 1495 h 2229"/>
                <a:gd name="T94" fmla="*/ 2794 w 2794"/>
                <a:gd name="T95" fmla="*/ 665 h 2229"/>
                <a:gd name="T96" fmla="*/ 2794 w 2794"/>
                <a:gd name="T97" fmla="*/ 0 h 2229"/>
                <a:gd name="T98" fmla="*/ 2203 w 2794"/>
                <a:gd name="T99" fmla="*/ 0 h 2229"/>
                <a:gd name="T100" fmla="*/ 2658 w 2794"/>
                <a:gd name="T101" fmla="*/ 747 h 2229"/>
                <a:gd name="T102" fmla="*/ 2203 w 2794"/>
                <a:gd name="T103" fmla="*/ 1447 h 2229"/>
                <a:gd name="T104" fmla="*/ 2100 w 2794"/>
                <a:gd name="T105" fmla="*/ 1395 h 2229"/>
                <a:gd name="T106" fmla="*/ 2109 w 2794"/>
                <a:gd name="T107" fmla="*/ 1234 h 2229"/>
                <a:gd name="T108" fmla="*/ 2109 w 2794"/>
                <a:gd name="T109" fmla="*/ 436 h 2229"/>
                <a:gd name="T110" fmla="*/ 1749 w 2794"/>
                <a:gd name="T111" fmla="*/ 436 h 2229"/>
                <a:gd name="T112" fmla="*/ 1749 w 2794"/>
                <a:gd name="T113" fmla="*/ 136 h 2229"/>
                <a:gd name="T114" fmla="*/ 2203 w 2794"/>
                <a:gd name="T115" fmla="*/ 136 h 2229"/>
                <a:gd name="T116" fmla="*/ 2658 w 2794"/>
                <a:gd name="T117" fmla="*/ 136 h 2229"/>
                <a:gd name="T118" fmla="*/ 2658 w 2794"/>
                <a:gd name="T119" fmla="*/ 747 h 222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 ang="0">
                  <a:pos x="T118" y="T119"/>
                </a:cxn>
              </a:cxnLst>
              <a:rect l="0" t="0" r="r" b="b"/>
              <a:pathLst>
                <a:path w="2794" h="2229">
                  <a:moveTo>
                    <a:pt x="2203" y="0"/>
                  </a:moveTo>
                  <a:cubicBezTo>
                    <a:pt x="1613" y="0"/>
                    <a:pt x="1613" y="0"/>
                    <a:pt x="1613" y="0"/>
                  </a:cubicBezTo>
                  <a:cubicBezTo>
                    <a:pt x="1613" y="665"/>
                    <a:pt x="1613" y="665"/>
                    <a:pt x="1613" y="665"/>
                  </a:cubicBezTo>
                  <a:cubicBezTo>
                    <a:pt x="1613" y="970"/>
                    <a:pt x="1719" y="1183"/>
                    <a:pt x="1904" y="1330"/>
                  </a:cubicBezTo>
                  <a:cubicBezTo>
                    <a:pt x="1904" y="1237"/>
                    <a:pt x="1904" y="1237"/>
                    <a:pt x="1904" y="1237"/>
                  </a:cubicBezTo>
                  <a:cubicBezTo>
                    <a:pt x="1769" y="1081"/>
                    <a:pt x="1749" y="901"/>
                    <a:pt x="1749" y="747"/>
                  </a:cubicBezTo>
                  <a:cubicBezTo>
                    <a:pt x="1749" y="573"/>
                    <a:pt x="1749" y="573"/>
                    <a:pt x="1749" y="573"/>
                  </a:cubicBezTo>
                  <a:cubicBezTo>
                    <a:pt x="1972" y="573"/>
                    <a:pt x="1972" y="573"/>
                    <a:pt x="1972" y="573"/>
                  </a:cubicBezTo>
                  <a:cubicBezTo>
                    <a:pt x="1972" y="1332"/>
                    <a:pt x="1972" y="1332"/>
                    <a:pt x="1972" y="1332"/>
                  </a:cubicBezTo>
                  <a:cubicBezTo>
                    <a:pt x="1972" y="1609"/>
                    <a:pt x="1895" y="1961"/>
                    <a:pt x="1401" y="2182"/>
                  </a:cubicBezTo>
                  <a:cubicBezTo>
                    <a:pt x="931" y="1972"/>
                    <a:pt x="838" y="1643"/>
                    <a:pt x="829" y="1374"/>
                  </a:cubicBezTo>
                  <a:cubicBezTo>
                    <a:pt x="1051" y="1225"/>
                    <a:pt x="1180" y="1001"/>
                    <a:pt x="1180" y="665"/>
                  </a:cubicBezTo>
                  <a:cubicBezTo>
                    <a:pt x="1180" y="573"/>
                    <a:pt x="1180" y="573"/>
                    <a:pt x="1180" y="573"/>
                  </a:cubicBezTo>
                  <a:cubicBezTo>
                    <a:pt x="1401" y="573"/>
                    <a:pt x="1401" y="573"/>
                    <a:pt x="1401" y="573"/>
                  </a:cubicBezTo>
                  <a:cubicBezTo>
                    <a:pt x="1542" y="573"/>
                    <a:pt x="1542" y="573"/>
                    <a:pt x="1542" y="573"/>
                  </a:cubicBezTo>
                  <a:cubicBezTo>
                    <a:pt x="1542" y="436"/>
                    <a:pt x="1542" y="436"/>
                    <a:pt x="1542" y="436"/>
                  </a:cubicBezTo>
                  <a:cubicBezTo>
                    <a:pt x="1401" y="436"/>
                    <a:pt x="1401" y="436"/>
                    <a:pt x="1401" y="436"/>
                  </a:cubicBezTo>
                  <a:cubicBezTo>
                    <a:pt x="1180" y="436"/>
                    <a:pt x="1180" y="436"/>
                    <a:pt x="1180" y="436"/>
                  </a:cubicBezTo>
                  <a:cubicBezTo>
                    <a:pt x="1180" y="436"/>
                    <a:pt x="1180" y="436"/>
                    <a:pt x="1180" y="436"/>
                  </a:cubicBezTo>
                  <a:cubicBezTo>
                    <a:pt x="1044" y="436"/>
                    <a:pt x="1044" y="436"/>
                    <a:pt x="1044" y="436"/>
                  </a:cubicBezTo>
                  <a:cubicBezTo>
                    <a:pt x="1044" y="436"/>
                    <a:pt x="1044" y="436"/>
                    <a:pt x="1044" y="436"/>
                  </a:cubicBezTo>
                  <a:cubicBezTo>
                    <a:pt x="692" y="436"/>
                    <a:pt x="692" y="436"/>
                    <a:pt x="692" y="436"/>
                  </a:cubicBezTo>
                  <a:cubicBezTo>
                    <a:pt x="692" y="1234"/>
                    <a:pt x="692" y="1234"/>
                    <a:pt x="692" y="1234"/>
                  </a:cubicBezTo>
                  <a:cubicBezTo>
                    <a:pt x="692" y="1262"/>
                    <a:pt x="693" y="1289"/>
                    <a:pt x="695" y="1315"/>
                  </a:cubicBezTo>
                  <a:cubicBezTo>
                    <a:pt x="695" y="1315"/>
                    <a:pt x="695" y="1315"/>
                    <a:pt x="695" y="1315"/>
                  </a:cubicBezTo>
                  <a:cubicBezTo>
                    <a:pt x="748" y="1280"/>
                    <a:pt x="792" y="1244"/>
                    <a:pt x="829" y="1205"/>
                  </a:cubicBezTo>
                  <a:cubicBezTo>
                    <a:pt x="829" y="1205"/>
                    <a:pt x="829" y="1205"/>
                    <a:pt x="829" y="1205"/>
                  </a:cubicBezTo>
                  <a:cubicBezTo>
                    <a:pt x="829" y="573"/>
                    <a:pt x="829" y="573"/>
                    <a:pt x="829" y="573"/>
                  </a:cubicBezTo>
                  <a:cubicBezTo>
                    <a:pt x="1044" y="573"/>
                    <a:pt x="1044" y="573"/>
                    <a:pt x="1044" y="573"/>
                  </a:cubicBezTo>
                  <a:cubicBezTo>
                    <a:pt x="1044" y="573"/>
                    <a:pt x="1044" y="573"/>
                    <a:pt x="1044" y="573"/>
                  </a:cubicBezTo>
                  <a:cubicBezTo>
                    <a:pt x="1044" y="747"/>
                    <a:pt x="1044" y="747"/>
                    <a:pt x="1044" y="747"/>
                  </a:cubicBezTo>
                  <a:cubicBezTo>
                    <a:pt x="1044" y="978"/>
                    <a:pt x="1001" y="1263"/>
                    <a:pt x="590" y="1447"/>
                  </a:cubicBezTo>
                  <a:cubicBezTo>
                    <a:pt x="178" y="1263"/>
                    <a:pt x="135" y="978"/>
                    <a:pt x="135" y="747"/>
                  </a:cubicBezTo>
                  <a:cubicBezTo>
                    <a:pt x="135" y="136"/>
                    <a:pt x="135" y="136"/>
                    <a:pt x="135" y="136"/>
                  </a:cubicBezTo>
                  <a:cubicBezTo>
                    <a:pt x="590" y="136"/>
                    <a:pt x="590" y="136"/>
                    <a:pt x="590" y="136"/>
                  </a:cubicBezTo>
                  <a:cubicBezTo>
                    <a:pt x="1044" y="136"/>
                    <a:pt x="1044" y="136"/>
                    <a:pt x="1044" y="136"/>
                  </a:cubicBezTo>
                  <a:cubicBezTo>
                    <a:pt x="1044" y="370"/>
                    <a:pt x="1044" y="370"/>
                    <a:pt x="1044" y="370"/>
                  </a:cubicBezTo>
                  <a:cubicBezTo>
                    <a:pt x="1180" y="370"/>
                    <a:pt x="1180" y="370"/>
                    <a:pt x="1180" y="370"/>
                  </a:cubicBezTo>
                  <a:cubicBezTo>
                    <a:pt x="1180" y="0"/>
                    <a:pt x="1180" y="0"/>
                    <a:pt x="1180" y="0"/>
                  </a:cubicBezTo>
                  <a:cubicBezTo>
                    <a:pt x="590" y="0"/>
                    <a:pt x="590" y="0"/>
                    <a:pt x="590" y="0"/>
                  </a:cubicBezTo>
                  <a:cubicBezTo>
                    <a:pt x="0" y="0"/>
                    <a:pt x="0" y="0"/>
                    <a:pt x="0" y="0"/>
                  </a:cubicBezTo>
                  <a:cubicBezTo>
                    <a:pt x="0" y="665"/>
                    <a:pt x="0" y="665"/>
                    <a:pt x="0" y="665"/>
                  </a:cubicBezTo>
                  <a:cubicBezTo>
                    <a:pt x="0" y="1109"/>
                    <a:pt x="224" y="1357"/>
                    <a:pt x="590" y="1495"/>
                  </a:cubicBezTo>
                  <a:cubicBezTo>
                    <a:pt x="631" y="1479"/>
                    <a:pt x="670" y="1462"/>
                    <a:pt x="708" y="1444"/>
                  </a:cubicBezTo>
                  <a:cubicBezTo>
                    <a:pt x="771" y="1847"/>
                    <a:pt x="1023" y="2087"/>
                    <a:pt x="1401" y="2229"/>
                  </a:cubicBezTo>
                  <a:cubicBezTo>
                    <a:pt x="1777" y="2087"/>
                    <a:pt x="2029" y="1848"/>
                    <a:pt x="2093" y="1447"/>
                  </a:cubicBezTo>
                  <a:cubicBezTo>
                    <a:pt x="2128" y="1464"/>
                    <a:pt x="2165" y="1480"/>
                    <a:pt x="2203" y="1495"/>
                  </a:cubicBezTo>
                  <a:cubicBezTo>
                    <a:pt x="2569" y="1357"/>
                    <a:pt x="2794" y="1109"/>
                    <a:pt x="2794" y="665"/>
                  </a:cubicBezTo>
                  <a:cubicBezTo>
                    <a:pt x="2794" y="0"/>
                    <a:pt x="2794" y="0"/>
                    <a:pt x="2794" y="0"/>
                  </a:cubicBezTo>
                  <a:lnTo>
                    <a:pt x="2203" y="0"/>
                  </a:lnTo>
                  <a:close/>
                  <a:moveTo>
                    <a:pt x="2658" y="747"/>
                  </a:moveTo>
                  <a:cubicBezTo>
                    <a:pt x="2658" y="978"/>
                    <a:pt x="2615" y="1263"/>
                    <a:pt x="2203" y="1447"/>
                  </a:cubicBezTo>
                  <a:cubicBezTo>
                    <a:pt x="2166" y="1431"/>
                    <a:pt x="2131" y="1413"/>
                    <a:pt x="2100" y="1395"/>
                  </a:cubicBezTo>
                  <a:cubicBezTo>
                    <a:pt x="2106" y="1344"/>
                    <a:pt x="2109" y="1290"/>
                    <a:pt x="2109" y="1234"/>
                  </a:cubicBezTo>
                  <a:cubicBezTo>
                    <a:pt x="2109" y="436"/>
                    <a:pt x="2109" y="436"/>
                    <a:pt x="2109" y="436"/>
                  </a:cubicBezTo>
                  <a:cubicBezTo>
                    <a:pt x="1749" y="436"/>
                    <a:pt x="1749" y="436"/>
                    <a:pt x="1749" y="436"/>
                  </a:cubicBezTo>
                  <a:cubicBezTo>
                    <a:pt x="1749" y="136"/>
                    <a:pt x="1749" y="136"/>
                    <a:pt x="1749" y="136"/>
                  </a:cubicBezTo>
                  <a:cubicBezTo>
                    <a:pt x="2203" y="136"/>
                    <a:pt x="2203" y="136"/>
                    <a:pt x="2203" y="136"/>
                  </a:cubicBezTo>
                  <a:cubicBezTo>
                    <a:pt x="2658" y="136"/>
                    <a:pt x="2658" y="136"/>
                    <a:pt x="2658" y="136"/>
                  </a:cubicBezTo>
                  <a:lnTo>
                    <a:pt x="2658" y="74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3" name="Freeform 6"/>
            <p:cNvSpPr>
              <a:spLocks/>
            </p:cNvSpPr>
            <p:nvPr userDrawn="1"/>
          </p:nvSpPr>
          <p:spPr bwMode="auto">
            <a:xfrm>
              <a:off x="915988" y="1003301"/>
              <a:ext cx="188913" cy="236538"/>
            </a:xfrm>
            <a:custGeom>
              <a:avLst/>
              <a:gdLst>
                <a:gd name="T0" fmla="*/ 49 w 596"/>
                <a:gd name="T1" fmla="*/ 747 h 747"/>
                <a:gd name="T2" fmla="*/ 49 w 596"/>
                <a:gd name="T3" fmla="*/ 721 h 747"/>
                <a:gd name="T4" fmla="*/ 91 w 596"/>
                <a:gd name="T5" fmla="*/ 696 h 747"/>
                <a:gd name="T6" fmla="*/ 99 w 596"/>
                <a:gd name="T7" fmla="*/ 684 h 747"/>
                <a:gd name="T8" fmla="*/ 105 w 596"/>
                <a:gd name="T9" fmla="*/ 621 h 747"/>
                <a:gd name="T10" fmla="*/ 109 w 596"/>
                <a:gd name="T11" fmla="*/ 535 h 747"/>
                <a:gd name="T12" fmla="*/ 109 w 596"/>
                <a:gd name="T13" fmla="*/ 252 h 747"/>
                <a:gd name="T14" fmla="*/ 105 w 596"/>
                <a:gd name="T15" fmla="*/ 112 h 747"/>
                <a:gd name="T16" fmla="*/ 98 w 596"/>
                <a:gd name="T17" fmla="*/ 52 h 747"/>
                <a:gd name="T18" fmla="*/ 78 w 596"/>
                <a:gd name="T19" fmla="*/ 39 h 747"/>
                <a:gd name="T20" fmla="*/ 0 w 596"/>
                <a:gd name="T21" fmla="*/ 33 h 747"/>
                <a:gd name="T22" fmla="*/ 0 w 596"/>
                <a:gd name="T23" fmla="*/ 0 h 747"/>
                <a:gd name="T24" fmla="*/ 165 w 596"/>
                <a:gd name="T25" fmla="*/ 3 h 747"/>
                <a:gd name="T26" fmla="*/ 323 w 596"/>
                <a:gd name="T27" fmla="*/ 0 h 747"/>
                <a:gd name="T28" fmla="*/ 323 w 596"/>
                <a:gd name="T29" fmla="*/ 33 h 747"/>
                <a:gd name="T30" fmla="*/ 243 w 596"/>
                <a:gd name="T31" fmla="*/ 39 h 747"/>
                <a:gd name="T32" fmla="*/ 224 w 596"/>
                <a:gd name="T33" fmla="*/ 51 h 747"/>
                <a:gd name="T34" fmla="*/ 216 w 596"/>
                <a:gd name="T35" fmla="*/ 102 h 747"/>
                <a:gd name="T36" fmla="*/ 213 w 596"/>
                <a:gd name="T37" fmla="*/ 252 h 747"/>
                <a:gd name="T38" fmla="*/ 213 w 596"/>
                <a:gd name="T39" fmla="*/ 606 h 747"/>
                <a:gd name="T40" fmla="*/ 216 w 596"/>
                <a:gd name="T41" fmla="*/ 696 h 747"/>
                <a:gd name="T42" fmla="*/ 303 w 596"/>
                <a:gd name="T43" fmla="*/ 700 h 747"/>
                <a:gd name="T44" fmla="*/ 525 w 596"/>
                <a:gd name="T45" fmla="*/ 681 h 747"/>
                <a:gd name="T46" fmla="*/ 538 w 596"/>
                <a:gd name="T47" fmla="*/ 644 h 747"/>
                <a:gd name="T48" fmla="*/ 560 w 596"/>
                <a:gd name="T49" fmla="*/ 557 h 747"/>
                <a:gd name="T50" fmla="*/ 596 w 596"/>
                <a:gd name="T51" fmla="*/ 557 h 747"/>
                <a:gd name="T52" fmla="*/ 573 w 596"/>
                <a:gd name="T53" fmla="*/ 741 h 747"/>
                <a:gd name="T54" fmla="*/ 537 w 596"/>
                <a:gd name="T55" fmla="*/ 746 h 747"/>
                <a:gd name="T56" fmla="*/ 449 w 596"/>
                <a:gd name="T57" fmla="*/ 747 h 747"/>
                <a:gd name="T58" fmla="*/ 156 w 596"/>
                <a:gd name="T59" fmla="*/ 744 h 747"/>
                <a:gd name="T60" fmla="*/ 49 w 596"/>
                <a:gd name="T61" fmla="*/ 747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Lst>
              <a:rect l="0" t="0" r="r" b="b"/>
              <a:pathLst>
                <a:path w="596" h="747">
                  <a:moveTo>
                    <a:pt x="49" y="747"/>
                  </a:moveTo>
                  <a:cubicBezTo>
                    <a:pt x="49" y="721"/>
                    <a:pt x="49" y="721"/>
                    <a:pt x="49" y="721"/>
                  </a:cubicBezTo>
                  <a:cubicBezTo>
                    <a:pt x="71" y="710"/>
                    <a:pt x="85" y="702"/>
                    <a:pt x="91" y="696"/>
                  </a:cubicBezTo>
                  <a:cubicBezTo>
                    <a:pt x="95" y="693"/>
                    <a:pt x="98" y="689"/>
                    <a:pt x="99" y="684"/>
                  </a:cubicBezTo>
                  <a:cubicBezTo>
                    <a:pt x="102" y="675"/>
                    <a:pt x="104" y="654"/>
                    <a:pt x="105" y="621"/>
                  </a:cubicBezTo>
                  <a:cubicBezTo>
                    <a:pt x="108" y="573"/>
                    <a:pt x="109" y="545"/>
                    <a:pt x="109" y="535"/>
                  </a:cubicBezTo>
                  <a:cubicBezTo>
                    <a:pt x="109" y="252"/>
                    <a:pt x="109" y="252"/>
                    <a:pt x="109" y="252"/>
                  </a:cubicBezTo>
                  <a:cubicBezTo>
                    <a:pt x="109" y="204"/>
                    <a:pt x="108" y="157"/>
                    <a:pt x="105" y="112"/>
                  </a:cubicBezTo>
                  <a:cubicBezTo>
                    <a:pt x="104" y="78"/>
                    <a:pt x="102" y="59"/>
                    <a:pt x="98" y="52"/>
                  </a:cubicBezTo>
                  <a:cubicBezTo>
                    <a:pt x="93" y="46"/>
                    <a:pt x="87" y="42"/>
                    <a:pt x="78" y="39"/>
                  </a:cubicBezTo>
                  <a:cubicBezTo>
                    <a:pt x="69" y="36"/>
                    <a:pt x="43" y="34"/>
                    <a:pt x="0" y="33"/>
                  </a:cubicBezTo>
                  <a:cubicBezTo>
                    <a:pt x="0" y="0"/>
                    <a:pt x="0" y="0"/>
                    <a:pt x="0" y="0"/>
                  </a:cubicBezTo>
                  <a:cubicBezTo>
                    <a:pt x="89" y="2"/>
                    <a:pt x="144" y="3"/>
                    <a:pt x="165" y="3"/>
                  </a:cubicBezTo>
                  <a:cubicBezTo>
                    <a:pt x="189" y="3"/>
                    <a:pt x="241" y="2"/>
                    <a:pt x="323" y="0"/>
                  </a:cubicBezTo>
                  <a:cubicBezTo>
                    <a:pt x="323" y="33"/>
                    <a:pt x="323" y="33"/>
                    <a:pt x="323" y="33"/>
                  </a:cubicBezTo>
                  <a:cubicBezTo>
                    <a:pt x="279" y="34"/>
                    <a:pt x="253" y="36"/>
                    <a:pt x="243" y="39"/>
                  </a:cubicBezTo>
                  <a:cubicBezTo>
                    <a:pt x="234" y="42"/>
                    <a:pt x="228" y="46"/>
                    <a:pt x="224" y="51"/>
                  </a:cubicBezTo>
                  <a:cubicBezTo>
                    <a:pt x="220" y="58"/>
                    <a:pt x="217" y="75"/>
                    <a:pt x="216" y="102"/>
                  </a:cubicBezTo>
                  <a:cubicBezTo>
                    <a:pt x="215" y="109"/>
                    <a:pt x="214" y="159"/>
                    <a:pt x="213" y="252"/>
                  </a:cubicBezTo>
                  <a:cubicBezTo>
                    <a:pt x="213" y="606"/>
                    <a:pt x="213" y="606"/>
                    <a:pt x="213" y="606"/>
                  </a:cubicBezTo>
                  <a:cubicBezTo>
                    <a:pt x="213" y="643"/>
                    <a:pt x="214" y="673"/>
                    <a:pt x="216" y="696"/>
                  </a:cubicBezTo>
                  <a:cubicBezTo>
                    <a:pt x="257" y="699"/>
                    <a:pt x="262" y="700"/>
                    <a:pt x="303" y="700"/>
                  </a:cubicBezTo>
                  <a:cubicBezTo>
                    <a:pt x="407" y="700"/>
                    <a:pt x="484" y="693"/>
                    <a:pt x="525" y="681"/>
                  </a:cubicBezTo>
                  <a:cubicBezTo>
                    <a:pt x="530" y="670"/>
                    <a:pt x="534" y="658"/>
                    <a:pt x="538" y="644"/>
                  </a:cubicBezTo>
                  <a:cubicBezTo>
                    <a:pt x="560" y="557"/>
                    <a:pt x="560" y="557"/>
                    <a:pt x="560" y="557"/>
                  </a:cubicBezTo>
                  <a:cubicBezTo>
                    <a:pt x="596" y="557"/>
                    <a:pt x="596" y="557"/>
                    <a:pt x="596" y="557"/>
                  </a:cubicBezTo>
                  <a:cubicBezTo>
                    <a:pt x="588" y="609"/>
                    <a:pt x="580" y="671"/>
                    <a:pt x="573" y="741"/>
                  </a:cubicBezTo>
                  <a:cubicBezTo>
                    <a:pt x="558" y="744"/>
                    <a:pt x="546" y="745"/>
                    <a:pt x="537" y="746"/>
                  </a:cubicBezTo>
                  <a:cubicBezTo>
                    <a:pt x="518" y="747"/>
                    <a:pt x="488" y="747"/>
                    <a:pt x="449" y="747"/>
                  </a:cubicBezTo>
                  <a:cubicBezTo>
                    <a:pt x="156" y="744"/>
                    <a:pt x="156" y="744"/>
                    <a:pt x="156" y="744"/>
                  </a:cubicBezTo>
                  <a:cubicBezTo>
                    <a:pt x="121" y="744"/>
                    <a:pt x="85" y="745"/>
                    <a:pt x="49"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4" name="Freeform 7"/>
            <p:cNvSpPr>
              <a:spLocks/>
            </p:cNvSpPr>
            <p:nvPr userDrawn="1"/>
          </p:nvSpPr>
          <p:spPr bwMode="auto">
            <a:xfrm>
              <a:off x="1127125" y="1003301"/>
              <a:ext cx="103188" cy="236538"/>
            </a:xfrm>
            <a:custGeom>
              <a:avLst/>
              <a:gdLst>
                <a:gd name="T0" fmla="*/ 321 w 321"/>
                <a:gd name="T1" fmla="*/ 714 h 747"/>
                <a:gd name="T2" fmla="*/ 321 w 321"/>
                <a:gd name="T3" fmla="*/ 747 h 747"/>
                <a:gd name="T4" fmla="*/ 168 w 321"/>
                <a:gd name="T5" fmla="*/ 744 h 747"/>
                <a:gd name="T6" fmla="*/ 0 w 321"/>
                <a:gd name="T7" fmla="*/ 747 h 747"/>
                <a:gd name="T8" fmla="*/ 0 w 321"/>
                <a:gd name="T9" fmla="*/ 714 h 747"/>
                <a:gd name="T10" fmla="*/ 77 w 321"/>
                <a:gd name="T11" fmla="*/ 708 h 747"/>
                <a:gd name="T12" fmla="*/ 97 w 321"/>
                <a:gd name="T13" fmla="*/ 696 h 747"/>
                <a:gd name="T14" fmla="*/ 105 w 321"/>
                <a:gd name="T15" fmla="*/ 645 h 747"/>
                <a:gd name="T16" fmla="*/ 108 w 321"/>
                <a:gd name="T17" fmla="*/ 495 h 747"/>
                <a:gd name="T18" fmla="*/ 108 w 321"/>
                <a:gd name="T19" fmla="*/ 251 h 747"/>
                <a:gd name="T20" fmla="*/ 105 w 321"/>
                <a:gd name="T21" fmla="*/ 111 h 747"/>
                <a:gd name="T22" fmla="*/ 97 w 321"/>
                <a:gd name="T23" fmla="*/ 52 h 747"/>
                <a:gd name="T24" fmla="*/ 77 w 321"/>
                <a:gd name="T25" fmla="*/ 39 h 747"/>
                <a:gd name="T26" fmla="*/ 0 w 321"/>
                <a:gd name="T27" fmla="*/ 33 h 747"/>
                <a:gd name="T28" fmla="*/ 0 w 321"/>
                <a:gd name="T29" fmla="*/ 0 h 747"/>
                <a:gd name="T30" fmla="*/ 161 w 321"/>
                <a:gd name="T31" fmla="*/ 3 h 747"/>
                <a:gd name="T32" fmla="*/ 321 w 321"/>
                <a:gd name="T33" fmla="*/ 0 h 747"/>
                <a:gd name="T34" fmla="*/ 321 w 321"/>
                <a:gd name="T35" fmla="*/ 33 h 747"/>
                <a:gd name="T36" fmla="*/ 243 w 321"/>
                <a:gd name="T37" fmla="*/ 39 h 747"/>
                <a:gd name="T38" fmla="*/ 224 w 321"/>
                <a:gd name="T39" fmla="*/ 51 h 747"/>
                <a:gd name="T40" fmla="*/ 216 w 321"/>
                <a:gd name="T41" fmla="*/ 102 h 747"/>
                <a:gd name="T42" fmla="*/ 212 w 321"/>
                <a:gd name="T43" fmla="*/ 251 h 747"/>
                <a:gd name="T44" fmla="*/ 212 w 321"/>
                <a:gd name="T45" fmla="*/ 495 h 747"/>
                <a:gd name="T46" fmla="*/ 214 w 321"/>
                <a:gd name="T47" fmla="*/ 635 h 747"/>
                <a:gd name="T48" fmla="*/ 222 w 321"/>
                <a:gd name="T49" fmla="*/ 694 h 747"/>
                <a:gd name="T50" fmla="*/ 242 w 321"/>
                <a:gd name="T51" fmla="*/ 708 h 747"/>
                <a:gd name="T52" fmla="*/ 321 w 321"/>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1" h="747">
                  <a:moveTo>
                    <a:pt x="321" y="714"/>
                  </a:moveTo>
                  <a:cubicBezTo>
                    <a:pt x="321" y="747"/>
                    <a:pt x="321" y="747"/>
                    <a:pt x="321" y="747"/>
                  </a:cubicBezTo>
                  <a:cubicBezTo>
                    <a:pt x="244" y="745"/>
                    <a:pt x="193" y="744"/>
                    <a:pt x="168" y="744"/>
                  </a:cubicBezTo>
                  <a:cubicBezTo>
                    <a:pt x="0" y="747"/>
                    <a:pt x="0" y="747"/>
                    <a:pt x="0" y="747"/>
                  </a:cubicBezTo>
                  <a:cubicBezTo>
                    <a:pt x="0" y="714"/>
                    <a:pt x="0" y="714"/>
                    <a:pt x="0" y="714"/>
                  </a:cubicBezTo>
                  <a:cubicBezTo>
                    <a:pt x="42" y="713"/>
                    <a:pt x="68" y="711"/>
                    <a:pt x="77" y="708"/>
                  </a:cubicBezTo>
                  <a:cubicBezTo>
                    <a:pt x="87" y="705"/>
                    <a:pt x="93" y="701"/>
                    <a:pt x="97" y="696"/>
                  </a:cubicBezTo>
                  <a:cubicBezTo>
                    <a:pt x="101" y="689"/>
                    <a:pt x="104" y="672"/>
                    <a:pt x="105" y="645"/>
                  </a:cubicBezTo>
                  <a:cubicBezTo>
                    <a:pt x="106" y="637"/>
                    <a:pt x="107" y="587"/>
                    <a:pt x="108" y="495"/>
                  </a:cubicBezTo>
                  <a:cubicBezTo>
                    <a:pt x="108" y="251"/>
                    <a:pt x="108" y="251"/>
                    <a:pt x="108" y="251"/>
                  </a:cubicBezTo>
                  <a:cubicBezTo>
                    <a:pt x="108" y="204"/>
                    <a:pt x="107" y="157"/>
                    <a:pt x="105" y="111"/>
                  </a:cubicBezTo>
                  <a:cubicBezTo>
                    <a:pt x="104" y="78"/>
                    <a:pt x="102" y="59"/>
                    <a:pt x="97" y="52"/>
                  </a:cubicBezTo>
                  <a:cubicBezTo>
                    <a:pt x="93" y="46"/>
                    <a:pt x="87" y="41"/>
                    <a:pt x="77" y="39"/>
                  </a:cubicBezTo>
                  <a:cubicBezTo>
                    <a:pt x="68" y="36"/>
                    <a:pt x="42" y="34"/>
                    <a:pt x="0" y="33"/>
                  </a:cubicBezTo>
                  <a:cubicBezTo>
                    <a:pt x="0" y="0"/>
                    <a:pt x="0" y="0"/>
                    <a:pt x="0" y="0"/>
                  </a:cubicBezTo>
                  <a:cubicBezTo>
                    <a:pt x="69" y="2"/>
                    <a:pt x="123" y="3"/>
                    <a:pt x="161" y="3"/>
                  </a:cubicBezTo>
                  <a:cubicBezTo>
                    <a:pt x="197" y="3"/>
                    <a:pt x="250" y="2"/>
                    <a:pt x="321" y="0"/>
                  </a:cubicBezTo>
                  <a:cubicBezTo>
                    <a:pt x="321" y="33"/>
                    <a:pt x="321" y="33"/>
                    <a:pt x="321" y="33"/>
                  </a:cubicBezTo>
                  <a:cubicBezTo>
                    <a:pt x="278" y="34"/>
                    <a:pt x="252" y="36"/>
                    <a:pt x="243" y="39"/>
                  </a:cubicBezTo>
                  <a:cubicBezTo>
                    <a:pt x="234" y="41"/>
                    <a:pt x="227" y="46"/>
                    <a:pt x="224" y="51"/>
                  </a:cubicBezTo>
                  <a:cubicBezTo>
                    <a:pt x="219" y="58"/>
                    <a:pt x="217" y="75"/>
                    <a:pt x="216" y="102"/>
                  </a:cubicBezTo>
                  <a:cubicBezTo>
                    <a:pt x="215" y="109"/>
                    <a:pt x="214" y="159"/>
                    <a:pt x="212" y="251"/>
                  </a:cubicBezTo>
                  <a:cubicBezTo>
                    <a:pt x="212" y="495"/>
                    <a:pt x="212" y="495"/>
                    <a:pt x="212" y="495"/>
                  </a:cubicBezTo>
                  <a:cubicBezTo>
                    <a:pt x="212" y="543"/>
                    <a:pt x="213" y="589"/>
                    <a:pt x="214" y="635"/>
                  </a:cubicBezTo>
                  <a:cubicBezTo>
                    <a:pt x="215" y="668"/>
                    <a:pt x="218" y="688"/>
                    <a:pt x="222" y="694"/>
                  </a:cubicBezTo>
                  <a:cubicBezTo>
                    <a:pt x="226" y="700"/>
                    <a:pt x="233" y="705"/>
                    <a:pt x="242" y="708"/>
                  </a:cubicBezTo>
                  <a:cubicBezTo>
                    <a:pt x="251" y="711"/>
                    <a:pt x="278" y="713"/>
                    <a:pt x="321"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5" name="Freeform 8"/>
            <p:cNvSpPr>
              <a:spLocks/>
            </p:cNvSpPr>
            <p:nvPr userDrawn="1"/>
          </p:nvSpPr>
          <p:spPr bwMode="auto">
            <a:xfrm>
              <a:off x="1266825" y="1003301"/>
              <a:ext cx="276225" cy="242888"/>
            </a:xfrm>
            <a:custGeom>
              <a:avLst/>
              <a:gdLst>
                <a:gd name="T0" fmla="*/ 5 w 869"/>
                <a:gd name="T1" fmla="*/ 747 h 766"/>
                <a:gd name="T2" fmla="*/ 5 w 869"/>
                <a:gd name="T3" fmla="*/ 714 h 766"/>
                <a:gd name="T4" fmla="*/ 80 w 869"/>
                <a:gd name="T5" fmla="*/ 705 h 766"/>
                <a:gd name="T6" fmla="*/ 91 w 869"/>
                <a:gd name="T7" fmla="*/ 695 h 766"/>
                <a:gd name="T8" fmla="*/ 99 w 869"/>
                <a:gd name="T9" fmla="*/ 640 h 766"/>
                <a:gd name="T10" fmla="*/ 102 w 869"/>
                <a:gd name="T11" fmla="*/ 520 h 766"/>
                <a:gd name="T12" fmla="*/ 102 w 869"/>
                <a:gd name="T13" fmla="*/ 92 h 766"/>
                <a:gd name="T14" fmla="*/ 100 w 869"/>
                <a:gd name="T15" fmla="*/ 69 h 766"/>
                <a:gd name="T16" fmla="*/ 80 w 869"/>
                <a:gd name="T17" fmla="*/ 47 h 766"/>
                <a:gd name="T18" fmla="*/ 57 w 869"/>
                <a:gd name="T19" fmla="*/ 36 h 766"/>
                <a:gd name="T20" fmla="*/ 0 w 869"/>
                <a:gd name="T21" fmla="*/ 33 h 766"/>
                <a:gd name="T22" fmla="*/ 0 w 869"/>
                <a:gd name="T23" fmla="*/ 0 h 766"/>
                <a:gd name="T24" fmla="*/ 119 w 869"/>
                <a:gd name="T25" fmla="*/ 3 h 766"/>
                <a:gd name="T26" fmla="*/ 202 w 869"/>
                <a:gd name="T27" fmla="*/ 0 h 766"/>
                <a:gd name="T28" fmla="*/ 269 w 869"/>
                <a:gd name="T29" fmla="*/ 86 h 766"/>
                <a:gd name="T30" fmla="*/ 381 w 869"/>
                <a:gd name="T31" fmla="*/ 220 h 766"/>
                <a:gd name="T32" fmla="*/ 545 w 869"/>
                <a:gd name="T33" fmla="*/ 411 h 766"/>
                <a:gd name="T34" fmla="*/ 671 w 869"/>
                <a:gd name="T35" fmla="*/ 554 h 766"/>
                <a:gd name="T36" fmla="*/ 721 w 869"/>
                <a:gd name="T37" fmla="*/ 609 h 766"/>
                <a:gd name="T38" fmla="*/ 721 w 869"/>
                <a:gd name="T39" fmla="*/ 226 h 766"/>
                <a:gd name="T40" fmla="*/ 718 w 869"/>
                <a:gd name="T41" fmla="*/ 105 h 766"/>
                <a:gd name="T42" fmla="*/ 711 w 869"/>
                <a:gd name="T43" fmla="*/ 51 h 766"/>
                <a:gd name="T44" fmla="*/ 699 w 869"/>
                <a:gd name="T45" fmla="*/ 41 h 766"/>
                <a:gd name="T46" fmla="*/ 624 w 869"/>
                <a:gd name="T47" fmla="*/ 33 h 766"/>
                <a:gd name="T48" fmla="*/ 624 w 869"/>
                <a:gd name="T49" fmla="*/ 0 h 766"/>
                <a:gd name="T50" fmla="*/ 756 w 869"/>
                <a:gd name="T51" fmla="*/ 3 h 766"/>
                <a:gd name="T52" fmla="*/ 869 w 869"/>
                <a:gd name="T53" fmla="*/ 0 h 766"/>
                <a:gd name="T54" fmla="*/ 869 w 869"/>
                <a:gd name="T55" fmla="*/ 33 h 766"/>
                <a:gd name="T56" fmla="*/ 794 w 869"/>
                <a:gd name="T57" fmla="*/ 41 h 766"/>
                <a:gd name="T58" fmla="*/ 783 w 869"/>
                <a:gd name="T59" fmla="*/ 52 h 766"/>
                <a:gd name="T60" fmla="*/ 775 w 869"/>
                <a:gd name="T61" fmla="*/ 107 h 766"/>
                <a:gd name="T62" fmla="*/ 772 w 869"/>
                <a:gd name="T63" fmla="*/ 226 h 766"/>
                <a:gd name="T64" fmla="*/ 772 w 869"/>
                <a:gd name="T65" fmla="*/ 479 h 766"/>
                <a:gd name="T66" fmla="*/ 775 w 869"/>
                <a:gd name="T67" fmla="*/ 766 h 766"/>
                <a:gd name="T68" fmla="*/ 721 w 869"/>
                <a:gd name="T69" fmla="*/ 766 h 766"/>
                <a:gd name="T70" fmla="*/ 707 w 869"/>
                <a:gd name="T71" fmla="*/ 752 h 766"/>
                <a:gd name="T72" fmla="*/ 698 w 869"/>
                <a:gd name="T73" fmla="*/ 744 h 766"/>
                <a:gd name="T74" fmla="*/ 678 w 869"/>
                <a:gd name="T75" fmla="*/ 723 h 766"/>
                <a:gd name="T76" fmla="*/ 611 w 869"/>
                <a:gd name="T77" fmla="*/ 647 h 766"/>
                <a:gd name="T78" fmla="*/ 540 w 869"/>
                <a:gd name="T79" fmla="*/ 560 h 766"/>
                <a:gd name="T80" fmla="*/ 151 w 869"/>
                <a:gd name="T81" fmla="*/ 110 h 766"/>
                <a:gd name="T82" fmla="*/ 151 w 869"/>
                <a:gd name="T83" fmla="*/ 518 h 766"/>
                <a:gd name="T84" fmla="*/ 154 w 869"/>
                <a:gd name="T85" fmla="*/ 641 h 766"/>
                <a:gd name="T86" fmla="*/ 161 w 869"/>
                <a:gd name="T87" fmla="*/ 695 h 766"/>
                <a:gd name="T88" fmla="*/ 173 w 869"/>
                <a:gd name="T89" fmla="*/ 705 h 766"/>
                <a:gd name="T90" fmla="*/ 249 w 869"/>
                <a:gd name="T91" fmla="*/ 714 h 766"/>
                <a:gd name="T92" fmla="*/ 249 w 869"/>
                <a:gd name="T93" fmla="*/ 747 h 766"/>
                <a:gd name="T94" fmla="*/ 143 w 869"/>
                <a:gd name="T95" fmla="*/ 744 h 766"/>
                <a:gd name="T96" fmla="*/ 5 w 869"/>
                <a:gd name="T97" fmla="*/ 747 h 76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869" h="766">
                  <a:moveTo>
                    <a:pt x="5" y="747"/>
                  </a:moveTo>
                  <a:cubicBezTo>
                    <a:pt x="5" y="714"/>
                    <a:pt x="5" y="714"/>
                    <a:pt x="5" y="714"/>
                  </a:cubicBezTo>
                  <a:cubicBezTo>
                    <a:pt x="43" y="714"/>
                    <a:pt x="68" y="711"/>
                    <a:pt x="80" y="705"/>
                  </a:cubicBezTo>
                  <a:cubicBezTo>
                    <a:pt x="86" y="703"/>
                    <a:pt x="89" y="700"/>
                    <a:pt x="91" y="695"/>
                  </a:cubicBezTo>
                  <a:cubicBezTo>
                    <a:pt x="95" y="688"/>
                    <a:pt x="98" y="670"/>
                    <a:pt x="99" y="640"/>
                  </a:cubicBezTo>
                  <a:cubicBezTo>
                    <a:pt x="101" y="594"/>
                    <a:pt x="102" y="554"/>
                    <a:pt x="102" y="520"/>
                  </a:cubicBezTo>
                  <a:cubicBezTo>
                    <a:pt x="102" y="92"/>
                    <a:pt x="102" y="92"/>
                    <a:pt x="102" y="92"/>
                  </a:cubicBezTo>
                  <a:cubicBezTo>
                    <a:pt x="102" y="80"/>
                    <a:pt x="102" y="73"/>
                    <a:pt x="100" y="69"/>
                  </a:cubicBezTo>
                  <a:cubicBezTo>
                    <a:pt x="97" y="63"/>
                    <a:pt x="91" y="56"/>
                    <a:pt x="80" y="47"/>
                  </a:cubicBezTo>
                  <a:cubicBezTo>
                    <a:pt x="74" y="41"/>
                    <a:pt x="66" y="38"/>
                    <a:pt x="57" y="36"/>
                  </a:cubicBezTo>
                  <a:cubicBezTo>
                    <a:pt x="49" y="34"/>
                    <a:pt x="30" y="33"/>
                    <a:pt x="0" y="33"/>
                  </a:cubicBezTo>
                  <a:cubicBezTo>
                    <a:pt x="0" y="0"/>
                    <a:pt x="0" y="0"/>
                    <a:pt x="0" y="0"/>
                  </a:cubicBezTo>
                  <a:cubicBezTo>
                    <a:pt x="63" y="2"/>
                    <a:pt x="103" y="3"/>
                    <a:pt x="119" y="3"/>
                  </a:cubicBezTo>
                  <a:cubicBezTo>
                    <a:pt x="147" y="3"/>
                    <a:pt x="174" y="2"/>
                    <a:pt x="202" y="0"/>
                  </a:cubicBezTo>
                  <a:cubicBezTo>
                    <a:pt x="232" y="39"/>
                    <a:pt x="255" y="67"/>
                    <a:pt x="269" y="86"/>
                  </a:cubicBezTo>
                  <a:cubicBezTo>
                    <a:pt x="381" y="220"/>
                    <a:pt x="381" y="220"/>
                    <a:pt x="381" y="220"/>
                  </a:cubicBezTo>
                  <a:cubicBezTo>
                    <a:pt x="545" y="411"/>
                    <a:pt x="545" y="411"/>
                    <a:pt x="545" y="411"/>
                  </a:cubicBezTo>
                  <a:cubicBezTo>
                    <a:pt x="597" y="472"/>
                    <a:pt x="639" y="520"/>
                    <a:pt x="671" y="554"/>
                  </a:cubicBezTo>
                  <a:cubicBezTo>
                    <a:pt x="691" y="578"/>
                    <a:pt x="708" y="596"/>
                    <a:pt x="721" y="609"/>
                  </a:cubicBezTo>
                  <a:cubicBezTo>
                    <a:pt x="721" y="226"/>
                    <a:pt x="721" y="226"/>
                    <a:pt x="721" y="226"/>
                  </a:cubicBezTo>
                  <a:cubicBezTo>
                    <a:pt x="721" y="191"/>
                    <a:pt x="720" y="151"/>
                    <a:pt x="718" y="105"/>
                  </a:cubicBezTo>
                  <a:cubicBezTo>
                    <a:pt x="717" y="76"/>
                    <a:pt x="714" y="58"/>
                    <a:pt x="711" y="51"/>
                  </a:cubicBezTo>
                  <a:cubicBezTo>
                    <a:pt x="708" y="46"/>
                    <a:pt x="705" y="43"/>
                    <a:pt x="699" y="41"/>
                  </a:cubicBezTo>
                  <a:cubicBezTo>
                    <a:pt x="687" y="36"/>
                    <a:pt x="662" y="33"/>
                    <a:pt x="624" y="33"/>
                  </a:cubicBezTo>
                  <a:cubicBezTo>
                    <a:pt x="624" y="0"/>
                    <a:pt x="624" y="0"/>
                    <a:pt x="624" y="0"/>
                  </a:cubicBezTo>
                  <a:cubicBezTo>
                    <a:pt x="667" y="2"/>
                    <a:pt x="711" y="3"/>
                    <a:pt x="756" y="3"/>
                  </a:cubicBezTo>
                  <a:cubicBezTo>
                    <a:pt x="797" y="3"/>
                    <a:pt x="835" y="2"/>
                    <a:pt x="869" y="0"/>
                  </a:cubicBezTo>
                  <a:cubicBezTo>
                    <a:pt x="869" y="33"/>
                    <a:pt x="869" y="33"/>
                    <a:pt x="869" y="33"/>
                  </a:cubicBezTo>
                  <a:cubicBezTo>
                    <a:pt x="831" y="33"/>
                    <a:pt x="806" y="36"/>
                    <a:pt x="794" y="41"/>
                  </a:cubicBezTo>
                  <a:cubicBezTo>
                    <a:pt x="789" y="43"/>
                    <a:pt x="785" y="47"/>
                    <a:pt x="783" y="52"/>
                  </a:cubicBezTo>
                  <a:cubicBezTo>
                    <a:pt x="779" y="58"/>
                    <a:pt x="776" y="77"/>
                    <a:pt x="775" y="107"/>
                  </a:cubicBezTo>
                  <a:cubicBezTo>
                    <a:pt x="773" y="153"/>
                    <a:pt x="772" y="193"/>
                    <a:pt x="772" y="226"/>
                  </a:cubicBezTo>
                  <a:cubicBezTo>
                    <a:pt x="772" y="479"/>
                    <a:pt x="772" y="479"/>
                    <a:pt x="772" y="479"/>
                  </a:cubicBezTo>
                  <a:cubicBezTo>
                    <a:pt x="772" y="531"/>
                    <a:pt x="773" y="626"/>
                    <a:pt x="775" y="766"/>
                  </a:cubicBezTo>
                  <a:cubicBezTo>
                    <a:pt x="721" y="766"/>
                    <a:pt x="721" y="766"/>
                    <a:pt x="721" y="766"/>
                  </a:cubicBezTo>
                  <a:cubicBezTo>
                    <a:pt x="707" y="752"/>
                    <a:pt x="707" y="752"/>
                    <a:pt x="707" y="752"/>
                  </a:cubicBezTo>
                  <a:cubicBezTo>
                    <a:pt x="705" y="751"/>
                    <a:pt x="700" y="746"/>
                    <a:pt x="698" y="744"/>
                  </a:cubicBezTo>
                  <a:cubicBezTo>
                    <a:pt x="696" y="742"/>
                    <a:pt x="689" y="735"/>
                    <a:pt x="678" y="723"/>
                  </a:cubicBezTo>
                  <a:cubicBezTo>
                    <a:pt x="647" y="689"/>
                    <a:pt x="625" y="664"/>
                    <a:pt x="611" y="647"/>
                  </a:cubicBezTo>
                  <a:cubicBezTo>
                    <a:pt x="540" y="560"/>
                    <a:pt x="540" y="560"/>
                    <a:pt x="540" y="560"/>
                  </a:cubicBezTo>
                  <a:cubicBezTo>
                    <a:pt x="151" y="110"/>
                    <a:pt x="151" y="110"/>
                    <a:pt x="151" y="110"/>
                  </a:cubicBezTo>
                  <a:cubicBezTo>
                    <a:pt x="151" y="518"/>
                    <a:pt x="151" y="518"/>
                    <a:pt x="151" y="518"/>
                  </a:cubicBezTo>
                  <a:cubicBezTo>
                    <a:pt x="151" y="552"/>
                    <a:pt x="152" y="593"/>
                    <a:pt x="154" y="641"/>
                  </a:cubicBezTo>
                  <a:cubicBezTo>
                    <a:pt x="156" y="670"/>
                    <a:pt x="158" y="688"/>
                    <a:pt x="161" y="695"/>
                  </a:cubicBezTo>
                  <a:cubicBezTo>
                    <a:pt x="164" y="700"/>
                    <a:pt x="168" y="704"/>
                    <a:pt x="173" y="705"/>
                  </a:cubicBezTo>
                  <a:cubicBezTo>
                    <a:pt x="185" y="711"/>
                    <a:pt x="210" y="714"/>
                    <a:pt x="249" y="714"/>
                  </a:cubicBezTo>
                  <a:cubicBezTo>
                    <a:pt x="249" y="747"/>
                    <a:pt x="249" y="747"/>
                    <a:pt x="249" y="747"/>
                  </a:cubicBezTo>
                  <a:cubicBezTo>
                    <a:pt x="217" y="745"/>
                    <a:pt x="181" y="744"/>
                    <a:pt x="143" y="744"/>
                  </a:cubicBezTo>
                  <a:cubicBezTo>
                    <a:pt x="100" y="744"/>
                    <a:pt x="54" y="745"/>
                    <a:pt x="5"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6" name="Freeform 9"/>
            <p:cNvSpPr>
              <a:spLocks/>
            </p:cNvSpPr>
            <p:nvPr userDrawn="1"/>
          </p:nvSpPr>
          <p:spPr bwMode="auto">
            <a:xfrm>
              <a:off x="1573213" y="1003301"/>
              <a:ext cx="101600" cy="236538"/>
            </a:xfrm>
            <a:custGeom>
              <a:avLst/>
              <a:gdLst>
                <a:gd name="T0" fmla="*/ 322 w 322"/>
                <a:gd name="T1" fmla="*/ 714 h 747"/>
                <a:gd name="T2" fmla="*/ 322 w 322"/>
                <a:gd name="T3" fmla="*/ 747 h 747"/>
                <a:gd name="T4" fmla="*/ 169 w 322"/>
                <a:gd name="T5" fmla="*/ 744 h 747"/>
                <a:gd name="T6" fmla="*/ 0 w 322"/>
                <a:gd name="T7" fmla="*/ 747 h 747"/>
                <a:gd name="T8" fmla="*/ 0 w 322"/>
                <a:gd name="T9" fmla="*/ 714 h 747"/>
                <a:gd name="T10" fmla="*/ 79 w 322"/>
                <a:gd name="T11" fmla="*/ 708 h 747"/>
                <a:gd name="T12" fmla="*/ 98 w 322"/>
                <a:gd name="T13" fmla="*/ 696 h 747"/>
                <a:gd name="T14" fmla="*/ 106 w 322"/>
                <a:gd name="T15" fmla="*/ 645 h 747"/>
                <a:gd name="T16" fmla="*/ 109 w 322"/>
                <a:gd name="T17" fmla="*/ 495 h 747"/>
                <a:gd name="T18" fmla="*/ 109 w 322"/>
                <a:gd name="T19" fmla="*/ 251 h 747"/>
                <a:gd name="T20" fmla="*/ 106 w 322"/>
                <a:gd name="T21" fmla="*/ 111 h 747"/>
                <a:gd name="T22" fmla="*/ 98 w 322"/>
                <a:gd name="T23" fmla="*/ 52 h 747"/>
                <a:gd name="T24" fmla="*/ 78 w 322"/>
                <a:gd name="T25" fmla="*/ 39 h 747"/>
                <a:gd name="T26" fmla="*/ 0 w 322"/>
                <a:gd name="T27" fmla="*/ 33 h 747"/>
                <a:gd name="T28" fmla="*/ 0 w 322"/>
                <a:gd name="T29" fmla="*/ 0 h 747"/>
                <a:gd name="T30" fmla="*/ 161 w 322"/>
                <a:gd name="T31" fmla="*/ 3 h 747"/>
                <a:gd name="T32" fmla="*/ 322 w 322"/>
                <a:gd name="T33" fmla="*/ 0 h 747"/>
                <a:gd name="T34" fmla="*/ 322 w 322"/>
                <a:gd name="T35" fmla="*/ 33 h 747"/>
                <a:gd name="T36" fmla="*/ 244 w 322"/>
                <a:gd name="T37" fmla="*/ 39 h 747"/>
                <a:gd name="T38" fmla="*/ 224 w 322"/>
                <a:gd name="T39" fmla="*/ 51 h 747"/>
                <a:gd name="T40" fmla="*/ 216 w 322"/>
                <a:gd name="T41" fmla="*/ 102 h 747"/>
                <a:gd name="T42" fmla="*/ 213 w 322"/>
                <a:gd name="T43" fmla="*/ 251 h 747"/>
                <a:gd name="T44" fmla="*/ 213 w 322"/>
                <a:gd name="T45" fmla="*/ 495 h 747"/>
                <a:gd name="T46" fmla="*/ 215 w 322"/>
                <a:gd name="T47" fmla="*/ 635 h 747"/>
                <a:gd name="T48" fmla="*/ 223 w 322"/>
                <a:gd name="T49" fmla="*/ 694 h 747"/>
                <a:gd name="T50" fmla="*/ 243 w 322"/>
                <a:gd name="T51" fmla="*/ 708 h 747"/>
                <a:gd name="T52" fmla="*/ 322 w 322"/>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2" h="747">
                  <a:moveTo>
                    <a:pt x="322" y="714"/>
                  </a:moveTo>
                  <a:cubicBezTo>
                    <a:pt x="322" y="747"/>
                    <a:pt x="322" y="747"/>
                    <a:pt x="322" y="747"/>
                  </a:cubicBezTo>
                  <a:cubicBezTo>
                    <a:pt x="244" y="745"/>
                    <a:pt x="193" y="744"/>
                    <a:pt x="169" y="744"/>
                  </a:cubicBezTo>
                  <a:cubicBezTo>
                    <a:pt x="0" y="747"/>
                    <a:pt x="0" y="747"/>
                    <a:pt x="0" y="747"/>
                  </a:cubicBezTo>
                  <a:cubicBezTo>
                    <a:pt x="0" y="714"/>
                    <a:pt x="0" y="714"/>
                    <a:pt x="0" y="714"/>
                  </a:cubicBezTo>
                  <a:cubicBezTo>
                    <a:pt x="43" y="713"/>
                    <a:pt x="69" y="711"/>
                    <a:pt x="79" y="708"/>
                  </a:cubicBezTo>
                  <a:cubicBezTo>
                    <a:pt x="88" y="705"/>
                    <a:pt x="94" y="701"/>
                    <a:pt x="98" y="696"/>
                  </a:cubicBezTo>
                  <a:cubicBezTo>
                    <a:pt x="102" y="689"/>
                    <a:pt x="105" y="672"/>
                    <a:pt x="106" y="645"/>
                  </a:cubicBezTo>
                  <a:cubicBezTo>
                    <a:pt x="107" y="637"/>
                    <a:pt x="108" y="587"/>
                    <a:pt x="109" y="495"/>
                  </a:cubicBezTo>
                  <a:cubicBezTo>
                    <a:pt x="109" y="251"/>
                    <a:pt x="109" y="251"/>
                    <a:pt x="109" y="251"/>
                  </a:cubicBezTo>
                  <a:cubicBezTo>
                    <a:pt x="109" y="204"/>
                    <a:pt x="108" y="157"/>
                    <a:pt x="106" y="111"/>
                  </a:cubicBezTo>
                  <a:cubicBezTo>
                    <a:pt x="105" y="78"/>
                    <a:pt x="102" y="59"/>
                    <a:pt x="98" y="52"/>
                  </a:cubicBezTo>
                  <a:cubicBezTo>
                    <a:pt x="94" y="46"/>
                    <a:pt x="88" y="41"/>
                    <a:pt x="78" y="39"/>
                  </a:cubicBezTo>
                  <a:cubicBezTo>
                    <a:pt x="69" y="36"/>
                    <a:pt x="43" y="34"/>
                    <a:pt x="0" y="33"/>
                  </a:cubicBezTo>
                  <a:cubicBezTo>
                    <a:pt x="0" y="0"/>
                    <a:pt x="0" y="0"/>
                    <a:pt x="0" y="0"/>
                  </a:cubicBezTo>
                  <a:cubicBezTo>
                    <a:pt x="70" y="2"/>
                    <a:pt x="124" y="3"/>
                    <a:pt x="161" y="3"/>
                  </a:cubicBezTo>
                  <a:cubicBezTo>
                    <a:pt x="198" y="3"/>
                    <a:pt x="251" y="2"/>
                    <a:pt x="322" y="0"/>
                  </a:cubicBezTo>
                  <a:cubicBezTo>
                    <a:pt x="322" y="33"/>
                    <a:pt x="322" y="33"/>
                    <a:pt x="322" y="33"/>
                  </a:cubicBezTo>
                  <a:cubicBezTo>
                    <a:pt x="279" y="34"/>
                    <a:pt x="253" y="36"/>
                    <a:pt x="244" y="39"/>
                  </a:cubicBezTo>
                  <a:cubicBezTo>
                    <a:pt x="234" y="41"/>
                    <a:pt x="228" y="46"/>
                    <a:pt x="224" y="51"/>
                  </a:cubicBezTo>
                  <a:cubicBezTo>
                    <a:pt x="220" y="58"/>
                    <a:pt x="217" y="75"/>
                    <a:pt x="216" y="102"/>
                  </a:cubicBezTo>
                  <a:cubicBezTo>
                    <a:pt x="216" y="109"/>
                    <a:pt x="215" y="159"/>
                    <a:pt x="213" y="251"/>
                  </a:cubicBezTo>
                  <a:cubicBezTo>
                    <a:pt x="213" y="495"/>
                    <a:pt x="213" y="495"/>
                    <a:pt x="213" y="495"/>
                  </a:cubicBezTo>
                  <a:cubicBezTo>
                    <a:pt x="213" y="543"/>
                    <a:pt x="214" y="589"/>
                    <a:pt x="215" y="635"/>
                  </a:cubicBezTo>
                  <a:cubicBezTo>
                    <a:pt x="216" y="668"/>
                    <a:pt x="219" y="688"/>
                    <a:pt x="223" y="694"/>
                  </a:cubicBezTo>
                  <a:cubicBezTo>
                    <a:pt x="227" y="700"/>
                    <a:pt x="234" y="705"/>
                    <a:pt x="243" y="708"/>
                  </a:cubicBezTo>
                  <a:cubicBezTo>
                    <a:pt x="252" y="711"/>
                    <a:pt x="278" y="713"/>
                    <a:pt x="322"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7" name="Freeform 10"/>
            <p:cNvSpPr>
              <a:spLocks/>
            </p:cNvSpPr>
            <p:nvPr userDrawn="1"/>
          </p:nvSpPr>
          <p:spPr bwMode="auto">
            <a:xfrm>
              <a:off x="1692275" y="998538"/>
              <a:ext cx="231775" cy="246063"/>
            </a:xfrm>
            <a:custGeom>
              <a:avLst/>
              <a:gdLst>
                <a:gd name="T0" fmla="*/ 728 w 728"/>
                <a:gd name="T1" fmla="*/ 667 h 774"/>
                <a:gd name="T2" fmla="*/ 707 w 728"/>
                <a:gd name="T3" fmla="*/ 716 h 774"/>
                <a:gd name="T4" fmla="*/ 581 w 728"/>
                <a:gd name="T5" fmla="*/ 761 h 774"/>
                <a:gd name="T6" fmla="*/ 447 w 728"/>
                <a:gd name="T7" fmla="*/ 774 h 774"/>
                <a:gd name="T8" fmla="*/ 288 w 728"/>
                <a:gd name="T9" fmla="*/ 754 h 774"/>
                <a:gd name="T10" fmla="*/ 161 w 728"/>
                <a:gd name="T11" fmla="*/ 696 h 774"/>
                <a:gd name="T12" fmla="*/ 71 w 728"/>
                <a:gd name="T13" fmla="*/ 610 h 774"/>
                <a:gd name="T14" fmla="*/ 18 w 728"/>
                <a:gd name="T15" fmla="*/ 508 h 774"/>
                <a:gd name="T16" fmla="*/ 0 w 728"/>
                <a:gd name="T17" fmla="*/ 386 h 774"/>
                <a:gd name="T18" fmla="*/ 123 w 728"/>
                <a:gd name="T19" fmla="*/ 110 h 774"/>
                <a:gd name="T20" fmla="*/ 457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5 w 728"/>
                <a:gd name="T35" fmla="*/ 143 h 774"/>
                <a:gd name="T36" fmla="*/ 605 w 728"/>
                <a:gd name="T37" fmla="*/ 66 h 774"/>
                <a:gd name="T38" fmla="*/ 446 w 728"/>
                <a:gd name="T39" fmla="*/ 41 h 774"/>
                <a:gd name="T40" fmla="*/ 313 w 728"/>
                <a:gd name="T41" fmla="*/ 60 h 774"/>
                <a:gd name="T42" fmla="*/ 217 w 728"/>
                <a:gd name="T43" fmla="*/ 117 h 774"/>
                <a:gd name="T44" fmla="*/ 149 w 728"/>
                <a:gd name="T45" fmla="*/ 216 h 774"/>
                <a:gd name="T46" fmla="*/ 122 w 728"/>
                <a:gd name="T47" fmla="*/ 366 h 774"/>
                <a:gd name="T48" fmla="*/ 223 w 728"/>
                <a:gd name="T49" fmla="*/ 621 h 774"/>
                <a:gd name="T50" fmla="*/ 492 w 728"/>
                <a:gd name="T51" fmla="*/ 717 h 774"/>
                <a:gd name="T52" fmla="*/ 632 w 728"/>
                <a:gd name="T53" fmla="*/ 698 h 774"/>
                <a:gd name="T54" fmla="*/ 719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7" y="716"/>
                    <a:pt x="707" y="716"/>
                    <a:pt x="707" y="716"/>
                  </a:cubicBezTo>
                  <a:cubicBezTo>
                    <a:pt x="664" y="736"/>
                    <a:pt x="622" y="751"/>
                    <a:pt x="581" y="761"/>
                  </a:cubicBezTo>
                  <a:cubicBezTo>
                    <a:pt x="540" y="770"/>
                    <a:pt x="495" y="774"/>
                    <a:pt x="447" y="774"/>
                  </a:cubicBezTo>
                  <a:cubicBezTo>
                    <a:pt x="390" y="774"/>
                    <a:pt x="337" y="768"/>
                    <a:pt x="288" y="754"/>
                  </a:cubicBezTo>
                  <a:cubicBezTo>
                    <a:pt x="240" y="740"/>
                    <a:pt x="197" y="721"/>
                    <a:pt x="161" y="696"/>
                  </a:cubicBezTo>
                  <a:cubicBezTo>
                    <a:pt x="124" y="670"/>
                    <a:pt x="94" y="642"/>
                    <a:pt x="71" y="610"/>
                  </a:cubicBezTo>
                  <a:cubicBezTo>
                    <a:pt x="48" y="579"/>
                    <a:pt x="31" y="545"/>
                    <a:pt x="18" y="508"/>
                  </a:cubicBezTo>
                  <a:cubicBezTo>
                    <a:pt x="6" y="471"/>
                    <a:pt x="0" y="430"/>
                    <a:pt x="0" y="386"/>
                  </a:cubicBezTo>
                  <a:cubicBezTo>
                    <a:pt x="0" y="275"/>
                    <a:pt x="41" y="183"/>
                    <a:pt x="123" y="110"/>
                  </a:cubicBezTo>
                  <a:cubicBezTo>
                    <a:pt x="204" y="37"/>
                    <a:pt x="316" y="0"/>
                    <a:pt x="457" y="0"/>
                  </a:cubicBezTo>
                  <a:cubicBezTo>
                    <a:pt x="490" y="0"/>
                    <a:pt x="521" y="2"/>
                    <a:pt x="549" y="6"/>
                  </a:cubicBezTo>
                  <a:cubicBezTo>
                    <a:pt x="578"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5" y="143"/>
                    <a:pt x="665" y="143"/>
                    <a:pt x="665" y="143"/>
                  </a:cubicBezTo>
                  <a:cubicBezTo>
                    <a:pt x="661" y="109"/>
                    <a:pt x="641" y="83"/>
                    <a:pt x="605" y="66"/>
                  </a:cubicBezTo>
                  <a:cubicBezTo>
                    <a:pt x="569" y="50"/>
                    <a:pt x="516" y="41"/>
                    <a:pt x="446" y="41"/>
                  </a:cubicBezTo>
                  <a:cubicBezTo>
                    <a:pt x="393" y="42"/>
                    <a:pt x="349" y="48"/>
                    <a:pt x="313" y="60"/>
                  </a:cubicBezTo>
                  <a:cubicBezTo>
                    <a:pt x="277" y="72"/>
                    <a:pt x="245" y="91"/>
                    <a:pt x="217" y="117"/>
                  </a:cubicBezTo>
                  <a:cubicBezTo>
                    <a:pt x="189" y="143"/>
                    <a:pt x="166" y="176"/>
                    <a:pt x="149" y="216"/>
                  </a:cubicBezTo>
                  <a:cubicBezTo>
                    <a:pt x="131" y="256"/>
                    <a:pt x="122" y="306"/>
                    <a:pt x="122" y="366"/>
                  </a:cubicBezTo>
                  <a:cubicBezTo>
                    <a:pt x="122" y="472"/>
                    <a:pt x="155" y="557"/>
                    <a:pt x="223" y="621"/>
                  </a:cubicBezTo>
                  <a:cubicBezTo>
                    <a:pt x="291" y="685"/>
                    <a:pt x="380" y="717"/>
                    <a:pt x="492" y="717"/>
                  </a:cubicBezTo>
                  <a:cubicBezTo>
                    <a:pt x="542" y="717"/>
                    <a:pt x="589" y="711"/>
                    <a:pt x="632" y="698"/>
                  </a:cubicBezTo>
                  <a:cubicBezTo>
                    <a:pt x="661" y="689"/>
                    <a:pt x="690" y="675"/>
                    <a:pt x="719"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8" name="Freeform 11"/>
            <p:cNvSpPr>
              <a:spLocks/>
            </p:cNvSpPr>
            <p:nvPr userDrawn="1"/>
          </p:nvSpPr>
          <p:spPr bwMode="auto">
            <a:xfrm>
              <a:off x="657225" y="998538"/>
              <a:ext cx="231775" cy="246063"/>
            </a:xfrm>
            <a:custGeom>
              <a:avLst/>
              <a:gdLst>
                <a:gd name="T0" fmla="*/ 728 w 728"/>
                <a:gd name="T1" fmla="*/ 667 h 774"/>
                <a:gd name="T2" fmla="*/ 706 w 728"/>
                <a:gd name="T3" fmla="*/ 716 h 774"/>
                <a:gd name="T4" fmla="*/ 580 w 728"/>
                <a:gd name="T5" fmla="*/ 761 h 774"/>
                <a:gd name="T6" fmla="*/ 446 w 728"/>
                <a:gd name="T7" fmla="*/ 774 h 774"/>
                <a:gd name="T8" fmla="*/ 288 w 728"/>
                <a:gd name="T9" fmla="*/ 754 h 774"/>
                <a:gd name="T10" fmla="*/ 160 w 728"/>
                <a:gd name="T11" fmla="*/ 696 h 774"/>
                <a:gd name="T12" fmla="*/ 71 w 728"/>
                <a:gd name="T13" fmla="*/ 610 h 774"/>
                <a:gd name="T14" fmla="*/ 18 w 728"/>
                <a:gd name="T15" fmla="*/ 508 h 774"/>
                <a:gd name="T16" fmla="*/ 0 w 728"/>
                <a:gd name="T17" fmla="*/ 386 h 774"/>
                <a:gd name="T18" fmla="*/ 122 w 728"/>
                <a:gd name="T19" fmla="*/ 110 h 774"/>
                <a:gd name="T20" fmla="*/ 456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4 w 728"/>
                <a:gd name="T35" fmla="*/ 143 h 774"/>
                <a:gd name="T36" fmla="*/ 604 w 728"/>
                <a:gd name="T37" fmla="*/ 66 h 774"/>
                <a:gd name="T38" fmla="*/ 445 w 728"/>
                <a:gd name="T39" fmla="*/ 41 h 774"/>
                <a:gd name="T40" fmla="*/ 313 w 728"/>
                <a:gd name="T41" fmla="*/ 60 h 774"/>
                <a:gd name="T42" fmla="*/ 216 w 728"/>
                <a:gd name="T43" fmla="*/ 117 h 774"/>
                <a:gd name="T44" fmla="*/ 148 w 728"/>
                <a:gd name="T45" fmla="*/ 216 h 774"/>
                <a:gd name="T46" fmla="*/ 121 w 728"/>
                <a:gd name="T47" fmla="*/ 366 h 774"/>
                <a:gd name="T48" fmla="*/ 223 w 728"/>
                <a:gd name="T49" fmla="*/ 621 h 774"/>
                <a:gd name="T50" fmla="*/ 492 w 728"/>
                <a:gd name="T51" fmla="*/ 717 h 774"/>
                <a:gd name="T52" fmla="*/ 631 w 728"/>
                <a:gd name="T53" fmla="*/ 698 h 774"/>
                <a:gd name="T54" fmla="*/ 718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6" y="716"/>
                    <a:pt x="706" y="716"/>
                    <a:pt x="706" y="716"/>
                  </a:cubicBezTo>
                  <a:cubicBezTo>
                    <a:pt x="663" y="736"/>
                    <a:pt x="621" y="751"/>
                    <a:pt x="580" y="761"/>
                  </a:cubicBezTo>
                  <a:cubicBezTo>
                    <a:pt x="539" y="770"/>
                    <a:pt x="495" y="774"/>
                    <a:pt x="446" y="774"/>
                  </a:cubicBezTo>
                  <a:cubicBezTo>
                    <a:pt x="389" y="774"/>
                    <a:pt x="337" y="768"/>
                    <a:pt x="288" y="754"/>
                  </a:cubicBezTo>
                  <a:cubicBezTo>
                    <a:pt x="239" y="740"/>
                    <a:pt x="197" y="721"/>
                    <a:pt x="160" y="696"/>
                  </a:cubicBezTo>
                  <a:cubicBezTo>
                    <a:pt x="124" y="670"/>
                    <a:pt x="94" y="642"/>
                    <a:pt x="71" y="610"/>
                  </a:cubicBezTo>
                  <a:cubicBezTo>
                    <a:pt x="48" y="579"/>
                    <a:pt x="30" y="545"/>
                    <a:pt x="18" y="508"/>
                  </a:cubicBezTo>
                  <a:cubicBezTo>
                    <a:pt x="6" y="471"/>
                    <a:pt x="0" y="430"/>
                    <a:pt x="0" y="386"/>
                  </a:cubicBezTo>
                  <a:cubicBezTo>
                    <a:pt x="0" y="275"/>
                    <a:pt x="41" y="183"/>
                    <a:pt x="122" y="110"/>
                  </a:cubicBezTo>
                  <a:cubicBezTo>
                    <a:pt x="204" y="37"/>
                    <a:pt x="315" y="0"/>
                    <a:pt x="456" y="0"/>
                  </a:cubicBezTo>
                  <a:cubicBezTo>
                    <a:pt x="490" y="0"/>
                    <a:pt x="520" y="2"/>
                    <a:pt x="549" y="6"/>
                  </a:cubicBezTo>
                  <a:cubicBezTo>
                    <a:pt x="577"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4" y="143"/>
                    <a:pt x="664" y="143"/>
                    <a:pt x="664" y="143"/>
                  </a:cubicBezTo>
                  <a:cubicBezTo>
                    <a:pt x="661" y="109"/>
                    <a:pt x="641" y="83"/>
                    <a:pt x="604" y="66"/>
                  </a:cubicBezTo>
                  <a:cubicBezTo>
                    <a:pt x="568" y="50"/>
                    <a:pt x="515" y="41"/>
                    <a:pt x="445" y="41"/>
                  </a:cubicBezTo>
                  <a:cubicBezTo>
                    <a:pt x="393" y="42"/>
                    <a:pt x="349" y="48"/>
                    <a:pt x="313" y="60"/>
                  </a:cubicBezTo>
                  <a:cubicBezTo>
                    <a:pt x="276" y="72"/>
                    <a:pt x="244" y="91"/>
                    <a:pt x="216" y="117"/>
                  </a:cubicBezTo>
                  <a:cubicBezTo>
                    <a:pt x="189" y="143"/>
                    <a:pt x="166" y="176"/>
                    <a:pt x="148" y="216"/>
                  </a:cubicBezTo>
                  <a:cubicBezTo>
                    <a:pt x="131" y="256"/>
                    <a:pt x="122" y="306"/>
                    <a:pt x="121" y="366"/>
                  </a:cubicBezTo>
                  <a:cubicBezTo>
                    <a:pt x="121" y="472"/>
                    <a:pt x="155" y="557"/>
                    <a:pt x="223" y="621"/>
                  </a:cubicBezTo>
                  <a:cubicBezTo>
                    <a:pt x="290" y="685"/>
                    <a:pt x="380" y="717"/>
                    <a:pt x="492" y="717"/>
                  </a:cubicBezTo>
                  <a:cubicBezTo>
                    <a:pt x="542" y="717"/>
                    <a:pt x="588" y="711"/>
                    <a:pt x="631" y="698"/>
                  </a:cubicBezTo>
                  <a:cubicBezTo>
                    <a:pt x="660" y="689"/>
                    <a:pt x="689" y="675"/>
                    <a:pt x="718"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9" name="Freeform 12"/>
            <p:cNvSpPr>
              <a:spLocks/>
            </p:cNvSpPr>
            <p:nvPr userDrawn="1"/>
          </p:nvSpPr>
          <p:spPr bwMode="auto">
            <a:xfrm>
              <a:off x="757238" y="687388"/>
              <a:ext cx="323850" cy="239713"/>
            </a:xfrm>
            <a:custGeom>
              <a:avLst/>
              <a:gdLst>
                <a:gd name="T0" fmla="*/ 0 w 1017"/>
                <a:gd name="T1" fmla="*/ 35 h 754"/>
                <a:gd name="T2" fmla="*/ 0 w 1017"/>
                <a:gd name="T3" fmla="*/ 0 h 754"/>
                <a:gd name="T4" fmla="*/ 110 w 1017"/>
                <a:gd name="T5" fmla="*/ 4 h 754"/>
                <a:gd name="T6" fmla="*/ 212 w 1017"/>
                <a:gd name="T7" fmla="*/ 0 h 754"/>
                <a:gd name="T8" fmla="*/ 300 w 1017"/>
                <a:gd name="T9" fmla="*/ 183 h 754"/>
                <a:gd name="T10" fmla="*/ 509 w 1017"/>
                <a:gd name="T11" fmla="*/ 592 h 754"/>
                <a:gd name="T12" fmla="*/ 697 w 1017"/>
                <a:gd name="T13" fmla="*/ 218 h 754"/>
                <a:gd name="T14" fmla="*/ 800 w 1017"/>
                <a:gd name="T15" fmla="*/ 0 h 754"/>
                <a:gd name="T16" fmla="*/ 898 w 1017"/>
                <a:gd name="T17" fmla="*/ 4 h 754"/>
                <a:gd name="T18" fmla="*/ 1017 w 1017"/>
                <a:gd name="T19" fmla="*/ 0 h 754"/>
                <a:gd name="T20" fmla="*/ 1017 w 1017"/>
                <a:gd name="T21" fmla="*/ 35 h 754"/>
                <a:gd name="T22" fmla="*/ 938 w 1017"/>
                <a:gd name="T23" fmla="*/ 40 h 754"/>
                <a:gd name="T24" fmla="*/ 918 w 1017"/>
                <a:gd name="T25" fmla="*/ 53 h 754"/>
                <a:gd name="T26" fmla="*/ 910 w 1017"/>
                <a:gd name="T27" fmla="*/ 103 h 754"/>
                <a:gd name="T28" fmla="*/ 907 w 1017"/>
                <a:gd name="T29" fmla="*/ 251 h 754"/>
                <a:gd name="T30" fmla="*/ 907 w 1017"/>
                <a:gd name="T31" fmla="*/ 492 h 754"/>
                <a:gd name="T32" fmla="*/ 910 w 1017"/>
                <a:gd name="T33" fmla="*/ 631 h 754"/>
                <a:gd name="T34" fmla="*/ 918 w 1017"/>
                <a:gd name="T35" fmla="*/ 690 h 754"/>
                <a:gd name="T36" fmla="*/ 938 w 1017"/>
                <a:gd name="T37" fmla="*/ 704 h 754"/>
                <a:gd name="T38" fmla="*/ 1017 w 1017"/>
                <a:gd name="T39" fmla="*/ 709 h 754"/>
                <a:gd name="T40" fmla="*/ 1017 w 1017"/>
                <a:gd name="T41" fmla="*/ 743 h 754"/>
                <a:gd name="T42" fmla="*/ 861 w 1017"/>
                <a:gd name="T43" fmla="*/ 739 h 754"/>
                <a:gd name="T44" fmla="*/ 699 w 1017"/>
                <a:gd name="T45" fmla="*/ 743 h 754"/>
                <a:gd name="T46" fmla="*/ 699 w 1017"/>
                <a:gd name="T47" fmla="*/ 709 h 754"/>
                <a:gd name="T48" fmla="*/ 778 w 1017"/>
                <a:gd name="T49" fmla="*/ 704 h 754"/>
                <a:gd name="T50" fmla="*/ 797 w 1017"/>
                <a:gd name="T51" fmla="*/ 691 h 754"/>
                <a:gd name="T52" fmla="*/ 806 w 1017"/>
                <a:gd name="T53" fmla="*/ 641 h 754"/>
                <a:gd name="T54" fmla="*/ 808 w 1017"/>
                <a:gd name="T55" fmla="*/ 492 h 754"/>
                <a:gd name="T56" fmla="*/ 808 w 1017"/>
                <a:gd name="T57" fmla="*/ 108 h 754"/>
                <a:gd name="T58" fmla="*/ 619 w 1017"/>
                <a:gd name="T59" fmla="*/ 486 h 754"/>
                <a:gd name="T60" fmla="*/ 549 w 1017"/>
                <a:gd name="T61" fmla="*/ 629 h 754"/>
                <a:gd name="T62" fmla="*/ 494 w 1017"/>
                <a:gd name="T63" fmla="*/ 754 h 754"/>
                <a:gd name="T64" fmla="*/ 472 w 1017"/>
                <a:gd name="T65" fmla="*/ 754 h 754"/>
                <a:gd name="T66" fmla="*/ 459 w 1017"/>
                <a:gd name="T67" fmla="*/ 722 h 754"/>
                <a:gd name="T68" fmla="*/ 422 w 1017"/>
                <a:gd name="T69" fmla="*/ 645 h 754"/>
                <a:gd name="T70" fmla="*/ 159 w 1017"/>
                <a:gd name="T71" fmla="*/ 126 h 754"/>
                <a:gd name="T72" fmla="*/ 159 w 1017"/>
                <a:gd name="T73" fmla="*/ 492 h 754"/>
                <a:gd name="T74" fmla="*/ 163 w 1017"/>
                <a:gd name="T75" fmla="*/ 631 h 754"/>
                <a:gd name="T76" fmla="*/ 171 w 1017"/>
                <a:gd name="T77" fmla="*/ 690 h 754"/>
                <a:gd name="T78" fmla="*/ 191 w 1017"/>
                <a:gd name="T79" fmla="*/ 704 h 754"/>
                <a:gd name="T80" fmla="*/ 271 w 1017"/>
                <a:gd name="T81" fmla="*/ 709 h 754"/>
                <a:gd name="T82" fmla="*/ 271 w 1017"/>
                <a:gd name="T83" fmla="*/ 743 h 754"/>
                <a:gd name="T84" fmla="*/ 138 w 1017"/>
                <a:gd name="T85" fmla="*/ 739 h 754"/>
                <a:gd name="T86" fmla="*/ 0 w 1017"/>
                <a:gd name="T87" fmla="*/ 743 h 754"/>
                <a:gd name="T88" fmla="*/ 0 w 1017"/>
                <a:gd name="T89" fmla="*/ 709 h 754"/>
                <a:gd name="T90" fmla="*/ 79 w 1017"/>
                <a:gd name="T91" fmla="*/ 704 h 754"/>
                <a:gd name="T92" fmla="*/ 98 w 1017"/>
                <a:gd name="T93" fmla="*/ 691 h 754"/>
                <a:gd name="T94" fmla="*/ 107 w 1017"/>
                <a:gd name="T95" fmla="*/ 641 h 754"/>
                <a:gd name="T96" fmla="*/ 109 w 1017"/>
                <a:gd name="T97" fmla="*/ 492 h 754"/>
                <a:gd name="T98" fmla="*/ 109 w 1017"/>
                <a:gd name="T99" fmla="*/ 251 h 754"/>
                <a:gd name="T100" fmla="*/ 107 w 1017"/>
                <a:gd name="T101" fmla="*/ 112 h 754"/>
                <a:gd name="T102" fmla="*/ 99 w 1017"/>
                <a:gd name="T103" fmla="*/ 54 h 754"/>
                <a:gd name="T104" fmla="*/ 78 w 1017"/>
                <a:gd name="T105" fmla="*/ 40 h 754"/>
                <a:gd name="T106" fmla="*/ 0 w 1017"/>
                <a:gd name="T107" fmla="*/ 35 h 75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Lst>
              <a:rect l="0" t="0" r="r" b="b"/>
              <a:pathLst>
                <a:path w="1017" h="754">
                  <a:moveTo>
                    <a:pt x="0" y="35"/>
                  </a:moveTo>
                  <a:cubicBezTo>
                    <a:pt x="0" y="0"/>
                    <a:pt x="0" y="0"/>
                    <a:pt x="0" y="0"/>
                  </a:cubicBezTo>
                  <a:cubicBezTo>
                    <a:pt x="38" y="2"/>
                    <a:pt x="75" y="4"/>
                    <a:pt x="110" y="4"/>
                  </a:cubicBezTo>
                  <a:cubicBezTo>
                    <a:pt x="145" y="4"/>
                    <a:pt x="179" y="2"/>
                    <a:pt x="212" y="0"/>
                  </a:cubicBezTo>
                  <a:cubicBezTo>
                    <a:pt x="244" y="70"/>
                    <a:pt x="274" y="131"/>
                    <a:pt x="300" y="183"/>
                  </a:cubicBezTo>
                  <a:cubicBezTo>
                    <a:pt x="509" y="592"/>
                    <a:pt x="509" y="592"/>
                    <a:pt x="509" y="592"/>
                  </a:cubicBezTo>
                  <a:cubicBezTo>
                    <a:pt x="697" y="218"/>
                    <a:pt x="697" y="218"/>
                    <a:pt x="697" y="218"/>
                  </a:cubicBezTo>
                  <a:cubicBezTo>
                    <a:pt x="749" y="116"/>
                    <a:pt x="783" y="43"/>
                    <a:pt x="800" y="0"/>
                  </a:cubicBezTo>
                  <a:cubicBezTo>
                    <a:pt x="839" y="2"/>
                    <a:pt x="872" y="4"/>
                    <a:pt x="898" y="4"/>
                  </a:cubicBezTo>
                  <a:cubicBezTo>
                    <a:pt x="923" y="4"/>
                    <a:pt x="962" y="2"/>
                    <a:pt x="1017" y="0"/>
                  </a:cubicBezTo>
                  <a:cubicBezTo>
                    <a:pt x="1017" y="35"/>
                    <a:pt x="1017" y="35"/>
                    <a:pt x="1017" y="35"/>
                  </a:cubicBezTo>
                  <a:cubicBezTo>
                    <a:pt x="974" y="35"/>
                    <a:pt x="947" y="37"/>
                    <a:pt x="938" y="40"/>
                  </a:cubicBezTo>
                  <a:cubicBezTo>
                    <a:pt x="928" y="43"/>
                    <a:pt x="922" y="47"/>
                    <a:pt x="918" y="53"/>
                  </a:cubicBezTo>
                  <a:cubicBezTo>
                    <a:pt x="914" y="60"/>
                    <a:pt x="911" y="76"/>
                    <a:pt x="910" y="103"/>
                  </a:cubicBezTo>
                  <a:cubicBezTo>
                    <a:pt x="910" y="110"/>
                    <a:pt x="909" y="159"/>
                    <a:pt x="907" y="251"/>
                  </a:cubicBezTo>
                  <a:cubicBezTo>
                    <a:pt x="907" y="492"/>
                    <a:pt x="907" y="492"/>
                    <a:pt x="907" y="492"/>
                  </a:cubicBezTo>
                  <a:cubicBezTo>
                    <a:pt x="907" y="540"/>
                    <a:pt x="908" y="586"/>
                    <a:pt x="910" y="631"/>
                  </a:cubicBezTo>
                  <a:cubicBezTo>
                    <a:pt x="911" y="664"/>
                    <a:pt x="914" y="684"/>
                    <a:pt x="918" y="690"/>
                  </a:cubicBezTo>
                  <a:cubicBezTo>
                    <a:pt x="922" y="696"/>
                    <a:pt x="929" y="701"/>
                    <a:pt x="938" y="704"/>
                  </a:cubicBezTo>
                  <a:cubicBezTo>
                    <a:pt x="948" y="707"/>
                    <a:pt x="974" y="709"/>
                    <a:pt x="1017" y="709"/>
                  </a:cubicBezTo>
                  <a:cubicBezTo>
                    <a:pt x="1017" y="743"/>
                    <a:pt x="1017" y="743"/>
                    <a:pt x="1017" y="743"/>
                  </a:cubicBezTo>
                  <a:cubicBezTo>
                    <a:pt x="943" y="740"/>
                    <a:pt x="891" y="739"/>
                    <a:pt x="861" y="739"/>
                  </a:cubicBezTo>
                  <a:cubicBezTo>
                    <a:pt x="837" y="739"/>
                    <a:pt x="782" y="740"/>
                    <a:pt x="699" y="743"/>
                  </a:cubicBezTo>
                  <a:cubicBezTo>
                    <a:pt x="699" y="709"/>
                    <a:pt x="699" y="709"/>
                    <a:pt x="699" y="709"/>
                  </a:cubicBezTo>
                  <a:cubicBezTo>
                    <a:pt x="742" y="709"/>
                    <a:pt x="768" y="707"/>
                    <a:pt x="778" y="704"/>
                  </a:cubicBezTo>
                  <a:cubicBezTo>
                    <a:pt x="788" y="701"/>
                    <a:pt x="794" y="697"/>
                    <a:pt x="797" y="691"/>
                  </a:cubicBezTo>
                  <a:cubicBezTo>
                    <a:pt x="802" y="684"/>
                    <a:pt x="805" y="668"/>
                    <a:pt x="806" y="641"/>
                  </a:cubicBezTo>
                  <a:cubicBezTo>
                    <a:pt x="806" y="633"/>
                    <a:pt x="807" y="584"/>
                    <a:pt x="808" y="492"/>
                  </a:cubicBezTo>
                  <a:cubicBezTo>
                    <a:pt x="808" y="108"/>
                    <a:pt x="808" y="108"/>
                    <a:pt x="808" y="108"/>
                  </a:cubicBezTo>
                  <a:cubicBezTo>
                    <a:pt x="619" y="486"/>
                    <a:pt x="619" y="486"/>
                    <a:pt x="619" y="486"/>
                  </a:cubicBezTo>
                  <a:cubicBezTo>
                    <a:pt x="589" y="545"/>
                    <a:pt x="566" y="593"/>
                    <a:pt x="549" y="629"/>
                  </a:cubicBezTo>
                  <a:cubicBezTo>
                    <a:pt x="537" y="655"/>
                    <a:pt x="518" y="696"/>
                    <a:pt x="494" y="754"/>
                  </a:cubicBezTo>
                  <a:cubicBezTo>
                    <a:pt x="472" y="754"/>
                    <a:pt x="472" y="754"/>
                    <a:pt x="472" y="754"/>
                  </a:cubicBezTo>
                  <a:cubicBezTo>
                    <a:pt x="468" y="740"/>
                    <a:pt x="463" y="729"/>
                    <a:pt x="459" y="722"/>
                  </a:cubicBezTo>
                  <a:cubicBezTo>
                    <a:pt x="422" y="645"/>
                    <a:pt x="422" y="645"/>
                    <a:pt x="422" y="645"/>
                  </a:cubicBezTo>
                  <a:cubicBezTo>
                    <a:pt x="159" y="126"/>
                    <a:pt x="159" y="126"/>
                    <a:pt x="159" y="126"/>
                  </a:cubicBezTo>
                  <a:cubicBezTo>
                    <a:pt x="159" y="492"/>
                    <a:pt x="159" y="492"/>
                    <a:pt x="159" y="492"/>
                  </a:cubicBezTo>
                  <a:cubicBezTo>
                    <a:pt x="159" y="540"/>
                    <a:pt x="160" y="586"/>
                    <a:pt x="163" y="631"/>
                  </a:cubicBezTo>
                  <a:cubicBezTo>
                    <a:pt x="164" y="664"/>
                    <a:pt x="167" y="683"/>
                    <a:pt x="171" y="690"/>
                  </a:cubicBezTo>
                  <a:cubicBezTo>
                    <a:pt x="175" y="696"/>
                    <a:pt x="182" y="701"/>
                    <a:pt x="191" y="704"/>
                  </a:cubicBezTo>
                  <a:cubicBezTo>
                    <a:pt x="200" y="707"/>
                    <a:pt x="227" y="709"/>
                    <a:pt x="271" y="709"/>
                  </a:cubicBezTo>
                  <a:cubicBezTo>
                    <a:pt x="271" y="743"/>
                    <a:pt x="271" y="743"/>
                    <a:pt x="271" y="743"/>
                  </a:cubicBezTo>
                  <a:cubicBezTo>
                    <a:pt x="138" y="739"/>
                    <a:pt x="138" y="739"/>
                    <a:pt x="138" y="739"/>
                  </a:cubicBezTo>
                  <a:cubicBezTo>
                    <a:pt x="0" y="743"/>
                    <a:pt x="0" y="743"/>
                    <a:pt x="0" y="743"/>
                  </a:cubicBezTo>
                  <a:cubicBezTo>
                    <a:pt x="0" y="709"/>
                    <a:pt x="0" y="709"/>
                    <a:pt x="0" y="709"/>
                  </a:cubicBezTo>
                  <a:cubicBezTo>
                    <a:pt x="43" y="709"/>
                    <a:pt x="69" y="707"/>
                    <a:pt x="79" y="704"/>
                  </a:cubicBezTo>
                  <a:cubicBezTo>
                    <a:pt x="88" y="701"/>
                    <a:pt x="95" y="697"/>
                    <a:pt x="98" y="691"/>
                  </a:cubicBezTo>
                  <a:cubicBezTo>
                    <a:pt x="103" y="684"/>
                    <a:pt x="105" y="668"/>
                    <a:pt x="107" y="641"/>
                  </a:cubicBezTo>
                  <a:cubicBezTo>
                    <a:pt x="107" y="634"/>
                    <a:pt x="108" y="584"/>
                    <a:pt x="109" y="492"/>
                  </a:cubicBezTo>
                  <a:cubicBezTo>
                    <a:pt x="109" y="251"/>
                    <a:pt x="109" y="251"/>
                    <a:pt x="109" y="251"/>
                  </a:cubicBezTo>
                  <a:cubicBezTo>
                    <a:pt x="109" y="204"/>
                    <a:pt x="108" y="158"/>
                    <a:pt x="107" y="112"/>
                  </a:cubicBezTo>
                  <a:cubicBezTo>
                    <a:pt x="105" y="79"/>
                    <a:pt x="103" y="60"/>
                    <a:pt x="99" y="54"/>
                  </a:cubicBezTo>
                  <a:cubicBezTo>
                    <a:pt x="94" y="48"/>
                    <a:pt x="88" y="43"/>
                    <a:pt x="78" y="40"/>
                  </a:cubicBezTo>
                  <a:cubicBezTo>
                    <a:pt x="69" y="37"/>
                    <a:pt x="43" y="35"/>
                    <a:pt x="0" y="35"/>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0" name="Freeform 13"/>
            <p:cNvSpPr>
              <a:spLocks noEditPoints="1"/>
            </p:cNvSpPr>
            <p:nvPr userDrawn="1"/>
          </p:nvSpPr>
          <p:spPr bwMode="auto">
            <a:xfrm>
              <a:off x="1092200" y="684213"/>
              <a:ext cx="263525" cy="238125"/>
            </a:xfrm>
            <a:custGeom>
              <a:avLst/>
              <a:gdLst>
                <a:gd name="T0" fmla="*/ 117 w 832"/>
                <a:gd name="T1" fmla="*/ 747 h 750"/>
                <a:gd name="T2" fmla="*/ 257 w 832"/>
                <a:gd name="T3" fmla="*/ 750 h 750"/>
                <a:gd name="T4" fmla="*/ 257 w 832"/>
                <a:gd name="T5" fmla="*/ 717 h 750"/>
                <a:gd name="T6" fmla="*/ 185 w 832"/>
                <a:gd name="T7" fmla="*/ 712 h 750"/>
                <a:gd name="T8" fmla="*/ 166 w 832"/>
                <a:gd name="T9" fmla="*/ 702 h 750"/>
                <a:gd name="T10" fmla="*/ 162 w 832"/>
                <a:gd name="T11" fmla="*/ 690 h 750"/>
                <a:gd name="T12" fmla="*/ 178 w 832"/>
                <a:gd name="T13" fmla="*/ 637 h 750"/>
                <a:gd name="T14" fmla="*/ 237 w 832"/>
                <a:gd name="T15" fmla="*/ 503 h 750"/>
                <a:gd name="T16" fmla="*/ 556 w 832"/>
                <a:gd name="T17" fmla="*/ 503 h 750"/>
                <a:gd name="T18" fmla="*/ 624 w 832"/>
                <a:gd name="T19" fmla="*/ 663 h 750"/>
                <a:gd name="T20" fmla="*/ 632 w 832"/>
                <a:gd name="T21" fmla="*/ 693 h 750"/>
                <a:gd name="T22" fmla="*/ 627 w 832"/>
                <a:gd name="T23" fmla="*/ 705 h 750"/>
                <a:gd name="T24" fmla="*/ 609 w 832"/>
                <a:gd name="T25" fmla="*/ 713 h 750"/>
                <a:gd name="T26" fmla="*/ 535 w 832"/>
                <a:gd name="T27" fmla="*/ 717 h 750"/>
                <a:gd name="T28" fmla="*/ 535 w 832"/>
                <a:gd name="T29" fmla="*/ 750 h 750"/>
                <a:gd name="T30" fmla="*/ 712 w 832"/>
                <a:gd name="T31" fmla="*/ 747 h 750"/>
                <a:gd name="T32" fmla="*/ 832 w 832"/>
                <a:gd name="T33" fmla="*/ 750 h 750"/>
                <a:gd name="T34" fmla="*/ 832 w 832"/>
                <a:gd name="T35" fmla="*/ 717 h 750"/>
                <a:gd name="T36" fmla="*/ 776 w 832"/>
                <a:gd name="T37" fmla="*/ 710 h 750"/>
                <a:gd name="T38" fmla="*/ 753 w 832"/>
                <a:gd name="T39" fmla="*/ 687 h 750"/>
                <a:gd name="T40" fmla="*/ 677 w 832"/>
                <a:gd name="T41" fmla="*/ 526 h 750"/>
                <a:gd name="T42" fmla="*/ 441 w 832"/>
                <a:gd name="T43" fmla="*/ 0 h 750"/>
                <a:gd name="T44" fmla="*/ 406 w 832"/>
                <a:gd name="T45" fmla="*/ 0 h 750"/>
                <a:gd name="T46" fmla="*/ 310 w 832"/>
                <a:gd name="T47" fmla="*/ 217 h 750"/>
                <a:gd name="T48" fmla="*/ 172 w 832"/>
                <a:gd name="T49" fmla="*/ 512 h 750"/>
                <a:gd name="T50" fmla="*/ 100 w 832"/>
                <a:gd name="T51" fmla="*/ 660 h 750"/>
                <a:gd name="T52" fmla="*/ 74 w 832"/>
                <a:gd name="T53" fmla="*/ 702 h 750"/>
                <a:gd name="T54" fmla="*/ 54 w 832"/>
                <a:gd name="T55" fmla="*/ 713 h 750"/>
                <a:gd name="T56" fmla="*/ 0 w 832"/>
                <a:gd name="T57" fmla="*/ 717 h 750"/>
                <a:gd name="T58" fmla="*/ 0 w 832"/>
                <a:gd name="T59" fmla="*/ 750 h 750"/>
                <a:gd name="T60" fmla="*/ 117 w 832"/>
                <a:gd name="T61" fmla="*/ 747 h 750"/>
                <a:gd name="T62" fmla="*/ 396 w 832"/>
                <a:gd name="T63" fmla="*/ 143 h 750"/>
                <a:gd name="T64" fmla="*/ 534 w 832"/>
                <a:gd name="T65" fmla="*/ 458 h 750"/>
                <a:gd name="T66" fmla="*/ 256 w 832"/>
                <a:gd name="T67" fmla="*/ 458 h 750"/>
                <a:gd name="T68" fmla="*/ 396 w 832"/>
                <a:gd name="T69" fmla="*/ 143 h 75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Lst>
              <a:rect l="0" t="0" r="r" b="b"/>
              <a:pathLst>
                <a:path w="832" h="750">
                  <a:moveTo>
                    <a:pt x="117" y="747"/>
                  </a:moveTo>
                  <a:cubicBezTo>
                    <a:pt x="148" y="747"/>
                    <a:pt x="195" y="748"/>
                    <a:pt x="257" y="750"/>
                  </a:cubicBezTo>
                  <a:cubicBezTo>
                    <a:pt x="257" y="717"/>
                    <a:pt x="257" y="717"/>
                    <a:pt x="257" y="717"/>
                  </a:cubicBezTo>
                  <a:cubicBezTo>
                    <a:pt x="222" y="716"/>
                    <a:pt x="199" y="715"/>
                    <a:pt x="185" y="712"/>
                  </a:cubicBezTo>
                  <a:cubicBezTo>
                    <a:pt x="177" y="710"/>
                    <a:pt x="170" y="707"/>
                    <a:pt x="166" y="702"/>
                  </a:cubicBezTo>
                  <a:cubicBezTo>
                    <a:pt x="163" y="699"/>
                    <a:pt x="162" y="695"/>
                    <a:pt x="162" y="690"/>
                  </a:cubicBezTo>
                  <a:cubicBezTo>
                    <a:pt x="162" y="679"/>
                    <a:pt x="167" y="662"/>
                    <a:pt x="178" y="637"/>
                  </a:cubicBezTo>
                  <a:cubicBezTo>
                    <a:pt x="237" y="503"/>
                    <a:pt x="237" y="503"/>
                    <a:pt x="237" y="503"/>
                  </a:cubicBezTo>
                  <a:cubicBezTo>
                    <a:pt x="556" y="503"/>
                    <a:pt x="556" y="503"/>
                    <a:pt x="556" y="503"/>
                  </a:cubicBezTo>
                  <a:cubicBezTo>
                    <a:pt x="624" y="663"/>
                    <a:pt x="624" y="663"/>
                    <a:pt x="624" y="663"/>
                  </a:cubicBezTo>
                  <a:cubicBezTo>
                    <a:pt x="629" y="675"/>
                    <a:pt x="632" y="685"/>
                    <a:pt x="632" y="693"/>
                  </a:cubicBezTo>
                  <a:cubicBezTo>
                    <a:pt x="632" y="698"/>
                    <a:pt x="630" y="702"/>
                    <a:pt x="627" y="705"/>
                  </a:cubicBezTo>
                  <a:cubicBezTo>
                    <a:pt x="624" y="708"/>
                    <a:pt x="618" y="711"/>
                    <a:pt x="609" y="713"/>
                  </a:cubicBezTo>
                  <a:cubicBezTo>
                    <a:pt x="601" y="715"/>
                    <a:pt x="576" y="716"/>
                    <a:pt x="535" y="717"/>
                  </a:cubicBezTo>
                  <a:cubicBezTo>
                    <a:pt x="535" y="750"/>
                    <a:pt x="535" y="750"/>
                    <a:pt x="535" y="750"/>
                  </a:cubicBezTo>
                  <a:cubicBezTo>
                    <a:pt x="712" y="747"/>
                    <a:pt x="712" y="747"/>
                    <a:pt x="712" y="747"/>
                  </a:cubicBezTo>
                  <a:cubicBezTo>
                    <a:pt x="734" y="747"/>
                    <a:pt x="775" y="748"/>
                    <a:pt x="832" y="750"/>
                  </a:cubicBezTo>
                  <a:cubicBezTo>
                    <a:pt x="832" y="717"/>
                    <a:pt x="832" y="717"/>
                    <a:pt x="832" y="717"/>
                  </a:cubicBezTo>
                  <a:cubicBezTo>
                    <a:pt x="803" y="716"/>
                    <a:pt x="784" y="714"/>
                    <a:pt x="776" y="710"/>
                  </a:cubicBezTo>
                  <a:cubicBezTo>
                    <a:pt x="767" y="707"/>
                    <a:pt x="760" y="699"/>
                    <a:pt x="753" y="687"/>
                  </a:cubicBezTo>
                  <a:cubicBezTo>
                    <a:pt x="740" y="664"/>
                    <a:pt x="715" y="611"/>
                    <a:pt x="677" y="526"/>
                  </a:cubicBezTo>
                  <a:cubicBezTo>
                    <a:pt x="441" y="0"/>
                    <a:pt x="441" y="0"/>
                    <a:pt x="441" y="0"/>
                  </a:cubicBezTo>
                  <a:cubicBezTo>
                    <a:pt x="406" y="0"/>
                    <a:pt x="406" y="0"/>
                    <a:pt x="406" y="0"/>
                  </a:cubicBezTo>
                  <a:cubicBezTo>
                    <a:pt x="357" y="112"/>
                    <a:pt x="325" y="185"/>
                    <a:pt x="310" y="217"/>
                  </a:cubicBezTo>
                  <a:cubicBezTo>
                    <a:pt x="172" y="512"/>
                    <a:pt x="172" y="512"/>
                    <a:pt x="172" y="512"/>
                  </a:cubicBezTo>
                  <a:cubicBezTo>
                    <a:pt x="131" y="598"/>
                    <a:pt x="107" y="647"/>
                    <a:pt x="100" y="660"/>
                  </a:cubicBezTo>
                  <a:cubicBezTo>
                    <a:pt x="89" y="683"/>
                    <a:pt x="80" y="697"/>
                    <a:pt x="74" y="702"/>
                  </a:cubicBezTo>
                  <a:cubicBezTo>
                    <a:pt x="68" y="708"/>
                    <a:pt x="61" y="711"/>
                    <a:pt x="54" y="713"/>
                  </a:cubicBezTo>
                  <a:cubicBezTo>
                    <a:pt x="47" y="715"/>
                    <a:pt x="29" y="716"/>
                    <a:pt x="0" y="717"/>
                  </a:cubicBezTo>
                  <a:cubicBezTo>
                    <a:pt x="0" y="750"/>
                    <a:pt x="0" y="750"/>
                    <a:pt x="0" y="750"/>
                  </a:cubicBezTo>
                  <a:cubicBezTo>
                    <a:pt x="42" y="748"/>
                    <a:pt x="81" y="747"/>
                    <a:pt x="117" y="747"/>
                  </a:cubicBezTo>
                  <a:close/>
                  <a:moveTo>
                    <a:pt x="396" y="143"/>
                  </a:moveTo>
                  <a:cubicBezTo>
                    <a:pt x="534" y="458"/>
                    <a:pt x="534" y="458"/>
                    <a:pt x="534" y="458"/>
                  </a:cubicBezTo>
                  <a:cubicBezTo>
                    <a:pt x="256" y="458"/>
                    <a:pt x="256" y="458"/>
                    <a:pt x="256" y="458"/>
                  </a:cubicBezTo>
                  <a:lnTo>
                    <a:pt x="396" y="143"/>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1" name="Freeform 14"/>
            <p:cNvSpPr>
              <a:spLocks/>
            </p:cNvSpPr>
            <p:nvPr userDrawn="1"/>
          </p:nvSpPr>
          <p:spPr bwMode="auto">
            <a:xfrm>
              <a:off x="1309688" y="687388"/>
              <a:ext cx="260350" cy="234950"/>
            </a:xfrm>
            <a:custGeom>
              <a:avLst/>
              <a:gdLst>
                <a:gd name="T0" fmla="*/ 601 w 817"/>
                <a:gd name="T1" fmla="*/ 111 h 743"/>
                <a:gd name="T2" fmla="*/ 634 w 817"/>
                <a:gd name="T3" fmla="*/ 52 h 743"/>
                <a:gd name="T4" fmla="*/ 624 w 817"/>
                <a:gd name="T5" fmla="*/ 39 h 743"/>
                <a:gd name="T6" fmla="*/ 543 w 817"/>
                <a:gd name="T7" fmla="*/ 33 h 743"/>
                <a:gd name="T8" fmla="*/ 543 w 817"/>
                <a:gd name="T9" fmla="*/ 0 h 743"/>
                <a:gd name="T10" fmla="*/ 688 w 817"/>
                <a:gd name="T11" fmla="*/ 3 h 743"/>
                <a:gd name="T12" fmla="*/ 817 w 817"/>
                <a:gd name="T13" fmla="*/ 0 h 743"/>
                <a:gd name="T14" fmla="*/ 817 w 817"/>
                <a:gd name="T15" fmla="*/ 33 h 743"/>
                <a:gd name="T16" fmla="*/ 746 w 817"/>
                <a:gd name="T17" fmla="*/ 39 h 743"/>
                <a:gd name="T18" fmla="*/ 718 w 817"/>
                <a:gd name="T19" fmla="*/ 51 h 743"/>
                <a:gd name="T20" fmla="*/ 675 w 817"/>
                <a:gd name="T21" fmla="*/ 102 h 743"/>
                <a:gd name="T22" fmla="*/ 514 w 817"/>
                <a:gd name="T23" fmla="*/ 333 h 743"/>
                <a:gd name="T24" fmla="*/ 461 w 817"/>
                <a:gd name="T25" fmla="*/ 422 h 743"/>
                <a:gd name="T26" fmla="*/ 455 w 817"/>
                <a:gd name="T27" fmla="*/ 453 h 743"/>
                <a:gd name="T28" fmla="*/ 455 w 817"/>
                <a:gd name="T29" fmla="*/ 493 h 743"/>
                <a:gd name="T30" fmla="*/ 459 w 817"/>
                <a:gd name="T31" fmla="*/ 631 h 743"/>
                <a:gd name="T32" fmla="*/ 466 w 817"/>
                <a:gd name="T33" fmla="*/ 690 h 743"/>
                <a:gd name="T34" fmla="*/ 486 w 817"/>
                <a:gd name="T35" fmla="*/ 704 h 743"/>
                <a:gd name="T36" fmla="*/ 564 w 817"/>
                <a:gd name="T37" fmla="*/ 710 h 743"/>
                <a:gd name="T38" fmla="*/ 564 w 817"/>
                <a:gd name="T39" fmla="*/ 743 h 743"/>
                <a:gd name="T40" fmla="*/ 410 w 817"/>
                <a:gd name="T41" fmla="*/ 740 h 743"/>
                <a:gd name="T42" fmla="*/ 244 w 817"/>
                <a:gd name="T43" fmla="*/ 743 h 743"/>
                <a:gd name="T44" fmla="*/ 244 w 817"/>
                <a:gd name="T45" fmla="*/ 710 h 743"/>
                <a:gd name="T46" fmla="*/ 322 w 817"/>
                <a:gd name="T47" fmla="*/ 704 h 743"/>
                <a:gd name="T48" fmla="*/ 341 w 817"/>
                <a:gd name="T49" fmla="*/ 692 h 743"/>
                <a:gd name="T50" fmla="*/ 350 w 817"/>
                <a:gd name="T51" fmla="*/ 641 h 743"/>
                <a:gd name="T52" fmla="*/ 353 w 817"/>
                <a:gd name="T53" fmla="*/ 493 h 743"/>
                <a:gd name="T54" fmla="*/ 353 w 817"/>
                <a:gd name="T55" fmla="*/ 432 h 743"/>
                <a:gd name="T56" fmla="*/ 331 w 817"/>
                <a:gd name="T57" fmla="*/ 390 h 743"/>
                <a:gd name="T58" fmla="*/ 275 w 817"/>
                <a:gd name="T59" fmla="*/ 300 h 743"/>
                <a:gd name="T60" fmla="*/ 135 w 817"/>
                <a:gd name="T61" fmla="*/ 102 h 743"/>
                <a:gd name="T62" fmla="*/ 96 w 817"/>
                <a:gd name="T63" fmla="*/ 51 h 743"/>
                <a:gd name="T64" fmla="*/ 69 w 817"/>
                <a:gd name="T65" fmla="*/ 39 h 743"/>
                <a:gd name="T66" fmla="*/ 0 w 817"/>
                <a:gd name="T67" fmla="*/ 33 h 743"/>
                <a:gd name="T68" fmla="*/ 0 w 817"/>
                <a:gd name="T69" fmla="*/ 0 h 743"/>
                <a:gd name="T70" fmla="*/ 130 w 817"/>
                <a:gd name="T71" fmla="*/ 3 h 743"/>
                <a:gd name="T72" fmla="*/ 333 w 817"/>
                <a:gd name="T73" fmla="*/ 0 h 743"/>
                <a:gd name="T74" fmla="*/ 333 w 817"/>
                <a:gd name="T75" fmla="*/ 33 h 743"/>
                <a:gd name="T76" fmla="*/ 246 w 817"/>
                <a:gd name="T77" fmla="*/ 39 h 743"/>
                <a:gd name="T78" fmla="*/ 234 w 817"/>
                <a:gd name="T79" fmla="*/ 52 h 743"/>
                <a:gd name="T80" fmla="*/ 262 w 817"/>
                <a:gd name="T81" fmla="*/ 111 h 743"/>
                <a:gd name="T82" fmla="*/ 426 w 817"/>
                <a:gd name="T83" fmla="*/ 376 h 743"/>
                <a:gd name="T84" fmla="*/ 601 w 817"/>
                <a:gd name="T85" fmla="*/ 111 h 74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Lst>
              <a:rect l="0" t="0" r="r" b="b"/>
              <a:pathLst>
                <a:path w="817" h="743">
                  <a:moveTo>
                    <a:pt x="601" y="111"/>
                  </a:moveTo>
                  <a:cubicBezTo>
                    <a:pt x="623" y="78"/>
                    <a:pt x="634" y="59"/>
                    <a:pt x="634" y="52"/>
                  </a:cubicBezTo>
                  <a:cubicBezTo>
                    <a:pt x="634" y="46"/>
                    <a:pt x="631" y="41"/>
                    <a:pt x="624" y="39"/>
                  </a:cubicBezTo>
                  <a:cubicBezTo>
                    <a:pt x="616" y="36"/>
                    <a:pt x="585" y="34"/>
                    <a:pt x="543" y="33"/>
                  </a:cubicBezTo>
                  <a:cubicBezTo>
                    <a:pt x="543" y="0"/>
                    <a:pt x="543" y="0"/>
                    <a:pt x="543" y="0"/>
                  </a:cubicBezTo>
                  <a:cubicBezTo>
                    <a:pt x="610" y="2"/>
                    <a:pt x="650" y="3"/>
                    <a:pt x="688" y="3"/>
                  </a:cubicBezTo>
                  <a:cubicBezTo>
                    <a:pt x="725" y="3"/>
                    <a:pt x="745" y="2"/>
                    <a:pt x="817" y="0"/>
                  </a:cubicBezTo>
                  <a:cubicBezTo>
                    <a:pt x="817" y="33"/>
                    <a:pt x="817" y="33"/>
                    <a:pt x="817" y="33"/>
                  </a:cubicBezTo>
                  <a:cubicBezTo>
                    <a:pt x="773" y="34"/>
                    <a:pt x="757" y="36"/>
                    <a:pt x="746" y="39"/>
                  </a:cubicBezTo>
                  <a:cubicBezTo>
                    <a:pt x="735" y="41"/>
                    <a:pt x="725" y="46"/>
                    <a:pt x="718" y="51"/>
                  </a:cubicBezTo>
                  <a:cubicBezTo>
                    <a:pt x="709" y="58"/>
                    <a:pt x="695" y="75"/>
                    <a:pt x="675" y="102"/>
                  </a:cubicBezTo>
                  <a:cubicBezTo>
                    <a:pt x="514" y="333"/>
                    <a:pt x="514" y="333"/>
                    <a:pt x="514" y="333"/>
                  </a:cubicBezTo>
                  <a:cubicBezTo>
                    <a:pt x="483" y="381"/>
                    <a:pt x="465" y="411"/>
                    <a:pt x="461" y="422"/>
                  </a:cubicBezTo>
                  <a:cubicBezTo>
                    <a:pt x="457" y="433"/>
                    <a:pt x="455" y="443"/>
                    <a:pt x="455" y="453"/>
                  </a:cubicBezTo>
                  <a:cubicBezTo>
                    <a:pt x="455" y="493"/>
                    <a:pt x="455" y="493"/>
                    <a:pt x="455" y="493"/>
                  </a:cubicBezTo>
                  <a:cubicBezTo>
                    <a:pt x="455" y="541"/>
                    <a:pt x="456" y="587"/>
                    <a:pt x="459" y="631"/>
                  </a:cubicBezTo>
                  <a:cubicBezTo>
                    <a:pt x="460" y="665"/>
                    <a:pt x="462" y="684"/>
                    <a:pt x="466" y="690"/>
                  </a:cubicBezTo>
                  <a:cubicBezTo>
                    <a:pt x="470" y="696"/>
                    <a:pt x="477" y="701"/>
                    <a:pt x="486" y="704"/>
                  </a:cubicBezTo>
                  <a:cubicBezTo>
                    <a:pt x="495" y="707"/>
                    <a:pt x="521" y="709"/>
                    <a:pt x="564" y="710"/>
                  </a:cubicBezTo>
                  <a:cubicBezTo>
                    <a:pt x="564" y="743"/>
                    <a:pt x="564" y="743"/>
                    <a:pt x="564" y="743"/>
                  </a:cubicBezTo>
                  <a:cubicBezTo>
                    <a:pt x="505" y="741"/>
                    <a:pt x="453" y="740"/>
                    <a:pt x="410" y="740"/>
                  </a:cubicBezTo>
                  <a:cubicBezTo>
                    <a:pt x="368" y="740"/>
                    <a:pt x="313" y="741"/>
                    <a:pt x="244" y="743"/>
                  </a:cubicBezTo>
                  <a:cubicBezTo>
                    <a:pt x="244" y="710"/>
                    <a:pt x="244" y="710"/>
                    <a:pt x="244" y="710"/>
                  </a:cubicBezTo>
                  <a:cubicBezTo>
                    <a:pt x="287" y="709"/>
                    <a:pt x="313" y="707"/>
                    <a:pt x="322" y="704"/>
                  </a:cubicBezTo>
                  <a:cubicBezTo>
                    <a:pt x="332" y="701"/>
                    <a:pt x="338" y="697"/>
                    <a:pt x="341" y="692"/>
                  </a:cubicBezTo>
                  <a:cubicBezTo>
                    <a:pt x="346" y="685"/>
                    <a:pt x="349" y="668"/>
                    <a:pt x="350" y="641"/>
                  </a:cubicBezTo>
                  <a:cubicBezTo>
                    <a:pt x="350" y="634"/>
                    <a:pt x="351" y="585"/>
                    <a:pt x="353" y="493"/>
                  </a:cubicBezTo>
                  <a:cubicBezTo>
                    <a:pt x="353" y="432"/>
                    <a:pt x="353" y="432"/>
                    <a:pt x="353" y="432"/>
                  </a:cubicBezTo>
                  <a:cubicBezTo>
                    <a:pt x="345" y="417"/>
                    <a:pt x="338" y="403"/>
                    <a:pt x="331" y="390"/>
                  </a:cubicBezTo>
                  <a:cubicBezTo>
                    <a:pt x="325" y="382"/>
                    <a:pt x="307" y="352"/>
                    <a:pt x="275" y="300"/>
                  </a:cubicBezTo>
                  <a:cubicBezTo>
                    <a:pt x="135" y="102"/>
                    <a:pt x="135" y="102"/>
                    <a:pt x="135" y="102"/>
                  </a:cubicBezTo>
                  <a:cubicBezTo>
                    <a:pt x="118" y="75"/>
                    <a:pt x="105" y="58"/>
                    <a:pt x="96" y="51"/>
                  </a:cubicBezTo>
                  <a:cubicBezTo>
                    <a:pt x="89" y="46"/>
                    <a:pt x="80" y="41"/>
                    <a:pt x="69" y="39"/>
                  </a:cubicBezTo>
                  <a:cubicBezTo>
                    <a:pt x="58" y="36"/>
                    <a:pt x="44" y="34"/>
                    <a:pt x="0" y="33"/>
                  </a:cubicBezTo>
                  <a:cubicBezTo>
                    <a:pt x="0" y="0"/>
                    <a:pt x="0" y="0"/>
                    <a:pt x="0" y="0"/>
                  </a:cubicBezTo>
                  <a:cubicBezTo>
                    <a:pt x="72" y="2"/>
                    <a:pt x="94" y="3"/>
                    <a:pt x="130" y="3"/>
                  </a:cubicBezTo>
                  <a:cubicBezTo>
                    <a:pt x="168" y="3"/>
                    <a:pt x="265" y="2"/>
                    <a:pt x="333" y="0"/>
                  </a:cubicBezTo>
                  <a:cubicBezTo>
                    <a:pt x="333" y="33"/>
                    <a:pt x="333" y="33"/>
                    <a:pt x="333" y="33"/>
                  </a:cubicBezTo>
                  <a:cubicBezTo>
                    <a:pt x="291" y="34"/>
                    <a:pt x="254" y="36"/>
                    <a:pt x="246" y="39"/>
                  </a:cubicBezTo>
                  <a:cubicBezTo>
                    <a:pt x="239" y="41"/>
                    <a:pt x="235" y="46"/>
                    <a:pt x="234" y="52"/>
                  </a:cubicBezTo>
                  <a:cubicBezTo>
                    <a:pt x="234" y="59"/>
                    <a:pt x="243" y="78"/>
                    <a:pt x="262" y="111"/>
                  </a:cubicBezTo>
                  <a:cubicBezTo>
                    <a:pt x="426" y="376"/>
                    <a:pt x="426" y="376"/>
                    <a:pt x="426" y="376"/>
                  </a:cubicBezTo>
                  <a:lnTo>
                    <a:pt x="601" y="111"/>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2" name="Freeform 15"/>
            <p:cNvSpPr>
              <a:spLocks noEditPoints="1"/>
            </p:cNvSpPr>
            <p:nvPr userDrawn="1"/>
          </p:nvSpPr>
          <p:spPr bwMode="auto">
            <a:xfrm>
              <a:off x="1558925" y="681038"/>
              <a:ext cx="263525" cy="246063"/>
            </a:xfrm>
            <a:custGeom>
              <a:avLst/>
              <a:gdLst>
                <a:gd name="T0" fmla="*/ 148 w 830"/>
                <a:gd name="T1" fmla="*/ 190 h 775"/>
                <a:gd name="T2" fmla="*/ 247 w 830"/>
                <a:gd name="T3" fmla="*/ 82 h 775"/>
                <a:gd name="T4" fmla="*/ 399 w 830"/>
                <a:gd name="T5" fmla="*/ 45 h 775"/>
                <a:gd name="T6" fmla="*/ 512 w 830"/>
                <a:gd name="T7" fmla="*/ 62 h 775"/>
                <a:gd name="T8" fmla="*/ 596 w 830"/>
                <a:gd name="T9" fmla="*/ 106 h 775"/>
                <a:gd name="T10" fmla="*/ 652 w 830"/>
                <a:gd name="T11" fmla="*/ 167 h 775"/>
                <a:gd name="T12" fmla="*/ 690 w 830"/>
                <a:gd name="T13" fmla="*/ 245 h 775"/>
                <a:gd name="T14" fmla="*/ 713 w 830"/>
                <a:gd name="T15" fmla="*/ 398 h 775"/>
                <a:gd name="T16" fmla="*/ 681 w 830"/>
                <a:gd name="T17" fmla="*/ 571 h 775"/>
                <a:gd name="T18" fmla="*/ 584 w 830"/>
                <a:gd name="T19" fmla="*/ 686 h 775"/>
                <a:gd name="T20" fmla="*/ 431 w 830"/>
                <a:gd name="T21" fmla="*/ 727 h 775"/>
                <a:gd name="T22" fmla="*/ 315 w 830"/>
                <a:gd name="T23" fmla="*/ 707 h 775"/>
                <a:gd name="T24" fmla="*/ 220 w 830"/>
                <a:gd name="T25" fmla="*/ 644 h 775"/>
                <a:gd name="T26" fmla="*/ 151 w 830"/>
                <a:gd name="T27" fmla="*/ 539 h 775"/>
                <a:gd name="T28" fmla="*/ 125 w 830"/>
                <a:gd name="T29" fmla="*/ 450 h 775"/>
                <a:gd name="T30" fmla="*/ 115 w 830"/>
                <a:gd name="T31" fmla="*/ 349 h 775"/>
                <a:gd name="T32" fmla="*/ 148 w 830"/>
                <a:gd name="T33" fmla="*/ 190 h 775"/>
                <a:gd name="T34" fmla="*/ 26 w 830"/>
                <a:gd name="T35" fmla="*/ 541 h 775"/>
                <a:gd name="T36" fmla="*/ 105 w 830"/>
                <a:gd name="T37" fmla="*/ 669 h 775"/>
                <a:gd name="T38" fmla="*/ 231 w 830"/>
                <a:gd name="T39" fmla="*/ 748 h 775"/>
                <a:gd name="T40" fmla="*/ 392 w 830"/>
                <a:gd name="T41" fmla="*/ 775 h 775"/>
                <a:gd name="T42" fmla="*/ 706 w 830"/>
                <a:gd name="T43" fmla="*/ 657 h 775"/>
                <a:gd name="T44" fmla="*/ 830 w 830"/>
                <a:gd name="T45" fmla="*/ 364 h 775"/>
                <a:gd name="T46" fmla="*/ 817 w 830"/>
                <a:gd name="T47" fmla="*/ 261 h 775"/>
                <a:gd name="T48" fmla="*/ 784 w 830"/>
                <a:gd name="T49" fmla="*/ 177 h 775"/>
                <a:gd name="T50" fmla="*/ 709 w 830"/>
                <a:gd name="T51" fmla="*/ 89 h 775"/>
                <a:gd name="T52" fmla="*/ 588 w 830"/>
                <a:gd name="T53" fmla="*/ 25 h 775"/>
                <a:gd name="T54" fmla="*/ 423 w 830"/>
                <a:gd name="T55" fmla="*/ 0 h 775"/>
                <a:gd name="T56" fmla="*/ 249 w 830"/>
                <a:gd name="T57" fmla="*/ 29 h 775"/>
                <a:gd name="T58" fmla="*/ 112 w 830"/>
                <a:gd name="T59" fmla="*/ 113 h 775"/>
                <a:gd name="T60" fmla="*/ 26 w 830"/>
                <a:gd name="T61" fmla="*/ 239 h 775"/>
                <a:gd name="T62" fmla="*/ 0 w 830"/>
                <a:gd name="T63" fmla="*/ 393 h 775"/>
                <a:gd name="T64" fmla="*/ 26 w 830"/>
                <a:gd name="T65" fmla="*/ 541 h 77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Lst>
              <a:rect l="0" t="0" r="r" b="b"/>
              <a:pathLst>
                <a:path w="830" h="775">
                  <a:moveTo>
                    <a:pt x="148" y="190"/>
                  </a:moveTo>
                  <a:cubicBezTo>
                    <a:pt x="170" y="143"/>
                    <a:pt x="203" y="107"/>
                    <a:pt x="247" y="82"/>
                  </a:cubicBezTo>
                  <a:cubicBezTo>
                    <a:pt x="290" y="57"/>
                    <a:pt x="341" y="45"/>
                    <a:pt x="399" y="45"/>
                  </a:cubicBezTo>
                  <a:cubicBezTo>
                    <a:pt x="440" y="45"/>
                    <a:pt x="477" y="51"/>
                    <a:pt x="512" y="62"/>
                  </a:cubicBezTo>
                  <a:cubicBezTo>
                    <a:pt x="546" y="74"/>
                    <a:pt x="575" y="89"/>
                    <a:pt x="596" y="106"/>
                  </a:cubicBezTo>
                  <a:cubicBezTo>
                    <a:pt x="618" y="124"/>
                    <a:pt x="637" y="144"/>
                    <a:pt x="652" y="167"/>
                  </a:cubicBezTo>
                  <a:cubicBezTo>
                    <a:pt x="668" y="190"/>
                    <a:pt x="681" y="216"/>
                    <a:pt x="690" y="245"/>
                  </a:cubicBezTo>
                  <a:cubicBezTo>
                    <a:pt x="706" y="292"/>
                    <a:pt x="713" y="343"/>
                    <a:pt x="713" y="398"/>
                  </a:cubicBezTo>
                  <a:cubicBezTo>
                    <a:pt x="713" y="463"/>
                    <a:pt x="703" y="521"/>
                    <a:pt x="681" y="571"/>
                  </a:cubicBezTo>
                  <a:cubicBezTo>
                    <a:pt x="660" y="620"/>
                    <a:pt x="627" y="659"/>
                    <a:pt x="584" y="686"/>
                  </a:cubicBezTo>
                  <a:cubicBezTo>
                    <a:pt x="541" y="714"/>
                    <a:pt x="490" y="727"/>
                    <a:pt x="431" y="727"/>
                  </a:cubicBezTo>
                  <a:cubicBezTo>
                    <a:pt x="388" y="727"/>
                    <a:pt x="350" y="721"/>
                    <a:pt x="315" y="707"/>
                  </a:cubicBezTo>
                  <a:cubicBezTo>
                    <a:pt x="280" y="694"/>
                    <a:pt x="248" y="673"/>
                    <a:pt x="220" y="644"/>
                  </a:cubicBezTo>
                  <a:cubicBezTo>
                    <a:pt x="192" y="616"/>
                    <a:pt x="169" y="581"/>
                    <a:pt x="151" y="539"/>
                  </a:cubicBezTo>
                  <a:cubicBezTo>
                    <a:pt x="141" y="514"/>
                    <a:pt x="132" y="484"/>
                    <a:pt x="125" y="450"/>
                  </a:cubicBezTo>
                  <a:cubicBezTo>
                    <a:pt x="118" y="416"/>
                    <a:pt x="115" y="382"/>
                    <a:pt x="115" y="349"/>
                  </a:cubicBezTo>
                  <a:cubicBezTo>
                    <a:pt x="115" y="290"/>
                    <a:pt x="126" y="236"/>
                    <a:pt x="148" y="190"/>
                  </a:cubicBezTo>
                  <a:close/>
                  <a:moveTo>
                    <a:pt x="26" y="541"/>
                  </a:moveTo>
                  <a:cubicBezTo>
                    <a:pt x="44" y="591"/>
                    <a:pt x="70" y="634"/>
                    <a:pt x="105" y="669"/>
                  </a:cubicBezTo>
                  <a:cubicBezTo>
                    <a:pt x="139" y="704"/>
                    <a:pt x="181" y="730"/>
                    <a:pt x="231" y="748"/>
                  </a:cubicBezTo>
                  <a:cubicBezTo>
                    <a:pt x="281" y="765"/>
                    <a:pt x="335" y="775"/>
                    <a:pt x="392" y="775"/>
                  </a:cubicBezTo>
                  <a:cubicBezTo>
                    <a:pt x="518" y="775"/>
                    <a:pt x="623" y="736"/>
                    <a:pt x="706" y="657"/>
                  </a:cubicBezTo>
                  <a:cubicBezTo>
                    <a:pt x="788" y="579"/>
                    <a:pt x="830" y="481"/>
                    <a:pt x="830" y="364"/>
                  </a:cubicBezTo>
                  <a:cubicBezTo>
                    <a:pt x="830" y="327"/>
                    <a:pt x="826" y="293"/>
                    <a:pt x="817" y="261"/>
                  </a:cubicBezTo>
                  <a:cubicBezTo>
                    <a:pt x="809" y="228"/>
                    <a:pt x="798" y="200"/>
                    <a:pt x="784" y="177"/>
                  </a:cubicBezTo>
                  <a:cubicBezTo>
                    <a:pt x="766" y="145"/>
                    <a:pt x="741" y="116"/>
                    <a:pt x="709" y="89"/>
                  </a:cubicBezTo>
                  <a:cubicBezTo>
                    <a:pt x="678" y="62"/>
                    <a:pt x="637" y="41"/>
                    <a:pt x="588" y="25"/>
                  </a:cubicBezTo>
                  <a:cubicBezTo>
                    <a:pt x="538" y="8"/>
                    <a:pt x="484" y="0"/>
                    <a:pt x="423" y="0"/>
                  </a:cubicBezTo>
                  <a:cubicBezTo>
                    <a:pt x="358" y="0"/>
                    <a:pt x="300" y="10"/>
                    <a:pt x="249" y="29"/>
                  </a:cubicBezTo>
                  <a:cubicBezTo>
                    <a:pt x="198" y="48"/>
                    <a:pt x="152" y="76"/>
                    <a:pt x="112" y="113"/>
                  </a:cubicBezTo>
                  <a:cubicBezTo>
                    <a:pt x="72" y="151"/>
                    <a:pt x="43" y="193"/>
                    <a:pt x="26" y="239"/>
                  </a:cubicBezTo>
                  <a:cubicBezTo>
                    <a:pt x="8" y="286"/>
                    <a:pt x="0" y="337"/>
                    <a:pt x="0" y="393"/>
                  </a:cubicBezTo>
                  <a:cubicBezTo>
                    <a:pt x="0" y="441"/>
                    <a:pt x="9" y="491"/>
                    <a:pt x="26" y="541"/>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spTree>
    <p:extLst>
      <p:ext uri="{BB962C8B-B14F-4D97-AF65-F5344CB8AC3E}">
        <p14:creationId xmlns:p14="http://schemas.microsoft.com/office/powerpoint/2010/main" val="1292685541"/>
      </p:ext>
    </p:extLst>
  </p:cSld>
  <p:clrMapOvr>
    <a:masterClrMapping/>
  </p:clrMapOvr>
  <p:timing>
    <p:tnLst>
      <p:par>
        <p:cTn id="1" dur="indefinite" restart="never" nodeType="tmRoot"/>
      </p:par>
    </p:tn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type="titleOnly" preserve="1">
  <p:cSld name="Mayo Ending Slide">
    <p:spTree>
      <p:nvGrpSpPr>
        <p:cNvPr id="1" name=""/>
        <p:cNvGrpSpPr/>
        <p:nvPr/>
      </p:nvGrpSpPr>
      <p:grpSpPr>
        <a:xfrm>
          <a:off x="0" y="0"/>
          <a:ext cx="0" cy="0"/>
          <a:chOff x="0" y="0"/>
          <a:chExt cx="0" cy="0"/>
        </a:xfrm>
      </p:grpSpPr>
      <p:sp>
        <p:nvSpPr>
          <p:cNvPr id="2" name="Title 1"/>
          <p:cNvSpPr>
            <a:spLocks noGrp="1"/>
          </p:cNvSpPr>
          <p:nvPr>
            <p:ph type="title"/>
          </p:nvPr>
        </p:nvSpPr>
        <p:spPr>
          <a:xfrm>
            <a:off x="0" y="2733675"/>
            <a:ext cx="9144000" cy="1371600"/>
          </a:xfrm>
        </p:spPr>
        <p:txBody>
          <a:bodyPr anchor="ctr" anchorCtr="0"/>
          <a:lstStyle>
            <a:lvl1pPr algn="ctr">
              <a:defRPr/>
            </a:lvl1p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C61AE04C-205F-4DAD-9513-A29BBF7C67C6}" type="datetime1">
              <a:rPr lang="en-US" smtClean="0"/>
              <a:t>10/28/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DC53FA5-AE81-45E0-8206-920AA27813B4}" type="slidenum">
              <a:rPr lang="en-US" smtClean="0"/>
              <a:t>‹#›</a:t>
            </a:fld>
            <a:endParaRPr lang="en-US"/>
          </a:p>
        </p:txBody>
      </p:sp>
      <p:grpSp>
        <p:nvGrpSpPr>
          <p:cNvPr id="31" name="Group 30"/>
          <p:cNvGrpSpPr/>
          <p:nvPr userDrawn="1"/>
        </p:nvGrpSpPr>
        <p:grpSpPr>
          <a:xfrm>
            <a:off x="3937794" y="681038"/>
            <a:ext cx="1266825" cy="1381125"/>
            <a:chOff x="657225" y="681038"/>
            <a:chExt cx="1266825" cy="1381125"/>
          </a:xfrm>
          <a:solidFill>
            <a:srgbClr val="FFFFFF"/>
          </a:solidFill>
        </p:grpSpPr>
        <p:sp>
          <p:nvSpPr>
            <p:cNvPr id="32" name="Freeform 5"/>
            <p:cNvSpPr>
              <a:spLocks noEditPoints="1"/>
            </p:cNvSpPr>
            <p:nvPr userDrawn="1"/>
          </p:nvSpPr>
          <p:spPr bwMode="auto">
            <a:xfrm>
              <a:off x="846138" y="1354138"/>
              <a:ext cx="887413" cy="708025"/>
            </a:xfrm>
            <a:custGeom>
              <a:avLst/>
              <a:gdLst>
                <a:gd name="T0" fmla="*/ 2203 w 2794"/>
                <a:gd name="T1" fmla="*/ 0 h 2229"/>
                <a:gd name="T2" fmla="*/ 1613 w 2794"/>
                <a:gd name="T3" fmla="*/ 0 h 2229"/>
                <a:gd name="T4" fmla="*/ 1613 w 2794"/>
                <a:gd name="T5" fmla="*/ 665 h 2229"/>
                <a:gd name="T6" fmla="*/ 1904 w 2794"/>
                <a:gd name="T7" fmla="*/ 1330 h 2229"/>
                <a:gd name="T8" fmla="*/ 1904 w 2794"/>
                <a:gd name="T9" fmla="*/ 1237 h 2229"/>
                <a:gd name="T10" fmla="*/ 1749 w 2794"/>
                <a:gd name="T11" fmla="*/ 747 h 2229"/>
                <a:gd name="T12" fmla="*/ 1749 w 2794"/>
                <a:gd name="T13" fmla="*/ 573 h 2229"/>
                <a:gd name="T14" fmla="*/ 1972 w 2794"/>
                <a:gd name="T15" fmla="*/ 573 h 2229"/>
                <a:gd name="T16" fmla="*/ 1972 w 2794"/>
                <a:gd name="T17" fmla="*/ 1332 h 2229"/>
                <a:gd name="T18" fmla="*/ 1401 w 2794"/>
                <a:gd name="T19" fmla="*/ 2182 h 2229"/>
                <a:gd name="T20" fmla="*/ 829 w 2794"/>
                <a:gd name="T21" fmla="*/ 1374 h 2229"/>
                <a:gd name="T22" fmla="*/ 1180 w 2794"/>
                <a:gd name="T23" fmla="*/ 665 h 2229"/>
                <a:gd name="T24" fmla="*/ 1180 w 2794"/>
                <a:gd name="T25" fmla="*/ 573 h 2229"/>
                <a:gd name="T26" fmla="*/ 1401 w 2794"/>
                <a:gd name="T27" fmla="*/ 573 h 2229"/>
                <a:gd name="T28" fmla="*/ 1542 w 2794"/>
                <a:gd name="T29" fmla="*/ 573 h 2229"/>
                <a:gd name="T30" fmla="*/ 1542 w 2794"/>
                <a:gd name="T31" fmla="*/ 436 h 2229"/>
                <a:gd name="T32" fmla="*/ 1401 w 2794"/>
                <a:gd name="T33" fmla="*/ 436 h 2229"/>
                <a:gd name="T34" fmla="*/ 1180 w 2794"/>
                <a:gd name="T35" fmla="*/ 436 h 2229"/>
                <a:gd name="T36" fmla="*/ 1180 w 2794"/>
                <a:gd name="T37" fmla="*/ 436 h 2229"/>
                <a:gd name="T38" fmla="*/ 1044 w 2794"/>
                <a:gd name="T39" fmla="*/ 436 h 2229"/>
                <a:gd name="T40" fmla="*/ 1044 w 2794"/>
                <a:gd name="T41" fmla="*/ 436 h 2229"/>
                <a:gd name="T42" fmla="*/ 692 w 2794"/>
                <a:gd name="T43" fmla="*/ 436 h 2229"/>
                <a:gd name="T44" fmla="*/ 692 w 2794"/>
                <a:gd name="T45" fmla="*/ 1234 h 2229"/>
                <a:gd name="T46" fmla="*/ 695 w 2794"/>
                <a:gd name="T47" fmla="*/ 1315 h 2229"/>
                <a:gd name="T48" fmla="*/ 695 w 2794"/>
                <a:gd name="T49" fmla="*/ 1315 h 2229"/>
                <a:gd name="T50" fmla="*/ 829 w 2794"/>
                <a:gd name="T51" fmla="*/ 1205 h 2229"/>
                <a:gd name="T52" fmla="*/ 829 w 2794"/>
                <a:gd name="T53" fmla="*/ 1205 h 2229"/>
                <a:gd name="T54" fmla="*/ 829 w 2794"/>
                <a:gd name="T55" fmla="*/ 573 h 2229"/>
                <a:gd name="T56" fmla="*/ 1044 w 2794"/>
                <a:gd name="T57" fmla="*/ 573 h 2229"/>
                <a:gd name="T58" fmla="*/ 1044 w 2794"/>
                <a:gd name="T59" fmla="*/ 573 h 2229"/>
                <a:gd name="T60" fmla="*/ 1044 w 2794"/>
                <a:gd name="T61" fmla="*/ 747 h 2229"/>
                <a:gd name="T62" fmla="*/ 590 w 2794"/>
                <a:gd name="T63" fmla="*/ 1447 h 2229"/>
                <a:gd name="T64" fmla="*/ 135 w 2794"/>
                <a:gd name="T65" fmla="*/ 747 h 2229"/>
                <a:gd name="T66" fmla="*/ 135 w 2794"/>
                <a:gd name="T67" fmla="*/ 136 h 2229"/>
                <a:gd name="T68" fmla="*/ 590 w 2794"/>
                <a:gd name="T69" fmla="*/ 136 h 2229"/>
                <a:gd name="T70" fmla="*/ 1044 w 2794"/>
                <a:gd name="T71" fmla="*/ 136 h 2229"/>
                <a:gd name="T72" fmla="*/ 1044 w 2794"/>
                <a:gd name="T73" fmla="*/ 370 h 2229"/>
                <a:gd name="T74" fmla="*/ 1180 w 2794"/>
                <a:gd name="T75" fmla="*/ 370 h 2229"/>
                <a:gd name="T76" fmla="*/ 1180 w 2794"/>
                <a:gd name="T77" fmla="*/ 0 h 2229"/>
                <a:gd name="T78" fmla="*/ 590 w 2794"/>
                <a:gd name="T79" fmla="*/ 0 h 2229"/>
                <a:gd name="T80" fmla="*/ 0 w 2794"/>
                <a:gd name="T81" fmla="*/ 0 h 2229"/>
                <a:gd name="T82" fmla="*/ 0 w 2794"/>
                <a:gd name="T83" fmla="*/ 665 h 2229"/>
                <a:gd name="T84" fmla="*/ 590 w 2794"/>
                <a:gd name="T85" fmla="*/ 1495 h 2229"/>
                <a:gd name="T86" fmla="*/ 708 w 2794"/>
                <a:gd name="T87" fmla="*/ 1444 h 2229"/>
                <a:gd name="T88" fmla="*/ 1401 w 2794"/>
                <a:gd name="T89" fmla="*/ 2229 h 2229"/>
                <a:gd name="T90" fmla="*/ 2093 w 2794"/>
                <a:gd name="T91" fmla="*/ 1447 h 2229"/>
                <a:gd name="T92" fmla="*/ 2203 w 2794"/>
                <a:gd name="T93" fmla="*/ 1495 h 2229"/>
                <a:gd name="T94" fmla="*/ 2794 w 2794"/>
                <a:gd name="T95" fmla="*/ 665 h 2229"/>
                <a:gd name="T96" fmla="*/ 2794 w 2794"/>
                <a:gd name="T97" fmla="*/ 0 h 2229"/>
                <a:gd name="T98" fmla="*/ 2203 w 2794"/>
                <a:gd name="T99" fmla="*/ 0 h 2229"/>
                <a:gd name="T100" fmla="*/ 2658 w 2794"/>
                <a:gd name="T101" fmla="*/ 747 h 2229"/>
                <a:gd name="T102" fmla="*/ 2203 w 2794"/>
                <a:gd name="T103" fmla="*/ 1447 h 2229"/>
                <a:gd name="T104" fmla="*/ 2100 w 2794"/>
                <a:gd name="T105" fmla="*/ 1395 h 2229"/>
                <a:gd name="T106" fmla="*/ 2109 w 2794"/>
                <a:gd name="T107" fmla="*/ 1234 h 2229"/>
                <a:gd name="T108" fmla="*/ 2109 w 2794"/>
                <a:gd name="T109" fmla="*/ 436 h 2229"/>
                <a:gd name="T110" fmla="*/ 1749 w 2794"/>
                <a:gd name="T111" fmla="*/ 436 h 2229"/>
                <a:gd name="T112" fmla="*/ 1749 w 2794"/>
                <a:gd name="T113" fmla="*/ 136 h 2229"/>
                <a:gd name="T114" fmla="*/ 2203 w 2794"/>
                <a:gd name="T115" fmla="*/ 136 h 2229"/>
                <a:gd name="T116" fmla="*/ 2658 w 2794"/>
                <a:gd name="T117" fmla="*/ 136 h 2229"/>
                <a:gd name="T118" fmla="*/ 2658 w 2794"/>
                <a:gd name="T119" fmla="*/ 747 h 222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 ang="0">
                  <a:pos x="T118" y="T119"/>
                </a:cxn>
              </a:cxnLst>
              <a:rect l="0" t="0" r="r" b="b"/>
              <a:pathLst>
                <a:path w="2794" h="2229">
                  <a:moveTo>
                    <a:pt x="2203" y="0"/>
                  </a:moveTo>
                  <a:cubicBezTo>
                    <a:pt x="1613" y="0"/>
                    <a:pt x="1613" y="0"/>
                    <a:pt x="1613" y="0"/>
                  </a:cubicBezTo>
                  <a:cubicBezTo>
                    <a:pt x="1613" y="665"/>
                    <a:pt x="1613" y="665"/>
                    <a:pt x="1613" y="665"/>
                  </a:cubicBezTo>
                  <a:cubicBezTo>
                    <a:pt x="1613" y="970"/>
                    <a:pt x="1719" y="1183"/>
                    <a:pt x="1904" y="1330"/>
                  </a:cubicBezTo>
                  <a:cubicBezTo>
                    <a:pt x="1904" y="1237"/>
                    <a:pt x="1904" y="1237"/>
                    <a:pt x="1904" y="1237"/>
                  </a:cubicBezTo>
                  <a:cubicBezTo>
                    <a:pt x="1769" y="1081"/>
                    <a:pt x="1749" y="901"/>
                    <a:pt x="1749" y="747"/>
                  </a:cubicBezTo>
                  <a:cubicBezTo>
                    <a:pt x="1749" y="573"/>
                    <a:pt x="1749" y="573"/>
                    <a:pt x="1749" y="573"/>
                  </a:cubicBezTo>
                  <a:cubicBezTo>
                    <a:pt x="1972" y="573"/>
                    <a:pt x="1972" y="573"/>
                    <a:pt x="1972" y="573"/>
                  </a:cubicBezTo>
                  <a:cubicBezTo>
                    <a:pt x="1972" y="1332"/>
                    <a:pt x="1972" y="1332"/>
                    <a:pt x="1972" y="1332"/>
                  </a:cubicBezTo>
                  <a:cubicBezTo>
                    <a:pt x="1972" y="1609"/>
                    <a:pt x="1895" y="1961"/>
                    <a:pt x="1401" y="2182"/>
                  </a:cubicBezTo>
                  <a:cubicBezTo>
                    <a:pt x="931" y="1972"/>
                    <a:pt x="838" y="1643"/>
                    <a:pt x="829" y="1374"/>
                  </a:cubicBezTo>
                  <a:cubicBezTo>
                    <a:pt x="1051" y="1225"/>
                    <a:pt x="1180" y="1001"/>
                    <a:pt x="1180" y="665"/>
                  </a:cubicBezTo>
                  <a:cubicBezTo>
                    <a:pt x="1180" y="573"/>
                    <a:pt x="1180" y="573"/>
                    <a:pt x="1180" y="573"/>
                  </a:cubicBezTo>
                  <a:cubicBezTo>
                    <a:pt x="1401" y="573"/>
                    <a:pt x="1401" y="573"/>
                    <a:pt x="1401" y="573"/>
                  </a:cubicBezTo>
                  <a:cubicBezTo>
                    <a:pt x="1542" y="573"/>
                    <a:pt x="1542" y="573"/>
                    <a:pt x="1542" y="573"/>
                  </a:cubicBezTo>
                  <a:cubicBezTo>
                    <a:pt x="1542" y="436"/>
                    <a:pt x="1542" y="436"/>
                    <a:pt x="1542" y="436"/>
                  </a:cubicBezTo>
                  <a:cubicBezTo>
                    <a:pt x="1401" y="436"/>
                    <a:pt x="1401" y="436"/>
                    <a:pt x="1401" y="436"/>
                  </a:cubicBezTo>
                  <a:cubicBezTo>
                    <a:pt x="1180" y="436"/>
                    <a:pt x="1180" y="436"/>
                    <a:pt x="1180" y="436"/>
                  </a:cubicBezTo>
                  <a:cubicBezTo>
                    <a:pt x="1180" y="436"/>
                    <a:pt x="1180" y="436"/>
                    <a:pt x="1180" y="436"/>
                  </a:cubicBezTo>
                  <a:cubicBezTo>
                    <a:pt x="1044" y="436"/>
                    <a:pt x="1044" y="436"/>
                    <a:pt x="1044" y="436"/>
                  </a:cubicBezTo>
                  <a:cubicBezTo>
                    <a:pt x="1044" y="436"/>
                    <a:pt x="1044" y="436"/>
                    <a:pt x="1044" y="436"/>
                  </a:cubicBezTo>
                  <a:cubicBezTo>
                    <a:pt x="692" y="436"/>
                    <a:pt x="692" y="436"/>
                    <a:pt x="692" y="436"/>
                  </a:cubicBezTo>
                  <a:cubicBezTo>
                    <a:pt x="692" y="1234"/>
                    <a:pt x="692" y="1234"/>
                    <a:pt x="692" y="1234"/>
                  </a:cubicBezTo>
                  <a:cubicBezTo>
                    <a:pt x="692" y="1262"/>
                    <a:pt x="693" y="1289"/>
                    <a:pt x="695" y="1315"/>
                  </a:cubicBezTo>
                  <a:cubicBezTo>
                    <a:pt x="695" y="1315"/>
                    <a:pt x="695" y="1315"/>
                    <a:pt x="695" y="1315"/>
                  </a:cubicBezTo>
                  <a:cubicBezTo>
                    <a:pt x="748" y="1280"/>
                    <a:pt x="792" y="1244"/>
                    <a:pt x="829" y="1205"/>
                  </a:cubicBezTo>
                  <a:cubicBezTo>
                    <a:pt x="829" y="1205"/>
                    <a:pt x="829" y="1205"/>
                    <a:pt x="829" y="1205"/>
                  </a:cubicBezTo>
                  <a:cubicBezTo>
                    <a:pt x="829" y="573"/>
                    <a:pt x="829" y="573"/>
                    <a:pt x="829" y="573"/>
                  </a:cubicBezTo>
                  <a:cubicBezTo>
                    <a:pt x="1044" y="573"/>
                    <a:pt x="1044" y="573"/>
                    <a:pt x="1044" y="573"/>
                  </a:cubicBezTo>
                  <a:cubicBezTo>
                    <a:pt x="1044" y="573"/>
                    <a:pt x="1044" y="573"/>
                    <a:pt x="1044" y="573"/>
                  </a:cubicBezTo>
                  <a:cubicBezTo>
                    <a:pt x="1044" y="747"/>
                    <a:pt x="1044" y="747"/>
                    <a:pt x="1044" y="747"/>
                  </a:cubicBezTo>
                  <a:cubicBezTo>
                    <a:pt x="1044" y="978"/>
                    <a:pt x="1001" y="1263"/>
                    <a:pt x="590" y="1447"/>
                  </a:cubicBezTo>
                  <a:cubicBezTo>
                    <a:pt x="178" y="1263"/>
                    <a:pt x="135" y="978"/>
                    <a:pt x="135" y="747"/>
                  </a:cubicBezTo>
                  <a:cubicBezTo>
                    <a:pt x="135" y="136"/>
                    <a:pt x="135" y="136"/>
                    <a:pt x="135" y="136"/>
                  </a:cubicBezTo>
                  <a:cubicBezTo>
                    <a:pt x="590" y="136"/>
                    <a:pt x="590" y="136"/>
                    <a:pt x="590" y="136"/>
                  </a:cubicBezTo>
                  <a:cubicBezTo>
                    <a:pt x="1044" y="136"/>
                    <a:pt x="1044" y="136"/>
                    <a:pt x="1044" y="136"/>
                  </a:cubicBezTo>
                  <a:cubicBezTo>
                    <a:pt x="1044" y="370"/>
                    <a:pt x="1044" y="370"/>
                    <a:pt x="1044" y="370"/>
                  </a:cubicBezTo>
                  <a:cubicBezTo>
                    <a:pt x="1180" y="370"/>
                    <a:pt x="1180" y="370"/>
                    <a:pt x="1180" y="370"/>
                  </a:cubicBezTo>
                  <a:cubicBezTo>
                    <a:pt x="1180" y="0"/>
                    <a:pt x="1180" y="0"/>
                    <a:pt x="1180" y="0"/>
                  </a:cubicBezTo>
                  <a:cubicBezTo>
                    <a:pt x="590" y="0"/>
                    <a:pt x="590" y="0"/>
                    <a:pt x="590" y="0"/>
                  </a:cubicBezTo>
                  <a:cubicBezTo>
                    <a:pt x="0" y="0"/>
                    <a:pt x="0" y="0"/>
                    <a:pt x="0" y="0"/>
                  </a:cubicBezTo>
                  <a:cubicBezTo>
                    <a:pt x="0" y="665"/>
                    <a:pt x="0" y="665"/>
                    <a:pt x="0" y="665"/>
                  </a:cubicBezTo>
                  <a:cubicBezTo>
                    <a:pt x="0" y="1109"/>
                    <a:pt x="224" y="1357"/>
                    <a:pt x="590" y="1495"/>
                  </a:cubicBezTo>
                  <a:cubicBezTo>
                    <a:pt x="631" y="1479"/>
                    <a:pt x="670" y="1462"/>
                    <a:pt x="708" y="1444"/>
                  </a:cubicBezTo>
                  <a:cubicBezTo>
                    <a:pt x="771" y="1847"/>
                    <a:pt x="1023" y="2087"/>
                    <a:pt x="1401" y="2229"/>
                  </a:cubicBezTo>
                  <a:cubicBezTo>
                    <a:pt x="1777" y="2087"/>
                    <a:pt x="2029" y="1848"/>
                    <a:pt x="2093" y="1447"/>
                  </a:cubicBezTo>
                  <a:cubicBezTo>
                    <a:pt x="2128" y="1464"/>
                    <a:pt x="2165" y="1480"/>
                    <a:pt x="2203" y="1495"/>
                  </a:cubicBezTo>
                  <a:cubicBezTo>
                    <a:pt x="2569" y="1357"/>
                    <a:pt x="2794" y="1109"/>
                    <a:pt x="2794" y="665"/>
                  </a:cubicBezTo>
                  <a:cubicBezTo>
                    <a:pt x="2794" y="0"/>
                    <a:pt x="2794" y="0"/>
                    <a:pt x="2794" y="0"/>
                  </a:cubicBezTo>
                  <a:lnTo>
                    <a:pt x="2203" y="0"/>
                  </a:lnTo>
                  <a:close/>
                  <a:moveTo>
                    <a:pt x="2658" y="747"/>
                  </a:moveTo>
                  <a:cubicBezTo>
                    <a:pt x="2658" y="978"/>
                    <a:pt x="2615" y="1263"/>
                    <a:pt x="2203" y="1447"/>
                  </a:cubicBezTo>
                  <a:cubicBezTo>
                    <a:pt x="2166" y="1431"/>
                    <a:pt x="2131" y="1413"/>
                    <a:pt x="2100" y="1395"/>
                  </a:cubicBezTo>
                  <a:cubicBezTo>
                    <a:pt x="2106" y="1344"/>
                    <a:pt x="2109" y="1290"/>
                    <a:pt x="2109" y="1234"/>
                  </a:cubicBezTo>
                  <a:cubicBezTo>
                    <a:pt x="2109" y="436"/>
                    <a:pt x="2109" y="436"/>
                    <a:pt x="2109" y="436"/>
                  </a:cubicBezTo>
                  <a:cubicBezTo>
                    <a:pt x="1749" y="436"/>
                    <a:pt x="1749" y="436"/>
                    <a:pt x="1749" y="436"/>
                  </a:cubicBezTo>
                  <a:cubicBezTo>
                    <a:pt x="1749" y="136"/>
                    <a:pt x="1749" y="136"/>
                    <a:pt x="1749" y="136"/>
                  </a:cubicBezTo>
                  <a:cubicBezTo>
                    <a:pt x="2203" y="136"/>
                    <a:pt x="2203" y="136"/>
                    <a:pt x="2203" y="136"/>
                  </a:cubicBezTo>
                  <a:cubicBezTo>
                    <a:pt x="2658" y="136"/>
                    <a:pt x="2658" y="136"/>
                    <a:pt x="2658" y="136"/>
                  </a:cubicBezTo>
                  <a:lnTo>
                    <a:pt x="2658" y="74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3" name="Freeform 6"/>
            <p:cNvSpPr>
              <a:spLocks/>
            </p:cNvSpPr>
            <p:nvPr userDrawn="1"/>
          </p:nvSpPr>
          <p:spPr bwMode="auto">
            <a:xfrm>
              <a:off x="915988" y="1003301"/>
              <a:ext cx="188913" cy="236538"/>
            </a:xfrm>
            <a:custGeom>
              <a:avLst/>
              <a:gdLst>
                <a:gd name="T0" fmla="*/ 49 w 596"/>
                <a:gd name="T1" fmla="*/ 747 h 747"/>
                <a:gd name="T2" fmla="*/ 49 w 596"/>
                <a:gd name="T3" fmla="*/ 721 h 747"/>
                <a:gd name="T4" fmla="*/ 91 w 596"/>
                <a:gd name="T5" fmla="*/ 696 h 747"/>
                <a:gd name="T6" fmla="*/ 99 w 596"/>
                <a:gd name="T7" fmla="*/ 684 h 747"/>
                <a:gd name="T8" fmla="*/ 105 w 596"/>
                <a:gd name="T9" fmla="*/ 621 h 747"/>
                <a:gd name="T10" fmla="*/ 109 w 596"/>
                <a:gd name="T11" fmla="*/ 535 h 747"/>
                <a:gd name="T12" fmla="*/ 109 w 596"/>
                <a:gd name="T13" fmla="*/ 252 h 747"/>
                <a:gd name="T14" fmla="*/ 105 w 596"/>
                <a:gd name="T15" fmla="*/ 112 h 747"/>
                <a:gd name="T16" fmla="*/ 98 w 596"/>
                <a:gd name="T17" fmla="*/ 52 h 747"/>
                <a:gd name="T18" fmla="*/ 78 w 596"/>
                <a:gd name="T19" fmla="*/ 39 h 747"/>
                <a:gd name="T20" fmla="*/ 0 w 596"/>
                <a:gd name="T21" fmla="*/ 33 h 747"/>
                <a:gd name="T22" fmla="*/ 0 w 596"/>
                <a:gd name="T23" fmla="*/ 0 h 747"/>
                <a:gd name="T24" fmla="*/ 165 w 596"/>
                <a:gd name="T25" fmla="*/ 3 h 747"/>
                <a:gd name="T26" fmla="*/ 323 w 596"/>
                <a:gd name="T27" fmla="*/ 0 h 747"/>
                <a:gd name="T28" fmla="*/ 323 w 596"/>
                <a:gd name="T29" fmla="*/ 33 h 747"/>
                <a:gd name="T30" fmla="*/ 243 w 596"/>
                <a:gd name="T31" fmla="*/ 39 h 747"/>
                <a:gd name="T32" fmla="*/ 224 w 596"/>
                <a:gd name="T33" fmla="*/ 51 h 747"/>
                <a:gd name="T34" fmla="*/ 216 w 596"/>
                <a:gd name="T35" fmla="*/ 102 h 747"/>
                <a:gd name="T36" fmla="*/ 213 w 596"/>
                <a:gd name="T37" fmla="*/ 252 h 747"/>
                <a:gd name="T38" fmla="*/ 213 w 596"/>
                <a:gd name="T39" fmla="*/ 606 h 747"/>
                <a:gd name="T40" fmla="*/ 216 w 596"/>
                <a:gd name="T41" fmla="*/ 696 h 747"/>
                <a:gd name="T42" fmla="*/ 303 w 596"/>
                <a:gd name="T43" fmla="*/ 700 h 747"/>
                <a:gd name="T44" fmla="*/ 525 w 596"/>
                <a:gd name="T45" fmla="*/ 681 h 747"/>
                <a:gd name="T46" fmla="*/ 538 w 596"/>
                <a:gd name="T47" fmla="*/ 644 h 747"/>
                <a:gd name="T48" fmla="*/ 560 w 596"/>
                <a:gd name="T49" fmla="*/ 557 h 747"/>
                <a:gd name="T50" fmla="*/ 596 w 596"/>
                <a:gd name="T51" fmla="*/ 557 h 747"/>
                <a:gd name="T52" fmla="*/ 573 w 596"/>
                <a:gd name="T53" fmla="*/ 741 h 747"/>
                <a:gd name="T54" fmla="*/ 537 w 596"/>
                <a:gd name="T55" fmla="*/ 746 h 747"/>
                <a:gd name="T56" fmla="*/ 449 w 596"/>
                <a:gd name="T57" fmla="*/ 747 h 747"/>
                <a:gd name="T58" fmla="*/ 156 w 596"/>
                <a:gd name="T59" fmla="*/ 744 h 747"/>
                <a:gd name="T60" fmla="*/ 49 w 596"/>
                <a:gd name="T61" fmla="*/ 747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Lst>
              <a:rect l="0" t="0" r="r" b="b"/>
              <a:pathLst>
                <a:path w="596" h="747">
                  <a:moveTo>
                    <a:pt x="49" y="747"/>
                  </a:moveTo>
                  <a:cubicBezTo>
                    <a:pt x="49" y="721"/>
                    <a:pt x="49" y="721"/>
                    <a:pt x="49" y="721"/>
                  </a:cubicBezTo>
                  <a:cubicBezTo>
                    <a:pt x="71" y="710"/>
                    <a:pt x="85" y="702"/>
                    <a:pt x="91" y="696"/>
                  </a:cubicBezTo>
                  <a:cubicBezTo>
                    <a:pt x="95" y="693"/>
                    <a:pt x="98" y="689"/>
                    <a:pt x="99" y="684"/>
                  </a:cubicBezTo>
                  <a:cubicBezTo>
                    <a:pt x="102" y="675"/>
                    <a:pt x="104" y="654"/>
                    <a:pt x="105" y="621"/>
                  </a:cubicBezTo>
                  <a:cubicBezTo>
                    <a:pt x="108" y="573"/>
                    <a:pt x="109" y="545"/>
                    <a:pt x="109" y="535"/>
                  </a:cubicBezTo>
                  <a:cubicBezTo>
                    <a:pt x="109" y="252"/>
                    <a:pt x="109" y="252"/>
                    <a:pt x="109" y="252"/>
                  </a:cubicBezTo>
                  <a:cubicBezTo>
                    <a:pt x="109" y="204"/>
                    <a:pt x="108" y="157"/>
                    <a:pt x="105" y="112"/>
                  </a:cubicBezTo>
                  <a:cubicBezTo>
                    <a:pt x="104" y="78"/>
                    <a:pt x="102" y="59"/>
                    <a:pt x="98" y="52"/>
                  </a:cubicBezTo>
                  <a:cubicBezTo>
                    <a:pt x="93" y="46"/>
                    <a:pt x="87" y="42"/>
                    <a:pt x="78" y="39"/>
                  </a:cubicBezTo>
                  <a:cubicBezTo>
                    <a:pt x="69" y="36"/>
                    <a:pt x="43" y="34"/>
                    <a:pt x="0" y="33"/>
                  </a:cubicBezTo>
                  <a:cubicBezTo>
                    <a:pt x="0" y="0"/>
                    <a:pt x="0" y="0"/>
                    <a:pt x="0" y="0"/>
                  </a:cubicBezTo>
                  <a:cubicBezTo>
                    <a:pt x="89" y="2"/>
                    <a:pt x="144" y="3"/>
                    <a:pt x="165" y="3"/>
                  </a:cubicBezTo>
                  <a:cubicBezTo>
                    <a:pt x="189" y="3"/>
                    <a:pt x="241" y="2"/>
                    <a:pt x="323" y="0"/>
                  </a:cubicBezTo>
                  <a:cubicBezTo>
                    <a:pt x="323" y="33"/>
                    <a:pt x="323" y="33"/>
                    <a:pt x="323" y="33"/>
                  </a:cubicBezTo>
                  <a:cubicBezTo>
                    <a:pt x="279" y="34"/>
                    <a:pt x="253" y="36"/>
                    <a:pt x="243" y="39"/>
                  </a:cubicBezTo>
                  <a:cubicBezTo>
                    <a:pt x="234" y="42"/>
                    <a:pt x="228" y="46"/>
                    <a:pt x="224" y="51"/>
                  </a:cubicBezTo>
                  <a:cubicBezTo>
                    <a:pt x="220" y="58"/>
                    <a:pt x="217" y="75"/>
                    <a:pt x="216" y="102"/>
                  </a:cubicBezTo>
                  <a:cubicBezTo>
                    <a:pt x="215" y="109"/>
                    <a:pt x="214" y="159"/>
                    <a:pt x="213" y="252"/>
                  </a:cubicBezTo>
                  <a:cubicBezTo>
                    <a:pt x="213" y="606"/>
                    <a:pt x="213" y="606"/>
                    <a:pt x="213" y="606"/>
                  </a:cubicBezTo>
                  <a:cubicBezTo>
                    <a:pt x="213" y="643"/>
                    <a:pt x="214" y="673"/>
                    <a:pt x="216" y="696"/>
                  </a:cubicBezTo>
                  <a:cubicBezTo>
                    <a:pt x="257" y="699"/>
                    <a:pt x="262" y="700"/>
                    <a:pt x="303" y="700"/>
                  </a:cubicBezTo>
                  <a:cubicBezTo>
                    <a:pt x="407" y="700"/>
                    <a:pt x="484" y="693"/>
                    <a:pt x="525" y="681"/>
                  </a:cubicBezTo>
                  <a:cubicBezTo>
                    <a:pt x="530" y="670"/>
                    <a:pt x="534" y="658"/>
                    <a:pt x="538" y="644"/>
                  </a:cubicBezTo>
                  <a:cubicBezTo>
                    <a:pt x="560" y="557"/>
                    <a:pt x="560" y="557"/>
                    <a:pt x="560" y="557"/>
                  </a:cubicBezTo>
                  <a:cubicBezTo>
                    <a:pt x="596" y="557"/>
                    <a:pt x="596" y="557"/>
                    <a:pt x="596" y="557"/>
                  </a:cubicBezTo>
                  <a:cubicBezTo>
                    <a:pt x="588" y="609"/>
                    <a:pt x="580" y="671"/>
                    <a:pt x="573" y="741"/>
                  </a:cubicBezTo>
                  <a:cubicBezTo>
                    <a:pt x="558" y="744"/>
                    <a:pt x="546" y="745"/>
                    <a:pt x="537" y="746"/>
                  </a:cubicBezTo>
                  <a:cubicBezTo>
                    <a:pt x="518" y="747"/>
                    <a:pt x="488" y="747"/>
                    <a:pt x="449" y="747"/>
                  </a:cubicBezTo>
                  <a:cubicBezTo>
                    <a:pt x="156" y="744"/>
                    <a:pt x="156" y="744"/>
                    <a:pt x="156" y="744"/>
                  </a:cubicBezTo>
                  <a:cubicBezTo>
                    <a:pt x="121" y="744"/>
                    <a:pt x="85" y="745"/>
                    <a:pt x="49"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4" name="Freeform 7"/>
            <p:cNvSpPr>
              <a:spLocks/>
            </p:cNvSpPr>
            <p:nvPr userDrawn="1"/>
          </p:nvSpPr>
          <p:spPr bwMode="auto">
            <a:xfrm>
              <a:off x="1127125" y="1003301"/>
              <a:ext cx="103188" cy="236538"/>
            </a:xfrm>
            <a:custGeom>
              <a:avLst/>
              <a:gdLst>
                <a:gd name="T0" fmla="*/ 321 w 321"/>
                <a:gd name="T1" fmla="*/ 714 h 747"/>
                <a:gd name="T2" fmla="*/ 321 w 321"/>
                <a:gd name="T3" fmla="*/ 747 h 747"/>
                <a:gd name="T4" fmla="*/ 168 w 321"/>
                <a:gd name="T5" fmla="*/ 744 h 747"/>
                <a:gd name="T6" fmla="*/ 0 w 321"/>
                <a:gd name="T7" fmla="*/ 747 h 747"/>
                <a:gd name="T8" fmla="*/ 0 w 321"/>
                <a:gd name="T9" fmla="*/ 714 h 747"/>
                <a:gd name="T10" fmla="*/ 77 w 321"/>
                <a:gd name="T11" fmla="*/ 708 h 747"/>
                <a:gd name="T12" fmla="*/ 97 w 321"/>
                <a:gd name="T13" fmla="*/ 696 h 747"/>
                <a:gd name="T14" fmla="*/ 105 w 321"/>
                <a:gd name="T15" fmla="*/ 645 h 747"/>
                <a:gd name="T16" fmla="*/ 108 w 321"/>
                <a:gd name="T17" fmla="*/ 495 h 747"/>
                <a:gd name="T18" fmla="*/ 108 w 321"/>
                <a:gd name="T19" fmla="*/ 251 h 747"/>
                <a:gd name="T20" fmla="*/ 105 w 321"/>
                <a:gd name="T21" fmla="*/ 111 h 747"/>
                <a:gd name="T22" fmla="*/ 97 w 321"/>
                <a:gd name="T23" fmla="*/ 52 h 747"/>
                <a:gd name="T24" fmla="*/ 77 w 321"/>
                <a:gd name="T25" fmla="*/ 39 h 747"/>
                <a:gd name="T26" fmla="*/ 0 w 321"/>
                <a:gd name="T27" fmla="*/ 33 h 747"/>
                <a:gd name="T28" fmla="*/ 0 w 321"/>
                <a:gd name="T29" fmla="*/ 0 h 747"/>
                <a:gd name="T30" fmla="*/ 161 w 321"/>
                <a:gd name="T31" fmla="*/ 3 h 747"/>
                <a:gd name="T32" fmla="*/ 321 w 321"/>
                <a:gd name="T33" fmla="*/ 0 h 747"/>
                <a:gd name="T34" fmla="*/ 321 w 321"/>
                <a:gd name="T35" fmla="*/ 33 h 747"/>
                <a:gd name="T36" fmla="*/ 243 w 321"/>
                <a:gd name="T37" fmla="*/ 39 h 747"/>
                <a:gd name="T38" fmla="*/ 224 w 321"/>
                <a:gd name="T39" fmla="*/ 51 h 747"/>
                <a:gd name="T40" fmla="*/ 216 w 321"/>
                <a:gd name="T41" fmla="*/ 102 h 747"/>
                <a:gd name="T42" fmla="*/ 212 w 321"/>
                <a:gd name="T43" fmla="*/ 251 h 747"/>
                <a:gd name="T44" fmla="*/ 212 w 321"/>
                <a:gd name="T45" fmla="*/ 495 h 747"/>
                <a:gd name="T46" fmla="*/ 214 w 321"/>
                <a:gd name="T47" fmla="*/ 635 h 747"/>
                <a:gd name="T48" fmla="*/ 222 w 321"/>
                <a:gd name="T49" fmla="*/ 694 h 747"/>
                <a:gd name="T50" fmla="*/ 242 w 321"/>
                <a:gd name="T51" fmla="*/ 708 h 747"/>
                <a:gd name="T52" fmla="*/ 321 w 321"/>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1" h="747">
                  <a:moveTo>
                    <a:pt x="321" y="714"/>
                  </a:moveTo>
                  <a:cubicBezTo>
                    <a:pt x="321" y="747"/>
                    <a:pt x="321" y="747"/>
                    <a:pt x="321" y="747"/>
                  </a:cubicBezTo>
                  <a:cubicBezTo>
                    <a:pt x="244" y="745"/>
                    <a:pt x="193" y="744"/>
                    <a:pt x="168" y="744"/>
                  </a:cubicBezTo>
                  <a:cubicBezTo>
                    <a:pt x="0" y="747"/>
                    <a:pt x="0" y="747"/>
                    <a:pt x="0" y="747"/>
                  </a:cubicBezTo>
                  <a:cubicBezTo>
                    <a:pt x="0" y="714"/>
                    <a:pt x="0" y="714"/>
                    <a:pt x="0" y="714"/>
                  </a:cubicBezTo>
                  <a:cubicBezTo>
                    <a:pt x="42" y="713"/>
                    <a:pt x="68" y="711"/>
                    <a:pt x="77" y="708"/>
                  </a:cubicBezTo>
                  <a:cubicBezTo>
                    <a:pt x="87" y="705"/>
                    <a:pt x="93" y="701"/>
                    <a:pt x="97" y="696"/>
                  </a:cubicBezTo>
                  <a:cubicBezTo>
                    <a:pt x="101" y="689"/>
                    <a:pt x="104" y="672"/>
                    <a:pt x="105" y="645"/>
                  </a:cubicBezTo>
                  <a:cubicBezTo>
                    <a:pt x="106" y="637"/>
                    <a:pt x="107" y="587"/>
                    <a:pt x="108" y="495"/>
                  </a:cubicBezTo>
                  <a:cubicBezTo>
                    <a:pt x="108" y="251"/>
                    <a:pt x="108" y="251"/>
                    <a:pt x="108" y="251"/>
                  </a:cubicBezTo>
                  <a:cubicBezTo>
                    <a:pt x="108" y="204"/>
                    <a:pt x="107" y="157"/>
                    <a:pt x="105" y="111"/>
                  </a:cubicBezTo>
                  <a:cubicBezTo>
                    <a:pt x="104" y="78"/>
                    <a:pt x="102" y="59"/>
                    <a:pt x="97" y="52"/>
                  </a:cubicBezTo>
                  <a:cubicBezTo>
                    <a:pt x="93" y="46"/>
                    <a:pt x="87" y="41"/>
                    <a:pt x="77" y="39"/>
                  </a:cubicBezTo>
                  <a:cubicBezTo>
                    <a:pt x="68" y="36"/>
                    <a:pt x="42" y="34"/>
                    <a:pt x="0" y="33"/>
                  </a:cubicBezTo>
                  <a:cubicBezTo>
                    <a:pt x="0" y="0"/>
                    <a:pt x="0" y="0"/>
                    <a:pt x="0" y="0"/>
                  </a:cubicBezTo>
                  <a:cubicBezTo>
                    <a:pt x="69" y="2"/>
                    <a:pt x="123" y="3"/>
                    <a:pt x="161" y="3"/>
                  </a:cubicBezTo>
                  <a:cubicBezTo>
                    <a:pt x="197" y="3"/>
                    <a:pt x="250" y="2"/>
                    <a:pt x="321" y="0"/>
                  </a:cubicBezTo>
                  <a:cubicBezTo>
                    <a:pt x="321" y="33"/>
                    <a:pt x="321" y="33"/>
                    <a:pt x="321" y="33"/>
                  </a:cubicBezTo>
                  <a:cubicBezTo>
                    <a:pt x="278" y="34"/>
                    <a:pt x="252" y="36"/>
                    <a:pt x="243" y="39"/>
                  </a:cubicBezTo>
                  <a:cubicBezTo>
                    <a:pt x="234" y="41"/>
                    <a:pt x="227" y="46"/>
                    <a:pt x="224" y="51"/>
                  </a:cubicBezTo>
                  <a:cubicBezTo>
                    <a:pt x="219" y="58"/>
                    <a:pt x="217" y="75"/>
                    <a:pt x="216" y="102"/>
                  </a:cubicBezTo>
                  <a:cubicBezTo>
                    <a:pt x="215" y="109"/>
                    <a:pt x="214" y="159"/>
                    <a:pt x="212" y="251"/>
                  </a:cubicBezTo>
                  <a:cubicBezTo>
                    <a:pt x="212" y="495"/>
                    <a:pt x="212" y="495"/>
                    <a:pt x="212" y="495"/>
                  </a:cubicBezTo>
                  <a:cubicBezTo>
                    <a:pt x="212" y="543"/>
                    <a:pt x="213" y="589"/>
                    <a:pt x="214" y="635"/>
                  </a:cubicBezTo>
                  <a:cubicBezTo>
                    <a:pt x="215" y="668"/>
                    <a:pt x="218" y="688"/>
                    <a:pt x="222" y="694"/>
                  </a:cubicBezTo>
                  <a:cubicBezTo>
                    <a:pt x="226" y="700"/>
                    <a:pt x="233" y="705"/>
                    <a:pt x="242" y="708"/>
                  </a:cubicBezTo>
                  <a:cubicBezTo>
                    <a:pt x="251" y="711"/>
                    <a:pt x="278" y="713"/>
                    <a:pt x="321"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5" name="Freeform 8"/>
            <p:cNvSpPr>
              <a:spLocks/>
            </p:cNvSpPr>
            <p:nvPr userDrawn="1"/>
          </p:nvSpPr>
          <p:spPr bwMode="auto">
            <a:xfrm>
              <a:off x="1266825" y="1003301"/>
              <a:ext cx="276225" cy="242888"/>
            </a:xfrm>
            <a:custGeom>
              <a:avLst/>
              <a:gdLst>
                <a:gd name="T0" fmla="*/ 5 w 869"/>
                <a:gd name="T1" fmla="*/ 747 h 766"/>
                <a:gd name="T2" fmla="*/ 5 w 869"/>
                <a:gd name="T3" fmla="*/ 714 h 766"/>
                <a:gd name="T4" fmla="*/ 80 w 869"/>
                <a:gd name="T5" fmla="*/ 705 h 766"/>
                <a:gd name="T6" fmla="*/ 91 w 869"/>
                <a:gd name="T7" fmla="*/ 695 h 766"/>
                <a:gd name="T8" fmla="*/ 99 w 869"/>
                <a:gd name="T9" fmla="*/ 640 h 766"/>
                <a:gd name="T10" fmla="*/ 102 w 869"/>
                <a:gd name="T11" fmla="*/ 520 h 766"/>
                <a:gd name="T12" fmla="*/ 102 w 869"/>
                <a:gd name="T13" fmla="*/ 92 h 766"/>
                <a:gd name="T14" fmla="*/ 100 w 869"/>
                <a:gd name="T15" fmla="*/ 69 h 766"/>
                <a:gd name="T16" fmla="*/ 80 w 869"/>
                <a:gd name="T17" fmla="*/ 47 h 766"/>
                <a:gd name="T18" fmla="*/ 57 w 869"/>
                <a:gd name="T19" fmla="*/ 36 h 766"/>
                <a:gd name="T20" fmla="*/ 0 w 869"/>
                <a:gd name="T21" fmla="*/ 33 h 766"/>
                <a:gd name="T22" fmla="*/ 0 w 869"/>
                <a:gd name="T23" fmla="*/ 0 h 766"/>
                <a:gd name="T24" fmla="*/ 119 w 869"/>
                <a:gd name="T25" fmla="*/ 3 h 766"/>
                <a:gd name="T26" fmla="*/ 202 w 869"/>
                <a:gd name="T27" fmla="*/ 0 h 766"/>
                <a:gd name="T28" fmla="*/ 269 w 869"/>
                <a:gd name="T29" fmla="*/ 86 h 766"/>
                <a:gd name="T30" fmla="*/ 381 w 869"/>
                <a:gd name="T31" fmla="*/ 220 h 766"/>
                <a:gd name="T32" fmla="*/ 545 w 869"/>
                <a:gd name="T33" fmla="*/ 411 h 766"/>
                <a:gd name="T34" fmla="*/ 671 w 869"/>
                <a:gd name="T35" fmla="*/ 554 h 766"/>
                <a:gd name="T36" fmla="*/ 721 w 869"/>
                <a:gd name="T37" fmla="*/ 609 h 766"/>
                <a:gd name="T38" fmla="*/ 721 w 869"/>
                <a:gd name="T39" fmla="*/ 226 h 766"/>
                <a:gd name="T40" fmla="*/ 718 w 869"/>
                <a:gd name="T41" fmla="*/ 105 h 766"/>
                <a:gd name="T42" fmla="*/ 711 w 869"/>
                <a:gd name="T43" fmla="*/ 51 h 766"/>
                <a:gd name="T44" fmla="*/ 699 w 869"/>
                <a:gd name="T45" fmla="*/ 41 h 766"/>
                <a:gd name="T46" fmla="*/ 624 w 869"/>
                <a:gd name="T47" fmla="*/ 33 h 766"/>
                <a:gd name="T48" fmla="*/ 624 w 869"/>
                <a:gd name="T49" fmla="*/ 0 h 766"/>
                <a:gd name="T50" fmla="*/ 756 w 869"/>
                <a:gd name="T51" fmla="*/ 3 h 766"/>
                <a:gd name="T52" fmla="*/ 869 w 869"/>
                <a:gd name="T53" fmla="*/ 0 h 766"/>
                <a:gd name="T54" fmla="*/ 869 w 869"/>
                <a:gd name="T55" fmla="*/ 33 h 766"/>
                <a:gd name="T56" fmla="*/ 794 w 869"/>
                <a:gd name="T57" fmla="*/ 41 h 766"/>
                <a:gd name="T58" fmla="*/ 783 w 869"/>
                <a:gd name="T59" fmla="*/ 52 h 766"/>
                <a:gd name="T60" fmla="*/ 775 w 869"/>
                <a:gd name="T61" fmla="*/ 107 h 766"/>
                <a:gd name="T62" fmla="*/ 772 w 869"/>
                <a:gd name="T63" fmla="*/ 226 h 766"/>
                <a:gd name="T64" fmla="*/ 772 w 869"/>
                <a:gd name="T65" fmla="*/ 479 h 766"/>
                <a:gd name="T66" fmla="*/ 775 w 869"/>
                <a:gd name="T67" fmla="*/ 766 h 766"/>
                <a:gd name="T68" fmla="*/ 721 w 869"/>
                <a:gd name="T69" fmla="*/ 766 h 766"/>
                <a:gd name="T70" fmla="*/ 707 w 869"/>
                <a:gd name="T71" fmla="*/ 752 h 766"/>
                <a:gd name="T72" fmla="*/ 698 w 869"/>
                <a:gd name="T73" fmla="*/ 744 h 766"/>
                <a:gd name="T74" fmla="*/ 678 w 869"/>
                <a:gd name="T75" fmla="*/ 723 h 766"/>
                <a:gd name="T76" fmla="*/ 611 w 869"/>
                <a:gd name="T77" fmla="*/ 647 h 766"/>
                <a:gd name="T78" fmla="*/ 540 w 869"/>
                <a:gd name="T79" fmla="*/ 560 h 766"/>
                <a:gd name="T80" fmla="*/ 151 w 869"/>
                <a:gd name="T81" fmla="*/ 110 h 766"/>
                <a:gd name="T82" fmla="*/ 151 w 869"/>
                <a:gd name="T83" fmla="*/ 518 h 766"/>
                <a:gd name="T84" fmla="*/ 154 w 869"/>
                <a:gd name="T85" fmla="*/ 641 h 766"/>
                <a:gd name="T86" fmla="*/ 161 w 869"/>
                <a:gd name="T87" fmla="*/ 695 h 766"/>
                <a:gd name="T88" fmla="*/ 173 w 869"/>
                <a:gd name="T89" fmla="*/ 705 h 766"/>
                <a:gd name="T90" fmla="*/ 249 w 869"/>
                <a:gd name="T91" fmla="*/ 714 h 766"/>
                <a:gd name="T92" fmla="*/ 249 w 869"/>
                <a:gd name="T93" fmla="*/ 747 h 766"/>
                <a:gd name="T94" fmla="*/ 143 w 869"/>
                <a:gd name="T95" fmla="*/ 744 h 766"/>
                <a:gd name="T96" fmla="*/ 5 w 869"/>
                <a:gd name="T97" fmla="*/ 747 h 76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869" h="766">
                  <a:moveTo>
                    <a:pt x="5" y="747"/>
                  </a:moveTo>
                  <a:cubicBezTo>
                    <a:pt x="5" y="714"/>
                    <a:pt x="5" y="714"/>
                    <a:pt x="5" y="714"/>
                  </a:cubicBezTo>
                  <a:cubicBezTo>
                    <a:pt x="43" y="714"/>
                    <a:pt x="68" y="711"/>
                    <a:pt x="80" y="705"/>
                  </a:cubicBezTo>
                  <a:cubicBezTo>
                    <a:pt x="86" y="703"/>
                    <a:pt x="89" y="700"/>
                    <a:pt x="91" y="695"/>
                  </a:cubicBezTo>
                  <a:cubicBezTo>
                    <a:pt x="95" y="688"/>
                    <a:pt x="98" y="670"/>
                    <a:pt x="99" y="640"/>
                  </a:cubicBezTo>
                  <a:cubicBezTo>
                    <a:pt x="101" y="594"/>
                    <a:pt x="102" y="554"/>
                    <a:pt x="102" y="520"/>
                  </a:cubicBezTo>
                  <a:cubicBezTo>
                    <a:pt x="102" y="92"/>
                    <a:pt x="102" y="92"/>
                    <a:pt x="102" y="92"/>
                  </a:cubicBezTo>
                  <a:cubicBezTo>
                    <a:pt x="102" y="80"/>
                    <a:pt x="102" y="73"/>
                    <a:pt x="100" y="69"/>
                  </a:cubicBezTo>
                  <a:cubicBezTo>
                    <a:pt x="97" y="63"/>
                    <a:pt x="91" y="56"/>
                    <a:pt x="80" y="47"/>
                  </a:cubicBezTo>
                  <a:cubicBezTo>
                    <a:pt x="74" y="41"/>
                    <a:pt x="66" y="38"/>
                    <a:pt x="57" y="36"/>
                  </a:cubicBezTo>
                  <a:cubicBezTo>
                    <a:pt x="49" y="34"/>
                    <a:pt x="30" y="33"/>
                    <a:pt x="0" y="33"/>
                  </a:cubicBezTo>
                  <a:cubicBezTo>
                    <a:pt x="0" y="0"/>
                    <a:pt x="0" y="0"/>
                    <a:pt x="0" y="0"/>
                  </a:cubicBezTo>
                  <a:cubicBezTo>
                    <a:pt x="63" y="2"/>
                    <a:pt x="103" y="3"/>
                    <a:pt x="119" y="3"/>
                  </a:cubicBezTo>
                  <a:cubicBezTo>
                    <a:pt x="147" y="3"/>
                    <a:pt x="174" y="2"/>
                    <a:pt x="202" y="0"/>
                  </a:cubicBezTo>
                  <a:cubicBezTo>
                    <a:pt x="232" y="39"/>
                    <a:pt x="255" y="67"/>
                    <a:pt x="269" y="86"/>
                  </a:cubicBezTo>
                  <a:cubicBezTo>
                    <a:pt x="381" y="220"/>
                    <a:pt x="381" y="220"/>
                    <a:pt x="381" y="220"/>
                  </a:cubicBezTo>
                  <a:cubicBezTo>
                    <a:pt x="545" y="411"/>
                    <a:pt x="545" y="411"/>
                    <a:pt x="545" y="411"/>
                  </a:cubicBezTo>
                  <a:cubicBezTo>
                    <a:pt x="597" y="472"/>
                    <a:pt x="639" y="520"/>
                    <a:pt x="671" y="554"/>
                  </a:cubicBezTo>
                  <a:cubicBezTo>
                    <a:pt x="691" y="578"/>
                    <a:pt x="708" y="596"/>
                    <a:pt x="721" y="609"/>
                  </a:cubicBezTo>
                  <a:cubicBezTo>
                    <a:pt x="721" y="226"/>
                    <a:pt x="721" y="226"/>
                    <a:pt x="721" y="226"/>
                  </a:cubicBezTo>
                  <a:cubicBezTo>
                    <a:pt x="721" y="191"/>
                    <a:pt x="720" y="151"/>
                    <a:pt x="718" y="105"/>
                  </a:cubicBezTo>
                  <a:cubicBezTo>
                    <a:pt x="717" y="76"/>
                    <a:pt x="714" y="58"/>
                    <a:pt x="711" y="51"/>
                  </a:cubicBezTo>
                  <a:cubicBezTo>
                    <a:pt x="708" y="46"/>
                    <a:pt x="705" y="43"/>
                    <a:pt x="699" y="41"/>
                  </a:cubicBezTo>
                  <a:cubicBezTo>
                    <a:pt x="687" y="36"/>
                    <a:pt x="662" y="33"/>
                    <a:pt x="624" y="33"/>
                  </a:cubicBezTo>
                  <a:cubicBezTo>
                    <a:pt x="624" y="0"/>
                    <a:pt x="624" y="0"/>
                    <a:pt x="624" y="0"/>
                  </a:cubicBezTo>
                  <a:cubicBezTo>
                    <a:pt x="667" y="2"/>
                    <a:pt x="711" y="3"/>
                    <a:pt x="756" y="3"/>
                  </a:cubicBezTo>
                  <a:cubicBezTo>
                    <a:pt x="797" y="3"/>
                    <a:pt x="835" y="2"/>
                    <a:pt x="869" y="0"/>
                  </a:cubicBezTo>
                  <a:cubicBezTo>
                    <a:pt x="869" y="33"/>
                    <a:pt x="869" y="33"/>
                    <a:pt x="869" y="33"/>
                  </a:cubicBezTo>
                  <a:cubicBezTo>
                    <a:pt x="831" y="33"/>
                    <a:pt x="806" y="36"/>
                    <a:pt x="794" y="41"/>
                  </a:cubicBezTo>
                  <a:cubicBezTo>
                    <a:pt x="789" y="43"/>
                    <a:pt x="785" y="47"/>
                    <a:pt x="783" y="52"/>
                  </a:cubicBezTo>
                  <a:cubicBezTo>
                    <a:pt x="779" y="58"/>
                    <a:pt x="776" y="77"/>
                    <a:pt x="775" y="107"/>
                  </a:cubicBezTo>
                  <a:cubicBezTo>
                    <a:pt x="773" y="153"/>
                    <a:pt x="772" y="193"/>
                    <a:pt x="772" y="226"/>
                  </a:cubicBezTo>
                  <a:cubicBezTo>
                    <a:pt x="772" y="479"/>
                    <a:pt x="772" y="479"/>
                    <a:pt x="772" y="479"/>
                  </a:cubicBezTo>
                  <a:cubicBezTo>
                    <a:pt x="772" y="531"/>
                    <a:pt x="773" y="626"/>
                    <a:pt x="775" y="766"/>
                  </a:cubicBezTo>
                  <a:cubicBezTo>
                    <a:pt x="721" y="766"/>
                    <a:pt x="721" y="766"/>
                    <a:pt x="721" y="766"/>
                  </a:cubicBezTo>
                  <a:cubicBezTo>
                    <a:pt x="707" y="752"/>
                    <a:pt x="707" y="752"/>
                    <a:pt x="707" y="752"/>
                  </a:cubicBezTo>
                  <a:cubicBezTo>
                    <a:pt x="705" y="751"/>
                    <a:pt x="700" y="746"/>
                    <a:pt x="698" y="744"/>
                  </a:cubicBezTo>
                  <a:cubicBezTo>
                    <a:pt x="696" y="742"/>
                    <a:pt x="689" y="735"/>
                    <a:pt x="678" y="723"/>
                  </a:cubicBezTo>
                  <a:cubicBezTo>
                    <a:pt x="647" y="689"/>
                    <a:pt x="625" y="664"/>
                    <a:pt x="611" y="647"/>
                  </a:cubicBezTo>
                  <a:cubicBezTo>
                    <a:pt x="540" y="560"/>
                    <a:pt x="540" y="560"/>
                    <a:pt x="540" y="560"/>
                  </a:cubicBezTo>
                  <a:cubicBezTo>
                    <a:pt x="151" y="110"/>
                    <a:pt x="151" y="110"/>
                    <a:pt x="151" y="110"/>
                  </a:cubicBezTo>
                  <a:cubicBezTo>
                    <a:pt x="151" y="518"/>
                    <a:pt x="151" y="518"/>
                    <a:pt x="151" y="518"/>
                  </a:cubicBezTo>
                  <a:cubicBezTo>
                    <a:pt x="151" y="552"/>
                    <a:pt x="152" y="593"/>
                    <a:pt x="154" y="641"/>
                  </a:cubicBezTo>
                  <a:cubicBezTo>
                    <a:pt x="156" y="670"/>
                    <a:pt x="158" y="688"/>
                    <a:pt x="161" y="695"/>
                  </a:cubicBezTo>
                  <a:cubicBezTo>
                    <a:pt x="164" y="700"/>
                    <a:pt x="168" y="704"/>
                    <a:pt x="173" y="705"/>
                  </a:cubicBezTo>
                  <a:cubicBezTo>
                    <a:pt x="185" y="711"/>
                    <a:pt x="210" y="714"/>
                    <a:pt x="249" y="714"/>
                  </a:cubicBezTo>
                  <a:cubicBezTo>
                    <a:pt x="249" y="747"/>
                    <a:pt x="249" y="747"/>
                    <a:pt x="249" y="747"/>
                  </a:cubicBezTo>
                  <a:cubicBezTo>
                    <a:pt x="217" y="745"/>
                    <a:pt x="181" y="744"/>
                    <a:pt x="143" y="744"/>
                  </a:cubicBezTo>
                  <a:cubicBezTo>
                    <a:pt x="100" y="744"/>
                    <a:pt x="54" y="745"/>
                    <a:pt x="5"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6" name="Freeform 9"/>
            <p:cNvSpPr>
              <a:spLocks/>
            </p:cNvSpPr>
            <p:nvPr userDrawn="1"/>
          </p:nvSpPr>
          <p:spPr bwMode="auto">
            <a:xfrm>
              <a:off x="1573213" y="1003301"/>
              <a:ext cx="101600" cy="236538"/>
            </a:xfrm>
            <a:custGeom>
              <a:avLst/>
              <a:gdLst>
                <a:gd name="T0" fmla="*/ 322 w 322"/>
                <a:gd name="T1" fmla="*/ 714 h 747"/>
                <a:gd name="T2" fmla="*/ 322 w 322"/>
                <a:gd name="T3" fmla="*/ 747 h 747"/>
                <a:gd name="T4" fmla="*/ 169 w 322"/>
                <a:gd name="T5" fmla="*/ 744 h 747"/>
                <a:gd name="T6" fmla="*/ 0 w 322"/>
                <a:gd name="T7" fmla="*/ 747 h 747"/>
                <a:gd name="T8" fmla="*/ 0 w 322"/>
                <a:gd name="T9" fmla="*/ 714 h 747"/>
                <a:gd name="T10" fmla="*/ 79 w 322"/>
                <a:gd name="T11" fmla="*/ 708 h 747"/>
                <a:gd name="T12" fmla="*/ 98 w 322"/>
                <a:gd name="T13" fmla="*/ 696 h 747"/>
                <a:gd name="T14" fmla="*/ 106 w 322"/>
                <a:gd name="T15" fmla="*/ 645 h 747"/>
                <a:gd name="T16" fmla="*/ 109 w 322"/>
                <a:gd name="T17" fmla="*/ 495 h 747"/>
                <a:gd name="T18" fmla="*/ 109 w 322"/>
                <a:gd name="T19" fmla="*/ 251 h 747"/>
                <a:gd name="T20" fmla="*/ 106 w 322"/>
                <a:gd name="T21" fmla="*/ 111 h 747"/>
                <a:gd name="T22" fmla="*/ 98 w 322"/>
                <a:gd name="T23" fmla="*/ 52 h 747"/>
                <a:gd name="T24" fmla="*/ 78 w 322"/>
                <a:gd name="T25" fmla="*/ 39 h 747"/>
                <a:gd name="T26" fmla="*/ 0 w 322"/>
                <a:gd name="T27" fmla="*/ 33 h 747"/>
                <a:gd name="T28" fmla="*/ 0 w 322"/>
                <a:gd name="T29" fmla="*/ 0 h 747"/>
                <a:gd name="T30" fmla="*/ 161 w 322"/>
                <a:gd name="T31" fmla="*/ 3 h 747"/>
                <a:gd name="T32" fmla="*/ 322 w 322"/>
                <a:gd name="T33" fmla="*/ 0 h 747"/>
                <a:gd name="T34" fmla="*/ 322 w 322"/>
                <a:gd name="T35" fmla="*/ 33 h 747"/>
                <a:gd name="T36" fmla="*/ 244 w 322"/>
                <a:gd name="T37" fmla="*/ 39 h 747"/>
                <a:gd name="T38" fmla="*/ 224 w 322"/>
                <a:gd name="T39" fmla="*/ 51 h 747"/>
                <a:gd name="T40" fmla="*/ 216 w 322"/>
                <a:gd name="T41" fmla="*/ 102 h 747"/>
                <a:gd name="T42" fmla="*/ 213 w 322"/>
                <a:gd name="T43" fmla="*/ 251 h 747"/>
                <a:gd name="T44" fmla="*/ 213 w 322"/>
                <a:gd name="T45" fmla="*/ 495 h 747"/>
                <a:gd name="T46" fmla="*/ 215 w 322"/>
                <a:gd name="T47" fmla="*/ 635 h 747"/>
                <a:gd name="T48" fmla="*/ 223 w 322"/>
                <a:gd name="T49" fmla="*/ 694 h 747"/>
                <a:gd name="T50" fmla="*/ 243 w 322"/>
                <a:gd name="T51" fmla="*/ 708 h 747"/>
                <a:gd name="T52" fmla="*/ 322 w 322"/>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2" h="747">
                  <a:moveTo>
                    <a:pt x="322" y="714"/>
                  </a:moveTo>
                  <a:cubicBezTo>
                    <a:pt x="322" y="747"/>
                    <a:pt x="322" y="747"/>
                    <a:pt x="322" y="747"/>
                  </a:cubicBezTo>
                  <a:cubicBezTo>
                    <a:pt x="244" y="745"/>
                    <a:pt x="193" y="744"/>
                    <a:pt x="169" y="744"/>
                  </a:cubicBezTo>
                  <a:cubicBezTo>
                    <a:pt x="0" y="747"/>
                    <a:pt x="0" y="747"/>
                    <a:pt x="0" y="747"/>
                  </a:cubicBezTo>
                  <a:cubicBezTo>
                    <a:pt x="0" y="714"/>
                    <a:pt x="0" y="714"/>
                    <a:pt x="0" y="714"/>
                  </a:cubicBezTo>
                  <a:cubicBezTo>
                    <a:pt x="43" y="713"/>
                    <a:pt x="69" y="711"/>
                    <a:pt x="79" y="708"/>
                  </a:cubicBezTo>
                  <a:cubicBezTo>
                    <a:pt x="88" y="705"/>
                    <a:pt x="94" y="701"/>
                    <a:pt x="98" y="696"/>
                  </a:cubicBezTo>
                  <a:cubicBezTo>
                    <a:pt x="102" y="689"/>
                    <a:pt x="105" y="672"/>
                    <a:pt x="106" y="645"/>
                  </a:cubicBezTo>
                  <a:cubicBezTo>
                    <a:pt x="107" y="637"/>
                    <a:pt x="108" y="587"/>
                    <a:pt x="109" y="495"/>
                  </a:cubicBezTo>
                  <a:cubicBezTo>
                    <a:pt x="109" y="251"/>
                    <a:pt x="109" y="251"/>
                    <a:pt x="109" y="251"/>
                  </a:cubicBezTo>
                  <a:cubicBezTo>
                    <a:pt x="109" y="204"/>
                    <a:pt x="108" y="157"/>
                    <a:pt x="106" y="111"/>
                  </a:cubicBezTo>
                  <a:cubicBezTo>
                    <a:pt x="105" y="78"/>
                    <a:pt x="102" y="59"/>
                    <a:pt x="98" y="52"/>
                  </a:cubicBezTo>
                  <a:cubicBezTo>
                    <a:pt x="94" y="46"/>
                    <a:pt x="88" y="41"/>
                    <a:pt x="78" y="39"/>
                  </a:cubicBezTo>
                  <a:cubicBezTo>
                    <a:pt x="69" y="36"/>
                    <a:pt x="43" y="34"/>
                    <a:pt x="0" y="33"/>
                  </a:cubicBezTo>
                  <a:cubicBezTo>
                    <a:pt x="0" y="0"/>
                    <a:pt x="0" y="0"/>
                    <a:pt x="0" y="0"/>
                  </a:cubicBezTo>
                  <a:cubicBezTo>
                    <a:pt x="70" y="2"/>
                    <a:pt x="124" y="3"/>
                    <a:pt x="161" y="3"/>
                  </a:cubicBezTo>
                  <a:cubicBezTo>
                    <a:pt x="198" y="3"/>
                    <a:pt x="251" y="2"/>
                    <a:pt x="322" y="0"/>
                  </a:cubicBezTo>
                  <a:cubicBezTo>
                    <a:pt x="322" y="33"/>
                    <a:pt x="322" y="33"/>
                    <a:pt x="322" y="33"/>
                  </a:cubicBezTo>
                  <a:cubicBezTo>
                    <a:pt x="279" y="34"/>
                    <a:pt x="253" y="36"/>
                    <a:pt x="244" y="39"/>
                  </a:cubicBezTo>
                  <a:cubicBezTo>
                    <a:pt x="234" y="41"/>
                    <a:pt x="228" y="46"/>
                    <a:pt x="224" y="51"/>
                  </a:cubicBezTo>
                  <a:cubicBezTo>
                    <a:pt x="220" y="58"/>
                    <a:pt x="217" y="75"/>
                    <a:pt x="216" y="102"/>
                  </a:cubicBezTo>
                  <a:cubicBezTo>
                    <a:pt x="216" y="109"/>
                    <a:pt x="215" y="159"/>
                    <a:pt x="213" y="251"/>
                  </a:cubicBezTo>
                  <a:cubicBezTo>
                    <a:pt x="213" y="495"/>
                    <a:pt x="213" y="495"/>
                    <a:pt x="213" y="495"/>
                  </a:cubicBezTo>
                  <a:cubicBezTo>
                    <a:pt x="213" y="543"/>
                    <a:pt x="214" y="589"/>
                    <a:pt x="215" y="635"/>
                  </a:cubicBezTo>
                  <a:cubicBezTo>
                    <a:pt x="216" y="668"/>
                    <a:pt x="219" y="688"/>
                    <a:pt x="223" y="694"/>
                  </a:cubicBezTo>
                  <a:cubicBezTo>
                    <a:pt x="227" y="700"/>
                    <a:pt x="234" y="705"/>
                    <a:pt x="243" y="708"/>
                  </a:cubicBezTo>
                  <a:cubicBezTo>
                    <a:pt x="252" y="711"/>
                    <a:pt x="278" y="713"/>
                    <a:pt x="322"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7" name="Freeform 10"/>
            <p:cNvSpPr>
              <a:spLocks/>
            </p:cNvSpPr>
            <p:nvPr userDrawn="1"/>
          </p:nvSpPr>
          <p:spPr bwMode="auto">
            <a:xfrm>
              <a:off x="1692275" y="998538"/>
              <a:ext cx="231775" cy="246063"/>
            </a:xfrm>
            <a:custGeom>
              <a:avLst/>
              <a:gdLst>
                <a:gd name="T0" fmla="*/ 728 w 728"/>
                <a:gd name="T1" fmla="*/ 667 h 774"/>
                <a:gd name="T2" fmla="*/ 707 w 728"/>
                <a:gd name="T3" fmla="*/ 716 h 774"/>
                <a:gd name="T4" fmla="*/ 581 w 728"/>
                <a:gd name="T5" fmla="*/ 761 h 774"/>
                <a:gd name="T6" fmla="*/ 447 w 728"/>
                <a:gd name="T7" fmla="*/ 774 h 774"/>
                <a:gd name="T8" fmla="*/ 288 w 728"/>
                <a:gd name="T9" fmla="*/ 754 h 774"/>
                <a:gd name="T10" fmla="*/ 161 w 728"/>
                <a:gd name="T11" fmla="*/ 696 h 774"/>
                <a:gd name="T12" fmla="*/ 71 w 728"/>
                <a:gd name="T13" fmla="*/ 610 h 774"/>
                <a:gd name="T14" fmla="*/ 18 w 728"/>
                <a:gd name="T15" fmla="*/ 508 h 774"/>
                <a:gd name="T16" fmla="*/ 0 w 728"/>
                <a:gd name="T17" fmla="*/ 386 h 774"/>
                <a:gd name="T18" fmla="*/ 123 w 728"/>
                <a:gd name="T19" fmla="*/ 110 h 774"/>
                <a:gd name="T20" fmla="*/ 457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5 w 728"/>
                <a:gd name="T35" fmla="*/ 143 h 774"/>
                <a:gd name="T36" fmla="*/ 605 w 728"/>
                <a:gd name="T37" fmla="*/ 66 h 774"/>
                <a:gd name="T38" fmla="*/ 446 w 728"/>
                <a:gd name="T39" fmla="*/ 41 h 774"/>
                <a:gd name="T40" fmla="*/ 313 w 728"/>
                <a:gd name="T41" fmla="*/ 60 h 774"/>
                <a:gd name="T42" fmla="*/ 217 w 728"/>
                <a:gd name="T43" fmla="*/ 117 h 774"/>
                <a:gd name="T44" fmla="*/ 149 w 728"/>
                <a:gd name="T45" fmla="*/ 216 h 774"/>
                <a:gd name="T46" fmla="*/ 122 w 728"/>
                <a:gd name="T47" fmla="*/ 366 h 774"/>
                <a:gd name="T48" fmla="*/ 223 w 728"/>
                <a:gd name="T49" fmla="*/ 621 h 774"/>
                <a:gd name="T50" fmla="*/ 492 w 728"/>
                <a:gd name="T51" fmla="*/ 717 h 774"/>
                <a:gd name="T52" fmla="*/ 632 w 728"/>
                <a:gd name="T53" fmla="*/ 698 h 774"/>
                <a:gd name="T54" fmla="*/ 719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7" y="716"/>
                    <a:pt x="707" y="716"/>
                    <a:pt x="707" y="716"/>
                  </a:cubicBezTo>
                  <a:cubicBezTo>
                    <a:pt x="664" y="736"/>
                    <a:pt x="622" y="751"/>
                    <a:pt x="581" y="761"/>
                  </a:cubicBezTo>
                  <a:cubicBezTo>
                    <a:pt x="540" y="770"/>
                    <a:pt x="495" y="774"/>
                    <a:pt x="447" y="774"/>
                  </a:cubicBezTo>
                  <a:cubicBezTo>
                    <a:pt x="390" y="774"/>
                    <a:pt x="337" y="768"/>
                    <a:pt x="288" y="754"/>
                  </a:cubicBezTo>
                  <a:cubicBezTo>
                    <a:pt x="240" y="740"/>
                    <a:pt x="197" y="721"/>
                    <a:pt x="161" y="696"/>
                  </a:cubicBezTo>
                  <a:cubicBezTo>
                    <a:pt x="124" y="670"/>
                    <a:pt x="94" y="642"/>
                    <a:pt x="71" y="610"/>
                  </a:cubicBezTo>
                  <a:cubicBezTo>
                    <a:pt x="48" y="579"/>
                    <a:pt x="31" y="545"/>
                    <a:pt x="18" y="508"/>
                  </a:cubicBezTo>
                  <a:cubicBezTo>
                    <a:pt x="6" y="471"/>
                    <a:pt x="0" y="430"/>
                    <a:pt x="0" y="386"/>
                  </a:cubicBezTo>
                  <a:cubicBezTo>
                    <a:pt x="0" y="275"/>
                    <a:pt x="41" y="183"/>
                    <a:pt x="123" y="110"/>
                  </a:cubicBezTo>
                  <a:cubicBezTo>
                    <a:pt x="204" y="37"/>
                    <a:pt x="316" y="0"/>
                    <a:pt x="457" y="0"/>
                  </a:cubicBezTo>
                  <a:cubicBezTo>
                    <a:pt x="490" y="0"/>
                    <a:pt x="521" y="2"/>
                    <a:pt x="549" y="6"/>
                  </a:cubicBezTo>
                  <a:cubicBezTo>
                    <a:pt x="578"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5" y="143"/>
                    <a:pt x="665" y="143"/>
                    <a:pt x="665" y="143"/>
                  </a:cubicBezTo>
                  <a:cubicBezTo>
                    <a:pt x="661" y="109"/>
                    <a:pt x="641" y="83"/>
                    <a:pt x="605" y="66"/>
                  </a:cubicBezTo>
                  <a:cubicBezTo>
                    <a:pt x="569" y="50"/>
                    <a:pt x="516" y="41"/>
                    <a:pt x="446" y="41"/>
                  </a:cubicBezTo>
                  <a:cubicBezTo>
                    <a:pt x="393" y="42"/>
                    <a:pt x="349" y="48"/>
                    <a:pt x="313" y="60"/>
                  </a:cubicBezTo>
                  <a:cubicBezTo>
                    <a:pt x="277" y="72"/>
                    <a:pt x="245" y="91"/>
                    <a:pt x="217" y="117"/>
                  </a:cubicBezTo>
                  <a:cubicBezTo>
                    <a:pt x="189" y="143"/>
                    <a:pt x="166" y="176"/>
                    <a:pt x="149" y="216"/>
                  </a:cubicBezTo>
                  <a:cubicBezTo>
                    <a:pt x="131" y="256"/>
                    <a:pt x="122" y="306"/>
                    <a:pt x="122" y="366"/>
                  </a:cubicBezTo>
                  <a:cubicBezTo>
                    <a:pt x="122" y="472"/>
                    <a:pt x="155" y="557"/>
                    <a:pt x="223" y="621"/>
                  </a:cubicBezTo>
                  <a:cubicBezTo>
                    <a:pt x="291" y="685"/>
                    <a:pt x="380" y="717"/>
                    <a:pt x="492" y="717"/>
                  </a:cubicBezTo>
                  <a:cubicBezTo>
                    <a:pt x="542" y="717"/>
                    <a:pt x="589" y="711"/>
                    <a:pt x="632" y="698"/>
                  </a:cubicBezTo>
                  <a:cubicBezTo>
                    <a:pt x="661" y="689"/>
                    <a:pt x="690" y="675"/>
                    <a:pt x="719"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8" name="Freeform 11"/>
            <p:cNvSpPr>
              <a:spLocks/>
            </p:cNvSpPr>
            <p:nvPr userDrawn="1"/>
          </p:nvSpPr>
          <p:spPr bwMode="auto">
            <a:xfrm>
              <a:off x="657225" y="998538"/>
              <a:ext cx="231775" cy="246063"/>
            </a:xfrm>
            <a:custGeom>
              <a:avLst/>
              <a:gdLst>
                <a:gd name="T0" fmla="*/ 728 w 728"/>
                <a:gd name="T1" fmla="*/ 667 h 774"/>
                <a:gd name="T2" fmla="*/ 706 w 728"/>
                <a:gd name="T3" fmla="*/ 716 h 774"/>
                <a:gd name="T4" fmla="*/ 580 w 728"/>
                <a:gd name="T5" fmla="*/ 761 h 774"/>
                <a:gd name="T6" fmla="*/ 446 w 728"/>
                <a:gd name="T7" fmla="*/ 774 h 774"/>
                <a:gd name="T8" fmla="*/ 288 w 728"/>
                <a:gd name="T9" fmla="*/ 754 h 774"/>
                <a:gd name="T10" fmla="*/ 160 w 728"/>
                <a:gd name="T11" fmla="*/ 696 h 774"/>
                <a:gd name="T12" fmla="*/ 71 w 728"/>
                <a:gd name="T13" fmla="*/ 610 h 774"/>
                <a:gd name="T14" fmla="*/ 18 w 728"/>
                <a:gd name="T15" fmla="*/ 508 h 774"/>
                <a:gd name="T16" fmla="*/ 0 w 728"/>
                <a:gd name="T17" fmla="*/ 386 h 774"/>
                <a:gd name="T18" fmla="*/ 122 w 728"/>
                <a:gd name="T19" fmla="*/ 110 h 774"/>
                <a:gd name="T20" fmla="*/ 456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4 w 728"/>
                <a:gd name="T35" fmla="*/ 143 h 774"/>
                <a:gd name="T36" fmla="*/ 604 w 728"/>
                <a:gd name="T37" fmla="*/ 66 h 774"/>
                <a:gd name="T38" fmla="*/ 445 w 728"/>
                <a:gd name="T39" fmla="*/ 41 h 774"/>
                <a:gd name="T40" fmla="*/ 313 w 728"/>
                <a:gd name="T41" fmla="*/ 60 h 774"/>
                <a:gd name="T42" fmla="*/ 216 w 728"/>
                <a:gd name="T43" fmla="*/ 117 h 774"/>
                <a:gd name="T44" fmla="*/ 148 w 728"/>
                <a:gd name="T45" fmla="*/ 216 h 774"/>
                <a:gd name="T46" fmla="*/ 121 w 728"/>
                <a:gd name="T47" fmla="*/ 366 h 774"/>
                <a:gd name="T48" fmla="*/ 223 w 728"/>
                <a:gd name="T49" fmla="*/ 621 h 774"/>
                <a:gd name="T50" fmla="*/ 492 w 728"/>
                <a:gd name="T51" fmla="*/ 717 h 774"/>
                <a:gd name="T52" fmla="*/ 631 w 728"/>
                <a:gd name="T53" fmla="*/ 698 h 774"/>
                <a:gd name="T54" fmla="*/ 718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6" y="716"/>
                    <a:pt x="706" y="716"/>
                    <a:pt x="706" y="716"/>
                  </a:cubicBezTo>
                  <a:cubicBezTo>
                    <a:pt x="663" y="736"/>
                    <a:pt x="621" y="751"/>
                    <a:pt x="580" y="761"/>
                  </a:cubicBezTo>
                  <a:cubicBezTo>
                    <a:pt x="539" y="770"/>
                    <a:pt x="495" y="774"/>
                    <a:pt x="446" y="774"/>
                  </a:cubicBezTo>
                  <a:cubicBezTo>
                    <a:pt x="389" y="774"/>
                    <a:pt x="337" y="768"/>
                    <a:pt x="288" y="754"/>
                  </a:cubicBezTo>
                  <a:cubicBezTo>
                    <a:pt x="239" y="740"/>
                    <a:pt x="197" y="721"/>
                    <a:pt x="160" y="696"/>
                  </a:cubicBezTo>
                  <a:cubicBezTo>
                    <a:pt x="124" y="670"/>
                    <a:pt x="94" y="642"/>
                    <a:pt x="71" y="610"/>
                  </a:cubicBezTo>
                  <a:cubicBezTo>
                    <a:pt x="48" y="579"/>
                    <a:pt x="30" y="545"/>
                    <a:pt x="18" y="508"/>
                  </a:cubicBezTo>
                  <a:cubicBezTo>
                    <a:pt x="6" y="471"/>
                    <a:pt x="0" y="430"/>
                    <a:pt x="0" y="386"/>
                  </a:cubicBezTo>
                  <a:cubicBezTo>
                    <a:pt x="0" y="275"/>
                    <a:pt x="41" y="183"/>
                    <a:pt x="122" y="110"/>
                  </a:cubicBezTo>
                  <a:cubicBezTo>
                    <a:pt x="204" y="37"/>
                    <a:pt x="315" y="0"/>
                    <a:pt x="456" y="0"/>
                  </a:cubicBezTo>
                  <a:cubicBezTo>
                    <a:pt x="490" y="0"/>
                    <a:pt x="520" y="2"/>
                    <a:pt x="549" y="6"/>
                  </a:cubicBezTo>
                  <a:cubicBezTo>
                    <a:pt x="577"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4" y="143"/>
                    <a:pt x="664" y="143"/>
                    <a:pt x="664" y="143"/>
                  </a:cubicBezTo>
                  <a:cubicBezTo>
                    <a:pt x="661" y="109"/>
                    <a:pt x="641" y="83"/>
                    <a:pt x="604" y="66"/>
                  </a:cubicBezTo>
                  <a:cubicBezTo>
                    <a:pt x="568" y="50"/>
                    <a:pt x="515" y="41"/>
                    <a:pt x="445" y="41"/>
                  </a:cubicBezTo>
                  <a:cubicBezTo>
                    <a:pt x="393" y="42"/>
                    <a:pt x="349" y="48"/>
                    <a:pt x="313" y="60"/>
                  </a:cubicBezTo>
                  <a:cubicBezTo>
                    <a:pt x="276" y="72"/>
                    <a:pt x="244" y="91"/>
                    <a:pt x="216" y="117"/>
                  </a:cubicBezTo>
                  <a:cubicBezTo>
                    <a:pt x="189" y="143"/>
                    <a:pt x="166" y="176"/>
                    <a:pt x="148" y="216"/>
                  </a:cubicBezTo>
                  <a:cubicBezTo>
                    <a:pt x="131" y="256"/>
                    <a:pt x="122" y="306"/>
                    <a:pt x="121" y="366"/>
                  </a:cubicBezTo>
                  <a:cubicBezTo>
                    <a:pt x="121" y="472"/>
                    <a:pt x="155" y="557"/>
                    <a:pt x="223" y="621"/>
                  </a:cubicBezTo>
                  <a:cubicBezTo>
                    <a:pt x="290" y="685"/>
                    <a:pt x="380" y="717"/>
                    <a:pt x="492" y="717"/>
                  </a:cubicBezTo>
                  <a:cubicBezTo>
                    <a:pt x="542" y="717"/>
                    <a:pt x="588" y="711"/>
                    <a:pt x="631" y="698"/>
                  </a:cubicBezTo>
                  <a:cubicBezTo>
                    <a:pt x="660" y="689"/>
                    <a:pt x="689" y="675"/>
                    <a:pt x="718"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9" name="Freeform 12"/>
            <p:cNvSpPr>
              <a:spLocks/>
            </p:cNvSpPr>
            <p:nvPr userDrawn="1"/>
          </p:nvSpPr>
          <p:spPr bwMode="auto">
            <a:xfrm>
              <a:off x="757238" y="687388"/>
              <a:ext cx="323850" cy="239713"/>
            </a:xfrm>
            <a:custGeom>
              <a:avLst/>
              <a:gdLst>
                <a:gd name="T0" fmla="*/ 0 w 1017"/>
                <a:gd name="T1" fmla="*/ 35 h 754"/>
                <a:gd name="T2" fmla="*/ 0 w 1017"/>
                <a:gd name="T3" fmla="*/ 0 h 754"/>
                <a:gd name="T4" fmla="*/ 110 w 1017"/>
                <a:gd name="T5" fmla="*/ 4 h 754"/>
                <a:gd name="T6" fmla="*/ 212 w 1017"/>
                <a:gd name="T7" fmla="*/ 0 h 754"/>
                <a:gd name="T8" fmla="*/ 300 w 1017"/>
                <a:gd name="T9" fmla="*/ 183 h 754"/>
                <a:gd name="T10" fmla="*/ 509 w 1017"/>
                <a:gd name="T11" fmla="*/ 592 h 754"/>
                <a:gd name="T12" fmla="*/ 697 w 1017"/>
                <a:gd name="T13" fmla="*/ 218 h 754"/>
                <a:gd name="T14" fmla="*/ 800 w 1017"/>
                <a:gd name="T15" fmla="*/ 0 h 754"/>
                <a:gd name="T16" fmla="*/ 898 w 1017"/>
                <a:gd name="T17" fmla="*/ 4 h 754"/>
                <a:gd name="T18" fmla="*/ 1017 w 1017"/>
                <a:gd name="T19" fmla="*/ 0 h 754"/>
                <a:gd name="T20" fmla="*/ 1017 w 1017"/>
                <a:gd name="T21" fmla="*/ 35 h 754"/>
                <a:gd name="T22" fmla="*/ 938 w 1017"/>
                <a:gd name="T23" fmla="*/ 40 h 754"/>
                <a:gd name="T24" fmla="*/ 918 w 1017"/>
                <a:gd name="T25" fmla="*/ 53 h 754"/>
                <a:gd name="T26" fmla="*/ 910 w 1017"/>
                <a:gd name="T27" fmla="*/ 103 h 754"/>
                <a:gd name="T28" fmla="*/ 907 w 1017"/>
                <a:gd name="T29" fmla="*/ 251 h 754"/>
                <a:gd name="T30" fmla="*/ 907 w 1017"/>
                <a:gd name="T31" fmla="*/ 492 h 754"/>
                <a:gd name="T32" fmla="*/ 910 w 1017"/>
                <a:gd name="T33" fmla="*/ 631 h 754"/>
                <a:gd name="T34" fmla="*/ 918 w 1017"/>
                <a:gd name="T35" fmla="*/ 690 h 754"/>
                <a:gd name="T36" fmla="*/ 938 w 1017"/>
                <a:gd name="T37" fmla="*/ 704 h 754"/>
                <a:gd name="T38" fmla="*/ 1017 w 1017"/>
                <a:gd name="T39" fmla="*/ 709 h 754"/>
                <a:gd name="T40" fmla="*/ 1017 w 1017"/>
                <a:gd name="T41" fmla="*/ 743 h 754"/>
                <a:gd name="T42" fmla="*/ 861 w 1017"/>
                <a:gd name="T43" fmla="*/ 739 h 754"/>
                <a:gd name="T44" fmla="*/ 699 w 1017"/>
                <a:gd name="T45" fmla="*/ 743 h 754"/>
                <a:gd name="T46" fmla="*/ 699 w 1017"/>
                <a:gd name="T47" fmla="*/ 709 h 754"/>
                <a:gd name="T48" fmla="*/ 778 w 1017"/>
                <a:gd name="T49" fmla="*/ 704 h 754"/>
                <a:gd name="T50" fmla="*/ 797 w 1017"/>
                <a:gd name="T51" fmla="*/ 691 h 754"/>
                <a:gd name="T52" fmla="*/ 806 w 1017"/>
                <a:gd name="T53" fmla="*/ 641 h 754"/>
                <a:gd name="T54" fmla="*/ 808 w 1017"/>
                <a:gd name="T55" fmla="*/ 492 h 754"/>
                <a:gd name="T56" fmla="*/ 808 w 1017"/>
                <a:gd name="T57" fmla="*/ 108 h 754"/>
                <a:gd name="T58" fmla="*/ 619 w 1017"/>
                <a:gd name="T59" fmla="*/ 486 h 754"/>
                <a:gd name="T60" fmla="*/ 549 w 1017"/>
                <a:gd name="T61" fmla="*/ 629 h 754"/>
                <a:gd name="T62" fmla="*/ 494 w 1017"/>
                <a:gd name="T63" fmla="*/ 754 h 754"/>
                <a:gd name="T64" fmla="*/ 472 w 1017"/>
                <a:gd name="T65" fmla="*/ 754 h 754"/>
                <a:gd name="T66" fmla="*/ 459 w 1017"/>
                <a:gd name="T67" fmla="*/ 722 h 754"/>
                <a:gd name="T68" fmla="*/ 422 w 1017"/>
                <a:gd name="T69" fmla="*/ 645 h 754"/>
                <a:gd name="T70" fmla="*/ 159 w 1017"/>
                <a:gd name="T71" fmla="*/ 126 h 754"/>
                <a:gd name="T72" fmla="*/ 159 w 1017"/>
                <a:gd name="T73" fmla="*/ 492 h 754"/>
                <a:gd name="T74" fmla="*/ 163 w 1017"/>
                <a:gd name="T75" fmla="*/ 631 h 754"/>
                <a:gd name="T76" fmla="*/ 171 w 1017"/>
                <a:gd name="T77" fmla="*/ 690 h 754"/>
                <a:gd name="T78" fmla="*/ 191 w 1017"/>
                <a:gd name="T79" fmla="*/ 704 h 754"/>
                <a:gd name="T80" fmla="*/ 271 w 1017"/>
                <a:gd name="T81" fmla="*/ 709 h 754"/>
                <a:gd name="T82" fmla="*/ 271 w 1017"/>
                <a:gd name="T83" fmla="*/ 743 h 754"/>
                <a:gd name="T84" fmla="*/ 138 w 1017"/>
                <a:gd name="T85" fmla="*/ 739 h 754"/>
                <a:gd name="T86" fmla="*/ 0 w 1017"/>
                <a:gd name="T87" fmla="*/ 743 h 754"/>
                <a:gd name="T88" fmla="*/ 0 w 1017"/>
                <a:gd name="T89" fmla="*/ 709 h 754"/>
                <a:gd name="T90" fmla="*/ 79 w 1017"/>
                <a:gd name="T91" fmla="*/ 704 h 754"/>
                <a:gd name="T92" fmla="*/ 98 w 1017"/>
                <a:gd name="T93" fmla="*/ 691 h 754"/>
                <a:gd name="T94" fmla="*/ 107 w 1017"/>
                <a:gd name="T95" fmla="*/ 641 h 754"/>
                <a:gd name="T96" fmla="*/ 109 w 1017"/>
                <a:gd name="T97" fmla="*/ 492 h 754"/>
                <a:gd name="T98" fmla="*/ 109 w 1017"/>
                <a:gd name="T99" fmla="*/ 251 h 754"/>
                <a:gd name="T100" fmla="*/ 107 w 1017"/>
                <a:gd name="T101" fmla="*/ 112 h 754"/>
                <a:gd name="T102" fmla="*/ 99 w 1017"/>
                <a:gd name="T103" fmla="*/ 54 h 754"/>
                <a:gd name="T104" fmla="*/ 78 w 1017"/>
                <a:gd name="T105" fmla="*/ 40 h 754"/>
                <a:gd name="T106" fmla="*/ 0 w 1017"/>
                <a:gd name="T107" fmla="*/ 35 h 75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Lst>
              <a:rect l="0" t="0" r="r" b="b"/>
              <a:pathLst>
                <a:path w="1017" h="754">
                  <a:moveTo>
                    <a:pt x="0" y="35"/>
                  </a:moveTo>
                  <a:cubicBezTo>
                    <a:pt x="0" y="0"/>
                    <a:pt x="0" y="0"/>
                    <a:pt x="0" y="0"/>
                  </a:cubicBezTo>
                  <a:cubicBezTo>
                    <a:pt x="38" y="2"/>
                    <a:pt x="75" y="4"/>
                    <a:pt x="110" y="4"/>
                  </a:cubicBezTo>
                  <a:cubicBezTo>
                    <a:pt x="145" y="4"/>
                    <a:pt x="179" y="2"/>
                    <a:pt x="212" y="0"/>
                  </a:cubicBezTo>
                  <a:cubicBezTo>
                    <a:pt x="244" y="70"/>
                    <a:pt x="274" y="131"/>
                    <a:pt x="300" y="183"/>
                  </a:cubicBezTo>
                  <a:cubicBezTo>
                    <a:pt x="509" y="592"/>
                    <a:pt x="509" y="592"/>
                    <a:pt x="509" y="592"/>
                  </a:cubicBezTo>
                  <a:cubicBezTo>
                    <a:pt x="697" y="218"/>
                    <a:pt x="697" y="218"/>
                    <a:pt x="697" y="218"/>
                  </a:cubicBezTo>
                  <a:cubicBezTo>
                    <a:pt x="749" y="116"/>
                    <a:pt x="783" y="43"/>
                    <a:pt x="800" y="0"/>
                  </a:cubicBezTo>
                  <a:cubicBezTo>
                    <a:pt x="839" y="2"/>
                    <a:pt x="872" y="4"/>
                    <a:pt x="898" y="4"/>
                  </a:cubicBezTo>
                  <a:cubicBezTo>
                    <a:pt x="923" y="4"/>
                    <a:pt x="962" y="2"/>
                    <a:pt x="1017" y="0"/>
                  </a:cubicBezTo>
                  <a:cubicBezTo>
                    <a:pt x="1017" y="35"/>
                    <a:pt x="1017" y="35"/>
                    <a:pt x="1017" y="35"/>
                  </a:cubicBezTo>
                  <a:cubicBezTo>
                    <a:pt x="974" y="35"/>
                    <a:pt x="947" y="37"/>
                    <a:pt x="938" y="40"/>
                  </a:cubicBezTo>
                  <a:cubicBezTo>
                    <a:pt x="928" y="43"/>
                    <a:pt x="922" y="47"/>
                    <a:pt x="918" y="53"/>
                  </a:cubicBezTo>
                  <a:cubicBezTo>
                    <a:pt x="914" y="60"/>
                    <a:pt x="911" y="76"/>
                    <a:pt x="910" y="103"/>
                  </a:cubicBezTo>
                  <a:cubicBezTo>
                    <a:pt x="910" y="110"/>
                    <a:pt x="909" y="159"/>
                    <a:pt x="907" y="251"/>
                  </a:cubicBezTo>
                  <a:cubicBezTo>
                    <a:pt x="907" y="492"/>
                    <a:pt x="907" y="492"/>
                    <a:pt x="907" y="492"/>
                  </a:cubicBezTo>
                  <a:cubicBezTo>
                    <a:pt x="907" y="540"/>
                    <a:pt x="908" y="586"/>
                    <a:pt x="910" y="631"/>
                  </a:cubicBezTo>
                  <a:cubicBezTo>
                    <a:pt x="911" y="664"/>
                    <a:pt x="914" y="684"/>
                    <a:pt x="918" y="690"/>
                  </a:cubicBezTo>
                  <a:cubicBezTo>
                    <a:pt x="922" y="696"/>
                    <a:pt x="929" y="701"/>
                    <a:pt x="938" y="704"/>
                  </a:cubicBezTo>
                  <a:cubicBezTo>
                    <a:pt x="948" y="707"/>
                    <a:pt x="974" y="709"/>
                    <a:pt x="1017" y="709"/>
                  </a:cubicBezTo>
                  <a:cubicBezTo>
                    <a:pt x="1017" y="743"/>
                    <a:pt x="1017" y="743"/>
                    <a:pt x="1017" y="743"/>
                  </a:cubicBezTo>
                  <a:cubicBezTo>
                    <a:pt x="943" y="740"/>
                    <a:pt x="891" y="739"/>
                    <a:pt x="861" y="739"/>
                  </a:cubicBezTo>
                  <a:cubicBezTo>
                    <a:pt x="837" y="739"/>
                    <a:pt x="782" y="740"/>
                    <a:pt x="699" y="743"/>
                  </a:cubicBezTo>
                  <a:cubicBezTo>
                    <a:pt x="699" y="709"/>
                    <a:pt x="699" y="709"/>
                    <a:pt x="699" y="709"/>
                  </a:cubicBezTo>
                  <a:cubicBezTo>
                    <a:pt x="742" y="709"/>
                    <a:pt x="768" y="707"/>
                    <a:pt x="778" y="704"/>
                  </a:cubicBezTo>
                  <a:cubicBezTo>
                    <a:pt x="788" y="701"/>
                    <a:pt x="794" y="697"/>
                    <a:pt x="797" y="691"/>
                  </a:cubicBezTo>
                  <a:cubicBezTo>
                    <a:pt x="802" y="684"/>
                    <a:pt x="805" y="668"/>
                    <a:pt x="806" y="641"/>
                  </a:cubicBezTo>
                  <a:cubicBezTo>
                    <a:pt x="806" y="633"/>
                    <a:pt x="807" y="584"/>
                    <a:pt x="808" y="492"/>
                  </a:cubicBezTo>
                  <a:cubicBezTo>
                    <a:pt x="808" y="108"/>
                    <a:pt x="808" y="108"/>
                    <a:pt x="808" y="108"/>
                  </a:cubicBezTo>
                  <a:cubicBezTo>
                    <a:pt x="619" y="486"/>
                    <a:pt x="619" y="486"/>
                    <a:pt x="619" y="486"/>
                  </a:cubicBezTo>
                  <a:cubicBezTo>
                    <a:pt x="589" y="545"/>
                    <a:pt x="566" y="593"/>
                    <a:pt x="549" y="629"/>
                  </a:cubicBezTo>
                  <a:cubicBezTo>
                    <a:pt x="537" y="655"/>
                    <a:pt x="518" y="696"/>
                    <a:pt x="494" y="754"/>
                  </a:cubicBezTo>
                  <a:cubicBezTo>
                    <a:pt x="472" y="754"/>
                    <a:pt x="472" y="754"/>
                    <a:pt x="472" y="754"/>
                  </a:cubicBezTo>
                  <a:cubicBezTo>
                    <a:pt x="468" y="740"/>
                    <a:pt x="463" y="729"/>
                    <a:pt x="459" y="722"/>
                  </a:cubicBezTo>
                  <a:cubicBezTo>
                    <a:pt x="422" y="645"/>
                    <a:pt x="422" y="645"/>
                    <a:pt x="422" y="645"/>
                  </a:cubicBezTo>
                  <a:cubicBezTo>
                    <a:pt x="159" y="126"/>
                    <a:pt x="159" y="126"/>
                    <a:pt x="159" y="126"/>
                  </a:cubicBezTo>
                  <a:cubicBezTo>
                    <a:pt x="159" y="492"/>
                    <a:pt x="159" y="492"/>
                    <a:pt x="159" y="492"/>
                  </a:cubicBezTo>
                  <a:cubicBezTo>
                    <a:pt x="159" y="540"/>
                    <a:pt x="160" y="586"/>
                    <a:pt x="163" y="631"/>
                  </a:cubicBezTo>
                  <a:cubicBezTo>
                    <a:pt x="164" y="664"/>
                    <a:pt x="167" y="683"/>
                    <a:pt x="171" y="690"/>
                  </a:cubicBezTo>
                  <a:cubicBezTo>
                    <a:pt x="175" y="696"/>
                    <a:pt x="182" y="701"/>
                    <a:pt x="191" y="704"/>
                  </a:cubicBezTo>
                  <a:cubicBezTo>
                    <a:pt x="200" y="707"/>
                    <a:pt x="227" y="709"/>
                    <a:pt x="271" y="709"/>
                  </a:cubicBezTo>
                  <a:cubicBezTo>
                    <a:pt x="271" y="743"/>
                    <a:pt x="271" y="743"/>
                    <a:pt x="271" y="743"/>
                  </a:cubicBezTo>
                  <a:cubicBezTo>
                    <a:pt x="138" y="739"/>
                    <a:pt x="138" y="739"/>
                    <a:pt x="138" y="739"/>
                  </a:cubicBezTo>
                  <a:cubicBezTo>
                    <a:pt x="0" y="743"/>
                    <a:pt x="0" y="743"/>
                    <a:pt x="0" y="743"/>
                  </a:cubicBezTo>
                  <a:cubicBezTo>
                    <a:pt x="0" y="709"/>
                    <a:pt x="0" y="709"/>
                    <a:pt x="0" y="709"/>
                  </a:cubicBezTo>
                  <a:cubicBezTo>
                    <a:pt x="43" y="709"/>
                    <a:pt x="69" y="707"/>
                    <a:pt x="79" y="704"/>
                  </a:cubicBezTo>
                  <a:cubicBezTo>
                    <a:pt x="88" y="701"/>
                    <a:pt x="95" y="697"/>
                    <a:pt x="98" y="691"/>
                  </a:cubicBezTo>
                  <a:cubicBezTo>
                    <a:pt x="103" y="684"/>
                    <a:pt x="105" y="668"/>
                    <a:pt x="107" y="641"/>
                  </a:cubicBezTo>
                  <a:cubicBezTo>
                    <a:pt x="107" y="634"/>
                    <a:pt x="108" y="584"/>
                    <a:pt x="109" y="492"/>
                  </a:cubicBezTo>
                  <a:cubicBezTo>
                    <a:pt x="109" y="251"/>
                    <a:pt x="109" y="251"/>
                    <a:pt x="109" y="251"/>
                  </a:cubicBezTo>
                  <a:cubicBezTo>
                    <a:pt x="109" y="204"/>
                    <a:pt x="108" y="158"/>
                    <a:pt x="107" y="112"/>
                  </a:cubicBezTo>
                  <a:cubicBezTo>
                    <a:pt x="105" y="79"/>
                    <a:pt x="103" y="60"/>
                    <a:pt x="99" y="54"/>
                  </a:cubicBezTo>
                  <a:cubicBezTo>
                    <a:pt x="94" y="48"/>
                    <a:pt x="88" y="43"/>
                    <a:pt x="78" y="40"/>
                  </a:cubicBezTo>
                  <a:cubicBezTo>
                    <a:pt x="69" y="37"/>
                    <a:pt x="43" y="35"/>
                    <a:pt x="0" y="35"/>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0" name="Freeform 13"/>
            <p:cNvSpPr>
              <a:spLocks noEditPoints="1"/>
            </p:cNvSpPr>
            <p:nvPr userDrawn="1"/>
          </p:nvSpPr>
          <p:spPr bwMode="auto">
            <a:xfrm>
              <a:off x="1092200" y="684213"/>
              <a:ext cx="263525" cy="238125"/>
            </a:xfrm>
            <a:custGeom>
              <a:avLst/>
              <a:gdLst>
                <a:gd name="T0" fmla="*/ 117 w 832"/>
                <a:gd name="T1" fmla="*/ 747 h 750"/>
                <a:gd name="T2" fmla="*/ 257 w 832"/>
                <a:gd name="T3" fmla="*/ 750 h 750"/>
                <a:gd name="T4" fmla="*/ 257 w 832"/>
                <a:gd name="T5" fmla="*/ 717 h 750"/>
                <a:gd name="T6" fmla="*/ 185 w 832"/>
                <a:gd name="T7" fmla="*/ 712 h 750"/>
                <a:gd name="T8" fmla="*/ 166 w 832"/>
                <a:gd name="T9" fmla="*/ 702 h 750"/>
                <a:gd name="T10" fmla="*/ 162 w 832"/>
                <a:gd name="T11" fmla="*/ 690 h 750"/>
                <a:gd name="T12" fmla="*/ 178 w 832"/>
                <a:gd name="T13" fmla="*/ 637 h 750"/>
                <a:gd name="T14" fmla="*/ 237 w 832"/>
                <a:gd name="T15" fmla="*/ 503 h 750"/>
                <a:gd name="T16" fmla="*/ 556 w 832"/>
                <a:gd name="T17" fmla="*/ 503 h 750"/>
                <a:gd name="T18" fmla="*/ 624 w 832"/>
                <a:gd name="T19" fmla="*/ 663 h 750"/>
                <a:gd name="T20" fmla="*/ 632 w 832"/>
                <a:gd name="T21" fmla="*/ 693 h 750"/>
                <a:gd name="T22" fmla="*/ 627 w 832"/>
                <a:gd name="T23" fmla="*/ 705 h 750"/>
                <a:gd name="T24" fmla="*/ 609 w 832"/>
                <a:gd name="T25" fmla="*/ 713 h 750"/>
                <a:gd name="T26" fmla="*/ 535 w 832"/>
                <a:gd name="T27" fmla="*/ 717 h 750"/>
                <a:gd name="T28" fmla="*/ 535 w 832"/>
                <a:gd name="T29" fmla="*/ 750 h 750"/>
                <a:gd name="T30" fmla="*/ 712 w 832"/>
                <a:gd name="T31" fmla="*/ 747 h 750"/>
                <a:gd name="T32" fmla="*/ 832 w 832"/>
                <a:gd name="T33" fmla="*/ 750 h 750"/>
                <a:gd name="T34" fmla="*/ 832 w 832"/>
                <a:gd name="T35" fmla="*/ 717 h 750"/>
                <a:gd name="T36" fmla="*/ 776 w 832"/>
                <a:gd name="T37" fmla="*/ 710 h 750"/>
                <a:gd name="T38" fmla="*/ 753 w 832"/>
                <a:gd name="T39" fmla="*/ 687 h 750"/>
                <a:gd name="T40" fmla="*/ 677 w 832"/>
                <a:gd name="T41" fmla="*/ 526 h 750"/>
                <a:gd name="T42" fmla="*/ 441 w 832"/>
                <a:gd name="T43" fmla="*/ 0 h 750"/>
                <a:gd name="T44" fmla="*/ 406 w 832"/>
                <a:gd name="T45" fmla="*/ 0 h 750"/>
                <a:gd name="T46" fmla="*/ 310 w 832"/>
                <a:gd name="T47" fmla="*/ 217 h 750"/>
                <a:gd name="T48" fmla="*/ 172 w 832"/>
                <a:gd name="T49" fmla="*/ 512 h 750"/>
                <a:gd name="T50" fmla="*/ 100 w 832"/>
                <a:gd name="T51" fmla="*/ 660 h 750"/>
                <a:gd name="T52" fmla="*/ 74 w 832"/>
                <a:gd name="T53" fmla="*/ 702 h 750"/>
                <a:gd name="T54" fmla="*/ 54 w 832"/>
                <a:gd name="T55" fmla="*/ 713 h 750"/>
                <a:gd name="T56" fmla="*/ 0 w 832"/>
                <a:gd name="T57" fmla="*/ 717 h 750"/>
                <a:gd name="T58" fmla="*/ 0 w 832"/>
                <a:gd name="T59" fmla="*/ 750 h 750"/>
                <a:gd name="T60" fmla="*/ 117 w 832"/>
                <a:gd name="T61" fmla="*/ 747 h 750"/>
                <a:gd name="T62" fmla="*/ 396 w 832"/>
                <a:gd name="T63" fmla="*/ 143 h 750"/>
                <a:gd name="T64" fmla="*/ 534 w 832"/>
                <a:gd name="T65" fmla="*/ 458 h 750"/>
                <a:gd name="T66" fmla="*/ 256 w 832"/>
                <a:gd name="T67" fmla="*/ 458 h 750"/>
                <a:gd name="T68" fmla="*/ 396 w 832"/>
                <a:gd name="T69" fmla="*/ 143 h 75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Lst>
              <a:rect l="0" t="0" r="r" b="b"/>
              <a:pathLst>
                <a:path w="832" h="750">
                  <a:moveTo>
                    <a:pt x="117" y="747"/>
                  </a:moveTo>
                  <a:cubicBezTo>
                    <a:pt x="148" y="747"/>
                    <a:pt x="195" y="748"/>
                    <a:pt x="257" y="750"/>
                  </a:cubicBezTo>
                  <a:cubicBezTo>
                    <a:pt x="257" y="717"/>
                    <a:pt x="257" y="717"/>
                    <a:pt x="257" y="717"/>
                  </a:cubicBezTo>
                  <a:cubicBezTo>
                    <a:pt x="222" y="716"/>
                    <a:pt x="199" y="715"/>
                    <a:pt x="185" y="712"/>
                  </a:cubicBezTo>
                  <a:cubicBezTo>
                    <a:pt x="177" y="710"/>
                    <a:pt x="170" y="707"/>
                    <a:pt x="166" y="702"/>
                  </a:cubicBezTo>
                  <a:cubicBezTo>
                    <a:pt x="163" y="699"/>
                    <a:pt x="162" y="695"/>
                    <a:pt x="162" y="690"/>
                  </a:cubicBezTo>
                  <a:cubicBezTo>
                    <a:pt x="162" y="679"/>
                    <a:pt x="167" y="662"/>
                    <a:pt x="178" y="637"/>
                  </a:cubicBezTo>
                  <a:cubicBezTo>
                    <a:pt x="237" y="503"/>
                    <a:pt x="237" y="503"/>
                    <a:pt x="237" y="503"/>
                  </a:cubicBezTo>
                  <a:cubicBezTo>
                    <a:pt x="556" y="503"/>
                    <a:pt x="556" y="503"/>
                    <a:pt x="556" y="503"/>
                  </a:cubicBezTo>
                  <a:cubicBezTo>
                    <a:pt x="624" y="663"/>
                    <a:pt x="624" y="663"/>
                    <a:pt x="624" y="663"/>
                  </a:cubicBezTo>
                  <a:cubicBezTo>
                    <a:pt x="629" y="675"/>
                    <a:pt x="632" y="685"/>
                    <a:pt x="632" y="693"/>
                  </a:cubicBezTo>
                  <a:cubicBezTo>
                    <a:pt x="632" y="698"/>
                    <a:pt x="630" y="702"/>
                    <a:pt x="627" y="705"/>
                  </a:cubicBezTo>
                  <a:cubicBezTo>
                    <a:pt x="624" y="708"/>
                    <a:pt x="618" y="711"/>
                    <a:pt x="609" y="713"/>
                  </a:cubicBezTo>
                  <a:cubicBezTo>
                    <a:pt x="601" y="715"/>
                    <a:pt x="576" y="716"/>
                    <a:pt x="535" y="717"/>
                  </a:cubicBezTo>
                  <a:cubicBezTo>
                    <a:pt x="535" y="750"/>
                    <a:pt x="535" y="750"/>
                    <a:pt x="535" y="750"/>
                  </a:cubicBezTo>
                  <a:cubicBezTo>
                    <a:pt x="712" y="747"/>
                    <a:pt x="712" y="747"/>
                    <a:pt x="712" y="747"/>
                  </a:cubicBezTo>
                  <a:cubicBezTo>
                    <a:pt x="734" y="747"/>
                    <a:pt x="775" y="748"/>
                    <a:pt x="832" y="750"/>
                  </a:cubicBezTo>
                  <a:cubicBezTo>
                    <a:pt x="832" y="717"/>
                    <a:pt x="832" y="717"/>
                    <a:pt x="832" y="717"/>
                  </a:cubicBezTo>
                  <a:cubicBezTo>
                    <a:pt x="803" y="716"/>
                    <a:pt x="784" y="714"/>
                    <a:pt x="776" y="710"/>
                  </a:cubicBezTo>
                  <a:cubicBezTo>
                    <a:pt x="767" y="707"/>
                    <a:pt x="760" y="699"/>
                    <a:pt x="753" y="687"/>
                  </a:cubicBezTo>
                  <a:cubicBezTo>
                    <a:pt x="740" y="664"/>
                    <a:pt x="715" y="611"/>
                    <a:pt x="677" y="526"/>
                  </a:cubicBezTo>
                  <a:cubicBezTo>
                    <a:pt x="441" y="0"/>
                    <a:pt x="441" y="0"/>
                    <a:pt x="441" y="0"/>
                  </a:cubicBezTo>
                  <a:cubicBezTo>
                    <a:pt x="406" y="0"/>
                    <a:pt x="406" y="0"/>
                    <a:pt x="406" y="0"/>
                  </a:cubicBezTo>
                  <a:cubicBezTo>
                    <a:pt x="357" y="112"/>
                    <a:pt x="325" y="185"/>
                    <a:pt x="310" y="217"/>
                  </a:cubicBezTo>
                  <a:cubicBezTo>
                    <a:pt x="172" y="512"/>
                    <a:pt x="172" y="512"/>
                    <a:pt x="172" y="512"/>
                  </a:cubicBezTo>
                  <a:cubicBezTo>
                    <a:pt x="131" y="598"/>
                    <a:pt x="107" y="647"/>
                    <a:pt x="100" y="660"/>
                  </a:cubicBezTo>
                  <a:cubicBezTo>
                    <a:pt x="89" y="683"/>
                    <a:pt x="80" y="697"/>
                    <a:pt x="74" y="702"/>
                  </a:cubicBezTo>
                  <a:cubicBezTo>
                    <a:pt x="68" y="708"/>
                    <a:pt x="61" y="711"/>
                    <a:pt x="54" y="713"/>
                  </a:cubicBezTo>
                  <a:cubicBezTo>
                    <a:pt x="47" y="715"/>
                    <a:pt x="29" y="716"/>
                    <a:pt x="0" y="717"/>
                  </a:cubicBezTo>
                  <a:cubicBezTo>
                    <a:pt x="0" y="750"/>
                    <a:pt x="0" y="750"/>
                    <a:pt x="0" y="750"/>
                  </a:cubicBezTo>
                  <a:cubicBezTo>
                    <a:pt x="42" y="748"/>
                    <a:pt x="81" y="747"/>
                    <a:pt x="117" y="747"/>
                  </a:cubicBezTo>
                  <a:close/>
                  <a:moveTo>
                    <a:pt x="396" y="143"/>
                  </a:moveTo>
                  <a:cubicBezTo>
                    <a:pt x="534" y="458"/>
                    <a:pt x="534" y="458"/>
                    <a:pt x="534" y="458"/>
                  </a:cubicBezTo>
                  <a:cubicBezTo>
                    <a:pt x="256" y="458"/>
                    <a:pt x="256" y="458"/>
                    <a:pt x="256" y="458"/>
                  </a:cubicBezTo>
                  <a:lnTo>
                    <a:pt x="396" y="143"/>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1" name="Freeform 14"/>
            <p:cNvSpPr>
              <a:spLocks/>
            </p:cNvSpPr>
            <p:nvPr userDrawn="1"/>
          </p:nvSpPr>
          <p:spPr bwMode="auto">
            <a:xfrm>
              <a:off x="1309688" y="687388"/>
              <a:ext cx="260350" cy="234950"/>
            </a:xfrm>
            <a:custGeom>
              <a:avLst/>
              <a:gdLst>
                <a:gd name="T0" fmla="*/ 601 w 817"/>
                <a:gd name="T1" fmla="*/ 111 h 743"/>
                <a:gd name="T2" fmla="*/ 634 w 817"/>
                <a:gd name="T3" fmla="*/ 52 h 743"/>
                <a:gd name="T4" fmla="*/ 624 w 817"/>
                <a:gd name="T5" fmla="*/ 39 h 743"/>
                <a:gd name="T6" fmla="*/ 543 w 817"/>
                <a:gd name="T7" fmla="*/ 33 h 743"/>
                <a:gd name="T8" fmla="*/ 543 w 817"/>
                <a:gd name="T9" fmla="*/ 0 h 743"/>
                <a:gd name="T10" fmla="*/ 688 w 817"/>
                <a:gd name="T11" fmla="*/ 3 h 743"/>
                <a:gd name="T12" fmla="*/ 817 w 817"/>
                <a:gd name="T13" fmla="*/ 0 h 743"/>
                <a:gd name="T14" fmla="*/ 817 w 817"/>
                <a:gd name="T15" fmla="*/ 33 h 743"/>
                <a:gd name="T16" fmla="*/ 746 w 817"/>
                <a:gd name="T17" fmla="*/ 39 h 743"/>
                <a:gd name="T18" fmla="*/ 718 w 817"/>
                <a:gd name="T19" fmla="*/ 51 h 743"/>
                <a:gd name="T20" fmla="*/ 675 w 817"/>
                <a:gd name="T21" fmla="*/ 102 h 743"/>
                <a:gd name="T22" fmla="*/ 514 w 817"/>
                <a:gd name="T23" fmla="*/ 333 h 743"/>
                <a:gd name="T24" fmla="*/ 461 w 817"/>
                <a:gd name="T25" fmla="*/ 422 h 743"/>
                <a:gd name="T26" fmla="*/ 455 w 817"/>
                <a:gd name="T27" fmla="*/ 453 h 743"/>
                <a:gd name="T28" fmla="*/ 455 w 817"/>
                <a:gd name="T29" fmla="*/ 493 h 743"/>
                <a:gd name="T30" fmla="*/ 459 w 817"/>
                <a:gd name="T31" fmla="*/ 631 h 743"/>
                <a:gd name="T32" fmla="*/ 466 w 817"/>
                <a:gd name="T33" fmla="*/ 690 h 743"/>
                <a:gd name="T34" fmla="*/ 486 w 817"/>
                <a:gd name="T35" fmla="*/ 704 h 743"/>
                <a:gd name="T36" fmla="*/ 564 w 817"/>
                <a:gd name="T37" fmla="*/ 710 h 743"/>
                <a:gd name="T38" fmla="*/ 564 w 817"/>
                <a:gd name="T39" fmla="*/ 743 h 743"/>
                <a:gd name="T40" fmla="*/ 410 w 817"/>
                <a:gd name="T41" fmla="*/ 740 h 743"/>
                <a:gd name="T42" fmla="*/ 244 w 817"/>
                <a:gd name="T43" fmla="*/ 743 h 743"/>
                <a:gd name="T44" fmla="*/ 244 w 817"/>
                <a:gd name="T45" fmla="*/ 710 h 743"/>
                <a:gd name="T46" fmla="*/ 322 w 817"/>
                <a:gd name="T47" fmla="*/ 704 h 743"/>
                <a:gd name="T48" fmla="*/ 341 w 817"/>
                <a:gd name="T49" fmla="*/ 692 h 743"/>
                <a:gd name="T50" fmla="*/ 350 w 817"/>
                <a:gd name="T51" fmla="*/ 641 h 743"/>
                <a:gd name="T52" fmla="*/ 353 w 817"/>
                <a:gd name="T53" fmla="*/ 493 h 743"/>
                <a:gd name="T54" fmla="*/ 353 w 817"/>
                <a:gd name="T55" fmla="*/ 432 h 743"/>
                <a:gd name="T56" fmla="*/ 331 w 817"/>
                <a:gd name="T57" fmla="*/ 390 h 743"/>
                <a:gd name="T58" fmla="*/ 275 w 817"/>
                <a:gd name="T59" fmla="*/ 300 h 743"/>
                <a:gd name="T60" fmla="*/ 135 w 817"/>
                <a:gd name="T61" fmla="*/ 102 h 743"/>
                <a:gd name="T62" fmla="*/ 96 w 817"/>
                <a:gd name="T63" fmla="*/ 51 h 743"/>
                <a:gd name="T64" fmla="*/ 69 w 817"/>
                <a:gd name="T65" fmla="*/ 39 h 743"/>
                <a:gd name="T66" fmla="*/ 0 w 817"/>
                <a:gd name="T67" fmla="*/ 33 h 743"/>
                <a:gd name="T68" fmla="*/ 0 w 817"/>
                <a:gd name="T69" fmla="*/ 0 h 743"/>
                <a:gd name="T70" fmla="*/ 130 w 817"/>
                <a:gd name="T71" fmla="*/ 3 h 743"/>
                <a:gd name="T72" fmla="*/ 333 w 817"/>
                <a:gd name="T73" fmla="*/ 0 h 743"/>
                <a:gd name="T74" fmla="*/ 333 w 817"/>
                <a:gd name="T75" fmla="*/ 33 h 743"/>
                <a:gd name="T76" fmla="*/ 246 w 817"/>
                <a:gd name="T77" fmla="*/ 39 h 743"/>
                <a:gd name="T78" fmla="*/ 234 w 817"/>
                <a:gd name="T79" fmla="*/ 52 h 743"/>
                <a:gd name="T80" fmla="*/ 262 w 817"/>
                <a:gd name="T81" fmla="*/ 111 h 743"/>
                <a:gd name="T82" fmla="*/ 426 w 817"/>
                <a:gd name="T83" fmla="*/ 376 h 743"/>
                <a:gd name="T84" fmla="*/ 601 w 817"/>
                <a:gd name="T85" fmla="*/ 111 h 74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Lst>
              <a:rect l="0" t="0" r="r" b="b"/>
              <a:pathLst>
                <a:path w="817" h="743">
                  <a:moveTo>
                    <a:pt x="601" y="111"/>
                  </a:moveTo>
                  <a:cubicBezTo>
                    <a:pt x="623" y="78"/>
                    <a:pt x="634" y="59"/>
                    <a:pt x="634" y="52"/>
                  </a:cubicBezTo>
                  <a:cubicBezTo>
                    <a:pt x="634" y="46"/>
                    <a:pt x="631" y="41"/>
                    <a:pt x="624" y="39"/>
                  </a:cubicBezTo>
                  <a:cubicBezTo>
                    <a:pt x="616" y="36"/>
                    <a:pt x="585" y="34"/>
                    <a:pt x="543" y="33"/>
                  </a:cubicBezTo>
                  <a:cubicBezTo>
                    <a:pt x="543" y="0"/>
                    <a:pt x="543" y="0"/>
                    <a:pt x="543" y="0"/>
                  </a:cubicBezTo>
                  <a:cubicBezTo>
                    <a:pt x="610" y="2"/>
                    <a:pt x="650" y="3"/>
                    <a:pt x="688" y="3"/>
                  </a:cubicBezTo>
                  <a:cubicBezTo>
                    <a:pt x="725" y="3"/>
                    <a:pt x="745" y="2"/>
                    <a:pt x="817" y="0"/>
                  </a:cubicBezTo>
                  <a:cubicBezTo>
                    <a:pt x="817" y="33"/>
                    <a:pt x="817" y="33"/>
                    <a:pt x="817" y="33"/>
                  </a:cubicBezTo>
                  <a:cubicBezTo>
                    <a:pt x="773" y="34"/>
                    <a:pt x="757" y="36"/>
                    <a:pt x="746" y="39"/>
                  </a:cubicBezTo>
                  <a:cubicBezTo>
                    <a:pt x="735" y="41"/>
                    <a:pt x="725" y="46"/>
                    <a:pt x="718" y="51"/>
                  </a:cubicBezTo>
                  <a:cubicBezTo>
                    <a:pt x="709" y="58"/>
                    <a:pt x="695" y="75"/>
                    <a:pt x="675" y="102"/>
                  </a:cubicBezTo>
                  <a:cubicBezTo>
                    <a:pt x="514" y="333"/>
                    <a:pt x="514" y="333"/>
                    <a:pt x="514" y="333"/>
                  </a:cubicBezTo>
                  <a:cubicBezTo>
                    <a:pt x="483" y="381"/>
                    <a:pt x="465" y="411"/>
                    <a:pt x="461" y="422"/>
                  </a:cubicBezTo>
                  <a:cubicBezTo>
                    <a:pt x="457" y="433"/>
                    <a:pt x="455" y="443"/>
                    <a:pt x="455" y="453"/>
                  </a:cubicBezTo>
                  <a:cubicBezTo>
                    <a:pt x="455" y="493"/>
                    <a:pt x="455" y="493"/>
                    <a:pt x="455" y="493"/>
                  </a:cubicBezTo>
                  <a:cubicBezTo>
                    <a:pt x="455" y="541"/>
                    <a:pt x="456" y="587"/>
                    <a:pt x="459" y="631"/>
                  </a:cubicBezTo>
                  <a:cubicBezTo>
                    <a:pt x="460" y="665"/>
                    <a:pt x="462" y="684"/>
                    <a:pt x="466" y="690"/>
                  </a:cubicBezTo>
                  <a:cubicBezTo>
                    <a:pt x="470" y="696"/>
                    <a:pt x="477" y="701"/>
                    <a:pt x="486" y="704"/>
                  </a:cubicBezTo>
                  <a:cubicBezTo>
                    <a:pt x="495" y="707"/>
                    <a:pt x="521" y="709"/>
                    <a:pt x="564" y="710"/>
                  </a:cubicBezTo>
                  <a:cubicBezTo>
                    <a:pt x="564" y="743"/>
                    <a:pt x="564" y="743"/>
                    <a:pt x="564" y="743"/>
                  </a:cubicBezTo>
                  <a:cubicBezTo>
                    <a:pt x="505" y="741"/>
                    <a:pt x="453" y="740"/>
                    <a:pt x="410" y="740"/>
                  </a:cubicBezTo>
                  <a:cubicBezTo>
                    <a:pt x="368" y="740"/>
                    <a:pt x="313" y="741"/>
                    <a:pt x="244" y="743"/>
                  </a:cubicBezTo>
                  <a:cubicBezTo>
                    <a:pt x="244" y="710"/>
                    <a:pt x="244" y="710"/>
                    <a:pt x="244" y="710"/>
                  </a:cubicBezTo>
                  <a:cubicBezTo>
                    <a:pt x="287" y="709"/>
                    <a:pt x="313" y="707"/>
                    <a:pt x="322" y="704"/>
                  </a:cubicBezTo>
                  <a:cubicBezTo>
                    <a:pt x="332" y="701"/>
                    <a:pt x="338" y="697"/>
                    <a:pt x="341" y="692"/>
                  </a:cubicBezTo>
                  <a:cubicBezTo>
                    <a:pt x="346" y="685"/>
                    <a:pt x="349" y="668"/>
                    <a:pt x="350" y="641"/>
                  </a:cubicBezTo>
                  <a:cubicBezTo>
                    <a:pt x="350" y="634"/>
                    <a:pt x="351" y="585"/>
                    <a:pt x="353" y="493"/>
                  </a:cubicBezTo>
                  <a:cubicBezTo>
                    <a:pt x="353" y="432"/>
                    <a:pt x="353" y="432"/>
                    <a:pt x="353" y="432"/>
                  </a:cubicBezTo>
                  <a:cubicBezTo>
                    <a:pt x="345" y="417"/>
                    <a:pt x="338" y="403"/>
                    <a:pt x="331" y="390"/>
                  </a:cubicBezTo>
                  <a:cubicBezTo>
                    <a:pt x="325" y="382"/>
                    <a:pt x="307" y="352"/>
                    <a:pt x="275" y="300"/>
                  </a:cubicBezTo>
                  <a:cubicBezTo>
                    <a:pt x="135" y="102"/>
                    <a:pt x="135" y="102"/>
                    <a:pt x="135" y="102"/>
                  </a:cubicBezTo>
                  <a:cubicBezTo>
                    <a:pt x="118" y="75"/>
                    <a:pt x="105" y="58"/>
                    <a:pt x="96" y="51"/>
                  </a:cubicBezTo>
                  <a:cubicBezTo>
                    <a:pt x="89" y="46"/>
                    <a:pt x="80" y="41"/>
                    <a:pt x="69" y="39"/>
                  </a:cubicBezTo>
                  <a:cubicBezTo>
                    <a:pt x="58" y="36"/>
                    <a:pt x="44" y="34"/>
                    <a:pt x="0" y="33"/>
                  </a:cubicBezTo>
                  <a:cubicBezTo>
                    <a:pt x="0" y="0"/>
                    <a:pt x="0" y="0"/>
                    <a:pt x="0" y="0"/>
                  </a:cubicBezTo>
                  <a:cubicBezTo>
                    <a:pt x="72" y="2"/>
                    <a:pt x="94" y="3"/>
                    <a:pt x="130" y="3"/>
                  </a:cubicBezTo>
                  <a:cubicBezTo>
                    <a:pt x="168" y="3"/>
                    <a:pt x="265" y="2"/>
                    <a:pt x="333" y="0"/>
                  </a:cubicBezTo>
                  <a:cubicBezTo>
                    <a:pt x="333" y="33"/>
                    <a:pt x="333" y="33"/>
                    <a:pt x="333" y="33"/>
                  </a:cubicBezTo>
                  <a:cubicBezTo>
                    <a:pt x="291" y="34"/>
                    <a:pt x="254" y="36"/>
                    <a:pt x="246" y="39"/>
                  </a:cubicBezTo>
                  <a:cubicBezTo>
                    <a:pt x="239" y="41"/>
                    <a:pt x="235" y="46"/>
                    <a:pt x="234" y="52"/>
                  </a:cubicBezTo>
                  <a:cubicBezTo>
                    <a:pt x="234" y="59"/>
                    <a:pt x="243" y="78"/>
                    <a:pt x="262" y="111"/>
                  </a:cubicBezTo>
                  <a:cubicBezTo>
                    <a:pt x="426" y="376"/>
                    <a:pt x="426" y="376"/>
                    <a:pt x="426" y="376"/>
                  </a:cubicBezTo>
                  <a:lnTo>
                    <a:pt x="601" y="111"/>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2" name="Freeform 15"/>
            <p:cNvSpPr>
              <a:spLocks noEditPoints="1"/>
            </p:cNvSpPr>
            <p:nvPr userDrawn="1"/>
          </p:nvSpPr>
          <p:spPr bwMode="auto">
            <a:xfrm>
              <a:off x="1558925" y="681038"/>
              <a:ext cx="263525" cy="246063"/>
            </a:xfrm>
            <a:custGeom>
              <a:avLst/>
              <a:gdLst>
                <a:gd name="T0" fmla="*/ 148 w 830"/>
                <a:gd name="T1" fmla="*/ 190 h 775"/>
                <a:gd name="T2" fmla="*/ 247 w 830"/>
                <a:gd name="T3" fmla="*/ 82 h 775"/>
                <a:gd name="T4" fmla="*/ 399 w 830"/>
                <a:gd name="T5" fmla="*/ 45 h 775"/>
                <a:gd name="T6" fmla="*/ 512 w 830"/>
                <a:gd name="T7" fmla="*/ 62 h 775"/>
                <a:gd name="T8" fmla="*/ 596 w 830"/>
                <a:gd name="T9" fmla="*/ 106 h 775"/>
                <a:gd name="T10" fmla="*/ 652 w 830"/>
                <a:gd name="T11" fmla="*/ 167 h 775"/>
                <a:gd name="T12" fmla="*/ 690 w 830"/>
                <a:gd name="T13" fmla="*/ 245 h 775"/>
                <a:gd name="T14" fmla="*/ 713 w 830"/>
                <a:gd name="T15" fmla="*/ 398 h 775"/>
                <a:gd name="T16" fmla="*/ 681 w 830"/>
                <a:gd name="T17" fmla="*/ 571 h 775"/>
                <a:gd name="T18" fmla="*/ 584 w 830"/>
                <a:gd name="T19" fmla="*/ 686 h 775"/>
                <a:gd name="T20" fmla="*/ 431 w 830"/>
                <a:gd name="T21" fmla="*/ 727 h 775"/>
                <a:gd name="T22" fmla="*/ 315 w 830"/>
                <a:gd name="T23" fmla="*/ 707 h 775"/>
                <a:gd name="T24" fmla="*/ 220 w 830"/>
                <a:gd name="T25" fmla="*/ 644 h 775"/>
                <a:gd name="T26" fmla="*/ 151 w 830"/>
                <a:gd name="T27" fmla="*/ 539 h 775"/>
                <a:gd name="T28" fmla="*/ 125 w 830"/>
                <a:gd name="T29" fmla="*/ 450 h 775"/>
                <a:gd name="T30" fmla="*/ 115 w 830"/>
                <a:gd name="T31" fmla="*/ 349 h 775"/>
                <a:gd name="T32" fmla="*/ 148 w 830"/>
                <a:gd name="T33" fmla="*/ 190 h 775"/>
                <a:gd name="T34" fmla="*/ 26 w 830"/>
                <a:gd name="T35" fmla="*/ 541 h 775"/>
                <a:gd name="T36" fmla="*/ 105 w 830"/>
                <a:gd name="T37" fmla="*/ 669 h 775"/>
                <a:gd name="T38" fmla="*/ 231 w 830"/>
                <a:gd name="T39" fmla="*/ 748 h 775"/>
                <a:gd name="T40" fmla="*/ 392 w 830"/>
                <a:gd name="T41" fmla="*/ 775 h 775"/>
                <a:gd name="T42" fmla="*/ 706 w 830"/>
                <a:gd name="T43" fmla="*/ 657 h 775"/>
                <a:gd name="T44" fmla="*/ 830 w 830"/>
                <a:gd name="T45" fmla="*/ 364 h 775"/>
                <a:gd name="T46" fmla="*/ 817 w 830"/>
                <a:gd name="T47" fmla="*/ 261 h 775"/>
                <a:gd name="T48" fmla="*/ 784 w 830"/>
                <a:gd name="T49" fmla="*/ 177 h 775"/>
                <a:gd name="T50" fmla="*/ 709 w 830"/>
                <a:gd name="T51" fmla="*/ 89 h 775"/>
                <a:gd name="T52" fmla="*/ 588 w 830"/>
                <a:gd name="T53" fmla="*/ 25 h 775"/>
                <a:gd name="T54" fmla="*/ 423 w 830"/>
                <a:gd name="T55" fmla="*/ 0 h 775"/>
                <a:gd name="T56" fmla="*/ 249 w 830"/>
                <a:gd name="T57" fmla="*/ 29 h 775"/>
                <a:gd name="T58" fmla="*/ 112 w 830"/>
                <a:gd name="T59" fmla="*/ 113 h 775"/>
                <a:gd name="T60" fmla="*/ 26 w 830"/>
                <a:gd name="T61" fmla="*/ 239 h 775"/>
                <a:gd name="T62" fmla="*/ 0 w 830"/>
                <a:gd name="T63" fmla="*/ 393 h 775"/>
                <a:gd name="T64" fmla="*/ 26 w 830"/>
                <a:gd name="T65" fmla="*/ 541 h 77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Lst>
              <a:rect l="0" t="0" r="r" b="b"/>
              <a:pathLst>
                <a:path w="830" h="775">
                  <a:moveTo>
                    <a:pt x="148" y="190"/>
                  </a:moveTo>
                  <a:cubicBezTo>
                    <a:pt x="170" y="143"/>
                    <a:pt x="203" y="107"/>
                    <a:pt x="247" y="82"/>
                  </a:cubicBezTo>
                  <a:cubicBezTo>
                    <a:pt x="290" y="57"/>
                    <a:pt x="341" y="45"/>
                    <a:pt x="399" y="45"/>
                  </a:cubicBezTo>
                  <a:cubicBezTo>
                    <a:pt x="440" y="45"/>
                    <a:pt x="477" y="51"/>
                    <a:pt x="512" y="62"/>
                  </a:cubicBezTo>
                  <a:cubicBezTo>
                    <a:pt x="546" y="74"/>
                    <a:pt x="575" y="89"/>
                    <a:pt x="596" y="106"/>
                  </a:cubicBezTo>
                  <a:cubicBezTo>
                    <a:pt x="618" y="124"/>
                    <a:pt x="637" y="144"/>
                    <a:pt x="652" y="167"/>
                  </a:cubicBezTo>
                  <a:cubicBezTo>
                    <a:pt x="668" y="190"/>
                    <a:pt x="681" y="216"/>
                    <a:pt x="690" y="245"/>
                  </a:cubicBezTo>
                  <a:cubicBezTo>
                    <a:pt x="706" y="292"/>
                    <a:pt x="713" y="343"/>
                    <a:pt x="713" y="398"/>
                  </a:cubicBezTo>
                  <a:cubicBezTo>
                    <a:pt x="713" y="463"/>
                    <a:pt x="703" y="521"/>
                    <a:pt x="681" y="571"/>
                  </a:cubicBezTo>
                  <a:cubicBezTo>
                    <a:pt x="660" y="620"/>
                    <a:pt x="627" y="659"/>
                    <a:pt x="584" y="686"/>
                  </a:cubicBezTo>
                  <a:cubicBezTo>
                    <a:pt x="541" y="714"/>
                    <a:pt x="490" y="727"/>
                    <a:pt x="431" y="727"/>
                  </a:cubicBezTo>
                  <a:cubicBezTo>
                    <a:pt x="388" y="727"/>
                    <a:pt x="350" y="721"/>
                    <a:pt x="315" y="707"/>
                  </a:cubicBezTo>
                  <a:cubicBezTo>
                    <a:pt x="280" y="694"/>
                    <a:pt x="248" y="673"/>
                    <a:pt x="220" y="644"/>
                  </a:cubicBezTo>
                  <a:cubicBezTo>
                    <a:pt x="192" y="616"/>
                    <a:pt x="169" y="581"/>
                    <a:pt x="151" y="539"/>
                  </a:cubicBezTo>
                  <a:cubicBezTo>
                    <a:pt x="141" y="514"/>
                    <a:pt x="132" y="484"/>
                    <a:pt x="125" y="450"/>
                  </a:cubicBezTo>
                  <a:cubicBezTo>
                    <a:pt x="118" y="416"/>
                    <a:pt x="115" y="382"/>
                    <a:pt x="115" y="349"/>
                  </a:cubicBezTo>
                  <a:cubicBezTo>
                    <a:pt x="115" y="290"/>
                    <a:pt x="126" y="236"/>
                    <a:pt x="148" y="190"/>
                  </a:cubicBezTo>
                  <a:close/>
                  <a:moveTo>
                    <a:pt x="26" y="541"/>
                  </a:moveTo>
                  <a:cubicBezTo>
                    <a:pt x="44" y="591"/>
                    <a:pt x="70" y="634"/>
                    <a:pt x="105" y="669"/>
                  </a:cubicBezTo>
                  <a:cubicBezTo>
                    <a:pt x="139" y="704"/>
                    <a:pt x="181" y="730"/>
                    <a:pt x="231" y="748"/>
                  </a:cubicBezTo>
                  <a:cubicBezTo>
                    <a:pt x="281" y="765"/>
                    <a:pt x="335" y="775"/>
                    <a:pt x="392" y="775"/>
                  </a:cubicBezTo>
                  <a:cubicBezTo>
                    <a:pt x="518" y="775"/>
                    <a:pt x="623" y="736"/>
                    <a:pt x="706" y="657"/>
                  </a:cubicBezTo>
                  <a:cubicBezTo>
                    <a:pt x="788" y="579"/>
                    <a:pt x="830" y="481"/>
                    <a:pt x="830" y="364"/>
                  </a:cubicBezTo>
                  <a:cubicBezTo>
                    <a:pt x="830" y="327"/>
                    <a:pt x="826" y="293"/>
                    <a:pt x="817" y="261"/>
                  </a:cubicBezTo>
                  <a:cubicBezTo>
                    <a:pt x="809" y="228"/>
                    <a:pt x="798" y="200"/>
                    <a:pt x="784" y="177"/>
                  </a:cubicBezTo>
                  <a:cubicBezTo>
                    <a:pt x="766" y="145"/>
                    <a:pt x="741" y="116"/>
                    <a:pt x="709" y="89"/>
                  </a:cubicBezTo>
                  <a:cubicBezTo>
                    <a:pt x="678" y="62"/>
                    <a:pt x="637" y="41"/>
                    <a:pt x="588" y="25"/>
                  </a:cubicBezTo>
                  <a:cubicBezTo>
                    <a:pt x="538" y="8"/>
                    <a:pt x="484" y="0"/>
                    <a:pt x="423" y="0"/>
                  </a:cubicBezTo>
                  <a:cubicBezTo>
                    <a:pt x="358" y="0"/>
                    <a:pt x="300" y="10"/>
                    <a:pt x="249" y="29"/>
                  </a:cubicBezTo>
                  <a:cubicBezTo>
                    <a:pt x="198" y="48"/>
                    <a:pt x="152" y="76"/>
                    <a:pt x="112" y="113"/>
                  </a:cubicBezTo>
                  <a:cubicBezTo>
                    <a:pt x="72" y="151"/>
                    <a:pt x="43" y="193"/>
                    <a:pt x="26" y="239"/>
                  </a:cubicBezTo>
                  <a:cubicBezTo>
                    <a:pt x="8" y="286"/>
                    <a:pt x="0" y="337"/>
                    <a:pt x="0" y="393"/>
                  </a:cubicBezTo>
                  <a:cubicBezTo>
                    <a:pt x="0" y="441"/>
                    <a:pt x="9" y="491"/>
                    <a:pt x="26" y="541"/>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spTree>
    <p:extLst>
      <p:ext uri="{BB962C8B-B14F-4D97-AF65-F5344CB8AC3E}">
        <p14:creationId xmlns:p14="http://schemas.microsoft.com/office/powerpoint/2010/main" val="1060360237"/>
      </p:ext>
    </p:extLst>
  </p:cSld>
  <p:clrMapOvr>
    <a:masterClrMapping/>
  </p:clrMapOvr>
  <p:timing>
    <p:tnLst>
      <p:par>
        <p:cTn id="1" dur="indefinite" restart="never" nodeType="tmRoot"/>
      </p:par>
    </p:tnLst>
  </p:timing>
</p:sldLayout>
</file>

<file path=ppt/slideLayouts/slideLayout1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82191FB-BFC2-4350-842B-B0B6EE5DEDAB}" type="datetime1">
              <a:rPr lang="en-US" smtClean="0"/>
              <a:t>10/2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C53FA5-AE81-45E0-8206-920AA27813B4}" type="slidenum">
              <a:rPr lang="en-US" smtClean="0"/>
              <a:t>‹#›</a:t>
            </a:fld>
            <a:endParaRPr lang="en-US"/>
          </a:p>
        </p:txBody>
      </p:sp>
    </p:spTree>
    <p:extLst>
      <p:ext uri="{BB962C8B-B14F-4D97-AF65-F5344CB8AC3E}">
        <p14:creationId xmlns:p14="http://schemas.microsoft.com/office/powerpoint/2010/main" val="357808665"/>
      </p:ext>
    </p:extLst>
  </p:cSld>
  <p:clrMapOvr>
    <a:masterClrMapping/>
  </p:clrMapOvr>
  <p:timing>
    <p:tnLst>
      <p:par>
        <p:cTn id="1" dur="indefinite" restart="never" nodeType="tmRoot"/>
      </p:par>
    </p:tnLst>
  </p:timing>
</p:sldLayout>
</file>

<file path=ppt/slideLayouts/slideLayout1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D51B3EB-9A34-4F66-9E58-F099C0B25413}" type="datetime1">
              <a:rPr lang="en-US" smtClean="0"/>
              <a:t>10/2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C53FA5-AE81-45E0-8206-920AA27813B4}" type="slidenum">
              <a:rPr lang="en-US" smtClean="0"/>
              <a:t>‹#›</a:t>
            </a:fld>
            <a:endParaRPr lang="en-US"/>
          </a:p>
        </p:txBody>
      </p:sp>
    </p:spTree>
    <p:extLst>
      <p:ext uri="{BB962C8B-B14F-4D97-AF65-F5344CB8AC3E}">
        <p14:creationId xmlns:p14="http://schemas.microsoft.com/office/powerpoint/2010/main" val="3081949907"/>
      </p:ext>
    </p:extLst>
  </p:cSld>
  <p:clrMapOvr>
    <a:masterClrMapping/>
  </p:clrMapOvr>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16F697D8-5DA9-40D5-BC3E-0717BC04406B}" type="datetime1">
              <a:rPr lang="en-US" smtClean="0"/>
              <a:t>10/2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C53FA5-AE81-45E0-8206-920AA27813B4}" type="slidenum">
              <a:rPr lang="en-US" smtClean="0"/>
              <a:t>‹#›</a:t>
            </a:fld>
            <a:endParaRPr lang="en-US"/>
          </a:p>
        </p:txBody>
      </p:sp>
      <p:grpSp>
        <p:nvGrpSpPr>
          <p:cNvPr id="20" name="Group 19"/>
          <p:cNvGrpSpPr/>
          <p:nvPr userDrawn="1"/>
        </p:nvGrpSpPr>
        <p:grpSpPr>
          <a:xfrm>
            <a:off x="120650" y="6299343"/>
            <a:ext cx="420688" cy="458645"/>
            <a:chOff x="657225" y="681038"/>
            <a:chExt cx="1266825" cy="1381125"/>
          </a:xfrm>
          <a:solidFill>
            <a:srgbClr val="FFFFFF"/>
          </a:solidFill>
        </p:grpSpPr>
        <p:sp>
          <p:nvSpPr>
            <p:cNvPr id="21" name="Freeform 5"/>
            <p:cNvSpPr>
              <a:spLocks noEditPoints="1"/>
            </p:cNvSpPr>
            <p:nvPr userDrawn="1"/>
          </p:nvSpPr>
          <p:spPr bwMode="auto">
            <a:xfrm>
              <a:off x="846138" y="1354138"/>
              <a:ext cx="887413" cy="708025"/>
            </a:xfrm>
            <a:custGeom>
              <a:avLst/>
              <a:gdLst>
                <a:gd name="T0" fmla="*/ 2203 w 2794"/>
                <a:gd name="T1" fmla="*/ 0 h 2229"/>
                <a:gd name="T2" fmla="*/ 1613 w 2794"/>
                <a:gd name="T3" fmla="*/ 0 h 2229"/>
                <a:gd name="T4" fmla="*/ 1613 w 2794"/>
                <a:gd name="T5" fmla="*/ 665 h 2229"/>
                <a:gd name="T6" fmla="*/ 1904 w 2794"/>
                <a:gd name="T7" fmla="*/ 1330 h 2229"/>
                <a:gd name="T8" fmla="*/ 1904 w 2794"/>
                <a:gd name="T9" fmla="*/ 1237 h 2229"/>
                <a:gd name="T10" fmla="*/ 1749 w 2794"/>
                <a:gd name="T11" fmla="*/ 747 h 2229"/>
                <a:gd name="T12" fmla="*/ 1749 w 2794"/>
                <a:gd name="T13" fmla="*/ 573 h 2229"/>
                <a:gd name="T14" fmla="*/ 1972 w 2794"/>
                <a:gd name="T15" fmla="*/ 573 h 2229"/>
                <a:gd name="T16" fmla="*/ 1972 w 2794"/>
                <a:gd name="T17" fmla="*/ 1332 h 2229"/>
                <a:gd name="T18" fmla="*/ 1401 w 2794"/>
                <a:gd name="T19" fmla="*/ 2182 h 2229"/>
                <a:gd name="T20" fmla="*/ 829 w 2794"/>
                <a:gd name="T21" fmla="*/ 1374 h 2229"/>
                <a:gd name="T22" fmla="*/ 1180 w 2794"/>
                <a:gd name="T23" fmla="*/ 665 h 2229"/>
                <a:gd name="T24" fmla="*/ 1180 w 2794"/>
                <a:gd name="T25" fmla="*/ 573 h 2229"/>
                <a:gd name="T26" fmla="*/ 1401 w 2794"/>
                <a:gd name="T27" fmla="*/ 573 h 2229"/>
                <a:gd name="T28" fmla="*/ 1542 w 2794"/>
                <a:gd name="T29" fmla="*/ 573 h 2229"/>
                <a:gd name="T30" fmla="*/ 1542 w 2794"/>
                <a:gd name="T31" fmla="*/ 436 h 2229"/>
                <a:gd name="T32" fmla="*/ 1401 w 2794"/>
                <a:gd name="T33" fmla="*/ 436 h 2229"/>
                <a:gd name="T34" fmla="*/ 1180 w 2794"/>
                <a:gd name="T35" fmla="*/ 436 h 2229"/>
                <a:gd name="T36" fmla="*/ 1180 w 2794"/>
                <a:gd name="T37" fmla="*/ 436 h 2229"/>
                <a:gd name="T38" fmla="*/ 1044 w 2794"/>
                <a:gd name="T39" fmla="*/ 436 h 2229"/>
                <a:gd name="T40" fmla="*/ 1044 w 2794"/>
                <a:gd name="T41" fmla="*/ 436 h 2229"/>
                <a:gd name="T42" fmla="*/ 692 w 2794"/>
                <a:gd name="T43" fmla="*/ 436 h 2229"/>
                <a:gd name="T44" fmla="*/ 692 w 2794"/>
                <a:gd name="T45" fmla="*/ 1234 h 2229"/>
                <a:gd name="T46" fmla="*/ 695 w 2794"/>
                <a:gd name="T47" fmla="*/ 1315 h 2229"/>
                <a:gd name="T48" fmla="*/ 695 w 2794"/>
                <a:gd name="T49" fmla="*/ 1315 h 2229"/>
                <a:gd name="T50" fmla="*/ 829 w 2794"/>
                <a:gd name="T51" fmla="*/ 1205 h 2229"/>
                <a:gd name="T52" fmla="*/ 829 w 2794"/>
                <a:gd name="T53" fmla="*/ 1205 h 2229"/>
                <a:gd name="T54" fmla="*/ 829 w 2794"/>
                <a:gd name="T55" fmla="*/ 573 h 2229"/>
                <a:gd name="T56" fmla="*/ 1044 w 2794"/>
                <a:gd name="T57" fmla="*/ 573 h 2229"/>
                <a:gd name="T58" fmla="*/ 1044 w 2794"/>
                <a:gd name="T59" fmla="*/ 573 h 2229"/>
                <a:gd name="T60" fmla="*/ 1044 w 2794"/>
                <a:gd name="T61" fmla="*/ 747 h 2229"/>
                <a:gd name="T62" fmla="*/ 590 w 2794"/>
                <a:gd name="T63" fmla="*/ 1447 h 2229"/>
                <a:gd name="T64" fmla="*/ 135 w 2794"/>
                <a:gd name="T65" fmla="*/ 747 h 2229"/>
                <a:gd name="T66" fmla="*/ 135 w 2794"/>
                <a:gd name="T67" fmla="*/ 136 h 2229"/>
                <a:gd name="T68" fmla="*/ 590 w 2794"/>
                <a:gd name="T69" fmla="*/ 136 h 2229"/>
                <a:gd name="T70" fmla="*/ 1044 w 2794"/>
                <a:gd name="T71" fmla="*/ 136 h 2229"/>
                <a:gd name="T72" fmla="*/ 1044 w 2794"/>
                <a:gd name="T73" fmla="*/ 370 h 2229"/>
                <a:gd name="T74" fmla="*/ 1180 w 2794"/>
                <a:gd name="T75" fmla="*/ 370 h 2229"/>
                <a:gd name="T76" fmla="*/ 1180 w 2794"/>
                <a:gd name="T77" fmla="*/ 0 h 2229"/>
                <a:gd name="T78" fmla="*/ 590 w 2794"/>
                <a:gd name="T79" fmla="*/ 0 h 2229"/>
                <a:gd name="T80" fmla="*/ 0 w 2794"/>
                <a:gd name="T81" fmla="*/ 0 h 2229"/>
                <a:gd name="T82" fmla="*/ 0 w 2794"/>
                <a:gd name="T83" fmla="*/ 665 h 2229"/>
                <a:gd name="T84" fmla="*/ 590 w 2794"/>
                <a:gd name="T85" fmla="*/ 1495 h 2229"/>
                <a:gd name="T86" fmla="*/ 708 w 2794"/>
                <a:gd name="T87" fmla="*/ 1444 h 2229"/>
                <a:gd name="T88" fmla="*/ 1401 w 2794"/>
                <a:gd name="T89" fmla="*/ 2229 h 2229"/>
                <a:gd name="T90" fmla="*/ 2093 w 2794"/>
                <a:gd name="T91" fmla="*/ 1447 h 2229"/>
                <a:gd name="T92" fmla="*/ 2203 w 2794"/>
                <a:gd name="T93" fmla="*/ 1495 h 2229"/>
                <a:gd name="T94" fmla="*/ 2794 w 2794"/>
                <a:gd name="T95" fmla="*/ 665 h 2229"/>
                <a:gd name="T96" fmla="*/ 2794 w 2794"/>
                <a:gd name="T97" fmla="*/ 0 h 2229"/>
                <a:gd name="T98" fmla="*/ 2203 w 2794"/>
                <a:gd name="T99" fmla="*/ 0 h 2229"/>
                <a:gd name="T100" fmla="*/ 2658 w 2794"/>
                <a:gd name="T101" fmla="*/ 747 h 2229"/>
                <a:gd name="T102" fmla="*/ 2203 w 2794"/>
                <a:gd name="T103" fmla="*/ 1447 h 2229"/>
                <a:gd name="T104" fmla="*/ 2100 w 2794"/>
                <a:gd name="T105" fmla="*/ 1395 h 2229"/>
                <a:gd name="T106" fmla="*/ 2109 w 2794"/>
                <a:gd name="T107" fmla="*/ 1234 h 2229"/>
                <a:gd name="T108" fmla="*/ 2109 w 2794"/>
                <a:gd name="T109" fmla="*/ 436 h 2229"/>
                <a:gd name="T110" fmla="*/ 1749 w 2794"/>
                <a:gd name="T111" fmla="*/ 436 h 2229"/>
                <a:gd name="T112" fmla="*/ 1749 w 2794"/>
                <a:gd name="T113" fmla="*/ 136 h 2229"/>
                <a:gd name="T114" fmla="*/ 2203 w 2794"/>
                <a:gd name="T115" fmla="*/ 136 h 2229"/>
                <a:gd name="T116" fmla="*/ 2658 w 2794"/>
                <a:gd name="T117" fmla="*/ 136 h 2229"/>
                <a:gd name="T118" fmla="*/ 2658 w 2794"/>
                <a:gd name="T119" fmla="*/ 747 h 222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 ang="0">
                  <a:pos x="T118" y="T119"/>
                </a:cxn>
              </a:cxnLst>
              <a:rect l="0" t="0" r="r" b="b"/>
              <a:pathLst>
                <a:path w="2794" h="2229">
                  <a:moveTo>
                    <a:pt x="2203" y="0"/>
                  </a:moveTo>
                  <a:cubicBezTo>
                    <a:pt x="1613" y="0"/>
                    <a:pt x="1613" y="0"/>
                    <a:pt x="1613" y="0"/>
                  </a:cubicBezTo>
                  <a:cubicBezTo>
                    <a:pt x="1613" y="665"/>
                    <a:pt x="1613" y="665"/>
                    <a:pt x="1613" y="665"/>
                  </a:cubicBezTo>
                  <a:cubicBezTo>
                    <a:pt x="1613" y="970"/>
                    <a:pt x="1719" y="1183"/>
                    <a:pt x="1904" y="1330"/>
                  </a:cubicBezTo>
                  <a:cubicBezTo>
                    <a:pt x="1904" y="1237"/>
                    <a:pt x="1904" y="1237"/>
                    <a:pt x="1904" y="1237"/>
                  </a:cubicBezTo>
                  <a:cubicBezTo>
                    <a:pt x="1769" y="1081"/>
                    <a:pt x="1749" y="901"/>
                    <a:pt x="1749" y="747"/>
                  </a:cubicBezTo>
                  <a:cubicBezTo>
                    <a:pt x="1749" y="573"/>
                    <a:pt x="1749" y="573"/>
                    <a:pt x="1749" y="573"/>
                  </a:cubicBezTo>
                  <a:cubicBezTo>
                    <a:pt x="1972" y="573"/>
                    <a:pt x="1972" y="573"/>
                    <a:pt x="1972" y="573"/>
                  </a:cubicBezTo>
                  <a:cubicBezTo>
                    <a:pt x="1972" y="1332"/>
                    <a:pt x="1972" y="1332"/>
                    <a:pt x="1972" y="1332"/>
                  </a:cubicBezTo>
                  <a:cubicBezTo>
                    <a:pt x="1972" y="1609"/>
                    <a:pt x="1895" y="1961"/>
                    <a:pt x="1401" y="2182"/>
                  </a:cubicBezTo>
                  <a:cubicBezTo>
                    <a:pt x="931" y="1972"/>
                    <a:pt x="838" y="1643"/>
                    <a:pt x="829" y="1374"/>
                  </a:cubicBezTo>
                  <a:cubicBezTo>
                    <a:pt x="1051" y="1225"/>
                    <a:pt x="1180" y="1001"/>
                    <a:pt x="1180" y="665"/>
                  </a:cubicBezTo>
                  <a:cubicBezTo>
                    <a:pt x="1180" y="573"/>
                    <a:pt x="1180" y="573"/>
                    <a:pt x="1180" y="573"/>
                  </a:cubicBezTo>
                  <a:cubicBezTo>
                    <a:pt x="1401" y="573"/>
                    <a:pt x="1401" y="573"/>
                    <a:pt x="1401" y="573"/>
                  </a:cubicBezTo>
                  <a:cubicBezTo>
                    <a:pt x="1542" y="573"/>
                    <a:pt x="1542" y="573"/>
                    <a:pt x="1542" y="573"/>
                  </a:cubicBezTo>
                  <a:cubicBezTo>
                    <a:pt x="1542" y="436"/>
                    <a:pt x="1542" y="436"/>
                    <a:pt x="1542" y="436"/>
                  </a:cubicBezTo>
                  <a:cubicBezTo>
                    <a:pt x="1401" y="436"/>
                    <a:pt x="1401" y="436"/>
                    <a:pt x="1401" y="436"/>
                  </a:cubicBezTo>
                  <a:cubicBezTo>
                    <a:pt x="1180" y="436"/>
                    <a:pt x="1180" y="436"/>
                    <a:pt x="1180" y="436"/>
                  </a:cubicBezTo>
                  <a:cubicBezTo>
                    <a:pt x="1180" y="436"/>
                    <a:pt x="1180" y="436"/>
                    <a:pt x="1180" y="436"/>
                  </a:cubicBezTo>
                  <a:cubicBezTo>
                    <a:pt x="1044" y="436"/>
                    <a:pt x="1044" y="436"/>
                    <a:pt x="1044" y="436"/>
                  </a:cubicBezTo>
                  <a:cubicBezTo>
                    <a:pt x="1044" y="436"/>
                    <a:pt x="1044" y="436"/>
                    <a:pt x="1044" y="436"/>
                  </a:cubicBezTo>
                  <a:cubicBezTo>
                    <a:pt x="692" y="436"/>
                    <a:pt x="692" y="436"/>
                    <a:pt x="692" y="436"/>
                  </a:cubicBezTo>
                  <a:cubicBezTo>
                    <a:pt x="692" y="1234"/>
                    <a:pt x="692" y="1234"/>
                    <a:pt x="692" y="1234"/>
                  </a:cubicBezTo>
                  <a:cubicBezTo>
                    <a:pt x="692" y="1262"/>
                    <a:pt x="693" y="1289"/>
                    <a:pt x="695" y="1315"/>
                  </a:cubicBezTo>
                  <a:cubicBezTo>
                    <a:pt x="695" y="1315"/>
                    <a:pt x="695" y="1315"/>
                    <a:pt x="695" y="1315"/>
                  </a:cubicBezTo>
                  <a:cubicBezTo>
                    <a:pt x="748" y="1280"/>
                    <a:pt x="792" y="1244"/>
                    <a:pt x="829" y="1205"/>
                  </a:cubicBezTo>
                  <a:cubicBezTo>
                    <a:pt x="829" y="1205"/>
                    <a:pt x="829" y="1205"/>
                    <a:pt x="829" y="1205"/>
                  </a:cubicBezTo>
                  <a:cubicBezTo>
                    <a:pt x="829" y="573"/>
                    <a:pt x="829" y="573"/>
                    <a:pt x="829" y="573"/>
                  </a:cubicBezTo>
                  <a:cubicBezTo>
                    <a:pt x="1044" y="573"/>
                    <a:pt x="1044" y="573"/>
                    <a:pt x="1044" y="573"/>
                  </a:cubicBezTo>
                  <a:cubicBezTo>
                    <a:pt x="1044" y="573"/>
                    <a:pt x="1044" y="573"/>
                    <a:pt x="1044" y="573"/>
                  </a:cubicBezTo>
                  <a:cubicBezTo>
                    <a:pt x="1044" y="747"/>
                    <a:pt x="1044" y="747"/>
                    <a:pt x="1044" y="747"/>
                  </a:cubicBezTo>
                  <a:cubicBezTo>
                    <a:pt x="1044" y="978"/>
                    <a:pt x="1001" y="1263"/>
                    <a:pt x="590" y="1447"/>
                  </a:cubicBezTo>
                  <a:cubicBezTo>
                    <a:pt x="178" y="1263"/>
                    <a:pt x="135" y="978"/>
                    <a:pt x="135" y="747"/>
                  </a:cubicBezTo>
                  <a:cubicBezTo>
                    <a:pt x="135" y="136"/>
                    <a:pt x="135" y="136"/>
                    <a:pt x="135" y="136"/>
                  </a:cubicBezTo>
                  <a:cubicBezTo>
                    <a:pt x="590" y="136"/>
                    <a:pt x="590" y="136"/>
                    <a:pt x="590" y="136"/>
                  </a:cubicBezTo>
                  <a:cubicBezTo>
                    <a:pt x="1044" y="136"/>
                    <a:pt x="1044" y="136"/>
                    <a:pt x="1044" y="136"/>
                  </a:cubicBezTo>
                  <a:cubicBezTo>
                    <a:pt x="1044" y="370"/>
                    <a:pt x="1044" y="370"/>
                    <a:pt x="1044" y="370"/>
                  </a:cubicBezTo>
                  <a:cubicBezTo>
                    <a:pt x="1180" y="370"/>
                    <a:pt x="1180" y="370"/>
                    <a:pt x="1180" y="370"/>
                  </a:cubicBezTo>
                  <a:cubicBezTo>
                    <a:pt x="1180" y="0"/>
                    <a:pt x="1180" y="0"/>
                    <a:pt x="1180" y="0"/>
                  </a:cubicBezTo>
                  <a:cubicBezTo>
                    <a:pt x="590" y="0"/>
                    <a:pt x="590" y="0"/>
                    <a:pt x="590" y="0"/>
                  </a:cubicBezTo>
                  <a:cubicBezTo>
                    <a:pt x="0" y="0"/>
                    <a:pt x="0" y="0"/>
                    <a:pt x="0" y="0"/>
                  </a:cubicBezTo>
                  <a:cubicBezTo>
                    <a:pt x="0" y="665"/>
                    <a:pt x="0" y="665"/>
                    <a:pt x="0" y="665"/>
                  </a:cubicBezTo>
                  <a:cubicBezTo>
                    <a:pt x="0" y="1109"/>
                    <a:pt x="224" y="1357"/>
                    <a:pt x="590" y="1495"/>
                  </a:cubicBezTo>
                  <a:cubicBezTo>
                    <a:pt x="631" y="1479"/>
                    <a:pt x="670" y="1462"/>
                    <a:pt x="708" y="1444"/>
                  </a:cubicBezTo>
                  <a:cubicBezTo>
                    <a:pt x="771" y="1847"/>
                    <a:pt x="1023" y="2087"/>
                    <a:pt x="1401" y="2229"/>
                  </a:cubicBezTo>
                  <a:cubicBezTo>
                    <a:pt x="1777" y="2087"/>
                    <a:pt x="2029" y="1848"/>
                    <a:pt x="2093" y="1447"/>
                  </a:cubicBezTo>
                  <a:cubicBezTo>
                    <a:pt x="2128" y="1464"/>
                    <a:pt x="2165" y="1480"/>
                    <a:pt x="2203" y="1495"/>
                  </a:cubicBezTo>
                  <a:cubicBezTo>
                    <a:pt x="2569" y="1357"/>
                    <a:pt x="2794" y="1109"/>
                    <a:pt x="2794" y="665"/>
                  </a:cubicBezTo>
                  <a:cubicBezTo>
                    <a:pt x="2794" y="0"/>
                    <a:pt x="2794" y="0"/>
                    <a:pt x="2794" y="0"/>
                  </a:cubicBezTo>
                  <a:lnTo>
                    <a:pt x="2203" y="0"/>
                  </a:lnTo>
                  <a:close/>
                  <a:moveTo>
                    <a:pt x="2658" y="747"/>
                  </a:moveTo>
                  <a:cubicBezTo>
                    <a:pt x="2658" y="978"/>
                    <a:pt x="2615" y="1263"/>
                    <a:pt x="2203" y="1447"/>
                  </a:cubicBezTo>
                  <a:cubicBezTo>
                    <a:pt x="2166" y="1431"/>
                    <a:pt x="2131" y="1413"/>
                    <a:pt x="2100" y="1395"/>
                  </a:cubicBezTo>
                  <a:cubicBezTo>
                    <a:pt x="2106" y="1344"/>
                    <a:pt x="2109" y="1290"/>
                    <a:pt x="2109" y="1234"/>
                  </a:cubicBezTo>
                  <a:cubicBezTo>
                    <a:pt x="2109" y="436"/>
                    <a:pt x="2109" y="436"/>
                    <a:pt x="2109" y="436"/>
                  </a:cubicBezTo>
                  <a:cubicBezTo>
                    <a:pt x="1749" y="436"/>
                    <a:pt x="1749" y="436"/>
                    <a:pt x="1749" y="436"/>
                  </a:cubicBezTo>
                  <a:cubicBezTo>
                    <a:pt x="1749" y="136"/>
                    <a:pt x="1749" y="136"/>
                    <a:pt x="1749" y="136"/>
                  </a:cubicBezTo>
                  <a:cubicBezTo>
                    <a:pt x="2203" y="136"/>
                    <a:pt x="2203" y="136"/>
                    <a:pt x="2203" y="136"/>
                  </a:cubicBezTo>
                  <a:cubicBezTo>
                    <a:pt x="2658" y="136"/>
                    <a:pt x="2658" y="136"/>
                    <a:pt x="2658" y="136"/>
                  </a:cubicBezTo>
                  <a:lnTo>
                    <a:pt x="2658" y="74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2" name="Freeform 6"/>
            <p:cNvSpPr>
              <a:spLocks/>
            </p:cNvSpPr>
            <p:nvPr userDrawn="1"/>
          </p:nvSpPr>
          <p:spPr bwMode="auto">
            <a:xfrm>
              <a:off x="915988" y="1003301"/>
              <a:ext cx="188913" cy="236538"/>
            </a:xfrm>
            <a:custGeom>
              <a:avLst/>
              <a:gdLst>
                <a:gd name="T0" fmla="*/ 49 w 596"/>
                <a:gd name="T1" fmla="*/ 747 h 747"/>
                <a:gd name="T2" fmla="*/ 49 w 596"/>
                <a:gd name="T3" fmla="*/ 721 h 747"/>
                <a:gd name="T4" fmla="*/ 91 w 596"/>
                <a:gd name="T5" fmla="*/ 696 h 747"/>
                <a:gd name="T6" fmla="*/ 99 w 596"/>
                <a:gd name="T7" fmla="*/ 684 h 747"/>
                <a:gd name="T8" fmla="*/ 105 w 596"/>
                <a:gd name="T9" fmla="*/ 621 h 747"/>
                <a:gd name="T10" fmla="*/ 109 w 596"/>
                <a:gd name="T11" fmla="*/ 535 h 747"/>
                <a:gd name="T12" fmla="*/ 109 w 596"/>
                <a:gd name="T13" fmla="*/ 252 h 747"/>
                <a:gd name="T14" fmla="*/ 105 w 596"/>
                <a:gd name="T15" fmla="*/ 112 h 747"/>
                <a:gd name="T16" fmla="*/ 98 w 596"/>
                <a:gd name="T17" fmla="*/ 52 h 747"/>
                <a:gd name="T18" fmla="*/ 78 w 596"/>
                <a:gd name="T19" fmla="*/ 39 h 747"/>
                <a:gd name="T20" fmla="*/ 0 w 596"/>
                <a:gd name="T21" fmla="*/ 33 h 747"/>
                <a:gd name="T22" fmla="*/ 0 w 596"/>
                <a:gd name="T23" fmla="*/ 0 h 747"/>
                <a:gd name="T24" fmla="*/ 165 w 596"/>
                <a:gd name="T25" fmla="*/ 3 h 747"/>
                <a:gd name="T26" fmla="*/ 323 w 596"/>
                <a:gd name="T27" fmla="*/ 0 h 747"/>
                <a:gd name="T28" fmla="*/ 323 w 596"/>
                <a:gd name="T29" fmla="*/ 33 h 747"/>
                <a:gd name="T30" fmla="*/ 243 w 596"/>
                <a:gd name="T31" fmla="*/ 39 h 747"/>
                <a:gd name="T32" fmla="*/ 224 w 596"/>
                <a:gd name="T33" fmla="*/ 51 h 747"/>
                <a:gd name="T34" fmla="*/ 216 w 596"/>
                <a:gd name="T35" fmla="*/ 102 h 747"/>
                <a:gd name="T36" fmla="*/ 213 w 596"/>
                <a:gd name="T37" fmla="*/ 252 h 747"/>
                <a:gd name="T38" fmla="*/ 213 w 596"/>
                <a:gd name="T39" fmla="*/ 606 h 747"/>
                <a:gd name="T40" fmla="*/ 216 w 596"/>
                <a:gd name="T41" fmla="*/ 696 h 747"/>
                <a:gd name="T42" fmla="*/ 303 w 596"/>
                <a:gd name="T43" fmla="*/ 700 h 747"/>
                <a:gd name="T44" fmla="*/ 525 w 596"/>
                <a:gd name="T45" fmla="*/ 681 h 747"/>
                <a:gd name="T46" fmla="*/ 538 w 596"/>
                <a:gd name="T47" fmla="*/ 644 h 747"/>
                <a:gd name="T48" fmla="*/ 560 w 596"/>
                <a:gd name="T49" fmla="*/ 557 h 747"/>
                <a:gd name="T50" fmla="*/ 596 w 596"/>
                <a:gd name="T51" fmla="*/ 557 h 747"/>
                <a:gd name="T52" fmla="*/ 573 w 596"/>
                <a:gd name="T53" fmla="*/ 741 h 747"/>
                <a:gd name="T54" fmla="*/ 537 w 596"/>
                <a:gd name="T55" fmla="*/ 746 h 747"/>
                <a:gd name="T56" fmla="*/ 449 w 596"/>
                <a:gd name="T57" fmla="*/ 747 h 747"/>
                <a:gd name="T58" fmla="*/ 156 w 596"/>
                <a:gd name="T59" fmla="*/ 744 h 747"/>
                <a:gd name="T60" fmla="*/ 49 w 596"/>
                <a:gd name="T61" fmla="*/ 747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Lst>
              <a:rect l="0" t="0" r="r" b="b"/>
              <a:pathLst>
                <a:path w="596" h="747">
                  <a:moveTo>
                    <a:pt x="49" y="747"/>
                  </a:moveTo>
                  <a:cubicBezTo>
                    <a:pt x="49" y="721"/>
                    <a:pt x="49" y="721"/>
                    <a:pt x="49" y="721"/>
                  </a:cubicBezTo>
                  <a:cubicBezTo>
                    <a:pt x="71" y="710"/>
                    <a:pt x="85" y="702"/>
                    <a:pt x="91" y="696"/>
                  </a:cubicBezTo>
                  <a:cubicBezTo>
                    <a:pt x="95" y="693"/>
                    <a:pt x="98" y="689"/>
                    <a:pt x="99" y="684"/>
                  </a:cubicBezTo>
                  <a:cubicBezTo>
                    <a:pt x="102" y="675"/>
                    <a:pt x="104" y="654"/>
                    <a:pt x="105" y="621"/>
                  </a:cubicBezTo>
                  <a:cubicBezTo>
                    <a:pt x="108" y="573"/>
                    <a:pt x="109" y="545"/>
                    <a:pt x="109" y="535"/>
                  </a:cubicBezTo>
                  <a:cubicBezTo>
                    <a:pt x="109" y="252"/>
                    <a:pt x="109" y="252"/>
                    <a:pt x="109" y="252"/>
                  </a:cubicBezTo>
                  <a:cubicBezTo>
                    <a:pt x="109" y="204"/>
                    <a:pt x="108" y="157"/>
                    <a:pt x="105" y="112"/>
                  </a:cubicBezTo>
                  <a:cubicBezTo>
                    <a:pt x="104" y="78"/>
                    <a:pt x="102" y="59"/>
                    <a:pt x="98" y="52"/>
                  </a:cubicBezTo>
                  <a:cubicBezTo>
                    <a:pt x="93" y="46"/>
                    <a:pt x="87" y="42"/>
                    <a:pt x="78" y="39"/>
                  </a:cubicBezTo>
                  <a:cubicBezTo>
                    <a:pt x="69" y="36"/>
                    <a:pt x="43" y="34"/>
                    <a:pt x="0" y="33"/>
                  </a:cubicBezTo>
                  <a:cubicBezTo>
                    <a:pt x="0" y="0"/>
                    <a:pt x="0" y="0"/>
                    <a:pt x="0" y="0"/>
                  </a:cubicBezTo>
                  <a:cubicBezTo>
                    <a:pt x="89" y="2"/>
                    <a:pt x="144" y="3"/>
                    <a:pt x="165" y="3"/>
                  </a:cubicBezTo>
                  <a:cubicBezTo>
                    <a:pt x="189" y="3"/>
                    <a:pt x="241" y="2"/>
                    <a:pt x="323" y="0"/>
                  </a:cubicBezTo>
                  <a:cubicBezTo>
                    <a:pt x="323" y="33"/>
                    <a:pt x="323" y="33"/>
                    <a:pt x="323" y="33"/>
                  </a:cubicBezTo>
                  <a:cubicBezTo>
                    <a:pt x="279" y="34"/>
                    <a:pt x="253" y="36"/>
                    <a:pt x="243" y="39"/>
                  </a:cubicBezTo>
                  <a:cubicBezTo>
                    <a:pt x="234" y="42"/>
                    <a:pt x="228" y="46"/>
                    <a:pt x="224" y="51"/>
                  </a:cubicBezTo>
                  <a:cubicBezTo>
                    <a:pt x="220" y="58"/>
                    <a:pt x="217" y="75"/>
                    <a:pt x="216" y="102"/>
                  </a:cubicBezTo>
                  <a:cubicBezTo>
                    <a:pt x="215" y="109"/>
                    <a:pt x="214" y="159"/>
                    <a:pt x="213" y="252"/>
                  </a:cubicBezTo>
                  <a:cubicBezTo>
                    <a:pt x="213" y="606"/>
                    <a:pt x="213" y="606"/>
                    <a:pt x="213" y="606"/>
                  </a:cubicBezTo>
                  <a:cubicBezTo>
                    <a:pt x="213" y="643"/>
                    <a:pt x="214" y="673"/>
                    <a:pt x="216" y="696"/>
                  </a:cubicBezTo>
                  <a:cubicBezTo>
                    <a:pt x="257" y="699"/>
                    <a:pt x="262" y="700"/>
                    <a:pt x="303" y="700"/>
                  </a:cubicBezTo>
                  <a:cubicBezTo>
                    <a:pt x="407" y="700"/>
                    <a:pt x="484" y="693"/>
                    <a:pt x="525" y="681"/>
                  </a:cubicBezTo>
                  <a:cubicBezTo>
                    <a:pt x="530" y="670"/>
                    <a:pt x="534" y="658"/>
                    <a:pt x="538" y="644"/>
                  </a:cubicBezTo>
                  <a:cubicBezTo>
                    <a:pt x="560" y="557"/>
                    <a:pt x="560" y="557"/>
                    <a:pt x="560" y="557"/>
                  </a:cubicBezTo>
                  <a:cubicBezTo>
                    <a:pt x="596" y="557"/>
                    <a:pt x="596" y="557"/>
                    <a:pt x="596" y="557"/>
                  </a:cubicBezTo>
                  <a:cubicBezTo>
                    <a:pt x="588" y="609"/>
                    <a:pt x="580" y="671"/>
                    <a:pt x="573" y="741"/>
                  </a:cubicBezTo>
                  <a:cubicBezTo>
                    <a:pt x="558" y="744"/>
                    <a:pt x="546" y="745"/>
                    <a:pt x="537" y="746"/>
                  </a:cubicBezTo>
                  <a:cubicBezTo>
                    <a:pt x="518" y="747"/>
                    <a:pt x="488" y="747"/>
                    <a:pt x="449" y="747"/>
                  </a:cubicBezTo>
                  <a:cubicBezTo>
                    <a:pt x="156" y="744"/>
                    <a:pt x="156" y="744"/>
                    <a:pt x="156" y="744"/>
                  </a:cubicBezTo>
                  <a:cubicBezTo>
                    <a:pt x="121" y="744"/>
                    <a:pt x="85" y="745"/>
                    <a:pt x="49"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3" name="Freeform 7"/>
            <p:cNvSpPr>
              <a:spLocks/>
            </p:cNvSpPr>
            <p:nvPr userDrawn="1"/>
          </p:nvSpPr>
          <p:spPr bwMode="auto">
            <a:xfrm>
              <a:off x="1127125" y="1003301"/>
              <a:ext cx="103188" cy="236538"/>
            </a:xfrm>
            <a:custGeom>
              <a:avLst/>
              <a:gdLst>
                <a:gd name="T0" fmla="*/ 321 w 321"/>
                <a:gd name="T1" fmla="*/ 714 h 747"/>
                <a:gd name="T2" fmla="*/ 321 w 321"/>
                <a:gd name="T3" fmla="*/ 747 h 747"/>
                <a:gd name="T4" fmla="*/ 168 w 321"/>
                <a:gd name="T5" fmla="*/ 744 h 747"/>
                <a:gd name="T6" fmla="*/ 0 w 321"/>
                <a:gd name="T7" fmla="*/ 747 h 747"/>
                <a:gd name="T8" fmla="*/ 0 w 321"/>
                <a:gd name="T9" fmla="*/ 714 h 747"/>
                <a:gd name="T10" fmla="*/ 77 w 321"/>
                <a:gd name="T11" fmla="*/ 708 h 747"/>
                <a:gd name="T12" fmla="*/ 97 w 321"/>
                <a:gd name="T13" fmla="*/ 696 h 747"/>
                <a:gd name="T14" fmla="*/ 105 w 321"/>
                <a:gd name="T15" fmla="*/ 645 h 747"/>
                <a:gd name="T16" fmla="*/ 108 w 321"/>
                <a:gd name="T17" fmla="*/ 495 h 747"/>
                <a:gd name="T18" fmla="*/ 108 w 321"/>
                <a:gd name="T19" fmla="*/ 251 h 747"/>
                <a:gd name="T20" fmla="*/ 105 w 321"/>
                <a:gd name="T21" fmla="*/ 111 h 747"/>
                <a:gd name="T22" fmla="*/ 97 w 321"/>
                <a:gd name="T23" fmla="*/ 52 h 747"/>
                <a:gd name="T24" fmla="*/ 77 w 321"/>
                <a:gd name="T25" fmla="*/ 39 h 747"/>
                <a:gd name="T26" fmla="*/ 0 w 321"/>
                <a:gd name="T27" fmla="*/ 33 h 747"/>
                <a:gd name="T28" fmla="*/ 0 w 321"/>
                <a:gd name="T29" fmla="*/ 0 h 747"/>
                <a:gd name="T30" fmla="*/ 161 w 321"/>
                <a:gd name="T31" fmla="*/ 3 h 747"/>
                <a:gd name="T32" fmla="*/ 321 w 321"/>
                <a:gd name="T33" fmla="*/ 0 h 747"/>
                <a:gd name="T34" fmla="*/ 321 w 321"/>
                <a:gd name="T35" fmla="*/ 33 h 747"/>
                <a:gd name="T36" fmla="*/ 243 w 321"/>
                <a:gd name="T37" fmla="*/ 39 h 747"/>
                <a:gd name="T38" fmla="*/ 224 w 321"/>
                <a:gd name="T39" fmla="*/ 51 h 747"/>
                <a:gd name="T40" fmla="*/ 216 w 321"/>
                <a:gd name="T41" fmla="*/ 102 h 747"/>
                <a:gd name="T42" fmla="*/ 212 w 321"/>
                <a:gd name="T43" fmla="*/ 251 h 747"/>
                <a:gd name="T44" fmla="*/ 212 w 321"/>
                <a:gd name="T45" fmla="*/ 495 h 747"/>
                <a:gd name="T46" fmla="*/ 214 w 321"/>
                <a:gd name="T47" fmla="*/ 635 h 747"/>
                <a:gd name="T48" fmla="*/ 222 w 321"/>
                <a:gd name="T49" fmla="*/ 694 h 747"/>
                <a:gd name="T50" fmla="*/ 242 w 321"/>
                <a:gd name="T51" fmla="*/ 708 h 747"/>
                <a:gd name="T52" fmla="*/ 321 w 321"/>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1" h="747">
                  <a:moveTo>
                    <a:pt x="321" y="714"/>
                  </a:moveTo>
                  <a:cubicBezTo>
                    <a:pt x="321" y="747"/>
                    <a:pt x="321" y="747"/>
                    <a:pt x="321" y="747"/>
                  </a:cubicBezTo>
                  <a:cubicBezTo>
                    <a:pt x="244" y="745"/>
                    <a:pt x="193" y="744"/>
                    <a:pt x="168" y="744"/>
                  </a:cubicBezTo>
                  <a:cubicBezTo>
                    <a:pt x="0" y="747"/>
                    <a:pt x="0" y="747"/>
                    <a:pt x="0" y="747"/>
                  </a:cubicBezTo>
                  <a:cubicBezTo>
                    <a:pt x="0" y="714"/>
                    <a:pt x="0" y="714"/>
                    <a:pt x="0" y="714"/>
                  </a:cubicBezTo>
                  <a:cubicBezTo>
                    <a:pt x="42" y="713"/>
                    <a:pt x="68" y="711"/>
                    <a:pt x="77" y="708"/>
                  </a:cubicBezTo>
                  <a:cubicBezTo>
                    <a:pt x="87" y="705"/>
                    <a:pt x="93" y="701"/>
                    <a:pt x="97" y="696"/>
                  </a:cubicBezTo>
                  <a:cubicBezTo>
                    <a:pt x="101" y="689"/>
                    <a:pt x="104" y="672"/>
                    <a:pt x="105" y="645"/>
                  </a:cubicBezTo>
                  <a:cubicBezTo>
                    <a:pt x="106" y="637"/>
                    <a:pt x="107" y="587"/>
                    <a:pt x="108" y="495"/>
                  </a:cubicBezTo>
                  <a:cubicBezTo>
                    <a:pt x="108" y="251"/>
                    <a:pt x="108" y="251"/>
                    <a:pt x="108" y="251"/>
                  </a:cubicBezTo>
                  <a:cubicBezTo>
                    <a:pt x="108" y="204"/>
                    <a:pt x="107" y="157"/>
                    <a:pt x="105" y="111"/>
                  </a:cubicBezTo>
                  <a:cubicBezTo>
                    <a:pt x="104" y="78"/>
                    <a:pt x="102" y="59"/>
                    <a:pt x="97" y="52"/>
                  </a:cubicBezTo>
                  <a:cubicBezTo>
                    <a:pt x="93" y="46"/>
                    <a:pt x="87" y="41"/>
                    <a:pt x="77" y="39"/>
                  </a:cubicBezTo>
                  <a:cubicBezTo>
                    <a:pt x="68" y="36"/>
                    <a:pt x="42" y="34"/>
                    <a:pt x="0" y="33"/>
                  </a:cubicBezTo>
                  <a:cubicBezTo>
                    <a:pt x="0" y="0"/>
                    <a:pt x="0" y="0"/>
                    <a:pt x="0" y="0"/>
                  </a:cubicBezTo>
                  <a:cubicBezTo>
                    <a:pt x="69" y="2"/>
                    <a:pt x="123" y="3"/>
                    <a:pt x="161" y="3"/>
                  </a:cubicBezTo>
                  <a:cubicBezTo>
                    <a:pt x="197" y="3"/>
                    <a:pt x="250" y="2"/>
                    <a:pt x="321" y="0"/>
                  </a:cubicBezTo>
                  <a:cubicBezTo>
                    <a:pt x="321" y="33"/>
                    <a:pt x="321" y="33"/>
                    <a:pt x="321" y="33"/>
                  </a:cubicBezTo>
                  <a:cubicBezTo>
                    <a:pt x="278" y="34"/>
                    <a:pt x="252" y="36"/>
                    <a:pt x="243" y="39"/>
                  </a:cubicBezTo>
                  <a:cubicBezTo>
                    <a:pt x="234" y="41"/>
                    <a:pt x="227" y="46"/>
                    <a:pt x="224" y="51"/>
                  </a:cubicBezTo>
                  <a:cubicBezTo>
                    <a:pt x="219" y="58"/>
                    <a:pt x="217" y="75"/>
                    <a:pt x="216" y="102"/>
                  </a:cubicBezTo>
                  <a:cubicBezTo>
                    <a:pt x="215" y="109"/>
                    <a:pt x="214" y="159"/>
                    <a:pt x="212" y="251"/>
                  </a:cubicBezTo>
                  <a:cubicBezTo>
                    <a:pt x="212" y="495"/>
                    <a:pt x="212" y="495"/>
                    <a:pt x="212" y="495"/>
                  </a:cubicBezTo>
                  <a:cubicBezTo>
                    <a:pt x="212" y="543"/>
                    <a:pt x="213" y="589"/>
                    <a:pt x="214" y="635"/>
                  </a:cubicBezTo>
                  <a:cubicBezTo>
                    <a:pt x="215" y="668"/>
                    <a:pt x="218" y="688"/>
                    <a:pt x="222" y="694"/>
                  </a:cubicBezTo>
                  <a:cubicBezTo>
                    <a:pt x="226" y="700"/>
                    <a:pt x="233" y="705"/>
                    <a:pt x="242" y="708"/>
                  </a:cubicBezTo>
                  <a:cubicBezTo>
                    <a:pt x="251" y="711"/>
                    <a:pt x="278" y="713"/>
                    <a:pt x="321"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4" name="Freeform 8"/>
            <p:cNvSpPr>
              <a:spLocks/>
            </p:cNvSpPr>
            <p:nvPr userDrawn="1"/>
          </p:nvSpPr>
          <p:spPr bwMode="auto">
            <a:xfrm>
              <a:off x="1266825" y="1003301"/>
              <a:ext cx="276225" cy="242888"/>
            </a:xfrm>
            <a:custGeom>
              <a:avLst/>
              <a:gdLst>
                <a:gd name="T0" fmla="*/ 5 w 869"/>
                <a:gd name="T1" fmla="*/ 747 h 766"/>
                <a:gd name="T2" fmla="*/ 5 w 869"/>
                <a:gd name="T3" fmla="*/ 714 h 766"/>
                <a:gd name="T4" fmla="*/ 80 w 869"/>
                <a:gd name="T5" fmla="*/ 705 h 766"/>
                <a:gd name="T6" fmla="*/ 91 w 869"/>
                <a:gd name="T7" fmla="*/ 695 h 766"/>
                <a:gd name="T8" fmla="*/ 99 w 869"/>
                <a:gd name="T9" fmla="*/ 640 h 766"/>
                <a:gd name="T10" fmla="*/ 102 w 869"/>
                <a:gd name="T11" fmla="*/ 520 h 766"/>
                <a:gd name="T12" fmla="*/ 102 w 869"/>
                <a:gd name="T13" fmla="*/ 92 h 766"/>
                <a:gd name="T14" fmla="*/ 100 w 869"/>
                <a:gd name="T15" fmla="*/ 69 h 766"/>
                <a:gd name="T16" fmla="*/ 80 w 869"/>
                <a:gd name="T17" fmla="*/ 47 h 766"/>
                <a:gd name="T18" fmla="*/ 57 w 869"/>
                <a:gd name="T19" fmla="*/ 36 h 766"/>
                <a:gd name="T20" fmla="*/ 0 w 869"/>
                <a:gd name="T21" fmla="*/ 33 h 766"/>
                <a:gd name="T22" fmla="*/ 0 w 869"/>
                <a:gd name="T23" fmla="*/ 0 h 766"/>
                <a:gd name="T24" fmla="*/ 119 w 869"/>
                <a:gd name="T25" fmla="*/ 3 h 766"/>
                <a:gd name="T26" fmla="*/ 202 w 869"/>
                <a:gd name="T27" fmla="*/ 0 h 766"/>
                <a:gd name="T28" fmla="*/ 269 w 869"/>
                <a:gd name="T29" fmla="*/ 86 h 766"/>
                <a:gd name="T30" fmla="*/ 381 w 869"/>
                <a:gd name="T31" fmla="*/ 220 h 766"/>
                <a:gd name="T32" fmla="*/ 545 w 869"/>
                <a:gd name="T33" fmla="*/ 411 h 766"/>
                <a:gd name="T34" fmla="*/ 671 w 869"/>
                <a:gd name="T35" fmla="*/ 554 h 766"/>
                <a:gd name="T36" fmla="*/ 721 w 869"/>
                <a:gd name="T37" fmla="*/ 609 h 766"/>
                <a:gd name="T38" fmla="*/ 721 w 869"/>
                <a:gd name="T39" fmla="*/ 226 h 766"/>
                <a:gd name="T40" fmla="*/ 718 w 869"/>
                <a:gd name="T41" fmla="*/ 105 h 766"/>
                <a:gd name="T42" fmla="*/ 711 w 869"/>
                <a:gd name="T43" fmla="*/ 51 h 766"/>
                <a:gd name="T44" fmla="*/ 699 w 869"/>
                <a:gd name="T45" fmla="*/ 41 h 766"/>
                <a:gd name="T46" fmla="*/ 624 w 869"/>
                <a:gd name="T47" fmla="*/ 33 h 766"/>
                <a:gd name="T48" fmla="*/ 624 w 869"/>
                <a:gd name="T49" fmla="*/ 0 h 766"/>
                <a:gd name="T50" fmla="*/ 756 w 869"/>
                <a:gd name="T51" fmla="*/ 3 h 766"/>
                <a:gd name="T52" fmla="*/ 869 w 869"/>
                <a:gd name="T53" fmla="*/ 0 h 766"/>
                <a:gd name="T54" fmla="*/ 869 w 869"/>
                <a:gd name="T55" fmla="*/ 33 h 766"/>
                <a:gd name="T56" fmla="*/ 794 w 869"/>
                <a:gd name="T57" fmla="*/ 41 h 766"/>
                <a:gd name="T58" fmla="*/ 783 w 869"/>
                <a:gd name="T59" fmla="*/ 52 h 766"/>
                <a:gd name="T60" fmla="*/ 775 w 869"/>
                <a:gd name="T61" fmla="*/ 107 h 766"/>
                <a:gd name="T62" fmla="*/ 772 w 869"/>
                <a:gd name="T63" fmla="*/ 226 h 766"/>
                <a:gd name="T64" fmla="*/ 772 w 869"/>
                <a:gd name="T65" fmla="*/ 479 h 766"/>
                <a:gd name="T66" fmla="*/ 775 w 869"/>
                <a:gd name="T67" fmla="*/ 766 h 766"/>
                <a:gd name="T68" fmla="*/ 721 w 869"/>
                <a:gd name="T69" fmla="*/ 766 h 766"/>
                <a:gd name="T70" fmla="*/ 707 w 869"/>
                <a:gd name="T71" fmla="*/ 752 h 766"/>
                <a:gd name="T72" fmla="*/ 698 w 869"/>
                <a:gd name="T73" fmla="*/ 744 h 766"/>
                <a:gd name="T74" fmla="*/ 678 w 869"/>
                <a:gd name="T75" fmla="*/ 723 h 766"/>
                <a:gd name="T76" fmla="*/ 611 w 869"/>
                <a:gd name="T77" fmla="*/ 647 h 766"/>
                <a:gd name="T78" fmla="*/ 540 w 869"/>
                <a:gd name="T79" fmla="*/ 560 h 766"/>
                <a:gd name="T80" fmla="*/ 151 w 869"/>
                <a:gd name="T81" fmla="*/ 110 h 766"/>
                <a:gd name="T82" fmla="*/ 151 w 869"/>
                <a:gd name="T83" fmla="*/ 518 h 766"/>
                <a:gd name="T84" fmla="*/ 154 w 869"/>
                <a:gd name="T85" fmla="*/ 641 h 766"/>
                <a:gd name="T86" fmla="*/ 161 w 869"/>
                <a:gd name="T87" fmla="*/ 695 h 766"/>
                <a:gd name="T88" fmla="*/ 173 w 869"/>
                <a:gd name="T89" fmla="*/ 705 h 766"/>
                <a:gd name="T90" fmla="*/ 249 w 869"/>
                <a:gd name="T91" fmla="*/ 714 h 766"/>
                <a:gd name="T92" fmla="*/ 249 w 869"/>
                <a:gd name="T93" fmla="*/ 747 h 766"/>
                <a:gd name="T94" fmla="*/ 143 w 869"/>
                <a:gd name="T95" fmla="*/ 744 h 766"/>
                <a:gd name="T96" fmla="*/ 5 w 869"/>
                <a:gd name="T97" fmla="*/ 747 h 76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869" h="766">
                  <a:moveTo>
                    <a:pt x="5" y="747"/>
                  </a:moveTo>
                  <a:cubicBezTo>
                    <a:pt x="5" y="714"/>
                    <a:pt x="5" y="714"/>
                    <a:pt x="5" y="714"/>
                  </a:cubicBezTo>
                  <a:cubicBezTo>
                    <a:pt x="43" y="714"/>
                    <a:pt x="68" y="711"/>
                    <a:pt x="80" y="705"/>
                  </a:cubicBezTo>
                  <a:cubicBezTo>
                    <a:pt x="86" y="703"/>
                    <a:pt x="89" y="700"/>
                    <a:pt x="91" y="695"/>
                  </a:cubicBezTo>
                  <a:cubicBezTo>
                    <a:pt x="95" y="688"/>
                    <a:pt x="98" y="670"/>
                    <a:pt x="99" y="640"/>
                  </a:cubicBezTo>
                  <a:cubicBezTo>
                    <a:pt x="101" y="594"/>
                    <a:pt x="102" y="554"/>
                    <a:pt x="102" y="520"/>
                  </a:cubicBezTo>
                  <a:cubicBezTo>
                    <a:pt x="102" y="92"/>
                    <a:pt x="102" y="92"/>
                    <a:pt x="102" y="92"/>
                  </a:cubicBezTo>
                  <a:cubicBezTo>
                    <a:pt x="102" y="80"/>
                    <a:pt x="102" y="73"/>
                    <a:pt x="100" y="69"/>
                  </a:cubicBezTo>
                  <a:cubicBezTo>
                    <a:pt x="97" y="63"/>
                    <a:pt x="91" y="56"/>
                    <a:pt x="80" y="47"/>
                  </a:cubicBezTo>
                  <a:cubicBezTo>
                    <a:pt x="74" y="41"/>
                    <a:pt x="66" y="38"/>
                    <a:pt x="57" y="36"/>
                  </a:cubicBezTo>
                  <a:cubicBezTo>
                    <a:pt x="49" y="34"/>
                    <a:pt x="30" y="33"/>
                    <a:pt x="0" y="33"/>
                  </a:cubicBezTo>
                  <a:cubicBezTo>
                    <a:pt x="0" y="0"/>
                    <a:pt x="0" y="0"/>
                    <a:pt x="0" y="0"/>
                  </a:cubicBezTo>
                  <a:cubicBezTo>
                    <a:pt x="63" y="2"/>
                    <a:pt x="103" y="3"/>
                    <a:pt x="119" y="3"/>
                  </a:cubicBezTo>
                  <a:cubicBezTo>
                    <a:pt x="147" y="3"/>
                    <a:pt x="174" y="2"/>
                    <a:pt x="202" y="0"/>
                  </a:cubicBezTo>
                  <a:cubicBezTo>
                    <a:pt x="232" y="39"/>
                    <a:pt x="255" y="67"/>
                    <a:pt x="269" y="86"/>
                  </a:cubicBezTo>
                  <a:cubicBezTo>
                    <a:pt x="381" y="220"/>
                    <a:pt x="381" y="220"/>
                    <a:pt x="381" y="220"/>
                  </a:cubicBezTo>
                  <a:cubicBezTo>
                    <a:pt x="545" y="411"/>
                    <a:pt x="545" y="411"/>
                    <a:pt x="545" y="411"/>
                  </a:cubicBezTo>
                  <a:cubicBezTo>
                    <a:pt x="597" y="472"/>
                    <a:pt x="639" y="520"/>
                    <a:pt x="671" y="554"/>
                  </a:cubicBezTo>
                  <a:cubicBezTo>
                    <a:pt x="691" y="578"/>
                    <a:pt x="708" y="596"/>
                    <a:pt x="721" y="609"/>
                  </a:cubicBezTo>
                  <a:cubicBezTo>
                    <a:pt x="721" y="226"/>
                    <a:pt x="721" y="226"/>
                    <a:pt x="721" y="226"/>
                  </a:cubicBezTo>
                  <a:cubicBezTo>
                    <a:pt x="721" y="191"/>
                    <a:pt x="720" y="151"/>
                    <a:pt x="718" y="105"/>
                  </a:cubicBezTo>
                  <a:cubicBezTo>
                    <a:pt x="717" y="76"/>
                    <a:pt x="714" y="58"/>
                    <a:pt x="711" y="51"/>
                  </a:cubicBezTo>
                  <a:cubicBezTo>
                    <a:pt x="708" y="46"/>
                    <a:pt x="705" y="43"/>
                    <a:pt x="699" y="41"/>
                  </a:cubicBezTo>
                  <a:cubicBezTo>
                    <a:pt x="687" y="36"/>
                    <a:pt x="662" y="33"/>
                    <a:pt x="624" y="33"/>
                  </a:cubicBezTo>
                  <a:cubicBezTo>
                    <a:pt x="624" y="0"/>
                    <a:pt x="624" y="0"/>
                    <a:pt x="624" y="0"/>
                  </a:cubicBezTo>
                  <a:cubicBezTo>
                    <a:pt x="667" y="2"/>
                    <a:pt x="711" y="3"/>
                    <a:pt x="756" y="3"/>
                  </a:cubicBezTo>
                  <a:cubicBezTo>
                    <a:pt x="797" y="3"/>
                    <a:pt x="835" y="2"/>
                    <a:pt x="869" y="0"/>
                  </a:cubicBezTo>
                  <a:cubicBezTo>
                    <a:pt x="869" y="33"/>
                    <a:pt x="869" y="33"/>
                    <a:pt x="869" y="33"/>
                  </a:cubicBezTo>
                  <a:cubicBezTo>
                    <a:pt x="831" y="33"/>
                    <a:pt x="806" y="36"/>
                    <a:pt x="794" y="41"/>
                  </a:cubicBezTo>
                  <a:cubicBezTo>
                    <a:pt x="789" y="43"/>
                    <a:pt x="785" y="47"/>
                    <a:pt x="783" y="52"/>
                  </a:cubicBezTo>
                  <a:cubicBezTo>
                    <a:pt x="779" y="58"/>
                    <a:pt x="776" y="77"/>
                    <a:pt x="775" y="107"/>
                  </a:cubicBezTo>
                  <a:cubicBezTo>
                    <a:pt x="773" y="153"/>
                    <a:pt x="772" y="193"/>
                    <a:pt x="772" y="226"/>
                  </a:cubicBezTo>
                  <a:cubicBezTo>
                    <a:pt x="772" y="479"/>
                    <a:pt x="772" y="479"/>
                    <a:pt x="772" y="479"/>
                  </a:cubicBezTo>
                  <a:cubicBezTo>
                    <a:pt x="772" y="531"/>
                    <a:pt x="773" y="626"/>
                    <a:pt x="775" y="766"/>
                  </a:cubicBezTo>
                  <a:cubicBezTo>
                    <a:pt x="721" y="766"/>
                    <a:pt x="721" y="766"/>
                    <a:pt x="721" y="766"/>
                  </a:cubicBezTo>
                  <a:cubicBezTo>
                    <a:pt x="707" y="752"/>
                    <a:pt x="707" y="752"/>
                    <a:pt x="707" y="752"/>
                  </a:cubicBezTo>
                  <a:cubicBezTo>
                    <a:pt x="705" y="751"/>
                    <a:pt x="700" y="746"/>
                    <a:pt x="698" y="744"/>
                  </a:cubicBezTo>
                  <a:cubicBezTo>
                    <a:pt x="696" y="742"/>
                    <a:pt x="689" y="735"/>
                    <a:pt x="678" y="723"/>
                  </a:cubicBezTo>
                  <a:cubicBezTo>
                    <a:pt x="647" y="689"/>
                    <a:pt x="625" y="664"/>
                    <a:pt x="611" y="647"/>
                  </a:cubicBezTo>
                  <a:cubicBezTo>
                    <a:pt x="540" y="560"/>
                    <a:pt x="540" y="560"/>
                    <a:pt x="540" y="560"/>
                  </a:cubicBezTo>
                  <a:cubicBezTo>
                    <a:pt x="151" y="110"/>
                    <a:pt x="151" y="110"/>
                    <a:pt x="151" y="110"/>
                  </a:cubicBezTo>
                  <a:cubicBezTo>
                    <a:pt x="151" y="518"/>
                    <a:pt x="151" y="518"/>
                    <a:pt x="151" y="518"/>
                  </a:cubicBezTo>
                  <a:cubicBezTo>
                    <a:pt x="151" y="552"/>
                    <a:pt x="152" y="593"/>
                    <a:pt x="154" y="641"/>
                  </a:cubicBezTo>
                  <a:cubicBezTo>
                    <a:pt x="156" y="670"/>
                    <a:pt x="158" y="688"/>
                    <a:pt x="161" y="695"/>
                  </a:cubicBezTo>
                  <a:cubicBezTo>
                    <a:pt x="164" y="700"/>
                    <a:pt x="168" y="704"/>
                    <a:pt x="173" y="705"/>
                  </a:cubicBezTo>
                  <a:cubicBezTo>
                    <a:pt x="185" y="711"/>
                    <a:pt x="210" y="714"/>
                    <a:pt x="249" y="714"/>
                  </a:cubicBezTo>
                  <a:cubicBezTo>
                    <a:pt x="249" y="747"/>
                    <a:pt x="249" y="747"/>
                    <a:pt x="249" y="747"/>
                  </a:cubicBezTo>
                  <a:cubicBezTo>
                    <a:pt x="217" y="745"/>
                    <a:pt x="181" y="744"/>
                    <a:pt x="143" y="744"/>
                  </a:cubicBezTo>
                  <a:cubicBezTo>
                    <a:pt x="100" y="744"/>
                    <a:pt x="54" y="745"/>
                    <a:pt x="5"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5" name="Freeform 9"/>
            <p:cNvSpPr>
              <a:spLocks/>
            </p:cNvSpPr>
            <p:nvPr userDrawn="1"/>
          </p:nvSpPr>
          <p:spPr bwMode="auto">
            <a:xfrm>
              <a:off x="1573213" y="1003301"/>
              <a:ext cx="101600" cy="236538"/>
            </a:xfrm>
            <a:custGeom>
              <a:avLst/>
              <a:gdLst>
                <a:gd name="T0" fmla="*/ 322 w 322"/>
                <a:gd name="T1" fmla="*/ 714 h 747"/>
                <a:gd name="T2" fmla="*/ 322 w 322"/>
                <a:gd name="T3" fmla="*/ 747 h 747"/>
                <a:gd name="T4" fmla="*/ 169 w 322"/>
                <a:gd name="T5" fmla="*/ 744 h 747"/>
                <a:gd name="T6" fmla="*/ 0 w 322"/>
                <a:gd name="T7" fmla="*/ 747 h 747"/>
                <a:gd name="T8" fmla="*/ 0 w 322"/>
                <a:gd name="T9" fmla="*/ 714 h 747"/>
                <a:gd name="T10" fmla="*/ 79 w 322"/>
                <a:gd name="T11" fmla="*/ 708 h 747"/>
                <a:gd name="T12" fmla="*/ 98 w 322"/>
                <a:gd name="T13" fmla="*/ 696 h 747"/>
                <a:gd name="T14" fmla="*/ 106 w 322"/>
                <a:gd name="T15" fmla="*/ 645 h 747"/>
                <a:gd name="T16" fmla="*/ 109 w 322"/>
                <a:gd name="T17" fmla="*/ 495 h 747"/>
                <a:gd name="T18" fmla="*/ 109 w 322"/>
                <a:gd name="T19" fmla="*/ 251 h 747"/>
                <a:gd name="T20" fmla="*/ 106 w 322"/>
                <a:gd name="T21" fmla="*/ 111 h 747"/>
                <a:gd name="T22" fmla="*/ 98 w 322"/>
                <a:gd name="T23" fmla="*/ 52 h 747"/>
                <a:gd name="T24" fmla="*/ 78 w 322"/>
                <a:gd name="T25" fmla="*/ 39 h 747"/>
                <a:gd name="T26" fmla="*/ 0 w 322"/>
                <a:gd name="T27" fmla="*/ 33 h 747"/>
                <a:gd name="T28" fmla="*/ 0 w 322"/>
                <a:gd name="T29" fmla="*/ 0 h 747"/>
                <a:gd name="T30" fmla="*/ 161 w 322"/>
                <a:gd name="T31" fmla="*/ 3 h 747"/>
                <a:gd name="T32" fmla="*/ 322 w 322"/>
                <a:gd name="T33" fmla="*/ 0 h 747"/>
                <a:gd name="T34" fmla="*/ 322 w 322"/>
                <a:gd name="T35" fmla="*/ 33 h 747"/>
                <a:gd name="T36" fmla="*/ 244 w 322"/>
                <a:gd name="T37" fmla="*/ 39 h 747"/>
                <a:gd name="T38" fmla="*/ 224 w 322"/>
                <a:gd name="T39" fmla="*/ 51 h 747"/>
                <a:gd name="T40" fmla="*/ 216 w 322"/>
                <a:gd name="T41" fmla="*/ 102 h 747"/>
                <a:gd name="T42" fmla="*/ 213 w 322"/>
                <a:gd name="T43" fmla="*/ 251 h 747"/>
                <a:gd name="T44" fmla="*/ 213 w 322"/>
                <a:gd name="T45" fmla="*/ 495 h 747"/>
                <a:gd name="T46" fmla="*/ 215 w 322"/>
                <a:gd name="T47" fmla="*/ 635 h 747"/>
                <a:gd name="T48" fmla="*/ 223 w 322"/>
                <a:gd name="T49" fmla="*/ 694 h 747"/>
                <a:gd name="T50" fmla="*/ 243 w 322"/>
                <a:gd name="T51" fmla="*/ 708 h 747"/>
                <a:gd name="T52" fmla="*/ 322 w 322"/>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2" h="747">
                  <a:moveTo>
                    <a:pt x="322" y="714"/>
                  </a:moveTo>
                  <a:cubicBezTo>
                    <a:pt x="322" y="747"/>
                    <a:pt x="322" y="747"/>
                    <a:pt x="322" y="747"/>
                  </a:cubicBezTo>
                  <a:cubicBezTo>
                    <a:pt x="244" y="745"/>
                    <a:pt x="193" y="744"/>
                    <a:pt x="169" y="744"/>
                  </a:cubicBezTo>
                  <a:cubicBezTo>
                    <a:pt x="0" y="747"/>
                    <a:pt x="0" y="747"/>
                    <a:pt x="0" y="747"/>
                  </a:cubicBezTo>
                  <a:cubicBezTo>
                    <a:pt x="0" y="714"/>
                    <a:pt x="0" y="714"/>
                    <a:pt x="0" y="714"/>
                  </a:cubicBezTo>
                  <a:cubicBezTo>
                    <a:pt x="43" y="713"/>
                    <a:pt x="69" y="711"/>
                    <a:pt x="79" y="708"/>
                  </a:cubicBezTo>
                  <a:cubicBezTo>
                    <a:pt x="88" y="705"/>
                    <a:pt x="94" y="701"/>
                    <a:pt x="98" y="696"/>
                  </a:cubicBezTo>
                  <a:cubicBezTo>
                    <a:pt x="102" y="689"/>
                    <a:pt x="105" y="672"/>
                    <a:pt x="106" y="645"/>
                  </a:cubicBezTo>
                  <a:cubicBezTo>
                    <a:pt x="107" y="637"/>
                    <a:pt x="108" y="587"/>
                    <a:pt x="109" y="495"/>
                  </a:cubicBezTo>
                  <a:cubicBezTo>
                    <a:pt x="109" y="251"/>
                    <a:pt x="109" y="251"/>
                    <a:pt x="109" y="251"/>
                  </a:cubicBezTo>
                  <a:cubicBezTo>
                    <a:pt x="109" y="204"/>
                    <a:pt x="108" y="157"/>
                    <a:pt x="106" y="111"/>
                  </a:cubicBezTo>
                  <a:cubicBezTo>
                    <a:pt x="105" y="78"/>
                    <a:pt x="102" y="59"/>
                    <a:pt x="98" y="52"/>
                  </a:cubicBezTo>
                  <a:cubicBezTo>
                    <a:pt x="94" y="46"/>
                    <a:pt x="88" y="41"/>
                    <a:pt x="78" y="39"/>
                  </a:cubicBezTo>
                  <a:cubicBezTo>
                    <a:pt x="69" y="36"/>
                    <a:pt x="43" y="34"/>
                    <a:pt x="0" y="33"/>
                  </a:cubicBezTo>
                  <a:cubicBezTo>
                    <a:pt x="0" y="0"/>
                    <a:pt x="0" y="0"/>
                    <a:pt x="0" y="0"/>
                  </a:cubicBezTo>
                  <a:cubicBezTo>
                    <a:pt x="70" y="2"/>
                    <a:pt x="124" y="3"/>
                    <a:pt x="161" y="3"/>
                  </a:cubicBezTo>
                  <a:cubicBezTo>
                    <a:pt x="198" y="3"/>
                    <a:pt x="251" y="2"/>
                    <a:pt x="322" y="0"/>
                  </a:cubicBezTo>
                  <a:cubicBezTo>
                    <a:pt x="322" y="33"/>
                    <a:pt x="322" y="33"/>
                    <a:pt x="322" y="33"/>
                  </a:cubicBezTo>
                  <a:cubicBezTo>
                    <a:pt x="279" y="34"/>
                    <a:pt x="253" y="36"/>
                    <a:pt x="244" y="39"/>
                  </a:cubicBezTo>
                  <a:cubicBezTo>
                    <a:pt x="234" y="41"/>
                    <a:pt x="228" y="46"/>
                    <a:pt x="224" y="51"/>
                  </a:cubicBezTo>
                  <a:cubicBezTo>
                    <a:pt x="220" y="58"/>
                    <a:pt x="217" y="75"/>
                    <a:pt x="216" y="102"/>
                  </a:cubicBezTo>
                  <a:cubicBezTo>
                    <a:pt x="216" y="109"/>
                    <a:pt x="215" y="159"/>
                    <a:pt x="213" y="251"/>
                  </a:cubicBezTo>
                  <a:cubicBezTo>
                    <a:pt x="213" y="495"/>
                    <a:pt x="213" y="495"/>
                    <a:pt x="213" y="495"/>
                  </a:cubicBezTo>
                  <a:cubicBezTo>
                    <a:pt x="213" y="543"/>
                    <a:pt x="214" y="589"/>
                    <a:pt x="215" y="635"/>
                  </a:cubicBezTo>
                  <a:cubicBezTo>
                    <a:pt x="216" y="668"/>
                    <a:pt x="219" y="688"/>
                    <a:pt x="223" y="694"/>
                  </a:cubicBezTo>
                  <a:cubicBezTo>
                    <a:pt x="227" y="700"/>
                    <a:pt x="234" y="705"/>
                    <a:pt x="243" y="708"/>
                  </a:cubicBezTo>
                  <a:cubicBezTo>
                    <a:pt x="252" y="711"/>
                    <a:pt x="278" y="713"/>
                    <a:pt x="322"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6" name="Freeform 10"/>
            <p:cNvSpPr>
              <a:spLocks/>
            </p:cNvSpPr>
            <p:nvPr userDrawn="1"/>
          </p:nvSpPr>
          <p:spPr bwMode="auto">
            <a:xfrm>
              <a:off x="1692275" y="998538"/>
              <a:ext cx="231775" cy="246063"/>
            </a:xfrm>
            <a:custGeom>
              <a:avLst/>
              <a:gdLst>
                <a:gd name="T0" fmla="*/ 728 w 728"/>
                <a:gd name="T1" fmla="*/ 667 h 774"/>
                <a:gd name="T2" fmla="*/ 707 w 728"/>
                <a:gd name="T3" fmla="*/ 716 h 774"/>
                <a:gd name="T4" fmla="*/ 581 w 728"/>
                <a:gd name="T5" fmla="*/ 761 h 774"/>
                <a:gd name="T6" fmla="*/ 447 w 728"/>
                <a:gd name="T7" fmla="*/ 774 h 774"/>
                <a:gd name="T8" fmla="*/ 288 w 728"/>
                <a:gd name="T9" fmla="*/ 754 h 774"/>
                <a:gd name="T10" fmla="*/ 161 w 728"/>
                <a:gd name="T11" fmla="*/ 696 h 774"/>
                <a:gd name="T12" fmla="*/ 71 w 728"/>
                <a:gd name="T13" fmla="*/ 610 h 774"/>
                <a:gd name="T14" fmla="*/ 18 w 728"/>
                <a:gd name="T15" fmla="*/ 508 h 774"/>
                <a:gd name="T16" fmla="*/ 0 w 728"/>
                <a:gd name="T17" fmla="*/ 386 h 774"/>
                <a:gd name="T18" fmla="*/ 123 w 728"/>
                <a:gd name="T19" fmla="*/ 110 h 774"/>
                <a:gd name="T20" fmla="*/ 457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5 w 728"/>
                <a:gd name="T35" fmla="*/ 143 h 774"/>
                <a:gd name="T36" fmla="*/ 605 w 728"/>
                <a:gd name="T37" fmla="*/ 66 h 774"/>
                <a:gd name="T38" fmla="*/ 446 w 728"/>
                <a:gd name="T39" fmla="*/ 41 h 774"/>
                <a:gd name="T40" fmla="*/ 313 w 728"/>
                <a:gd name="T41" fmla="*/ 60 h 774"/>
                <a:gd name="T42" fmla="*/ 217 w 728"/>
                <a:gd name="T43" fmla="*/ 117 h 774"/>
                <a:gd name="T44" fmla="*/ 149 w 728"/>
                <a:gd name="T45" fmla="*/ 216 h 774"/>
                <a:gd name="T46" fmla="*/ 122 w 728"/>
                <a:gd name="T47" fmla="*/ 366 h 774"/>
                <a:gd name="T48" fmla="*/ 223 w 728"/>
                <a:gd name="T49" fmla="*/ 621 h 774"/>
                <a:gd name="T50" fmla="*/ 492 w 728"/>
                <a:gd name="T51" fmla="*/ 717 h 774"/>
                <a:gd name="T52" fmla="*/ 632 w 728"/>
                <a:gd name="T53" fmla="*/ 698 h 774"/>
                <a:gd name="T54" fmla="*/ 719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7" y="716"/>
                    <a:pt x="707" y="716"/>
                    <a:pt x="707" y="716"/>
                  </a:cubicBezTo>
                  <a:cubicBezTo>
                    <a:pt x="664" y="736"/>
                    <a:pt x="622" y="751"/>
                    <a:pt x="581" y="761"/>
                  </a:cubicBezTo>
                  <a:cubicBezTo>
                    <a:pt x="540" y="770"/>
                    <a:pt x="495" y="774"/>
                    <a:pt x="447" y="774"/>
                  </a:cubicBezTo>
                  <a:cubicBezTo>
                    <a:pt x="390" y="774"/>
                    <a:pt x="337" y="768"/>
                    <a:pt x="288" y="754"/>
                  </a:cubicBezTo>
                  <a:cubicBezTo>
                    <a:pt x="240" y="740"/>
                    <a:pt x="197" y="721"/>
                    <a:pt x="161" y="696"/>
                  </a:cubicBezTo>
                  <a:cubicBezTo>
                    <a:pt x="124" y="670"/>
                    <a:pt x="94" y="642"/>
                    <a:pt x="71" y="610"/>
                  </a:cubicBezTo>
                  <a:cubicBezTo>
                    <a:pt x="48" y="579"/>
                    <a:pt x="31" y="545"/>
                    <a:pt x="18" y="508"/>
                  </a:cubicBezTo>
                  <a:cubicBezTo>
                    <a:pt x="6" y="471"/>
                    <a:pt x="0" y="430"/>
                    <a:pt x="0" y="386"/>
                  </a:cubicBezTo>
                  <a:cubicBezTo>
                    <a:pt x="0" y="275"/>
                    <a:pt x="41" y="183"/>
                    <a:pt x="123" y="110"/>
                  </a:cubicBezTo>
                  <a:cubicBezTo>
                    <a:pt x="204" y="37"/>
                    <a:pt x="316" y="0"/>
                    <a:pt x="457" y="0"/>
                  </a:cubicBezTo>
                  <a:cubicBezTo>
                    <a:pt x="490" y="0"/>
                    <a:pt x="521" y="2"/>
                    <a:pt x="549" y="6"/>
                  </a:cubicBezTo>
                  <a:cubicBezTo>
                    <a:pt x="578"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5" y="143"/>
                    <a:pt x="665" y="143"/>
                    <a:pt x="665" y="143"/>
                  </a:cubicBezTo>
                  <a:cubicBezTo>
                    <a:pt x="661" y="109"/>
                    <a:pt x="641" y="83"/>
                    <a:pt x="605" y="66"/>
                  </a:cubicBezTo>
                  <a:cubicBezTo>
                    <a:pt x="569" y="50"/>
                    <a:pt x="516" y="41"/>
                    <a:pt x="446" y="41"/>
                  </a:cubicBezTo>
                  <a:cubicBezTo>
                    <a:pt x="393" y="42"/>
                    <a:pt x="349" y="48"/>
                    <a:pt x="313" y="60"/>
                  </a:cubicBezTo>
                  <a:cubicBezTo>
                    <a:pt x="277" y="72"/>
                    <a:pt x="245" y="91"/>
                    <a:pt x="217" y="117"/>
                  </a:cubicBezTo>
                  <a:cubicBezTo>
                    <a:pt x="189" y="143"/>
                    <a:pt x="166" y="176"/>
                    <a:pt x="149" y="216"/>
                  </a:cubicBezTo>
                  <a:cubicBezTo>
                    <a:pt x="131" y="256"/>
                    <a:pt x="122" y="306"/>
                    <a:pt x="122" y="366"/>
                  </a:cubicBezTo>
                  <a:cubicBezTo>
                    <a:pt x="122" y="472"/>
                    <a:pt x="155" y="557"/>
                    <a:pt x="223" y="621"/>
                  </a:cubicBezTo>
                  <a:cubicBezTo>
                    <a:pt x="291" y="685"/>
                    <a:pt x="380" y="717"/>
                    <a:pt x="492" y="717"/>
                  </a:cubicBezTo>
                  <a:cubicBezTo>
                    <a:pt x="542" y="717"/>
                    <a:pt x="589" y="711"/>
                    <a:pt x="632" y="698"/>
                  </a:cubicBezTo>
                  <a:cubicBezTo>
                    <a:pt x="661" y="689"/>
                    <a:pt x="690" y="675"/>
                    <a:pt x="719"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7" name="Freeform 11"/>
            <p:cNvSpPr>
              <a:spLocks/>
            </p:cNvSpPr>
            <p:nvPr userDrawn="1"/>
          </p:nvSpPr>
          <p:spPr bwMode="auto">
            <a:xfrm>
              <a:off x="657225" y="998538"/>
              <a:ext cx="231775" cy="246063"/>
            </a:xfrm>
            <a:custGeom>
              <a:avLst/>
              <a:gdLst>
                <a:gd name="T0" fmla="*/ 728 w 728"/>
                <a:gd name="T1" fmla="*/ 667 h 774"/>
                <a:gd name="T2" fmla="*/ 706 w 728"/>
                <a:gd name="T3" fmla="*/ 716 h 774"/>
                <a:gd name="T4" fmla="*/ 580 w 728"/>
                <a:gd name="T5" fmla="*/ 761 h 774"/>
                <a:gd name="T6" fmla="*/ 446 w 728"/>
                <a:gd name="T7" fmla="*/ 774 h 774"/>
                <a:gd name="T8" fmla="*/ 288 w 728"/>
                <a:gd name="T9" fmla="*/ 754 h 774"/>
                <a:gd name="T10" fmla="*/ 160 w 728"/>
                <a:gd name="T11" fmla="*/ 696 h 774"/>
                <a:gd name="T12" fmla="*/ 71 w 728"/>
                <a:gd name="T13" fmla="*/ 610 h 774"/>
                <a:gd name="T14" fmla="*/ 18 w 728"/>
                <a:gd name="T15" fmla="*/ 508 h 774"/>
                <a:gd name="T16" fmla="*/ 0 w 728"/>
                <a:gd name="T17" fmla="*/ 386 h 774"/>
                <a:gd name="T18" fmla="*/ 122 w 728"/>
                <a:gd name="T19" fmla="*/ 110 h 774"/>
                <a:gd name="T20" fmla="*/ 456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4 w 728"/>
                <a:gd name="T35" fmla="*/ 143 h 774"/>
                <a:gd name="T36" fmla="*/ 604 w 728"/>
                <a:gd name="T37" fmla="*/ 66 h 774"/>
                <a:gd name="T38" fmla="*/ 445 w 728"/>
                <a:gd name="T39" fmla="*/ 41 h 774"/>
                <a:gd name="T40" fmla="*/ 313 w 728"/>
                <a:gd name="T41" fmla="*/ 60 h 774"/>
                <a:gd name="T42" fmla="*/ 216 w 728"/>
                <a:gd name="T43" fmla="*/ 117 h 774"/>
                <a:gd name="T44" fmla="*/ 148 w 728"/>
                <a:gd name="T45" fmla="*/ 216 h 774"/>
                <a:gd name="T46" fmla="*/ 121 w 728"/>
                <a:gd name="T47" fmla="*/ 366 h 774"/>
                <a:gd name="T48" fmla="*/ 223 w 728"/>
                <a:gd name="T49" fmla="*/ 621 h 774"/>
                <a:gd name="T50" fmla="*/ 492 w 728"/>
                <a:gd name="T51" fmla="*/ 717 h 774"/>
                <a:gd name="T52" fmla="*/ 631 w 728"/>
                <a:gd name="T53" fmla="*/ 698 h 774"/>
                <a:gd name="T54" fmla="*/ 718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6" y="716"/>
                    <a:pt x="706" y="716"/>
                    <a:pt x="706" y="716"/>
                  </a:cubicBezTo>
                  <a:cubicBezTo>
                    <a:pt x="663" y="736"/>
                    <a:pt x="621" y="751"/>
                    <a:pt x="580" y="761"/>
                  </a:cubicBezTo>
                  <a:cubicBezTo>
                    <a:pt x="539" y="770"/>
                    <a:pt x="495" y="774"/>
                    <a:pt x="446" y="774"/>
                  </a:cubicBezTo>
                  <a:cubicBezTo>
                    <a:pt x="389" y="774"/>
                    <a:pt x="337" y="768"/>
                    <a:pt x="288" y="754"/>
                  </a:cubicBezTo>
                  <a:cubicBezTo>
                    <a:pt x="239" y="740"/>
                    <a:pt x="197" y="721"/>
                    <a:pt x="160" y="696"/>
                  </a:cubicBezTo>
                  <a:cubicBezTo>
                    <a:pt x="124" y="670"/>
                    <a:pt x="94" y="642"/>
                    <a:pt x="71" y="610"/>
                  </a:cubicBezTo>
                  <a:cubicBezTo>
                    <a:pt x="48" y="579"/>
                    <a:pt x="30" y="545"/>
                    <a:pt x="18" y="508"/>
                  </a:cubicBezTo>
                  <a:cubicBezTo>
                    <a:pt x="6" y="471"/>
                    <a:pt x="0" y="430"/>
                    <a:pt x="0" y="386"/>
                  </a:cubicBezTo>
                  <a:cubicBezTo>
                    <a:pt x="0" y="275"/>
                    <a:pt x="41" y="183"/>
                    <a:pt x="122" y="110"/>
                  </a:cubicBezTo>
                  <a:cubicBezTo>
                    <a:pt x="204" y="37"/>
                    <a:pt x="315" y="0"/>
                    <a:pt x="456" y="0"/>
                  </a:cubicBezTo>
                  <a:cubicBezTo>
                    <a:pt x="490" y="0"/>
                    <a:pt x="520" y="2"/>
                    <a:pt x="549" y="6"/>
                  </a:cubicBezTo>
                  <a:cubicBezTo>
                    <a:pt x="577"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4" y="143"/>
                    <a:pt x="664" y="143"/>
                    <a:pt x="664" y="143"/>
                  </a:cubicBezTo>
                  <a:cubicBezTo>
                    <a:pt x="661" y="109"/>
                    <a:pt x="641" y="83"/>
                    <a:pt x="604" y="66"/>
                  </a:cubicBezTo>
                  <a:cubicBezTo>
                    <a:pt x="568" y="50"/>
                    <a:pt x="515" y="41"/>
                    <a:pt x="445" y="41"/>
                  </a:cubicBezTo>
                  <a:cubicBezTo>
                    <a:pt x="393" y="42"/>
                    <a:pt x="349" y="48"/>
                    <a:pt x="313" y="60"/>
                  </a:cubicBezTo>
                  <a:cubicBezTo>
                    <a:pt x="276" y="72"/>
                    <a:pt x="244" y="91"/>
                    <a:pt x="216" y="117"/>
                  </a:cubicBezTo>
                  <a:cubicBezTo>
                    <a:pt x="189" y="143"/>
                    <a:pt x="166" y="176"/>
                    <a:pt x="148" y="216"/>
                  </a:cubicBezTo>
                  <a:cubicBezTo>
                    <a:pt x="131" y="256"/>
                    <a:pt x="122" y="306"/>
                    <a:pt x="121" y="366"/>
                  </a:cubicBezTo>
                  <a:cubicBezTo>
                    <a:pt x="121" y="472"/>
                    <a:pt x="155" y="557"/>
                    <a:pt x="223" y="621"/>
                  </a:cubicBezTo>
                  <a:cubicBezTo>
                    <a:pt x="290" y="685"/>
                    <a:pt x="380" y="717"/>
                    <a:pt x="492" y="717"/>
                  </a:cubicBezTo>
                  <a:cubicBezTo>
                    <a:pt x="542" y="717"/>
                    <a:pt x="588" y="711"/>
                    <a:pt x="631" y="698"/>
                  </a:cubicBezTo>
                  <a:cubicBezTo>
                    <a:pt x="660" y="689"/>
                    <a:pt x="689" y="675"/>
                    <a:pt x="718"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8" name="Freeform 12"/>
            <p:cNvSpPr>
              <a:spLocks/>
            </p:cNvSpPr>
            <p:nvPr userDrawn="1"/>
          </p:nvSpPr>
          <p:spPr bwMode="auto">
            <a:xfrm>
              <a:off x="757238" y="687388"/>
              <a:ext cx="323850" cy="239713"/>
            </a:xfrm>
            <a:custGeom>
              <a:avLst/>
              <a:gdLst>
                <a:gd name="T0" fmla="*/ 0 w 1017"/>
                <a:gd name="T1" fmla="*/ 35 h 754"/>
                <a:gd name="T2" fmla="*/ 0 w 1017"/>
                <a:gd name="T3" fmla="*/ 0 h 754"/>
                <a:gd name="T4" fmla="*/ 110 w 1017"/>
                <a:gd name="T5" fmla="*/ 4 h 754"/>
                <a:gd name="T6" fmla="*/ 212 w 1017"/>
                <a:gd name="T7" fmla="*/ 0 h 754"/>
                <a:gd name="T8" fmla="*/ 300 w 1017"/>
                <a:gd name="T9" fmla="*/ 183 h 754"/>
                <a:gd name="T10" fmla="*/ 509 w 1017"/>
                <a:gd name="T11" fmla="*/ 592 h 754"/>
                <a:gd name="T12" fmla="*/ 697 w 1017"/>
                <a:gd name="T13" fmla="*/ 218 h 754"/>
                <a:gd name="T14" fmla="*/ 800 w 1017"/>
                <a:gd name="T15" fmla="*/ 0 h 754"/>
                <a:gd name="T16" fmla="*/ 898 w 1017"/>
                <a:gd name="T17" fmla="*/ 4 h 754"/>
                <a:gd name="T18" fmla="*/ 1017 w 1017"/>
                <a:gd name="T19" fmla="*/ 0 h 754"/>
                <a:gd name="T20" fmla="*/ 1017 w 1017"/>
                <a:gd name="T21" fmla="*/ 35 h 754"/>
                <a:gd name="T22" fmla="*/ 938 w 1017"/>
                <a:gd name="T23" fmla="*/ 40 h 754"/>
                <a:gd name="T24" fmla="*/ 918 w 1017"/>
                <a:gd name="T25" fmla="*/ 53 h 754"/>
                <a:gd name="T26" fmla="*/ 910 w 1017"/>
                <a:gd name="T27" fmla="*/ 103 h 754"/>
                <a:gd name="T28" fmla="*/ 907 w 1017"/>
                <a:gd name="T29" fmla="*/ 251 h 754"/>
                <a:gd name="T30" fmla="*/ 907 w 1017"/>
                <a:gd name="T31" fmla="*/ 492 h 754"/>
                <a:gd name="T32" fmla="*/ 910 w 1017"/>
                <a:gd name="T33" fmla="*/ 631 h 754"/>
                <a:gd name="T34" fmla="*/ 918 w 1017"/>
                <a:gd name="T35" fmla="*/ 690 h 754"/>
                <a:gd name="T36" fmla="*/ 938 w 1017"/>
                <a:gd name="T37" fmla="*/ 704 h 754"/>
                <a:gd name="T38" fmla="*/ 1017 w 1017"/>
                <a:gd name="T39" fmla="*/ 709 h 754"/>
                <a:gd name="T40" fmla="*/ 1017 w 1017"/>
                <a:gd name="T41" fmla="*/ 743 h 754"/>
                <a:gd name="T42" fmla="*/ 861 w 1017"/>
                <a:gd name="T43" fmla="*/ 739 h 754"/>
                <a:gd name="T44" fmla="*/ 699 w 1017"/>
                <a:gd name="T45" fmla="*/ 743 h 754"/>
                <a:gd name="T46" fmla="*/ 699 w 1017"/>
                <a:gd name="T47" fmla="*/ 709 h 754"/>
                <a:gd name="T48" fmla="*/ 778 w 1017"/>
                <a:gd name="T49" fmla="*/ 704 h 754"/>
                <a:gd name="T50" fmla="*/ 797 w 1017"/>
                <a:gd name="T51" fmla="*/ 691 h 754"/>
                <a:gd name="T52" fmla="*/ 806 w 1017"/>
                <a:gd name="T53" fmla="*/ 641 h 754"/>
                <a:gd name="T54" fmla="*/ 808 w 1017"/>
                <a:gd name="T55" fmla="*/ 492 h 754"/>
                <a:gd name="T56" fmla="*/ 808 w 1017"/>
                <a:gd name="T57" fmla="*/ 108 h 754"/>
                <a:gd name="T58" fmla="*/ 619 w 1017"/>
                <a:gd name="T59" fmla="*/ 486 h 754"/>
                <a:gd name="T60" fmla="*/ 549 w 1017"/>
                <a:gd name="T61" fmla="*/ 629 h 754"/>
                <a:gd name="T62" fmla="*/ 494 w 1017"/>
                <a:gd name="T63" fmla="*/ 754 h 754"/>
                <a:gd name="T64" fmla="*/ 472 w 1017"/>
                <a:gd name="T65" fmla="*/ 754 h 754"/>
                <a:gd name="T66" fmla="*/ 459 w 1017"/>
                <a:gd name="T67" fmla="*/ 722 h 754"/>
                <a:gd name="T68" fmla="*/ 422 w 1017"/>
                <a:gd name="T69" fmla="*/ 645 h 754"/>
                <a:gd name="T70" fmla="*/ 159 w 1017"/>
                <a:gd name="T71" fmla="*/ 126 h 754"/>
                <a:gd name="T72" fmla="*/ 159 w 1017"/>
                <a:gd name="T73" fmla="*/ 492 h 754"/>
                <a:gd name="T74" fmla="*/ 163 w 1017"/>
                <a:gd name="T75" fmla="*/ 631 h 754"/>
                <a:gd name="T76" fmla="*/ 171 w 1017"/>
                <a:gd name="T77" fmla="*/ 690 h 754"/>
                <a:gd name="T78" fmla="*/ 191 w 1017"/>
                <a:gd name="T79" fmla="*/ 704 h 754"/>
                <a:gd name="T80" fmla="*/ 271 w 1017"/>
                <a:gd name="T81" fmla="*/ 709 h 754"/>
                <a:gd name="T82" fmla="*/ 271 w 1017"/>
                <a:gd name="T83" fmla="*/ 743 h 754"/>
                <a:gd name="T84" fmla="*/ 138 w 1017"/>
                <a:gd name="T85" fmla="*/ 739 h 754"/>
                <a:gd name="T86" fmla="*/ 0 w 1017"/>
                <a:gd name="T87" fmla="*/ 743 h 754"/>
                <a:gd name="T88" fmla="*/ 0 w 1017"/>
                <a:gd name="T89" fmla="*/ 709 h 754"/>
                <a:gd name="T90" fmla="*/ 79 w 1017"/>
                <a:gd name="T91" fmla="*/ 704 h 754"/>
                <a:gd name="T92" fmla="*/ 98 w 1017"/>
                <a:gd name="T93" fmla="*/ 691 h 754"/>
                <a:gd name="T94" fmla="*/ 107 w 1017"/>
                <a:gd name="T95" fmla="*/ 641 h 754"/>
                <a:gd name="T96" fmla="*/ 109 w 1017"/>
                <a:gd name="T97" fmla="*/ 492 h 754"/>
                <a:gd name="T98" fmla="*/ 109 w 1017"/>
                <a:gd name="T99" fmla="*/ 251 h 754"/>
                <a:gd name="T100" fmla="*/ 107 w 1017"/>
                <a:gd name="T101" fmla="*/ 112 h 754"/>
                <a:gd name="T102" fmla="*/ 99 w 1017"/>
                <a:gd name="T103" fmla="*/ 54 h 754"/>
                <a:gd name="T104" fmla="*/ 78 w 1017"/>
                <a:gd name="T105" fmla="*/ 40 h 754"/>
                <a:gd name="T106" fmla="*/ 0 w 1017"/>
                <a:gd name="T107" fmla="*/ 35 h 75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Lst>
              <a:rect l="0" t="0" r="r" b="b"/>
              <a:pathLst>
                <a:path w="1017" h="754">
                  <a:moveTo>
                    <a:pt x="0" y="35"/>
                  </a:moveTo>
                  <a:cubicBezTo>
                    <a:pt x="0" y="0"/>
                    <a:pt x="0" y="0"/>
                    <a:pt x="0" y="0"/>
                  </a:cubicBezTo>
                  <a:cubicBezTo>
                    <a:pt x="38" y="2"/>
                    <a:pt x="75" y="4"/>
                    <a:pt x="110" y="4"/>
                  </a:cubicBezTo>
                  <a:cubicBezTo>
                    <a:pt x="145" y="4"/>
                    <a:pt x="179" y="2"/>
                    <a:pt x="212" y="0"/>
                  </a:cubicBezTo>
                  <a:cubicBezTo>
                    <a:pt x="244" y="70"/>
                    <a:pt x="274" y="131"/>
                    <a:pt x="300" y="183"/>
                  </a:cubicBezTo>
                  <a:cubicBezTo>
                    <a:pt x="509" y="592"/>
                    <a:pt x="509" y="592"/>
                    <a:pt x="509" y="592"/>
                  </a:cubicBezTo>
                  <a:cubicBezTo>
                    <a:pt x="697" y="218"/>
                    <a:pt x="697" y="218"/>
                    <a:pt x="697" y="218"/>
                  </a:cubicBezTo>
                  <a:cubicBezTo>
                    <a:pt x="749" y="116"/>
                    <a:pt x="783" y="43"/>
                    <a:pt x="800" y="0"/>
                  </a:cubicBezTo>
                  <a:cubicBezTo>
                    <a:pt x="839" y="2"/>
                    <a:pt x="872" y="4"/>
                    <a:pt x="898" y="4"/>
                  </a:cubicBezTo>
                  <a:cubicBezTo>
                    <a:pt x="923" y="4"/>
                    <a:pt x="962" y="2"/>
                    <a:pt x="1017" y="0"/>
                  </a:cubicBezTo>
                  <a:cubicBezTo>
                    <a:pt x="1017" y="35"/>
                    <a:pt x="1017" y="35"/>
                    <a:pt x="1017" y="35"/>
                  </a:cubicBezTo>
                  <a:cubicBezTo>
                    <a:pt x="974" y="35"/>
                    <a:pt x="947" y="37"/>
                    <a:pt x="938" y="40"/>
                  </a:cubicBezTo>
                  <a:cubicBezTo>
                    <a:pt x="928" y="43"/>
                    <a:pt x="922" y="47"/>
                    <a:pt x="918" y="53"/>
                  </a:cubicBezTo>
                  <a:cubicBezTo>
                    <a:pt x="914" y="60"/>
                    <a:pt x="911" y="76"/>
                    <a:pt x="910" y="103"/>
                  </a:cubicBezTo>
                  <a:cubicBezTo>
                    <a:pt x="910" y="110"/>
                    <a:pt x="909" y="159"/>
                    <a:pt x="907" y="251"/>
                  </a:cubicBezTo>
                  <a:cubicBezTo>
                    <a:pt x="907" y="492"/>
                    <a:pt x="907" y="492"/>
                    <a:pt x="907" y="492"/>
                  </a:cubicBezTo>
                  <a:cubicBezTo>
                    <a:pt x="907" y="540"/>
                    <a:pt x="908" y="586"/>
                    <a:pt x="910" y="631"/>
                  </a:cubicBezTo>
                  <a:cubicBezTo>
                    <a:pt x="911" y="664"/>
                    <a:pt x="914" y="684"/>
                    <a:pt x="918" y="690"/>
                  </a:cubicBezTo>
                  <a:cubicBezTo>
                    <a:pt x="922" y="696"/>
                    <a:pt x="929" y="701"/>
                    <a:pt x="938" y="704"/>
                  </a:cubicBezTo>
                  <a:cubicBezTo>
                    <a:pt x="948" y="707"/>
                    <a:pt x="974" y="709"/>
                    <a:pt x="1017" y="709"/>
                  </a:cubicBezTo>
                  <a:cubicBezTo>
                    <a:pt x="1017" y="743"/>
                    <a:pt x="1017" y="743"/>
                    <a:pt x="1017" y="743"/>
                  </a:cubicBezTo>
                  <a:cubicBezTo>
                    <a:pt x="943" y="740"/>
                    <a:pt x="891" y="739"/>
                    <a:pt x="861" y="739"/>
                  </a:cubicBezTo>
                  <a:cubicBezTo>
                    <a:pt x="837" y="739"/>
                    <a:pt x="782" y="740"/>
                    <a:pt x="699" y="743"/>
                  </a:cubicBezTo>
                  <a:cubicBezTo>
                    <a:pt x="699" y="709"/>
                    <a:pt x="699" y="709"/>
                    <a:pt x="699" y="709"/>
                  </a:cubicBezTo>
                  <a:cubicBezTo>
                    <a:pt x="742" y="709"/>
                    <a:pt x="768" y="707"/>
                    <a:pt x="778" y="704"/>
                  </a:cubicBezTo>
                  <a:cubicBezTo>
                    <a:pt x="788" y="701"/>
                    <a:pt x="794" y="697"/>
                    <a:pt x="797" y="691"/>
                  </a:cubicBezTo>
                  <a:cubicBezTo>
                    <a:pt x="802" y="684"/>
                    <a:pt x="805" y="668"/>
                    <a:pt x="806" y="641"/>
                  </a:cubicBezTo>
                  <a:cubicBezTo>
                    <a:pt x="806" y="633"/>
                    <a:pt x="807" y="584"/>
                    <a:pt x="808" y="492"/>
                  </a:cubicBezTo>
                  <a:cubicBezTo>
                    <a:pt x="808" y="108"/>
                    <a:pt x="808" y="108"/>
                    <a:pt x="808" y="108"/>
                  </a:cubicBezTo>
                  <a:cubicBezTo>
                    <a:pt x="619" y="486"/>
                    <a:pt x="619" y="486"/>
                    <a:pt x="619" y="486"/>
                  </a:cubicBezTo>
                  <a:cubicBezTo>
                    <a:pt x="589" y="545"/>
                    <a:pt x="566" y="593"/>
                    <a:pt x="549" y="629"/>
                  </a:cubicBezTo>
                  <a:cubicBezTo>
                    <a:pt x="537" y="655"/>
                    <a:pt x="518" y="696"/>
                    <a:pt x="494" y="754"/>
                  </a:cubicBezTo>
                  <a:cubicBezTo>
                    <a:pt x="472" y="754"/>
                    <a:pt x="472" y="754"/>
                    <a:pt x="472" y="754"/>
                  </a:cubicBezTo>
                  <a:cubicBezTo>
                    <a:pt x="468" y="740"/>
                    <a:pt x="463" y="729"/>
                    <a:pt x="459" y="722"/>
                  </a:cubicBezTo>
                  <a:cubicBezTo>
                    <a:pt x="422" y="645"/>
                    <a:pt x="422" y="645"/>
                    <a:pt x="422" y="645"/>
                  </a:cubicBezTo>
                  <a:cubicBezTo>
                    <a:pt x="159" y="126"/>
                    <a:pt x="159" y="126"/>
                    <a:pt x="159" y="126"/>
                  </a:cubicBezTo>
                  <a:cubicBezTo>
                    <a:pt x="159" y="492"/>
                    <a:pt x="159" y="492"/>
                    <a:pt x="159" y="492"/>
                  </a:cubicBezTo>
                  <a:cubicBezTo>
                    <a:pt x="159" y="540"/>
                    <a:pt x="160" y="586"/>
                    <a:pt x="163" y="631"/>
                  </a:cubicBezTo>
                  <a:cubicBezTo>
                    <a:pt x="164" y="664"/>
                    <a:pt x="167" y="683"/>
                    <a:pt x="171" y="690"/>
                  </a:cubicBezTo>
                  <a:cubicBezTo>
                    <a:pt x="175" y="696"/>
                    <a:pt x="182" y="701"/>
                    <a:pt x="191" y="704"/>
                  </a:cubicBezTo>
                  <a:cubicBezTo>
                    <a:pt x="200" y="707"/>
                    <a:pt x="227" y="709"/>
                    <a:pt x="271" y="709"/>
                  </a:cubicBezTo>
                  <a:cubicBezTo>
                    <a:pt x="271" y="743"/>
                    <a:pt x="271" y="743"/>
                    <a:pt x="271" y="743"/>
                  </a:cubicBezTo>
                  <a:cubicBezTo>
                    <a:pt x="138" y="739"/>
                    <a:pt x="138" y="739"/>
                    <a:pt x="138" y="739"/>
                  </a:cubicBezTo>
                  <a:cubicBezTo>
                    <a:pt x="0" y="743"/>
                    <a:pt x="0" y="743"/>
                    <a:pt x="0" y="743"/>
                  </a:cubicBezTo>
                  <a:cubicBezTo>
                    <a:pt x="0" y="709"/>
                    <a:pt x="0" y="709"/>
                    <a:pt x="0" y="709"/>
                  </a:cubicBezTo>
                  <a:cubicBezTo>
                    <a:pt x="43" y="709"/>
                    <a:pt x="69" y="707"/>
                    <a:pt x="79" y="704"/>
                  </a:cubicBezTo>
                  <a:cubicBezTo>
                    <a:pt x="88" y="701"/>
                    <a:pt x="95" y="697"/>
                    <a:pt x="98" y="691"/>
                  </a:cubicBezTo>
                  <a:cubicBezTo>
                    <a:pt x="103" y="684"/>
                    <a:pt x="105" y="668"/>
                    <a:pt x="107" y="641"/>
                  </a:cubicBezTo>
                  <a:cubicBezTo>
                    <a:pt x="107" y="634"/>
                    <a:pt x="108" y="584"/>
                    <a:pt x="109" y="492"/>
                  </a:cubicBezTo>
                  <a:cubicBezTo>
                    <a:pt x="109" y="251"/>
                    <a:pt x="109" y="251"/>
                    <a:pt x="109" y="251"/>
                  </a:cubicBezTo>
                  <a:cubicBezTo>
                    <a:pt x="109" y="204"/>
                    <a:pt x="108" y="158"/>
                    <a:pt x="107" y="112"/>
                  </a:cubicBezTo>
                  <a:cubicBezTo>
                    <a:pt x="105" y="79"/>
                    <a:pt x="103" y="60"/>
                    <a:pt x="99" y="54"/>
                  </a:cubicBezTo>
                  <a:cubicBezTo>
                    <a:pt x="94" y="48"/>
                    <a:pt x="88" y="43"/>
                    <a:pt x="78" y="40"/>
                  </a:cubicBezTo>
                  <a:cubicBezTo>
                    <a:pt x="69" y="37"/>
                    <a:pt x="43" y="35"/>
                    <a:pt x="0" y="35"/>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9" name="Freeform 13"/>
            <p:cNvSpPr>
              <a:spLocks noEditPoints="1"/>
            </p:cNvSpPr>
            <p:nvPr userDrawn="1"/>
          </p:nvSpPr>
          <p:spPr bwMode="auto">
            <a:xfrm>
              <a:off x="1092200" y="684213"/>
              <a:ext cx="263525" cy="238125"/>
            </a:xfrm>
            <a:custGeom>
              <a:avLst/>
              <a:gdLst>
                <a:gd name="T0" fmla="*/ 117 w 832"/>
                <a:gd name="T1" fmla="*/ 747 h 750"/>
                <a:gd name="T2" fmla="*/ 257 w 832"/>
                <a:gd name="T3" fmla="*/ 750 h 750"/>
                <a:gd name="T4" fmla="*/ 257 w 832"/>
                <a:gd name="T5" fmla="*/ 717 h 750"/>
                <a:gd name="T6" fmla="*/ 185 w 832"/>
                <a:gd name="T7" fmla="*/ 712 h 750"/>
                <a:gd name="T8" fmla="*/ 166 w 832"/>
                <a:gd name="T9" fmla="*/ 702 h 750"/>
                <a:gd name="T10" fmla="*/ 162 w 832"/>
                <a:gd name="T11" fmla="*/ 690 h 750"/>
                <a:gd name="T12" fmla="*/ 178 w 832"/>
                <a:gd name="T13" fmla="*/ 637 h 750"/>
                <a:gd name="T14" fmla="*/ 237 w 832"/>
                <a:gd name="T15" fmla="*/ 503 h 750"/>
                <a:gd name="T16" fmla="*/ 556 w 832"/>
                <a:gd name="T17" fmla="*/ 503 h 750"/>
                <a:gd name="T18" fmla="*/ 624 w 832"/>
                <a:gd name="T19" fmla="*/ 663 h 750"/>
                <a:gd name="T20" fmla="*/ 632 w 832"/>
                <a:gd name="T21" fmla="*/ 693 h 750"/>
                <a:gd name="T22" fmla="*/ 627 w 832"/>
                <a:gd name="T23" fmla="*/ 705 h 750"/>
                <a:gd name="T24" fmla="*/ 609 w 832"/>
                <a:gd name="T25" fmla="*/ 713 h 750"/>
                <a:gd name="T26" fmla="*/ 535 w 832"/>
                <a:gd name="T27" fmla="*/ 717 h 750"/>
                <a:gd name="T28" fmla="*/ 535 w 832"/>
                <a:gd name="T29" fmla="*/ 750 h 750"/>
                <a:gd name="T30" fmla="*/ 712 w 832"/>
                <a:gd name="T31" fmla="*/ 747 h 750"/>
                <a:gd name="T32" fmla="*/ 832 w 832"/>
                <a:gd name="T33" fmla="*/ 750 h 750"/>
                <a:gd name="T34" fmla="*/ 832 w 832"/>
                <a:gd name="T35" fmla="*/ 717 h 750"/>
                <a:gd name="T36" fmla="*/ 776 w 832"/>
                <a:gd name="T37" fmla="*/ 710 h 750"/>
                <a:gd name="T38" fmla="*/ 753 w 832"/>
                <a:gd name="T39" fmla="*/ 687 h 750"/>
                <a:gd name="T40" fmla="*/ 677 w 832"/>
                <a:gd name="T41" fmla="*/ 526 h 750"/>
                <a:gd name="T42" fmla="*/ 441 w 832"/>
                <a:gd name="T43" fmla="*/ 0 h 750"/>
                <a:gd name="T44" fmla="*/ 406 w 832"/>
                <a:gd name="T45" fmla="*/ 0 h 750"/>
                <a:gd name="T46" fmla="*/ 310 w 832"/>
                <a:gd name="T47" fmla="*/ 217 h 750"/>
                <a:gd name="T48" fmla="*/ 172 w 832"/>
                <a:gd name="T49" fmla="*/ 512 h 750"/>
                <a:gd name="T50" fmla="*/ 100 w 832"/>
                <a:gd name="T51" fmla="*/ 660 h 750"/>
                <a:gd name="T52" fmla="*/ 74 w 832"/>
                <a:gd name="T53" fmla="*/ 702 h 750"/>
                <a:gd name="T54" fmla="*/ 54 w 832"/>
                <a:gd name="T55" fmla="*/ 713 h 750"/>
                <a:gd name="T56" fmla="*/ 0 w 832"/>
                <a:gd name="T57" fmla="*/ 717 h 750"/>
                <a:gd name="T58" fmla="*/ 0 w 832"/>
                <a:gd name="T59" fmla="*/ 750 h 750"/>
                <a:gd name="T60" fmla="*/ 117 w 832"/>
                <a:gd name="T61" fmla="*/ 747 h 750"/>
                <a:gd name="T62" fmla="*/ 396 w 832"/>
                <a:gd name="T63" fmla="*/ 143 h 750"/>
                <a:gd name="T64" fmla="*/ 534 w 832"/>
                <a:gd name="T65" fmla="*/ 458 h 750"/>
                <a:gd name="T66" fmla="*/ 256 w 832"/>
                <a:gd name="T67" fmla="*/ 458 h 750"/>
                <a:gd name="T68" fmla="*/ 396 w 832"/>
                <a:gd name="T69" fmla="*/ 143 h 75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Lst>
              <a:rect l="0" t="0" r="r" b="b"/>
              <a:pathLst>
                <a:path w="832" h="750">
                  <a:moveTo>
                    <a:pt x="117" y="747"/>
                  </a:moveTo>
                  <a:cubicBezTo>
                    <a:pt x="148" y="747"/>
                    <a:pt x="195" y="748"/>
                    <a:pt x="257" y="750"/>
                  </a:cubicBezTo>
                  <a:cubicBezTo>
                    <a:pt x="257" y="717"/>
                    <a:pt x="257" y="717"/>
                    <a:pt x="257" y="717"/>
                  </a:cubicBezTo>
                  <a:cubicBezTo>
                    <a:pt x="222" y="716"/>
                    <a:pt x="199" y="715"/>
                    <a:pt x="185" y="712"/>
                  </a:cubicBezTo>
                  <a:cubicBezTo>
                    <a:pt x="177" y="710"/>
                    <a:pt x="170" y="707"/>
                    <a:pt x="166" y="702"/>
                  </a:cubicBezTo>
                  <a:cubicBezTo>
                    <a:pt x="163" y="699"/>
                    <a:pt x="162" y="695"/>
                    <a:pt x="162" y="690"/>
                  </a:cubicBezTo>
                  <a:cubicBezTo>
                    <a:pt x="162" y="679"/>
                    <a:pt x="167" y="662"/>
                    <a:pt x="178" y="637"/>
                  </a:cubicBezTo>
                  <a:cubicBezTo>
                    <a:pt x="237" y="503"/>
                    <a:pt x="237" y="503"/>
                    <a:pt x="237" y="503"/>
                  </a:cubicBezTo>
                  <a:cubicBezTo>
                    <a:pt x="556" y="503"/>
                    <a:pt x="556" y="503"/>
                    <a:pt x="556" y="503"/>
                  </a:cubicBezTo>
                  <a:cubicBezTo>
                    <a:pt x="624" y="663"/>
                    <a:pt x="624" y="663"/>
                    <a:pt x="624" y="663"/>
                  </a:cubicBezTo>
                  <a:cubicBezTo>
                    <a:pt x="629" y="675"/>
                    <a:pt x="632" y="685"/>
                    <a:pt x="632" y="693"/>
                  </a:cubicBezTo>
                  <a:cubicBezTo>
                    <a:pt x="632" y="698"/>
                    <a:pt x="630" y="702"/>
                    <a:pt x="627" y="705"/>
                  </a:cubicBezTo>
                  <a:cubicBezTo>
                    <a:pt x="624" y="708"/>
                    <a:pt x="618" y="711"/>
                    <a:pt x="609" y="713"/>
                  </a:cubicBezTo>
                  <a:cubicBezTo>
                    <a:pt x="601" y="715"/>
                    <a:pt x="576" y="716"/>
                    <a:pt x="535" y="717"/>
                  </a:cubicBezTo>
                  <a:cubicBezTo>
                    <a:pt x="535" y="750"/>
                    <a:pt x="535" y="750"/>
                    <a:pt x="535" y="750"/>
                  </a:cubicBezTo>
                  <a:cubicBezTo>
                    <a:pt x="712" y="747"/>
                    <a:pt x="712" y="747"/>
                    <a:pt x="712" y="747"/>
                  </a:cubicBezTo>
                  <a:cubicBezTo>
                    <a:pt x="734" y="747"/>
                    <a:pt x="775" y="748"/>
                    <a:pt x="832" y="750"/>
                  </a:cubicBezTo>
                  <a:cubicBezTo>
                    <a:pt x="832" y="717"/>
                    <a:pt x="832" y="717"/>
                    <a:pt x="832" y="717"/>
                  </a:cubicBezTo>
                  <a:cubicBezTo>
                    <a:pt x="803" y="716"/>
                    <a:pt x="784" y="714"/>
                    <a:pt x="776" y="710"/>
                  </a:cubicBezTo>
                  <a:cubicBezTo>
                    <a:pt x="767" y="707"/>
                    <a:pt x="760" y="699"/>
                    <a:pt x="753" y="687"/>
                  </a:cubicBezTo>
                  <a:cubicBezTo>
                    <a:pt x="740" y="664"/>
                    <a:pt x="715" y="611"/>
                    <a:pt x="677" y="526"/>
                  </a:cubicBezTo>
                  <a:cubicBezTo>
                    <a:pt x="441" y="0"/>
                    <a:pt x="441" y="0"/>
                    <a:pt x="441" y="0"/>
                  </a:cubicBezTo>
                  <a:cubicBezTo>
                    <a:pt x="406" y="0"/>
                    <a:pt x="406" y="0"/>
                    <a:pt x="406" y="0"/>
                  </a:cubicBezTo>
                  <a:cubicBezTo>
                    <a:pt x="357" y="112"/>
                    <a:pt x="325" y="185"/>
                    <a:pt x="310" y="217"/>
                  </a:cubicBezTo>
                  <a:cubicBezTo>
                    <a:pt x="172" y="512"/>
                    <a:pt x="172" y="512"/>
                    <a:pt x="172" y="512"/>
                  </a:cubicBezTo>
                  <a:cubicBezTo>
                    <a:pt x="131" y="598"/>
                    <a:pt x="107" y="647"/>
                    <a:pt x="100" y="660"/>
                  </a:cubicBezTo>
                  <a:cubicBezTo>
                    <a:pt x="89" y="683"/>
                    <a:pt x="80" y="697"/>
                    <a:pt x="74" y="702"/>
                  </a:cubicBezTo>
                  <a:cubicBezTo>
                    <a:pt x="68" y="708"/>
                    <a:pt x="61" y="711"/>
                    <a:pt x="54" y="713"/>
                  </a:cubicBezTo>
                  <a:cubicBezTo>
                    <a:pt x="47" y="715"/>
                    <a:pt x="29" y="716"/>
                    <a:pt x="0" y="717"/>
                  </a:cubicBezTo>
                  <a:cubicBezTo>
                    <a:pt x="0" y="750"/>
                    <a:pt x="0" y="750"/>
                    <a:pt x="0" y="750"/>
                  </a:cubicBezTo>
                  <a:cubicBezTo>
                    <a:pt x="42" y="748"/>
                    <a:pt x="81" y="747"/>
                    <a:pt x="117" y="747"/>
                  </a:cubicBezTo>
                  <a:close/>
                  <a:moveTo>
                    <a:pt x="396" y="143"/>
                  </a:moveTo>
                  <a:cubicBezTo>
                    <a:pt x="534" y="458"/>
                    <a:pt x="534" y="458"/>
                    <a:pt x="534" y="458"/>
                  </a:cubicBezTo>
                  <a:cubicBezTo>
                    <a:pt x="256" y="458"/>
                    <a:pt x="256" y="458"/>
                    <a:pt x="256" y="458"/>
                  </a:cubicBezTo>
                  <a:lnTo>
                    <a:pt x="396" y="143"/>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0" name="Freeform 14"/>
            <p:cNvSpPr>
              <a:spLocks/>
            </p:cNvSpPr>
            <p:nvPr userDrawn="1"/>
          </p:nvSpPr>
          <p:spPr bwMode="auto">
            <a:xfrm>
              <a:off x="1309688" y="687388"/>
              <a:ext cx="260350" cy="234950"/>
            </a:xfrm>
            <a:custGeom>
              <a:avLst/>
              <a:gdLst>
                <a:gd name="T0" fmla="*/ 601 w 817"/>
                <a:gd name="T1" fmla="*/ 111 h 743"/>
                <a:gd name="T2" fmla="*/ 634 w 817"/>
                <a:gd name="T3" fmla="*/ 52 h 743"/>
                <a:gd name="T4" fmla="*/ 624 w 817"/>
                <a:gd name="T5" fmla="*/ 39 h 743"/>
                <a:gd name="T6" fmla="*/ 543 w 817"/>
                <a:gd name="T7" fmla="*/ 33 h 743"/>
                <a:gd name="T8" fmla="*/ 543 w 817"/>
                <a:gd name="T9" fmla="*/ 0 h 743"/>
                <a:gd name="T10" fmla="*/ 688 w 817"/>
                <a:gd name="T11" fmla="*/ 3 h 743"/>
                <a:gd name="T12" fmla="*/ 817 w 817"/>
                <a:gd name="T13" fmla="*/ 0 h 743"/>
                <a:gd name="T14" fmla="*/ 817 w 817"/>
                <a:gd name="T15" fmla="*/ 33 h 743"/>
                <a:gd name="T16" fmla="*/ 746 w 817"/>
                <a:gd name="T17" fmla="*/ 39 h 743"/>
                <a:gd name="T18" fmla="*/ 718 w 817"/>
                <a:gd name="T19" fmla="*/ 51 h 743"/>
                <a:gd name="T20" fmla="*/ 675 w 817"/>
                <a:gd name="T21" fmla="*/ 102 h 743"/>
                <a:gd name="T22" fmla="*/ 514 w 817"/>
                <a:gd name="T23" fmla="*/ 333 h 743"/>
                <a:gd name="T24" fmla="*/ 461 w 817"/>
                <a:gd name="T25" fmla="*/ 422 h 743"/>
                <a:gd name="T26" fmla="*/ 455 w 817"/>
                <a:gd name="T27" fmla="*/ 453 h 743"/>
                <a:gd name="T28" fmla="*/ 455 w 817"/>
                <a:gd name="T29" fmla="*/ 493 h 743"/>
                <a:gd name="T30" fmla="*/ 459 w 817"/>
                <a:gd name="T31" fmla="*/ 631 h 743"/>
                <a:gd name="T32" fmla="*/ 466 w 817"/>
                <a:gd name="T33" fmla="*/ 690 h 743"/>
                <a:gd name="T34" fmla="*/ 486 w 817"/>
                <a:gd name="T35" fmla="*/ 704 h 743"/>
                <a:gd name="T36" fmla="*/ 564 w 817"/>
                <a:gd name="T37" fmla="*/ 710 h 743"/>
                <a:gd name="T38" fmla="*/ 564 w 817"/>
                <a:gd name="T39" fmla="*/ 743 h 743"/>
                <a:gd name="T40" fmla="*/ 410 w 817"/>
                <a:gd name="T41" fmla="*/ 740 h 743"/>
                <a:gd name="T42" fmla="*/ 244 w 817"/>
                <a:gd name="T43" fmla="*/ 743 h 743"/>
                <a:gd name="T44" fmla="*/ 244 w 817"/>
                <a:gd name="T45" fmla="*/ 710 h 743"/>
                <a:gd name="T46" fmla="*/ 322 w 817"/>
                <a:gd name="T47" fmla="*/ 704 h 743"/>
                <a:gd name="T48" fmla="*/ 341 w 817"/>
                <a:gd name="T49" fmla="*/ 692 h 743"/>
                <a:gd name="T50" fmla="*/ 350 w 817"/>
                <a:gd name="T51" fmla="*/ 641 h 743"/>
                <a:gd name="T52" fmla="*/ 353 w 817"/>
                <a:gd name="T53" fmla="*/ 493 h 743"/>
                <a:gd name="T54" fmla="*/ 353 w 817"/>
                <a:gd name="T55" fmla="*/ 432 h 743"/>
                <a:gd name="T56" fmla="*/ 331 w 817"/>
                <a:gd name="T57" fmla="*/ 390 h 743"/>
                <a:gd name="T58" fmla="*/ 275 w 817"/>
                <a:gd name="T59" fmla="*/ 300 h 743"/>
                <a:gd name="T60" fmla="*/ 135 w 817"/>
                <a:gd name="T61" fmla="*/ 102 h 743"/>
                <a:gd name="T62" fmla="*/ 96 w 817"/>
                <a:gd name="T63" fmla="*/ 51 h 743"/>
                <a:gd name="T64" fmla="*/ 69 w 817"/>
                <a:gd name="T65" fmla="*/ 39 h 743"/>
                <a:gd name="T66" fmla="*/ 0 w 817"/>
                <a:gd name="T67" fmla="*/ 33 h 743"/>
                <a:gd name="T68" fmla="*/ 0 w 817"/>
                <a:gd name="T69" fmla="*/ 0 h 743"/>
                <a:gd name="T70" fmla="*/ 130 w 817"/>
                <a:gd name="T71" fmla="*/ 3 h 743"/>
                <a:gd name="T72" fmla="*/ 333 w 817"/>
                <a:gd name="T73" fmla="*/ 0 h 743"/>
                <a:gd name="T74" fmla="*/ 333 w 817"/>
                <a:gd name="T75" fmla="*/ 33 h 743"/>
                <a:gd name="T76" fmla="*/ 246 w 817"/>
                <a:gd name="T77" fmla="*/ 39 h 743"/>
                <a:gd name="T78" fmla="*/ 234 w 817"/>
                <a:gd name="T79" fmla="*/ 52 h 743"/>
                <a:gd name="T80" fmla="*/ 262 w 817"/>
                <a:gd name="T81" fmla="*/ 111 h 743"/>
                <a:gd name="T82" fmla="*/ 426 w 817"/>
                <a:gd name="T83" fmla="*/ 376 h 743"/>
                <a:gd name="T84" fmla="*/ 601 w 817"/>
                <a:gd name="T85" fmla="*/ 111 h 74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Lst>
              <a:rect l="0" t="0" r="r" b="b"/>
              <a:pathLst>
                <a:path w="817" h="743">
                  <a:moveTo>
                    <a:pt x="601" y="111"/>
                  </a:moveTo>
                  <a:cubicBezTo>
                    <a:pt x="623" y="78"/>
                    <a:pt x="634" y="59"/>
                    <a:pt x="634" y="52"/>
                  </a:cubicBezTo>
                  <a:cubicBezTo>
                    <a:pt x="634" y="46"/>
                    <a:pt x="631" y="41"/>
                    <a:pt x="624" y="39"/>
                  </a:cubicBezTo>
                  <a:cubicBezTo>
                    <a:pt x="616" y="36"/>
                    <a:pt x="585" y="34"/>
                    <a:pt x="543" y="33"/>
                  </a:cubicBezTo>
                  <a:cubicBezTo>
                    <a:pt x="543" y="0"/>
                    <a:pt x="543" y="0"/>
                    <a:pt x="543" y="0"/>
                  </a:cubicBezTo>
                  <a:cubicBezTo>
                    <a:pt x="610" y="2"/>
                    <a:pt x="650" y="3"/>
                    <a:pt x="688" y="3"/>
                  </a:cubicBezTo>
                  <a:cubicBezTo>
                    <a:pt x="725" y="3"/>
                    <a:pt x="745" y="2"/>
                    <a:pt x="817" y="0"/>
                  </a:cubicBezTo>
                  <a:cubicBezTo>
                    <a:pt x="817" y="33"/>
                    <a:pt x="817" y="33"/>
                    <a:pt x="817" y="33"/>
                  </a:cubicBezTo>
                  <a:cubicBezTo>
                    <a:pt x="773" y="34"/>
                    <a:pt x="757" y="36"/>
                    <a:pt x="746" y="39"/>
                  </a:cubicBezTo>
                  <a:cubicBezTo>
                    <a:pt x="735" y="41"/>
                    <a:pt x="725" y="46"/>
                    <a:pt x="718" y="51"/>
                  </a:cubicBezTo>
                  <a:cubicBezTo>
                    <a:pt x="709" y="58"/>
                    <a:pt x="695" y="75"/>
                    <a:pt x="675" y="102"/>
                  </a:cubicBezTo>
                  <a:cubicBezTo>
                    <a:pt x="514" y="333"/>
                    <a:pt x="514" y="333"/>
                    <a:pt x="514" y="333"/>
                  </a:cubicBezTo>
                  <a:cubicBezTo>
                    <a:pt x="483" y="381"/>
                    <a:pt x="465" y="411"/>
                    <a:pt x="461" y="422"/>
                  </a:cubicBezTo>
                  <a:cubicBezTo>
                    <a:pt x="457" y="433"/>
                    <a:pt x="455" y="443"/>
                    <a:pt x="455" y="453"/>
                  </a:cubicBezTo>
                  <a:cubicBezTo>
                    <a:pt x="455" y="493"/>
                    <a:pt x="455" y="493"/>
                    <a:pt x="455" y="493"/>
                  </a:cubicBezTo>
                  <a:cubicBezTo>
                    <a:pt x="455" y="541"/>
                    <a:pt x="456" y="587"/>
                    <a:pt x="459" y="631"/>
                  </a:cubicBezTo>
                  <a:cubicBezTo>
                    <a:pt x="460" y="665"/>
                    <a:pt x="462" y="684"/>
                    <a:pt x="466" y="690"/>
                  </a:cubicBezTo>
                  <a:cubicBezTo>
                    <a:pt x="470" y="696"/>
                    <a:pt x="477" y="701"/>
                    <a:pt x="486" y="704"/>
                  </a:cubicBezTo>
                  <a:cubicBezTo>
                    <a:pt x="495" y="707"/>
                    <a:pt x="521" y="709"/>
                    <a:pt x="564" y="710"/>
                  </a:cubicBezTo>
                  <a:cubicBezTo>
                    <a:pt x="564" y="743"/>
                    <a:pt x="564" y="743"/>
                    <a:pt x="564" y="743"/>
                  </a:cubicBezTo>
                  <a:cubicBezTo>
                    <a:pt x="505" y="741"/>
                    <a:pt x="453" y="740"/>
                    <a:pt x="410" y="740"/>
                  </a:cubicBezTo>
                  <a:cubicBezTo>
                    <a:pt x="368" y="740"/>
                    <a:pt x="313" y="741"/>
                    <a:pt x="244" y="743"/>
                  </a:cubicBezTo>
                  <a:cubicBezTo>
                    <a:pt x="244" y="710"/>
                    <a:pt x="244" y="710"/>
                    <a:pt x="244" y="710"/>
                  </a:cubicBezTo>
                  <a:cubicBezTo>
                    <a:pt x="287" y="709"/>
                    <a:pt x="313" y="707"/>
                    <a:pt x="322" y="704"/>
                  </a:cubicBezTo>
                  <a:cubicBezTo>
                    <a:pt x="332" y="701"/>
                    <a:pt x="338" y="697"/>
                    <a:pt x="341" y="692"/>
                  </a:cubicBezTo>
                  <a:cubicBezTo>
                    <a:pt x="346" y="685"/>
                    <a:pt x="349" y="668"/>
                    <a:pt x="350" y="641"/>
                  </a:cubicBezTo>
                  <a:cubicBezTo>
                    <a:pt x="350" y="634"/>
                    <a:pt x="351" y="585"/>
                    <a:pt x="353" y="493"/>
                  </a:cubicBezTo>
                  <a:cubicBezTo>
                    <a:pt x="353" y="432"/>
                    <a:pt x="353" y="432"/>
                    <a:pt x="353" y="432"/>
                  </a:cubicBezTo>
                  <a:cubicBezTo>
                    <a:pt x="345" y="417"/>
                    <a:pt x="338" y="403"/>
                    <a:pt x="331" y="390"/>
                  </a:cubicBezTo>
                  <a:cubicBezTo>
                    <a:pt x="325" y="382"/>
                    <a:pt x="307" y="352"/>
                    <a:pt x="275" y="300"/>
                  </a:cubicBezTo>
                  <a:cubicBezTo>
                    <a:pt x="135" y="102"/>
                    <a:pt x="135" y="102"/>
                    <a:pt x="135" y="102"/>
                  </a:cubicBezTo>
                  <a:cubicBezTo>
                    <a:pt x="118" y="75"/>
                    <a:pt x="105" y="58"/>
                    <a:pt x="96" y="51"/>
                  </a:cubicBezTo>
                  <a:cubicBezTo>
                    <a:pt x="89" y="46"/>
                    <a:pt x="80" y="41"/>
                    <a:pt x="69" y="39"/>
                  </a:cubicBezTo>
                  <a:cubicBezTo>
                    <a:pt x="58" y="36"/>
                    <a:pt x="44" y="34"/>
                    <a:pt x="0" y="33"/>
                  </a:cubicBezTo>
                  <a:cubicBezTo>
                    <a:pt x="0" y="0"/>
                    <a:pt x="0" y="0"/>
                    <a:pt x="0" y="0"/>
                  </a:cubicBezTo>
                  <a:cubicBezTo>
                    <a:pt x="72" y="2"/>
                    <a:pt x="94" y="3"/>
                    <a:pt x="130" y="3"/>
                  </a:cubicBezTo>
                  <a:cubicBezTo>
                    <a:pt x="168" y="3"/>
                    <a:pt x="265" y="2"/>
                    <a:pt x="333" y="0"/>
                  </a:cubicBezTo>
                  <a:cubicBezTo>
                    <a:pt x="333" y="33"/>
                    <a:pt x="333" y="33"/>
                    <a:pt x="333" y="33"/>
                  </a:cubicBezTo>
                  <a:cubicBezTo>
                    <a:pt x="291" y="34"/>
                    <a:pt x="254" y="36"/>
                    <a:pt x="246" y="39"/>
                  </a:cubicBezTo>
                  <a:cubicBezTo>
                    <a:pt x="239" y="41"/>
                    <a:pt x="235" y="46"/>
                    <a:pt x="234" y="52"/>
                  </a:cubicBezTo>
                  <a:cubicBezTo>
                    <a:pt x="234" y="59"/>
                    <a:pt x="243" y="78"/>
                    <a:pt x="262" y="111"/>
                  </a:cubicBezTo>
                  <a:cubicBezTo>
                    <a:pt x="426" y="376"/>
                    <a:pt x="426" y="376"/>
                    <a:pt x="426" y="376"/>
                  </a:cubicBezTo>
                  <a:lnTo>
                    <a:pt x="601" y="111"/>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1" name="Freeform 15"/>
            <p:cNvSpPr>
              <a:spLocks noEditPoints="1"/>
            </p:cNvSpPr>
            <p:nvPr userDrawn="1"/>
          </p:nvSpPr>
          <p:spPr bwMode="auto">
            <a:xfrm>
              <a:off x="1558925" y="681038"/>
              <a:ext cx="263525" cy="246063"/>
            </a:xfrm>
            <a:custGeom>
              <a:avLst/>
              <a:gdLst>
                <a:gd name="T0" fmla="*/ 148 w 830"/>
                <a:gd name="T1" fmla="*/ 190 h 775"/>
                <a:gd name="T2" fmla="*/ 247 w 830"/>
                <a:gd name="T3" fmla="*/ 82 h 775"/>
                <a:gd name="T4" fmla="*/ 399 w 830"/>
                <a:gd name="T5" fmla="*/ 45 h 775"/>
                <a:gd name="T6" fmla="*/ 512 w 830"/>
                <a:gd name="T7" fmla="*/ 62 h 775"/>
                <a:gd name="T8" fmla="*/ 596 w 830"/>
                <a:gd name="T9" fmla="*/ 106 h 775"/>
                <a:gd name="T10" fmla="*/ 652 w 830"/>
                <a:gd name="T11" fmla="*/ 167 h 775"/>
                <a:gd name="T12" fmla="*/ 690 w 830"/>
                <a:gd name="T13" fmla="*/ 245 h 775"/>
                <a:gd name="T14" fmla="*/ 713 w 830"/>
                <a:gd name="T15" fmla="*/ 398 h 775"/>
                <a:gd name="T16" fmla="*/ 681 w 830"/>
                <a:gd name="T17" fmla="*/ 571 h 775"/>
                <a:gd name="T18" fmla="*/ 584 w 830"/>
                <a:gd name="T19" fmla="*/ 686 h 775"/>
                <a:gd name="T20" fmla="*/ 431 w 830"/>
                <a:gd name="T21" fmla="*/ 727 h 775"/>
                <a:gd name="T22" fmla="*/ 315 w 830"/>
                <a:gd name="T23" fmla="*/ 707 h 775"/>
                <a:gd name="T24" fmla="*/ 220 w 830"/>
                <a:gd name="T25" fmla="*/ 644 h 775"/>
                <a:gd name="T26" fmla="*/ 151 w 830"/>
                <a:gd name="T27" fmla="*/ 539 h 775"/>
                <a:gd name="T28" fmla="*/ 125 w 830"/>
                <a:gd name="T29" fmla="*/ 450 h 775"/>
                <a:gd name="T30" fmla="*/ 115 w 830"/>
                <a:gd name="T31" fmla="*/ 349 h 775"/>
                <a:gd name="T32" fmla="*/ 148 w 830"/>
                <a:gd name="T33" fmla="*/ 190 h 775"/>
                <a:gd name="T34" fmla="*/ 26 w 830"/>
                <a:gd name="T35" fmla="*/ 541 h 775"/>
                <a:gd name="T36" fmla="*/ 105 w 830"/>
                <a:gd name="T37" fmla="*/ 669 h 775"/>
                <a:gd name="T38" fmla="*/ 231 w 830"/>
                <a:gd name="T39" fmla="*/ 748 h 775"/>
                <a:gd name="T40" fmla="*/ 392 w 830"/>
                <a:gd name="T41" fmla="*/ 775 h 775"/>
                <a:gd name="T42" fmla="*/ 706 w 830"/>
                <a:gd name="T43" fmla="*/ 657 h 775"/>
                <a:gd name="T44" fmla="*/ 830 w 830"/>
                <a:gd name="T45" fmla="*/ 364 h 775"/>
                <a:gd name="T46" fmla="*/ 817 w 830"/>
                <a:gd name="T47" fmla="*/ 261 h 775"/>
                <a:gd name="T48" fmla="*/ 784 w 830"/>
                <a:gd name="T49" fmla="*/ 177 h 775"/>
                <a:gd name="T50" fmla="*/ 709 w 830"/>
                <a:gd name="T51" fmla="*/ 89 h 775"/>
                <a:gd name="T52" fmla="*/ 588 w 830"/>
                <a:gd name="T53" fmla="*/ 25 h 775"/>
                <a:gd name="T54" fmla="*/ 423 w 830"/>
                <a:gd name="T55" fmla="*/ 0 h 775"/>
                <a:gd name="T56" fmla="*/ 249 w 830"/>
                <a:gd name="T57" fmla="*/ 29 h 775"/>
                <a:gd name="T58" fmla="*/ 112 w 830"/>
                <a:gd name="T59" fmla="*/ 113 h 775"/>
                <a:gd name="T60" fmla="*/ 26 w 830"/>
                <a:gd name="T61" fmla="*/ 239 h 775"/>
                <a:gd name="T62" fmla="*/ 0 w 830"/>
                <a:gd name="T63" fmla="*/ 393 h 775"/>
                <a:gd name="T64" fmla="*/ 26 w 830"/>
                <a:gd name="T65" fmla="*/ 541 h 77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Lst>
              <a:rect l="0" t="0" r="r" b="b"/>
              <a:pathLst>
                <a:path w="830" h="775">
                  <a:moveTo>
                    <a:pt x="148" y="190"/>
                  </a:moveTo>
                  <a:cubicBezTo>
                    <a:pt x="170" y="143"/>
                    <a:pt x="203" y="107"/>
                    <a:pt x="247" y="82"/>
                  </a:cubicBezTo>
                  <a:cubicBezTo>
                    <a:pt x="290" y="57"/>
                    <a:pt x="341" y="45"/>
                    <a:pt x="399" y="45"/>
                  </a:cubicBezTo>
                  <a:cubicBezTo>
                    <a:pt x="440" y="45"/>
                    <a:pt x="477" y="51"/>
                    <a:pt x="512" y="62"/>
                  </a:cubicBezTo>
                  <a:cubicBezTo>
                    <a:pt x="546" y="74"/>
                    <a:pt x="575" y="89"/>
                    <a:pt x="596" y="106"/>
                  </a:cubicBezTo>
                  <a:cubicBezTo>
                    <a:pt x="618" y="124"/>
                    <a:pt x="637" y="144"/>
                    <a:pt x="652" y="167"/>
                  </a:cubicBezTo>
                  <a:cubicBezTo>
                    <a:pt x="668" y="190"/>
                    <a:pt x="681" y="216"/>
                    <a:pt x="690" y="245"/>
                  </a:cubicBezTo>
                  <a:cubicBezTo>
                    <a:pt x="706" y="292"/>
                    <a:pt x="713" y="343"/>
                    <a:pt x="713" y="398"/>
                  </a:cubicBezTo>
                  <a:cubicBezTo>
                    <a:pt x="713" y="463"/>
                    <a:pt x="703" y="521"/>
                    <a:pt x="681" y="571"/>
                  </a:cubicBezTo>
                  <a:cubicBezTo>
                    <a:pt x="660" y="620"/>
                    <a:pt x="627" y="659"/>
                    <a:pt x="584" y="686"/>
                  </a:cubicBezTo>
                  <a:cubicBezTo>
                    <a:pt x="541" y="714"/>
                    <a:pt x="490" y="727"/>
                    <a:pt x="431" y="727"/>
                  </a:cubicBezTo>
                  <a:cubicBezTo>
                    <a:pt x="388" y="727"/>
                    <a:pt x="350" y="721"/>
                    <a:pt x="315" y="707"/>
                  </a:cubicBezTo>
                  <a:cubicBezTo>
                    <a:pt x="280" y="694"/>
                    <a:pt x="248" y="673"/>
                    <a:pt x="220" y="644"/>
                  </a:cubicBezTo>
                  <a:cubicBezTo>
                    <a:pt x="192" y="616"/>
                    <a:pt x="169" y="581"/>
                    <a:pt x="151" y="539"/>
                  </a:cubicBezTo>
                  <a:cubicBezTo>
                    <a:pt x="141" y="514"/>
                    <a:pt x="132" y="484"/>
                    <a:pt x="125" y="450"/>
                  </a:cubicBezTo>
                  <a:cubicBezTo>
                    <a:pt x="118" y="416"/>
                    <a:pt x="115" y="382"/>
                    <a:pt x="115" y="349"/>
                  </a:cubicBezTo>
                  <a:cubicBezTo>
                    <a:pt x="115" y="290"/>
                    <a:pt x="126" y="236"/>
                    <a:pt x="148" y="190"/>
                  </a:cubicBezTo>
                  <a:close/>
                  <a:moveTo>
                    <a:pt x="26" y="541"/>
                  </a:moveTo>
                  <a:cubicBezTo>
                    <a:pt x="44" y="591"/>
                    <a:pt x="70" y="634"/>
                    <a:pt x="105" y="669"/>
                  </a:cubicBezTo>
                  <a:cubicBezTo>
                    <a:pt x="139" y="704"/>
                    <a:pt x="181" y="730"/>
                    <a:pt x="231" y="748"/>
                  </a:cubicBezTo>
                  <a:cubicBezTo>
                    <a:pt x="281" y="765"/>
                    <a:pt x="335" y="775"/>
                    <a:pt x="392" y="775"/>
                  </a:cubicBezTo>
                  <a:cubicBezTo>
                    <a:pt x="518" y="775"/>
                    <a:pt x="623" y="736"/>
                    <a:pt x="706" y="657"/>
                  </a:cubicBezTo>
                  <a:cubicBezTo>
                    <a:pt x="788" y="579"/>
                    <a:pt x="830" y="481"/>
                    <a:pt x="830" y="364"/>
                  </a:cubicBezTo>
                  <a:cubicBezTo>
                    <a:pt x="830" y="327"/>
                    <a:pt x="826" y="293"/>
                    <a:pt x="817" y="261"/>
                  </a:cubicBezTo>
                  <a:cubicBezTo>
                    <a:pt x="809" y="228"/>
                    <a:pt x="798" y="200"/>
                    <a:pt x="784" y="177"/>
                  </a:cubicBezTo>
                  <a:cubicBezTo>
                    <a:pt x="766" y="145"/>
                    <a:pt x="741" y="116"/>
                    <a:pt x="709" y="89"/>
                  </a:cubicBezTo>
                  <a:cubicBezTo>
                    <a:pt x="678" y="62"/>
                    <a:pt x="637" y="41"/>
                    <a:pt x="588" y="25"/>
                  </a:cubicBezTo>
                  <a:cubicBezTo>
                    <a:pt x="538" y="8"/>
                    <a:pt x="484" y="0"/>
                    <a:pt x="423" y="0"/>
                  </a:cubicBezTo>
                  <a:cubicBezTo>
                    <a:pt x="358" y="0"/>
                    <a:pt x="300" y="10"/>
                    <a:pt x="249" y="29"/>
                  </a:cubicBezTo>
                  <a:cubicBezTo>
                    <a:pt x="198" y="48"/>
                    <a:pt x="152" y="76"/>
                    <a:pt x="112" y="113"/>
                  </a:cubicBezTo>
                  <a:cubicBezTo>
                    <a:pt x="72" y="151"/>
                    <a:pt x="43" y="193"/>
                    <a:pt x="26" y="239"/>
                  </a:cubicBezTo>
                  <a:cubicBezTo>
                    <a:pt x="8" y="286"/>
                    <a:pt x="0" y="337"/>
                    <a:pt x="0" y="393"/>
                  </a:cubicBezTo>
                  <a:cubicBezTo>
                    <a:pt x="0" y="441"/>
                    <a:pt x="9" y="491"/>
                    <a:pt x="26" y="541"/>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spTree>
    <p:extLst>
      <p:ext uri="{BB962C8B-B14F-4D97-AF65-F5344CB8AC3E}">
        <p14:creationId xmlns:p14="http://schemas.microsoft.com/office/powerpoint/2010/main" val="1368158223"/>
      </p:ext>
    </p:extLst>
  </p:cSld>
  <p:clrMapOvr>
    <a:masterClrMapping/>
  </p:clrMapOvr>
  <p:timing>
    <p:tnLst>
      <p:par>
        <p:cTn id="1" dur="indefinite" restart="never" nodeType="tmRoot"/>
      </p:par>
    </p:tnLst>
  </p:timing>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Mayo Reduced Siz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a:xfrm>
            <a:off x="1316736" y="1673352"/>
            <a:ext cx="6528816" cy="411480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2F0C072-4C78-470E-9A10-19681AF1B83A}" type="datetime1">
              <a:rPr lang="en-US" smtClean="0"/>
              <a:t>10/2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C53FA5-AE81-45E0-8206-920AA27813B4}" type="slidenum">
              <a:rPr lang="en-US" smtClean="0"/>
              <a:t>‹#›</a:t>
            </a:fld>
            <a:endParaRPr lang="en-US"/>
          </a:p>
        </p:txBody>
      </p:sp>
      <p:grpSp>
        <p:nvGrpSpPr>
          <p:cNvPr id="20" name="Group 19"/>
          <p:cNvGrpSpPr/>
          <p:nvPr userDrawn="1"/>
        </p:nvGrpSpPr>
        <p:grpSpPr>
          <a:xfrm>
            <a:off x="120650" y="6299343"/>
            <a:ext cx="420688" cy="458645"/>
            <a:chOff x="657225" y="681038"/>
            <a:chExt cx="1266825" cy="1381125"/>
          </a:xfrm>
          <a:solidFill>
            <a:srgbClr val="FFFFFF"/>
          </a:solidFill>
        </p:grpSpPr>
        <p:sp>
          <p:nvSpPr>
            <p:cNvPr id="21" name="Freeform 5"/>
            <p:cNvSpPr>
              <a:spLocks noEditPoints="1"/>
            </p:cNvSpPr>
            <p:nvPr userDrawn="1"/>
          </p:nvSpPr>
          <p:spPr bwMode="auto">
            <a:xfrm>
              <a:off x="846138" y="1354138"/>
              <a:ext cx="887413" cy="708025"/>
            </a:xfrm>
            <a:custGeom>
              <a:avLst/>
              <a:gdLst>
                <a:gd name="T0" fmla="*/ 2203 w 2794"/>
                <a:gd name="T1" fmla="*/ 0 h 2229"/>
                <a:gd name="T2" fmla="*/ 1613 w 2794"/>
                <a:gd name="T3" fmla="*/ 0 h 2229"/>
                <a:gd name="T4" fmla="*/ 1613 w 2794"/>
                <a:gd name="T5" fmla="*/ 665 h 2229"/>
                <a:gd name="T6" fmla="*/ 1904 w 2794"/>
                <a:gd name="T7" fmla="*/ 1330 h 2229"/>
                <a:gd name="T8" fmla="*/ 1904 w 2794"/>
                <a:gd name="T9" fmla="*/ 1237 h 2229"/>
                <a:gd name="T10" fmla="*/ 1749 w 2794"/>
                <a:gd name="T11" fmla="*/ 747 h 2229"/>
                <a:gd name="T12" fmla="*/ 1749 w 2794"/>
                <a:gd name="T13" fmla="*/ 573 h 2229"/>
                <a:gd name="T14" fmla="*/ 1972 w 2794"/>
                <a:gd name="T15" fmla="*/ 573 h 2229"/>
                <a:gd name="T16" fmla="*/ 1972 w 2794"/>
                <a:gd name="T17" fmla="*/ 1332 h 2229"/>
                <a:gd name="T18" fmla="*/ 1401 w 2794"/>
                <a:gd name="T19" fmla="*/ 2182 h 2229"/>
                <a:gd name="T20" fmla="*/ 829 w 2794"/>
                <a:gd name="T21" fmla="*/ 1374 h 2229"/>
                <a:gd name="T22" fmla="*/ 1180 w 2794"/>
                <a:gd name="T23" fmla="*/ 665 h 2229"/>
                <a:gd name="T24" fmla="*/ 1180 w 2794"/>
                <a:gd name="T25" fmla="*/ 573 h 2229"/>
                <a:gd name="T26" fmla="*/ 1401 w 2794"/>
                <a:gd name="T27" fmla="*/ 573 h 2229"/>
                <a:gd name="T28" fmla="*/ 1542 w 2794"/>
                <a:gd name="T29" fmla="*/ 573 h 2229"/>
                <a:gd name="T30" fmla="*/ 1542 w 2794"/>
                <a:gd name="T31" fmla="*/ 436 h 2229"/>
                <a:gd name="T32" fmla="*/ 1401 w 2794"/>
                <a:gd name="T33" fmla="*/ 436 h 2229"/>
                <a:gd name="T34" fmla="*/ 1180 w 2794"/>
                <a:gd name="T35" fmla="*/ 436 h 2229"/>
                <a:gd name="T36" fmla="*/ 1180 w 2794"/>
                <a:gd name="T37" fmla="*/ 436 h 2229"/>
                <a:gd name="T38" fmla="*/ 1044 w 2794"/>
                <a:gd name="T39" fmla="*/ 436 h 2229"/>
                <a:gd name="T40" fmla="*/ 1044 w 2794"/>
                <a:gd name="T41" fmla="*/ 436 h 2229"/>
                <a:gd name="T42" fmla="*/ 692 w 2794"/>
                <a:gd name="T43" fmla="*/ 436 h 2229"/>
                <a:gd name="T44" fmla="*/ 692 w 2794"/>
                <a:gd name="T45" fmla="*/ 1234 h 2229"/>
                <a:gd name="T46" fmla="*/ 695 w 2794"/>
                <a:gd name="T47" fmla="*/ 1315 h 2229"/>
                <a:gd name="T48" fmla="*/ 695 w 2794"/>
                <a:gd name="T49" fmla="*/ 1315 h 2229"/>
                <a:gd name="T50" fmla="*/ 829 w 2794"/>
                <a:gd name="T51" fmla="*/ 1205 h 2229"/>
                <a:gd name="T52" fmla="*/ 829 w 2794"/>
                <a:gd name="T53" fmla="*/ 1205 h 2229"/>
                <a:gd name="T54" fmla="*/ 829 w 2794"/>
                <a:gd name="T55" fmla="*/ 573 h 2229"/>
                <a:gd name="T56" fmla="*/ 1044 w 2794"/>
                <a:gd name="T57" fmla="*/ 573 h 2229"/>
                <a:gd name="T58" fmla="*/ 1044 w 2794"/>
                <a:gd name="T59" fmla="*/ 573 h 2229"/>
                <a:gd name="T60" fmla="*/ 1044 w 2794"/>
                <a:gd name="T61" fmla="*/ 747 h 2229"/>
                <a:gd name="T62" fmla="*/ 590 w 2794"/>
                <a:gd name="T63" fmla="*/ 1447 h 2229"/>
                <a:gd name="T64" fmla="*/ 135 w 2794"/>
                <a:gd name="T65" fmla="*/ 747 h 2229"/>
                <a:gd name="T66" fmla="*/ 135 w 2794"/>
                <a:gd name="T67" fmla="*/ 136 h 2229"/>
                <a:gd name="T68" fmla="*/ 590 w 2794"/>
                <a:gd name="T69" fmla="*/ 136 h 2229"/>
                <a:gd name="T70" fmla="*/ 1044 w 2794"/>
                <a:gd name="T71" fmla="*/ 136 h 2229"/>
                <a:gd name="T72" fmla="*/ 1044 w 2794"/>
                <a:gd name="T73" fmla="*/ 370 h 2229"/>
                <a:gd name="T74" fmla="*/ 1180 w 2794"/>
                <a:gd name="T75" fmla="*/ 370 h 2229"/>
                <a:gd name="T76" fmla="*/ 1180 w 2794"/>
                <a:gd name="T77" fmla="*/ 0 h 2229"/>
                <a:gd name="T78" fmla="*/ 590 w 2794"/>
                <a:gd name="T79" fmla="*/ 0 h 2229"/>
                <a:gd name="T80" fmla="*/ 0 w 2794"/>
                <a:gd name="T81" fmla="*/ 0 h 2229"/>
                <a:gd name="T82" fmla="*/ 0 w 2794"/>
                <a:gd name="T83" fmla="*/ 665 h 2229"/>
                <a:gd name="T84" fmla="*/ 590 w 2794"/>
                <a:gd name="T85" fmla="*/ 1495 h 2229"/>
                <a:gd name="T86" fmla="*/ 708 w 2794"/>
                <a:gd name="T87" fmla="*/ 1444 h 2229"/>
                <a:gd name="T88" fmla="*/ 1401 w 2794"/>
                <a:gd name="T89" fmla="*/ 2229 h 2229"/>
                <a:gd name="T90" fmla="*/ 2093 w 2794"/>
                <a:gd name="T91" fmla="*/ 1447 h 2229"/>
                <a:gd name="T92" fmla="*/ 2203 w 2794"/>
                <a:gd name="T93" fmla="*/ 1495 h 2229"/>
                <a:gd name="T94" fmla="*/ 2794 w 2794"/>
                <a:gd name="T95" fmla="*/ 665 h 2229"/>
                <a:gd name="T96" fmla="*/ 2794 w 2794"/>
                <a:gd name="T97" fmla="*/ 0 h 2229"/>
                <a:gd name="T98" fmla="*/ 2203 w 2794"/>
                <a:gd name="T99" fmla="*/ 0 h 2229"/>
                <a:gd name="T100" fmla="*/ 2658 w 2794"/>
                <a:gd name="T101" fmla="*/ 747 h 2229"/>
                <a:gd name="T102" fmla="*/ 2203 w 2794"/>
                <a:gd name="T103" fmla="*/ 1447 h 2229"/>
                <a:gd name="T104" fmla="*/ 2100 w 2794"/>
                <a:gd name="T105" fmla="*/ 1395 h 2229"/>
                <a:gd name="T106" fmla="*/ 2109 w 2794"/>
                <a:gd name="T107" fmla="*/ 1234 h 2229"/>
                <a:gd name="T108" fmla="*/ 2109 w 2794"/>
                <a:gd name="T109" fmla="*/ 436 h 2229"/>
                <a:gd name="T110" fmla="*/ 1749 w 2794"/>
                <a:gd name="T111" fmla="*/ 436 h 2229"/>
                <a:gd name="T112" fmla="*/ 1749 w 2794"/>
                <a:gd name="T113" fmla="*/ 136 h 2229"/>
                <a:gd name="T114" fmla="*/ 2203 w 2794"/>
                <a:gd name="T115" fmla="*/ 136 h 2229"/>
                <a:gd name="T116" fmla="*/ 2658 w 2794"/>
                <a:gd name="T117" fmla="*/ 136 h 2229"/>
                <a:gd name="T118" fmla="*/ 2658 w 2794"/>
                <a:gd name="T119" fmla="*/ 747 h 222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 ang="0">
                  <a:pos x="T118" y="T119"/>
                </a:cxn>
              </a:cxnLst>
              <a:rect l="0" t="0" r="r" b="b"/>
              <a:pathLst>
                <a:path w="2794" h="2229">
                  <a:moveTo>
                    <a:pt x="2203" y="0"/>
                  </a:moveTo>
                  <a:cubicBezTo>
                    <a:pt x="1613" y="0"/>
                    <a:pt x="1613" y="0"/>
                    <a:pt x="1613" y="0"/>
                  </a:cubicBezTo>
                  <a:cubicBezTo>
                    <a:pt x="1613" y="665"/>
                    <a:pt x="1613" y="665"/>
                    <a:pt x="1613" y="665"/>
                  </a:cubicBezTo>
                  <a:cubicBezTo>
                    <a:pt x="1613" y="970"/>
                    <a:pt x="1719" y="1183"/>
                    <a:pt x="1904" y="1330"/>
                  </a:cubicBezTo>
                  <a:cubicBezTo>
                    <a:pt x="1904" y="1237"/>
                    <a:pt x="1904" y="1237"/>
                    <a:pt x="1904" y="1237"/>
                  </a:cubicBezTo>
                  <a:cubicBezTo>
                    <a:pt x="1769" y="1081"/>
                    <a:pt x="1749" y="901"/>
                    <a:pt x="1749" y="747"/>
                  </a:cubicBezTo>
                  <a:cubicBezTo>
                    <a:pt x="1749" y="573"/>
                    <a:pt x="1749" y="573"/>
                    <a:pt x="1749" y="573"/>
                  </a:cubicBezTo>
                  <a:cubicBezTo>
                    <a:pt x="1972" y="573"/>
                    <a:pt x="1972" y="573"/>
                    <a:pt x="1972" y="573"/>
                  </a:cubicBezTo>
                  <a:cubicBezTo>
                    <a:pt x="1972" y="1332"/>
                    <a:pt x="1972" y="1332"/>
                    <a:pt x="1972" y="1332"/>
                  </a:cubicBezTo>
                  <a:cubicBezTo>
                    <a:pt x="1972" y="1609"/>
                    <a:pt x="1895" y="1961"/>
                    <a:pt x="1401" y="2182"/>
                  </a:cubicBezTo>
                  <a:cubicBezTo>
                    <a:pt x="931" y="1972"/>
                    <a:pt x="838" y="1643"/>
                    <a:pt x="829" y="1374"/>
                  </a:cubicBezTo>
                  <a:cubicBezTo>
                    <a:pt x="1051" y="1225"/>
                    <a:pt x="1180" y="1001"/>
                    <a:pt x="1180" y="665"/>
                  </a:cubicBezTo>
                  <a:cubicBezTo>
                    <a:pt x="1180" y="573"/>
                    <a:pt x="1180" y="573"/>
                    <a:pt x="1180" y="573"/>
                  </a:cubicBezTo>
                  <a:cubicBezTo>
                    <a:pt x="1401" y="573"/>
                    <a:pt x="1401" y="573"/>
                    <a:pt x="1401" y="573"/>
                  </a:cubicBezTo>
                  <a:cubicBezTo>
                    <a:pt x="1542" y="573"/>
                    <a:pt x="1542" y="573"/>
                    <a:pt x="1542" y="573"/>
                  </a:cubicBezTo>
                  <a:cubicBezTo>
                    <a:pt x="1542" y="436"/>
                    <a:pt x="1542" y="436"/>
                    <a:pt x="1542" y="436"/>
                  </a:cubicBezTo>
                  <a:cubicBezTo>
                    <a:pt x="1401" y="436"/>
                    <a:pt x="1401" y="436"/>
                    <a:pt x="1401" y="436"/>
                  </a:cubicBezTo>
                  <a:cubicBezTo>
                    <a:pt x="1180" y="436"/>
                    <a:pt x="1180" y="436"/>
                    <a:pt x="1180" y="436"/>
                  </a:cubicBezTo>
                  <a:cubicBezTo>
                    <a:pt x="1180" y="436"/>
                    <a:pt x="1180" y="436"/>
                    <a:pt x="1180" y="436"/>
                  </a:cubicBezTo>
                  <a:cubicBezTo>
                    <a:pt x="1044" y="436"/>
                    <a:pt x="1044" y="436"/>
                    <a:pt x="1044" y="436"/>
                  </a:cubicBezTo>
                  <a:cubicBezTo>
                    <a:pt x="1044" y="436"/>
                    <a:pt x="1044" y="436"/>
                    <a:pt x="1044" y="436"/>
                  </a:cubicBezTo>
                  <a:cubicBezTo>
                    <a:pt x="692" y="436"/>
                    <a:pt x="692" y="436"/>
                    <a:pt x="692" y="436"/>
                  </a:cubicBezTo>
                  <a:cubicBezTo>
                    <a:pt x="692" y="1234"/>
                    <a:pt x="692" y="1234"/>
                    <a:pt x="692" y="1234"/>
                  </a:cubicBezTo>
                  <a:cubicBezTo>
                    <a:pt x="692" y="1262"/>
                    <a:pt x="693" y="1289"/>
                    <a:pt x="695" y="1315"/>
                  </a:cubicBezTo>
                  <a:cubicBezTo>
                    <a:pt x="695" y="1315"/>
                    <a:pt x="695" y="1315"/>
                    <a:pt x="695" y="1315"/>
                  </a:cubicBezTo>
                  <a:cubicBezTo>
                    <a:pt x="748" y="1280"/>
                    <a:pt x="792" y="1244"/>
                    <a:pt x="829" y="1205"/>
                  </a:cubicBezTo>
                  <a:cubicBezTo>
                    <a:pt x="829" y="1205"/>
                    <a:pt x="829" y="1205"/>
                    <a:pt x="829" y="1205"/>
                  </a:cubicBezTo>
                  <a:cubicBezTo>
                    <a:pt x="829" y="573"/>
                    <a:pt x="829" y="573"/>
                    <a:pt x="829" y="573"/>
                  </a:cubicBezTo>
                  <a:cubicBezTo>
                    <a:pt x="1044" y="573"/>
                    <a:pt x="1044" y="573"/>
                    <a:pt x="1044" y="573"/>
                  </a:cubicBezTo>
                  <a:cubicBezTo>
                    <a:pt x="1044" y="573"/>
                    <a:pt x="1044" y="573"/>
                    <a:pt x="1044" y="573"/>
                  </a:cubicBezTo>
                  <a:cubicBezTo>
                    <a:pt x="1044" y="747"/>
                    <a:pt x="1044" y="747"/>
                    <a:pt x="1044" y="747"/>
                  </a:cubicBezTo>
                  <a:cubicBezTo>
                    <a:pt x="1044" y="978"/>
                    <a:pt x="1001" y="1263"/>
                    <a:pt x="590" y="1447"/>
                  </a:cubicBezTo>
                  <a:cubicBezTo>
                    <a:pt x="178" y="1263"/>
                    <a:pt x="135" y="978"/>
                    <a:pt x="135" y="747"/>
                  </a:cubicBezTo>
                  <a:cubicBezTo>
                    <a:pt x="135" y="136"/>
                    <a:pt x="135" y="136"/>
                    <a:pt x="135" y="136"/>
                  </a:cubicBezTo>
                  <a:cubicBezTo>
                    <a:pt x="590" y="136"/>
                    <a:pt x="590" y="136"/>
                    <a:pt x="590" y="136"/>
                  </a:cubicBezTo>
                  <a:cubicBezTo>
                    <a:pt x="1044" y="136"/>
                    <a:pt x="1044" y="136"/>
                    <a:pt x="1044" y="136"/>
                  </a:cubicBezTo>
                  <a:cubicBezTo>
                    <a:pt x="1044" y="370"/>
                    <a:pt x="1044" y="370"/>
                    <a:pt x="1044" y="370"/>
                  </a:cubicBezTo>
                  <a:cubicBezTo>
                    <a:pt x="1180" y="370"/>
                    <a:pt x="1180" y="370"/>
                    <a:pt x="1180" y="370"/>
                  </a:cubicBezTo>
                  <a:cubicBezTo>
                    <a:pt x="1180" y="0"/>
                    <a:pt x="1180" y="0"/>
                    <a:pt x="1180" y="0"/>
                  </a:cubicBezTo>
                  <a:cubicBezTo>
                    <a:pt x="590" y="0"/>
                    <a:pt x="590" y="0"/>
                    <a:pt x="590" y="0"/>
                  </a:cubicBezTo>
                  <a:cubicBezTo>
                    <a:pt x="0" y="0"/>
                    <a:pt x="0" y="0"/>
                    <a:pt x="0" y="0"/>
                  </a:cubicBezTo>
                  <a:cubicBezTo>
                    <a:pt x="0" y="665"/>
                    <a:pt x="0" y="665"/>
                    <a:pt x="0" y="665"/>
                  </a:cubicBezTo>
                  <a:cubicBezTo>
                    <a:pt x="0" y="1109"/>
                    <a:pt x="224" y="1357"/>
                    <a:pt x="590" y="1495"/>
                  </a:cubicBezTo>
                  <a:cubicBezTo>
                    <a:pt x="631" y="1479"/>
                    <a:pt x="670" y="1462"/>
                    <a:pt x="708" y="1444"/>
                  </a:cubicBezTo>
                  <a:cubicBezTo>
                    <a:pt x="771" y="1847"/>
                    <a:pt x="1023" y="2087"/>
                    <a:pt x="1401" y="2229"/>
                  </a:cubicBezTo>
                  <a:cubicBezTo>
                    <a:pt x="1777" y="2087"/>
                    <a:pt x="2029" y="1848"/>
                    <a:pt x="2093" y="1447"/>
                  </a:cubicBezTo>
                  <a:cubicBezTo>
                    <a:pt x="2128" y="1464"/>
                    <a:pt x="2165" y="1480"/>
                    <a:pt x="2203" y="1495"/>
                  </a:cubicBezTo>
                  <a:cubicBezTo>
                    <a:pt x="2569" y="1357"/>
                    <a:pt x="2794" y="1109"/>
                    <a:pt x="2794" y="665"/>
                  </a:cubicBezTo>
                  <a:cubicBezTo>
                    <a:pt x="2794" y="0"/>
                    <a:pt x="2794" y="0"/>
                    <a:pt x="2794" y="0"/>
                  </a:cubicBezTo>
                  <a:lnTo>
                    <a:pt x="2203" y="0"/>
                  </a:lnTo>
                  <a:close/>
                  <a:moveTo>
                    <a:pt x="2658" y="747"/>
                  </a:moveTo>
                  <a:cubicBezTo>
                    <a:pt x="2658" y="978"/>
                    <a:pt x="2615" y="1263"/>
                    <a:pt x="2203" y="1447"/>
                  </a:cubicBezTo>
                  <a:cubicBezTo>
                    <a:pt x="2166" y="1431"/>
                    <a:pt x="2131" y="1413"/>
                    <a:pt x="2100" y="1395"/>
                  </a:cubicBezTo>
                  <a:cubicBezTo>
                    <a:pt x="2106" y="1344"/>
                    <a:pt x="2109" y="1290"/>
                    <a:pt x="2109" y="1234"/>
                  </a:cubicBezTo>
                  <a:cubicBezTo>
                    <a:pt x="2109" y="436"/>
                    <a:pt x="2109" y="436"/>
                    <a:pt x="2109" y="436"/>
                  </a:cubicBezTo>
                  <a:cubicBezTo>
                    <a:pt x="1749" y="436"/>
                    <a:pt x="1749" y="436"/>
                    <a:pt x="1749" y="436"/>
                  </a:cubicBezTo>
                  <a:cubicBezTo>
                    <a:pt x="1749" y="136"/>
                    <a:pt x="1749" y="136"/>
                    <a:pt x="1749" y="136"/>
                  </a:cubicBezTo>
                  <a:cubicBezTo>
                    <a:pt x="2203" y="136"/>
                    <a:pt x="2203" y="136"/>
                    <a:pt x="2203" y="136"/>
                  </a:cubicBezTo>
                  <a:cubicBezTo>
                    <a:pt x="2658" y="136"/>
                    <a:pt x="2658" y="136"/>
                    <a:pt x="2658" y="136"/>
                  </a:cubicBezTo>
                  <a:lnTo>
                    <a:pt x="2658" y="74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2" name="Freeform 6"/>
            <p:cNvSpPr>
              <a:spLocks/>
            </p:cNvSpPr>
            <p:nvPr userDrawn="1"/>
          </p:nvSpPr>
          <p:spPr bwMode="auto">
            <a:xfrm>
              <a:off x="915988" y="1003301"/>
              <a:ext cx="188913" cy="236538"/>
            </a:xfrm>
            <a:custGeom>
              <a:avLst/>
              <a:gdLst>
                <a:gd name="T0" fmla="*/ 49 w 596"/>
                <a:gd name="T1" fmla="*/ 747 h 747"/>
                <a:gd name="T2" fmla="*/ 49 w 596"/>
                <a:gd name="T3" fmla="*/ 721 h 747"/>
                <a:gd name="T4" fmla="*/ 91 w 596"/>
                <a:gd name="T5" fmla="*/ 696 h 747"/>
                <a:gd name="T6" fmla="*/ 99 w 596"/>
                <a:gd name="T7" fmla="*/ 684 h 747"/>
                <a:gd name="T8" fmla="*/ 105 w 596"/>
                <a:gd name="T9" fmla="*/ 621 h 747"/>
                <a:gd name="T10" fmla="*/ 109 w 596"/>
                <a:gd name="T11" fmla="*/ 535 h 747"/>
                <a:gd name="T12" fmla="*/ 109 w 596"/>
                <a:gd name="T13" fmla="*/ 252 h 747"/>
                <a:gd name="T14" fmla="*/ 105 w 596"/>
                <a:gd name="T15" fmla="*/ 112 h 747"/>
                <a:gd name="T16" fmla="*/ 98 w 596"/>
                <a:gd name="T17" fmla="*/ 52 h 747"/>
                <a:gd name="T18" fmla="*/ 78 w 596"/>
                <a:gd name="T19" fmla="*/ 39 h 747"/>
                <a:gd name="T20" fmla="*/ 0 w 596"/>
                <a:gd name="T21" fmla="*/ 33 h 747"/>
                <a:gd name="T22" fmla="*/ 0 w 596"/>
                <a:gd name="T23" fmla="*/ 0 h 747"/>
                <a:gd name="T24" fmla="*/ 165 w 596"/>
                <a:gd name="T25" fmla="*/ 3 h 747"/>
                <a:gd name="T26" fmla="*/ 323 w 596"/>
                <a:gd name="T27" fmla="*/ 0 h 747"/>
                <a:gd name="T28" fmla="*/ 323 w 596"/>
                <a:gd name="T29" fmla="*/ 33 h 747"/>
                <a:gd name="T30" fmla="*/ 243 w 596"/>
                <a:gd name="T31" fmla="*/ 39 h 747"/>
                <a:gd name="T32" fmla="*/ 224 w 596"/>
                <a:gd name="T33" fmla="*/ 51 h 747"/>
                <a:gd name="T34" fmla="*/ 216 w 596"/>
                <a:gd name="T35" fmla="*/ 102 h 747"/>
                <a:gd name="T36" fmla="*/ 213 w 596"/>
                <a:gd name="T37" fmla="*/ 252 h 747"/>
                <a:gd name="T38" fmla="*/ 213 w 596"/>
                <a:gd name="T39" fmla="*/ 606 h 747"/>
                <a:gd name="T40" fmla="*/ 216 w 596"/>
                <a:gd name="T41" fmla="*/ 696 h 747"/>
                <a:gd name="T42" fmla="*/ 303 w 596"/>
                <a:gd name="T43" fmla="*/ 700 h 747"/>
                <a:gd name="T44" fmla="*/ 525 w 596"/>
                <a:gd name="T45" fmla="*/ 681 h 747"/>
                <a:gd name="T46" fmla="*/ 538 w 596"/>
                <a:gd name="T47" fmla="*/ 644 h 747"/>
                <a:gd name="T48" fmla="*/ 560 w 596"/>
                <a:gd name="T49" fmla="*/ 557 h 747"/>
                <a:gd name="T50" fmla="*/ 596 w 596"/>
                <a:gd name="T51" fmla="*/ 557 h 747"/>
                <a:gd name="T52" fmla="*/ 573 w 596"/>
                <a:gd name="T53" fmla="*/ 741 h 747"/>
                <a:gd name="T54" fmla="*/ 537 w 596"/>
                <a:gd name="T55" fmla="*/ 746 h 747"/>
                <a:gd name="T56" fmla="*/ 449 w 596"/>
                <a:gd name="T57" fmla="*/ 747 h 747"/>
                <a:gd name="T58" fmla="*/ 156 w 596"/>
                <a:gd name="T59" fmla="*/ 744 h 747"/>
                <a:gd name="T60" fmla="*/ 49 w 596"/>
                <a:gd name="T61" fmla="*/ 747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Lst>
              <a:rect l="0" t="0" r="r" b="b"/>
              <a:pathLst>
                <a:path w="596" h="747">
                  <a:moveTo>
                    <a:pt x="49" y="747"/>
                  </a:moveTo>
                  <a:cubicBezTo>
                    <a:pt x="49" y="721"/>
                    <a:pt x="49" y="721"/>
                    <a:pt x="49" y="721"/>
                  </a:cubicBezTo>
                  <a:cubicBezTo>
                    <a:pt x="71" y="710"/>
                    <a:pt x="85" y="702"/>
                    <a:pt x="91" y="696"/>
                  </a:cubicBezTo>
                  <a:cubicBezTo>
                    <a:pt x="95" y="693"/>
                    <a:pt x="98" y="689"/>
                    <a:pt x="99" y="684"/>
                  </a:cubicBezTo>
                  <a:cubicBezTo>
                    <a:pt x="102" y="675"/>
                    <a:pt x="104" y="654"/>
                    <a:pt x="105" y="621"/>
                  </a:cubicBezTo>
                  <a:cubicBezTo>
                    <a:pt x="108" y="573"/>
                    <a:pt x="109" y="545"/>
                    <a:pt x="109" y="535"/>
                  </a:cubicBezTo>
                  <a:cubicBezTo>
                    <a:pt x="109" y="252"/>
                    <a:pt x="109" y="252"/>
                    <a:pt x="109" y="252"/>
                  </a:cubicBezTo>
                  <a:cubicBezTo>
                    <a:pt x="109" y="204"/>
                    <a:pt x="108" y="157"/>
                    <a:pt x="105" y="112"/>
                  </a:cubicBezTo>
                  <a:cubicBezTo>
                    <a:pt x="104" y="78"/>
                    <a:pt x="102" y="59"/>
                    <a:pt x="98" y="52"/>
                  </a:cubicBezTo>
                  <a:cubicBezTo>
                    <a:pt x="93" y="46"/>
                    <a:pt x="87" y="42"/>
                    <a:pt x="78" y="39"/>
                  </a:cubicBezTo>
                  <a:cubicBezTo>
                    <a:pt x="69" y="36"/>
                    <a:pt x="43" y="34"/>
                    <a:pt x="0" y="33"/>
                  </a:cubicBezTo>
                  <a:cubicBezTo>
                    <a:pt x="0" y="0"/>
                    <a:pt x="0" y="0"/>
                    <a:pt x="0" y="0"/>
                  </a:cubicBezTo>
                  <a:cubicBezTo>
                    <a:pt x="89" y="2"/>
                    <a:pt x="144" y="3"/>
                    <a:pt x="165" y="3"/>
                  </a:cubicBezTo>
                  <a:cubicBezTo>
                    <a:pt x="189" y="3"/>
                    <a:pt x="241" y="2"/>
                    <a:pt x="323" y="0"/>
                  </a:cubicBezTo>
                  <a:cubicBezTo>
                    <a:pt x="323" y="33"/>
                    <a:pt x="323" y="33"/>
                    <a:pt x="323" y="33"/>
                  </a:cubicBezTo>
                  <a:cubicBezTo>
                    <a:pt x="279" y="34"/>
                    <a:pt x="253" y="36"/>
                    <a:pt x="243" y="39"/>
                  </a:cubicBezTo>
                  <a:cubicBezTo>
                    <a:pt x="234" y="42"/>
                    <a:pt x="228" y="46"/>
                    <a:pt x="224" y="51"/>
                  </a:cubicBezTo>
                  <a:cubicBezTo>
                    <a:pt x="220" y="58"/>
                    <a:pt x="217" y="75"/>
                    <a:pt x="216" y="102"/>
                  </a:cubicBezTo>
                  <a:cubicBezTo>
                    <a:pt x="215" y="109"/>
                    <a:pt x="214" y="159"/>
                    <a:pt x="213" y="252"/>
                  </a:cubicBezTo>
                  <a:cubicBezTo>
                    <a:pt x="213" y="606"/>
                    <a:pt x="213" y="606"/>
                    <a:pt x="213" y="606"/>
                  </a:cubicBezTo>
                  <a:cubicBezTo>
                    <a:pt x="213" y="643"/>
                    <a:pt x="214" y="673"/>
                    <a:pt x="216" y="696"/>
                  </a:cubicBezTo>
                  <a:cubicBezTo>
                    <a:pt x="257" y="699"/>
                    <a:pt x="262" y="700"/>
                    <a:pt x="303" y="700"/>
                  </a:cubicBezTo>
                  <a:cubicBezTo>
                    <a:pt x="407" y="700"/>
                    <a:pt x="484" y="693"/>
                    <a:pt x="525" y="681"/>
                  </a:cubicBezTo>
                  <a:cubicBezTo>
                    <a:pt x="530" y="670"/>
                    <a:pt x="534" y="658"/>
                    <a:pt x="538" y="644"/>
                  </a:cubicBezTo>
                  <a:cubicBezTo>
                    <a:pt x="560" y="557"/>
                    <a:pt x="560" y="557"/>
                    <a:pt x="560" y="557"/>
                  </a:cubicBezTo>
                  <a:cubicBezTo>
                    <a:pt x="596" y="557"/>
                    <a:pt x="596" y="557"/>
                    <a:pt x="596" y="557"/>
                  </a:cubicBezTo>
                  <a:cubicBezTo>
                    <a:pt x="588" y="609"/>
                    <a:pt x="580" y="671"/>
                    <a:pt x="573" y="741"/>
                  </a:cubicBezTo>
                  <a:cubicBezTo>
                    <a:pt x="558" y="744"/>
                    <a:pt x="546" y="745"/>
                    <a:pt x="537" y="746"/>
                  </a:cubicBezTo>
                  <a:cubicBezTo>
                    <a:pt x="518" y="747"/>
                    <a:pt x="488" y="747"/>
                    <a:pt x="449" y="747"/>
                  </a:cubicBezTo>
                  <a:cubicBezTo>
                    <a:pt x="156" y="744"/>
                    <a:pt x="156" y="744"/>
                    <a:pt x="156" y="744"/>
                  </a:cubicBezTo>
                  <a:cubicBezTo>
                    <a:pt x="121" y="744"/>
                    <a:pt x="85" y="745"/>
                    <a:pt x="49"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3" name="Freeform 7"/>
            <p:cNvSpPr>
              <a:spLocks/>
            </p:cNvSpPr>
            <p:nvPr userDrawn="1"/>
          </p:nvSpPr>
          <p:spPr bwMode="auto">
            <a:xfrm>
              <a:off x="1127125" y="1003301"/>
              <a:ext cx="103188" cy="236538"/>
            </a:xfrm>
            <a:custGeom>
              <a:avLst/>
              <a:gdLst>
                <a:gd name="T0" fmla="*/ 321 w 321"/>
                <a:gd name="T1" fmla="*/ 714 h 747"/>
                <a:gd name="T2" fmla="*/ 321 w 321"/>
                <a:gd name="T3" fmla="*/ 747 h 747"/>
                <a:gd name="T4" fmla="*/ 168 w 321"/>
                <a:gd name="T5" fmla="*/ 744 h 747"/>
                <a:gd name="T6" fmla="*/ 0 w 321"/>
                <a:gd name="T7" fmla="*/ 747 h 747"/>
                <a:gd name="T8" fmla="*/ 0 w 321"/>
                <a:gd name="T9" fmla="*/ 714 h 747"/>
                <a:gd name="T10" fmla="*/ 77 w 321"/>
                <a:gd name="T11" fmla="*/ 708 h 747"/>
                <a:gd name="T12" fmla="*/ 97 w 321"/>
                <a:gd name="T13" fmla="*/ 696 h 747"/>
                <a:gd name="T14" fmla="*/ 105 w 321"/>
                <a:gd name="T15" fmla="*/ 645 h 747"/>
                <a:gd name="T16" fmla="*/ 108 w 321"/>
                <a:gd name="T17" fmla="*/ 495 h 747"/>
                <a:gd name="T18" fmla="*/ 108 w 321"/>
                <a:gd name="T19" fmla="*/ 251 h 747"/>
                <a:gd name="T20" fmla="*/ 105 w 321"/>
                <a:gd name="T21" fmla="*/ 111 h 747"/>
                <a:gd name="T22" fmla="*/ 97 w 321"/>
                <a:gd name="T23" fmla="*/ 52 h 747"/>
                <a:gd name="T24" fmla="*/ 77 w 321"/>
                <a:gd name="T25" fmla="*/ 39 h 747"/>
                <a:gd name="T26" fmla="*/ 0 w 321"/>
                <a:gd name="T27" fmla="*/ 33 h 747"/>
                <a:gd name="T28" fmla="*/ 0 w 321"/>
                <a:gd name="T29" fmla="*/ 0 h 747"/>
                <a:gd name="T30" fmla="*/ 161 w 321"/>
                <a:gd name="T31" fmla="*/ 3 h 747"/>
                <a:gd name="T32" fmla="*/ 321 w 321"/>
                <a:gd name="T33" fmla="*/ 0 h 747"/>
                <a:gd name="T34" fmla="*/ 321 w 321"/>
                <a:gd name="T35" fmla="*/ 33 h 747"/>
                <a:gd name="T36" fmla="*/ 243 w 321"/>
                <a:gd name="T37" fmla="*/ 39 h 747"/>
                <a:gd name="T38" fmla="*/ 224 w 321"/>
                <a:gd name="T39" fmla="*/ 51 h 747"/>
                <a:gd name="T40" fmla="*/ 216 w 321"/>
                <a:gd name="T41" fmla="*/ 102 h 747"/>
                <a:gd name="T42" fmla="*/ 212 w 321"/>
                <a:gd name="T43" fmla="*/ 251 h 747"/>
                <a:gd name="T44" fmla="*/ 212 w 321"/>
                <a:gd name="T45" fmla="*/ 495 h 747"/>
                <a:gd name="T46" fmla="*/ 214 w 321"/>
                <a:gd name="T47" fmla="*/ 635 h 747"/>
                <a:gd name="T48" fmla="*/ 222 w 321"/>
                <a:gd name="T49" fmla="*/ 694 h 747"/>
                <a:gd name="T50" fmla="*/ 242 w 321"/>
                <a:gd name="T51" fmla="*/ 708 h 747"/>
                <a:gd name="T52" fmla="*/ 321 w 321"/>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1" h="747">
                  <a:moveTo>
                    <a:pt x="321" y="714"/>
                  </a:moveTo>
                  <a:cubicBezTo>
                    <a:pt x="321" y="747"/>
                    <a:pt x="321" y="747"/>
                    <a:pt x="321" y="747"/>
                  </a:cubicBezTo>
                  <a:cubicBezTo>
                    <a:pt x="244" y="745"/>
                    <a:pt x="193" y="744"/>
                    <a:pt x="168" y="744"/>
                  </a:cubicBezTo>
                  <a:cubicBezTo>
                    <a:pt x="0" y="747"/>
                    <a:pt x="0" y="747"/>
                    <a:pt x="0" y="747"/>
                  </a:cubicBezTo>
                  <a:cubicBezTo>
                    <a:pt x="0" y="714"/>
                    <a:pt x="0" y="714"/>
                    <a:pt x="0" y="714"/>
                  </a:cubicBezTo>
                  <a:cubicBezTo>
                    <a:pt x="42" y="713"/>
                    <a:pt x="68" y="711"/>
                    <a:pt x="77" y="708"/>
                  </a:cubicBezTo>
                  <a:cubicBezTo>
                    <a:pt x="87" y="705"/>
                    <a:pt x="93" y="701"/>
                    <a:pt x="97" y="696"/>
                  </a:cubicBezTo>
                  <a:cubicBezTo>
                    <a:pt x="101" y="689"/>
                    <a:pt x="104" y="672"/>
                    <a:pt x="105" y="645"/>
                  </a:cubicBezTo>
                  <a:cubicBezTo>
                    <a:pt x="106" y="637"/>
                    <a:pt x="107" y="587"/>
                    <a:pt x="108" y="495"/>
                  </a:cubicBezTo>
                  <a:cubicBezTo>
                    <a:pt x="108" y="251"/>
                    <a:pt x="108" y="251"/>
                    <a:pt x="108" y="251"/>
                  </a:cubicBezTo>
                  <a:cubicBezTo>
                    <a:pt x="108" y="204"/>
                    <a:pt x="107" y="157"/>
                    <a:pt x="105" y="111"/>
                  </a:cubicBezTo>
                  <a:cubicBezTo>
                    <a:pt x="104" y="78"/>
                    <a:pt x="102" y="59"/>
                    <a:pt x="97" y="52"/>
                  </a:cubicBezTo>
                  <a:cubicBezTo>
                    <a:pt x="93" y="46"/>
                    <a:pt x="87" y="41"/>
                    <a:pt x="77" y="39"/>
                  </a:cubicBezTo>
                  <a:cubicBezTo>
                    <a:pt x="68" y="36"/>
                    <a:pt x="42" y="34"/>
                    <a:pt x="0" y="33"/>
                  </a:cubicBezTo>
                  <a:cubicBezTo>
                    <a:pt x="0" y="0"/>
                    <a:pt x="0" y="0"/>
                    <a:pt x="0" y="0"/>
                  </a:cubicBezTo>
                  <a:cubicBezTo>
                    <a:pt x="69" y="2"/>
                    <a:pt x="123" y="3"/>
                    <a:pt x="161" y="3"/>
                  </a:cubicBezTo>
                  <a:cubicBezTo>
                    <a:pt x="197" y="3"/>
                    <a:pt x="250" y="2"/>
                    <a:pt x="321" y="0"/>
                  </a:cubicBezTo>
                  <a:cubicBezTo>
                    <a:pt x="321" y="33"/>
                    <a:pt x="321" y="33"/>
                    <a:pt x="321" y="33"/>
                  </a:cubicBezTo>
                  <a:cubicBezTo>
                    <a:pt x="278" y="34"/>
                    <a:pt x="252" y="36"/>
                    <a:pt x="243" y="39"/>
                  </a:cubicBezTo>
                  <a:cubicBezTo>
                    <a:pt x="234" y="41"/>
                    <a:pt x="227" y="46"/>
                    <a:pt x="224" y="51"/>
                  </a:cubicBezTo>
                  <a:cubicBezTo>
                    <a:pt x="219" y="58"/>
                    <a:pt x="217" y="75"/>
                    <a:pt x="216" y="102"/>
                  </a:cubicBezTo>
                  <a:cubicBezTo>
                    <a:pt x="215" y="109"/>
                    <a:pt x="214" y="159"/>
                    <a:pt x="212" y="251"/>
                  </a:cubicBezTo>
                  <a:cubicBezTo>
                    <a:pt x="212" y="495"/>
                    <a:pt x="212" y="495"/>
                    <a:pt x="212" y="495"/>
                  </a:cubicBezTo>
                  <a:cubicBezTo>
                    <a:pt x="212" y="543"/>
                    <a:pt x="213" y="589"/>
                    <a:pt x="214" y="635"/>
                  </a:cubicBezTo>
                  <a:cubicBezTo>
                    <a:pt x="215" y="668"/>
                    <a:pt x="218" y="688"/>
                    <a:pt x="222" y="694"/>
                  </a:cubicBezTo>
                  <a:cubicBezTo>
                    <a:pt x="226" y="700"/>
                    <a:pt x="233" y="705"/>
                    <a:pt x="242" y="708"/>
                  </a:cubicBezTo>
                  <a:cubicBezTo>
                    <a:pt x="251" y="711"/>
                    <a:pt x="278" y="713"/>
                    <a:pt x="321"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4" name="Freeform 8"/>
            <p:cNvSpPr>
              <a:spLocks/>
            </p:cNvSpPr>
            <p:nvPr userDrawn="1"/>
          </p:nvSpPr>
          <p:spPr bwMode="auto">
            <a:xfrm>
              <a:off x="1266825" y="1003301"/>
              <a:ext cx="276225" cy="242888"/>
            </a:xfrm>
            <a:custGeom>
              <a:avLst/>
              <a:gdLst>
                <a:gd name="T0" fmla="*/ 5 w 869"/>
                <a:gd name="T1" fmla="*/ 747 h 766"/>
                <a:gd name="T2" fmla="*/ 5 w 869"/>
                <a:gd name="T3" fmla="*/ 714 h 766"/>
                <a:gd name="T4" fmla="*/ 80 w 869"/>
                <a:gd name="T5" fmla="*/ 705 h 766"/>
                <a:gd name="T6" fmla="*/ 91 w 869"/>
                <a:gd name="T7" fmla="*/ 695 h 766"/>
                <a:gd name="T8" fmla="*/ 99 w 869"/>
                <a:gd name="T9" fmla="*/ 640 h 766"/>
                <a:gd name="T10" fmla="*/ 102 w 869"/>
                <a:gd name="T11" fmla="*/ 520 h 766"/>
                <a:gd name="T12" fmla="*/ 102 w 869"/>
                <a:gd name="T13" fmla="*/ 92 h 766"/>
                <a:gd name="T14" fmla="*/ 100 w 869"/>
                <a:gd name="T15" fmla="*/ 69 h 766"/>
                <a:gd name="T16" fmla="*/ 80 w 869"/>
                <a:gd name="T17" fmla="*/ 47 h 766"/>
                <a:gd name="T18" fmla="*/ 57 w 869"/>
                <a:gd name="T19" fmla="*/ 36 h 766"/>
                <a:gd name="T20" fmla="*/ 0 w 869"/>
                <a:gd name="T21" fmla="*/ 33 h 766"/>
                <a:gd name="T22" fmla="*/ 0 w 869"/>
                <a:gd name="T23" fmla="*/ 0 h 766"/>
                <a:gd name="T24" fmla="*/ 119 w 869"/>
                <a:gd name="T25" fmla="*/ 3 h 766"/>
                <a:gd name="T26" fmla="*/ 202 w 869"/>
                <a:gd name="T27" fmla="*/ 0 h 766"/>
                <a:gd name="T28" fmla="*/ 269 w 869"/>
                <a:gd name="T29" fmla="*/ 86 h 766"/>
                <a:gd name="T30" fmla="*/ 381 w 869"/>
                <a:gd name="T31" fmla="*/ 220 h 766"/>
                <a:gd name="T32" fmla="*/ 545 w 869"/>
                <a:gd name="T33" fmla="*/ 411 h 766"/>
                <a:gd name="T34" fmla="*/ 671 w 869"/>
                <a:gd name="T35" fmla="*/ 554 h 766"/>
                <a:gd name="T36" fmla="*/ 721 w 869"/>
                <a:gd name="T37" fmla="*/ 609 h 766"/>
                <a:gd name="T38" fmla="*/ 721 w 869"/>
                <a:gd name="T39" fmla="*/ 226 h 766"/>
                <a:gd name="T40" fmla="*/ 718 w 869"/>
                <a:gd name="T41" fmla="*/ 105 h 766"/>
                <a:gd name="T42" fmla="*/ 711 w 869"/>
                <a:gd name="T43" fmla="*/ 51 h 766"/>
                <a:gd name="T44" fmla="*/ 699 w 869"/>
                <a:gd name="T45" fmla="*/ 41 h 766"/>
                <a:gd name="T46" fmla="*/ 624 w 869"/>
                <a:gd name="T47" fmla="*/ 33 h 766"/>
                <a:gd name="T48" fmla="*/ 624 w 869"/>
                <a:gd name="T49" fmla="*/ 0 h 766"/>
                <a:gd name="T50" fmla="*/ 756 w 869"/>
                <a:gd name="T51" fmla="*/ 3 h 766"/>
                <a:gd name="T52" fmla="*/ 869 w 869"/>
                <a:gd name="T53" fmla="*/ 0 h 766"/>
                <a:gd name="T54" fmla="*/ 869 w 869"/>
                <a:gd name="T55" fmla="*/ 33 h 766"/>
                <a:gd name="T56" fmla="*/ 794 w 869"/>
                <a:gd name="T57" fmla="*/ 41 h 766"/>
                <a:gd name="T58" fmla="*/ 783 w 869"/>
                <a:gd name="T59" fmla="*/ 52 h 766"/>
                <a:gd name="T60" fmla="*/ 775 w 869"/>
                <a:gd name="T61" fmla="*/ 107 h 766"/>
                <a:gd name="T62" fmla="*/ 772 w 869"/>
                <a:gd name="T63" fmla="*/ 226 h 766"/>
                <a:gd name="T64" fmla="*/ 772 w 869"/>
                <a:gd name="T65" fmla="*/ 479 h 766"/>
                <a:gd name="T66" fmla="*/ 775 w 869"/>
                <a:gd name="T67" fmla="*/ 766 h 766"/>
                <a:gd name="T68" fmla="*/ 721 w 869"/>
                <a:gd name="T69" fmla="*/ 766 h 766"/>
                <a:gd name="T70" fmla="*/ 707 w 869"/>
                <a:gd name="T71" fmla="*/ 752 h 766"/>
                <a:gd name="T72" fmla="*/ 698 w 869"/>
                <a:gd name="T73" fmla="*/ 744 h 766"/>
                <a:gd name="T74" fmla="*/ 678 w 869"/>
                <a:gd name="T75" fmla="*/ 723 h 766"/>
                <a:gd name="T76" fmla="*/ 611 w 869"/>
                <a:gd name="T77" fmla="*/ 647 h 766"/>
                <a:gd name="T78" fmla="*/ 540 w 869"/>
                <a:gd name="T79" fmla="*/ 560 h 766"/>
                <a:gd name="T80" fmla="*/ 151 w 869"/>
                <a:gd name="T81" fmla="*/ 110 h 766"/>
                <a:gd name="T82" fmla="*/ 151 w 869"/>
                <a:gd name="T83" fmla="*/ 518 h 766"/>
                <a:gd name="T84" fmla="*/ 154 w 869"/>
                <a:gd name="T85" fmla="*/ 641 h 766"/>
                <a:gd name="T86" fmla="*/ 161 w 869"/>
                <a:gd name="T87" fmla="*/ 695 h 766"/>
                <a:gd name="T88" fmla="*/ 173 w 869"/>
                <a:gd name="T89" fmla="*/ 705 h 766"/>
                <a:gd name="T90" fmla="*/ 249 w 869"/>
                <a:gd name="T91" fmla="*/ 714 h 766"/>
                <a:gd name="T92" fmla="*/ 249 w 869"/>
                <a:gd name="T93" fmla="*/ 747 h 766"/>
                <a:gd name="T94" fmla="*/ 143 w 869"/>
                <a:gd name="T95" fmla="*/ 744 h 766"/>
                <a:gd name="T96" fmla="*/ 5 w 869"/>
                <a:gd name="T97" fmla="*/ 747 h 76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869" h="766">
                  <a:moveTo>
                    <a:pt x="5" y="747"/>
                  </a:moveTo>
                  <a:cubicBezTo>
                    <a:pt x="5" y="714"/>
                    <a:pt x="5" y="714"/>
                    <a:pt x="5" y="714"/>
                  </a:cubicBezTo>
                  <a:cubicBezTo>
                    <a:pt x="43" y="714"/>
                    <a:pt x="68" y="711"/>
                    <a:pt x="80" y="705"/>
                  </a:cubicBezTo>
                  <a:cubicBezTo>
                    <a:pt x="86" y="703"/>
                    <a:pt x="89" y="700"/>
                    <a:pt x="91" y="695"/>
                  </a:cubicBezTo>
                  <a:cubicBezTo>
                    <a:pt x="95" y="688"/>
                    <a:pt x="98" y="670"/>
                    <a:pt x="99" y="640"/>
                  </a:cubicBezTo>
                  <a:cubicBezTo>
                    <a:pt x="101" y="594"/>
                    <a:pt x="102" y="554"/>
                    <a:pt x="102" y="520"/>
                  </a:cubicBezTo>
                  <a:cubicBezTo>
                    <a:pt x="102" y="92"/>
                    <a:pt x="102" y="92"/>
                    <a:pt x="102" y="92"/>
                  </a:cubicBezTo>
                  <a:cubicBezTo>
                    <a:pt x="102" y="80"/>
                    <a:pt x="102" y="73"/>
                    <a:pt x="100" y="69"/>
                  </a:cubicBezTo>
                  <a:cubicBezTo>
                    <a:pt x="97" y="63"/>
                    <a:pt x="91" y="56"/>
                    <a:pt x="80" y="47"/>
                  </a:cubicBezTo>
                  <a:cubicBezTo>
                    <a:pt x="74" y="41"/>
                    <a:pt x="66" y="38"/>
                    <a:pt x="57" y="36"/>
                  </a:cubicBezTo>
                  <a:cubicBezTo>
                    <a:pt x="49" y="34"/>
                    <a:pt x="30" y="33"/>
                    <a:pt x="0" y="33"/>
                  </a:cubicBezTo>
                  <a:cubicBezTo>
                    <a:pt x="0" y="0"/>
                    <a:pt x="0" y="0"/>
                    <a:pt x="0" y="0"/>
                  </a:cubicBezTo>
                  <a:cubicBezTo>
                    <a:pt x="63" y="2"/>
                    <a:pt x="103" y="3"/>
                    <a:pt x="119" y="3"/>
                  </a:cubicBezTo>
                  <a:cubicBezTo>
                    <a:pt x="147" y="3"/>
                    <a:pt x="174" y="2"/>
                    <a:pt x="202" y="0"/>
                  </a:cubicBezTo>
                  <a:cubicBezTo>
                    <a:pt x="232" y="39"/>
                    <a:pt x="255" y="67"/>
                    <a:pt x="269" y="86"/>
                  </a:cubicBezTo>
                  <a:cubicBezTo>
                    <a:pt x="381" y="220"/>
                    <a:pt x="381" y="220"/>
                    <a:pt x="381" y="220"/>
                  </a:cubicBezTo>
                  <a:cubicBezTo>
                    <a:pt x="545" y="411"/>
                    <a:pt x="545" y="411"/>
                    <a:pt x="545" y="411"/>
                  </a:cubicBezTo>
                  <a:cubicBezTo>
                    <a:pt x="597" y="472"/>
                    <a:pt x="639" y="520"/>
                    <a:pt x="671" y="554"/>
                  </a:cubicBezTo>
                  <a:cubicBezTo>
                    <a:pt x="691" y="578"/>
                    <a:pt x="708" y="596"/>
                    <a:pt x="721" y="609"/>
                  </a:cubicBezTo>
                  <a:cubicBezTo>
                    <a:pt x="721" y="226"/>
                    <a:pt x="721" y="226"/>
                    <a:pt x="721" y="226"/>
                  </a:cubicBezTo>
                  <a:cubicBezTo>
                    <a:pt x="721" y="191"/>
                    <a:pt x="720" y="151"/>
                    <a:pt x="718" y="105"/>
                  </a:cubicBezTo>
                  <a:cubicBezTo>
                    <a:pt x="717" y="76"/>
                    <a:pt x="714" y="58"/>
                    <a:pt x="711" y="51"/>
                  </a:cubicBezTo>
                  <a:cubicBezTo>
                    <a:pt x="708" y="46"/>
                    <a:pt x="705" y="43"/>
                    <a:pt x="699" y="41"/>
                  </a:cubicBezTo>
                  <a:cubicBezTo>
                    <a:pt x="687" y="36"/>
                    <a:pt x="662" y="33"/>
                    <a:pt x="624" y="33"/>
                  </a:cubicBezTo>
                  <a:cubicBezTo>
                    <a:pt x="624" y="0"/>
                    <a:pt x="624" y="0"/>
                    <a:pt x="624" y="0"/>
                  </a:cubicBezTo>
                  <a:cubicBezTo>
                    <a:pt x="667" y="2"/>
                    <a:pt x="711" y="3"/>
                    <a:pt x="756" y="3"/>
                  </a:cubicBezTo>
                  <a:cubicBezTo>
                    <a:pt x="797" y="3"/>
                    <a:pt x="835" y="2"/>
                    <a:pt x="869" y="0"/>
                  </a:cubicBezTo>
                  <a:cubicBezTo>
                    <a:pt x="869" y="33"/>
                    <a:pt x="869" y="33"/>
                    <a:pt x="869" y="33"/>
                  </a:cubicBezTo>
                  <a:cubicBezTo>
                    <a:pt x="831" y="33"/>
                    <a:pt x="806" y="36"/>
                    <a:pt x="794" y="41"/>
                  </a:cubicBezTo>
                  <a:cubicBezTo>
                    <a:pt x="789" y="43"/>
                    <a:pt x="785" y="47"/>
                    <a:pt x="783" y="52"/>
                  </a:cubicBezTo>
                  <a:cubicBezTo>
                    <a:pt x="779" y="58"/>
                    <a:pt x="776" y="77"/>
                    <a:pt x="775" y="107"/>
                  </a:cubicBezTo>
                  <a:cubicBezTo>
                    <a:pt x="773" y="153"/>
                    <a:pt x="772" y="193"/>
                    <a:pt x="772" y="226"/>
                  </a:cubicBezTo>
                  <a:cubicBezTo>
                    <a:pt x="772" y="479"/>
                    <a:pt x="772" y="479"/>
                    <a:pt x="772" y="479"/>
                  </a:cubicBezTo>
                  <a:cubicBezTo>
                    <a:pt x="772" y="531"/>
                    <a:pt x="773" y="626"/>
                    <a:pt x="775" y="766"/>
                  </a:cubicBezTo>
                  <a:cubicBezTo>
                    <a:pt x="721" y="766"/>
                    <a:pt x="721" y="766"/>
                    <a:pt x="721" y="766"/>
                  </a:cubicBezTo>
                  <a:cubicBezTo>
                    <a:pt x="707" y="752"/>
                    <a:pt x="707" y="752"/>
                    <a:pt x="707" y="752"/>
                  </a:cubicBezTo>
                  <a:cubicBezTo>
                    <a:pt x="705" y="751"/>
                    <a:pt x="700" y="746"/>
                    <a:pt x="698" y="744"/>
                  </a:cubicBezTo>
                  <a:cubicBezTo>
                    <a:pt x="696" y="742"/>
                    <a:pt x="689" y="735"/>
                    <a:pt x="678" y="723"/>
                  </a:cubicBezTo>
                  <a:cubicBezTo>
                    <a:pt x="647" y="689"/>
                    <a:pt x="625" y="664"/>
                    <a:pt x="611" y="647"/>
                  </a:cubicBezTo>
                  <a:cubicBezTo>
                    <a:pt x="540" y="560"/>
                    <a:pt x="540" y="560"/>
                    <a:pt x="540" y="560"/>
                  </a:cubicBezTo>
                  <a:cubicBezTo>
                    <a:pt x="151" y="110"/>
                    <a:pt x="151" y="110"/>
                    <a:pt x="151" y="110"/>
                  </a:cubicBezTo>
                  <a:cubicBezTo>
                    <a:pt x="151" y="518"/>
                    <a:pt x="151" y="518"/>
                    <a:pt x="151" y="518"/>
                  </a:cubicBezTo>
                  <a:cubicBezTo>
                    <a:pt x="151" y="552"/>
                    <a:pt x="152" y="593"/>
                    <a:pt x="154" y="641"/>
                  </a:cubicBezTo>
                  <a:cubicBezTo>
                    <a:pt x="156" y="670"/>
                    <a:pt x="158" y="688"/>
                    <a:pt x="161" y="695"/>
                  </a:cubicBezTo>
                  <a:cubicBezTo>
                    <a:pt x="164" y="700"/>
                    <a:pt x="168" y="704"/>
                    <a:pt x="173" y="705"/>
                  </a:cubicBezTo>
                  <a:cubicBezTo>
                    <a:pt x="185" y="711"/>
                    <a:pt x="210" y="714"/>
                    <a:pt x="249" y="714"/>
                  </a:cubicBezTo>
                  <a:cubicBezTo>
                    <a:pt x="249" y="747"/>
                    <a:pt x="249" y="747"/>
                    <a:pt x="249" y="747"/>
                  </a:cubicBezTo>
                  <a:cubicBezTo>
                    <a:pt x="217" y="745"/>
                    <a:pt x="181" y="744"/>
                    <a:pt x="143" y="744"/>
                  </a:cubicBezTo>
                  <a:cubicBezTo>
                    <a:pt x="100" y="744"/>
                    <a:pt x="54" y="745"/>
                    <a:pt x="5"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5" name="Freeform 9"/>
            <p:cNvSpPr>
              <a:spLocks/>
            </p:cNvSpPr>
            <p:nvPr userDrawn="1"/>
          </p:nvSpPr>
          <p:spPr bwMode="auto">
            <a:xfrm>
              <a:off x="1573213" y="1003301"/>
              <a:ext cx="101600" cy="236538"/>
            </a:xfrm>
            <a:custGeom>
              <a:avLst/>
              <a:gdLst>
                <a:gd name="T0" fmla="*/ 322 w 322"/>
                <a:gd name="T1" fmla="*/ 714 h 747"/>
                <a:gd name="T2" fmla="*/ 322 w 322"/>
                <a:gd name="T3" fmla="*/ 747 h 747"/>
                <a:gd name="T4" fmla="*/ 169 w 322"/>
                <a:gd name="T5" fmla="*/ 744 h 747"/>
                <a:gd name="T6" fmla="*/ 0 w 322"/>
                <a:gd name="T7" fmla="*/ 747 h 747"/>
                <a:gd name="T8" fmla="*/ 0 w 322"/>
                <a:gd name="T9" fmla="*/ 714 h 747"/>
                <a:gd name="T10" fmla="*/ 79 w 322"/>
                <a:gd name="T11" fmla="*/ 708 h 747"/>
                <a:gd name="T12" fmla="*/ 98 w 322"/>
                <a:gd name="T13" fmla="*/ 696 h 747"/>
                <a:gd name="T14" fmla="*/ 106 w 322"/>
                <a:gd name="T15" fmla="*/ 645 h 747"/>
                <a:gd name="T16" fmla="*/ 109 w 322"/>
                <a:gd name="T17" fmla="*/ 495 h 747"/>
                <a:gd name="T18" fmla="*/ 109 w 322"/>
                <a:gd name="T19" fmla="*/ 251 h 747"/>
                <a:gd name="T20" fmla="*/ 106 w 322"/>
                <a:gd name="T21" fmla="*/ 111 h 747"/>
                <a:gd name="T22" fmla="*/ 98 w 322"/>
                <a:gd name="T23" fmla="*/ 52 h 747"/>
                <a:gd name="T24" fmla="*/ 78 w 322"/>
                <a:gd name="T25" fmla="*/ 39 h 747"/>
                <a:gd name="T26" fmla="*/ 0 w 322"/>
                <a:gd name="T27" fmla="*/ 33 h 747"/>
                <a:gd name="T28" fmla="*/ 0 w 322"/>
                <a:gd name="T29" fmla="*/ 0 h 747"/>
                <a:gd name="T30" fmla="*/ 161 w 322"/>
                <a:gd name="T31" fmla="*/ 3 h 747"/>
                <a:gd name="T32" fmla="*/ 322 w 322"/>
                <a:gd name="T33" fmla="*/ 0 h 747"/>
                <a:gd name="T34" fmla="*/ 322 w 322"/>
                <a:gd name="T35" fmla="*/ 33 h 747"/>
                <a:gd name="T36" fmla="*/ 244 w 322"/>
                <a:gd name="T37" fmla="*/ 39 h 747"/>
                <a:gd name="T38" fmla="*/ 224 w 322"/>
                <a:gd name="T39" fmla="*/ 51 h 747"/>
                <a:gd name="T40" fmla="*/ 216 w 322"/>
                <a:gd name="T41" fmla="*/ 102 h 747"/>
                <a:gd name="T42" fmla="*/ 213 w 322"/>
                <a:gd name="T43" fmla="*/ 251 h 747"/>
                <a:gd name="T44" fmla="*/ 213 w 322"/>
                <a:gd name="T45" fmla="*/ 495 h 747"/>
                <a:gd name="T46" fmla="*/ 215 w 322"/>
                <a:gd name="T47" fmla="*/ 635 h 747"/>
                <a:gd name="T48" fmla="*/ 223 w 322"/>
                <a:gd name="T49" fmla="*/ 694 h 747"/>
                <a:gd name="T50" fmla="*/ 243 w 322"/>
                <a:gd name="T51" fmla="*/ 708 h 747"/>
                <a:gd name="T52" fmla="*/ 322 w 322"/>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2" h="747">
                  <a:moveTo>
                    <a:pt x="322" y="714"/>
                  </a:moveTo>
                  <a:cubicBezTo>
                    <a:pt x="322" y="747"/>
                    <a:pt x="322" y="747"/>
                    <a:pt x="322" y="747"/>
                  </a:cubicBezTo>
                  <a:cubicBezTo>
                    <a:pt x="244" y="745"/>
                    <a:pt x="193" y="744"/>
                    <a:pt x="169" y="744"/>
                  </a:cubicBezTo>
                  <a:cubicBezTo>
                    <a:pt x="0" y="747"/>
                    <a:pt x="0" y="747"/>
                    <a:pt x="0" y="747"/>
                  </a:cubicBezTo>
                  <a:cubicBezTo>
                    <a:pt x="0" y="714"/>
                    <a:pt x="0" y="714"/>
                    <a:pt x="0" y="714"/>
                  </a:cubicBezTo>
                  <a:cubicBezTo>
                    <a:pt x="43" y="713"/>
                    <a:pt x="69" y="711"/>
                    <a:pt x="79" y="708"/>
                  </a:cubicBezTo>
                  <a:cubicBezTo>
                    <a:pt x="88" y="705"/>
                    <a:pt x="94" y="701"/>
                    <a:pt x="98" y="696"/>
                  </a:cubicBezTo>
                  <a:cubicBezTo>
                    <a:pt x="102" y="689"/>
                    <a:pt x="105" y="672"/>
                    <a:pt x="106" y="645"/>
                  </a:cubicBezTo>
                  <a:cubicBezTo>
                    <a:pt x="107" y="637"/>
                    <a:pt x="108" y="587"/>
                    <a:pt x="109" y="495"/>
                  </a:cubicBezTo>
                  <a:cubicBezTo>
                    <a:pt x="109" y="251"/>
                    <a:pt x="109" y="251"/>
                    <a:pt x="109" y="251"/>
                  </a:cubicBezTo>
                  <a:cubicBezTo>
                    <a:pt x="109" y="204"/>
                    <a:pt x="108" y="157"/>
                    <a:pt x="106" y="111"/>
                  </a:cubicBezTo>
                  <a:cubicBezTo>
                    <a:pt x="105" y="78"/>
                    <a:pt x="102" y="59"/>
                    <a:pt x="98" y="52"/>
                  </a:cubicBezTo>
                  <a:cubicBezTo>
                    <a:pt x="94" y="46"/>
                    <a:pt x="88" y="41"/>
                    <a:pt x="78" y="39"/>
                  </a:cubicBezTo>
                  <a:cubicBezTo>
                    <a:pt x="69" y="36"/>
                    <a:pt x="43" y="34"/>
                    <a:pt x="0" y="33"/>
                  </a:cubicBezTo>
                  <a:cubicBezTo>
                    <a:pt x="0" y="0"/>
                    <a:pt x="0" y="0"/>
                    <a:pt x="0" y="0"/>
                  </a:cubicBezTo>
                  <a:cubicBezTo>
                    <a:pt x="70" y="2"/>
                    <a:pt x="124" y="3"/>
                    <a:pt x="161" y="3"/>
                  </a:cubicBezTo>
                  <a:cubicBezTo>
                    <a:pt x="198" y="3"/>
                    <a:pt x="251" y="2"/>
                    <a:pt x="322" y="0"/>
                  </a:cubicBezTo>
                  <a:cubicBezTo>
                    <a:pt x="322" y="33"/>
                    <a:pt x="322" y="33"/>
                    <a:pt x="322" y="33"/>
                  </a:cubicBezTo>
                  <a:cubicBezTo>
                    <a:pt x="279" y="34"/>
                    <a:pt x="253" y="36"/>
                    <a:pt x="244" y="39"/>
                  </a:cubicBezTo>
                  <a:cubicBezTo>
                    <a:pt x="234" y="41"/>
                    <a:pt x="228" y="46"/>
                    <a:pt x="224" y="51"/>
                  </a:cubicBezTo>
                  <a:cubicBezTo>
                    <a:pt x="220" y="58"/>
                    <a:pt x="217" y="75"/>
                    <a:pt x="216" y="102"/>
                  </a:cubicBezTo>
                  <a:cubicBezTo>
                    <a:pt x="216" y="109"/>
                    <a:pt x="215" y="159"/>
                    <a:pt x="213" y="251"/>
                  </a:cubicBezTo>
                  <a:cubicBezTo>
                    <a:pt x="213" y="495"/>
                    <a:pt x="213" y="495"/>
                    <a:pt x="213" y="495"/>
                  </a:cubicBezTo>
                  <a:cubicBezTo>
                    <a:pt x="213" y="543"/>
                    <a:pt x="214" y="589"/>
                    <a:pt x="215" y="635"/>
                  </a:cubicBezTo>
                  <a:cubicBezTo>
                    <a:pt x="216" y="668"/>
                    <a:pt x="219" y="688"/>
                    <a:pt x="223" y="694"/>
                  </a:cubicBezTo>
                  <a:cubicBezTo>
                    <a:pt x="227" y="700"/>
                    <a:pt x="234" y="705"/>
                    <a:pt x="243" y="708"/>
                  </a:cubicBezTo>
                  <a:cubicBezTo>
                    <a:pt x="252" y="711"/>
                    <a:pt x="278" y="713"/>
                    <a:pt x="322"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6" name="Freeform 10"/>
            <p:cNvSpPr>
              <a:spLocks/>
            </p:cNvSpPr>
            <p:nvPr userDrawn="1"/>
          </p:nvSpPr>
          <p:spPr bwMode="auto">
            <a:xfrm>
              <a:off x="1692275" y="998538"/>
              <a:ext cx="231775" cy="246063"/>
            </a:xfrm>
            <a:custGeom>
              <a:avLst/>
              <a:gdLst>
                <a:gd name="T0" fmla="*/ 728 w 728"/>
                <a:gd name="T1" fmla="*/ 667 h 774"/>
                <a:gd name="T2" fmla="*/ 707 w 728"/>
                <a:gd name="T3" fmla="*/ 716 h 774"/>
                <a:gd name="T4" fmla="*/ 581 w 728"/>
                <a:gd name="T5" fmla="*/ 761 h 774"/>
                <a:gd name="T6" fmla="*/ 447 w 728"/>
                <a:gd name="T7" fmla="*/ 774 h 774"/>
                <a:gd name="T8" fmla="*/ 288 w 728"/>
                <a:gd name="T9" fmla="*/ 754 h 774"/>
                <a:gd name="T10" fmla="*/ 161 w 728"/>
                <a:gd name="T11" fmla="*/ 696 h 774"/>
                <a:gd name="T12" fmla="*/ 71 w 728"/>
                <a:gd name="T13" fmla="*/ 610 h 774"/>
                <a:gd name="T14" fmla="*/ 18 w 728"/>
                <a:gd name="T15" fmla="*/ 508 h 774"/>
                <a:gd name="T16" fmla="*/ 0 w 728"/>
                <a:gd name="T17" fmla="*/ 386 h 774"/>
                <a:gd name="T18" fmla="*/ 123 w 728"/>
                <a:gd name="T19" fmla="*/ 110 h 774"/>
                <a:gd name="T20" fmla="*/ 457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5 w 728"/>
                <a:gd name="T35" fmla="*/ 143 h 774"/>
                <a:gd name="T36" fmla="*/ 605 w 728"/>
                <a:gd name="T37" fmla="*/ 66 h 774"/>
                <a:gd name="T38" fmla="*/ 446 w 728"/>
                <a:gd name="T39" fmla="*/ 41 h 774"/>
                <a:gd name="T40" fmla="*/ 313 w 728"/>
                <a:gd name="T41" fmla="*/ 60 h 774"/>
                <a:gd name="T42" fmla="*/ 217 w 728"/>
                <a:gd name="T43" fmla="*/ 117 h 774"/>
                <a:gd name="T44" fmla="*/ 149 w 728"/>
                <a:gd name="T45" fmla="*/ 216 h 774"/>
                <a:gd name="T46" fmla="*/ 122 w 728"/>
                <a:gd name="T47" fmla="*/ 366 h 774"/>
                <a:gd name="T48" fmla="*/ 223 w 728"/>
                <a:gd name="T49" fmla="*/ 621 h 774"/>
                <a:gd name="T50" fmla="*/ 492 w 728"/>
                <a:gd name="T51" fmla="*/ 717 h 774"/>
                <a:gd name="T52" fmla="*/ 632 w 728"/>
                <a:gd name="T53" fmla="*/ 698 h 774"/>
                <a:gd name="T54" fmla="*/ 719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7" y="716"/>
                    <a:pt x="707" y="716"/>
                    <a:pt x="707" y="716"/>
                  </a:cubicBezTo>
                  <a:cubicBezTo>
                    <a:pt x="664" y="736"/>
                    <a:pt x="622" y="751"/>
                    <a:pt x="581" y="761"/>
                  </a:cubicBezTo>
                  <a:cubicBezTo>
                    <a:pt x="540" y="770"/>
                    <a:pt x="495" y="774"/>
                    <a:pt x="447" y="774"/>
                  </a:cubicBezTo>
                  <a:cubicBezTo>
                    <a:pt x="390" y="774"/>
                    <a:pt x="337" y="768"/>
                    <a:pt x="288" y="754"/>
                  </a:cubicBezTo>
                  <a:cubicBezTo>
                    <a:pt x="240" y="740"/>
                    <a:pt x="197" y="721"/>
                    <a:pt x="161" y="696"/>
                  </a:cubicBezTo>
                  <a:cubicBezTo>
                    <a:pt x="124" y="670"/>
                    <a:pt x="94" y="642"/>
                    <a:pt x="71" y="610"/>
                  </a:cubicBezTo>
                  <a:cubicBezTo>
                    <a:pt x="48" y="579"/>
                    <a:pt x="31" y="545"/>
                    <a:pt x="18" y="508"/>
                  </a:cubicBezTo>
                  <a:cubicBezTo>
                    <a:pt x="6" y="471"/>
                    <a:pt x="0" y="430"/>
                    <a:pt x="0" y="386"/>
                  </a:cubicBezTo>
                  <a:cubicBezTo>
                    <a:pt x="0" y="275"/>
                    <a:pt x="41" y="183"/>
                    <a:pt x="123" y="110"/>
                  </a:cubicBezTo>
                  <a:cubicBezTo>
                    <a:pt x="204" y="37"/>
                    <a:pt x="316" y="0"/>
                    <a:pt x="457" y="0"/>
                  </a:cubicBezTo>
                  <a:cubicBezTo>
                    <a:pt x="490" y="0"/>
                    <a:pt x="521" y="2"/>
                    <a:pt x="549" y="6"/>
                  </a:cubicBezTo>
                  <a:cubicBezTo>
                    <a:pt x="578"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5" y="143"/>
                    <a:pt x="665" y="143"/>
                    <a:pt x="665" y="143"/>
                  </a:cubicBezTo>
                  <a:cubicBezTo>
                    <a:pt x="661" y="109"/>
                    <a:pt x="641" y="83"/>
                    <a:pt x="605" y="66"/>
                  </a:cubicBezTo>
                  <a:cubicBezTo>
                    <a:pt x="569" y="50"/>
                    <a:pt x="516" y="41"/>
                    <a:pt x="446" y="41"/>
                  </a:cubicBezTo>
                  <a:cubicBezTo>
                    <a:pt x="393" y="42"/>
                    <a:pt x="349" y="48"/>
                    <a:pt x="313" y="60"/>
                  </a:cubicBezTo>
                  <a:cubicBezTo>
                    <a:pt x="277" y="72"/>
                    <a:pt x="245" y="91"/>
                    <a:pt x="217" y="117"/>
                  </a:cubicBezTo>
                  <a:cubicBezTo>
                    <a:pt x="189" y="143"/>
                    <a:pt x="166" y="176"/>
                    <a:pt x="149" y="216"/>
                  </a:cubicBezTo>
                  <a:cubicBezTo>
                    <a:pt x="131" y="256"/>
                    <a:pt x="122" y="306"/>
                    <a:pt x="122" y="366"/>
                  </a:cubicBezTo>
                  <a:cubicBezTo>
                    <a:pt x="122" y="472"/>
                    <a:pt x="155" y="557"/>
                    <a:pt x="223" y="621"/>
                  </a:cubicBezTo>
                  <a:cubicBezTo>
                    <a:pt x="291" y="685"/>
                    <a:pt x="380" y="717"/>
                    <a:pt x="492" y="717"/>
                  </a:cubicBezTo>
                  <a:cubicBezTo>
                    <a:pt x="542" y="717"/>
                    <a:pt x="589" y="711"/>
                    <a:pt x="632" y="698"/>
                  </a:cubicBezTo>
                  <a:cubicBezTo>
                    <a:pt x="661" y="689"/>
                    <a:pt x="690" y="675"/>
                    <a:pt x="719"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7" name="Freeform 11"/>
            <p:cNvSpPr>
              <a:spLocks/>
            </p:cNvSpPr>
            <p:nvPr userDrawn="1"/>
          </p:nvSpPr>
          <p:spPr bwMode="auto">
            <a:xfrm>
              <a:off x="657225" y="998538"/>
              <a:ext cx="231775" cy="246063"/>
            </a:xfrm>
            <a:custGeom>
              <a:avLst/>
              <a:gdLst>
                <a:gd name="T0" fmla="*/ 728 w 728"/>
                <a:gd name="T1" fmla="*/ 667 h 774"/>
                <a:gd name="T2" fmla="*/ 706 w 728"/>
                <a:gd name="T3" fmla="*/ 716 h 774"/>
                <a:gd name="T4" fmla="*/ 580 w 728"/>
                <a:gd name="T5" fmla="*/ 761 h 774"/>
                <a:gd name="T6" fmla="*/ 446 w 728"/>
                <a:gd name="T7" fmla="*/ 774 h 774"/>
                <a:gd name="T8" fmla="*/ 288 w 728"/>
                <a:gd name="T9" fmla="*/ 754 h 774"/>
                <a:gd name="T10" fmla="*/ 160 w 728"/>
                <a:gd name="T11" fmla="*/ 696 h 774"/>
                <a:gd name="T12" fmla="*/ 71 w 728"/>
                <a:gd name="T13" fmla="*/ 610 h 774"/>
                <a:gd name="T14" fmla="*/ 18 w 728"/>
                <a:gd name="T15" fmla="*/ 508 h 774"/>
                <a:gd name="T16" fmla="*/ 0 w 728"/>
                <a:gd name="T17" fmla="*/ 386 h 774"/>
                <a:gd name="T18" fmla="*/ 122 w 728"/>
                <a:gd name="T19" fmla="*/ 110 h 774"/>
                <a:gd name="T20" fmla="*/ 456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4 w 728"/>
                <a:gd name="T35" fmla="*/ 143 h 774"/>
                <a:gd name="T36" fmla="*/ 604 w 728"/>
                <a:gd name="T37" fmla="*/ 66 h 774"/>
                <a:gd name="T38" fmla="*/ 445 w 728"/>
                <a:gd name="T39" fmla="*/ 41 h 774"/>
                <a:gd name="T40" fmla="*/ 313 w 728"/>
                <a:gd name="T41" fmla="*/ 60 h 774"/>
                <a:gd name="T42" fmla="*/ 216 w 728"/>
                <a:gd name="T43" fmla="*/ 117 h 774"/>
                <a:gd name="T44" fmla="*/ 148 w 728"/>
                <a:gd name="T45" fmla="*/ 216 h 774"/>
                <a:gd name="T46" fmla="*/ 121 w 728"/>
                <a:gd name="T47" fmla="*/ 366 h 774"/>
                <a:gd name="T48" fmla="*/ 223 w 728"/>
                <a:gd name="T49" fmla="*/ 621 h 774"/>
                <a:gd name="T50" fmla="*/ 492 w 728"/>
                <a:gd name="T51" fmla="*/ 717 h 774"/>
                <a:gd name="T52" fmla="*/ 631 w 728"/>
                <a:gd name="T53" fmla="*/ 698 h 774"/>
                <a:gd name="T54" fmla="*/ 718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6" y="716"/>
                    <a:pt x="706" y="716"/>
                    <a:pt x="706" y="716"/>
                  </a:cubicBezTo>
                  <a:cubicBezTo>
                    <a:pt x="663" y="736"/>
                    <a:pt x="621" y="751"/>
                    <a:pt x="580" y="761"/>
                  </a:cubicBezTo>
                  <a:cubicBezTo>
                    <a:pt x="539" y="770"/>
                    <a:pt x="495" y="774"/>
                    <a:pt x="446" y="774"/>
                  </a:cubicBezTo>
                  <a:cubicBezTo>
                    <a:pt x="389" y="774"/>
                    <a:pt x="337" y="768"/>
                    <a:pt x="288" y="754"/>
                  </a:cubicBezTo>
                  <a:cubicBezTo>
                    <a:pt x="239" y="740"/>
                    <a:pt x="197" y="721"/>
                    <a:pt x="160" y="696"/>
                  </a:cubicBezTo>
                  <a:cubicBezTo>
                    <a:pt x="124" y="670"/>
                    <a:pt x="94" y="642"/>
                    <a:pt x="71" y="610"/>
                  </a:cubicBezTo>
                  <a:cubicBezTo>
                    <a:pt x="48" y="579"/>
                    <a:pt x="30" y="545"/>
                    <a:pt x="18" y="508"/>
                  </a:cubicBezTo>
                  <a:cubicBezTo>
                    <a:pt x="6" y="471"/>
                    <a:pt x="0" y="430"/>
                    <a:pt x="0" y="386"/>
                  </a:cubicBezTo>
                  <a:cubicBezTo>
                    <a:pt x="0" y="275"/>
                    <a:pt x="41" y="183"/>
                    <a:pt x="122" y="110"/>
                  </a:cubicBezTo>
                  <a:cubicBezTo>
                    <a:pt x="204" y="37"/>
                    <a:pt x="315" y="0"/>
                    <a:pt x="456" y="0"/>
                  </a:cubicBezTo>
                  <a:cubicBezTo>
                    <a:pt x="490" y="0"/>
                    <a:pt x="520" y="2"/>
                    <a:pt x="549" y="6"/>
                  </a:cubicBezTo>
                  <a:cubicBezTo>
                    <a:pt x="577"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4" y="143"/>
                    <a:pt x="664" y="143"/>
                    <a:pt x="664" y="143"/>
                  </a:cubicBezTo>
                  <a:cubicBezTo>
                    <a:pt x="661" y="109"/>
                    <a:pt x="641" y="83"/>
                    <a:pt x="604" y="66"/>
                  </a:cubicBezTo>
                  <a:cubicBezTo>
                    <a:pt x="568" y="50"/>
                    <a:pt x="515" y="41"/>
                    <a:pt x="445" y="41"/>
                  </a:cubicBezTo>
                  <a:cubicBezTo>
                    <a:pt x="393" y="42"/>
                    <a:pt x="349" y="48"/>
                    <a:pt x="313" y="60"/>
                  </a:cubicBezTo>
                  <a:cubicBezTo>
                    <a:pt x="276" y="72"/>
                    <a:pt x="244" y="91"/>
                    <a:pt x="216" y="117"/>
                  </a:cubicBezTo>
                  <a:cubicBezTo>
                    <a:pt x="189" y="143"/>
                    <a:pt x="166" y="176"/>
                    <a:pt x="148" y="216"/>
                  </a:cubicBezTo>
                  <a:cubicBezTo>
                    <a:pt x="131" y="256"/>
                    <a:pt x="122" y="306"/>
                    <a:pt x="121" y="366"/>
                  </a:cubicBezTo>
                  <a:cubicBezTo>
                    <a:pt x="121" y="472"/>
                    <a:pt x="155" y="557"/>
                    <a:pt x="223" y="621"/>
                  </a:cubicBezTo>
                  <a:cubicBezTo>
                    <a:pt x="290" y="685"/>
                    <a:pt x="380" y="717"/>
                    <a:pt x="492" y="717"/>
                  </a:cubicBezTo>
                  <a:cubicBezTo>
                    <a:pt x="542" y="717"/>
                    <a:pt x="588" y="711"/>
                    <a:pt x="631" y="698"/>
                  </a:cubicBezTo>
                  <a:cubicBezTo>
                    <a:pt x="660" y="689"/>
                    <a:pt x="689" y="675"/>
                    <a:pt x="718"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8" name="Freeform 12"/>
            <p:cNvSpPr>
              <a:spLocks/>
            </p:cNvSpPr>
            <p:nvPr userDrawn="1"/>
          </p:nvSpPr>
          <p:spPr bwMode="auto">
            <a:xfrm>
              <a:off x="757238" y="687388"/>
              <a:ext cx="323850" cy="239713"/>
            </a:xfrm>
            <a:custGeom>
              <a:avLst/>
              <a:gdLst>
                <a:gd name="T0" fmla="*/ 0 w 1017"/>
                <a:gd name="T1" fmla="*/ 35 h 754"/>
                <a:gd name="T2" fmla="*/ 0 w 1017"/>
                <a:gd name="T3" fmla="*/ 0 h 754"/>
                <a:gd name="T4" fmla="*/ 110 w 1017"/>
                <a:gd name="T5" fmla="*/ 4 h 754"/>
                <a:gd name="T6" fmla="*/ 212 w 1017"/>
                <a:gd name="T7" fmla="*/ 0 h 754"/>
                <a:gd name="T8" fmla="*/ 300 w 1017"/>
                <a:gd name="T9" fmla="*/ 183 h 754"/>
                <a:gd name="T10" fmla="*/ 509 w 1017"/>
                <a:gd name="T11" fmla="*/ 592 h 754"/>
                <a:gd name="T12" fmla="*/ 697 w 1017"/>
                <a:gd name="T13" fmla="*/ 218 h 754"/>
                <a:gd name="T14" fmla="*/ 800 w 1017"/>
                <a:gd name="T15" fmla="*/ 0 h 754"/>
                <a:gd name="T16" fmla="*/ 898 w 1017"/>
                <a:gd name="T17" fmla="*/ 4 h 754"/>
                <a:gd name="T18" fmla="*/ 1017 w 1017"/>
                <a:gd name="T19" fmla="*/ 0 h 754"/>
                <a:gd name="T20" fmla="*/ 1017 w 1017"/>
                <a:gd name="T21" fmla="*/ 35 h 754"/>
                <a:gd name="T22" fmla="*/ 938 w 1017"/>
                <a:gd name="T23" fmla="*/ 40 h 754"/>
                <a:gd name="T24" fmla="*/ 918 w 1017"/>
                <a:gd name="T25" fmla="*/ 53 h 754"/>
                <a:gd name="T26" fmla="*/ 910 w 1017"/>
                <a:gd name="T27" fmla="*/ 103 h 754"/>
                <a:gd name="T28" fmla="*/ 907 w 1017"/>
                <a:gd name="T29" fmla="*/ 251 h 754"/>
                <a:gd name="T30" fmla="*/ 907 w 1017"/>
                <a:gd name="T31" fmla="*/ 492 h 754"/>
                <a:gd name="T32" fmla="*/ 910 w 1017"/>
                <a:gd name="T33" fmla="*/ 631 h 754"/>
                <a:gd name="T34" fmla="*/ 918 w 1017"/>
                <a:gd name="T35" fmla="*/ 690 h 754"/>
                <a:gd name="T36" fmla="*/ 938 w 1017"/>
                <a:gd name="T37" fmla="*/ 704 h 754"/>
                <a:gd name="T38" fmla="*/ 1017 w 1017"/>
                <a:gd name="T39" fmla="*/ 709 h 754"/>
                <a:gd name="T40" fmla="*/ 1017 w 1017"/>
                <a:gd name="T41" fmla="*/ 743 h 754"/>
                <a:gd name="T42" fmla="*/ 861 w 1017"/>
                <a:gd name="T43" fmla="*/ 739 h 754"/>
                <a:gd name="T44" fmla="*/ 699 w 1017"/>
                <a:gd name="T45" fmla="*/ 743 h 754"/>
                <a:gd name="T46" fmla="*/ 699 w 1017"/>
                <a:gd name="T47" fmla="*/ 709 h 754"/>
                <a:gd name="T48" fmla="*/ 778 w 1017"/>
                <a:gd name="T49" fmla="*/ 704 h 754"/>
                <a:gd name="T50" fmla="*/ 797 w 1017"/>
                <a:gd name="T51" fmla="*/ 691 h 754"/>
                <a:gd name="T52" fmla="*/ 806 w 1017"/>
                <a:gd name="T53" fmla="*/ 641 h 754"/>
                <a:gd name="T54" fmla="*/ 808 w 1017"/>
                <a:gd name="T55" fmla="*/ 492 h 754"/>
                <a:gd name="T56" fmla="*/ 808 w 1017"/>
                <a:gd name="T57" fmla="*/ 108 h 754"/>
                <a:gd name="T58" fmla="*/ 619 w 1017"/>
                <a:gd name="T59" fmla="*/ 486 h 754"/>
                <a:gd name="T60" fmla="*/ 549 w 1017"/>
                <a:gd name="T61" fmla="*/ 629 h 754"/>
                <a:gd name="T62" fmla="*/ 494 w 1017"/>
                <a:gd name="T63" fmla="*/ 754 h 754"/>
                <a:gd name="T64" fmla="*/ 472 w 1017"/>
                <a:gd name="T65" fmla="*/ 754 h 754"/>
                <a:gd name="T66" fmla="*/ 459 w 1017"/>
                <a:gd name="T67" fmla="*/ 722 h 754"/>
                <a:gd name="T68" fmla="*/ 422 w 1017"/>
                <a:gd name="T69" fmla="*/ 645 h 754"/>
                <a:gd name="T70" fmla="*/ 159 w 1017"/>
                <a:gd name="T71" fmla="*/ 126 h 754"/>
                <a:gd name="T72" fmla="*/ 159 w 1017"/>
                <a:gd name="T73" fmla="*/ 492 h 754"/>
                <a:gd name="T74" fmla="*/ 163 w 1017"/>
                <a:gd name="T75" fmla="*/ 631 h 754"/>
                <a:gd name="T76" fmla="*/ 171 w 1017"/>
                <a:gd name="T77" fmla="*/ 690 h 754"/>
                <a:gd name="T78" fmla="*/ 191 w 1017"/>
                <a:gd name="T79" fmla="*/ 704 h 754"/>
                <a:gd name="T80" fmla="*/ 271 w 1017"/>
                <a:gd name="T81" fmla="*/ 709 h 754"/>
                <a:gd name="T82" fmla="*/ 271 w 1017"/>
                <a:gd name="T83" fmla="*/ 743 h 754"/>
                <a:gd name="T84" fmla="*/ 138 w 1017"/>
                <a:gd name="T85" fmla="*/ 739 h 754"/>
                <a:gd name="T86" fmla="*/ 0 w 1017"/>
                <a:gd name="T87" fmla="*/ 743 h 754"/>
                <a:gd name="T88" fmla="*/ 0 w 1017"/>
                <a:gd name="T89" fmla="*/ 709 h 754"/>
                <a:gd name="T90" fmla="*/ 79 w 1017"/>
                <a:gd name="T91" fmla="*/ 704 h 754"/>
                <a:gd name="T92" fmla="*/ 98 w 1017"/>
                <a:gd name="T93" fmla="*/ 691 h 754"/>
                <a:gd name="T94" fmla="*/ 107 w 1017"/>
                <a:gd name="T95" fmla="*/ 641 h 754"/>
                <a:gd name="T96" fmla="*/ 109 w 1017"/>
                <a:gd name="T97" fmla="*/ 492 h 754"/>
                <a:gd name="T98" fmla="*/ 109 w 1017"/>
                <a:gd name="T99" fmla="*/ 251 h 754"/>
                <a:gd name="T100" fmla="*/ 107 w 1017"/>
                <a:gd name="T101" fmla="*/ 112 h 754"/>
                <a:gd name="T102" fmla="*/ 99 w 1017"/>
                <a:gd name="T103" fmla="*/ 54 h 754"/>
                <a:gd name="T104" fmla="*/ 78 w 1017"/>
                <a:gd name="T105" fmla="*/ 40 h 754"/>
                <a:gd name="T106" fmla="*/ 0 w 1017"/>
                <a:gd name="T107" fmla="*/ 35 h 75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Lst>
              <a:rect l="0" t="0" r="r" b="b"/>
              <a:pathLst>
                <a:path w="1017" h="754">
                  <a:moveTo>
                    <a:pt x="0" y="35"/>
                  </a:moveTo>
                  <a:cubicBezTo>
                    <a:pt x="0" y="0"/>
                    <a:pt x="0" y="0"/>
                    <a:pt x="0" y="0"/>
                  </a:cubicBezTo>
                  <a:cubicBezTo>
                    <a:pt x="38" y="2"/>
                    <a:pt x="75" y="4"/>
                    <a:pt x="110" y="4"/>
                  </a:cubicBezTo>
                  <a:cubicBezTo>
                    <a:pt x="145" y="4"/>
                    <a:pt x="179" y="2"/>
                    <a:pt x="212" y="0"/>
                  </a:cubicBezTo>
                  <a:cubicBezTo>
                    <a:pt x="244" y="70"/>
                    <a:pt x="274" y="131"/>
                    <a:pt x="300" y="183"/>
                  </a:cubicBezTo>
                  <a:cubicBezTo>
                    <a:pt x="509" y="592"/>
                    <a:pt x="509" y="592"/>
                    <a:pt x="509" y="592"/>
                  </a:cubicBezTo>
                  <a:cubicBezTo>
                    <a:pt x="697" y="218"/>
                    <a:pt x="697" y="218"/>
                    <a:pt x="697" y="218"/>
                  </a:cubicBezTo>
                  <a:cubicBezTo>
                    <a:pt x="749" y="116"/>
                    <a:pt x="783" y="43"/>
                    <a:pt x="800" y="0"/>
                  </a:cubicBezTo>
                  <a:cubicBezTo>
                    <a:pt x="839" y="2"/>
                    <a:pt x="872" y="4"/>
                    <a:pt x="898" y="4"/>
                  </a:cubicBezTo>
                  <a:cubicBezTo>
                    <a:pt x="923" y="4"/>
                    <a:pt x="962" y="2"/>
                    <a:pt x="1017" y="0"/>
                  </a:cubicBezTo>
                  <a:cubicBezTo>
                    <a:pt x="1017" y="35"/>
                    <a:pt x="1017" y="35"/>
                    <a:pt x="1017" y="35"/>
                  </a:cubicBezTo>
                  <a:cubicBezTo>
                    <a:pt x="974" y="35"/>
                    <a:pt x="947" y="37"/>
                    <a:pt x="938" y="40"/>
                  </a:cubicBezTo>
                  <a:cubicBezTo>
                    <a:pt x="928" y="43"/>
                    <a:pt x="922" y="47"/>
                    <a:pt x="918" y="53"/>
                  </a:cubicBezTo>
                  <a:cubicBezTo>
                    <a:pt x="914" y="60"/>
                    <a:pt x="911" y="76"/>
                    <a:pt x="910" y="103"/>
                  </a:cubicBezTo>
                  <a:cubicBezTo>
                    <a:pt x="910" y="110"/>
                    <a:pt x="909" y="159"/>
                    <a:pt x="907" y="251"/>
                  </a:cubicBezTo>
                  <a:cubicBezTo>
                    <a:pt x="907" y="492"/>
                    <a:pt x="907" y="492"/>
                    <a:pt x="907" y="492"/>
                  </a:cubicBezTo>
                  <a:cubicBezTo>
                    <a:pt x="907" y="540"/>
                    <a:pt x="908" y="586"/>
                    <a:pt x="910" y="631"/>
                  </a:cubicBezTo>
                  <a:cubicBezTo>
                    <a:pt x="911" y="664"/>
                    <a:pt x="914" y="684"/>
                    <a:pt x="918" y="690"/>
                  </a:cubicBezTo>
                  <a:cubicBezTo>
                    <a:pt x="922" y="696"/>
                    <a:pt x="929" y="701"/>
                    <a:pt x="938" y="704"/>
                  </a:cubicBezTo>
                  <a:cubicBezTo>
                    <a:pt x="948" y="707"/>
                    <a:pt x="974" y="709"/>
                    <a:pt x="1017" y="709"/>
                  </a:cubicBezTo>
                  <a:cubicBezTo>
                    <a:pt x="1017" y="743"/>
                    <a:pt x="1017" y="743"/>
                    <a:pt x="1017" y="743"/>
                  </a:cubicBezTo>
                  <a:cubicBezTo>
                    <a:pt x="943" y="740"/>
                    <a:pt x="891" y="739"/>
                    <a:pt x="861" y="739"/>
                  </a:cubicBezTo>
                  <a:cubicBezTo>
                    <a:pt x="837" y="739"/>
                    <a:pt x="782" y="740"/>
                    <a:pt x="699" y="743"/>
                  </a:cubicBezTo>
                  <a:cubicBezTo>
                    <a:pt x="699" y="709"/>
                    <a:pt x="699" y="709"/>
                    <a:pt x="699" y="709"/>
                  </a:cubicBezTo>
                  <a:cubicBezTo>
                    <a:pt x="742" y="709"/>
                    <a:pt x="768" y="707"/>
                    <a:pt x="778" y="704"/>
                  </a:cubicBezTo>
                  <a:cubicBezTo>
                    <a:pt x="788" y="701"/>
                    <a:pt x="794" y="697"/>
                    <a:pt x="797" y="691"/>
                  </a:cubicBezTo>
                  <a:cubicBezTo>
                    <a:pt x="802" y="684"/>
                    <a:pt x="805" y="668"/>
                    <a:pt x="806" y="641"/>
                  </a:cubicBezTo>
                  <a:cubicBezTo>
                    <a:pt x="806" y="633"/>
                    <a:pt x="807" y="584"/>
                    <a:pt x="808" y="492"/>
                  </a:cubicBezTo>
                  <a:cubicBezTo>
                    <a:pt x="808" y="108"/>
                    <a:pt x="808" y="108"/>
                    <a:pt x="808" y="108"/>
                  </a:cubicBezTo>
                  <a:cubicBezTo>
                    <a:pt x="619" y="486"/>
                    <a:pt x="619" y="486"/>
                    <a:pt x="619" y="486"/>
                  </a:cubicBezTo>
                  <a:cubicBezTo>
                    <a:pt x="589" y="545"/>
                    <a:pt x="566" y="593"/>
                    <a:pt x="549" y="629"/>
                  </a:cubicBezTo>
                  <a:cubicBezTo>
                    <a:pt x="537" y="655"/>
                    <a:pt x="518" y="696"/>
                    <a:pt x="494" y="754"/>
                  </a:cubicBezTo>
                  <a:cubicBezTo>
                    <a:pt x="472" y="754"/>
                    <a:pt x="472" y="754"/>
                    <a:pt x="472" y="754"/>
                  </a:cubicBezTo>
                  <a:cubicBezTo>
                    <a:pt x="468" y="740"/>
                    <a:pt x="463" y="729"/>
                    <a:pt x="459" y="722"/>
                  </a:cubicBezTo>
                  <a:cubicBezTo>
                    <a:pt x="422" y="645"/>
                    <a:pt x="422" y="645"/>
                    <a:pt x="422" y="645"/>
                  </a:cubicBezTo>
                  <a:cubicBezTo>
                    <a:pt x="159" y="126"/>
                    <a:pt x="159" y="126"/>
                    <a:pt x="159" y="126"/>
                  </a:cubicBezTo>
                  <a:cubicBezTo>
                    <a:pt x="159" y="492"/>
                    <a:pt x="159" y="492"/>
                    <a:pt x="159" y="492"/>
                  </a:cubicBezTo>
                  <a:cubicBezTo>
                    <a:pt x="159" y="540"/>
                    <a:pt x="160" y="586"/>
                    <a:pt x="163" y="631"/>
                  </a:cubicBezTo>
                  <a:cubicBezTo>
                    <a:pt x="164" y="664"/>
                    <a:pt x="167" y="683"/>
                    <a:pt x="171" y="690"/>
                  </a:cubicBezTo>
                  <a:cubicBezTo>
                    <a:pt x="175" y="696"/>
                    <a:pt x="182" y="701"/>
                    <a:pt x="191" y="704"/>
                  </a:cubicBezTo>
                  <a:cubicBezTo>
                    <a:pt x="200" y="707"/>
                    <a:pt x="227" y="709"/>
                    <a:pt x="271" y="709"/>
                  </a:cubicBezTo>
                  <a:cubicBezTo>
                    <a:pt x="271" y="743"/>
                    <a:pt x="271" y="743"/>
                    <a:pt x="271" y="743"/>
                  </a:cubicBezTo>
                  <a:cubicBezTo>
                    <a:pt x="138" y="739"/>
                    <a:pt x="138" y="739"/>
                    <a:pt x="138" y="739"/>
                  </a:cubicBezTo>
                  <a:cubicBezTo>
                    <a:pt x="0" y="743"/>
                    <a:pt x="0" y="743"/>
                    <a:pt x="0" y="743"/>
                  </a:cubicBezTo>
                  <a:cubicBezTo>
                    <a:pt x="0" y="709"/>
                    <a:pt x="0" y="709"/>
                    <a:pt x="0" y="709"/>
                  </a:cubicBezTo>
                  <a:cubicBezTo>
                    <a:pt x="43" y="709"/>
                    <a:pt x="69" y="707"/>
                    <a:pt x="79" y="704"/>
                  </a:cubicBezTo>
                  <a:cubicBezTo>
                    <a:pt x="88" y="701"/>
                    <a:pt x="95" y="697"/>
                    <a:pt x="98" y="691"/>
                  </a:cubicBezTo>
                  <a:cubicBezTo>
                    <a:pt x="103" y="684"/>
                    <a:pt x="105" y="668"/>
                    <a:pt x="107" y="641"/>
                  </a:cubicBezTo>
                  <a:cubicBezTo>
                    <a:pt x="107" y="634"/>
                    <a:pt x="108" y="584"/>
                    <a:pt x="109" y="492"/>
                  </a:cubicBezTo>
                  <a:cubicBezTo>
                    <a:pt x="109" y="251"/>
                    <a:pt x="109" y="251"/>
                    <a:pt x="109" y="251"/>
                  </a:cubicBezTo>
                  <a:cubicBezTo>
                    <a:pt x="109" y="204"/>
                    <a:pt x="108" y="158"/>
                    <a:pt x="107" y="112"/>
                  </a:cubicBezTo>
                  <a:cubicBezTo>
                    <a:pt x="105" y="79"/>
                    <a:pt x="103" y="60"/>
                    <a:pt x="99" y="54"/>
                  </a:cubicBezTo>
                  <a:cubicBezTo>
                    <a:pt x="94" y="48"/>
                    <a:pt x="88" y="43"/>
                    <a:pt x="78" y="40"/>
                  </a:cubicBezTo>
                  <a:cubicBezTo>
                    <a:pt x="69" y="37"/>
                    <a:pt x="43" y="35"/>
                    <a:pt x="0" y="35"/>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9" name="Freeform 13"/>
            <p:cNvSpPr>
              <a:spLocks noEditPoints="1"/>
            </p:cNvSpPr>
            <p:nvPr userDrawn="1"/>
          </p:nvSpPr>
          <p:spPr bwMode="auto">
            <a:xfrm>
              <a:off x="1092200" y="684213"/>
              <a:ext cx="263525" cy="238125"/>
            </a:xfrm>
            <a:custGeom>
              <a:avLst/>
              <a:gdLst>
                <a:gd name="T0" fmla="*/ 117 w 832"/>
                <a:gd name="T1" fmla="*/ 747 h 750"/>
                <a:gd name="T2" fmla="*/ 257 w 832"/>
                <a:gd name="T3" fmla="*/ 750 h 750"/>
                <a:gd name="T4" fmla="*/ 257 w 832"/>
                <a:gd name="T5" fmla="*/ 717 h 750"/>
                <a:gd name="T6" fmla="*/ 185 w 832"/>
                <a:gd name="T7" fmla="*/ 712 h 750"/>
                <a:gd name="T8" fmla="*/ 166 w 832"/>
                <a:gd name="T9" fmla="*/ 702 h 750"/>
                <a:gd name="T10" fmla="*/ 162 w 832"/>
                <a:gd name="T11" fmla="*/ 690 h 750"/>
                <a:gd name="T12" fmla="*/ 178 w 832"/>
                <a:gd name="T13" fmla="*/ 637 h 750"/>
                <a:gd name="T14" fmla="*/ 237 w 832"/>
                <a:gd name="T15" fmla="*/ 503 h 750"/>
                <a:gd name="T16" fmla="*/ 556 w 832"/>
                <a:gd name="T17" fmla="*/ 503 h 750"/>
                <a:gd name="T18" fmla="*/ 624 w 832"/>
                <a:gd name="T19" fmla="*/ 663 h 750"/>
                <a:gd name="T20" fmla="*/ 632 w 832"/>
                <a:gd name="T21" fmla="*/ 693 h 750"/>
                <a:gd name="T22" fmla="*/ 627 w 832"/>
                <a:gd name="T23" fmla="*/ 705 h 750"/>
                <a:gd name="T24" fmla="*/ 609 w 832"/>
                <a:gd name="T25" fmla="*/ 713 h 750"/>
                <a:gd name="T26" fmla="*/ 535 w 832"/>
                <a:gd name="T27" fmla="*/ 717 h 750"/>
                <a:gd name="T28" fmla="*/ 535 w 832"/>
                <a:gd name="T29" fmla="*/ 750 h 750"/>
                <a:gd name="T30" fmla="*/ 712 w 832"/>
                <a:gd name="T31" fmla="*/ 747 h 750"/>
                <a:gd name="T32" fmla="*/ 832 w 832"/>
                <a:gd name="T33" fmla="*/ 750 h 750"/>
                <a:gd name="T34" fmla="*/ 832 w 832"/>
                <a:gd name="T35" fmla="*/ 717 h 750"/>
                <a:gd name="T36" fmla="*/ 776 w 832"/>
                <a:gd name="T37" fmla="*/ 710 h 750"/>
                <a:gd name="T38" fmla="*/ 753 w 832"/>
                <a:gd name="T39" fmla="*/ 687 h 750"/>
                <a:gd name="T40" fmla="*/ 677 w 832"/>
                <a:gd name="T41" fmla="*/ 526 h 750"/>
                <a:gd name="T42" fmla="*/ 441 w 832"/>
                <a:gd name="T43" fmla="*/ 0 h 750"/>
                <a:gd name="T44" fmla="*/ 406 w 832"/>
                <a:gd name="T45" fmla="*/ 0 h 750"/>
                <a:gd name="T46" fmla="*/ 310 w 832"/>
                <a:gd name="T47" fmla="*/ 217 h 750"/>
                <a:gd name="T48" fmla="*/ 172 w 832"/>
                <a:gd name="T49" fmla="*/ 512 h 750"/>
                <a:gd name="T50" fmla="*/ 100 w 832"/>
                <a:gd name="T51" fmla="*/ 660 h 750"/>
                <a:gd name="T52" fmla="*/ 74 w 832"/>
                <a:gd name="T53" fmla="*/ 702 h 750"/>
                <a:gd name="T54" fmla="*/ 54 w 832"/>
                <a:gd name="T55" fmla="*/ 713 h 750"/>
                <a:gd name="T56" fmla="*/ 0 w 832"/>
                <a:gd name="T57" fmla="*/ 717 h 750"/>
                <a:gd name="T58" fmla="*/ 0 w 832"/>
                <a:gd name="T59" fmla="*/ 750 h 750"/>
                <a:gd name="T60" fmla="*/ 117 w 832"/>
                <a:gd name="T61" fmla="*/ 747 h 750"/>
                <a:gd name="T62" fmla="*/ 396 w 832"/>
                <a:gd name="T63" fmla="*/ 143 h 750"/>
                <a:gd name="T64" fmla="*/ 534 w 832"/>
                <a:gd name="T65" fmla="*/ 458 h 750"/>
                <a:gd name="T66" fmla="*/ 256 w 832"/>
                <a:gd name="T67" fmla="*/ 458 h 750"/>
                <a:gd name="T68" fmla="*/ 396 w 832"/>
                <a:gd name="T69" fmla="*/ 143 h 75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Lst>
              <a:rect l="0" t="0" r="r" b="b"/>
              <a:pathLst>
                <a:path w="832" h="750">
                  <a:moveTo>
                    <a:pt x="117" y="747"/>
                  </a:moveTo>
                  <a:cubicBezTo>
                    <a:pt x="148" y="747"/>
                    <a:pt x="195" y="748"/>
                    <a:pt x="257" y="750"/>
                  </a:cubicBezTo>
                  <a:cubicBezTo>
                    <a:pt x="257" y="717"/>
                    <a:pt x="257" y="717"/>
                    <a:pt x="257" y="717"/>
                  </a:cubicBezTo>
                  <a:cubicBezTo>
                    <a:pt x="222" y="716"/>
                    <a:pt x="199" y="715"/>
                    <a:pt x="185" y="712"/>
                  </a:cubicBezTo>
                  <a:cubicBezTo>
                    <a:pt x="177" y="710"/>
                    <a:pt x="170" y="707"/>
                    <a:pt x="166" y="702"/>
                  </a:cubicBezTo>
                  <a:cubicBezTo>
                    <a:pt x="163" y="699"/>
                    <a:pt x="162" y="695"/>
                    <a:pt x="162" y="690"/>
                  </a:cubicBezTo>
                  <a:cubicBezTo>
                    <a:pt x="162" y="679"/>
                    <a:pt x="167" y="662"/>
                    <a:pt x="178" y="637"/>
                  </a:cubicBezTo>
                  <a:cubicBezTo>
                    <a:pt x="237" y="503"/>
                    <a:pt x="237" y="503"/>
                    <a:pt x="237" y="503"/>
                  </a:cubicBezTo>
                  <a:cubicBezTo>
                    <a:pt x="556" y="503"/>
                    <a:pt x="556" y="503"/>
                    <a:pt x="556" y="503"/>
                  </a:cubicBezTo>
                  <a:cubicBezTo>
                    <a:pt x="624" y="663"/>
                    <a:pt x="624" y="663"/>
                    <a:pt x="624" y="663"/>
                  </a:cubicBezTo>
                  <a:cubicBezTo>
                    <a:pt x="629" y="675"/>
                    <a:pt x="632" y="685"/>
                    <a:pt x="632" y="693"/>
                  </a:cubicBezTo>
                  <a:cubicBezTo>
                    <a:pt x="632" y="698"/>
                    <a:pt x="630" y="702"/>
                    <a:pt x="627" y="705"/>
                  </a:cubicBezTo>
                  <a:cubicBezTo>
                    <a:pt x="624" y="708"/>
                    <a:pt x="618" y="711"/>
                    <a:pt x="609" y="713"/>
                  </a:cubicBezTo>
                  <a:cubicBezTo>
                    <a:pt x="601" y="715"/>
                    <a:pt x="576" y="716"/>
                    <a:pt x="535" y="717"/>
                  </a:cubicBezTo>
                  <a:cubicBezTo>
                    <a:pt x="535" y="750"/>
                    <a:pt x="535" y="750"/>
                    <a:pt x="535" y="750"/>
                  </a:cubicBezTo>
                  <a:cubicBezTo>
                    <a:pt x="712" y="747"/>
                    <a:pt x="712" y="747"/>
                    <a:pt x="712" y="747"/>
                  </a:cubicBezTo>
                  <a:cubicBezTo>
                    <a:pt x="734" y="747"/>
                    <a:pt x="775" y="748"/>
                    <a:pt x="832" y="750"/>
                  </a:cubicBezTo>
                  <a:cubicBezTo>
                    <a:pt x="832" y="717"/>
                    <a:pt x="832" y="717"/>
                    <a:pt x="832" y="717"/>
                  </a:cubicBezTo>
                  <a:cubicBezTo>
                    <a:pt x="803" y="716"/>
                    <a:pt x="784" y="714"/>
                    <a:pt x="776" y="710"/>
                  </a:cubicBezTo>
                  <a:cubicBezTo>
                    <a:pt x="767" y="707"/>
                    <a:pt x="760" y="699"/>
                    <a:pt x="753" y="687"/>
                  </a:cubicBezTo>
                  <a:cubicBezTo>
                    <a:pt x="740" y="664"/>
                    <a:pt x="715" y="611"/>
                    <a:pt x="677" y="526"/>
                  </a:cubicBezTo>
                  <a:cubicBezTo>
                    <a:pt x="441" y="0"/>
                    <a:pt x="441" y="0"/>
                    <a:pt x="441" y="0"/>
                  </a:cubicBezTo>
                  <a:cubicBezTo>
                    <a:pt x="406" y="0"/>
                    <a:pt x="406" y="0"/>
                    <a:pt x="406" y="0"/>
                  </a:cubicBezTo>
                  <a:cubicBezTo>
                    <a:pt x="357" y="112"/>
                    <a:pt x="325" y="185"/>
                    <a:pt x="310" y="217"/>
                  </a:cubicBezTo>
                  <a:cubicBezTo>
                    <a:pt x="172" y="512"/>
                    <a:pt x="172" y="512"/>
                    <a:pt x="172" y="512"/>
                  </a:cubicBezTo>
                  <a:cubicBezTo>
                    <a:pt x="131" y="598"/>
                    <a:pt x="107" y="647"/>
                    <a:pt x="100" y="660"/>
                  </a:cubicBezTo>
                  <a:cubicBezTo>
                    <a:pt x="89" y="683"/>
                    <a:pt x="80" y="697"/>
                    <a:pt x="74" y="702"/>
                  </a:cubicBezTo>
                  <a:cubicBezTo>
                    <a:pt x="68" y="708"/>
                    <a:pt x="61" y="711"/>
                    <a:pt x="54" y="713"/>
                  </a:cubicBezTo>
                  <a:cubicBezTo>
                    <a:pt x="47" y="715"/>
                    <a:pt x="29" y="716"/>
                    <a:pt x="0" y="717"/>
                  </a:cubicBezTo>
                  <a:cubicBezTo>
                    <a:pt x="0" y="750"/>
                    <a:pt x="0" y="750"/>
                    <a:pt x="0" y="750"/>
                  </a:cubicBezTo>
                  <a:cubicBezTo>
                    <a:pt x="42" y="748"/>
                    <a:pt x="81" y="747"/>
                    <a:pt x="117" y="747"/>
                  </a:cubicBezTo>
                  <a:close/>
                  <a:moveTo>
                    <a:pt x="396" y="143"/>
                  </a:moveTo>
                  <a:cubicBezTo>
                    <a:pt x="534" y="458"/>
                    <a:pt x="534" y="458"/>
                    <a:pt x="534" y="458"/>
                  </a:cubicBezTo>
                  <a:cubicBezTo>
                    <a:pt x="256" y="458"/>
                    <a:pt x="256" y="458"/>
                    <a:pt x="256" y="458"/>
                  </a:cubicBezTo>
                  <a:lnTo>
                    <a:pt x="396" y="143"/>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0" name="Freeform 14"/>
            <p:cNvSpPr>
              <a:spLocks/>
            </p:cNvSpPr>
            <p:nvPr userDrawn="1"/>
          </p:nvSpPr>
          <p:spPr bwMode="auto">
            <a:xfrm>
              <a:off x="1309688" y="687388"/>
              <a:ext cx="260350" cy="234950"/>
            </a:xfrm>
            <a:custGeom>
              <a:avLst/>
              <a:gdLst>
                <a:gd name="T0" fmla="*/ 601 w 817"/>
                <a:gd name="T1" fmla="*/ 111 h 743"/>
                <a:gd name="T2" fmla="*/ 634 w 817"/>
                <a:gd name="T3" fmla="*/ 52 h 743"/>
                <a:gd name="T4" fmla="*/ 624 w 817"/>
                <a:gd name="T5" fmla="*/ 39 h 743"/>
                <a:gd name="T6" fmla="*/ 543 w 817"/>
                <a:gd name="T7" fmla="*/ 33 h 743"/>
                <a:gd name="T8" fmla="*/ 543 w 817"/>
                <a:gd name="T9" fmla="*/ 0 h 743"/>
                <a:gd name="T10" fmla="*/ 688 w 817"/>
                <a:gd name="T11" fmla="*/ 3 h 743"/>
                <a:gd name="T12" fmla="*/ 817 w 817"/>
                <a:gd name="T13" fmla="*/ 0 h 743"/>
                <a:gd name="T14" fmla="*/ 817 w 817"/>
                <a:gd name="T15" fmla="*/ 33 h 743"/>
                <a:gd name="T16" fmla="*/ 746 w 817"/>
                <a:gd name="T17" fmla="*/ 39 h 743"/>
                <a:gd name="T18" fmla="*/ 718 w 817"/>
                <a:gd name="T19" fmla="*/ 51 h 743"/>
                <a:gd name="T20" fmla="*/ 675 w 817"/>
                <a:gd name="T21" fmla="*/ 102 h 743"/>
                <a:gd name="T22" fmla="*/ 514 w 817"/>
                <a:gd name="T23" fmla="*/ 333 h 743"/>
                <a:gd name="T24" fmla="*/ 461 w 817"/>
                <a:gd name="T25" fmla="*/ 422 h 743"/>
                <a:gd name="T26" fmla="*/ 455 w 817"/>
                <a:gd name="T27" fmla="*/ 453 h 743"/>
                <a:gd name="T28" fmla="*/ 455 w 817"/>
                <a:gd name="T29" fmla="*/ 493 h 743"/>
                <a:gd name="T30" fmla="*/ 459 w 817"/>
                <a:gd name="T31" fmla="*/ 631 h 743"/>
                <a:gd name="T32" fmla="*/ 466 w 817"/>
                <a:gd name="T33" fmla="*/ 690 h 743"/>
                <a:gd name="T34" fmla="*/ 486 w 817"/>
                <a:gd name="T35" fmla="*/ 704 h 743"/>
                <a:gd name="T36" fmla="*/ 564 w 817"/>
                <a:gd name="T37" fmla="*/ 710 h 743"/>
                <a:gd name="T38" fmla="*/ 564 w 817"/>
                <a:gd name="T39" fmla="*/ 743 h 743"/>
                <a:gd name="T40" fmla="*/ 410 w 817"/>
                <a:gd name="T41" fmla="*/ 740 h 743"/>
                <a:gd name="T42" fmla="*/ 244 w 817"/>
                <a:gd name="T43" fmla="*/ 743 h 743"/>
                <a:gd name="T44" fmla="*/ 244 w 817"/>
                <a:gd name="T45" fmla="*/ 710 h 743"/>
                <a:gd name="T46" fmla="*/ 322 w 817"/>
                <a:gd name="T47" fmla="*/ 704 h 743"/>
                <a:gd name="T48" fmla="*/ 341 w 817"/>
                <a:gd name="T49" fmla="*/ 692 h 743"/>
                <a:gd name="T50" fmla="*/ 350 w 817"/>
                <a:gd name="T51" fmla="*/ 641 h 743"/>
                <a:gd name="T52" fmla="*/ 353 w 817"/>
                <a:gd name="T53" fmla="*/ 493 h 743"/>
                <a:gd name="T54" fmla="*/ 353 w 817"/>
                <a:gd name="T55" fmla="*/ 432 h 743"/>
                <a:gd name="T56" fmla="*/ 331 w 817"/>
                <a:gd name="T57" fmla="*/ 390 h 743"/>
                <a:gd name="T58" fmla="*/ 275 w 817"/>
                <a:gd name="T59" fmla="*/ 300 h 743"/>
                <a:gd name="T60" fmla="*/ 135 w 817"/>
                <a:gd name="T61" fmla="*/ 102 h 743"/>
                <a:gd name="T62" fmla="*/ 96 w 817"/>
                <a:gd name="T63" fmla="*/ 51 h 743"/>
                <a:gd name="T64" fmla="*/ 69 w 817"/>
                <a:gd name="T65" fmla="*/ 39 h 743"/>
                <a:gd name="T66" fmla="*/ 0 w 817"/>
                <a:gd name="T67" fmla="*/ 33 h 743"/>
                <a:gd name="T68" fmla="*/ 0 w 817"/>
                <a:gd name="T69" fmla="*/ 0 h 743"/>
                <a:gd name="T70" fmla="*/ 130 w 817"/>
                <a:gd name="T71" fmla="*/ 3 h 743"/>
                <a:gd name="T72" fmla="*/ 333 w 817"/>
                <a:gd name="T73" fmla="*/ 0 h 743"/>
                <a:gd name="T74" fmla="*/ 333 w 817"/>
                <a:gd name="T75" fmla="*/ 33 h 743"/>
                <a:gd name="T76" fmla="*/ 246 w 817"/>
                <a:gd name="T77" fmla="*/ 39 h 743"/>
                <a:gd name="T78" fmla="*/ 234 w 817"/>
                <a:gd name="T79" fmla="*/ 52 h 743"/>
                <a:gd name="T80" fmla="*/ 262 w 817"/>
                <a:gd name="T81" fmla="*/ 111 h 743"/>
                <a:gd name="T82" fmla="*/ 426 w 817"/>
                <a:gd name="T83" fmla="*/ 376 h 743"/>
                <a:gd name="T84" fmla="*/ 601 w 817"/>
                <a:gd name="T85" fmla="*/ 111 h 74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Lst>
              <a:rect l="0" t="0" r="r" b="b"/>
              <a:pathLst>
                <a:path w="817" h="743">
                  <a:moveTo>
                    <a:pt x="601" y="111"/>
                  </a:moveTo>
                  <a:cubicBezTo>
                    <a:pt x="623" y="78"/>
                    <a:pt x="634" y="59"/>
                    <a:pt x="634" y="52"/>
                  </a:cubicBezTo>
                  <a:cubicBezTo>
                    <a:pt x="634" y="46"/>
                    <a:pt x="631" y="41"/>
                    <a:pt x="624" y="39"/>
                  </a:cubicBezTo>
                  <a:cubicBezTo>
                    <a:pt x="616" y="36"/>
                    <a:pt x="585" y="34"/>
                    <a:pt x="543" y="33"/>
                  </a:cubicBezTo>
                  <a:cubicBezTo>
                    <a:pt x="543" y="0"/>
                    <a:pt x="543" y="0"/>
                    <a:pt x="543" y="0"/>
                  </a:cubicBezTo>
                  <a:cubicBezTo>
                    <a:pt x="610" y="2"/>
                    <a:pt x="650" y="3"/>
                    <a:pt x="688" y="3"/>
                  </a:cubicBezTo>
                  <a:cubicBezTo>
                    <a:pt x="725" y="3"/>
                    <a:pt x="745" y="2"/>
                    <a:pt x="817" y="0"/>
                  </a:cubicBezTo>
                  <a:cubicBezTo>
                    <a:pt x="817" y="33"/>
                    <a:pt x="817" y="33"/>
                    <a:pt x="817" y="33"/>
                  </a:cubicBezTo>
                  <a:cubicBezTo>
                    <a:pt x="773" y="34"/>
                    <a:pt x="757" y="36"/>
                    <a:pt x="746" y="39"/>
                  </a:cubicBezTo>
                  <a:cubicBezTo>
                    <a:pt x="735" y="41"/>
                    <a:pt x="725" y="46"/>
                    <a:pt x="718" y="51"/>
                  </a:cubicBezTo>
                  <a:cubicBezTo>
                    <a:pt x="709" y="58"/>
                    <a:pt x="695" y="75"/>
                    <a:pt x="675" y="102"/>
                  </a:cubicBezTo>
                  <a:cubicBezTo>
                    <a:pt x="514" y="333"/>
                    <a:pt x="514" y="333"/>
                    <a:pt x="514" y="333"/>
                  </a:cubicBezTo>
                  <a:cubicBezTo>
                    <a:pt x="483" y="381"/>
                    <a:pt x="465" y="411"/>
                    <a:pt x="461" y="422"/>
                  </a:cubicBezTo>
                  <a:cubicBezTo>
                    <a:pt x="457" y="433"/>
                    <a:pt x="455" y="443"/>
                    <a:pt x="455" y="453"/>
                  </a:cubicBezTo>
                  <a:cubicBezTo>
                    <a:pt x="455" y="493"/>
                    <a:pt x="455" y="493"/>
                    <a:pt x="455" y="493"/>
                  </a:cubicBezTo>
                  <a:cubicBezTo>
                    <a:pt x="455" y="541"/>
                    <a:pt x="456" y="587"/>
                    <a:pt x="459" y="631"/>
                  </a:cubicBezTo>
                  <a:cubicBezTo>
                    <a:pt x="460" y="665"/>
                    <a:pt x="462" y="684"/>
                    <a:pt x="466" y="690"/>
                  </a:cubicBezTo>
                  <a:cubicBezTo>
                    <a:pt x="470" y="696"/>
                    <a:pt x="477" y="701"/>
                    <a:pt x="486" y="704"/>
                  </a:cubicBezTo>
                  <a:cubicBezTo>
                    <a:pt x="495" y="707"/>
                    <a:pt x="521" y="709"/>
                    <a:pt x="564" y="710"/>
                  </a:cubicBezTo>
                  <a:cubicBezTo>
                    <a:pt x="564" y="743"/>
                    <a:pt x="564" y="743"/>
                    <a:pt x="564" y="743"/>
                  </a:cubicBezTo>
                  <a:cubicBezTo>
                    <a:pt x="505" y="741"/>
                    <a:pt x="453" y="740"/>
                    <a:pt x="410" y="740"/>
                  </a:cubicBezTo>
                  <a:cubicBezTo>
                    <a:pt x="368" y="740"/>
                    <a:pt x="313" y="741"/>
                    <a:pt x="244" y="743"/>
                  </a:cubicBezTo>
                  <a:cubicBezTo>
                    <a:pt x="244" y="710"/>
                    <a:pt x="244" y="710"/>
                    <a:pt x="244" y="710"/>
                  </a:cubicBezTo>
                  <a:cubicBezTo>
                    <a:pt x="287" y="709"/>
                    <a:pt x="313" y="707"/>
                    <a:pt x="322" y="704"/>
                  </a:cubicBezTo>
                  <a:cubicBezTo>
                    <a:pt x="332" y="701"/>
                    <a:pt x="338" y="697"/>
                    <a:pt x="341" y="692"/>
                  </a:cubicBezTo>
                  <a:cubicBezTo>
                    <a:pt x="346" y="685"/>
                    <a:pt x="349" y="668"/>
                    <a:pt x="350" y="641"/>
                  </a:cubicBezTo>
                  <a:cubicBezTo>
                    <a:pt x="350" y="634"/>
                    <a:pt x="351" y="585"/>
                    <a:pt x="353" y="493"/>
                  </a:cubicBezTo>
                  <a:cubicBezTo>
                    <a:pt x="353" y="432"/>
                    <a:pt x="353" y="432"/>
                    <a:pt x="353" y="432"/>
                  </a:cubicBezTo>
                  <a:cubicBezTo>
                    <a:pt x="345" y="417"/>
                    <a:pt x="338" y="403"/>
                    <a:pt x="331" y="390"/>
                  </a:cubicBezTo>
                  <a:cubicBezTo>
                    <a:pt x="325" y="382"/>
                    <a:pt x="307" y="352"/>
                    <a:pt x="275" y="300"/>
                  </a:cubicBezTo>
                  <a:cubicBezTo>
                    <a:pt x="135" y="102"/>
                    <a:pt x="135" y="102"/>
                    <a:pt x="135" y="102"/>
                  </a:cubicBezTo>
                  <a:cubicBezTo>
                    <a:pt x="118" y="75"/>
                    <a:pt x="105" y="58"/>
                    <a:pt x="96" y="51"/>
                  </a:cubicBezTo>
                  <a:cubicBezTo>
                    <a:pt x="89" y="46"/>
                    <a:pt x="80" y="41"/>
                    <a:pt x="69" y="39"/>
                  </a:cubicBezTo>
                  <a:cubicBezTo>
                    <a:pt x="58" y="36"/>
                    <a:pt x="44" y="34"/>
                    <a:pt x="0" y="33"/>
                  </a:cubicBezTo>
                  <a:cubicBezTo>
                    <a:pt x="0" y="0"/>
                    <a:pt x="0" y="0"/>
                    <a:pt x="0" y="0"/>
                  </a:cubicBezTo>
                  <a:cubicBezTo>
                    <a:pt x="72" y="2"/>
                    <a:pt x="94" y="3"/>
                    <a:pt x="130" y="3"/>
                  </a:cubicBezTo>
                  <a:cubicBezTo>
                    <a:pt x="168" y="3"/>
                    <a:pt x="265" y="2"/>
                    <a:pt x="333" y="0"/>
                  </a:cubicBezTo>
                  <a:cubicBezTo>
                    <a:pt x="333" y="33"/>
                    <a:pt x="333" y="33"/>
                    <a:pt x="333" y="33"/>
                  </a:cubicBezTo>
                  <a:cubicBezTo>
                    <a:pt x="291" y="34"/>
                    <a:pt x="254" y="36"/>
                    <a:pt x="246" y="39"/>
                  </a:cubicBezTo>
                  <a:cubicBezTo>
                    <a:pt x="239" y="41"/>
                    <a:pt x="235" y="46"/>
                    <a:pt x="234" y="52"/>
                  </a:cubicBezTo>
                  <a:cubicBezTo>
                    <a:pt x="234" y="59"/>
                    <a:pt x="243" y="78"/>
                    <a:pt x="262" y="111"/>
                  </a:cubicBezTo>
                  <a:cubicBezTo>
                    <a:pt x="426" y="376"/>
                    <a:pt x="426" y="376"/>
                    <a:pt x="426" y="376"/>
                  </a:cubicBezTo>
                  <a:lnTo>
                    <a:pt x="601" y="111"/>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1" name="Freeform 15"/>
            <p:cNvSpPr>
              <a:spLocks noEditPoints="1"/>
            </p:cNvSpPr>
            <p:nvPr userDrawn="1"/>
          </p:nvSpPr>
          <p:spPr bwMode="auto">
            <a:xfrm>
              <a:off x="1558925" y="681038"/>
              <a:ext cx="263525" cy="246063"/>
            </a:xfrm>
            <a:custGeom>
              <a:avLst/>
              <a:gdLst>
                <a:gd name="T0" fmla="*/ 148 w 830"/>
                <a:gd name="T1" fmla="*/ 190 h 775"/>
                <a:gd name="T2" fmla="*/ 247 w 830"/>
                <a:gd name="T3" fmla="*/ 82 h 775"/>
                <a:gd name="T4" fmla="*/ 399 w 830"/>
                <a:gd name="T5" fmla="*/ 45 h 775"/>
                <a:gd name="T6" fmla="*/ 512 w 830"/>
                <a:gd name="T7" fmla="*/ 62 h 775"/>
                <a:gd name="T8" fmla="*/ 596 w 830"/>
                <a:gd name="T9" fmla="*/ 106 h 775"/>
                <a:gd name="T10" fmla="*/ 652 w 830"/>
                <a:gd name="T11" fmla="*/ 167 h 775"/>
                <a:gd name="T12" fmla="*/ 690 w 830"/>
                <a:gd name="T13" fmla="*/ 245 h 775"/>
                <a:gd name="T14" fmla="*/ 713 w 830"/>
                <a:gd name="T15" fmla="*/ 398 h 775"/>
                <a:gd name="T16" fmla="*/ 681 w 830"/>
                <a:gd name="T17" fmla="*/ 571 h 775"/>
                <a:gd name="T18" fmla="*/ 584 w 830"/>
                <a:gd name="T19" fmla="*/ 686 h 775"/>
                <a:gd name="T20" fmla="*/ 431 w 830"/>
                <a:gd name="T21" fmla="*/ 727 h 775"/>
                <a:gd name="T22" fmla="*/ 315 w 830"/>
                <a:gd name="T23" fmla="*/ 707 h 775"/>
                <a:gd name="T24" fmla="*/ 220 w 830"/>
                <a:gd name="T25" fmla="*/ 644 h 775"/>
                <a:gd name="T26" fmla="*/ 151 w 830"/>
                <a:gd name="T27" fmla="*/ 539 h 775"/>
                <a:gd name="T28" fmla="*/ 125 w 830"/>
                <a:gd name="T29" fmla="*/ 450 h 775"/>
                <a:gd name="T30" fmla="*/ 115 w 830"/>
                <a:gd name="T31" fmla="*/ 349 h 775"/>
                <a:gd name="T32" fmla="*/ 148 w 830"/>
                <a:gd name="T33" fmla="*/ 190 h 775"/>
                <a:gd name="T34" fmla="*/ 26 w 830"/>
                <a:gd name="T35" fmla="*/ 541 h 775"/>
                <a:gd name="T36" fmla="*/ 105 w 830"/>
                <a:gd name="T37" fmla="*/ 669 h 775"/>
                <a:gd name="T38" fmla="*/ 231 w 830"/>
                <a:gd name="T39" fmla="*/ 748 h 775"/>
                <a:gd name="T40" fmla="*/ 392 w 830"/>
                <a:gd name="T41" fmla="*/ 775 h 775"/>
                <a:gd name="T42" fmla="*/ 706 w 830"/>
                <a:gd name="T43" fmla="*/ 657 h 775"/>
                <a:gd name="T44" fmla="*/ 830 w 830"/>
                <a:gd name="T45" fmla="*/ 364 h 775"/>
                <a:gd name="T46" fmla="*/ 817 w 830"/>
                <a:gd name="T47" fmla="*/ 261 h 775"/>
                <a:gd name="T48" fmla="*/ 784 w 830"/>
                <a:gd name="T49" fmla="*/ 177 h 775"/>
                <a:gd name="T50" fmla="*/ 709 w 830"/>
                <a:gd name="T51" fmla="*/ 89 h 775"/>
                <a:gd name="T52" fmla="*/ 588 w 830"/>
                <a:gd name="T53" fmla="*/ 25 h 775"/>
                <a:gd name="T54" fmla="*/ 423 w 830"/>
                <a:gd name="T55" fmla="*/ 0 h 775"/>
                <a:gd name="T56" fmla="*/ 249 w 830"/>
                <a:gd name="T57" fmla="*/ 29 h 775"/>
                <a:gd name="T58" fmla="*/ 112 w 830"/>
                <a:gd name="T59" fmla="*/ 113 h 775"/>
                <a:gd name="T60" fmla="*/ 26 w 830"/>
                <a:gd name="T61" fmla="*/ 239 h 775"/>
                <a:gd name="T62" fmla="*/ 0 w 830"/>
                <a:gd name="T63" fmla="*/ 393 h 775"/>
                <a:gd name="T64" fmla="*/ 26 w 830"/>
                <a:gd name="T65" fmla="*/ 541 h 77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Lst>
              <a:rect l="0" t="0" r="r" b="b"/>
              <a:pathLst>
                <a:path w="830" h="775">
                  <a:moveTo>
                    <a:pt x="148" y="190"/>
                  </a:moveTo>
                  <a:cubicBezTo>
                    <a:pt x="170" y="143"/>
                    <a:pt x="203" y="107"/>
                    <a:pt x="247" y="82"/>
                  </a:cubicBezTo>
                  <a:cubicBezTo>
                    <a:pt x="290" y="57"/>
                    <a:pt x="341" y="45"/>
                    <a:pt x="399" y="45"/>
                  </a:cubicBezTo>
                  <a:cubicBezTo>
                    <a:pt x="440" y="45"/>
                    <a:pt x="477" y="51"/>
                    <a:pt x="512" y="62"/>
                  </a:cubicBezTo>
                  <a:cubicBezTo>
                    <a:pt x="546" y="74"/>
                    <a:pt x="575" y="89"/>
                    <a:pt x="596" y="106"/>
                  </a:cubicBezTo>
                  <a:cubicBezTo>
                    <a:pt x="618" y="124"/>
                    <a:pt x="637" y="144"/>
                    <a:pt x="652" y="167"/>
                  </a:cubicBezTo>
                  <a:cubicBezTo>
                    <a:pt x="668" y="190"/>
                    <a:pt x="681" y="216"/>
                    <a:pt x="690" y="245"/>
                  </a:cubicBezTo>
                  <a:cubicBezTo>
                    <a:pt x="706" y="292"/>
                    <a:pt x="713" y="343"/>
                    <a:pt x="713" y="398"/>
                  </a:cubicBezTo>
                  <a:cubicBezTo>
                    <a:pt x="713" y="463"/>
                    <a:pt x="703" y="521"/>
                    <a:pt x="681" y="571"/>
                  </a:cubicBezTo>
                  <a:cubicBezTo>
                    <a:pt x="660" y="620"/>
                    <a:pt x="627" y="659"/>
                    <a:pt x="584" y="686"/>
                  </a:cubicBezTo>
                  <a:cubicBezTo>
                    <a:pt x="541" y="714"/>
                    <a:pt x="490" y="727"/>
                    <a:pt x="431" y="727"/>
                  </a:cubicBezTo>
                  <a:cubicBezTo>
                    <a:pt x="388" y="727"/>
                    <a:pt x="350" y="721"/>
                    <a:pt x="315" y="707"/>
                  </a:cubicBezTo>
                  <a:cubicBezTo>
                    <a:pt x="280" y="694"/>
                    <a:pt x="248" y="673"/>
                    <a:pt x="220" y="644"/>
                  </a:cubicBezTo>
                  <a:cubicBezTo>
                    <a:pt x="192" y="616"/>
                    <a:pt x="169" y="581"/>
                    <a:pt x="151" y="539"/>
                  </a:cubicBezTo>
                  <a:cubicBezTo>
                    <a:pt x="141" y="514"/>
                    <a:pt x="132" y="484"/>
                    <a:pt x="125" y="450"/>
                  </a:cubicBezTo>
                  <a:cubicBezTo>
                    <a:pt x="118" y="416"/>
                    <a:pt x="115" y="382"/>
                    <a:pt x="115" y="349"/>
                  </a:cubicBezTo>
                  <a:cubicBezTo>
                    <a:pt x="115" y="290"/>
                    <a:pt x="126" y="236"/>
                    <a:pt x="148" y="190"/>
                  </a:cubicBezTo>
                  <a:close/>
                  <a:moveTo>
                    <a:pt x="26" y="541"/>
                  </a:moveTo>
                  <a:cubicBezTo>
                    <a:pt x="44" y="591"/>
                    <a:pt x="70" y="634"/>
                    <a:pt x="105" y="669"/>
                  </a:cubicBezTo>
                  <a:cubicBezTo>
                    <a:pt x="139" y="704"/>
                    <a:pt x="181" y="730"/>
                    <a:pt x="231" y="748"/>
                  </a:cubicBezTo>
                  <a:cubicBezTo>
                    <a:pt x="281" y="765"/>
                    <a:pt x="335" y="775"/>
                    <a:pt x="392" y="775"/>
                  </a:cubicBezTo>
                  <a:cubicBezTo>
                    <a:pt x="518" y="775"/>
                    <a:pt x="623" y="736"/>
                    <a:pt x="706" y="657"/>
                  </a:cubicBezTo>
                  <a:cubicBezTo>
                    <a:pt x="788" y="579"/>
                    <a:pt x="830" y="481"/>
                    <a:pt x="830" y="364"/>
                  </a:cubicBezTo>
                  <a:cubicBezTo>
                    <a:pt x="830" y="327"/>
                    <a:pt x="826" y="293"/>
                    <a:pt x="817" y="261"/>
                  </a:cubicBezTo>
                  <a:cubicBezTo>
                    <a:pt x="809" y="228"/>
                    <a:pt x="798" y="200"/>
                    <a:pt x="784" y="177"/>
                  </a:cubicBezTo>
                  <a:cubicBezTo>
                    <a:pt x="766" y="145"/>
                    <a:pt x="741" y="116"/>
                    <a:pt x="709" y="89"/>
                  </a:cubicBezTo>
                  <a:cubicBezTo>
                    <a:pt x="678" y="62"/>
                    <a:pt x="637" y="41"/>
                    <a:pt x="588" y="25"/>
                  </a:cubicBezTo>
                  <a:cubicBezTo>
                    <a:pt x="538" y="8"/>
                    <a:pt x="484" y="0"/>
                    <a:pt x="423" y="0"/>
                  </a:cubicBezTo>
                  <a:cubicBezTo>
                    <a:pt x="358" y="0"/>
                    <a:pt x="300" y="10"/>
                    <a:pt x="249" y="29"/>
                  </a:cubicBezTo>
                  <a:cubicBezTo>
                    <a:pt x="198" y="48"/>
                    <a:pt x="152" y="76"/>
                    <a:pt x="112" y="113"/>
                  </a:cubicBezTo>
                  <a:cubicBezTo>
                    <a:pt x="72" y="151"/>
                    <a:pt x="43" y="193"/>
                    <a:pt x="26" y="239"/>
                  </a:cubicBezTo>
                  <a:cubicBezTo>
                    <a:pt x="8" y="286"/>
                    <a:pt x="0" y="337"/>
                    <a:pt x="0" y="393"/>
                  </a:cubicBezTo>
                  <a:cubicBezTo>
                    <a:pt x="0" y="441"/>
                    <a:pt x="9" y="491"/>
                    <a:pt x="26" y="541"/>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spTree>
    <p:extLst>
      <p:ext uri="{BB962C8B-B14F-4D97-AF65-F5344CB8AC3E}">
        <p14:creationId xmlns:p14="http://schemas.microsoft.com/office/powerpoint/2010/main" val="725258283"/>
      </p:ext>
    </p:extLst>
  </p:cSld>
  <p:clrMapOvr>
    <a:masterClrMapping/>
  </p:clrMapOvr>
  <p:timing>
    <p:tnLst>
      <p:par>
        <p:cTn id="1" dur="indefinite" restart="never" nodeType="tmRoot"/>
      </p:par>
    </p:tnLst>
  </p:timing>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58368" y="2743200"/>
            <a:ext cx="7827264" cy="1371600"/>
          </a:xfrm>
        </p:spPr>
        <p:txBody>
          <a:bodyPr anchor="b" anchorCtr="0"/>
          <a:lstStyle>
            <a:lvl1pPr algn="l">
              <a:defRPr sz="3600" b="0" cap="none" baseline="0"/>
            </a:lvl1pPr>
          </a:lstStyle>
          <a:p>
            <a:r>
              <a:rPr lang="en-US" smtClean="0"/>
              <a:t>Click to edit Master title style</a:t>
            </a:r>
            <a:endParaRPr lang="en-US" dirty="0"/>
          </a:p>
        </p:txBody>
      </p:sp>
      <p:sp>
        <p:nvSpPr>
          <p:cNvPr id="3" name="Text Placeholder 2"/>
          <p:cNvSpPr>
            <a:spLocks noGrp="1"/>
          </p:cNvSpPr>
          <p:nvPr>
            <p:ph type="body" idx="1"/>
          </p:nvPr>
        </p:nvSpPr>
        <p:spPr>
          <a:xfrm>
            <a:off x="658368" y="4114800"/>
            <a:ext cx="7827264" cy="685800"/>
          </a:xfrm>
        </p:spPr>
        <p:txBody>
          <a:bodyPr anchor="t" anchorCtr="0"/>
          <a:lstStyle>
            <a:lvl1pPr marL="0" indent="0">
              <a:buNone/>
              <a:defRPr sz="22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C7F62C3D-D224-4638-BC65-8FCE05E0DE3C}" type="datetime1">
              <a:rPr lang="en-US" smtClean="0"/>
              <a:t>10/2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DC53FA5-AE81-45E0-8206-920AA27813B4}" type="slidenum">
              <a:rPr lang="en-US" smtClean="0"/>
              <a:t>‹#›</a:t>
            </a:fld>
            <a:endParaRPr lang="en-US"/>
          </a:p>
        </p:txBody>
      </p:sp>
      <p:grpSp>
        <p:nvGrpSpPr>
          <p:cNvPr id="20" name="Group 19"/>
          <p:cNvGrpSpPr/>
          <p:nvPr userDrawn="1"/>
        </p:nvGrpSpPr>
        <p:grpSpPr>
          <a:xfrm>
            <a:off x="120650" y="6299343"/>
            <a:ext cx="420688" cy="458645"/>
            <a:chOff x="657225" y="681038"/>
            <a:chExt cx="1266825" cy="1381125"/>
          </a:xfrm>
          <a:solidFill>
            <a:srgbClr val="FFFFFF"/>
          </a:solidFill>
        </p:grpSpPr>
        <p:sp>
          <p:nvSpPr>
            <p:cNvPr id="21" name="Freeform 5"/>
            <p:cNvSpPr>
              <a:spLocks noEditPoints="1"/>
            </p:cNvSpPr>
            <p:nvPr userDrawn="1"/>
          </p:nvSpPr>
          <p:spPr bwMode="auto">
            <a:xfrm>
              <a:off x="846138" y="1354138"/>
              <a:ext cx="887413" cy="708025"/>
            </a:xfrm>
            <a:custGeom>
              <a:avLst/>
              <a:gdLst>
                <a:gd name="T0" fmla="*/ 2203 w 2794"/>
                <a:gd name="T1" fmla="*/ 0 h 2229"/>
                <a:gd name="T2" fmla="*/ 1613 w 2794"/>
                <a:gd name="T3" fmla="*/ 0 h 2229"/>
                <a:gd name="T4" fmla="*/ 1613 w 2794"/>
                <a:gd name="T5" fmla="*/ 665 h 2229"/>
                <a:gd name="T6" fmla="*/ 1904 w 2794"/>
                <a:gd name="T7" fmla="*/ 1330 h 2229"/>
                <a:gd name="T8" fmla="*/ 1904 w 2794"/>
                <a:gd name="T9" fmla="*/ 1237 h 2229"/>
                <a:gd name="T10" fmla="*/ 1749 w 2794"/>
                <a:gd name="T11" fmla="*/ 747 h 2229"/>
                <a:gd name="T12" fmla="*/ 1749 w 2794"/>
                <a:gd name="T13" fmla="*/ 573 h 2229"/>
                <a:gd name="T14" fmla="*/ 1972 w 2794"/>
                <a:gd name="T15" fmla="*/ 573 h 2229"/>
                <a:gd name="T16" fmla="*/ 1972 w 2794"/>
                <a:gd name="T17" fmla="*/ 1332 h 2229"/>
                <a:gd name="T18" fmla="*/ 1401 w 2794"/>
                <a:gd name="T19" fmla="*/ 2182 h 2229"/>
                <a:gd name="T20" fmla="*/ 829 w 2794"/>
                <a:gd name="T21" fmla="*/ 1374 h 2229"/>
                <a:gd name="T22" fmla="*/ 1180 w 2794"/>
                <a:gd name="T23" fmla="*/ 665 h 2229"/>
                <a:gd name="T24" fmla="*/ 1180 w 2794"/>
                <a:gd name="T25" fmla="*/ 573 h 2229"/>
                <a:gd name="T26" fmla="*/ 1401 w 2794"/>
                <a:gd name="T27" fmla="*/ 573 h 2229"/>
                <a:gd name="T28" fmla="*/ 1542 w 2794"/>
                <a:gd name="T29" fmla="*/ 573 h 2229"/>
                <a:gd name="T30" fmla="*/ 1542 w 2794"/>
                <a:gd name="T31" fmla="*/ 436 h 2229"/>
                <a:gd name="T32" fmla="*/ 1401 w 2794"/>
                <a:gd name="T33" fmla="*/ 436 h 2229"/>
                <a:gd name="T34" fmla="*/ 1180 w 2794"/>
                <a:gd name="T35" fmla="*/ 436 h 2229"/>
                <a:gd name="T36" fmla="*/ 1180 w 2794"/>
                <a:gd name="T37" fmla="*/ 436 h 2229"/>
                <a:gd name="T38" fmla="*/ 1044 w 2794"/>
                <a:gd name="T39" fmla="*/ 436 h 2229"/>
                <a:gd name="T40" fmla="*/ 1044 w 2794"/>
                <a:gd name="T41" fmla="*/ 436 h 2229"/>
                <a:gd name="T42" fmla="*/ 692 w 2794"/>
                <a:gd name="T43" fmla="*/ 436 h 2229"/>
                <a:gd name="T44" fmla="*/ 692 w 2794"/>
                <a:gd name="T45" fmla="*/ 1234 h 2229"/>
                <a:gd name="T46" fmla="*/ 695 w 2794"/>
                <a:gd name="T47" fmla="*/ 1315 h 2229"/>
                <a:gd name="T48" fmla="*/ 695 w 2794"/>
                <a:gd name="T49" fmla="*/ 1315 h 2229"/>
                <a:gd name="T50" fmla="*/ 829 w 2794"/>
                <a:gd name="T51" fmla="*/ 1205 h 2229"/>
                <a:gd name="T52" fmla="*/ 829 w 2794"/>
                <a:gd name="T53" fmla="*/ 1205 h 2229"/>
                <a:gd name="T54" fmla="*/ 829 w 2794"/>
                <a:gd name="T55" fmla="*/ 573 h 2229"/>
                <a:gd name="T56" fmla="*/ 1044 w 2794"/>
                <a:gd name="T57" fmla="*/ 573 h 2229"/>
                <a:gd name="T58" fmla="*/ 1044 w 2794"/>
                <a:gd name="T59" fmla="*/ 573 h 2229"/>
                <a:gd name="T60" fmla="*/ 1044 w 2794"/>
                <a:gd name="T61" fmla="*/ 747 h 2229"/>
                <a:gd name="T62" fmla="*/ 590 w 2794"/>
                <a:gd name="T63" fmla="*/ 1447 h 2229"/>
                <a:gd name="T64" fmla="*/ 135 w 2794"/>
                <a:gd name="T65" fmla="*/ 747 h 2229"/>
                <a:gd name="T66" fmla="*/ 135 w 2794"/>
                <a:gd name="T67" fmla="*/ 136 h 2229"/>
                <a:gd name="T68" fmla="*/ 590 w 2794"/>
                <a:gd name="T69" fmla="*/ 136 h 2229"/>
                <a:gd name="T70" fmla="*/ 1044 w 2794"/>
                <a:gd name="T71" fmla="*/ 136 h 2229"/>
                <a:gd name="T72" fmla="*/ 1044 w 2794"/>
                <a:gd name="T73" fmla="*/ 370 h 2229"/>
                <a:gd name="T74" fmla="*/ 1180 w 2794"/>
                <a:gd name="T75" fmla="*/ 370 h 2229"/>
                <a:gd name="T76" fmla="*/ 1180 w 2794"/>
                <a:gd name="T77" fmla="*/ 0 h 2229"/>
                <a:gd name="T78" fmla="*/ 590 w 2794"/>
                <a:gd name="T79" fmla="*/ 0 h 2229"/>
                <a:gd name="T80" fmla="*/ 0 w 2794"/>
                <a:gd name="T81" fmla="*/ 0 h 2229"/>
                <a:gd name="T82" fmla="*/ 0 w 2794"/>
                <a:gd name="T83" fmla="*/ 665 h 2229"/>
                <a:gd name="T84" fmla="*/ 590 w 2794"/>
                <a:gd name="T85" fmla="*/ 1495 h 2229"/>
                <a:gd name="T86" fmla="*/ 708 w 2794"/>
                <a:gd name="T87" fmla="*/ 1444 h 2229"/>
                <a:gd name="T88" fmla="*/ 1401 w 2794"/>
                <a:gd name="T89" fmla="*/ 2229 h 2229"/>
                <a:gd name="T90" fmla="*/ 2093 w 2794"/>
                <a:gd name="T91" fmla="*/ 1447 h 2229"/>
                <a:gd name="T92" fmla="*/ 2203 w 2794"/>
                <a:gd name="T93" fmla="*/ 1495 h 2229"/>
                <a:gd name="T94" fmla="*/ 2794 w 2794"/>
                <a:gd name="T95" fmla="*/ 665 h 2229"/>
                <a:gd name="T96" fmla="*/ 2794 w 2794"/>
                <a:gd name="T97" fmla="*/ 0 h 2229"/>
                <a:gd name="T98" fmla="*/ 2203 w 2794"/>
                <a:gd name="T99" fmla="*/ 0 h 2229"/>
                <a:gd name="T100" fmla="*/ 2658 w 2794"/>
                <a:gd name="T101" fmla="*/ 747 h 2229"/>
                <a:gd name="T102" fmla="*/ 2203 w 2794"/>
                <a:gd name="T103" fmla="*/ 1447 h 2229"/>
                <a:gd name="T104" fmla="*/ 2100 w 2794"/>
                <a:gd name="T105" fmla="*/ 1395 h 2229"/>
                <a:gd name="T106" fmla="*/ 2109 w 2794"/>
                <a:gd name="T107" fmla="*/ 1234 h 2229"/>
                <a:gd name="T108" fmla="*/ 2109 w 2794"/>
                <a:gd name="T109" fmla="*/ 436 h 2229"/>
                <a:gd name="T110" fmla="*/ 1749 w 2794"/>
                <a:gd name="T111" fmla="*/ 436 h 2229"/>
                <a:gd name="T112" fmla="*/ 1749 w 2794"/>
                <a:gd name="T113" fmla="*/ 136 h 2229"/>
                <a:gd name="T114" fmla="*/ 2203 w 2794"/>
                <a:gd name="T115" fmla="*/ 136 h 2229"/>
                <a:gd name="T116" fmla="*/ 2658 w 2794"/>
                <a:gd name="T117" fmla="*/ 136 h 2229"/>
                <a:gd name="T118" fmla="*/ 2658 w 2794"/>
                <a:gd name="T119" fmla="*/ 747 h 222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 ang="0">
                  <a:pos x="T118" y="T119"/>
                </a:cxn>
              </a:cxnLst>
              <a:rect l="0" t="0" r="r" b="b"/>
              <a:pathLst>
                <a:path w="2794" h="2229">
                  <a:moveTo>
                    <a:pt x="2203" y="0"/>
                  </a:moveTo>
                  <a:cubicBezTo>
                    <a:pt x="1613" y="0"/>
                    <a:pt x="1613" y="0"/>
                    <a:pt x="1613" y="0"/>
                  </a:cubicBezTo>
                  <a:cubicBezTo>
                    <a:pt x="1613" y="665"/>
                    <a:pt x="1613" y="665"/>
                    <a:pt x="1613" y="665"/>
                  </a:cubicBezTo>
                  <a:cubicBezTo>
                    <a:pt x="1613" y="970"/>
                    <a:pt x="1719" y="1183"/>
                    <a:pt x="1904" y="1330"/>
                  </a:cubicBezTo>
                  <a:cubicBezTo>
                    <a:pt x="1904" y="1237"/>
                    <a:pt x="1904" y="1237"/>
                    <a:pt x="1904" y="1237"/>
                  </a:cubicBezTo>
                  <a:cubicBezTo>
                    <a:pt x="1769" y="1081"/>
                    <a:pt x="1749" y="901"/>
                    <a:pt x="1749" y="747"/>
                  </a:cubicBezTo>
                  <a:cubicBezTo>
                    <a:pt x="1749" y="573"/>
                    <a:pt x="1749" y="573"/>
                    <a:pt x="1749" y="573"/>
                  </a:cubicBezTo>
                  <a:cubicBezTo>
                    <a:pt x="1972" y="573"/>
                    <a:pt x="1972" y="573"/>
                    <a:pt x="1972" y="573"/>
                  </a:cubicBezTo>
                  <a:cubicBezTo>
                    <a:pt x="1972" y="1332"/>
                    <a:pt x="1972" y="1332"/>
                    <a:pt x="1972" y="1332"/>
                  </a:cubicBezTo>
                  <a:cubicBezTo>
                    <a:pt x="1972" y="1609"/>
                    <a:pt x="1895" y="1961"/>
                    <a:pt x="1401" y="2182"/>
                  </a:cubicBezTo>
                  <a:cubicBezTo>
                    <a:pt x="931" y="1972"/>
                    <a:pt x="838" y="1643"/>
                    <a:pt x="829" y="1374"/>
                  </a:cubicBezTo>
                  <a:cubicBezTo>
                    <a:pt x="1051" y="1225"/>
                    <a:pt x="1180" y="1001"/>
                    <a:pt x="1180" y="665"/>
                  </a:cubicBezTo>
                  <a:cubicBezTo>
                    <a:pt x="1180" y="573"/>
                    <a:pt x="1180" y="573"/>
                    <a:pt x="1180" y="573"/>
                  </a:cubicBezTo>
                  <a:cubicBezTo>
                    <a:pt x="1401" y="573"/>
                    <a:pt x="1401" y="573"/>
                    <a:pt x="1401" y="573"/>
                  </a:cubicBezTo>
                  <a:cubicBezTo>
                    <a:pt x="1542" y="573"/>
                    <a:pt x="1542" y="573"/>
                    <a:pt x="1542" y="573"/>
                  </a:cubicBezTo>
                  <a:cubicBezTo>
                    <a:pt x="1542" y="436"/>
                    <a:pt x="1542" y="436"/>
                    <a:pt x="1542" y="436"/>
                  </a:cubicBezTo>
                  <a:cubicBezTo>
                    <a:pt x="1401" y="436"/>
                    <a:pt x="1401" y="436"/>
                    <a:pt x="1401" y="436"/>
                  </a:cubicBezTo>
                  <a:cubicBezTo>
                    <a:pt x="1180" y="436"/>
                    <a:pt x="1180" y="436"/>
                    <a:pt x="1180" y="436"/>
                  </a:cubicBezTo>
                  <a:cubicBezTo>
                    <a:pt x="1180" y="436"/>
                    <a:pt x="1180" y="436"/>
                    <a:pt x="1180" y="436"/>
                  </a:cubicBezTo>
                  <a:cubicBezTo>
                    <a:pt x="1044" y="436"/>
                    <a:pt x="1044" y="436"/>
                    <a:pt x="1044" y="436"/>
                  </a:cubicBezTo>
                  <a:cubicBezTo>
                    <a:pt x="1044" y="436"/>
                    <a:pt x="1044" y="436"/>
                    <a:pt x="1044" y="436"/>
                  </a:cubicBezTo>
                  <a:cubicBezTo>
                    <a:pt x="692" y="436"/>
                    <a:pt x="692" y="436"/>
                    <a:pt x="692" y="436"/>
                  </a:cubicBezTo>
                  <a:cubicBezTo>
                    <a:pt x="692" y="1234"/>
                    <a:pt x="692" y="1234"/>
                    <a:pt x="692" y="1234"/>
                  </a:cubicBezTo>
                  <a:cubicBezTo>
                    <a:pt x="692" y="1262"/>
                    <a:pt x="693" y="1289"/>
                    <a:pt x="695" y="1315"/>
                  </a:cubicBezTo>
                  <a:cubicBezTo>
                    <a:pt x="695" y="1315"/>
                    <a:pt x="695" y="1315"/>
                    <a:pt x="695" y="1315"/>
                  </a:cubicBezTo>
                  <a:cubicBezTo>
                    <a:pt x="748" y="1280"/>
                    <a:pt x="792" y="1244"/>
                    <a:pt x="829" y="1205"/>
                  </a:cubicBezTo>
                  <a:cubicBezTo>
                    <a:pt x="829" y="1205"/>
                    <a:pt x="829" y="1205"/>
                    <a:pt x="829" y="1205"/>
                  </a:cubicBezTo>
                  <a:cubicBezTo>
                    <a:pt x="829" y="573"/>
                    <a:pt x="829" y="573"/>
                    <a:pt x="829" y="573"/>
                  </a:cubicBezTo>
                  <a:cubicBezTo>
                    <a:pt x="1044" y="573"/>
                    <a:pt x="1044" y="573"/>
                    <a:pt x="1044" y="573"/>
                  </a:cubicBezTo>
                  <a:cubicBezTo>
                    <a:pt x="1044" y="573"/>
                    <a:pt x="1044" y="573"/>
                    <a:pt x="1044" y="573"/>
                  </a:cubicBezTo>
                  <a:cubicBezTo>
                    <a:pt x="1044" y="747"/>
                    <a:pt x="1044" y="747"/>
                    <a:pt x="1044" y="747"/>
                  </a:cubicBezTo>
                  <a:cubicBezTo>
                    <a:pt x="1044" y="978"/>
                    <a:pt x="1001" y="1263"/>
                    <a:pt x="590" y="1447"/>
                  </a:cubicBezTo>
                  <a:cubicBezTo>
                    <a:pt x="178" y="1263"/>
                    <a:pt x="135" y="978"/>
                    <a:pt x="135" y="747"/>
                  </a:cubicBezTo>
                  <a:cubicBezTo>
                    <a:pt x="135" y="136"/>
                    <a:pt x="135" y="136"/>
                    <a:pt x="135" y="136"/>
                  </a:cubicBezTo>
                  <a:cubicBezTo>
                    <a:pt x="590" y="136"/>
                    <a:pt x="590" y="136"/>
                    <a:pt x="590" y="136"/>
                  </a:cubicBezTo>
                  <a:cubicBezTo>
                    <a:pt x="1044" y="136"/>
                    <a:pt x="1044" y="136"/>
                    <a:pt x="1044" y="136"/>
                  </a:cubicBezTo>
                  <a:cubicBezTo>
                    <a:pt x="1044" y="370"/>
                    <a:pt x="1044" y="370"/>
                    <a:pt x="1044" y="370"/>
                  </a:cubicBezTo>
                  <a:cubicBezTo>
                    <a:pt x="1180" y="370"/>
                    <a:pt x="1180" y="370"/>
                    <a:pt x="1180" y="370"/>
                  </a:cubicBezTo>
                  <a:cubicBezTo>
                    <a:pt x="1180" y="0"/>
                    <a:pt x="1180" y="0"/>
                    <a:pt x="1180" y="0"/>
                  </a:cubicBezTo>
                  <a:cubicBezTo>
                    <a:pt x="590" y="0"/>
                    <a:pt x="590" y="0"/>
                    <a:pt x="590" y="0"/>
                  </a:cubicBezTo>
                  <a:cubicBezTo>
                    <a:pt x="0" y="0"/>
                    <a:pt x="0" y="0"/>
                    <a:pt x="0" y="0"/>
                  </a:cubicBezTo>
                  <a:cubicBezTo>
                    <a:pt x="0" y="665"/>
                    <a:pt x="0" y="665"/>
                    <a:pt x="0" y="665"/>
                  </a:cubicBezTo>
                  <a:cubicBezTo>
                    <a:pt x="0" y="1109"/>
                    <a:pt x="224" y="1357"/>
                    <a:pt x="590" y="1495"/>
                  </a:cubicBezTo>
                  <a:cubicBezTo>
                    <a:pt x="631" y="1479"/>
                    <a:pt x="670" y="1462"/>
                    <a:pt x="708" y="1444"/>
                  </a:cubicBezTo>
                  <a:cubicBezTo>
                    <a:pt x="771" y="1847"/>
                    <a:pt x="1023" y="2087"/>
                    <a:pt x="1401" y="2229"/>
                  </a:cubicBezTo>
                  <a:cubicBezTo>
                    <a:pt x="1777" y="2087"/>
                    <a:pt x="2029" y="1848"/>
                    <a:pt x="2093" y="1447"/>
                  </a:cubicBezTo>
                  <a:cubicBezTo>
                    <a:pt x="2128" y="1464"/>
                    <a:pt x="2165" y="1480"/>
                    <a:pt x="2203" y="1495"/>
                  </a:cubicBezTo>
                  <a:cubicBezTo>
                    <a:pt x="2569" y="1357"/>
                    <a:pt x="2794" y="1109"/>
                    <a:pt x="2794" y="665"/>
                  </a:cubicBezTo>
                  <a:cubicBezTo>
                    <a:pt x="2794" y="0"/>
                    <a:pt x="2794" y="0"/>
                    <a:pt x="2794" y="0"/>
                  </a:cubicBezTo>
                  <a:lnTo>
                    <a:pt x="2203" y="0"/>
                  </a:lnTo>
                  <a:close/>
                  <a:moveTo>
                    <a:pt x="2658" y="747"/>
                  </a:moveTo>
                  <a:cubicBezTo>
                    <a:pt x="2658" y="978"/>
                    <a:pt x="2615" y="1263"/>
                    <a:pt x="2203" y="1447"/>
                  </a:cubicBezTo>
                  <a:cubicBezTo>
                    <a:pt x="2166" y="1431"/>
                    <a:pt x="2131" y="1413"/>
                    <a:pt x="2100" y="1395"/>
                  </a:cubicBezTo>
                  <a:cubicBezTo>
                    <a:pt x="2106" y="1344"/>
                    <a:pt x="2109" y="1290"/>
                    <a:pt x="2109" y="1234"/>
                  </a:cubicBezTo>
                  <a:cubicBezTo>
                    <a:pt x="2109" y="436"/>
                    <a:pt x="2109" y="436"/>
                    <a:pt x="2109" y="436"/>
                  </a:cubicBezTo>
                  <a:cubicBezTo>
                    <a:pt x="1749" y="436"/>
                    <a:pt x="1749" y="436"/>
                    <a:pt x="1749" y="436"/>
                  </a:cubicBezTo>
                  <a:cubicBezTo>
                    <a:pt x="1749" y="136"/>
                    <a:pt x="1749" y="136"/>
                    <a:pt x="1749" y="136"/>
                  </a:cubicBezTo>
                  <a:cubicBezTo>
                    <a:pt x="2203" y="136"/>
                    <a:pt x="2203" y="136"/>
                    <a:pt x="2203" y="136"/>
                  </a:cubicBezTo>
                  <a:cubicBezTo>
                    <a:pt x="2658" y="136"/>
                    <a:pt x="2658" y="136"/>
                    <a:pt x="2658" y="136"/>
                  </a:cubicBezTo>
                  <a:lnTo>
                    <a:pt x="2658" y="74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2" name="Freeform 6"/>
            <p:cNvSpPr>
              <a:spLocks/>
            </p:cNvSpPr>
            <p:nvPr userDrawn="1"/>
          </p:nvSpPr>
          <p:spPr bwMode="auto">
            <a:xfrm>
              <a:off x="915988" y="1003301"/>
              <a:ext cx="188913" cy="236538"/>
            </a:xfrm>
            <a:custGeom>
              <a:avLst/>
              <a:gdLst>
                <a:gd name="T0" fmla="*/ 49 w 596"/>
                <a:gd name="T1" fmla="*/ 747 h 747"/>
                <a:gd name="T2" fmla="*/ 49 w 596"/>
                <a:gd name="T3" fmla="*/ 721 h 747"/>
                <a:gd name="T4" fmla="*/ 91 w 596"/>
                <a:gd name="T5" fmla="*/ 696 h 747"/>
                <a:gd name="T6" fmla="*/ 99 w 596"/>
                <a:gd name="T7" fmla="*/ 684 h 747"/>
                <a:gd name="T8" fmla="*/ 105 w 596"/>
                <a:gd name="T9" fmla="*/ 621 h 747"/>
                <a:gd name="T10" fmla="*/ 109 w 596"/>
                <a:gd name="T11" fmla="*/ 535 h 747"/>
                <a:gd name="T12" fmla="*/ 109 w 596"/>
                <a:gd name="T13" fmla="*/ 252 h 747"/>
                <a:gd name="T14" fmla="*/ 105 w 596"/>
                <a:gd name="T15" fmla="*/ 112 h 747"/>
                <a:gd name="T16" fmla="*/ 98 w 596"/>
                <a:gd name="T17" fmla="*/ 52 h 747"/>
                <a:gd name="T18" fmla="*/ 78 w 596"/>
                <a:gd name="T19" fmla="*/ 39 h 747"/>
                <a:gd name="T20" fmla="*/ 0 w 596"/>
                <a:gd name="T21" fmla="*/ 33 h 747"/>
                <a:gd name="T22" fmla="*/ 0 w 596"/>
                <a:gd name="T23" fmla="*/ 0 h 747"/>
                <a:gd name="T24" fmla="*/ 165 w 596"/>
                <a:gd name="T25" fmla="*/ 3 h 747"/>
                <a:gd name="T26" fmla="*/ 323 w 596"/>
                <a:gd name="T27" fmla="*/ 0 h 747"/>
                <a:gd name="T28" fmla="*/ 323 w 596"/>
                <a:gd name="T29" fmla="*/ 33 h 747"/>
                <a:gd name="T30" fmla="*/ 243 w 596"/>
                <a:gd name="T31" fmla="*/ 39 h 747"/>
                <a:gd name="T32" fmla="*/ 224 w 596"/>
                <a:gd name="T33" fmla="*/ 51 h 747"/>
                <a:gd name="T34" fmla="*/ 216 w 596"/>
                <a:gd name="T35" fmla="*/ 102 h 747"/>
                <a:gd name="T36" fmla="*/ 213 w 596"/>
                <a:gd name="T37" fmla="*/ 252 h 747"/>
                <a:gd name="T38" fmla="*/ 213 w 596"/>
                <a:gd name="T39" fmla="*/ 606 h 747"/>
                <a:gd name="T40" fmla="*/ 216 w 596"/>
                <a:gd name="T41" fmla="*/ 696 h 747"/>
                <a:gd name="T42" fmla="*/ 303 w 596"/>
                <a:gd name="T43" fmla="*/ 700 h 747"/>
                <a:gd name="T44" fmla="*/ 525 w 596"/>
                <a:gd name="T45" fmla="*/ 681 h 747"/>
                <a:gd name="T46" fmla="*/ 538 w 596"/>
                <a:gd name="T47" fmla="*/ 644 h 747"/>
                <a:gd name="T48" fmla="*/ 560 w 596"/>
                <a:gd name="T49" fmla="*/ 557 h 747"/>
                <a:gd name="T50" fmla="*/ 596 w 596"/>
                <a:gd name="T51" fmla="*/ 557 h 747"/>
                <a:gd name="T52" fmla="*/ 573 w 596"/>
                <a:gd name="T53" fmla="*/ 741 h 747"/>
                <a:gd name="T54" fmla="*/ 537 w 596"/>
                <a:gd name="T55" fmla="*/ 746 h 747"/>
                <a:gd name="T56" fmla="*/ 449 w 596"/>
                <a:gd name="T57" fmla="*/ 747 h 747"/>
                <a:gd name="T58" fmla="*/ 156 w 596"/>
                <a:gd name="T59" fmla="*/ 744 h 747"/>
                <a:gd name="T60" fmla="*/ 49 w 596"/>
                <a:gd name="T61" fmla="*/ 747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Lst>
              <a:rect l="0" t="0" r="r" b="b"/>
              <a:pathLst>
                <a:path w="596" h="747">
                  <a:moveTo>
                    <a:pt x="49" y="747"/>
                  </a:moveTo>
                  <a:cubicBezTo>
                    <a:pt x="49" y="721"/>
                    <a:pt x="49" y="721"/>
                    <a:pt x="49" y="721"/>
                  </a:cubicBezTo>
                  <a:cubicBezTo>
                    <a:pt x="71" y="710"/>
                    <a:pt x="85" y="702"/>
                    <a:pt x="91" y="696"/>
                  </a:cubicBezTo>
                  <a:cubicBezTo>
                    <a:pt x="95" y="693"/>
                    <a:pt x="98" y="689"/>
                    <a:pt x="99" y="684"/>
                  </a:cubicBezTo>
                  <a:cubicBezTo>
                    <a:pt x="102" y="675"/>
                    <a:pt x="104" y="654"/>
                    <a:pt x="105" y="621"/>
                  </a:cubicBezTo>
                  <a:cubicBezTo>
                    <a:pt x="108" y="573"/>
                    <a:pt x="109" y="545"/>
                    <a:pt x="109" y="535"/>
                  </a:cubicBezTo>
                  <a:cubicBezTo>
                    <a:pt x="109" y="252"/>
                    <a:pt x="109" y="252"/>
                    <a:pt x="109" y="252"/>
                  </a:cubicBezTo>
                  <a:cubicBezTo>
                    <a:pt x="109" y="204"/>
                    <a:pt x="108" y="157"/>
                    <a:pt x="105" y="112"/>
                  </a:cubicBezTo>
                  <a:cubicBezTo>
                    <a:pt x="104" y="78"/>
                    <a:pt x="102" y="59"/>
                    <a:pt x="98" y="52"/>
                  </a:cubicBezTo>
                  <a:cubicBezTo>
                    <a:pt x="93" y="46"/>
                    <a:pt x="87" y="42"/>
                    <a:pt x="78" y="39"/>
                  </a:cubicBezTo>
                  <a:cubicBezTo>
                    <a:pt x="69" y="36"/>
                    <a:pt x="43" y="34"/>
                    <a:pt x="0" y="33"/>
                  </a:cubicBezTo>
                  <a:cubicBezTo>
                    <a:pt x="0" y="0"/>
                    <a:pt x="0" y="0"/>
                    <a:pt x="0" y="0"/>
                  </a:cubicBezTo>
                  <a:cubicBezTo>
                    <a:pt x="89" y="2"/>
                    <a:pt x="144" y="3"/>
                    <a:pt x="165" y="3"/>
                  </a:cubicBezTo>
                  <a:cubicBezTo>
                    <a:pt x="189" y="3"/>
                    <a:pt x="241" y="2"/>
                    <a:pt x="323" y="0"/>
                  </a:cubicBezTo>
                  <a:cubicBezTo>
                    <a:pt x="323" y="33"/>
                    <a:pt x="323" y="33"/>
                    <a:pt x="323" y="33"/>
                  </a:cubicBezTo>
                  <a:cubicBezTo>
                    <a:pt x="279" y="34"/>
                    <a:pt x="253" y="36"/>
                    <a:pt x="243" y="39"/>
                  </a:cubicBezTo>
                  <a:cubicBezTo>
                    <a:pt x="234" y="42"/>
                    <a:pt x="228" y="46"/>
                    <a:pt x="224" y="51"/>
                  </a:cubicBezTo>
                  <a:cubicBezTo>
                    <a:pt x="220" y="58"/>
                    <a:pt x="217" y="75"/>
                    <a:pt x="216" y="102"/>
                  </a:cubicBezTo>
                  <a:cubicBezTo>
                    <a:pt x="215" y="109"/>
                    <a:pt x="214" y="159"/>
                    <a:pt x="213" y="252"/>
                  </a:cubicBezTo>
                  <a:cubicBezTo>
                    <a:pt x="213" y="606"/>
                    <a:pt x="213" y="606"/>
                    <a:pt x="213" y="606"/>
                  </a:cubicBezTo>
                  <a:cubicBezTo>
                    <a:pt x="213" y="643"/>
                    <a:pt x="214" y="673"/>
                    <a:pt x="216" y="696"/>
                  </a:cubicBezTo>
                  <a:cubicBezTo>
                    <a:pt x="257" y="699"/>
                    <a:pt x="262" y="700"/>
                    <a:pt x="303" y="700"/>
                  </a:cubicBezTo>
                  <a:cubicBezTo>
                    <a:pt x="407" y="700"/>
                    <a:pt x="484" y="693"/>
                    <a:pt x="525" y="681"/>
                  </a:cubicBezTo>
                  <a:cubicBezTo>
                    <a:pt x="530" y="670"/>
                    <a:pt x="534" y="658"/>
                    <a:pt x="538" y="644"/>
                  </a:cubicBezTo>
                  <a:cubicBezTo>
                    <a:pt x="560" y="557"/>
                    <a:pt x="560" y="557"/>
                    <a:pt x="560" y="557"/>
                  </a:cubicBezTo>
                  <a:cubicBezTo>
                    <a:pt x="596" y="557"/>
                    <a:pt x="596" y="557"/>
                    <a:pt x="596" y="557"/>
                  </a:cubicBezTo>
                  <a:cubicBezTo>
                    <a:pt x="588" y="609"/>
                    <a:pt x="580" y="671"/>
                    <a:pt x="573" y="741"/>
                  </a:cubicBezTo>
                  <a:cubicBezTo>
                    <a:pt x="558" y="744"/>
                    <a:pt x="546" y="745"/>
                    <a:pt x="537" y="746"/>
                  </a:cubicBezTo>
                  <a:cubicBezTo>
                    <a:pt x="518" y="747"/>
                    <a:pt x="488" y="747"/>
                    <a:pt x="449" y="747"/>
                  </a:cubicBezTo>
                  <a:cubicBezTo>
                    <a:pt x="156" y="744"/>
                    <a:pt x="156" y="744"/>
                    <a:pt x="156" y="744"/>
                  </a:cubicBezTo>
                  <a:cubicBezTo>
                    <a:pt x="121" y="744"/>
                    <a:pt x="85" y="745"/>
                    <a:pt x="49"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3" name="Freeform 7"/>
            <p:cNvSpPr>
              <a:spLocks/>
            </p:cNvSpPr>
            <p:nvPr userDrawn="1"/>
          </p:nvSpPr>
          <p:spPr bwMode="auto">
            <a:xfrm>
              <a:off x="1127125" y="1003301"/>
              <a:ext cx="103188" cy="236538"/>
            </a:xfrm>
            <a:custGeom>
              <a:avLst/>
              <a:gdLst>
                <a:gd name="T0" fmla="*/ 321 w 321"/>
                <a:gd name="T1" fmla="*/ 714 h 747"/>
                <a:gd name="T2" fmla="*/ 321 w 321"/>
                <a:gd name="T3" fmla="*/ 747 h 747"/>
                <a:gd name="T4" fmla="*/ 168 w 321"/>
                <a:gd name="T5" fmla="*/ 744 h 747"/>
                <a:gd name="T6" fmla="*/ 0 w 321"/>
                <a:gd name="T7" fmla="*/ 747 h 747"/>
                <a:gd name="T8" fmla="*/ 0 w 321"/>
                <a:gd name="T9" fmla="*/ 714 h 747"/>
                <a:gd name="T10" fmla="*/ 77 w 321"/>
                <a:gd name="T11" fmla="*/ 708 h 747"/>
                <a:gd name="T12" fmla="*/ 97 w 321"/>
                <a:gd name="T13" fmla="*/ 696 h 747"/>
                <a:gd name="T14" fmla="*/ 105 w 321"/>
                <a:gd name="T15" fmla="*/ 645 h 747"/>
                <a:gd name="T16" fmla="*/ 108 w 321"/>
                <a:gd name="T17" fmla="*/ 495 h 747"/>
                <a:gd name="T18" fmla="*/ 108 w 321"/>
                <a:gd name="T19" fmla="*/ 251 h 747"/>
                <a:gd name="T20" fmla="*/ 105 w 321"/>
                <a:gd name="T21" fmla="*/ 111 h 747"/>
                <a:gd name="T22" fmla="*/ 97 w 321"/>
                <a:gd name="T23" fmla="*/ 52 h 747"/>
                <a:gd name="T24" fmla="*/ 77 w 321"/>
                <a:gd name="T25" fmla="*/ 39 h 747"/>
                <a:gd name="T26" fmla="*/ 0 w 321"/>
                <a:gd name="T27" fmla="*/ 33 h 747"/>
                <a:gd name="T28" fmla="*/ 0 w 321"/>
                <a:gd name="T29" fmla="*/ 0 h 747"/>
                <a:gd name="T30" fmla="*/ 161 w 321"/>
                <a:gd name="T31" fmla="*/ 3 h 747"/>
                <a:gd name="T32" fmla="*/ 321 w 321"/>
                <a:gd name="T33" fmla="*/ 0 h 747"/>
                <a:gd name="T34" fmla="*/ 321 w 321"/>
                <a:gd name="T35" fmla="*/ 33 h 747"/>
                <a:gd name="T36" fmla="*/ 243 w 321"/>
                <a:gd name="T37" fmla="*/ 39 h 747"/>
                <a:gd name="T38" fmla="*/ 224 w 321"/>
                <a:gd name="T39" fmla="*/ 51 h 747"/>
                <a:gd name="T40" fmla="*/ 216 w 321"/>
                <a:gd name="T41" fmla="*/ 102 h 747"/>
                <a:gd name="T42" fmla="*/ 212 w 321"/>
                <a:gd name="T43" fmla="*/ 251 h 747"/>
                <a:gd name="T44" fmla="*/ 212 w 321"/>
                <a:gd name="T45" fmla="*/ 495 h 747"/>
                <a:gd name="T46" fmla="*/ 214 w 321"/>
                <a:gd name="T47" fmla="*/ 635 h 747"/>
                <a:gd name="T48" fmla="*/ 222 w 321"/>
                <a:gd name="T49" fmla="*/ 694 h 747"/>
                <a:gd name="T50" fmla="*/ 242 w 321"/>
                <a:gd name="T51" fmla="*/ 708 h 747"/>
                <a:gd name="T52" fmla="*/ 321 w 321"/>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1" h="747">
                  <a:moveTo>
                    <a:pt x="321" y="714"/>
                  </a:moveTo>
                  <a:cubicBezTo>
                    <a:pt x="321" y="747"/>
                    <a:pt x="321" y="747"/>
                    <a:pt x="321" y="747"/>
                  </a:cubicBezTo>
                  <a:cubicBezTo>
                    <a:pt x="244" y="745"/>
                    <a:pt x="193" y="744"/>
                    <a:pt x="168" y="744"/>
                  </a:cubicBezTo>
                  <a:cubicBezTo>
                    <a:pt x="0" y="747"/>
                    <a:pt x="0" y="747"/>
                    <a:pt x="0" y="747"/>
                  </a:cubicBezTo>
                  <a:cubicBezTo>
                    <a:pt x="0" y="714"/>
                    <a:pt x="0" y="714"/>
                    <a:pt x="0" y="714"/>
                  </a:cubicBezTo>
                  <a:cubicBezTo>
                    <a:pt x="42" y="713"/>
                    <a:pt x="68" y="711"/>
                    <a:pt x="77" y="708"/>
                  </a:cubicBezTo>
                  <a:cubicBezTo>
                    <a:pt x="87" y="705"/>
                    <a:pt x="93" y="701"/>
                    <a:pt x="97" y="696"/>
                  </a:cubicBezTo>
                  <a:cubicBezTo>
                    <a:pt x="101" y="689"/>
                    <a:pt x="104" y="672"/>
                    <a:pt x="105" y="645"/>
                  </a:cubicBezTo>
                  <a:cubicBezTo>
                    <a:pt x="106" y="637"/>
                    <a:pt x="107" y="587"/>
                    <a:pt x="108" y="495"/>
                  </a:cubicBezTo>
                  <a:cubicBezTo>
                    <a:pt x="108" y="251"/>
                    <a:pt x="108" y="251"/>
                    <a:pt x="108" y="251"/>
                  </a:cubicBezTo>
                  <a:cubicBezTo>
                    <a:pt x="108" y="204"/>
                    <a:pt x="107" y="157"/>
                    <a:pt x="105" y="111"/>
                  </a:cubicBezTo>
                  <a:cubicBezTo>
                    <a:pt x="104" y="78"/>
                    <a:pt x="102" y="59"/>
                    <a:pt x="97" y="52"/>
                  </a:cubicBezTo>
                  <a:cubicBezTo>
                    <a:pt x="93" y="46"/>
                    <a:pt x="87" y="41"/>
                    <a:pt x="77" y="39"/>
                  </a:cubicBezTo>
                  <a:cubicBezTo>
                    <a:pt x="68" y="36"/>
                    <a:pt x="42" y="34"/>
                    <a:pt x="0" y="33"/>
                  </a:cubicBezTo>
                  <a:cubicBezTo>
                    <a:pt x="0" y="0"/>
                    <a:pt x="0" y="0"/>
                    <a:pt x="0" y="0"/>
                  </a:cubicBezTo>
                  <a:cubicBezTo>
                    <a:pt x="69" y="2"/>
                    <a:pt x="123" y="3"/>
                    <a:pt x="161" y="3"/>
                  </a:cubicBezTo>
                  <a:cubicBezTo>
                    <a:pt x="197" y="3"/>
                    <a:pt x="250" y="2"/>
                    <a:pt x="321" y="0"/>
                  </a:cubicBezTo>
                  <a:cubicBezTo>
                    <a:pt x="321" y="33"/>
                    <a:pt x="321" y="33"/>
                    <a:pt x="321" y="33"/>
                  </a:cubicBezTo>
                  <a:cubicBezTo>
                    <a:pt x="278" y="34"/>
                    <a:pt x="252" y="36"/>
                    <a:pt x="243" y="39"/>
                  </a:cubicBezTo>
                  <a:cubicBezTo>
                    <a:pt x="234" y="41"/>
                    <a:pt x="227" y="46"/>
                    <a:pt x="224" y="51"/>
                  </a:cubicBezTo>
                  <a:cubicBezTo>
                    <a:pt x="219" y="58"/>
                    <a:pt x="217" y="75"/>
                    <a:pt x="216" y="102"/>
                  </a:cubicBezTo>
                  <a:cubicBezTo>
                    <a:pt x="215" y="109"/>
                    <a:pt x="214" y="159"/>
                    <a:pt x="212" y="251"/>
                  </a:cubicBezTo>
                  <a:cubicBezTo>
                    <a:pt x="212" y="495"/>
                    <a:pt x="212" y="495"/>
                    <a:pt x="212" y="495"/>
                  </a:cubicBezTo>
                  <a:cubicBezTo>
                    <a:pt x="212" y="543"/>
                    <a:pt x="213" y="589"/>
                    <a:pt x="214" y="635"/>
                  </a:cubicBezTo>
                  <a:cubicBezTo>
                    <a:pt x="215" y="668"/>
                    <a:pt x="218" y="688"/>
                    <a:pt x="222" y="694"/>
                  </a:cubicBezTo>
                  <a:cubicBezTo>
                    <a:pt x="226" y="700"/>
                    <a:pt x="233" y="705"/>
                    <a:pt x="242" y="708"/>
                  </a:cubicBezTo>
                  <a:cubicBezTo>
                    <a:pt x="251" y="711"/>
                    <a:pt x="278" y="713"/>
                    <a:pt x="321"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4" name="Freeform 8"/>
            <p:cNvSpPr>
              <a:spLocks/>
            </p:cNvSpPr>
            <p:nvPr userDrawn="1"/>
          </p:nvSpPr>
          <p:spPr bwMode="auto">
            <a:xfrm>
              <a:off x="1266825" y="1003301"/>
              <a:ext cx="276225" cy="242888"/>
            </a:xfrm>
            <a:custGeom>
              <a:avLst/>
              <a:gdLst>
                <a:gd name="T0" fmla="*/ 5 w 869"/>
                <a:gd name="T1" fmla="*/ 747 h 766"/>
                <a:gd name="T2" fmla="*/ 5 w 869"/>
                <a:gd name="T3" fmla="*/ 714 h 766"/>
                <a:gd name="T4" fmla="*/ 80 w 869"/>
                <a:gd name="T5" fmla="*/ 705 h 766"/>
                <a:gd name="T6" fmla="*/ 91 w 869"/>
                <a:gd name="T7" fmla="*/ 695 h 766"/>
                <a:gd name="T8" fmla="*/ 99 w 869"/>
                <a:gd name="T9" fmla="*/ 640 h 766"/>
                <a:gd name="T10" fmla="*/ 102 w 869"/>
                <a:gd name="T11" fmla="*/ 520 h 766"/>
                <a:gd name="T12" fmla="*/ 102 w 869"/>
                <a:gd name="T13" fmla="*/ 92 h 766"/>
                <a:gd name="T14" fmla="*/ 100 w 869"/>
                <a:gd name="T15" fmla="*/ 69 h 766"/>
                <a:gd name="T16" fmla="*/ 80 w 869"/>
                <a:gd name="T17" fmla="*/ 47 h 766"/>
                <a:gd name="T18" fmla="*/ 57 w 869"/>
                <a:gd name="T19" fmla="*/ 36 h 766"/>
                <a:gd name="T20" fmla="*/ 0 w 869"/>
                <a:gd name="T21" fmla="*/ 33 h 766"/>
                <a:gd name="T22" fmla="*/ 0 w 869"/>
                <a:gd name="T23" fmla="*/ 0 h 766"/>
                <a:gd name="T24" fmla="*/ 119 w 869"/>
                <a:gd name="T25" fmla="*/ 3 h 766"/>
                <a:gd name="T26" fmla="*/ 202 w 869"/>
                <a:gd name="T27" fmla="*/ 0 h 766"/>
                <a:gd name="T28" fmla="*/ 269 w 869"/>
                <a:gd name="T29" fmla="*/ 86 h 766"/>
                <a:gd name="T30" fmla="*/ 381 w 869"/>
                <a:gd name="T31" fmla="*/ 220 h 766"/>
                <a:gd name="T32" fmla="*/ 545 w 869"/>
                <a:gd name="T33" fmla="*/ 411 h 766"/>
                <a:gd name="T34" fmla="*/ 671 w 869"/>
                <a:gd name="T35" fmla="*/ 554 h 766"/>
                <a:gd name="T36" fmla="*/ 721 w 869"/>
                <a:gd name="T37" fmla="*/ 609 h 766"/>
                <a:gd name="T38" fmla="*/ 721 w 869"/>
                <a:gd name="T39" fmla="*/ 226 h 766"/>
                <a:gd name="T40" fmla="*/ 718 w 869"/>
                <a:gd name="T41" fmla="*/ 105 h 766"/>
                <a:gd name="T42" fmla="*/ 711 w 869"/>
                <a:gd name="T43" fmla="*/ 51 h 766"/>
                <a:gd name="T44" fmla="*/ 699 w 869"/>
                <a:gd name="T45" fmla="*/ 41 h 766"/>
                <a:gd name="T46" fmla="*/ 624 w 869"/>
                <a:gd name="T47" fmla="*/ 33 h 766"/>
                <a:gd name="T48" fmla="*/ 624 w 869"/>
                <a:gd name="T49" fmla="*/ 0 h 766"/>
                <a:gd name="T50" fmla="*/ 756 w 869"/>
                <a:gd name="T51" fmla="*/ 3 h 766"/>
                <a:gd name="T52" fmla="*/ 869 w 869"/>
                <a:gd name="T53" fmla="*/ 0 h 766"/>
                <a:gd name="T54" fmla="*/ 869 w 869"/>
                <a:gd name="T55" fmla="*/ 33 h 766"/>
                <a:gd name="T56" fmla="*/ 794 w 869"/>
                <a:gd name="T57" fmla="*/ 41 h 766"/>
                <a:gd name="T58" fmla="*/ 783 w 869"/>
                <a:gd name="T59" fmla="*/ 52 h 766"/>
                <a:gd name="T60" fmla="*/ 775 w 869"/>
                <a:gd name="T61" fmla="*/ 107 h 766"/>
                <a:gd name="T62" fmla="*/ 772 w 869"/>
                <a:gd name="T63" fmla="*/ 226 h 766"/>
                <a:gd name="T64" fmla="*/ 772 w 869"/>
                <a:gd name="T65" fmla="*/ 479 h 766"/>
                <a:gd name="T66" fmla="*/ 775 w 869"/>
                <a:gd name="T67" fmla="*/ 766 h 766"/>
                <a:gd name="T68" fmla="*/ 721 w 869"/>
                <a:gd name="T69" fmla="*/ 766 h 766"/>
                <a:gd name="T70" fmla="*/ 707 w 869"/>
                <a:gd name="T71" fmla="*/ 752 h 766"/>
                <a:gd name="T72" fmla="*/ 698 w 869"/>
                <a:gd name="T73" fmla="*/ 744 h 766"/>
                <a:gd name="T74" fmla="*/ 678 w 869"/>
                <a:gd name="T75" fmla="*/ 723 h 766"/>
                <a:gd name="T76" fmla="*/ 611 w 869"/>
                <a:gd name="T77" fmla="*/ 647 h 766"/>
                <a:gd name="T78" fmla="*/ 540 w 869"/>
                <a:gd name="T79" fmla="*/ 560 h 766"/>
                <a:gd name="T80" fmla="*/ 151 w 869"/>
                <a:gd name="T81" fmla="*/ 110 h 766"/>
                <a:gd name="T82" fmla="*/ 151 w 869"/>
                <a:gd name="T83" fmla="*/ 518 h 766"/>
                <a:gd name="T84" fmla="*/ 154 w 869"/>
                <a:gd name="T85" fmla="*/ 641 h 766"/>
                <a:gd name="T86" fmla="*/ 161 w 869"/>
                <a:gd name="T87" fmla="*/ 695 h 766"/>
                <a:gd name="T88" fmla="*/ 173 w 869"/>
                <a:gd name="T89" fmla="*/ 705 h 766"/>
                <a:gd name="T90" fmla="*/ 249 w 869"/>
                <a:gd name="T91" fmla="*/ 714 h 766"/>
                <a:gd name="T92" fmla="*/ 249 w 869"/>
                <a:gd name="T93" fmla="*/ 747 h 766"/>
                <a:gd name="T94" fmla="*/ 143 w 869"/>
                <a:gd name="T95" fmla="*/ 744 h 766"/>
                <a:gd name="T96" fmla="*/ 5 w 869"/>
                <a:gd name="T97" fmla="*/ 747 h 76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869" h="766">
                  <a:moveTo>
                    <a:pt x="5" y="747"/>
                  </a:moveTo>
                  <a:cubicBezTo>
                    <a:pt x="5" y="714"/>
                    <a:pt x="5" y="714"/>
                    <a:pt x="5" y="714"/>
                  </a:cubicBezTo>
                  <a:cubicBezTo>
                    <a:pt x="43" y="714"/>
                    <a:pt x="68" y="711"/>
                    <a:pt x="80" y="705"/>
                  </a:cubicBezTo>
                  <a:cubicBezTo>
                    <a:pt x="86" y="703"/>
                    <a:pt x="89" y="700"/>
                    <a:pt x="91" y="695"/>
                  </a:cubicBezTo>
                  <a:cubicBezTo>
                    <a:pt x="95" y="688"/>
                    <a:pt x="98" y="670"/>
                    <a:pt x="99" y="640"/>
                  </a:cubicBezTo>
                  <a:cubicBezTo>
                    <a:pt x="101" y="594"/>
                    <a:pt x="102" y="554"/>
                    <a:pt x="102" y="520"/>
                  </a:cubicBezTo>
                  <a:cubicBezTo>
                    <a:pt x="102" y="92"/>
                    <a:pt x="102" y="92"/>
                    <a:pt x="102" y="92"/>
                  </a:cubicBezTo>
                  <a:cubicBezTo>
                    <a:pt x="102" y="80"/>
                    <a:pt x="102" y="73"/>
                    <a:pt x="100" y="69"/>
                  </a:cubicBezTo>
                  <a:cubicBezTo>
                    <a:pt x="97" y="63"/>
                    <a:pt x="91" y="56"/>
                    <a:pt x="80" y="47"/>
                  </a:cubicBezTo>
                  <a:cubicBezTo>
                    <a:pt x="74" y="41"/>
                    <a:pt x="66" y="38"/>
                    <a:pt x="57" y="36"/>
                  </a:cubicBezTo>
                  <a:cubicBezTo>
                    <a:pt x="49" y="34"/>
                    <a:pt x="30" y="33"/>
                    <a:pt x="0" y="33"/>
                  </a:cubicBezTo>
                  <a:cubicBezTo>
                    <a:pt x="0" y="0"/>
                    <a:pt x="0" y="0"/>
                    <a:pt x="0" y="0"/>
                  </a:cubicBezTo>
                  <a:cubicBezTo>
                    <a:pt x="63" y="2"/>
                    <a:pt x="103" y="3"/>
                    <a:pt x="119" y="3"/>
                  </a:cubicBezTo>
                  <a:cubicBezTo>
                    <a:pt x="147" y="3"/>
                    <a:pt x="174" y="2"/>
                    <a:pt x="202" y="0"/>
                  </a:cubicBezTo>
                  <a:cubicBezTo>
                    <a:pt x="232" y="39"/>
                    <a:pt x="255" y="67"/>
                    <a:pt x="269" y="86"/>
                  </a:cubicBezTo>
                  <a:cubicBezTo>
                    <a:pt x="381" y="220"/>
                    <a:pt x="381" y="220"/>
                    <a:pt x="381" y="220"/>
                  </a:cubicBezTo>
                  <a:cubicBezTo>
                    <a:pt x="545" y="411"/>
                    <a:pt x="545" y="411"/>
                    <a:pt x="545" y="411"/>
                  </a:cubicBezTo>
                  <a:cubicBezTo>
                    <a:pt x="597" y="472"/>
                    <a:pt x="639" y="520"/>
                    <a:pt x="671" y="554"/>
                  </a:cubicBezTo>
                  <a:cubicBezTo>
                    <a:pt x="691" y="578"/>
                    <a:pt x="708" y="596"/>
                    <a:pt x="721" y="609"/>
                  </a:cubicBezTo>
                  <a:cubicBezTo>
                    <a:pt x="721" y="226"/>
                    <a:pt x="721" y="226"/>
                    <a:pt x="721" y="226"/>
                  </a:cubicBezTo>
                  <a:cubicBezTo>
                    <a:pt x="721" y="191"/>
                    <a:pt x="720" y="151"/>
                    <a:pt x="718" y="105"/>
                  </a:cubicBezTo>
                  <a:cubicBezTo>
                    <a:pt x="717" y="76"/>
                    <a:pt x="714" y="58"/>
                    <a:pt x="711" y="51"/>
                  </a:cubicBezTo>
                  <a:cubicBezTo>
                    <a:pt x="708" y="46"/>
                    <a:pt x="705" y="43"/>
                    <a:pt x="699" y="41"/>
                  </a:cubicBezTo>
                  <a:cubicBezTo>
                    <a:pt x="687" y="36"/>
                    <a:pt x="662" y="33"/>
                    <a:pt x="624" y="33"/>
                  </a:cubicBezTo>
                  <a:cubicBezTo>
                    <a:pt x="624" y="0"/>
                    <a:pt x="624" y="0"/>
                    <a:pt x="624" y="0"/>
                  </a:cubicBezTo>
                  <a:cubicBezTo>
                    <a:pt x="667" y="2"/>
                    <a:pt x="711" y="3"/>
                    <a:pt x="756" y="3"/>
                  </a:cubicBezTo>
                  <a:cubicBezTo>
                    <a:pt x="797" y="3"/>
                    <a:pt x="835" y="2"/>
                    <a:pt x="869" y="0"/>
                  </a:cubicBezTo>
                  <a:cubicBezTo>
                    <a:pt x="869" y="33"/>
                    <a:pt x="869" y="33"/>
                    <a:pt x="869" y="33"/>
                  </a:cubicBezTo>
                  <a:cubicBezTo>
                    <a:pt x="831" y="33"/>
                    <a:pt x="806" y="36"/>
                    <a:pt x="794" y="41"/>
                  </a:cubicBezTo>
                  <a:cubicBezTo>
                    <a:pt x="789" y="43"/>
                    <a:pt x="785" y="47"/>
                    <a:pt x="783" y="52"/>
                  </a:cubicBezTo>
                  <a:cubicBezTo>
                    <a:pt x="779" y="58"/>
                    <a:pt x="776" y="77"/>
                    <a:pt x="775" y="107"/>
                  </a:cubicBezTo>
                  <a:cubicBezTo>
                    <a:pt x="773" y="153"/>
                    <a:pt x="772" y="193"/>
                    <a:pt x="772" y="226"/>
                  </a:cubicBezTo>
                  <a:cubicBezTo>
                    <a:pt x="772" y="479"/>
                    <a:pt x="772" y="479"/>
                    <a:pt x="772" y="479"/>
                  </a:cubicBezTo>
                  <a:cubicBezTo>
                    <a:pt x="772" y="531"/>
                    <a:pt x="773" y="626"/>
                    <a:pt x="775" y="766"/>
                  </a:cubicBezTo>
                  <a:cubicBezTo>
                    <a:pt x="721" y="766"/>
                    <a:pt x="721" y="766"/>
                    <a:pt x="721" y="766"/>
                  </a:cubicBezTo>
                  <a:cubicBezTo>
                    <a:pt x="707" y="752"/>
                    <a:pt x="707" y="752"/>
                    <a:pt x="707" y="752"/>
                  </a:cubicBezTo>
                  <a:cubicBezTo>
                    <a:pt x="705" y="751"/>
                    <a:pt x="700" y="746"/>
                    <a:pt x="698" y="744"/>
                  </a:cubicBezTo>
                  <a:cubicBezTo>
                    <a:pt x="696" y="742"/>
                    <a:pt x="689" y="735"/>
                    <a:pt x="678" y="723"/>
                  </a:cubicBezTo>
                  <a:cubicBezTo>
                    <a:pt x="647" y="689"/>
                    <a:pt x="625" y="664"/>
                    <a:pt x="611" y="647"/>
                  </a:cubicBezTo>
                  <a:cubicBezTo>
                    <a:pt x="540" y="560"/>
                    <a:pt x="540" y="560"/>
                    <a:pt x="540" y="560"/>
                  </a:cubicBezTo>
                  <a:cubicBezTo>
                    <a:pt x="151" y="110"/>
                    <a:pt x="151" y="110"/>
                    <a:pt x="151" y="110"/>
                  </a:cubicBezTo>
                  <a:cubicBezTo>
                    <a:pt x="151" y="518"/>
                    <a:pt x="151" y="518"/>
                    <a:pt x="151" y="518"/>
                  </a:cubicBezTo>
                  <a:cubicBezTo>
                    <a:pt x="151" y="552"/>
                    <a:pt x="152" y="593"/>
                    <a:pt x="154" y="641"/>
                  </a:cubicBezTo>
                  <a:cubicBezTo>
                    <a:pt x="156" y="670"/>
                    <a:pt x="158" y="688"/>
                    <a:pt x="161" y="695"/>
                  </a:cubicBezTo>
                  <a:cubicBezTo>
                    <a:pt x="164" y="700"/>
                    <a:pt x="168" y="704"/>
                    <a:pt x="173" y="705"/>
                  </a:cubicBezTo>
                  <a:cubicBezTo>
                    <a:pt x="185" y="711"/>
                    <a:pt x="210" y="714"/>
                    <a:pt x="249" y="714"/>
                  </a:cubicBezTo>
                  <a:cubicBezTo>
                    <a:pt x="249" y="747"/>
                    <a:pt x="249" y="747"/>
                    <a:pt x="249" y="747"/>
                  </a:cubicBezTo>
                  <a:cubicBezTo>
                    <a:pt x="217" y="745"/>
                    <a:pt x="181" y="744"/>
                    <a:pt x="143" y="744"/>
                  </a:cubicBezTo>
                  <a:cubicBezTo>
                    <a:pt x="100" y="744"/>
                    <a:pt x="54" y="745"/>
                    <a:pt x="5"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5" name="Freeform 9"/>
            <p:cNvSpPr>
              <a:spLocks/>
            </p:cNvSpPr>
            <p:nvPr userDrawn="1"/>
          </p:nvSpPr>
          <p:spPr bwMode="auto">
            <a:xfrm>
              <a:off x="1573213" y="1003301"/>
              <a:ext cx="101600" cy="236538"/>
            </a:xfrm>
            <a:custGeom>
              <a:avLst/>
              <a:gdLst>
                <a:gd name="T0" fmla="*/ 322 w 322"/>
                <a:gd name="T1" fmla="*/ 714 h 747"/>
                <a:gd name="T2" fmla="*/ 322 w 322"/>
                <a:gd name="T3" fmla="*/ 747 h 747"/>
                <a:gd name="T4" fmla="*/ 169 w 322"/>
                <a:gd name="T5" fmla="*/ 744 h 747"/>
                <a:gd name="T6" fmla="*/ 0 w 322"/>
                <a:gd name="T7" fmla="*/ 747 h 747"/>
                <a:gd name="T8" fmla="*/ 0 w 322"/>
                <a:gd name="T9" fmla="*/ 714 h 747"/>
                <a:gd name="T10" fmla="*/ 79 w 322"/>
                <a:gd name="T11" fmla="*/ 708 h 747"/>
                <a:gd name="T12" fmla="*/ 98 w 322"/>
                <a:gd name="T13" fmla="*/ 696 h 747"/>
                <a:gd name="T14" fmla="*/ 106 w 322"/>
                <a:gd name="T15" fmla="*/ 645 h 747"/>
                <a:gd name="T16" fmla="*/ 109 w 322"/>
                <a:gd name="T17" fmla="*/ 495 h 747"/>
                <a:gd name="T18" fmla="*/ 109 w 322"/>
                <a:gd name="T19" fmla="*/ 251 h 747"/>
                <a:gd name="T20" fmla="*/ 106 w 322"/>
                <a:gd name="T21" fmla="*/ 111 h 747"/>
                <a:gd name="T22" fmla="*/ 98 w 322"/>
                <a:gd name="T23" fmla="*/ 52 h 747"/>
                <a:gd name="T24" fmla="*/ 78 w 322"/>
                <a:gd name="T25" fmla="*/ 39 h 747"/>
                <a:gd name="T26" fmla="*/ 0 w 322"/>
                <a:gd name="T27" fmla="*/ 33 h 747"/>
                <a:gd name="T28" fmla="*/ 0 w 322"/>
                <a:gd name="T29" fmla="*/ 0 h 747"/>
                <a:gd name="T30" fmla="*/ 161 w 322"/>
                <a:gd name="T31" fmla="*/ 3 h 747"/>
                <a:gd name="T32" fmla="*/ 322 w 322"/>
                <a:gd name="T33" fmla="*/ 0 h 747"/>
                <a:gd name="T34" fmla="*/ 322 w 322"/>
                <a:gd name="T35" fmla="*/ 33 h 747"/>
                <a:gd name="T36" fmla="*/ 244 w 322"/>
                <a:gd name="T37" fmla="*/ 39 h 747"/>
                <a:gd name="T38" fmla="*/ 224 w 322"/>
                <a:gd name="T39" fmla="*/ 51 h 747"/>
                <a:gd name="T40" fmla="*/ 216 w 322"/>
                <a:gd name="T41" fmla="*/ 102 h 747"/>
                <a:gd name="T42" fmla="*/ 213 w 322"/>
                <a:gd name="T43" fmla="*/ 251 h 747"/>
                <a:gd name="T44" fmla="*/ 213 w 322"/>
                <a:gd name="T45" fmla="*/ 495 h 747"/>
                <a:gd name="T46" fmla="*/ 215 w 322"/>
                <a:gd name="T47" fmla="*/ 635 h 747"/>
                <a:gd name="T48" fmla="*/ 223 w 322"/>
                <a:gd name="T49" fmla="*/ 694 h 747"/>
                <a:gd name="T50" fmla="*/ 243 w 322"/>
                <a:gd name="T51" fmla="*/ 708 h 747"/>
                <a:gd name="T52" fmla="*/ 322 w 322"/>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2" h="747">
                  <a:moveTo>
                    <a:pt x="322" y="714"/>
                  </a:moveTo>
                  <a:cubicBezTo>
                    <a:pt x="322" y="747"/>
                    <a:pt x="322" y="747"/>
                    <a:pt x="322" y="747"/>
                  </a:cubicBezTo>
                  <a:cubicBezTo>
                    <a:pt x="244" y="745"/>
                    <a:pt x="193" y="744"/>
                    <a:pt x="169" y="744"/>
                  </a:cubicBezTo>
                  <a:cubicBezTo>
                    <a:pt x="0" y="747"/>
                    <a:pt x="0" y="747"/>
                    <a:pt x="0" y="747"/>
                  </a:cubicBezTo>
                  <a:cubicBezTo>
                    <a:pt x="0" y="714"/>
                    <a:pt x="0" y="714"/>
                    <a:pt x="0" y="714"/>
                  </a:cubicBezTo>
                  <a:cubicBezTo>
                    <a:pt x="43" y="713"/>
                    <a:pt x="69" y="711"/>
                    <a:pt x="79" y="708"/>
                  </a:cubicBezTo>
                  <a:cubicBezTo>
                    <a:pt x="88" y="705"/>
                    <a:pt x="94" y="701"/>
                    <a:pt x="98" y="696"/>
                  </a:cubicBezTo>
                  <a:cubicBezTo>
                    <a:pt x="102" y="689"/>
                    <a:pt x="105" y="672"/>
                    <a:pt x="106" y="645"/>
                  </a:cubicBezTo>
                  <a:cubicBezTo>
                    <a:pt x="107" y="637"/>
                    <a:pt x="108" y="587"/>
                    <a:pt x="109" y="495"/>
                  </a:cubicBezTo>
                  <a:cubicBezTo>
                    <a:pt x="109" y="251"/>
                    <a:pt x="109" y="251"/>
                    <a:pt x="109" y="251"/>
                  </a:cubicBezTo>
                  <a:cubicBezTo>
                    <a:pt x="109" y="204"/>
                    <a:pt x="108" y="157"/>
                    <a:pt x="106" y="111"/>
                  </a:cubicBezTo>
                  <a:cubicBezTo>
                    <a:pt x="105" y="78"/>
                    <a:pt x="102" y="59"/>
                    <a:pt x="98" y="52"/>
                  </a:cubicBezTo>
                  <a:cubicBezTo>
                    <a:pt x="94" y="46"/>
                    <a:pt x="88" y="41"/>
                    <a:pt x="78" y="39"/>
                  </a:cubicBezTo>
                  <a:cubicBezTo>
                    <a:pt x="69" y="36"/>
                    <a:pt x="43" y="34"/>
                    <a:pt x="0" y="33"/>
                  </a:cubicBezTo>
                  <a:cubicBezTo>
                    <a:pt x="0" y="0"/>
                    <a:pt x="0" y="0"/>
                    <a:pt x="0" y="0"/>
                  </a:cubicBezTo>
                  <a:cubicBezTo>
                    <a:pt x="70" y="2"/>
                    <a:pt x="124" y="3"/>
                    <a:pt x="161" y="3"/>
                  </a:cubicBezTo>
                  <a:cubicBezTo>
                    <a:pt x="198" y="3"/>
                    <a:pt x="251" y="2"/>
                    <a:pt x="322" y="0"/>
                  </a:cubicBezTo>
                  <a:cubicBezTo>
                    <a:pt x="322" y="33"/>
                    <a:pt x="322" y="33"/>
                    <a:pt x="322" y="33"/>
                  </a:cubicBezTo>
                  <a:cubicBezTo>
                    <a:pt x="279" y="34"/>
                    <a:pt x="253" y="36"/>
                    <a:pt x="244" y="39"/>
                  </a:cubicBezTo>
                  <a:cubicBezTo>
                    <a:pt x="234" y="41"/>
                    <a:pt x="228" y="46"/>
                    <a:pt x="224" y="51"/>
                  </a:cubicBezTo>
                  <a:cubicBezTo>
                    <a:pt x="220" y="58"/>
                    <a:pt x="217" y="75"/>
                    <a:pt x="216" y="102"/>
                  </a:cubicBezTo>
                  <a:cubicBezTo>
                    <a:pt x="216" y="109"/>
                    <a:pt x="215" y="159"/>
                    <a:pt x="213" y="251"/>
                  </a:cubicBezTo>
                  <a:cubicBezTo>
                    <a:pt x="213" y="495"/>
                    <a:pt x="213" y="495"/>
                    <a:pt x="213" y="495"/>
                  </a:cubicBezTo>
                  <a:cubicBezTo>
                    <a:pt x="213" y="543"/>
                    <a:pt x="214" y="589"/>
                    <a:pt x="215" y="635"/>
                  </a:cubicBezTo>
                  <a:cubicBezTo>
                    <a:pt x="216" y="668"/>
                    <a:pt x="219" y="688"/>
                    <a:pt x="223" y="694"/>
                  </a:cubicBezTo>
                  <a:cubicBezTo>
                    <a:pt x="227" y="700"/>
                    <a:pt x="234" y="705"/>
                    <a:pt x="243" y="708"/>
                  </a:cubicBezTo>
                  <a:cubicBezTo>
                    <a:pt x="252" y="711"/>
                    <a:pt x="278" y="713"/>
                    <a:pt x="322"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6" name="Freeform 10"/>
            <p:cNvSpPr>
              <a:spLocks/>
            </p:cNvSpPr>
            <p:nvPr userDrawn="1"/>
          </p:nvSpPr>
          <p:spPr bwMode="auto">
            <a:xfrm>
              <a:off x="1692275" y="998538"/>
              <a:ext cx="231775" cy="246063"/>
            </a:xfrm>
            <a:custGeom>
              <a:avLst/>
              <a:gdLst>
                <a:gd name="T0" fmla="*/ 728 w 728"/>
                <a:gd name="T1" fmla="*/ 667 h 774"/>
                <a:gd name="T2" fmla="*/ 707 w 728"/>
                <a:gd name="T3" fmla="*/ 716 h 774"/>
                <a:gd name="T4" fmla="*/ 581 w 728"/>
                <a:gd name="T5" fmla="*/ 761 h 774"/>
                <a:gd name="T6" fmla="*/ 447 w 728"/>
                <a:gd name="T7" fmla="*/ 774 h 774"/>
                <a:gd name="T8" fmla="*/ 288 w 728"/>
                <a:gd name="T9" fmla="*/ 754 h 774"/>
                <a:gd name="T10" fmla="*/ 161 w 728"/>
                <a:gd name="T11" fmla="*/ 696 h 774"/>
                <a:gd name="T12" fmla="*/ 71 w 728"/>
                <a:gd name="T13" fmla="*/ 610 h 774"/>
                <a:gd name="T14" fmla="*/ 18 w 728"/>
                <a:gd name="T15" fmla="*/ 508 h 774"/>
                <a:gd name="T16" fmla="*/ 0 w 728"/>
                <a:gd name="T17" fmla="*/ 386 h 774"/>
                <a:gd name="T18" fmla="*/ 123 w 728"/>
                <a:gd name="T19" fmla="*/ 110 h 774"/>
                <a:gd name="T20" fmla="*/ 457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5 w 728"/>
                <a:gd name="T35" fmla="*/ 143 h 774"/>
                <a:gd name="T36" fmla="*/ 605 w 728"/>
                <a:gd name="T37" fmla="*/ 66 h 774"/>
                <a:gd name="T38" fmla="*/ 446 w 728"/>
                <a:gd name="T39" fmla="*/ 41 h 774"/>
                <a:gd name="T40" fmla="*/ 313 w 728"/>
                <a:gd name="T41" fmla="*/ 60 h 774"/>
                <a:gd name="T42" fmla="*/ 217 w 728"/>
                <a:gd name="T43" fmla="*/ 117 h 774"/>
                <a:gd name="T44" fmla="*/ 149 w 728"/>
                <a:gd name="T45" fmla="*/ 216 h 774"/>
                <a:gd name="T46" fmla="*/ 122 w 728"/>
                <a:gd name="T47" fmla="*/ 366 h 774"/>
                <a:gd name="T48" fmla="*/ 223 w 728"/>
                <a:gd name="T49" fmla="*/ 621 h 774"/>
                <a:gd name="T50" fmla="*/ 492 w 728"/>
                <a:gd name="T51" fmla="*/ 717 h 774"/>
                <a:gd name="T52" fmla="*/ 632 w 728"/>
                <a:gd name="T53" fmla="*/ 698 h 774"/>
                <a:gd name="T54" fmla="*/ 719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7" y="716"/>
                    <a:pt x="707" y="716"/>
                    <a:pt x="707" y="716"/>
                  </a:cubicBezTo>
                  <a:cubicBezTo>
                    <a:pt x="664" y="736"/>
                    <a:pt x="622" y="751"/>
                    <a:pt x="581" y="761"/>
                  </a:cubicBezTo>
                  <a:cubicBezTo>
                    <a:pt x="540" y="770"/>
                    <a:pt x="495" y="774"/>
                    <a:pt x="447" y="774"/>
                  </a:cubicBezTo>
                  <a:cubicBezTo>
                    <a:pt x="390" y="774"/>
                    <a:pt x="337" y="768"/>
                    <a:pt x="288" y="754"/>
                  </a:cubicBezTo>
                  <a:cubicBezTo>
                    <a:pt x="240" y="740"/>
                    <a:pt x="197" y="721"/>
                    <a:pt x="161" y="696"/>
                  </a:cubicBezTo>
                  <a:cubicBezTo>
                    <a:pt x="124" y="670"/>
                    <a:pt x="94" y="642"/>
                    <a:pt x="71" y="610"/>
                  </a:cubicBezTo>
                  <a:cubicBezTo>
                    <a:pt x="48" y="579"/>
                    <a:pt x="31" y="545"/>
                    <a:pt x="18" y="508"/>
                  </a:cubicBezTo>
                  <a:cubicBezTo>
                    <a:pt x="6" y="471"/>
                    <a:pt x="0" y="430"/>
                    <a:pt x="0" y="386"/>
                  </a:cubicBezTo>
                  <a:cubicBezTo>
                    <a:pt x="0" y="275"/>
                    <a:pt x="41" y="183"/>
                    <a:pt x="123" y="110"/>
                  </a:cubicBezTo>
                  <a:cubicBezTo>
                    <a:pt x="204" y="37"/>
                    <a:pt x="316" y="0"/>
                    <a:pt x="457" y="0"/>
                  </a:cubicBezTo>
                  <a:cubicBezTo>
                    <a:pt x="490" y="0"/>
                    <a:pt x="521" y="2"/>
                    <a:pt x="549" y="6"/>
                  </a:cubicBezTo>
                  <a:cubicBezTo>
                    <a:pt x="578"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5" y="143"/>
                    <a:pt x="665" y="143"/>
                    <a:pt x="665" y="143"/>
                  </a:cubicBezTo>
                  <a:cubicBezTo>
                    <a:pt x="661" y="109"/>
                    <a:pt x="641" y="83"/>
                    <a:pt x="605" y="66"/>
                  </a:cubicBezTo>
                  <a:cubicBezTo>
                    <a:pt x="569" y="50"/>
                    <a:pt x="516" y="41"/>
                    <a:pt x="446" y="41"/>
                  </a:cubicBezTo>
                  <a:cubicBezTo>
                    <a:pt x="393" y="42"/>
                    <a:pt x="349" y="48"/>
                    <a:pt x="313" y="60"/>
                  </a:cubicBezTo>
                  <a:cubicBezTo>
                    <a:pt x="277" y="72"/>
                    <a:pt x="245" y="91"/>
                    <a:pt x="217" y="117"/>
                  </a:cubicBezTo>
                  <a:cubicBezTo>
                    <a:pt x="189" y="143"/>
                    <a:pt x="166" y="176"/>
                    <a:pt x="149" y="216"/>
                  </a:cubicBezTo>
                  <a:cubicBezTo>
                    <a:pt x="131" y="256"/>
                    <a:pt x="122" y="306"/>
                    <a:pt x="122" y="366"/>
                  </a:cubicBezTo>
                  <a:cubicBezTo>
                    <a:pt x="122" y="472"/>
                    <a:pt x="155" y="557"/>
                    <a:pt x="223" y="621"/>
                  </a:cubicBezTo>
                  <a:cubicBezTo>
                    <a:pt x="291" y="685"/>
                    <a:pt x="380" y="717"/>
                    <a:pt x="492" y="717"/>
                  </a:cubicBezTo>
                  <a:cubicBezTo>
                    <a:pt x="542" y="717"/>
                    <a:pt x="589" y="711"/>
                    <a:pt x="632" y="698"/>
                  </a:cubicBezTo>
                  <a:cubicBezTo>
                    <a:pt x="661" y="689"/>
                    <a:pt x="690" y="675"/>
                    <a:pt x="719"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7" name="Freeform 11"/>
            <p:cNvSpPr>
              <a:spLocks/>
            </p:cNvSpPr>
            <p:nvPr userDrawn="1"/>
          </p:nvSpPr>
          <p:spPr bwMode="auto">
            <a:xfrm>
              <a:off x="657225" y="998538"/>
              <a:ext cx="231775" cy="246063"/>
            </a:xfrm>
            <a:custGeom>
              <a:avLst/>
              <a:gdLst>
                <a:gd name="T0" fmla="*/ 728 w 728"/>
                <a:gd name="T1" fmla="*/ 667 h 774"/>
                <a:gd name="T2" fmla="*/ 706 w 728"/>
                <a:gd name="T3" fmla="*/ 716 h 774"/>
                <a:gd name="T4" fmla="*/ 580 w 728"/>
                <a:gd name="T5" fmla="*/ 761 h 774"/>
                <a:gd name="T6" fmla="*/ 446 w 728"/>
                <a:gd name="T7" fmla="*/ 774 h 774"/>
                <a:gd name="T8" fmla="*/ 288 w 728"/>
                <a:gd name="T9" fmla="*/ 754 h 774"/>
                <a:gd name="T10" fmla="*/ 160 w 728"/>
                <a:gd name="T11" fmla="*/ 696 h 774"/>
                <a:gd name="T12" fmla="*/ 71 w 728"/>
                <a:gd name="T13" fmla="*/ 610 h 774"/>
                <a:gd name="T14" fmla="*/ 18 w 728"/>
                <a:gd name="T15" fmla="*/ 508 h 774"/>
                <a:gd name="T16" fmla="*/ 0 w 728"/>
                <a:gd name="T17" fmla="*/ 386 h 774"/>
                <a:gd name="T18" fmla="*/ 122 w 728"/>
                <a:gd name="T19" fmla="*/ 110 h 774"/>
                <a:gd name="T20" fmla="*/ 456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4 w 728"/>
                <a:gd name="T35" fmla="*/ 143 h 774"/>
                <a:gd name="T36" fmla="*/ 604 w 728"/>
                <a:gd name="T37" fmla="*/ 66 h 774"/>
                <a:gd name="T38" fmla="*/ 445 w 728"/>
                <a:gd name="T39" fmla="*/ 41 h 774"/>
                <a:gd name="T40" fmla="*/ 313 w 728"/>
                <a:gd name="T41" fmla="*/ 60 h 774"/>
                <a:gd name="T42" fmla="*/ 216 w 728"/>
                <a:gd name="T43" fmla="*/ 117 h 774"/>
                <a:gd name="T44" fmla="*/ 148 w 728"/>
                <a:gd name="T45" fmla="*/ 216 h 774"/>
                <a:gd name="T46" fmla="*/ 121 w 728"/>
                <a:gd name="T47" fmla="*/ 366 h 774"/>
                <a:gd name="T48" fmla="*/ 223 w 728"/>
                <a:gd name="T49" fmla="*/ 621 h 774"/>
                <a:gd name="T50" fmla="*/ 492 w 728"/>
                <a:gd name="T51" fmla="*/ 717 h 774"/>
                <a:gd name="T52" fmla="*/ 631 w 728"/>
                <a:gd name="T53" fmla="*/ 698 h 774"/>
                <a:gd name="T54" fmla="*/ 718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6" y="716"/>
                    <a:pt x="706" y="716"/>
                    <a:pt x="706" y="716"/>
                  </a:cubicBezTo>
                  <a:cubicBezTo>
                    <a:pt x="663" y="736"/>
                    <a:pt x="621" y="751"/>
                    <a:pt x="580" y="761"/>
                  </a:cubicBezTo>
                  <a:cubicBezTo>
                    <a:pt x="539" y="770"/>
                    <a:pt x="495" y="774"/>
                    <a:pt x="446" y="774"/>
                  </a:cubicBezTo>
                  <a:cubicBezTo>
                    <a:pt x="389" y="774"/>
                    <a:pt x="337" y="768"/>
                    <a:pt x="288" y="754"/>
                  </a:cubicBezTo>
                  <a:cubicBezTo>
                    <a:pt x="239" y="740"/>
                    <a:pt x="197" y="721"/>
                    <a:pt x="160" y="696"/>
                  </a:cubicBezTo>
                  <a:cubicBezTo>
                    <a:pt x="124" y="670"/>
                    <a:pt x="94" y="642"/>
                    <a:pt x="71" y="610"/>
                  </a:cubicBezTo>
                  <a:cubicBezTo>
                    <a:pt x="48" y="579"/>
                    <a:pt x="30" y="545"/>
                    <a:pt x="18" y="508"/>
                  </a:cubicBezTo>
                  <a:cubicBezTo>
                    <a:pt x="6" y="471"/>
                    <a:pt x="0" y="430"/>
                    <a:pt x="0" y="386"/>
                  </a:cubicBezTo>
                  <a:cubicBezTo>
                    <a:pt x="0" y="275"/>
                    <a:pt x="41" y="183"/>
                    <a:pt x="122" y="110"/>
                  </a:cubicBezTo>
                  <a:cubicBezTo>
                    <a:pt x="204" y="37"/>
                    <a:pt x="315" y="0"/>
                    <a:pt x="456" y="0"/>
                  </a:cubicBezTo>
                  <a:cubicBezTo>
                    <a:pt x="490" y="0"/>
                    <a:pt x="520" y="2"/>
                    <a:pt x="549" y="6"/>
                  </a:cubicBezTo>
                  <a:cubicBezTo>
                    <a:pt x="577"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4" y="143"/>
                    <a:pt x="664" y="143"/>
                    <a:pt x="664" y="143"/>
                  </a:cubicBezTo>
                  <a:cubicBezTo>
                    <a:pt x="661" y="109"/>
                    <a:pt x="641" y="83"/>
                    <a:pt x="604" y="66"/>
                  </a:cubicBezTo>
                  <a:cubicBezTo>
                    <a:pt x="568" y="50"/>
                    <a:pt x="515" y="41"/>
                    <a:pt x="445" y="41"/>
                  </a:cubicBezTo>
                  <a:cubicBezTo>
                    <a:pt x="393" y="42"/>
                    <a:pt x="349" y="48"/>
                    <a:pt x="313" y="60"/>
                  </a:cubicBezTo>
                  <a:cubicBezTo>
                    <a:pt x="276" y="72"/>
                    <a:pt x="244" y="91"/>
                    <a:pt x="216" y="117"/>
                  </a:cubicBezTo>
                  <a:cubicBezTo>
                    <a:pt x="189" y="143"/>
                    <a:pt x="166" y="176"/>
                    <a:pt x="148" y="216"/>
                  </a:cubicBezTo>
                  <a:cubicBezTo>
                    <a:pt x="131" y="256"/>
                    <a:pt x="122" y="306"/>
                    <a:pt x="121" y="366"/>
                  </a:cubicBezTo>
                  <a:cubicBezTo>
                    <a:pt x="121" y="472"/>
                    <a:pt x="155" y="557"/>
                    <a:pt x="223" y="621"/>
                  </a:cubicBezTo>
                  <a:cubicBezTo>
                    <a:pt x="290" y="685"/>
                    <a:pt x="380" y="717"/>
                    <a:pt x="492" y="717"/>
                  </a:cubicBezTo>
                  <a:cubicBezTo>
                    <a:pt x="542" y="717"/>
                    <a:pt x="588" y="711"/>
                    <a:pt x="631" y="698"/>
                  </a:cubicBezTo>
                  <a:cubicBezTo>
                    <a:pt x="660" y="689"/>
                    <a:pt x="689" y="675"/>
                    <a:pt x="718"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8" name="Freeform 12"/>
            <p:cNvSpPr>
              <a:spLocks/>
            </p:cNvSpPr>
            <p:nvPr userDrawn="1"/>
          </p:nvSpPr>
          <p:spPr bwMode="auto">
            <a:xfrm>
              <a:off x="757238" y="687388"/>
              <a:ext cx="323850" cy="239713"/>
            </a:xfrm>
            <a:custGeom>
              <a:avLst/>
              <a:gdLst>
                <a:gd name="T0" fmla="*/ 0 w 1017"/>
                <a:gd name="T1" fmla="*/ 35 h 754"/>
                <a:gd name="T2" fmla="*/ 0 w 1017"/>
                <a:gd name="T3" fmla="*/ 0 h 754"/>
                <a:gd name="T4" fmla="*/ 110 w 1017"/>
                <a:gd name="T5" fmla="*/ 4 h 754"/>
                <a:gd name="T6" fmla="*/ 212 w 1017"/>
                <a:gd name="T7" fmla="*/ 0 h 754"/>
                <a:gd name="T8" fmla="*/ 300 w 1017"/>
                <a:gd name="T9" fmla="*/ 183 h 754"/>
                <a:gd name="T10" fmla="*/ 509 w 1017"/>
                <a:gd name="T11" fmla="*/ 592 h 754"/>
                <a:gd name="T12" fmla="*/ 697 w 1017"/>
                <a:gd name="T13" fmla="*/ 218 h 754"/>
                <a:gd name="T14" fmla="*/ 800 w 1017"/>
                <a:gd name="T15" fmla="*/ 0 h 754"/>
                <a:gd name="T16" fmla="*/ 898 w 1017"/>
                <a:gd name="T17" fmla="*/ 4 h 754"/>
                <a:gd name="T18" fmla="*/ 1017 w 1017"/>
                <a:gd name="T19" fmla="*/ 0 h 754"/>
                <a:gd name="T20" fmla="*/ 1017 w 1017"/>
                <a:gd name="T21" fmla="*/ 35 h 754"/>
                <a:gd name="T22" fmla="*/ 938 w 1017"/>
                <a:gd name="T23" fmla="*/ 40 h 754"/>
                <a:gd name="T24" fmla="*/ 918 w 1017"/>
                <a:gd name="T25" fmla="*/ 53 h 754"/>
                <a:gd name="T26" fmla="*/ 910 w 1017"/>
                <a:gd name="T27" fmla="*/ 103 h 754"/>
                <a:gd name="T28" fmla="*/ 907 w 1017"/>
                <a:gd name="T29" fmla="*/ 251 h 754"/>
                <a:gd name="T30" fmla="*/ 907 w 1017"/>
                <a:gd name="T31" fmla="*/ 492 h 754"/>
                <a:gd name="T32" fmla="*/ 910 w 1017"/>
                <a:gd name="T33" fmla="*/ 631 h 754"/>
                <a:gd name="T34" fmla="*/ 918 w 1017"/>
                <a:gd name="T35" fmla="*/ 690 h 754"/>
                <a:gd name="T36" fmla="*/ 938 w 1017"/>
                <a:gd name="T37" fmla="*/ 704 h 754"/>
                <a:gd name="T38" fmla="*/ 1017 w 1017"/>
                <a:gd name="T39" fmla="*/ 709 h 754"/>
                <a:gd name="T40" fmla="*/ 1017 w 1017"/>
                <a:gd name="T41" fmla="*/ 743 h 754"/>
                <a:gd name="T42" fmla="*/ 861 w 1017"/>
                <a:gd name="T43" fmla="*/ 739 h 754"/>
                <a:gd name="T44" fmla="*/ 699 w 1017"/>
                <a:gd name="T45" fmla="*/ 743 h 754"/>
                <a:gd name="T46" fmla="*/ 699 w 1017"/>
                <a:gd name="T47" fmla="*/ 709 h 754"/>
                <a:gd name="T48" fmla="*/ 778 w 1017"/>
                <a:gd name="T49" fmla="*/ 704 h 754"/>
                <a:gd name="T50" fmla="*/ 797 w 1017"/>
                <a:gd name="T51" fmla="*/ 691 h 754"/>
                <a:gd name="T52" fmla="*/ 806 w 1017"/>
                <a:gd name="T53" fmla="*/ 641 h 754"/>
                <a:gd name="T54" fmla="*/ 808 w 1017"/>
                <a:gd name="T55" fmla="*/ 492 h 754"/>
                <a:gd name="T56" fmla="*/ 808 w 1017"/>
                <a:gd name="T57" fmla="*/ 108 h 754"/>
                <a:gd name="T58" fmla="*/ 619 w 1017"/>
                <a:gd name="T59" fmla="*/ 486 h 754"/>
                <a:gd name="T60" fmla="*/ 549 w 1017"/>
                <a:gd name="T61" fmla="*/ 629 h 754"/>
                <a:gd name="T62" fmla="*/ 494 w 1017"/>
                <a:gd name="T63" fmla="*/ 754 h 754"/>
                <a:gd name="T64" fmla="*/ 472 w 1017"/>
                <a:gd name="T65" fmla="*/ 754 h 754"/>
                <a:gd name="T66" fmla="*/ 459 w 1017"/>
                <a:gd name="T67" fmla="*/ 722 h 754"/>
                <a:gd name="T68" fmla="*/ 422 w 1017"/>
                <a:gd name="T69" fmla="*/ 645 h 754"/>
                <a:gd name="T70" fmla="*/ 159 w 1017"/>
                <a:gd name="T71" fmla="*/ 126 h 754"/>
                <a:gd name="T72" fmla="*/ 159 w 1017"/>
                <a:gd name="T73" fmla="*/ 492 h 754"/>
                <a:gd name="T74" fmla="*/ 163 w 1017"/>
                <a:gd name="T75" fmla="*/ 631 h 754"/>
                <a:gd name="T76" fmla="*/ 171 w 1017"/>
                <a:gd name="T77" fmla="*/ 690 h 754"/>
                <a:gd name="T78" fmla="*/ 191 w 1017"/>
                <a:gd name="T79" fmla="*/ 704 h 754"/>
                <a:gd name="T80" fmla="*/ 271 w 1017"/>
                <a:gd name="T81" fmla="*/ 709 h 754"/>
                <a:gd name="T82" fmla="*/ 271 w 1017"/>
                <a:gd name="T83" fmla="*/ 743 h 754"/>
                <a:gd name="T84" fmla="*/ 138 w 1017"/>
                <a:gd name="T85" fmla="*/ 739 h 754"/>
                <a:gd name="T86" fmla="*/ 0 w 1017"/>
                <a:gd name="T87" fmla="*/ 743 h 754"/>
                <a:gd name="T88" fmla="*/ 0 w 1017"/>
                <a:gd name="T89" fmla="*/ 709 h 754"/>
                <a:gd name="T90" fmla="*/ 79 w 1017"/>
                <a:gd name="T91" fmla="*/ 704 h 754"/>
                <a:gd name="T92" fmla="*/ 98 w 1017"/>
                <a:gd name="T93" fmla="*/ 691 h 754"/>
                <a:gd name="T94" fmla="*/ 107 w 1017"/>
                <a:gd name="T95" fmla="*/ 641 h 754"/>
                <a:gd name="T96" fmla="*/ 109 w 1017"/>
                <a:gd name="T97" fmla="*/ 492 h 754"/>
                <a:gd name="T98" fmla="*/ 109 w 1017"/>
                <a:gd name="T99" fmla="*/ 251 h 754"/>
                <a:gd name="T100" fmla="*/ 107 w 1017"/>
                <a:gd name="T101" fmla="*/ 112 h 754"/>
                <a:gd name="T102" fmla="*/ 99 w 1017"/>
                <a:gd name="T103" fmla="*/ 54 h 754"/>
                <a:gd name="T104" fmla="*/ 78 w 1017"/>
                <a:gd name="T105" fmla="*/ 40 h 754"/>
                <a:gd name="T106" fmla="*/ 0 w 1017"/>
                <a:gd name="T107" fmla="*/ 35 h 75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Lst>
              <a:rect l="0" t="0" r="r" b="b"/>
              <a:pathLst>
                <a:path w="1017" h="754">
                  <a:moveTo>
                    <a:pt x="0" y="35"/>
                  </a:moveTo>
                  <a:cubicBezTo>
                    <a:pt x="0" y="0"/>
                    <a:pt x="0" y="0"/>
                    <a:pt x="0" y="0"/>
                  </a:cubicBezTo>
                  <a:cubicBezTo>
                    <a:pt x="38" y="2"/>
                    <a:pt x="75" y="4"/>
                    <a:pt x="110" y="4"/>
                  </a:cubicBezTo>
                  <a:cubicBezTo>
                    <a:pt x="145" y="4"/>
                    <a:pt x="179" y="2"/>
                    <a:pt x="212" y="0"/>
                  </a:cubicBezTo>
                  <a:cubicBezTo>
                    <a:pt x="244" y="70"/>
                    <a:pt x="274" y="131"/>
                    <a:pt x="300" y="183"/>
                  </a:cubicBezTo>
                  <a:cubicBezTo>
                    <a:pt x="509" y="592"/>
                    <a:pt x="509" y="592"/>
                    <a:pt x="509" y="592"/>
                  </a:cubicBezTo>
                  <a:cubicBezTo>
                    <a:pt x="697" y="218"/>
                    <a:pt x="697" y="218"/>
                    <a:pt x="697" y="218"/>
                  </a:cubicBezTo>
                  <a:cubicBezTo>
                    <a:pt x="749" y="116"/>
                    <a:pt x="783" y="43"/>
                    <a:pt x="800" y="0"/>
                  </a:cubicBezTo>
                  <a:cubicBezTo>
                    <a:pt x="839" y="2"/>
                    <a:pt x="872" y="4"/>
                    <a:pt x="898" y="4"/>
                  </a:cubicBezTo>
                  <a:cubicBezTo>
                    <a:pt x="923" y="4"/>
                    <a:pt x="962" y="2"/>
                    <a:pt x="1017" y="0"/>
                  </a:cubicBezTo>
                  <a:cubicBezTo>
                    <a:pt x="1017" y="35"/>
                    <a:pt x="1017" y="35"/>
                    <a:pt x="1017" y="35"/>
                  </a:cubicBezTo>
                  <a:cubicBezTo>
                    <a:pt x="974" y="35"/>
                    <a:pt x="947" y="37"/>
                    <a:pt x="938" y="40"/>
                  </a:cubicBezTo>
                  <a:cubicBezTo>
                    <a:pt x="928" y="43"/>
                    <a:pt x="922" y="47"/>
                    <a:pt x="918" y="53"/>
                  </a:cubicBezTo>
                  <a:cubicBezTo>
                    <a:pt x="914" y="60"/>
                    <a:pt x="911" y="76"/>
                    <a:pt x="910" y="103"/>
                  </a:cubicBezTo>
                  <a:cubicBezTo>
                    <a:pt x="910" y="110"/>
                    <a:pt x="909" y="159"/>
                    <a:pt x="907" y="251"/>
                  </a:cubicBezTo>
                  <a:cubicBezTo>
                    <a:pt x="907" y="492"/>
                    <a:pt x="907" y="492"/>
                    <a:pt x="907" y="492"/>
                  </a:cubicBezTo>
                  <a:cubicBezTo>
                    <a:pt x="907" y="540"/>
                    <a:pt x="908" y="586"/>
                    <a:pt x="910" y="631"/>
                  </a:cubicBezTo>
                  <a:cubicBezTo>
                    <a:pt x="911" y="664"/>
                    <a:pt x="914" y="684"/>
                    <a:pt x="918" y="690"/>
                  </a:cubicBezTo>
                  <a:cubicBezTo>
                    <a:pt x="922" y="696"/>
                    <a:pt x="929" y="701"/>
                    <a:pt x="938" y="704"/>
                  </a:cubicBezTo>
                  <a:cubicBezTo>
                    <a:pt x="948" y="707"/>
                    <a:pt x="974" y="709"/>
                    <a:pt x="1017" y="709"/>
                  </a:cubicBezTo>
                  <a:cubicBezTo>
                    <a:pt x="1017" y="743"/>
                    <a:pt x="1017" y="743"/>
                    <a:pt x="1017" y="743"/>
                  </a:cubicBezTo>
                  <a:cubicBezTo>
                    <a:pt x="943" y="740"/>
                    <a:pt x="891" y="739"/>
                    <a:pt x="861" y="739"/>
                  </a:cubicBezTo>
                  <a:cubicBezTo>
                    <a:pt x="837" y="739"/>
                    <a:pt x="782" y="740"/>
                    <a:pt x="699" y="743"/>
                  </a:cubicBezTo>
                  <a:cubicBezTo>
                    <a:pt x="699" y="709"/>
                    <a:pt x="699" y="709"/>
                    <a:pt x="699" y="709"/>
                  </a:cubicBezTo>
                  <a:cubicBezTo>
                    <a:pt x="742" y="709"/>
                    <a:pt x="768" y="707"/>
                    <a:pt x="778" y="704"/>
                  </a:cubicBezTo>
                  <a:cubicBezTo>
                    <a:pt x="788" y="701"/>
                    <a:pt x="794" y="697"/>
                    <a:pt x="797" y="691"/>
                  </a:cubicBezTo>
                  <a:cubicBezTo>
                    <a:pt x="802" y="684"/>
                    <a:pt x="805" y="668"/>
                    <a:pt x="806" y="641"/>
                  </a:cubicBezTo>
                  <a:cubicBezTo>
                    <a:pt x="806" y="633"/>
                    <a:pt x="807" y="584"/>
                    <a:pt x="808" y="492"/>
                  </a:cubicBezTo>
                  <a:cubicBezTo>
                    <a:pt x="808" y="108"/>
                    <a:pt x="808" y="108"/>
                    <a:pt x="808" y="108"/>
                  </a:cubicBezTo>
                  <a:cubicBezTo>
                    <a:pt x="619" y="486"/>
                    <a:pt x="619" y="486"/>
                    <a:pt x="619" y="486"/>
                  </a:cubicBezTo>
                  <a:cubicBezTo>
                    <a:pt x="589" y="545"/>
                    <a:pt x="566" y="593"/>
                    <a:pt x="549" y="629"/>
                  </a:cubicBezTo>
                  <a:cubicBezTo>
                    <a:pt x="537" y="655"/>
                    <a:pt x="518" y="696"/>
                    <a:pt x="494" y="754"/>
                  </a:cubicBezTo>
                  <a:cubicBezTo>
                    <a:pt x="472" y="754"/>
                    <a:pt x="472" y="754"/>
                    <a:pt x="472" y="754"/>
                  </a:cubicBezTo>
                  <a:cubicBezTo>
                    <a:pt x="468" y="740"/>
                    <a:pt x="463" y="729"/>
                    <a:pt x="459" y="722"/>
                  </a:cubicBezTo>
                  <a:cubicBezTo>
                    <a:pt x="422" y="645"/>
                    <a:pt x="422" y="645"/>
                    <a:pt x="422" y="645"/>
                  </a:cubicBezTo>
                  <a:cubicBezTo>
                    <a:pt x="159" y="126"/>
                    <a:pt x="159" y="126"/>
                    <a:pt x="159" y="126"/>
                  </a:cubicBezTo>
                  <a:cubicBezTo>
                    <a:pt x="159" y="492"/>
                    <a:pt x="159" y="492"/>
                    <a:pt x="159" y="492"/>
                  </a:cubicBezTo>
                  <a:cubicBezTo>
                    <a:pt x="159" y="540"/>
                    <a:pt x="160" y="586"/>
                    <a:pt x="163" y="631"/>
                  </a:cubicBezTo>
                  <a:cubicBezTo>
                    <a:pt x="164" y="664"/>
                    <a:pt x="167" y="683"/>
                    <a:pt x="171" y="690"/>
                  </a:cubicBezTo>
                  <a:cubicBezTo>
                    <a:pt x="175" y="696"/>
                    <a:pt x="182" y="701"/>
                    <a:pt x="191" y="704"/>
                  </a:cubicBezTo>
                  <a:cubicBezTo>
                    <a:pt x="200" y="707"/>
                    <a:pt x="227" y="709"/>
                    <a:pt x="271" y="709"/>
                  </a:cubicBezTo>
                  <a:cubicBezTo>
                    <a:pt x="271" y="743"/>
                    <a:pt x="271" y="743"/>
                    <a:pt x="271" y="743"/>
                  </a:cubicBezTo>
                  <a:cubicBezTo>
                    <a:pt x="138" y="739"/>
                    <a:pt x="138" y="739"/>
                    <a:pt x="138" y="739"/>
                  </a:cubicBezTo>
                  <a:cubicBezTo>
                    <a:pt x="0" y="743"/>
                    <a:pt x="0" y="743"/>
                    <a:pt x="0" y="743"/>
                  </a:cubicBezTo>
                  <a:cubicBezTo>
                    <a:pt x="0" y="709"/>
                    <a:pt x="0" y="709"/>
                    <a:pt x="0" y="709"/>
                  </a:cubicBezTo>
                  <a:cubicBezTo>
                    <a:pt x="43" y="709"/>
                    <a:pt x="69" y="707"/>
                    <a:pt x="79" y="704"/>
                  </a:cubicBezTo>
                  <a:cubicBezTo>
                    <a:pt x="88" y="701"/>
                    <a:pt x="95" y="697"/>
                    <a:pt x="98" y="691"/>
                  </a:cubicBezTo>
                  <a:cubicBezTo>
                    <a:pt x="103" y="684"/>
                    <a:pt x="105" y="668"/>
                    <a:pt x="107" y="641"/>
                  </a:cubicBezTo>
                  <a:cubicBezTo>
                    <a:pt x="107" y="634"/>
                    <a:pt x="108" y="584"/>
                    <a:pt x="109" y="492"/>
                  </a:cubicBezTo>
                  <a:cubicBezTo>
                    <a:pt x="109" y="251"/>
                    <a:pt x="109" y="251"/>
                    <a:pt x="109" y="251"/>
                  </a:cubicBezTo>
                  <a:cubicBezTo>
                    <a:pt x="109" y="204"/>
                    <a:pt x="108" y="158"/>
                    <a:pt x="107" y="112"/>
                  </a:cubicBezTo>
                  <a:cubicBezTo>
                    <a:pt x="105" y="79"/>
                    <a:pt x="103" y="60"/>
                    <a:pt x="99" y="54"/>
                  </a:cubicBezTo>
                  <a:cubicBezTo>
                    <a:pt x="94" y="48"/>
                    <a:pt x="88" y="43"/>
                    <a:pt x="78" y="40"/>
                  </a:cubicBezTo>
                  <a:cubicBezTo>
                    <a:pt x="69" y="37"/>
                    <a:pt x="43" y="35"/>
                    <a:pt x="0" y="35"/>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9" name="Freeform 13"/>
            <p:cNvSpPr>
              <a:spLocks noEditPoints="1"/>
            </p:cNvSpPr>
            <p:nvPr userDrawn="1"/>
          </p:nvSpPr>
          <p:spPr bwMode="auto">
            <a:xfrm>
              <a:off x="1092200" y="684213"/>
              <a:ext cx="263525" cy="238125"/>
            </a:xfrm>
            <a:custGeom>
              <a:avLst/>
              <a:gdLst>
                <a:gd name="T0" fmla="*/ 117 w 832"/>
                <a:gd name="T1" fmla="*/ 747 h 750"/>
                <a:gd name="T2" fmla="*/ 257 w 832"/>
                <a:gd name="T3" fmla="*/ 750 h 750"/>
                <a:gd name="T4" fmla="*/ 257 w 832"/>
                <a:gd name="T5" fmla="*/ 717 h 750"/>
                <a:gd name="T6" fmla="*/ 185 w 832"/>
                <a:gd name="T7" fmla="*/ 712 h 750"/>
                <a:gd name="T8" fmla="*/ 166 w 832"/>
                <a:gd name="T9" fmla="*/ 702 h 750"/>
                <a:gd name="T10" fmla="*/ 162 w 832"/>
                <a:gd name="T11" fmla="*/ 690 h 750"/>
                <a:gd name="T12" fmla="*/ 178 w 832"/>
                <a:gd name="T13" fmla="*/ 637 h 750"/>
                <a:gd name="T14" fmla="*/ 237 w 832"/>
                <a:gd name="T15" fmla="*/ 503 h 750"/>
                <a:gd name="T16" fmla="*/ 556 w 832"/>
                <a:gd name="T17" fmla="*/ 503 h 750"/>
                <a:gd name="T18" fmla="*/ 624 w 832"/>
                <a:gd name="T19" fmla="*/ 663 h 750"/>
                <a:gd name="T20" fmla="*/ 632 w 832"/>
                <a:gd name="T21" fmla="*/ 693 h 750"/>
                <a:gd name="T22" fmla="*/ 627 w 832"/>
                <a:gd name="T23" fmla="*/ 705 h 750"/>
                <a:gd name="T24" fmla="*/ 609 w 832"/>
                <a:gd name="T25" fmla="*/ 713 h 750"/>
                <a:gd name="T26" fmla="*/ 535 w 832"/>
                <a:gd name="T27" fmla="*/ 717 h 750"/>
                <a:gd name="T28" fmla="*/ 535 w 832"/>
                <a:gd name="T29" fmla="*/ 750 h 750"/>
                <a:gd name="T30" fmla="*/ 712 w 832"/>
                <a:gd name="T31" fmla="*/ 747 h 750"/>
                <a:gd name="T32" fmla="*/ 832 w 832"/>
                <a:gd name="T33" fmla="*/ 750 h 750"/>
                <a:gd name="T34" fmla="*/ 832 w 832"/>
                <a:gd name="T35" fmla="*/ 717 h 750"/>
                <a:gd name="T36" fmla="*/ 776 w 832"/>
                <a:gd name="T37" fmla="*/ 710 h 750"/>
                <a:gd name="T38" fmla="*/ 753 w 832"/>
                <a:gd name="T39" fmla="*/ 687 h 750"/>
                <a:gd name="T40" fmla="*/ 677 w 832"/>
                <a:gd name="T41" fmla="*/ 526 h 750"/>
                <a:gd name="T42" fmla="*/ 441 w 832"/>
                <a:gd name="T43" fmla="*/ 0 h 750"/>
                <a:gd name="T44" fmla="*/ 406 w 832"/>
                <a:gd name="T45" fmla="*/ 0 h 750"/>
                <a:gd name="T46" fmla="*/ 310 w 832"/>
                <a:gd name="T47" fmla="*/ 217 h 750"/>
                <a:gd name="T48" fmla="*/ 172 w 832"/>
                <a:gd name="T49" fmla="*/ 512 h 750"/>
                <a:gd name="T50" fmla="*/ 100 w 832"/>
                <a:gd name="T51" fmla="*/ 660 h 750"/>
                <a:gd name="T52" fmla="*/ 74 w 832"/>
                <a:gd name="T53" fmla="*/ 702 h 750"/>
                <a:gd name="T54" fmla="*/ 54 w 832"/>
                <a:gd name="T55" fmla="*/ 713 h 750"/>
                <a:gd name="T56" fmla="*/ 0 w 832"/>
                <a:gd name="T57" fmla="*/ 717 h 750"/>
                <a:gd name="T58" fmla="*/ 0 w 832"/>
                <a:gd name="T59" fmla="*/ 750 h 750"/>
                <a:gd name="T60" fmla="*/ 117 w 832"/>
                <a:gd name="T61" fmla="*/ 747 h 750"/>
                <a:gd name="T62" fmla="*/ 396 w 832"/>
                <a:gd name="T63" fmla="*/ 143 h 750"/>
                <a:gd name="T64" fmla="*/ 534 w 832"/>
                <a:gd name="T65" fmla="*/ 458 h 750"/>
                <a:gd name="T66" fmla="*/ 256 w 832"/>
                <a:gd name="T67" fmla="*/ 458 h 750"/>
                <a:gd name="T68" fmla="*/ 396 w 832"/>
                <a:gd name="T69" fmla="*/ 143 h 75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Lst>
              <a:rect l="0" t="0" r="r" b="b"/>
              <a:pathLst>
                <a:path w="832" h="750">
                  <a:moveTo>
                    <a:pt x="117" y="747"/>
                  </a:moveTo>
                  <a:cubicBezTo>
                    <a:pt x="148" y="747"/>
                    <a:pt x="195" y="748"/>
                    <a:pt x="257" y="750"/>
                  </a:cubicBezTo>
                  <a:cubicBezTo>
                    <a:pt x="257" y="717"/>
                    <a:pt x="257" y="717"/>
                    <a:pt x="257" y="717"/>
                  </a:cubicBezTo>
                  <a:cubicBezTo>
                    <a:pt x="222" y="716"/>
                    <a:pt x="199" y="715"/>
                    <a:pt x="185" y="712"/>
                  </a:cubicBezTo>
                  <a:cubicBezTo>
                    <a:pt x="177" y="710"/>
                    <a:pt x="170" y="707"/>
                    <a:pt x="166" y="702"/>
                  </a:cubicBezTo>
                  <a:cubicBezTo>
                    <a:pt x="163" y="699"/>
                    <a:pt x="162" y="695"/>
                    <a:pt x="162" y="690"/>
                  </a:cubicBezTo>
                  <a:cubicBezTo>
                    <a:pt x="162" y="679"/>
                    <a:pt x="167" y="662"/>
                    <a:pt x="178" y="637"/>
                  </a:cubicBezTo>
                  <a:cubicBezTo>
                    <a:pt x="237" y="503"/>
                    <a:pt x="237" y="503"/>
                    <a:pt x="237" y="503"/>
                  </a:cubicBezTo>
                  <a:cubicBezTo>
                    <a:pt x="556" y="503"/>
                    <a:pt x="556" y="503"/>
                    <a:pt x="556" y="503"/>
                  </a:cubicBezTo>
                  <a:cubicBezTo>
                    <a:pt x="624" y="663"/>
                    <a:pt x="624" y="663"/>
                    <a:pt x="624" y="663"/>
                  </a:cubicBezTo>
                  <a:cubicBezTo>
                    <a:pt x="629" y="675"/>
                    <a:pt x="632" y="685"/>
                    <a:pt x="632" y="693"/>
                  </a:cubicBezTo>
                  <a:cubicBezTo>
                    <a:pt x="632" y="698"/>
                    <a:pt x="630" y="702"/>
                    <a:pt x="627" y="705"/>
                  </a:cubicBezTo>
                  <a:cubicBezTo>
                    <a:pt x="624" y="708"/>
                    <a:pt x="618" y="711"/>
                    <a:pt x="609" y="713"/>
                  </a:cubicBezTo>
                  <a:cubicBezTo>
                    <a:pt x="601" y="715"/>
                    <a:pt x="576" y="716"/>
                    <a:pt x="535" y="717"/>
                  </a:cubicBezTo>
                  <a:cubicBezTo>
                    <a:pt x="535" y="750"/>
                    <a:pt x="535" y="750"/>
                    <a:pt x="535" y="750"/>
                  </a:cubicBezTo>
                  <a:cubicBezTo>
                    <a:pt x="712" y="747"/>
                    <a:pt x="712" y="747"/>
                    <a:pt x="712" y="747"/>
                  </a:cubicBezTo>
                  <a:cubicBezTo>
                    <a:pt x="734" y="747"/>
                    <a:pt x="775" y="748"/>
                    <a:pt x="832" y="750"/>
                  </a:cubicBezTo>
                  <a:cubicBezTo>
                    <a:pt x="832" y="717"/>
                    <a:pt x="832" y="717"/>
                    <a:pt x="832" y="717"/>
                  </a:cubicBezTo>
                  <a:cubicBezTo>
                    <a:pt x="803" y="716"/>
                    <a:pt x="784" y="714"/>
                    <a:pt x="776" y="710"/>
                  </a:cubicBezTo>
                  <a:cubicBezTo>
                    <a:pt x="767" y="707"/>
                    <a:pt x="760" y="699"/>
                    <a:pt x="753" y="687"/>
                  </a:cubicBezTo>
                  <a:cubicBezTo>
                    <a:pt x="740" y="664"/>
                    <a:pt x="715" y="611"/>
                    <a:pt x="677" y="526"/>
                  </a:cubicBezTo>
                  <a:cubicBezTo>
                    <a:pt x="441" y="0"/>
                    <a:pt x="441" y="0"/>
                    <a:pt x="441" y="0"/>
                  </a:cubicBezTo>
                  <a:cubicBezTo>
                    <a:pt x="406" y="0"/>
                    <a:pt x="406" y="0"/>
                    <a:pt x="406" y="0"/>
                  </a:cubicBezTo>
                  <a:cubicBezTo>
                    <a:pt x="357" y="112"/>
                    <a:pt x="325" y="185"/>
                    <a:pt x="310" y="217"/>
                  </a:cubicBezTo>
                  <a:cubicBezTo>
                    <a:pt x="172" y="512"/>
                    <a:pt x="172" y="512"/>
                    <a:pt x="172" y="512"/>
                  </a:cubicBezTo>
                  <a:cubicBezTo>
                    <a:pt x="131" y="598"/>
                    <a:pt x="107" y="647"/>
                    <a:pt x="100" y="660"/>
                  </a:cubicBezTo>
                  <a:cubicBezTo>
                    <a:pt x="89" y="683"/>
                    <a:pt x="80" y="697"/>
                    <a:pt x="74" y="702"/>
                  </a:cubicBezTo>
                  <a:cubicBezTo>
                    <a:pt x="68" y="708"/>
                    <a:pt x="61" y="711"/>
                    <a:pt x="54" y="713"/>
                  </a:cubicBezTo>
                  <a:cubicBezTo>
                    <a:pt x="47" y="715"/>
                    <a:pt x="29" y="716"/>
                    <a:pt x="0" y="717"/>
                  </a:cubicBezTo>
                  <a:cubicBezTo>
                    <a:pt x="0" y="750"/>
                    <a:pt x="0" y="750"/>
                    <a:pt x="0" y="750"/>
                  </a:cubicBezTo>
                  <a:cubicBezTo>
                    <a:pt x="42" y="748"/>
                    <a:pt x="81" y="747"/>
                    <a:pt x="117" y="747"/>
                  </a:cubicBezTo>
                  <a:close/>
                  <a:moveTo>
                    <a:pt x="396" y="143"/>
                  </a:moveTo>
                  <a:cubicBezTo>
                    <a:pt x="534" y="458"/>
                    <a:pt x="534" y="458"/>
                    <a:pt x="534" y="458"/>
                  </a:cubicBezTo>
                  <a:cubicBezTo>
                    <a:pt x="256" y="458"/>
                    <a:pt x="256" y="458"/>
                    <a:pt x="256" y="458"/>
                  </a:cubicBezTo>
                  <a:lnTo>
                    <a:pt x="396" y="143"/>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0" name="Freeform 14"/>
            <p:cNvSpPr>
              <a:spLocks/>
            </p:cNvSpPr>
            <p:nvPr userDrawn="1"/>
          </p:nvSpPr>
          <p:spPr bwMode="auto">
            <a:xfrm>
              <a:off x="1309688" y="687388"/>
              <a:ext cx="260350" cy="234950"/>
            </a:xfrm>
            <a:custGeom>
              <a:avLst/>
              <a:gdLst>
                <a:gd name="T0" fmla="*/ 601 w 817"/>
                <a:gd name="T1" fmla="*/ 111 h 743"/>
                <a:gd name="T2" fmla="*/ 634 w 817"/>
                <a:gd name="T3" fmla="*/ 52 h 743"/>
                <a:gd name="T4" fmla="*/ 624 w 817"/>
                <a:gd name="T5" fmla="*/ 39 h 743"/>
                <a:gd name="T6" fmla="*/ 543 w 817"/>
                <a:gd name="T7" fmla="*/ 33 h 743"/>
                <a:gd name="T8" fmla="*/ 543 w 817"/>
                <a:gd name="T9" fmla="*/ 0 h 743"/>
                <a:gd name="T10" fmla="*/ 688 w 817"/>
                <a:gd name="T11" fmla="*/ 3 h 743"/>
                <a:gd name="T12" fmla="*/ 817 w 817"/>
                <a:gd name="T13" fmla="*/ 0 h 743"/>
                <a:gd name="T14" fmla="*/ 817 w 817"/>
                <a:gd name="T15" fmla="*/ 33 h 743"/>
                <a:gd name="T16" fmla="*/ 746 w 817"/>
                <a:gd name="T17" fmla="*/ 39 h 743"/>
                <a:gd name="T18" fmla="*/ 718 w 817"/>
                <a:gd name="T19" fmla="*/ 51 h 743"/>
                <a:gd name="T20" fmla="*/ 675 w 817"/>
                <a:gd name="T21" fmla="*/ 102 h 743"/>
                <a:gd name="T22" fmla="*/ 514 w 817"/>
                <a:gd name="T23" fmla="*/ 333 h 743"/>
                <a:gd name="T24" fmla="*/ 461 w 817"/>
                <a:gd name="T25" fmla="*/ 422 h 743"/>
                <a:gd name="T26" fmla="*/ 455 w 817"/>
                <a:gd name="T27" fmla="*/ 453 h 743"/>
                <a:gd name="T28" fmla="*/ 455 w 817"/>
                <a:gd name="T29" fmla="*/ 493 h 743"/>
                <a:gd name="T30" fmla="*/ 459 w 817"/>
                <a:gd name="T31" fmla="*/ 631 h 743"/>
                <a:gd name="T32" fmla="*/ 466 w 817"/>
                <a:gd name="T33" fmla="*/ 690 h 743"/>
                <a:gd name="T34" fmla="*/ 486 w 817"/>
                <a:gd name="T35" fmla="*/ 704 h 743"/>
                <a:gd name="T36" fmla="*/ 564 w 817"/>
                <a:gd name="T37" fmla="*/ 710 h 743"/>
                <a:gd name="T38" fmla="*/ 564 w 817"/>
                <a:gd name="T39" fmla="*/ 743 h 743"/>
                <a:gd name="T40" fmla="*/ 410 w 817"/>
                <a:gd name="T41" fmla="*/ 740 h 743"/>
                <a:gd name="T42" fmla="*/ 244 w 817"/>
                <a:gd name="T43" fmla="*/ 743 h 743"/>
                <a:gd name="T44" fmla="*/ 244 w 817"/>
                <a:gd name="T45" fmla="*/ 710 h 743"/>
                <a:gd name="T46" fmla="*/ 322 w 817"/>
                <a:gd name="T47" fmla="*/ 704 h 743"/>
                <a:gd name="T48" fmla="*/ 341 w 817"/>
                <a:gd name="T49" fmla="*/ 692 h 743"/>
                <a:gd name="T50" fmla="*/ 350 w 817"/>
                <a:gd name="T51" fmla="*/ 641 h 743"/>
                <a:gd name="T52" fmla="*/ 353 w 817"/>
                <a:gd name="T53" fmla="*/ 493 h 743"/>
                <a:gd name="T54" fmla="*/ 353 w 817"/>
                <a:gd name="T55" fmla="*/ 432 h 743"/>
                <a:gd name="T56" fmla="*/ 331 w 817"/>
                <a:gd name="T57" fmla="*/ 390 h 743"/>
                <a:gd name="T58" fmla="*/ 275 w 817"/>
                <a:gd name="T59" fmla="*/ 300 h 743"/>
                <a:gd name="T60" fmla="*/ 135 w 817"/>
                <a:gd name="T61" fmla="*/ 102 h 743"/>
                <a:gd name="T62" fmla="*/ 96 w 817"/>
                <a:gd name="T63" fmla="*/ 51 h 743"/>
                <a:gd name="T64" fmla="*/ 69 w 817"/>
                <a:gd name="T65" fmla="*/ 39 h 743"/>
                <a:gd name="T66" fmla="*/ 0 w 817"/>
                <a:gd name="T67" fmla="*/ 33 h 743"/>
                <a:gd name="T68" fmla="*/ 0 w 817"/>
                <a:gd name="T69" fmla="*/ 0 h 743"/>
                <a:gd name="T70" fmla="*/ 130 w 817"/>
                <a:gd name="T71" fmla="*/ 3 h 743"/>
                <a:gd name="T72" fmla="*/ 333 w 817"/>
                <a:gd name="T73" fmla="*/ 0 h 743"/>
                <a:gd name="T74" fmla="*/ 333 w 817"/>
                <a:gd name="T75" fmla="*/ 33 h 743"/>
                <a:gd name="T76" fmla="*/ 246 w 817"/>
                <a:gd name="T77" fmla="*/ 39 h 743"/>
                <a:gd name="T78" fmla="*/ 234 w 817"/>
                <a:gd name="T79" fmla="*/ 52 h 743"/>
                <a:gd name="T80" fmla="*/ 262 w 817"/>
                <a:gd name="T81" fmla="*/ 111 h 743"/>
                <a:gd name="T82" fmla="*/ 426 w 817"/>
                <a:gd name="T83" fmla="*/ 376 h 743"/>
                <a:gd name="T84" fmla="*/ 601 w 817"/>
                <a:gd name="T85" fmla="*/ 111 h 74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Lst>
              <a:rect l="0" t="0" r="r" b="b"/>
              <a:pathLst>
                <a:path w="817" h="743">
                  <a:moveTo>
                    <a:pt x="601" y="111"/>
                  </a:moveTo>
                  <a:cubicBezTo>
                    <a:pt x="623" y="78"/>
                    <a:pt x="634" y="59"/>
                    <a:pt x="634" y="52"/>
                  </a:cubicBezTo>
                  <a:cubicBezTo>
                    <a:pt x="634" y="46"/>
                    <a:pt x="631" y="41"/>
                    <a:pt x="624" y="39"/>
                  </a:cubicBezTo>
                  <a:cubicBezTo>
                    <a:pt x="616" y="36"/>
                    <a:pt x="585" y="34"/>
                    <a:pt x="543" y="33"/>
                  </a:cubicBezTo>
                  <a:cubicBezTo>
                    <a:pt x="543" y="0"/>
                    <a:pt x="543" y="0"/>
                    <a:pt x="543" y="0"/>
                  </a:cubicBezTo>
                  <a:cubicBezTo>
                    <a:pt x="610" y="2"/>
                    <a:pt x="650" y="3"/>
                    <a:pt x="688" y="3"/>
                  </a:cubicBezTo>
                  <a:cubicBezTo>
                    <a:pt x="725" y="3"/>
                    <a:pt x="745" y="2"/>
                    <a:pt x="817" y="0"/>
                  </a:cubicBezTo>
                  <a:cubicBezTo>
                    <a:pt x="817" y="33"/>
                    <a:pt x="817" y="33"/>
                    <a:pt x="817" y="33"/>
                  </a:cubicBezTo>
                  <a:cubicBezTo>
                    <a:pt x="773" y="34"/>
                    <a:pt x="757" y="36"/>
                    <a:pt x="746" y="39"/>
                  </a:cubicBezTo>
                  <a:cubicBezTo>
                    <a:pt x="735" y="41"/>
                    <a:pt x="725" y="46"/>
                    <a:pt x="718" y="51"/>
                  </a:cubicBezTo>
                  <a:cubicBezTo>
                    <a:pt x="709" y="58"/>
                    <a:pt x="695" y="75"/>
                    <a:pt x="675" y="102"/>
                  </a:cubicBezTo>
                  <a:cubicBezTo>
                    <a:pt x="514" y="333"/>
                    <a:pt x="514" y="333"/>
                    <a:pt x="514" y="333"/>
                  </a:cubicBezTo>
                  <a:cubicBezTo>
                    <a:pt x="483" y="381"/>
                    <a:pt x="465" y="411"/>
                    <a:pt x="461" y="422"/>
                  </a:cubicBezTo>
                  <a:cubicBezTo>
                    <a:pt x="457" y="433"/>
                    <a:pt x="455" y="443"/>
                    <a:pt x="455" y="453"/>
                  </a:cubicBezTo>
                  <a:cubicBezTo>
                    <a:pt x="455" y="493"/>
                    <a:pt x="455" y="493"/>
                    <a:pt x="455" y="493"/>
                  </a:cubicBezTo>
                  <a:cubicBezTo>
                    <a:pt x="455" y="541"/>
                    <a:pt x="456" y="587"/>
                    <a:pt x="459" y="631"/>
                  </a:cubicBezTo>
                  <a:cubicBezTo>
                    <a:pt x="460" y="665"/>
                    <a:pt x="462" y="684"/>
                    <a:pt x="466" y="690"/>
                  </a:cubicBezTo>
                  <a:cubicBezTo>
                    <a:pt x="470" y="696"/>
                    <a:pt x="477" y="701"/>
                    <a:pt x="486" y="704"/>
                  </a:cubicBezTo>
                  <a:cubicBezTo>
                    <a:pt x="495" y="707"/>
                    <a:pt x="521" y="709"/>
                    <a:pt x="564" y="710"/>
                  </a:cubicBezTo>
                  <a:cubicBezTo>
                    <a:pt x="564" y="743"/>
                    <a:pt x="564" y="743"/>
                    <a:pt x="564" y="743"/>
                  </a:cubicBezTo>
                  <a:cubicBezTo>
                    <a:pt x="505" y="741"/>
                    <a:pt x="453" y="740"/>
                    <a:pt x="410" y="740"/>
                  </a:cubicBezTo>
                  <a:cubicBezTo>
                    <a:pt x="368" y="740"/>
                    <a:pt x="313" y="741"/>
                    <a:pt x="244" y="743"/>
                  </a:cubicBezTo>
                  <a:cubicBezTo>
                    <a:pt x="244" y="710"/>
                    <a:pt x="244" y="710"/>
                    <a:pt x="244" y="710"/>
                  </a:cubicBezTo>
                  <a:cubicBezTo>
                    <a:pt x="287" y="709"/>
                    <a:pt x="313" y="707"/>
                    <a:pt x="322" y="704"/>
                  </a:cubicBezTo>
                  <a:cubicBezTo>
                    <a:pt x="332" y="701"/>
                    <a:pt x="338" y="697"/>
                    <a:pt x="341" y="692"/>
                  </a:cubicBezTo>
                  <a:cubicBezTo>
                    <a:pt x="346" y="685"/>
                    <a:pt x="349" y="668"/>
                    <a:pt x="350" y="641"/>
                  </a:cubicBezTo>
                  <a:cubicBezTo>
                    <a:pt x="350" y="634"/>
                    <a:pt x="351" y="585"/>
                    <a:pt x="353" y="493"/>
                  </a:cubicBezTo>
                  <a:cubicBezTo>
                    <a:pt x="353" y="432"/>
                    <a:pt x="353" y="432"/>
                    <a:pt x="353" y="432"/>
                  </a:cubicBezTo>
                  <a:cubicBezTo>
                    <a:pt x="345" y="417"/>
                    <a:pt x="338" y="403"/>
                    <a:pt x="331" y="390"/>
                  </a:cubicBezTo>
                  <a:cubicBezTo>
                    <a:pt x="325" y="382"/>
                    <a:pt x="307" y="352"/>
                    <a:pt x="275" y="300"/>
                  </a:cubicBezTo>
                  <a:cubicBezTo>
                    <a:pt x="135" y="102"/>
                    <a:pt x="135" y="102"/>
                    <a:pt x="135" y="102"/>
                  </a:cubicBezTo>
                  <a:cubicBezTo>
                    <a:pt x="118" y="75"/>
                    <a:pt x="105" y="58"/>
                    <a:pt x="96" y="51"/>
                  </a:cubicBezTo>
                  <a:cubicBezTo>
                    <a:pt x="89" y="46"/>
                    <a:pt x="80" y="41"/>
                    <a:pt x="69" y="39"/>
                  </a:cubicBezTo>
                  <a:cubicBezTo>
                    <a:pt x="58" y="36"/>
                    <a:pt x="44" y="34"/>
                    <a:pt x="0" y="33"/>
                  </a:cubicBezTo>
                  <a:cubicBezTo>
                    <a:pt x="0" y="0"/>
                    <a:pt x="0" y="0"/>
                    <a:pt x="0" y="0"/>
                  </a:cubicBezTo>
                  <a:cubicBezTo>
                    <a:pt x="72" y="2"/>
                    <a:pt x="94" y="3"/>
                    <a:pt x="130" y="3"/>
                  </a:cubicBezTo>
                  <a:cubicBezTo>
                    <a:pt x="168" y="3"/>
                    <a:pt x="265" y="2"/>
                    <a:pt x="333" y="0"/>
                  </a:cubicBezTo>
                  <a:cubicBezTo>
                    <a:pt x="333" y="33"/>
                    <a:pt x="333" y="33"/>
                    <a:pt x="333" y="33"/>
                  </a:cubicBezTo>
                  <a:cubicBezTo>
                    <a:pt x="291" y="34"/>
                    <a:pt x="254" y="36"/>
                    <a:pt x="246" y="39"/>
                  </a:cubicBezTo>
                  <a:cubicBezTo>
                    <a:pt x="239" y="41"/>
                    <a:pt x="235" y="46"/>
                    <a:pt x="234" y="52"/>
                  </a:cubicBezTo>
                  <a:cubicBezTo>
                    <a:pt x="234" y="59"/>
                    <a:pt x="243" y="78"/>
                    <a:pt x="262" y="111"/>
                  </a:cubicBezTo>
                  <a:cubicBezTo>
                    <a:pt x="426" y="376"/>
                    <a:pt x="426" y="376"/>
                    <a:pt x="426" y="376"/>
                  </a:cubicBezTo>
                  <a:lnTo>
                    <a:pt x="601" y="111"/>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1" name="Freeform 15"/>
            <p:cNvSpPr>
              <a:spLocks noEditPoints="1"/>
            </p:cNvSpPr>
            <p:nvPr userDrawn="1"/>
          </p:nvSpPr>
          <p:spPr bwMode="auto">
            <a:xfrm>
              <a:off x="1558925" y="681038"/>
              <a:ext cx="263525" cy="246063"/>
            </a:xfrm>
            <a:custGeom>
              <a:avLst/>
              <a:gdLst>
                <a:gd name="T0" fmla="*/ 148 w 830"/>
                <a:gd name="T1" fmla="*/ 190 h 775"/>
                <a:gd name="T2" fmla="*/ 247 w 830"/>
                <a:gd name="T3" fmla="*/ 82 h 775"/>
                <a:gd name="T4" fmla="*/ 399 w 830"/>
                <a:gd name="T5" fmla="*/ 45 h 775"/>
                <a:gd name="T6" fmla="*/ 512 w 830"/>
                <a:gd name="T7" fmla="*/ 62 h 775"/>
                <a:gd name="T8" fmla="*/ 596 w 830"/>
                <a:gd name="T9" fmla="*/ 106 h 775"/>
                <a:gd name="T10" fmla="*/ 652 w 830"/>
                <a:gd name="T11" fmla="*/ 167 h 775"/>
                <a:gd name="T12" fmla="*/ 690 w 830"/>
                <a:gd name="T13" fmla="*/ 245 h 775"/>
                <a:gd name="T14" fmla="*/ 713 w 830"/>
                <a:gd name="T15" fmla="*/ 398 h 775"/>
                <a:gd name="T16" fmla="*/ 681 w 830"/>
                <a:gd name="T17" fmla="*/ 571 h 775"/>
                <a:gd name="T18" fmla="*/ 584 w 830"/>
                <a:gd name="T19" fmla="*/ 686 h 775"/>
                <a:gd name="T20" fmla="*/ 431 w 830"/>
                <a:gd name="T21" fmla="*/ 727 h 775"/>
                <a:gd name="T22" fmla="*/ 315 w 830"/>
                <a:gd name="T23" fmla="*/ 707 h 775"/>
                <a:gd name="T24" fmla="*/ 220 w 830"/>
                <a:gd name="T25" fmla="*/ 644 h 775"/>
                <a:gd name="T26" fmla="*/ 151 w 830"/>
                <a:gd name="T27" fmla="*/ 539 h 775"/>
                <a:gd name="T28" fmla="*/ 125 w 830"/>
                <a:gd name="T29" fmla="*/ 450 h 775"/>
                <a:gd name="T30" fmla="*/ 115 w 830"/>
                <a:gd name="T31" fmla="*/ 349 h 775"/>
                <a:gd name="T32" fmla="*/ 148 w 830"/>
                <a:gd name="T33" fmla="*/ 190 h 775"/>
                <a:gd name="T34" fmla="*/ 26 w 830"/>
                <a:gd name="T35" fmla="*/ 541 h 775"/>
                <a:gd name="T36" fmla="*/ 105 w 830"/>
                <a:gd name="T37" fmla="*/ 669 h 775"/>
                <a:gd name="T38" fmla="*/ 231 w 830"/>
                <a:gd name="T39" fmla="*/ 748 h 775"/>
                <a:gd name="T40" fmla="*/ 392 w 830"/>
                <a:gd name="T41" fmla="*/ 775 h 775"/>
                <a:gd name="T42" fmla="*/ 706 w 830"/>
                <a:gd name="T43" fmla="*/ 657 h 775"/>
                <a:gd name="T44" fmla="*/ 830 w 830"/>
                <a:gd name="T45" fmla="*/ 364 h 775"/>
                <a:gd name="T46" fmla="*/ 817 w 830"/>
                <a:gd name="T47" fmla="*/ 261 h 775"/>
                <a:gd name="T48" fmla="*/ 784 w 830"/>
                <a:gd name="T49" fmla="*/ 177 h 775"/>
                <a:gd name="T50" fmla="*/ 709 w 830"/>
                <a:gd name="T51" fmla="*/ 89 h 775"/>
                <a:gd name="T52" fmla="*/ 588 w 830"/>
                <a:gd name="T53" fmla="*/ 25 h 775"/>
                <a:gd name="T54" fmla="*/ 423 w 830"/>
                <a:gd name="T55" fmla="*/ 0 h 775"/>
                <a:gd name="T56" fmla="*/ 249 w 830"/>
                <a:gd name="T57" fmla="*/ 29 h 775"/>
                <a:gd name="T58" fmla="*/ 112 w 830"/>
                <a:gd name="T59" fmla="*/ 113 h 775"/>
                <a:gd name="T60" fmla="*/ 26 w 830"/>
                <a:gd name="T61" fmla="*/ 239 h 775"/>
                <a:gd name="T62" fmla="*/ 0 w 830"/>
                <a:gd name="T63" fmla="*/ 393 h 775"/>
                <a:gd name="T64" fmla="*/ 26 w 830"/>
                <a:gd name="T65" fmla="*/ 541 h 77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Lst>
              <a:rect l="0" t="0" r="r" b="b"/>
              <a:pathLst>
                <a:path w="830" h="775">
                  <a:moveTo>
                    <a:pt x="148" y="190"/>
                  </a:moveTo>
                  <a:cubicBezTo>
                    <a:pt x="170" y="143"/>
                    <a:pt x="203" y="107"/>
                    <a:pt x="247" y="82"/>
                  </a:cubicBezTo>
                  <a:cubicBezTo>
                    <a:pt x="290" y="57"/>
                    <a:pt x="341" y="45"/>
                    <a:pt x="399" y="45"/>
                  </a:cubicBezTo>
                  <a:cubicBezTo>
                    <a:pt x="440" y="45"/>
                    <a:pt x="477" y="51"/>
                    <a:pt x="512" y="62"/>
                  </a:cubicBezTo>
                  <a:cubicBezTo>
                    <a:pt x="546" y="74"/>
                    <a:pt x="575" y="89"/>
                    <a:pt x="596" y="106"/>
                  </a:cubicBezTo>
                  <a:cubicBezTo>
                    <a:pt x="618" y="124"/>
                    <a:pt x="637" y="144"/>
                    <a:pt x="652" y="167"/>
                  </a:cubicBezTo>
                  <a:cubicBezTo>
                    <a:pt x="668" y="190"/>
                    <a:pt x="681" y="216"/>
                    <a:pt x="690" y="245"/>
                  </a:cubicBezTo>
                  <a:cubicBezTo>
                    <a:pt x="706" y="292"/>
                    <a:pt x="713" y="343"/>
                    <a:pt x="713" y="398"/>
                  </a:cubicBezTo>
                  <a:cubicBezTo>
                    <a:pt x="713" y="463"/>
                    <a:pt x="703" y="521"/>
                    <a:pt x="681" y="571"/>
                  </a:cubicBezTo>
                  <a:cubicBezTo>
                    <a:pt x="660" y="620"/>
                    <a:pt x="627" y="659"/>
                    <a:pt x="584" y="686"/>
                  </a:cubicBezTo>
                  <a:cubicBezTo>
                    <a:pt x="541" y="714"/>
                    <a:pt x="490" y="727"/>
                    <a:pt x="431" y="727"/>
                  </a:cubicBezTo>
                  <a:cubicBezTo>
                    <a:pt x="388" y="727"/>
                    <a:pt x="350" y="721"/>
                    <a:pt x="315" y="707"/>
                  </a:cubicBezTo>
                  <a:cubicBezTo>
                    <a:pt x="280" y="694"/>
                    <a:pt x="248" y="673"/>
                    <a:pt x="220" y="644"/>
                  </a:cubicBezTo>
                  <a:cubicBezTo>
                    <a:pt x="192" y="616"/>
                    <a:pt x="169" y="581"/>
                    <a:pt x="151" y="539"/>
                  </a:cubicBezTo>
                  <a:cubicBezTo>
                    <a:pt x="141" y="514"/>
                    <a:pt x="132" y="484"/>
                    <a:pt x="125" y="450"/>
                  </a:cubicBezTo>
                  <a:cubicBezTo>
                    <a:pt x="118" y="416"/>
                    <a:pt x="115" y="382"/>
                    <a:pt x="115" y="349"/>
                  </a:cubicBezTo>
                  <a:cubicBezTo>
                    <a:pt x="115" y="290"/>
                    <a:pt x="126" y="236"/>
                    <a:pt x="148" y="190"/>
                  </a:cubicBezTo>
                  <a:close/>
                  <a:moveTo>
                    <a:pt x="26" y="541"/>
                  </a:moveTo>
                  <a:cubicBezTo>
                    <a:pt x="44" y="591"/>
                    <a:pt x="70" y="634"/>
                    <a:pt x="105" y="669"/>
                  </a:cubicBezTo>
                  <a:cubicBezTo>
                    <a:pt x="139" y="704"/>
                    <a:pt x="181" y="730"/>
                    <a:pt x="231" y="748"/>
                  </a:cubicBezTo>
                  <a:cubicBezTo>
                    <a:pt x="281" y="765"/>
                    <a:pt x="335" y="775"/>
                    <a:pt x="392" y="775"/>
                  </a:cubicBezTo>
                  <a:cubicBezTo>
                    <a:pt x="518" y="775"/>
                    <a:pt x="623" y="736"/>
                    <a:pt x="706" y="657"/>
                  </a:cubicBezTo>
                  <a:cubicBezTo>
                    <a:pt x="788" y="579"/>
                    <a:pt x="830" y="481"/>
                    <a:pt x="830" y="364"/>
                  </a:cubicBezTo>
                  <a:cubicBezTo>
                    <a:pt x="830" y="327"/>
                    <a:pt x="826" y="293"/>
                    <a:pt x="817" y="261"/>
                  </a:cubicBezTo>
                  <a:cubicBezTo>
                    <a:pt x="809" y="228"/>
                    <a:pt x="798" y="200"/>
                    <a:pt x="784" y="177"/>
                  </a:cubicBezTo>
                  <a:cubicBezTo>
                    <a:pt x="766" y="145"/>
                    <a:pt x="741" y="116"/>
                    <a:pt x="709" y="89"/>
                  </a:cubicBezTo>
                  <a:cubicBezTo>
                    <a:pt x="678" y="62"/>
                    <a:pt x="637" y="41"/>
                    <a:pt x="588" y="25"/>
                  </a:cubicBezTo>
                  <a:cubicBezTo>
                    <a:pt x="538" y="8"/>
                    <a:pt x="484" y="0"/>
                    <a:pt x="423" y="0"/>
                  </a:cubicBezTo>
                  <a:cubicBezTo>
                    <a:pt x="358" y="0"/>
                    <a:pt x="300" y="10"/>
                    <a:pt x="249" y="29"/>
                  </a:cubicBezTo>
                  <a:cubicBezTo>
                    <a:pt x="198" y="48"/>
                    <a:pt x="152" y="76"/>
                    <a:pt x="112" y="113"/>
                  </a:cubicBezTo>
                  <a:cubicBezTo>
                    <a:pt x="72" y="151"/>
                    <a:pt x="43" y="193"/>
                    <a:pt x="26" y="239"/>
                  </a:cubicBezTo>
                  <a:cubicBezTo>
                    <a:pt x="8" y="286"/>
                    <a:pt x="0" y="337"/>
                    <a:pt x="0" y="393"/>
                  </a:cubicBezTo>
                  <a:cubicBezTo>
                    <a:pt x="0" y="441"/>
                    <a:pt x="9" y="491"/>
                    <a:pt x="26" y="541"/>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spTree>
    <p:extLst>
      <p:ext uri="{BB962C8B-B14F-4D97-AF65-F5344CB8AC3E}">
        <p14:creationId xmlns:p14="http://schemas.microsoft.com/office/powerpoint/2010/main" val="3031830298"/>
      </p:ext>
    </p:extLst>
  </p:cSld>
  <p:clrMapOvr>
    <a:masterClrMapping/>
  </p:clrMapOvr>
  <p:timing>
    <p:tnLst>
      <p:par>
        <p:cTn id="1" dur="indefinite" restart="never" nodeType="tmRoot"/>
      </p:par>
    </p:tnLst>
  </p:timing>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658368" y="1371600"/>
            <a:ext cx="3840480" cy="4800600"/>
          </a:xfrm>
        </p:spPr>
        <p:txBody>
          <a:bodyPr/>
          <a:lstStyle>
            <a:lvl1pPr>
              <a:defRPr sz="2400"/>
            </a:lvl1pPr>
            <a:lvl2pPr>
              <a:defRPr sz="2400"/>
            </a:lvl2pPr>
            <a:lvl3pPr>
              <a:defRPr sz="2400"/>
            </a:lvl3pPr>
            <a:lvl4pPr>
              <a:defRPr sz="2400"/>
            </a:lvl4pPr>
            <a:lvl5pPr>
              <a:defRPr sz="24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648200" y="1371600"/>
            <a:ext cx="3840480" cy="4800600"/>
          </a:xfrm>
        </p:spPr>
        <p:txBody>
          <a:bodyPr/>
          <a:lstStyle>
            <a:lvl1pPr>
              <a:defRPr sz="2400"/>
            </a:lvl1pPr>
            <a:lvl2pPr>
              <a:defRPr sz="2400"/>
            </a:lvl2pPr>
            <a:lvl3pPr>
              <a:defRPr sz="2400"/>
            </a:lvl3pPr>
            <a:lvl4pPr>
              <a:defRPr sz="2400"/>
            </a:lvl4pPr>
            <a:lvl5pPr>
              <a:defRPr sz="24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22E46A41-B371-4476-AE62-5156B5E8C721}" type="datetime1">
              <a:rPr lang="en-US" smtClean="0"/>
              <a:t>10/2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DC53FA5-AE81-45E0-8206-920AA27813B4}" type="slidenum">
              <a:rPr lang="en-US" smtClean="0"/>
              <a:t>‹#›</a:t>
            </a:fld>
            <a:endParaRPr lang="en-US"/>
          </a:p>
        </p:txBody>
      </p:sp>
      <p:grpSp>
        <p:nvGrpSpPr>
          <p:cNvPr id="21" name="Group 20"/>
          <p:cNvGrpSpPr/>
          <p:nvPr userDrawn="1"/>
        </p:nvGrpSpPr>
        <p:grpSpPr>
          <a:xfrm>
            <a:off x="120650" y="6299343"/>
            <a:ext cx="420688" cy="458645"/>
            <a:chOff x="657225" y="681038"/>
            <a:chExt cx="1266825" cy="1381125"/>
          </a:xfrm>
          <a:solidFill>
            <a:srgbClr val="FFFFFF"/>
          </a:solidFill>
        </p:grpSpPr>
        <p:sp>
          <p:nvSpPr>
            <p:cNvPr id="22" name="Freeform 5"/>
            <p:cNvSpPr>
              <a:spLocks noEditPoints="1"/>
            </p:cNvSpPr>
            <p:nvPr userDrawn="1"/>
          </p:nvSpPr>
          <p:spPr bwMode="auto">
            <a:xfrm>
              <a:off x="846138" y="1354138"/>
              <a:ext cx="887413" cy="708025"/>
            </a:xfrm>
            <a:custGeom>
              <a:avLst/>
              <a:gdLst>
                <a:gd name="T0" fmla="*/ 2203 w 2794"/>
                <a:gd name="T1" fmla="*/ 0 h 2229"/>
                <a:gd name="T2" fmla="*/ 1613 w 2794"/>
                <a:gd name="T3" fmla="*/ 0 h 2229"/>
                <a:gd name="T4" fmla="*/ 1613 w 2794"/>
                <a:gd name="T5" fmla="*/ 665 h 2229"/>
                <a:gd name="T6" fmla="*/ 1904 w 2794"/>
                <a:gd name="T7" fmla="*/ 1330 h 2229"/>
                <a:gd name="T8" fmla="*/ 1904 w 2794"/>
                <a:gd name="T9" fmla="*/ 1237 h 2229"/>
                <a:gd name="T10" fmla="*/ 1749 w 2794"/>
                <a:gd name="T11" fmla="*/ 747 h 2229"/>
                <a:gd name="T12" fmla="*/ 1749 w 2794"/>
                <a:gd name="T13" fmla="*/ 573 h 2229"/>
                <a:gd name="T14" fmla="*/ 1972 w 2794"/>
                <a:gd name="T15" fmla="*/ 573 h 2229"/>
                <a:gd name="T16" fmla="*/ 1972 w 2794"/>
                <a:gd name="T17" fmla="*/ 1332 h 2229"/>
                <a:gd name="T18" fmla="*/ 1401 w 2794"/>
                <a:gd name="T19" fmla="*/ 2182 h 2229"/>
                <a:gd name="T20" fmla="*/ 829 w 2794"/>
                <a:gd name="T21" fmla="*/ 1374 h 2229"/>
                <a:gd name="T22" fmla="*/ 1180 w 2794"/>
                <a:gd name="T23" fmla="*/ 665 h 2229"/>
                <a:gd name="T24" fmla="*/ 1180 w 2794"/>
                <a:gd name="T25" fmla="*/ 573 h 2229"/>
                <a:gd name="T26" fmla="*/ 1401 w 2794"/>
                <a:gd name="T27" fmla="*/ 573 h 2229"/>
                <a:gd name="T28" fmla="*/ 1542 w 2794"/>
                <a:gd name="T29" fmla="*/ 573 h 2229"/>
                <a:gd name="T30" fmla="*/ 1542 w 2794"/>
                <a:gd name="T31" fmla="*/ 436 h 2229"/>
                <a:gd name="T32" fmla="*/ 1401 w 2794"/>
                <a:gd name="T33" fmla="*/ 436 h 2229"/>
                <a:gd name="T34" fmla="*/ 1180 w 2794"/>
                <a:gd name="T35" fmla="*/ 436 h 2229"/>
                <a:gd name="T36" fmla="*/ 1180 w 2794"/>
                <a:gd name="T37" fmla="*/ 436 h 2229"/>
                <a:gd name="T38" fmla="*/ 1044 w 2794"/>
                <a:gd name="T39" fmla="*/ 436 h 2229"/>
                <a:gd name="T40" fmla="*/ 1044 w 2794"/>
                <a:gd name="T41" fmla="*/ 436 h 2229"/>
                <a:gd name="T42" fmla="*/ 692 w 2794"/>
                <a:gd name="T43" fmla="*/ 436 h 2229"/>
                <a:gd name="T44" fmla="*/ 692 w 2794"/>
                <a:gd name="T45" fmla="*/ 1234 h 2229"/>
                <a:gd name="T46" fmla="*/ 695 w 2794"/>
                <a:gd name="T47" fmla="*/ 1315 h 2229"/>
                <a:gd name="T48" fmla="*/ 695 w 2794"/>
                <a:gd name="T49" fmla="*/ 1315 h 2229"/>
                <a:gd name="T50" fmla="*/ 829 w 2794"/>
                <a:gd name="T51" fmla="*/ 1205 h 2229"/>
                <a:gd name="T52" fmla="*/ 829 w 2794"/>
                <a:gd name="T53" fmla="*/ 1205 h 2229"/>
                <a:gd name="T54" fmla="*/ 829 w 2794"/>
                <a:gd name="T55" fmla="*/ 573 h 2229"/>
                <a:gd name="T56" fmla="*/ 1044 w 2794"/>
                <a:gd name="T57" fmla="*/ 573 h 2229"/>
                <a:gd name="T58" fmla="*/ 1044 w 2794"/>
                <a:gd name="T59" fmla="*/ 573 h 2229"/>
                <a:gd name="T60" fmla="*/ 1044 w 2794"/>
                <a:gd name="T61" fmla="*/ 747 h 2229"/>
                <a:gd name="T62" fmla="*/ 590 w 2794"/>
                <a:gd name="T63" fmla="*/ 1447 h 2229"/>
                <a:gd name="T64" fmla="*/ 135 w 2794"/>
                <a:gd name="T65" fmla="*/ 747 h 2229"/>
                <a:gd name="T66" fmla="*/ 135 w 2794"/>
                <a:gd name="T67" fmla="*/ 136 h 2229"/>
                <a:gd name="T68" fmla="*/ 590 w 2794"/>
                <a:gd name="T69" fmla="*/ 136 h 2229"/>
                <a:gd name="T70" fmla="*/ 1044 w 2794"/>
                <a:gd name="T71" fmla="*/ 136 h 2229"/>
                <a:gd name="T72" fmla="*/ 1044 w 2794"/>
                <a:gd name="T73" fmla="*/ 370 h 2229"/>
                <a:gd name="T74" fmla="*/ 1180 w 2794"/>
                <a:gd name="T75" fmla="*/ 370 h 2229"/>
                <a:gd name="T76" fmla="*/ 1180 w 2794"/>
                <a:gd name="T77" fmla="*/ 0 h 2229"/>
                <a:gd name="T78" fmla="*/ 590 w 2794"/>
                <a:gd name="T79" fmla="*/ 0 h 2229"/>
                <a:gd name="T80" fmla="*/ 0 w 2794"/>
                <a:gd name="T81" fmla="*/ 0 h 2229"/>
                <a:gd name="T82" fmla="*/ 0 w 2794"/>
                <a:gd name="T83" fmla="*/ 665 h 2229"/>
                <a:gd name="T84" fmla="*/ 590 w 2794"/>
                <a:gd name="T85" fmla="*/ 1495 h 2229"/>
                <a:gd name="T86" fmla="*/ 708 w 2794"/>
                <a:gd name="T87" fmla="*/ 1444 h 2229"/>
                <a:gd name="T88" fmla="*/ 1401 w 2794"/>
                <a:gd name="T89" fmla="*/ 2229 h 2229"/>
                <a:gd name="T90" fmla="*/ 2093 w 2794"/>
                <a:gd name="T91" fmla="*/ 1447 h 2229"/>
                <a:gd name="T92" fmla="*/ 2203 w 2794"/>
                <a:gd name="T93" fmla="*/ 1495 h 2229"/>
                <a:gd name="T94" fmla="*/ 2794 w 2794"/>
                <a:gd name="T95" fmla="*/ 665 h 2229"/>
                <a:gd name="T96" fmla="*/ 2794 w 2794"/>
                <a:gd name="T97" fmla="*/ 0 h 2229"/>
                <a:gd name="T98" fmla="*/ 2203 w 2794"/>
                <a:gd name="T99" fmla="*/ 0 h 2229"/>
                <a:gd name="T100" fmla="*/ 2658 w 2794"/>
                <a:gd name="T101" fmla="*/ 747 h 2229"/>
                <a:gd name="T102" fmla="*/ 2203 w 2794"/>
                <a:gd name="T103" fmla="*/ 1447 h 2229"/>
                <a:gd name="T104" fmla="*/ 2100 w 2794"/>
                <a:gd name="T105" fmla="*/ 1395 h 2229"/>
                <a:gd name="T106" fmla="*/ 2109 w 2794"/>
                <a:gd name="T107" fmla="*/ 1234 h 2229"/>
                <a:gd name="T108" fmla="*/ 2109 w 2794"/>
                <a:gd name="T109" fmla="*/ 436 h 2229"/>
                <a:gd name="T110" fmla="*/ 1749 w 2794"/>
                <a:gd name="T111" fmla="*/ 436 h 2229"/>
                <a:gd name="T112" fmla="*/ 1749 w 2794"/>
                <a:gd name="T113" fmla="*/ 136 h 2229"/>
                <a:gd name="T114" fmla="*/ 2203 w 2794"/>
                <a:gd name="T115" fmla="*/ 136 h 2229"/>
                <a:gd name="T116" fmla="*/ 2658 w 2794"/>
                <a:gd name="T117" fmla="*/ 136 h 2229"/>
                <a:gd name="T118" fmla="*/ 2658 w 2794"/>
                <a:gd name="T119" fmla="*/ 747 h 222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 ang="0">
                  <a:pos x="T118" y="T119"/>
                </a:cxn>
              </a:cxnLst>
              <a:rect l="0" t="0" r="r" b="b"/>
              <a:pathLst>
                <a:path w="2794" h="2229">
                  <a:moveTo>
                    <a:pt x="2203" y="0"/>
                  </a:moveTo>
                  <a:cubicBezTo>
                    <a:pt x="1613" y="0"/>
                    <a:pt x="1613" y="0"/>
                    <a:pt x="1613" y="0"/>
                  </a:cubicBezTo>
                  <a:cubicBezTo>
                    <a:pt x="1613" y="665"/>
                    <a:pt x="1613" y="665"/>
                    <a:pt x="1613" y="665"/>
                  </a:cubicBezTo>
                  <a:cubicBezTo>
                    <a:pt x="1613" y="970"/>
                    <a:pt x="1719" y="1183"/>
                    <a:pt x="1904" y="1330"/>
                  </a:cubicBezTo>
                  <a:cubicBezTo>
                    <a:pt x="1904" y="1237"/>
                    <a:pt x="1904" y="1237"/>
                    <a:pt x="1904" y="1237"/>
                  </a:cubicBezTo>
                  <a:cubicBezTo>
                    <a:pt x="1769" y="1081"/>
                    <a:pt x="1749" y="901"/>
                    <a:pt x="1749" y="747"/>
                  </a:cubicBezTo>
                  <a:cubicBezTo>
                    <a:pt x="1749" y="573"/>
                    <a:pt x="1749" y="573"/>
                    <a:pt x="1749" y="573"/>
                  </a:cubicBezTo>
                  <a:cubicBezTo>
                    <a:pt x="1972" y="573"/>
                    <a:pt x="1972" y="573"/>
                    <a:pt x="1972" y="573"/>
                  </a:cubicBezTo>
                  <a:cubicBezTo>
                    <a:pt x="1972" y="1332"/>
                    <a:pt x="1972" y="1332"/>
                    <a:pt x="1972" y="1332"/>
                  </a:cubicBezTo>
                  <a:cubicBezTo>
                    <a:pt x="1972" y="1609"/>
                    <a:pt x="1895" y="1961"/>
                    <a:pt x="1401" y="2182"/>
                  </a:cubicBezTo>
                  <a:cubicBezTo>
                    <a:pt x="931" y="1972"/>
                    <a:pt x="838" y="1643"/>
                    <a:pt x="829" y="1374"/>
                  </a:cubicBezTo>
                  <a:cubicBezTo>
                    <a:pt x="1051" y="1225"/>
                    <a:pt x="1180" y="1001"/>
                    <a:pt x="1180" y="665"/>
                  </a:cubicBezTo>
                  <a:cubicBezTo>
                    <a:pt x="1180" y="573"/>
                    <a:pt x="1180" y="573"/>
                    <a:pt x="1180" y="573"/>
                  </a:cubicBezTo>
                  <a:cubicBezTo>
                    <a:pt x="1401" y="573"/>
                    <a:pt x="1401" y="573"/>
                    <a:pt x="1401" y="573"/>
                  </a:cubicBezTo>
                  <a:cubicBezTo>
                    <a:pt x="1542" y="573"/>
                    <a:pt x="1542" y="573"/>
                    <a:pt x="1542" y="573"/>
                  </a:cubicBezTo>
                  <a:cubicBezTo>
                    <a:pt x="1542" y="436"/>
                    <a:pt x="1542" y="436"/>
                    <a:pt x="1542" y="436"/>
                  </a:cubicBezTo>
                  <a:cubicBezTo>
                    <a:pt x="1401" y="436"/>
                    <a:pt x="1401" y="436"/>
                    <a:pt x="1401" y="436"/>
                  </a:cubicBezTo>
                  <a:cubicBezTo>
                    <a:pt x="1180" y="436"/>
                    <a:pt x="1180" y="436"/>
                    <a:pt x="1180" y="436"/>
                  </a:cubicBezTo>
                  <a:cubicBezTo>
                    <a:pt x="1180" y="436"/>
                    <a:pt x="1180" y="436"/>
                    <a:pt x="1180" y="436"/>
                  </a:cubicBezTo>
                  <a:cubicBezTo>
                    <a:pt x="1044" y="436"/>
                    <a:pt x="1044" y="436"/>
                    <a:pt x="1044" y="436"/>
                  </a:cubicBezTo>
                  <a:cubicBezTo>
                    <a:pt x="1044" y="436"/>
                    <a:pt x="1044" y="436"/>
                    <a:pt x="1044" y="436"/>
                  </a:cubicBezTo>
                  <a:cubicBezTo>
                    <a:pt x="692" y="436"/>
                    <a:pt x="692" y="436"/>
                    <a:pt x="692" y="436"/>
                  </a:cubicBezTo>
                  <a:cubicBezTo>
                    <a:pt x="692" y="1234"/>
                    <a:pt x="692" y="1234"/>
                    <a:pt x="692" y="1234"/>
                  </a:cubicBezTo>
                  <a:cubicBezTo>
                    <a:pt x="692" y="1262"/>
                    <a:pt x="693" y="1289"/>
                    <a:pt x="695" y="1315"/>
                  </a:cubicBezTo>
                  <a:cubicBezTo>
                    <a:pt x="695" y="1315"/>
                    <a:pt x="695" y="1315"/>
                    <a:pt x="695" y="1315"/>
                  </a:cubicBezTo>
                  <a:cubicBezTo>
                    <a:pt x="748" y="1280"/>
                    <a:pt x="792" y="1244"/>
                    <a:pt x="829" y="1205"/>
                  </a:cubicBezTo>
                  <a:cubicBezTo>
                    <a:pt x="829" y="1205"/>
                    <a:pt x="829" y="1205"/>
                    <a:pt x="829" y="1205"/>
                  </a:cubicBezTo>
                  <a:cubicBezTo>
                    <a:pt x="829" y="573"/>
                    <a:pt x="829" y="573"/>
                    <a:pt x="829" y="573"/>
                  </a:cubicBezTo>
                  <a:cubicBezTo>
                    <a:pt x="1044" y="573"/>
                    <a:pt x="1044" y="573"/>
                    <a:pt x="1044" y="573"/>
                  </a:cubicBezTo>
                  <a:cubicBezTo>
                    <a:pt x="1044" y="573"/>
                    <a:pt x="1044" y="573"/>
                    <a:pt x="1044" y="573"/>
                  </a:cubicBezTo>
                  <a:cubicBezTo>
                    <a:pt x="1044" y="747"/>
                    <a:pt x="1044" y="747"/>
                    <a:pt x="1044" y="747"/>
                  </a:cubicBezTo>
                  <a:cubicBezTo>
                    <a:pt x="1044" y="978"/>
                    <a:pt x="1001" y="1263"/>
                    <a:pt x="590" y="1447"/>
                  </a:cubicBezTo>
                  <a:cubicBezTo>
                    <a:pt x="178" y="1263"/>
                    <a:pt x="135" y="978"/>
                    <a:pt x="135" y="747"/>
                  </a:cubicBezTo>
                  <a:cubicBezTo>
                    <a:pt x="135" y="136"/>
                    <a:pt x="135" y="136"/>
                    <a:pt x="135" y="136"/>
                  </a:cubicBezTo>
                  <a:cubicBezTo>
                    <a:pt x="590" y="136"/>
                    <a:pt x="590" y="136"/>
                    <a:pt x="590" y="136"/>
                  </a:cubicBezTo>
                  <a:cubicBezTo>
                    <a:pt x="1044" y="136"/>
                    <a:pt x="1044" y="136"/>
                    <a:pt x="1044" y="136"/>
                  </a:cubicBezTo>
                  <a:cubicBezTo>
                    <a:pt x="1044" y="370"/>
                    <a:pt x="1044" y="370"/>
                    <a:pt x="1044" y="370"/>
                  </a:cubicBezTo>
                  <a:cubicBezTo>
                    <a:pt x="1180" y="370"/>
                    <a:pt x="1180" y="370"/>
                    <a:pt x="1180" y="370"/>
                  </a:cubicBezTo>
                  <a:cubicBezTo>
                    <a:pt x="1180" y="0"/>
                    <a:pt x="1180" y="0"/>
                    <a:pt x="1180" y="0"/>
                  </a:cubicBezTo>
                  <a:cubicBezTo>
                    <a:pt x="590" y="0"/>
                    <a:pt x="590" y="0"/>
                    <a:pt x="590" y="0"/>
                  </a:cubicBezTo>
                  <a:cubicBezTo>
                    <a:pt x="0" y="0"/>
                    <a:pt x="0" y="0"/>
                    <a:pt x="0" y="0"/>
                  </a:cubicBezTo>
                  <a:cubicBezTo>
                    <a:pt x="0" y="665"/>
                    <a:pt x="0" y="665"/>
                    <a:pt x="0" y="665"/>
                  </a:cubicBezTo>
                  <a:cubicBezTo>
                    <a:pt x="0" y="1109"/>
                    <a:pt x="224" y="1357"/>
                    <a:pt x="590" y="1495"/>
                  </a:cubicBezTo>
                  <a:cubicBezTo>
                    <a:pt x="631" y="1479"/>
                    <a:pt x="670" y="1462"/>
                    <a:pt x="708" y="1444"/>
                  </a:cubicBezTo>
                  <a:cubicBezTo>
                    <a:pt x="771" y="1847"/>
                    <a:pt x="1023" y="2087"/>
                    <a:pt x="1401" y="2229"/>
                  </a:cubicBezTo>
                  <a:cubicBezTo>
                    <a:pt x="1777" y="2087"/>
                    <a:pt x="2029" y="1848"/>
                    <a:pt x="2093" y="1447"/>
                  </a:cubicBezTo>
                  <a:cubicBezTo>
                    <a:pt x="2128" y="1464"/>
                    <a:pt x="2165" y="1480"/>
                    <a:pt x="2203" y="1495"/>
                  </a:cubicBezTo>
                  <a:cubicBezTo>
                    <a:pt x="2569" y="1357"/>
                    <a:pt x="2794" y="1109"/>
                    <a:pt x="2794" y="665"/>
                  </a:cubicBezTo>
                  <a:cubicBezTo>
                    <a:pt x="2794" y="0"/>
                    <a:pt x="2794" y="0"/>
                    <a:pt x="2794" y="0"/>
                  </a:cubicBezTo>
                  <a:lnTo>
                    <a:pt x="2203" y="0"/>
                  </a:lnTo>
                  <a:close/>
                  <a:moveTo>
                    <a:pt x="2658" y="747"/>
                  </a:moveTo>
                  <a:cubicBezTo>
                    <a:pt x="2658" y="978"/>
                    <a:pt x="2615" y="1263"/>
                    <a:pt x="2203" y="1447"/>
                  </a:cubicBezTo>
                  <a:cubicBezTo>
                    <a:pt x="2166" y="1431"/>
                    <a:pt x="2131" y="1413"/>
                    <a:pt x="2100" y="1395"/>
                  </a:cubicBezTo>
                  <a:cubicBezTo>
                    <a:pt x="2106" y="1344"/>
                    <a:pt x="2109" y="1290"/>
                    <a:pt x="2109" y="1234"/>
                  </a:cubicBezTo>
                  <a:cubicBezTo>
                    <a:pt x="2109" y="436"/>
                    <a:pt x="2109" y="436"/>
                    <a:pt x="2109" y="436"/>
                  </a:cubicBezTo>
                  <a:cubicBezTo>
                    <a:pt x="1749" y="436"/>
                    <a:pt x="1749" y="436"/>
                    <a:pt x="1749" y="436"/>
                  </a:cubicBezTo>
                  <a:cubicBezTo>
                    <a:pt x="1749" y="136"/>
                    <a:pt x="1749" y="136"/>
                    <a:pt x="1749" y="136"/>
                  </a:cubicBezTo>
                  <a:cubicBezTo>
                    <a:pt x="2203" y="136"/>
                    <a:pt x="2203" y="136"/>
                    <a:pt x="2203" y="136"/>
                  </a:cubicBezTo>
                  <a:cubicBezTo>
                    <a:pt x="2658" y="136"/>
                    <a:pt x="2658" y="136"/>
                    <a:pt x="2658" y="136"/>
                  </a:cubicBezTo>
                  <a:lnTo>
                    <a:pt x="2658" y="74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3" name="Freeform 6"/>
            <p:cNvSpPr>
              <a:spLocks/>
            </p:cNvSpPr>
            <p:nvPr userDrawn="1"/>
          </p:nvSpPr>
          <p:spPr bwMode="auto">
            <a:xfrm>
              <a:off x="915988" y="1003301"/>
              <a:ext cx="188913" cy="236538"/>
            </a:xfrm>
            <a:custGeom>
              <a:avLst/>
              <a:gdLst>
                <a:gd name="T0" fmla="*/ 49 w 596"/>
                <a:gd name="T1" fmla="*/ 747 h 747"/>
                <a:gd name="T2" fmla="*/ 49 w 596"/>
                <a:gd name="T3" fmla="*/ 721 h 747"/>
                <a:gd name="T4" fmla="*/ 91 w 596"/>
                <a:gd name="T5" fmla="*/ 696 h 747"/>
                <a:gd name="T6" fmla="*/ 99 w 596"/>
                <a:gd name="T7" fmla="*/ 684 h 747"/>
                <a:gd name="T8" fmla="*/ 105 w 596"/>
                <a:gd name="T9" fmla="*/ 621 h 747"/>
                <a:gd name="T10" fmla="*/ 109 w 596"/>
                <a:gd name="T11" fmla="*/ 535 h 747"/>
                <a:gd name="T12" fmla="*/ 109 w 596"/>
                <a:gd name="T13" fmla="*/ 252 h 747"/>
                <a:gd name="T14" fmla="*/ 105 w 596"/>
                <a:gd name="T15" fmla="*/ 112 h 747"/>
                <a:gd name="T16" fmla="*/ 98 w 596"/>
                <a:gd name="T17" fmla="*/ 52 h 747"/>
                <a:gd name="T18" fmla="*/ 78 w 596"/>
                <a:gd name="T19" fmla="*/ 39 h 747"/>
                <a:gd name="T20" fmla="*/ 0 w 596"/>
                <a:gd name="T21" fmla="*/ 33 h 747"/>
                <a:gd name="T22" fmla="*/ 0 w 596"/>
                <a:gd name="T23" fmla="*/ 0 h 747"/>
                <a:gd name="T24" fmla="*/ 165 w 596"/>
                <a:gd name="T25" fmla="*/ 3 h 747"/>
                <a:gd name="T26" fmla="*/ 323 w 596"/>
                <a:gd name="T27" fmla="*/ 0 h 747"/>
                <a:gd name="T28" fmla="*/ 323 w 596"/>
                <a:gd name="T29" fmla="*/ 33 h 747"/>
                <a:gd name="T30" fmla="*/ 243 w 596"/>
                <a:gd name="T31" fmla="*/ 39 h 747"/>
                <a:gd name="T32" fmla="*/ 224 w 596"/>
                <a:gd name="T33" fmla="*/ 51 h 747"/>
                <a:gd name="T34" fmla="*/ 216 w 596"/>
                <a:gd name="T35" fmla="*/ 102 h 747"/>
                <a:gd name="T36" fmla="*/ 213 w 596"/>
                <a:gd name="T37" fmla="*/ 252 h 747"/>
                <a:gd name="T38" fmla="*/ 213 w 596"/>
                <a:gd name="T39" fmla="*/ 606 h 747"/>
                <a:gd name="T40" fmla="*/ 216 w 596"/>
                <a:gd name="T41" fmla="*/ 696 h 747"/>
                <a:gd name="T42" fmla="*/ 303 w 596"/>
                <a:gd name="T43" fmla="*/ 700 h 747"/>
                <a:gd name="T44" fmla="*/ 525 w 596"/>
                <a:gd name="T45" fmla="*/ 681 h 747"/>
                <a:gd name="T46" fmla="*/ 538 w 596"/>
                <a:gd name="T47" fmla="*/ 644 h 747"/>
                <a:gd name="T48" fmla="*/ 560 w 596"/>
                <a:gd name="T49" fmla="*/ 557 h 747"/>
                <a:gd name="T50" fmla="*/ 596 w 596"/>
                <a:gd name="T51" fmla="*/ 557 h 747"/>
                <a:gd name="T52" fmla="*/ 573 w 596"/>
                <a:gd name="T53" fmla="*/ 741 h 747"/>
                <a:gd name="T54" fmla="*/ 537 w 596"/>
                <a:gd name="T55" fmla="*/ 746 h 747"/>
                <a:gd name="T56" fmla="*/ 449 w 596"/>
                <a:gd name="T57" fmla="*/ 747 h 747"/>
                <a:gd name="T58" fmla="*/ 156 w 596"/>
                <a:gd name="T59" fmla="*/ 744 h 747"/>
                <a:gd name="T60" fmla="*/ 49 w 596"/>
                <a:gd name="T61" fmla="*/ 747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Lst>
              <a:rect l="0" t="0" r="r" b="b"/>
              <a:pathLst>
                <a:path w="596" h="747">
                  <a:moveTo>
                    <a:pt x="49" y="747"/>
                  </a:moveTo>
                  <a:cubicBezTo>
                    <a:pt x="49" y="721"/>
                    <a:pt x="49" y="721"/>
                    <a:pt x="49" y="721"/>
                  </a:cubicBezTo>
                  <a:cubicBezTo>
                    <a:pt x="71" y="710"/>
                    <a:pt x="85" y="702"/>
                    <a:pt x="91" y="696"/>
                  </a:cubicBezTo>
                  <a:cubicBezTo>
                    <a:pt x="95" y="693"/>
                    <a:pt x="98" y="689"/>
                    <a:pt x="99" y="684"/>
                  </a:cubicBezTo>
                  <a:cubicBezTo>
                    <a:pt x="102" y="675"/>
                    <a:pt x="104" y="654"/>
                    <a:pt x="105" y="621"/>
                  </a:cubicBezTo>
                  <a:cubicBezTo>
                    <a:pt x="108" y="573"/>
                    <a:pt x="109" y="545"/>
                    <a:pt x="109" y="535"/>
                  </a:cubicBezTo>
                  <a:cubicBezTo>
                    <a:pt x="109" y="252"/>
                    <a:pt x="109" y="252"/>
                    <a:pt x="109" y="252"/>
                  </a:cubicBezTo>
                  <a:cubicBezTo>
                    <a:pt x="109" y="204"/>
                    <a:pt x="108" y="157"/>
                    <a:pt x="105" y="112"/>
                  </a:cubicBezTo>
                  <a:cubicBezTo>
                    <a:pt x="104" y="78"/>
                    <a:pt x="102" y="59"/>
                    <a:pt x="98" y="52"/>
                  </a:cubicBezTo>
                  <a:cubicBezTo>
                    <a:pt x="93" y="46"/>
                    <a:pt x="87" y="42"/>
                    <a:pt x="78" y="39"/>
                  </a:cubicBezTo>
                  <a:cubicBezTo>
                    <a:pt x="69" y="36"/>
                    <a:pt x="43" y="34"/>
                    <a:pt x="0" y="33"/>
                  </a:cubicBezTo>
                  <a:cubicBezTo>
                    <a:pt x="0" y="0"/>
                    <a:pt x="0" y="0"/>
                    <a:pt x="0" y="0"/>
                  </a:cubicBezTo>
                  <a:cubicBezTo>
                    <a:pt x="89" y="2"/>
                    <a:pt x="144" y="3"/>
                    <a:pt x="165" y="3"/>
                  </a:cubicBezTo>
                  <a:cubicBezTo>
                    <a:pt x="189" y="3"/>
                    <a:pt x="241" y="2"/>
                    <a:pt x="323" y="0"/>
                  </a:cubicBezTo>
                  <a:cubicBezTo>
                    <a:pt x="323" y="33"/>
                    <a:pt x="323" y="33"/>
                    <a:pt x="323" y="33"/>
                  </a:cubicBezTo>
                  <a:cubicBezTo>
                    <a:pt x="279" y="34"/>
                    <a:pt x="253" y="36"/>
                    <a:pt x="243" y="39"/>
                  </a:cubicBezTo>
                  <a:cubicBezTo>
                    <a:pt x="234" y="42"/>
                    <a:pt x="228" y="46"/>
                    <a:pt x="224" y="51"/>
                  </a:cubicBezTo>
                  <a:cubicBezTo>
                    <a:pt x="220" y="58"/>
                    <a:pt x="217" y="75"/>
                    <a:pt x="216" y="102"/>
                  </a:cubicBezTo>
                  <a:cubicBezTo>
                    <a:pt x="215" y="109"/>
                    <a:pt x="214" y="159"/>
                    <a:pt x="213" y="252"/>
                  </a:cubicBezTo>
                  <a:cubicBezTo>
                    <a:pt x="213" y="606"/>
                    <a:pt x="213" y="606"/>
                    <a:pt x="213" y="606"/>
                  </a:cubicBezTo>
                  <a:cubicBezTo>
                    <a:pt x="213" y="643"/>
                    <a:pt x="214" y="673"/>
                    <a:pt x="216" y="696"/>
                  </a:cubicBezTo>
                  <a:cubicBezTo>
                    <a:pt x="257" y="699"/>
                    <a:pt x="262" y="700"/>
                    <a:pt x="303" y="700"/>
                  </a:cubicBezTo>
                  <a:cubicBezTo>
                    <a:pt x="407" y="700"/>
                    <a:pt x="484" y="693"/>
                    <a:pt x="525" y="681"/>
                  </a:cubicBezTo>
                  <a:cubicBezTo>
                    <a:pt x="530" y="670"/>
                    <a:pt x="534" y="658"/>
                    <a:pt x="538" y="644"/>
                  </a:cubicBezTo>
                  <a:cubicBezTo>
                    <a:pt x="560" y="557"/>
                    <a:pt x="560" y="557"/>
                    <a:pt x="560" y="557"/>
                  </a:cubicBezTo>
                  <a:cubicBezTo>
                    <a:pt x="596" y="557"/>
                    <a:pt x="596" y="557"/>
                    <a:pt x="596" y="557"/>
                  </a:cubicBezTo>
                  <a:cubicBezTo>
                    <a:pt x="588" y="609"/>
                    <a:pt x="580" y="671"/>
                    <a:pt x="573" y="741"/>
                  </a:cubicBezTo>
                  <a:cubicBezTo>
                    <a:pt x="558" y="744"/>
                    <a:pt x="546" y="745"/>
                    <a:pt x="537" y="746"/>
                  </a:cubicBezTo>
                  <a:cubicBezTo>
                    <a:pt x="518" y="747"/>
                    <a:pt x="488" y="747"/>
                    <a:pt x="449" y="747"/>
                  </a:cubicBezTo>
                  <a:cubicBezTo>
                    <a:pt x="156" y="744"/>
                    <a:pt x="156" y="744"/>
                    <a:pt x="156" y="744"/>
                  </a:cubicBezTo>
                  <a:cubicBezTo>
                    <a:pt x="121" y="744"/>
                    <a:pt x="85" y="745"/>
                    <a:pt x="49"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4" name="Freeform 7"/>
            <p:cNvSpPr>
              <a:spLocks/>
            </p:cNvSpPr>
            <p:nvPr userDrawn="1"/>
          </p:nvSpPr>
          <p:spPr bwMode="auto">
            <a:xfrm>
              <a:off x="1127125" y="1003301"/>
              <a:ext cx="103188" cy="236538"/>
            </a:xfrm>
            <a:custGeom>
              <a:avLst/>
              <a:gdLst>
                <a:gd name="T0" fmla="*/ 321 w 321"/>
                <a:gd name="T1" fmla="*/ 714 h 747"/>
                <a:gd name="T2" fmla="*/ 321 w 321"/>
                <a:gd name="T3" fmla="*/ 747 h 747"/>
                <a:gd name="T4" fmla="*/ 168 w 321"/>
                <a:gd name="T5" fmla="*/ 744 h 747"/>
                <a:gd name="T6" fmla="*/ 0 w 321"/>
                <a:gd name="T7" fmla="*/ 747 h 747"/>
                <a:gd name="T8" fmla="*/ 0 w 321"/>
                <a:gd name="T9" fmla="*/ 714 h 747"/>
                <a:gd name="T10" fmla="*/ 77 w 321"/>
                <a:gd name="T11" fmla="*/ 708 h 747"/>
                <a:gd name="T12" fmla="*/ 97 w 321"/>
                <a:gd name="T13" fmla="*/ 696 h 747"/>
                <a:gd name="T14" fmla="*/ 105 w 321"/>
                <a:gd name="T15" fmla="*/ 645 h 747"/>
                <a:gd name="T16" fmla="*/ 108 w 321"/>
                <a:gd name="T17" fmla="*/ 495 h 747"/>
                <a:gd name="T18" fmla="*/ 108 w 321"/>
                <a:gd name="T19" fmla="*/ 251 h 747"/>
                <a:gd name="T20" fmla="*/ 105 w 321"/>
                <a:gd name="T21" fmla="*/ 111 h 747"/>
                <a:gd name="T22" fmla="*/ 97 w 321"/>
                <a:gd name="T23" fmla="*/ 52 h 747"/>
                <a:gd name="T24" fmla="*/ 77 w 321"/>
                <a:gd name="T25" fmla="*/ 39 h 747"/>
                <a:gd name="T26" fmla="*/ 0 w 321"/>
                <a:gd name="T27" fmla="*/ 33 h 747"/>
                <a:gd name="T28" fmla="*/ 0 w 321"/>
                <a:gd name="T29" fmla="*/ 0 h 747"/>
                <a:gd name="T30" fmla="*/ 161 w 321"/>
                <a:gd name="T31" fmla="*/ 3 h 747"/>
                <a:gd name="T32" fmla="*/ 321 w 321"/>
                <a:gd name="T33" fmla="*/ 0 h 747"/>
                <a:gd name="T34" fmla="*/ 321 w 321"/>
                <a:gd name="T35" fmla="*/ 33 h 747"/>
                <a:gd name="T36" fmla="*/ 243 w 321"/>
                <a:gd name="T37" fmla="*/ 39 h 747"/>
                <a:gd name="T38" fmla="*/ 224 w 321"/>
                <a:gd name="T39" fmla="*/ 51 h 747"/>
                <a:gd name="T40" fmla="*/ 216 w 321"/>
                <a:gd name="T41" fmla="*/ 102 h 747"/>
                <a:gd name="T42" fmla="*/ 212 w 321"/>
                <a:gd name="T43" fmla="*/ 251 h 747"/>
                <a:gd name="T44" fmla="*/ 212 w 321"/>
                <a:gd name="T45" fmla="*/ 495 h 747"/>
                <a:gd name="T46" fmla="*/ 214 w 321"/>
                <a:gd name="T47" fmla="*/ 635 h 747"/>
                <a:gd name="T48" fmla="*/ 222 w 321"/>
                <a:gd name="T49" fmla="*/ 694 h 747"/>
                <a:gd name="T50" fmla="*/ 242 w 321"/>
                <a:gd name="T51" fmla="*/ 708 h 747"/>
                <a:gd name="T52" fmla="*/ 321 w 321"/>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1" h="747">
                  <a:moveTo>
                    <a:pt x="321" y="714"/>
                  </a:moveTo>
                  <a:cubicBezTo>
                    <a:pt x="321" y="747"/>
                    <a:pt x="321" y="747"/>
                    <a:pt x="321" y="747"/>
                  </a:cubicBezTo>
                  <a:cubicBezTo>
                    <a:pt x="244" y="745"/>
                    <a:pt x="193" y="744"/>
                    <a:pt x="168" y="744"/>
                  </a:cubicBezTo>
                  <a:cubicBezTo>
                    <a:pt x="0" y="747"/>
                    <a:pt x="0" y="747"/>
                    <a:pt x="0" y="747"/>
                  </a:cubicBezTo>
                  <a:cubicBezTo>
                    <a:pt x="0" y="714"/>
                    <a:pt x="0" y="714"/>
                    <a:pt x="0" y="714"/>
                  </a:cubicBezTo>
                  <a:cubicBezTo>
                    <a:pt x="42" y="713"/>
                    <a:pt x="68" y="711"/>
                    <a:pt x="77" y="708"/>
                  </a:cubicBezTo>
                  <a:cubicBezTo>
                    <a:pt x="87" y="705"/>
                    <a:pt x="93" y="701"/>
                    <a:pt x="97" y="696"/>
                  </a:cubicBezTo>
                  <a:cubicBezTo>
                    <a:pt x="101" y="689"/>
                    <a:pt x="104" y="672"/>
                    <a:pt x="105" y="645"/>
                  </a:cubicBezTo>
                  <a:cubicBezTo>
                    <a:pt x="106" y="637"/>
                    <a:pt x="107" y="587"/>
                    <a:pt x="108" y="495"/>
                  </a:cubicBezTo>
                  <a:cubicBezTo>
                    <a:pt x="108" y="251"/>
                    <a:pt x="108" y="251"/>
                    <a:pt x="108" y="251"/>
                  </a:cubicBezTo>
                  <a:cubicBezTo>
                    <a:pt x="108" y="204"/>
                    <a:pt x="107" y="157"/>
                    <a:pt x="105" y="111"/>
                  </a:cubicBezTo>
                  <a:cubicBezTo>
                    <a:pt x="104" y="78"/>
                    <a:pt x="102" y="59"/>
                    <a:pt x="97" y="52"/>
                  </a:cubicBezTo>
                  <a:cubicBezTo>
                    <a:pt x="93" y="46"/>
                    <a:pt x="87" y="41"/>
                    <a:pt x="77" y="39"/>
                  </a:cubicBezTo>
                  <a:cubicBezTo>
                    <a:pt x="68" y="36"/>
                    <a:pt x="42" y="34"/>
                    <a:pt x="0" y="33"/>
                  </a:cubicBezTo>
                  <a:cubicBezTo>
                    <a:pt x="0" y="0"/>
                    <a:pt x="0" y="0"/>
                    <a:pt x="0" y="0"/>
                  </a:cubicBezTo>
                  <a:cubicBezTo>
                    <a:pt x="69" y="2"/>
                    <a:pt x="123" y="3"/>
                    <a:pt x="161" y="3"/>
                  </a:cubicBezTo>
                  <a:cubicBezTo>
                    <a:pt x="197" y="3"/>
                    <a:pt x="250" y="2"/>
                    <a:pt x="321" y="0"/>
                  </a:cubicBezTo>
                  <a:cubicBezTo>
                    <a:pt x="321" y="33"/>
                    <a:pt x="321" y="33"/>
                    <a:pt x="321" y="33"/>
                  </a:cubicBezTo>
                  <a:cubicBezTo>
                    <a:pt x="278" y="34"/>
                    <a:pt x="252" y="36"/>
                    <a:pt x="243" y="39"/>
                  </a:cubicBezTo>
                  <a:cubicBezTo>
                    <a:pt x="234" y="41"/>
                    <a:pt x="227" y="46"/>
                    <a:pt x="224" y="51"/>
                  </a:cubicBezTo>
                  <a:cubicBezTo>
                    <a:pt x="219" y="58"/>
                    <a:pt x="217" y="75"/>
                    <a:pt x="216" y="102"/>
                  </a:cubicBezTo>
                  <a:cubicBezTo>
                    <a:pt x="215" y="109"/>
                    <a:pt x="214" y="159"/>
                    <a:pt x="212" y="251"/>
                  </a:cubicBezTo>
                  <a:cubicBezTo>
                    <a:pt x="212" y="495"/>
                    <a:pt x="212" y="495"/>
                    <a:pt x="212" y="495"/>
                  </a:cubicBezTo>
                  <a:cubicBezTo>
                    <a:pt x="212" y="543"/>
                    <a:pt x="213" y="589"/>
                    <a:pt x="214" y="635"/>
                  </a:cubicBezTo>
                  <a:cubicBezTo>
                    <a:pt x="215" y="668"/>
                    <a:pt x="218" y="688"/>
                    <a:pt x="222" y="694"/>
                  </a:cubicBezTo>
                  <a:cubicBezTo>
                    <a:pt x="226" y="700"/>
                    <a:pt x="233" y="705"/>
                    <a:pt x="242" y="708"/>
                  </a:cubicBezTo>
                  <a:cubicBezTo>
                    <a:pt x="251" y="711"/>
                    <a:pt x="278" y="713"/>
                    <a:pt x="321"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5" name="Freeform 8"/>
            <p:cNvSpPr>
              <a:spLocks/>
            </p:cNvSpPr>
            <p:nvPr userDrawn="1"/>
          </p:nvSpPr>
          <p:spPr bwMode="auto">
            <a:xfrm>
              <a:off x="1266825" y="1003301"/>
              <a:ext cx="276225" cy="242888"/>
            </a:xfrm>
            <a:custGeom>
              <a:avLst/>
              <a:gdLst>
                <a:gd name="T0" fmla="*/ 5 w 869"/>
                <a:gd name="T1" fmla="*/ 747 h 766"/>
                <a:gd name="T2" fmla="*/ 5 w 869"/>
                <a:gd name="T3" fmla="*/ 714 h 766"/>
                <a:gd name="T4" fmla="*/ 80 w 869"/>
                <a:gd name="T5" fmla="*/ 705 h 766"/>
                <a:gd name="T6" fmla="*/ 91 w 869"/>
                <a:gd name="T7" fmla="*/ 695 h 766"/>
                <a:gd name="T8" fmla="*/ 99 w 869"/>
                <a:gd name="T9" fmla="*/ 640 h 766"/>
                <a:gd name="T10" fmla="*/ 102 w 869"/>
                <a:gd name="T11" fmla="*/ 520 h 766"/>
                <a:gd name="T12" fmla="*/ 102 w 869"/>
                <a:gd name="T13" fmla="*/ 92 h 766"/>
                <a:gd name="T14" fmla="*/ 100 w 869"/>
                <a:gd name="T15" fmla="*/ 69 h 766"/>
                <a:gd name="T16" fmla="*/ 80 w 869"/>
                <a:gd name="T17" fmla="*/ 47 h 766"/>
                <a:gd name="T18" fmla="*/ 57 w 869"/>
                <a:gd name="T19" fmla="*/ 36 h 766"/>
                <a:gd name="T20" fmla="*/ 0 w 869"/>
                <a:gd name="T21" fmla="*/ 33 h 766"/>
                <a:gd name="T22" fmla="*/ 0 w 869"/>
                <a:gd name="T23" fmla="*/ 0 h 766"/>
                <a:gd name="T24" fmla="*/ 119 w 869"/>
                <a:gd name="T25" fmla="*/ 3 h 766"/>
                <a:gd name="T26" fmla="*/ 202 w 869"/>
                <a:gd name="T27" fmla="*/ 0 h 766"/>
                <a:gd name="T28" fmla="*/ 269 w 869"/>
                <a:gd name="T29" fmla="*/ 86 h 766"/>
                <a:gd name="T30" fmla="*/ 381 w 869"/>
                <a:gd name="T31" fmla="*/ 220 h 766"/>
                <a:gd name="T32" fmla="*/ 545 w 869"/>
                <a:gd name="T33" fmla="*/ 411 h 766"/>
                <a:gd name="T34" fmla="*/ 671 w 869"/>
                <a:gd name="T35" fmla="*/ 554 h 766"/>
                <a:gd name="T36" fmla="*/ 721 w 869"/>
                <a:gd name="T37" fmla="*/ 609 h 766"/>
                <a:gd name="T38" fmla="*/ 721 w 869"/>
                <a:gd name="T39" fmla="*/ 226 h 766"/>
                <a:gd name="T40" fmla="*/ 718 w 869"/>
                <a:gd name="T41" fmla="*/ 105 h 766"/>
                <a:gd name="T42" fmla="*/ 711 w 869"/>
                <a:gd name="T43" fmla="*/ 51 h 766"/>
                <a:gd name="T44" fmla="*/ 699 w 869"/>
                <a:gd name="T45" fmla="*/ 41 h 766"/>
                <a:gd name="T46" fmla="*/ 624 w 869"/>
                <a:gd name="T47" fmla="*/ 33 h 766"/>
                <a:gd name="T48" fmla="*/ 624 w 869"/>
                <a:gd name="T49" fmla="*/ 0 h 766"/>
                <a:gd name="T50" fmla="*/ 756 w 869"/>
                <a:gd name="T51" fmla="*/ 3 h 766"/>
                <a:gd name="T52" fmla="*/ 869 w 869"/>
                <a:gd name="T53" fmla="*/ 0 h 766"/>
                <a:gd name="T54" fmla="*/ 869 w 869"/>
                <a:gd name="T55" fmla="*/ 33 h 766"/>
                <a:gd name="T56" fmla="*/ 794 w 869"/>
                <a:gd name="T57" fmla="*/ 41 h 766"/>
                <a:gd name="T58" fmla="*/ 783 w 869"/>
                <a:gd name="T59" fmla="*/ 52 h 766"/>
                <a:gd name="T60" fmla="*/ 775 w 869"/>
                <a:gd name="T61" fmla="*/ 107 h 766"/>
                <a:gd name="T62" fmla="*/ 772 w 869"/>
                <a:gd name="T63" fmla="*/ 226 h 766"/>
                <a:gd name="T64" fmla="*/ 772 w 869"/>
                <a:gd name="T65" fmla="*/ 479 h 766"/>
                <a:gd name="T66" fmla="*/ 775 w 869"/>
                <a:gd name="T67" fmla="*/ 766 h 766"/>
                <a:gd name="T68" fmla="*/ 721 w 869"/>
                <a:gd name="T69" fmla="*/ 766 h 766"/>
                <a:gd name="T70" fmla="*/ 707 w 869"/>
                <a:gd name="T71" fmla="*/ 752 h 766"/>
                <a:gd name="T72" fmla="*/ 698 w 869"/>
                <a:gd name="T73" fmla="*/ 744 h 766"/>
                <a:gd name="T74" fmla="*/ 678 w 869"/>
                <a:gd name="T75" fmla="*/ 723 h 766"/>
                <a:gd name="T76" fmla="*/ 611 w 869"/>
                <a:gd name="T77" fmla="*/ 647 h 766"/>
                <a:gd name="T78" fmla="*/ 540 w 869"/>
                <a:gd name="T79" fmla="*/ 560 h 766"/>
                <a:gd name="T80" fmla="*/ 151 w 869"/>
                <a:gd name="T81" fmla="*/ 110 h 766"/>
                <a:gd name="T82" fmla="*/ 151 w 869"/>
                <a:gd name="T83" fmla="*/ 518 h 766"/>
                <a:gd name="T84" fmla="*/ 154 w 869"/>
                <a:gd name="T85" fmla="*/ 641 h 766"/>
                <a:gd name="T86" fmla="*/ 161 w 869"/>
                <a:gd name="T87" fmla="*/ 695 h 766"/>
                <a:gd name="T88" fmla="*/ 173 w 869"/>
                <a:gd name="T89" fmla="*/ 705 h 766"/>
                <a:gd name="T90" fmla="*/ 249 w 869"/>
                <a:gd name="T91" fmla="*/ 714 h 766"/>
                <a:gd name="T92" fmla="*/ 249 w 869"/>
                <a:gd name="T93" fmla="*/ 747 h 766"/>
                <a:gd name="T94" fmla="*/ 143 w 869"/>
                <a:gd name="T95" fmla="*/ 744 h 766"/>
                <a:gd name="T96" fmla="*/ 5 w 869"/>
                <a:gd name="T97" fmla="*/ 747 h 76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869" h="766">
                  <a:moveTo>
                    <a:pt x="5" y="747"/>
                  </a:moveTo>
                  <a:cubicBezTo>
                    <a:pt x="5" y="714"/>
                    <a:pt x="5" y="714"/>
                    <a:pt x="5" y="714"/>
                  </a:cubicBezTo>
                  <a:cubicBezTo>
                    <a:pt x="43" y="714"/>
                    <a:pt x="68" y="711"/>
                    <a:pt x="80" y="705"/>
                  </a:cubicBezTo>
                  <a:cubicBezTo>
                    <a:pt x="86" y="703"/>
                    <a:pt x="89" y="700"/>
                    <a:pt x="91" y="695"/>
                  </a:cubicBezTo>
                  <a:cubicBezTo>
                    <a:pt x="95" y="688"/>
                    <a:pt x="98" y="670"/>
                    <a:pt x="99" y="640"/>
                  </a:cubicBezTo>
                  <a:cubicBezTo>
                    <a:pt x="101" y="594"/>
                    <a:pt x="102" y="554"/>
                    <a:pt x="102" y="520"/>
                  </a:cubicBezTo>
                  <a:cubicBezTo>
                    <a:pt x="102" y="92"/>
                    <a:pt x="102" y="92"/>
                    <a:pt x="102" y="92"/>
                  </a:cubicBezTo>
                  <a:cubicBezTo>
                    <a:pt x="102" y="80"/>
                    <a:pt x="102" y="73"/>
                    <a:pt x="100" y="69"/>
                  </a:cubicBezTo>
                  <a:cubicBezTo>
                    <a:pt x="97" y="63"/>
                    <a:pt x="91" y="56"/>
                    <a:pt x="80" y="47"/>
                  </a:cubicBezTo>
                  <a:cubicBezTo>
                    <a:pt x="74" y="41"/>
                    <a:pt x="66" y="38"/>
                    <a:pt x="57" y="36"/>
                  </a:cubicBezTo>
                  <a:cubicBezTo>
                    <a:pt x="49" y="34"/>
                    <a:pt x="30" y="33"/>
                    <a:pt x="0" y="33"/>
                  </a:cubicBezTo>
                  <a:cubicBezTo>
                    <a:pt x="0" y="0"/>
                    <a:pt x="0" y="0"/>
                    <a:pt x="0" y="0"/>
                  </a:cubicBezTo>
                  <a:cubicBezTo>
                    <a:pt x="63" y="2"/>
                    <a:pt x="103" y="3"/>
                    <a:pt x="119" y="3"/>
                  </a:cubicBezTo>
                  <a:cubicBezTo>
                    <a:pt x="147" y="3"/>
                    <a:pt x="174" y="2"/>
                    <a:pt x="202" y="0"/>
                  </a:cubicBezTo>
                  <a:cubicBezTo>
                    <a:pt x="232" y="39"/>
                    <a:pt x="255" y="67"/>
                    <a:pt x="269" y="86"/>
                  </a:cubicBezTo>
                  <a:cubicBezTo>
                    <a:pt x="381" y="220"/>
                    <a:pt x="381" y="220"/>
                    <a:pt x="381" y="220"/>
                  </a:cubicBezTo>
                  <a:cubicBezTo>
                    <a:pt x="545" y="411"/>
                    <a:pt x="545" y="411"/>
                    <a:pt x="545" y="411"/>
                  </a:cubicBezTo>
                  <a:cubicBezTo>
                    <a:pt x="597" y="472"/>
                    <a:pt x="639" y="520"/>
                    <a:pt x="671" y="554"/>
                  </a:cubicBezTo>
                  <a:cubicBezTo>
                    <a:pt x="691" y="578"/>
                    <a:pt x="708" y="596"/>
                    <a:pt x="721" y="609"/>
                  </a:cubicBezTo>
                  <a:cubicBezTo>
                    <a:pt x="721" y="226"/>
                    <a:pt x="721" y="226"/>
                    <a:pt x="721" y="226"/>
                  </a:cubicBezTo>
                  <a:cubicBezTo>
                    <a:pt x="721" y="191"/>
                    <a:pt x="720" y="151"/>
                    <a:pt x="718" y="105"/>
                  </a:cubicBezTo>
                  <a:cubicBezTo>
                    <a:pt x="717" y="76"/>
                    <a:pt x="714" y="58"/>
                    <a:pt x="711" y="51"/>
                  </a:cubicBezTo>
                  <a:cubicBezTo>
                    <a:pt x="708" y="46"/>
                    <a:pt x="705" y="43"/>
                    <a:pt x="699" y="41"/>
                  </a:cubicBezTo>
                  <a:cubicBezTo>
                    <a:pt x="687" y="36"/>
                    <a:pt x="662" y="33"/>
                    <a:pt x="624" y="33"/>
                  </a:cubicBezTo>
                  <a:cubicBezTo>
                    <a:pt x="624" y="0"/>
                    <a:pt x="624" y="0"/>
                    <a:pt x="624" y="0"/>
                  </a:cubicBezTo>
                  <a:cubicBezTo>
                    <a:pt x="667" y="2"/>
                    <a:pt x="711" y="3"/>
                    <a:pt x="756" y="3"/>
                  </a:cubicBezTo>
                  <a:cubicBezTo>
                    <a:pt x="797" y="3"/>
                    <a:pt x="835" y="2"/>
                    <a:pt x="869" y="0"/>
                  </a:cubicBezTo>
                  <a:cubicBezTo>
                    <a:pt x="869" y="33"/>
                    <a:pt x="869" y="33"/>
                    <a:pt x="869" y="33"/>
                  </a:cubicBezTo>
                  <a:cubicBezTo>
                    <a:pt x="831" y="33"/>
                    <a:pt x="806" y="36"/>
                    <a:pt x="794" y="41"/>
                  </a:cubicBezTo>
                  <a:cubicBezTo>
                    <a:pt x="789" y="43"/>
                    <a:pt x="785" y="47"/>
                    <a:pt x="783" y="52"/>
                  </a:cubicBezTo>
                  <a:cubicBezTo>
                    <a:pt x="779" y="58"/>
                    <a:pt x="776" y="77"/>
                    <a:pt x="775" y="107"/>
                  </a:cubicBezTo>
                  <a:cubicBezTo>
                    <a:pt x="773" y="153"/>
                    <a:pt x="772" y="193"/>
                    <a:pt x="772" y="226"/>
                  </a:cubicBezTo>
                  <a:cubicBezTo>
                    <a:pt x="772" y="479"/>
                    <a:pt x="772" y="479"/>
                    <a:pt x="772" y="479"/>
                  </a:cubicBezTo>
                  <a:cubicBezTo>
                    <a:pt x="772" y="531"/>
                    <a:pt x="773" y="626"/>
                    <a:pt x="775" y="766"/>
                  </a:cubicBezTo>
                  <a:cubicBezTo>
                    <a:pt x="721" y="766"/>
                    <a:pt x="721" y="766"/>
                    <a:pt x="721" y="766"/>
                  </a:cubicBezTo>
                  <a:cubicBezTo>
                    <a:pt x="707" y="752"/>
                    <a:pt x="707" y="752"/>
                    <a:pt x="707" y="752"/>
                  </a:cubicBezTo>
                  <a:cubicBezTo>
                    <a:pt x="705" y="751"/>
                    <a:pt x="700" y="746"/>
                    <a:pt x="698" y="744"/>
                  </a:cubicBezTo>
                  <a:cubicBezTo>
                    <a:pt x="696" y="742"/>
                    <a:pt x="689" y="735"/>
                    <a:pt x="678" y="723"/>
                  </a:cubicBezTo>
                  <a:cubicBezTo>
                    <a:pt x="647" y="689"/>
                    <a:pt x="625" y="664"/>
                    <a:pt x="611" y="647"/>
                  </a:cubicBezTo>
                  <a:cubicBezTo>
                    <a:pt x="540" y="560"/>
                    <a:pt x="540" y="560"/>
                    <a:pt x="540" y="560"/>
                  </a:cubicBezTo>
                  <a:cubicBezTo>
                    <a:pt x="151" y="110"/>
                    <a:pt x="151" y="110"/>
                    <a:pt x="151" y="110"/>
                  </a:cubicBezTo>
                  <a:cubicBezTo>
                    <a:pt x="151" y="518"/>
                    <a:pt x="151" y="518"/>
                    <a:pt x="151" y="518"/>
                  </a:cubicBezTo>
                  <a:cubicBezTo>
                    <a:pt x="151" y="552"/>
                    <a:pt x="152" y="593"/>
                    <a:pt x="154" y="641"/>
                  </a:cubicBezTo>
                  <a:cubicBezTo>
                    <a:pt x="156" y="670"/>
                    <a:pt x="158" y="688"/>
                    <a:pt x="161" y="695"/>
                  </a:cubicBezTo>
                  <a:cubicBezTo>
                    <a:pt x="164" y="700"/>
                    <a:pt x="168" y="704"/>
                    <a:pt x="173" y="705"/>
                  </a:cubicBezTo>
                  <a:cubicBezTo>
                    <a:pt x="185" y="711"/>
                    <a:pt x="210" y="714"/>
                    <a:pt x="249" y="714"/>
                  </a:cubicBezTo>
                  <a:cubicBezTo>
                    <a:pt x="249" y="747"/>
                    <a:pt x="249" y="747"/>
                    <a:pt x="249" y="747"/>
                  </a:cubicBezTo>
                  <a:cubicBezTo>
                    <a:pt x="217" y="745"/>
                    <a:pt x="181" y="744"/>
                    <a:pt x="143" y="744"/>
                  </a:cubicBezTo>
                  <a:cubicBezTo>
                    <a:pt x="100" y="744"/>
                    <a:pt x="54" y="745"/>
                    <a:pt x="5"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6" name="Freeform 9"/>
            <p:cNvSpPr>
              <a:spLocks/>
            </p:cNvSpPr>
            <p:nvPr userDrawn="1"/>
          </p:nvSpPr>
          <p:spPr bwMode="auto">
            <a:xfrm>
              <a:off x="1573213" y="1003301"/>
              <a:ext cx="101600" cy="236538"/>
            </a:xfrm>
            <a:custGeom>
              <a:avLst/>
              <a:gdLst>
                <a:gd name="T0" fmla="*/ 322 w 322"/>
                <a:gd name="T1" fmla="*/ 714 h 747"/>
                <a:gd name="T2" fmla="*/ 322 w 322"/>
                <a:gd name="T3" fmla="*/ 747 h 747"/>
                <a:gd name="T4" fmla="*/ 169 w 322"/>
                <a:gd name="T5" fmla="*/ 744 h 747"/>
                <a:gd name="T6" fmla="*/ 0 w 322"/>
                <a:gd name="T7" fmla="*/ 747 h 747"/>
                <a:gd name="T8" fmla="*/ 0 w 322"/>
                <a:gd name="T9" fmla="*/ 714 h 747"/>
                <a:gd name="T10" fmla="*/ 79 w 322"/>
                <a:gd name="T11" fmla="*/ 708 h 747"/>
                <a:gd name="T12" fmla="*/ 98 w 322"/>
                <a:gd name="T13" fmla="*/ 696 h 747"/>
                <a:gd name="T14" fmla="*/ 106 w 322"/>
                <a:gd name="T15" fmla="*/ 645 h 747"/>
                <a:gd name="T16" fmla="*/ 109 w 322"/>
                <a:gd name="T17" fmla="*/ 495 h 747"/>
                <a:gd name="T18" fmla="*/ 109 w 322"/>
                <a:gd name="T19" fmla="*/ 251 h 747"/>
                <a:gd name="T20" fmla="*/ 106 w 322"/>
                <a:gd name="T21" fmla="*/ 111 h 747"/>
                <a:gd name="T22" fmla="*/ 98 w 322"/>
                <a:gd name="T23" fmla="*/ 52 h 747"/>
                <a:gd name="T24" fmla="*/ 78 w 322"/>
                <a:gd name="T25" fmla="*/ 39 h 747"/>
                <a:gd name="T26" fmla="*/ 0 w 322"/>
                <a:gd name="T27" fmla="*/ 33 h 747"/>
                <a:gd name="T28" fmla="*/ 0 w 322"/>
                <a:gd name="T29" fmla="*/ 0 h 747"/>
                <a:gd name="T30" fmla="*/ 161 w 322"/>
                <a:gd name="T31" fmla="*/ 3 h 747"/>
                <a:gd name="T32" fmla="*/ 322 w 322"/>
                <a:gd name="T33" fmla="*/ 0 h 747"/>
                <a:gd name="T34" fmla="*/ 322 w 322"/>
                <a:gd name="T35" fmla="*/ 33 h 747"/>
                <a:gd name="T36" fmla="*/ 244 w 322"/>
                <a:gd name="T37" fmla="*/ 39 h 747"/>
                <a:gd name="T38" fmla="*/ 224 w 322"/>
                <a:gd name="T39" fmla="*/ 51 h 747"/>
                <a:gd name="T40" fmla="*/ 216 w 322"/>
                <a:gd name="T41" fmla="*/ 102 h 747"/>
                <a:gd name="T42" fmla="*/ 213 w 322"/>
                <a:gd name="T43" fmla="*/ 251 h 747"/>
                <a:gd name="T44" fmla="*/ 213 w 322"/>
                <a:gd name="T45" fmla="*/ 495 h 747"/>
                <a:gd name="T46" fmla="*/ 215 w 322"/>
                <a:gd name="T47" fmla="*/ 635 h 747"/>
                <a:gd name="T48" fmla="*/ 223 w 322"/>
                <a:gd name="T49" fmla="*/ 694 h 747"/>
                <a:gd name="T50" fmla="*/ 243 w 322"/>
                <a:gd name="T51" fmla="*/ 708 h 747"/>
                <a:gd name="T52" fmla="*/ 322 w 322"/>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2" h="747">
                  <a:moveTo>
                    <a:pt x="322" y="714"/>
                  </a:moveTo>
                  <a:cubicBezTo>
                    <a:pt x="322" y="747"/>
                    <a:pt x="322" y="747"/>
                    <a:pt x="322" y="747"/>
                  </a:cubicBezTo>
                  <a:cubicBezTo>
                    <a:pt x="244" y="745"/>
                    <a:pt x="193" y="744"/>
                    <a:pt x="169" y="744"/>
                  </a:cubicBezTo>
                  <a:cubicBezTo>
                    <a:pt x="0" y="747"/>
                    <a:pt x="0" y="747"/>
                    <a:pt x="0" y="747"/>
                  </a:cubicBezTo>
                  <a:cubicBezTo>
                    <a:pt x="0" y="714"/>
                    <a:pt x="0" y="714"/>
                    <a:pt x="0" y="714"/>
                  </a:cubicBezTo>
                  <a:cubicBezTo>
                    <a:pt x="43" y="713"/>
                    <a:pt x="69" y="711"/>
                    <a:pt x="79" y="708"/>
                  </a:cubicBezTo>
                  <a:cubicBezTo>
                    <a:pt x="88" y="705"/>
                    <a:pt x="94" y="701"/>
                    <a:pt x="98" y="696"/>
                  </a:cubicBezTo>
                  <a:cubicBezTo>
                    <a:pt x="102" y="689"/>
                    <a:pt x="105" y="672"/>
                    <a:pt x="106" y="645"/>
                  </a:cubicBezTo>
                  <a:cubicBezTo>
                    <a:pt x="107" y="637"/>
                    <a:pt x="108" y="587"/>
                    <a:pt x="109" y="495"/>
                  </a:cubicBezTo>
                  <a:cubicBezTo>
                    <a:pt x="109" y="251"/>
                    <a:pt x="109" y="251"/>
                    <a:pt x="109" y="251"/>
                  </a:cubicBezTo>
                  <a:cubicBezTo>
                    <a:pt x="109" y="204"/>
                    <a:pt x="108" y="157"/>
                    <a:pt x="106" y="111"/>
                  </a:cubicBezTo>
                  <a:cubicBezTo>
                    <a:pt x="105" y="78"/>
                    <a:pt x="102" y="59"/>
                    <a:pt x="98" y="52"/>
                  </a:cubicBezTo>
                  <a:cubicBezTo>
                    <a:pt x="94" y="46"/>
                    <a:pt x="88" y="41"/>
                    <a:pt x="78" y="39"/>
                  </a:cubicBezTo>
                  <a:cubicBezTo>
                    <a:pt x="69" y="36"/>
                    <a:pt x="43" y="34"/>
                    <a:pt x="0" y="33"/>
                  </a:cubicBezTo>
                  <a:cubicBezTo>
                    <a:pt x="0" y="0"/>
                    <a:pt x="0" y="0"/>
                    <a:pt x="0" y="0"/>
                  </a:cubicBezTo>
                  <a:cubicBezTo>
                    <a:pt x="70" y="2"/>
                    <a:pt x="124" y="3"/>
                    <a:pt x="161" y="3"/>
                  </a:cubicBezTo>
                  <a:cubicBezTo>
                    <a:pt x="198" y="3"/>
                    <a:pt x="251" y="2"/>
                    <a:pt x="322" y="0"/>
                  </a:cubicBezTo>
                  <a:cubicBezTo>
                    <a:pt x="322" y="33"/>
                    <a:pt x="322" y="33"/>
                    <a:pt x="322" y="33"/>
                  </a:cubicBezTo>
                  <a:cubicBezTo>
                    <a:pt x="279" y="34"/>
                    <a:pt x="253" y="36"/>
                    <a:pt x="244" y="39"/>
                  </a:cubicBezTo>
                  <a:cubicBezTo>
                    <a:pt x="234" y="41"/>
                    <a:pt x="228" y="46"/>
                    <a:pt x="224" y="51"/>
                  </a:cubicBezTo>
                  <a:cubicBezTo>
                    <a:pt x="220" y="58"/>
                    <a:pt x="217" y="75"/>
                    <a:pt x="216" y="102"/>
                  </a:cubicBezTo>
                  <a:cubicBezTo>
                    <a:pt x="216" y="109"/>
                    <a:pt x="215" y="159"/>
                    <a:pt x="213" y="251"/>
                  </a:cubicBezTo>
                  <a:cubicBezTo>
                    <a:pt x="213" y="495"/>
                    <a:pt x="213" y="495"/>
                    <a:pt x="213" y="495"/>
                  </a:cubicBezTo>
                  <a:cubicBezTo>
                    <a:pt x="213" y="543"/>
                    <a:pt x="214" y="589"/>
                    <a:pt x="215" y="635"/>
                  </a:cubicBezTo>
                  <a:cubicBezTo>
                    <a:pt x="216" y="668"/>
                    <a:pt x="219" y="688"/>
                    <a:pt x="223" y="694"/>
                  </a:cubicBezTo>
                  <a:cubicBezTo>
                    <a:pt x="227" y="700"/>
                    <a:pt x="234" y="705"/>
                    <a:pt x="243" y="708"/>
                  </a:cubicBezTo>
                  <a:cubicBezTo>
                    <a:pt x="252" y="711"/>
                    <a:pt x="278" y="713"/>
                    <a:pt x="322"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7" name="Freeform 10"/>
            <p:cNvSpPr>
              <a:spLocks/>
            </p:cNvSpPr>
            <p:nvPr userDrawn="1"/>
          </p:nvSpPr>
          <p:spPr bwMode="auto">
            <a:xfrm>
              <a:off x="1692275" y="998538"/>
              <a:ext cx="231775" cy="246063"/>
            </a:xfrm>
            <a:custGeom>
              <a:avLst/>
              <a:gdLst>
                <a:gd name="T0" fmla="*/ 728 w 728"/>
                <a:gd name="T1" fmla="*/ 667 h 774"/>
                <a:gd name="T2" fmla="*/ 707 w 728"/>
                <a:gd name="T3" fmla="*/ 716 h 774"/>
                <a:gd name="T4" fmla="*/ 581 w 728"/>
                <a:gd name="T5" fmla="*/ 761 h 774"/>
                <a:gd name="T6" fmla="*/ 447 w 728"/>
                <a:gd name="T7" fmla="*/ 774 h 774"/>
                <a:gd name="T8" fmla="*/ 288 w 728"/>
                <a:gd name="T9" fmla="*/ 754 h 774"/>
                <a:gd name="T10" fmla="*/ 161 w 728"/>
                <a:gd name="T11" fmla="*/ 696 h 774"/>
                <a:gd name="T12" fmla="*/ 71 w 728"/>
                <a:gd name="T13" fmla="*/ 610 h 774"/>
                <a:gd name="T14" fmla="*/ 18 w 728"/>
                <a:gd name="T15" fmla="*/ 508 h 774"/>
                <a:gd name="T16" fmla="*/ 0 w 728"/>
                <a:gd name="T17" fmla="*/ 386 h 774"/>
                <a:gd name="T18" fmla="*/ 123 w 728"/>
                <a:gd name="T19" fmla="*/ 110 h 774"/>
                <a:gd name="T20" fmla="*/ 457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5 w 728"/>
                <a:gd name="T35" fmla="*/ 143 h 774"/>
                <a:gd name="T36" fmla="*/ 605 w 728"/>
                <a:gd name="T37" fmla="*/ 66 h 774"/>
                <a:gd name="T38" fmla="*/ 446 w 728"/>
                <a:gd name="T39" fmla="*/ 41 h 774"/>
                <a:gd name="T40" fmla="*/ 313 w 728"/>
                <a:gd name="T41" fmla="*/ 60 h 774"/>
                <a:gd name="T42" fmla="*/ 217 w 728"/>
                <a:gd name="T43" fmla="*/ 117 h 774"/>
                <a:gd name="T44" fmla="*/ 149 w 728"/>
                <a:gd name="T45" fmla="*/ 216 h 774"/>
                <a:gd name="T46" fmla="*/ 122 w 728"/>
                <a:gd name="T47" fmla="*/ 366 h 774"/>
                <a:gd name="T48" fmla="*/ 223 w 728"/>
                <a:gd name="T49" fmla="*/ 621 h 774"/>
                <a:gd name="T50" fmla="*/ 492 w 728"/>
                <a:gd name="T51" fmla="*/ 717 h 774"/>
                <a:gd name="T52" fmla="*/ 632 w 728"/>
                <a:gd name="T53" fmla="*/ 698 h 774"/>
                <a:gd name="T54" fmla="*/ 719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7" y="716"/>
                    <a:pt x="707" y="716"/>
                    <a:pt x="707" y="716"/>
                  </a:cubicBezTo>
                  <a:cubicBezTo>
                    <a:pt x="664" y="736"/>
                    <a:pt x="622" y="751"/>
                    <a:pt x="581" y="761"/>
                  </a:cubicBezTo>
                  <a:cubicBezTo>
                    <a:pt x="540" y="770"/>
                    <a:pt x="495" y="774"/>
                    <a:pt x="447" y="774"/>
                  </a:cubicBezTo>
                  <a:cubicBezTo>
                    <a:pt x="390" y="774"/>
                    <a:pt x="337" y="768"/>
                    <a:pt x="288" y="754"/>
                  </a:cubicBezTo>
                  <a:cubicBezTo>
                    <a:pt x="240" y="740"/>
                    <a:pt x="197" y="721"/>
                    <a:pt x="161" y="696"/>
                  </a:cubicBezTo>
                  <a:cubicBezTo>
                    <a:pt x="124" y="670"/>
                    <a:pt x="94" y="642"/>
                    <a:pt x="71" y="610"/>
                  </a:cubicBezTo>
                  <a:cubicBezTo>
                    <a:pt x="48" y="579"/>
                    <a:pt x="31" y="545"/>
                    <a:pt x="18" y="508"/>
                  </a:cubicBezTo>
                  <a:cubicBezTo>
                    <a:pt x="6" y="471"/>
                    <a:pt x="0" y="430"/>
                    <a:pt x="0" y="386"/>
                  </a:cubicBezTo>
                  <a:cubicBezTo>
                    <a:pt x="0" y="275"/>
                    <a:pt x="41" y="183"/>
                    <a:pt x="123" y="110"/>
                  </a:cubicBezTo>
                  <a:cubicBezTo>
                    <a:pt x="204" y="37"/>
                    <a:pt x="316" y="0"/>
                    <a:pt x="457" y="0"/>
                  </a:cubicBezTo>
                  <a:cubicBezTo>
                    <a:pt x="490" y="0"/>
                    <a:pt x="521" y="2"/>
                    <a:pt x="549" y="6"/>
                  </a:cubicBezTo>
                  <a:cubicBezTo>
                    <a:pt x="578"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5" y="143"/>
                    <a:pt x="665" y="143"/>
                    <a:pt x="665" y="143"/>
                  </a:cubicBezTo>
                  <a:cubicBezTo>
                    <a:pt x="661" y="109"/>
                    <a:pt x="641" y="83"/>
                    <a:pt x="605" y="66"/>
                  </a:cubicBezTo>
                  <a:cubicBezTo>
                    <a:pt x="569" y="50"/>
                    <a:pt x="516" y="41"/>
                    <a:pt x="446" y="41"/>
                  </a:cubicBezTo>
                  <a:cubicBezTo>
                    <a:pt x="393" y="42"/>
                    <a:pt x="349" y="48"/>
                    <a:pt x="313" y="60"/>
                  </a:cubicBezTo>
                  <a:cubicBezTo>
                    <a:pt x="277" y="72"/>
                    <a:pt x="245" y="91"/>
                    <a:pt x="217" y="117"/>
                  </a:cubicBezTo>
                  <a:cubicBezTo>
                    <a:pt x="189" y="143"/>
                    <a:pt x="166" y="176"/>
                    <a:pt x="149" y="216"/>
                  </a:cubicBezTo>
                  <a:cubicBezTo>
                    <a:pt x="131" y="256"/>
                    <a:pt x="122" y="306"/>
                    <a:pt x="122" y="366"/>
                  </a:cubicBezTo>
                  <a:cubicBezTo>
                    <a:pt x="122" y="472"/>
                    <a:pt x="155" y="557"/>
                    <a:pt x="223" y="621"/>
                  </a:cubicBezTo>
                  <a:cubicBezTo>
                    <a:pt x="291" y="685"/>
                    <a:pt x="380" y="717"/>
                    <a:pt x="492" y="717"/>
                  </a:cubicBezTo>
                  <a:cubicBezTo>
                    <a:pt x="542" y="717"/>
                    <a:pt x="589" y="711"/>
                    <a:pt x="632" y="698"/>
                  </a:cubicBezTo>
                  <a:cubicBezTo>
                    <a:pt x="661" y="689"/>
                    <a:pt x="690" y="675"/>
                    <a:pt x="719"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8" name="Freeform 11"/>
            <p:cNvSpPr>
              <a:spLocks/>
            </p:cNvSpPr>
            <p:nvPr userDrawn="1"/>
          </p:nvSpPr>
          <p:spPr bwMode="auto">
            <a:xfrm>
              <a:off x="657225" y="998538"/>
              <a:ext cx="231775" cy="246063"/>
            </a:xfrm>
            <a:custGeom>
              <a:avLst/>
              <a:gdLst>
                <a:gd name="T0" fmla="*/ 728 w 728"/>
                <a:gd name="T1" fmla="*/ 667 h 774"/>
                <a:gd name="T2" fmla="*/ 706 w 728"/>
                <a:gd name="T3" fmla="*/ 716 h 774"/>
                <a:gd name="T4" fmla="*/ 580 w 728"/>
                <a:gd name="T5" fmla="*/ 761 h 774"/>
                <a:gd name="T6" fmla="*/ 446 w 728"/>
                <a:gd name="T7" fmla="*/ 774 h 774"/>
                <a:gd name="T8" fmla="*/ 288 w 728"/>
                <a:gd name="T9" fmla="*/ 754 h 774"/>
                <a:gd name="T10" fmla="*/ 160 w 728"/>
                <a:gd name="T11" fmla="*/ 696 h 774"/>
                <a:gd name="T12" fmla="*/ 71 w 728"/>
                <a:gd name="T13" fmla="*/ 610 h 774"/>
                <a:gd name="T14" fmla="*/ 18 w 728"/>
                <a:gd name="T15" fmla="*/ 508 h 774"/>
                <a:gd name="T16" fmla="*/ 0 w 728"/>
                <a:gd name="T17" fmla="*/ 386 h 774"/>
                <a:gd name="T18" fmla="*/ 122 w 728"/>
                <a:gd name="T19" fmla="*/ 110 h 774"/>
                <a:gd name="T20" fmla="*/ 456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4 w 728"/>
                <a:gd name="T35" fmla="*/ 143 h 774"/>
                <a:gd name="T36" fmla="*/ 604 w 728"/>
                <a:gd name="T37" fmla="*/ 66 h 774"/>
                <a:gd name="T38" fmla="*/ 445 w 728"/>
                <a:gd name="T39" fmla="*/ 41 h 774"/>
                <a:gd name="T40" fmla="*/ 313 w 728"/>
                <a:gd name="T41" fmla="*/ 60 h 774"/>
                <a:gd name="T42" fmla="*/ 216 w 728"/>
                <a:gd name="T43" fmla="*/ 117 h 774"/>
                <a:gd name="T44" fmla="*/ 148 w 728"/>
                <a:gd name="T45" fmla="*/ 216 h 774"/>
                <a:gd name="T46" fmla="*/ 121 w 728"/>
                <a:gd name="T47" fmla="*/ 366 h 774"/>
                <a:gd name="T48" fmla="*/ 223 w 728"/>
                <a:gd name="T49" fmla="*/ 621 h 774"/>
                <a:gd name="T50" fmla="*/ 492 w 728"/>
                <a:gd name="T51" fmla="*/ 717 h 774"/>
                <a:gd name="T52" fmla="*/ 631 w 728"/>
                <a:gd name="T53" fmla="*/ 698 h 774"/>
                <a:gd name="T54" fmla="*/ 718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6" y="716"/>
                    <a:pt x="706" y="716"/>
                    <a:pt x="706" y="716"/>
                  </a:cubicBezTo>
                  <a:cubicBezTo>
                    <a:pt x="663" y="736"/>
                    <a:pt x="621" y="751"/>
                    <a:pt x="580" y="761"/>
                  </a:cubicBezTo>
                  <a:cubicBezTo>
                    <a:pt x="539" y="770"/>
                    <a:pt x="495" y="774"/>
                    <a:pt x="446" y="774"/>
                  </a:cubicBezTo>
                  <a:cubicBezTo>
                    <a:pt x="389" y="774"/>
                    <a:pt x="337" y="768"/>
                    <a:pt x="288" y="754"/>
                  </a:cubicBezTo>
                  <a:cubicBezTo>
                    <a:pt x="239" y="740"/>
                    <a:pt x="197" y="721"/>
                    <a:pt x="160" y="696"/>
                  </a:cubicBezTo>
                  <a:cubicBezTo>
                    <a:pt x="124" y="670"/>
                    <a:pt x="94" y="642"/>
                    <a:pt x="71" y="610"/>
                  </a:cubicBezTo>
                  <a:cubicBezTo>
                    <a:pt x="48" y="579"/>
                    <a:pt x="30" y="545"/>
                    <a:pt x="18" y="508"/>
                  </a:cubicBezTo>
                  <a:cubicBezTo>
                    <a:pt x="6" y="471"/>
                    <a:pt x="0" y="430"/>
                    <a:pt x="0" y="386"/>
                  </a:cubicBezTo>
                  <a:cubicBezTo>
                    <a:pt x="0" y="275"/>
                    <a:pt x="41" y="183"/>
                    <a:pt x="122" y="110"/>
                  </a:cubicBezTo>
                  <a:cubicBezTo>
                    <a:pt x="204" y="37"/>
                    <a:pt x="315" y="0"/>
                    <a:pt x="456" y="0"/>
                  </a:cubicBezTo>
                  <a:cubicBezTo>
                    <a:pt x="490" y="0"/>
                    <a:pt x="520" y="2"/>
                    <a:pt x="549" y="6"/>
                  </a:cubicBezTo>
                  <a:cubicBezTo>
                    <a:pt x="577"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4" y="143"/>
                    <a:pt x="664" y="143"/>
                    <a:pt x="664" y="143"/>
                  </a:cubicBezTo>
                  <a:cubicBezTo>
                    <a:pt x="661" y="109"/>
                    <a:pt x="641" y="83"/>
                    <a:pt x="604" y="66"/>
                  </a:cubicBezTo>
                  <a:cubicBezTo>
                    <a:pt x="568" y="50"/>
                    <a:pt x="515" y="41"/>
                    <a:pt x="445" y="41"/>
                  </a:cubicBezTo>
                  <a:cubicBezTo>
                    <a:pt x="393" y="42"/>
                    <a:pt x="349" y="48"/>
                    <a:pt x="313" y="60"/>
                  </a:cubicBezTo>
                  <a:cubicBezTo>
                    <a:pt x="276" y="72"/>
                    <a:pt x="244" y="91"/>
                    <a:pt x="216" y="117"/>
                  </a:cubicBezTo>
                  <a:cubicBezTo>
                    <a:pt x="189" y="143"/>
                    <a:pt x="166" y="176"/>
                    <a:pt x="148" y="216"/>
                  </a:cubicBezTo>
                  <a:cubicBezTo>
                    <a:pt x="131" y="256"/>
                    <a:pt x="122" y="306"/>
                    <a:pt x="121" y="366"/>
                  </a:cubicBezTo>
                  <a:cubicBezTo>
                    <a:pt x="121" y="472"/>
                    <a:pt x="155" y="557"/>
                    <a:pt x="223" y="621"/>
                  </a:cubicBezTo>
                  <a:cubicBezTo>
                    <a:pt x="290" y="685"/>
                    <a:pt x="380" y="717"/>
                    <a:pt x="492" y="717"/>
                  </a:cubicBezTo>
                  <a:cubicBezTo>
                    <a:pt x="542" y="717"/>
                    <a:pt x="588" y="711"/>
                    <a:pt x="631" y="698"/>
                  </a:cubicBezTo>
                  <a:cubicBezTo>
                    <a:pt x="660" y="689"/>
                    <a:pt x="689" y="675"/>
                    <a:pt x="718"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9" name="Freeform 12"/>
            <p:cNvSpPr>
              <a:spLocks/>
            </p:cNvSpPr>
            <p:nvPr userDrawn="1"/>
          </p:nvSpPr>
          <p:spPr bwMode="auto">
            <a:xfrm>
              <a:off x="757238" y="687388"/>
              <a:ext cx="323850" cy="239713"/>
            </a:xfrm>
            <a:custGeom>
              <a:avLst/>
              <a:gdLst>
                <a:gd name="T0" fmla="*/ 0 w 1017"/>
                <a:gd name="T1" fmla="*/ 35 h 754"/>
                <a:gd name="T2" fmla="*/ 0 w 1017"/>
                <a:gd name="T3" fmla="*/ 0 h 754"/>
                <a:gd name="T4" fmla="*/ 110 w 1017"/>
                <a:gd name="T5" fmla="*/ 4 h 754"/>
                <a:gd name="T6" fmla="*/ 212 w 1017"/>
                <a:gd name="T7" fmla="*/ 0 h 754"/>
                <a:gd name="T8" fmla="*/ 300 w 1017"/>
                <a:gd name="T9" fmla="*/ 183 h 754"/>
                <a:gd name="T10" fmla="*/ 509 w 1017"/>
                <a:gd name="T11" fmla="*/ 592 h 754"/>
                <a:gd name="T12" fmla="*/ 697 w 1017"/>
                <a:gd name="T13" fmla="*/ 218 h 754"/>
                <a:gd name="T14" fmla="*/ 800 w 1017"/>
                <a:gd name="T15" fmla="*/ 0 h 754"/>
                <a:gd name="T16" fmla="*/ 898 w 1017"/>
                <a:gd name="T17" fmla="*/ 4 h 754"/>
                <a:gd name="T18" fmla="*/ 1017 w 1017"/>
                <a:gd name="T19" fmla="*/ 0 h 754"/>
                <a:gd name="T20" fmla="*/ 1017 w 1017"/>
                <a:gd name="T21" fmla="*/ 35 h 754"/>
                <a:gd name="T22" fmla="*/ 938 w 1017"/>
                <a:gd name="T23" fmla="*/ 40 h 754"/>
                <a:gd name="T24" fmla="*/ 918 w 1017"/>
                <a:gd name="T25" fmla="*/ 53 h 754"/>
                <a:gd name="T26" fmla="*/ 910 w 1017"/>
                <a:gd name="T27" fmla="*/ 103 h 754"/>
                <a:gd name="T28" fmla="*/ 907 w 1017"/>
                <a:gd name="T29" fmla="*/ 251 h 754"/>
                <a:gd name="T30" fmla="*/ 907 w 1017"/>
                <a:gd name="T31" fmla="*/ 492 h 754"/>
                <a:gd name="T32" fmla="*/ 910 w 1017"/>
                <a:gd name="T33" fmla="*/ 631 h 754"/>
                <a:gd name="T34" fmla="*/ 918 w 1017"/>
                <a:gd name="T35" fmla="*/ 690 h 754"/>
                <a:gd name="T36" fmla="*/ 938 w 1017"/>
                <a:gd name="T37" fmla="*/ 704 h 754"/>
                <a:gd name="T38" fmla="*/ 1017 w 1017"/>
                <a:gd name="T39" fmla="*/ 709 h 754"/>
                <a:gd name="T40" fmla="*/ 1017 w 1017"/>
                <a:gd name="T41" fmla="*/ 743 h 754"/>
                <a:gd name="T42" fmla="*/ 861 w 1017"/>
                <a:gd name="T43" fmla="*/ 739 h 754"/>
                <a:gd name="T44" fmla="*/ 699 w 1017"/>
                <a:gd name="T45" fmla="*/ 743 h 754"/>
                <a:gd name="T46" fmla="*/ 699 w 1017"/>
                <a:gd name="T47" fmla="*/ 709 h 754"/>
                <a:gd name="T48" fmla="*/ 778 w 1017"/>
                <a:gd name="T49" fmla="*/ 704 h 754"/>
                <a:gd name="T50" fmla="*/ 797 w 1017"/>
                <a:gd name="T51" fmla="*/ 691 h 754"/>
                <a:gd name="T52" fmla="*/ 806 w 1017"/>
                <a:gd name="T53" fmla="*/ 641 h 754"/>
                <a:gd name="T54" fmla="*/ 808 w 1017"/>
                <a:gd name="T55" fmla="*/ 492 h 754"/>
                <a:gd name="T56" fmla="*/ 808 w 1017"/>
                <a:gd name="T57" fmla="*/ 108 h 754"/>
                <a:gd name="T58" fmla="*/ 619 w 1017"/>
                <a:gd name="T59" fmla="*/ 486 h 754"/>
                <a:gd name="T60" fmla="*/ 549 w 1017"/>
                <a:gd name="T61" fmla="*/ 629 h 754"/>
                <a:gd name="T62" fmla="*/ 494 w 1017"/>
                <a:gd name="T63" fmla="*/ 754 h 754"/>
                <a:gd name="T64" fmla="*/ 472 w 1017"/>
                <a:gd name="T65" fmla="*/ 754 h 754"/>
                <a:gd name="T66" fmla="*/ 459 w 1017"/>
                <a:gd name="T67" fmla="*/ 722 h 754"/>
                <a:gd name="T68" fmla="*/ 422 w 1017"/>
                <a:gd name="T69" fmla="*/ 645 h 754"/>
                <a:gd name="T70" fmla="*/ 159 w 1017"/>
                <a:gd name="T71" fmla="*/ 126 h 754"/>
                <a:gd name="T72" fmla="*/ 159 w 1017"/>
                <a:gd name="T73" fmla="*/ 492 h 754"/>
                <a:gd name="T74" fmla="*/ 163 w 1017"/>
                <a:gd name="T75" fmla="*/ 631 h 754"/>
                <a:gd name="T76" fmla="*/ 171 w 1017"/>
                <a:gd name="T77" fmla="*/ 690 h 754"/>
                <a:gd name="T78" fmla="*/ 191 w 1017"/>
                <a:gd name="T79" fmla="*/ 704 h 754"/>
                <a:gd name="T80" fmla="*/ 271 w 1017"/>
                <a:gd name="T81" fmla="*/ 709 h 754"/>
                <a:gd name="T82" fmla="*/ 271 w 1017"/>
                <a:gd name="T83" fmla="*/ 743 h 754"/>
                <a:gd name="T84" fmla="*/ 138 w 1017"/>
                <a:gd name="T85" fmla="*/ 739 h 754"/>
                <a:gd name="T86" fmla="*/ 0 w 1017"/>
                <a:gd name="T87" fmla="*/ 743 h 754"/>
                <a:gd name="T88" fmla="*/ 0 w 1017"/>
                <a:gd name="T89" fmla="*/ 709 h 754"/>
                <a:gd name="T90" fmla="*/ 79 w 1017"/>
                <a:gd name="T91" fmla="*/ 704 h 754"/>
                <a:gd name="T92" fmla="*/ 98 w 1017"/>
                <a:gd name="T93" fmla="*/ 691 h 754"/>
                <a:gd name="T94" fmla="*/ 107 w 1017"/>
                <a:gd name="T95" fmla="*/ 641 h 754"/>
                <a:gd name="T96" fmla="*/ 109 w 1017"/>
                <a:gd name="T97" fmla="*/ 492 h 754"/>
                <a:gd name="T98" fmla="*/ 109 w 1017"/>
                <a:gd name="T99" fmla="*/ 251 h 754"/>
                <a:gd name="T100" fmla="*/ 107 w 1017"/>
                <a:gd name="T101" fmla="*/ 112 h 754"/>
                <a:gd name="T102" fmla="*/ 99 w 1017"/>
                <a:gd name="T103" fmla="*/ 54 h 754"/>
                <a:gd name="T104" fmla="*/ 78 w 1017"/>
                <a:gd name="T105" fmla="*/ 40 h 754"/>
                <a:gd name="T106" fmla="*/ 0 w 1017"/>
                <a:gd name="T107" fmla="*/ 35 h 75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Lst>
              <a:rect l="0" t="0" r="r" b="b"/>
              <a:pathLst>
                <a:path w="1017" h="754">
                  <a:moveTo>
                    <a:pt x="0" y="35"/>
                  </a:moveTo>
                  <a:cubicBezTo>
                    <a:pt x="0" y="0"/>
                    <a:pt x="0" y="0"/>
                    <a:pt x="0" y="0"/>
                  </a:cubicBezTo>
                  <a:cubicBezTo>
                    <a:pt x="38" y="2"/>
                    <a:pt x="75" y="4"/>
                    <a:pt x="110" y="4"/>
                  </a:cubicBezTo>
                  <a:cubicBezTo>
                    <a:pt x="145" y="4"/>
                    <a:pt x="179" y="2"/>
                    <a:pt x="212" y="0"/>
                  </a:cubicBezTo>
                  <a:cubicBezTo>
                    <a:pt x="244" y="70"/>
                    <a:pt x="274" y="131"/>
                    <a:pt x="300" y="183"/>
                  </a:cubicBezTo>
                  <a:cubicBezTo>
                    <a:pt x="509" y="592"/>
                    <a:pt x="509" y="592"/>
                    <a:pt x="509" y="592"/>
                  </a:cubicBezTo>
                  <a:cubicBezTo>
                    <a:pt x="697" y="218"/>
                    <a:pt x="697" y="218"/>
                    <a:pt x="697" y="218"/>
                  </a:cubicBezTo>
                  <a:cubicBezTo>
                    <a:pt x="749" y="116"/>
                    <a:pt x="783" y="43"/>
                    <a:pt x="800" y="0"/>
                  </a:cubicBezTo>
                  <a:cubicBezTo>
                    <a:pt x="839" y="2"/>
                    <a:pt x="872" y="4"/>
                    <a:pt x="898" y="4"/>
                  </a:cubicBezTo>
                  <a:cubicBezTo>
                    <a:pt x="923" y="4"/>
                    <a:pt x="962" y="2"/>
                    <a:pt x="1017" y="0"/>
                  </a:cubicBezTo>
                  <a:cubicBezTo>
                    <a:pt x="1017" y="35"/>
                    <a:pt x="1017" y="35"/>
                    <a:pt x="1017" y="35"/>
                  </a:cubicBezTo>
                  <a:cubicBezTo>
                    <a:pt x="974" y="35"/>
                    <a:pt x="947" y="37"/>
                    <a:pt x="938" y="40"/>
                  </a:cubicBezTo>
                  <a:cubicBezTo>
                    <a:pt x="928" y="43"/>
                    <a:pt x="922" y="47"/>
                    <a:pt x="918" y="53"/>
                  </a:cubicBezTo>
                  <a:cubicBezTo>
                    <a:pt x="914" y="60"/>
                    <a:pt x="911" y="76"/>
                    <a:pt x="910" y="103"/>
                  </a:cubicBezTo>
                  <a:cubicBezTo>
                    <a:pt x="910" y="110"/>
                    <a:pt x="909" y="159"/>
                    <a:pt x="907" y="251"/>
                  </a:cubicBezTo>
                  <a:cubicBezTo>
                    <a:pt x="907" y="492"/>
                    <a:pt x="907" y="492"/>
                    <a:pt x="907" y="492"/>
                  </a:cubicBezTo>
                  <a:cubicBezTo>
                    <a:pt x="907" y="540"/>
                    <a:pt x="908" y="586"/>
                    <a:pt x="910" y="631"/>
                  </a:cubicBezTo>
                  <a:cubicBezTo>
                    <a:pt x="911" y="664"/>
                    <a:pt x="914" y="684"/>
                    <a:pt x="918" y="690"/>
                  </a:cubicBezTo>
                  <a:cubicBezTo>
                    <a:pt x="922" y="696"/>
                    <a:pt x="929" y="701"/>
                    <a:pt x="938" y="704"/>
                  </a:cubicBezTo>
                  <a:cubicBezTo>
                    <a:pt x="948" y="707"/>
                    <a:pt x="974" y="709"/>
                    <a:pt x="1017" y="709"/>
                  </a:cubicBezTo>
                  <a:cubicBezTo>
                    <a:pt x="1017" y="743"/>
                    <a:pt x="1017" y="743"/>
                    <a:pt x="1017" y="743"/>
                  </a:cubicBezTo>
                  <a:cubicBezTo>
                    <a:pt x="943" y="740"/>
                    <a:pt x="891" y="739"/>
                    <a:pt x="861" y="739"/>
                  </a:cubicBezTo>
                  <a:cubicBezTo>
                    <a:pt x="837" y="739"/>
                    <a:pt x="782" y="740"/>
                    <a:pt x="699" y="743"/>
                  </a:cubicBezTo>
                  <a:cubicBezTo>
                    <a:pt x="699" y="709"/>
                    <a:pt x="699" y="709"/>
                    <a:pt x="699" y="709"/>
                  </a:cubicBezTo>
                  <a:cubicBezTo>
                    <a:pt x="742" y="709"/>
                    <a:pt x="768" y="707"/>
                    <a:pt x="778" y="704"/>
                  </a:cubicBezTo>
                  <a:cubicBezTo>
                    <a:pt x="788" y="701"/>
                    <a:pt x="794" y="697"/>
                    <a:pt x="797" y="691"/>
                  </a:cubicBezTo>
                  <a:cubicBezTo>
                    <a:pt x="802" y="684"/>
                    <a:pt x="805" y="668"/>
                    <a:pt x="806" y="641"/>
                  </a:cubicBezTo>
                  <a:cubicBezTo>
                    <a:pt x="806" y="633"/>
                    <a:pt x="807" y="584"/>
                    <a:pt x="808" y="492"/>
                  </a:cubicBezTo>
                  <a:cubicBezTo>
                    <a:pt x="808" y="108"/>
                    <a:pt x="808" y="108"/>
                    <a:pt x="808" y="108"/>
                  </a:cubicBezTo>
                  <a:cubicBezTo>
                    <a:pt x="619" y="486"/>
                    <a:pt x="619" y="486"/>
                    <a:pt x="619" y="486"/>
                  </a:cubicBezTo>
                  <a:cubicBezTo>
                    <a:pt x="589" y="545"/>
                    <a:pt x="566" y="593"/>
                    <a:pt x="549" y="629"/>
                  </a:cubicBezTo>
                  <a:cubicBezTo>
                    <a:pt x="537" y="655"/>
                    <a:pt x="518" y="696"/>
                    <a:pt x="494" y="754"/>
                  </a:cubicBezTo>
                  <a:cubicBezTo>
                    <a:pt x="472" y="754"/>
                    <a:pt x="472" y="754"/>
                    <a:pt x="472" y="754"/>
                  </a:cubicBezTo>
                  <a:cubicBezTo>
                    <a:pt x="468" y="740"/>
                    <a:pt x="463" y="729"/>
                    <a:pt x="459" y="722"/>
                  </a:cubicBezTo>
                  <a:cubicBezTo>
                    <a:pt x="422" y="645"/>
                    <a:pt x="422" y="645"/>
                    <a:pt x="422" y="645"/>
                  </a:cubicBezTo>
                  <a:cubicBezTo>
                    <a:pt x="159" y="126"/>
                    <a:pt x="159" y="126"/>
                    <a:pt x="159" y="126"/>
                  </a:cubicBezTo>
                  <a:cubicBezTo>
                    <a:pt x="159" y="492"/>
                    <a:pt x="159" y="492"/>
                    <a:pt x="159" y="492"/>
                  </a:cubicBezTo>
                  <a:cubicBezTo>
                    <a:pt x="159" y="540"/>
                    <a:pt x="160" y="586"/>
                    <a:pt x="163" y="631"/>
                  </a:cubicBezTo>
                  <a:cubicBezTo>
                    <a:pt x="164" y="664"/>
                    <a:pt x="167" y="683"/>
                    <a:pt x="171" y="690"/>
                  </a:cubicBezTo>
                  <a:cubicBezTo>
                    <a:pt x="175" y="696"/>
                    <a:pt x="182" y="701"/>
                    <a:pt x="191" y="704"/>
                  </a:cubicBezTo>
                  <a:cubicBezTo>
                    <a:pt x="200" y="707"/>
                    <a:pt x="227" y="709"/>
                    <a:pt x="271" y="709"/>
                  </a:cubicBezTo>
                  <a:cubicBezTo>
                    <a:pt x="271" y="743"/>
                    <a:pt x="271" y="743"/>
                    <a:pt x="271" y="743"/>
                  </a:cubicBezTo>
                  <a:cubicBezTo>
                    <a:pt x="138" y="739"/>
                    <a:pt x="138" y="739"/>
                    <a:pt x="138" y="739"/>
                  </a:cubicBezTo>
                  <a:cubicBezTo>
                    <a:pt x="0" y="743"/>
                    <a:pt x="0" y="743"/>
                    <a:pt x="0" y="743"/>
                  </a:cubicBezTo>
                  <a:cubicBezTo>
                    <a:pt x="0" y="709"/>
                    <a:pt x="0" y="709"/>
                    <a:pt x="0" y="709"/>
                  </a:cubicBezTo>
                  <a:cubicBezTo>
                    <a:pt x="43" y="709"/>
                    <a:pt x="69" y="707"/>
                    <a:pt x="79" y="704"/>
                  </a:cubicBezTo>
                  <a:cubicBezTo>
                    <a:pt x="88" y="701"/>
                    <a:pt x="95" y="697"/>
                    <a:pt x="98" y="691"/>
                  </a:cubicBezTo>
                  <a:cubicBezTo>
                    <a:pt x="103" y="684"/>
                    <a:pt x="105" y="668"/>
                    <a:pt x="107" y="641"/>
                  </a:cubicBezTo>
                  <a:cubicBezTo>
                    <a:pt x="107" y="634"/>
                    <a:pt x="108" y="584"/>
                    <a:pt x="109" y="492"/>
                  </a:cubicBezTo>
                  <a:cubicBezTo>
                    <a:pt x="109" y="251"/>
                    <a:pt x="109" y="251"/>
                    <a:pt x="109" y="251"/>
                  </a:cubicBezTo>
                  <a:cubicBezTo>
                    <a:pt x="109" y="204"/>
                    <a:pt x="108" y="158"/>
                    <a:pt x="107" y="112"/>
                  </a:cubicBezTo>
                  <a:cubicBezTo>
                    <a:pt x="105" y="79"/>
                    <a:pt x="103" y="60"/>
                    <a:pt x="99" y="54"/>
                  </a:cubicBezTo>
                  <a:cubicBezTo>
                    <a:pt x="94" y="48"/>
                    <a:pt x="88" y="43"/>
                    <a:pt x="78" y="40"/>
                  </a:cubicBezTo>
                  <a:cubicBezTo>
                    <a:pt x="69" y="37"/>
                    <a:pt x="43" y="35"/>
                    <a:pt x="0" y="35"/>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0" name="Freeform 13"/>
            <p:cNvSpPr>
              <a:spLocks noEditPoints="1"/>
            </p:cNvSpPr>
            <p:nvPr userDrawn="1"/>
          </p:nvSpPr>
          <p:spPr bwMode="auto">
            <a:xfrm>
              <a:off x="1092200" y="684213"/>
              <a:ext cx="263525" cy="238125"/>
            </a:xfrm>
            <a:custGeom>
              <a:avLst/>
              <a:gdLst>
                <a:gd name="T0" fmla="*/ 117 w 832"/>
                <a:gd name="T1" fmla="*/ 747 h 750"/>
                <a:gd name="T2" fmla="*/ 257 w 832"/>
                <a:gd name="T3" fmla="*/ 750 h 750"/>
                <a:gd name="T4" fmla="*/ 257 w 832"/>
                <a:gd name="T5" fmla="*/ 717 h 750"/>
                <a:gd name="T6" fmla="*/ 185 w 832"/>
                <a:gd name="T7" fmla="*/ 712 h 750"/>
                <a:gd name="T8" fmla="*/ 166 w 832"/>
                <a:gd name="T9" fmla="*/ 702 h 750"/>
                <a:gd name="T10" fmla="*/ 162 w 832"/>
                <a:gd name="T11" fmla="*/ 690 h 750"/>
                <a:gd name="T12" fmla="*/ 178 w 832"/>
                <a:gd name="T13" fmla="*/ 637 h 750"/>
                <a:gd name="T14" fmla="*/ 237 w 832"/>
                <a:gd name="T15" fmla="*/ 503 h 750"/>
                <a:gd name="T16" fmla="*/ 556 w 832"/>
                <a:gd name="T17" fmla="*/ 503 h 750"/>
                <a:gd name="T18" fmla="*/ 624 w 832"/>
                <a:gd name="T19" fmla="*/ 663 h 750"/>
                <a:gd name="T20" fmla="*/ 632 w 832"/>
                <a:gd name="T21" fmla="*/ 693 h 750"/>
                <a:gd name="T22" fmla="*/ 627 w 832"/>
                <a:gd name="T23" fmla="*/ 705 h 750"/>
                <a:gd name="T24" fmla="*/ 609 w 832"/>
                <a:gd name="T25" fmla="*/ 713 h 750"/>
                <a:gd name="T26" fmla="*/ 535 w 832"/>
                <a:gd name="T27" fmla="*/ 717 h 750"/>
                <a:gd name="T28" fmla="*/ 535 w 832"/>
                <a:gd name="T29" fmla="*/ 750 h 750"/>
                <a:gd name="T30" fmla="*/ 712 w 832"/>
                <a:gd name="T31" fmla="*/ 747 h 750"/>
                <a:gd name="T32" fmla="*/ 832 w 832"/>
                <a:gd name="T33" fmla="*/ 750 h 750"/>
                <a:gd name="T34" fmla="*/ 832 w 832"/>
                <a:gd name="T35" fmla="*/ 717 h 750"/>
                <a:gd name="T36" fmla="*/ 776 w 832"/>
                <a:gd name="T37" fmla="*/ 710 h 750"/>
                <a:gd name="T38" fmla="*/ 753 w 832"/>
                <a:gd name="T39" fmla="*/ 687 h 750"/>
                <a:gd name="T40" fmla="*/ 677 w 832"/>
                <a:gd name="T41" fmla="*/ 526 h 750"/>
                <a:gd name="T42" fmla="*/ 441 w 832"/>
                <a:gd name="T43" fmla="*/ 0 h 750"/>
                <a:gd name="T44" fmla="*/ 406 w 832"/>
                <a:gd name="T45" fmla="*/ 0 h 750"/>
                <a:gd name="T46" fmla="*/ 310 w 832"/>
                <a:gd name="T47" fmla="*/ 217 h 750"/>
                <a:gd name="T48" fmla="*/ 172 w 832"/>
                <a:gd name="T49" fmla="*/ 512 h 750"/>
                <a:gd name="T50" fmla="*/ 100 w 832"/>
                <a:gd name="T51" fmla="*/ 660 h 750"/>
                <a:gd name="T52" fmla="*/ 74 w 832"/>
                <a:gd name="T53" fmla="*/ 702 h 750"/>
                <a:gd name="T54" fmla="*/ 54 w 832"/>
                <a:gd name="T55" fmla="*/ 713 h 750"/>
                <a:gd name="T56" fmla="*/ 0 w 832"/>
                <a:gd name="T57" fmla="*/ 717 h 750"/>
                <a:gd name="T58" fmla="*/ 0 w 832"/>
                <a:gd name="T59" fmla="*/ 750 h 750"/>
                <a:gd name="T60" fmla="*/ 117 w 832"/>
                <a:gd name="T61" fmla="*/ 747 h 750"/>
                <a:gd name="T62" fmla="*/ 396 w 832"/>
                <a:gd name="T63" fmla="*/ 143 h 750"/>
                <a:gd name="T64" fmla="*/ 534 w 832"/>
                <a:gd name="T65" fmla="*/ 458 h 750"/>
                <a:gd name="T66" fmla="*/ 256 w 832"/>
                <a:gd name="T67" fmla="*/ 458 h 750"/>
                <a:gd name="T68" fmla="*/ 396 w 832"/>
                <a:gd name="T69" fmla="*/ 143 h 75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Lst>
              <a:rect l="0" t="0" r="r" b="b"/>
              <a:pathLst>
                <a:path w="832" h="750">
                  <a:moveTo>
                    <a:pt x="117" y="747"/>
                  </a:moveTo>
                  <a:cubicBezTo>
                    <a:pt x="148" y="747"/>
                    <a:pt x="195" y="748"/>
                    <a:pt x="257" y="750"/>
                  </a:cubicBezTo>
                  <a:cubicBezTo>
                    <a:pt x="257" y="717"/>
                    <a:pt x="257" y="717"/>
                    <a:pt x="257" y="717"/>
                  </a:cubicBezTo>
                  <a:cubicBezTo>
                    <a:pt x="222" y="716"/>
                    <a:pt x="199" y="715"/>
                    <a:pt x="185" y="712"/>
                  </a:cubicBezTo>
                  <a:cubicBezTo>
                    <a:pt x="177" y="710"/>
                    <a:pt x="170" y="707"/>
                    <a:pt x="166" y="702"/>
                  </a:cubicBezTo>
                  <a:cubicBezTo>
                    <a:pt x="163" y="699"/>
                    <a:pt x="162" y="695"/>
                    <a:pt x="162" y="690"/>
                  </a:cubicBezTo>
                  <a:cubicBezTo>
                    <a:pt x="162" y="679"/>
                    <a:pt x="167" y="662"/>
                    <a:pt x="178" y="637"/>
                  </a:cubicBezTo>
                  <a:cubicBezTo>
                    <a:pt x="237" y="503"/>
                    <a:pt x="237" y="503"/>
                    <a:pt x="237" y="503"/>
                  </a:cubicBezTo>
                  <a:cubicBezTo>
                    <a:pt x="556" y="503"/>
                    <a:pt x="556" y="503"/>
                    <a:pt x="556" y="503"/>
                  </a:cubicBezTo>
                  <a:cubicBezTo>
                    <a:pt x="624" y="663"/>
                    <a:pt x="624" y="663"/>
                    <a:pt x="624" y="663"/>
                  </a:cubicBezTo>
                  <a:cubicBezTo>
                    <a:pt x="629" y="675"/>
                    <a:pt x="632" y="685"/>
                    <a:pt x="632" y="693"/>
                  </a:cubicBezTo>
                  <a:cubicBezTo>
                    <a:pt x="632" y="698"/>
                    <a:pt x="630" y="702"/>
                    <a:pt x="627" y="705"/>
                  </a:cubicBezTo>
                  <a:cubicBezTo>
                    <a:pt x="624" y="708"/>
                    <a:pt x="618" y="711"/>
                    <a:pt x="609" y="713"/>
                  </a:cubicBezTo>
                  <a:cubicBezTo>
                    <a:pt x="601" y="715"/>
                    <a:pt x="576" y="716"/>
                    <a:pt x="535" y="717"/>
                  </a:cubicBezTo>
                  <a:cubicBezTo>
                    <a:pt x="535" y="750"/>
                    <a:pt x="535" y="750"/>
                    <a:pt x="535" y="750"/>
                  </a:cubicBezTo>
                  <a:cubicBezTo>
                    <a:pt x="712" y="747"/>
                    <a:pt x="712" y="747"/>
                    <a:pt x="712" y="747"/>
                  </a:cubicBezTo>
                  <a:cubicBezTo>
                    <a:pt x="734" y="747"/>
                    <a:pt x="775" y="748"/>
                    <a:pt x="832" y="750"/>
                  </a:cubicBezTo>
                  <a:cubicBezTo>
                    <a:pt x="832" y="717"/>
                    <a:pt x="832" y="717"/>
                    <a:pt x="832" y="717"/>
                  </a:cubicBezTo>
                  <a:cubicBezTo>
                    <a:pt x="803" y="716"/>
                    <a:pt x="784" y="714"/>
                    <a:pt x="776" y="710"/>
                  </a:cubicBezTo>
                  <a:cubicBezTo>
                    <a:pt x="767" y="707"/>
                    <a:pt x="760" y="699"/>
                    <a:pt x="753" y="687"/>
                  </a:cubicBezTo>
                  <a:cubicBezTo>
                    <a:pt x="740" y="664"/>
                    <a:pt x="715" y="611"/>
                    <a:pt x="677" y="526"/>
                  </a:cubicBezTo>
                  <a:cubicBezTo>
                    <a:pt x="441" y="0"/>
                    <a:pt x="441" y="0"/>
                    <a:pt x="441" y="0"/>
                  </a:cubicBezTo>
                  <a:cubicBezTo>
                    <a:pt x="406" y="0"/>
                    <a:pt x="406" y="0"/>
                    <a:pt x="406" y="0"/>
                  </a:cubicBezTo>
                  <a:cubicBezTo>
                    <a:pt x="357" y="112"/>
                    <a:pt x="325" y="185"/>
                    <a:pt x="310" y="217"/>
                  </a:cubicBezTo>
                  <a:cubicBezTo>
                    <a:pt x="172" y="512"/>
                    <a:pt x="172" y="512"/>
                    <a:pt x="172" y="512"/>
                  </a:cubicBezTo>
                  <a:cubicBezTo>
                    <a:pt x="131" y="598"/>
                    <a:pt x="107" y="647"/>
                    <a:pt x="100" y="660"/>
                  </a:cubicBezTo>
                  <a:cubicBezTo>
                    <a:pt x="89" y="683"/>
                    <a:pt x="80" y="697"/>
                    <a:pt x="74" y="702"/>
                  </a:cubicBezTo>
                  <a:cubicBezTo>
                    <a:pt x="68" y="708"/>
                    <a:pt x="61" y="711"/>
                    <a:pt x="54" y="713"/>
                  </a:cubicBezTo>
                  <a:cubicBezTo>
                    <a:pt x="47" y="715"/>
                    <a:pt x="29" y="716"/>
                    <a:pt x="0" y="717"/>
                  </a:cubicBezTo>
                  <a:cubicBezTo>
                    <a:pt x="0" y="750"/>
                    <a:pt x="0" y="750"/>
                    <a:pt x="0" y="750"/>
                  </a:cubicBezTo>
                  <a:cubicBezTo>
                    <a:pt x="42" y="748"/>
                    <a:pt x="81" y="747"/>
                    <a:pt x="117" y="747"/>
                  </a:cubicBezTo>
                  <a:close/>
                  <a:moveTo>
                    <a:pt x="396" y="143"/>
                  </a:moveTo>
                  <a:cubicBezTo>
                    <a:pt x="534" y="458"/>
                    <a:pt x="534" y="458"/>
                    <a:pt x="534" y="458"/>
                  </a:cubicBezTo>
                  <a:cubicBezTo>
                    <a:pt x="256" y="458"/>
                    <a:pt x="256" y="458"/>
                    <a:pt x="256" y="458"/>
                  </a:cubicBezTo>
                  <a:lnTo>
                    <a:pt x="396" y="143"/>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1" name="Freeform 14"/>
            <p:cNvSpPr>
              <a:spLocks/>
            </p:cNvSpPr>
            <p:nvPr userDrawn="1"/>
          </p:nvSpPr>
          <p:spPr bwMode="auto">
            <a:xfrm>
              <a:off x="1309688" y="687388"/>
              <a:ext cx="260350" cy="234950"/>
            </a:xfrm>
            <a:custGeom>
              <a:avLst/>
              <a:gdLst>
                <a:gd name="T0" fmla="*/ 601 w 817"/>
                <a:gd name="T1" fmla="*/ 111 h 743"/>
                <a:gd name="T2" fmla="*/ 634 w 817"/>
                <a:gd name="T3" fmla="*/ 52 h 743"/>
                <a:gd name="T4" fmla="*/ 624 w 817"/>
                <a:gd name="T5" fmla="*/ 39 h 743"/>
                <a:gd name="T6" fmla="*/ 543 w 817"/>
                <a:gd name="T7" fmla="*/ 33 h 743"/>
                <a:gd name="T8" fmla="*/ 543 w 817"/>
                <a:gd name="T9" fmla="*/ 0 h 743"/>
                <a:gd name="T10" fmla="*/ 688 w 817"/>
                <a:gd name="T11" fmla="*/ 3 h 743"/>
                <a:gd name="T12" fmla="*/ 817 w 817"/>
                <a:gd name="T13" fmla="*/ 0 h 743"/>
                <a:gd name="T14" fmla="*/ 817 w 817"/>
                <a:gd name="T15" fmla="*/ 33 h 743"/>
                <a:gd name="T16" fmla="*/ 746 w 817"/>
                <a:gd name="T17" fmla="*/ 39 h 743"/>
                <a:gd name="T18" fmla="*/ 718 w 817"/>
                <a:gd name="T19" fmla="*/ 51 h 743"/>
                <a:gd name="T20" fmla="*/ 675 w 817"/>
                <a:gd name="T21" fmla="*/ 102 h 743"/>
                <a:gd name="T22" fmla="*/ 514 w 817"/>
                <a:gd name="T23" fmla="*/ 333 h 743"/>
                <a:gd name="T24" fmla="*/ 461 w 817"/>
                <a:gd name="T25" fmla="*/ 422 h 743"/>
                <a:gd name="T26" fmla="*/ 455 w 817"/>
                <a:gd name="T27" fmla="*/ 453 h 743"/>
                <a:gd name="T28" fmla="*/ 455 w 817"/>
                <a:gd name="T29" fmla="*/ 493 h 743"/>
                <a:gd name="T30" fmla="*/ 459 w 817"/>
                <a:gd name="T31" fmla="*/ 631 h 743"/>
                <a:gd name="T32" fmla="*/ 466 w 817"/>
                <a:gd name="T33" fmla="*/ 690 h 743"/>
                <a:gd name="T34" fmla="*/ 486 w 817"/>
                <a:gd name="T35" fmla="*/ 704 h 743"/>
                <a:gd name="T36" fmla="*/ 564 w 817"/>
                <a:gd name="T37" fmla="*/ 710 h 743"/>
                <a:gd name="T38" fmla="*/ 564 w 817"/>
                <a:gd name="T39" fmla="*/ 743 h 743"/>
                <a:gd name="T40" fmla="*/ 410 w 817"/>
                <a:gd name="T41" fmla="*/ 740 h 743"/>
                <a:gd name="T42" fmla="*/ 244 w 817"/>
                <a:gd name="T43" fmla="*/ 743 h 743"/>
                <a:gd name="T44" fmla="*/ 244 w 817"/>
                <a:gd name="T45" fmla="*/ 710 h 743"/>
                <a:gd name="T46" fmla="*/ 322 w 817"/>
                <a:gd name="T47" fmla="*/ 704 h 743"/>
                <a:gd name="T48" fmla="*/ 341 w 817"/>
                <a:gd name="T49" fmla="*/ 692 h 743"/>
                <a:gd name="T50" fmla="*/ 350 w 817"/>
                <a:gd name="T51" fmla="*/ 641 h 743"/>
                <a:gd name="T52" fmla="*/ 353 w 817"/>
                <a:gd name="T53" fmla="*/ 493 h 743"/>
                <a:gd name="T54" fmla="*/ 353 w 817"/>
                <a:gd name="T55" fmla="*/ 432 h 743"/>
                <a:gd name="T56" fmla="*/ 331 w 817"/>
                <a:gd name="T57" fmla="*/ 390 h 743"/>
                <a:gd name="T58" fmla="*/ 275 w 817"/>
                <a:gd name="T59" fmla="*/ 300 h 743"/>
                <a:gd name="T60" fmla="*/ 135 w 817"/>
                <a:gd name="T61" fmla="*/ 102 h 743"/>
                <a:gd name="T62" fmla="*/ 96 w 817"/>
                <a:gd name="T63" fmla="*/ 51 h 743"/>
                <a:gd name="T64" fmla="*/ 69 w 817"/>
                <a:gd name="T65" fmla="*/ 39 h 743"/>
                <a:gd name="T66" fmla="*/ 0 w 817"/>
                <a:gd name="T67" fmla="*/ 33 h 743"/>
                <a:gd name="T68" fmla="*/ 0 w 817"/>
                <a:gd name="T69" fmla="*/ 0 h 743"/>
                <a:gd name="T70" fmla="*/ 130 w 817"/>
                <a:gd name="T71" fmla="*/ 3 h 743"/>
                <a:gd name="T72" fmla="*/ 333 w 817"/>
                <a:gd name="T73" fmla="*/ 0 h 743"/>
                <a:gd name="T74" fmla="*/ 333 w 817"/>
                <a:gd name="T75" fmla="*/ 33 h 743"/>
                <a:gd name="T76" fmla="*/ 246 w 817"/>
                <a:gd name="T77" fmla="*/ 39 h 743"/>
                <a:gd name="T78" fmla="*/ 234 w 817"/>
                <a:gd name="T79" fmla="*/ 52 h 743"/>
                <a:gd name="T80" fmla="*/ 262 w 817"/>
                <a:gd name="T81" fmla="*/ 111 h 743"/>
                <a:gd name="T82" fmla="*/ 426 w 817"/>
                <a:gd name="T83" fmla="*/ 376 h 743"/>
                <a:gd name="T84" fmla="*/ 601 w 817"/>
                <a:gd name="T85" fmla="*/ 111 h 74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Lst>
              <a:rect l="0" t="0" r="r" b="b"/>
              <a:pathLst>
                <a:path w="817" h="743">
                  <a:moveTo>
                    <a:pt x="601" y="111"/>
                  </a:moveTo>
                  <a:cubicBezTo>
                    <a:pt x="623" y="78"/>
                    <a:pt x="634" y="59"/>
                    <a:pt x="634" y="52"/>
                  </a:cubicBezTo>
                  <a:cubicBezTo>
                    <a:pt x="634" y="46"/>
                    <a:pt x="631" y="41"/>
                    <a:pt x="624" y="39"/>
                  </a:cubicBezTo>
                  <a:cubicBezTo>
                    <a:pt x="616" y="36"/>
                    <a:pt x="585" y="34"/>
                    <a:pt x="543" y="33"/>
                  </a:cubicBezTo>
                  <a:cubicBezTo>
                    <a:pt x="543" y="0"/>
                    <a:pt x="543" y="0"/>
                    <a:pt x="543" y="0"/>
                  </a:cubicBezTo>
                  <a:cubicBezTo>
                    <a:pt x="610" y="2"/>
                    <a:pt x="650" y="3"/>
                    <a:pt x="688" y="3"/>
                  </a:cubicBezTo>
                  <a:cubicBezTo>
                    <a:pt x="725" y="3"/>
                    <a:pt x="745" y="2"/>
                    <a:pt x="817" y="0"/>
                  </a:cubicBezTo>
                  <a:cubicBezTo>
                    <a:pt x="817" y="33"/>
                    <a:pt x="817" y="33"/>
                    <a:pt x="817" y="33"/>
                  </a:cubicBezTo>
                  <a:cubicBezTo>
                    <a:pt x="773" y="34"/>
                    <a:pt x="757" y="36"/>
                    <a:pt x="746" y="39"/>
                  </a:cubicBezTo>
                  <a:cubicBezTo>
                    <a:pt x="735" y="41"/>
                    <a:pt x="725" y="46"/>
                    <a:pt x="718" y="51"/>
                  </a:cubicBezTo>
                  <a:cubicBezTo>
                    <a:pt x="709" y="58"/>
                    <a:pt x="695" y="75"/>
                    <a:pt x="675" y="102"/>
                  </a:cubicBezTo>
                  <a:cubicBezTo>
                    <a:pt x="514" y="333"/>
                    <a:pt x="514" y="333"/>
                    <a:pt x="514" y="333"/>
                  </a:cubicBezTo>
                  <a:cubicBezTo>
                    <a:pt x="483" y="381"/>
                    <a:pt x="465" y="411"/>
                    <a:pt x="461" y="422"/>
                  </a:cubicBezTo>
                  <a:cubicBezTo>
                    <a:pt x="457" y="433"/>
                    <a:pt x="455" y="443"/>
                    <a:pt x="455" y="453"/>
                  </a:cubicBezTo>
                  <a:cubicBezTo>
                    <a:pt x="455" y="493"/>
                    <a:pt x="455" y="493"/>
                    <a:pt x="455" y="493"/>
                  </a:cubicBezTo>
                  <a:cubicBezTo>
                    <a:pt x="455" y="541"/>
                    <a:pt x="456" y="587"/>
                    <a:pt x="459" y="631"/>
                  </a:cubicBezTo>
                  <a:cubicBezTo>
                    <a:pt x="460" y="665"/>
                    <a:pt x="462" y="684"/>
                    <a:pt x="466" y="690"/>
                  </a:cubicBezTo>
                  <a:cubicBezTo>
                    <a:pt x="470" y="696"/>
                    <a:pt x="477" y="701"/>
                    <a:pt x="486" y="704"/>
                  </a:cubicBezTo>
                  <a:cubicBezTo>
                    <a:pt x="495" y="707"/>
                    <a:pt x="521" y="709"/>
                    <a:pt x="564" y="710"/>
                  </a:cubicBezTo>
                  <a:cubicBezTo>
                    <a:pt x="564" y="743"/>
                    <a:pt x="564" y="743"/>
                    <a:pt x="564" y="743"/>
                  </a:cubicBezTo>
                  <a:cubicBezTo>
                    <a:pt x="505" y="741"/>
                    <a:pt x="453" y="740"/>
                    <a:pt x="410" y="740"/>
                  </a:cubicBezTo>
                  <a:cubicBezTo>
                    <a:pt x="368" y="740"/>
                    <a:pt x="313" y="741"/>
                    <a:pt x="244" y="743"/>
                  </a:cubicBezTo>
                  <a:cubicBezTo>
                    <a:pt x="244" y="710"/>
                    <a:pt x="244" y="710"/>
                    <a:pt x="244" y="710"/>
                  </a:cubicBezTo>
                  <a:cubicBezTo>
                    <a:pt x="287" y="709"/>
                    <a:pt x="313" y="707"/>
                    <a:pt x="322" y="704"/>
                  </a:cubicBezTo>
                  <a:cubicBezTo>
                    <a:pt x="332" y="701"/>
                    <a:pt x="338" y="697"/>
                    <a:pt x="341" y="692"/>
                  </a:cubicBezTo>
                  <a:cubicBezTo>
                    <a:pt x="346" y="685"/>
                    <a:pt x="349" y="668"/>
                    <a:pt x="350" y="641"/>
                  </a:cubicBezTo>
                  <a:cubicBezTo>
                    <a:pt x="350" y="634"/>
                    <a:pt x="351" y="585"/>
                    <a:pt x="353" y="493"/>
                  </a:cubicBezTo>
                  <a:cubicBezTo>
                    <a:pt x="353" y="432"/>
                    <a:pt x="353" y="432"/>
                    <a:pt x="353" y="432"/>
                  </a:cubicBezTo>
                  <a:cubicBezTo>
                    <a:pt x="345" y="417"/>
                    <a:pt x="338" y="403"/>
                    <a:pt x="331" y="390"/>
                  </a:cubicBezTo>
                  <a:cubicBezTo>
                    <a:pt x="325" y="382"/>
                    <a:pt x="307" y="352"/>
                    <a:pt x="275" y="300"/>
                  </a:cubicBezTo>
                  <a:cubicBezTo>
                    <a:pt x="135" y="102"/>
                    <a:pt x="135" y="102"/>
                    <a:pt x="135" y="102"/>
                  </a:cubicBezTo>
                  <a:cubicBezTo>
                    <a:pt x="118" y="75"/>
                    <a:pt x="105" y="58"/>
                    <a:pt x="96" y="51"/>
                  </a:cubicBezTo>
                  <a:cubicBezTo>
                    <a:pt x="89" y="46"/>
                    <a:pt x="80" y="41"/>
                    <a:pt x="69" y="39"/>
                  </a:cubicBezTo>
                  <a:cubicBezTo>
                    <a:pt x="58" y="36"/>
                    <a:pt x="44" y="34"/>
                    <a:pt x="0" y="33"/>
                  </a:cubicBezTo>
                  <a:cubicBezTo>
                    <a:pt x="0" y="0"/>
                    <a:pt x="0" y="0"/>
                    <a:pt x="0" y="0"/>
                  </a:cubicBezTo>
                  <a:cubicBezTo>
                    <a:pt x="72" y="2"/>
                    <a:pt x="94" y="3"/>
                    <a:pt x="130" y="3"/>
                  </a:cubicBezTo>
                  <a:cubicBezTo>
                    <a:pt x="168" y="3"/>
                    <a:pt x="265" y="2"/>
                    <a:pt x="333" y="0"/>
                  </a:cubicBezTo>
                  <a:cubicBezTo>
                    <a:pt x="333" y="33"/>
                    <a:pt x="333" y="33"/>
                    <a:pt x="333" y="33"/>
                  </a:cubicBezTo>
                  <a:cubicBezTo>
                    <a:pt x="291" y="34"/>
                    <a:pt x="254" y="36"/>
                    <a:pt x="246" y="39"/>
                  </a:cubicBezTo>
                  <a:cubicBezTo>
                    <a:pt x="239" y="41"/>
                    <a:pt x="235" y="46"/>
                    <a:pt x="234" y="52"/>
                  </a:cubicBezTo>
                  <a:cubicBezTo>
                    <a:pt x="234" y="59"/>
                    <a:pt x="243" y="78"/>
                    <a:pt x="262" y="111"/>
                  </a:cubicBezTo>
                  <a:cubicBezTo>
                    <a:pt x="426" y="376"/>
                    <a:pt x="426" y="376"/>
                    <a:pt x="426" y="376"/>
                  </a:cubicBezTo>
                  <a:lnTo>
                    <a:pt x="601" y="111"/>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2" name="Freeform 15"/>
            <p:cNvSpPr>
              <a:spLocks noEditPoints="1"/>
            </p:cNvSpPr>
            <p:nvPr userDrawn="1"/>
          </p:nvSpPr>
          <p:spPr bwMode="auto">
            <a:xfrm>
              <a:off x="1558925" y="681038"/>
              <a:ext cx="263525" cy="246063"/>
            </a:xfrm>
            <a:custGeom>
              <a:avLst/>
              <a:gdLst>
                <a:gd name="T0" fmla="*/ 148 w 830"/>
                <a:gd name="T1" fmla="*/ 190 h 775"/>
                <a:gd name="T2" fmla="*/ 247 w 830"/>
                <a:gd name="T3" fmla="*/ 82 h 775"/>
                <a:gd name="T4" fmla="*/ 399 w 830"/>
                <a:gd name="T5" fmla="*/ 45 h 775"/>
                <a:gd name="T6" fmla="*/ 512 w 830"/>
                <a:gd name="T7" fmla="*/ 62 h 775"/>
                <a:gd name="T8" fmla="*/ 596 w 830"/>
                <a:gd name="T9" fmla="*/ 106 h 775"/>
                <a:gd name="T10" fmla="*/ 652 w 830"/>
                <a:gd name="T11" fmla="*/ 167 h 775"/>
                <a:gd name="T12" fmla="*/ 690 w 830"/>
                <a:gd name="T13" fmla="*/ 245 h 775"/>
                <a:gd name="T14" fmla="*/ 713 w 830"/>
                <a:gd name="T15" fmla="*/ 398 h 775"/>
                <a:gd name="T16" fmla="*/ 681 w 830"/>
                <a:gd name="T17" fmla="*/ 571 h 775"/>
                <a:gd name="T18" fmla="*/ 584 w 830"/>
                <a:gd name="T19" fmla="*/ 686 h 775"/>
                <a:gd name="T20" fmla="*/ 431 w 830"/>
                <a:gd name="T21" fmla="*/ 727 h 775"/>
                <a:gd name="T22" fmla="*/ 315 w 830"/>
                <a:gd name="T23" fmla="*/ 707 h 775"/>
                <a:gd name="T24" fmla="*/ 220 w 830"/>
                <a:gd name="T25" fmla="*/ 644 h 775"/>
                <a:gd name="T26" fmla="*/ 151 w 830"/>
                <a:gd name="T27" fmla="*/ 539 h 775"/>
                <a:gd name="T28" fmla="*/ 125 w 830"/>
                <a:gd name="T29" fmla="*/ 450 h 775"/>
                <a:gd name="T30" fmla="*/ 115 w 830"/>
                <a:gd name="T31" fmla="*/ 349 h 775"/>
                <a:gd name="T32" fmla="*/ 148 w 830"/>
                <a:gd name="T33" fmla="*/ 190 h 775"/>
                <a:gd name="T34" fmla="*/ 26 w 830"/>
                <a:gd name="T35" fmla="*/ 541 h 775"/>
                <a:gd name="T36" fmla="*/ 105 w 830"/>
                <a:gd name="T37" fmla="*/ 669 h 775"/>
                <a:gd name="T38" fmla="*/ 231 w 830"/>
                <a:gd name="T39" fmla="*/ 748 h 775"/>
                <a:gd name="T40" fmla="*/ 392 w 830"/>
                <a:gd name="T41" fmla="*/ 775 h 775"/>
                <a:gd name="T42" fmla="*/ 706 w 830"/>
                <a:gd name="T43" fmla="*/ 657 h 775"/>
                <a:gd name="T44" fmla="*/ 830 w 830"/>
                <a:gd name="T45" fmla="*/ 364 h 775"/>
                <a:gd name="T46" fmla="*/ 817 w 830"/>
                <a:gd name="T47" fmla="*/ 261 h 775"/>
                <a:gd name="T48" fmla="*/ 784 w 830"/>
                <a:gd name="T49" fmla="*/ 177 h 775"/>
                <a:gd name="T50" fmla="*/ 709 w 830"/>
                <a:gd name="T51" fmla="*/ 89 h 775"/>
                <a:gd name="T52" fmla="*/ 588 w 830"/>
                <a:gd name="T53" fmla="*/ 25 h 775"/>
                <a:gd name="T54" fmla="*/ 423 w 830"/>
                <a:gd name="T55" fmla="*/ 0 h 775"/>
                <a:gd name="T56" fmla="*/ 249 w 830"/>
                <a:gd name="T57" fmla="*/ 29 h 775"/>
                <a:gd name="T58" fmla="*/ 112 w 830"/>
                <a:gd name="T59" fmla="*/ 113 h 775"/>
                <a:gd name="T60" fmla="*/ 26 w 830"/>
                <a:gd name="T61" fmla="*/ 239 h 775"/>
                <a:gd name="T62" fmla="*/ 0 w 830"/>
                <a:gd name="T63" fmla="*/ 393 h 775"/>
                <a:gd name="T64" fmla="*/ 26 w 830"/>
                <a:gd name="T65" fmla="*/ 541 h 77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Lst>
              <a:rect l="0" t="0" r="r" b="b"/>
              <a:pathLst>
                <a:path w="830" h="775">
                  <a:moveTo>
                    <a:pt x="148" y="190"/>
                  </a:moveTo>
                  <a:cubicBezTo>
                    <a:pt x="170" y="143"/>
                    <a:pt x="203" y="107"/>
                    <a:pt x="247" y="82"/>
                  </a:cubicBezTo>
                  <a:cubicBezTo>
                    <a:pt x="290" y="57"/>
                    <a:pt x="341" y="45"/>
                    <a:pt x="399" y="45"/>
                  </a:cubicBezTo>
                  <a:cubicBezTo>
                    <a:pt x="440" y="45"/>
                    <a:pt x="477" y="51"/>
                    <a:pt x="512" y="62"/>
                  </a:cubicBezTo>
                  <a:cubicBezTo>
                    <a:pt x="546" y="74"/>
                    <a:pt x="575" y="89"/>
                    <a:pt x="596" y="106"/>
                  </a:cubicBezTo>
                  <a:cubicBezTo>
                    <a:pt x="618" y="124"/>
                    <a:pt x="637" y="144"/>
                    <a:pt x="652" y="167"/>
                  </a:cubicBezTo>
                  <a:cubicBezTo>
                    <a:pt x="668" y="190"/>
                    <a:pt x="681" y="216"/>
                    <a:pt x="690" y="245"/>
                  </a:cubicBezTo>
                  <a:cubicBezTo>
                    <a:pt x="706" y="292"/>
                    <a:pt x="713" y="343"/>
                    <a:pt x="713" y="398"/>
                  </a:cubicBezTo>
                  <a:cubicBezTo>
                    <a:pt x="713" y="463"/>
                    <a:pt x="703" y="521"/>
                    <a:pt x="681" y="571"/>
                  </a:cubicBezTo>
                  <a:cubicBezTo>
                    <a:pt x="660" y="620"/>
                    <a:pt x="627" y="659"/>
                    <a:pt x="584" y="686"/>
                  </a:cubicBezTo>
                  <a:cubicBezTo>
                    <a:pt x="541" y="714"/>
                    <a:pt x="490" y="727"/>
                    <a:pt x="431" y="727"/>
                  </a:cubicBezTo>
                  <a:cubicBezTo>
                    <a:pt x="388" y="727"/>
                    <a:pt x="350" y="721"/>
                    <a:pt x="315" y="707"/>
                  </a:cubicBezTo>
                  <a:cubicBezTo>
                    <a:pt x="280" y="694"/>
                    <a:pt x="248" y="673"/>
                    <a:pt x="220" y="644"/>
                  </a:cubicBezTo>
                  <a:cubicBezTo>
                    <a:pt x="192" y="616"/>
                    <a:pt x="169" y="581"/>
                    <a:pt x="151" y="539"/>
                  </a:cubicBezTo>
                  <a:cubicBezTo>
                    <a:pt x="141" y="514"/>
                    <a:pt x="132" y="484"/>
                    <a:pt x="125" y="450"/>
                  </a:cubicBezTo>
                  <a:cubicBezTo>
                    <a:pt x="118" y="416"/>
                    <a:pt x="115" y="382"/>
                    <a:pt x="115" y="349"/>
                  </a:cubicBezTo>
                  <a:cubicBezTo>
                    <a:pt x="115" y="290"/>
                    <a:pt x="126" y="236"/>
                    <a:pt x="148" y="190"/>
                  </a:cubicBezTo>
                  <a:close/>
                  <a:moveTo>
                    <a:pt x="26" y="541"/>
                  </a:moveTo>
                  <a:cubicBezTo>
                    <a:pt x="44" y="591"/>
                    <a:pt x="70" y="634"/>
                    <a:pt x="105" y="669"/>
                  </a:cubicBezTo>
                  <a:cubicBezTo>
                    <a:pt x="139" y="704"/>
                    <a:pt x="181" y="730"/>
                    <a:pt x="231" y="748"/>
                  </a:cubicBezTo>
                  <a:cubicBezTo>
                    <a:pt x="281" y="765"/>
                    <a:pt x="335" y="775"/>
                    <a:pt x="392" y="775"/>
                  </a:cubicBezTo>
                  <a:cubicBezTo>
                    <a:pt x="518" y="775"/>
                    <a:pt x="623" y="736"/>
                    <a:pt x="706" y="657"/>
                  </a:cubicBezTo>
                  <a:cubicBezTo>
                    <a:pt x="788" y="579"/>
                    <a:pt x="830" y="481"/>
                    <a:pt x="830" y="364"/>
                  </a:cubicBezTo>
                  <a:cubicBezTo>
                    <a:pt x="830" y="327"/>
                    <a:pt x="826" y="293"/>
                    <a:pt x="817" y="261"/>
                  </a:cubicBezTo>
                  <a:cubicBezTo>
                    <a:pt x="809" y="228"/>
                    <a:pt x="798" y="200"/>
                    <a:pt x="784" y="177"/>
                  </a:cubicBezTo>
                  <a:cubicBezTo>
                    <a:pt x="766" y="145"/>
                    <a:pt x="741" y="116"/>
                    <a:pt x="709" y="89"/>
                  </a:cubicBezTo>
                  <a:cubicBezTo>
                    <a:pt x="678" y="62"/>
                    <a:pt x="637" y="41"/>
                    <a:pt x="588" y="25"/>
                  </a:cubicBezTo>
                  <a:cubicBezTo>
                    <a:pt x="538" y="8"/>
                    <a:pt x="484" y="0"/>
                    <a:pt x="423" y="0"/>
                  </a:cubicBezTo>
                  <a:cubicBezTo>
                    <a:pt x="358" y="0"/>
                    <a:pt x="300" y="10"/>
                    <a:pt x="249" y="29"/>
                  </a:cubicBezTo>
                  <a:cubicBezTo>
                    <a:pt x="198" y="48"/>
                    <a:pt x="152" y="76"/>
                    <a:pt x="112" y="113"/>
                  </a:cubicBezTo>
                  <a:cubicBezTo>
                    <a:pt x="72" y="151"/>
                    <a:pt x="43" y="193"/>
                    <a:pt x="26" y="239"/>
                  </a:cubicBezTo>
                  <a:cubicBezTo>
                    <a:pt x="8" y="286"/>
                    <a:pt x="0" y="337"/>
                    <a:pt x="0" y="393"/>
                  </a:cubicBezTo>
                  <a:cubicBezTo>
                    <a:pt x="0" y="441"/>
                    <a:pt x="9" y="491"/>
                    <a:pt x="26" y="541"/>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spTree>
    <p:extLst>
      <p:ext uri="{BB962C8B-B14F-4D97-AF65-F5344CB8AC3E}">
        <p14:creationId xmlns:p14="http://schemas.microsoft.com/office/powerpoint/2010/main" val="3886004889"/>
      </p:ext>
    </p:extLst>
  </p:cSld>
  <p:clrMapOvr>
    <a:masterClrMapping/>
  </p:clrMapOvr>
  <p:timing>
    <p:tnLst>
      <p:par>
        <p:cTn id="1" dur="indefinite" restart="never" nodeType="tmRoot"/>
      </p:par>
    </p:tn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658368" y="1371600"/>
            <a:ext cx="3840480" cy="804672"/>
          </a:xfrm>
        </p:spPr>
        <p:txBody>
          <a:bodyPr anchor="b"/>
          <a:lstStyle>
            <a:lvl1pPr marL="0" indent="0">
              <a:buNone/>
              <a:defRPr sz="2400" b="0">
                <a:solidFill>
                  <a:schemeClr val="accent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658368" y="2174875"/>
            <a:ext cx="3840480" cy="3986784"/>
          </a:xfrm>
        </p:spPr>
        <p:txBody>
          <a:bodyPr/>
          <a:lstStyle>
            <a:lvl1pPr>
              <a:defRPr sz="2400"/>
            </a:lvl1pPr>
            <a:lvl2pPr>
              <a:defRPr sz="2400"/>
            </a:lvl2pPr>
            <a:lvl3pPr>
              <a:defRPr sz="2400"/>
            </a:lvl3pPr>
            <a:lvl4pPr>
              <a:defRPr sz="2400"/>
            </a:lvl4pPr>
            <a:lvl5pPr>
              <a:defRPr sz="24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4645025" y="1371600"/>
            <a:ext cx="3840480" cy="804672"/>
          </a:xfrm>
        </p:spPr>
        <p:txBody>
          <a:bodyPr anchor="b"/>
          <a:lstStyle>
            <a:lvl1pPr marL="0" indent="0">
              <a:buNone/>
              <a:defRPr sz="2400" b="0">
                <a:solidFill>
                  <a:schemeClr val="accent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3840480" cy="3986784"/>
          </a:xfrm>
        </p:spPr>
        <p:txBody>
          <a:bodyPr/>
          <a:lstStyle>
            <a:lvl1pPr>
              <a:defRPr sz="2400"/>
            </a:lvl1pPr>
            <a:lvl2pPr>
              <a:defRPr sz="2400"/>
            </a:lvl2pPr>
            <a:lvl3pPr>
              <a:defRPr sz="2400"/>
            </a:lvl3pPr>
            <a:lvl4pPr>
              <a:defRPr sz="2400"/>
            </a:lvl4pPr>
            <a:lvl5pPr>
              <a:defRPr sz="24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842C3D2A-A05D-41A5-BC1D-FC1E84133084}" type="datetime1">
              <a:rPr lang="en-US" smtClean="0"/>
              <a:t>10/28/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DC53FA5-AE81-45E0-8206-920AA27813B4}" type="slidenum">
              <a:rPr lang="en-US" smtClean="0"/>
              <a:t>‹#›</a:t>
            </a:fld>
            <a:endParaRPr lang="en-US"/>
          </a:p>
        </p:txBody>
      </p:sp>
      <p:grpSp>
        <p:nvGrpSpPr>
          <p:cNvPr id="23" name="Group 22"/>
          <p:cNvGrpSpPr/>
          <p:nvPr userDrawn="1"/>
        </p:nvGrpSpPr>
        <p:grpSpPr>
          <a:xfrm>
            <a:off x="120650" y="6299343"/>
            <a:ext cx="420688" cy="458645"/>
            <a:chOff x="657225" y="681038"/>
            <a:chExt cx="1266825" cy="1381125"/>
          </a:xfrm>
          <a:solidFill>
            <a:srgbClr val="FFFFFF"/>
          </a:solidFill>
        </p:grpSpPr>
        <p:sp>
          <p:nvSpPr>
            <p:cNvPr id="24" name="Freeform 5"/>
            <p:cNvSpPr>
              <a:spLocks noEditPoints="1"/>
            </p:cNvSpPr>
            <p:nvPr userDrawn="1"/>
          </p:nvSpPr>
          <p:spPr bwMode="auto">
            <a:xfrm>
              <a:off x="846138" y="1354138"/>
              <a:ext cx="887413" cy="708025"/>
            </a:xfrm>
            <a:custGeom>
              <a:avLst/>
              <a:gdLst>
                <a:gd name="T0" fmla="*/ 2203 w 2794"/>
                <a:gd name="T1" fmla="*/ 0 h 2229"/>
                <a:gd name="T2" fmla="*/ 1613 w 2794"/>
                <a:gd name="T3" fmla="*/ 0 h 2229"/>
                <a:gd name="T4" fmla="*/ 1613 w 2794"/>
                <a:gd name="T5" fmla="*/ 665 h 2229"/>
                <a:gd name="T6" fmla="*/ 1904 w 2794"/>
                <a:gd name="T7" fmla="*/ 1330 h 2229"/>
                <a:gd name="T8" fmla="*/ 1904 w 2794"/>
                <a:gd name="T9" fmla="*/ 1237 h 2229"/>
                <a:gd name="T10" fmla="*/ 1749 w 2794"/>
                <a:gd name="T11" fmla="*/ 747 h 2229"/>
                <a:gd name="T12" fmla="*/ 1749 w 2794"/>
                <a:gd name="T13" fmla="*/ 573 h 2229"/>
                <a:gd name="T14" fmla="*/ 1972 w 2794"/>
                <a:gd name="T15" fmla="*/ 573 h 2229"/>
                <a:gd name="T16" fmla="*/ 1972 w 2794"/>
                <a:gd name="T17" fmla="*/ 1332 h 2229"/>
                <a:gd name="T18" fmla="*/ 1401 w 2794"/>
                <a:gd name="T19" fmla="*/ 2182 h 2229"/>
                <a:gd name="T20" fmla="*/ 829 w 2794"/>
                <a:gd name="T21" fmla="*/ 1374 h 2229"/>
                <a:gd name="T22" fmla="*/ 1180 w 2794"/>
                <a:gd name="T23" fmla="*/ 665 h 2229"/>
                <a:gd name="T24" fmla="*/ 1180 w 2794"/>
                <a:gd name="T25" fmla="*/ 573 h 2229"/>
                <a:gd name="T26" fmla="*/ 1401 w 2794"/>
                <a:gd name="T27" fmla="*/ 573 h 2229"/>
                <a:gd name="T28" fmla="*/ 1542 w 2794"/>
                <a:gd name="T29" fmla="*/ 573 h 2229"/>
                <a:gd name="T30" fmla="*/ 1542 w 2794"/>
                <a:gd name="T31" fmla="*/ 436 h 2229"/>
                <a:gd name="T32" fmla="*/ 1401 w 2794"/>
                <a:gd name="T33" fmla="*/ 436 h 2229"/>
                <a:gd name="T34" fmla="*/ 1180 w 2794"/>
                <a:gd name="T35" fmla="*/ 436 h 2229"/>
                <a:gd name="T36" fmla="*/ 1180 w 2794"/>
                <a:gd name="T37" fmla="*/ 436 h 2229"/>
                <a:gd name="T38" fmla="*/ 1044 w 2794"/>
                <a:gd name="T39" fmla="*/ 436 h 2229"/>
                <a:gd name="T40" fmla="*/ 1044 w 2794"/>
                <a:gd name="T41" fmla="*/ 436 h 2229"/>
                <a:gd name="T42" fmla="*/ 692 w 2794"/>
                <a:gd name="T43" fmla="*/ 436 h 2229"/>
                <a:gd name="T44" fmla="*/ 692 w 2794"/>
                <a:gd name="T45" fmla="*/ 1234 h 2229"/>
                <a:gd name="T46" fmla="*/ 695 w 2794"/>
                <a:gd name="T47" fmla="*/ 1315 h 2229"/>
                <a:gd name="T48" fmla="*/ 695 w 2794"/>
                <a:gd name="T49" fmla="*/ 1315 h 2229"/>
                <a:gd name="T50" fmla="*/ 829 w 2794"/>
                <a:gd name="T51" fmla="*/ 1205 h 2229"/>
                <a:gd name="T52" fmla="*/ 829 w 2794"/>
                <a:gd name="T53" fmla="*/ 1205 h 2229"/>
                <a:gd name="T54" fmla="*/ 829 w 2794"/>
                <a:gd name="T55" fmla="*/ 573 h 2229"/>
                <a:gd name="T56" fmla="*/ 1044 w 2794"/>
                <a:gd name="T57" fmla="*/ 573 h 2229"/>
                <a:gd name="T58" fmla="*/ 1044 w 2794"/>
                <a:gd name="T59" fmla="*/ 573 h 2229"/>
                <a:gd name="T60" fmla="*/ 1044 w 2794"/>
                <a:gd name="T61" fmla="*/ 747 h 2229"/>
                <a:gd name="T62" fmla="*/ 590 w 2794"/>
                <a:gd name="T63" fmla="*/ 1447 h 2229"/>
                <a:gd name="T64" fmla="*/ 135 w 2794"/>
                <a:gd name="T65" fmla="*/ 747 h 2229"/>
                <a:gd name="T66" fmla="*/ 135 w 2794"/>
                <a:gd name="T67" fmla="*/ 136 h 2229"/>
                <a:gd name="T68" fmla="*/ 590 w 2794"/>
                <a:gd name="T69" fmla="*/ 136 h 2229"/>
                <a:gd name="T70" fmla="*/ 1044 w 2794"/>
                <a:gd name="T71" fmla="*/ 136 h 2229"/>
                <a:gd name="T72" fmla="*/ 1044 w 2794"/>
                <a:gd name="T73" fmla="*/ 370 h 2229"/>
                <a:gd name="T74" fmla="*/ 1180 w 2794"/>
                <a:gd name="T75" fmla="*/ 370 h 2229"/>
                <a:gd name="T76" fmla="*/ 1180 w 2794"/>
                <a:gd name="T77" fmla="*/ 0 h 2229"/>
                <a:gd name="T78" fmla="*/ 590 w 2794"/>
                <a:gd name="T79" fmla="*/ 0 h 2229"/>
                <a:gd name="T80" fmla="*/ 0 w 2794"/>
                <a:gd name="T81" fmla="*/ 0 h 2229"/>
                <a:gd name="T82" fmla="*/ 0 w 2794"/>
                <a:gd name="T83" fmla="*/ 665 h 2229"/>
                <a:gd name="T84" fmla="*/ 590 w 2794"/>
                <a:gd name="T85" fmla="*/ 1495 h 2229"/>
                <a:gd name="T86" fmla="*/ 708 w 2794"/>
                <a:gd name="T87" fmla="*/ 1444 h 2229"/>
                <a:gd name="T88" fmla="*/ 1401 w 2794"/>
                <a:gd name="T89" fmla="*/ 2229 h 2229"/>
                <a:gd name="T90" fmla="*/ 2093 w 2794"/>
                <a:gd name="T91" fmla="*/ 1447 h 2229"/>
                <a:gd name="T92" fmla="*/ 2203 w 2794"/>
                <a:gd name="T93" fmla="*/ 1495 h 2229"/>
                <a:gd name="T94" fmla="*/ 2794 w 2794"/>
                <a:gd name="T95" fmla="*/ 665 h 2229"/>
                <a:gd name="T96" fmla="*/ 2794 w 2794"/>
                <a:gd name="T97" fmla="*/ 0 h 2229"/>
                <a:gd name="T98" fmla="*/ 2203 w 2794"/>
                <a:gd name="T99" fmla="*/ 0 h 2229"/>
                <a:gd name="T100" fmla="*/ 2658 w 2794"/>
                <a:gd name="T101" fmla="*/ 747 h 2229"/>
                <a:gd name="T102" fmla="*/ 2203 w 2794"/>
                <a:gd name="T103" fmla="*/ 1447 h 2229"/>
                <a:gd name="T104" fmla="*/ 2100 w 2794"/>
                <a:gd name="T105" fmla="*/ 1395 h 2229"/>
                <a:gd name="T106" fmla="*/ 2109 w 2794"/>
                <a:gd name="T107" fmla="*/ 1234 h 2229"/>
                <a:gd name="T108" fmla="*/ 2109 w 2794"/>
                <a:gd name="T109" fmla="*/ 436 h 2229"/>
                <a:gd name="T110" fmla="*/ 1749 w 2794"/>
                <a:gd name="T111" fmla="*/ 436 h 2229"/>
                <a:gd name="T112" fmla="*/ 1749 w 2794"/>
                <a:gd name="T113" fmla="*/ 136 h 2229"/>
                <a:gd name="T114" fmla="*/ 2203 w 2794"/>
                <a:gd name="T115" fmla="*/ 136 h 2229"/>
                <a:gd name="T116" fmla="*/ 2658 w 2794"/>
                <a:gd name="T117" fmla="*/ 136 h 2229"/>
                <a:gd name="T118" fmla="*/ 2658 w 2794"/>
                <a:gd name="T119" fmla="*/ 747 h 222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 ang="0">
                  <a:pos x="T118" y="T119"/>
                </a:cxn>
              </a:cxnLst>
              <a:rect l="0" t="0" r="r" b="b"/>
              <a:pathLst>
                <a:path w="2794" h="2229">
                  <a:moveTo>
                    <a:pt x="2203" y="0"/>
                  </a:moveTo>
                  <a:cubicBezTo>
                    <a:pt x="1613" y="0"/>
                    <a:pt x="1613" y="0"/>
                    <a:pt x="1613" y="0"/>
                  </a:cubicBezTo>
                  <a:cubicBezTo>
                    <a:pt x="1613" y="665"/>
                    <a:pt x="1613" y="665"/>
                    <a:pt x="1613" y="665"/>
                  </a:cubicBezTo>
                  <a:cubicBezTo>
                    <a:pt x="1613" y="970"/>
                    <a:pt x="1719" y="1183"/>
                    <a:pt x="1904" y="1330"/>
                  </a:cubicBezTo>
                  <a:cubicBezTo>
                    <a:pt x="1904" y="1237"/>
                    <a:pt x="1904" y="1237"/>
                    <a:pt x="1904" y="1237"/>
                  </a:cubicBezTo>
                  <a:cubicBezTo>
                    <a:pt x="1769" y="1081"/>
                    <a:pt x="1749" y="901"/>
                    <a:pt x="1749" y="747"/>
                  </a:cubicBezTo>
                  <a:cubicBezTo>
                    <a:pt x="1749" y="573"/>
                    <a:pt x="1749" y="573"/>
                    <a:pt x="1749" y="573"/>
                  </a:cubicBezTo>
                  <a:cubicBezTo>
                    <a:pt x="1972" y="573"/>
                    <a:pt x="1972" y="573"/>
                    <a:pt x="1972" y="573"/>
                  </a:cubicBezTo>
                  <a:cubicBezTo>
                    <a:pt x="1972" y="1332"/>
                    <a:pt x="1972" y="1332"/>
                    <a:pt x="1972" y="1332"/>
                  </a:cubicBezTo>
                  <a:cubicBezTo>
                    <a:pt x="1972" y="1609"/>
                    <a:pt x="1895" y="1961"/>
                    <a:pt x="1401" y="2182"/>
                  </a:cubicBezTo>
                  <a:cubicBezTo>
                    <a:pt x="931" y="1972"/>
                    <a:pt x="838" y="1643"/>
                    <a:pt x="829" y="1374"/>
                  </a:cubicBezTo>
                  <a:cubicBezTo>
                    <a:pt x="1051" y="1225"/>
                    <a:pt x="1180" y="1001"/>
                    <a:pt x="1180" y="665"/>
                  </a:cubicBezTo>
                  <a:cubicBezTo>
                    <a:pt x="1180" y="573"/>
                    <a:pt x="1180" y="573"/>
                    <a:pt x="1180" y="573"/>
                  </a:cubicBezTo>
                  <a:cubicBezTo>
                    <a:pt x="1401" y="573"/>
                    <a:pt x="1401" y="573"/>
                    <a:pt x="1401" y="573"/>
                  </a:cubicBezTo>
                  <a:cubicBezTo>
                    <a:pt x="1542" y="573"/>
                    <a:pt x="1542" y="573"/>
                    <a:pt x="1542" y="573"/>
                  </a:cubicBezTo>
                  <a:cubicBezTo>
                    <a:pt x="1542" y="436"/>
                    <a:pt x="1542" y="436"/>
                    <a:pt x="1542" y="436"/>
                  </a:cubicBezTo>
                  <a:cubicBezTo>
                    <a:pt x="1401" y="436"/>
                    <a:pt x="1401" y="436"/>
                    <a:pt x="1401" y="436"/>
                  </a:cubicBezTo>
                  <a:cubicBezTo>
                    <a:pt x="1180" y="436"/>
                    <a:pt x="1180" y="436"/>
                    <a:pt x="1180" y="436"/>
                  </a:cubicBezTo>
                  <a:cubicBezTo>
                    <a:pt x="1180" y="436"/>
                    <a:pt x="1180" y="436"/>
                    <a:pt x="1180" y="436"/>
                  </a:cubicBezTo>
                  <a:cubicBezTo>
                    <a:pt x="1044" y="436"/>
                    <a:pt x="1044" y="436"/>
                    <a:pt x="1044" y="436"/>
                  </a:cubicBezTo>
                  <a:cubicBezTo>
                    <a:pt x="1044" y="436"/>
                    <a:pt x="1044" y="436"/>
                    <a:pt x="1044" y="436"/>
                  </a:cubicBezTo>
                  <a:cubicBezTo>
                    <a:pt x="692" y="436"/>
                    <a:pt x="692" y="436"/>
                    <a:pt x="692" y="436"/>
                  </a:cubicBezTo>
                  <a:cubicBezTo>
                    <a:pt x="692" y="1234"/>
                    <a:pt x="692" y="1234"/>
                    <a:pt x="692" y="1234"/>
                  </a:cubicBezTo>
                  <a:cubicBezTo>
                    <a:pt x="692" y="1262"/>
                    <a:pt x="693" y="1289"/>
                    <a:pt x="695" y="1315"/>
                  </a:cubicBezTo>
                  <a:cubicBezTo>
                    <a:pt x="695" y="1315"/>
                    <a:pt x="695" y="1315"/>
                    <a:pt x="695" y="1315"/>
                  </a:cubicBezTo>
                  <a:cubicBezTo>
                    <a:pt x="748" y="1280"/>
                    <a:pt x="792" y="1244"/>
                    <a:pt x="829" y="1205"/>
                  </a:cubicBezTo>
                  <a:cubicBezTo>
                    <a:pt x="829" y="1205"/>
                    <a:pt x="829" y="1205"/>
                    <a:pt x="829" y="1205"/>
                  </a:cubicBezTo>
                  <a:cubicBezTo>
                    <a:pt x="829" y="573"/>
                    <a:pt x="829" y="573"/>
                    <a:pt x="829" y="573"/>
                  </a:cubicBezTo>
                  <a:cubicBezTo>
                    <a:pt x="1044" y="573"/>
                    <a:pt x="1044" y="573"/>
                    <a:pt x="1044" y="573"/>
                  </a:cubicBezTo>
                  <a:cubicBezTo>
                    <a:pt x="1044" y="573"/>
                    <a:pt x="1044" y="573"/>
                    <a:pt x="1044" y="573"/>
                  </a:cubicBezTo>
                  <a:cubicBezTo>
                    <a:pt x="1044" y="747"/>
                    <a:pt x="1044" y="747"/>
                    <a:pt x="1044" y="747"/>
                  </a:cubicBezTo>
                  <a:cubicBezTo>
                    <a:pt x="1044" y="978"/>
                    <a:pt x="1001" y="1263"/>
                    <a:pt x="590" y="1447"/>
                  </a:cubicBezTo>
                  <a:cubicBezTo>
                    <a:pt x="178" y="1263"/>
                    <a:pt x="135" y="978"/>
                    <a:pt x="135" y="747"/>
                  </a:cubicBezTo>
                  <a:cubicBezTo>
                    <a:pt x="135" y="136"/>
                    <a:pt x="135" y="136"/>
                    <a:pt x="135" y="136"/>
                  </a:cubicBezTo>
                  <a:cubicBezTo>
                    <a:pt x="590" y="136"/>
                    <a:pt x="590" y="136"/>
                    <a:pt x="590" y="136"/>
                  </a:cubicBezTo>
                  <a:cubicBezTo>
                    <a:pt x="1044" y="136"/>
                    <a:pt x="1044" y="136"/>
                    <a:pt x="1044" y="136"/>
                  </a:cubicBezTo>
                  <a:cubicBezTo>
                    <a:pt x="1044" y="370"/>
                    <a:pt x="1044" y="370"/>
                    <a:pt x="1044" y="370"/>
                  </a:cubicBezTo>
                  <a:cubicBezTo>
                    <a:pt x="1180" y="370"/>
                    <a:pt x="1180" y="370"/>
                    <a:pt x="1180" y="370"/>
                  </a:cubicBezTo>
                  <a:cubicBezTo>
                    <a:pt x="1180" y="0"/>
                    <a:pt x="1180" y="0"/>
                    <a:pt x="1180" y="0"/>
                  </a:cubicBezTo>
                  <a:cubicBezTo>
                    <a:pt x="590" y="0"/>
                    <a:pt x="590" y="0"/>
                    <a:pt x="590" y="0"/>
                  </a:cubicBezTo>
                  <a:cubicBezTo>
                    <a:pt x="0" y="0"/>
                    <a:pt x="0" y="0"/>
                    <a:pt x="0" y="0"/>
                  </a:cubicBezTo>
                  <a:cubicBezTo>
                    <a:pt x="0" y="665"/>
                    <a:pt x="0" y="665"/>
                    <a:pt x="0" y="665"/>
                  </a:cubicBezTo>
                  <a:cubicBezTo>
                    <a:pt x="0" y="1109"/>
                    <a:pt x="224" y="1357"/>
                    <a:pt x="590" y="1495"/>
                  </a:cubicBezTo>
                  <a:cubicBezTo>
                    <a:pt x="631" y="1479"/>
                    <a:pt x="670" y="1462"/>
                    <a:pt x="708" y="1444"/>
                  </a:cubicBezTo>
                  <a:cubicBezTo>
                    <a:pt x="771" y="1847"/>
                    <a:pt x="1023" y="2087"/>
                    <a:pt x="1401" y="2229"/>
                  </a:cubicBezTo>
                  <a:cubicBezTo>
                    <a:pt x="1777" y="2087"/>
                    <a:pt x="2029" y="1848"/>
                    <a:pt x="2093" y="1447"/>
                  </a:cubicBezTo>
                  <a:cubicBezTo>
                    <a:pt x="2128" y="1464"/>
                    <a:pt x="2165" y="1480"/>
                    <a:pt x="2203" y="1495"/>
                  </a:cubicBezTo>
                  <a:cubicBezTo>
                    <a:pt x="2569" y="1357"/>
                    <a:pt x="2794" y="1109"/>
                    <a:pt x="2794" y="665"/>
                  </a:cubicBezTo>
                  <a:cubicBezTo>
                    <a:pt x="2794" y="0"/>
                    <a:pt x="2794" y="0"/>
                    <a:pt x="2794" y="0"/>
                  </a:cubicBezTo>
                  <a:lnTo>
                    <a:pt x="2203" y="0"/>
                  </a:lnTo>
                  <a:close/>
                  <a:moveTo>
                    <a:pt x="2658" y="747"/>
                  </a:moveTo>
                  <a:cubicBezTo>
                    <a:pt x="2658" y="978"/>
                    <a:pt x="2615" y="1263"/>
                    <a:pt x="2203" y="1447"/>
                  </a:cubicBezTo>
                  <a:cubicBezTo>
                    <a:pt x="2166" y="1431"/>
                    <a:pt x="2131" y="1413"/>
                    <a:pt x="2100" y="1395"/>
                  </a:cubicBezTo>
                  <a:cubicBezTo>
                    <a:pt x="2106" y="1344"/>
                    <a:pt x="2109" y="1290"/>
                    <a:pt x="2109" y="1234"/>
                  </a:cubicBezTo>
                  <a:cubicBezTo>
                    <a:pt x="2109" y="436"/>
                    <a:pt x="2109" y="436"/>
                    <a:pt x="2109" y="436"/>
                  </a:cubicBezTo>
                  <a:cubicBezTo>
                    <a:pt x="1749" y="436"/>
                    <a:pt x="1749" y="436"/>
                    <a:pt x="1749" y="436"/>
                  </a:cubicBezTo>
                  <a:cubicBezTo>
                    <a:pt x="1749" y="136"/>
                    <a:pt x="1749" y="136"/>
                    <a:pt x="1749" y="136"/>
                  </a:cubicBezTo>
                  <a:cubicBezTo>
                    <a:pt x="2203" y="136"/>
                    <a:pt x="2203" y="136"/>
                    <a:pt x="2203" y="136"/>
                  </a:cubicBezTo>
                  <a:cubicBezTo>
                    <a:pt x="2658" y="136"/>
                    <a:pt x="2658" y="136"/>
                    <a:pt x="2658" y="136"/>
                  </a:cubicBezTo>
                  <a:lnTo>
                    <a:pt x="2658" y="74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5" name="Freeform 6"/>
            <p:cNvSpPr>
              <a:spLocks/>
            </p:cNvSpPr>
            <p:nvPr userDrawn="1"/>
          </p:nvSpPr>
          <p:spPr bwMode="auto">
            <a:xfrm>
              <a:off x="915988" y="1003301"/>
              <a:ext cx="188913" cy="236538"/>
            </a:xfrm>
            <a:custGeom>
              <a:avLst/>
              <a:gdLst>
                <a:gd name="T0" fmla="*/ 49 w 596"/>
                <a:gd name="T1" fmla="*/ 747 h 747"/>
                <a:gd name="T2" fmla="*/ 49 w 596"/>
                <a:gd name="T3" fmla="*/ 721 h 747"/>
                <a:gd name="T4" fmla="*/ 91 w 596"/>
                <a:gd name="T5" fmla="*/ 696 h 747"/>
                <a:gd name="T6" fmla="*/ 99 w 596"/>
                <a:gd name="T7" fmla="*/ 684 h 747"/>
                <a:gd name="T8" fmla="*/ 105 w 596"/>
                <a:gd name="T9" fmla="*/ 621 h 747"/>
                <a:gd name="T10" fmla="*/ 109 w 596"/>
                <a:gd name="T11" fmla="*/ 535 h 747"/>
                <a:gd name="T12" fmla="*/ 109 w 596"/>
                <a:gd name="T13" fmla="*/ 252 h 747"/>
                <a:gd name="T14" fmla="*/ 105 w 596"/>
                <a:gd name="T15" fmla="*/ 112 h 747"/>
                <a:gd name="T16" fmla="*/ 98 w 596"/>
                <a:gd name="T17" fmla="*/ 52 h 747"/>
                <a:gd name="T18" fmla="*/ 78 w 596"/>
                <a:gd name="T19" fmla="*/ 39 h 747"/>
                <a:gd name="T20" fmla="*/ 0 w 596"/>
                <a:gd name="T21" fmla="*/ 33 h 747"/>
                <a:gd name="T22" fmla="*/ 0 w 596"/>
                <a:gd name="T23" fmla="*/ 0 h 747"/>
                <a:gd name="T24" fmla="*/ 165 w 596"/>
                <a:gd name="T25" fmla="*/ 3 h 747"/>
                <a:gd name="T26" fmla="*/ 323 w 596"/>
                <a:gd name="T27" fmla="*/ 0 h 747"/>
                <a:gd name="T28" fmla="*/ 323 w 596"/>
                <a:gd name="T29" fmla="*/ 33 h 747"/>
                <a:gd name="T30" fmla="*/ 243 w 596"/>
                <a:gd name="T31" fmla="*/ 39 h 747"/>
                <a:gd name="T32" fmla="*/ 224 w 596"/>
                <a:gd name="T33" fmla="*/ 51 h 747"/>
                <a:gd name="T34" fmla="*/ 216 w 596"/>
                <a:gd name="T35" fmla="*/ 102 h 747"/>
                <a:gd name="T36" fmla="*/ 213 w 596"/>
                <a:gd name="T37" fmla="*/ 252 h 747"/>
                <a:gd name="T38" fmla="*/ 213 w 596"/>
                <a:gd name="T39" fmla="*/ 606 h 747"/>
                <a:gd name="T40" fmla="*/ 216 w 596"/>
                <a:gd name="T41" fmla="*/ 696 h 747"/>
                <a:gd name="T42" fmla="*/ 303 w 596"/>
                <a:gd name="T43" fmla="*/ 700 h 747"/>
                <a:gd name="T44" fmla="*/ 525 w 596"/>
                <a:gd name="T45" fmla="*/ 681 h 747"/>
                <a:gd name="T46" fmla="*/ 538 w 596"/>
                <a:gd name="T47" fmla="*/ 644 h 747"/>
                <a:gd name="T48" fmla="*/ 560 w 596"/>
                <a:gd name="T49" fmla="*/ 557 h 747"/>
                <a:gd name="T50" fmla="*/ 596 w 596"/>
                <a:gd name="T51" fmla="*/ 557 h 747"/>
                <a:gd name="T52" fmla="*/ 573 w 596"/>
                <a:gd name="T53" fmla="*/ 741 h 747"/>
                <a:gd name="T54" fmla="*/ 537 w 596"/>
                <a:gd name="T55" fmla="*/ 746 h 747"/>
                <a:gd name="T56" fmla="*/ 449 w 596"/>
                <a:gd name="T57" fmla="*/ 747 h 747"/>
                <a:gd name="T58" fmla="*/ 156 w 596"/>
                <a:gd name="T59" fmla="*/ 744 h 747"/>
                <a:gd name="T60" fmla="*/ 49 w 596"/>
                <a:gd name="T61" fmla="*/ 747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Lst>
              <a:rect l="0" t="0" r="r" b="b"/>
              <a:pathLst>
                <a:path w="596" h="747">
                  <a:moveTo>
                    <a:pt x="49" y="747"/>
                  </a:moveTo>
                  <a:cubicBezTo>
                    <a:pt x="49" y="721"/>
                    <a:pt x="49" y="721"/>
                    <a:pt x="49" y="721"/>
                  </a:cubicBezTo>
                  <a:cubicBezTo>
                    <a:pt x="71" y="710"/>
                    <a:pt x="85" y="702"/>
                    <a:pt x="91" y="696"/>
                  </a:cubicBezTo>
                  <a:cubicBezTo>
                    <a:pt x="95" y="693"/>
                    <a:pt x="98" y="689"/>
                    <a:pt x="99" y="684"/>
                  </a:cubicBezTo>
                  <a:cubicBezTo>
                    <a:pt x="102" y="675"/>
                    <a:pt x="104" y="654"/>
                    <a:pt x="105" y="621"/>
                  </a:cubicBezTo>
                  <a:cubicBezTo>
                    <a:pt x="108" y="573"/>
                    <a:pt x="109" y="545"/>
                    <a:pt x="109" y="535"/>
                  </a:cubicBezTo>
                  <a:cubicBezTo>
                    <a:pt x="109" y="252"/>
                    <a:pt x="109" y="252"/>
                    <a:pt x="109" y="252"/>
                  </a:cubicBezTo>
                  <a:cubicBezTo>
                    <a:pt x="109" y="204"/>
                    <a:pt x="108" y="157"/>
                    <a:pt x="105" y="112"/>
                  </a:cubicBezTo>
                  <a:cubicBezTo>
                    <a:pt x="104" y="78"/>
                    <a:pt x="102" y="59"/>
                    <a:pt x="98" y="52"/>
                  </a:cubicBezTo>
                  <a:cubicBezTo>
                    <a:pt x="93" y="46"/>
                    <a:pt x="87" y="42"/>
                    <a:pt x="78" y="39"/>
                  </a:cubicBezTo>
                  <a:cubicBezTo>
                    <a:pt x="69" y="36"/>
                    <a:pt x="43" y="34"/>
                    <a:pt x="0" y="33"/>
                  </a:cubicBezTo>
                  <a:cubicBezTo>
                    <a:pt x="0" y="0"/>
                    <a:pt x="0" y="0"/>
                    <a:pt x="0" y="0"/>
                  </a:cubicBezTo>
                  <a:cubicBezTo>
                    <a:pt x="89" y="2"/>
                    <a:pt x="144" y="3"/>
                    <a:pt x="165" y="3"/>
                  </a:cubicBezTo>
                  <a:cubicBezTo>
                    <a:pt x="189" y="3"/>
                    <a:pt x="241" y="2"/>
                    <a:pt x="323" y="0"/>
                  </a:cubicBezTo>
                  <a:cubicBezTo>
                    <a:pt x="323" y="33"/>
                    <a:pt x="323" y="33"/>
                    <a:pt x="323" y="33"/>
                  </a:cubicBezTo>
                  <a:cubicBezTo>
                    <a:pt x="279" y="34"/>
                    <a:pt x="253" y="36"/>
                    <a:pt x="243" y="39"/>
                  </a:cubicBezTo>
                  <a:cubicBezTo>
                    <a:pt x="234" y="42"/>
                    <a:pt x="228" y="46"/>
                    <a:pt x="224" y="51"/>
                  </a:cubicBezTo>
                  <a:cubicBezTo>
                    <a:pt x="220" y="58"/>
                    <a:pt x="217" y="75"/>
                    <a:pt x="216" y="102"/>
                  </a:cubicBezTo>
                  <a:cubicBezTo>
                    <a:pt x="215" y="109"/>
                    <a:pt x="214" y="159"/>
                    <a:pt x="213" y="252"/>
                  </a:cubicBezTo>
                  <a:cubicBezTo>
                    <a:pt x="213" y="606"/>
                    <a:pt x="213" y="606"/>
                    <a:pt x="213" y="606"/>
                  </a:cubicBezTo>
                  <a:cubicBezTo>
                    <a:pt x="213" y="643"/>
                    <a:pt x="214" y="673"/>
                    <a:pt x="216" y="696"/>
                  </a:cubicBezTo>
                  <a:cubicBezTo>
                    <a:pt x="257" y="699"/>
                    <a:pt x="262" y="700"/>
                    <a:pt x="303" y="700"/>
                  </a:cubicBezTo>
                  <a:cubicBezTo>
                    <a:pt x="407" y="700"/>
                    <a:pt x="484" y="693"/>
                    <a:pt x="525" y="681"/>
                  </a:cubicBezTo>
                  <a:cubicBezTo>
                    <a:pt x="530" y="670"/>
                    <a:pt x="534" y="658"/>
                    <a:pt x="538" y="644"/>
                  </a:cubicBezTo>
                  <a:cubicBezTo>
                    <a:pt x="560" y="557"/>
                    <a:pt x="560" y="557"/>
                    <a:pt x="560" y="557"/>
                  </a:cubicBezTo>
                  <a:cubicBezTo>
                    <a:pt x="596" y="557"/>
                    <a:pt x="596" y="557"/>
                    <a:pt x="596" y="557"/>
                  </a:cubicBezTo>
                  <a:cubicBezTo>
                    <a:pt x="588" y="609"/>
                    <a:pt x="580" y="671"/>
                    <a:pt x="573" y="741"/>
                  </a:cubicBezTo>
                  <a:cubicBezTo>
                    <a:pt x="558" y="744"/>
                    <a:pt x="546" y="745"/>
                    <a:pt x="537" y="746"/>
                  </a:cubicBezTo>
                  <a:cubicBezTo>
                    <a:pt x="518" y="747"/>
                    <a:pt x="488" y="747"/>
                    <a:pt x="449" y="747"/>
                  </a:cubicBezTo>
                  <a:cubicBezTo>
                    <a:pt x="156" y="744"/>
                    <a:pt x="156" y="744"/>
                    <a:pt x="156" y="744"/>
                  </a:cubicBezTo>
                  <a:cubicBezTo>
                    <a:pt x="121" y="744"/>
                    <a:pt x="85" y="745"/>
                    <a:pt x="49"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6" name="Freeform 7"/>
            <p:cNvSpPr>
              <a:spLocks/>
            </p:cNvSpPr>
            <p:nvPr userDrawn="1"/>
          </p:nvSpPr>
          <p:spPr bwMode="auto">
            <a:xfrm>
              <a:off x="1127125" y="1003301"/>
              <a:ext cx="103188" cy="236538"/>
            </a:xfrm>
            <a:custGeom>
              <a:avLst/>
              <a:gdLst>
                <a:gd name="T0" fmla="*/ 321 w 321"/>
                <a:gd name="T1" fmla="*/ 714 h 747"/>
                <a:gd name="T2" fmla="*/ 321 w 321"/>
                <a:gd name="T3" fmla="*/ 747 h 747"/>
                <a:gd name="T4" fmla="*/ 168 w 321"/>
                <a:gd name="T5" fmla="*/ 744 h 747"/>
                <a:gd name="T6" fmla="*/ 0 w 321"/>
                <a:gd name="T7" fmla="*/ 747 h 747"/>
                <a:gd name="T8" fmla="*/ 0 w 321"/>
                <a:gd name="T9" fmla="*/ 714 h 747"/>
                <a:gd name="T10" fmla="*/ 77 w 321"/>
                <a:gd name="T11" fmla="*/ 708 h 747"/>
                <a:gd name="T12" fmla="*/ 97 w 321"/>
                <a:gd name="T13" fmla="*/ 696 h 747"/>
                <a:gd name="T14" fmla="*/ 105 w 321"/>
                <a:gd name="T15" fmla="*/ 645 h 747"/>
                <a:gd name="T16" fmla="*/ 108 w 321"/>
                <a:gd name="T17" fmla="*/ 495 h 747"/>
                <a:gd name="T18" fmla="*/ 108 w 321"/>
                <a:gd name="T19" fmla="*/ 251 h 747"/>
                <a:gd name="T20" fmla="*/ 105 w 321"/>
                <a:gd name="T21" fmla="*/ 111 h 747"/>
                <a:gd name="T22" fmla="*/ 97 w 321"/>
                <a:gd name="T23" fmla="*/ 52 h 747"/>
                <a:gd name="T24" fmla="*/ 77 w 321"/>
                <a:gd name="T25" fmla="*/ 39 h 747"/>
                <a:gd name="T26" fmla="*/ 0 w 321"/>
                <a:gd name="T27" fmla="*/ 33 h 747"/>
                <a:gd name="T28" fmla="*/ 0 w 321"/>
                <a:gd name="T29" fmla="*/ 0 h 747"/>
                <a:gd name="T30" fmla="*/ 161 w 321"/>
                <a:gd name="T31" fmla="*/ 3 h 747"/>
                <a:gd name="T32" fmla="*/ 321 w 321"/>
                <a:gd name="T33" fmla="*/ 0 h 747"/>
                <a:gd name="T34" fmla="*/ 321 w 321"/>
                <a:gd name="T35" fmla="*/ 33 h 747"/>
                <a:gd name="T36" fmla="*/ 243 w 321"/>
                <a:gd name="T37" fmla="*/ 39 h 747"/>
                <a:gd name="T38" fmla="*/ 224 w 321"/>
                <a:gd name="T39" fmla="*/ 51 h 747"/>
                <a:gd name="T40" fmla="*/ 216 w 321"/>
                <a:gd name="T41" fmla="*/ 102 h 747"/>
                <a:gd name="T42" fmla="*/ 212 w 321"/>
                <a:gd name="T43" fmla="*/ 251 h 747"/>
                <a:gd name="T44" fmla="*/ 212 w 321"/>
                <a:gd name="T45" fmla="*/ 495 h 747"/>
                <a:gd name="T46" fmla="*/ 214 w 321"/>
                <a:gd name="T47" fmla="*/ 635 h 747"/>
                <a:gd name="T48" fmla="*/ 222 w 321"/>
                <a:gd name="T49" fmla="*/ 694 h 747"/>
                <a:gd name="T50" fmla="*/ 242 w 321"/>
                <a:gd name="T51" fmla="*/ 708 h 747"/>
                <a:gd name="T52" fmla="*/ 321 w 321"/>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1" h="747">
                  <a:moveTo>
                    <a:pt x="321" y="714"/>
                  </a:moveTo>
                  <a:cubicBezTo>
                    <a:pt x="321" y="747"/>
                    <a:pt x="321" y="747"/>
                    <a:pt x="321" y="747"/>
                  </a:cubicBezTo>
                  <a:cubicBezTo>
                    <a:pt x="244" y="745"/>
                    <a:pt x="193" y="744"/>
                    <a:pt x="168" y="744"/>
                  </a:cubicBezTo>
                  <a:cubicBezTo>
                    <a:pt x="0" y="747"/>
                    <a:pt x="0" y="747"/>
                    <a:pt x="0" y="747"/>
                  </a:cubicBezTo>
                  <a:cubicBezTo>
                    <a:pt x="0" y="714"/>
                    <a:pt x="0" y="714"/>
                    <a:pt x="0" y="714"/>
                  </a:cubicBezTo>
                  <a:cubicBezTo>
                    <a:pt x="42" y="713"/>
                    <a:pt x="68" y="711"/>
                    <a:pt x="77" y="708"/>
                  </a:cubicBezTo>
                  <a:cubicBezTo>
                    <a:pt x="87" y="705"/>
                    <a:pt x="93" y="701"/>
                    <a:pt x="97" y="696"/>
                  </a:cubicBezTo>
                  <a:cubicBezTo>
                    <a:pt x="101" y="689"/>
                    <a:pt x="104" y="672"/>
                    <a:pt x="105" y="645"/>
                  </a:cubicBezTo>
                  <a:cubicBezTo>
                    <a:pt x="106" y="637"/>
                    <a:pt x="107" y="587"/>
                    <a:pt x="108" y="495"/>
                  </a:cubicBezTo>
                  <a:cubicBezTo>
                    <a:pt x="108" y="251"/>
                    <a:pt x="108" y="251"/>
                    <a:pt x="108" y="251"/>
                  </a:cubicBezTo>
                  <a:cubicBezTo>
                    <a:pt x="108" y="204"/>
                    <a:pt x="107" y="157"/>
                    <a:pt x="105" y="111"/>
                  </a:cubicBezTo>
                  <a:cubicBezTo>
                    <a:pt x="104" y="78"/>
                    <a:pt x="102" y="59"/>
                    <a:pt x="97" y="52"/>
                  </a:cubicBezTo>
                  <a:cubicBezTo>
                    <a:pt x="93" y="46"/>
                    <a:pt x="87" y="41"/>
                    <a:pt x="77" y="39"/>
                  </a:cubicBezTo>
                  <a:cubicBezTo>
                    <a:pt x="68" y="36"/>
                    <a:pt x="42" y="34"/>
                    <a:pt x="0" y="33"/>
                  </a:cubicBezTo>
                  <a:cubicBezTo>
                    <a:pt x="0" y="0"/>
                    <a:pt x="0" y="0"/>
                    <a:pt x="0" y="0"/>
                  </a:cubicBezTo>
                  <a:cubicBezTo>
                    <a:pt x="69" y="2"/>
                    <a:pt x="123" y="3"/>
                    <a:pt x="161" y="3"/>
                  </a:cubicBezTo>
                  <a:cubicBezTo>
                    <a:pt x="197" y="3"/>
                    <a:pt x="250" y="2"/>
                    <a:pt x="321" y="0"/>
                  </a:cubicBezTo>
                  <a:cubicBezTo>
                    <a:pt x="321" y="33"/>
                    <a:pt x="321" y="33"/>
                    <a:pt x="321" y="33"/>
                  </a:cubicBezTo>
                  <a:cubicBezTo>
                    <a:pt x="278" y="34"/>
                    <a:pt x="252" y="36"/>
                    <a:pt x="243" y="39"/>
                  </a:cubicBezTo>
                  <a:cubicBezTo>
                    <a:pt x="234" y="41"/>
                    <a:pt x="227" y="46"/>
                    <a:pt x="224" y="51"/>
                  </a:cubicBezTo>
                  <a:cubicBezTo>
                    <a:pt x="219" y="58"/>
                    <a:pt x="217" y="75"/>
                    <a:pt x="216" y="102"/>
                  </a:cubicBezTo>
                  <a:cubicBezTo>
                    <a:pt x="215" y="109"/>
                    <a:pt x="214" y="159"/>
                    <a:pt x="212" y="251"/>
                  </a:cubicBezTo>
                  <a:cubicBezTo>
                    <a:pt x="212" y="495"/>
                    <a:pt x="212" y="495"/>
                    <a:pt x="212" y="495"/>
                  </a:cubicBezTo>
                  <a:cubicBezTo>
                    <a:pt x="212" y="543"/>
                    <a:pt x="213" y="589"/>
                    <a:pt x="214" y="635"/>
                  </a:cubicBezTo>
                  <a:cubicBezTo>
                    <a:pt x="215" y="668"/>
                    <a:pt x="218" y="688"/>
                    <a:pt x="222" y="694"/>
                  </a:cubicBezTo>
                  <a:cubicBezTo>
                    <a:pt x="226" y="700"/>
                    <a:pt x="233" y="705"/>
                    <a:pt x="242" y="708"/>
                  </a:cubicBezTo>
                  <a:cubicBezTo>
                    <a:pt x="251" y="711"/>
                    <a:pt x="278" y="713"/>
                    <a:pt x="321"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7" name="Freeform 8"/>
            <p:cNvSpPr>
              <a:spLocks/>
            </p:cNvSpPr>
            <p:nvPr userDrawn="1"/>
          </p:nvSpPr>
          <p:spPr bwMode="auto">
            <a:xfrm>
              <a:off x="1266825" y="1003301"/>
              <a:ext cx="276225" cy="242888"/>
            </a:xfrm>
            <a:custGeom>
              <a:avLst/>
              <a:gdLst>
                <a:gd name="T0" fmla="*/ 5 w 869"/>
                <a:gd name="T1" fmla="*/ 747 h 766"/>
                <a:gd name="T2" fmla="*/ 5 w 869"/>
                <a:gd name="T3" fmla="*/ 714 h 766"/>
                <a:gd name="T4" fmla="*/ 80 w 869"/>
                <a:gd name="T5" fmla="*/ 705 h 766"/>
                <a:gd name="T6" fmla="*/ 91 w 869"/>
                <a:gd name="T7" fmla="*/ 695 h 766"/>
                <a:gd name="T8" fmla="*/ 99 w 869"/>
                <a:gd name="T9" fmla="*/ 640 h 766"/>
                <a:gd name="T10" fmla="*/ 102 w 869"/>
                <a:gd name="T11" fmla="*/ 520 h 766"/>
                <a:gd name="T12" fmla="*/ 102 w 869"/>
                <a:gd name="T13" fmla="*/ 92 h 766"/>
                <a:gd name="T14" fmla="*/ 100 w 869"/>
                <a:gd name="T15" fmla="*/ 69 h 766"/>
                <a:gd name="T16" fmla="*/ 80 w 869"/>
                <a:gd name="T17" fmla="*/ 47 h 766"/>
                <a:gd name="T18" fmla="*/ 57 w 869"/>
                <a:gd name="T19" fmla="*/ 36 h 766"/>
                <a:gd name="T20" fmla="*/ 0 w 869"/>
                <a:gd name="T21" fmla="*/ 33 h 766"/>
                <a:gd name="T22" fmla="*/ 0 w 869"/>
                <a:gd name="T23" fmla="*/ 0 h 766"/>
                <a:gd name="T24" fmla="*/ 119 w 869"/>
                <a:gd name="T25" fmla="*/ 3 h 766"/>
                <a:gd name="T26" fmla="*/ 202 w 869"/>
                <a:gd name="T27" fmla="*/ 0 h 766"/>
                <a:gd name="T28" fmla="*/ 269 w 869"/>
                <a:gd name="T29" fmla="*/ 86 h 766"/>
                <a:gd name="T30" fmla="*/ 381 w 869"/>
                <a:gd name="T31" fmla="*/ 220 h 766"/>
                <a:gd name="T32" fmla="*/ 545 w 869"/>
                <a:gd name="T33" fmla="*/ 411 h 766"/>
                <a:gd name="T34" fmla="*/ 671 w 869"/>
                <a:gd name="T35" fmla="*/ 554 h 766"/>
                <a:gd name="T36" fmla="*/ 721 w 869"/>
                <a:gd name="T37" fmla="*/ 609 h 766"/>
                <a:gd name="T38" fmla="*/ 721 w 869"/>
                <a:gd name="T39" fmla="*/ 226 h 766"/>
                <a:gd name="T40" fmla="*/ 718 w 869"/>
                <a:gd name="T41" fmla="*/ 105 h 766"/>
                <a:gd name="T42" fmla="*/ 711 w 869"/>
                <a:gd name="T43" fmla="*/ 51 h 766"/>
                <a:gd name="T44" fmla="*/ 699 w 869"/>
                <a:gd name="T45" fmla="*/ 41 h 766"/>
                <a:gd name="T46" fmla="*/ 624 w 869"/>
                <a:gd name="T47" fmla="*/ 33 h 766"/>
                <a:gd name="T48" fmla="*/ 624 w 869"/>
                <a:gd name="T49" fmla="*/ 0 h 766"/>
                <a:gd name="T50" fmla="*/ 756 w 869"/>
                <a:gd name="T51" fmla="*/ 3 h 766"/>
                <a:gd name="T52" fmla="*/ 869 w 869"/>
                <a:gd name="T53" fmla="*/ 0 h 766"/>
                <a:gd name="T54" fmla="*/ 869 w 869"/>
                <a:gd name="T55" fmla="*/ 33 h 766"/>
                <a:gd name="T56" fmla="*/ 794 w 869"/>
                <a:gd name="T57" fmla="*/ 41 h 766"/>
                <a:gd name="T58" fmla="*/ 783 w 869"/>
                <a:gd name="T59" fmla="*/ 52 h 766"/>
                <a:gd name="T60" fmla="*/ 775 w 869"/>
                <a:gd name="T61" fmla="*/ 107 h 766"/>
                <a:gd name="T62" fmla="*/ 772 w 869"/>
                <a:gd name="T63" fmla="*/ 226 h 766"/>
                <a:gd name="T64" fmla="*/ 772 w 869"/>
                <a:gd name="T65" fmla="*/ 479 h 766"/>
                <a:gd name="T66" fmla="*/ 775 w 869"/>
                <a:gd name="T67" fmla="*/ 766 h 766"/>
                <a:gd name="T68" fmla="*/ 721 w 869"/>
                <a:gd name="T69" fmla="*/ 766 h 766"/>
                <a:gd name="T70" fmla="*/ 707 w 869"/>
                <a:gd name="T71" fmla="*/ 752 h 766"/>
                <a:gd name="T72" fmla="*/ 698 w 869"/>
                <a:gd name="T73" fmla="*/ 744 h 766"/>
                <a:gd name="T74" fmla="*/ 678 w 869"/>
                <a:gd name="T75" fmla="*/ 723 h 766"/>
                <a:gd name="T76" fmla="*/ 611 w 869"/>
                <a:gd name="T77" fmla="*/ 647 h 766"/>
                <a:gd name="T78" fmla="*/ 540 w 869"/>
                <a:gd name="T79" fmla="*/ 560 h 766"/>
                <a:gd name="T80" fmla="*/ 151 w 869"/>
                <a:gd name="T81" fmla="*/ 110 h 766"/>
                <a:gd name="T82" fmla="*/ 151 w 869"/>
                <a:gd name="T83" fmla="*/ 518 h 766"/>
                <a:gd name="T84" fmla="*/ 154 w 869"/>
                <a:gd name="T85" fmla="*/ 641 h 766"/>
                <a:gd name="T86" fmla="*/ 161 w 869"/>
                <a:gd name="T87" fmla="*/ 695 h 766"/>
                <a:gd name="T88" fmla="*/ 173 w 869"/>
                <a:gd name="T89" fmla="*/ 705 h 766"/>
                <a:gd name="T90" fmla="*/ 249 w 869"/>
                <a:gd name="T91" fmla="*/ 714 h 766"/>
                <a:gd name="T92" fmla="*/ 249 w 869"/>
                <a:gd name="T93" fmla="*/ 747 h 766"/>
                <a:gd name="T94" fmla="*/ 143 w 869"/>
                <a:gd name="T95" fmla="*/ 744 h 766"/>
                <a:gd name="T96" fmla="*/ 5 w 869"/>
                <a:gd name="T97" fmla="*/ 747 h 76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869" h="766">
                  <a:moveTo>
                    <a:pt x="5" y="747"/>
                  </a:moveTo>
                  <a:cubicBezTo>
                    <a:pt x="5" y="714"/>
                    <a:pt x="5" y="714"/>
                    <a:pt x="5" y="714"/>
                  </a:cubicBezTo>
                  <a:cubicBezTo>
                    <a:pt x="43" y="714"/>
                    <a:pt x="68" y="711"/>
                    <a:pt x="80" y="705"/>
                  </a:cubicBezTo>
                  <a:cubicBezTo>
                    <a:pt x="86" y="703"/>
                    <a:pt x="89" y="700"/>
                    <a:pt x="91" y="695"/>
                  </a:cubicBezTo>
                  <a:cubicBezTo>
                    <a:pt x="95" y="688"/>
                    <a:pt x="98" y="670"/>
                    <a:pt x="99" y="640"/>
                  </a:cubicBezTo>
                  <a:cubicBezTo>
                    <a:pt x="101" y="594"/>
                    <a:pt x="102" y="554"/>
                    <a:pt x="102" y="520"/>
                  </a:cubicBezTo>
                  <a:cubicBezTo>
                    <a:pt x="102" y="92"/>
                    <a:pt x="102" y="92"/>
                    <a:pt x="102" y="92"/>
                  </a:cubicBezTo>
                  <a:cubicBezTo>
                    <a:pt x="102" y="80"/>
                    <a:pt x="102" y="73"/>
                    <a:pt x="100" y="69"/>
                  </a:cubicBezTo>
                  <a:cubicBezTo>
                    <a:pt x="97" y="63"/>
                    <a:pt x="91" y="56"/>
                    <a:pt x="80" y="47"/>
                  </a:cubicBezTo>
                  <a:cubicBezTo>
                    <a:pt x="74" y="41"/>
                    <a:pt x="66" y="38"/>
                    <a:pt x="57" y="36"/>
                  </a:cubicBezTo>
                  <a:cubicBezTo>
                    <a:pt x="49" y="34"/>
                    <a:pt x="30" y="33"/>
                    <a:pt x="0" y="33"/>
                  </a:cubicBezTo>
                  <a:cubicBezTo>
                    <a:pt x="0" y="0"/>
                    <a:pt x="0" y="0"/>
                    <a:pt x="0" y="0"/>
                  </a:cubicBezTo>
                  <a:cubicBezTo>
                    <a:pt x="63" y="2"/>
                    <a:pt x="103" y="3"/>
                    <a:pt x="119" y="3"/>
                  </a:cubicBezTo>
                  <a:cubicBezTo>
                    <a:pt x="147" y="3"/>
                    <a:pt x="174" y="2"/>
                    <a:pt x="202" y="0"/>
                  </a:cubicBezTo>
                  <a:cubicBezTo>
                    <a:pt x="232" y="39"/>
                    <a:pt x="255" y="67"/>
                    <a:pt x="269" y="86"/>
                  </a:cubicBezTo>
                  <a:cubicBezTo>
                    <a:pt x="381" y="220"/>
                    <a:pt x="381" y="220"/>
                    <a:pt x="381" y="220"/>
                  </a:cubicBezTo>
                  <a:cubicBezTo>
                    <a:pt x="545" y="411"/>
                    <a:pt x="545" y="411"/>
                    <a:pt x="545" y="411"/>
                  </a:cubicBezTo>
                  <a:cubicBezTo>
                    <a:pt x="597" y="472"/>
                    <a:pt x="639" y="520"/>
                    <a:pt x="671" y="554"/>
                  </a:cubicBezTo>
                  <a:cubicBezTo>
                    <a:pt x="691" y="578"/>
                    <a:pt x="708" y="596"/>
                    <a:pt x="721" y="609"/>
                  </a:cubicBezTo>
                  <a:cubicBezTo>
                    <a:pt x="721" y="226"/>
                    <a:pt x="721" y="226"/>
                    <a:pt x="721" y="226"/>
                  </a:cubicBezTo>
                  <a:cubicBezTo>
                    <a:pt x="721" y="191"/>
                    <a:pt x="720" y="151"/>
                    <a:pt x="718" y="105"/>
                  </a:cubicBezTo>
                  <a:cubicBezTo>
                    <a:pt x="717" y="76"/>
                    <a:pt x="714" y="58"/>
                    <a:pt x="711" y="51"/>
                  </a:cubicBezTo>
                  <a:cubicBezTo>
                    <a:pt x="708" y="46"/>
                    <a:pt x="705" y="43"/>
                    <a:pt x="699" y="41"/>
                  </a:cubicBezTo>
                  <a:cubicBezTo>
                    <a:pt x="687" y="36"/>
                    <a:pt x="662" y="33"/>
                    <a:pt x="624" y="33"/>
                  </a:cubicBezTo>
                  <a:cubicBezTo>
                    <a:pt x="624" y="0"/>
                    <a:pt x="624" y="0"/>
                    <a:pt x="624" y="0"/>
                  </a:cubicBezTo>
                  <a:cubicBezTo>
                    <a:pt x="667" y="2"/>
                    <a:pt x="711" y="3"/>
                    <a:pt x="756" y="3"/>
                  </a:cubicBezTo>
                  <a:cubicBezTo>
                    <a:pt x="797" y="3"/>
                    <a:pt x="835" y="2"/>
                    <a:pt x="869" y="0"/>
                  </a:cubicBezTo>
                  <a:cubicBezTo>
                    <a:pt x="869" y="33"/>
                    <a:pt x="869" y="33"/>
                    <a:pt x="869" y="33"/>
                  </a:cubicBezTo>
                  <a:cubicBezTo>
                    <a:pt x="831" y="33"/>
                    <a:pt x="806" y="36"/>
                    <a:pt x="794" y="41"/>
                  </a:cubicBezTo>
                  <a:cubicBezTo>
                    <a:pt x="789" y="43"/>
                    <a:pt x="785" y="47"/>
                    <a:pt x="783" y="52"/>
                  </a:cubicBezTo>
                  <a:cubicBezTo>
                    <a:pt x="779" y="58"/>
                    <a:pt x="776" y="77"/>
                    <a:pt x="775" y="107"/>
                  </a:cubicBezTo>
                  <a:cubicBezTo>
                    <a:pt x="773" y="153"/>
                    <a:pt x="772" y="193"/>
                    <a:pt x="772" y="226"/>
                  </a:cubicBezTo>
                  <a:cubicBezTo>
                    <a:pt x="772" y="479"/>
                    <a:pt x="772" y="479"/>
                    <a:pt x="772" y="479"/>
                  </a:cubicBezTo>
                  <a:cubicBezTo>
                    <a:pt x="772" y="531"/>
                    <a:pt x="773" y="626"/>
                    <a:pt x="775" y="766"/>
                  </a:cubicBezTo>
                  <a:cubicBezTo>
                    <a:pt x="721" y="766"/>
                    <a:pt x="721" y="766"/>
                    <a:pt x="721" y="766"/>
                  </a:cubicBezTo>
                  <a:cubicBezTo>
                    <a:pt x="707" y="752"/>
                    <a:pt x="707" y="752"/>
                    <a:pt x="707" y="752"/>
                  </a:cubicBezTo>
                  <a:cubicBezTo>
                    <a:pt x="705" y="751"/>
                    <a:pt x="700" y="746"/>
                    <a:pt x="698" y="744"/>
                  </a:cubicBezTo>
                  <a:cubicBezTo>
                    <a:pt x="696" y="742"/>
                    <a:pt x="689" y="735"/>
                    <a:pt x="678" y="723"/>
                  </a:cubicBezTo>
                  <a:cubicBezTo>
                    <a:pt x="647" y="689"/>
                    <a:pt x="625" y="664"/>
                    <a:pt x="611" y="647"/>
                  </a:cubicBezTo>
                  <a:cubicBezTo>
                    <a:pt x="540" y="560"/>
                    <a:pt x="540" y="560"/>
                    <a:pt x="540" y="560"/>
                  </a:cubicBezTo>
                  <a:cubicBezTo>
                    <a:pt x="151" y="110"/>
                    <a:pt x="151" y="110"/>
                    <a:pt x="151" y="110"/>
                  </a:cubicBezTo>
                  <a:cubicBezTo>
                    <a:pt x="151" y="518"/>
                    <a:pt x="151" y="518"/>
                    <a:pt x="151" y="518"/>
                  </a:cubicBezTo>
                  <a:cubicBezTo>
                    <a:pt x="151" y="552"/>
                    <a:pt x="152" y="593"/>
                    <a:pt x="154" y="641"/>
                  </a:cubicBezTo>
                  <a:cubicBezTo>
                    <a:pt x="156" y="670"/>
                    <a:pt x="158" y="688"/>
                    <a:pt x="161" y="695"/>
                  </a:cubicBezTo>
                  <a:cubicBezTo>
                    <a:pt x="164" y="700"/>
                    <a:pt x="168" y="704"/>
                    <a:pt x="173" y="705"/>
                  </a:cubicBezTo>
                  <a:cubicBezTo>
                    <a:pt x="185" y="711"/>
                    <a:pt x="210" y="714"/>
                    <a:pt x="249" y="714"/>
                  </a:cubicBezTo>
                  <a:cubicBezTo>
                    <a:pt x="249" y="747"/>
                    <a:pt x="249" y="747"/>
                    <a:pt x="249" y="747"/>
                  </a:cubicBezTo>
                  <a:cubicBezTo>
                    <a:pt x="217" y="745"/>
                    <a:pt x="181" y="744"/>
                    <a:pt x="143" y="744"/>
                  </a:cubicBezTo>
                  <a:cubicBezTo>
                    <a:pt x="100" y="744"/>
                    <a:pt x="54" y="745"/>
                    <a:pt x="5"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8" name="Freeform 9"/>
            <p:cNvSpPr>
              <a:spLocks/>
            </p:cNvSpPr>
            <p:nvPr userDrawn="1"/>
          </p:nvSpPr>
          <p:spPr bwMode="auto">
            <a:xfrm>
              <a:off x="1573213" y="1003301"/>
              <a:ext cx="101600" cy="236538"/>
            </a:xfrm>
            <a:custGeom>
              <a:avLst/>
              <a:gdLst>
                <a:gd name="T0" fmla="*/ 322 w 322"/>
                <a:gd name="T1" fmla="*/ 714 h 747"/>
                <a:gd name="T2" fmla="*/ 322 w 322"/>
                <a:gd name="T3" fmla="*/ 747 h 747"/>
                <a:gd name="T4" fmla="*/ 169 w 322"/>
                <a:gd name="T5" fmla="*/ 744 h 747"/>
                <a:gd name="T6" fmla="*/ 0 w 322"/>
                <a:gd name="T7" fmla="*/ 747 h 747"/>
                <a:gd name="T8" fmla="*/ 0 w 322"/>
                <a:gd name="T9" fmla="*/ 714 h 747"/>
                <a:gd name="T10" fmla="*/ 79 w 322"/>
                <a:gd name="T11" fmla="*/ 708 h 747"/>
                <a:gd name="T12" fmla="*/ 98 w 322"/>
                <a:gd name="T13" fmla="*/ 696 h 747"/>
                <a:gd name="T14" fmla="*/ 106 w 322"/>
                <a:gd name="T15" fmla="*/ 645 h 747"/>
                <a:gd name="T16" fmla="*/ 109 w 322"/>
                <a:gd name="T17" fmla="*/ 495 h 747"/>
                <a:gd name="T18" fmla="*/ 109 w 322"/>
                <a:gd name="T19" fmla="*/ 251 h 747"/>
                <a:gd name="T20" fmla="*/ 106 w 322"/>
                <a:gd name="T21" fmla="*/ 111 h 747"/>
                <a:gd name="T22" fmla="*/ 98 w 322"/>
                <a:gd name="T23" fmla="*/ 52 h 747"/>
                <a:gd name="T24" fmla="*/ 78 w 322"/>
                <a:gd name="T25" fmla="*/ 39 h 747"/>
                <a:gd name="T26" fmla="*/ 0 w 322"/>
                <a:gd name="T27" fmla="*/ 33 h 747"/>
                <a:gd name="T28" fmla="*/ 0 w 322"/>
                <a:gd name="T29" fmla="*/ 0 h 747"/>
                <a:gd name="T30" fmla="*/ 161 w 322"/>
                <a:gd name="T31" fmla="*/ 3 h 747"/>
                <a:gd name="T32" fmla="*/ 322 w 322"/>
                <a:gd name="T33" fmla="*/ 0 h 747"/>
                <a:gd name="T34" fmla="*/ 322 w 322"/>
                <a:gd name="T35" fmla="*/ 33 h 747"/>
                <a:gd name="T36" fmla="*/ 244 w 322"/>
                <a:gd name="T37" fmla="*/ 39 h 747"/>
                <a:gd name="T38" fmla="*/ 224 w 322"/>
                <a:gd name="T39" fmla="*/ 51 h 747"/>
                <a:gd name="T40" fmla="*/ 216 w 322"/>
                <a:gd name="T41" fmla="*/ 102 h 747"/>
                <a:gd name="T42" fmla="*/ 213 w 322"/>
                <a:gd name="T43" fmla="*/ 251 h 747"/>
                <a:gd name="T44" fmla="*/ 213 w 322"/>
                <a:gd name="T45" fmla="*/ 495 h 747"/>
                <a:gd name="T46" fmla="*/ 215 w 322"/>
                <a:gd name="T47" fmla="*/ 635 h 747"/>
                <a:gd name="T48" fmla="*/ 223 w 322"/>
                <a:gd name="T49" fmla="*/ 694 h 747"/>
                <a:gd name="T50" fmla="*/ 243 w 322"/>
                <a:gd name="T51" fmla="*/ 708 h 747"/>
                <a:gd name="T52" fmla="*/ 322 w 322"/>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2" h="747">
                  <a:moveTo>
                    <a:pt x="322" y="714"/>
                  </a:moveTo>
                  <a:cubicBezTo>
                    <a:pt x="322" y="747"/>
                    <a:pt x="322" y="747"/>
                    <a:pt x="322" y="747"/>
                  </a:cubicBezTo>
                  <a:cubicBezTo>
                    <a:pt x="244" y="745"/>
                    <a:pt x="193" y="744"/>
                    <a:pt x="169" y="744"/>
                  </a:cubicBezTo>
                  <a:cubicBezTo>
                    <a:pt x="0" y="747"/>
                    <a:pt x="0" y="747"/>
                    <a:pt x="0" y="747"/>
                  </a:cubicBezTo>
                  <a:cubicBezTo>
                    <a:pt x="0" y="714"/>
                    <a:pt x="0" y="714"/>
                    <a:pt x="0" y="714"/>
                  </a:cubicBezTo>
                  <a:cubicBezTo>
                    <a:pt x="43" y="713"/>
                    <a:pt x="69" y="711"/>
                    <a:pt x="79" y="708"/>
                  </a:cubicBezTo>
                  <a:cubicBezTo>
                    <a:pt x="88" y="705"/>
                    <a:pt x="94" y="701"/>
                    <a:pt x="98" y="696"/>
                  </a:cubicBezTo>
                  <a:cubicBezTo>
                    <a:pt x="102" y="689"/>
                    <a:pt x="105" y="672"/>
                    <a:pt x="106" y="645"/>
                  </a:cubicBezTo>
                  <a:cubicBezTo>
                    <a:pt x="107" y="637"/>
                    <a:pt x="108" y="587"/>
                    <a:pt x="109" y="495"/>
                  </a:cubicBezTo>
                  <a:cubicBezTo>
                    <a:pt x="109" y="251"/>
                    <a:pt x="109" y="251"/>
                    <a:pt x="109" y="251"/>
                  </a:cubicBezTo>
                  <a:cubicBezTo>
                    <a:pt x="109" y="204"/>
                    <a:pt x="108" y="157"/>
                    <a:pt x="106" y="111"/>
                  </a:cubicBezTo>
                  <a:cubicBezTo>
                    <a:pt x="105" y="78"/>
                    <a:pt x="102" y="59"/>
                    <a:pt x="98" y="52"/>
                  </a:cubicBezTo>
                  <a:cubicBezTo>
                    <a:pt x="94" y="46"/>
                    <a:pt x="88" y="41"/>
                    <a:pt x="78" y="39"/>
                  </a:cubicBezTo>
                  <a:cubicBezTo>
                    <a:pt x="69" y="36"/>
                    <a:pt x="43" y="34"/>
                    <a:pt x="0" y="33"/>
                  </a:cubicBezTo>
                  <a:cubicBezTo>
                    <a:pt x="0" y="0"/>
                    <a:pt x="0" y="0"/>
                    <a:pt x="0" y="0"/>
                  </a:cubicBezTo>
                  <a:cubicBezTo>
                    <a:pt x="70" y="2"/>
                    <a:pt x="124" y="3"/>
                    <a:pt x="161" y="3"/>
                  </a:cubicBezTo>
                  <a:cubicBezTo>
                    <a:pt x="198" y="3"/>
                    <a:pt x="251" y="2"/>
                    <a:pt x="322" y="0"/>
                  </a:cubicBezTo>
                  <a:cubicBezTo>
                    <a:pt x="322" y="33"/>
                    <a:pt x="322" y="33"/>
                    <a:pt x="322" y="33"/>
                  </a:cubicBezTo>
                  <a:cubicBezTo>
                    <a:pt x="279" y="34"/>
                    <a:pt x="253" y="36"/>
                    <a:pt x="244" y="39"/>
                  </a:cubicBezTo>
                  <a:cubicBezTo>
                    <a:pt x="234" y="41"/>
                    <a:pt x="228" y="46"/>
                    <a:pt x="224" y="51"/>
                  </a:cubicBezTo>
                  <a:cubicBezTo>
                    <a:pt x="220" y="58"/>
                    <a:pt x="217" y="75"/>
                    <a:pt x="216" y="102"/>
                  </a:cubicBezTo>
                  <a:cubicBezTo>
                    <a:pt x="216" y="109"/>
                    <a:pt x="215" y="159"/>
                    <a:pt x="213" y="251"/>
                  </a:cubicBezTo>
                  <a:cubicBezTo>
                    <a:pt x="213" y="495"/>
                    <a:pt x="213" y="495"/>
                    <a:pt x="213" y="495"/>
                  </a:cubicBezTo>
                  <a:cubicBezTo>
                    <a:pt x="213" y="543"/>
                    <a:pt x="214" y="589"/>
                    <a:pt x="215" y="635"/>
                  </a:cubicBezTo>
                  <a:cubicBezTo>
                    <a:pt x="216" y="668"/>
                    <a:pt x="219" y="688"/>
                    <a:pt x="223" y="694"/>
                  </a:cubicBezTo>
                  <a:cubicBezTo>
                    <a:pt x="227" y="700"/>
                    <a:pt x="234" y="705"/>
                    <a:pt x="243" y="708"/>
                  </a:cubicBezTo>
                  <a:cubicBezTo>
                    <a:pt x="252" y="711"/>
                    <a:pt x="278" y="713"/>
                    <a:pt x="322"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9" name="Freeform 10"/>
            <p:cNvSpPr>
              <a:spLocks/>
            </p:cNvSpPr>
            <p:nvPr userDrawn="1"/>
          </p:nvSpPr>
          <p:spPr bwMode="auto">
            <a:xfrm>
              <a:off x="1692275" y="998538"/>
              <a:ext cx="231775" cy="246063"/>
            </a:xfrm>
            <a:custGeom>
              <a:avLst/>
              <a:gdLst>
                <a:gd name="T0" fmla="*/ 728 w 728"/>
                <a:gd name="T1" fmla="*/ 667 h 774"/>
                <a:gd name="T2" fmla="*/ 707 w 728"/>
                <a:gd name="T3" fmla="*/ 716 h 774"/>
                <a:gd name="T4" fmla="*/ 581 w 728"/>
                <a:gd name="T5" fmla="*/ 761 h 774"/>
                <a:gd name="T6" fmla="*/ 447 w 728"/>
                <a:gd name="T7" fmla="*/ 774 h 774"/>
                <a:gd name="T8" fmla="*/ 288 w 728"/>
                <a:gd name="T9" fmla="*/ 754 h 774"/>
                <a:gd name="T10" fmla="*/ 161 w 728"/>
                <a:gd name="T11" fmla="*/ 696 h 774"/>
                <a:gd name="T12" fmla="*/ 71 w 728"/>
                <a:gd name="T13" fmla="*/ 610 h 774"/>
                <a:gd name="T14" fmla="*/ 18 w 728"/>
                <a:gd name="T15" fmla="*/ 508 h 774"/>
                <a:gd name="T16" fmla="*/ 0 w 728"/>
                <a:gd name="T17" fmla="*/ 386 h 774"/>
                <a:gd name="T18" fmla="*/ 123 w 728"/>
                <a:gd name="T19" fmla="*/ 110 h 774"/>
                <a:gd name="T20" fmla="*/ 457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5 w 728"/>
                <a:gd name="T35" fmla="*/ 143 h 774"/>
                <a:gd name="T36" fmla="*/ 605 w 728"/>
                <a:gd name="T37" fmla="*/ 66 h 774"/>
                <a:gd name="T38" fmla="*/ 446 w 728"/>
                <a:gd name="T39" fmla="*/ 41 h 774"/>
                <a:gd name="T40" fmla="*/ 313 w 728"/>
                <a:gd name="T41" fmla="*/ 60 h 774"/>
                <a:gd name="T42" fmla="*/ 217 w 728"/>
                <a:gd name="T43" fmla="*/ 117 h 774"/>
                <a:gd name="T44" fmla="*/ 149 w 728"/>
                <a:gd name="T45" fmla="*/ 216 h 774"/>
                <a:gd name="T46" fmla="*/ 122 w 728"/>
                <a:gd name="T47" fmla="*/ 366 h 774"/>
                <a:gd name="T48" fmla="*/ 223 w 728"/>
                <a:gd name="T49" fmla="*/ 621 h 774"/>
                <a:gd name="T50" fmla="*/ 492 w 728"/>
                <a:gd name="T51" fmla="*/ 717 h 774"/>
                <a:gd name="T52" fmla="*/ 632 w 728"/>
                <a:gd name="T53" fmla="*/ 698 h 774"/>
                <a:gd name="T54" fmla="*/ 719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7" y="716"/>
                    <a:pt x="707" y="716"/>
                    <a:pt x="707" y="716"/>
                  </a:cubicBezTo>
                  <a:cubicBezTo>
                    <a:pt x="664" y="736"/>
                    <a:pt x="622" y="751"/>
                    <a:pt x="581" y="761"/>
                  </a:cubicBezTo>
                  <a:cubicBezTo>
                    <a:pt x="540" y="770"/>
                    <a:pt x="495" y="774"/>
                    <a:pt x="447" y="774"/>
                  </a:cubicBezTo>
                  <a:cubicBezTo>
                    <a:pt x="390" y="774"/>
                    <a:pt x="337" y="768"/>
                    <a:pt x="288" y="754"/>
                  </a:cubicBezTo>
                  <a:cubicBezTo>
                    <a:pt x="240" y="740"/>
                    <a:pt x="197" y="721"/>
                    <a:pt x="161" y="696"/>
                  </a:cubicBezTo>
                  <a:cubicBezTo>
                    <a:pt x="124" y="670"/>
                    <a:pt x="94" y="642"/>
                    <a:pt x="71" y="610"/>
                  </a:cubicBezTo>
                  <a:cubicBezTo>
                    <a:pt x="48" y="579"/>
                    <a:pt x="31" y="545"/>
                    <a:pt x="18" y="508"/>
                  </a:cubicBezTo>
                  <a:cubicBezTo>
                    <a:pt x="6" y="471"/>
                    <a:pt x="0" y="430"/>
                    <a:pt x="0" y="386"/>
                  </a:cubicBezTo>
                  <a:cubicBezTo>
                    <a:pt x="0" y="275"/>
                    <a:pt x="41" y="183"/>
                    <a:pt x="123" y="110"/>
                  </a:cubicBezTo>
                  <a:cubicBezTo>
                    <a:pt x="204" y="37"/>
                    <a:pt x="316" y="0"/>
                    <a:pt x="457" y="0"/>
                  </a:cubicBezTo>
                  <a:cubicBezTo>
                    <a:pt x="490" y="0"/>
                    <a:pt x="521" y="2"/>
                    <a:pt x="549" y="6"/>
                  </a:cubicBezTo>
                  <a:cubicBezTo>
                    <a:pt x="578"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5" y="143"/>
                    <a:pt x="665" y="143"/>
                    <a:pt x="665" y="143"/>
                  </a:cubicBezTo>
                  <a:cubicBezTo>
                    <a:pt x="661" y="109"/>
                    <a:pt x="641" y="83"/>
                    <a:pt x="605" y="66"/>
                  </a:cubicBezTo>
                  <a:cubicBezTo>
                    <a:pt x="569" y="50"/>
                    <a:pt x="516" y="41"/>
                    <a:pt x="446" y="41"/>
                  </a:cubicBezTo>
                  <a:cubicBezTo>
                    <a:pt x="393" y="42"/>
                    <a:pt x="349" y="48"/>
                    <a:pt x="313" y="60"/>
                  </a:cubicBezTo>
                  <a:cubicBezTo>
                    <a:pt x="277" y="72"/>
                    <a:pt x="245" y="91"/>
                    <a:pt x="217" y="117"/>
                  </a:cubicBezTo>
                  <a:cubicBezTo>
                    <a:pt x="189" y="143"/>
                    <a:pt x="166" y="176"/>
                    <a:pt x="149" y="216"/>
                  </a:cubicBezTo>
                  <a:cubicBezTo>
                    <a:pt x="131" y="256"/>
                    <a:pt x="122" y="306"/>
                    <a:pt x="122" y="366"/>
                  </a:cubicBezTo>
                  <a:cubicBezTo>
                    <a:pt x="122" y="472"/>
                    <a:pt x="155" y="557"/>
                    <a:pt x="223" y="621"/>
                  </a:cubicBezTo>
                  <a:cubicBezTo>
                    <a:pt x="291" y="685"/>
                    <a:pt x="380" y="717"/>
                    <a:pt x="492" y="717"/>
                  </a:cubicBezTo>
                  <a:cubicBezTo>
                    <a:pt x="542" y="717"/>
                    <a:pt x="589" y="711"/>
                    <a:pt x="632" y="698"/>
                  </a:cubicBezTo>
                  <a:cubicBezTo>
                    <a:pt x="661" y="689"/>
                    <a:pt x="690" y="675"/>
                    <a:pt x="719"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0" name="Freeform 11"/>
            <p:cNvSpPr>
              <a:spLocks/>
            </p:cNvSpPr>
            <p:nvPr userDrawn="1"/>
          </p:nvSpPr>
          <p:spPr bwMode="auto">
            <a:xfrm>
              <a:off x="657225" y="998538"/>
              <a:ext cx="231775" cy="246063"/>
            </a:xfrm>
            <a:custGeom>
              <a:avLst/>
              <a:gdLst>
                <a:gd name="T0" fmla="*/ 728 w 728"/>
                <a:gd name="T1" fmla="*/ 667 h 774"/>
                <a:gd name="T2" fmla="*/ 706 w 728"/>
                <a:gd name="T3" fmla="*/ 716 h 774"/>
                <a:gd name="T4" fmla="*/ 580 w 728"/>
                <a:gd name="T5" fmla="*/ 761 h 774"/>
                <a:gd name="T6" fmla="*/ 446 w 728"/>
                <a:gd name="T7" fmla="*/ 774 h 774"/>
                <a:gd name="T8" fmla="*/ 288 w 728"/>
                <a:gd name="T9" fmla="*/ 754 h 774"/>
                <a:gd name="T10" fmla="*/ 160 w 728"/>
                <a:gd name="T11" fmla="*/ 696 h 774"/>
                <a:gd name="T12" fmla="*/ 71 w 728"/>
                <a:gd name="T13" fmla="*/ 610 h 774"/>
                <a:gd name="T14" fmla="*/ 18 w 728"/>
                <a:gd name="T15" fmla="*/ 508 h 774"/>
                <a:gd name="T16" fmla="*/ 0 w 728"/>
                <a:gd name="T17" fmla="*/ 386 h 774"/>
                <a:gd name="T18" fmla="*/ 122 w 728"/>
                <a:gd name="T19" fmla="*/ 110 h 774"/>
                <a:gd name="T20" fmla="*/ 456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4 w 728"/>
                <a:gd name="T35" fmla="*/ 143 h 774"/>
                <a:gd name="T36" fmla="*/ 604 w 728"/>
                <a:gd name="T37" fmla="*/ 66 h 774"/>
                <a:gd name="T38" fmla="*/ 445 w 728"/>
                <a:gd name="T39" fmla="*/ 41 h 774"/>
                <a:gd name="T40" fmla="*/ 313 w 728"/>
                <a:gd name="T41" fmla="*/ 60 h 774"/>
                <a:gd name="T42" fmla="*/ 216 w 728"/>
                <a:gd name="T43" fmla="*/ 117 h 774"/>
                <a:gd name="T44" fmla="*/ 148 w 728"/>
                <a:gd name="T45" fmla="*/ 216 h 774"/>
                <a:gd name="T46" fmla="*/ 121 w 728"/>
                <a:gd name="T47" fmla="*/ 366 h 774"/>
                <a:gd name="T48" fmla="*/ 223 w 728"/>
                <a:gd name="T49" fmla="*/ 621 h 774"/>
                <a:gd name="T50" fmla="*/ 492 w 728"/>
                <a:gd name="T51" fmla="*/ 717 h 774"/>
                <a:gd name="T52" fmla="*/ 631 w 728"/>
                <a:gd name="T53" fmla="*/ 698 h 774"/>
                <a:gd name="T54" fmla="*/ 718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6" y="716"/>
                    <a:pt x="706" y="716"/>
                    <a:pt x="706" y="716"/>
                  </a:cubicBezTo>
                  <a:cubicBezTo>
                    <a:pt x="663" y="736"/>
                    <a:pt x="621" y="751"/>
                    <a:pt x="580" y="761"/>
                  </a:cubicBezTo>
                  <a:cubicBezTo>
                    <a:pt x="539" y="770"/>
                    <a:pt x="495" y="774"/>
                    <a:pt x="446" y="774"/>
                  </a:cubicBezTo>
                  <a:cubicBezTo>
                    <a:pt x="389" y="774"/>
                    <a:pt x="337" y="768"/>
                    <a:pt x="288" y="754"/>
                  </a:cubicBezTo>
                  <a:cubicBezTo>
                    <a:pt x="239" y="740"/>
                    <a:pt x="197" y="721"/>
                    <a:pt x="160" y="696"/>
                  </a:cubicBezTo>
                  <a:cubicBezTo>
                    <a:pt x="124" y="670"/>
                    <a:pt x="94" y="642"/>
                    <a:pt x="71" y="610"/>
                  </a:cubicBezTo>
                  <a:cubicBezTo>
                    <a:pt x="48" y="579"/>
                    <a:pt x="30" y="545"/>
                    <a:pt x="18" y="508"/>
                  </a:cubicBezTo>
                  <a:cubicBezTo>
                    <a:pt x="6" y="471"/>
                    <a:pt x="0" y="430"/>
                    <a:pt x="0" y="386"/>
                  </a:cubicBezTo>
                  <a:cubicBezTo>
                    <a:pt x="0" y="275"/>
                    <a:pt x="41" y="183"/>
                    <a:pt x="122" y="110"/>
                  </a:cubicBezTo>
                  <a:cubicBezTo>
                    <a:pt x="204" y="37"/>
                    <a:pt x="315" y="0"/>
                    <a:pt x="456" y="0"/>
                  </a:cubicBezTo>
                  <a:cubicBezTo>
                    <a:pt x="490" y="0"/>
                    <a:pt x="520" y="2"/>
                    <a:pt x="549" y="6"/>
                  </a:cubicBezTo>
                  <a:cubicBezTo>
                    <a:pt x="577"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4" y="143"/>
                    <a:pt x="664" y="143"/>
                    <a:pt x="664" y="143"/>
                  </a:cubicBezTo>
                  <a:cubicBezTo>
                    <a:pt x="661" y="109"/>
                    <a:pt x="641" y="83"/>
                    <a:pt x="604" y="66"/>
                  </a:cubicBezTo>
                  <a:cubicBezTo>
                    <a:pt x="568" y="50"/>
                    <a:pt x="515" y="41"/>
                    <a:pt x="445" y="41"/>
                  </a:cubicBezTo>
                  <a:cubicBezTo>
                    <a:pt x="393" y="42"/>
                    <a:pt x="349" y="48"/>
                    <a:pt x="313" y="60"/>
                  </a:cubicBezTo>
                  <a:cubicBezTo>
                    <a:pt x="276" y="72"/>
                    <a:pt x="244" y="91"/>
                    <a:pt x="216" y="117"/>
                  </a:cubicBezTo>
                  <a:cubicBezTo>
                    <a:pt x="189" y="143"/>
                    <a:pt x="166" y="176"/>
                    <a:pt x="148" y="216"/>
                  </a:cubicBezTo>
                  <a:cubicBezTo>
                    <a:pt x="131" y="256"/>
                    <a:pt x="122" y="306"/>
                    <a:pt x="121" y="366"/>
                  </a:cubicBezTo>
                  <a:cubicBezTo>
                    <a:pt x="121" y="472"/>
                    <a:pt x="155" y="557"/>
                    <a:pt x="223" y="621"/>
                  </a:cubicBezTo>
                  <a:cubicBezTo>
                    <a:pt x="290" y="685"/>
                    <a:pt x="380" y="717"/>
                    <a:pt x="492" y="717"/>
                  </a:cubicBezTo>
                  <a:cubicBezTo>
                    <a:pt x="542" y="717"/>
                    <a:pt x="588" y="711"/>
                    <a:pt x="631" y="698"/>
                  </a:cubicBezTo>
                  <a:cubicBezTo>
                    <a:pt x="660" y="689"/>
                    <a:pt x="689" y="675"/>
                    <a:pt x="718"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1" name="Freeform 12"/>
            <p:cNvSpPr>
              <a:spLocks/>
            </p:cNvSpPr>
            <p:nvPr userDrawn="1"/>
          </p:nvSpPr>
          <p:spPr bwMode="auto">
            <a:xfrm>
              <a:off x="757238" y="687388"/>
              <a:ext cx="323850" cy="239713"/>
            </a:xfrm>
            <a:custGeom>
              <a:avLst/>
              <a:gdLst>
                <a:gd name="T0" fmla="*/ 0 w 1017"/>
                <a:gd name="T1" fmla="*/ 35 h 754"/>
                <a:gd name="T2" fmla="*/ 0 w 1017"/>
                <a:gd name="T3" fmla="*/ 0 h 754"/>
                <a:gd name="T4" fmla="*/ 110 w 1017"/>
                <a:gd name="T5" fmla="*/ 4 h 754"/>
                <a:gd name="T6" fmla="*/ 212 w 1017"/>
                <a:gd name="T7" fmla="*/ 0 h 754"/>
                <a:gd name="T8" fmla="*/ 300 w 1017"/>
                <a:gd name="T9" fmla="*/ 183 h 754"/>
                <a:gd name="T10" fmla="*/ 509 w 1017"/>
                <a:gd name="T11" fmla="*/ 592 h 754"/>
                <a:gd name="T12" fmla="*/ 697 w 1017"/>
                <a:gd name="T13" fmla="*/ 218 h 754"/>
                <a:gd name="T14" fmla="*/ 800 w 1017"/>
                <a:gd name="T15" fmla="*/ 0 h 754"/>
                <a:gd name="T16" fmla="*/ 898 w 1017"/>
                <a:gd name="T17" fmla="*/ 4 h 754"/>
                <a:gd name="T18" fmla="*/ 1017 w 1017"/>
                <a:gd name="T19" fmla="*/ 0 h 754"/>
                <a:gd name="T20" fmla="*/ 1017 w 1017"/>
                <a:gd name="T21" fmla="*/ 35 h 754"/>
                <a:gd name="T22" fmla="*/ 938 w 1017"/>
                <a:gd name="T23" fmla="*/ 40 h 754"/>
                <a:gd name="T24" fmla="*/ 918 w 1017"/>
                <a:gd name="T25" fmla="*/ 53 h 754"/>
                <a:gd name="T26" fmla="*/ 910 w 1017"/>
                <a:gd name="T27" fmla="*/ 103 h 754"/>
                <a:gd name="T28" fmla="*/ 907 w 1017"/>
                <a:gd name="T29" fmla="*/ 251 h 754"/>
                <a:gd name="T30" fmla="*/ 907 w 1017"/>
                <a:gd name="T31" fmla="*/ 492 h 754"/>
                <a:gd name="T32" fmla="*/ 910 w 1017"/>
                <a:gd name="T33" fmla="*/ 631 h 754"/>
                <a:gd name="T34" fmla="*/ 918 w 1017"/>
                <a:gd name="T35" fmla="*/ 690 h 754"/>
                <a:gd name="T36" fmla="*/ 938 w 1017"/>
                <a:gd name="T37" fmla="*/ 704 h 754"/>
                <a:gd name="T38" fmla="*/ 1017 w 1017"/>
                <a:gd name="T39" fmla="*/ 709 h 754"/>
                <a:gd name="T40" fmla="*/ 1017 w 1017"/>
                <a:gd name="T41" fmla="*/ 743 h 754"/>
                <a:gd name="T42" fmla="*/ 861 w 1017"/>
                <a:gd name="T43" fmla="*/ 739 h 754"/>
                <a:gd name="T44" fmla="*/ 699 w 1017"/>
                <a:gd name="T45" fmla="*/ 743 h 754"/>
                <a:gd name="T46" fmla="*/ 699 w 1017"/>
                <a:gd name="T47" fmla="*/ 709 h 754"/>
                <a:gd name="T48" fmla="*/ 778 w 1017"/>
                <a:gd name="T49" fmla="*/ 704 h 754"/>
                <a:gd name="T50" fmla="*/ 797 w 1017"/>
                <a:gd name="T51" fmla="*/ 691 h 754"/>
                <a:gd name="T52" fmla="*/ 806 w 1017"/>
                <a:gd name="T53" fmla="*/ 641 h 754"/>
                <a:gd name="T54" fmla="*/ 808 w 1017"/>
                <a:gd name="T55" fmla="*/ 492 h 754"/>
                <a:gd name="T56" fmla="*/ 808 w 1017"/>
                <a:gd name="T57" fmla="*/ 108 h 754"/>
                <a:gd name="T58" fmla="*/ 619 w 1017"/>
                <a:gd name="T59" fmla="*/ 486 h 754"/>
                <a:gd name="T60" fmla="*/ 549 w 1017"/>
                <a:gd name="T61" fmla="*/ 629 h 754"/>
                <a:gd name="T62" fmla="*/ 494 w 1017"/>
                <a:gd name="T63" fmla="*/ 754 h 754"/>
                <a:gd name="T64" fmla="*/ 472 w 1017"/>
                <a:gd name="T65" fmla="*/ 754 h 754"/>
                <a:gd name="T66" fmla="*/ 459 w 1017"/>
                <a:gd name="T67" fmla="*/ 722 h 754"/>
                <a:gd name="T68" fmla="*/ 422 w 1017"/>
                <a:gd name="T69" fmla="*/ 645 h 754"/>
                <a:gd name="T70" fmla="*/ 159 w 1017"/>
                <a:gd name="T71" fmla="*/ 126 h 754"/>
                <a:gd name="T72" fmla="*/ 159 w 1017"/>
                <a:gd name="T73" fmla="*/ 492 h 754"/>
                <a:gd name="T74" fmla="*/ 163 w 1017"/>
                <a:gd name="T75" fmla="*/ 631 h 754"/>
                <a:gd name="T76" fmla="*/ 171 w 1017"/>
                <a:gd name="T77" fmla="*/ 690 h 754"/>
                <a:gd name="T78" fmla="*/ 191 w 1017"/>
                <a:gd name="T79" fmla="*/ 704 h 754"/>
                <a:gd name="T80" fmla="*/ 271 w 1017"/>
                <a:gd name="T81" fmla="*/ 709 h 754"/>
                <a:gd name="T82" fmla="*/ 271 w 1017"/>
                <a:gd name="T83" fmla="*/ 743 h 754"/>
                <a:gd name="T84" fmla="*/ 138 w 1017"/>
                <a:gd name="T85" fmla="*/ 739 h 754"/>
                <a:gd name="T86" fmla="*/ 0 w 1017"/>
                <a:gd name="T87" fmla="*/ 743 h 754"/>
                <a:gd name="T88" fmla="*/ 0 w 1017"/>
                <a:gd name="T89" fmla="*/ 709 h 754"/>
                <a:gd name="T90" fmla="*/ 79 w 1017"/>
                <a:gd name="T91" fmla="*/ 704 h 754"/>
                <a:gd name="T92" fmla="*/ 98 w 1017"/>
                <a:gd name="T93" fmla="*/ 691 h 754"/>
                <a:gd name="T94" fmla="*/ 107 w 1017"/>
                <a:gd name="T95" fmla="*/ 641 h 754"/>
                <a:gd name="T96" fmla="*/ 109 w 1017"/>
                <a:gd name="T97" fmla="*/ 492 h 754"/>
                <a:gd name="T98" fmla="*/ 109 w 1017"/>
                <a:gd name="T99" fmla="*/ 251 h 754"/>
                <a:gd name="T100" fmla="*/ 107 w 1017"/>
                <a:gd name="T101" fmla="*/ 112 h 754"/>
                <a:gd name="T102" fmla="*/ 99 w 1017"/>
                <a:gd name="T103" fmla="*/ 54 h 754"/>
                <a:gd name="T104" fmla="*/ 78 w 1017"/>
                <a:gd name="T105" fmla="*/ 40 h 754"/>
                <a:gd name="T106" fmla="*/ 0 w 1017"/>
                <a:gd name="T107" fmla="*/ 35 h 75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Lst>
              <a:rect l="0" t="0" r="r" b="b"/>
              <a:pathLst>
                <a:path w="1017" h="754">
                  <a:moveTo>
                    <a:pt x="0" y="35"/>
                  </a:moveTo>
                  <a:cubicBezTo>
                    <a:pt x="0" y="0"/>
                    <a:pt x="0" y="0"/>
                    <a:pt x="0" y="0"/>
                  </a:cubicBezTo>
                  <a:cubicBezTo>
                    <a:pt x="38" y="2"/>
                    <a:pt x="75" y="4"/>
                    <a:pt x="110" y="4"/>
                  </a:cubicBezTo>
                  <a:cubicBezTo>
                    <a:pt x="145" y="4"/>
                    <a:pt x="179" y="2"/>
                    <a:pt x="212" y="0"/>
                  </a:cubicBezTo>
                  <a:cubicBezTo>
                    <a:pt x="244" y="70"/>
                    <a:pt x="274" y="131"/>
                    <a:pt x="300" y="183"/>
                  </a:cubicBezTo>
                  <a:cubicBezTo>
                    <a:pt x="509" y="592"/>
                    <a:pt x="509" y="592"/>
                    <a:pt x="509" y="592"/>
                  </a:cubicBezTo>
                  <a:cubicBezTo>
                    <a:pt x="697" y="218"/>
                    <a:pt x="697" y="218"/>
                    <a:pt x="697" y="218"/>
                  </a:cubicBezTo>
                  <a:cubicBezTo>
                    <a:pt x="749" y="116"/>
                    <a:pt x="783" y="43"/>
                    <a:pt x="800" y="0"/>
                  </a:cubicBezTo>
                  <a:cubicBezTo>
                    <a:pt x="839" y="2"/>
                    <a:pt x="872" y="4"/>
                    <a:pt x="898" y="4"/>
                  </a:cubicBezTo>
                  <a:cubicBezTo>
                    <a:pt x="923" y="4"/>
                    <a:pt x="962" y="2"/>
                    <a:pt x="1017" y="0"/>
                  </a:cubicBezTo>
                  <a:cubicBezTo>
                    <a:pt x="1017" y="35"/>
                    <a:pt x="1017" y="35"/>
                    <a:pt x="1017" y="35"/>
                  </a:cubicBezTo>
                  <a:cubicBezTo>
                    <a:pt x="974" y="35"/>
                    <a:pt x="947" y="37"/>
                    <a:pt x="938" y="40"/>
                  </a:cubicBezTo>
                  <a:cubicBezTo>
                    <a:pt x="928" y="43"/>
                    <a:pt x="922" y="47"/>
                    <a:pt x="918" y="53"/>
                  </a:cubicBezTo>
                  <a:cubicBezTo>
                    <a:pt x="914" y="60"/>
                    <a:pt x="911" y="76"/>
                    <a:pt x="910" y="103"/>
                  </a:cubicBezTo>
                  <a:cubicBezTo>
                    <a:pt x="910" y="110"/>
                    <a:pt x="909" y="159"/>
                    <a:pt x="907" y="251"/>
                  </a:cubicBezTo>
                  <a:cubicBezTo>
                    <a:pt x="907" y="492"/>
                    <a:pt x="907" y="492"/>
                    <a:pt x="907" y="492"/>
                  </a:cubicBezTo>
                  <a:cubicBezTo>
                    <a:pt x="907" y="540"/>
                    <a:pt x="908" y="586"/>
                    <a:pt x="910" y="631"/>
                  </a:cubicBezTo>
                  <a:cubicBezTo>
                    <a:pt x="911" y="664"/>
                    <a:pt x="914" y="684"/>
                    <a:pt x="918" y="690"/>
                  </a:cubicBezTo>
                  <a:cubicBezTo>
                    <a:pt x="922" y="696"/>
                    <a:pt x="929" y="701"/>
                    <a:pt x="938" y="704"/>
                  </a:cubicBezTo>
                  <a:cubicBezTo>
                    <a:pt x="948" y="707"/>
                    <a:pt x="974" y="709"/>
                    <a:pt x="1017" y="709"/>
                  </a:cubicBezTo>
                  <a:cubicBezTo>
                    <a:pt x="1017" y="743"/>
                    <a:pt x="1017" y="743"/>
                    <a:pt x="1017" y="743"/>
                  </a:cubicBezTo>
                  <a:cubicBezTo>
                    <a:pt x="943" y="740"/>
                    <a:pt x="891" y="739"/>
                    <a:pt x="861" y="739"/>
                  </a:cubicBezTo>
                  <a:cubicBezTo>
                    <a:pt x="837" y="739"/>
                    <a:pt x="782" y="740"/>
                    <a:pt x="699" y="743"/>
                  </a:cubicBezTo>
                  <a:cubicBezTo>
                    <a:pt x="699" y="709"/>
                    <a:pt x="699" y="709"/>
                    <a:pt x="699" y="709"/>
                  </a:cubicBezTo>
                  <a:cubicBezTo>
                    <a:pt x="742" y="709"/>
                    <a:pt x="768" y="707"/>
                    <a:pt x="778" y="704"/>
                  </a:cubicBezTo>
                  <a:cubicBezTo>
                    <a:pt x="788" y="701"/>
                    <a:pt x="794" y="697"/>
                    <a:pt x="797" y="691"/>
                  </a:cubicBezTo>
                  <a:cubicBezTo>
                    <a:pt x="802" y="684"/>
                    <a:pt x="805" y="668"/>
                    <a:pt x="806" y="641"/>
                  </a:cubicBezTo>
                  <a:cubicBezTo>
                    <a:pt x="806" y="633"/>
                    <a:pt x="807" y="584"/>
                    <a:pt x="808" y="492"/>
                  </a:cubicBezTo>
                  <a:cubicBezTo>
                    <a:pt x="808" y="108"/>
                    <a:pt x="808" y="108"/>
                    <a:pt x="808" y="108"/>
                  </a:cubicBezTo>
                  <a:cubicBezTo>
                    <a:pt x="619" y="486"/>
                    <a:pt x="619" y="486"/>
                    <a:pt x="619" y="486"/>
                  </a:cubicBezTo>
                  <a:cubicBezTo>
                    <a:pt x="589" y="545"/>
                    <a:pt x="566" y="593"/>
                    <a:pt x="549" y="629"/>
                  </a:cubicBezTo>
                  <a:cubicBezTo>
                    <a:pt x="537" y="655"/>
                    <a:pt x="518" y="696"/>
                    <a:pt x="494" y="754"/>
                  </a:cubicBezTo>
                  <a:cubicBezTo>
                    <a:pt x="472" y="754"/>
                    <a:pt x="472" y="754"/>
                    <a:pt x="472" y="754"/>
                  </a:cubicBezTo>
                  <a:cubicBezTo>
                    <a:pt x="468" y="740"/>
                    <a:pt x="463" y="729"/>
                    <a:pt x="459" y="722"/>
                  </a:cubicBezTo>
                  <a:cubicBezTo>
                    <a:pt x="422" y="645"/>
                    <a:pt x="422" y="645"/>
                    <a:pt x="422" y="645"/>
                  </a:cubicBezTo>
                  <a:cubicBezTo>
                    <a:pt x="159" y="126"/>
                    <a:pt x="159" y="126"/>
                    <a:pt x="159" y="126"/>
                  </a:cubicBezTo>
                  <a:cubicBezTo>
                    <a:pt x="159" y="492"/>
                    <a:pt x="159" y="492"/>
                    <a:pt x="159" y="492"/>
                  </a:cubicBezTo>
                  <a:cubicBezTo>
                    <a:pt x="159" y="540"/>
                    <a:pt x="160" y="586"/>
                    <a:pt x="163" y="631"/>
                  </a:cubicBezTo>
                  <a:cubicBezTo>
                    <a:pt x="164" y="664"/>
                    <a:pt x="167" y="683"/>
                    <a:pt x="171" y="690"/>
                  </a:cubicBezTo>
                  <a:cubicBezTo>
                    <a:pt x="175" y="696"/>
                    <a:pt x="182" y="701"/>
                    <a:pt x="191" y="704"/>
                  </a:cubicBezTo>
                  <a:cubicBezTo>
                    <a:pt x="200" y="707"/>
                    <a:pt x="227" y="709"/>
                    <a:pt x="271" y="709"/>
                  </a:cubicBezTo>
                  <a:cubicBezTo>
                    <a:pt x="271" y="743"/>
                    <a:pt x="271" y="743"/>
                    <a:pt x="271" y="743"/>
                  </a:cubicBezTo>
                  <a:cubicBezTo>
                    <a:pt x="138" y="739"/>
                    <a:pt x="138" y="739"/>
                    <a:pt x="138" y="739"/>
                  </a:cubicBezTo>
                  <a:cubicBezTo>
                    <a:pt x="0" y="743"/>
                    <a:pt x="0" y="743"/>
                    <a:pt x="0" y="743"/>
                  </a:cubicBezTo>
                  <a:cubicBezTo>
                    <a:pt x="0" y="709"/>
                    <a:pt x="0" y="709"/>
                    <a:pt x="0" y="709"/>
                  </a:cubicBezTo>
                  <a:cubicBezTo>
                    <a:pt x="43" y="709"/>
                    <a:pt x="69" y="707"/>
                    <a:pt x="79" y="704"/>
                  </a:cubicBezTo>
                  <a:cubicBezTo>
                    <a:pt x="88" y="701"/>
                    <a:pt x="95" y="697"/>
                    <a:pt x="98" y="691"/>
                  </a:cubicBezTo>
                  <a:cubicBezTo>
                    <a:pt x="103" y="684"/>
                    <a:pt x="105" y="668"/>
                    <a:pt x="107" y="641"/>
                  </a:cubicBezTo>
                  <a:cubicBezTo>
                    <a:pt x="107" y="634"/>
                    <a:pt x="108" y="584"/>
                    <a:pt x="109" y="492"/>
                  </a:cubicBezTo>
                  <a:cubicBezTo>
                    <a:pt x="109" y="251"/>
                    <a:pt x="109" y="251"/>
                    <a:pt x="109" y="251"/>
                  </a:cubicBezTo>
                  <a:cubicBezTo>
                    <a:pt x="109" y="204"/>
                    <a:pt x="108" y="158"/>
                    <a:pt x="107" y="112"/>
                  </a:cubicBezTo>
                  <a:cubicBezTo>
                    <a:pt x="105" y="79"/>
                    <a:pt x="103" y="60"/>
                    <a:pt x="99" y="54"/>
                  </a:cubicBezTo>
                  <a:cubicBezTo>
                    <a:pt x="94" y="48"/>
                    <a:pt x="88" y="43"/>
                    <a:pt x="78" y="40"/>
                  </a:cubicBezTo>
                  <a:cubicBezTo>
                    <a:pt x="69" y="37"/>
                    <a:pt x="43" y="35"/>
                    <a:pt x="0" y="35"/>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2" name="Freeform 13"/>
            <p:cNvSpPr>
              <a:spLocks noEditPoints="1"/>
            </p:cNvSpPr>
            <p:nvPr userDrawn="1"/>
          </p:nvSpPr>
          <p:spPr bwMode="auto">
            <a:xfrm>
              <a:off x="1092200" y="684213"/>
              <a:ext cx="263525" cy="238125"/>
            </a:xfrm>
            <a:custGeom>
              <a:avLst/>
              <a:gdLst>
                <a:gd name="T0" fmla="*/ 117 w 832"/>
                <a:gd name="T1" fmla="*/ 747 h 750"/>
                <a:gd name="T2" fmla="*/ 257 w 832"/>
                <a:gd name="T3" fmla="*/ 750 h 750"/>
                <a:gd name="T4" fmla="*/ 257 w 832"/>
                <a:gd name="T5" fmla="*/ 717 h 750"/>
                <a:gd name="T6" fmla="*/ 185 w 832"/>
                <a:gd name="T7" fmla="*/ 712 h 750"/>
                <a:gd name="T8" fmla="*/ 166 w 832"/>
                <a:gd name="T9" fmla="*/ 702 h 750"/>
                <a:gd name="T10" fmla="*/ 162 w 832"/>
                <a:gd name="T11" fmla="*/ 690 h 750"/>
                <a:gd name="T12" fmla="*/ 178 w 832"/>
                <a:gd name="T13" fmla="*/ 637 h 750"/>
                <a:gd name="T14" fmla="*/ 237 w 832"/>
                <a:gd name="T15" fmla="*/ 503 h 750"/>
                <a:gd name="T16" fmla="*/ 556 w 832"/>
                <a:gd name="T17" fmla="*/ 503 h 750"/>
                <a:gd name="T18" fmla="*/ 624 w 832"/>
                <a:gd name="T19" fmla="*/ 663 h 750"/>
                <a:gd name="T20" fmla="*/ 632 w 832"/>
                <a:gd name="T21" fmla="*/ 693 h 750"/>
                <a:gd name="T22" fmla="*/ 627 w 832"/>
                <a:gd name="T23" fmla="*/ 705 h 750"/>
                <a:gd name="T24" fmla="*/ 609 w 832"/>
                <a:gd name="T25" fmla="*/ 713 h 750"/>
                <a:gd name="T26" fmla="*/ 535 w 832"/>
                <a:gd name="T27" fmla="*/ 717 h 750"/>
                <a:gd name="T28" fmla="*/ 535 w 832"/>
                <a:gd name="T29" fmla="*/ 750 h 750"/>
                <a:gd name="T30" fmla="*/ 712 w 832"/>
                <a:gd name="T31" fmla="*/ 747 h 750"/>
                <a:gd name="T32" fmla="*/ 832 w 832"/>
                <a:gd name="T33" fmla="*/ 750 h 750"/>
                <a:gd name="T34" fmla="*/ 832 w 832"/>
                <a:gd name="T35" fmla="*/ 717 h 750"/>
                <a:gd name="T36" fmla="*/ 776 w 832"/>
                <a:gd name="T37" fmla="*/ 710 h 750"/>
                <a:gd name="T38" fmla="*/ 753 w 832"/>
                <a:gd name="T39" fmla="*/ 687 h 750"/>
                <a:gd name="T40" fmla="*/ 677 w 832"/>
                <a:gd name="T41" fmla="*/ 526 h 750"/>
                <a:gd name="T42" fmla="*/ 441 w 832"/>
                <a:gd name="T43" fmla="*/ 0 h 750"/>
                <a:gd name="T44" fmla="*/ 406 w 832"/>
                <a:gd name="T45" fmla="*/ 0 h 750"/>
                <a:gd name="T46" fmla="*/ 310 w 832"/>
                <a:gd name="T47" fmla="*/ 217 h 750"/>
                <a:gd name="T48" fmla="*/ 172 w 832"/>
                <a:gd name="T49" fmla="*/ 512 h 750"/>
                <a:gd name="T50" fmla="*/ 100 w 832"/>
                <a:gd name="T51" fmla="*/ 660 h 750"/>
                <a:gd name="T52" fmla="*/ 74 w 832"/>
                <a:gd name="T53" fmla="*/ 702 h 750"/>
                <a:gd name="T54" fmla="*/ 54 w 832"/>
                <a:gd name="T55" fmla="*/ 713 h 750"/>
                <a:gd name="T56" fmla="*/ 0 w 832"/>
                <a:gd name="T57" fmla="*/ 717 h 750"/>
                <a:gd name="T58" fmla="*/ 0 w 832"/>
                <a:gd name="T59" fmla="*/ 750 h 750"/>
                <a:gd name="T60" fmla="*/ 117 w 832"/>
                <a:gd name="T61" fmla="*/ 747 h 750"/>
                <a:gd name="T62" fmla="*/ 396 w 832"/>
                <a:gd name="T63" fmla="*/ 143 h 750"/>
                <a:gd name="T64" fmla="*/ 534 w 832"/>
                <a:gd name="T65" fmla="*/ 458 h 750"/>
                <a:gd name="T66" fmla="*/ 256 w 832"/>
                <a:gd name="T67" fmla="*/ 458 h 750"/>
                <a:gd name="T68" fmla="*/ 396 w 832"/>
                <a:gd name="T69" fmla="*/ 143 h 75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Lst>
              <a:rect l="0" t="0" r="r" b="b"/>
              <a:pathLst>
                <a:path w="832" h="750">
                  <a:moveTo>
                    <a:pt x="117" y="747"/>
                  </a:moveTo>
                  <a:cubicBezTo>
                    <a:pt x="148" y="747"/>
                    <a:pt x="195" y="748"/>
                    <a:pt x="257" y="750"/>
                  </a:cubicBezTo>
                  <a:cubicBezTo>
                    <a:pt x="257" y="717"/>
                    <a:pt x="257" y="717"/>
                    <a:pt x="257" y="717"/>
                  </a:cubicBezTo>
                  <a:cubicBezTo>
                    <a:pt x="222" y="716"/>
                    <a:pt x="199" y="715"/>
                    <a:pt x="185" y="712"/>
                  </a:cubicBezTo>
                  <a:cubicBezTo>
                    <a:pt x="177" y="710"/>
                    <a:pt x="170" y="707"/>
                    <a:pt x="166" y="702"/>
                  </a:cubicBezTo>
                  <a:cubicBezTo>
                    <a:pt x="163" y="699"/>
                    <a:pt x="162" y="695"/>
                    <a:pt x="162" y="690"/>
                  </a:cubicBezTo>
                  <a:cubicBezTo>
                    <a:pt x="162" y="679"/>
                    <a:pt x="167" y="662"/>
                    <a:pt x="178" y="637"/>
                  </a:cubicBezTo>
                  <a:cubicBezTo>
                    <a:pt x="237" y="503"/>
                    <a:pt x="237" y="503"/>
                    <a:pt x="237" y="503"/>
                  </a:cubicBezTo>
                  <a:cubicBezTo>
                    <a:pt x="556" y="503"/>
                    <a:pt x="556" y="503"/>
                    <a:pt x="556" y="503"/>
                  </a:cubicBezTo>
                  <a:cubicBezTo>
                    <a:pt x="624" y="663"/>
                    <a:pt x="624" y="663"/>
                    <a:pt x="624" y="663"/>
                  </a:cubicBezTo>
                  <a:cubicBezTo>
                    <a:pt x="629" y="675"/>
                    <a:pt x="632" y="685"/>
                    <a:pt x="632" y="693"/>
                  </a:cubicBezTo>
                  <a:cubicBezTo>
                    <a:pt x="632" y="698"/>
                    <a:pt x="630" y="702"/>
                    <a:pt x="627" y="705"/>
                  </a:cubicBezTo>
                  <a:cubicBezTo>
                    <a:pt x="624" y="708"/>
                    <a:pt x="618" y="711"/>
                    <a:pt x="609" y="713"/>
                  </a:cubicBezTo>
                  <a:cubicBezTo>
                    <a:pt x="601" y="715"/>
                    <a:pt x="576" y="716"/>
                    <a:pt x="535" y="717"/>
                  </a:cubicBezTo>
                  <a:cubicBezTo>
                    <a:pt x="535" y="750"/>
                    <a:pt x="535" y="750"/>
                    <a:pt x="535" y="750"/>
                  </a:cubicBezTo>
                  <a:cubicBezTo>
                    <a:pt x="712" y="747"/>
                    <a:pt x="712" y="747"/>
                    <a:pt x="712" y="747"/>
                  </a:cubicBezTo>
                  <a:cubicBezTo>
                    <a:pt x="734" y="747"/>
                    <a:pt x="775" y="748"/>
                    <a:pt x="832" y="750"/>
                  </a:cubicBezTo>
                  <a:cubicBezTo>
                    <a:pt x="832" y="717"/>
                    <a:pt x="832" y="717"/>
                    <a:pt x="832" y="717"/>
                  </a:cubicBezTo>
                  <a:cubicBezTo>
                    <a:pt x="803" y="716"/>
                    <a:pt x="784" y="714"/>
                    <a:pt x="776" y="710"/>
                  </a:cubicBezTo>
                  <a:cubicBezTo>
                    <a:pt x="767" y="707"/>
                    <a:pt x="760" y="699"/>
                    <a:pt x="753" y="687"/>
                  </a:cubicBezTo>
                  <a:cubicBezTo>
                    <a:pt x="740" y="664"/>
                    <a:pt x="715" y="611"/>
                    <a:pt x="677" y="526"/>
                  </a:cubicBezTo>
                  <a:cubicBezTo>
                    <a:pt x="441" y="0"/>
                    <a:pt x="441" y="0"/>
                    <a:pt x="441" y="0"/>
                  </a:cubicBezTo>
                  <a:cubicBezTo>
                    <a:pt x="406" y="0"/>
                    <a:pt x="406" y="0"/>
                    <a:pt x="406" y="0"/>
                  </a:cubicBezTo>
                  <a:cubicBezTo>
                    <a:pt x="357" y="112"/>
                    <a:pt x="325" y="185"/>
                    <a:pt x="310" y="217"/>
                  </a:cubicBezTo>
                  <a:cubicBezTo>
                    <a:pt x="172" y="512"/>
                    <a:pt x="172" y="512"/>
                    <a:pt x="172" y="512"/>
                  </a:cubicBezTo>
                  <a:cubicBezTo>
                    <a:pt x="131" y="598"/>
                    <a:pt x="107" y="647"/>
                    <a:pt x="100" y="660"/>
                  </a:cubicBezTo>
                  <a:cubicBezTo>
                    <a:pt x="89" y="683"/>
                    <a:pt x="80" y="697"/>
                    <a:pt x="74" y="702"/>
                  </a:cubicBezTo>
                  <a:cubicBezTo>
                    <a:pt x="68" y="708"/>
                    <a:pt x="61" y="711"/>
                    <a:pt x="54" y="713"/>
                  </a:cubicBezTo>
                  <a:cubicBezTo>
                    <a:pt x="47" y="715"/>
                    <a:pt x="29" y="716"/>
                    <a:pt x="0" y="717"/>
                  </a:cubicBezTo>
                  <a:cubicBezTo>
                    <a:pt x="0" y="750"/>
                    <a:pt x="0" y="750"/>
                    <a:pt x="0" y="750"/>
                  </a:cubicBezTo>
                  <a:cubicBezTo>
                    <a:pt x="42" y="748"/>
                    <a:pt x="81" y="747"/>
                    <a:pt x="117" y="747"/>
                  </a:cubicBezTo>
                  <a:close/>
                  <a:moveTo>
                    <a:pt x="396" y="143"/>
                  </a:moveTo>
                  <a:cubicBezTo>
                    <a:pt x="534" y="458"/>
                    <a:pt x="534" y="458"/>
                    <a:pt x="534" y="458"/>
                  </a:cubicBezTo>
                  <a:cubicBezTo>
                    <a:pt x="256" y="458"/>
                    <a:pt x="256" y="458"/>
                    <a:pt x="256" y="458"/>
                  </a:cubicBezTo>
                  <a:lnTo>
                    <a:pt x="396" y="143"/>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3" name="Freeform 14"/>
            <p:cNvSpPr>
              <a:spLocks/>
            </p:cNvSpPr>
            <p:nvPr userDrawn="1"/>
          </p:nvSpPr>
          <p:spPr bwMode="auto">
            <a:xfrm>
              <a:off x="1309688" y="687388"/>
              <a:ext cx="260350" cy="234950"/>
            </a:xfrm>
            <a:custGeom>
              <a:avLst/>
              <a:gdLst>
                <a:gd name="T0" fmla="*/ 601 w 817"/>
                <a:gd name="T1" fmla="*/ 111 h 743"/>
                <a:gd name="T2" fmla="*/ 634 w 817"/>
                <a:gd name="T3" fmla="*/ 52 h 743"/>
                <a:gd name="T4" fmla="*/ 624 w 817"/>
                <a:gd name="T5" fmla="*/ 39 h 743"/>
                <a:gd name="T6" fmla="*/ 543 w 817"/>
                <a:gd name="T7" fmla="*/ 33 h 743"/>
                <a:gd name="T8" fmla="*/ 543 w 817"/>
                <a:gd name="T9" fmla="*/ 0 h 743"/>
                <a:gd name="T10" fmla="*/ 688 w 817"/>
                <a:gd name="T11" fmla="*/ 3 h 743"/>
                <a:gd name="T12" fmla="*/ 817 w 817"/>
                <a:gd name="T13" fmla="*/ 0 h 743"/>
                <a:gd name="T14" fmla="*/ 817 w 817"/>
                <a:gd name="T15" fmla="*/ 33 h 743"/>
                <a:gd name="T16" fmla="*/ 746 w 817"/>
                <a:gd name="T17" fmla="*/ 39 h 743"/>
                <a:gd name="T18" fmla="*/ 718 w 817"/>
                <a:gd name="T19" fmla="*/ 51 h 743"/>
                <a:gd name="T20" fmla="*/ 675 w 817"/>
                <a:gd name="T21" fmla="*/ 102 h 743"/>
                <a:gd name="T22" fmla="*/ 514 w 817"/>
                <a:gd name="T23" fmla="*/ 333 h 743"/>
                <a:gd name="T24" fmla="*/ 461 w 817"/>
                <a:gd name="T25" fmla="*/ 422 h 743"/>
                <a:gd name="T26" fmla="*/ 455 w 817"/>
                <a:gd name="T27" fmla="*/ 453 h 743"/>
                <a:gd name="T28" fmla="*/ 455 w 817"/>
                <a:gd name="T29" fmla="*/ 493 h 743"/>
                <a:gd name="T30" fmla="*/ 459 w 817"/>
                <a:gd name="T31" fmla="*/ 631 h 743"/>
                <a:gd name="T32" fmla="*/ 466 w 817"/>
                <a:gd name="T33" fmla="*/ 690 h 743"/>
                <a:gd name="T34" fmla="*/ 486 w 817"/>
                <a:gd name="T35" fmla="*/ 704 h 743"/>
                <a:gd name="T36" fmla="*/ 564 w 817"/>
                <a:gd name="T37" fmla="*/ 710 h 743"/>
                <a:gd name="T38" fmla="*/ 564 w 817"/>
                <a:gd name="T39" fmla="*/ 743 h 743"/>
                <a:gd name="T40" fmla="*/ 410 w 817"/>
                <a:gd name="T41" fmla="*/ 740 h 743"/>
                <a:gd name="T42" fmla="*/ 244 w 817"/>
                <a:gd name="T43" fmla="*/ 743 h 743"/>
                <a:gd name="T44" fmla="*/ 244 w 817"/>
                <a:gd name="T45" fmla="*/ 710 h 743"/>
                <a:gd name="T46" fmla="*/ 322 w 817"/>
                <a:gd name="T47" fmla="*/ 704 h 743"/>
                <a:gd name="T48" fmla="*/ 341 w 817"/>
                <a:gd name="T49" fmla="*/ 692 h 743"/>
                <a:gd name="T50" fmla="*/ 350 w 817"/>
                <a:gd name="T51" fmla="*/ 641 h 743"/>
                <a:gd name="T52" fmla="*/ 353 w 817"/>
                <a:gd name="T53" fmla="*/ 493 h 743"/>
                <a:gd name="T54" fmla="*/ 353 w 817"/>
                <a:gd name="T55" fmla="*/ 432 h 743"/>
                <a:gd name="T56" fmla="*/ 331 w 817"/>
                <a:gd name="T57" fmla="*/ 390 h 743"/>
                <a:gd name="T58" fmla="*/ 275 w 817"/>
                <a:gd name="T59" fmla="*/ 300 h 743"/>
                <a:gd name="T60" fmla="*/ 135 w 817"/>
                <a:gd name="T61" fmla="*/ 102 h 743"/>
                <a:gd name="T62" fmla="*/ 96 w 817"/>
                <a:gd name="T63" fmla="*/ 51 h 743"/>
                <a:gd name="T64" fmla="*/ 69 w 817"/>
                <a:gd name="T65" fmla="*/ 39 h 743"/>
                <a:gd name="T66" fmla="*/ 0 w 817"/>
                <a:gd name="T67" fmla="*/ 33 h 743"/>
                <a:gd name="T68" fmla="*/ 0 w 817"/>
                <a:gd name="T69" fmla="*/ 0 h 743"/>
                <a:gd name="T70" fmla="*/ 130 w 817"/>
                <a:gd name="T71" fmla="*/ 3 h 743"/>
                <a:gd name="T72" fmla="*/ 333 w 817"/>
                <a:gd name="T73" fmla="*/ 0 h 743"/>
                <a:gd name="T74" fmla="*/ 333 w 817"/>
                <a:gd name="T75" fmla="*/ 33 h 743"/>
                <a:gd name="T76" fmla="*/ 246 w 817"/>
                <a:gd name="T77" fmla="*/ 39 h 743"/>
                <a:gd name="T78" fmla="*/ 234 w 817"/>
                <a:gd name="T79" fmla="*/ 52 h 743"/>
                <a:gd name="T80" fmla="*/ 262 w 817"/>
                <a:gd name="T81" fmla="*/ 111 h 743"/>
                <a:gd name="T82" fmla="*/ 426 w 817"/>
                <a:gd name="T83" fmla="*/ 376 h 743"/>
                <a:gd name="T84" fmla="*/ 601 w 817"/>
                <a:gd name="T85" fmla="*/ 111 h 74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Lst>
              <a:rect l="0" t="0" r="r" b="b"/>
              <a:pathLst>
                <a:path w="817" h="743">
                  <a:moveTo>
                    <a:pt x="601" y="111"/>
                  </a:moveTo>
                  <a:cubicBezTo>
                    <a:pt x="623" y="78"/>
                    <a:pt x="634" y="59"/>
                    <a:pt x="634" y="52"/>
                  </a:cubicBezTo>
                  <a:cubicBezTo>
                    <a:pt x="634" y="46"/>
                    <a:pt x="631" y="41"/>
                    <a:pt x="624" y="39"/>
                  </a:cubicBezTo>
                  <a:cubicBezTo>
                    <a:pt x="616" y="36"/>
                    <a:pt x="585" y="34"/>
                    <a:pt x="543" y="33"/>
                  </a:cubicBezTo>
                  <a:cubicBezTo>
                    <a:pt x="543" y="0"/>
                    <a:pt x="543" y="0"/>
                    <a:pt x="543" y="0"/>
                  </a:cubicBezTo>
                  <a:cubicBezTo>
                    <a:pt x="610" y="2"/>
                    <a:pt x="650" y="3"/>
                    <a:pt x="688" y="3"/>
                  </a:cubicBezTo>
                  <a:cubicBezTo>
                    <a:pt x="725" y="3"/>
                    <a:pt x="745" y="2"/>
                    <a:pt x="817" y="0"/>
                  </a:cubicBezTo>
                  <a:cubicBezTo>
                    <a:pt x="817" y="33"/>
                    <a:pt x="817" y="33"/>
                    <a:pt x="817" y="33"/>
                  </a:cubicBezTo>
                  <a:cubicBezTo>
                    <a:pt x="773" y="34"/>
                    <a:pt x="757" y="36"/>
                    <a:pt x="746" y="39"/>
                  </a:cubicBezTo>
                  <a:cubicBezTo>
                    <a:pt x="735" y="41"/>
                    <a:pt x="725" y="46"/>
                    <a:pt x="718" y="51"/>
                  </a:cubicBezTo>
                  <a:cubicBezTo>
                    <a:pt x="709" y="58"/>
                    <a:pt x="695" y="75"/>
                    <a:pt x="675" y="102"/>
                  </a:cubicBezTo>
                  <a:cubicBezTo>
                    <a:pt x="514" y="333"/>
                    <a:pt x="514" y="333"/>
                    <a:pt x="514" y="333"/>
                  </a:cubicBezTo>
                  <a:cubicBezTo>
                    <a:pt x="483" y="381"/>
                    <a:pt x="465" y="411"/>
                    <a:pt x="461" y="422"/>
                  </a:cubicBezTo>
                  <a:cubicBezTo>
                    <a:pt x="457" y="433"/>
                    <a:pt x="455" y="443"/>
                    <a:pt x="455" y="453"/>
                  </a:cubicBezTo>
                  <a:cubicBezTo>
                    <a:pt x="455" y="493"/>
                    <a:pt x="455" y="493"/>
                    <a:pt x="455" y="493"/>
                  </a:cubicBezTo>
                  <a:cubicBezTo>
                    <a:pt x="455" y="541"/>
                    <a:pt x="456" y="587"/>
                    <a:pt x="459" y="631"/>
                  </a:cubicBezTo>
                  <a:cubicBezTo>
                    <a:pt x="460" y="665"/>
                    <a:pt x="462" y="684"/>
                    <a:pt x="466" y="690"/>
                  </a:cubicBezTo>
                  <a:cubicBezTo>
                    <a:pt x="470" y="696"/>
                    <a:pt x="477" y="701"/>
                    <a:pt x="486" y="704"/>
                  </a:cubicBezTo>
                  <a:cubicBezTo>
                    <a:pt x="495" y="707"/>
                    <a:pt x="521" y="709"/>
                    <a:pt x="564" y="710"/>
                  </a:cubicBezTo>
                  <a:cubicBezTo>
                    <a:pt x="564" y="743"/>
                    <a:pt x="564" y="743"/>
                    <a:pt x="564" y="743"/>
                  </a:cubicBezTo>
                  <a:cubicBezTo>
                    <a:pt x="505" y="741"/>
                    <a:pt x="453" y="740"/>
                    <a:pt x="410" y="740"/>
                  </a:cubicBezTo>
                  <a:cubicBezTo>
                    <a:pt x="368" y="740"/>
                    <a:pt x="313" y="741"/>
                    <a:pt x="244" y="743"/>
                  </a:cubicBezTo>
                  <a:cubicBezTo>
                    <a:pt x="244" y="710"/>
                    <a:pt x="244" y="710"/>
                    <a:pt x="244" y="710"/>
                  </a:cubicBezTo>
                  <a:cubicBezTo>
                    <a:pt x="287" y="709"/>
                    <a:pt x="313" y="707"/>
                    <a:pt x="322" y="704"/>
                  </a:cubicBezTo>
                  <a:cubicBezTo>
                    <a:pt x="332" y="701"/>
                    <a:pt x="338" y="697"/>
                    <a:pt x="341" y="692"/>
                  </a:cubicBezTo>
                  <a:cubicBezTo>
                    <a:pt x="346" y="685"/>
                    <a:pt x="349" y="668"/>
                    <a:pt x="350" y="641"/>
                  </a:cubicBezTo>
                  <a:cubicBezTo>
                    <a:pt x="350" y="634"/>
                    <a:pt x="351" y="585"/>
                    <a:pt x="353" y="493"/>
                  </a:cubicBezTo>
                  <a:cubicBezTo>
                    <a:pt x="353" y="432"/>
                    <a:pt x="353" y="432"/>
                    <a:pt x="353" y="432"/>
                  </a:cubicBezTo>
                  <a:cubicBezTo>
                    <a:pt x="345" y="417"/>
                    <a:pt x="338" y="403"/>
                    <a:pt x="331" y="390"/>
                  </a:cubicBezTo>
                  <a:cubicBezTo>
                    <a:pt x="325" y="382"/>
                    <a:pt x="307" y="352"/>
                    <a:pt x="275" y="300"/>
                  </a:cubicBezTo>
                  <a:cubicBezTo>
                    <a:pt x="135" y="102"/>
                    <a:pt x="135" y="102"/>
                    <a:pt x="135" y="102"/>
                  </a:cubicBezTo>
                  <a:cubicBezTo>
                    <a:pt x="118" y="75"/>
                    <a:pt x="105" y="58"/>
                    <a:pt x="96" y="51"/>
                  </a:cubicBezTo>
                  <a:cubicBezTo>
                    <a:pt x="89" y="46"/>
                    <a:pt x="80" y="41"/>
                    <a:pt x="69" y="39"/>
                  </a:cubicBezTo>
                  <a:cubicBezTo>
                    <a:pt x="58" y="36"/>
                    <a:pt x="44" y="34"/>
                    <a:pt x="0" y="33"/>
                  </a:cubicBezTo>
                  <a:cubicBezTo>
                    <a:pt x="0" y="0"/>
                    <a:pt x="0" y="0"/>
                    <a:pt x="0" y="0"/>
                  </a:cubicBezTo>
                  <a:cubicBezTo>
                    <a:pt x="72" y="2"/>
                    <a:pt x="94" y="3"/>
                    <a:pt x="130" y="3"/>
                  </a:cubicBezTo>
                  <a:cubicBezTo>
                    <a:pt x="168" y="3"/>
                    <a:pt x="265" y="2"/>
                    <a:pt x="333" y="0"/>
                  </a:cubicBezTo>
                  <a:cubicBezTo>
                    <a:pt x="333" y="33"/>
                    <a:pt x="333" y="33"/>
                    <a:pt x="333" y="33"/>
                  </a:cubicBezTo>
                  <a:cubicBezTo>
                    <a:pt x="291" y="34"/>
                    <a:pt x="254" y="36"/>
                    <a:pt x="246" y="39"/>
                  </a:cubicBezTo>
                  <a:cubicBezTo>
                    <a:pt x="239" y="41"/>
                    <a:pt x="235" y="46"/>
                    <a:pt x="234" y="52"/>
                  </a:cubicBezTo>
                  <a:cubicBezTo>
                    <a:pt x="234" y="59"/>
                    <a:pt x="243" y="78"/>
                    <a:pt x="262" y="111"/>
                  </a:cubicBezTo>
                  <a:cubicBezTo>
                    <a:pt x="426" y="376"/>
                    <a:pt x="426" y="376"/>
                    <a:pt x="426" y="376"/>
                  </a:cubicBezTo>
                  <a:lnTo>
                    <a:pt x="601" y="111"/>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4" name="Freeform 15"/>
            <p:cNvSpPr>
              <a:spLocks noEditPoints="1"/>
            </p:cNvSpPr>
            <p:nvPr userDrawn="1"/>
          </p:nvSpPr>
          <p:spPr bwMode="auto">
            <a:xfrm>
              <a:off x="1558925" y="681038"/>
              <a:ext cx="263525" cy="246063"/>
            </a:xfrm>
            <a:custGeom>
              <a:avLst/>
              <a:gdLst>
                <a:gd name="T0" fmla="*/ 148 w 830"/>
                <a:gd name="T1" fmla="*/ 190 h 775"/>
                <a:gd name="T2" fmla="*/ 247 w 830"/>
                <a:gd name="T3" fmla="*/ 82 h 775"/>
                <a:gd name="T4" fmla="*/ 399 w 830"/>
                <a:gd name="T5" fmla="*/ 45 h 775"/>
                <a:gd name="T6" fmla="*/ 512 w 830"/>
                <a:gd name="T7" fmla="*/ 62 h 775"/>
                <a:gd name="T8" fmla="*/ 596 w 830"/>
                <a:gd name="T9" fmla="*/ 106 h 775"/>
                <a:gd name="T10" fmla="*/ 652 w 830"/>
                <a:gd name="T11" fmla="*/ 167 h 775"/>
                <a:gd name="T12" fmla="*/ 690 w 830"/>
                <a:gd name="T13" fmla="*/ 245 h 775"/>
                <a:gd name="T14" fmla="*/ 713 w 830"/>
                <a:gd name="T15" fmla="*/ 398 h 775"/>
                <a:gd name="T16" fmla="*/ 681 w 830"/>
                <a:gd name="T17" fmla="*/ 571 h 775"/>
                <a:gd name="T18" fmla="*/ 584 w 830"/>
                <a:gd name="T19" fmla="*/ 686 h 775"/>
                <a:gd name="T20" fmla="*/ 431 w 830"/>
                <a:gd name="T21" fmla="*/ 727 h 775"/>
                <a:gd name="T22" fmla="*/ 315 w 830"/>
                <a:gd name="T23" fmla="*/ 707 h 775"/>
                <a:gd name="T24" fmla="*/ 220 w 830"/>
                <a:gd name="T25" fmla="*/ 644 h 775"/>
                <a:gd name="T26" fmla="*/ 151 w 830"/>
                <a:gd name="T27" fmla="*/ 539 h 775"/>
                <a:gd name="T28" fmla="*/ 125 w 830"/>
                <a:gd name="T29" fmla="*/ 450 h 775"/>
                <a:gd name="T30" fmla="*/ 115 w 830"/>
                <a:gd name="T31" fmla="*/ 349 h 775"/>
                <a:gd name="T32" fmla="*/ 148 w 830"/>
                <a:gd name="T33" fmla="*/ 190 h 775"/>
                <a:gd name="T34" fmla="*/ 26 w 830"/>
                <a:gd name="T35" fmla="*/ 541 h 775"/>
                <a:gd name="T36" fmla="*/ 105 w 830"/>
                <a:gd name="T37" fmla="*/ 669 h 775"/>
                <a:gd name="T38" fmla="*/ 231 w 830"/>
                <a:gd name="T39" fmla="*/ 748 h 775"/>
                <a:gd name="T40" fmla="*/ 392 w 830"/>
                <a:gd name="T41" fmla="*/ 775 h 775"/>
                <a:gd name="T42" fmla="*/ 706 w 830"/>
                <a:gd name="T43" fmla="*/ 657 h 775"/>
                <a:gd name="T44" fmla="*/ 830 w 830"/>
                <a:gd name="T45" fmla="*/ 364 h 775"/>
                <a:gd name="T46" fmla="*/ 817 w 830"/>
                <a:gd name="T47" fmla="*/ 261 h 775"/>
                <a:gd name="T48" fmla="*/ 784 w 830"/>
                <a:gd name="T49" fmla="*/ 177 h 775"/>
                <a:gd name="T50" fmla="*/ 709 w 830"/>
                <a:gd name="T51" fmla="*/ 89 h 775"/>
                <a:gd name="T52" fmla="*/ 588 w 830"/>
                <a:gd name="T53" fmla="*/ 25 h 775"/>
                <a:gd name="T54" fmla="*/ 423 w 830"/>
                <a:gd name="T55" fmla="*/ 0 h 775"/>
                <a:gd name="T56" fmla="*/ 249 w 830"/>
                <a:gd name="T57" fmla="*/ 29 h 775"/>
                <a:gd name="T58" fmla="*/ 112 w 830"/>
                <a:gd name="T59" fmla="*/ 113 h 775"/>
                <a:gd name="T60" fmla="*/ 26 w 830"/>
                <a:gd name="T61" fmla="*/ 239 h 775"/>
                <a:gd name="T62" fmla="*/ 0 w 830"/>
                <a:gd name="T63" fmla="*/ 393 h 775"/>
                <a:gd name="T64" fmla="*/ 26 w 830"/>
                <a:gd name="T65" fmla="*/ 541 h 77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Lst>
              <a:rect l="0" t="0" r="r" b="b"/>
              <a:pathLst>
                <a:path w="830" h="775">
                  <a:moveTo>
                    <a:pt x="148" y="190"/>
                  </a:moveTo>
                  <a:cubicBezTo>
                    <a:pt x="170" y="143"/>
                    <a:pt x="203" y="107"/>
                    <a:pt x="247" y="82"/>
                  </a:cubicBezTo>
                  <a:cubicBezTo>
                    <a:pt x="290" y="57"/>
                    <a:pt x="341" y="45"/>
                    <a:pt x="399" y="45"/>
                  </a:cubicBezTo>
                  <a:cubicBezTo>
                    <a:pt x="440" y="45"/>
                    <a:pt x="477" y="51"/>
                    <a:pt x="512" y="62"/>
                  </a:cubicBezTo>
                  <a:cubicBezTo>
                    <a:pt x="546" y="74"/>
                    <a:pt x="575" y="89"/>
                    <a:pt x="596" y="106"/>
                  </a:cubicBezTo>
                  <a:cubicBezTo>
                    <a:pt x="618" y="124"/>
                    <a:pt x="637" y="144"/>
                    <a:pt x="652" y="167"/>
                  </a:cubicBezTo>
                  <a:cubicBezTo>
                    <a:pt x="668" y="190"/>
                    <a:pt x="681" y="216"/>
                    <a:pt x="690" y="245"/>
                  </a:cubicBezTo>
                  <a:cubicBezTo>
                    <a:pt x="706" y="292"/>
                    <a:pt x="713" y="343"/>
                    <a:pt x="713" y="398"/>
                  </a:cubicBezTo>
                  <a:cubicBezTo>
                    <a:pt x="713" y="463"/>
                    <a:pt x="703" y="521"/>
                    <a:pt x="681" y="571"/>
                  </a:cubicBezTo>
                  <a:cubicBezTo>
                    <a:pt x="660" y="620"/>
                    <a:pt x="627" y="659"/>
                    <a:pt x="584" y="686"/>
                  </a:cubicBezTo>
                  <a:cubicBezTo>
                    <a:pt x="541" y="714"/>
                    <a:pt x="490" y="727"/>
                    <a:pt x="431" y="727"/>
                  </a:cubicBezTo>
                  <a:cubicBezTo>
                    <a:pt x="388" y="727"/>
                    <a:pt x="350" y="721"/>
                    <a:pt x="315" y="707"/>
                  </a:cubicBezTo>
                  <a:cubicBezTo>
                    <a:pt x="280" y="694"/>
                    <a:pt x="248" y="673"/>
                    <a:pt x="220" y="644"/>
                  </a:cubicBezTo>
                  <a:cubicBezTo>
                    <a:pt x="192" y="616"/>
                    <a:pt x="169" y="581"/>
                    <a:pt x="151" y="539"/>
                  </a:cubicBezTo>
                  <a:cubicBezTo>
                    <a:pt x="141" y="514"/>
                    <a:pt x="132" y="484"/>
                    <a:pt x="125" y="450"/>
                  </a:cubicBezTo>
                  <a:cubicBezTo>
                    <a:pt x="118" y="416"/>
                    <a:pt x="115" y="382"/>
                    <a:pt x="115" y="349"/>
                  </a:cubicBezTo>
                  <a:cubicBezTo>
                    <a:pt x="115" y="290"/>
                    <a:pt x="126" y="236"/>
                    <a:pt x="148" y="190"/>
                  </a:cubicBezTo>
                  <a:close/>
                  <a:moveTo>
                    <a:pt x="26" y="541"/>
                  </a:moveTo>
                  <a:cubicBezTo>
                    <a:pt x="44" y="591"/>
                    <a:pt x="70" y="634"/>
                    <a:pt x="105" y="669"/>
                  </a:cubicBezTo>
                  <a:cubicBezTo>
                    <a:pt x="139" y="704"/>
                    <a:pt x="181" y="730"/>
                    <a:pt x="231" y="748"/>
                  </a:cubicBezTo>
                  <a:cubicBezTo>
                    <a:pt x="281" y="765"/>
                    <a:pt x="335" y="775"/>
                    <a:pt x="392" y="775"/>
                  </a:cubicBezTo>
                  <a:cubicBezTo>
                    <a:pt x="518" y="775"/>
                    <a:pt x="623" y="736"/>
                    <a:pt x="706" y="657"/>
                  </a:cubicBezTo>
                  <a:cubicBezTo>
                    <a:pt x="788" y="579"/>
                    <a:pt x="830" y="481"/>
                    <a:pt x="830" y="364"/>
                  </a:cubicBezTo>
                  <a:cubicBezTo>
                    <a:pt x="830" y="327"/>
                    <a:pt x="826" y="293"/>
                    <a:pt x="817" y="261"/>
                  </a:cubicBezTo>
                  <a:cubicBezTo>
                    <a:pt x="809" y="228"/>
                    <a:pt x="798" y="200"/>
                    <a:pt x="784" y="177"/>
                  </a:cubicBezTo>
                  <a:cubicBezTo>
                    <a:pt x="766" y="145"/>
                    <a:pt x="741" y="116"/>
                    <a:pt x="709" y="89"/>
                  </a:cubicBezTo>
                  <a:cubicBezTo>
                    <a:pt x="678" y="62"/>
                    <a:pt x="637" y="41"/>
                    <a:pt x="588" y="25"/>
                  </a:cubicBezTo>
                  <a:cubicBezTo>
                    <a:pt x="538" y="8"/>
                    <a:pt x="484" y="0"/>
                    <a:pt x="423" y="0"/>
                  </a:cubicBezTo>
                  <a:cubicBezTo>
                    <a:pt x="358" y="0"/>
                    <a:pt x="300" y="10"/>
                    <a:pt x="249" y="29"/>
                  </a:cubicBezTo>
                  <a:cubicBezTo>
                    <a:pt x="198" y="48"/>
                    <a:pt x="152" y="76"/>
                    <a:pt x="112" y="113"/>
                  </a:cubicBezTo>
                  <a:cubicBezTo>
                    <a:pt x="72" y="151"/>
                    <a:pt x="43" y="193"/>
                    <a:pt x="26" y="239"/>
                  </a:cubicBezTo>
                  <a:cubicBezTo>
                    <a:pt x="8" y="286"/>
                    <a:pt x="0" y="337"/>
                    <a:pt x="0" y="393"/>
                  </a:cubicBezTo>
                  <a:cubicBezTo>
                    <a:pt x="0" y="441"/>
                    <a:pt x="9" y="491"/>
                    <a:pt x="26" y="541"/>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spTree>
    <p:extLst>
      <p:ext uri="{BB962C8B-B14F-4D97-AF65-F5344CB8AC3E}">
        <p14:creationId xmlns:p14="http://schemas.microsoft.com/office/powerpoint/2010/main" val="199043869"/>
      </p:ext>
    </p:extLst>
  </p:cSld>
  <p:clrMapOvr>
    <a:masterClrMapping/>
  </p:clrMapOvr>
  <p:timing>
    <p:tnLst>
      <p:par>
        <p:cTn id="1" dur="indefinite" restart="never" nodeType="tmRoot"/>
      </p:par>
    </p:tn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06710F16-2A29-4576-9FBC-221E3EF05506}" type="datetime1">
              <a:rPr lang="en-US" smtClean="0"/>
              <a:t>10/28/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DC53FA5-AE81-45E0-8206-920AA27813B4}" type="slidenum">
              <a:rPr lang="en-US" smtClean="0"/>
              <a:t>‹#›</a:t>
            </a:fld>
            <a:endParaRPr lang="en-US"/>
          </a:p>
        </p:txBody>
      </p:sp>
      <p:grpSp>
        <p:nvGrpSpPr>
          <p:cNvPr id="19" name="Group 18"/>
          <p:cNvGrpSpPr/>
          <p:nvPr userDrawn="1"/>
        </p:nvGrpSpPr>
        <p:grpSpPr>
          <a:xfrm>
            <a:off x="120650" y="6299343"/>
            <a:ext cx="420688" cy="458645"/>
            <a:chOff x="657225" y="681038"/>
            <a:chExt cx="1266825" cy="1381125"/>
          </a:xfrm>
          <a:solidFill>
            <a:srgbClr val="FFFFFF"/>
          </a:solidFill>
        </p:grpSpPr>
        <p:sp>
          <p:nvSpPr>
            <p:cNvPr id="20" name="Freeform 5"/>
            <p:cNvSpPr>
              <a:spLocks noEditPoints="1"/>
            </p:cNvSpPr>
            <p:nvPr userDrawn="1"/>
          </p:nvSpPr>
          <p:spPr bwMode="auto">
            <a:xfrm>
              <a:off x="846138" y="1354138"/>
              <a:ext cx="887413" cy="708025"/>
            </a:xfrm>
            <a:custGeom>
              <a:avLst/>
              <a:gdLst>
                <a:gd name="T0" fmla="*/ 2203 w 2794"/>
                <a:gd name="T1" fmla="*/ 0 h 2229"/>
                <a:gd name="T2" fmla="*/ 1613 w 2794"/>
                <a:gd name="T3" fmla="*/ 0 h 2229"/>
                <a:gd name="T4" fmla="*/ 1613 w 2794"/>
                <a:gd name="T5" fmla="*/ 665 h 2229"/>
                <a:gd name="T6" fmla="*/ 1904 w 2794"/>
                <a:gd name="T7" fmla="*/ 1330 h 2229"/>
                <a:gd name="T8" fmla="*/ 1904 w 2794"/>
                <a:gd name="T9" fmla="*/ 1237 h 2229"/>
                <a:gd name="T10" fmla="*/ 1749 w 2794"/>
                <a:gd name="T11" fmla="*/ 747 h 2229"/>
                <a:gd name="T12" fmla="*/ 1749 w 2794"/>
                <a:gd name="T13" fmla="*/ 573 h 2229"/>
                <a:gd name="T14" fmla="*/ 1972 w 2794"/>
                <a:gd name="T15" fmla="*/ 573 h 2229"/>
                <a:gd name="T16" fmla="*/ 1972 w 2794"/>
                <a:gd name="T17" fmla="*/ 1332 h 2229"/>
                <a:gd name="T18" fmla="*/ 1401 w 2794"/>
                <a:gd name="T19" fmla="*/ 2182 h 2229"/>
                <a:gd name="T20" fmla="*/ 829 w 2794"/>
                <a:gd name="T21" fmla="*/ 1374 h 2229"/>
                <a:gd name="T22" fmla="*/ 1180 w 2794"/>
                <a:gd name="T23" fmla="*/ 665 h 2229"/>
                <a:gd name="T24" fmla="*/ 1180 w 2794"/>
                <a:gd name="T25" fmla="*/ 573 h 2229"/>
                <a:gd name="T26" fmla="*/ 1401 w 2794"/>
                <a:gd name="T27" fmla="*/ 573 h 2229"/>
                <a:gd name="T28" fmla="*/ 1542 w 2794"/>
                <a:gd name="T29" fmla="*/ 573 h 2229"/>
                <a:gd name="T30" fmla="*/ 1542 w 2794"/>
                <a:gd name="T31" fmla="*/ 436 h 2229"/>
                <a:gd name="T32" fmla="*/ 1401 w 2794"/>
                <a:gd name="T33" fmla="*/ 436 h 2229"/>
                <a:gd name="T34" fmla="*/ 1180 w 2794"/>
                <a:gd name="T35" fmla="*/ 436 h 2229"/>
                <a:gd name="T36" fmla="*/ 1180 w 2794"/>
                <a:gd name="T37" fmla="*/ 436 h 2229"/>
                <a:gd name="T38" fmla="*/ 1044 w 2794"/>
                <a:gd name="T39" fmla="*/ 436 h 2229"/>
                <a:gd name="T40" fmla="*/ 1044 w 2794"/>
                <a:gd name="T41" fmla="*/ 436 h 2229"/>
                <a:gd name="T42" fmla="*/ 692 w 2794"/>
                <a:gd name="T43" fmla="*/ 436 h 2229"/>
                <a:gd name="T44" fmla="*/ 692 w 2794"/>
                <a:gd name="T45" fmla="*/ 1234 h 2229"/>
                <a:gd name="T46" fmla="*/ 695 w 2794"/>
                <a:gd name="T47" fmla="*/ 1315 h 2229"/>
                <a:gd name="T48" fmla="*/ 695 w 2794"/>
                <a:gd name="T49" fmla="*/ 1315 h 2229"/>
                <a:gd name="T50" fmla="*/ 829 w 2794"/>
                <a:gd name="T51" fmla="*/ 1205 h 2229"/>
                <a:gd name="T52" fmla="*/ 829 w 2794"/>
                <a:gd name="T53" fmla="*/ 1205 h 2229"/>
                <a:gd name="T54" fmla="*/ 829 w 2794"/>
                <a:gd name="T55" fmla="*/ 573 h 2229"/>
                <a:gd name="T56" fmla="*/ 1044 w 2794"/>
                <a:gd name="T57" fmla="*/ 573 h 2229"/>
                <a:gd name="T58" fmla="*/ 1044 w 2794"/>
                <a:gd name="T59" fmla="*/ 573 h 2229"/>
                <a:gd name="T60" fmla="*/ 1044 w 2794"/>
                <a:gd name="T61" fmla="*/ 747 h 2229"/>
                <a:gd name="T62" fmla="*/ 590 w 2794"/>
                <a:gd name="T63" fmla="*/ 1447 h 2229"/>
                <a:gd name="T64" fmla="*/ 135 w 2794"/>
                <a:gd name="T65" fmla="*/ 747 h 2229"/>
                <a:gd name="T66" fmla="*/ 135 w 2794"/>
                <a:gd name="T67" fmla="*/ 136 h 2229"/>
                <a:gd name="T68" fmla="*/ 590 w 2794"/>
                <a:gd name="T69" fmla="*/ 136 h 2229"/>
                <a:gd name="T70" fmla="*/ 1044 w 2794"/>
                <a:gd name="T71" fmla="*/ 136 h 2229"/>
                <a:gd name="T72" fmla="*/ 1044 w 2794"/>
                <a:gd name="T73" fmla="*/ 370 h 2229"/>
                <a:gd name="T74" fmla="*/ 1180 w 2794"/>
                <a:gd name="T75" fmla="*/ 370 h 2229"/>
                <a:gd name="T76" fmla="*/ 1180 w 2794"/>
                <a:gd name="T77" fmla="*/ 0 h 2229"/>
                <a:gd name="T78" fmla="*/ 590 w 2794"/>
                <a:gd name="T79" fmla="*/ 0 h 2229"/>
                <a:gd name="T80" fmla="*/ 0 w 2794"/>
                <a:gd name="T81" fmla="*/ 0 h 2229"/>
                <a:gd name="T82" fmla="*/ 0 w 2794"/>
                <a:gd name="T83" fmla="*/ 665 h 2229"/>
                <a:gd name="T84" fmla="*/ 590 w 2794"/>
                <a:gd name="T85" fmla="*/ 1495 h 2229"/>
                <a:gd name="T86" fmla="*/ 708 w 2794"/>
                <a:gd name="T87" fmla="*/ 1444 h 2229"/>
                <a:gd name="T88" fmla="*/ 1401 w 2794"/>
                <a:gd name="T89" fmla="*/ 2229 h 2229"/>
                <a:gd name="T90" fmla="*/ 2093 w 2794"/>
                <a:gd name="T91" fmla="*/ 1447 h 2229"/>
                <a:gd name="T92" fmla="*/ 2203 w 2794"/>
                <a:gd name="T93" fmla="*/ 1495 h 2229"/>
                <a:gd name="T94" fmla="*/ 2794 w 2794"/>
                <a:gd name="T95" fmla="*/ 665 h 2229"/>
                <a:gd name="T96" fmla="*/ 2794 w 2794"/>
                <a:gd name="T97" fmla="*/ 0 h 2229"/>
                <a:gd name="T98" fmla="*/ 2203 w 2794"/>
                <a:gd name="T99" fmla="*/ 0 h 2229"/>
                <a:gd name="T100" fmla="*/ 2658 w 2794"/>
                <a:gd name="T101" fmla="*/ 747 h 2229"/>
                <a:gd name="T102" fmla="*/ 2203 w 2794"/>
                <a:gd name="T103" fmla="*/ 1447 h 2229"/>
                <a:gd name="T104" fmla="*/ 2100 w 2794"/>
                <a:gd name="T105" fmla="*/ 1395 h 2229"/>
                <a:gd name="T106" fmla="*/ 2109 w 2794"/>
                <a:gd name="T107" fmla="*/ 1234 h 2229"/>
                <a:gd name="T108" fmla="*/ 2109 w 2794"/>
                <a:gd name="T109" fmla="*/ 436 h 2229"/>
                <a:gd name="T110" fmla="*/ 1749 w 2794"/>
                <a:gd name="T111" fmla="*/ 436 h 2229"/>
                <a:gd name="T112" fmla="*/ 1749 w 2794"/>
                <a:gd name="T113" fmla="*/ 136 h 2229"/>
                <a:gd name="T114" fmla="*/ 2203 w 2794"/>
                <a:gd name="T115" fmla="*/ 136 h 2229"/>
                <a:gd name="T116" fmla="*/ 2658 w 2794"/>
                <a:gd name="T117" fmla="*/ 136 h 2229"/>
                <a:gd name="T118" fmla="*/ 2658 w 2794"/>
                <a:gd name="T119" fmla="*/ 747 h 222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 ang="0">
                  <a:pos x="T118" y="T119"/>
                </a:cxn>
              </a:cxnLst>
              <a:rect l="0" t="0" r="r" b="b"/>
              <a:pathLst>
                <a:path w="2794" h="2229">
                  <a:moveTo>
                    <a:pt x="2203" y="0"/>
                  </a:moveTo>
                  <a:cubicBezTo>
                    <a:pt x="1613" y="0"/>
                    <a:pt x="1613" y="0"/>
                    <a:pt x="1613" y="0"/>
                  </a:cubicBezTo>
                  <a:cubicBezTo>
                    <a:pt x="1613" y="665"/>
                    <a:pt x="1613" y="665"/>
                    <a:pt x="1613" y="665"/>
                  </a:cubicBezTo>
                  <a:cubicBezTo>
                    <a:pt x="1613" y="970"/>
                    <a:pt x="1719" y="1183"/>
                    <a:pt x="1904" y="1330"/>
                  </a:cubicBezTo>
                  <a:cubicBezTo>
                    <a:pt x="1904" y="1237"/>
                    <a:pt x="1904" y="1237"/>
                    <a:pt x="1904" y="1237"/>
                  </a:cubicBezTo>
                  <a:cubicBezTo>
                    <a:pt x="1769" y="1081"/>
                    <a:pt x="1749" y="901"/>
                    <a:pt x="1749" y="747"/>
                  </a:cubicBezTo>
                  <a:cubicBezTo>
                    <a:pt x="1749" y="573"/>
                    <a:pt x="1749" y="573"/>
                    <a:pt x="1749" y="573"/>
                  </a:cubicBezTo>
                  <a:cubicBezTo>
                    <a:pt x="1972" y="573"/>
                    <a:pt x="1972" y="573"/>
                    <a:pt x="1972" y="573"/>
                  </a:cubicBezTo>
                  <a:cubicBezTo>
                    <a:pt x="1972" y="1332"/>
                    <a:pt x="1972" y="1332"/>
                    <a:pt x="1972" y="1332"/>
                  </a:cubicBezTo>
                  <a:cubicBezTo>
                    <a:pt x="1972" y="1609"/>
                    <a:pt x="1895" y="1961"/>
                    <a:pt x="1401" y="2182"/>
                  </a:cubicBezTo>
                  <a:cubicBezTo>
                    <a:pt x="931" y="1972"/>
                    <a:pt x="838" y="1643"/>
                    <a:pt x="829" y="1374"/>
                  </a:cubicBezTo>
                  <a:cubicBezTo>
                    <a:pt x="1051" y="1225"/>
                    <a:pt x="1180" y="1001"/>
                    <a:pt x="1180" y="665"/>
                  </a:cubicBezTo>
                  <a:cubicBezTo>
                    <a:pt x="1180" y="573"/>
                    <a:pt x="1180" y="573"/>
                    <a:pt x="1180" y="573"/>
                  </a:cubicBezTo>
                  <a:cubicBezTo>
                    <a:pt x="1401" y="573"/>
                    <a:pt x="1401" y="573"/>
                    <a:pt x="1401" y="573"/>
                  </a:cubicBezTo>
                  <a:cubicBezTo>
                    <a:pt x="1542" y="573"/>
                    <a:pt x="1542" y="573"/>
                    <a:pt x="1542" y="573"/>
                  </a:cubicBezTo>
                  <a:cubicBezTo>
                    <a:pt x="1542" y="436"/>
                    <a:pt x="1542" y="436"/>
                    <a:pt x="1542" y="436"/>
                  </a:cubicBezTo>
                  <a:cubicBezTo>
                    <a:pt x="1401" y="436"/>
                    <a:pt x="1401" y="436"/>
                    <a:pt x="1401" y="436"/>
                  </a:cubicBezTo>
                  <a:cubicBezTo>
                    <a:pt x="1180" y="436"/>
                    <a:pt x="1180" y="436"/>
                    <a:pt x="1180" y="436"/>
                  </a:cubicBezTo>
                  <a:cubicBezTo>
                    <a:pt x="1180" y="436"/>
                    <a:pt x="1180" y="436"/>
                    <a:pt x="1180" y="436"/>
                  </a:cubicBezTo>
                  <a:cubicBezTo>
                    <a:pt x="1044" y="436"/>
                    <a:pt x="1044" y="436"/>
                    <a:pt x="1044" y="436"/>
                  </a:cubicBezTo>
                  <a:cubicBezTo>
                    <a:pt x="1044" y="436"/>
                    <a:pt x="1044" y="436"/>
                    <a:pt x="1044" y="436"/>
                  </a:cubicBezTo>
                  <a:cubicBezTo>
                    <a:pt x="692" y="436"/>
                    <a:pt x="692" y="436"/>
                    <a:pt x="692" y="436"/>
                  </a:cubicBezTo>
                  <a:cubicBezTo>
                    <a:pt x="692" y="1234"/>
                    <a:pt x="692" y="1234"/>
                    <a:pt x="692" y="1234"/>
                  </a:cubicBezTo>
                  <a:cubicBezTo>
                    <a:pt x="692" y="1262"/>
                    <a:pt x="693" y="1289"/>
                    <a:pt x="695" y="1315"/>
                  </a:cubicBezTo>
                  <a:cubicBezTo>
                    <a:pt x="695" y="1315"/>
                    <a:pt x="695" y="1315"/>
                    <a:pt x="695" y="1315"/>
                  </a:cubicBezTo>
                  <a:cubicBezTo>
                    <a:pt x="748" y="1280"/>
                    <a:pt x="792" y="1244"/>
                    <a:pt x="829" y="1205"/>
                  </a:cubicBezTo>
                  <a:cubicBezTo>
                    <a:pt x="829" y="1205"/>
                    <a:pt x="829" y="1205"/>
                    <a:pt x="829" y="1205"/>
                  </a:cubicBezTo>
                  <a:cubicBezTo>
                    <a:pt x="829" y="573"/>
                    <a:pt x="829" y="573"/>
                    <a:pt x="829" y="573"/>
                  </a:cubicBezTo>
                  <a:cubicBezTo>
                    <a:pt x="1044" y="573"/>
                    <a:pt x="1044" y="573"/>
                    <a:pt x="1044" y="573"/>
                  </a:cubicBezTo>
                  <a:cubicBezTo>
                    <a:pt x="1044" y="573"/>
                    <a:pt x="1044" y="573"/>
                    <a:pt x="1044" y="573"/>
                  </a:cubicBezTo>
                  <a:cubicBezTo>
                    <a:pt x="1044" y="747"/>
                    <a:pt x="1044" y="747"/>
                    <a:pt x="1044" y="747"/>
                  </a:cubicBezTo>
                  <a:cubicBezTo>
                    <a:pt x="1044" y="978"/>
                    <a:pt x="1001" y="1263"/>
                    <a:pt x="590" y="1447"/>
                  </a:cubicBezTo>
                  <a:cubicBezTo>
                    <a:pt x="178" y="1263"/>
                    <a:pt x="135" y="978"/>
                    <a:pt x="135" y="747"/>
                  </a:cubicBezTo>
                  <a:cubicBezTo>
                    <a:pt x="135" y="136"/>
                    <a:pt x="135" y="136"/>
                    <a:pt x="135" y="136"/>
                  </a:cubicBezTo>
                  <a:cubicBezTo>
                    <a:pt x="590" y="136"/>
                    <a:pt x="590" y="136"/>
                    <a:pt x="590" y="136"/>
                  </a:cubicBezTo>
                  <a:cubicBezTo>
                    <a:pt x="1044" y="136"/>
                    <a:pt x="1044" y="136"/>
                    <a:pt x="1044" y="136"/>
                  </a:cubicBezTo>
                  <a:cubicBezTo>
                    <a:pt x="1044" y="370"/>
                    <a:pt x="1044" y="370"/>
                    <a:pt x="1044" y="370"/>
                  </a:cubicBezTo>
                  <a:cubicBezTo>
                    <a:pt x="1180" y="370"/>
                    <a:pt x="1180" y="370"/>
                    <a:pt x="1180" y="370"/>
                  </a:cubicBezTo>
                  <a:cubicBezTo>
                    <a:pt x="1180" y="0"/>
                    <a:pt x="1180" y="0"/>
                    <a:pt x="1180" y="0"/>
                  </a:cubicBezTo>
                  <a:cubicBezTo>
                    <a:pt x="590" y="0"/>
                    <a:pt x="590" y="0"/>
                    <a:pt x="590" y="0"/>
                  </a:cubicBezTo>
                  <a:cubicBezTo>
                    <a:pt x="0" y="0"/>
                    <a:pt x="0" y="0"/>
                    <a:pt x="0" y="0"/>
                  </a:cubicBezTo>
                  <a:cubicBezTo>
                    <a:pt x="0" y="665"/>
                    <a:pt x="0" y="665"/>
                    <a:pt x="0" y="665"/>
                  </a:cubicBezTo>
                  <a:cubicBezTo>
                    <a:pt x="0" y="1109"/>
                    <a:pt x="224" y="1357"/>
                    <a:pt x="590" y="1495"/>
                  </a:cubicBezTo>
                  <a:cubicBezTo>
                    <a:pt x="631" y="1479"/>
                    <a:pt x="670" y="1462"/>
                    <a:pt x="708" y="1444"/>
                  </a:cubicBezTo>
                  <a:cubicBezTo>
                    <a:pt x="771" y="1847"/>
                    <a:pt x="1023" y="2087"/>
                    <a:pt x="1401" y="2229"/>
                  </a:cubicBezTo>
                  <a:cubicBezTo>
                    <a:pt x="1777" y="2087"/>
                    <a:pt x="2029" y="1848"/>
                    <a:pt x="2093" y="1447"/>
                  </a:cubicBezTo>
                  <a:cubicBezTo>
                    <a:pt x="2128" y="1464"/>
                    <a:pt x="2165" y="1480"/>
                    <a:pt x="2203" y="1495"/>
                  </a:cubicBezTo>
                  <a:cubicBezTo>
                    <a:pt x="2569" y="1357"/>
                    <a:pt x="2794" y="1109"/>
                    <a:pt x="2794" y="665"/>
                  </a:cubicBezTo>
                  <a:cubicBezTo>
                    <a:pt x="2794" y="0"/>
                    <a:pt x="2794" y="0"/>
                    <a:pt x="2794" y="0"/>
                  </a:cubicBezTo>
                  <a:lnTo>
                    <a:pt x="2203" y="0"/>
                  </a:lnTo>
                  <a:close/>
                  <a:moveTo>
                    <a:pt x="2658" y="747"/>
                  </a:moveTo>
                  <a:cubicBezTo>
                    <a:pt x="2658" y="978"/>
                    <a:pt x="2615" y="1263"/>
                    <a:pt x="2203" y="1447"/>
                  </a:cubicBezTo>
                  <a:cubicBezTo>
                    <a:pt x="2166" y="1431"/>
                    <a:pt x="2131" y="1413"/>
                    <a:pt x="2100" y="1395"/>
                  </a:cubicBezTo>
                  <a:cubicBezTo>
                    <a:pt x="2106" y="1344"/>
                    <a:pt x="2109" y="1290"/>
                    <a:pt x="2109" y="1234"/>
                  </a:cubicBezTo>
                  <a:cubicBezTo>
                    <a:pt x="2109" y="436"/>
                    <a:pt x="2109" y="436"/>
                    <a:pt x="2109" y="436"/>
                  </a:cubicBezTo>
                  <a:cubicBezTo>
                    <a:pt x="1749" y="436"/>
                    <a:pt x="1749" y="436"/>
                    <a:pt x="1749" y="436"/>
                  </a:cubicBezTo>
                  <a:cubicBezTo>
                    <a:pt x="1749" y="136"/>
                    <a:pt x="1749" y="136"/>
                    <a:pt x="1749" y="136"/>
                  </a:cubicBezTo>
                  <a:cubicBezTo>
                    <a:pt x="2203" y="136"/>
                    <a:pt x="2203" y="136"/>
                    <a:pt x="2203" y="136"/>
                  </a:cubicBezTo>
                  <a:cubicBezTo>
                    <a:pt x="2658" y="136"/>
                    <a:pt x="2658" y="136"/>
                    <a:pt x="2658" y="136"/>
                  </a:cubicBezTo>
                  <a:lnTo>
                    <a:pt x="2658" y="74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1" name="Freeform 6"/>
            <p:cNvSpPr>
              <a:spLocks/>
            </p:cNvSpPr>
            <p:nvPr userDrawn="1"/>
          </p:nvSpPr>
          <p:spPr bwMode="auto">
            <a:xfrm>
              <a:off x="915988" y="1003301"/>
              <a:ext cx="188913" cy="236538"/>
            </a:xfrm>
            <a:custGeom>
              <a:avLst/>
              <a:gdLst>
                <a:gd name="T0" fmla="*/ 49 w 596"/>
                <a:gd name="T1" fmla="*/ 747 h 747"/>
                <a:gd name="T2" fmla="*/ 49 w 596"/>
                <a:gd name="T3" fmla="*/ 721 h 747"/>
                <a:gd name="T4" fmla="*/ 91 w 596"/>
                <a:gd name="T5" fmla="*/ 696 h 747"/>
                <a:gd name="T6" fmla="*/ 99 w 596"/>
                <a:gd name="T7" fmla="*/ 684 h 747"/>
                <a:gd name="T8" fmla="*/ 105 w 596"/>
                <a:gd name="T9" fmla="*/ 621 h 747"/>
                <a:gd name="T10" fmla="*/ 109 w 596"/>
                <a:gd name="T11" fmla="*/ 535 h 747"/>
                <a:gd name="T12" fmla="*/ 109 w 596"/>
                <a:gd name="T13" fmla="*/ 252 h 747"/>
                <a:gd name="T14" fmla="*/ 105 w 596"/>
                <a:gd name="T15" fmla="*/ 112 h 747"/>
                <a:gd name="T16" fmla="*/ 98 w 596"/>
                <a:gd name="T17" fmla="*/ 52 h 747"/>
                <a:gd name="T18" fmla="*/ 78 w 596"/>
                <a:gd name="T19" fmla="*/ 39 h 747"/>
                <a:gd name="T20" fmla="*/ 0 w 596"/>
                <a:gd name="T21" fmla="*/ 33 h 747"/>
                <a:gd name="T22" fmla="*/ 0 w 596"/>
                <a:gd name="T23" fmla="*/ 0 h 747"/>
                <a:gd name="T24" fmla="*/ 165 w 596"/>
                <a:gd name="T25" fmla="*/ 3 h 747"/>
                <a:gd name="T26" fmla="*/ 323 w 596"/>
                <a:gd name="T27" fmla="*/ 0 h 747"/>
                <a:gd name="T28" fmla="*/ 323 w 596"/>
                <a:gd name="T29" fmla="*/ 33 h 747"/>
                <a:gd name="T30" fmla="*/ 243 w 596"/>
                <a:gd name="T31" fmla="*/ 39 h 747"/>
                <a:gd name="T32" fmla="*/ 224 w 596"/>
                <a:gd name="T33" fmla="*/ 51 h 747"/>
                <a:gd name="T34" fmla="*/ 216 w 596"/>
                <a:gd name="T35" fmla="*/ 102 h 747"/>
                <a:gd name="T36" fmla="*/ 213 w 596"/>
                <a:gd name="T37" fmla="*/ 252 h 747"/>
                <a:gd name="T38" fmla="*/ 213 w 596"/>
                <a:gd name="T39" fmla="*/ 606 h 747"/>
                <a:gd name="T40" fmla="*/ 216 w 596"/>
                <a:gd name="T41" fmla="*/ 696 h 747"/>
                <a:gd name="T42" fmla="*/ 303 w 596"/>
                <a:gd name="T43" fmla="*/ 700 h 747"/>
                <a:gd name="T44" fmla="*/ 525 w 596"/>
                <a:gd name="T45" fmla="*/ 681 h 747"/>
                <a:gd name="T46" fmla="*/ 538 w 596"/>
                <a:gd name="T47" fmla="*/ 644 h 747"/>
                <a:gd name="T48" fmla="*/ 560 w 596"/>
                <a:gd name="T49" fmla="*/ 557 h 747"/>
                <a:gd name="T50" fmla="*/ 596 w 596"/>
                <a:gd name="T51" fmla="*/ 557 h 747"/>
                <a:gd name="T52" fmla="*/ 573 w 596"/>
                <a:gd name="T53" fmla="*/ 741 h 747"/>
                <a:gd name="T54" fmla="*/ 537 w 596"/>
                <a:gd name="T55" fmla="*/ 746 h 747"/>
                <a:gd name="T56" fmla="*/ 449 w 596"/>
                <a:gd name="T57" fmla="*/ 747 h 747"/>
                <a:gd name="T58" fmla="*/ 156 w 596"/>
                <a:gd name="T59" fmla="*/ 744 h 747"/>
                <a:gd name="T60" fmla="*/ 49 w 596"/>
                <a:gd name="T61" fmla="*/ 747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Lst>
              <a:rect l="0" t="0" r="r" b="b"/>
              <a:pathLst>
                <a:path w="596" h="747">
                  <a:moveTo>
                    <a:pt x="49" y="747"/>
                  </a:moveTo>
                  <a:cubicBezTo>
                    <a:pt x="49" y="721"/>
                    <a:pt x="49" y="721"/>
                    <a:pt x="49" y="721"/>
                  </a:cubicBezTo>
                  <a:cubicBezTo>
                    <a:pt x="71" y="710"/>
                    <a:pt x="85" y="702"/>
                    <a:pt x="91" y="696"/>
                  </a:cubicBezTo>
                  <a:cubicBezTo>
                    <a:pt x="95" y="693"/>
                    <a:pt x="98" y="689"/>
                    <a:pt x="99" y="684"/>
                  </a:cubicBezTo>
                  <a:cubicBezTo>
                    <a:pt x="102" y="675"/>
                    <a:pt x="104" y="654"/>
                    <a:pt x="105" y="621"/>
                  </a:cubicBezTo>
                  <a:cubicBezTo>
                    <a:pt x="108" y="573"/>
                    <a:pt x="109" y="545"/>
                    <a:pt x="109" y="535"/>
                  </a:cubicBezTo>
                  <a:cubicBezTo>
                    <a:pt x="109" y="252"/>
                    <a:pt x="109" y="252"/>
                    <a:pt x="109" y="252"/>
                  </a:cubicBezTo>
                  <a:cubicBezTo>
                    <a:pt x="109" y="204"/>
                    <a:pt x="108" y="157"/>
                    <a:pt x="105" y="112"/>
                  </a:cubicBezTo>
                  <a:cubicBezTo>
                    <a:pt x="104" y="78"/>
                    <a:pt x="102" y="59"/>
                    <a:pt x="98" y="52"/>
                  </a:cubicBezTo>
                  <a:cubicBezTo>
                    <a:pt x="93" y="46"/>
                    <a:pt x="87" y="42"/>
                    <a:pt x="78" y="39"/>
                  </a:cubicBezTo>
                  <a:cubicBezTo>
                    <a:pt x="69" y="36"/>
                    <a:pt x="43" y="34"/>
                    <a:pt x="0" y="33"/>
                  </a:cubicBezTo>
                  <a:cubicBezTo>
                    <a:pt x="0" y="0"/>
                    <a:pt x="0" y="0"/>
                    <a:pt x="0" y="0"/>
                  </a:cubicBezTo>
                  <a:cubicBezTo>
                    <a:pt x="89" y="2"/>
                    <a:pt x="144" y="3"/>
                    <a:pt x="165" y="3"/>
                  </a:cubicBezTo>
                  <a:cubicBezTo>
                    <a:pt x="189" y="3"/>
                    <a:pt x="241" y="2"/>
                    <a:pt x="323" y="0"/>
                  </a:cubicBezTo>
                  <a:cubicBezTo>
                    <a:pt x="323" y="33"/>
                    <a:pt x="323" y="33"/>
                    <a:pt x="323" y="33"/>
                  </a:cubicBezTo>
                  <a:cubicBezTo>
                    <a:pt x="279" y="34"/>
                    <a:pt x="253" y="36"/>
                    <a:pt x="243" y="39"/>
                  </a:cubicBezTo>
                  <a:cubicBezTo>
                    <a:pt x="234" y="42"/>
                    <a:pt x="228" y="46"/>
                    <a:pt x="224" y="51"/>
                  </a:cubicBezTo>
                  <a:cubicBezTo>
                    <a:pt x="220" y="58"/>
                    <a:pt x="217" y="75"/>
                    <a:pt x="216" y="102"/>
                  </a:cubicBezTo>
                  <a:cubicBezTo>
                    <a:pt x="215" y="109"/>
                    <a:pt x="214" y="159"/>
                    <a:pt x="213" y="252"/>
                  </a:cubicBezTo>
                  <a:cubicBezTo>
                    <a:pt x="213" y="606"/>
                    <a:pt x="213" y="606"/>
                    <a:pt x="213" y="606"/>
                  </a:cubicBezTo>
                  <a:cubicBezTo>
                    <a:pt x="213" y="643"/>
                    <a:pt x="214" y="673"/>
                    <a:pt x="216" y="696"/>
                  </a:cubicBezTo>
                  <a:cubicBezTo>
                    <a:pt x="257" y="699"/>
                    <a:pt x="262" y="700"/>
                    <a:pt x="303" y="700"/>
                  </a:cubicBezTo>
                  <a:cubicBezTo>
                    <a:pt x="407" y="700"/>
                    <a:pt x="484" y="693"/>
                    <a:pt x="525" y="681"/>
                  </a:cubicBezTo>
                  <a:cubicBezTo>
                    <a:pt x="530" y="670"/>
                    <a:pt x="534" y="658"/>
                    <a:pt x="538" y="644"/>
                  </a:cubicBezTo>
                  <a:cubicBezTo>
                    <a:pt x="560" y="557"/>
                    <a:pt x="560" y="557"/>
                    <a:pt x="560" y="557"/>
                  </a:cubicBezTo>
                  <a:cubicBezTo>
                    <a:pt x="596" y="557"/>
                    <a:pt x="596" y="557"/>
                    <a:pt x="596" y="557"/>
                  </a:cubicBezTo>
                  <a:cubicBezTo>
                    <a:pt x="588" y="609"/>
                    <a:pt x="580" y="671"/>
                    <a:pt x="573" y="741"/>
                  </a:cubicBezTo>
                  <a:cubicBezTo>
                    <a:pt x="558" y="744"/>
                    <a:pt x="546" y="745"/>
                    <a:pt x="537" y="746"/>
                  </a:cubicBezTo>
                  <a:cubicBezTo>
                    <a:pt x="518" y="747"/>
                    <a:pt x="488" y="747"/>
                    <a:pt x="449" y="747"/>
                  </a:cubicBezTo>
                  <a:cubicBezTo>
                    <a:pt x="156" y="744"/>
                    <a:pt x="156" y="744"/>
                    <a:pt x="156" y="744"/>
                  </a:cubicBezTo>
                  <a:cubicBezTo>
                    <a:pt x="121" y="744"/>
                    <a:pt x="85" y="745"/>
                    <a:pt x="49"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2" name="Freeform 7"/>
            <p:cNvSpPr>
              <a:spLocks/>
            </p:cNvSpPr>
            <p:nvPr userDrawn="1"/>
          </p:nvSpPr>
          <p:spPr bwMode="auto">
            <a:xfrm>
              <a:off x="1127125" y="1003301"/>
              <a:ext cx="103188" cy="236538"/>
            </a:xfrm>
            <a:custGeom>
              <a:avLst/>
              <a:gdLst>
                <a:gd name="T0" fmla="*/ 321 w 321"/>
                <a:gd name="T1" fmla="*/ 714 h 747"/>
                <a:gd name="T2" fmla="*/ 321 w 321"/>
                <a:gd name="T3" fmla="*/ 747 h 747"/>
                <a:gd name="T4" fmla="*/ 168 w 321"/>
                <a:gd name="T5" fmla="*/ 744 h 747"/>
                <a:gd name="T6" fmla="*/ 0 w 321"/>
                <a:gd name="T7" fmla="*/ 747 h 747"/>
                <a:gd name="T8" fmla="*/ 0 w 321"/>
                <a:gd name="T9" fmla="*/ 714 h 747"/>
                <a:gd name="T10" fmla="*/ 77 w 321"/>
                <a:gd name="T11" fmla="*/ 708 h 747"/>
                <a:gd name="T12" fmla="*/ 97 w 321"/>
                <a:gd name="T13" fmla="*/ 696 h 747"/>
                <a:gd name="T14" fmla="*/ 105 w 321"/>
                <a:gd name="T15" fmla="*/ 645 h 747"/>
                <a:gd name="T16" fmla="*/ 108 w 321"/>
                <a:gd name="T17" fmla="*/ 495 h 747"/>
                <a:gd name="T18" fmla="*/ 108 w 321"/>
                <a:gd name="T19" fmla="*/ 251 h 747"/>
                <a:gd name="T20" fmla="*/ 105 w 321"/>
                <a:gd name="T21" fmla="*/ 111 h 747"/>
                <a:gd name="T22" fmla="*/ 97 w 321"/>
                <a:gd name="T23" fmla="*/ 52 h 747"/>
                <a:gd name="T24" fmla="*/ 77 w 321"/>
                <a:gd name="T25" fmla="*/ 39 h 747"/>
                <a:gd name="T26" fmla="*/ 0 w 321"/>
                <a:gd name="T27" fmla="*/ 33 h 747"/>
                <a:gd name="T28" fmla="*/ 0 w 321"/>
                <a:gd name="T29" fmla="*/ 0 h 747"/>
                <a:gd name="T30" fmla="*/ 161 w 321"/>
                <a:gd name="T31" fmla="*/ 3 h 747"/>
                <a:gd name="T32" fmla="*/ 321 w 321"/>
                <a:gd name="T33" fmla="*/ 0 h 747"/>
                <a:gd name="T34" fmla="*/ 321 w 321"/>
                <a:gd name="T35" fmla="*/ 33 h 747"/>
                <a:gd name="T36" fmla="*/ 243 w 321"/>
                <a:gd name="T37" fmla="*/ 39 h 747"/>
                <a:gd name="T38" fmla="*/ 224 w 321"/>
                <a:gd name="T39" fmla="*/ 51 h 747"/>
                <a:gd name="T40" fmla="*/ 216 w 321"/>
                <a:gd name="T41" fmla="*/ 102 h 747"/>
                <a:gd name="T42" fmla="*/ 212 w 321"/>
                <a:gd name="T43" fmla="*/ 251 h 747"/>
                <a:gd name="T44" fmla="*/ 212 w 321"/>
                <a:gd name="T45" fmla="*/ 495 h 747"/>
                <a:gd name="T46" fmla="*/ 214 w 321"/>
                <a:gd name="T47" fmla="*/ 635 h 747"/>
                <a:gd name="T48" fmla="*/ 222 w 321"/>
                <a:gd name="T49" fmla="*/ 694 h 747"/>
                <a:gd name="T50" fmla="*/ 242 w 321"/>
                <a:gd name="T51" fmla="*/ 708 h 747"/>
                <a:gd name="T52" fmla="*/ 321 w 321"/>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1" h="747">
                  <a:moveTo>
                    <a:pt x="321" y="714"/>
                  </a:moveTo>
                  <a:cubicBezTo>
                    <a:pt x="321" y="747"/>
                    <a:pt x="321" y="747"/>
                    <a:pt x="321" y="747"/>
                  </a:cubicBezTo>
                  <a:cubicBezTo>
                    <a:pt x="244" y="745"/>
                    <a:pt x="193" y="744"/>
                    <a:pt x="168" y="744"/>
                  </a:cubicBezTo>
                  <a:cubicBezTo>
                    <a:pt x="0" y="747"/>
                    <a:pt x="0" y="747"/>
                    <a:pt x="0" y="747"/>
                  </a:cubicBezTo>
                  <a:cubicBezTo>
                    <a:pt x="0" y="714"/>
                    <a:pt x="0" y="714"/>
                    <a:pt x="0" y="714"/>
                  </a:cubicBezTo>
                  <a:cubicBezTo>
                    <a:pt x="42" y="713"/>
                    <a:pt x="68" y="711"/>
                    <a:pt x="77" y="708"/>
                  </a:cubicBezTo>
                  <a:cubicBezTo>
                    <a:pt x="87" y="705"/>
                    <a:pt x="93" y="701"/>
                    <a:pt x="97" y="696"/>
                  </a:cubicBezTo>
                  <a:cubicBezTo>
                    <a:pt x="101" y="689"/>
                    <a:pt x="104" y="672"/>
                    <a:pt x="105" y="645"/>
                  </a:cubicBezTo>
                  <a:cubicBezTo>
                    <a:pt x="106" y="637"/>
                    <a:pt x="107" y="587"/>
                    <a:pt x="108" y="495"/>
                  </a:cubicBezTo>
                  <a:cubicBezTo>
                    <a:pt x="108" y="251"/>
                    <a:pt x="108" y="251"/>
                    <a:pt x="108" y="251"/>
                  </a:cubicBezTo>
                  <a:cubicBezTo>
                    <a:pt x="108" y="204"/>
                    <a:pt x="107" y="157"/>
                    <a:pt x="105" y="111"/>
                  </a:cubicBezTo>
                  <a:cubicBezTo>
                    <a:pt x="104" y="78"/>
                    <a:pt x="102" y="59"/>
                    <a:pt x="97" y="52"/>
                  </a:cubicBezTo>
                  <a:cubicBezTo>
                    <a:pt x="93" y="46"/>
                    <a:pt x="87" y="41"/>
                    <a:pt x="77" y="39"/>
                  </a:cubicBezTo>
                  <a:cubicBezTo>
                    <a:pt x="68" y="36"/>
                    <a:pt x="42" y="34"/>
                    <a:pt x="0" y="33"/>
                  </a:cubicBezTo>
                  <a:cubicBezTo>
                    <a:pt x="0" y="0"/>
                    <a:pt x="0" y="0"/>
                    <a:pt x="0" y="0"/>
                  </a:cubicBezTo>
                  <a:cubicBezTo>
                    <a:pt x="69" y="2"/>
                    <a:pt x="123" y="3"/>
                    <a:pt x="161" y="3"/>
                  </a:cubicBezTo>
                  <a:cubicBezTo>
                    <a:pt x="197" y="3"/>
                    <a:pt x="250" y="2"/>
                    <a:pt x="321" y="0"/>
                  </a:cubicBezTo>
                  <a:cubicBezTo>
                    <a:pt x="321" y="33"/>
                    <a:pt x="321" y="33"/>
                    <a:pt x="321" y="33"/>
                  </a:cubicBezTo>
                  <a:cubicBezTo>
                    <a:pt x="278" y="34"/>
                    <a:pt x="252" y="36"/>
                    <a:pt x="243" y="39"/>
                  </a:cubicBezTo>
                  <a:cubicBezTo>
                    <a:pt x="234" y="41"/>
                    <a:pt x="227" y="46"/>
                    <a:pt x="224" y="51"/>
                  </a:cubicBezTo>
                  <a:cubicBezTo>
                    <a:pt x="219" y="58"/>
                    <a:pt x="217" y="75"/>
                    <a:pt x="216" y="102"/>
                  </a:cubicBezTo>
                  <a:cubicBezTo>
                    <a:pt x="215" y="109"/>
                    <a:pt x="214" y="159"/>
                    <a:pt x="212" y="251"/>
                  </a:cubicBezTo>
                  <a:cubicBezTo>
                    <a:pt x="212" y="495"/>
                    <a:pt x="212" y="495"/>
                    <a:pt x="212" y="495"/>
                  </a:cubicBezTo>
                  <a:cubicBezTo>
                    <a:pt x="212" y="543"/>
                    <a:pt x="213" y="589"/>
                    <a:pt x="214" y="635"/>
                  </a:cubicBezTo>
                  <a:cubicBezTo>
                    <a:pt x="215" y="668"/>
                    <a:pt x="218" y="688"/>
                    <a:pt x="222" y="694"/>
                  </a:cubicBezTo>
                  <a:cubicBezTo>
                    <a:pt x="226" y="700"/>
                    <a:pt x="233" y="705"/>
                    <a:pt x="242" y="708"/>
                  </a:cubicBezTo>
                  <a:cubicBezTo>
                    <a:pt x="251" y="711"/>
                    <a:pt x="278" y="713"/>
                    <a:pt x="321"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3" name="Freeform 8"/>
            <p:cNvSpPr>
              <a:spLocks/>
            </p:cNvSpPr>
            <p:nvPr userDrawn="1"/>
          </p:nvSpPr>
          <p:spPr bwMode="auto">
            <a:xfrm>
              <a:off x="1266825" y="1003301"/>
              <a:ext cx="276225" cy="242888"/>
            </a:xfrm>
            <a:custGeom>
              <a:avLst/>
              <a:gdLst>
                <a:gd name="T0" fmla="*/ 5 w 869"/>
                <a:gd name="T1" fmla="*/ 747 h 766"/>
                <a:gd name="T2" fmla="*/ 5 w 869"/>
                <a:gd name="T3" fmla="*/ 714 h 766"/>
                <a:gd name="T4" fmla="*/ 80 w 869"/>
                <a:gd name="T5" fmla="*/ 705 h 766"/>
                <a:gd name="T6" fmla="*/ 91 w 869"/>
                <a:gd name="T7" fmla="*/ 695 h 766"/>
                <a:gd name="T8" fmla="*/ 99 w 869"/>
                <a:gd name="T9" fmla="*/ 640 h 766"/>
                <a:gd name="T10" fmla="*/ 102 w 869"/>
                <a:gd name="T11" fmla="*/ 520 h 766"/>
                <a:gd name="T12" fmla="*/ 102 w 869"/>
                <a:gd name="T13" fmla="*/ 92 h 766"/>
                <a:gd name="T14" fmla="*/ 100 w 869"/>
                <a:gd name="T15" fmla="*/ 69 h 766"/>
                <a:gd name="T16" fmla="*/ 80 w 869"/>
                <a:gd name="T17" fmla="*/ 47 h 766"/>
                <a:gd name="T18" fmla="*/ 57 w 869"/>
                <a:gd name="T19" fmla="*/ 36 h 766"/>
                <a:gd name="T20" fmla="*/ 0 w 869"/>
                <a:gd name="T21" fmla="*/ 33 h 766"/>
                <a:gd name="T22" fmla="*/ 0 w 869"/>
                <a:gd name="T23" fmla="*/ 0 h 766"/>
                <a:gd name="T24" fmla="*/ 119 w 869"/>
                <a:gd name="T25" fmla="*/ 3 h 766"/>
                <a:gd name="T26" fmla="*/ 202 w 869"/>
                <a:gd name="T27" fmla="*/ 0 h 766"/>
                <a:gd name="T28" fmla="*/ 269 w 869"/>
                <a:gd name="T29" fmla="*/ 86 h 766"/>
                <a:gd name="T30" fmla="*/ 381 w 869"/>
                <a:gd name="T31" fmla="*/ 220 h 766"/>
                <a:gd name="T32" fmla="*/ 545 w 869"/>
                <a:gd name="T33" fmla="*/ 411 h 766"/>
                <a:gd name="T34" fmla="*/ 671 w 869"/>
                <a:gd name="T35" fmla="*/ 554 h 766"/>
                <a:gd name="T36" fmla="*/ 721 w 869"/>
                <a:gd name="T37" fmla="*/ 609 h 766"/>
                <a:gd name="T38" fmla="*/ 721 w 869"/>
                <a:gd name="T39" fmla="*/ 226 h 766"/>
                <a:gd name="T40" fmla="*/ 718 w 869"/>
                <a:gd name="T41" fmla="*/ 105 h 766"/>
                <a:gd name="T42" fmla="*/ 711 w 869"/>
                <a:gd name="T43" fmla="*/ 51 h 766"/>
                <a:gd name="T44" fmla="*/ 699 w 869"/>
                <a:gd name="T45" fmla="*/ 41 h 766"/>
                <a:gd name="T46" fmla="*/ 624 w 869"/>
                <a:gd name="T47" fmla="*/ 33 h 766"/>
                <a:gd name="T48" fmla="*/ 624 w 869"/>
                <a:gd name="T49" fmla="*/ 0 h 766"/>
                <a:gd name="T50" fmla="*/ 756 w 869"/>
                <a:gd name="T51" fmla="*/ 3 h 766"/>
                <a:gd name="T52" fmla="*/ 869 w 869"/>
                <a:gd name="T53" fmla="*/ 0 h 766"/>
                <a:gd name="T54" fmla="*/ 869 w 869"/>
                <a:gd name="T55" fmla="*/ 33 h 766"/>
                <a:gd name="T56" fmla="*/ 794 w 869"/>
                <a:gd name="T57" fmla="*/ 41 h 766"/>
                <a:gd name="T58" fmla="*/ 783 w 869"/>
                <a:gd name="T59" fmla="*/ 52 h 766"/>
                <a:gd name="T60" fmla="*/ 775 w 869"/>
                <a:gd name="T61" fmla="*/ 107 h 766"/>
                <a:gd name="T62" fmla="*/ 772 w 869"/>
                <a:gd name="T63" fmla="*/ 226 h 766"/>
                <a:gd name="T64" fmla="*/ 772 w 869"/>
                <a:gd name="T65" fmla="*/ 479 h 766"/>
                <a:gd name="T66" fmla="*/ 775 w 869"/>
                <a:gd name="T67" fmla="*/ 766 h 766"/>
                <a:gd name="T68" fmla="*/ 721 w 869"/>
                <a:gd name="T69" fmla="*/ 766 h 766"/>
                <a:gd name="T70" fmla="*/ 707 w 869"/>
                <a:gd name="T71" fmla="*/ 752 h 766"/>
                <a:gd name="T72" fmla="*/ 698 w 869"/>
                <a:gd name="T73" fmla="*/ 744 h 766"/>
                <a:gd name="T74" fmla="*/ 678 w 869"/>
                <a:gd name="T75" fmla="*/ 723 h 766"/>
                <a:gd name="T76" fmla="*/ 611 w 869"/>
                <a:gd name="T77" fmla="*/ 647 h 766"/>
                <a:gd name="T78" fmla="*/ 540 w 869"/>
                <a:gd name="T79" fmla="*/ 560 h 766"/>
                <a:gd name="T80" fmla="*/ 151 w 869"/>
                <a:gd name="T81" fmla="*/ 110 h 766"/>
                <a:gd name="T82" fmla="*/ 151 w 869"/>
                <a:gd name="T83" fmla="*/ 518 h 766"/>
                <a:gd name="T84" fmla="*/ 154 w 869"/>
                <a:gd name="T85" fmla="*/ 641 h 766"/>
                <a:gd name="T86" fmla="*/ 161 w 869"/>
                <a:gd name="T87" fmla="*/ 695 h 766"/>
                <a:gd name="T88" fmla="*/ 173 w 869"/>
                <a:gd name="T89" fmla="*/ 705 h 766"/>
                <a:gd name="T90" fmla="*/ 249 w 869"/>
                <a:gd name="T91" fmla="*/ 714 h 766"/>
                <a:gd name="T92" fmla="*/ 249 w 869"/>
                <a:gd name="T93" fmla="*/ 747 h 766"/>
                <a:gd name="T94" fmla="*/ 143 w 869"/>
                <a:gd name="T95" fmla="*/ 744 h 766"/>
                <a:gd name="T96" fmla="*/ 5 w 869"/>
                <a:gd name="T97" fmla="*/ 747 h 76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869" h="766">
                  <a:moveTo>
                    <a:pt x="5" y="747"/>
                  </a:moveTo>
                  <a:cubicBezTo>
                    <a:pt x="5" y="714"/>
                    <a:pt x="5" y="714"/>
                    <a:pt x="5" y="714"/>
                  </a:cubicBezTo>
                  <a:cubicBezTo>
                    <a:pt x="43" y="714"/>
                    <a:pt x="68" y="711"/>
                    <a:pt x="80" y="705"/>
                  </a:cubicBezTo>
                  <a:cubicBezTo>
                    <a:pt x="86" y="703"/>
                    <a:pt x="89" y="700"/>
                    <a:pt x="91" y="695"/>
                  </a:cubicBezTo>
                  <a:cubicBezTo>
                    <a:pt x="95" y="688"/>
                    <a:pt x="98" y="670"/>
                    <a:pt x="99" y="640"/>
                  </a:cubicBezTo>
                  <a:cubicBezTo>
                    <a:pt x="101" y="594"/>
                    <a:pt x="102" y="554"/>
                    <a:pt x="102" y="520"/>
                  </a:cubicBezTo>
                  <a:cubicBezTo>
                    <a:pt x="102" y="92"/>
                    <a:pt x="102" y="92"/>
                    <a:pt x="102" y="92"/>
                  </a:cubicBezTo>
                  <a:cubicBezTo>
                    <a:pt x="102" y="80"/>
                    <a:pt x="102" y="73"/>
                    <a:pt x="100" y="69"/>
                  </a:cubicBezTo>
                  <a:cubicBezTo>
                    <a:pt x="97" y="63"/>
                    <a:pt x="91" y="56"/>
                    <a:pt x="80" y="47"/>
                  </a:cubicBezTo>
                  <a:cubicBezTo>
                    <a:pt x="74" y="41"/>
                    <a:pt x="66" y="38"/>
                    <a:pt x="57" y="36"/>
                  </a:cubicBezTo>
                  <a:cubicBezTo>
                    <a:pt x="49" y="34"/>
                    <a:pt x="30" y="33"/>
                    <a:pt x="0" y="33"/>
                  </a:cubicBezTo>
                  <a:cubicBezTo>
                    <a:pt x="0" y="0"/>
                    <a:pt x="0" y="0"/>
                    <a:pt x="0" y="0"/>
                  </a:cubicBezTo>
                  <a:cubicBezTo>
                    <a:pt x="63" y="2"/>
                    <a:pt x="103" y="3"/>
                    <a:pt x="119" y="3"/>
                  </a:cubicBezTo>
                  <a:cubicBezTo>
                    <a:pt x="147" y="3"/>
                    <a:pt x="174" y="2"/>
                    <a:pt x="202" y="0"/>
                  </a:cubicBezTo>
                  <a:cubicBezTo>
                    <a:pt x="232" y="39"/>
                    <a:pt x="255" y="67"/>
                    <a:pt x="269" y="86"/>
                  </a:cubicBezTo>
                  <a:cubicBezTo>
                    <a:pt x="381" y="220"/>
                    <a:pt x="381" y="220"/>
                    <a:pt x="381" y="220"/>
                  </a:cubicBezTo>
                  <a:cubicBezTo>
                    <a:pt x="545" y="411"/>
                    <a:pt x="545" y="411"/>
                    <a:pt x="545" y="411"/>
                  </a:cubicBezTo>
                  <a:cubicBezTo>
                    <a:pt x="597" y="472"/>
                    <a:pt x="639" y="520"/>
                    <a:pt x="671" y="554"/>
                  </a:cubicBezTo>
                  <a:cubicBezTo>
                    <a:pt x="691" y="578"/>
                    <a:pt x="708" y="596"/>
                    <a:pt x="721" y="609"/>
                  </a:cubicBezTo>
                  <a:cubicBezTo>
                    <a:pt x="721" y="226"/>
                    <a:pt x="721" y="226"/>
                    <a:pt x="721" y="226"/>
                  </a:cubicBezTo>
                  <a:cubicBezTo>
                    <a:pt x="721" y="191"/>
                    <a:pt x="720" y="151"/>
                    <a:pt x="718" y="105"/>
                  </a:cubicBezTo>
                  <a:cubicBezTo>
                    <a:pt x="717" y="76"/>
                    <a:pt x="714" y="58"/>
                    <a:pt x="711" y="51"/>
                  </a:cubicBezTo>
                  <a:cubicBezTo>
                    <a:pt x="708" y="46"/>
                    <a:pt x="705" y="43"/>
                    <a:pt x="699" y="41"/>
                  </a:cubicBezTo>
                  <a:cubicBezTo>
                    <a:pt x="687" y="36"/>
                    <a:pt x="662" y="33"/>
                    <a:pt x="624" y="33"/>
                  </a:cubicBezTo>
                  <a:cubicBezTo>
                    <a:pt x="624" y="0"/>
                    <a:pt x="624" y="0"/>
                    <a:pt x="624" y="0"/>
                  </a:cubicBezTo>
                  <a:cubicBezTo>
                    <a:pt x="667" y="2"/>
                    <a:pt x="711" y="3"/>
                    <a:pt x="756" y="3"/>
                  </a:cubicBezTo>
                  <a:cubicBezTo>
                    <a:pt x="797" y="3"/>
                    <a:pt x="835" y="2"/>
                    <a:pt x="869" y="0"/>
                  </a:cubicBezTo>
                  <a:cubicBezTo>
                    <a:pt x="869" y="33"/>
                    <a:pt x="869" y="33"/>
                    <a:pt x="869" y="33"/>
                  </a:cubicBezTo>
                  <a:cubicBezTo>
                    <a:pt x="831" y="33"/>
                    <a:pt x="806" y="36"/>
                    <a:pt x="794" y="41"/>
                  </a:cubicBezTo>
                  <a:cubicBezTo>
                    <a:pt x="789" y="43"/>
                    <a:pt x="785" y="47"/>
                    <a:pt x="783" y="52"/>
                  </a:cubicBezTo>
                  <a:cubicBezTo>
                    <a:pt x="779" y="58"/>
                    <a:pt x="776" y="77"/>
                    <a:pt x="775" y="107"/>
                  </a:cubicBezTo>
                  <a:cubicBezTo>
                    <a:pt x="773" y="153"/>
                    <a:pt x="772" y="193"/>
                    <a:pt x="772" y="226"/>
                  </a:cubicBezTo>
                  <a:cubicBezTo>
                    <a:pt x="772" y="479"/>
                    <a:pt x="772" y="479"/>
                    <a:pt x="772" y="479"/>
                  </a:cubicBezTo>
                  <a:cubicBezTo>
                    <a:pt x="772" y="531"/>
                    <a:pt x="773" y="626"/>
                    <a:pt x="775" y="766"/>
                  </a:cubicBezTo>
                  <a:cubicBezTo>
                    <a:pt x="721" y="766"/>
                    <a:pt x="721" y="766"/>
                    <a:pt x="721" y="766"/>
                  </a:cubicBezTo>
                  <a:cubicBezTo>
                    <a:pt x="707" y="752"/>
                    <a:pt x="707" y="752"/>
                    <a:pt x="707" y="752"/>
                  </a:cubicBezTo>
                  <a:cubicBezTo>
                    <a:pt x="705" y="751"/>
                    <a:pt x="700" y="746"/>
                    <a:pt x="698" y="744"/>
                  </a:cubicBezTo>
                  <a:cubicBezTo>
                    <a:pt x="696" y="742"/>
                    <a:pt x="689" y="735"/>
                    <a:pt x="678" y="723"/>
                  </a:cubicBezTo>
                  <a:cubicBezTo>
                    <a:pt x="647" y="689"/>
                    <a:pt x="625" y="664"/>
                    <a:pt x="611" y="647"/>
                  </a:cubicBezTo>
                  <a:cubicBezTo>
                    <a:pt x="540" y="560"/>
                    <a:pt x="540" y="560"/>
                    <a:pt x="540" y="560"/>
                  </a:cubicBezTo>
                  <a:cubicBezTo>
                    <a:pt x="151" y="110"/>
                    <a:pt x="151" y="110"/>
                    <a:pt x="151" y="110"/>
                  </a:cubicBezTo>
                  <a:cubicBezTo>
                    <a:pt x="151" y="518"/>
                    <a:pt x="151" y="518"/>
                    <a:pt x="151" y="518"/>
                  </a:cubicBezTo>
                  <a:cubicBezTo>
                    <a:pt x="151" y="552"/>
                    <a:pt x="152" y="593"/>
                    <a:pt x="154" y="641"/>
                  </a:cubicBezTo>
                  <a:cubicBezTo>
                    <a:pt x="156" y="670"/>
                    <a:pt x="158" y="688"/>
                    <a:pt x="161" y="695"/>
                  </a:cubicBezTo>
                  <a:cubicBezTo>
                    <a:pt x="164" y="700"/>
                    <a:pt x="168" y="704"/>
                    <a:pt x="173" y="705"/>
                  </a:cubicBezTo>
                  <a:cubicBezTo>
                    <a:pt x="185" y="711"/>
                    <a:pt x="210" y="714"/>
                    <a:pt x="249" y="714"/>
                  </a:cubicBezTo>
                  <a:cubicBezTo>
                    <a:pt x="249" y="747"/>
                    <a:pt x="249" y="747"/>
                    <a:pt x="249" y="747"/>
                  </a:cubicBezTo>
                  <a:cubicBezTo>
                    <a:pt x="217" y="745"/>
                    <a:pt x="181" y="744"/>
                    <a:pt x="143" y="744"/>
                  </a:cubicBezTo>
                  <a:cubicBezTo>
                    <a:pt x="100" y="744"/>
                    <a:pt x="54" y="745"/>
                    <a:pt x="5"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4" name="Freeform 9"/>
            <p:cNvSpPr>
              <a:spLocks/>
            </p:cNvSpPr>
            <p:nvPr userDrawn="1"/>
          </p:nvSpPr>
          <p:spPr bwMode="auto">
            <a:xfrm>
              <a:off x="1573213" y="1003301"/>
              <a:ext cx="101600" cy="236538"/>
            </a:xfrm>
            <a:custGeom>
              <a:avLst/>
              <a:gdLst>
                <a:gd name="T0" fmla="*/ 322 w 322"/>
                <a:gd name="T1" fmla="*/ 714 h 747"/>
                <a:gd name="T2" fmla="*/ 322 w 322"/>
                <a:gd name="T3" fmla="*/ 747 h 747"/>
                <a:gd name="T4" fmla="*/ 169 w 322"/>
                <a:gd name="T5" fmla="*/ 744 h 747"/>
                <a:gd name="T6" fmla="*/ 0 w 322"/>
                <a:gd name="T7" fmla="*/ 747 h 747"/>
                <a:gd name="T8" fmla="*/ 0 w 322"/>
                <a:gd name="T9" fmla="*/ 714 h 747"/>
                <a:gd name="T10" fmla="*/ 79 w 322"/>
                <a:gd name="T11" fmla="*/ 708 h 747"/>
                <a:gd name="T12" fmla="*/ 98 w 322"/>
                <a:gd name="T13" fmla="*/ 696 h 747"/>
                <a:gd name="T14" fmla="*/ 106 w 322"/>
                <a:gd name="T15" fmla="*/ 645 h 747"/>
                <a:gd name="T16" fmla="*/ 109 w 322"/>
                <a:gd name="T17" fmla="*/ 495 h 747"/>
                <a:gd name="T18" fmla="*/ 109 w 322"/>
                <a:gd name="T19" fmla="*/ 251 h 747"/>
                <a:gd name="T20" fmla="*/ 106 w 322"/>
                <a:gd name="T21" fmla="*/ 111 h 747"/>
                <a:gd name="T22" fmla="*/ 98 w 322"/>
                <a:gd name="T23" fmla="*/ 52 h 747"/>
                <a:gd name="T24" fmla="*/ 78 w 322"/>
                <a:gd name="T25" fmla="*/ 39 h 747"/>
                <a:gd name="T26" fmla="*/ 0 w 322"/>
                <a:gd name="T27" fmla="*/ 33 h 747"/>
                <a:gd name="T28" fmla="*/ 0 w 322"/>
                <a:gd name="T29" fmla="*/ 0 h 747"/>
                <a:gd name="T30" fmla="*/ 161 w 322"/>
                <a:gd name="T31" fmla="*/ 3 h 747"/>
                <a:gd name="T32" fmla="*/ 322 w 322"/>
                <a:gd name="T33" fmla="*/ 0 h 747"/>
                <a:gd name="T34" fmla="*/ 322 w 322"/>
                <a:gd name="T35" fmla="*/ 33 h 747"/>
                <a:gd name="T36" fmla="*/ 244 w 322"/>
                <a:gd name="T37" fmla="*/ 39 h 747"/>
                <a:gd name="T38" fmla="*/ 224 w 322"/>
                <a:gd name="T39" fmla="*/ 51 h 747"/>
                <a:gd name="T40" fmla="*/ 216 w 322"/>
                <a:gd name="T41" fmla="*/ 102 h 747"/>
                <a:gd name="T42" fmla="*/ 213 w 322"/>
                <a:gd name="T43" fmla="*/ 251 h 747"/>
                <a:gd name="T44" fmla="*/ 213 w 322"/>
                <a:gd name="T45" fmla="*/ 495 h 747"/>
                <a:gd name="T46" fmla="*/ 215 w 322"/>
                <a:gd name="T47" fmla="*/ 635 h 747"/>
                <a:gd name="T48" fmla="*/ 223 w 322"/>
                <a:gd name="T49" fmla="*/ 694 h 747"/>
                <a:gd name="T50" fmla="*/ 243 w 322"/>
                <a:gd name="T51" fmla="*/ 708 h 747"/>
                <a:gd name="T52" fmla="*/ 322 w 322"/>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2" h="747">
                  <a:moveTo>
                    <a:pt x="322" y="714"/>
                  </a:moveTo>
                  <a:cubicBezTo>
                    <a:pt x="322" y="747"/>
                    <a:pt x="322" y="747"/>
                    <a:pt x="322" y="747"/>
                  </a:cubicBezTo>
                  <a:cubicBezTo>
                    <a:pt x="244" y="745"/>
                    <a:pt x="193" y="744"/>
                    <a:pt x="169" y="744"/>
                  </a:cubicBezTo>
                  <a:cubicBezTo>
                    <a:pt x="0" y="747"/>
                    <a:pt x="0" y="747"/>
                    <a:pt x="0" y="747"/>
                  </a:cubicBezTo>
                  <a:cubicBezTo>
                    <a:pt x="0" y="714"/>
                    <a:pt x="0" y="714"/>
                    <a:pt x="0" y="714"/>
                  </a:cubicBezTo>
                  <a:cubicBezTo>
                    <a:pt x="43" y="713"/>
                    <a:pt x="69" y="711"/>
                    <a:pt x="79" y="708"/>
                  </a:cubicBezTo>
                  <a:cubicBezTo>
                    <a:pt x="88" y="705"/>
                    <a:pt x="94" y="701"/>
                    <a:pt x="98" y="696"/>
                  </a:cubicBezTo>
                  <a:cubicBezTo>
                    <a:pt x="102" y="689"/>
                    <a:pt x="105" y="672"/>
                    <a:pt x="106" y="645"/>
                  </a:cubicBezTo>
                  <a:cubicBezTo>
                    <a:pt x="107" y="637"/>
                    <a:pt x="108" y="587"/>
                    <a:pt x="109" y="495"/>
                  </a:cubicBezTo>
                  <a:cubicBezTo>
                    <a:pt x="109" y="251"/>
                    <a:pt x="109" y="251"/>
                    <a:pt x="109" y="251"/>
                  </a:cubicBezTo>
                  <a:cubicBezTo>
                    <a:pt x="109" y="204"/>
                    <a:pt x="108" y="157"/>
                    <a:pt x="106" y="111"/>
                  </a:cubicBezTo>
                  <a:cubicBezTo>
                    <a:pt x="105" y="78"/>
                    <a:pt x="102" y="59"/>
                    <a:pt x="98" y="52"/>
                  </a:cubicBezTo>
                  <a:cubicBezTo>
                    <a:pt x="94" y="46"/>
                    <a:pt x="88" y="41"/>
                    <a:pt x="78" y="39"/>
                  </a:cubicBezTo>
                  <a:cubicBezTo>
                    <a:pt x="69" y="36"/>
                    <a:pt x="43" y="34"/>
                    <a:pt x="0" y="33"/>
                  </a:cubicBezTo>
                  <a:cubicBezTo>
                    <a:pt x="0" y="0"/>
                    <a:pt x="0" y="0"/>
                    <a:pt x="0" y="0"/>
                  </a:cubicBezTo>
                  <a:cubicBezTo>
                    <a:pt x="70" y="2"/>
                    <a:pt x="124" y="3"/>
                    <a:pt x="161" y="3"/>
                  </a:cubicBezTo>
                  <a:cubicBezTo>
                    <a:pt x="198" y="3"/>
                    <a:pt x="251" y="2"/>
                    <a:pt x="322" y="0"/>
                  </a:cubicBezTo>
                  <a:cubicBezTo>
                    <a:pt x="322" y="33"/>
                    <a:pt x="322" y="33"/>
                    <a:pt x="322" y="33"/>
                  </a:cubicBezTo>
                  <a:cubicBezTo>
                    <a:pt x="279" y="34"/>
                    <a:pt x="253" y="36"/>
                    <a:pt x="244" y="39"/>
                  </a:cubicBezTo>
                  <a:cubicBezTo>
                    <a:pt x="234" y="41"/>
                    <a:pt x="228" y="46"/>
                    <a:pt x="224" y="51"/>
                  </a:cubicBezTo>
                  <a:cubicBezTo>
                    <a:pt x="220" y="58"/>
                    <a:pt x="217" y="75"/>
                    <a:pt x="216" y="102"/>
                  </a:cubicBezTo>
                  <a:cubicBezTo>
                    <a:pt x="216" y="109"/>
                    <a:pt x="215" y="159"/>
                    <a:pt x="213" y="251"/>
                  </a:cubicBezTo>
                  <a:cubicBezTo>
                    <a:pt x="213" y="495"/>
                    <a:pt x="213" y="495"/>
                    <a:pt x="213" y="495"/>
                  </a:cubicBezTo>
                  <a:cubicBezTo>
                    <a:pt x="213" y="543"/>
                    <a:pt x="214" y="589"/>
                    <a:pt x="215" y="635"/>
                  </a:cubicBezTo>
                  <a:cubicBezTo>
                    <a:pt x="216" y="668"/>
                    <a:pt x="219" y="688"/>
                    <a:pt x="223" y="694"/>
                  </a:cubicBezTo>
                  <a:cubicBezTo>
                    <a:pt x="227" y="700"/>
                    <a:pt x="234" y="705"/>
                    <a:pt x="243" y="708"/>
                  </a:cubicBezTo>
                  <a:cubicBezTo>
                    <a:pt x="252" y="711"/>
                    <a:pt x="278" y="713"/>
                    <a:pt x="322"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5" name="Freeform 10"/>
            <p:cNvSpPr>
              <a:spLocks/>
            </p:cNvSpPr>
            <p:nvPr userDrawn="1"/>
          </p:nvSpPr>
          <p:spPr bwMode="auto">
            <a:xfrm>
              <a:off x="1692275" y="998538"/>
              <a:ext cx="231775" cy="246063"/>
            </a:xfrm>
            <a:custGeom>
              <a:avLst/>
              <a:gdLst>
                <a:gd name="T0" fmla="*/ 728 w 728"/>
                <a:gd name="T1" fmla="*/ 667 h 774"/>
                <a:gd name="T2" fmla="*/ 707 w 728"/>
                <a:gd name="T3" fmla="*/ 716 h 774"/>
                <a:gd name="T4" fmla="*/ 581 w 728"/>
                <a:gd name="T5" fmla="*/ 761 h 774"/>
                <a:gd name="T6" fmla="*/ 447 w 728"/>
                <a:gd name="T7" fmla="*/ 774 h 774"/>
                <a:gd name="T8" fmla="*/ 288 w 728"/>
                <a:gd name="T9" fmla="*/ 754 h 774"/>
                <a:gd name="T10" fmla="*/ 161 w 728"/>
                <a:gd name="T11" fmla="*/ 696 h 774"/>
                <a:gd name="T12" fmla="*/ 71 w 728"/>
                <a:gd name="T13" fmla="*/ 610 h 774"/>
                <a:gd name="T14" fmla="*/ 18 w 728"/>
                <a:gd name="T15" fmla="*/ 508 h 774"/>
                <a:gd name="T16" fmla="*/ 0 w 728"/>
                <a:gd name="T17" fmla="*/ 386 h 774"/>
                <a:gd name="T18" fmla="*/ 123 w 728"/>
                <a:gd name="T19" fmla="*/ 110 h 774"/>
                <a:gd name="T20" fmla="*/ 457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5 w 728"/>
                <a:gd name="T35" fmla="*/ 143 h 774"/>
                <a:gd name="T36" fmla="*/ 605 w 728"/>
                <a:gd name="T37" fmla="*/ 66 h 774"/>
                <a:gd name="T38" fmla="*/ 446 w 728"/>
                <a:gd name="T39" fmla="*/ 41 h 774"/>
                <a:gd name="T40" fmla="*/ 313 w 728"/>
                <a:gd name="T41" fmla="*/ 60 h 774"/>
                <a:gd name="T42" fmla="*/ 217 w 728"/>
                <a:gd name="T43" fmla="*/ 117 h 774"/>
                <a:gd name="T44" fmla="*/ 149 w 728"/>
                <a:gd name="T45" fmla="*/ 216 h 774"/>
                <a:gd name="T46" fmla="*/ 122 w 728"/>
                <a:gd name="T47" fmla="*/ 366 h 774"/>
                <a:gd name="T48" fmla="*/ 223 w 728"/>
                <a:gd name="T49" fmla="*/ 621 h 774"/>
                <a:gd name="T50" fmla="*/ 492 w 728"/>
                <a:gd name="T51" fmla="*/ 717 h 774"/>
                <a:gd name="T52" fmla="*/ 632 w 728"/>
                <a:gd name="T53" fmla="*/ 698 h 774"/>
                <a:gd name="T54" fmla="*/ 719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7" y="716"/>
                    <a:pt x="707" y="716"/>
                    <a:pt x="707" y="716"/>
                  </a:cubicBezTo>
                  <a:cubicBezTo>
                    <a:pt x="664" y="736"/>
                    <a:pt x="622" y="751"/>
                    <a:pt x="581" y="761"/>
                  </a:cubicBezTo>
                  <a:cubicBezTo>
                    <a:pt x="540" y="770"/>
                    <a:pt x="495" y="774"/>
                    <a:pt x="447" y="774"/>
                  </a:cubicBezTo>
                  <a:cubicBezTo>
                    <a:pt x="390" y="774"/>
                    <a:pt x="337" y="768"/>
                    <a:pt x="288" y="754"/>
                  </a:cubicBezTo>
                  <a:cubicBezTo>
                    <a:pt x="240" y="740"/>
                    <a:pt x="197" y="721"/>
                    <a:pt x="161" y="696"/>
                  </a:cubicBezTo>
                  <a:cubicBezTo>
                    <a:pt x="124" y="670"/>
                    <a:pt x="94" y="642"/>
                    <a:pt x="71" y="610"/>
                  </a:cubicBezTo>
                  <a:cubicBezTo>
                    <a:pt x="48" y="579"/>
                    <a:pt x="31" y="545"/>
                    <a:pt x="18" y="508"/>
                  </a:cubicBezTo>
                  <a:cubicBezTo>
                    <a:pt x="6" y="471"/>
                    <a:pt x="0" y="430"/>
                    <a:pt x="0" y="386"/>
                  </a:cubicBezTo>
                  <a:cubicBezTo>
                    <a:pt x="0" y="275"/>
                    <a:pt x="41" y="183"/>
                    <a:pt x="123" y="110"/>
                  </a:cubicBezTo>
                  <a:cubicBezTo>
                    <a:pt x="204" y="37"/>
                    <a:pt x="316" y="0"/>
                    <a:pt x="457" y="0"/>
                  </a:cubicBezTo>
                  <a:cubicBezTo>
                    <a:pt x="490" y="0"/>
                    <a:pt x="521" y="2"/>
                    <a:pt x="549" y="6"/>
                  </a:cubicBezTo>
                  <a:cubicBezTo>
                    <a:pt x="578"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5" y="143"/>
                    <a:pt x="665" y="143"/>
                    <a:pt x="665" y="143"/>
                  </a:cubicBezTo>
                  <a:cubicBezTo>
                    <a:pt x="661" y="109"/>
                    <a:pt x="641" y="83"/>
                    <a:pt x="605" y="66"/>
                  </a:cubicBezTo>
                  <a:cubicBezTo>
                    <a:pt x="569" y="50"/>
                    <a:pt x="516" y="41"/>
                    <a:pt x="446" y="41"/>
                  </a:cubicBezTo>
                  <a:cubicBezTo>
                    <a:pt x="393" y="42"/>
                    <a:pt x="349" y="48"/>
                    <a:pt x="313" y="60"/>
                  </a:cubicBezTo>
                  <a:cubicBezTo>
                    <a:pt x="277" y="72"/>
                    <a:pt x="245" y="91"/>
                    <a:pt x="217" y="117"/>
                  </a:cubicBezTo>
                  <a:cubicBezTo>
                    <a:pt x="189" y="143"/>
                    <a:pt x="166" y="176"/>
                    <a:pt x="149" y="216"/>
                  </a:cubicBezTo>
                  <a:cubicBezTo>
                    <a:pt x="131" y="256"/>
                    <a:pt x="122" y="306"/>
                    <a:pt x="122" y="366"/>
                  </a:cubicBezTo>
                  <a:cubicBezTo>
                    <a:pt x="122" y="472"/>
                    <a:pt x="155" y="557"/>
                    <a:pt x="223" y="621"/>
                  </a:cubicBezTo>
                  <a:cubicBezTo>
                    <a:pt x="291" y="685"/>
                    <a:pt x="380" y="717"/>
                    <a:pt x="492" y="717"/>
                  </a:cubicBezTo>
                  <a:cubicBezTo>
                    <a:pt x="542" y="717"/>
                    <a:pt x="589" y="711"/>
                    <a:pt x="632" y="698"/>
                  </a:cubicBezTo>
                  <a:cubicBezTo>
                    <a:pt x="661" y="689"/>
                    <a:pt x="690" y="675"/>
                    <a:pt x="719"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6" name="Freeform 11"/>
            <p:cNvSpPr>
              <a:spLocks/>
            </p:cNvSpPr>
            <p:nvPr userDrawn="1"/>
          </p:nvSpPr>
          <p:spPr bwMode="auto">
            <a:xfrm>
              <a:off x="657225" y="998538"/>
              <a:ext cx="231775" cy="246063"/>
            </a:xfrm>
            <a:custGeom>
              <a:avLst/>
              <a:gdLst>
                <a:gd name="T0" fmla="*/ 728 w 728"/>
                <a:gd name="T1" fmla="*/ 667 h 774"/>
                <a:gd name="T2" fmla="*/ 706 w 728"/>
                <a:gd name="T3" fmla="*/ 716 h 774"/>
                <a:gd name="T4" fmla="*/ 580 w 728"/>
                <a:gd name="T5" fmla="*/ 761 h 774"/>
                <a:gd name="T6" fmla="*/ 446 w 728"/>
                <a:gd name="T7" fmla="*/ 774 h 774"/>
                <a:gd name="T8" fmla="*/ 288 w 728"/>
                <a:gd name="T9" fmla="*/ 754 h 774"/>
                <a:gd name="T10" fmla="*/ 160 w 728"/>
                <a:gd name="T11" fmla="*/ 696 h 774"/>
                <a:gd name="T12" fmla="*/ 71 w 728"/>
                <a:gd name="T13" fmla="*/ 610 h 774"/>
                <a:gd name="T14" fmla="*/ 18 w 728"/>
                <a:gd name="T15" fmla="*/ 508 h 774"/>
                <a:gd name="T16" fmla="*/ 0 w 728"/>
                <a:gd name="T17" fmla="*/ 386 h 774"/>
                <a:gd name="T18" fmla="*/ 122 w 728"/>
                <a:gd name="T19" fmla="*/ 110 h 774"/>
                <a:gd name="T20" fmla="*/ 456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4 w 728"/>
                <a:gd name="T35" fmla="*/ 143 h 774"/>
                <a:gd name="T36" fmla="*/ 604 w 728"/>
                <a:gd name="T37" fmla="*/ 66 h 774"/>
                <a:gd name="T38" fmla="*/ 445 w 728"/>
                <a:gd name="T39" fmla="*/ 41 h 774"/>
                <a:gd name="T40" fmla="*/ 313 w 728"/>
                <a:gd name="T41" fmla="*/ 60 h 774"/>
                <a:gd name="T42" fmla="*/ 216 w 728"/>
                <a:gd name="T43" fmla="*/ 117 h 774"/>
                <a:gd name="T44" fmla="*/ 148 w 728"/>
                <a:gd name="T45" fmla="*/ 216 h 774"/>
                <a:gd name="T46" fmla="*/ 121 w 728"/>
                <a:gd name="T47" fmla="*/ 366 h 774"/>
                <a:gd name="T48" fmla="*/ 223 w 728"/>
                <a:gd name="T49" fmla="*/ 621 h 774"/>
                <a:gd name="T50" fmla="*/ 492 w 728"/>
                <a:gd name="T51" fmla="*/ 717 h 774"/>
                <a:gd name="T52" fmla="*/ 631 w 728"/>
                <a:gd name="T53" fmla="*/ 698 h 774"/>
                <a:gd name="T54" fmla="*/ 718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6" y="716"/>
                    <a:pt x="706" y="716"/>
                    <a:pt x="706" y="716"/>
                  </a:cubicBezTo>
                  <a:cubicBezTo>
                    <a:pt x="663" y="736"/>
                    <a:pt x="621" y="751"/>
                    <a:pt x="580" y="761"/>
                  </a:cubicBezTo>
                  <a:cubicBezTo>
                    <a:pt x="539" y="770"/>
                    <a:pt x="495" y="774"/>
                    <a:pt x="446" y="774"/>
                  </a:cubicBezTo>
                  <a:cubicBezTo>
                    <a:pt x="389" y="774"/>
                    <a:pt x="337" y="768"/>
                    <a:pt x="288" y="754"/>
                  </a:cubicBezTo>
                  <a:cubicBezTo>
                    <a:pt x="239" y="740"/>
                    <a:pt x="197" y="721"/>
                    <a:pt x="160" y="696"/>
                  </a:cubicBezTo>
                  <a:cubicBezTo>
                    <a:pt x="124" y="670"/>
                    <a:pt x="94" y="642"/>
                    <a:pt x="71" y="610"/>
                  </a:cubicBezTo>
                  <a:cubicBezTo>
                    <a:pt x="48" y="579"/>
                    <a:pt x="30" y="545"/>
                    <a:pt x="18" y="508"/>
                  </a:cubicBezTo>
                  <a:cubicBezTo>
                    <a:pt x="6" y="471"/>
                    <a:pt x="0" y="430"/>
                    <a:pt x="0" y="386"/>
                  </a:cubicBezTo>
                  <a:cubicBezTo>
                    <a:pt x="0" y="275"/>
                    <a:pt x="41" y="183"/>
                    <a:pt x="122" y="110"/>
                  </a:cubicBezTo>
                  <a:cubicBezTo>
                    <a:pt x="204" y="37"/>
                    <a:pt x="315" y="0"/>
                    <a:pt x="456" y="0"/>
                  </a:cubicBezTo>
                  <a:cubicBezTo>
                    <a:pt x="490" y="0"/>
                    <a:pt x="520" y="2"/>
                    <a:pt x="549" y="6"/>
                  </a:cubicBezTo>
                  <a:cubicBezTo>
                    <a:pt x="577"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4" y="143"/>
                    <a:pt x="664" y="143"/>
                    <a:pt x="664" y="143"/>
                  </a:cubicBezTo>
                  <a:cubicBezTo>
                    <a:pt x="661" y="109"/>
                    <a:pt x="641" y="83"/>
                    <a:pt x="604" y="66"/>
                  </a:cubicBezTo>
                  <a:cubicBezTo>
                    <a:pt x="568" y="50"/>
                    <a:pt x="515" y="41"/>
                    <a:pt x="445" y="41"/>
                  </a:cubicBezTo>
                  <a:cubicBezTo>
                    <a:pt x="393" y="42"/>
                    <a:pt x="349" y="48"/>
                    <a:pt x="313" y="60"/>
                  </a:cubicBezTo>
                  <a:cubicBezTo>
                    <a:pt x="276" y="72"/>
                    <a:pt x="244" y="91"/>
                    <a:pt x="216" y="117"/>
                  </a:cubicBezTo>
                  <a:cubicBezTo>
                    <a:pt x="189" y="143"/>
                    <a:pt x="166" y="176"/>
                    <a:pt x="148" y="216"/>
                  </a:cubicBezTo>
                  <a:cubicBezTo>
                    <a:pt x="131" y="256"/>
                    <a:pt x="122" y="306"/>
                    <a:pt x="121" y="366"/>
                  </a:cubicBezTo>
                  <a:cubicBezTo>
                    <a:pt x="121" y="472"/>
                    <a:pt x="155" y="557"/>
                    <a:pt x="223" y="621"/>
                  </a:cubicBezTo>
                  <a:cubicBezTo>
                    <a:pt x="290" y="685"/>
                    <a:pt x="380" y="717"/>
                    <a:pt x="492" y="717"/>
                  </a:cubicBezTo>
                  <a:cubicBezTo>
                    <a:pt x="542" y="717"/>
                    <a:pt x="588" y="711"/>
                    <a:pt x="631" y="698"/>
                  </a:cubicBezTo>
                  <a:cubicBezTo>
                    <a:pt x="660" y="689"/>
                    <a:pt x="689" y="675"/>
                    <a:pt x="718"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7" name="Freeform 12"/>
            <p:cNvSpPr>
              <a:spLocks/>
            </p:cNvSpPr>
            <p:nvPr userDrawn="1"/>
          </p:nvSpPr>
          <p:spPr bwMode="auto">
            <a:xfrm>
              <a:off x="757238" y="687388"/>
              <a:ext cx="323850" cy="239713"/>
            </a:xfrm>
            <a:custGeom>
              <a:avLst/>
              <a:gdLst>
                <a:gd name="T0" fmla="*/ 0 w 1017"/>
                <a:gd name="T1" fmla="*/ 35 h 754"/>
                <a:gd name="T2" fmla="*/ 0 w 1017"/>
                <a:gd name="T3" fmla="*/ 0 h 754"/>
                <a:gd name="T4" fmla="*/ 110 w 1017"/>
                <a:gd name="T5" fmla="*/ 4 h 754"/>
                <a:gd name="T6" fmla="*/ 212 w 1017"/>
                <a:gd name="T7" fmla="*/ 0 h 754"/>
                <a:gd name="T8" fmla="*/ 300 w 1017"/>
                <a:gd name="T9" fmla="*/ 183 h 754"/>
                <a:gd name="T10" fmla="*/ 509 w 1017"/>
                <a:gd name="T11" fmla="*/ 592 h 754"/>
                <a:gd name="T12" fmla="*/ 697 w 1017"/>
                <a:gd name="T13" fmla="*/ 218 h 754"/>
                <a:gd name="T14" fmla="*/ 800 w 1017"/>
                <a:gd name="T15" fmla="*/ 0 h 754"/>
                <a:gd name="T16" fmla="*/ 898 w 1017"/>
                <a:gd name="T17" fmla="*/ 4 h 754"/>
                <a:gd name="T18" fmla="*/ 1017 w 1017"/>
                <a:gd name="T19" fmla="*/ 0 h 754"/>
                <a:gd name="T20" fmla="*/ 1017 w 1017"/>
                <a:gd name="T21" fmla="*/ 35 h 754"/>
                <a:gd name="T22" fmla="*/ 938 w 1017"/>
                <a:gd name="T23" fmla="*/ 40 h 754"/>
                <a:gd name="T24" fmla="*/ 918 w 1017"/>
                <a:gd name="T25" fmla="*/ 53 h 754"/>
                <a:gd name="T26" fmla="*/ 910 w 1017"/>
                <a:gd name="T27" fmla="*/ 103 h 754"/>
                <a:gd name="T28" fmla="*/ 907 w 1017"/>
                <a:gd name="T29" fmla="*/ 251 h 754"/>
                <a:gd name="T30" fmla="*/ 907 w 1017"/>
                <a:gd name="T31" fmla="*/ 492 h 754"/>
                <a:gd name="T32" fmla="*/ 910 w 1017"/>
                <a:gd name="T33" fmla="*/ 631 h 754"/>
                <a:gd name="T34" fmla="*/ 918 w 1017"/>
                <a:gd name="T35" fmla="*/ 690 h 754"/>
                <a:gd name="T36" fmla="*/ 938 w 1017"/>
                <a:gd name="T37" fmla="*/ 704 h 754"/>
                <a:gd name="T38" fmla="*/ 1017 w 1017"/>
                <a:gd name="T39" fmla="*/ 709 h 754"/>
                <a:gd name="T40" fmla="*/ 1017 w 1017"/>
                <a:gd name="T41" fmla="*/ 743 h 754"/>
                <a:gd name="T42" fmla="*/ 861 w 1017"/>
                <a:gd name="T43" fmla="*/ 739 h 754"/>
                <a:gd name="T44" fmla="*/ 699 w 1017"/>
                <a:gd name="T45" fmla="*/ 743 h 754"/>
                <a:gd name="T46" fmla="*/ 699 w 1017"/>
                <a:gd name="T47" fmla="*/ 709 h 754"/>
                <a:gd name="T48" fmla="*/ 778 w 1017"/>
                <a:gd name="T49" fmla="*/ 704 h 754"/>
                <a:gd name="T50" fmla="*/ 797 w 1017"/>
                <a:gd name="T51" fmla="*/ 691 h 754"/>
                <a:gd name="T52" fmla="*/ 806 w 1017"/>
                <a:gd name="T53" fmla="*/ 641 h 754"/>
                <a:gd name="T54" fmla="*/ 808 w 1017"/>
                <a:gd name="T55" fmla="*/ 492 h 754"/>
                <a:gd name="T56" fmla="*/ 808 w 1017"/>
                <a:gd name="T57" fmla="*/ 108 h 754"/>
                <a:gd name="T58" fmla="*/ 619 w 1017"/>
                <a:gd name="T59" fmla="*/ 486 h 754"/>
                <a:gd name="T60" fmla="*/ 549 w 1017"/>
                <a:gd name="T61" fmla="*/ 629 h 754"/>
                <a:gd name="T62" fmla="*/ 494 w 1017"/>
                <a:gd name="T63" fmla="*/ 754 h 754"/>
                <a:gd name="T64" fmla="*/ 472 w 1017"/>
                <a:gd name="T65" fmla="*/ 754 h 754"/>
                <a:gd name="T66" fmla="*/ 459 w 1017"/>
                <a:gd name="T67" fmla="*/ 722 h 754"/>
                <a:gd name="T68" fmla="*/ 422 w 1017"/>
                <a:gd name="T69" fmla="*/ 645 h 754"/>
                <a:gd name="T70" fmla="*/ 159 w 1017"/>
                <a:gd name="T71" fmla="*/ 126 h 754"/>
                <a:gd name="T72" fmla="*/ 159 w 1017"/>
                <a:gd name="T73" fmla="*/ 492 h 754"/>
                <a:gd name="T74" fmla="*/ 163 w 1017"/>
                <a:gd name="T75" fmla="*/ 631 h 754"/>
                <a:gd name="T76" fmla="*/ 171 w 1017"/>
                <a:gd name="T77" fmla="*/ 690 h 754"/>
                <a:gd name="T78" fmla="*/ 191 w 1017"/>
                <a:gd name="T79" fmla="*/ 704 h 754"/>
                <a:gd name="T80" fmla="*/ 271 w 1017"/>
                <a:gd name="T81" fmla="*/ 709 h 754"/>
                <a:gd name="T82" fmla="*/ 271 w 1017"/>
                <a:gd name="T83" fmla="*/ 743 h 754"/>
                <a:gd name="T84" fmla="*/ 138 w 1017"/>
                <a:gd name="T85" fmla="*/ 739 h 754"/>
                <a:gd name="T86" fmla="*/ 0 w 1017"/>
                <a:gd name="T87" fmla="*/ 743 h 754"/>
                <a:gd name="T88" fmla="*/ 0 w 1017"/>
                <a:gd name="T89" fmla="*/ 709 h 754"/>
                <a:gd name="T90" fmla="*/ 79 w 1017"/>
                <a:gd name="T91" fmla="*/ 704 h 754"/>
                <a:gd name="T92" fmla="*/ 98 w 1017"/>
                <a:gd name="T93" fmla="*/ 691 h 754"/>
                <a:gd name="T94" fmla="*/ 107 w 1017"/>
                <a:gd name="T95" fmla="*/ 641 h 754"/>
                <a:gd name="T96" fmla="*/ 109 w 1017"/>
                <a:gd name="T97" fmla="*/ 492 h 754"/>
                <a:gd name="T98" fmla="*/ 109 w 1017"/>
                <a:gd name="T99" fmla="*/ 251 h 754"/>
                <a:gd name="T100" fmla="*/ 107 w 1017"/>
                <a:gd name="T101" fmla="*/ 112 h 754"/>
                <a:gd name="T102" fmla="*/ 99 w 1017"/>
                <a:gd name="T103" fmla="*/ 54 h 754"/>
                <a:gd name="T104" fmla="*/ 78 w 1017"/>
                <a:gd name="T105" fmla="*/ 40 h 754"/>
                <a:gd name="T106" fmla="*/ 0 w 1017"/>
                <a:gd name="T107" fmla="*/ 35 h 75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Lst>
              <a:rect l="0" t="0" r="r" b="b"/>
              <a:pathLst>
                <a:path w="1017" h="754">
                  <a:moveTo>
                    <a:pt x="0" y="35"/>
                  </a:moveTo>
                  <a:cubicBezTo>
                    <a:pt x="0" y="0"/>
                    <a:pt x="0" y="0"/>
                    <a:pt x="0" y="0"/>
                  </a:cubicBezTo>
                  <a:cubicBezTo>
                    <a:pt x="38" y="2"/>
                    <a:pt x="75" y="4"/>
                    <a:pt x="110" y="4"/>
                  </a:cubicBezTo>
                  <a:cubicBezTo>
                    <a:pt x="145" y="4"/>
                    <a:pt x="179" y="2"/>
                    <a:pt x="212" y="0"/>
                  </a:cubicBezTo>
                  <a:cubicBezTo>
                    <a:pt x="244" y="70"/>
                    <a:pt x="274" y="131"/>
                    <a:pt x="300" y="183"/>
                  </a:cubicBezTo>
                  <a:cubicBezTo>
                    <a:pt x="509" y="592"/>
                    <a:pt x="509" y="592"/>
                    <a:pt x="509" y="592"/>
                  </a:cubicBezTo>
                  <a:cubicBezTo>
                    <a:pt x="697" y="218"/>
                    <a:pt x="697" y="218"/>
                    <a:pt x="697" y="218"/>
                  </a:cubicBezTo>
                  <a:cubicBezTo>
                    <a:pt x="749" y="116"/>
                    <a:pt x="783" y="43"/>
                    <a:pt x="800" y="0"/>
                  </a:cubicBezTo>
                  <a:cubicBezTo>
                    <a:pt x="839" y="2"/>
                    <a:pt x="872" y="4"/>
                    <a:pt x="898" y="4"/>
                  </a:cubicBezTo>
                  <a:cubicBezTo>
                    <a:pt x="923" y="4"/>
                    <a:pt x="962" y="2"/>
                    <a:pt x="1017" y="0"/>
                  </a:cubicBezTo>
                  <a:cubicBezTo>
                    <a:pt x="1017" y="35"/>
                    <a:pt x="1017" y="35"/>
                    <a:pt x="1017" y="35"/>
                  </a:cubicBezTo>
                  <a:cubicBezTo>
                    <a:pt x="974" y="35"/>
                    <a:pt x="947" y="37"/>
                    <a:pt x="938" y="40"/>
                  </a:cubicBezTo>
                  <a:cubicBezTo>
                    <a:pt x="928" y="43"/>
                    <a:pt x="922" y="47"/>
                    <a:pt x="918" y="53"/>
                  </a:cubicBezTo>
                  <a:cubicBezTo>
                    <a:pt x="914" y="60"/>
                    <a:pt x="911" y="76"/>
                    <a:pt x="910" y="103"/>
                  </a:cubicBezTo>
                  <a:cubicBezTo>
                    <a:pt x="910" y="110"/>
                    <a:pt x="909" y="159"/>
                    <a:pt x="907" y="251"/>
                  </a:cubicBezTo>
                  <a:cubicBezTo>
                    <a:pt x="907" y="492"/>
                    <a:pt x="907" y="492"/>
                    <a:pt x="907" y="492"/>
                  </a:cubicBezTo>
                  <a:cubicBezTo>
                    <a:pt x="907" y="540"/>
                    <a:pt x="908" y="586"/>
                    <a:pt x="910" y="631"/>
                  </a:cubicBezTo>
                  <a:cubicBezTo>
                    <a:pt x="911" y="664"/>
                    <a:pt x="914" y="684"/>
                    <a:pt x="918" y="690"/>
                  </a:cubicBezTo>
                  <a:cubicBezTo>
                    <a:pt x="922" y="696"/>
                    <a:pt x="929" y="701"/>
                    <a:pt x="938" y="704"/>
                  </a:cubicBezTo>
                  <a:cubicBezTo>
                    <a:pt x="948" y="707"/>
                    <a:pt x="974" y="709"/>
                    <a:pt x="1017" y="709"/>
                  </a:cubicBezTo>
                  <a:cubicBezTo>
                    <a:pt x="1017" y="743"/>
                    <a:pt x="1017" y="743"/>
                    <a:pt x="1017" y="743"/>
                  </a:cubicBezTo>
                  <a:cubicBezTo>
                    <a:pt x="943" y="740"/>
                    <a:pt x="891" y="739"/>
                    <a:pt x="861" y="739"/>
                  </a:cubicBezTo>
                  <a:cubicBezTo>
                    <a:pt x="837" y="739"/>
                    <a:pt x="782" y="740"/>
                    <a:pt x="699" y="743"/>
                  </a:cubicBezTo>
                  <a:cubicBezTo>
                    <a:pt x="699" y="709"/>
                    <a:pt x="699" y="709"/>
                    <a:pt x="699" y="709"/>
                  </a:cubicBezTo>
                  <a:cubicBezTo>
                    <a:pt x="742" y="709"/>
                    <a:pt x="768" y="707"/>
                    <a:pt x="778" y="704"/>
                  </a:cubicBezTo>
                  <a:cubicBezTo>
                    <a:pt x="788" y="701"/>
                    <a:pt x="794" y="697"/>
                    <a:pt x="797" y="691"/>
                  </a:cubicBezTo>
                  <a:cubicBezTo>
                    <a:pt x="802" y="684"/>
                    <a:pt x="805" y="668"/>
                    <a:pt x="806" y="641"/>
                  </a:cubicBezTo>
                  <a:cubicBezTo>
                    <a:pt x="806" y="633"/>
                    <a:pt x="807" y="584"/>
                    <a:pt x="808" y="492"/>
                  </a:cubicBezTo>
                  <a:cubicBezTo>
                    <a:pt x="808" y="108"/>
                    <a:pt x="808" y="108"/>
                    <a:pt x="808" y="108"/>
                  </a:cubicBezTo>
                  <a:cubicBezTo>
                    <a:pt x="619" y="486"/>
                    <a:pt x="619" y="486"/>
                    <a:pt x="619" y="486"/>
                  </a:cubicBezTo>
                  <a:cubicBezTo>
                    <a:pt x="589" y="545"/>
                    <a:pt x="566" y="593"/>
                    <a:pt x="549" y="629"/>
                  </a:cubicBezTo>
                  <a:cubicBezTo>
                    <a:pt x="537" y="655"/>
                    <a:pt x="518" y="696"/>
                    <a:pt x="494" y="754"/>
                  </a:cubicBezTo>
                  <a:cubicBezTo>
                    <a:pt x="472" y="754"/>
                    <a:pt x="472" y="754"/>
                    <a:pt x="472" y="754"/>
                  </a:cubicBezTo>
                  <a:cubicBezTo>
                    <a:pt x="468" y="740"/>
                    <a:pt x="463" y="729"/>
                    <a:pt x="459" y="722"/>
                  </a:cubicBezTo>
                  <a:cubicBezTo>
                    <a:pt x="422" y="645"/>
                    <a:pt x="422" y="645"/>
                    <a:pt x="422" y="645"/>
                  </a:cubicBezTo>
                  <a:cubicBezTo>
                    <a:pt x="159" y="126"/>
                    <a:pt x="159" y="126"/>
                    <a:pt x="159" y="126"/>
                  </a:cubicBezTo>
                  <a:cubicBezTo>
                    <a:pt x="159" y="492"/>
                    <a:pt x="159" y="492"/>
                    <a:pt x="159" y="492"/>
                  </a:cubicBezTo>
                  <a:cubicBezTo>
                    <a:pt x="159" y="540"/>
                    <a:pt x="160" y="586"/>
                    <a:pt x="163" y="631"/>
                  </a:cubicBezTo>
                  <a:cubicBezTo>
                    <a:pt x="164" y="664"/>
                    <a:pt x="167" y="683"/>
                    <a:pt x="171" y="690"/>
                  </a:cubicBezTo>
                  <a:cubicBezTo>
                    <a:pt x="175" y="696"/>
                    <a:pt x="182" y="701"/>
                    <a:pt x="191" y="704"/>
                  </a:cubicBezTo>
                  <a:cubicBezTo>
                    <a:pt x="200" y="707"/>
                    <a:pt x="227" y="709"/>
                    <a:pt x="271" y="709"/>
                  </a:cubicBezTo>
                  <a:cubicBezTo>
                    <a:pt x="271" y="743"/>
                    <a:pt x="271" y="743"/>
                    <a:pt x="271" y="743"/>
                  </a:cubicBezTo>
                  <a:cubicBezTo>
                    <a:pt x="138" y="739"/>
                    <a:pt x="138" y="739"/>
                    <a:pt x="138" y="739"/>
                  </a:cubicBezTo>
                  <a:cubicBezTo>
                    <a:pt x="0" y="743"/>
                    <a:pt x="0" y="743"/>
                    <a:pt x="0" y="743"/>
                  </a:cubicBezTo>
                  <a:cubicBezTo>
                    <a:pt x="0" y="709"/>
                    <a:pt x="0" y="709"/>
                    <a:pt x="0" y="709"/>
                  </a:cubicBezTo>
                  <a:cubicBezTo>
                    <a:pt x="43" y="709"/>
                    <a:pt x="69" y="707"/>
                    <a:pt x="79" y="704"/>
                  </a:cubicBezTo>
                  <a:cubicBezTo>
                    <a:pt x="88" y="701"/>
                    <a:pt x="95" y="697"/>
                    <a:pt x="98" y="691"/>
                  </a:cubicBezTo>
                  <a:cubicBezTo>
                    <a:pt x="103" y="684"/>
                    <a:pt x="105" y="668"/>
                    <a:pt x="107" y="641"/>
                  </a:cubicBezTo>
                  <a:cubicBezTo>
                    <a:pt x="107" y="634"/>
                    <a:pt x="108" y="584"/>
                    <a:pt x="109" y="492"/>
                  </a:cubicBezTo>
                  <a:cubicBezTo>
                    <a:pt x="109" y="251"/>
                    <a:pt x="109" y="251"/>
                    <a:pt x="109" y="251"/>
                  </a:cubicBezTo>
                  <a:cubicBezTo>
                    <a:pt x="109" y="204"/>
                    <a:pt x="108" y="158"/>
                    <a:pt x="107" y="112"/>
                  </a:cubicBezTo>
                  <a:cubicBezTo>
                    <a:pt x="105" y="79"/>
                    <a:pt x="103" y="60"/>
                    <a:pt x="99" y="54"/>
                  </a:cubicBezTo>
                  <a:cubicBezTo>
                    <a:pt x="94" y="48"/>
                    <a:pt x="88" y="43"/>
                    <a:pt x="78" y="40"/>
                  </a:cubicBezTo>
                  <a:cubicBezTo>
                    <a:pt x="69" y="37"/>
                    <a:pt x="43" y="35"/>
                    <a:pt x="0" y="35"/>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8" name="Freeform 13"/>
            <p:cNvSpPr>
              <a:spLocks noEditPoints="1"/>
            </p:cNvSpPr>
            <p:nvPr userDrawn="1"/>
          </p:nvSpPr>
          <p:spPr bwMode="auto">
            <a:xfrm>
              <a:off x="1092200" y="684213"/>
              <a:ext cx="263525" cy="238125"/>
            </a:xfrm>
            <a:custGeom>
              <a:avLst/>
              <a:gdLst>
                <a:gd name="T0" fmla="*/ 117 w 832"/>
                <a:gd name="T1" fmla="*/ 747 h 750"/>
                <a:gd name="T2" fmla="*/ 257 w 832"/>
                <a:gd name="T3" fmla="*/ 750 h 750"/>
                <a:gd name="T4" fmla="*/ 257 w 832"/>
                <a:gd name="T5" fmla="*/ 717 h 750"/>
                <a:gd name="T6" fmla="*/ 185 w 832"/>
                <a:gd name="T7" fmla="*/ 712 h 750"/>
                <a:gd name="T8" fmla="*/ 166 w 832"/>
                <a:gd name="T9" fmla="*/ 702 h 750"/>
                <a:gd name="T10" fmla="*/ 162 w 832"/>
                <a:gd name="T11" fmla="*/ 690 h 750"/>
                <a:gd name="T12" fmla="*/ 178 w 832"/>
                <a:gd name="T13" fmla="*/ 637 h 750"/>
                <a:gd name="T14" fmla="*/ 237 w 832"/>
                <a:gd name="T15" fmla="*/ 503 h 750"/>
                <a:gd name="T16" fmla="*/ 556 w 832"/>
                <a:gd name="T17" fmla="*/ 503 h 750"/>
                <a:gd name="T18" fmla="*/ 624 w 832"/>
                <a:gd name="T19" fmla="*/ 663 h 750"/>
                <a:gd name="T20" fmla="*/ 632 w 832"/>
                <a:gd name="T21" fmla="*/ 693 h 750"/>
                <a:gd name="T22" fmla="*/ 627 w 832"/>
                <a:gd name="T23" fmla="*/ 705 h 750"/>
                <a:gd name="T24" fmla="*/ 609 w 832"/>
                <a:gd name="T25" fmla="*/ 713 h 750"/>
                <a:gd name="T26" fmla="*/ 535 w 832"/>
                <a:gd name="T27" fmla="*/ 717 h 750"/>
                <a:gd name="T28" fmla="*/ 535 w 832"/>
                <a:gd name="T29" fmla="*/ 750 h 750"/>
                <a:gd name="T30" fmla="*/ 712 w 832"/>
                <a:gd name="T31" fmla="*/ 747 h 750"/>
                <a:gd name="T32" fmla="*/ 832 w 832"/>
                <a:gd name="T33" fmla="*/ 750 h 750"/>
                <a:gd name="T34" fmla="*/ 832 w 832"/>
                <a:gd name="T35" fmla="*/ 717 h 750"/>
                <a:gd name="T36" fmla="*/ 776 w 832"/>
                <a:gd name="T37" fmla="*/ 710 h 750"/>
                <a:gd name="T38" fmla="*/ 753 w 832"/>
                <a:gd name="T39" fmla="*/ 687 h 750"/>
                <a:gd name="T40" fmla="*/ 677 w 832"/>
                <a:gd name="T41" fmla="*/ 526 h 750"/>
                <a:gd name="T42" fmla="*/ 441 w 832"/>
                <a:gd name="T43" fmla="*/ 0 h 750"/>
                <a:gd name="T44" fmla="*/ 406 w 832"/>
                <a:gd name="T45" fmla="*/ 0 h 750"/>
                <a:gd name="T46" fmla="*/ 310 w 832"/>
                <a:gd name="T47" fmla="*/ 217 h 750"/>
                <a:gd name="T48" fmla="*/ 172 w 832"/>
                <a:gd name="T49" fmla="*/ 512 h 750"/>
                <a:gd name="T50" fmla="*/ 100 w 832"/>
                <a:gd name="T51" fmla="*/ 660 h 750"/>
                <a:gd name="T52" fmla="*/ 74 w 832"/>
                <a:gd name="T53" fmla="*/ 702 h 750"/>
                <a:gd name="T54" fmla="*/ 54 w 832"/>
                <a:gd name="T55" fmla="*/ 713 h 750"/>
                <a:gd name="T56" fmla="*/ 0 w 832"/>
                <a:gd name="T57" fmla="*/ 717 h 750"/>
                <a:gd name="T58" fmla="*/ 0 w 832"/>
                <a:gd name="T59" fmla="*/ 750 h 750"/>
                <a:gd name="T60" fmla="*/ 117 w 832"/>
                <a:gd name="T61" fmla="*/ 747 h 750"/>
                <a:gd name="T62" fmla="*/ 396 w 832"/>
                <a:gd name="T63" fmla="*/ 143 h 750"/>
                <a:gd name="T64" fmla="*/ 534 w 832"/>
                <a:gd name="T65" fmla="*/ 458 h 750"/>
                <a:gd name="T66" fmla="*/ 256 w 832"/>
                <a:gd name="T67" fmla="*/ 458 h 750"/>
                <a:gd name="T68" fmla="*/ 396 w 832"/>
                <a:gd name="T69" fmla="*/ 143 h 75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Lst>
              <a:rect l="0" t="0" r="r" b="b"/>
              <a:pathLst>
                <a:path w="832" h="750">
                  <a:moveTo>
                    <a:pt x="117" y="747"/>
                  </a:moveTo>
                  <a:cubicBezTo>
                    <a:pt x="148" y="747"/>
                    <a:pt x="195" y="748"/>
                    <a:pt x="257" y="750"/>
                  </a:cubicBezTo>
                  <a:cubicBezTo>
                    <a:pt x="257" y="717"/>
                    <a:pt x="257" y="717"/>
                    <a:pt x="257" y="717"/>
                  </a:cubicBezTo>
                  <a:cubicBezTo>
                    <a:pt x="222" y="716"/>
                    <a:pt x="199" y="715"/>
                    <a:pt x="185" y="712"/>
                  </a:cubicBezTo>
                  <a:cubicBezTo>
                    <a:pt x="177" y="710"/>
                    <a:pt x="170" y="707"/>
                    <a:pt x="166" y="702"/>
                  </a:cubicBezTo>
                  <a:cubicBezTo>
                    <a:pt x="163" y="699"/>
                    <a:pt x="162" y="695"/>
                    <a:pt x="162" y="690"/>
                  </a:cubicBezTo>
                  <a:cubicBezTo>
                    <a:pt x="162" y="679"/>
                    <a:pt x="167" y="662"/>
                    <a:pt x="178" y="637"/>
                  </a:cubicBezTo>
                  <a:cubicBezTo>
                    <a:pt x="237" y="503"/>
                    <a:pt x="237" y="503"/>
                    <a:pt x="237" y="503"/>
                  </a:cubicBezTo>
                  <a:cubicBezTo>
                    <a:pt x="556" y="503"/>
                    <a:pt x="556" y="503"/>
                    <a:pt x="556" y="503"/>
                  </a:cubicBezTo>
                  <a:cubicBezTo>
                    <a:pt x="624" y="663"/>
                    <a:pt x="624" y="663"/>
                    <a:pt x="624" y="663"/>
                  </a:cubicBezTo>
                  <a:cubicBezTo>
                    <a:pt x="629" y="675"/>
                    <a:pt x="632" y="685"/>
                    <a:pt x="632" y="693"/>
                  </a:cubicBezTo>
                  <a:cubicBezTo>
                    <a:pt x="632" y="698"/>
                    <a:pt x="630" y="702"/>
                    <a:pt x="627" y="705"/>
                  </a:cubicBezTo>
                  <a:cubicBezTo>
                    <a:pt x="624" y="708"/>
                    <a:pt x="618" y="711"/>
                    <a:pt x="609" y="713"/>
                  </a:cubicBezTo>
                  <a:cubicBezTo>
                    <a:pt x="601" y="715"/>
                    <a:pt x="576" y="716"/>
                    <a:pt x="535" y="717"/>
                  </a:cubicBezTo>
                  <a:cubicBezTo>
                    <a:pt x="535" y="750"/>
                    <a:pt x="535" y="750"/>
                    <a:pt x="535" y="750"/>
                  </a:cubicBezTo>
                  <a:cubicBezTo>
                    <a:pt x="712" y="747"/>
                    <a:pt x="712" y="747"/>
                    <a:pt x="712" y="747"/>
                  </a:cubicBezTo>
                  <a:cubicBezTo>
                    <a:pt x="734" y="747"/>
                    <a:pt x="775" y="748"/>
                    <a:pt x="832" y="750"/>
                  </a:cubicBezTo>
                  <a:cubicBezTo>
                    <a:pt x="832" y="717"/>
                    <a:pt x="832" y="717"/>
                    <a:pt x="832" y="717"/>
                  </a:cubicBezTo>
                  <a:cubicBezTo>
                    <a:pt x="803" y="716"/>
                    <a:pt x="784" y="714"/>
                    <a:pt x="776" y="710"/>
                  </a:cubicBezTo>
                  <a:cubicBezTo>
                    <a:pt x="767" y="707"/>
                    <a:pt x="760" y="699"/>
                    <a:pt x="753" y="687"/>
                  </a:cubicBezTo>
                  <a:cubicBezTo>
                    <a:pt x="740" y="664"/>
                    <a:pt x="715" y="611"/>
                    <a:pt x="677" y="526"/>
                  </a:cubicBezTo>
                  <a:cubicBezTo>
                    <a:pt x="441" y="0"/>
                    <a:pt x="441" y="0"/>
                    <a:pt x="441" y="0"/>
                  </a:cubicBezTo>
                  <a:cubicBezTo>
                    <a:pt x="406" y="0"/>
                    <a:pt x="406" y="0"/>
                    <a:pt x="406" y="0"/>
                  </a:cubicBezTo>
                  <a:cubicBezTo>
                    <a:pt x="357" y="112"/>
                    <a:pt x="325" y="185"/>
                    <a:pt x="310" y="217"/>
                  </a:cubicBezTo>
                  <a:cubicBezTo>
                    <a:pt x="172" y="512"/>
                    <a:pt x="172" y="512"/>
                    <a:pt x="172" y="512"/>
                  </a:cubicBezTo>
                  <a:cubicBezTo>
                    <a:pt x="131" y="598"/>
                    <a:pt x="107" y="647"/>
                    <a:pt x="100" y="660"/>
                  </a:cubicBezTo>
                  <a:cubicBezTo>
                    <a:pt x="89" y="683"/>
                    <a:pt x="80" y="697"/>
                    <a:pt x="74" y="702"/>
                  </a:cubicBezTo>
                  <a:cubicBezTo>
                    <a:pt x="68" y="708"/>
                    <a:pt x="61" y="711"/>
                    <a:pt x="54" y="713"/>
                  </a:cubicBezTo>
                  <a:cubicBezTo>
                    <a:pt x="47" y="715"/>
                    <a:pt x="29" y="716"/>
                    <a:pt x="0" y="717"/>
                  </a:cubicBezTo>
                  <a:cubicBezTo>
                    <a:pt x="0" y="750"/>
                    <a:pt x="0" y="750"/>
                    <a:pt x="0" y="750"/>
                  </a:cubicBezTo>
                  <a:cubicBezTo>
                    <a:pt x="42" y="748"/>
                    <a:pt x="81" y="747"/>
                    <a:pt x="117" y="747"/>
                  </a:cubicBezTo>
                  <a:close/>
                  <a:moveTo>
                    <a:pt x="396" y="143"/>
                  </a:moveTo>
                  <a:cubicBezTo>
                    <a:pt x="534" y="458"/>
                    <a:pt x="534" y="458"/>
                    <a:pt x="534" y="458"/>
                  </a:cubicBezTo>
                  <a:cubicBezTo>
                    <a:pt x="256" y="458"/>
                    <a:pt x="256" y="458"/>
                    <a:pt x="256" y="458"/>
                  </a:cubicBezTo>
                  <a:lnTo>
                    <a:pt x="396" y="143"/>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9" name="Freeform 14"/>
            <p:cNvSpPr>
              <a:spLocks/>
            </p:cNvSpPr>
            <p:nvPr userDrawn="1"/>
          </p:nvSpPr>
          <p:spPr bwMode="auto">
            <a:xfrm>
              <a:off x="1309688" y="687388"/>
              <a:ext cx="260350" cy="234950"/>
            </a:xfrm>
            <a:custGeom>
              <a:avLst/>
              <a:gdLst>
                <a:gd name="T0" fmla="*/ 601 w 817"/>
                <a:gd name="T1" fmla="*/ 111 h 743"/>
                <a:gd name="T2" fmla="*/ 634 w 817"/>
                <a:gd name="T3" fmla="*/ 52 h 743"/>
                <a:gd name="T4" fmla="*/ 624 w 817"/>
                <a:gd name="T5" fmla="*/ 39 h 743"/>
                <a:gd name="T6" fmla="*/ 543 w 817"/>
                <a:gd name="T7" fmla="*/ 33 h 743"/>
                <a:gd name="T8" fmla="*/ 543 w 817"/>
                <a:gd name="T9" fmla="*/ 0 h 743"/>
                <a:gd name="T10" fmla="*/ 688 w 817"/>
                <a:gd name="T11" fmla="*/ 3 h 743"/>
                <a:gd name="T12" fmla="*/ 817 w 817"/>
                <a:gd name="T13" fmla="*/ 0 h 743"/>
                <a:gd name="T14" fmla="*/ 817 w 817"/>
                <a:gd name="T15" fmla="*/ 33 h 743"/>
                <a:gd name="T16" fmla="*/ 746 w 817"/>
                <a:gd name="T17" fmla="*/ 39 h 743"/>
                <a:gd name="T18" fmla="*/ 718 w 817"/>
                <a:gd name="T19" fmla="*/ 51 h 743"/>
                <a:gd name="T20" fmla="*/ 675 w 817"/>
                <a:gd name="T21" fmla="*/ 102 h 743"/>
                <a:gd name="T22" fmla="*/ 514 w 817"/>
                <a:gd name="T23" fmla="*/ 333 h 743"/>
                <a:gd name="T24" fmla="*/ 461 w 817"/>
                <a:gd name="T25" fmla="*/ 422 h 743"/>
                <a:gd name="T26" fmla="*/ 455 w 817"/>
                <a:gd name="T27" fmla="*/ 453 h 743"/>
                <a:gd name="T28" fmla="*/ 455 w 817"/>
                <a:gd name="T29" fmla="*/ 493 h 743"/>
                <a:gd name="T30" fmla="*/ 459 w 817"/>
                <a:gd name="T31" fmla="*/ 631 h 743"/>
                <a:gd name="T32" fmla="*/ 466 w 817"/>
                <a:gd name="T33" fmla="*/ 690 h 743"/>
                <a:gd name="T34" fmla="*/ 486 w 817"/>
                <a:gd name="T35" fmla="*/ 704 h 743"/>
                <a:gd name="T36" fmla="*/ 564 w 817"/>
                <a:gd name="T37" fmla="*/ 710 h 743"/>
                <a:gd name="T38" fmla="*/ 564 w 817"/>
                <a:gd name="T39" fmla="*/ 743 h 743"/>
                <a:gd name="T40" fmla="*/ 410 w 817"/>
                <a:gd name="T41" fmla="*/ 740 h 743"/>
                <a:gd name="T42" fmla="*/ 244 w 817"/>
                <a:gd name="T43" fmla="*/ 743 h 743"/>
                <a:gd name="T44" fmla="*/ 244 w 817"/>
                <a:gd name="T45" fmla="*/ 710 h 743"/>
                <a:gd name="T46" fmla="*/ 322 w 817"/>
                <a:gd name="T47" fmla="*/ 704 h 743"/>
                <a:gd name="T48" fmla="*/ 341 w 817"/>
                <a:gd name="T49" fmla="*/ 692 h 743"/>
                <a:gd name="T50" fmla="*/ 350 w 817"/>
                <a:gd name="T51" fmla="*/ 641 h 743"/>
                <a:gd name="T52" fmla="*/ 353 w 817"/>
                <a:gd name="T53" fmla="*/ 493 h 743"/>
                <a:gd name="T54" fmla="*/ 353 w 817"/>
                <a:gd name="T55" fmla="*/ 432 h 743"/>
                <a:gd name="T56" fmla="*/ 331 w 817"/>
                <a:gd name="T57" fmla="*/ 390 h 743"/>
                <a:gd name="T58" fmla="*/ 275 w 817"/>
                <a:gd name="T59" fmla="*/ 300 h 743"/>
                <a:gd name="T60" fmla="*/ 135 w 817"/>
                <a:gd name="T61" fmla="*/ 102 h 743"/>
                <a:gd name="T62" fmla="*/ 96 w 817"/>
                <a:gd name="T63" fmla="*/ 51 h 743"/>
                <a:gd name="T64" fmla="*/ 69 w 817"/>
                <a:gd name="T65" fmla="*/ 39 h 743"/>
                <a:gd name="T66" fmla="*/ 0 w 817"/>
                <a:gd name="T67" fmla="*/ 33 h 743"/>
                <a:gd name="T68" fmla="*/ 0 w 817"/>
                <a:gd name="T69" fmla="*/ 0 h 743"/>
                <a:gd name="T70" fmla="*/ 130 w 817"/>
                <a:gd name="T71" fmla="*/ 3 h 743"/>
                <a:gd name="T72" fmla="*/ 333 w 817"/>
                <a:gd name="T73" fmla="*/ 0 h 743"/>
                <a:gd name="T74" fmla="*/ 333 w 817"/>
                <a:gd name="T75" fmla="*/ 33 h 743"/>
                <a:gd name="T76" fmla="*/ 246 w 817"/>
                <a:gd name="T77" fmla="*/ 39 h 743"/>
                <a:gd name="T78" fmla="*/ 234 w 817"/>
                <a:gd name="T79" fmla="*/ 52 h 743"/>
                <a:gd name="T80" fmla="*/ 262 w 817"/>
                <a:gd name="T81" fmla="*/ 111 h 743"/>
                <a:gd name="T82" fmla="*/ 426 w 817"/>
                <a:gd name="T83" fmla="*/ 376 h 743"/>
                <a:gd name="T84" fmla="*/ 601 w 817"/>
                <a:gd name="T85" fmla="*/ 111 h 74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Lst>
              <a:rect l="0" t="0" r="r" b="b"/>
              <a:pathLst>
                <a:path w="817" h="743">
                  <a:moveTo>
                    <a:pt x="601" y="111"/>
                  </a:moveTo>
                  <a:cubicBezTo>
                    <a:pt x="623" y="78"/>
                    <a:pt x="634" y="59"/>
                    <a:pt x="634" y="52"/>
                  </a:cubicBezTo>
                  <a:cubicBezTo>
                    <a:pt x="634" y="46"/>
                    <a:pt x="631" y="41"/>
                    <a:pt x="624" y="39"/>
                  </a:cubicBezTo>
                  <a:cubicBezTo>
                    <a:pt x="616" y="36"/>
                    <a:pt x="585" y="34"/>
                    <a:pt x="543" y="33"/>
                  </a:cubicBezTo>
                  <a:cubicBezTo>
                    <a:pt x="543" y="0"/>
                    <a:pt x="543" y="0"/>
                    <a:pt x="543" y="0"/>
                  </a:cubicBezTo>
                  <a:cubicBezTo>
                    <a:pt x="610" y="2"/>
                    <a:pt x="650" y="3"/>
                    <a:pt x="688" y="3"/>
                  </a:cubicBezTo>
                  <a:cubicBezTo>
                    <a:pt x="725" y="3"/>
                    <a:pt x="745" y="2"/>
                    <a:pt x="817" y="0"/>
                  </a:cubicBezTo>
                  <a:cubicBezTo>
                    <a:pt x="817" y="33"/>
                    <a:pt x="817" y="33"/>
                    <a:pt x="817" y="33"/>
                  </a:cubicBezTo>
                  <a:cubicBezTo>
                    <a:pt x="773" y="34"/>
                    <a:pt x="757" y="36"/>
                    <a:pt x="746" y="39"/>
                  </a:cubicBezTo>
                  <a:cubicBezTo>
                    <a:pt x="735" y="41"/>
                    <a:pt x="725" y="46"/>
                    <a:pt x="718" y="51"/>
                  </a:cubicBezTo>
                  <a:cubicBezTo>
                    <a:pt x="709" y="58"/>
                    <a:pt x="695" y="75"/>
                    <a:pt x="675" y="102"/>
                  </a:cubicBezTo>
                  <a:cubicBezTo>
                    <a:pt x="514" y="333"/>
                    <a:pt x="514" y="333"/>
                    <a:pt x="514" y="333"/>
                  </a:cubicBezTo>
                  <a:cubicBezTo>
                    <a:pt x="483" y="381"/>
                    <a:pt x="465" y="411"/>
                    <a:pt x="461" y="422"/>
                  </a:cubicBezTo>
                  <a:cubicBezTo>
                    <a:pt x="457" y="433"/>
                    <a:pt x="455" y="443"/>
                    <a:pt x="455" y="453"/>
                  </a:cubicBezTo>
                  <a:cubicBezTo>
                    <a:pt x="455" y="493"/>
                    <a:pt x="455" y="493"/>
                    <a:pt x="455" y="493"/>
                  </a:cubicBezTo>
                  <a:cubicBezTo>
                    <a:pt x="455" y="541"/>
                    <a:pt x="456" y="587"/>
                    <a:pt x="459" y="631"/>
                  </a:cubicBezTo>
                  <a:cubicBezTo>
                    <a:pt x="460" y="665"/>
                    <a:pt x="462" y="684"/>
                    <a:pt x="466" y="690"/>
                  </a:cubicBezTo>
                  <a:cubicBezTo>
                    <a:pt x="470" y="696"/>
                    <a:pt x="477" y="701"/>
                    <a:pt x="486" y="704"/>
                  </a:cubicBezTo>
                  <a:cubicBezTo>
                    <a:pt x="495" y="707"/>
                    <a:pt x="521" y="709"/>
                    <a:pt x="564" y="710"/>
                  </a:cubicBezTo>
                  <a:cubicBezTo>
                    <a:pt x="564" y="743"/>
                    <a:pt x="564" y="743"/>
                    <a:pt x="564" y="743"/>
                  </a:cubicBezTo>
                  <a:cubicBezTo>
                    <a:pt x="505" y="741"/>
                    <a:pt x="453" y="740"/>
                    <a:pt x="410" y="740"/>
                  </a:cubicBezTo>
                  <a:cubicBezTo>
                    <a:pt x="368" y="740"/>
                    <a:pt x="313" y="741"/>
                    <a:pt x="244" y="743"/>
                  </a:cubicBezTo>
                  <a:cubicBezTo>
                    <a:pt x="244" y="710"/>
                    <a:pt x="244" y="710"/>
                    <a:pt x="244" y="710"/>
                  </a:cubicBezTo>
                  <a:cubicBezTo>
                    <a:pt x="287" y="709"/>
                    <a:pt x="313" y="707"/>
                    <a:pt x="322" y="704"/>
                  </a:cubicBezTo>
                  <a:cubicBezTo>
                    <a:pt x="332" y="701"/>
                    <a:pt x="338" y="697"/>
                    <a:pt x="341" y="692"/>
                  </a:cubicBezTo>
                  <a:cubicBezTo>
                    <a:pt x="346" y="685"/>
                    <a:pt x="349" y="668"/>
                    <a:pt x="350" y="641"/>
                  </a:cubicBezTo>
                  <a:cubicBezTo>
                    <a:pt x="350" y="634"/>
                    <a:pt x="351" y="585"/>
                    <a:pt x="353" y="493"/>
                  </a:cubicBezTo>
                  <a:cubicBezTo>
                    <a:pt x="353" y="432"/>
                    <a:pt x="353" y="432"/>
                    <a:pt x="353" y="432"/>
                  </a:cubicBezTo>
                  <a:cubicBezTo>
                    <a:pt x="345" y="417"/>
                    <a:pt x="338" y="403"/>
                    <a:pt x="331" y="390"/>
                  </a:cubicBezTo>
                  <a:cubicBezTo>
                    <a:pt x="325" y="382"/>
                    <a:pt x="307" y="352"/>
                    <a:pt x="275" y="300"/>
                  </a:cubicBezTo>
                  <a:cubicBezTo>
                    <a:pt x="135" y="102"/>
                    <a:pt x="135" y="102"/>
                    <a:pt x="135" y="102"/>
                  </a:cubicBezTo>
                  <a:cubicBezTo>
                    <a:pt x="118" y="75"/>
                    <a:pt x="105" y="58"/>
                    <a:pt x="96" y="51"/>
                  </a:cubicBezTo>
                  <a:cubicBezTo>
                    <a:pt x="89" y="46"/>
                    <a:pt x="80" y="41"/>
                    <a:pt x="69" y="39"/>
                  </a:cubicBezTo>
                  <a:cubicBezTo>
                    <a:pt x="58" y="36"/>
                    <a:pt x="44" y="34"/>
                    <a:pt x="0" y="33"/>
                  </a:cubicBezTo>
                  <a:cubicBezTo>
                    <a:pt x="0" y="0"/>
                    <a:pt x="0" y="0"/>
                    <a:pt x="0" y="0"/>
                  </a:cubicBezTo>
                  <a:cubicBezTo>
                    <a:pt x="72" y="2"/>
                    <a:pt x="94" y="3"/>
                    <a:pt x="130" y="3"/>
                  </a:cubicBezTo>
                  <a:cubicBezTo>
                    <a:pt x="168" y="3"/>
                    <a:pt x="265" y="2"/>
                    <a:pt x="333" y="0"/>
                  </a:cubicBezTo>
                  <a:cubicBezTo>
                    <a:pt x="333" y="33"/>
                    <a:pt x="333" y="33"/>
                    <a:pt x="333" y="33"/>
                  </a:cubicBezTo>
                  <a:cubicBezTo>
                    <a:pt x="291" y="34"/>
                    <a:pt x="254" y="36"/>
                    <a:pt x="246" y="39"/>
                  </a:cubicBezTo>
                  <a:cubicBezTo>
                    <a:pt x="239" y="41"/>
                    <a:pt x="235" y="46"/>
                    <a:pt x="234" y="52"/>
                  </a:cubicBezTo>
                  <a:cubicBezTo>
                    <a:pt x="234" y="59"/>
                    <a:pt x="243" y="78"/>
                    <a:pt x="262" y="111"/>
                  </a:cubicBezTo>
                  <a:cubicBezTo>
                    <a:pt x="426" y="376"/>
                    <a:pt x="426" y="376"/>
                    <a:pt x="426" y="376"/>
                  </a:cubicBezTo>
                  <a:lnTo>
                    <a:pt x="601" y="111"/>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0" name="Freeform 15"/>
            <p:cNvSpPr>
              <a:spLocks noEditPoints="1"/>
            </p:cNvSpPr>
            <p:nvPr userDrawn="1"/>
          </p:nvSpPr>
          <p:spPr bwMode="auto">
            <a:xfrm>
              <a:off x="1558925" y="681038"/>
              <a:ext cx="263525" cy="246063"/>
            </a:xfrm>
            <a:custGeom>
              <a:avLst/>
              <a:gdLst>
                <a:gd name="T0" fmla="*/ 148 w 830"/>
                <a:gd name="T1" fmla="*/ 190 h 775"/>
                <a:gd name="T2" fmla="*/ 247 w 830"/>
                <a:gd name="T3" fmla="*/ 82 h 775"/>
                <a:gd name="T4" fmla="*/ 399 w 830"/>
                <a:gd name="T5" fmla="*/ 45 h 775"/>
                <a:gd name="T6" fmla="*/ 512 w 830"/>
                <a:gd name="T7" fmla="*/ 62 h 775"/>
                <a:gd name="T8" fmla="*/ 596 w 830"/>
                <a:gd name="T9" fmla="*/ 106 h 775"/>
                <a:gd name="T10" fmla="*/ 652 w 830"/>
                <a:gd name="T11" fmla="*/ 167 h 775"/>
                <a:gd name="T12" fmla="*/ 690 w 830"/>
                <a:gd name="T13" fmla="*/ 245 h 775"/>
                <a:gd name="T14" fmla="*/ 713 w 830"/>
                <a:gd name="T15" fmla="*/ 398 h 775"/>
                <a:gd name="T16" fmla="*/ 681 w 830"/>
                <a:gd name="T17" fmla="*/ 571 h 775"/>
                <a:gd name="T18" fmla="*/ 584 w 830"/>
                <a:gd name="T19" fmla="*/ 686 h 775"/>
                <a:gd name="T20" fmla="*/ 431 w 830"/>
                <a:gd name="T21" fmla="*/ 727 h 775"/>
                <a:gd name="T22" fmla="*/ 315 w 830"/>
                <a:gd name="T23" fmla="*/ 707 h 775"/>
                <a:gd name="T24" fmla="*/ 220 w 830"/>
                <a:gd name="T25" fmla="*/ 644 h 775"/>
                <a:gd name="T26" fmla="*/ 151 w 830"/>
                <a:gd name="T27" fmla="*/ 539 h 775"/>
                <a:gd name="T28" fmla="*/ 125 w 830"/>
                <a:gd name="T29" fmla="*/ 450 h 775"/>
                <a:gd name="T30" fmla="*/ 115 w 830"/>
                <a:gd name="T31" fmla="*/ 349 h 775"/>
                <a:gd name="T32" fmla="*/ 148 w 830"/>
                <a:gd name="T33" fmla="*/ 190 h 775"/>
                <a:gd name="T34" fmla="*/ 26 w 830"/>
                <a:gd name="T35" fmla="*/ 541 h 775"/>
                <a:gd name="T36" fmla="*/ 105 w 830"/>
                <a:gd name="T37" fmla="*/ 669 h 775"/>
                <a:gd name="T38" fmla="*/ 231 w 830"/>
                <a:gd name="T39" fmla="*/ 748 h 775"/>
                <a:gd name="T40" fmla="*/ 392 w 830"/>
                <a:gd name="T41" fmla="*/ 775 h 775"/>
                <a:gd name="T42" fmla="*/ 706 w 830"/>
                <a:gd name="T43" fmla="*/ 657 h 775"/>
                <a:gd name="T44" fmla="*/ 830 w 830"/>
                <a:gd name="T45" fmla="*/ 364 h 775"/>
                <a:gd name="T46" fmla="*/ 817 w 830"/>
                <a:gd name="T47" fmla="*/ 261 h 775"/>
                <a:gd name="T48" fmla="*/ 784 w 830"/>
                <a:gd name="T49" fmla="*/ 177 h 775"/>
                <a:gd name="T50" fmla="*/ 709 w 830"/>
                <a:gd name="T51" fmla="*/ 89 h 775"/>
                <a:gd name="T52" fmla="*/ 588 w 830"/>
                <a:gd name="T53" fmla="*/ 25 h 775"/>
                <a:gd name="T54" fmla="*/ 423 w 830"/>
                <a:gd name="T55" fmla="*/ 0 h 775"/>
                <a:gd name="T56" fmla="*/ 249 w 830"/>
                <a:gd name="T57" fmla="*/ 29 h 775"/>
                <a:gd name="T58" fmla="*/ 112 w 830"/>
                <a:gd name="T59" fmla="*/ 113 h 775"/>
                <a:gd name="T60" fmla="*/ 26 w 830"/>
                <a:gd name="T61" fmla="*/ 239 h 775"/>
                <a:gd name="T62" fmla="*/ 0 w 830"/>
                <a:gd name="T63" fmla="*/ 393 h 775"/>
                <a:gd name="T64" fmla="*/ 26 w 830"/>
                <a:gd name="T65" fmla="*/ 541 h 77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Lst>
              <a:rect l="0" t="0" r="r" b="b"/>
              <a:pathLst>
                <a:path w="830" h="775">
                  <a:moveTo>
                    <a:pt x="148" y="190"/>
                  </a:moveTo>
                  <a:cubicBezTo>
                    <a:pt x="170" y="143"/>
                    <a:pt x="203" y="107"/>
                    <a:pt x="247" y="82"/>
                  </a:cubicBezTo>
                  <a:cubicBezTo>
                    <a:pt x="290" y="57"/>
                    <a:pt x="341" y="45"/>
                    <a:pt x="399" y="45"/>
                  </a:cubicBezTo>
                  <a:cubicBezTo>
                    <a:pt x="440" y="45"/>
                    <a:pt x="477" y="51"/>
                    <a:pt x="512" y="62"/>
                  </a:cubicBezTo>
                  <a:cubicBezTo>
                    <a:pt x="546" y="74"/>
                    <a:pt x="575" y="89"/>
                    <a:pt x="596" y="106"/>
                  </a:cubicBezTo>
                  <a:cubicBezTo>
                    <a:pt x="618" y="124"/>
                    <a:pt x="637" y="144"/>
                    <a:pt x="652" y="167"/>
                  </a:cubicBezTo>
                  <a:cubicBezTo>
                    <a:pt x="668" y="190"/>
                    <a:pt x="681" y="216"/>
                    <a:pt x="690" y="245"/>
                  </a:cubicBezTo>
                  <a:cubicBezTo>
                    <a:pt x="706" y="292"/>
                    <a:pt x="713" y="343"/>
                    <a:pt x="713" y="398"/>
                  </a:cubicBezTo>
                  <a:cubicBezTo>
                    <a:pt x="713" y="463"/>
                    <a:pt x="703" y="521"/>
                    <a:pt x="681" y="571"/>
                  </a:cubicBezTo>
                  <a:cubicBezTo>
                    <a:pt x="660" y="620"/>
                    <a:pt x="627" y="659"/>
                    <a:pt x="584" y="686"/>
                  </a:cubicBezTo>
                  <a:cubicBezTo>
                    <a:pt x="541" y="714"/>
                    <a:pt x="490" y="727"/>
                    <a:pt x="431" y="727"/>
                  </a:cubicBezTo>
                  <a:cubicBezTo>
                    <a:pt x="388" y="727"/>
                    <a:pt x="350" y="721"/>
                    <a:pt x="315" y="707"/>
                  </a:cubicBezTo>
                  <a:cubicBezTo>
                    <a:pt x="280" y="694"/>
                    <a:pt x="248" y="673"/>
                    <a:pt x="220" y="644"/>
                  </a:cubicBezTo>
                  <a:cubicBezTo>
                    <a:pt x="192" y="616"/>
                    <a:pt x="169" y="581"/>
                    <a:pt x="151" y="539"/>
                  </a:cubicBezTo>
                  <a:cubicBezTo>
                    <a:pt x="141" y="514"/>
                    <a:pt x="132" y="484"/>
                    <a:pt x="125" y="450"/>
                  </a:cubicBezTo>
                  <a:cubicBezTo>
                    <a:pt x="118" y="416"/>
                    <a:pt x="115" y="382"/>
                    <a:pt x="115" y="349"/>
                  </a:cubicBezTo>
                  <a:cubicBezTo>
                    <a:pt x="115" y="290"/>
                    <a:pt x="126" y="236"/>
                    <a:pt x="148" y="190"/>
                  </a:cubicBezTo>
                  <a:close/>
                  <a:moveTo>
                    <a:pt x="26" y="541"/>
                  </a:moveTo>
                  <a:cubicBezTo>
                    <a:pt x="44" y="591"/>
                    <a:pt x="70" y="634"/>
                    <a:pt x="105" y="669"/>
                  </a:cubicBezTo>
                  <a:cubicBezTo>
                    <a:pt x="139" y="704"/>
                    <a:pt x="181" y="730"/>
                    <a:pt x="231" y="748"/>
                  </a:cubicBezTo>
                  <a:cubicBezTo>
                    <a:pt x="281" y="765"/>
                    <a:pt x="335" y="775"/>
                    <a:pt x="392" y="775"/>
                  </a:cubicBezTo>
                  <a:cubicBezTo>
                    <a:pt x="518" y="775"/>
                    <a:pt x="623" y="736"/>
                    <a:pt x="706" y="657"/>
                  </a:cubicBezTo>
                  <a:cubicBezTo>
                    <a:pt x="788" y="579"/>
                    <a:pt x="830" y="481"/>
                    <a:pt x="830" y="364"/>
                  </a:cubicBezTo>
                  <a:cubicBezTo>
                    <a:pt x="830" y="327"/>
                    <a:pt x="826" y="293"/>
                    <a:pt x="817" y="261"/>
                  </a:cubicBezTo>
                  <a:cubicBezTo>
                    <a:pt x="809" y="228"/>
                    <a:pt x="798" y="200"/>
                    <a:pt x="784" y="177"/>
                  </a:cubicBezTo>
                  <a:cubicBezTo>
                    <a:pt x="766" y="145"/>
                    <a:pt x="741" y="116"/>
                    <a:pt x="709" y="89"/>
                  </a:cubicBezTo>
                  <a:cubicBezTo>
                    <a:pt x="678" y="62"/>
                    <a:pt x="637" y="41"/>
                    <a:pt x="588" y="25"/>
                  </a:cubicBezTo>
                  <a:cubicBezTo>
                    <a:pt x="538" y="8"/>
                    <a:pt x="484" y="0"/>
                    <a:pt x="423" y="0"/>
                  </a:cubicBezTo>
                  <a:cubicBezTo>
                    <a:pt x="358" y="0"/>
                    <a:pt x="300" y="10"/>
                    <a:pt x="249" y="29"/>
                  </a:cubicBezTo>
                  <a:cubicBezTo>
                    <a:pt x="198" y="48"/>
                    <a:pt x="152" y="76"/>
                    <a:pt x="112" y="113"/>
                  </a:cubicBezTo>
                  <a:cubicBezTo>
                    <a:pt x="72" y="151"/>
                    <a:pt x="43" y="193"/>
                    <a:pt x="26" y="239"/>
                  </a:cubicBezTo>
                  <a:cubicBezTo>
                    <a:pt x="8" y="286"/>
                    <a:pt x="0" y="337"/>
                    <a:pt x="0" y="393"/>
                  </a:cubicBezTo>
                  <a:cubicBezTo>
                    <a:pt x="0" y="441"/>
                    <a:pt x="9" y="491"/>
                    <a:pt x="26" y="541"/>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spTree>
    <p:extLst>
      <p:ext uri="{BB962C8B-B14F-4D97-AF65-F5344CB8AC3E}">
        <p14:creationId xmlns:p14="http://schemas.microsoft.com/office/powerpoint/2010/main" val="780499835"/>
      </p:ext>
    </p:extLst>
  </p:cSld>
  <p:clrMapOvr>
    <a:masterClrMapping/>
  </p:clrMapOvr>
  <p:timing>
    <p:tnLst>
      <p:par>
        <p:cTn id="1" dur="indefinite" restart="never" nodeType="tmRoot"/>
      </p:par>
    </p:tnLst>
  </p:timing>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C7D783B-1AF8-48D0-B14B-C55AF9187F22}" type="datetime1">
              <a:rPr lang="en-US" smtClean="0"/>
              <a:t>10/28/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DC53FA5-AE81-45E0-8206-920AA27813B4}" type="slidenum">
              <a:rPr lang="en-US" smtClean="0"/>
              <a:t>‹#›</a:t>
            </a:fld>
            <a:endParaRPr lang="en-US"/>
          </a:p>
        </p:txBody>
      </p:sp>
      <p:grpSp>
        <p:nvGrpSpPr>
          <p:cNvPr id="18" name="Group 17"/>
          <p:cNvGrpSpPr/>
          <p:nvPr userDrawn="1"/>
        </p:nvGrpSpPr>
        <p:grpSpPr>
          <a:xfrm>
            <a:off x="120650" y="6299343"/>
            <a:ext cx="420688" cy="458645"/>
            <a:chOff x="657225" y="681038"/>
            <a:chExt cx="1266825" cy="1381125"/>
          </a:xfrm>
          <a:solidFill>
            <a:srgbClr val="FFFFFF"/>
          </a:solidFill>
        </p:grpSpPr>
        <p:sp>
          <p:nvSpPr>
            <p:cNvPr id="19" name="Freeform 5"/>
            <p:cNvSpPr>
              <a:spLocks noEditPoints="1"/>
            </p:cNvSpPr>
            <p:nvPr userDrawn="1"/>
          </p:nvSpPr>
          <p:spPr bwMode="auto">
            <a:xfrm>
              <a:off x="846138" y="1354138"/>
              <a:ext cx="887413" cy="708025"/>
            </a:xfrm>
            <a:custGeom>
              <a:avLst/>
              <a:gdLst>
                <a:gd name="T0" fmla="*/ 2203 w 2794"/>
                <a:gd name="T1" fmla="*/ 0 h 2229"/>
                <a:gd name="T2" fmla="*/ 1613 w 2794"/>
                <a:gd name="T3" fmla="*/ 0 h 2229"/>
                <a:gd name="T4" fmla="*/ 1613 w 2794"/>
                <a:gd name="T5" fmla="*/ 665 h 2229"/>
                <a:gd name="T6" fmla="*/ 1904 w 2794"/>
                <a:gd name="T7" fmla="*/ 1330 h 2229"/>
                <a:gd name="T8" fmla="*/ 1904 w 2794"/>
                <a:gd name="T9" fmla="*/ 1237 h 2229"/>
                <a:gd name="T10" fmla="*/ 1749 w 2794"/>
                <a:gd name="T11" fmla="*/ 747 h 2229"/>
                <a:gd name="T12" fmla="*/ 1749 w 2794"/>
                <a:gd name="T13" fmla="*/ 573 h 2229"/>
                <a:gd name="T14" fmla="*/ 1972 w 2794"/>
                <a:gd name="T15" fmla="*/ 573 h 2229"/>
                <a:gd name="T16" fmla="*/ 1972 w 2794"/>
                <a:gd name="T17" fmla="*/ 1332 h 2229"/>
                <a:gd name="T18" fmla="*/ 1401 w 2794"/>
                <a:gd name="T19" fmla="*/ 2182 h 2229"/>
                <a:gd name="T20" fmla="*/ 829 w 2794"/>
                <a:gd name="T21" fmla="*/ 1374 h 2229"/>
                <a:gd name="T22" fmla="*/ 1180 w 2794"/>
                <a:gd name="T23" fmla="*/ 665 h 2229"/>
                <a:gd name="T24" fmla="*/ 1180 w 2794"/>
                <a:gd name="T25" fmla="*/ 573 h 2229"/>
                <a:gd name="T26" fmla="*/ 1401 w 2794"/>
                <a:gd name="T27" fmla="*/ 573 h 2229"/>
                <a:gd name="T28" fmla="*/ 1542 w 2794"/>
                <a:gd name="T29" fmla="*/ 573 h 2229"/>
                <a:gd name="T30" fmla="*/ 1542 w 2794"/>
                <a:gd name="T31" fmla="*/ 436 h 2229"/>
                <a:gd name="T32" fmla="*/ 1401 w 2794"/>
                <a:gd name="T33" fmla="*/ 436 h 2229"/>
                <a:gd name="T34" fmla="*/ 1180 w 2794"/>
                <a:gd name="T35" fmla="*/ 436 h 2229"/>
                <a:gd name="T36" fmla="*/ 1180 w 2794"/>
                <a:gd name="T37" fmla="*/ 436 h 2229"/>
                <a:gd name="T38" fmla="*/ 1044 w 2794"/>
                <a:gd name="T39" fmla="*/ 436 h 2229"/>
                <a:gd name="T40" fmla="*/ 1044 w 2794"/>
                <a:gd name="T41" fmla="*/ 436 h 2229"/>
                <a:gd name="T42" fmla="*/ 692 w 2794"/>
                <a:gd name="T43" fmla="*/ 436 h 2229"/>
                <a:gd name="T44" fmla="*/ 692 w 2794"/>
                <a:gd name="T45" fmla="*/ 1234 h 2229"/>
                <a:gd name="T46" fmla="*/ 695 w 2794"/>
                <a:gd name="T47" fmla="*/ 1315 h 2229"/>
                <a:gd name="T48" fmla="*/ 695 w 2794"/>
                <a:gd name="T49" fmla="*/ 1315 h 2229"/>
                <a:gd name="T50" fmla="*/ 829 w 2794"/>
                <a:gd name="T51" fmla="*/ 1205 h 2229"/>
                <a:gd name="T52" fmla="*/ 829 w 2794"/>
                <a:gd name="T53" fmla="*/ 1205 h 2229"/>
                <a:gd name="T54" fmla="*/ 829 w 2794"/>
                <a:gd name="T55" fmla="*/ 573 h 2229"/>
                <a:gd name="T56" fmla="*/ 1044 w 2794"/>
                <a:gd name="T57" fmla="*/ 573 h 2229"/>
                <a:gd name="T58" fmla="*/ 1044 w 2794"/>
                <a:gd name="T59" fmla="*/ 573 h 2229"/>
                <a:gd name="T60" fmla="*/ 1044 w 2794"/>
                <a:gd name="T61" fmla="*/ 747 h 2229"/>
                <a:gd name="T62" fmla="*/ 590 w 2794"/>
                <a:gd name="T63" fmla="*/ 1447 h 2229"/>
                <a:gd name="T64" fmla="*/ 135 w 2794"/>
                <a:gd name="T65" fmla="*/ 747 h 2229"/>
                <a:gd name="T66" fmla="*/ 135 w 2794"/>
                <a:gd name="T67" fmla="*/ 136 h 2229"/>
                <a:gd name="T68" fmla="*/ 590 w 2794"/>
                <a:gd name="T69" fmla="*/ 136 h 2229"/>
                <a:gd name="T70" fmla="*/ 1044 w 2794"/>
                <a:gd name="T71" fmla="*/ 136 h 2229"/>
                <a:gd name="T72" fmla="*/ 1044 w 2794"/>
                <a:gd name="T73" fmla="*/ 370 h 2229"/>
                <a:gd name="T74" fmla="*/ 1180 w 2794"/>
                <a:gd name="T75" fmla="*/ 370 h 2229"/>
                <a:gd name="T76" fmla="*/ 1180 w 2794"/>
                <a:gd name="T77" fmla="*/ 0 h 2229"/>
                <a:gd name="T78" fmla="*/ 590 w 2794"/>
                <a:gd name="T79" fmla="*/ 0 h 2229"/>
                <a:gd name="T80" fmla="*/ 0 w 2794"/>
                <a:gd name="T81" fmla="*/ 0 h 2229"/>
                <a:gd name="T82" fmla="*/ 0 w 2794"/>
                <a:gd name="T83" fmla="*/ 665 h 2229"/>
                <a:gd name="T84" fmla="*/ 590 w 2794"/>
                <a:gd name="T85" fmla="*/ 1495 h 2229"/>
                <a:gd name="T86" fmla="*/ 708 w 2794"/>
                <a:gd name="T87" fmla="*/ 1444 h 2229"/>
                <a:gd name="T88" fmla="*/ 1401 w 2794"/>
                <a:gd name="T89" fmla="*/ 2229 h 2229"/>
                <a:gd name="T90" fmla="*/ 2093 w 2794"/>
                <a:gd name="T91" fmla="*/ 1447 h 2229"/>
                <a:gd name="T92" fmla="*/ 2203 w 2794"/>
                <a:gd name="T93" fmla="*/ 1495 h 2229"/>
                <a:gd name="T94" fmla="*/ 2794 w 2794"/>
                <a:gd name="T95" fmla="*/ 665 h 2229"/>
                <a:gd name="T96" fmla="*/ 2794 w 2794"/>
                <a:gd name="T97" fmla="*/ 0 h 2229"/>
                <a:gd name="T98" fmla="*/ 2203 w 2794"/>
                <a:gd name="T99" fmla="*/ 0 h 2229"/>
                <a:gd name="T100" fmla="*/ 2658 w 2794"/>
                <a:gd name="T101" fmla="*/ 747 h 2229"/>
                <a:gd name="T102" fmla="*/ 2203 w 2794"/>
                <a:gd name="T103" fmla="*/ 1447 h 2229"/>
                <a:gd name="T104" fmla="*/ 2100 w 2794"/>
                <a:gd name="T105" fmla="*/ 1395 h 2229"/>
                <a:gd name="T106" fmla="*/ 2109 w 2794"/>
                <a:gd name="T107" fmla="*/ 1234 h 2229"/>
                <a:gd name="T108" fmla="*/ 2109 w 2794"/>
                <a:gd name="T109" fmla="*/ 436 h 2229"/>
                <a:gd name="T110" fmla="*/ 1749 w 2794"/>
                <a:gd name="T111" fmla="*/ 436 h 2229"/>
                <a:gd name="T112" fmla="*/ 1749 w 2794"/>
                <a:gd name="T113" fmla="*/ 136 h 2229"/>
                <a:gd name="T114" fmla="*/ 2203 w 2794"/>
                <a:gd name="T115" fmla="*/ 136 h 2229"/>
                <a:gd name="T116" fmla="*/ 2658 w 2794"/>
                <a:gd name="T117" fmla="*/ 136 h 2229"/>
                <a:gd name="T118" fmla="*/ 2658 w 2794"/>
                <a:gd name="T119" fmla="*/ 747 h 222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 ang="0">
                  <a:pos x="T118" y="T119"/>
                </a:cxn>
              </a:cxnLst>
              <a:rect l="0" t="0" r="r" b="b"/>
              <a:pathLst>
                <a:path w="2794" h="2229">
                  <a:moveTo>
                    <a:pt x="2203" y="0"/>
                  </a:moveTo>
                  <a:cubicBezTo>
                    <a:pt x="1613" y="0"/>
                    <a:pt x="1613" y="0"/>
                    <a:pt x="1613" y="0"/>
                  </a:cubicBezTo>
                  <a:cubicBezTo>
                    <a:pt x="1613" y="665"/>
                    <a:pt x="1613" y="665"/>
                    <a:pt x="1613" y="665"/>
                  </a:cubicBezTo>
                  <a:cubicBezTo>
                    <a:pt x="1613" y="970"/>
                    <a:pt x="1719" y="1183"/>
                    <a:pt x="1904" y="1330"/>
                  </a:cubicBezTo>
                  <a:cubicBezTo>
                    <a:pt x="1904" y="1237"/>
                    <a:pt x="1904" y="1237"/>
                    <a:pt x="1904" y="1237"/>
                  </a:cubicBezTo>
                  <a:cubicBezTo>
                    <a:pt x="1769" y="1081"/>
                    <a:pt x="1749" y="901"/>
                    <a:pt x="1749" y="747"/>
                  </a:cubicBezTo>
                  <a:cubicBezTo>
                    <a:pt x="1749" y="573"/>
                    <a:pt x="1749" y="573"/>
                    <a:pt x="1749" y="573"/>
                  </a:cubicBezTo>
                  <a:cubicBezTo>
                    <a:pt x="1972" y="573"/>
                    <a:pt x="1972" y="573"/>
                    <a:pt x="1972" y="573"/>
                  </a:cubicBezTo>
                  <a:cubicBezTo>
                    <a:pt x="1972" y="1332"/>
                    <a:pt x="1972" y="1332"/>
                    <a:pt x="1972" y="1332"/>
                  </a:cubicBezTo>
                  <a:cubicBezTo>
                    <a:pt x="1972" y="1609"/>
                    <a:pt x="1895" y="1961"/>
                    <a:pt x="1401" y="2182"/>
                  </a:cubicBezTo>
                  <a:cubicBezTo>
                    <a:pt x="931" y="1972"/>
                    <a:pt x="838" y="1643"/>
                    <a:pt x="829" y="1374"/>
                  </a:cubicBezTo>
                  <a:cubicBezTo>
                    <a:pt x="1051" y="1225"/>
                    <a:pt x="1180" y="1001"/>
                    <a:pt x="1180" y="665"/>
                  </a:cubicBezTo>
                  <a:cubicBezTo>
                    <a:pt x="1180" y="573"/>
                    <a:pt x="1180" y="573"/>
                    <a:pt x="1180" y="573"/>
                  </a:cubicBezTo>
                  <a:cubicBezTo>
                    <a:pt x="1401" y="573"/>
                    <a:pt x="1401" y="573"/>
                    <a:pt x="1401" y="573"/>
                  </a:cubicBezTo>
                  <a:cubicBezTo>
                    <a:pt x="1542" y="573"/>
                    <a:pt x="1542" y="573"/>
                    <a:pt x="1542" y="573"/>
                  </a:cubicBezTo>
                  <a:cubicBezTo>
                    <a:pt x="1542" y="436"/>
                    <a:pt x="1542" y="436"/>
                    <a:pt x="1542" y="436"/>
                  </a:cubicBezTo>
                  <a:cubicBezTo>
                    <a:pt x="1401" y="436"/>
                    <a:pt x="1401" y="436"/>
                    <a:pt x="1401" y="436"/>
                  </a:cubicBezTo>
                  <a:cubicBezTo>
                    <a:pt x="1180" y="436"/>
                    <a:pt x="1180" y="436"/>
                    <a:pt x="1180" y="436"/>
                  </a:cubicBezTo>
                  <a:cubicBezTo>
                    <a:pt x="1180" y="436"/>
                    <a:pt x="1180" y="436"/>
                    <a:pt x="1180" y="436"/>
                  </a:cubicBezTo>
                  <a:cubicBezTo>
                    <a:pt x="1044" y="436"/>
                    <a:pt x="1044" y="436"/>
                    <a:pt x="1044" y="436"/>
                  </a:cubicBezTo>
                  <a:cubicBezTo>
                    <a:pt x="1044" y="436"/>
                    <a:pt x="1044" y="436"/>
                    <a:pt x="1044" y="436"/>
                  </a:cubicBezTo>
                  <a:cubicBezTo>
                    <a:pt x="692" y="436"/>
                    <a:pt x="692" y="436"/>
                    <a:pt x="692" y="436"/>
                  </a:cubicBezTo>
                  <a:cubicBezTo>
                    <a:pt x="692" y="1234"/>
                    <a:pt x="692" y="1234"/>
                    <a:pt x="692" y="1234"/>
                  </a:cubicBezTo>
                  <a:cubicBezTo>
                    <a:pt x="692" y="1262"/>
                    <a:pt x="693" y="1289"/>
                    <a:pt x="695" y="1315"/>
                  </a:cubicBezTo>
                  <a:cubicBezTo>
                    <a:pt x="695" y="1315"/>
                    <a:pt x="695" y="1315"/>
                    <a:pt x="695" y="1315"/>
                  </a:cubicBezTo>
                  <a:cubicBezTo>
                    <a:pt x="748" y="1280"/>
                    <a:pt x="792" y="1244"/>
                    <a:pt x="829" y="1205"/>
                  </a:cubicBezTo>
                  <a:cubicBezTo>
                    <a:pt x="829" y="1205"/>
                    <a:pt x="829" y="1205"/>
                    <a:pt x="829" y="1205"/>
                  </a:cubicBezTo>
                  <a:cubicBezTo>
                    <a:pt x="829" y="573"/>
                    <a:pt x="829" y="573"/>
                    <a:pt x="829" y="573"/>
                  </a:cubicBezTo>
                  <a:cubicBezTo>
                    <a:pt x="1044" y="573"/>
                    <a:pt x="1044" y="573"/>
                    <a:pt x="1044" y="573"/>
                  </a:cubicBezTo>
                  <a:cubicBezTo>
                    <a:pt x="1044" y="573"/>
                    <a:pt x="1044" y="573"/>
                    <a:pt x="1044" y="573"/>
                  </a:cubicBezTo>
                  <a:cubicBezTo>
                    <a:pt x="1044" y="747"/>
                    <a:pt x="1044" y="747"/>
                    <a:pt x="1044" y="747"/>
                  </a:cubicBezTo>
                  <a:cubicBezTo>
                    <a:pt x="1044" y="978"/>
                    <a:pt x="1001" y="1263"/>
                    <a:pt x="590" y="1447"/>
                  </a:cubicBezTo>
                  <a:cubicBezTo>
                    <a:pt x="178" y="1263"/>
                    <a:pt x="135" y="978"/>
                    <a:pt x="135" y="747"/>
                  </a:cubicBezTo>
                  <a:cubicBezTo>
                    <a:pt x="135" y="136"/>
                    <a:pt x="135" y="136"/>
                    <a:pt x="135" y="136"/>
                  </a:cubicBezTo>
                  <a:cubicBezTo>
                    <a:pt x="590" y="136"/>
                    <a:pt x="590" y="136"/>
                    <a:pt x="590" y="136"/>
                  </a:cubicBezTo>
                  <a:cubicBezTo>
                    <a:pt x="1044" y="136"/>
                    <a:pt x="1044" y="136"/>
                    <a:pt x="1044" y="136"/>
                  </a:cubicBezTo>
                  <a:cubicBezTo>
                    <a:pt x="1044" y="370"/>
                    <a:pt x="1044" y="370"/>
                    <a:pt x="1044" y="370"/>
                  </a:cubicBezTo>
                  <a:cubicBezTo>
                    <a:pt x="1180" y="370"/>
                    <a:pt x="1180" y="370"/>
                    <a:pt x="1180" y="370"/>
                  </a:cubicBezTo>
                  <a:cubicBezTo>
                    <a:pt x="1180" y="0"/>
                    <a:pt x="1180" y="0"/>
                    <a:pt x="1180" y="0"/>
                  </a:cubicBezTo>
                  <a:cubicBezTo>
                    <a:pt x="590" y="0"/>
                    <a:pt x="590" y="0"/>
                    <a:pt x="590" y="0"/>
                  </a:cubicBezTo>
                  <a:cubicBezTo>
                    <a:pt x="0" y="0"/>
                    <a:pt x="0" y="0"/>
                    <a:pt x="0" y="0"/>
                  </a:cubicBezTo>
                  <a:cubicBezTo>
                    <a:pt x="0" y="665"/>
                    <a:pt x="0" y="665"/>
                    <a:pt x="0" y="665"/>
                  </a:cubicBezTo>
                  <a:cubicBezTo>
                    <a:pt x="0" y="1109"/>
                    <a:pt x="224" y="1357"/>
                    <a:pt x="590" y="1495"/>
                  </a:cubicBezTo>
                  <a:cubicBezTo>
                    <a:pt x="631" y="1479"/>
                    <a:pt x="670" y="1462"/>
                    <a:pt x="708" y="1444"/>
                  </a:cubicBezTo>
                  <a:cubicBezTo>
                    <a:pt x="771" y="1847"/>
                    <a:pt x="1023" y="2087"/>
                    <a:pt x="1401" y="2229"/>
                  </a:cubicBezTo>
                  <a:cubicBezTo>
                    <a:pt x="1777" y="2087"/>
                    <a:pt x="2029" y="1848"/>
                    <a:pt x="2093" y="1447"/>
                  </a:cubicBezTo>
                  <a:cubicBezTo>
                    <a:pt x="2128" y="1464"/>
                    <a:pt x="2165" y="1480"/>
                    <a:pt x="2203" y="1495"/>
                  </a:cubicBezTo>
                  <a:cubicBezTo>
                    <a:pt x="2569" y="1357"/>
                    <a:pt x="2794" y="1109"/>
                    <a:pt x="2794" y="665"/>
                  </a:cubicBezTo>
                  <a:cubicBezTo>
                    <a:pt x="2794" y="0"/>
                    <a:pt x="2794" y="0"/>
                    <a:pt x="2794" y="0"/>
                  </a:cubicBezTo>
                  <a:lnTo>
                    <a:pt x="2203" y="0"/>
                  </a:lnTo>
                  <a:close/>
                  <a:moveTo>
                    <a:pt x="2658" y="747"/>
                  </a:moveTo>
                  <a:cubicBezTo>
                    <a:pt x="2658" y="978"/>
                    <a:pt x="2615" y="1263"/>
                    <a:pt x="2203" y="1447"/>
                  </a:cubicBezTo>
                  <a:cubicBezTo>
                    <a:pt x="2166" y="1431"/>
                    <a:pt x="2131" y="1413"/>
                    <a:pt x="2100" y="1395"/>
                  </a:cubicBezTo>
                  <a:cubicBezTo>
                    <a:pt x="2106" y="1344"/>
                    <a:pt x="2109" y="1290"/>
                    <a:pt x="2109" y="1234"/>
                  </a:cubicBezTo>
                  <a:cubicBezTo>
                    <a:pt x="2109" y="436"/>
                    <a:pt x="2109" y="436"/>
                    <a:pt x="2109" y="436"/>
                  </a:cubicBezTo>
                  <a:cubicBezTo>
                    <a:pt x="1749" y="436"/>
                    <a:pt x="1749" y="436"/>
                    <a:pt x="1749" y="436"/>
                  </a:cubicBezTo>
                  <a:cubicBezTo>
                    <a:pt x="1749" y="136"/>
                    <a:pt x="1749" y="136"/>
                    <a:pt x="1749" y="136"/>
                  </a:cubicBezTo>
                  <a:cubicBezTo>
                    <a:pt x="2203" y="136"/>
                    <a:pt x="2203" y="136"/>
                    <a:pt x="2203" y="136"/>
                  </a:cubicBezTo>
                  <a:cubicBezTo>
                    <a:pt x="2658" y="136"/>
                    <a:pt x="2658" y="136"/>
                    <a:pt x="2658" y="136"/>
                  </a:cubicBezTo>
                  <a:lnTo>
                    <a:pt x="2658" y="74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0" name="Freeform 6"/>
            <p:cNvSpPr>
              <a:spLocks/>
            </p:cNvSpPr>
            <p:nvPr userDrawn="1"/>
          </p:nvSpPr>
          <p:spPr bwMode="auto">
            <a:xfrm>
              <a:off x="915988" y="1003301"/>
              <a:ext cx="188913" cy="236538"/>
            </a:xfrm>
            <a:custGeom>
              <a:avLst/>
              <a:gdLst>
                <a:gd name="T0" fmla="*/ 49 w 596"/>
                <a:gd name="T1" fmla="*/ 747 h 747"/>
                <a:gd name="T2" fmla="*/ 49 w 596"/>
                <a:gd name="T3" fmla="*/ 721 h 747"/>
                <a:gd name="T4" fmla="*/ 91 w 596"/>
                <a:gd name="T5" fmla="*/ 696 h 747"/>
                <a:gd name="T6" fmla="*/ 99 w 596"/>
                <a:gd name="T7" fmla="*/ 684 h 747"/>
                <a:gd name="T8" fmla="*/ 105 w 596"/>
                <a:gd name="T9" fmla="*/ 621 h 747"/>
                <a:gd name="T10" fmla="*/ 109 w 596"/>
                <a:gd name="T11" fmla="*/ 535 h 747"/>
                <a:gd name="T12" fmla="*/ 109 w 596"/>
                <a:gd name="T13" fmla="*/ 252 h 747"/>
                <a:gd name="T14" fmla="*/ 105 w 596"/>
                <a:gd name="T15" fmla="*/ 112 h 747"/>
                <a:gd name="T16" fmla="*/ 98 w 596"/>
                <a:gd name="T17" fmla="*/ 52 h 747"/>
                <a:gd name="T18" fmla="*/ 78 w 596"/>
                <a:gd name="T19" fmla="*/ 39 h 747"/>
                <a:gd name="T20" fmla="*/ 0 w 596"/>
                <a:gd name="T21" fmla="*/ 33 h 747"/>
                <a:gd name="T22" fmla="*/ 0 w 596"/>
                <a:gd name="T23" fmla="*/ 0 h 747"/>
                <a:gd name="T24" fmla="*/ 165 w 596"/>
                <a:gd name="T25" fmla="*/ 3 h 747"/>
                <a:gd name="T26" fmla="*/ 323 w 596"/>
                <a:gd name="T27" fmla="*/ 0 h 747"/>
                <a:gd name="T28" fmla="*/ 323 w 596"/>
                <a:gd name="T29" fmla="*/ 33 h 747"/>
                <a:gd name="T30" fmla="*/ 243 w 596"/>
                <a:gd name="T31" fmla="*/ 39 h 747"/>
                <a:gd name="T32" fmla="*/ 224 w 596"/>
                <a:gd name="T33" fmla="*/ 51 h 747"/>
                <a:gd name="T34" fmla="*/ 216 w 596"/>
                <a:gd name="T35" fmla="*/ 102 h 747"/>
                <a:gd name="T36" fmla="*/ 213 w 596"/>
                <a:gd name="T37" fmla="*/ 252 h 747"/>
                <a:gd name="T38" fmla="*/ 213 w 596"/>
                <a:gd name="T39" fmla="*/ 606 h 747"/>
                <a:gd name="T40" fmla="*/ 216 w 596"/>
                <a:gd name="T41" fmla="*/ 696 h 747"/>
                <a:gd name="T42" fmla="*/ 303 w 596"/>
                <a:gd name="T43" fmla="*/ 700 h 747"/>
                <a:gd name="T44" fmla="*/ 525 w 596"/>
                <a:gd name="T45" fmla="*/ 681 h 747"/>
                <a:gd name="T46" fmla="*/ 538 w 596"/>
                <a:gd name="T47" fmla="*/ 644 h 747"/>
                <a:gd name="T48" fmla="*/ 560 w 596"/>
                <a:gd name="T49" fmla="*/ 557 h 747"/>
                <a:gd name="T50" fmla="*/ 596 w 596"/>
                <a:gd name="T51" fmla="*/ 557 h 747"/>
                <a:gd name="T52" fmla="*/ 573 w 596"/>
                <a:gd name="T53" fmla="*/ 741 h 747"/>
                <a:gd name="T54" fmla="*/ 537 w 596"/>
                <a:gd name="T55" fmla="*/ 746 h 747"/>
                <a:gd name="T56" fmla="*/ 449 w 596"/>
                <a:gd name="T57" fmla="*/ 747 h 747"/>
                <a:gd name="T58" fmla="*/ 156 w 596"/>
                <a:gd name="T59" fmla="*/ 744 h 747"/>
                <a:gd name="T60" fmla="*/ 49 w 596"/>
                <a:gd name="T61" fmla="*/ 747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Lst>
              <a:rect l="0" t="0" r="r" b="b"/>
              <a:pathLst>
                <a:path w="596" h="747">
                  <a:moveTo>
                    <a:pt x="49" y="747"/>
                  </a:moveTo>
                  <a:cubicBezTo>
                    <a:pt x="49" y="721"/>
                    <a:pt x="49" y="721"/>
                    <a:pt x="49" y="721"/>
                  </a:cubicBezTo>
                  <a:cubicBezTo>
                    <a:pt x="71" y="710"/>
                    <a:pt x="85" y="702"/>
                    <a:pt x="91" y="696"/>
                  </a:cubicBezTo>
                  <a:cubicBezTo>
                    <a:pt x="95" y="693"/>
                    <a:pt x="98" y="689"/>
                    <a:pt x="99" y="684"/>
                  </a:cubicBezTo>
                  <a:cubicBezTo>
                    <a:pt x="102" y="675"/>
                    <a:pt x="104" y="654"/>
                    <a:pt x="105" y="621"/>
                  </a:cubicBezTo>
                  <a:cubicBezTo>
                    <a:pt x="108" y="573"/>
                    <a:pt x="109" y="545"/>
                    <a:pt x="109" y="535"/>
                  </a:cubicBezTo>
                  <a:cubicBezTo>
                    <a:pt x="109" y="252"/>
                    <a:pt x="109" y="252"/>
                    <a:pt x="109" y="252"/>
                  </a:cubicBezTo>
                  <a:cubicBezTo>
                    <a:pt x="109" y="204"/>
                    <a:pt x="108" y="157"/>
                    <a:pt x="105" y="112"/>
                  </a:cubicBezTo>
                  <a:cubicBezTo>
                    <a:pt x="104" y="78"/>
                    <a:pt x="102" y="59"/>
                    <a:pt x="98" y="52"/>
                  </a:cubicBezTo>
                  <a:cubicBezTo>
                    <a:pt x="93" y="46"/>
                    <a:pt x="87" y="42"/>
                    <a:pt x="78" y="39"/>
                  </a:cubicBezTo>
                  <a:cubicBezTo>
                    <a:pt x="69" y="36"/>
                    <a:pt x="43" y="34"/>
                    <a:pt x="0" y="33"/>
                  </a:cubicBezTo>
                  <a:cubicBezTo>
                    <a:pt x="0" y="0"/>
                    <a:pt x="0" y="0"/>
                    <a:pt x="0" y="0"/>
                  </a:cubicBezTo>
                  <a:cubicBezTo>
                    <a:pt x="89" y="2"/>
                    <a:pt x="144" y="3"/>
                    <a:pt x="165" y="3"/>
                  </a:cubicBezTo>
                  <a:cubicBezTo>
                    <a:pt x="189" y="3"/>
                    <a:pt x="241" y="2"/>
                    <a:pt x="323" y="0"/>
                  </a:cubicBezTo>
                  <a:cubicBezTo>
                    <a:pt x="323" y="33"/>
                    <a:pt x="323" y="33"/>
                    <a:pt x="323" y="33"/>
                  </a:cubicBezTo>
                  <a:cubicBezTo>
                    <a:pt x="279" y="34"/>
                    <a:pt x="253" y="36"/>
                    <a:pt x="243" y="39"/>
                  </a:cubicBezTo>
                  <a:cubicBezTo>
                    <a:pt x="234" y="42"/>
                    <a:pt x="228" y="46"/>
                    <a:pt x="224" y="51"/>
                  </a:cubicBezTo>
                  <a:cubicBezTo>
                    <a:pt x="220" y="58"/>
                    <a:pt x="217" y="75"/>
                    <a:pt x="216" y="102"/>
                  </a:cubicBezTo>
                  <a:cubicBezTo>
                    <a:pt x="215" y="109"/>
                    <a:pt x="214" y="159"/>
                    <a:pt x="213" y="252"/>
                  </a:cubicBezTo>
                  <a:cubicBezTo>
                    <a:pt x="213" y="606"/>
                    <a:pt x="213" y="606"/>
                    <a:pt x="213" y="606"/>
                  </a:cubicBezTo>
                  <a:cubicBezTo>
                    <a:pt x="213" y="643"/>
                    <a:pt x="214" y="673"/>
                    <a:pt x="216" y="696"/>
                  </a:cubicBezTo>
                  <a:cubicBezTo>
                    <a:pt x="257" y="699"/>
                    <a:pt x="262" y="700"/>
                    <a:pt x="303" y="700"/>
                  </a:cubicBezTo>
                  <a:cubicBezTo>
                    <a:pt x="407" y="700"/>
                    <a:pt x="484" y="693"/>
                    <a:pt x="525" y="681"/>
                  </a:cubicBezTo>
                  <a:cubicBezTo>
                    <a:pt x="530" y="670"/>
                    <a:pt x="534" y="658"/>
                    <a:pt x="538" y="644"/>
                  </a:cubicBezTo>
                  <a:cubicBezTo>
                    <a:pt x="560" y="557"/>
                    <a:pt x="560" y="557"/>
                    <a:pt x="560" y="557"/>
                  </a:cubicBezTo>
                  <a:cubicBezTo>
                    <a:pt x="596" y="557"/>
                    <a:pt x="596" y="557"/>
                    <a:pt x="596" y="557"/>
                  </a:cubicBezTo>
                  <a:cubicBezTo>
                    <a:pt x="588" y="609"/>
                    <a:pt x="580" y="671"/>
                    <a:pt x="573" y="741"/>
                  </a:cubicBezTo>
                  <a:cubicBezTo>
                    <a:pt x="558" y="744"/>
                    <a:pt x="546" y="745"/>
                    <a:pt x="537" y="746"/>
                  </a:cubicBezTo>
                  <a:cubicBezTo>
                    <a:pt x="518" y="747"/>
                    <a:pt x="488" y="747"/>
                    <a:pt x="449" y="747"/>
                  </a:cubicBezTo>
                  <a:cubicBezTo>
                    <a:pt x="156" y="744"/>
                    <a:pt x="156" y="744"/>
                    <a:pt x="156" y="744"/>
                  </a:cubicBezTo>
                  <a:cubicBezTo>
                    <a:pt x="121" y="744"/>
                    <a:pt x="85" y="745"/>
                    <a:pt x="49"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1" name="Freeform 7"/>
            <p:cNvSpPr>
              <a:spLocks/>
            </p:cNvSpPr>
            <p:nvPr userDrawn="1"/>
          </p:nvSpPr>
          <p:spPr bwMode="auto">
            <a:xfrm>
              <a:off x="1127125" y="1003301"/>
              <a:ext cx="103188" cy="236538"/>
            </a:xfrm>
            <a:custGeom>
              <a:avLst/>
              <a:gdLst>
                <a:gd name="T0" fmla="*/ 321 w 321"/>
                <a:gd name="T1" fmla="*/ 714 h 747"/>
                <a:gd name="T2" fmla="*/ 321 w 321"/>
                <a:gd name="T3" fmla="*/ 747 h 747"/>
                <a:gd name="T4" fmla="*/ 168 w 321"/>
                <a:gd name="T5" fmla="*/ 744 h 747"/>
                <a:gd name="T6" fmla="*/ 0 w 321"/>
                <a:gd name="T7" fmla="*/ 747 h 747"/>
                <a:gd name="T8" fmla="*/ 0 w 321"/>
                <a:gd name="T9" fmla="*/ 714 h 747"/>
                <a:gd name="T10" fmla="*/ 77 w 321"/>
                <a:gd name="T11" fmla="*/ 708 h 747"/>
                <a:gd name="T12" fmla="*/ 97 w 321"/>
                <a:gd name="T13" fmla="*/ 696 h 747"/>
                <a:gd name="T14" fmla="*/ 105 w 321"/>
                <a:gd name="T15" fmla="*/ 645 h 747"/>
                <a:gd name="T16" fmla="*/ 108 w 321"/>
                <a:gd name="T17" fmla="*/ 495 h 747"/>
                <a:gd name="T18" fmla="*/ 108 w 321"/>
                <a:gd name="T19" fmla="*/ 251 h 747"/>
                <a:gd name="T20" fmla="*/ 105 w 321"/>
                <a:gd name="T21" fmla="*/ 111 h 747"/>
                <a:gd name="T22" fmla="*/ 97 w 321"/>
                <a:gd name="T23" fmla="*/ 52 h 747"/>
                <a:gd name="T24" fmla="*/ 77 w 321"/>
                <a:gd name="T25" fmla="*/ 39 h 747"/>
                <a:gd name="T26" fmla="*/ 0 w 321"/>
                <a:gd name="T27" fmla="*/ 33 h 747"/>
                <a:gd name="T28" fmla="*/ 0 w 321"/>
                <a:gd name="T29" fmla="*/ 0 h 747"/>
                <a:gd name="T30" fmla="*/ 161 w 321"/>
                <a:gd name="T31" fmla="*/ 3 h 747"/>
                <a:gd name="T32" fmla="*/ 321 w 321"/>
                <a:gd name="T33" fmla="*/ 0 h 747"/>
                <a:gd name="T34" fmla="*/ 321 w 321"/>
                <a:gd name="T35" fmla="*/ 33 h 747"/>
                <a:gd name="T36" fmla="*/ 243 w 321"/>
                <a:gd name="T37" fmla="*/ 39 h 747"/>
                <a:gd name="T38" fmla="*/ 224 w 321"/>
                <a:gd name="T39" fmla="*/ 51 h 747"/>
                <a:gd name="T40" fmla="*/ 216 w 321"/>
                <a:gd name="T41" fmla="*/ 102 h 747"/>
                <a:gd name="T42" fmla="*/ 212 w 321"/>
                <a:gd name="T43" fmla="*/ 251 h 747"/>
                <a:gd name="T44" fmla="*/ 212 w 321"/>
                <a:gd name="T45" fmla="*/ 495 h 747"/>
                <a:gd name="T46" fmla="*/ 214 w 321"/>
                <a:gd name="T47" fmla="*/ 635 h 747"/>
                <a:gd name="T48" fmla="*/ 222 w 321"/>
                <a:gd name="T49" fmla="*/ 694 h 747"/>
                <a:gd name="T50" fmla="*/ 242 w 321"/>
                <a:gd name="T51" fmla="*/ 708 h 747"/>
                <a:gd name="T52" fmla="*/ 321 w 321"/>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1" h="747">
                  <a:moveTo>
                    <a:pt x="321" y="714"/>
                  </a:moveTo>
                  <a:cubicBezTo>
                    <a:pt x="321" y="747"/>
                    <a:pt x="321" y="747"/>
                    <a:pt x="321" y="747"/>
                  </a:cubicBezTo>
                  <a:cubicBezTo>
                    <a:pt x="244" y="745"/>
                    <a:pt x="193" y="744"/>
                    <a:pt x="168" y="744"/>
                  </a:cubicBezTo>
                  <a:cubicBezTo>
                    <a:pt x="0" y="747"/>
                    <a:pt x="0" y="747"/>
                    <a:pt x="0" y="747"/>
                  </a:cubicBezTo>
                  <a:cubicBezTo>
                    <a:pt x="0" y="714"/>
                    <a:pt x="0" y="714"/>
                    <a:pt x="0" y="714"/>
                  </a:cubicBezTo>
                  <a:cubicBezTo>
                    <a:pt x="42" y="713"/>
                    <a:pt x="68" y="711"/>
                    <a:pt x="77" y="708"/>
                  </a:cubicBezTo>
                  <a:cubicBezTo>
                    <a:pt x="87" y="705"/>
                    <a:pt x="93" y="701"/>
                    <a:pt x="97" y="696"/>
                  </a:cubicBezTo>
                  <a:cubicBezTo>
                    <a:pt x="101" y="689"/>
                    <a:pt x="104" y="672"/>
                    <a:pt x="105" y="645"/>
                  </a:cubicBezTo>
                  <a:cubicBezTo>
                    <a:pt x="106" y="637"/>
                    <a:pt x="107" y="587"/>
                    <a:pt x="108" y="495"/>
                  </a:cubicBezTo>
                  <a:cubicBezTo>
                    <a:pt x="108" y="251"/>
                    <a:pt x="108" y="251"/>
                    <a:pt x="108" y="251"/>
                  </a:cubicBezTo>
                  <a:cubicBezTo>
                    <a:pt x="108" y="204"/>
                    <a:pt x="107" y="157"/>
                    <a:pt x="105" y="111"/>
                  </a:cubicBezTo>
                  <a:cubicBezTo>
                    <a:pt x="104" y="78"/>
                    <a:pt x="102" y="59"/>
                    <a:pt x="97" y="52"/>
                  </a:cubicBezTo>
                  <a:cubicBezTo>
                    <a:pt x="93" y="46"/>
                    <a:pt x="87" y="41"/>
                    <a:pt x="77" y="39"/>
                  </a:cubicBezTo>
                  <a:cubicBezTo>
                    <a:pt x="68" y="36"/>
                    <a:pt x="42" y="34"/>
                    <a:pt x="0" y="33"/>
                  </a:cubicBezTo>
                  <a:cubicBezTo>
                    <a:pt x="0" y="0"/>
                    <a:pt x="0" y="0"/>
                    <a:pt x="0" y="0"/>
                  </a:cubicBezTo>
                  <a:cubicBezTo>
                    <a:pt x="69" y="2"/>
                    <a:pt x="123" y="3"/>
                    <a:pt x="161" y="3"/>
                  </a:cubicBezTo>
                  <a:cubicBezTo>
                    <a:pt x="197" y="3"/>
                    <a:pt x="250" y="2"/>
                    <a:pt x="321" y="0"/>
                  </a:cubicBezTo>
                  <a:cubicBezTo>
                    <a:pt x="321" y="33"/>
                    <a:pt x="321" y="33"/>
                    <a:pt x="321" y="33"/>
                  </a:cubicBezTo>
                  <a:cubicBezTo>
                    <a:pt x="278" y="34"/>
                    <a:pt x="252" y="36"/>
                    <a:pt x="243" y="39"/>
                  </a:cubicBezTo>
                  <a:cubicBezTo>
                    <a:pt x="234" y="41"/>
                    <a:pt x="227" y="46"/>
                    <a:pt x="224" y="51"/>
                  </a:cubicBezTo>
                  <a:cubicBezTo>
                    <a:pt x="219" y="58"/>
                    <a:pt x="217" y="75"/>
                    <a:pt x="216" y="102"/>
                  </a:cubicBezTo>
                  <a:cubicBezTo>
                    <a:pt x="215" y="109"/>
                    <a:pt x="214" y="159"/>
                    <a:pt x="212" y="251"/>
                  </a:cubicBezTo>
                  <a:cubicBezTo>
                    <a:pt x="212" y="495"/>
                    <a:pt x="212" y="495"/>
                    <a:pt x="212" y="495"/>
                  </a:cubicBezTo>
                  <a:cubicBezTo>
                    <a:pt x="212" y="543"/>
                    <a:pt x="213" y="589"/>
                    <a:pt x="214" y="635"/>
                  </a:cubicBezTo>
                  <a:cubicBezTo>
                    <a:pt x="215" y="668"/>
                    <a:pt x="218" y="688"/>
                    <a:pt x="222" y="694"/>
                  </a:cubicBezTo>
                  <a:cubicBezTo>
                    <a:pt x="226" y="700"/>
                    <a:pt x="233" y="705"/>
                    <a:pt x="242" y="708"/>
                  </a:cubicBezTo>
                  <a:cubicBezTo>
                    <a:pt x="251" y="711"/>
                    <a:pt x="278" y="713"/>
                    <a:pt x="321"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2" name="Freeform 8"/>
            <p:cNvSpPr>
              <a:spLocks/>
            </p:cNvSpPr>
            <p:nvPr userDrawn="1"/>
          </p:nvSpPr>
          <p:spPr bwMode="auto">
            <a:xfrm>
              <a:off x="1266825" y="1003301"/>
              <a:ext cx="276225" cy="242888"/>
            </a:xfrm>
            <a:custGeom>
              <a:avLst/>
              <a:gdLst>
                <a:gd name="T0" fmla="*/ 5 w 869"/>
                <a:gd name="T1" fmla="*/ 747 h 766"/>
                <a:gd name="T2" fmla="*/ 5 w 869"/>
                <a:gd name="T3" fmla="*/ 714 h 766"/>
                <a:gd name="T4" fmla="*/ 80 w 869"/>
                <a:gd name="T5" fmla="*/ 705 h 766"/>
                <a:gd name="T6" fmla="*/ 91 w 869"/>
                <a:gd name="T7" fmla="*/ 695 h 766"/>
                <a:gd name="T8" fmla="*/ 99 w 869"/>
                <a:gd name="T9" fmla="*/ 640 h 766"/>
                <a:gd name="T10" fmla="*/ 102 w 869"/>
                <a:gd name="T11" fmla="*/ 520 h 766"/>
                <a:gd name="T12" fmla="*/ 102 w 869"/>
                <a:gd name="T13" fmla="*/ 92 h 766"/>
                <a:gd name="T14" fmla="*/ 100 w 869"/>
                <a:gd name="T15" fmla="*/ 69 h 766"/>
                <a:gd name="T16" fmla="*/ 80 w 869"/>
                <a:gd name="T17" fmla="*/ 47 h 766"/>
                <a:gd name="T18" fmla="*/ 57 w 869"/>
                <a:gd name="T19" fmla="*/ 36 h 766"/>
                <a:gd name="T20" fmla="*/ 0 w 869"/>
                <a:gd name="T21" fmla="*/ 33 h 766"/>
                <a:gd name="T22" fmla="*/ 0 w 869"/>
                <a:gd name="T23" fmla="*/ 0 h 766"/>
                <a:gd name="T24" fmla="*/ 119 w 869"/>
                <a:gd name="T25" fmla="*/ 3 h 766"/>
                <a:gd name="T26" fmla="*/ 202 w 869"/>
                <a:gd name="T27" fmla="*/ 0 h 766"/>
                <a:gd name="T28" fmla="*/ 269 w 869"/>
                <a:gd name="T29" fmla="*/ 86 h 766"/>
                <a:gd name="T30" fmla="*/ 381 w 869"/>
                <a:gd name="T31" fmla="*/ 220 h 766"/>
                <a:gd name="T32" fmla="*/ 545 w 869"/>
                <a:gd name="T33" fmla="*/ 411 h 766"/>
                <a:gd name="T34" fmla="*/ 671 w 869"/>
                <a:gd name="T35" fmla="*/ 554 h 766"/>
                <a:gd name="T36" fmla="*/ 721 w 869"/>
                <a:gd name="T37" fmla="*/ 609 h 766"/>
                <a:gd name="T38" fmla="*/ 721 w 869"/>
                <a:gd name="T39" fmla="*/ 226 h 766"/>
                <a:gd name="T40" fmla="*/ 718 w 869"/>
                <a:gd name="T41" fmla="*/ 105 h 766"/>
                <a:gd name="T42" fmla="*/ 711 w 869"/>
                <a:gd name="T43" fmla="*/ 51 h 766"/>
                <a:gd name="T44" fmla="*/ 699 w 869"/>
                <a:gd name="T45" fmla="*/ 41 h 766"/>
                <a:gd name="T46" fmla="*/ 624 w 869"/>
                <a:gd name="T47" fmla="*/ 33 h 766"/>
                <a:gd name="T48" fmla="*/ 624 w 869"/>
                <a:gd name="T49" fmla="*/ 0 h 766"/>
                <a:gd name="T50" fmla="*/ 756 w 869"/>
                <a:gd name="T51" fmla="*/ 3 h 766"/>
                <a:gd name="T52" fmla="*/ 869 w 869"/>
                <a:gd name="T53" fmla="*/ 0 h 766"/>
                <a:gd name="T54" fmla="*/ 869 w 869"/>
                <a:gd name="T55" fmla="*/ 33 h 766"/>
                <a:gd name="T56" fmla="*/ 794 w 869"/>
                <a:gd name="T57" fmla="*/ 41 h 766"/>
                <a:gd name="T58" fmla="*/ 783 w 869"/>
                <a:gd name="T59" fmla="*/ 52 h 766"/>
                <a:gd name="T60" fmla="*/ 775 w 869"/>
                <a:gd name="T61" fmla="*/ 107 h 766"/>
                <a:gd name="T62" fmla="*/ 772 w 869"/>
                <a:gd name="T63" fmla="*/ 226 h 766"/>
                <a:gd name="T64" fmla="*/ 772 w 869"/>
                <a:gd name="T65" fmla="*/ 479 h 766"/>
                <a:gd name="T66" fmla="*/ 775 w 869"/>
                <a:gd name="T67" fmla="*/ 766 h 766"/>
                <a:gd name="T68" fmla="*/ 721 w 869"/>
                <a:gd name="T69" fmla="*/ 766 h 766"/>
                <a:gd name="T70" fmla="*/ 707 w 869"/>
                <a:gd name="T71" fmla="*/ 752 h 766"/>
                <a:gd name="T72" fmla="*/ 698 w 869"/>
                <a:gd name="T73" fmla="*/ 744 h 766"/>
                <a:gd name="T74" fmla="*/ 678 w 869"/>
                <a:gd name="T75" fmla="*/ 723 h 766"/>
                <a:gd name="T76" fmla="*/ 611 w 869"/>
                <a:gd name="T77" fmla="*/ 647 h 766"/>
                <a:gd name="T78" fmla="*/ 540 w 869"/>
                <a:gd name="T79" fmla="*/ 560 h 766"/>
                <a:gd name="T80" fmla="*/ 151 w 869"/>
                <a:gd name="T81" fmla="*/ 110 h 766"/>
                <a:gd name="T82" fmla="*/ 151 w 869"/>
                <a:gd name="T83" fmla="*/ 518 h 766"/>
                <a:gd name="T84" fmla="*/ 154 w 869"/>
                <a:gd name="T85" fmla="*/ 641 h 766"/>
                <a:gd name="T86" fmla="*/ 161 w 869"/>
                <a:gd name="T87" fmla="*/ 695 h 766"/>
                <a:gd name="T88" fmla="*/ 173 w 869"/>
                <a:gd name="T89" fmla="*/ 705 h 766"/>
                <a:gd name="T90" fmla="*/ 249 w 869"/>
                <a:gd name="T91" fmla="*/ 714 h 766"/>
                <a:gd name="T92" fmla="*/ 249 w 869"/>
                <a:gd name="T93" fmla="*/ 747 h 766"/>
                <a:gd name="T94" fmla="*/ 143 w 869"/>
                <a:gd name="T95" fmla="*/ 744 h 766"/>
                <a:gd name="T96" fmla="*/ 5 w 869"/>
                <a:gd name="T97" fmla="*/ 747 h 76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869" h="766">
                  <a:moveTo>
                    <a:pt x="5" y="747"/>
                  </a:moveTo>
                  <a:cubicBezTo>
                    <a:pt x="5" y="714"/>
                    <a:pt x="5" y="714"/>
                    <a:pt x="5" y="714"/>
                  </a:cubicBezTo>
                  <a:cubicBezTo>
                    <a:pt x="43" y="714"/>
                    <a:pt x="68" y="711"/>
                    <a:pt x="80" y="705"/>
                  </a:cubicBezTo>
                  <a:cubicBezTo>
                    <a:pt x="86" y="703"/>
                    <a:pt x="89" y="700"/>
                    <a:pt x="91" y="695"/>
                  </a:cubicBezTo>
                  <a:cubicBezTo>
                    <a:pt x="95" y="688"/>
                    <a:pt x="98" y="670"/>
                    <a:pt x="99" y="640"/>
                  </a:cubicBezTo>
                  <a:cubicBezTo>
                    <a:pt x="101" y="594"/>
                    <a:pt x="102" y="554"/>
                    <a:pt x="102" y="520"/>
                  </a:cubicBezTo>
                  <a:cubicBezTo>
                    <a:pt x="102" y="92"/>
                    <a:pt x="102" y="92"/>
                    <a:pt x="102" y="92"/>
                  </a:cubicBezTo>
                  <a:cubicBezTo>
                    <a:pt x="102" y="80"/>
                    <a:pt x="102" y="73"/>
                    <a:pt x="100" y="69"/>
                  </a:cubicBezTo>
                  <a:cubicBezTo>
                    <a:pt x="97" y="63"/>
                    <a:pt x="91" y="56"/>
                    <a:pt x="80" y="47"/>
                  </a:cubicBezTo>
                  <a:cubicBezTo>
                    <a:pt x="74" y="41"/>
                    <a:pt x="66" y="38"/>
                    <a:pt x="57" y="36"/>
                  </a:cubicBezTo>
                  <a:cubicBezTo>
                    <a:pt x="49" y="34"/>
                    <a:pt x="30" y="33"/>
                    <a:pt x="0" y="33"/>
                  </a:cubicBezTo>
                  <a:cubicBezTo>
                    <a:pt x="0" y="0"/>
                    <a:pt x="0" y="0"/>
                    <a:pt x="0" y="0"/>
                  </a:cubicBezTo>
                  <a:cubicBezTo>
                    <a:pt x="63" y="2"/>
                    <a:pt x="103" y="3"/>
                    <a:pt x="119" y="3"/>
                  </a:cubicBezTo>
                  <a:cubicBezTo>
                    <a:pt x="147" y="3"/>
                    <a:pt x="174" y="2"/>
                    <a:pt x="202" y="0"/>
                  </a:cubicBezTo>
                  <a:cubicBezTo>
                    <a:pt x="232" y="39"/>
                    <a:pt x="255" y="67"/>
                    <a:pt x="269" y="86"/>
                  </a:cubicBezTo>
                  <a:cubicBezTo>
                    <a:pt x="381" y="220"/>
                    <a:pt x="381" y="220"/>
                    <a:pt x="381" y="220"/>
                  </a:cubicBezTo>
                  <a:cubicBezTo>
                    <a:pt x="545" y="411"/>
                    <a:pt x="545" y="411"/>
                    <a:pt x="545" y="411"/>
                  </a:cubicBezTo>
                  <a:cubicBezTo>
                    <a:pt x="597" y="472"/>
                    <a:pt x="639" y="520"/>
                    <a:pt x="671" y="554"/>
                  </a:cubicBezTo>
                  <a:cubicBezTo>
                    <a:pt x="691" y="578"/>
                    <a:pt x="708" y="596"/>
                    <a:pt x="721" y="609"/>
                  </a:cubicBezTo>
                  <a:cubicBezTo>
                    <a:pt x="721" y="226"/>
                    <a:pt x="721" y="226"/>
                    <a:pt x="721" y="226"/>
                  </a:cubicBezTo>
                  <a:cubicBezTo>
                    <a:pt x="721" y="191"/>
                    <a:pt x="720" y="151"/>
                    <a:pt x="718" y="105"/>
                  </a:cubicBezTo>
                  <a:cubicBezTo>
                    <a:pt x="717" y="76"/>
                    <a:pt x="714" y="58"/>
                    <a:pt x="711" y="51"/>
                  </a:cubicBezTo>
                  <a:cubicBezTo>
                    <a:pt x="708" y="46"/>
                    <a:pt x="705" y="43"/>
                    <a:pt x="699" y="41"/>
                  </a:cubicBezTo>
                  <a:cubicBezTo>
                    <a:pt x="687" y="36"/>
                    <a:pt x="662" y="33"/>
                    <a:pt x="624" y="33"/>
                  </a:cubicBezTo>
                  <a:cubicBezTo>
                    <a:pt x="624" y="0"/>
                    <a:pt x="624" y="0"/>
                    <a:pt x="624" y="0"/>
                  </a:cubicBezTo>
                  <a:cubicBezTo>
                    <a:pt x="667" y="2"/>
                    <a:pt x="711" y="3"/>
                    <a:pt x="756" y="3"/>
                  </a:cubicBezTo>
                  <a:cubicBezTo>
                    <a:pt x="797" y="3"/>
                    <a:pt x="835" y="2"/>
                    <a:pt x="869" y="0"/>
                  </a:cubicBezTo>
                  <a:cubicBezTo>
                    <a:pt x="869" y="33"/>
                    <a:pt x="869" y="33"/>
                    <a:pt x="869" y="33"/>
                  </a:cubicBezTo>
                  <a:cubicBezTo>
                    <a:pt x="831" y="33"/>
                    <a:pt x="806" y="36"/>
                    <a:pt x="794" y="41"/>
                  </a:cubicBezTo>
                  <a:cubicBezTo>
                    <a:pt x="789" y="43"/>
                    <a:pt x="785" y="47"/>
                    <a:pt x="783" y="52"/>
                  </a:cubicBezTo>
                  <a:cubicBezTo>
                    <a:pt x="779" y="58"/>
                    <a:pt x="776" y="77"/>
                    <a:pt x="775" y="107"/>
                  </a:cubicBezTo>
                  <a:cubicBezTo>
                    <a:pt x="773" y="153"/>
                    <a:pt x="772" y="193"/>
                    <a:pt x="772" y="226"/>
                  </a:cubicBezTo>
                  <a:cubicBezTo>
                    <a:pt x="772" y="479"/>
                    <a:pt x="772" y="479"/>
                    <a:pt x="772" y="479"/>
                  </a:cubicBezTo>
                  <a:cubicBezTo>
                    <a:pt x="772" y="531"/>
                    <a:pt x="773" y="626"/>
                    <a:pt x="775" y="766"/>
                  </a:cubicBezTo>
                  <a:cubicBezTo>
                    <a:pt x="721" y="766"/>
                    <a:pt x="721" y="766"/>
                    <a:pt x="721" y="766"/>
                  </a:cubicBezTo>
                  <a:cubicBezTo>
                    <a:pt x="707" y="752"/>
                    <a:pt x="707" y="752"/>
                    <a:pt x="707" y="752"/>
                  </a:cubicBezTo>
                  <a:cubicBezTo>
                    <a:pt x="705" y="751"/>
                    <a:pt x="700" y="746"/>
                    <a:pt x="698" y="744"/>
                  </a:cubicBezTo>
                  <a:cubicBezTo>
                    <a:pt x="696" y="742"/>
                    <a:pt x="689" y="735"/>
                    <a:pt x="678" y="723"/>
                  </a:cubicBezTo>
                  <a:cubicBezTo>
                    <a:pt x="647" y="689"/>
                    <a:pt x="625" y="664"/>
                    <a:pt x="611" y="647"/>
                  </a:cubicBezTo>
                  <a:cubicBezTo>
                    <a:pt x="540" y="560"/>
                    <a:pt x="540" y="560"/>
                    <a:pt x="540" y="560"/>
                  </a:cubicBezTo>
                  <a:cubicBezTo>
                    <a:pt x="151" y="110"/>
                    <a:pt x="151" y="110"/>
                    <a:pt x="151" y="110"/>
                  </a:cubicBezTo>
                  <a:cubicBezTo>
                    <a:pt x="151" y="518"/>
                    <a:pt x="151" y="518"/>
                    <a:pt x="151" y="518"/>
                  </a:cubicBezTo>
                  <a:cubicBezTo>
                    <a:pt x="151" y="552"/>
                    <a:pt x="152" y="593"/>
                    <a:pt x="154" y="641"/>
                  </a:cubicBezTo>
                  <a:cubicBezTo>
                    <a:pt x="156" y="670"/>
                    <a:pt x="158" y="688"/>
                    <a:pt x="161" y="695"/>
                  </a:cubicBezTo>
                  <a:cubicBezTo>
                    <a:pt x="164" y="700"/>
                    <a:pt x="168" y="704"/>
                    <a:pt x="173" y="705"/>
                  </a:cubicBezTo>
                  <a:cubicBezTo>
                    <a:pt x="185" y="711"/>
                    <a:pt x="210" y="714"/>
                    <a:pt x="249" y="714"/>
                  </a:cubicBezTo>
                  <a:cubicBezTo>
                    <a:pt x="249" y="747"/>
                    <a:pt x="249" y="747"/>
                    <a:pt x="249" y="747"/>
                  </a:cubicBezTo>
                  <a:cubicBezTo>
                    <a:pt x="217" y="745"/>
                    <a:pt x="181" y="744"/>
                    <a:pt x="143" y="744"/>
                  </a:cubicBezTo>
                  <a:cubicBezTo>
                    <a:pt x="100" y="744"/>
                    <a:pt x="54" y="745"/>
                    <a:pt x="5"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3" name="Freeform 9"/>
            <p:cNvSpPr>
              <a:spLocks/>
            </p:cNvSpPr>
            <p:nvPr userDrawn="1"/>
          </p:nvSpPr>
          <p:spPr bwMode="auto">
            <a:xfrm>
              <a:off x="1573213" y="1003301"/>
              <a:ext cx="101600" cy="236538"/>
            </a:xfrm>
            <a:custGeom>
              <a:avLst/>
              <a:gdLst>
                <a:gd name="T0" fmla="*/ 322 w 322"/>
                <a:gd name="T1" fmla="*/ 714 h 747"/>
                <a:gd name="T2" fmla="*/ 322 w 322"/>
                <a:gd name="T3" fmla="*/ 747 h 747"/>
                <a:gd name="T4" fmla="*/ 169 w 322"/>
                <a:gd name="T5" fmla="*/ 744 h 747"/>
                <a:gd name="T6" fmla="*/ 0 w 322"/>
                <a:gd name="T7" fmla="*/ 747 h 747"/>
                <a:gd name="T8" fmla="*/ 0 w 322"/>
                <a:gd name="T9" fmla="*/ 714 h 747"/>
                <a:gd name="T10" fmla="*/ 79 w 322"/>
                <a:gd name="T11" fmla="*/ 708 h 747"/>
                <a:gd name="T12" fmla="*/ 98 w 322"/>
                <a:gd name="T13" fmla="*/ 696 h 747"/>
                <a:gd name="T14" fmla="*/ 106 w 322"/>
                <a:gd name="T15" fmla="*/ 645 h 747"/>
                <a:gd name="T16" fmla="*/ 109 w 322"/>
                <a:gd name="T17" fmla="*/ 495 h 747"/>
                <a:gd name="T18" fmla="*/ 109 w 322"/>
                <a:gd name="T19" fmla="*/ 251 h 747"/>
                <a:gd name="T20" fmla="*/ 106 w 322"/>
                <a:gd name="T21" fmla="*/ 111 h 747"/>
                <a:gd name="T22" fmla="*/ 98 w 322"/>
                <a:gd name="T23" fmla="*/ 52 h 747"/>
                <a:gd name="T24" fmla="*/ 78 w 322"/>
                <a:gd name="T25" fmla="*/ 39 h 747"/>
                <a:gd name="T26" fmla="*/ 0 w 322"/>
                <a:gd name="T27" fmla="*/ 33 h 747"/>
                <a:gd name="T28" fmla="*/ 0 w 322"/>
                <a:gd name="T29" fmla="*/ 0 h 747"/>
                <a:gd name="T30" fmla="*/ 161 w 322"/>
                <a:gd name="T31" fmla="*/ 3 h 747"/>
                <a:gd name="T32" fmla="*/ 322 w 322"/>
                <a:gd name="T33" fmla="*/ 0 h 747"/>
                <a:gd name="T34" fmla="*/ 322 w 322"/>
                <a:gd name="T35" fmla="*/ 33 h 747"/>
                <a:gd name="T36" fmla="*/ 244 w 322"/>
                <a:gd name="T37" fmla="*/ 39 h 747"/>
                <a:gd name="T38" fmla="*/ 224 w 322"/>
                <a:gd name="T39" fmla="*/ 51 h 747"/>
                <a:gd name="T40" fmla="*/ 216 w 322"/>
                <a:gd name="T41" fmla="*/ 102 h 747"/>
                <a:gd name="T42" fmla="*/ 213 w 322"/>
                <a:gd name="T43" fmla="*/ 251 h 747"/>
                <a:gd name="T44" fmla="*/ 213 w 322"/>
                <a:gd name="T45" fmla="*/ 495 h 747"/>
                <a:gd name="T46" fmla="*/ 215 w 322"/>
                <a:gd name="T47" fmla="*/ 635 h 747"/>
                <a:gd name="T48" fmla="*/ 223 w 322"/>
                <a:gd name="T49" fmla="*/ 694 h 747"/>
                <a:gd name="T50" fmla="*/ 243 w 322"/>
                <a:gd name="T51" fmla="*/ 708 h 747"/>
                <a:gd name="T52" fmla="*/ 322 w 322"/>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2" h="747">
                  <a:moveTo>
                    <a:pt x="322" y="714"/>
                  </a:moveTo>
                  <a:cubicBezTo>
                    <a:pt x="322" y="747"/>
                    <a:pt x="322" y="747"/>
                    <a:pt x="322" y="747"/>
                  </a:cubicBezTo>
                  <a:cubicBezTo>
                    <a:pt x="244" y="745"/>
                    <a:pt x="193" y="744"/>
                    <a:pt x="169" y="744"/>
                  </a:cubicBezTo>
                  <a:cubicBezTo>
                    <a:pt x="0" y="747"/>
                    <a:pt x="0" y="747"/>
                    <a:pt x="0" y="747"/>
                  </a:cubicBezTo>
                  <a:cubicBezTo>
                    <a:pt x="0" y="714"/>
                    <a:pt x="0" y="714"/>
                    <a:pt x="0" y="714"/>
                  </a:cubicBezTo>
                  <a:cubicBezTo>
                    <a:pt x="43" y="713"/>
                    <a:pt x="69" y="711"/>
                    <a:pt x="79" y="708"/>
                  </a:cubicBezTo>
                  <a:cubicBezTo>
                    <a:pt x="88" y="705"/>
                    <a:pt x="94" y="701"/>
                    <a:pt x="98" y="696"/>
                  </a:cubicBezTo>
                  <a:cubicBezTo>
                    <a:pt x="102" y="689"/>
                    <a:pt x="105" y="672"/>
                    <a:pt x="106" y="645"/>
                  </a:cubicBezTo>
                  <a:cubicBezTo>
                    <a:pt x="107" y="637"/>
                    <a:pt x="108" y="587"/>
                    <a:pt x="109" y="495"/>
                  </a:cubicBezTo>
                  <a:cubicBezTo>
                    <a:pt x="109" y="251"/>
                    <a:pt x="109" y="251"/>
                    <a:pt x="109" y="251"/>
                  </a:cubicBezTo>
                  <a:cubicBezTo>
                    <a:pt x="109" y="204"/>
                    <a:pt x="108" y="157"/>
                    <a:pt x="106" y="111"/>
                  </a:cubicBezTo>
                  <a:cubicBezTo>
                    <a:pt x="105" y="78"/>
                    <a:pt x="102" y="59"/>
                    <a:pt x="98" y="52"/>
                  </a:cubicBezTo>
                  <a:cubicBezTo>
                    <a:pt x="94" y="46"/>
                    <a:pt x="88" y="41"/>
                    <a:pt x="78" y="39"/>
                  </a:cubicBezTo>
                  <a:cubicBezTo>
                    <a:pt x="69" y="36"/>
                    <a:pt x="43" y="34"/>
                    <a:pt x="0" y="33"/>
                  </a:cubicBezTo>
                  <a:cubicBezTo>
                    <a:pt x="0" y="0"/>
                    <a:pt x="0" y="0"/>
                    <a:pt x="0" y="0"/>
                  </a:cubicBezTo>
                  <a:cubicBezTo>
                    <a:pt x="70" y="2"/>
                    <a:pt x="124" y="3"/>
                    <a:pt x="161" y="3"/>
                  </a:cubicBezTo>
                  <a:cubicBezTo>
                    <a:pt x="198" y="3"/>
                    <a:pt x="251" y="2"/>
                    <a:pt x="322" y="0"/>
                  </a:cubicBezTo>
                  <a:cubicBezTo>
                    <a:pt x="322" y="33"/>
                    <a:pt x="322" y="33"/>
                    <a:pt x="322" y="33"/>
                  </a:cubicBezTo>
                  <a:cubicBezTo>
                    <a:pt x="279" y="34"/>
                    <a:pt x="253" y="36"/>
                    <a:pt x="244" y="39"/>
                  </a:cubicBezTo>
                  <a:cubicBezTo>
                    <a:pt x="234" y="41"/>
                    <a:pt x="228" y="46"/>
                    <a:pt x="224" y="51"/>
                  </a:cubicBezTo>
                  <a:cubicBezTo>
                    <a:pt x="220" y="58"/>
                    <a:pt x="217" y="75"/>
                    <a:pt x="216" y="102"/>
                  </a:cubicBezTo>
                  <a:cubicBezTo>
                    <a:pt x="216" y="109"/>
                    <a:pt x="215" y="159"/>
                    <a:pt x="213" y="251"/>
                  </a:cubicBezTo>
                  <a:cubicBezTo>
                    <a:pt x="213" y="495"/>
                    <a:pt x="213" y="495"/>
                    <a:pt x="213" y="495"/>
                  </a:cubicBezTo>
                  <a:cubicBezTo>
                    <a:pt x="213" y="543"/>
                    <a:pt x="214" y="589"/>
                    <a:pt x="215" y="635"/>
                  </a:cubicBezTo>
                  <a:cubicBezTo>
                    <a:pt x="216" y="668"/>
                    <a:pt x="219" y="688"/>
                    <a:pt x="223" y="694"/>
                  </a:cubicBezTo>
                  <a:cubicBezTo>
                    <a:pt x="227" y="700"/>
                    <a:pt x="234" y="705"/>
                    <a:pt x="243" y="708"/>
                  </a:cubicBezTo>
                  <a:cubicBezTo>
                    <a:pt x="252" y="711"/>
                    <a:pt x="278" y="713"/>
                    <a:pt x="322"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4" name="Freeform 10"/>
            <p:cNvSpPr>
              <a:spLocks/>
            </p:cNvSpPr>
            <p:nvPr userDrawn="1"/>
          </p:nvSpPr>
          <p:spPr bwMode="auto">
            <a:xfrm>
              <a:off x="1692275" y="998538"/>
              <a:ext cx="231775" cy="246063"/>
            </a:xfrm>
            <a:custGeom>
              <a:avLst/>
              <a:gdLst>
                <a:gd name="T0" fmla="*/ 728 w 728"/>
                <a:gd name="T1" fmla="*/ 667 h 774"/>
                <a:gd name="T2" fmla="*/ 707 w 728"/>
                <a:gd name="T3" fmla="*/ 716 h 774"/>
                <a:gd name="T4" fmla="*/ 581 w 728"/>
                <a:gd name="T5" fmla="*/ 761 h 774"/>
                <a:gd name="T6" fmla="*/ 447 w 728"/>
                <a:gd name="T7" fmla="*/ 774 h 774"/>
                <a:gd name="T8" fmla="*/ 288 w 728"/>
                <a:gd name="T9" fmla="*/ 754 h 774"/>
                <a:gd name="T10" fmla="*/ 161 w 728"/>
                <a:gd name="T11" fmla="*/ 696 h 774"/>
                <a:gd name="T12" fmla="*/ 71 w 728"/>
                <a:gd name="T13" fmla="*/ 610 h 774"/>
                <a:gd name="T14" fmla="*/ 18 w 728"/>
                <a:gd name="T15" fmla="*/ 508 h 774"/>
                <a:gd name="T16" fmla="*/ 0 w 728"/>
                <a:gd name="T17" fmla="*/ 386 h 774"/>
                <a:gd name="T18" fmla="*/ 123 w 728"/>
                <a:gd name="T19" fmla="*/ 110 h 774"/>
                <a:gd name="T20" fmla="*/ 457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5 w 728"/>
                <a:gd name="T35" fmla="*/ 143 h 774"/>
                <a:gd name="T36" fmla="*/ 605 w 728"/>
                <a:gd name="T37" fmla="*/ 66 h 774"/>
                <a:gd name="T38" fmla="*/ 446 w 728"/>
                <a:gd name="T39" fmla="*/ 41 h 774"/>
                <a:gd name="T40" fmla="*/ 313 w 728"/>
                <a:gd name="T41" fmla="*/ 60 h 774"/>
                <a:gd name="T42" fmla="*/ 217 w 728"/>
                <a:gd name="T43" fmla="*/ 117 h 774"/>
                <a:gd name="T44" fmla="*/ 149 w 728"/>
                <a:gd name="T45" fmla="*/ 216 h 774"/>
                <a:gd name="T46" fmla="*/ 122 w 728"/>
                <a:gd name="T47" fmla="*/ 366 h 774"/>
                <a:gd name="T48" fmla="*/ 223 w 728"/>
                <a:gd name="T49" fmla="*/ 621 h 774"/>
                <a:gd name="T50" fmla="*/ 492 w 728"/>
                <a:gd name="T51" fmla="*/ 717 h 774"/>
                <a:gd name="T52" fmla="*/ 632 w 728"/>
                <a:gd name="T53" fmla="*/ 698 h 774"/>
                <a:gd name="T54" fmla="*/ 719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7" y="716"/>
                    <a:pt x="707" y="716"/>
                    <a:pt x="707" y="716"/>
                  </a:cubicBezTo>
                  <a:cubicBezTo>
                    <a:pt x="664" y="736"/>
                    <a:pt x="622" y="751"/>
                    <a:pt x="581" y="761"/>
                  </a:cubicBezTo>
                  <a:cubicBezTo>
                    <a:pt x="540" y="770"/>
                    <a:pt x="495" y="774"/>
                    <a:pt x="447" y="774"/>
                  </a:cubicBezTo>
                  <a:cubicBezTo>
                    <a:pt x="390" y="774"/>
                    <a:pt x="337" y="768"/>
                    <a:pt x="288" y="754"/>
                  </a:cubicBezTo>
                  <a:cubicBezTo>
                    <a:pt x="240" y="740"/>
                    <a:pt x="197" y="721"/>
                    <a:pt x="161" y="696"/>
                  </a:cubicBezTo>
                  <a:cubicBezTo>
                    <a:pt x="124" y="670"/>
                    <a:pt x="94" y="642"/>
                    <a:pt x="71" y="610"/>
                  </a:cubicBezTo>
                  <a:cubicBezTo>
                    <a:pt x="48" y="579"/>
                    <a:pt x="31" y="545"/>
                    <a:pt x="18" y="508"/>
                  </a:cubicBezTo>
                  <a:cubicBezTo>
                    <a:pt x="6" y="471"/>
                    <a:pt x="0" y="430"/>
                    <a:pt x="0" y="386"/>
                  </a:cubicBezTo>
                  <a:cubicBezTo>
                    <a:pt x="0" y="275"/>
                    <a:pt x="41" y="183"/>
                    <a:pt x="123" y="110"/>
                  </a:cubicBezTo>
                  <a:cubicBezTo>
                    <a:pt x="204" y="37"/>
                    <a:pt x="316" y="0"/>
                    <a:pt x="457" y="0"/>
                  </a:cubicBezTo>
                  <a:cubicBezTo>
                    <a:pt x="490" y="0"/>
                    <a:pt x="521" y="2"/>
                    <a:pt x="549" y="6"/>
                  </a:cubicBezTo>
                  <a:cubicBezTo>
                    <a:pt x="578"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5" y="143"/>
                    <a:pt x="665" y="143"/>
                    <a:pt x="665" y="143"/>
                  </a:cubicBezTo>
                  <a:cubicBezTo>
                    <a:pt x="661" y="109"/>
                    <a:pt x="641" y="83"/>
                    <a:pt x="605" y="66"/>
                  </a:cubicBezTo>
                  <a:cubicBezTo>
                    <a:pt x="569" y="50"/>
                    <a:pt x="516" y="41"/>
                    <a:pt x="446" y="41"/>
                  </a:cubicBezTo>
                  <a:cubicBezTo>
                    <a:pt x="393" y="42"/>
                    <a:pt x="349" y="48"/>
                    <a:pt x="313" y="60"/>
                  </a:cubicBezTo>
                  <a:cubicBezTo>
                    <a:pt x="277" y="72"/>
                    <a:pt x="245" y="91"/>
                    <a:pt x="217" y="117"/>
                  </a:cubicBezTo>
                  <a:cubicBezTo>
                    <a:pt x="189" y="143"/>
                    <a:pt x="166" y="176"/>
                    <a:pt x="149" y="216"/>
                  </a:cubicBezTo>
                  <a:cubicBezTo>
                    <a:pt x="131" y="256"/>
                    <a:pt x="122" y="306"/>
                    <a:pt x="122" y="366"/>
                  </a:cubicBezTo>
                  <a:cubicBezTo>
                    <a:pt x="122" y="472"/>
                    <a:pt x="155" y="557"/>
                    <a:pt x="223" y="621"/>
                  </a:cubicBezTo>
                  <a:cubicBezTo>
                    <a:pt x="291" y="685"/>
                    <a:pt x="380" y="717"/>
                    <a:pt x="492" y="717"/>
                  </a:cubicBezTo>
                  <a:cubicBezTo>
                    <a:pt x="542" y="717"/>
                    <a:pt x="589" y="711"/>
                    <a:pt x="632" y="698"/>
                  </a:cubicBezTo>
                  <a:cubicBezTo>
                    <a:pt x="661" y="689"/>
                    <a:pt x="690" y="675"/>
                    <a:pt x="719"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5" name="Freeform 11"/>
            <p:cNvSpPr>
              <a:spLocks/>
            </p:cNvSpPr>
            <p:nvPr userDrawn="1"/>
          </p:nvSpPr>
          <p:spPr bwMode="auto">
            <a:xfrm>
              <a:off x="657225" y="998538"/>
              <a:ext cx="231775" cy="246063"/>
            </a:xfrm>
            <a:custGeom>
              <a:avLst/>
              <a:gdLst>
                <a:gd name="T0" fmla="*/ 728 w 728"/>
                <a:gd name="T1" fmla="*/ 667 h 774"/>
                <a:gd name="T2" fmla="*/ 706 w 728"/>
                <a:gd name="T3" fmla="*/ 716 h 774"/>
                <a:gd name="T4" fmla="*/ 580 w 728"/>
                <a:gd name="T5" fmla="*/ 761 h 774"/>
                <a:gd name="T6" fmla="*/ 446 w 728"/>
                <a:gd name="T7" fmla="*/ 774 h 774"/>
                <a:gd name="T8" fmla="*/ 288 w 728"/>
                <a:gd name="T9" fmla="*/ 754 h 774"/>
                <a:gd name="T10" fmla="*/ 160 w 728"/>
                <a:gd name="T11" fmla="*/ 696 h 774"/>
                <a:gd name="T12" fmla="*/ 71 w 728"/>
                <a:gd name="T13" fmla="*/ 610 h 774"/>
                <a:gd name="T14" fmla="*/ 18 w 728"/>
                <a:gd name="T15" fmla="*/ 508 h 774"/>
                <a:gd name="T16" fmla="*/ 0 w 728"/>
                <a:gd name="T17" fmla="*/ 386 h 774"/>
                <a:gd name="T18" fmla="*/ 122 w 728"/>
                <a:gd name="T19" fmla="*/ 110 h 774"/>
                <a:gd name="T20" fmla="*/ 456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4 w 728"/>
                <a:gd name="T35" fmla="*/ 143 h 774"/>
                <a:gd name="T36" fmla="*/ 604 w 728"/>
                <a:gd name="T37" fmla="*/ 66 h 774"/>
                <a:gd name="T38" fmla="*/ 445 w 728"/>
                <a:gd name="T39" fmla="*/ 41 h 774"/>
                <a:gd name="T40" fmla="*/ 313 w 728"/>
                <a:gd name="T41" fmla="*/ 60 h 774"/>
                <a:gd name="T42" fmla="*/ 216 w 728"/>
                <a:gd name="T43" fmla="*/ 117 h 774"/>
                <a:gd name="T44" fmla="*/ 148 w 728"/>
                <a:gd name="T45" fmla="*/ 216 h 774"/>
                <a:gd name="T46" fmla="*/ 121 w 728"/>
                <a:gd name="T47" fmla="*/ 366 h 774"/>
                <a:gd name="T48" fmla="*/ 223 w 728"/>
                <a:gd name="T49" fmla="*/ 621 h 774"/>
                <a:gd name="T50" fmla="*/ 492 w 728"/>
                <a:gd name="T51" fmla="*/ 717 h 774"/>
                <a:gd name="T52" fmla="*/ 631 w 728"/>
                <a:gd name="T53" fmla="*/ 698 h 774"/>
                <a:gd name="T54" fmla="*/ 718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6" y="716"/>
                    <a:pt x="706" y="716"/>
                    <a:pt x="706" y="716"/>
                  </a:cubicBezTo>
                  <a:cubicBezTo>
                    <a:pt x="663" y="736"/>
                    <a:pt x="621" y="751"/>
                    <a:pt x="580" y="761"/>
                  </a:cubicBezTo>
                  <a:cubicBezTo>
                    <a:pt x="539" y="770"/>
                    <a:pt x="495" y="774"/>
                    <a:pt x="446" y="774"/>
                  </a:cubicBezTo>
                  <a:cubicBezTo>
                    <a:pt x="389" y="774"/>
                    <a:pt x="337" y="768"/>
                    <a:pt x="288" y="754"/>
                  </a:cubicBezTo>
                  <a:cubicBezTo>
                    <a:pt x="239" y="740"/>
                    <a:pt x="197" y="721"/>
                    <a:pt x="160" y="696"/>
                  </a:cubicBezTo>
                  <a:cubicBezTo>
                    <a:pt x="124" y="670"/>
                    <a:pt x="94" y="642"/>
                    <a:pt x="71" y="610"/>
                  </a:cubicBezTo>
                  <a:cubicBezTo>
                    <a:pt x="48" y="579"/>
                    <a:pt x="30" y="545"/>
                    <a:pt x="18" y="508"/>
                  </a:cubicBezTo>
                  <a:cubicBezTo>
                    <a:pt x="6" y="471"/>
                    <a:pt x="0" y="430"/>
                    <a:pt x="0" y="386"/>
                  </a:cubicBezTo>
                  <a:cubicBezTo>
                    <a:pt x="0" y="275"/>
                    <a:pt x="41" y="183"/>
                    <a:pt x="122" y="110"/>
                  </a:cubicBezTo>
                  <a:cubicBezTo>
                    <a:pt x="204" y="37"/>
                    <a:pt x="315" y="0"/>
                    <a:pt x="456" y="0"/>
                  </a:cubicBezTo>
                  <a:cubicBezTo>
                    <a:pt x="490" y="0"/>
                    <a:pt x="520" y="2"/>
                    <a:pt x="549" y="6"/>
                  </a:cubicBezTo>
                  <a:cubicBezTo>
                    <a:pt x="577"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4" y="143"/>
                    <a:pt x="664" y="143"/>
                    <a:pt x="664" y="143"/>
                  </a:cubicBezTo>
                  <a:cubicBezTo>
                    <a:pt x="661" y="109"/>
                    <a:pt x="641" y="83"/>
                    <a:pt x="604" y="66"/>
                  </a:cubicBezTo>
                  <a:cubicBezTo>
                    <a:pt x="568" y="50"/>
                    <a:pt x="515" y="41"/>
                    <a:pt x="445" y="41"/>
                  </a:cubicBezTo>
                  <a:cubicBezTo>
                    <a:pt x="393" y="42"/>
                    <a:pt x="349" y="48"/>
                    <a:pt x="313" y="60"/>
                  </a:cubicBezTo>
                  <a:cubicBezTo>
                    <a:pt x="276" y="72"/>
                    <a:pt x="244" y="91"/>
                    <a:pt x="216" y="117"/>
                  </a:cubicBezTo>
                  <a:cubicBezTo>
                    <a:pt x="189" y="143"/>
                    <a:pt x="166" y="176"/>
                    <a:pt x="148" y="216"/>
                  </a:cubicBezTo>
                  <a:cubicBezTo>
                    <a:pt x="131" y="256"/>
                    <a:pt x="122" y="306"/>
                    <a:pt x="121" y="366"/>
                  </a:cubicBezTo>
                  <a:cubicBezTo>
                    <a:pt x="121" y="472"/>
                    <a:pt x="155" y="557"/>
                    <a:pt x="223" y="621"/>
                  </a:cubicBezTo>
                  <a:cubicBezTo>
                    <a:pt x="290" y="685"/>
                    <a:pt x="380" y="717"/>
                    <a:pt x="492" y="717"/>
                  </a:cubicBezTo>
                  <a:cubicBezTo>
                    <a:pt x="542" y="717"/>
                    <a:pt x="588" y="711"/>
                    <a:pt x="631" y="698"/>
                  </a:cubicBezTo>
                  <a:cubicBezTo>
                    <a:pt x="660" y="689"/>
                    <a:pt x="689" y="675"/>
                    <a:pt x="718"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6" name="Freeform 12"/>
            <p:cNvSpPr>
              <a:spLocks/>
            </p:cNvSpPr>
            <p:nvPr userDrawn="1"/>
          </p:nvSpPr>
          <p:spPr bwMode="auto">
            <a:xfrm>
              <a:off x="757238" y="687388"/>
              <a:ext cx="323850" cy="239713"/>
            </a:xfrm>
            <a:custGeom>
              <a:avLst/>
              <a:gdLst>
                <a:gd name="T0" fmla="*/ 0 w 1017"/>
                <a:gd name="T1" fmla="*/ 35 h 754"/>
                <a:gd name="T2" fmla="*/ 0 w 1017"/>
                <a:gd name="T3" fmla="*/ 0 h 754"/>
                <a:gd name="T4" fmla="*/ 110 w 1017"/>
                <a:gd name="T5" fmla="*/ 4 h 754"/>
                <a:gd name="T6" fmla="*/ 212 w 1017"/>
                <a:gd name="T7" fmla="*/ 0 h 754"/>
                <a:gd name="T8" fmla="*/ 300 w 1017"/>
                <a:gd name="T9" fmla="*/ 183 h 754"/>
                <a:gd name="T10" fmla="*/ 509 w 1017"/>
                <a:gd name="T11" fmla="*/ 592 h 754"/>
                <a:gd name="T12" fmla="*/ 697 w 1017"/>
                <a:gd name="T13" fmla="*/ 218 h 754"/>
                <a:gd name="T14" fmla="*/ 800 w 1017"/>
                <a:gd name="T15" fmla="*/ 0 h 754"/>
                <a:gd name="T16" fmla="*/ 898 w 1017"/>
                <a:gd name="T17" fmla="*/ 4 h 754"/>
                <a:gd name="T18" fmla="*/ 1017 w 1017"/>
                <a:gd name="T19" fmla="*/ 0 h 754"/>
                <a:gd name="T20" fmla="*/ 1017 w 1017"/>
                <a:gd name="T21" fmla="*/ 35 h 754"/>
                <a:gd name="T22" fmla="*/ 938 w 1017"/>
                <a:gd name="T23" fmla="*/ 40 h 754"/>
                <a:gd name="T24" fmla="*/ 918 w 1017"/>
                <a:gd name="T25" fmla="*/ 53 h 754"/>
                <a:gd name="T26" fmla="*/ 910 w 1017"/>
                <a:gd name="T27" fmla="*/ 103 h 754"/>
                <a:gd name="T28" fmla="*/ 907 w 1017"/>
                <a:gd name="T29" fmla="*/ 251 h 754"/>
                <a:gd name="T30" fmla="*/ 907 w 1017"/>
                <a:gd name="T31" fmla="*/ 492 h 754"/>
                <a:gd name="T32" fmla="*/ 910 w 1017"/>
                <a:gd name="T33" fmla="*/ 631 h 754"/>
                <a:gd name="T34" fmla="*/ 918 w 1017"/>
                <a:gd name="T35" fmla="*/ 690 h 754"/>
                <a:gd name="T36" fmla="*/ 938 w 1017"/>
                <a:gd name="T37" fmla="*/ 704 h 754"/>
                <a:gd name="T38" fmla="*/ 1017 w 1017"/>
                <a:gd name="T39" fmla="*/ 709 h 754"/>
                <a:gd name="T40" fmla="*/ 1017 w 1017"/>
                <a:gd name="T41" fmla="*/ 743 h 754"/>
                <a:gd name="T42" fmla="*/ 861 w 1017"/>
                <a:gd name="T43" fmla="*/ 739 h 754"/>
                <a:gd name="T44" fmla="*/ 699 w 1017"/>
                <a:gd name="T45" fmla="*/ 743 h 754"/>
                <a:gd name="T46" fmla="*/ 699 w 1017"/>
                <a:gd name="T47" fmla="*/ 709 h 754"/>
                <a:gd name="T48" fmla="*/ 778 w 1017"/>
                <a:gd name="T49" fmla="*/ 704 h 754"/>
                <a:gd name="T50" fmla="*/ 797 w 1017"/>
                <a:gd name="T51" fmla="*/ 691 h 754"/>
                <a:gd name="T52" fmla="*/ 806 w 1017"/>
                <a:gd name="T53" fmla="*/ 641 h 754"/>
                <a:gd name="T54" fmla="*/ 808 w 1017"/>
                <a:gd name="T55" fmla="*/ 492 h 754"/>
                <a:gd name="T56" fmla="*/ 808 w 1017"/>
                <a:gd name="T57" fmla="*/ 108 h 754"/>
                <a:gd name="T58" fmla="*/ 619 w 1017"/>
                <a:gd name="T59" fmla="*/ 486 h 754"/>
                <a:gd name="T60" fmla="*/ 549 w 1017"/>
                <a:gd name="T61" fmla="*/ 629 h 754"/>
                <a:gd name="T62" fmla="*/ 494 w 1017"/>
                <a:gd name="T63" fmla="*/ 754 h 754"/>
                <a:gd name="T64" fmla="*/ 472 w 1017"/>
                <a:gd name="T65" fmla="*/ 754 h 754"/>
                <a:gd name="T66" fmla="*/ 459 w 1017"/>
                <a:gd name="T67" fmla="*/ 722 h 754"/>
                <a:gd name="T68" fmla="*/ 422 w 1017"/>
                <a:gd name="T69" fmla="*/ 645 h 754"/>
                <a:gd name="T70" fmla="*/ 159 w 1017"/>
                <a:gd name="T71" fmla="*/ 126 h 754"/>
                <a:gd name="T72" fmla="*/ 159 w 1017"/>
                <a:gd name="T73" fmla="*/ 492 h 754"/>
                <a:gd name="T74" fmla="*/ 163 w 1017"/>
                <a:gd name="T75" fmla="*/ 631 h 754"/>
                <a:gd name="T76" fmla="*/ 171 w 1017"/>
                <a:gd name="T77" fmla="*/ 690 h 754"/>
                <a:gd name="T78" fmla="*/ 191 w 1017"/>
                <a:gd name="T79" fmla="*/ 704 h 754"/>
                <a:gd name="T80" fmla="*/ 271 w 1017"/>
                <a:gd name="T81" fmla="*/ 709 h 754"/>
                <a:gd name="T82" fmla="*/ 271 w 1017"/>
                <a:gd name="T83" fmla="*/ 743 h 754"/>
                <a:gd name="T84" fmla="*/ 138 w 1017"/>
                <a:gd name="T85" fmla="*/ 739 h 754"/>
                <a:gd name="T86" fmla="*/ 0 w 1017"/>
                <a:gd name="T87" fmla="*/ 743 h 754"/>
                <a:gd name="T88" fmla="*/ 0 w 1017"/>
                <a:gd name="T89" fmla="*/ 709 h 754"/>
                <a:gd name="T90" fmla="*/ 79 w 1017"/>
                <a:gd name="T91" fmla="*/ 704 h 754"/>
                <a:gd name="T92" fmla="*/ 98 w 1017"/>
                <a:gd name="T93" fmla="*/ 691 h 754"/>
                <a:gd name="T94" fmla="*/ 107 w 1017"/>
                <a:gd name="T95" fmla="*/ 641 h 754"/>
                <a:gd name="T96" fmla="*/ 109 w 1017"/>
                <a:gd name="T97" fmla="*/ 492 h 754"/>
                <a:gd name="T98" fmla="*/ 109 w 1017"/>
                <a:gd name="T99" fmla="*/ 251 h 754"/>
                <a:gd name="T100" fmla="*/ 107 w 1017"/>
                <a:gd name="T101" fmla="*/ 112 h 754"/>
                <a:gd name="T102" fmla="*/ 99 w 1017"/>
                <a:gd name="T103" fmla="*/ 54 h 754"/>
                <a:gd name="T104" fmla="*/ 78 w 1017"/>
                <a:gd name="T105" fmla="*/ 40 h 754"/>
                <a:gd name="T106" fmla="*/ 0 w 1017"/>
                <a:gd name="T107" fmla="*/ 35 h 75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Lst>
              <a:rect l="0" t="0" r="r" b="b"/>
              <a:pathLst>
                <a:path w="1017" h="754">
                  <a:moveTo>
                    <a:pt x="0" y="35"/>
                  </a:moveTo>
                  <a:cubicBezTo>
                    <a:pt x="0" y="0"/>
                    <a:pt x="0" y="0"/>
                    <a:pt x="0" y="0"/>
                  </a:cubicBezTo>
                  <a:cubicBezTo>
                    <a:pt x="38" y="2"/>
                    <a:pt x="75" y="4"/>
                    <a:pt x="110" y="4"/>
                  </a:cubicBezTo>
                  <a:cubicBezTo>
                    <a:pt x="145" y="4"/>
                    <a:pt x="179" y="2"/>
                    <a:pt x="212" y="0"/>
                  </a:cubicBezTo>
                  <a:cubicBezTo>
                    <a:pt x="244" y="70"/>
                    <a:pt x="274" y="131"/>
                    <a:pt x="300" y="183"/>
                  </a:cubicBezTo>
                  <a:cubicBezTo>
                    <a:pt x="509" y="592"/>
                    <a:pt x="509" y="592"/>
                    <a:pt x="509" y="592"/>
                  </a:cubicBezTo>
                  <a:cubicBezTo>
                    <a:pt x="697" y="218"/>
                    <a:pt x="697" y="218"/>
                    <a:pt x="697" y="218"/>
                  </a:cubicBezTo>
                  <a:cubicBezTo>
                    <a:pt x="749" y="116"/>
                    <a:pt x="783" y="43"/>
                    <a:pt x="800" y="0"/>
                  </a:cubicBezTo>
                  <a:cubicBezTo>
                    <a:pt x="839" y="2"/>
                    <a:pt x="872" y="4"/>
                    <a:pt x="898" y="4"/>
                  </a:cubicBezTo>
                  <a:cubicBezTo>
                    <a:pt x="923" y="4"/>
                    <a:pt x="962" y="2"/>
                    <a:pt x="1017" y="0"/>
                  </a:cubicBezTo>
                  <a:cubicBezTo>
                    <a:pt x="1017" y="35"/>
                    <a:pt x="1017" y="35"/>
                    <a:pt x="1017" y="35"/>
                  </a:cubicBezTo>
                  <a:cubicBezTo>
                    <a:pt x="974" y="35"/>
                    <a:pt x="947" y="37"/>
                    <a:pt x="938" y="40"/>
                  </a:cubicBezTo>
                  <a:cubicBezTo>
                    <a:pt x="928" y="43"/>
                    <a:pt x="922" y="47"/>
                    <a:pt x="918" y="53"/>
                  </a:cubicBezTo>
                  <a:cubicBezTo>
                    <a:pt x="914" y="60"/>
                    <a:pt x="911" y="76"/>
                    <a:pt x="910" y="103"/>
                  </a:cubicBezTo>
                  <a:cubicBezTo>
                    <a:pt x="910" y="110"/>
                    <a:pt x="909" y="159"/>
                    <a:pt x="907" y="251"/>
                  </a:cubicBezTo>
                  <a:cubicBezTo>
                    <a:pt x="907" y="492"/>
                    <a:pt x="907" y="492"/>
                    <a:pt x="907" y="492"/>
                  </a:cubicBezTo>
                  <a:cubicBezTo>
                    <a:pt x="907" y="540"/>
                    <a:pt x="908" y="586"/>
                    <a:pt x="910" y="631"/>
                  </a:cubicBezTo>
                  <a:cubicBezTo>
                    <a:pt x="911" y="664"/>
                    <a:pt x="914" y="684"/>
                    <a:pt x="918" y="690"/>
                  </a:cubicBezTo>
                  <a:cubicBezTo>
                    <a:pt x="922" y="696"/>
                    <a:pt x="929" y="701"/>
                    <a:pt x="938" y="704"/>
                  </a:cubicBezTo>
                  <a:cubicBezTo>
                    <a:pt x="948" y="707"/>
                    <a:pt x="974" y="709"/>
                    <a:pt x="1017" y="709"/>
                  </a:cubicBezTo>
                  <a:cubicBezTo>
                    <a:pt x="1017" y="743"/>
                    <a:pt x="1017" y="743"/>
                    <a:pt x="1017" y="743"/>
                  </a:cubicBezTo>
                  <a:cubicBezTo>
                    <a:pt x="943" y="740"/>
                    <a:pt x="891" y="739"/>
                    <a:pt x="861" y="739"/>
                  </a:cubicBezTo>
                  <a:cubicBezTo>
                    <a:pt x="837" y="739"/>
                    <a:pt x="782" y="740"/>
                    <a:pt x="699" y="743"/>
                  </a:cubicBezTo>
                  <a:cubicBezTo>
                    <a:pt x="699" y="709"/>
                    <a:pt x="699" y="709"/>
                    <a:pt x="699" y="709"/>
                  </a:cubicBezTo>
                  <a:cubicBezTo>
                    <a:pt x="742" y="709"/>
                    <a:pt x="768" y="707"/>
                    <a:pt x="778" y="704"/>
                  </a:cubicBezTo>
                  <a:cubicBezTo>
                    <a:pt x="788" y="701"/>
                    <a:pt x="794" y="697"/>
                    <a:pt x="797" y="691"/>
                  </a:cubicBezTo>
                  <a:cubicBezTo>
                    <a:pt x="802" y="684"/>
                    <a:pt x="805" y="668"/>
                    <a:pt x="806" y="641"/>
                  </a:cubicBezTo>
                  <a:cubicBezTo>
                    <a:pt x="806" y="633"/>
                    <a:pt x="807" y="584"/>
                    <a:pt x="808" y="492"/>
                  </a:cubicBezTo>
                  <a:cubicBezTo>
                    <a:pt x="808" y="108"/>
                    <a:pt x="808" y="108"/>
                    <a:pt x="808" y="108"/>
                  </a:cubicBezTo>
                  <a:cubicBezTo>
                    <a:pt x="619" y="486"/>
                    <a:pt x="619" y="486"/>
                    <a:pt x="619" y="486"/>
                  </a:cubicBezTo>
                  <a:cubicBezTo>
                    <a:pt x="589" y="545"/>
                    <a:pt x="566" y="593"/>
                    <a:pt x="549" y="629"/>
                  </a:cubicBezTo>
                  <a:cubicBezTo>
                    <a:pt x="537" y="655"/>
                    <a:pt x="518" y="696"/>
                    <a:pt x="494" y="754"/>
                  </a:cubicBezTo>
                  <a:cubicBezTo>
                    <a:pt x="472" y="754"/>
                    <a:pt x="472" y="754"/>
                    <a:pt x="472" y="754"/>
                  </a:cubicBezTo>
                  <a:cubicBezTo>
                    <a:pt x="468" y="740"/>
                    <a:pt x="463" y="729"/>
                    <a:pt x="459" y="722"/>
                  </a:cubicBezTo>
                  <a:cubicBezTo>
                    <a:pt x="422" y="645"/>
                    <a:pt x="422" y="645"/>
                    <a:pt x="422" y="645"/>
                  </a:cubicBezTo>
                  <a:cubicBezTo>
                    <a:pt x="159" y="126"/>
                    <a:pt x="159" y="126"/>
                    <a:pt x="159" y="126"/>
                  </a:cubicBezTo>
                  <a:cubicBezTo>
                    <a:pt x="159" y="492"/>
                    <a:pt x="159" y="492"/>
                    <a:pt x="159" y="492"/>
                  </a:cubicBezTo>
                  <a:cubicBezTo>
                    <a:pt x="159" y="540"/>
                    <a:pt x="160" y="586"/>
                    <a:pt x="163" y="631"/>
                  </a:cubicBezTo>
                  <a:cubicBezTo>
                    <a:pt x="164" y="664"/>
                    <a:pt x="167" y="683"/>
                    <a:pt x="171" y="690"/>
                  </a:cubicBezTo>
                  <a:cubicBezTo>
                    <a:pt x="175" y="696"/>
                    <a:pt x="182" y="701"/>
                    <a:pt x="191" y="704"/>
                  </a:cubicBezTo>
                  <a:cubicBezTo>
                    <a:pt x="200" y="707"/>
                    <a:pt x="227" y="709"/>
                    <a:pt x="271" y="709"/>
                  </a:cubicBezTo>
                  <a:cubicBezTo>
                    <a:pt x="271" y="743"/>
                    <a:pt x="271" y="743"/>
                    <a:pt x="271" y="743"/>
                  </a:cubicBezTo>
                  <a:cubicBezTo>
                    <a:pt x="138" y="739"/>
                    <a:pt x="138" y="739"/>
                    <a:pt x="138" y="739"/>
                  </a:cubicBezTo>
                  <a:cubicBezTo>
                    <a:pt x="0" y="743"/>
                    <a:pt x="0" y="743"/>
                    <a:pt x="0" y="743"/>
                  </a:cubicBezTo>
                  <a:cubicBezTo>
                    <a:pt x="0" y="709"/>
                    <a:pt x="0" y="709"/>
                    <a:pt x="0" y="709"/>
                  </a:cubicBezTo>
                  <a:cubicBezTo>
                    <a:pt x="43" y="709"/>
                    <a:pt x="69" y="707"/>
                    <a:pt x="79" y="704"/>
                  </a:cubicBezTo>
                  <a:cubicBezTo>
                    <a:pt x="88" y="701"/>
                    <a:pt x="95" y="697"/>
                    <a:pt x="98" y="691"/>
                  </a:cubicBezTo>
                  <a:cubicBezTo>
                    <a:pt x="103" y="684"/>
                    <a:pt x="105" y="668"/>
                    <a:pt x="107" y="641"/>
                  </a:cubicBezTo>
                  <a:cubicBezTo>
                    <a:pt x="107" y="634"/>
                    <a:pt x="108" y="584"/>
                    <a:pt x="109" y="492"/>
                  </a:cubicBezTo>
                  <a:cubicBezTo>
                    <a:pt x="109" y="251"/>
                    <a:pt x="109" y="251"/>
                    <a:pt x="109" y="251"/>
                  </a:cubicBezTo>
                  <a:cubicBezTo>
                    <a:pt x="109" y="204"/>
                    <a:pt x="108" y="158"/>
                    <a:pt x="107" y="112"/>
                  </a:cubicBezTo>
                  <a:cubicBezTo>
                    <a:pt x="105" y="79"/>
                    <a:pt x="103" y="60"/>
                    <a:pt x="99" y="54"/>
                  </a:cubicBezTo>
                  <a:cubicBezTo>
                    <a:pt x="94" y="48"/>
                    <a:pt x="88" y="43"/>
                    <a:pt x="78" y="40"/>
                  </a:cubicBezTo>
                  <a:cubicBezTo>
                    <a:pt x="69" y="37"/>
                    <a:pt x="43" y="35"/>
                    <a:pt x="0" y="35"/>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7" name="Freeform 13"/>
            <p:cNvSpPr>
              <a:spLocks noEditPoints="1"/>
            </p:cNvSpPr>
            <p:nvPr userDrawn="1"/>
          </p:nvSpPr>
          <p:spPr bwMode="auto">
            <a:xfrm>
              <a:off x="1092200" y="684213"/>
              <a:ext cx="263525" cy="238125"/>
            </a:xfrm>
            <a:custGeom>
              <a:avLst/>
              <a:gdLst>
                <a:gd name="T0" fmla="*/ 117 w 832"/>
                <a:gd name="T1" fmla="*/ 747 h 750"/>
                <a:gd name="T2" fmla="*/ 257 w 832"/>
                <a:gd name="T3" fmla="*/ 750 h 750"/>
                <a:gd name="T4" fmla="*/ 257 w 832"/>
                <a:gd name="T5" fmla="*/ 717 h 750"/>
                <a:gd name="T6" fmla="*/ 185 w 832"/>
                <a:gd name="T7" fmla="*/ 712 h 750"/>
                <a:gd name="T8" fmla="*/ 166 w 832"/>
                <a:gd name="T9" fmla="*/ 702 h 750"/>
                <a:gd name="T10" fmla="*/ 162 w 832"/>
                <a:gd name="T11" fmla="*/ 690 h 750"/>
                <a:gd name="T12" fmla="*/ 178 w 832"/>
                <a:gd name="T13" fmla="*/ 637 h 750"/>
                <a:gd name="T14" fmla="*/ 237 w 832"/>
                <a:gd name="T15" fmla="*/ 503 h 750"/>
                <a:gd name="T16" fmla="*/ 556 w 832"/>
                <a:gd name="T17" fmla="*/ 503 h 750"/>
                <a:gd name="T18" fmla="*/ 624 w 832"/>
                <a:gd name="T19" fmla="*/ 663 h 750"/>
                <a:gd name="T20" fmla="*/ 632 w 832"/>
                <a:gd name="T21" fmla="*/ 693 h 750"/>
                <a:gd name="T22" fmla="*/ 627 w 832"/>
                <a:gd name="T23" fmla="*/ 705 h 750"/>
                <a:gd name="T24" fmla="*/ 609 w 832"/>
                <a:gd name="T25" fmla="*/ 713 h 750"/>
                <a:gd name="T26" fmla="*/ 535 w 832"/>
                <a:gd name="T27" fmla="*/ 717 h 750"/>
                <a:gd name="T28" fmla="*/ 535 w 832"/>
                <a:gd name="T29" fmla="*/ 750 h 750"/>
                <a:gd name="T30" fmla="*/ 712 w 832"/>
                <a:gd name="T31" fmla="*/ 747 h 750"/>
                <a:gd name="T32" fmla="*/ 832 w 832"/>
                <a:gd name="T33" fmla="*/ 750 h 750"/>
                <a:gd name="T34" fmla="*/ 832 w 832"/>
                <a:gd name="T35" fmla="*/ 717 h 750"/>
                <a:gd name="T36" fmla="*/ 776 w 832"/>
                <a:gd name="T37" fmla="*/ 710 h 750"/>
                <a:gd name="T38" fmla="*/ 753 w 832"/>
                <a:gd name="T39" fmla="*/ 687 h 750"/>
                <a:gd name="T40" fmla="*/ 677 w 832"/>
                <a:gd name="T41" fmla="*/ 526 h 750"/>
                <a:gd name="T42" fmla="*/ 441 w 832"/>
                <a:gd name="T43" fmla="*/ 0 h 750"/>
                <a:gd name="T44" fmla="*/ 406 w 832"/>
                <a:gd name="T45" fmla="*/ 0 h 750"/>
                <a:gd name="T46" fmla="*/ 310 w 832"/>
                <a:gd name="T47" fmla="*/ 217 h 750"/>
                <a:gd name="T48" fmla="*/ 172 w 832"/>
                <a:gd name="T49" fmla="*/ 512 h 750"/>
                <a:gd name="T50" fmla="*/ 100 w 832"/>
                <a:gd name="T51" fmla="*/ 660 h 750"/>
                <a:gd name="T52" fmla="*/ 74 w 832"/>
                <a:gd name="T53" fmla="*/ 702 h 750"/>
                <a:gd name="T54" fmla="*/ 54 w 832"/>
                <a:gd name="T55" fmla="*/ 713 h 750"/>
                <a:gd name="T56" fmla="*/ 0 w 832"/>
                <a:gd name="T57" fmla="*/ 717 h 750"/>
                <a:gd name="T58" fmla="*/ 0 w 832"/>
                <a:gd name="T59" fmla="*/ 750 h 750"/>
                <a:gd name="T60" fmla="*/ 117 w 832"/>
                <a:gd name="T61" fmla="*/ 747 h 750"/>
                <a:gd name="T62" fmla="*/ 396 w 832"/>
                <a:gd name="T63" fmla="*/ 143 h 750"/>
                <a:gd name="T64" fmla="*/ 534 w 832"/>
                <a:gd name="T65" fmla="*/ 458 h 750"/>
                <a:gd name="T66" fmla="*/ 256 w 832"/>
                <a:gd name="T67" fmla="*/ 458 h 750"/>
                <a:gd name="T68" fmla="*/ 396 w 832"/>
                <a:gd name="T69" fmla="*/ 143 h 75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Lst>
              <a:rect l="0" t="0" r="r" b="b"/>
              <a:pathLst>
                <a:path w="832" h="750">
                  <a:moveTo>
                    <a:pt x="117" y="747"/>
                  </a:moveTo>
                  <a:cubicBezTo>
                    <a:pt x="148" y="747"/>
                    <a:pt x="195" y="748"/>
                    <a:pt x="257" y="750"/>
                  </a:cubicBezTo>
                  <a:cubicBezTo>
                    <a:pt x="257" y="717"/>
                    <a:pt x="257" y="717"/>
                    <a:pt x="257" y="717"/>
                  </a:cubicBezTo>
                  <a:cubicBezTo>
                    <a:pt x="222" y="716"/>
                    <a:pt x="199" y="715"/>
                    <a:pt x="185" y="712"/>
                  </a:cubicBezTo>
                  <a:cubicBezTo>
                    <a:pt x="177" y="710"/>
                    <a:pt x="170" y="707"/>
                    <a:pt x="166" y="702"/>
                  </a:cubicBezTo>
                  <a:cubicBezTo>
                    <a:pt x="163" y="699"/>
                    <a:pt x="162" y="695"/>
                    <a:pt x="162" y="690"/>
                  </a:cubicBezTo>
                  <a:cubicBezTo>
                    <a:pt x="162" y="679"/>
                    <a:pt x="167" y="662"/>
                    <a:pt x="178" y="637"/>
                  </a:cubicBezTo>
                  <a:cubicBezTo>
                    <a:pt x="237" y="503"/>
                    <a:pt x="237" y="503"/>
                    <a:pt x="237" y="503"/>
                  </a:cubicBezTo>
                  <a:cubicBezTo>
                    <a:pt x="556" y="503"/>
                    <a:pt x="556" y="503"/>
                    <a:pt x="556" y="503"/>
                  </a:cubicBezTo>
                  <a:cubicBezTo>
                    <a:pt x="624" y="663"/>
                    <a:pt x="624" y="663"/>
                    <a:pt x="624" y="663"/>
                  </a:cubicBezTo>
                  <a:cubicBezTo>
                    <a:pt x="629" y="675"/>
                    <a:pt x="632" y="685"/>
                    <a:pt x="632" y="693"/>
                  </a:cubicBezTo>
                  <a:cubicBezTo>
                    <a:pt x="632" y="698"/>
                    <a:pt x="630" y="702"/>
                    <a:pt x="627" y="705"/>
                  </a:cubicBezTo>
                  <a:cubicBezTo>
                    <a:pt x="624" y="708"/>
                    <a:pt x="618" y="711"/>
                    <a:pt x="609" y="713"/>
                  </a:cubicBezTo>
                  <a:cubicBezTo>
                    <a:pt x="601" y="715"/>
                    <a:pt x="576" y="716"/>
                    <a:pt x="535" y="717"/>
                  </a:cubicBezTo>
                  <a:cubicBezTo>
                    <a:pt x="535" y="750"/>
                    <a:pt x="535" y="750"/>
                    <a:pt x="535" y="750"/>
                  </a:cubicBezTo>
                  <a:cubicBezTo>
                    <a:pt x="712" y="747"/>
                    <a:pt x="712" y="747"/>
                    <a:pt x="712" y="747"/>
                  </a:cubicBezTo>
                  <a:cubicBezTo>
                    <a:pt x="734" y="747"/>
                    <a:pt x="775" y="748"/>
                    <a:pt x="832" y="750"/>
                  </a:cubicBezTo>
                  <a:cubicBezTo>
                    <a:pt x="832" y="717"/>
                    <a:pt x="832" y="717"/>
                    <a:pt x="832" y="717"/>
                  </a:cubicBezTo>
                  <a:cubicBezTo>
                    <a:pt x="803" y="716"/>
                    <a:pt x="784" y="714"/>
                    <a:pt x="776" y="710"/>
                  </a:cubicBezTo>
                  <a:cubicBezTo>
                    <a:pt x="767" y="707"/>
                    <a:pt x="760" y="699"/>
                    <a:pt x="753" y="687"/>
                  </a:cubicBezTo>
                  <a:cubicBezTo>
                    <a:pt x="740" y="664"/>
                    <a:pt x="715" y="611"/>
                    <a:pt x="677" y="526"/>
                  </a:cubicBezTo>
                  <a:cubicBezTo>
                    <a:pt x="441" y="0"/>
                    <a:pt x="441" y="0"/>
                    <a:pt x="441" y="0"/>
                  </a:cubicBezTo>
                  <a:cubicBezTo>
                    <a:pt x="406" y="0"/>
                    <a:pt x="406" y="0"/>
                    <a:pt x="406" y="0"/>
                  </a:cubicBezTo>
                  <a:cubicBezTo>
                    <a:pt x="357" y="112"/>
                    <a:pt x="325" y="185"/>
                    <a:pt x="310" y="217"/>
                  </a:cubicBezTo>
                  <a:cubicBezTo>
                    <a:pt x="172" y="512"/>
                    <a:pt x="172" y="512"/>
                    <a:pt x="172" y="512"/>
                  </a:cubicBezTo>
                  <a:cubicBezTo>
                    <a:pt x="131" y="598"/>
                    <a:pt x="107" y="647"/>
                    <a:pt x="100" y="660"/>
                  </a:cubicBezTo>
                  <a:cubicBezTo>
                    <a:pt x="89" y="683"/>
                    <a:pt x="80" y="697"/>
                    <a:pt x="74" y="702"/>
                  </a:cubicBezTo>
                  <a:cubicBezTo>
                    <a:pt x="68" y="708"/>
                    <a:pt x="61" y="711"/>
                    <a:pt x="54" y="713"/>
                  </a:cubicBezTo>
                  <a:cubicBezTo>
                    <a:pt x="47" y="715"/>
                    <a:pt x="29" y="716"/>
                    <a:pt x="0" y="717"/>
                  </a:cubicBezTo>
                  <a:cubicBezTo>
                    <a:pt x="0" y="750"/>
                    <a:pt x="0" y="750"/>
                    <a:pt x="0" y="750"/>
                  </a:cubicBezTo>
                  <a:cubicBezTo>
                    <a:pt x="42" y="748"/>
                    <a:pt x="81" y="747"/>
                    <a:pt x="117" y="747"/>
                  </a:cubicBezTo>
                  <a:close/>
                  <a:moveTo>
                    <a:pt x="396" y="143"/>
                  </a:moveTo>
                  <a:cubicBezTo>
                    <a:pt x="534" y="458"/>
                    <a:pt x="534" y="458"/>
                    <a:pt x="534" y="458"/>
                  </a:cubicBezTo>
                  <a:cubicBezTo>
                    <a:pt x="256" y="458"/>
                    <a:pt x="256" y="458"/>
                    <a:pt x="256" y="458"/>
                  </a:cubicBezTo>
                  <a:lnTo>
                    <a:pt x="396" y="143"/>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8" name="Freeform 14"/>
            <p:cNvSpPr>
              <a:spLocks/>
            </p:cNvSpPr>
            <p:nvPr userDrawn="1"/>
          </p:nvSpPr>
          <p:spPr bwMode="auto">
            <a:xfrm>
              <a:off x="1309688" y="687388"/>
              <a:ext cx="260350" cy="234950"/>
            </a:xfrm>
            <a:custGeom>
              <a:avLst/>
              <a:gdLst>
                <a:gd name="T0" fmla="*/ 601 w 817"/>
                <a:gd name="T1" fmla="*/ 111 h 743"/>
                <a:gd name="T2" fmla="*/ 634 w 817"/>
                <a:gd name="T3" fmla="*/ 52 h 743"/>
                <a:gd name="T4" fmla="*/ 624 w 817"/>
                <a:gd name="T5" fmla="*/ 39 h 743"/>
                <a:gd name="T6" fmla="*/ 543 w 817"/>
                <a:gd name="T7" fmla="*/ 33 h 743"/>
                <a:gd name="T8" fmla="*/ 543 w 817"/>
                <a:gd name="T9" fmla="*/ 0 h 743"/>
                <a:gd name="T10" fmla="*/ 688 w 817"/>
                <a:gd name="T11" fmla="*/ 3 h 743"/>
                <a:gd name="T12" fmla="*/ 817 w 817"/>
                <a:gd name="T13" fmla="*/ 0 h 743"/>
                <a:gd name="T14" fmla="*/ 817 w 817"/>
                <a:gd name="T15" fmla="*/ 33 h 743"/>
                <a:gd name="T16" fmla="*/ 746 w 817"/>
                <a:gd name="T17" fmla="*/ 39 h 743"/>
                <a:gd name="T18" fmla="*/ 718 w 817"/>
                <a:gd name="T19" fmla="*/ 51 h 743"/>
                <a:gd name="T20" fmla="*/ 675 w 817"/>
                <a:gd name="T21" fmla="*/ 102 h 743"/>
                <a:gd name="T22" fmla="*/ 514 w 817"/>
                <a:gd name="T23" fmla="*/ 333 h 743"/>
                <a:gd name="T24" fmla="*/ 461 w 817"/>
                <a:gd name="T25" fmla="*/ 422 h 743"/>
                <a:gd name="T26" fmla="*/ 455 w 817"/>
                <a:gd name="T27" fmla="*/ 453 h 743"/>
                <a:gd name="T28" fmla="*/ 455 w 817"/>
                <a:gd name="T29" fmla="*/ 493 h 743"/>
                <a:gd name="T30" fmla="*/ 459 w 817"/>
                <a:gd name="T31" fmla="*/ 631 h 743"/>
                <a:gd name="T32" fmla="*/ 466 w 817"/>
                <a:gd name="T33" fmla="*/ 690 h 743"/>
                <a:gd name="T34" fmla="*/ 486 w 817"/>
                <a:gd name="T35" fmla="*/ 704 h 743"/>
                <a:gd name="T36" fmla="*/ 564 w 817"/>
                <a:gd name="T37" fmla="*/ 710 h 743"/>
                <a:gd name="T38" fmla="*/ 564 w 817"/>
                <a:gd name="T39" fmla="*/ 743 h 743"/>
                <a:gd name="T40" fmla="*/ 410 w 817"/>
                <a:gd name="T41" fmla="*/ 740 h 743"/>
                <a:gd name="T42" fmla="*/ 244 w 817"/>
                <a:gd name="T43" fmla="*/ 743 h 743"/>
                <a:gd name="T44" fmla="*/ 244 w 817"/>
                <a:gd name="T45" fmla="*/ 710 h 743"/>
                <a:gd name="T46" fmla="*/ 322 w 817"/>
                <a:gd name="T47" fmla="*/ 704 h 743"/>
                <a:gd name="T48" fmla="*/ 341 w 817"/>
                <a:gd name="T49" fmla="*/ 692 h 743"/>
                <a:gd name="T50" fmla="*/ 350 w 817"/>
                <a:gd name="T51" fmla="*/ 641 h 743"/>
                <a:gd name="T52" fmla="*/ 353 w 817"/>
                <a:gd name="T53" fmla="*/ 493 h 743"/>
                <a:gd name="T54" fmla="*/ 353 w 817"/>
                <a:gd name="T55" fmla="*/ 432 h 743"/>
                <a:gd name="T56" fmla="*/ 331 w 817"/>
                <a:gd name="T57" fmla="*/ 390 h 743"/>
                <a:gd name="T58" fmla="*/ 275 w 817"/>
                <a:gd name="T59" fmla="*/ 300 h 743"/>
                <a:gd name="T60" fmla="*/ 135 w 817"/>
                <a:gd name="T61" fmla="*/ 102 h 743"/>
                <a:gd name="T62" fmla="*/ 96 w 817"/>
                <a:gd name="T63" fmla="*/ 51 h 743"/>
                <a:gd name="T64" fmla="*/ 69 w 817"/>
                <a:gd name="T65" fmla="*/ 39 h 743"/>
                <a:gd name="T66" fmla="*/ 0 w 817"/>
                <a:gd name="T67" fmla="*/ 33 h 743"/>
                <a:gd name="T68" fmla="*/ 0 w 817"/>
                <a:gd name="T69" fmla="*/ 0 h 743"/>
                <a:gd name="T70" fmla="*/ 130 w 817"/>
                <a:gd name="T71" fmla="*/ 3 h 743"/>
                <a:gd name="T72" fmla="*/ 333 w 817"/>
                <a:gd name="T73" fmla="*/ 0 h 743"/>
                <a:gd name="T74" fmla="*/ 333 w 817"/>
                <a:gd name="T75" fmla="*/ 33 h 743"/>
                <a:gd name="T76" fmla="*/ 246 w 817"/>
                <a:gd name="T77" fmla="*/ 39 h 743"/>
                <a:gd name="T78" fmla="*/ 234 w 817"/>
                <a:gd name="T79" fmla="*/ 52 h 743"/>
                <a:gd name="T80" fmla="*/ 262 w 817"/>
                <a:gd name="T81" fmla="*/ 111 h 743"/>
                <a:gd name="T82" fmla="*/ 426 w 817"/>
                <a:gd name="T83" fmla="*/ 376 h 743"/>
                <a:gd name="T84" fmla="*/ 601 w 817"/>
                <a:gd name="T85" fmla="*/ 111 h 74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Lst>
              <a:rect l="0" t="0" r="r" b="b"/>
              <a:pathLst>
                <a:path w="817" h="743">
                  <a:moveTo>
                    <a:pt x="601" y="111"/>
                  </a:moveTo>
                  <a:cubicBezTo>
                    <a:pt x="623" y="78"/>
                    <a:pt x="634" y="59"/>
                    <a:pt x="634" y="52"/>
                  </a:cubicBezTo>
                  <a:cubicBezTo>
                    <a:pt x="634" y="46"/>
                    <a:pt x="631" y="41"/>
                    <a:pt x="624" y="39"/>
                  </a:cubicBezTo>
                  <a:cubicBezTo>
                    <a:pt x="616" y="36"/>
                    <a:pt x="585" y="34"/>
                    <a:pt x="543" y="33"/>
                  </a:cubicBezTo>
                  <a:cubicBezTo>
                    <a:pt x="543" y="0"/>
                    <a:pt x="543" y="0"/>
                    <a:pt x="543" y="0"/>
                  </a:cubicBezTo>
                  <a:cubicBezTo>
                    <a:pt x="610" y="2"/>
                    <a:pt x="650" y="3"/>
                    <a:pt x="688" y="3"/>
                  </a:cubicBezTo>
                  <a:cubicBezTo>
                    <a:pt x="725" y="3"/>
                    <a:pt x="745" y="2"/>
                    <a:pt x="817" y="0"/>
                  </a:cubicBezTo>
                  <a:cubicBezTo>
                    <a:pt x="817" y="33"/>
                    <a:pt x="817" y="33"/>
                    <a:pt x="817" y="33"/>
                  </a:cubicBezTo>
                  <a:cubicBezTo>
                    <a:pt x="773" y="34"/>
                    <a:pt x="757" y="36"/>
                    <a:pt x="746" y="39"/>
                  </a:cubicBezTo>
                  <a:cubicBezTo>
                    <a:pt x="735" y="41"/>
                    <a:pt x="725" y="46"/>
                    <a:pt x="718" y="51"/>
                  </a:cubicBezTo>
                  <a:cubicBezTo>
                    <a:pt x="709" y="58"/>
                    <a:pt x="695" y="75"/>
                    <a:pt x="675" y="102"/>
                  </a:cubicBezTo>
                  <a:cubicBezTo>
                    <a:pt x="514" y="333"/>
                    <a:pt x="514" y="333"/>
                    <a:pt x="514" y="333"/>
                  </a:cubicBezTo>
                  <a:cubicBezTo>
                    <a:pt x="483" y="381"/>
                    <a:pt x="465" y="411"/>
                    <a:pt x="461" y="422"/>
                  </a:cubicBezTo>
                  <a:cubicBezTo>
                    <a:pt x="457" y="433"/>
                    <a:pt x="455" y="443"/>
                    <a:pt x="455" y="453"/>
                  </a:cubicBezTo>
                  <a:cubicBezTo>
                    <a:pt x="455" y="493"/>
                    <a:pt x="455" y="493"/>
                    <a:pt x="455" y="493"/>
                  </a:cubicBezTo>
                  <a:cubicBezTo>
                    <a:pt x="455" y="541"/>
                    <a:pt x="456" y="587"/>
                    <a:pt x="459" y="631"/>
                  </a:cubicBezTo>
                  <a:cubicBezTo>
                    <a:pt x="460" y="665"/>
                    <a:pt x="462" y="684"/>
                    <a:pt x="466" y="690"/>
                  </a:cubicBezTo>
                  <a:cubicBezTo>
                    <a:pt x="470" y="696"/>
                    <a:pt x="477" y="701"/>
                    <a:pt x="486" y="704"/>
                  </a:cubicBezTo>
                  <a:cubicBezTo>
                    <a:pt x="495" y="707"/>
                    <a:pt x="521" y="709"/>
                    <a:pt x="564" y="710"/>
                  </a:cubicBezTo>
                  <a:cubicBezTo>
                    <a:pt x="564" y="743"/>
                    <a:pt x="564" y="743"/>
                    <a:pt x="564" y="743"/>
                  </a:cubicBezTo>
                  <a:cubicBezTo>
                    <a:pt x="505" y="741"/>
                    <a:pt x="453" y="740"/>
                    <a:pt x="410" y="740"/>
                  </a:cubicBezTo>
                  <a:cubicBezTo>
                    <a:pt x="368" y="740"/>
                    <a:pt x="313" y="741"/>
                    <a:pt x="244" y="743"/>
                  </a:cubicBezTo>
                  <a:cubicBezTo>
                    <a:pt x="244" y="710"/>
                    <a:pt x="244" y="710"/>
                    <a:pt x="244" y="710"/>
                  </a:cubicBezTo>
                  <a:cubicBezTo>
                    <a:pt x="287" y="709"/>
                    <a:pt x="313" y="707"/>
                    <a:pt x="322" y="704"/>
                  </a:cubicBezTo>
                  <a:cubicBezTo>
                    <a:pt x="332" y="701"/>
                    <a:pt x="338" y="697"/>
                    <a:pt x="341" y="692"/>
                  </a:cubicBezTo>
                  <a:cubicBezTo>
                    <a:pt x="346" y="685"/>
                    <a:pt x="349" y="668"/>
                    <a:pt x="350" y="641"/>
                  </a:cubicBezTo>
                  <a:cubicBezTo>
                    <a:pt x="350" y="634"/>
                    <a:pt x="351" y="585"/>
                    <a:pt x="353" y="493"/>
                  </a:cubicBezTo>
                  <a:cubicBezTo>
                    <a:pt x="353" y="432"/>
                    <a:pt x="353" y="432"/>
                    <a:pt x="353" y="432"/>
                  </a:cubicBezTo>
                  <a:cubicBezTo>
                    <a:pt x="345" y="417"/>
                    <a:pt x="338" y="403"/>
                    <a:pt x="331" y="390"/>
                  </a:cubicBezTo>
                  <a:cubicBezTo>
                    <a:pt x="325" y="382"/>
                    <a:pt x="307" y="352"/>
                    <a:pt x="275" y="300"/>
                  </a:cubicBezTo>
                  <a:cubicBezTo>
                    <a:pt x="135" y="102"/>
                    <a:pt x="135" y="102"/>
                    <a:pt x="135" y="102"/>
                  </a:cubicBezTo>
                  <a:cubicBezTo>
                    <a:pt x="118" y="75"/>
                    <a:pt x="105" y="58"/>
                    <a:pt x="96" y="51"/>
                  </a:cubicBezTo>
                  <a:cubicBezTo>
                    <a:pt x="89" y="46"/>
                    <a:pt x="80" y="41"/>
                    <a:pt x="69" y="39"/>
                  </a:cubicBezTo>
                  <a:cubicBezTo>
                    <a:pt x="58" y="36"/>
                    <a:pt x="44" y="34"/>
                    <a:pt x="0" y="33"/>
                  </a:cubicBezTo>
                  <a:cubicBezTo>
                    <a:pt x="0" y="0"/>
                    <a:pt x="0" y="0"/>
                    <a:pt x="0" y="0"/>
                  </a:cubicBezTo>
                  <a:cubicBezTo>
                    <a:pt x="72" y="2"/>
                    <a:pt x="94" y="3"/>
                    <a:pt x="130" y="3"/>
                  </a:cubicBezTo>
                  <a:cubicBezTo>
                    <a:pt x="168" y="3"/>
                    <a:pt x="265" y="2"/>
                    <a:pt x="333" y="0"/>
                  </a:cubicBezTo>
                  <a:cubicBezTo>
                    <a:pt x="333" y="33"/>
                    <a:pt x="333" y="33"/>
                    <a:pt x="333" y="33"/>
                  </a:cubicBezTo>
                  <a:cubicBezTo>
                    <a:pt x="291" y="34"/>
                    <a:pt x="254" y="36"/>
                    <a:pt x="246" y="39"/>
                  </a:cubicBezTo>
                  <a:cubicBezTo>
                    <a:pt x="239" y="41"/>
                    <a:pt x="235" y="46"/>
                    <a:pt x="234" y="52"/>
                  </a:cubicBezTo>
                  <a:cubicBezTo>
                    <a:pt x="234" y="59"/>
                    <a:pt x="243" y="78"/>
                    <a:pt x="262" y="111"/>
                  </a:cubicBezTo>
                  <a:cubicBezTo>
                    <a:pt x="426" y="376"/>
                    <a:pt x="426" y="376"/>
                    <a:pt x="426" y="376"/>
                  </a:cubicBezTo>
                  <a:lnTo>
                    <a:pt x="601" y="111"/>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9" name="Freeform 15"/>
            <p:cNvSpPr>
              <a:spLocks noEditPoints="1"/>
            </p:cNvSpPr>
            <p:nvPr userDrawn="1"/>
          </p:nvSpPr>
          <p:spPr bwMode="auto">
            <a:xfrm>
              <a:off x="1558925" y="681038"/>
              <a:ext cx="263525" cy="246063"/>
            </a:xfrm>
            <a:custGeom>
              <a:avLst/>
              <a:gdLst>
                <a:gd name="T0" fmla="*/ 148 w 830"/>
                <a:gd name="T1" fmla="*/ 190 h 775"/>
                <a:gd name="T2" fmla="*/ 247 w 830"/>
                <a:gd name="T3" fmla="*/ 82 h 775"/>
                <a:gd name="T4" fmla="*/ 399 w 830"/>
                <a:gd name="T5" fmla="*/ 45 h 775"/>
                <a:gd name="T6" fmla="*/ 512 w 830"/>
                <a:gd name="T7" fmla="*/ 62 h 775"/>
                <a:gd name="T8" fmla="*/ 596 w 830"/>
                <a:gd name="T9" fmla="*/ 106 h 775"/>
                <a:gd name="T10" fmla="*/ 652 w 830"/>
                <a:gd name="T11" fmla="*/ 167 h 775"/>
                <a:gd name="T12" fmla="*/ 690 w 830"/>
                <a:gd name="T13" fmla="*/ 245 h 775"/>
                <a:gd name="T14" fmla="*/ 713 w 830"/>
                <a:gd name="T15" fmla="*/ 398 h 775"/>
                <a:gd name="T16" fmla="*/ 681 w 830"/>
                <a:gd name="T17" fmla="*/ 571 h 775"/>
                <a:gd name="T18" fmla="*/ 584 w 830"/>
                <a:gd name="T19" fmla="*/ 686 h 775"/>
                <a:gd name="T20" fmla="*/ 431 w 830"/>
                <a:gd name="T21" fmla="*/ 727 h 775"/>
                <a:gd name="T22" fmla="*/ 315 w 830"/>
                <a:gd name="T23" fmla="*/ 707 h 775"/>
                <a:gd name="T24" fmla="*/ 220 w 830"/>
                <a:gd name="T25" fmla="*/ 644 h 775"/>
                <a:gd name="T26" fmla="*/ 151 w 830"/>
                <a:gd name="T27" fmla="*/ 539 h 775"/>
                <a:gd name="T28" fmla="*/ 125 w 830"/>
                <a:gd name="T29" fmla="*/ 450 h 775"/>
                <a:gd name="T30" fmla="*/ 115 w 830"/>
                <a:gd name="T31" fmla="*/ 349 h 775"/>
                <a:gd name="T32" fmla="*/ 148 w 830"/>
                <a:gd name="T33" fmla="*/ 190 h 775"/>
                <a:gd name="T34" fmla="*/ 26 w 830"/>
                <a:gd name="T35" fmla="*/ 541 h 775"/>
                <a:gd name="T36" fmla="*/ 105 w 830"/>
                <a:gd name="T37" fmla="*/ 669 h 775"/>
                <a:gd name="T38" fmla="*/ 231 w 830"/>
                <a:gd name="T39" fmla="*/ 748 h 775"/>
                <a:gd name="T40" fmla="*/ 392 w 830"/>
                <a:gd name="T41" fmla="*/ 775 h 775"/>
                <a:gd name="T42" fmla="*/ 706 w 830"/>
                <a:gd name="T43" fmla="*/ 657 h 775"/>
                <a:gd name="T44" fmla="*/ 830 w 830"/>
                <a:gd name="T45" fmla="*/ 364 h 775"/>
                <a:gd name="T46" fmla="*/ 817 w 830"/>
                <a:gd name="T47" fmla="*/ 261 h 775"/>
                <a:gd name="T48" fmla="*/ 784 w 830"/>
                <a:gd name="T49" fmla="*/ 177 h 775"/>
                <a:gd name="T50" fmla="*/ 709 w 830"/>
                <a:gd name="T51" fmla="*/ 89 h 775"/>
                <a:gd name="T52" fmla="*/ 588 w 830"/>
                <a:gd name="T53" fmla="*/ 25 h 775"/>
                <a:gd name="T54" fmla="*/ 423 w 830"/>
                <a:gd name="T55" fmla="*/ 0 h 775"/>
                <a:gd name="T56" fmla="*/ 249 w 830"/>
                <a:gd name="T57" fmla="*/ 29 h 775"/>
                <a:gd name="T58" fmla="*/ 112 w 830"/>
                <a:gd name="T59" fmla="*/ 113 h 775"/>
                <a:gd name="T60" fmla="*/ 26 w 830"/>
                <a:gd name="T61" fmla="*/ 239 h 775"/>
                <a:gd name="T62" fmla="*/ 0 w 830"/>
                <a:gd name="T63" fmla="*/ 393 h 775"/>
                <a:gd name="T64" fmla="*/ 26 w 830"/>
                <a:gd name="T65" fmla="*/ 541 h 77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Lst>
              <a:rect l="0" t="0" r="r" b="b"/>
              <a:pathLst>
                <a:path w="830" h="775">
                  <a:moveTo>
                    <a:pt x="148" y="190"/>
                  </a:moveTo>
                  <a:cubicBezTo>
                    <a:pt x="170" y="143"/>
                    <a:pt x="203" y="107"/>
                    <a:pt x="247" y="82"/>
                  </a:cubicBezTo>
                  <a:cubicBezTo>
                    <a:pt x="290" y="57"/>
                    <a:pt x="341" y="45"/>
                    <a:pt x="399" y="45"/>
                  </a:cubicBezTo>
                  <a:cubicBezTo>
                    <a:pt x="440" y="45"/>
                    <a:pt x="477" y="51"/>
                    <a:pt x="512" y="62"/>
                  </a:cubicBezTo>
                  <a:cubicBezTo>
                    <a:pt x="546" y="74"/>
                    <a:pt x="575" y="89"/>
                    <a:pt x="596" y="106"/>
                  </a:cubicBezTo>
                  <a:cubicBezTo>
                    <a:pt x="618" y="124"/>
                    <a:pt x="637" y="144"/>
                    <a:pt x="652" y="167"/>
                  </a:cubicBezTo>
                  <a:cubicBezTo>
                    <a:pt x="668" y="190"/>
                    <a:pt x="681" y="216"/>
                    <a:pt x="690" y="245"/>
                  </a:cubicBezTo>
                  <a:cubicBezTo>
                    <a:pt x="706" y="292"/>
                    <a:pt x="713" y="343"/>
                    <a:pt x="713" y="398"/>
                  </a:cubicBezTo>
                  <a:cubicBezTo>
                    <a:pt x="713" y="463"/>
                    <a:pt x="703" y="521"/>
                    <a:pt x="681" y="571"/>
                  </a:cubicBezTo>
                  <a:cubicBezTo>
                    <a:pt x="660" y="620"/>
                    <a:pt x="627" y="659"/>
                    <a:pt x="584" y="686"/>
                  </a:cubicBezTo>
                  <a:cubicBezTo>
                    <a:pt x="541" y="714"/>
                    <a:pt x="490" y="727"/>
                    <a:pt x="431" y="727"/>
                  </a:cubicBezTo>
                  <a:cubicBezTo>
                    <a:pt x="388" y="727"/>
                    <a:pt x="350" y="721"/>
                    <a:pt x="315" y="707"/>
                  </a:cubicBezTo>
                  <a:cubicBezTo>
                    <a:pt x="280" y="694"/>
                    <a:pt x="248" y="673"/>
                    <a:pt x="220" y="644"/>
                  </a:cubicBezTo>
                  <a:cubicBezTo>
                    <a:pt x="192" y="616"/>
                    <a:pt x="169" y="581"/>
                    <a:pt x="151" y="539"/>
                  </a:cubicBezTo>
                  <a:cubicBezTo>
                    <a:pt x="141" y="514"/>
                    <a:pt x="132" y="484"/>
                    <a:pt x="125" y="450"/>
                  </a:cubicBezTo>
                  <a:cubicBezTo>
                    <a:pt x="118" y="416"/>
                    <a:pt x="115" y="382"/>
                    <a:pt x="115" y="349"/>
                  </a:cubicBezTo>
                  <a:cubicBezTo>
                    <a:pt x="115" y="290"/>
                    <a:pt x="126" y="236"/>
                    <a:pt x="148" y="190"/>
                  </a:cubicBezTo>
                  <a:close/>
                  <a:moveTo>
                    <a:pt x="26" y="541"/>
                  </a:moveTo>
                  <a:cubicBezTo>
                    <a:pt x="44" y="591"/>
                    <a:pt x="70" y="634"/>
                    <a:pt x="105" y="669"/>
                  </a:cubicBezTo>
                  <a:cubicBezTo>
                    <a:pt x="139" y="704"/>
                    <a:pt x="181" y="730"/>
                    <a:pt x="231" y="748"/>
                  </a:cubicBezTo>
                  <a:cubicBezTo>
                    <a:pt x="281" y="765"/>
                    <a:pt x="335" y="775"/>
                    <a:pt x="392" y="775"/>
                  </a:cubicBezTo>
                  <a:cubicBezTo>
                    <a:pt x="518" y="775"/>
                    <a:pt x="623" y="736"/>
                    <a:pt x="706" y="657"/>
                  </a:cubicBezTo>
                  <a:cubicBezTo>
                    <a:pt x="788" y="579"/>
                    <a:pt x="830" y="481"/>
                    <a:pt x="830" y="364"/>
                  </a:cubicBezTo>
                  <a:cubicBezTo>
                    <a:pt x="830" y="327"/>
                    <a:pt x="826" y="293"/>
                    <a:pt x="817" y="261"/>
                  </a:cubicBezTo>
                  <a:cubicBezTo>
                    <a:pt x="809" y="228"/>
                    <a:pt x="798" y="200"/>
                    <a:pt x="784" y="177"/>
                  </a:cubicBezTo>
                  <a:cubicBezTo>
                    <a:pt x="766" y="145"/>
                    <a:pt x="741" y="116"/>
                    <a:pt x="709" y="89"/>
                  </a:cubicBezTo>
                  <a:cubicBezTo>
                    <a:pt x="678" y="62"/>
                    <a:pt x="637" y="41"/>
                    <a:pt x="588" y="25"/>
                  </a:cubicBezTo>
                  <a:cubicBezTo>
                    <a:pt x="538" y="8"/>
                    <a:pt x="484" y="0"/>
                    <a:pt x="423" y="0"/>
                  </a:cubicBezTo>
                  <a:cubicBezTo>
                    <a:pt x="358" y="0"/>
                    <a:pt x="300" y="10"/>
                    <a:pt x="249" y="29"/>
                  </a:cubicBezTo>
                  <a:cubicBezTo>
                    <a:pt x="198" y="48"/>
                    <a:pt x="152" y="76"/>
                    <a:pt x="112" y="113"/>
                  </a:cubicBezTo>
                  <a:cubicBezTo>
                    <a:pt x="72" y="151"/>
                    <a:pt x="43" y="193"/>
                    <a:pt x="26" y="239"/>
                  </a:cubicBezTo>
                  <a:cubicBezTo>
                    <a:pt x="8" y="286"/>
                    <a:pt x="0" y="337"/>
                    <a:pt x="0" y="393"/>
                  </a:cubicBezTo>
                  <a:cubicBezTo>
                    <a:pt x="0" y="441"/>
                    <a:pt x="9" y="491"/>
                    <a:pt x="26" y="541"/>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spTree>
    <p:extLst>
      <p:ext uri="{BB962C8B-B14F-4D97-AF65-F5344CB8AC3E}">
        <p14:creationId xmlns:p14="http://schemas.microsoft.com/office/powerpoint/2010/main" val="3217252322"/>
      </p:ext>
    </p:extLst>
  </p:cSld>
  <p:clrMapOvr>
    <a:masterClrMapping/>
  </p:clrMapOvr>
  <p:timing>
    <p:tnLst>
      <p:par>
        <p:cTn id="1" dur="indefinite" restart="never" nodeType="tmRoot"/>
      </p:par>
    </p:tn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58368" y="0"/>
            <a:ext cx="2807208" cy="1371600"/>
          </a:xfrm>
        </p:spPr>
        <p:txBody>
          <a:bodyPr anchor="b"/>
          <a:lstStyle>
            <a:lvl1pPr algn="l">
              <a:defRPr sz="2400" b="0"/>
            </a:lvl1pPr>
          </a:lstStyle>
          <a:p>
            <a:r>
              <a:rPr lang="en-US" smtClean="0"/>
              <a:t>Click to edit Master title style</a:t>
            </a:r>
            <a:endParaRPr lang="en-US"/>
          </a:p>
        </p:txBody>
      </p:sp>
      <p:sp>
        <p:nvSpPr>
          <p:cNvPr id="3" name="Content Placeholder 2"/>
          <p:cNvSpPr>
            <a:spLocks noGrp="1"/>
          </p:cNvSpPr>
          <p:nvPr>
            <p:ph idx="1"/>
          </p:nvPr>
        </p:nvSpPr>
        <p:spPr>
          <a:xfrm>
            <a:off x="3575050" y="457200"/>
            <a:ext cx="4910328" cy="5715000"/>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658368" y="1371600"/>
            <a:ext cx="2807208" cy="4800600"/>
          </a:xfrm>
        </p:spPr>
        <p:txBody>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8D52940-8773-4A70-8AF6-B301E8B4FD31}" type="datetime1">
              <a:rPr lang="en-US" smtClean="0"/>
              <a:t>10/2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DC53FA5-AE81-45E0-8206-920AA27813B4}" type="slidenum">
              <a:rPr lang="en-US" smtClean="0"/>
              <a:t>‹#›</a:t>
            </a:fld>
            <a:endParaRPr lang="en-US"/>
          </a:p>
        </p:txBody>
      </p:sp>
      <p:grpSp>
        <p:nvGrpSpPr>
          <p:cNvPr id="21" name="Group 20"/>
          <p:cNvGrpSpPr/>
          <p:nvPr userDrawn="1"/>
        </p:nvGrpSpPr>
        <p:grpSpPr>
          <a:xfrm>
            <a:off x="120650" y="6299343"/>
            <a:ext cx="420688" cy="458645"/>
            <a:chOff x="657225" y="681038"/>
            <a:chExt cx="1266825" cy="1381125"/>
          </a:xfrm>
          <a:solidFill>
            <a:srgbClr val="FFFFFF"/>
          </a:solidFill>
        </p:grpSpPr>
        <p:sp>
          <p:nvSpPr>
            <p:cNvPr id="22" name="Freeform 5"/>
            <p:cNvSpPr>
              <a:spLocks noEditPoints="1"/>
            </p:cNvSpPr>
            <p:nvPr userDrawn="1"/>
          </p:nvSpPr>
          <p:spPr bwMode="auto">
            <a:xfrm>
              <a:off x="846138" y="1354138"/>
              <a:ext cx="887413" cy="708025"/>
            </a:xfrm>
            <a:custGeom>
              <a:avLst/>
              <a:gdLst>
                <a:gd name="T0" fmla="*/ 2203 w 2794"/>
                <a:gd name="T1" fmla="*/ 0 h 2229"/>
                <a:gd name="T2" fmla="*/ 1613 w 2794"/>
                <a:gd name="T3" fmla="*/ 0 h 2229"/>
                <a:gd name="T4" fmla="*/ 1613 w 2794"/>
                <a:gd name="T5" fmla="*/ 665 h 2229"/>
                <a:gd name="T6" fmla="*/ 1904 w 2794"/>
                <a:gd name="T7" fmla="*/ 1330 h 2229"/>
                <a:gd name="T8" fmla="*/ 1904 w 2794"/>
                <a:gd name="T9" fmla="*/ 1237 h 2229"/>
                <a:gd name="T10" fmla="*/ 1749 w 2794"/>
                <a:gd name="T11" fmla="*/ 747 h 2229"/>
                <a:gd name="T12" fmla="*/ 1749 w 2794"/>
                <a:gd name="T13" fmla="*/ 573 h 2229"/>
                <a:gd name="T14" fmla="*/ 1972 w 2794"/>
                <a:gd name="T15" fmla="*/ 573 h 2229"/>
                <a:gd name="T16" fmla="*/ 1972 w 2794"/>
                <a:gd name="T17" fmla="*/ 1332 h 2229"/>
                <a:gd name="T18" fmla="*/ 1401 w 2794"/>
                <a:gd name="T19" fmla="*/ 2182 h 2229"/>
                <a:gd name="T20" fmla="*/ 829 w 2794"/>
                <a:gd name="T21" fmla="*/ 1374 h 2229"/>
                <a:gd name="T22" fmla="*/ 1180 w 2794"/>
                <a:gd name="T23" fmla="*/ 665 h 2229"/>
                <a:gd name="T24" fmla="*/ 1180 w 2794"/>
                <a:gd name="T25" fmla="*/ 573 h 2229"/>
                <a:gd name="T26" fmla="*/ 1401 w 2794"/>
                <a:gd name="T27" fmla="*/ 573 h 2229"/>
                <a:gd name="T28" fmla="*/ 1542 w 2794"/>
                <a:gd name="T29" fmla="*/ 573 h 2229"/>
                <a:gd name="T30" fmla="*/ 1542 w 2794"/>
                <a:gd name="T31" fmla="*/ 436 h 2229"/>
                <a:gd name="T32" fmla="*/ 1401 w 2794"/>
                <a:gd name="T33" fmla="*/ 436 h 2229"/>
                <a:gd name="T34" fmla="*/ 1180 w 2794"/>
                <a:gd name="T35" fmla="*/ 436 h 2229"/>
                <a:gd name="T36" fmla="*/ 1180 w 2794"/>
                <a:gd name="T37" fmla="*/ 436 h 2229"/>
                <a:gd name="T38" fmla="*/ 1044 w 2794"/>
                <a:gd name="T39" fmla="*/ 436 h 2229"/>
                <a:gd name="T40" fmla="*/ 1044 w 2794"/>
                <a:gd name="T41" fmla="*/ 436 h 2229"/>
                <a:gd name="T42" fmla="*/ 692 w 2794"/>
                <a:gd name="T43" fmla="*/ 436 h 2229"/>
                <a:gd name="T44" fmla="*/ 692 w 2794"/>
                <a:gd name="T45" fmla="*/ 1234 h 2229"/>
                <a:gd name="T46" fmla="*/ 695 w 2794"/>
                <a:gd name="T47" fmla="*/ 1315 h 2229"/>
                <a:gd name="T48" fmla="*/ 695 w 2794"/>
                <a:gd name="T49" fmla="*/ 1315 h 2229"/>
                <a:gd name="T50" fmla="*/ 829 w 2794"/>
                <a:gd name="T51" fmla="*/ 1205 h 2229"/>
                <a:gd name="T52" fmla="*/ 829 w 2794"/>
                <a:gd name="T53" fmla="*/ 1205 h 2229"/>
                <a:gd name="T54" fmla="*/ 829 w 2794"/>
                <a:gd name="T55" fmla="*/ 573 h 2229"/>
                <a:gd name="T56" fmla="*/ 1044 w 2794"/>
                <a:gd name="T57" fmla="*/ 573 h 2229"/>
                <a:gd name="T58" fmla="*/ 1044 w 2794"/>
                <a:gd name="T59" fmla="*/ 573 h 2229"/>
                <a:gd name="T60" fmla="*/ 1044 w 2794"/>
                <a:gd name="T61" fmla="*/ 747 h 2229"/>
                <a:gd name="T62" fmla="*/ 590 w 2794"/>
                <a:gd name="T63" fmla="*/ 1447 h 2229"/>
                <a:gd name="T64" fmla="*/ 135 w 2794"/>
                <a:gd name="T65" fmla="*/ 747 h 2229"/>
                <a:gd name="T66" fmla="*/ 135 w 2794"/>
                <a:gd name="T67" fmla="*/ 136 h 2229"/>
                <a:gd name="T68" fmla="*/ 590 w 2794"/>
                <a:gd name="T69" fmla="*/ 136 h 2229"/>
                <a:gd name="T70" fmla="*/ 1044 w 2794"/>
                <a:gd name="T71" fmla="*/ 136 h 2229"/>
                <a:gd name="T72" fmla="*/ 1044 w 2794"/>
                <a:gd name="T73" fmla="*/ 370 h 2229"/>
                <a:gd name="T74" fmla="*/ 1180 w 2794"/>
                <a:gd name="T75" fmla="*/ 370 h 2229"/>
                <a:gd name="T76" fmla="*/ 1180 w 2794"/>
                <a:gd name="T77" fmla="*/ 0 h 2229"/>
                <a:gd name="T78" fmla="*/ 590 w 2794"/>
                <a:gd name="T79" fmla="*/ 0 h 2229"/>
                <a:gd name="T80" fmla="*/ 0 w 2794"/>
                <a:gd name="T81" fmla="*/ 0 h 2229"/>
                <a:gd name="T82" fmla="*/ 0 w 2794"/>
                <a:gd name="T83" fmla="*/ 665 h 2229"/>
                <a:gd name="T84" fmla="*/ 590 w 2794"/>
                <a:gd name="T85" fmla="*/ 1495 h 2229"/>
                <a:gd name="T86" fmla="*/ 708 w 2794"/>
                <a:gd name="T87" fmla="*/ 1444 h 2229"/>
                <a:gd name="T88" fmla="*/ 1401 w 2794"/>
                <a:gd name="T89" fmla="*/ 2229 h 2229"/>
                <a:gd name="T90" fmla="*/ 2093 w 2794"/>
                <a:gd name="T91" fmla="*/ 1447 h 2229"/>
                <a:gd name="T92" fmla="*/ 2203 w 2794"/>
                <a:gd name="T93" fmla="*/ 1495 h 2229"/>
                <a:gd name="T94" fmla="*/ 2794 w 2794"/>
                <a:gd name="T95" fmla="*/ 665 h 2229"/>
                <a:gd name="T96" fmla="*/ 2794 w 2794"/>
                <a:gd name="T97" fmla="*/ 0 h 2229"/>
                <a:gd name="T98" fmla="*/ 2203 w 2794"/>
                <a:gd name="T99" fmla="*/ 0 h 2229"/>
                <a:gd name="T100" fmla="*/ 2658 w 2794"/>
                <a:gd name="T101" fmla="*/ 747 h 2229"/>
                <a:gd name="T102" fmla="*/ 2203 w 2794"/>
                <a:gd name="T103" fmla="*/ 1447 h 2229"/>
                <a:gd name="T104" fmla="*/ 2100 w 2794"/>
                <a:gd name="T105" fmla="*/ 1395 h 2229"/>
                <a:gd name="T106" fmla="*/ 2109 w 2794"/>
                <a:gd name="T107" fmla="*/ 1234 h 2229"/>
                <a:gd name="T108" fmla="*/ 2109 w 2794"/>
                <a:gd name="T109" fmla="*/ 436 h 2229"/>
                <a:gd name="T110" fmla="*/ 1749 w 2794"/>
                <a:gd name="T111" fmla="*/ 436 h 2229"/>
                <a:gd name="T112" fmla="*/ 1749 w 2794"/>
                <a:gd name="T113" fmla="*/ 136 h 2229"/>
                <a:gd name="T114" fmla="*/ 2203 w 2794"/>
                <a:gd name="T115" fmla="*/ 136 h 2229"/>
                <a:gd name="T116" fmla="*/ 2658 w 2794"/>
                <a:gd name="T117" fmla="*/ 136 h 2229"/>
                <a:gd name="T118" fmla="*/ 2658 w 2794"/>
                <a:gd name="T119" fmla="*/ 747 h 222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 ang="0">
                  <a:pos x="T118" y="T119"/>
                </a:cxn>
              </a:cxnLst>
              <a:rect l="0" t="0" r="r" b="b"/>
              <a:pathLst>
                <a:path w="2794" h="2229">
                  <a:moveTo>
                    <a:pt x="2203" y="0"/>
                  </a:moveTo>
                  <a:cubicBezTo>
                    <a:pt x="1613" y="0"/>
                    <a:pt x="1613" y="0"/>
                    <a:pt x="1613" y="0"/>
                  </a:cubicBezTo>
                  <a:cubicBezTo>
                    <a:pt x="1613" y="665"/>
                    <a:pt x="1613" y="665"/>
                    <a:pt x="1613" y="665"/>
                  </a:cubicBezTo>
                  <a:cubicBezTo>
                    <a:pt x="1613" y="970"/>
                    <a:pt x="1719" y="1183"/>
                    <a:pt x="1904" y="1330"/>
                  </a:cubicBezTo>
                  <a:cubicBezTo>
                    <a:pt x="1904" y="1237"/>
                    <a:pt x="1904" y="1237"/>
                    <a:pt x="1904" y="1237"/>
                  </a:cubicBezTo>
                  <a:cubicBezTo>
                    <a:pt x="1769" y="1081"/>
                    <a:pt x="1749" y="901"/>
                    <a:pt x="1749" y="747"/>
                  </a:cubicBezTo>
                  <a:cubicBezTo>
                    <a:pt x="1749" y="573"/>
                    <a:pt x="1749" y="573"/>
                    <a:pt x="1749" y="573"/>
                  </a:cubicBezTo>
                  <a:cubicBezTo>
                    <a:pt x="1972" y="573"/>
                    <a:pt x="1972" y="573"/>
                    <a:pt x="1972" y="573"/>
                  </a:cubicBezTo>
                  <a:cubicBezTo>
                    <a:pt x="1972" y="1332"/>
                    <a:pt x="1972" y="1332"/>
                    <a:pt x="1972" y="1332"/>
                  </a:cubicBezTo>
                  <a:cubicBezTo>
                    <a:pt x="1972" y="1609"/>
                    <a:pt x="1895" y="1961"/>
                    <a:pt x="1401" y="2182"/>
                  </a:cubicBezTo>
                  <a:cubicBezTo>
                    <a:pt x="931" y="1972"/>
                    <a:pt x="838" y="1643"/>
                    <a:pt x="829" y="1374"/>
                  </a:cubicBezTo>
                  <a:cubicBezTo>
                    <a:pt x="1051" y="1225"/>
                    <a:pt x="1180" y="1001"/>
                    <a:pt x="1180" y="665"/>
                  </a:cubicBezTo>
                  <a:cubicBezTo>
                    <a:pt x="1180" y="573"/>
                    <a:pt x="1180" y="573"/>
                    <a:pt x="1180" y="573"/>
                  </a:cubicBezTo>
                  <a:cubicBezTo>
                    <a:pt x="1401" y="573"/>
                    <a:pt x="1401" y="573"/>
                    <a:pt x="1401" y="573"/>
                  </a:cubicBezTo>
                  <a:cubicBezTo>
                    <a:pt x="1542" y="573"/>
                    <a:pt x="1542" y="573"/>
                    <a:pt x="1542" y="573"/>
                  </a:cubicBezTo>
                  <a:cubicBezTo>
                    <a:pt x="1542" y="436"/>
                    <a:pt x="1542" y="436"/>
                    <a:pt x="1542" y="436"/>
                  </a:cubicBezTo>
                  <a:cubicBezTo>
                    <a:pt x="1401" y="436"/>
                    <a:pt x="1401" y="436"/>
                    <a:pt x="1401" y="436"/>
                  </a:cubicBezTo>
                  <a:cubicBezTo>
                    <a:pt x="1180" y="436"/>
                    <a:pt x="1180" y="436"/>
                    <a:pt x="1180" y="436"/>
                  </a:cubicBezTo>
                  <a:cubicBezTo>
                    <a:pt x="1180" y="436"/>
                    <a:pt x="1180" y="436"/>
                    <a:pt x="1180" y="436"/>
                  </a:cubicBezTo>
                  <a:cubicBezTo>
                    <a:pt x="1044" y="436"/>
                    <a:pt x="1044" y="436"/>
                    <a:pt x="1044" y="436"/>
                  </a:cubicBezTo>
                  <a:cubicBezTo>
                    <a:pt x="1044" y="436"/>
                    <a:pt x="1044" y="436"/>
                    <a:pt x="1044" y="436"/>
                  </a:cubicBezTo>
                  <a:cubicBezTo>
                    <a:pt x="692" y="436"/>
                    <a:pt x="692" y="436"/>
                    <a:pt x="692" y="436"/>
                  </a:cubicBezTo>
                  <a:cubicBezTo>
                    <a:pt x="692" y="1234"/>
                    <a:pt x="692" y="1234"/>
                    <a:pt x="692" y="1234"/>
                  </a:cubicBezTo>
                  <a:cubicBezTo>
                    <a:pt x="692" y="1262"/>
                    <a:pt x="693" y="1289"/>
                    <a:pt x="695" y="1315"/>
                  </a:cubicBezTo>
                  <a:cubicBezTo>
                    <a:pt x="695" y="1315"/>
                    <a:pt x="695" y="1315"/>
                    <a:pt x="695" y="1315"/>
                  </a:cubicBezTo>
                  <a:cubicBezTo>
                    <a:pt x="748" y="1280"/>
                    <a:pt x="792" y="1244"/>
                    <a:pt x="829" y="1205"/>
                  </a:cubicBezTo>
                  <a:cubicBezTo>
                    <a:pt x="829" y="1205"/>
                    <a:pt x="829" y="1205"/>
                    <a:pt x="829" y="1205"/>
                  </a:cubicBezTo>
                  <a:cubicBezTo>
                    <a:pt x="829" y="573"/>
                    <a:pt x="829" y="573"/>
                    <a:pt x="829" y="573"/>
                  </a:cubicBezTo>
                  <a:cubicBezTo>
                    <a:pt x="1044" y="573"/>
                    <a:pt x="1044" y="573"/>
                    <a:pt x="1044" y="573"/>
                  </a:cubicBezTo>
                  <a:cubicBezTo>
                    <a:pt x="1044" y="573"/>
                    <a:pt x="1044" y="573"/>
                    <a:pt x="1044" y="573"/>
                  </a:cubicBezTo>
                  <a:cubicBezTo>
                    <a:pt x="1044" y="747"/>
                    <a:pt x="1044" y="747"/>
                    <a:pt x="1044" y="747"/>
                  </a:cubicBezTo>
                  <a:cubicBezTo>
                    <a:pt x="1044" y="978"/>
                    <a:pt x="1001" y="1263"/>
                    <a:pt x="590" y="1447"/>
                  </a:cubicBezTo>
                  <a:cubicBezTo>
                    <a:pt x="178" y="1263"/>
                    <a:pt x="135" y="978"/>
                    <a:pt x="135" y="747"/>
                  </a:cubicBezTo>
                  <a:cubicBezTo>
                    <a:pt x="135" y="136"/>
                    <a:pt x="135" y="136"/>
                    <a:pt x="135" y="136"/>
                  </a:cubicBezTo>
                  <a:cubicBezTo>
                    <a:pt x="590" y="136"/>
                    <a:pt x="590" y="136"/>
                    <a:pt x="590" y="136"/>
                  </a:cubicBezTo>
                  <a:cubicBezTo>
                    <a:pt x="1044" y="136"/>
                    <a:pt x="1044" y="136"/>
                    <a:pt x="1044" y="136"/>
                  </a:cubicBezTo>
                  <a:cubicBezTo>
                    <a:pt x="1044" y="370"/>
                    <a:pt x="1044" y="370"/>
                    <a:pt x="1044" y="370"/>
                  </a:cubicBezTo>
                  <a:cubicBezTo>
                    <a:pt x="1180" y="370"/>
                    <a:pt x="1180" y="370"/>
                    <a:pt x="1180" y="370"/>
                  </a:cubicBezTo>
                  <a:cubicBezTo>
                    <a:pt x="1180" y="0"/>
                    <a:pt x="1180" y="0"/>
                    <a:pt x="1180" y="0"/>
                  </a:cubicBezTo>
                  <a:cubicBezTo>
                    <a:pt x="590" y="0"/>
                    <a:pt x="590" y="0"/>
                    <a:pt x="590" y="0"/>
                  </a:cubicBezTo>
                  <a:cubicBezTo>
                    <a:pt x="0" y="0"/>
                    <a:pt x="0" y="0"/>
                    <a:pt x="0" y="0"/>
                  </a:cubicBezTo>
                  <a:cubicBezTo>
                    <a:pt x="0" y="665"/>
                    <a:pt x="0" y="665"/>
                    <a:pt x="0" y="665"/>
                  </a:cubicBezTo>
                  <a:cubicBezTo>
                    <a:pt x="0" y="1109"/>
                    <a:pt x="224" y="1357"/>
                    <a:pt x="590" y="1495"/>
                  </a:cubicBezTo>
                  <a:cubicBezTo>
                    <a:pt x="631" y="1479"/>
                    <a:pt x="670" y="1462"/>
                    <a:pt x="708" y="1444"/>
                  </a:cubicBezTo>
                  <a:cubicBezTo>
                    <a:pt x="771" y="1847"/>
                    <a:pt x="1023" y="2087"/>
                    <a:pt x="1401" y="2229"/>
                  </a:cubicBezTo>
                  <a:cubicBezTo>
                    <a:pt x="1777" y="2087"/>
                    <a:pt x="2029" y="1848"/>
                    <a:pt x="2093" y="1447"/>
                  </a:cubicBezTo>
                  <a:cubicBezTo>
                    <a:pt x="2128" y="1464"/>
                    <a:pt x="2165" y="1480"/>
                    <a:pt x="2203" y="1495"/>
                  </a:cubicBezTo>
                  <a:cubicBezTo>
                    <a:pt x="2569" y="1357"/>
                    <a:pt x="2794" y="1109"/>
                    <a:pt x="2794" y="665"/>
                  </a:cubicBezTo>
                  <a:cubicBezTo>
                    <a:pt x="2794" y="0"/>
                    <a:pt x="2794" y="0"/>
                    <a:pt x="2794" y="0"/>
                  </a:cubicBezTo>
                  <a:lnTo>
                    <a:pt x="2203" y="0"/>
                  </a:lnTo>
                  <a:close/>
                  <a:moveTo>
                    <a:pt x="2658" y="747"/>
                  </a:moveTo>
                  <a:cubicBezTo>
                    <a:pt x="2658" y="978"/>
                    <a:pt x="2615" y="1263"/>
                    <a:pt x="2203" y="1447"/>
                  </a:cubicBezTo>
                  <a:cubicBezTo>
                    <a:pt x="2166" y="1431"/>
                    <a:pt x="2131" y="1413"/>
                    <a:pt x="2100" y="1395"/>
                  </a:cubicBezTo>
                  <a:cubicBezTo>
                    <a:pt x="2106" y="1344"/>
                    <a:pt x="2109" y="1290"/>
                    <a:pt x="2109" y="1234"/>
                  </a:cubicBezTo>
                  <a:cubicBezTo>
                    <a:pt x="2109" y="436"/>
                    <a:pt x="2109" y="436"/>
                    <a:pt x="2109" y="436"/>
                  </a:cubicBezTo>
                  <a:cubicBezTo>
                    <a:pt x="1749" y="436"/>
                    <a:pt x="1749" y="436"/>
                    <a:pt x="1749" y="436"/>
                  </a:cubicBezTo>
                  <a:cubicBezTo>
                    <a:pt x="1749" y="136"/>
                    <a:pt x="1749" y="136"/>
                    <a:pt x="1749" y="136"/>
                  </a:cubicBezTo>
                  <a:cubicBezTo>
                    <a:pt x="2203" y="136"/>
                    <a:pt x="2203" y="136"/>
                    <a:pt x="2203" y="136"/>
                  </a:cubicBezTo>
                  <a:cubicBezTo>
                    <a:pt x="2658" y="136"/>
                    <a:pt x="2658" y="136"/>
                    <a:pt x="2658" y="136"/>
                  </a:cubicBezTo>
                  <a:lnTo>
                    <a:pt x="2658" y="74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3" name="Freeform 6"/>
            <p:cNvSpPr>
              <a:spLocks/>
            </p:cNvSpPr>
            <p:nvPr userDrawn="1"/>
          </p:nvSpPr>
          <p:spPr bwMode="auto">
            <a:xfrm>
              <a:off x="915988" y="1003301"/>
              <a:ext cx="188913" cy="236538"/>
            </a:xfrm>
            <a:custGeom>
              <a:avLst/>
              <a:gdLst>
                <a:gd name="T0" fmla="*/ 49 w 596"/>
                <a:gd name="T1" fmla="*/ 747 h 747"/>
                <a:gd name="T2" fmla="*/ 49 w 596"/>
                <a:gd name="T3" fmla="*/ 721 h 747"/>
                <a:gd name="T4" fmla="*/ 91 w 596"/>
                <a:gd name="T5" fmla="*/ 696 h 747"/>
                <a:gd name="T6" fmla="*/ 99 w 596"/>
                <a:gd name="T7" fmla="*/ 684 h 747"/>
                <a:gd name="T8" fmla="*/ 105 w 596"/>
                <a:gd name="T9" fmla="*/ 621 h 747"/>
                <a:gd name="T10" fmla="*/ 109 w 596"/>
                <a:gd name="T11" fmla="*/ 535 h 747"/>
                <a:gd name="T12" fmla="*/ 109 w 596"/>
                <a:gd name="T13" fmla="*/ 252 h 747"/>
                <a:gd name="T14" fmla="*/ 105 w 596"/>
                <a:gd name="T15" fmla="*/ 112 h 747"/>
                <a:gd name="T16" fmla="*/ 98 w 596"/>
                <a:gd name="T17" fmla="*/ 52 h 747"/>
                <a:gd name="T18" fmla="*/ 78 w 596"/>
                <a:gd name="T19" fmla="*/ 39 h 747"/>
                <a:gd name="T20" fmla="*/ 0 w 596"/>
                <a:gd name="T21" fmla="*/ 33 h 747"/>
                <a:gd name="T22" fmla="*/ 0 w 596"/>
                <a:gd name="T23" fmla="*/ 0 h 747"/>
                <a:gd name="T24" fmla="*/ 165 w 596"/>
                <a:gd name="T25" fmla="*/ 3 h 747"/>
                <a:gd name="T26" fmla="*/ 323 w 596"/>
                <a:gd name="T27" fmla="*/ 0 h 747"/>
                <a:gd name="T28" fmla="*/ 323 w 596"/>
                <a:gd name="T29" fmla="*/ 33 h 747"/>
                <a:gd name="T30" fmla="*/ 243 w 596"/>
                <a:gd name="T31" fmla="*/ 39 h 747"/>
                <a:gd name="T32" fmla="*/ 224 w 596"/>
                <a:gd name="T33" fmla="*/ 51 h 747"/>
                <a:gd name="T34" fmla="*/ 216 w 596"/>
                <a:gd name="T35" fmla="*/ 102 h 747"/>
                <a:gd name="T36" fmla="*/ 213 w 596"/>
                <a:gd name="T37" fmla="*/ 252 h 747"/>
                <a:gd name="T38" fmla="*/ 213 w 596"/>
                <a:gd name="T39" fmla="*/ 606 h 747"/>
                <a:gd name="T40" fmla="*/ 216 w 596"/>
                <a:gd name="T41" fmla="*/ 696 h 747"/>
                <a:gd name="T42" fmla="*/ 303 w 596"/>
                <a:gd name="T43" fmla="*/ 700 h 747"/>
                <a:gd name="T44" fmla="*/ 525 w 596"/>
                <a:gd name="T45" fmla="*/ 681 h 747"/>
                <a:gd name="T46" fmla="*/ 538 w 596"/>
                <a:gd name="T47" fmla="*/ 644 h 747"/>
                <a:gd name="T48" fmla="*/ 560 w 596"/>
                <a:gd name="T49" fmla="*/ 557 h 747"/>
                <a:gd name="T50" fmla="*/ 596 w 596"/>
                <a:gd name="T51" fmla="*/ 557 h 747"/>
                <a:gd name="T52" fmla="*/ 573 w 596"/>
                <a:gd name="T53" fmla="*/ 741 h 747"/>
                <a:gd name="T54" fmla="*/ 537 w 596"/>
                <a:gd name="T55" fmla="*/ 746 h 747"/>
                <a:gd name="T56" fmla="*/ 449 w 596"/>
                <a:gd name="T57" fmla="*/ 747 h 747"/>
                <a:gd name="T58" fmla="*/ 156 w 596"/>
                <a:gd name="T59" fmla="*/ 744 h 747"/>
                <a:gd name="T60" fmla="*/ 49 w 596"/>
                <a:gd name="T61" fmla="*/ 747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Lst>
              <a:rect l="0" t="0" r="r" b="b"/>
              <a:pathLst>
                <a:path w="596" h="747">
                  <a:moveTo>
                    <a:pt x="49" y="747"/>
                  </a:moveTo>
                  <a:cubicBezTo>
                    <a:pt x="49" y="721"/>
                    <a:pt x="49" y="721"/>
                    <a:pt x="49" y="721"/>
                  </a:cubicBezTo>
                  <a:cubicBezTo>
                    <a:pt x="71" y="710"/>
                    <a:pt x="85" y="702"/>
                    <a:pt x="91" y="696"/>
                  </a:cubicBezTo>
                  <a:cubicBezTo>
                    <a:pt x="95" y="693"/>
                    <a:pt x="98" y="689"/>
                    <a:pt x="99" y="684"/>
                  </a:cubicBezTo>
                  <a:cubicBezTo>
                    <a:pt x="102" y="675"/>
                    <a:pt x="104" y="654"/>
                    <a:pt x="105" y="621"/>
                  </a:cubicBezTo>
                  <a:cubicBezTo>
                    <a:pt x="108" y="573"/>
                    <a:pt x="109" y="545"/>
                    <a:pt x="109" y="535"/>
                  </a:cubicBezTo>
                  <a:cubicBezTo>
                    <a:pt x="109" y="252"/>
                    <a:pt x="109" y="252"/>
                    <a:pt x="109" y="252"/>
                  </a:cubicBezTo>
                  <a:cubicBezTo>
                    <a:pt x="109" y="204"/>
                    <a:pt x="108" y="157"/>
                    <a:pt x="105" y="112"/>
                  </a:cubicBezTo>
                  <a:cubicBezTo>
                    <a:pt x="104" y="78"/>
                    <a:pt x="102" y="59"/>
                    <a:pt x="98" y="52"/>
                  </a:cubicBezTo>
                  <a:cubicBezTo>
                    <a:pt x="93" y="46"/>
                    <a:pt x="87" y="42"/>
                    <a:pt x="78" y="39"/>
                  </a:cubicBezTo>
                  <a:cubicBezTo>
                    <a:pt x="69" y="36"/>
                    <a:pt x="43" y="34"/>
                    <a:pt x="0" y="33"/>
                  </a:cubicBezTo>
                  <a:cubicBezTo>
                    <a:pt x="0" y="0"/>
                    <a:pt x="0" y="0"/>
                    <a:pt x="0" y="0"/>
                  </a:cubicBezTo>
                  <a:cubicBezTo>
                    <a:pt x="89" y="2"/>
                    <a:pt x="144" y="3"/>
                    <a:pt x="165" y="3"/>
                  </a:cubicBezTo>
                  <a:cubicBezTo>
                    <a:pt x="189" y="3"/>
                    <a:pt x="241" y="2"/>
                    <a:pt x="323" y="0"/>
                  </a:cubicBezTo>
                  <a:cubicBezTo>
                    <a:pt x="323" y="33"/>
                    <a:pt x="323" y="33"/>
                    <a:pt x="323" y="33"/>
                  </a:cubicBezTo>
                  <a:cubicBezTo>
                    <a:pt x="279" y="34"/>
                    <a:pt x="253" y="36"/>
                    <a:pt x="243" y="39"/>
                  </a:cubicBezTo>
                  <a:cubicBezTo>
                    <a:pt x="234" y="42"/>
                    <a:pt x="228" y="46"/>
                    <a:pt x="224" y="51"/>
                  </a:cubicBezTo>
                  <a:cubicBezTo>
                    <a:pt x="220" y="58"/>
                    <a:pt x="217" y="75"/>
                    <a:pt x="216" y="102"/>
                  </a:cubicBezTo>
                  <a:cubicBezTo>
                    <a:pt x="215" y="109"/>
                    <a:pt x="214" y="159"/>
                    <a:pt x="213" y="252"/>
                  </a:cubicBezTo>
                  <a:cubicBezTo>
                    <a:pt x="213" y="606"/>
                    <a:pt x="213" y="606"/>
                    <a:pt x="213" y="606"/>
                  </a:cubicBezTo>
                  <a:cubicBezTo>
                    <a:pt x="213" y="643"/>
                    <a:pt x="214" y="673"/>
                    <a:pt x="216" y="696"/>
                  </a:cubicBezTo>
                  <a:cubicBezTo>
                    <a:pt x="257" y="699"/>
                    <a:pt x="262" y="700"/>
                    <a:pt x="303" y="700"/>
                  </a:cubicBezTo>
                  <a:cubicBezTo>
                    <a:pt x="407" y="700"/>
                    <a:pt x="484" y="693"/>
                    <a:pt x="525" y="681"/>
                  </a:cubicBezTo>
                  <a:cubicBezTo>
                    <a:pt x="530" y="670"/>
                    <a:pt x="534" y="658"/>
                    <a:pt x="538" y="644"/>
                  </a:cubicBezTo>
                  <a:cubicBezTo>
                    <a:pt x="560" y="557"/>
                    <a:pt x="560" y="557"/>
                    <a:pt x="560" y="557"/>
                  </a:cubicBezTo>
                  <a:cubicBezTo>
                    <a:pt x="596" y="557"/>
                    <a:pt x="596" y="557"/>
                    <a:pt x="596" y="557"/>
                  </a:cubicBezTo>
                  <a:cubicBezTo>
                    <a:pt x="588" y="609"/>
                    <a:pt x="580" y="671"/>
                    <a:pt x="573" y="741"/>
                  </a:cubicBezTo>
                  <a:cubicBezTo>
                    <a:pt x="558" y="744"/>
                    <a:pt x="546" y="745"/>
                    <a:pt x="537" y="746"/>
                  </a:cubicBezTo>
                  <a:cubicBezTo>
                    <a:pt x="518" y="747"/>
                    <a:pt x="488" y="747"/>
                    <a:pt x="449" y="747"/>
                  </a:cubicBezTo>
                  <a:cubicBezTo>
                    <a:pt x="156" y="744"/>
                    <a:pt x="156" y="744"/>
                    <a:pt x="156" y="744"/>
                  </a:cubicBezTo>
                  <a:cubicBezTo>
                    <a:pt x="121" y="744"/>
                    <a:pt x="85" y="745"/>
                    <a:pt x="49"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4" name="Freeform 7"/>
            <p:cNvSpPr>
              <a:spLocks/>
            </p:cNvSpPr>
            <p:nvPr userDrawn="1"/>
          </p:nvSpPr>
          <p:spPr bwMode="auto">
            <a:xfrm>
              <a:off x="1127125" y="1003301"/>
              <a:ext cx="103188" cy="236538"/>
            </a:xfrm>
            <a:custGeom>
              <a:avLst/>
              <a:gdLst>
                <a:gd name="T0" fmla="*/ 321 w 321"/>
                <a:gd name="T1" fmla="*/ 714 h 747"/>
                <a:gd name="T2" fmla="*/ 321 w 321"/>
                <a:gd name="T3" fmla="*/ 747 h 747"/>
                <a:gd name="T4" fmla="*/ 168 w 321"/>
                <a:gd name="T5" fmla="*/ 744 h 747"/>
                <a:gd name="T6" fmla="*/ 0 w 321"/>
                <a:gd name="T7" fmla="*/ 747 h 747"/>
                <a:gd name="T8" fmla="*/ 0 w 321"/>
                <a:gd name="T9" fmla="*/ 714 h 747"/>
                <a:gd name="T10" fmla="*/ 77 w 321"/>
                <a:gd name="T11" fmla="*/ 708 h 747"/>
                <a:gd name="T12" fmla="*/ 97 w 321"/>
                <a:gd name="T13" fmla="*/ 696 h 747"/>
                <a:gd name="T14" fmla="*/ 105 w 321"/>
                <a:gd name="T15" fmla="*/ 645 h 747"/>
                <a:gd name="T16" fmla="*/ 108 w 321"/>
                <a:gd name="T17" fmla="*/ 495 h 747"/>
                <a:gd name="T18" fmla="*/ 108 w 321"/>
                <a:gd name="T19" fmla="*/ 251 h 747"/>
                <a:gd name="T20" fmla="*/ 105 w 321"/>
                <a:gd name="T21" fmla="*/ 111 h 747"/>
                <a:gd name="T22" fmla="*/ 97 w 321"/>
                <a:gd name="T23" fmla="*/ 52 h 747"/>
                <a:gd name="T24" fmla="*/ 77 w 321"/>
                <a:gd name="T25" fmla="*/ 39 h 747"/>
                <a:gd name="T26" fmla="*/ 0 w 321"/>
                <a:gd name="T27" fmla="*/ 33 h 747"/>
                <a:gd name="T28" fmla="*/ 0 w 321"/>
                <a:gd name="T29" fmla="*/ 0 h 747"/>
                <a:gd name="T30" fmla="*/ 161 w 321"/>
                <a:gd name="T31" fmla="*/ 3 h 747"/>
                <a:gd name="T32" fmla="*/ 321 w 321"/>
                <a:gd name="T33" fmla="*/ 0 h 747"/>
                <a:gd name="T34" fmla="*/ 321 w 321"/>
                <a:gd name="T35" fmla="*/ 33 h 747"/>
                <a:gd name="T36" fmla="*/ 243 w 321"/>
                <a:gd name="T37" fmla="*/ 39 h 747"/>
                <a:gd name="T38" fmla="*/ 224 w 321"/>
                <a:gd name="T39" fmla="*/ 51 h 747"/>
                <a:gd name="T40" fmla="*/ 216 w 321"/>
                <a:gd name="T41" fmla="*/ 102 h 747"/>
                <a:gd name="T42" fmla="*/ 212 w 321"/>
                <a:gd name="T43" fmla="*/ 251 h 747"/>
                <a:gd name="T44" fmla="*/ 212 w 321"/>
                <a:gd name="T45" fmla="*/ 495 h 747"/>
                <a:gd name="T46" fmla="*/ 214 w 321"/>
                <a:gd name="T47" fmla="*/ 635 h 747"/>
                <a:gd name="T48" fmla="*/ 222 w 321"/>
                <a:gd name="T49" fmla="*/ 694 h 747"/>
                <a:gd name="T50" fmla="*/ 242 w 321"/>
                <a:gd name="T51" fmla="*/ 708 h 747"/>
                <a:gd name="T52" fmla="*/ 321 w 321"/>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1" h="747">
                  <a:moveTo>
                    <a:pt x="321" y="714"/>
                  </a:moveTo>
                  <a:cubicBezTo>
                    <a:pt x="321" y="747"/>
                    <a:pt x="321" y="747"/>
                    <a:pt x="321" y="747"/>
                  </a:cubicBezTo>
                  <a:cubicBezTo>
                    <a:pt x="244" y="745"/>
                    <a:pt x="193" y="744"/>
                    <a:pt x="168" y="744"/>
                  </a:cubicBezTo>
                  <a:cubicBezTo>
                    <a:pt x="0" y="747"/>
                    <a:pt x="0" y="747"/>
                    <a:pt x="0" y="747"/>
                  </a:cubicBezTo>
                  <a:cubicBezTo>
                    <a:pt x="0" y="714"/>
                    <a:pt x="0" y="714"/>
                    <a:pt x="0" y="714"/>
                  </a:cubicBezTo>
                  <a:cubicBezTo>
                    <a:pt x="42" y="713"/>
                    <a:pt x="68" y="711"/>
                    <a:pt x="77" y="708"/>
                  </a:cubicBezTo>
                  <a:cubicBezTo>
                    <a:pt x="87" y="705"/>
                    <a:pt x="93" y="701"/>
                    <a:pt x="97" y="696"/>
                  </a:cubicBezTo>
                  <a:cubicBezTo>
                    <a:pt x="101" y="689"/>
                    <a:pt x="104" y="672"/>
                    <a:pt x="105" y="645"/>
                  </a:cubicBezTo>
                  <a:cubicBezTo>
                    <a:pt x="106" y="637"/>
                    <a:pt x="107" y="587"/>
                    <a:pt x="108" y="495"/>
                  </a:cubicBezTo>
                  <a:cubicBezTo>
                    <a:pt x="108" y="251"/>
                    <a:pt x="108" y="251"/>
                    <a:pt x="108" y="251"/>
                  </a:cubicBezTo>
                  <a:cubicBezTo>
                    <a:pt x="108" y="204"/>
                    <a:pt x="107" y="157"/>
                    <a:pt x="105" y="111"/>
                  </a:cubicBezTo>
                  <a:cubicBezTo>
                    <a:pt x="104" y="78"/>
                    <a:pt x="102" y="59"/>
                    <a:pt x="97" y="52"/>
                  </a:cubicBezTo>
                  <a:cubicBezTo>
                    <a:pt x="93" y="46"/>
                    <a:pt x="87" y="41"/>
                    <a:pt x="77" y="39"/>
                  </a:cubicBezTo>
                  <a:cubicBezTo>
                    <a:pt x="68" y="36"/>
                    <a:pt x="42" y="34"/>
                    <a:pt x="0" y="33"/>
                  </a:cubicBezTo>
                  <a:cubicBezTo>
                    <a:pt x="0" y="0"/>
                    <a:pt x="0" y="0"/>
                    <a:pt x="0" y="0"/>
                  </a:cubicBezTo>
                  <a:cubicBezTo>
                    <a:pt x="69" y="2"/>
                    <a:pt x="123" y="3"/>
                    <a:pt x="161" y="3"/>
                  </a:cubicBezTo>
                  <a:cubicBezTo>
                    <a:pt x="197" y="3"/>
                    <a:pt x="250" y="2"/>
                    <a:pt x="321" y="0"/>
                  </a:cubicBezTo>
                  <a:cubicBezTo>
                    <a:pt x="321" y="33"/>
                    <a:pt x="321" y="33"/>
                    <a:pt x="321" y="33"/>
                  </a:cubicBezTo>
                  <a:cubicBezTo>
                    <a:pt x="278" y="34"/>
                    <a:pt x="252" y="36"/>
                    <a:pt x="243" y="39"/>
                  </a:cubicBezTo>
                  <a:cubicBezTo>
                    <a:pt x="234" y="41"/>
                    <a:pt x="227" y="46"/>
                    <a:pt x="224" y="51"/>
                  </a:cubicBezTo>
                  <a:cubicBezTo>
                    <a:pt x="219" y="58"/>
                    <a:pt x="217" y="75"/>
                    <a:pt x="216" y="102"/>
                  </a:cubicBezTo>
                  <a:cubicBezTo>
                    <a:pt x="215" y="109"/>
                    <a:pt x="214" y="159"/>
                    <a:pt x="212" y="251"/>
                  </a:cubicBezTo>
                  <a:cubicBezTo>
                    <a:pt x="212" y="495"/>
                    <a:pt x="212" y="495"/>
                    <a:pt x="212" y="495"/>
                  </a:cubicBezTo>
                  <a:cubicBezTo>
                    <a:pt x="212" y="543"/>
                    <a:pt x="213" y="589"/>
                    <a:pt x="214" y="635"/>
                  </a:cubicBezTo>
                  <a:cubicBezTo>
                    <a:pt x="215" y="668"/>
                    <a:pt x="218" y="688"/>
                    <a:pt x="222" y="694"/>
                  </a:cubicBezTo>
                  <a:cubicBezTo>
                    <a:pt x="226" y="700"/>
                    <a:pt x="233" y="705"/>
                    <a:pt x="242" y="708"/>
                  </a:cubicBezTo>
                  <a:cubicBezTo>
                    <a:pt x="251" y="711"/>
                    <a:pt x="278" y="713"/>
                    <a:pt x="321"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5" name="Freeform 8"/>
            <p:cNvSpPr>
              <a:spLocks/>
            </p:cNvSpPr>
            <p:nvPr userDrawn="1"/>
          </p:nvSpPr>
          <p:spPr bwMode="auto">
            <a:xfrm>
              <a:off x="1266825" y="1003301"/>
              <a:ext cx="276225" cy="242888"/>
            </a:xfrm>
            <a:custGeom>
              <a:avLst/>
              <a:gdLst>
                <a:gd name="T0" fmla="*/ 5 w 869"/>
                <a:gd name="T1" fmla="*/ 747 h 766"/>
                <a:gd name="T2" fmla="*/ 5 w 869"/>
                <a:gd name="T3" fmla="*/ 714 h 766"/>
                <a:gd name="T4" fmla="*/ 80 w 869"/>
                <a:gd name="T5" fmla="*/ 705 h 766"/>
                <a:gd name="T6" fmla="*/ 91 w 869"/>
                <a:gd name="T7" fmla="*/ 695 h 766"/>
                <a:gd name="T8" fmla="*/ 99 w 869"/>
                <a:gd name="T9" fmla="*/ 640 h 766"/>
                <a:gd name="T10" fmla="*/ 102 w 869"/>
                <a:gd name="T11" fmla="*/ 520 h 766"/>
                <a:gd name="T12" fmla="*/ 102 w 869"/>
                <a:gd name="T13" fmla="*/ 92 h 766"/>
                <a:gd name="T14" fmla="*/ 100 w 869"/>
                <a:gd name="T15" fmla="*/ 69 h 766"/>
                <a:gd name="T16" fmla="*/ 80 w 869"/>
                <a:gd name="T17" fmla="*/ 47 h 766"/>
                <a:gd name="T18" fmla="*/ 57 w 869"/>
                <a:gd name="T19" fmla="*/ 36 h 766"/>
                <a:gd name="T20" fmla="*/ 0 w 869"/>
                <a:gd name="T21" fmla="*/ 33 h 766"/>
                <a:gd name="T22" fmla="*/ 0 w 869"/>
                <a:gd name="T23" fmla="*/ 0 h 766"/>
                <a:gd name="T24" fmla="*/ 119 w 869"/>
                <a:gd name="T25" fmla="*/ 3 h 766"/>
                <a:gd name="T26" fmla="*/ 202 w 869"/>
                <a:gd name="T27" fmla="*/ 0 h 766"/>
                <a:gd name="T28" fmla="*/ 269 w 869"/>
                <a:gd name="T29" fmla="*/ 86 h 766"/>
                <a:gd name="T30" fmla="*/ 381 w 869"/>
                <a:gd name="T31" fmla="*/ 220 h 766"/>
                <a:gd name="T32" fmla="*/ 545 w 869"/>
                <a:gd name="T33" fmla="*/ 411 h 766"/>
                <a:gd name="T34" fmla="*/ 671 w 869"/>
                <a:gd name="T35" fmla="*/ 554 h 766"/>
                <a:gd name="T36" fmla="*/ 721 w 869"/>
                <a:gd name="T37" fmla="*/ 609 h 766"/>
                <a:gd name="T38" fmla="*/ 721 w 869"/>
                <a:gd name="T39" fmla="*/ 226 h 766"/>
                <a:gd name="T40" fmla="*/ 718 w 869"/>
                <a:gd name="T41" fmla="*/ 105 h 766"/>
                <a:gd name="T42" fmla="*/ 711 w 869"/>
                <a:gd name="T43" fmla="*/ 51 h 766"/>
                <a:gd name="T44" fmla="*/ 699 w 869"/>
                <a:gd name="T45" fmla="*/ 41 h 766"/>
                <a:gd name="T46" fmla="*/ 624 w 869"/>
                <a:gd name="T47" fmla="*/ 33 h 766"/>
                <a:gd name="T48" fmla="*/ 624 w 869"/>
                <a:gd name="T49" fmla="*/ 0 h 766"/>
                <a:gd name="T50" fmla="*/ 756 w 869"/>
                <a:gd name="T51" fmla="*/ 3 h 766"/>
                <a:gd name="T52" fmla="*/ 869 w 869"/>
                <a:gd name="T53" fmla="*/ 0 h 766"/>
                <a:gd name="T54" fmla="*/ 869 w 869"/>
                <a:gd name="T55" fmla="*/ 33 h 766"/>
                <a:gd name="T56" fmla="*/ 794 w 869"/>
                <a:gd name="T57" fmla="*/ 41 h 766"/>
                <a:gd name="T58" fmla="*/ 783 w 869"/>
                <a:gd name="T59" fmla="*/ 52 h 766"/>
                <a:gd name="T60" fmla="*/ 775 w 869"/>
                <a:gd name="T61" fmla="*/ 107 h 766"/>
                <a:gd name="T62" fmla="*/ 772 w 869"/>
                <a:gd name="T63" fmla="*/ 226 h 766"/>
                <a:gd name="T64" fmla="*/ 772 w 869"/>
                <a:gd name="T65" fmla="*/ 479 h 766"/>
                <a:gd name="T66" fmla="*/ 775 w 869"/>
                <a:gd name="T67" fmla="*/ 766 h 766"/>
                <a:gd name="T68" fmla="*/ 721 w 869"/>
                <a:gd name="T69" fmla="*/ 766 h 766"/>
                <a:gd name="T70" fmla="*/ 707 w 869"/>
                <a:gd name="T71" fmla="*/ 752 h 766"/>
                <a:gd name="T72" fmla="*/ 698 w 869"/>
                <a:gd name="T73" fmla="*/ 744 h 766"/>
                <a:gd name="T74" fmla="*/ 678 w 869"/>
                <a:gd name="T75" fmla="*/ 723 h 766"/>
                <a:gd name="T76" fmla="*/ 611 w 869"/>
                <a:gd name="T77" fmla="*/ 647 h 766"/>
                <a:gd name="T78" fmla="*/ 540 w 869"/>
                <a:gd name="T79" fmla="*/ 560 h 766"/>
                <a:gd name="T80" fmla="*/ 151 w 869"/>
                <a:gd name="T81" fmla="*/ 110 h 766"/>
                <a:gd name="T82" fmla="*/ 151 w 869"/>
                <a:gd name="T83" fmla="*/ 518 h 766"/>
                <a:gd name="T84" fmla="*/ 154 w 869"/>
                <a:gd name="T85" fmla="*/ 641 h 766"/>
                <a:gd name="T86" fmla="*/ 161 w 869"/>
                <a:gd name="T87" fmla="*/ 695 h 766"/>
                <a:gd name="T88" fmla="*/ 173 w 869"/>
                <a:gd name="T89" fmla="*/ 705 h 766"/>
                <a:gd name="T90" fmla="*/ 249 w 869"/>
                <a:gd name="T91" fmla="*/ 714 h 766"/>
                <a:gd name="T92" fmla="*/ 249 w 869"/>
                <a:gd name="T93" fmla="*/ 747 h 766"/>
                <a:gd name="T94" fmla="*/ 143 w 869"/>
                <a:gd name="T95" fmla="*/ 744 h 766"/>
                <a:gd name="T96" fmla="*/ 5 w 869"/>
                <a:gd name="T97" fmla="*/ 747 h 76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869" h="766">
                  <a:moveTo>
                    <a:pt x="5" y="747"/>
                  </a:moveTo>
                  <a:cubicBezTo>
                    <a:pt x="5" y="714"/>
                    <a:pt x="5" y="714"/>
                    <a:pt x="5" y="714"/>
                  </a:cubicBezTo>
                  <a:cubicBezTo>
                    <a:pt x="43" y="714"/>
                    <a:pt x="68" y="711"/>
                    <a:pt x="80" y="705"/>
                  </a:cubicBezTo>
                  <a:cubicBezTo>
                    <a:pt x="86" y="703"/>
                    <a:pt x="89" y="700"/>
                    <a:pt x="91" y="695"/>
                  </a:cubicBezTo>
                  <a:cubicBezTo>
                    <a:pt x="95" y="688"/>
                    <a:pt x="98" y="670"/>
                    <a:pt x="99" y="640"/>
                  </a:cubicBezTo>
                  <a:cubicBezTo>
                    <a:pt x="101" y="594"/>
                    <a:pt x="102" y="554"/>
                    <a:pt x="102" y="520"/>
                  </a:cubicBezTo>
                  <a:cubicBezTo>
                    <a:pt x="102" y="92"/>
                    <a:pt x="102" y="92"/>
                    <a:pt x="102" y="92"/>
                  </a:cubicBezTo>
                  <a:cubicBezTo>
                    <a:pt x="102" y="80"/>
                    <a:pt x="102" y="73"/>
                    <a:pt x="100" y="69"/>
                  </a:cubicBezTo>
                  <a:cubicBezTo>
                    <a:pt x="97" y="63"/>
                    <a:pt x="91" y="56"/>
                    <a:pt x="80" y="47"/>
                  </a:cubicBezTo>
                  <a:cubicBezTo>
                    <a:pt x="74" y="41"/>
                    <a:pt x="66" y="38"/>
                    <a:pt x="57" y="36"/>
                  </a:cubicBezTo>
                  <a:cubicBezTo>
                    <a:pt x="49" y="34"/>
                    <a:pt x="30" y="33"/>
                    <a:pt x="0" y="33"/>
                  </a:cubicBezTo>
                  <a:cubicBezTo>
                    <a:pt x="0" y="0"/>
                    <a:pt x="0" y="0"/>
                    <a:pt x="0" y="0"/>
                  </a:cubicBezTo>
                  <a:cubicBezTo>
                    <a:pt x="63" y="2"/>
                    <a:pt x="103" y="3"/>
                    <a:pt x="119" y="3"/>
                  </a:cubicBezTo>
                  <a:cubicBezTo>
                    <a:pt x="147" y="3"/>
                    <a:pt x="174" y="2"/>
                    <a:pt x="202" y="0"/>
                  </a:cubicBezTo>
                  <a:cubicBezTo>
                    <a:pt x="232" y="39"/>
                    <a:pt x="255" y="67"/>
                    <a:pt x="269" y="86"/>
                  </a:cubicBezTo>
                  <a:cubicBezTo>
                    <a:pt x="381" y="220"/>
                    <a:pt x="381" y="220"/>
                    <a:pt x="381" y="220"/>
                  </a:cubicBezTo>
                  <a:cubicBezTo>
                    <a:pt x="545" y="411"/>
                    <a:pt x="545" y="411"/>
                    <a:pt x="545" y="411"/>
                  </a:cubicBezTo>
                  <a:cubicBezTo>
                    <a:pt x="597" y="472"/>
                    <a:pt x="639" y="520"/>
                    <a:pt x="671" y="554"/>
                  </a:cubicBezTo>
                  <a:cubicBezTo>
                    <a:pt x="691" y="578"/>
                    <a:pt x="708" y="596"/>
                    <a:pt x="721" y="609"/>
                  </a:cubicBezTo>
                  <a:cubicBezTo>
                    <a:pt x="721" y="226"/>
                    <a:pt x="721" y="226"/>
                    <a:pt x="721" y="226"/>
                  </a:cubicBezTo>
                  <a:cubicBezTo>
                    <a:pt x="721" y="191"/>
                    <a:pt x="720" y="151"/>
                    <a:pt x="718" y="105"/>
                  </a:cubicBezTo>
                  <a:cubicBezTo>
                    <a:pt x="717" y="76"/>
                    <a:pt x="714" y="58"/>
                    <a:pt x="711" y="51"/>
                  </a:cubicBezTo>
                  <a:cubicBezTo>
                    <a:pt x="708" y="46"/>
                    <a:pt x="705" y="43"/>
                    <a:pt x="699" y="41"/>
                  </a:cubicBezTo>
                  <a:cubicBezTo>
                    <a:pt x="687" y="36"/>
                    <a:pt x="662" y="33"/>
                    <a:pt x="624" y="33"/>
                  </a:cubicBezTo>
                  <a:cubicBezTo>
                    <a:pt x="624" y="0"/>
                    <a:pt x="624" y="0"/>
                    <a:pt x="624" y="0"/>
                  </a:cubicBezTo>
                  <a:cubicBezTo>
                    <a:pt x="667" y="2"/>
                    <a:pt x="711" y="3"/>
                    <a:pt x="756" y="3"/>
                  </a:cubicBezTo>
                  <a:cubicBezTo>
                    <a:pt x="797" y="3"/>
                    <a:pt x="835" y="2"/>
                    <a:pt x="869" y="0"/>
                  </a:cubicBezTo>
                  <a:cubicBezTo>
                    <a:pt x="869" y="33"/>
                    <a:pt x="869" y="33"/>
                    <a:pt x="869" y="33"/>
                  </a:cubicBezTo>
                  <a:cubicBezTo>
                    <a:pt x="831" y="33"/>
                    <a:pt x="806" y="36"/>
                    <a:pt x="794" y="41"/>
                  </a:cubicBezTo>
                  <a:cubicBezTo>
                    <a:pt x="789" y="43"/>
                    <a:pt x="785" y="47"/>
                    <a:pt x="783" y="52"/>
                  </a:cubicBezTo>
                  <a:cubicBezTo>
                    <a:pt x="779" y="58"/>
                    <a:pt x="776" y="77"/>
                    <a:pt x="775" y="107"/>
                  </a:cubicBezTo>
                  <a:cubicBezTo>
                    <a:pt x="773" y="153"/>
                    <a:pt x="772" y="193"/>
                    <a:pt x="772" y="226"/>
                  </a:cubicBezTo>
                  <a:cubicBezTo>
                    <a:pt x="772" y="479"/>
                    <a:pt x="772" y="479"/>
                    <a:pt x="772" y="479"/>
                  </a:cubicBezTo>
                  <a:cubicBezTo>
                    <a:pt x="772" y="531"/>
                    <a:pt x="773" y="626"/>
                    <a:pt x="775" y="766"/>
                  </a:cubicBezTo>
                  <a:cubicBezTo>
                    <a:pt x="721" y="766"/>
                    <a:pt x="721" y="766"/>
                    <a:pt x="721" y="766"/>
                  </a:cubicBezTo>
                  <a:cubicBezTo>
                    <a:pt x="707" y="752"/>
                    <a:pt x="707" y="752"/>
                    <a:pt x="707" y="752"/>
                  </a:cubicBezTo>
                  <a:cubicBezTo>
                    <a:pt x="705" y="751"/>
                    <a:pt x="700" y="746"/>
                    <a:pt x="698" y="744"/>
                  </a:cubicBezTo>
                  <a:cubicBezTo>
                    <a:pt x="696" y="742"/>
                    <a:pt x="689" y="735"/>
                    <a:pt x="678" y="723"/>
                  </a:cubicBezTo>
                  <a:cubicBezTo>
                    <a:pt x="647" y="689"/>
                    <a:pt x="625" y="664"/>
                    <a:pt x="611" y="647"/>
                  </a:cubicBezTo>
                  <a:cubicBezTo>
                    <a:pt x="540" y="560"/>
                    <a:pt x="540" y="560"/>
                    <a:pt x="540" y="560"/>
                  </a:cubicBezTo>
                  <a:cubicBezTo>
                    <a:pt x="151" y="110"/>
                    <a:pt x="151" y="110"/>
                    <a:pt x="151" y="110"/>
                  </a:cubicBezTo>
                  <a:cubicBezTo>
                    <a:pt x="151" y="518"/>
                    <a:pt x="151" y="518"/>
                    <a:pt x="151" y="518"/>
                  </a:cubicBezTo>
                  <a:cubicBezTo>
                    <a:pt x="151" y="552"/>
                    <a:pt x="152" y="593"/>
                    <a:pt x="154" y="641"/>
                  </a:cubicBezTo>
                  <a:cubicBezTo>
                    <a:pt x="156" y="670"/>
                    <a:pt x="158" y="688"/>
                    <a:pt x="161" y="695"/>
                  </a:cubicBezTo>
                  <a:cubicBezTo>
                    <a:pt x="164" y="700"/>
                    <a:pt x="168" y="704"/>
                    <a:pt x="173" y="705"/>
                  </a:cubicBezTo>
                  <a:cubicBezTo>
                    <a:pt x="185" y="711"/>
                    <a:pt x="210" y="714"/>
                    <a:pt x="249" y="714"/>
                  </a:cubicBezTo>
                  <a:cubicBezTo>
                    <a:pt x="249" y="747"/>
                    <a:pt x="249" y="747"/>
                    <a:pt x="249" y="747"/>
                  </a:cubicBezTo>
                  <a:cubicBezTo>
                    <a:pt x="217" y="745"/>
                    <a:pt x="181" y="744"/>
                    <a:pt x="143" y="744"/>
                  </a:cubicBezTo>
                  <a:cubicBezTo>
                    <a:pt x="100" y="744"/>
                    <a:pt x="54" y="745"/>
                    <a:pt x="5" y="747"/>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6" name="Freeform 9"/>
            <p:cNvSpPr>
              <a:spLocks/>
            </p:cNvSpPr>
            <p:nvPr userDrawn="1"/>
          </p:nvSpPr>
          <p:spPr bwMode="auto">
            <a:xfrm>
              <a:off x="1573213" y="1003301"/>
              <a:ext cx="101600" cy="236538"/>
            </a:xfrm>
            <a:custGeom>
              <a:avLst/>
              <a:gdLst>
                <a:gd name="T0" fmla="*/ 322 w 322"/>
                <a:gd name="T1" fmla="*/ 714 h 747"/>
                <a:gd name="T2" fmla="*/ 322 w 322"/>
                <a:gd name="T3" fmla="*/ 747 h 747"/>
                <a:gd name="T4" fmla="*/ 169 w 322"/>
                <a:gd name="T5" fmla="*/ 744 h 747"/>
                <a:gd name="T6" fmla="*/ 0 w 322"/>
                <a:gd name="T7" fmla="*/ 747 h 747"/>
                <a:gd name="T8" fmla="*/ 0 w 322"/>
                <a:gd name="T9" fmla="*/ 714 h 747"/>
                <a:gd name="T10" fmla="*/ 79 w 322"/>
                <a:gd name="T11" fmla="*/ 708 h 747"/>
                <a:gd name="T12" fmla="*/ 98 w 322"/>
                <a:gd name="T13" fmla="*/ 696 h 747"/>
                <a:gd name="T14" fmla="*/ 106 w 322"/>
                <a:gd name="T15" fmla="*/ 645 h 747"/>
                <a:gd name="T16" fmla="*/ 109 w 322"/>
                <a:gd name="T17" fmla="*/ 495 h 747"/>
                <a:gd name="T18" fmla="*/ 109 w 322"/>
                <a:gd name="T19" fmla="*/ 251 h 747"/>
                <a:gd name="T20" fmla="*/ 106 w 322"/>
                <a:gd name="T21" fmla="*/ 111 h 747"/>
                <a:gd name="T22" fmla="*/ 98 w 322"/>
                <a:gd name="T23" fmla="*/ 52 h 747"/>
                <a:gd name="T24" fmla="*/ 78 w 322"/>
                <a:gd name="T25" fmla="*/ 39 h 747"/>
                <a:gd name="T26" fmla="*/ 0 w 322"/>
                <a:gd name="T27" fmla="*/ 33 h 747"/>
                <a:gd name="T28" fmla="*/ 0 w 322"/>
                <a:gd name="T29" fmla="*/ 0 h 747"/>
                <a:gd name="T30" fmla="*/ 161 w 322"/>
                <a:gd name="T31" fmla="*/ 3 h 747"/>
                <a:gd name="T32" fmla="*/ 322 w 322"/>
                <a:gd name="T33" fmla="*/ 0 h 747"/>
                <a:gd name="T34" fmla="*/ 322 w 322"/>
                <a:gd name="T35" fmla="*/ 33 h 747"/>
                <a:gd name="T36" fmla="*/ 244 w 322"/>
                <a:gd name="T37" fmla="*/ 39 h 747"/>
                <a:gd name="T38" fmla="*/ 224 w 322"/>
                <a:gd name="T39" fmla="*/ 51 h 747"/>
                <a:gd name="T40" fmla="*/ 216 w 322"/>
                <a:gd name="T41" fmla="*/ 102 h 747"/>
                <a:gd name="T42" fmla="*/ 213 w 322"/>
                <a:gd name="T43" fmla="*/ 251 h 747"/>
                <a:gd name="T44" fmla="*/ 213 w 322"/>
                <a:gd name="T45" fmla="*/ 495 h 747"/>
                <a:gd name="T46" fmla="*/ 215 w 322"/>
                <a:gd name="T47" fmla="*/ 635 h 747"/>
                <a:gd name="T48" fmla="*/ 223 w 322"/>
                <a:gd name="T49" fmla="*/ 694 h 747"/>
                <a:gd name="T50" fmla="*/ 243 w 322"/>
                <a:gd name="T51" fmla="*/ 708 h 747"/>
                <a:gd name="T52" fmla="*/ 322 w 322"/>
                <a:gd name="T53" fmla="*/ 714 h 7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Lst>
              <a:rect l="0" t="0" r="r" b="b"/>
              <a:pathLst>
                <a:path w="322" h="747">
                  <a:moveTo>
                    <a:pt x="322" y="714"/>
                  </a:moveTo>
                  <a:cubicBezTo>
                    <a:pt x="322" y="747"/>
                    <a:pt x="322" y="747"/>
                    <a:pt x="322" y="747"/>
                  </a:cubicBezTo>
                  <a:cubicBezTo>
                    <a:pt x="244" y="745"/>
                    <a:pt x="193" y="744"/>
                    <a:pt x="169" y="744"/>
                  </a:cubicBezTo>
                  <a:cubicBezTo>
                    <a:pt x="0" y="747"/>
                    <a:pt x="0" y="747"/>
                    <a:pt x="0" y="747"/>
                  </a:cubicBezTo>
                  <a:cubicBezTo>
                    <a:pt x="0" y="714"/>
                    <a:pt x="0" y="714"/>
                    <a:pt x="0" y="714"/>
                  </a:cubicBezTo>
                  <a:cubicBezTo>
                    <a:pt x="43" y="713"/>
                    <a:pt x="69" y="711"/>
                    <a:pt x="79" y="708"/>
                  </a:cubicBezTo>
                  <a:cubicBezTo>
                    <a:pt x="88" y="705"/>
                    <a:pt x="94" y="701"/>
                    <a:pt x="98" y="696"/>
                  </a:cubicBezTo>
                  <a:cubicBezTo>
                    <a:pt x="102" y="689"/>
                    <a:pt x="105" y="672"/>
                    <a:pt x="106" y="645"/>
                  </a:cubicBezTo>
                  <a:cubicBezTo>
                    <a:pt x="107" y="637"/>
                    <a:pt x="108" y="587"/>
                    <a:pt x="109" y="495"/>
                  </a:cubicBezTo>
                  <a:cubicBezTo>
                    <a:pt x="109" y="251"/>
                    <a:pt x="109" y="251"/>
                    <a:pt x="109" y="251"/>
                  </a:cubicBezTo>
                  <a:cubicBezTo>
                    <a:pt x="109" y="204"/>
                    <a:pt x="108" y="157"/>
                    <a:pt x="106" y="111"/>
                  </a:cubicBezTo>
                  <a:cubicBezTo>
                    <a:pt x="105" y="78"/>
                    <a:pt x="102" y="59"/>
                    <a:pt x="98" y="52"/>
                  </a:cubicBezTo>
                  <a:cubicBezTo>
                    <a:pt x="94" y="46"/>
                    <a:pt x="88" y="41"/>
                    <a:pt x="78" y="39"/>
                  </a:cubicBezTo>
                  <a:cubicBezTo>
                    <a:pt x="69" y="36"/>
                    <a:pt x="43" y="34"/>
                    <a:pt x="0" y="33"/>
                  </a:cubicBezTo>
                  <a:cubicBezTo>
                    <a:pt x="0" y="0"/>
                    <a:pt x="0" y="0"/>
                    <a:pt x="0" y="0"/>
                  </a:cubicBezTo>
                  <a:cubicBezTo>
                    <a:pt x="70" y="2"/>
                    <a:pt x="124" y="3"/>
                    <a:pt x="161" y="3"/>
                  </a:cubicBezTo>
                  <a:cubicBezTo>
                    <a:pt x="198" y="3"/>
                    <a:pt x="251" y="2"/>
                    <a:pt x="322" y="0"/>
                  </a:cubicBezTo>
                  <a:cubicBezTo>
                    <a:pt x="322" y="33"/>
                    <a:pt x="322" y="33"/>
                    <a:pt x="322" y="33"/>
                  </a:cubicBezTo>
                  <a:cubicBezTo>
                    <a:pt x="279" y="34"/>
                    <a:pt x="253" y="36"/>
                    <a:pt x="244" y="39"/>
                  </a:cubicBezTo>
                  <a:cubicBezTo>
                    <a:pt x="234" y="41"/>
                    <a:pt x="228" y="46"/>
                    <a:pt x="224" y="51"/>
                  </a:cubicBezTo>
                  <a:cubicBezTo>
                    <a:pt x="220" y="58"/>
                    <a:pt x="217" y="75"/>
                    <a:pt x="216" y="102"/>
                  </a:cubicBezTo>
                  <a:cubicBezTo>
                    <a:pt x="216" y="109"/>
                    <a:pt x="215" y="159"/>
                    <a:pt x="213" y="251"/>
                  </a:cubicBezTo>
                  <a:cubicBezTo>
                    <a:pt x="213" y="495"/>
                    <a:pt x="213" y="495"/>
                    <a:pt x="213" y="495"/>
                  </a:cubicBezTo>
                  <a:cubicBezTo>
                    <a:pt x="213" y="543"/>
                    <a:pt x="214" y="589"/>
                    <a:pt x="215" y="635"/>
                  </a:cubicBezTo>
                  <a:cubicBezTo>
                    <a:pt x="216" y="668"/>
                    <a:pt x="219" y="688"/>
                    <a:pt x="223" y="694"/>
                  </a:cubicBezTo>
                  <a:cubicBezTo>
                    <a:pt x="227" y="700"/>
                    <a:pt x="234" y="705"/>
                    <a:pt x="243" y="708"/>
                  </a:cubicBezTo>
                  <a:cubicBezTo>
                    <a:pt x="252" y="711"/>
                    <a:pt x="278" y="713"/>
                    <a:pt x="322" y="714"/>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7" name="Freeform 10"/>
            <p:cNvSpPr>
              <a:spLocks/>
            </p:cNvSpPr>
            <p:nvPr userDrawn="1"/>
          </p:nvSpPr>
          <p:spPr bwMode="auto">
            <a:xfrm>
              <a:off x="1692275" y="998538"/>
              <a:ext cx="231775" cy="246063"/>
            </a:xfrm>
            <a:custGeom>
              <a:avLst/>
              <a:gdLst>
                <a:gd name="T0" fmla="*/ 728 w 728"/>
                <a:gd name="T1" fmla="*/ 667 h 774"/>
                <a:gd name="T2" fmla="*/ 707 w 728"/>
                <a:gd name="T3" fmla="*/ 716 h 774"/>
                <a:gd name="T4" fmla="*/ 581 w 728"/>
                <a:gd name="T5" fmla="*/ 761 h 774"/>
                <a:gd name="T6" fmla="*/ 447 w 728"/>
                <a:gd name="T7" fmla="*/ 774 h 774"/>
                <a:gd name="T8" fmla="*/ 288 w 728"/>
                <a:gd name="T9" fmla="*/ 754 h 774"/>
                <a:gd name="T10" fmla="*/ 161 w 728"/>
                <a:gd name="T11" fmla="*/ 696 h 774"/>
                <a:gd name="T12" fmla="*/ 71 w 728"/>
                <a:gd name="T13" fmla="*/ 610 h 774"/>
                <a:gd name="T14" fmla="*/ 18 w 728"/>
                <a:gd name="T15" fmla="*/ 508 h 774"/>
                <a:gd name="T16" fmla="*/ 0 w 728"/>
                <a:gd name="T17" fmla="*/ 386 h 774"/>
                <a:gd name="T18" fmla="*/ 123 w 728"/>
                <a:gd name="T19" fmla="*/ 110 h 774"/>
                <a:gd name="T20" fmla="*/ 457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5 w 728"/>
                <a:gd name="T35" fmla="*/ 143 h 774"/>
                <a:gd name="T36" fmla="*/ 605 w 728"/>
                <a:gd name="T37" fmla="*/ 66 h 774"/>
                <a:gd name="T38" fmla="*/ 446 w 728"/>
                <a:gd name="T39" fmla="*/ 41 h 774"/>
                <a:gd name="T40" fmla="*/ 313 w 728"/>
                <a:gd name="T41" fmla="*/ 60 h 774"/>
                <a:gd name="T42" fmla="*/ 217 w 728"/>
                <a:gd name="T43" fmla="*/ 117 h 774"/>
                <a:gd name="T44" fmla="*/ 149 w 728"/>
                <a:gd name="T45" fmla="*/ 216 h 774"/>
                <a:gd name="T46" fmla="*/ 122 w 728"/>
                <a:gd name="T47" fmla="*/ 366 h 774"/>
                <a:gd name="T48" fmla="*/ 223 w 728"/>
                <a:gd name="T49" fmla="*/ 621 h 774"/>
                <a:gd name="T50" fmla="*/ 492 w 728"/>
                <a:gd name="T51" fmla="*/ 717 h 774"/>
                <a:gd name="T52" fmla="*/ 632 w 728"/>
                <a:gd name="T53" fmla="*/ 698 h 774"/>
                <a:gd name="T54" fmla="*/ 719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7" y="716"/>
                    <a:pt x="707" y="716"/>
                    <a:pt x="707" y="716"/>
                  </a:cubicBezTo>
                  <a:cubicBezTo>
                    <a:pt x="664" y="736"/>
                    <a:pt x="622" y="751"/>
                    <a:pt x="581" y="761"/>
                  </a:cubicBezTo>
                  <a:cubicBezTo>
                    <a:pt x="540" y="770"/>
                    <a:pt x="495" y="774"/>
                    <a:pt x="447" y="774"/>
                  </a:cubicBezTo>
                  <a:cubicBezTo>
                    <a:pt x="390" y="774"/>
                    <a:pt x="337" y="768"/>
                    <a:pt x="288" y="754"/>
                  </a:cubicBezTo>
                  <a:cubicBezTo>
                    <a:pt x="240" y="740"/>
                    <a:pt x="197" y="721"/>
                    <a:pt x="161" y="696"/>
                  </a:cubicBezTo>
                  <a:cubicBezTo>
                    <a:pt x="124" y="670"/>
                    <a:pt x="94" y="642"/>
                    <a:pt x="71" y="610"/>
                  </a:cubicBezTo>
                  <a:cubicBezTo>
                    <a:pt x="48" y="579"/>
                    <a:pt x="31" y="545"/>
                    <a:pt x="18" y="508"/>
                  </a:cubicBezTo>
                  <a:cubicBezTo>
                    <a:pt x="6" y="471"/>
                    <a:pt x="0" y="430"/>
                    <a:pt x="0" y="386"/>
                  </a:cubicBezTo>
                  <a:cubicBezTo>
                    <a:pt x="0" y="275"/>
                    <a:pt x="41" y="183"/>
                    <a:pt x="123" y="110"/>
                  </a:cubicBezTo>
                  <a:cubicBezTo>
                    <a:pt x="204" y="37"/>
                    <a:pt x="316" y="0"/>
                    <a:pt x="457" y="0"/>
                  </a:cubicBezTo>
                  <a:cubicBezTo>
                    <a:pt x="490" y="0"/>
                    <a:pt x="521" y="2"/>
                    <a:pt x="549" y="6"/>
                  </a:cubicBezTo>
                  <a:cubicBezTo>
                    <a:pt x="578"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5" y="143"/>
                    <a:pt x="665" y="143"/>
                    <a:pt x="665" y="143"/>
                  </a:cubicBezTo>
                  <a:cubicBezTo>
                    <a:pt x="661" y="109"/>
                    <a:pt x="641" y="83"/>
                    <a:pt x="605" y="66"/>
                  </a:cubicBezTo>
                  <a:cubicBezTo>
                    <a:pt x="569" y="50"/>
                    <a:pt x="516" y="41"/>
                    <a:pt x="446" y="41"/>
                  </a:cubicBezTo>
                  <a:cubicBezTo>
                    <a:pt x="393" y="42"/>
                    <a:pt x="349" y="48"/>
                    <a:pt x="313" y="60"/>
                  </a:cubicBezTo>
                  <a:cubicBezTo>
                    <a:pt x="277" y="72"/>
                    <a:pt x="245" y="91"/>
                    <a:pt x="217" y="117"/>
                  </a:cubicBezTo>
                  <a:cubicBezTo>
                    <a:pt x="189" y="143"/>
                    <a:pt x="166" y="176"/>
                    <a:pt x="149" y="216"/>
                  </a:cubicBezTo>
                  <a:cubicBezTo>
                    <a:pt x="131" y="256"/>
                    <a:pt x="122" y="306"/>
                    <a:pt x="122" y="366"/>
                  </a:cubicBezTo>
                  <a:cubicBezTo>
                    <a:pt x="122" y="472"/>
                    <a:pt x="155" y="557"/>
                    <a:pt x="223" y="621"/>
                  </a:cubicBezTo>
                  <a:cubicBezTo>
                    <a:pt x="291" y="685"/>
                    <a:pt x="380" y="717"/>
                    <a:pt x="492" y="717"/>
                  </a:cubicBezTo>
                  <a:cubicBezTo>
                    <a:pt x="542" y="717"/>
                    <a:pt x="589" y="711"/>
                    <a:pt x="632" y="698"/>
                  </a:cubicBezTo>
                  <a:cubicBezTo>
                    <a:pt x="661" y="689"/>
                    <a:pt x="690" y="675"/>
                    <a:pt x="719"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8" name="Freeform 11"/>
            <p:cNvSpPr>
              <a:spLocks/>
            </p:cNvSpPr>
            <p:nvPr userDrawn="1"/>
          </p:nvSpPr>
          <p:spPr bwMode="auto">
            <a:xfrm>
              <a:off x="657225" y="998538"/>
              <a:ext cx="231775" cy="246063"/>
            </a:xfrm>
            <a:custGeom>
              <a:avLst/>
              <a:gdLst>
                <a:gd name="T0" fmla="*/ 728 w 728"/>
                <a:gd name="T1" fmla="*/ 667 h 774"/>
                <a:gd name="T2" fmla="*/ 706 w 728"/>
                <a:gd name="T3" fmla="*/ 716 h 774"/>
                <a:gd name="T4" fmla="*/ 580 w 728"/>
                <a:gd name="T5" fmla="*/ 761 h 774"/>
                <a:gd name="T6" fmla="*/ 446 w 728"/>
                <a:gd name="T7" fmla="*/ 774 h 774"/>
                <a:gd name="T8" fmla="*/ 288 w 728"/>
                <a:gd name="T9" fmla="*/ 754 h 774"/>
                <a:gd name="T10" fmla="*/ 160 w 728"/>
                <a:gd name="T11" fmla="*/ 696 h 774"/>
                <a:gd name="T12" fmla="*/ 71 w 728"/>
                <a:gd name="T13" fmla="*/ 610 h 774"/>
                <a:gd name="T14" fmla="*/ 18 w 728"/>
                <a:gd name="T15" fmla="*/ 508 h 774"/>
                <a:gd name="T16" fmla="*/ 0 w 728"/>
                <a:gd name="T17" fmla="*/ 386 h 774"/>
                <a:gd name="T18" fmla="*/ 122 w 728"/>
                <a:gd name="T19" fmla="*/ 110 h 774"/>
                <a:gd name="T20" fmla="*/ 456 w 728"/>
                <a:gd name="T21" fmla="*/ 0 h 774"/>
                <a:gd name="T22" fmla="*/ 549 w 728"/>
                <a:gd name="T23" fmla="*/ 6 h 774"/>
                <a:gd name="T24" fmla="*/ 653 w 728"/>
                <a:gd name="T25" fmla="*/ 27 h 774"/>
                <a:gd name="T26" fmla="*/ 728 w 728"/>
                <a:gd name="T27" fmla="*/ 45 h 774"/>
                <a:gd name="T28" fmla="*/ 710 w 728"/>
                <a:gd name="T29" fmla="*/ 101 h 774"/>
                <a:gd name="T30" fmla="*/ 698 w 728"/>
                <a:gd name="T31" fmla="*/ 204 h 774"/>
                <a:gd name="T32" fmla="*/ 665 w 728"/>
                <a:gd name="T33" fmla="*/ 204 h 774"/>
                <a:gd name="T34" fmla="*/ 664 w 728"/>
                <a:gd name="T35" fmla="*/ 143 h 774"/>
                <a:gd name="T36" fmla="*/ 604 w 728"/>
                <a:gd name="T37" fmla="*/ 66 h 774"/>
                <a:gd name="T38" fmla="*/ 445 w 728"/>
                <a:gd name="T39" fmla="*/ 41 h 774"/>
                <a:gd name="T40" fmla="*/ 313 w 728"/>
                <a:gd name="T41" fmla="*/ 60 h 774"/>
                <a:gd name="T42" fmla="*/ 216 w 728"/>
                <a:gd name="T43" fmla="*/ 117 h 774"/>
                <a:gd name="T44" fmla="*/ 148 w 728"/>
                <a:gd name="T45" fmla="*/ 216 h 774"/>
                <a:gd name="T46" fmla="*/ 121 w 728"/>
                <a:gd name="T47" fmla="*/ 366 h 774"/>
                <a:gd name="T48" fmla="*/ 223 w 728"/>
                <a:gd name="T49" fmla="*/ 621 h 774"/>
                <a:gd name="T50" fmla="*/ 492 w 728"/>
                <a:gd name="T51" fmla="*/ 717 h 774"/>
                <a:gd name="T52" fmla="*/ 631 w 728"/>
                <a:gd name="T53" fmla="*/ 698 h 774"/>
                <a:gd name="T54" fmla="*/ 718 w 728"/>
                <a:gd name="T55" fmla="*/ 656 h 774"/>
                <a:gd name="T56" fmla="*/ 728 w 728"/>
                <a:gd name="T57" fmla="*/ 667 h 77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728" h="774">
                  <a:moveTo>
                    <a:pt x="728" y="667"/>
                  </a:moveTo>
                  <a:cubicBezTo>
                    <a:pt x="706" y="716"/>
                    <a:pt x="706" y="716"/>
                    <a:pt x="706" y="716"/>
                  </a:cubicBezTo>
                  <a:cubicBezTo>
                    <a:pt x="663" y="736"/>
                    <a:pt x="621" y="751"/>
                    <a:pt x="580" y="761"/>
                  </a:cubicBezTo>
                  <a:cubicBezTo>
                    <a:pt x="539" y="770"/>
                    <a:pt x="495" y="774"/>
                    <a:pt x="446" y="774"/>
                  </a:cubicBezTo>
                  <a:cubicBezTo>
                    <a:pt x="389" y="774"/>
                    <a:pt x="337" y="768"/>
                    <a:pt x="288" y="754"/>
                  </a:cubicBezTo>
                  <a:cubicBezTo>
                    <a:pt x="239" y="740"/>
                    <a:pt x="197" y="721"/>
                    <a:pt x="160" y="696"/>
                  </a:cubicBezTo>
                  <a:cubicBezTo>
                    <a:pt x="124" y="670"/>
                    <a:pt x="94" y="642"/>
                    <a:pt x="71" y="610"/>
                  </a:cubicBezTo>
                  <a:cubicBezTo>
                    <a:pt x="48" y="579"/>
                    <a:pt x="30" y="545"/>
                    <a:pt x="18" y="508"/>
                  </a:cubicBezTo>
                  <a:cubicBezTo>
                    <a:pt x="6" y="471"/>
                    <a:pt x="0" y="430"/>
                    <a:pt x="0" y="386"/>
                  </a:cubicBezTo>
                  <a:cubicBezTo>
                    <a:pt x="0" y="275"/>
                    <a:pt x="41" y="183"/>
                    <a:pt x="122" y="110"/>
                  </a:cubicBezTo>
                  <a:cubicBezTo>
                    <a:pt x="204" y="37"/>
                    <a:pt x="315" y="0"/>
                    <a:pt x="456" y="0"/>
                  </a:cubicBezTo>
                  <a:cubicBezTo>
                    <a:pt x="490" y="0"/>
                    <a:pt x="520" y="2"/>
                    <a:pt x="549" y="6"/>
                  </a:cubicBezTo>
                  <a:cubicBezTo>
                    <a:pt x="577" y="9"/>
                    <a:pt x="612" y="16"/>
                    <a:pt x="653" y="27"/>
                  </a:cubicBezTo>
                  <a:cubicBezTo>
                    <a:pt x="694" y="37"/>
                    <a:pt x="719" y="43"/>
                    <a:pt x="728" y="45"/>
                  </a:cubicBezTo>
                  <a:cubicBezTo>
                    <a:pt x="720" y="64"/>
                    <a:pt x="714" y="82"/>
                    <a:pt x="710" y="101"/>
                  </a:cubicBezTo>
                  <a:cubicBezTo>
                    <a:pt x="704" y="131"/>
                    <a:pt x="700" y="165"/>
                    <a:pt x="698" y="204"/>
                  </a:cubicBezTo>
                  <a:cubicBezTo>
                    <a:pt x="665" y="204"/>
                    <a:pt x="665" y="204"/>
                    <a:pt x="665" y="204"/>
                  </a:cubicBezTo>
                  <a:cubicBezTo>
                    <a:pt x="664" y="143"/>
                    <a:pt x="664" y="143"/>
                    <a:pt x="664" y="143"/>
                  </a:cubicBezTo>
                  <a:cubicBezTo>
                    <a:pt x="661" y="109"/>
                    <a:pt x="641" y="83"/>
                    <a:pt x="604" y="66"/>
                  </a:cubicBezTo>
                  <a:cubicBezTo>
                    <a:pt x="568" y="50"/>
                    <a:pt x="515" y="41"/>
                    <a:pt x="445" y="41"/>
                  </a:cubicBezTo>
                  <a:cubicBezTo>
                    <a:pt x="393" y="42"/>
                    <a:pt x="349" y="48"/>
                    <a:pt x="313" y="60"/>
                  </a:cubicBezTo>
                  <a:cubicBezTo>
                    <a:pt x="276" y="72"/>
                    <a:pt x="244" y="91"/>
                    <a:pt x="216" y="117"/>
                  </a:cubicBezTo>
                  <a:cubicBezTo>
                    <a:pt x="189" y="143"/>
                    <a:pt x="166" y="176"/>
                    <a:pt x="148" y="216"/>
                  </a:cubicBezTo>
                  <a:cubicBezTo>
                    <a:pt x="131" y="256"/>
                    <a:pt x="122" y="306"/>
                    <a:pt x="121" y="366"/>
                  </a:cubicBezTo>
                  <a:cubicBezTo>
                    <a:pt x="121" y="472"/>
                    <a:pt x="155" y="557"/>
                    <a:pt x="223" y="621"/>
                  </a:cubicBezTo>
                  <a:cubicBezTo>
                    <a:pt x="290" y="685"/>
                    <a:pt x="380" y="717"/>
                    <a:pt x="492" y="717"/>
                  </a:cubicBezTo>
                  <a:cubicBezTo>
                    <a:pt x="542" y="717"/>
                    <a:pt x="588" y="711"/>
                    <a:pt x="631" y="698"/>
                  </a:cubicBezTo>
                  <a:cubicBezTo>
                    <a:pt x="660" y="689"/>
                    <a:pt x="689" y="675"/>
                    <a:pt x="718" y="656"/>
                  </a:cubicBezTo>
                  <a:lnTo>
                    <a:pt x="728" y="667"/>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9" name="Freeform 12"/>
            <p:cNvSpPr>
              <a:spLocks/>
            </p:cNvSpPr>
            <p:nvPr userDrawn="1"/>
          </p:nvSpPr>
          <p:spPr bwMode="auto">
            <a:xfrm>
              <a:off x="757238" y="687388"/>
              <a:ext cx="323850" cy="239713"/>
            </a:xfrm>
            <a:custGeom>
              <a:avLst/>
              <a:gdLst>
                <a:gd name="T0" fmla="*/ 0 w 1017"/>
                <a:gd name="T1" fmla="*/ 35 h 754"/>
                <a:gd name="T2" fmla="*/ 0 w 1017"/>
                <a:gd name="T3" fmla="*/ 0 h 754"/>
                <a:gd name="T4" fmla="*/ 110 w 1017"/>
                <a:gd name="T5" fmla="*/ 4 h 754"/>
                <a:gd name="T6" fmla="*/ 212 w 1017"/>
                <a:gd name="T7" fmla="*/ 0 h 754"/>
                <a:gd name="T8" fmla="*/ 300 w 1017"/>
                <a:gd name="T9" fmla="*/ 183 h 754"/>
                <a:gd name="T10" fmla="*/ 509 w 1017"/>
                <a:gd name="T11" fmla="*/ 592 h 754"/>
                <a:gd name="T12" fmla="*/ 697 w 1017"/>
                <a:gd name="T13" fmla="*/ 218 h 754"/>
                <a:gd name="T14" fmla="*/ 800 w 1017"/>
                <a:gd name="T15" fmla="*/ 0 h 754"/>
                <a:gd name="T16" fmla="*/ 898 w 1017"/>
                <a:gd name="T17" fmla="*/ 4 h 754"/>
                <a:gd name="T18" fmla="*/ 1017 w 1017"/>
                <a:gd name="T19" fmla="*/ 0 h 754"/>
                <a:gd name="T20" fmla="*/ 1017 w 1017"/>
                <a:gd name="T21" fmla="*/ 35 h 754"/>
                <a:gd name="T22" fmla="*/ 938 w 1017"/>
                <a:gd name="T23" fmla="*/ 40 h 754"/>
                <a:gd name="T24" fmla="*/ 918 w 1017"/>
                <a:gd name="T25" fmla="*/ 53 h 754"/>
                <a:gd name="T26" fmla="*/ 910 w 1017"/>
                <a:gd name="T27" fmla="*/ 103 h 754"/>
                <a:gd name="T28" fmla="*/ 907 w 1017"/>
                <a:gd name="T29" fmla="*/ 251 h 754"/>
                <a:gd name="T30" fmla="*/ 907 w 1017"/>
                <a:gd name="T31" fmla="*/ 492 h 754"/>
                <a:gd name="T32" fmla="*/ 910 w 1017"/>
                <a:gd name="T33" fmla="*/ 631 h 754"/>
                <a:gd name="T34" fmla="*/ 918 w 1017"/>
                <a:gd name="T35" fmla="*/ 690 h 754"/>
                <a:gd name="T36" fmla="*/ 938 w 1017"/>
                <a:gd name="T37" fmla="*/ 704 h 754"/>
                <a:gd name="T38" fmla="*/ 1017 w 1017"/>
                <a:gd name="T39" fmla="*/ 709 h 754"/>
                <a:gd name="T40" fmla="*/ 1017 w 1017"/>
                <a:gd name="T41" fmla="*/ 743 h 754"/>
                <a:gd name="T42" fmla="*/ 861 w 1017"/>
                <a:gd name="T43" fmla="*/ 739 h 754"/>
                <a:gd name="T44" fmla="*/ 699 w 1017"/>
                <a:gd name="T45" fmla="*/ 743 h 754"/>
                <a:gd name="T46" fmla="*/ 699 w 1017"/>
                <a:gd name="T47" fmla="*/ 709 h 754"/>
                <a:gd name="T48" fmla="*/ 778 w 1017"/>
                <a:gd name="T49" fmla="*/ 704 h 754"/>
                <a:gd name="T50" fmla="*/ 797 w 1017"/>
                <a:gd name="T51" fmla="*/ 691 h 754"/>
                <a:gd name="T52" fmla="*/ 806 w 1017"/>
                <a:gd name="T53" fmla="*/ 641 h 754"/>
                <a:gd name="T54" fmla="*/ 808 w 1017"/>
                <a:gd name="T55" fmla="*/ 492 h 754"/>
                <a:gd name="T56" fmla="*/ 808 w 1017"/>
                <a:gd name="T57" fmla="*/ 108 h 754"/>
                <a:gd name="T58" fmla="*/ 619 w 1017"/>
                <a:gd name="T59" fmla="*/ 486 h 754"/>
                <a:gd name="T60" fmla="*/ 549 w 1017"/>
                <a:gd name="T61" fmla="*/ 629 h 754"/>
                <a:gd name="T62" fmla="*/ 494 w 1017"/>
                <a:gd name="T63" fmla="*/ 754 h 754"/>
                <a:gd name="T64" fmla="*/ 472 w 1017"/>
                <a:gd name="T65" fmla="*/ 754 h 754"/>
                <a:gd name="T66" fmla="*/ 459 w 1017"/>
                <a:gd name="T67" fmla="*/ 722 h 754"/>
                <a:gd name="T68" fmla="*/ 422 w 1017"/>
                <a:gd name="T69" fmla="*/ 645 h 754"/>
                <a:gd name="T70" fmla="*/ 159 w 1017"/>
                <a:gd name="T71" fmla="*/ 126 h 754"/>
                <a:gd name="T72" fmla="*/ 159 w 1017"/>
                <a:gd name="T73" fmla="*/ 492 h 754"/>
                <a:gd name="T74" fmla="*/ 163 w 1017"/>
                <a:gd name="T75" fmla="*/ 631 h 754"/>
                <a:gd name="T76" fmla="*/ 171 w 1017"/>
                <a:gd name="T77" fmla="*/ 690 h 754"/>
                <a:gd name="T78" fmla="*/ 191 w 1017"/>
                <a:gd name="T79" fmla="*/ 704 h 754"/>
                <a:gd name="T80" fmla="*/ 271 w 1017"/>
                <a:gd name="T81" fmla="*/ 709 h 754"/>
                <a:gd name="T82" fmla="*/ 271 w 1017"/>
                <a:gd name="T83" fmla="*/ 743 h 754"/>
                <a:gd name="T84" fmla="*/ 138 w 1017"/>
                <a:gd name="T85" fmla="*/ 739 h 754"/>
                <a:gd name="T86" fmla="*/ 0 w 1017"/>
                <a:gd name="T87" fmla="*/ 743 h 754"/>
                <a:gd name="T88" fmla="*/ 0 w 1017"/>
                <a:gd name="T89" fmla="*/ 709 h 754"/>
                <a:gd name="T90" fmla="*/ 79 w 1017"/>
                <a:gd name="T91" fmla="*/ 704 h 754"/>
                <a:gd name="T92" fmla="*/ 98 w 1017"/>
                <a:gd name="T93" fmla="*/ 691 h 754"/>
                <a:gd name="T94" fmla="*/ 107 w 1017"/>
                <a:gd name="T95" fmla="*/ 641 h 754"/>
                <a:gd name="T96" fmla="*/ 109 w 1017"/>
                <a:gd name="T97" fmla="*/ 492 h 754"/>
                <a:gd name="T98" fmla="*/ 109 w 1017"/>
                <a:gd name="T99" fmla="*/ 251 h 754"/>
                <a:gd name="T100" fmla="*/ 107 w 1017"/>
                <a:gd name="T101" fmla="*/ 112 h 754"/>
                <a:gd name="T102" fmla="*/ 99 w 1017"/>
                <a:gd name="T103" fmla="*/ 54 h 754"/>
                <a:gd name="T104" fmla="*/ 78 w 1017"/>
                <a:gd name="T105" fmla="*/ 40 h 754"/>
                <a:gd name="T106" fmla="*/ 0 w 1017"/>
                <a:gd name="T107" fmla="*/ 35 h 75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Lst>
              <a:rect l="0" t="0" r="r" b="b"/>
              <a:pathLst>
                <a:path w="1017" h="754">
                  <a:moveTo>
                    <a:pt x="0" y="35"/>
                  </a:moveTo>
                  <a:cubicBezTo>
                    <a:pt x="0" y="0"/>
                    <a:pt x="0" y="0"/>
                    <a:pt x="0" y="0"/>
                  </a:cubicBezTo>
                  <a:cubicBezTo>
                    <a:pt x="38" y="2"/>
                    <a:pt x="75" y="4"/>
                    <a:pt x="110" y="4"/>
                  </a:cubicBezTo>
                  <a:cubicBezTo>
                    <a:pt x="145" y="4"/>
                    <a:pt x="179" y="2"/>
                    <a:pt x="212" y="0"/>
                  </a:cubicBezTo>
                  <a:cubicBezTo>
                    <a:pt x="244" y="70"/>
                    <a:pt x="274" y="131"/>
                    <a:pt x="300" y="183"/>
                  </a:cubicBezTo>
                  <a:cubicBezTo>
                    <a:pt x="509" y="592"/>
                    <a:pt x="509" y="592"/>
                    <a:pt x="509" y="592"/>
                  </a:cubicBezTo>
                  <a:cubicBezTo>
                    <a:pt x="697" y="218"/>
                    <a:pt x="697" y="218"/>
                    <a:pt x="697" y="218"/>
                  </a:cubicBezTo>
                  <a:cubicBezTo>
                    <a:pt x="749" y="116"/>
                    <a:pt x="783" y="43"/>
                    <a:pt x="800" y="0"/>
                  </a:cubicBezTo>
                  <a:cubicBezTo>
                    <a:pt x="839" y="2"/>
                    <a:pt x="872" y="4"/>
                    <a:pt x="898" y="4"/>
                  </a:cubicBezTo>
                  <a:cubicBezTo>
                    <a:pt x="923" y="4"/>
                    <a:pt x="962" y="2"/>
                    <a:pt x="1017" y="0"/>
                  </a:cubicBezTo>
                  <a:cubicBezTo>
                    <a:pt x="1017" y="35"/>
                    <a:pt x="1017" y="35"/>
                    <a:pt x="1017" y="35"/>
                  </a:cubicBezTo>
                  <a:cubicBezTo>
                    <a:pt x="974" y="35"/>
                    <a:pt x="947" y="37"/>
                    <a:pt x="938" y="40"/>
                  </a:cubicBezTo>
                  <a:cubicBezTo>
                    <a:pt x="928" y="43"/>
                    <a:pt x="922" y="47"/>
                    <a:pt x="918" y="53"/>
                  </a:cubicBezTo>
                  <a:cubicBezTo>
                    <a:pt x="914" y="60"/>
                    <a:pt x="911" y="76"/>
                    <a:pt x="910" y="103"/>
                  </a:cubicBezTo>
                  <a:cubicBezTo>
                    <a:pt x="910" y="110"/>
                    <a:pt x="909" y="159"/>
                    <a:pt x="907" y="251"/>
                  </a:cubicBezTo>
                  <a:cubicBezTo>
                    <a:pt x="907" y="492"/>
                    <a:pt x="907" y="492"/>
                    <a:pt x="907" y="492"/>
                  </a:cubicBezTo>
                  <a:cubicBezTo>
                    <a:pt x="907" y="540"/>
                    <a:pt x="908" y="586"/>
                    <a:pt x="910" y="631"/>
                  </a:cubicBezTo>
                  <a:cubicBezTo>
                    <a:pt x="911" y="664"/>
                    <a:pt x="914" y="684"/>
                    <a:pt x="918" y="690"/>
                  </a:cubicBezTo>
                  <a:cubicBezTo>
                    <a:pt x="922" y="696"/>
                    <a:pt x="929" y="701"/>
                    <a:pt x="938" y="704"/>
                  </a:cubicBezTo>
                  <a:cubicBezTo>
                    <a:pt x="948" y="707"/>
                    <a:pt x="974" y="709"/>
                    <a:pt x="1017" y="709"/>
                  </a:cubicBezTo>
                  <a:cubicBezTo>
                    <a:pt x="1017" y="743"/>
                    <a:pt x="1017" y="743"/>
                    <a:pt x="1017" y="743"/>
                  </a:cubicBezTo>
                  <a:cubicBezTo>
                    <a:pt x="943" y="740"/>
                    <a:pt x="891" y="739"/>
                    <a:pt x="861" y="739"/>
                  </a:cubicBezTo>
                  <a:cubicBezTo>
                    <a:pt x="837" y="739"/>
                    <a:pt x="782" y="740"/>
                    <a:pt x="699" y="743"/>
                  </a:cubicBezTo>
                  <a:cubicBezTo>
                    <a:pt x="699" y="709"/>
                    <a:pt x="699" y="709"/>
                    <a:pt x="699" y="709"/>
                  </a:cubicBezTo>
                  <a:cubicBezTo>
                    <a:pt x="742" y="709"/>
                    <a:pt x="768" y="707"/>
                    <a:pt x="778" y="704"/>
                  </a:cubicBezTo>
                  <a:cubicBezTo>
                    <a:pt x="788" y="701"/>
                    <a:pt x="794" y="697"/>
                    <a:pt x="797" y="691"/>
                  </a:cubicBezTo>
                  <a:cubicBezTo>
                    <a:pt x="802" y="684"/>
                    <a:pt x="805" y="668"/>
                    <a:pt x="806" y="641"/>
                  </a:cubicBezTo>
                  <a:cubicBezTo>
                    <a:pt x="806" y="633"/>
                    <a:pt x="807" y="584"/>
                    <a:pt x="808" y="492"/>
                  </a:cubicBezTo>
                  <a:cubicBezTo>
                    <a:pt x="808" y="108"/>
                    <a:pt x="808" y="108"/>
                    <a:pt x="808" y="108"/>
                  </a:cubicBezTo>
                  <a:cubicBezTo>
                    <a:pt x="619" y="486"/>
                    <a:pt x="619" y="486"/>
                    <a:pt x="619" y="486"/>
                  </a:cubicBezTo>
                  <a:cubicBezTo>
                    <a:pt x="589" y="545"/>
                    <a:pt x="566" y="593"/>
                    <a:pt x="549" y="629"/>
                  </a:cubicBezTo>
                  <a:cubicBezTo>
                    <a:pt x="537" y="655"/>
                    <a:pt x="518" y="696"/>
                    <a:pt x="494" y="754"/>
                  </a:cubicBezTo>
                  <a:cubicBezTo>
                    <a:pt x="472" y="754"/>
                    <a:pt x="472" y="754"/>
                    <a:pt x="472" y="754"/>
                  </a:cubicBezTo>
                  <a:cubicBezTo>
                    <a:pt x="468" y="740"/>
                    <a:pt x="463" y="729"/>
                    <a:pt x="459" y="722"/>
                  </a:cubicBezTo>
                  <a:cubicBezTo>
                    <a:pt x="422" y="645"/>
                    <a:pt x="422" y="645"/>
                    <a:pt x="422" y="645"/>
                  </a:cubicBezTo>
                  <a:cubicBezTo>
                    <a:pt x="159" y="126"/>
                    <a:pt x="159" y="126"/>
                    <a:pt x="159" y="126"/>
                  </a:cubicBezTo>
                  <a:cubicBezTo>
                    <a:pt x="159" y="492"/>
                    <a:pt x="159" y="492"/>
                    <a:pt x="159" y="492"/>
                  </a:cubicBezTo>
                  <a:cubicBezTo>
                    <a:pt x="159" y="540"/>
                    <a:pt x="160" y="586"/>
                    <a:pt x="163" y="631"/>
                  </a:cubicBezTo>
                  <a:cubicBezTo>
                    <a:pt x="164" y="664"/>
                    <a:pt x="167" y="683"/>
                    <a:pt x="171" y="690"/>
                  </a:cubicBezTo>
                  <a:cubicBezTo>
                    <a:pt x="175" y="696"/>
                    <a:pt x="182" y="701"/>
                    <a:pt x="191" y="704"/>
                  </a:cubicBezTo>
                  <a:cubicBezTo>
                    <a:pt x="200" y="707"/>
                    <a:pt x="227" y="709"/>
                    <a:pt x="271" y="709"/>
                  </a:cubicBezTo>
                  <a:cubicBezTo>
                    <a:pt x="271" y="743"/>
                    <a:pt x="271" y="743"/>
                    <a:pt x="271" y="743"/>
                  </a:cubicBezTo>
                  <a:cubicBezTo>
                    <a:pt x="138" y="739"/>
                    <a:pt x="138" y="739"/>
                    <a:pt x="138" y="739"/>
                  </a:cubicBezTo>
                  <a:cubicBezTo>
                    <a:pt x="0" y="743"/>
                    <a:pt x="0" y="743"/>
                    <a:pt x="0" y="743"/>
                  </a:cubicBezTo>
                  <a:cubicBezTo>
                    <a:pt x="0" y="709"/>
                    <a:pt x="0" y="709"/>
                    <a:pt x="0" y="709"/>
                  </a:cubicBezTo>
                  <a:cubicBezTo>
                    <a:pt x="43" y="709"/>
                    <a:pt x="69" y="707"/>
                    <a:pt x="79" y="704"/>
                  </a:cubicBezTo>
                  <a:cubicBezTo>
                    <a:pt x="88" y="701"/>
                    <a:pt x="95" y="697"/>
                    <a:pt x="98" y="691"/>
                  </a:cubicBezTo>
                  <a:cubicBezTo>
                    <a:pt x="103" y="684"/>
                    <a:pt x="105" y="668"/>
                    <a:pt x="107" y="641"/>
                  </a:cubicBezTo>
                  <a:cubicBezTo>
                    <a:pt x="107" y="634"/>
                    <a:pt x="108" y="584"/>
                    <a:pt x="109" y="492"/>
                  </a:cubicBezTo>
                  <a:cubicBezTo>
                    <a:pt x="109" y="251"/>
                    <a:pt x="109" y="251"/>
                    <a:pt x="109" y="251"/>
                  </a:cubicBezTo>
                  <a:cubicBezTo>
                    <a:pt x="109" y="204"/>
                    <a:pt x="108" y="158"/>
                    <a:pt x="107" y="112"/>
                  </a:cubicBezTo>
                  <a:cubicBezTo>
                    <a:pt x="105" y="79"/>
                    <a:pt x="103" y="60"/>
                    <a:pt x="99" y="54"/>
                  </a:cubicBezTo>
                  <a:cubicBezTo>
                    <a:pt x="94" y="48"/>
                    <a:pt x="88" y="43"/>
                    <a:pt x="78" y="40"/>
                  </a:cubicBezTo>
                  <a:cubicBezTo>
                    <a:pt x="69" y="37"/>
                    <a:pt x="43" y="35"/>
                    <a:pt x="0" y="35"/>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0" name="Freeform 13"/>
            <p:cNvSpPr>
              <a:spLocks noEditPoints="1"/>
            </p:cNvSpPr>
            <p:nvPr userDrawn="1"/>
          </p:nvSpPr>
          <p:spPr bwMode="auto">
            <a:xfrm>
              <a:off x="1092200" y="684213"/>
              <a:ext cx="263525" cy="238125"/>
            </a:xfrm>
            <a:custGeom>
              <a:avLst/>
              <a:gdLst>
                <a:gd name="T0" fmla="*/ 117 w 832"/>
                <a:gd name="T1" fmla="*/ 747 h 750"/>
                <a:gd name="T2" fmla="*/ 257 w 832"/>
                <a:gd name="T3" fmla="*/ 750 h 750"/>
                <a:gd name="T4" fmla="*/ 257 w 832"/>
                <a:gd name="T5" fmla="*/ 717 h 750"/>
                <a:gd name="T6" fmla="*/ 185 w 832"/>
                <a:gd name="T7" fmla="*/ 712 h 750"/>
                <a:gd name="T8" fmla="*/ 166 w 832"/>
                <a:gd name="T9" fmla="*/ 702 h 750"/>
                <a:gd name="T10" fmla="*/ 162 w 832"/>
                <a:gd name="T11" fmla="*/ 690 h 750"/>
                <a:gd name="T12" fmla="*/ 178 w 832"/>
                <a:gd name="T13" fmla="*/ 637 h 750"/>
                <a:gd name="T14" fmla="*/ 237 w 832"/>
                <a:gd name="T15" fmla="*/ 503 h 750"/>
                <a:gd name="T16" fmla="*/ 556 w 832"/>
                <a:gd name="T17" fmla="*/ 503 h 750"/>
                <a:gd name="T18" fmla="*/ 624 w 832"/>
                <a:gd name="T19" fmla="*/ 663 h 750"/>
                <a:gd name="T20" fmla="*/ 632 w 832"/>
                <a:gd name="T21" fmla="*/ 693 h 750"/>
                <a:gd name="T22" fmla="*/ 627 w 832"/>
                <a:gd name="T23" fmla="*/ 705 h 750"/>
                <a:gd name="T24" fmla="*/ 609 w 832"/>
                <a:gd name="T25" fmla="*/ 713 h 750"/>
                <a:gd name="T26" fmla="*/ 535 w 832"/>
                <a:gd name="T27" fmla="*/ 717 h 750"/>
                <a:gd name="T28" fmla="*/ 535 w 832"/>
                <a:gd name="T29" fmla="*/ 750 h 750"/>
                <a:gd name="T30" fmla="*/ 712 w 832"/>
                <a:gd name="T31" fmla="*/ 747 h 750"/>
                <a:gd name="T32" fmla="*/ 832 w 832"/>
                <a:gd name="T33" fmla="*/ 750 h 750"/>
                <a:gd name="T34" fmla="*/ 832 w 832"/>
                <a:gd name="T35" fmla="*/ 717 h 750"/>
                <a:gd name="T36" fmla="*/ 776 w 832"/>
                <a:gd name="T37" fmla="*/ 710 h 750"/>
                <a:gd name="T38" fmla="*/ 753 w 832"/>
                <a:gd name="T39" fmla="*/ 687 h 750"/>
                <a:gd name="T40" fmla="*/ 677 w 832"/>
                <a:gd name="T41" fmla="*/ 526 h 750"/>
                <a:gd name="T42" fmla="*/ 441 w 832"/>
                <a:gd name="T43" fmla="*/ 0 h 750"/>
                <a:gd name="T44" fmla="*/ 406 w 832"/>
                <a:gd name="T45" fmla="*/ 0 h 750"/>
                <a:gd name="T46" fmla="*/ 310 w 832"/>
                <a:gd name="T47" fmla="*/ 217 h 750"/>
                <a:gd name="T48" fmla="*/ 172 w 832"/>
                <a:gd name="T49" fmla="*/ 512 h 750"/>
                <a:gd name="T50" fmla="*/ 100 w 832"/>
                <a:gd name="T51" fmla="*/ 660 h 750"/>
                <a:gd name="T52" fmla="*/ 74 w 832"/>
                <a:gd name="T53" fmla="*/ 702 h 750"/>
                <a:gd name="T54" fmla="*/ 54 w 832"/>
                <a:gd name="T55" fmla="*/ 713 h 750"/>
                <a:gd name="T56" fmla="*/ 0 w 832"/>
                <a:gd name="T57" fmla="*/ 717 h 750"/>
                <a:gd name="T58" fmla="*/ 0 w 832"/>
                <a:gd name="T59" fmla="*/ 750 h 750"/>
                <a:gd name="T60" fmla="*/ 117 w 832"/>
                <a:gd name="T61" fmla="*/ 747 h 750"/>
                <a:gd name="T62" fmla="*/ 396 w 832"/>
                <a:gd name="T63" fmla="*/ 143 h 750"/>
                <a:gd name="T64" fmla="*/ 534 w 832"/>
                <a:gd name="T65" fmla="*/ 458 h 750"/>
                <a:gd name="T66" fmla="*/ 256 w 832"/>
                <a:gd name="T67" fmla="*/ 458 h 750"/>
                <a:gd name="T68" fmla="*/ 396 w 832"/>
                <a:gd name="T69" fmla="*/ 143 h 75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Lst>
              <a:rect l="0" t="0" r="r" b="b"/>
              <a:pathLst>
                <a:path w="832" h="750">
                  <a:moveTo>
                    <a:pt x="117" y="747"/>
                  </a:moveTo>
                  <a:cubicBezTo>
                    <a:pt x="148" y="747"/>
                    <a:pt x="195" y="748"/>
                    <a:pt x="257" y="750"/>
                  </a:cubicBezTo>
                  <a:cubicBezTo>
                    <a:pt x="257" y="717"/>
                    <a:pt x="257" y="717"/>
                    <a:pt x="257" y="717"/>
                  </a:cubicBezTo>
                  <a:cubicBezTo>
                    <a:pt x="222" y="716"/>
                    <a:pt x="199" y="715"/>
                    <a:pt x="185" y="712"/>
                  </a:cubicBezTo>
                  <a:cubicBezTo>
                    <a:pt x="177" y="710"/>
                    <a:pt x="170" y="707"/>
                    <a:pt x="166" y="702"/>
                  </a:cubicBezTo>
                  <a:cubicBezTo>
                    <a:pt x="163" y="699"/>
                    <a:pt x="162" y="695"/>
                    <a:pt x="162" y="690"/>
                  </a:cubicBezTo>
                  <a:cubicBezTo>
                    <a:pt x="162" y="679"/>
                    <a:pt x="167" y="662"/>
                    <a:pt x="178" y="637"/>
                  </a:cubicBezTo>
                  <a:cubicBezTo>
                    <a:pt x="237" y="503"/>
                    <a:pt x="237" y="503"/>
                    <a:pt x="237" y="503"/>
                  </a:cubicBezTo>
                  <a:cubicBezTo>
                    <a:pt x="556" y="503"/>
                    <a:pt x="556" y="503"/>
                    <a:pt x="556" y="503"/>
                  </a:cubicBezTo>
                  <a:cubicBezTo>
                    <a:pt x="624" y="663"/>
                    <a:pt x="624" y="663"/>
                    <a:pt x="624" y="663"/>
                  </a:cubicBezTo>
                  <a:cubicBezTo>
                    <a:pt x="629" y="675"/>
                    <a:pt x="632" y="685"/>
                    <a:pt x="632" y="693"/>
                  </a:cubicBezTo>
                  <a:cubicBezTo>
                    <a:pt x="632" y="698"/>
                    <a:pt x="630" y="702"/>
                    <a:pt x="627" y="705"/>
                  </a:cubicBezTo>
                  <a:cubicBezTo>
                    <a:pt x="624" y="708"/>
                    <a:pt x="618" y="711"/>
                    <a:pt x="609" y="713"/>
                  </a:cubicBezTo>
                  <a:cubicBezTo>
                    <a:pt x="601" y="715"/>
                    <a:pt x="576" y="716"/>
                    <a:pt x="535" y="717"/>
                  </a:cubicBezTo>
                  <a:cubicBezTo>
                    <a:pt x="535" y="750"/>
                    <a:pt x="535" y="750"/>
                    <a:pt x="535" y="750"/>
                  </a:cubicBezTo>
                  <a:cubicBezTo>
                    <a:pt x="712" y="747"/>
                    <a:pt x="712" y="747"/>
                    <a:pt x="712" y="747"/>
                  </a:cubicBezTo>
                  <a:cubicBezTo>
                    <a:pt x="734" y="747"/>
                    <a:pt x="775" y="748"/>
                    <a:pt x="832" y="750"/>
                  </a:cubicBezTo>
                  <a:cubicBezTo>
                    <a:pt x="832" y="717"/>
                    <a:pt x="832" y="717"/>
                    <a:pt x="832" y="717"/>
                  </a:cubicBezTo>
                  <a:cubicBezTo>
                    <a:pt x="803" y="716"/>
                    <a:pt x="784" y="714"/>
                    <a:pt x="776" y="710"/>
                  </a:cubicBezTo>
                  <a:cubicBezTo>
                    <a:pt x="767" y="707"/>
                    <a:pt x="760" y="699"/>
                    <a:pt x="753" y="687"/>
                  </a:cubicBezTo>
                  <a:cubicBezTo>
                    <a:pt x="740" y="664"/>
                    <a:pt x="715" y="611"/>
                    <a:pt x="677" y="526"/>
                  </a:cubicBezTo>
                  <a:cubicBezTo>
                    <a:pt x="441" y="0"/>
                    <a:pt x="441" y="0"/>
                    <a:pt x="441" y="0"/>
                  </a:cubicBezTo>
                  <a:cubicBezTo>
                    <a:pt x="406" y="0"/>
                    <a:pt x="406" y="0"/>
                    <a:pt x="406" y="0"/>
                  </a:cubicBezTo>
                  <a:cubicBezTo>
                    <a:pt x="357" y="112"/>
                    <a:pt x="325" y="185"/>
                    <a:pt x="310" y="217"/>
                  </a:cubicBezTo>
                  <a:cubicBezTo>
                    <a:pt x="172" y="512"/>
                    <a:pt x="172" y="512"/>
                    <a:pt x="172" y="512"/>
                  </a:cubicBezTo>
                  <a:cubicBezTo>
                    <a:pt x="131" y="598"/>
                    <a:pt x="107" y="647"/>
                    <a:pt x="100" y="660"/>
                  </a:cubicBezTo>
                  <a:cubicBezTo>
                    <a:pt x="89" y="683"/>
                    <a:pt x="80" y="697"/>
                    <a:pt x="74" y="702"/>
                  </a:cubicBezTo>
                  <a:cubicBezTo>
                    <a:pt x="68" y="708"/>
                    <a:pt x="61" y="711"/>
                    <a:pt x="54" y="713"/>
                  </a:cubicBezTo>
                  <a:cubicBezTo>
                    <a:pt x="47" y="715"/>
                    <a:pt x="29" y="716"/>
                    <a:pt x="0" y="717"/>
                  </a:cubicBezTo>
                  <a:cubicBezTo>
                    <a:pt x="0" y="750"/>
                    <a:pt x="0" y="750"/>
                    <a:pt x="0" y="750"/>
                  </a:cubicBezTo>
                  <a:cubicBezTo>
                    <a:pt x="42" y="748"/>
                    <a:pt x="81" y="747"/>
                    <a:pt x="117" y="747"/>
                  </a:cubicBezTo>
                  <a:close/>
                  <a:moveTo>
                    <a:pt x="396" y="143"/>
                  </a:moveTo>
                  <a:cubicBezTo>
                    <a:pt x="534" y="458"/>
                    <a:pt x="534" y="458"/>
                    <a:pt x="534" y="458"/>
                  </a:cubicBezTo>
                  <a:cubicBezTo>
                    <a:pt x="256" y="458"/>
                    <a:pt x="256" y="458"/>
                    <a:pt x="256" y="458"/>
                  </a:cubicBezTo>
                  <a:lnTo>
                    <a:pt x="396" y="143"/>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1" name="Freeform 14"/>
            <p:cNvSpPr>
              <a:spLocks/>
            </p:cNvSpPr>
            <p:nvPr userDrawn="1"/>
          </p:nvSpPr>
          <p:spPr bwMode="auto">
            <a:xfrm>
              <a:off x="1309688" y="687388"/>
              <a:ext cx="260350" cy="234950"/>
            </a:xfrm>
            <a:custGeom>
              <a:avLst/>
              <a:gdLst>
                <a:gd name="T0" fmla="*/ 601 w 817"/>
                <a:gd name="T1" fmla="*/ 111 h 743"/>
                <a:gd name="T2" fmla="*/ 634 w 817"/>
                <a:gd name="T3" fmla="*/ 52 h 743"/>
                <a:gd name="T4" fmla="*/ 624 w 817"/>
                <a:gd name="T5" fmla="*/ 39 h 743"/>
                <a:gd name="T6" fmla="*/ 543 w 817"/>
                <a:gd name="T7" fmla="*/ 33 h 743"/>
                <a:gd name="T8" fmla="*/ 543 w 817"/>
                <a:gd name="T9" fmla="*/ 0 h 743"/>
                <a:gd name="T10" fmla="*/ 688 w 817"/>
                <a:gd name="T11" fmla="*/ 3 h 743"/>
                <a:gd name="T12" fmla="*/ 817 w 817"/>
                <a:gd name="T13" fmla="*/ 0 h 743"/>
                <a:gd name="T14" fmla="*/ 817 w 817"/>
                <a:gd name="T15" fmla="*/ 33 h 743"/>
                <a:gd name="T16" fmla="*/ 746 w 817"/>
                <a:gd name="T17" fmla="*/ 39 h 743"/>
                <a:gd name="T18" fmla="*/ 718 w 817"/>
                <a:gd name="T19" fmla="*/ 51 h 743"/>
                <a:gd name="T20" fmla="*/ 675 w 817"/>
                <a:gd name="T21" fmla="*/ 102 h 743"/>
                <a:gd name="T22" fmla="*/ 514 w 817"/>
                <a:gd name="T23" fmla="*/ 333 h 743"/>
                <a:gd name="T24" fmla="*/ 461 w 817"/>
                <a:gd name="T25" fmla="*/ 422 h 743"/>
                <a:gd name="T26" fmla="*/ 455 w 817"/>
                <a:gd name="T27" fmla="*/ 453 h 743"/>
                <a:gd name="T28" fmla="*/ 455 w 817"/>
                <a:gd name="T29" fmla="*/ 493 h 743"/>
                <a:gd name="T30" fmla="*/ 459 w 817"/>
                <a:gd name="T31" fmla="*/ 631 h 743"/>
                <a:gd name="T32" fmla="*/ 466 w 817"/>
                <a:gd name="T33" fmla="*/ 690 h 743"/>
                <a:gd name="T34" fmla="*/ 486 w 817"/>
                <a:gd name="T35" fmla="*/ 704 h 743"/>
                <a:gd name="T36" fmla="*/ 564 w 817"/>
                <a:gd name="T37" fmla="*/ 710 h 743"/>
                <a:gd name="T38" fmla="*/ 564 w 817"/>
                <a:gd name="T39" fmla="*/ 743 h 743"/>
                <a:gd name="T40" fmla="*/ 410 w 817"/>
                <a:gd name="T41" fmla="*/ 740 h 743"/>
                <a:gd name="T42" fmla="*/ 244 w 817"/>
                <a:gd name="T43" fmla="*/ 743 h 743"/>
                <a:gd name="T44" fmla="*/ 244 w 817"/>
                <a:gd name="T45" fmla="*/ 710 h 743"/>
                <a:gd name="T46" fmla="*/ 322 w 817"/>
                <a:gd name="T47" fmla="*/ 704 h 743"/>
                <a:gd name="T48" fmla="*/ 341 w 817"/>
                <a:gd name="T49" fmla="*/ 692 h 743"/>
                <a:gd name="T50" fmla="*/ 350 w 817"/>
                <a:gd name="T51" fmla="*/ 641 h 743"/>
                <a:gd name="T52" fmla="*/ 353 w 817"/>
                <a:gd name="T53" fmla="*/ 493 h 743"/>
                <a:gd name="T54" fmla="*/ 353 w 817"/>
                <a:gd name="T55" fmla="*/ 432 h 743"/>
                <a:gd name="T56" fmla="*/ 331 w 817"/>
                <a:gd name="T57" fmla="*/ 390 h 743"/>
                <a:gd name="T58" fmla="*/ 275 w 817"/>
                <a:gd name="T59" fmla="*/ 300 h 743"/>
                <a:gd name="T60" fmla="*/ 135 w 817"/>
                <a:gd name="T61" fmla="*/ 102 h 743"/>
                <a:gd name="T62" fmla="*/ 96 w 817"/>
                <a:gd name="T63" fmla="*/ 51 h 743"/>
                <a:gd name="T64" fmla="*/ 69 w 817"/>
                <a:gd name="T65" fmla="*/ 39 h 743"/>
                <a:gd name="T66" fmla="*/ 0 w 817"/>
                <a:gd name="T67" fmla="*/ 33 h 743"/>
                <a:gd name="T68" fmla="*/ 0 w 817"/>
                <a:gd name="T69" fmla="*/ 0 h 743"/>
                <a:gd name="T70" fmla="*/ 130 w 817"/>
                <a:gd name="T71" fmla="*/ 3 h 743"/>
                <a:gd name="T72" fmla="*/ 333 w 817"/>
                <a:gd name="T73" fmla="*/ 0 h 743"/>
                <a:gd name="T74" fmla="*/ 333 w 817"/>
                <a:gd name="T75" fmla="*/ 33 h 743"/>
                <a:gd name="T76" fmla="*/ 246 w 817"/>
                <a:gd name="T77" fmla="*/ 39 h 743"/>
                <a:gd name="T78" fmla="*/ 234 w 817"/>
                <a:gd name="T79" fmla="*/ 52 h 743"/>
                <a:gd name="T80" fmla="*/ 262 w 817"/>
                <a:gd name="T81" fmla="*/ 111 h 743"/>
                <a:gd name="T82" fmla="*/ 426 w 817"/>
                <a:gd name="T83" fmla="*/ 376 h 743"/>
                <a:gd name="T84" fmla="*/ 601 w 817"/>
                <a:gd name="T85" fmla="*/ 111 h 74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Lst>
              <a:rect l="0" t="0" r="r" b="b"/>
              <a:pathLst>
                <a:path w="817" h="743">
                  <a:moveTo>
                    <a:pt x="601" y="111"/>
                  </a:moveTo>
                  <a:cubicBezTo>
                    <a:pt x="623" y="78"/>
                    <a:pt x="634" y="59"/>
                    <a:pt x="634" y="52"/>
                  </a:cubicBezTo>
                  <a:cubicBezTo>
                    <a:pt x="634" y="46"/>
                    <a:pt x="631" y="41"/>
                    <a:pt x="624" y="39"/>
                  </a:cubicBezTo>
                  <a:cubicBezTo>
                    <a:pt x="616" y="36"/>
                    <a:pt x="585" y="34"/>
                    <a:pt x="543" y="33"/>
                  </a:cubicBezTo>
                  <a:cubicBezTo>
                    <a:pt x="543" y="0"/>
                    <a:pt x="543" y="0"/>
                    <a:pt x="543" y="0"/>
                  </a:cubicBezTo>
                  <a:cubicBezTo>
                    <a:pt x="610" y="2"/>
                    <a:pt x="650" y="3"/>
                    <a:pt x="688" y="3"/>
                  </a:cubicBezTo>
                  <a:cubicBezTo>
                    <a:pt x="725" y="3"/>
                    <a:pt x="745" y="2"/>
                    <a:pt x="817" y="0"/>
                  </a:cubicBezTo>
                  <a:cubicBezTo>
                    <a:pt x="817" y="33"/>
                    <a:pt x="817" y="33"/>
                    <a:pt x="817" y="33"/>
                  </a:cubicBezTo>
                  <a:cubicBezTo>
                    <a:pt x="773" y="34"/>
                    <a:pt x="757" y="36"/>
                    <a:pt x="746" y="39"/>
                  </a:cubicBezTo>
                  <a:cubicBezTo>
                    <a:pt x="735" y="41"/>
                    <a:pt x="725" y="46"/>
                    <a:pt x="718" y="51"/>
                  </a:cubicBezTo>
                  <a:cubicBezTo>
                    <a:pt x="709" y="58"/>
                    <a:pt x="695" y="75"/>
                    <a:pt x="675" y="102"/>
                  </a:cubicBezTo>
                  <a:cubicBezTo>
                    <a:pt x="514" y="333"/>
                    <a:pt x="514" y="333"/>
                    <a:pt x="514" y="333"/>
                  </a:cubicBezTo>
                  <a:cubicBezTo>
                    <a:pt x="483" y="381"/>
                    <a:pt x="465" y="411"/>
                    <a:pt x="461" y="422"/>
                  </a:cubicBezTo>
                  <a:cubicBezTo>
                    <a:pt x="457" y="433"/>
                    <a:pt x="455" y="443"/>
                    <a:pt x="455" y="453"/>
                  </a:cubicBezTo>
                  <a:cubicBezTo>
                    <a:pt x="455" y="493"/>
                    <a:pt x="455" y="493"/>
                    <a:pt x="455" y="493"/>
                  </a:cubicBezTo>
                  <a:cubicBezTo>
                    <a:pt x="455" y="541"/>
                    <a:pt x="456" y="587"/>
                    <a:pt x="459" y="631"/>
                  </a:cubicBezTo>
                  <a:cubicBezTo>
                    <a:pt x="460" y="665"/>
                    <a:pt x="462" y="684"/>
                    <a:pt x="466" y="690"/>
                  </a:cubicBezTo>
                  <a:cubicBezTo>
                    <a:pt x="470" y="696"/>
                    <a:pt x="477" y="701"/>
                    <a:pt x="486" y="704"/>
                  </a:cubicBezTo>
                  <a:cubicBezTo>
                    <a:pt x="495" y="707"/>
                    <a:pt x="521" y="709"/>
                    <a:pt x="564" y="710"/>
                  </a:cubicBezTo>
                  <a:cubicBezTo>
                    <a:pt x="564" y="743"/>
                    <a:pt x="564" y="743"/>
                    <a:pt x="564" y="743"/>
                  </a:cubicBezTo>
                  <a:cubicBezTo>
                    <a:pt x="505" y="741"/>
                    <a:pt x="453" y="740"/>
                    <a:pt x="410" y="740"/>
                  </a:cubicBezTo>
                  <a:cubicBezTo>
                    <a:pt x="368" y="740"/>
                    <a:pt x="313" y="741"/>
                    <a:pt x="244" y="743"/>
                  </a:cubicBezTo>
                  <a:cubicBezTo>
                    <a:pt x="244" y="710"/>
                    <a:pt x="244" y="710"/>
                    <a:pt x="244" y="710"/>
                  </a:cubicBezTo>
                  <a:cubicBezTo>
                    <a:pt x="287" y="709"/>
                    <a:pt x="313" y="707"/>
                    <a:pt x="322" y="704"/>
                  </a:cubicBezTo>
                  <a:cubicBezTo>
                    <a:pt x="332" y="701"/>
                    <a:pt x="338" y="697"/>
                    <a:pt x="341" y="692"/>
                  </a:cubicBezTo>
                  <a:cubicBezTo>
                    <a:pt x="346" y="685"/>
                    <a:pt x="349" y="668"/>
                    <a:pt x="350" y="641"/>
                  </a:cubicBezTo>
                  <a:cubicBezTo>
                    <a:pt x="350" y="634"/>
                    <a:pt x="351" y="585"/>
                    <a:pt x="353" y="493"/>
                  </a:cubicBezTo>
                  <a:cubicBezTo>
                    <a:pt x="353" y="432"/>
                    <a:pt x="353" y="432"/>
                    <a:pt x="353" y="432"/>
                  </a:cubicBezTo>
                  <a:cubicBezTo>
                    <a:pt x="345" y="417"/>
                    <a:pt x="338" y="403"/>
                    <a:pt x="331" y="390"/>
                  </a:cubicBezTo>
                  <a:cubicBezTo>
                    <a:pt x="325" y="382"/>
                    <a:pt x="307" y="352"/>
                    <a:pt x="275" y="300"/>
                  </a:cubicBezTo>
                  <a:cubicBezTo>
                    <a:pt x="135" y="102"/>
                    <a:pt x="135" y="102"/>
                    <a:pt x="135" y="102"/>
                  </a:cubicBezTo>
                  <a:cubicBezTo>
                    <a:pt x="118" y="75"/>
                    <a:pt x="105" y="58"/>
                    <a:pt x="96" y="51"/>
                  </a:cubicBezTo>
                  <a:cubicBezTo>
                    <a:pt x="89" y="46"/>
                    <a:pt x="80" y="41"/>
                    <a:pt x="69" y="39"/>
                  </a:cubicBezTo>
                  <a:cubicBezTo>
                    <a:pt x="58" y="36"/>
                    <a:pt x="44" y="34"/>
                    <a:pt x="0" y="33"/>
                  </a:cubicBezTo>
                  <a:cubicBezTo>
                    <a:pt x="0" y="0"/>
                    <a:pt x="0" y="0"/>
                    <a:pt x="0" y="0"/>
                  </a:cubicBezTo>
                  <a:cubicBezTo>
                    <a:pt x="72" y="2"/>
                    <a:pt x="94" y="3"/>
                    <a:pt x="130" y="3"/>
                  </a:cubicBezTo>
                  <a:cubicBezTo>
                    <a:pt x="168" y="3"/>
                    <a:pt x="265" y="2"/>
                    <a:pt x="333" y="0"/>
                  </a:cubicBezTo>
                  <a:cubicBezTo>
                    <a:pt x="333" y="33"/>
                    <a:pt x="333" y="33"/>
                    <a:pt x="333" y="33"/>
                  </a:cubicBezTo>
                  <a:cubicBezTo>
                    <a:pt x="291" y="34"/>
                    <a:pt x="254" y="36"/>
                    <a:pt x="246" y="39"/>
                  </a:cubicBezTo>
                  <a:cubicBezTo>
                    <a:pt x="239" y="41"/>
                    <a:pt x="235" y="46"/>
                    <a:pt x="234" y="52"/>
                  </a:cubicBezTo>
                  <a:cubicBezTo>
                    <a:pt x="234" y="59"/>
                    <a:pt x="243" y="78"/>
                    <a:pt x="262" y="111"/>
                  </a:cubicBezTo>
                  <a:cubicBezTo>
                    <a:pt x="426" y="376"/>
                    <a:pt x="426" y="376"/>
                    <a:pt x="426" y="376"/>
                  </a:cubicBezTo>
                  <a:lnTo>
                    <a:pt x="601" y="111"/>
                  </a:ln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2" name="Freeform 15"/>
            <p:cNvSpPr>
              <a:spLocks noEditPoints="1"/>
            </p:cNvSpPr>
            <p:nvPr userDrawn="1"/>
          </p:nvSpPr>
          <p:spPr bwMode="auto">
            <a:xfrm>
              <a:off x="1558925" y="681038"/>
              <a:ext cx="263525" cy="246063"/>
            </a:xfrm>
            <a:custGeom>
              <a:avLst/>
              <a:gdLst>
                <a:gd name="T0" fmla="*/ 148 w 830"/>
                <a:gd name="T1" fmla="*/ 190 h 775"/>
                <a:gd name="T2" fmla="*/ 247 w 830"/>
                <a:gd name="T3" fmla="*/ 82 h 775"/>
                <a:gd name="T4" fmla="*/ 399 w 830"/>
                <a:gd name="T5" fmla="*/ 45 h 775"/>
                <a:gd name="T6" fmla="*/ 512 w 830"/>
                <a:gd name="T7" fmla="*/ 62 h 775"/>
                <a:gd name="T8" fmla="*/ 596 w 830"/>
                <a:gd name="T9" fmla="*/ 106 h 775"/>
                <a:gd name="T10" fmla="*/ 652 w 830"/>
                <a:gd name="T11" fmla="*/ 167 h 775"/>
                <a:gd name="T12" fmla="*/ 690 w 830"/>
                <a:gd name="T13" fmla="*/ 245 h 775"/>
                <a:gd name="T14" fmla="*/ 713 w 830"/>
                <a:gd name="T15" fmla="*/ 398 h 775"/>
                <a:gd name="T16" fmla="*/ 681 w 830"/>
                <a:gd name="T17" fmla="*/ 571 h 775"/>
                <a:gd name="T18" fmla="*/ 584 w 830"/>
                <a:gd name="T19" fmla="*/ 686 h 775"/>
                <a:gd name="T20" fmla="*/ 431 w 830"/>
                <a:gd name="T21" fmla="*/ 727 h 775"/>
                <a:gd name="T22" fmla="*/ 315 w 830"/>
                <a:gd name="T23" fmla="*/ 707 h 775"/>
                <a:gd name="T24" fmla="*/ 220 w 830"/>
                <a:gd name="T25" fmla="*/ 644 h 775"/>
                <a:gd name="T26" fmla="*/ 151 w 830"/>
                <a:gd name="T27" fmla="*/ 539 h 775"/>
                <a:gd name="T28" fmla="*/ 125 w 830"/>
                <a:gd name="T29" fmla="*/ 450 h 775"/>
                <a:gd name="T30" fmla="*/ 115 w 830"/>
                <a:gd name="T31" fmla="*/ 349 h 775"/>
                <a:gd name="T32" fmla="*/ 148 w 830"/>
                <a:gd name="T33" fmla="*/ 190 h 775"/>
                <a:gd name="T34" fmla="*/ 26 w 830"/>
                <a:gd name="T35" fmla="*/ 541 h 775"/>
                <a:gd name="T36" fmla="*/ 105 w 830"/>
                <a:gd name="T37" fmla="*/ 669 h 775"/>
                <a:gd name="T38" fmla="*/ 231 w 830"/>
                <a:gd name="T39" fmla="*/ 748 h 775"/>
                <a:gd name="T40" fmla="*/ 392 w 830"/>
                <a:gd name="T41" fmla="*/ 775 h 775"/>
                <a:gd name="T42" fmla="*/ 706 w 830"/>
                <a:gd name="T43" fmla="*/ 657 h 775"/>
                <a:gd name="T44" fmla="*/ 830 w 830"/>
                <a:gd name="T45" fmla="*/ 364 h 775"/>
                <a:gd name="T46" fmla="*/ 817 w 830"/>
                <a:gd name="T47" fmla="*/ 261 h 775"/>
                <a:gd name="T48" fmla="*/ 784 w 830"/>
                <a:gd name="T49" fmla="*/ 177 h 775"/>
                <a:gd name="T50" fmla="*/ 709 w 830"/>
                <a:gd name="T51" fmla="*/ 89 h 775"/>
                <a:gd name="T52" fmla="*/ 588 w 830"/>
                <a:gd name="T53" fmla="*/ 25 h 775"/>
                <a:gd name="T54" fmla="*/ 423 w 830"/>
                <a:gd name="T55" fmla="*/ 0 h 775"/>
                <a:gd name="T56" fmla="*/ 249 w 830"/>
                <a:gd name="T57" fmla="*/ 29 h 775"/>
                <a:gd name="T58" fmla="*/ 112 w 830"/>
                <a:gd name="T59" fmla="*/ 113 h 775"/>
                <a:gd name="T60" fmla="*/ 26 w 830"/>
                <a:gd name="T61" fmla="*/ 239 h 775"/>
                <a:gd name="T62" fmla="*/ 0 w 830"/>
                <a:gd name="T63" fmla="*/ 393 h 775"/>
                <a:gd name="T64" fmla="*/ 26 w 830"/>
                <a:gd name="T65" fmla="*/ 541 h 77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Lst>
              <a:rect l="0" t="0" r="r" b="b"/>
              <a:pathLst>
                <a:path w="830" h="775">
                  <a:moveTo>
                    <a:pt x="148" y="190"/>
                  </a:moveTo>
                  <a:cubicBezTo>
                    <a:pt x="170" y="143"/>
                    <a:pt x="203" y="107"/>
                    <a:pt x="247" y="82"/>
                  </a:cubicBezTo>
                  <a:cubicBezTo>
                    <a:pt x="290" y="57"/>
                    <a:pt x="341" y="45"/>
                    <a:pt x="399" y="45"/>
                  </a:cubicBezTo>
                  <a:cubicBezTo>
                    <a:pt x="440" y="45"/>
                    <a:pt x="477" y="51"/>
                    <a:pt x="512" y="62"/>
                  </a:cubicBezTo>
                  <a:cubicBezTo>
                    <a:pt x="546" y="74"/>
                    <a:pt x="575" y="89"/>
                    <a:pt x="596" y="106"/>
                  </a:cubicBezTo>
                  <a:cubicBezTo>
                    <a:pt x="618" y="124"/>
                    <a:pt x="637" y="144"/>
                    <a:pt x="652" y="167"/>
                  </a:cubicBezTo>
                  <a:cubicBezTo>
                    <a:pt x="668" y="190"/>
                    <a:pt x="681" y="216"/>
                    <a:pt x="690" y="245"/>
                  </a:cubicBezTo>
                  <a:cubicBezTo>
                    <a:pt x="706" y="292"/>
                    <a:pt x="713" y="343"/>
                    <a:pt x="713" y="398"/>
                  </a:cubicBezTo>
                  <a:cubicBezTo>
                    <a:pt x="713" y="463"/>
                    <a:pt x="703" y="521"/>
                    <a:pt x="681" y="571"/>
                  </a:cubicBezTo>
                  <a:cubicBezTo>
                    <a:pt x="660" y="620"/>
                    <a:pt x="627" y="659"/>
                    <a:pt x="584" y="686"/>
                  </a:cubicBezTo>
                  <a:cubicBezTo>
                    <a:pt x="541" y="714"/>
                    <a:pt x="490" y="727"/>
                    <a:pt x="431" y="727"/>
                  </a:cubicBezTo>
                  <a:cubicBezTo>
                    <a:pt x="388" y="727"/>
                    <a:pt x="350" y="721"/>
                    <a:pt x="315" y="707"/>
                  </a:cubicBezTo>
                  <a:cubicBezTo>
                    <a:pt x="280" y="694"/>
                    <a:pt x="248" y="673"/>
                    <a:pt x="220" y="644"/>
                  </a:cubicBezTo>
                  <a:cubicBezTo>
                    <a:pt x="192" y="616"/>
                    <a:pt x="169" y="581"/>
                    <a:pt x="151" y="539"/>
                  </a:cubicBezTo>
                  <a:cubicBezTo>
                    <a:pt x="141" y="514"/>
                    <a:pt x="132" y="484"/>
                    <a:pt x="125" y="450"/>
                  </a:cubicBezTo>
                  <a:cubicBezTo>
                    <a:pt x="118" y="416"/>
                    <a:pt x="115" y="382"/>
                    <a:pt x="115" y="349"/>
                  </a:cubicBezTo>
                  <a:cubicBezTo>
                    <a:pt x="115" y="290"/>
                    <a:pt x="126" y="236"/>
                    <a:pt x="148" y="190"/>
                  </a:cubicBezTo>
                  <a:close/>
                  <a:moveTo>
                    <a:pt x="26" y="541"/>
                  </a:moveTo>
                  <a:cubicBezTo>
                    <a:pt x="44" y="591"/>
                    <a:pt x="70" y="634"/>
                    <a:pt x="105" y="669"/>
                  </a:cubicBezTo>
                  <a:cubicBezTo>
                    <a:pt x="139" y="704"/>
                    <a:pt x="181" y="730"/>
                    <a:pt x="231" y="748"/>
                  </a:cubicBezTo>
                  <a:cubicBezTo>
                    <a:pt x="281" y="765"/>
                    <a:pt x="335" y="775"/>
                    <a:pt x="392" y="775"/>
                  </a:cubicBezTo>
                  <a:cubicBezTo>
                    <a:pt x="518" y="775"/>
                    <a:pt x="623" y="736"/>
                    <a:pt x="706" y="657"/>
                  </a:cubicBezTo>
                  <a:cubicBezTo>
                    <a:pt x="788" y="579"/>
                    <a:pt x="830" y="481"/>
                    <a:pt x="830" y="364"/>
                  </a:cubicBezTo>
                  <a:cubicBezTo>
                    <a:pt x="830" y="327"/>
                    <a:pt x="826" y="293"/>
                    <a:pt x="817" y="261"/>
                  </a:cubicBezTo>
                  <a:cubicBezTo>
                    <a:pt x="809" y="228"/>
                    <a:pt x="798" y="200"/>
                    <a:pt x="784" y="177"/>
                  </a:cubicBezTo>
                  <a:cubicBezTo>
                    <a:pt x="766" y="145"/>
                    <a:pt x="741" y="116"/>
                    <a:pt x="709" y="89"/>
                  </a:cubicBezTo>
                  <a:cubicBezTo>
                    <a:pt x="678" y="62"/>
                    <a:pt x="637" y="41"/>
                    <a:pt x="588" y="25"/>
                  </a:cubicBezTo>
                  <a:cubicBezTo>
                    <a:pt x="538" y="8"/>
                    <a:pt x="484" y="0"/>
                    <a:pt x="423" y="0"/>
                  </a:cubicBezTo>
                  <a:cubicBezTo>
                    <a:pt x="358" y="0"/>
                    <a:pt x="300" y="10"/>
                    <a:pt x="249" y="29"/>
                  </a:cubicBezTo>
                  <a:cubicBezTo>
                    <a:pt x="198" y="48"/>
                    <a:pt x="152" y="76"/>
                    <a:pt x="112" y="113"/>
                  </a:cubicBezTo>
                  <a:cubicBezTo>
                    <a:pt x="72" y="151"/>
                    <a:pt x="43" y="193"/>
                    <a:pt x="26" y="239"/>
                  </a:cubicBezTo>
                  <a:cubicBezTo>
                    <a:pt x="8" y="286"/>
                    <a:pt x="0" y="337"/>
                    <a:pt x="0" y="393"/>
                  </a:cubicBezTo>
                  <a:cubicBezTo>
                    <a:pt x="0" y="441"/>
                    <a:pt x="9" y="491"/>
                    <a:pt x="26" y="541"/>
                  </a:cubicBezTo>
                  <a:close/>
                </a:path>
              </a:pathLst>
            </a:custGeom>
            <a:grp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spTree>
    <p:extLst>
      <p:ext uri="{BB962C8B-B14F-4D97-AF65-F5344CB8AC3E}">
        <p14:creationId xmlns:p14="http://schemas.microsoft.com/office/powerpoint/2010/main" val="3341888927"/>
      </p:ext>
    </p:extLst>
  </p:cSld>
  <p:clrMapOvr>
    <a:masterClrMapping/>
  </p:clrMapOvr>
  <p:timing>
    <p:tnLst>
      <p:par>
        <p:cTn id="1" dur="indefinite" restart="never" nodeType="tmRoot"/>
      </p:par>
    </p:tnLst>
  </p:timing>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image" Target="../media/image1.jpg"/><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15">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58368" y="0"/>
            <a:ext cx="7827264" cy="1371600"/>
          </a:xfrm>
          <a:prstGeom prst="rect">
            <a:avLst/>
          </a:prstGeom>
        </p:spPr>
        <p:txBody>
          <a:bodyPr vert="horz" lIns="0" tIns="45720" rIns="0" bIns="45720" rtlCol="0" anchor="b" anchorCtr="0">
            <a:noAutofit/>
          </a:bodyPr>
          <a:lstStyle/>
          <a:p>
            <a:r>
              <a:rPr lang="en-US" smtClean="0"/>
              <a:t>Click to edit Master title style</a:t>
            </a:r>
            <a:endParaRPr lang="en-US" dirty="0"/>
          </a:p>
        </p:txBody>
      </p:sp>
      <p:sp>
        <p:nvSpPr>
          <p:cNvPr id="3" name="Text Placeholder 2"/>
          <p:cNvSpPr>
            <a:spLocks noGrp="1"/>
          </p:cNvSpPr>
          <p:nvPr>
            <p:ph type="body" idx="1"/>
          </p:nvPr>
        </p:nvSpPr>
        <p:spPr>
          <a:xfrm>
            <a:off x="658368" y="1371600"/>
            <a:ext cx="7827264" cy="4800600"/>
          </a:xfrm>
          <a:prstGeom prst="rect">
            <a:avLst/>
          </a:prstGeom>
        </p:spPr>
        <p:txBody>
          <a:bodyPr vert="horz" lIns="0" tIns="228600" rIns="0" bIns="45720" rtlCol="0">
            <a:no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8485632" y="6528816"/>
            <a:ext cx="658368" cy="109728"/>
          </a:xfrm>
          <a:prstGeom prst="rect">
            <a:avLst/>
          </a:prstGeom>
        </p:spPr>
        <p:txBody>
          <a:bodyPr vert="horz" lIns="91440" tIns="0" rIns="91440" bIns="0" rtlCol="0" anchor="ctr"/>
          <a:lstStyle>
            <a:lvl1pPr algn="r">
              <a:defRPr sz="700">
                <a:solidFill>
                  <a:schemeClr val="bg2">
                    <a:lumMod val="60000"/>
                    <a:lumOff val="40000"/>
                  </a:schemeClr>
                </a:solidFill>
              </a:defRPr>
            </a:lvl1pPr>
          </a:lstStyle>
          <a:p>
            <a:fld id="{8B170F43-B478-4377-B9A4-9AFD59D1CBAC}" type="datetime1">
              <a:rPr lang="en-US" smtClean="0"/>
              <a:t>10/28/2020</a:t>
            </a:fld>
            <a:endParaRPr lang="en-US"/>
          </a:p>
        </p:txBody>
      </p:sp>
      <p:sp>
        <p:nvSpPr>
          <p:cNvPr id="5" name="Footer Placeholder 4"/>
          <p:cNvSpPr>
            <a:spLocks noGrp="1"/>
          </p:cNvSpPr>
          <p:nvPr>
            <p:ph type="ftr" sz="quarter" idx="3"/>
          </p:nvPr>
        </p:nvSpPr>
        <p:spPr>
          <a:xfrm>
            <a:off x="1984248" y="6172200"/>
            <a:ext cx="6510528" cy="457200"/>
          </a:xfrm>
          <a:prstGeom prst="rect">
            <a:avLst/>
          </a:prstGeom>
        </p:spPr>
        <p:txBody>
          <a:bodyPr vert="horz" lIns="0" tIns="45720" rIns="0" bIns="0" rtlCol="0" anchor="t" anchorCtr="0"/>
          <a:lstStyle>
            <a:lvl1pPr algn="r">
              <a:lnSpc>
                <a:spcPct val="90000"/>
              </a:lnSpc>
              <a:defRPr sz="1400">
                <a:solidFill>
                  <a:schemeClr val="bg2">
                    <a:lumMod val="40000"/>
                    <a:lumOff val="60000"/>
                  </a:schemeClr>
                </a:solidFill>
              </a:defRPr>
            </a:lvl1pPr>
          </a:lstStyle>
          <a:p>
            <a:endParaRPr lang="en-US" dirty="0"/>
          </a:p>
        </p:txBody>
      </p:sp>
      <p:sp>
        <p:nvSpPr>
          <p:cNvPr id="6" name="Slide Number Placeholder 5"/>
          <p:cNvSpPr>
            <a:spLocks noGrp="1"/>
          </p:cNvSpPr>
          <p:nvPr>
            <p:ph type="sldNum" sz="quarter" idx="4"/>
          </p:nvPr>
        </p:nvSpPr>
        <p:spPr>
          <a:xfrm>
            <a:off x="8485632" y="6931152"/>
            <a:ext cx="658368" cy="109728"/>
          </a:xfrm>
          <a:prstGeom prst="rect">
            <a:avLst/>
          </a:prstGeom>
        </p:spPr>
        <p:txBody>
          <a:bodyPr vert="horz" lIns="91440" tIns="45720" rIns="91440" bIns="45720" rtlCol="0" anchor="ctr"/>
          <a:lstStyle>
            <a:lvl1pPr algn="r">
              <a:defRPr sz="1200">
                <a:solidFill>
                  <a:schemeClr val="bg2">
                    <a:lumMod val="60000"/>
                    <a:lumOff val="40000"/>
                  </a:schemeClr>
                </a:solidFill>
              </a:defRPr>
            </a:lvl1pPr>
          </a:lstStyle>
          <a:p>
            <a:fld id="{CDC53FA5-AE81-45E0-8206-920AA27813B4}" type="slidenum">
              <a:rPr lang="en-US" smtClean="0"/>
              <a:t>‹#›</a:t>
            </a:fld>
            <a:endParaRPr lang="en-US"/>
          </a:p>
        </p:txBody>
      </p:sp>
      <p:sp>
        <p:nvSpPr>
          <p:cNvPr id="7" name="TextBox 6"/>
          <p:cNvSpPr txBox="1"/>
          <p:nvPr/>
        </p:nvSpPr>
        <p:spPr>
          <a:xfrm>
            <a:off x="7010400" y="6657945"/>
            <a:ext cx="2133600" cy="200055"/>
          </a:xfrm>
          <a:prstGeom prst="rect">
            <a:avLst/>
          </a:prstGeom>
        </p:spPr>
        <p:txBody>
          <a:bodyPr vert="horz" lIns="91440" tIns="45720" rIns="91440" bIns="45720" rtlCol="0" anchor="ctr">
            <a:noAutofit/>
          </a:bodyPr>
          <a:lstStyle>
            <a:defPPr>
              <a:defRPr lang="en-US"/>
            </a:defPPr>
            <a:lvl1pPr algn="r">
              <a:defRPr sz="1200">
                <a:solidFill>
                  <a:schemeClr val="tx1">
                    <a:tint val="75000"/>
                  </a:schemeClr>
                </a:solidFill>
              </a:defRPr>
            </a:lvl1pPr>
          </a:lstStyle>
          <a:p>
            <a:pPr lvl="0"/>
            <a:r>
              <a:rPr lang="en-US" sz="700" dirty="0" smtClean="0">
                <a:solidFill>
                  <a:schemeClr val="bg2">
                    <a:lumMod val="60000"/>
                    <a:lumOff val="40000"/>
                  </a:schemeClr>
                </a:solidFill>
              </a:rPr>
              <a:t>©2019 MFMER  |  slide-</a:t>
            </a:r>
            <a:fld id="{D445C29B-035B-48ED-941F-A66A11A8A322}" type="slidenum">
              <a:rPr lang="en-US" sz="700" smtClean="0">
                <a:solidFill>
                  <a:schemeClr val="bg2">
                    <a:lumMod val="60000"/>
                    <a:lumOff val="40000"/>
                  </a:schemeClr>
                </a:solidFill>
              </a:rPr>
              <a:pPr lvl="0"/>
              <a:t>‹#›</a:t>
            </a:fld>
            <a:endParaRPr lang="en-US" sz="700" dirty="0" smtClean="0">
              <a:solidFill>
                <a:schemeClr val="bg2">
                  <a:lumMod val="60000"/>
                  <a:lumOff val="40000"/>
                </a:schemeClr>
              </a:solidFill>
            </a:endParaRPr>
          </a:p>
        </p:txBody>
      </p:sp>
    </p:spTree>
    <p:extLst>
      <p:ext uri="{BB962C8B-B14F-4D97-AF65-F5344CB8AC3E}">
        <p14:creationId xmlns:p14="http://schemas.microsoft.com/office/powerpoint/2010/main" val="1279081648"/>
      </p:ext>
    </p:extLst>
  </p:cSld>
  <p:clrMap bg1="dk1" tx1="lt1" bg2="dk2" tx2="lt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timing>
    <p:tnLst>
      <p:par>
        <p:cTn id="1" dur="indefinite" restart="never" nodeType="tmRoot"/>
      </p:par>
    </p:tnLst>
  </p:timing>
  <p:hf sldNum="0" hdr="0" ftr="0" dt="0"/>
  <p:txStyles>
    <p:titleStyle>
      <a:lvl1pPr algn="l" defTabSz="914400" rtl="0" eaLnBrk="1" latinLnBrk="0" hangingPunct="1">
        <a:lnSpc>
          <a:spcPct val="90000"/>
        </a:lnSpc>
        <a:spcBef>
          <a:spcPct val="0"/>
        </a:spcBef>
        <a:buNone/>
        <a:defRPr sz="3200" kern="1200">
          <a:solidFill>
            <a:schemeClr val="tx2"/>
          </a:solidFill>
          <a:latin typeface="+mj-lt"/>
          <a:ea typeface="+mj-ea"/>
          <a:cs typeface="+mj-cs"/>
        </a:defRPr>
      </a:lvl1pPr>
    </p:titleStyle>
    <p:bodyStyle>
      <a:lvl1pPr marL="228600" indent="-228600" algn="l" defTabSz="914400" rtl="0" eaLnBrk="1" latinLnBrk="0" hangingPunct="1">
        <a:lnSpc>
          <a:spcPct val="90000"/>
        </a:lnSpc>
        <a:spcBef>
          <a:spcPts val="1500"/>
        </a:spcBef>
        <a:buClr>
          <a:schemeClr val="tx2"/>
        </a:buClr>
        <a:buFont typeface="Arial" pitchFamily="34" charset="0"/>
        <a:buChar char="•"/>
        <a:defRPr sz="2800" kern="1200">
          <a:solidFill>
            <a:schemeClr val="tx1"/>
          </a:solidFill>
          <a:latin typeface="+mn-lt"/>
          <a:ea typeface="+mn-ea"/>
          <a:cs typeface="+mn-cs"/>
        </a:defRPr>
      </a:lvl1pPr>
      <a:lvl2pPr marL="692150" indent="-234950" algn="l" defTabSz="914400" rtl="0" eaLnBrk="1" latinLnBrk="0" hangingPunct="1">
        <a:lnSpc>
          <a:spcPct val="90000"/>
        </a:lnSpc>
        <a:spcBef>
          <a:spcPts val="600"/>
        </a:spcBef>
        <a:buClr>
          <a:schemeClr val="bg2">
            <a:lumMod val="40000"/>
            <a:lumOff val="60000"/>
          </a:schemeClr>
        </a:buClr>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lnSpc>
          <a:spcPct val="90000"/>
        </a:lnSpc>
        <a:spcBef>
          <a:spcPts val="600"/>
        </a:spcBef>
        <a:buClr>
          <a:schemeClr val="bg2">
            <a:lumMod val="40000"/>
            <a:lumOff val="60000"/>
          </a:schemeClr>
        </a:buClr>
        <a:buFont typeface="Arial" pitchFamily="34" charset="0"/>
        <a:buChar char="•"/>
        <a:defRPr sz="2800" kern="1200">
          <a:solidFill>
            <a:schemeClr val="tx1"/>
          </a:solidFill>
          <a:latin typeface="+mn-lt"/>
          <a:ea typeface="+mn-ea"/>
          <a:cs typeface="+mn-cs"/>
        </a:defRPr>
      </a:lvl3pPr>
      <a:lvl4pPr marL="1600200" indent="-228600" algn="l" defTabSz="914400" rtl="0" eaLnBrk="1" latinLnBrk="0" hangingPunct="1">
        <a:lnSpc>
          <a:spcPct val="90000"/>
        </a:lnSpc>
        <a:spcBef>
          <a:spcPts val="600"/>
        </a:spcBef>
        <a:buClr>
          <a:schemeClr val="bg2">
            <a:lumMod val="40000"/>
            <a:lumOff val="60000"/>
          </a:schemeClr>
        </a:buClr>
        <a:buFont typeface="Arial" pitchFamily="34" charset="0"/>
        <a:buChar char="•"/>
        <a:defRPr sz="2800" kern="1200">
          <a:solidFill>
            <a:schemeClr val="tx1"/>
          </a:solidFill>
          <a:latin typeface="+mn-lt"/>
          <a:ea typeface="+mn-ea"/>
          <a:cs typeface="+mn-cs"/>
        </a:defRPr>
      </a:lvl4pPr>
      <a:lvl5pPr marL="2057400" indent="-228600" algn="l" defTabSz="914400" rtl="0" eaLnBrk="1" latinLnBrk="0" hangingPunct="1">
        <a:lnSpc>
          <a:spcPct val="90000"/>
        </a:lnSpc>
        <a:spcBef>
          <a:spcPts val="600"/>
        </a:spcBef>
        <a:buClr>
          <a:schemeClr val="bg2">
            <a:lumMod val="40000"/>
            <a:lumOff val="60000"/>
          </a:schemeClr>
        </a:buClr>
        <a:buFont typeface="Arial" pitchFamily="34" charset="0"/>
        <a:buChar char="•"/>
        <a:defRPr sz="28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4.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11.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4.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0.xml"/><Relationship Id="rId1" Type="http://schemas.openxmlformats.org/officeDocument/2006/relationships/slideLayout" Target="../slideLayouts/slideLayout8.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1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11.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4.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4.xml"/><Relationship Id="rId1" Type="http://schemas.openxmlformats.org/officeDocument/2006/relationships/slideLayout" Target="../slideLayouts/slideLayout4.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1" Type="http://schemas.openxmlformats.org/officeDocument/2006/relationships/slideLayout" Target="../slideLayouts/slideLayout11.xml"/></Relationships>
</file>

<file path=ppt/slides/_rels/slide5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Training the Trainer</a:t>
            </a:r>
          </a:p>
        </p:txBody>
      </p:sp>
      <p:sp>
        <p:nvSpPr>
          <p:cNvPr id="3" name="Subtitle 2"/>
          <p:cNvSpPr>
            <a:spLocks noGrp="1"/>
          </p:cNvSpPr>
          <p:nvPr>
            <p:ph type="subTitle" idx="1"/>
          </p:nvPr>
        </p:nvSpPr>
        <p:spPr/>
        <p:txBody>
          <a:bodyPr/>
          <a:lstStyle/>
          <a:p>
            <a:r>
              <a:rPr lang="en-US" dirty="0" smtClean="0"/>
              <a:t>Leverage </a:t>
            </a:r>
            <a:r>
              <a:rPr lang="en-US" dirty="0"/>
              <a:t>Learning Theory </a:t>
            </a:r>
            <a:r>
              <a:rPr lang="en-US" dirty="0" smtClean="0"/>
              <a:t>to </a:t>
            </a:r>
            <a:r>
              <a:rPr lang="en-US" dirty="0"/>
              <a:t>Become a Better Trainer</a:t>
            </a:r>
            <a:endParaRPr lang="en-US" dirty="0" smtClean="0"/>
          </a:p>
        </p:txBody>
      </p:sp>
    </p:spTree>
    <p:extLst>
      <p:ext uri="{BB962C8B-B14F-4D97-AF65-F5344CB8AC3E}">
        <p14:creationId xmlns:p14="http://schemas.microsoft.com/office/powerpoint/2010/main" val="628648858"/>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smtClean="0"/>
              <a:t>Part </a:t>
            </a:r>
            <a:r>
              <a:rPr lang="en-US" dirty="0"/>
              <a:t>1</a:t>
            </a:r>
            <a:r>
              <a:rPr lang="en-US" dirty="0" smtClean="0"/>
              <a:t/>
            </a:r>
            <a:br>
              <a:rPr lang="en-US" dirty="0" smtClean="0"/>
            </a:br>
            <a:r>
              <a:rPr lang="en-US" dirty="0" smtClean="0"/>
              <a:t>Questions/Discussion</a:t>
            </a:r>
            <a:endParaRPr lang="en-US" dirty="0">
              <a:solidFill>
                <a:schemeClr val="tx1"/>
              </a:solidFill>
            </a:endParaRPr>
          </a:p>
        </p:txBody>
      </p:sp>
    </p:spTree>
    <p:extLst>
      <p:ext uri="{BB962C8B-B14F-4D97-AF65-F5344CB8AC3E}">
        <p14:creationId xmlns:p14="http://schemas.microsoft.com/office/powerpoint/2010/main" val="920405101"/>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smtClean="0"/>
              <a:t>Part 2: General Principles of Effective Teaching</a:t>
            </a:r>
            <a:endParaRPr lang="en-US" dirty="0"/>
          </a:p>
        </p:txBody>
      </p:sp>
      <p:sp>
        <p:nvSpPr>
          <p:cNvPr id="5" name="Text Placeholder 4"/>
          <p:cNvSpPr>
            <a:spLocks noGrp="1"/>
          </p:cNvSpPr>
          <p:nvPr>
            <p:ph type="body" idx="1"/>
          </p:nvPr>
        </p:nvSpPr>
        <p:spPr/>
        <p:txBody>
          <a:bodyPr/>
          <a:lstStyle/>
          <a:p>
            <a:r>
              <a:rPr lang="en-US" dirty="0" smtClean="0"/>
              <a:t>An Overview</a:t>
            </a:r>
            <a:endParaRPr lang="en-US" dirty="0"/>
          </a:p>
        </p:txBody>
      </p:sp>
    </p:spTree>
    <p:extLst>
      <p:ext uri="{BB962C8B-B14F-4D97-AF65-F5344CB8AC3E}">
        <p14:creationId xmlns:p14="http://schemas.microsoft.com/office/powerpoint/2010/main" val="1223030989"/>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General Principles</a:t>
            </a:r>
            <a:endParaRPr lang="en-US" dirty="0"/>
          </a:p>
        </p:txBody>
      </p:sp>
      <p:sp>
        <p:nvSpPr>
          <p:cNvPr id="3" name="Content Placeholder 2"/>
          <p:cNvSpPr>
            <a:spLocks noGrp="1"/>
          </p:cNvSpPr>
          <p:nvPr>
            <p:ph idx="1"/>
          </p:nvPr>
        </p:nvSpPr>
        <p:spPr/>
        <p:txBody>
          <a:bodyPr/>
          <a:lstStyle/>
          <a:p>
            <a:r>
              <a:rPr lang="en-US" dirty="0" smtClean="0"/>
              <a:t>Allow sufficient time</a:t>
            </a:r>
          </a:p>
          <a:p>
            <a:r>
              <a:rPr lang="en-US" dirty="0" smtClean="0"/>
              <a:t>Let them figure it out</a:t>
            </a:r>
          </a:p>
          <a:p>
            <a:r>
              <a:rPr lang="en-US" dirty="0" smtClean="0"/>
              <a:t>Encourage autonomy</a:t>
            </a:r>
          </a:p>
          <a:p>
            <a:endParaRPr lang="en-US" dirty="0"/>
          </a:p>
        </p:txBody>
      </p:sp>
    </p:spTree>
    <p:extLst>
      <p:ext uri="{BB962C8B-B14F-4D97-AF65-F5344CB8AC3E}">
        <p14:creationId xmlns:p14="http://schemas.microsoft.com/office/powerpoint/2010/main" val="439720699"/>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General Principles</a:t>
            </a:r>
            <a:endParaRPr lang="en-US" dirty="0"/>
          </a:p>
        </p:txBody>
      </p:sp>
      <p:sp>
        <p:nvSpPr>
          <p:cNvPr id="3" name="Content Placeholder 2"/>
          <p:cNvSpPr>
            <a:spLocks noGrp="1"/>
          </p:cNvSpPr>
          <p:nvPr>
            <p:ph idx="1"/>
          </p:nvPr>
        </p:nvSpPr>
        <p:spPr/>
        <p:txBody>
          <a:bodyPr/>
          <a:lstStyle/>
          <a:p>
            <a:r>
              <a:rPr lang="en-US" dirty="0" smtClean="0"/>
              <a:t>Allow sufficient time</a:t>
            </a:r>
          </a:p>
          <a:p>
            <a:r>
              <a:rPr lang="en-US" dirty="0" smtClean="0">
                <a:solidFill>
                  <a:schemeClr val="tx1">
                    <a:lumMod val="50000"/>
                  </a:schemeClr>
                </a:solidFill>
              </a:rPr>
              <a:t>Let them figure it out</a:t>
            </a:r>
          </a:p>
          <a:p>
            <a:r>
              <a:rPr lang="en-US" dirty="0" smtClean="0">
                <a:solidFill>
                  <a:schemeClr val="tx1">
                    <a:lumMod val="50000"/>
                  </a:schemeClr>
                </a:solidFill>
              </a:rPr>
              <a:t>Encourage autonomy</a:t>
            </a:r>
          </a:p>
          <a:p>
            <a:endParaRPr lang="en-US" dirty="0"/>
          </a:p>
        </p:txBody>
      </p:sp>
      <p:pic>
        <p:nvPicPr>
          <p:cNvPr id="5" name="Picture 4"/>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752600" y="3352800"/>
            <a:ext cx="5410200" cy="332697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141227868"/>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General Principles</a:t>
            </a:r>
            <a:endParaRPr lang="en-US" dirty="0"/>
          </a:p>
        </p:txBody>
      </p:sp>
      <p:sp>
        <p:nvSpPr>
          <p:cNvPr id="3" name="Content Placeholder 2"/>
          <p:cNvSpPr>
            <a:spLocks noGrp="1"/>
          </p:cNvSpPr>
          <p:nvPr>
            <p:ph idx="1"/>
          </p:nvPr>
        </p:nvSpPr>
        <p:spPr/>
        <p:txBody>
          <a:bodyPr/>
          <a:lstStyle/>
          <a:p>
            <a:r>
              <a:rPr lang="en-US" smtClean="0">
                <a:solidFill>
                  <a:schemeClr val="tx1">
                    <a:lumMod val="50000"/>
                  </a:schemeClr>
                </a:solidFill>
              </a:rPr>
              <a:t>Allow </a:t>
            </a:r>
            <a:r>
              <a:rPr lang="en-US" dirty="0" smtClean="0">
                <a:solidFill>
                  <a:schemeClr val="tx1">
                    <a:lumMod val="50000"/>
                  </a:schemeClr>
                </a:solidFill>
              </a:rPr>
              <a:t>sufficient time</a:t>
            </a:r>
          </a:p>
          <a:p>
            <a:r>
              <a:rPr lang="en-US" dirty="0" smtClean="0"/>
              <a:t>Let them figure it out</a:t>
            </a:r>
          </a:p>
          <a:p>
            <a:r>
              <a:rPr lang="en-US" dirty="0" smtClean="0">
                <a:solidFill>
                  <a:schemeClr val="tx1">
                    <a:lumMod val="50000"/>
                  </a:schemeClr>
                </a:solidFill>
              </a:rPr>
              <a:t>Encourage autonomy</a:t>
            </a:r>
          </a:p>
          <a:p>
            <a:endParaRPr lang="en-US" dirty="0"/>
          </a:p>
        </p:txBody>
      </p:sp>
      <p:pic>
        <p:nvPicPr>
          <p:cNvPr id="4098"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209800" y="3352800"/>
            <a:ext cx="4724400" cy="328560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141227868"/>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General Principles</a:t>
            </a:r>
            <a:endParaRPr lang="en-US" dirty="0"/>
          </a:p>
        </p:txBody>
      </p:sp>
      <p:sp>
        <p:nvSpPr>
          <p:cNvPr id="3" name="Content Placeholder 2"/>
          <p:cNvSpPr>
            <a:spLocks noGrp="1"/>
          </p:cNvSpPr>
          <p:nvPr>
            <p:ph idx="1"/>
          </p:nvPr>
        </p:nvSpPr>
        <p:spPr/>
        <p:txBody>
          <a:bodyPr/>
          <a:lstStyle/>
          <a:p>
            <a:r>
              <a:rPr lang="en-US" dirty="0" smtClean="0">
                <a:solidFill>
                  <a:schemeClr val="tx1">
                    <a:lumMod val="50000"/>
                  </a:schemeClr>
                </a:solidFill>
              </a:rPr>
              <a:t>Allow sufficient time</a:t>
            </a:r>
          </a:p>
          <a:p>
            <a:r>
              <a:rPr lang="en-US" dirty="0" smtClean="0">
                <a:solidFill>
                  <a:schemeClr val="tx1">
                    <a:lumMod val="50000"/>
                  </a:schemeClr>
                </a:solidFill>
              </a:rPr>
              <a:t>Let them figure it out</a:t>
            </a:r>
          </a:p>
          <a:p>
            <a:r>
              <a:rPr lang="en-US" dirty="0" smtClean="0"/>
              <a:t>Encourage autonomy</a:t>
            </a:r>
          </a:p>
          <a:p>
            <a:endParaRPr lang="en-US" dirty="0"/>
          </a:p>
        </p:txBody>
      </p:sp>
    </p:spTree>
    <p:extLst>
      <p:ext uri="{BB962C8B-B14F-4D97-AF65-F5344CB8AC3E}">
        <p14:creationId xmlns:p14="http://schemas.microsoft.com/office/powerpoint/2010/main" val="2141227868"/>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elf-determination theory</a:t>
            </a:r>
            <a:endParaRPr lang="en-US" dirty="0"/>
          </a:p>
        </p:txBody>
      </p:sp>
      <p:sp>
        <p:nvSpPr>
          <p:cNvPr id="3" name="Content Placeholder 2"/>
          <p:cNvSpPr>
            <a:spLocks noGrp="1"/>
          </p:cNvSpPr>
          <p:nvPr>
            <p:ph idx="1"/>
          </p:nvPr>
        </p:nvSpPr>
        <p:spPr/>
        <p:txBody>
          <a:bodyPr/>
          <a:lstStyle/>
          <a:p>
            <a:r>
              <a:rPr lang="en-US" dirty="0" smtClean="0"/>
              <a:t>Relatedness</a:t>
            </a:r>
          </a:p>
          <a:p>
            <a:r>
              <a:rPr lang="en-US" dirty="0" smtClean="0"/>
              <a:t>Competence</a:t>
            </a:r>
          </a:p>
          <a:p>
            <a:r>
              <a:rPr lang="en-US" dirty="0" smtClean="0"/>
              <a:t>Autonomy</a:t>
            </a:r>
            <a:endParaRPr lang="en-US" dirty="0"/>
          </a:p>
        </p:txBody>
      </p:sp>
      <p:pic>
        <p:nvPicPr>
          <p:cNvPr id="5122"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467100" y="1905000"/>
            <a:ext cx="5143500" cy="3429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3476409237"/>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Part 2 Summary</a:t>
            </a:r>
            <a:endParaRPr lang="en-US" dirty="0"/>
          </a:p>
        </p:txBody>
      </p:sp>
      <p:sp>
        <p:nvSpPr>
          <p:cNvPr id="3" name="Content Placeholder 2"/>
          <p:cNvSpPr>
            <a:spLocks noGrp="1"/>
          </p:cNvSpPr>
          <p:nvPr>
            <p:ph idx="1"/>
          </p:nvPr>
        </p:nvSpPr>
        <p:spPr/>
        <p:txBody>
          <a:bodyPr/>
          <a:lstStyle/>
          <a:p>
            <a:r>
              <a:rPr lang="en-US" dirty="0" smtClean="0"/>
              <a:t>Allow sufficient time</a:t>
            </a:r>
            <a:endParaRPr lang="en-US" dirty="0"/>
          </a:p>
          <a:p>
            <a:r>
              <a:rPr lang="en-US" dirty="0" smtClean="0"/>
              <a:t>Let them figure it out</a:t>
            </a:r>
            <a:endParaRPr lang="en-US" dirty="0"/>
          </a:p>
          <a:p>
            <a:r>
              <a:rPr lang="en-US" dirty="0"/>
              <a:t>Encourage </a:t>
            </a:r>
            <a:r>
              <a:rPr lang="en-US" dirty="0" smtClean="0"/>
              <a:t>autonomy</a:t>
            </a:r>
            <a:endParaRPr lang="en-US" dirty="0"/>
          </a:p>
        </p:txBody>
      </p:sp>
    </p:spTree>
    <p:extLst>
      <p:ext uri="{BB962C8B-B14F-4D97-AF65-F5344CB8AC3E}">
        <p14:creationId xmlns:p14="http://schemas.microsoft.com/office/powerpoint/2010/main" val="2782637322"/>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smtClean="0"/>
              <a:t>Part 2</a:t>
            </a:r>
            <a:br>
              <a:rPr lang="en-US" dirty="0" smtClean="0"/>
            </a:br>
            <a:r>
              <a:rPr lang="en-US" dirty="0" smtClean="0"/>
              <a:t>Questions/Discussion</a:t>
            </a:r>
            <a:endParaRPr lang="en-US" dirty="0">
              <a:solidFill>
                <a:schemeClr val="tx1"/>
              </a:solidFill>
            </a:endParaRPr>
          </a:p>
        </p:txBody>
      </p:sp>
    </p:spTree>
    <p:extLst>
      <p:ext uri="{BB962C8B-B14F-4D97-AF65-F5344CB8AC3E}">
        <p14:creationId xmlns:p14="http://schemas.microsoft.com/office/powerpoint/2010/main" val="2630788419"/>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smtClean="0"/>
              <a:t>Part 3: A Standardized Framework for Evaluating the Quality of Teaching</a:t>
            </a:r>
            <a:endParaRPr lang="en-US" dirty="0"/>
          </a:p>
        </p:txBody>
      </p:sp>
      <p:sp>
        <p:nvSpPr>
          <p:cNvPr id="5" name="Text Placeholder 4"/>
          <p:cNvSpPr>
            <a:spLocks noGrp="1"/>
          </p:cNvSpPr>
          <p:nvPr>
            <p:ph type="body" idx="1"/>
          </p:nvPr>
        </p:nvSpPr>
        <p:spPr/>
        <p:txBody>
          <a:bodyPr/>
          <a:lstStyle/>
          <a:p>
            <a:r>
              <a:rPr lang="en-US" dirty="0" smtClean="0"/>
              <a:t>Self-reflection</a:t>
            </a:r>
            <a:endParaRPr lang="en-US" dirty="0"/>
          </a:p>
        </p:txBody>
      </p:sp>
    </p:spTree>
    <p:extLst>
      <p:ext uri="{BB962C8B-B14F-4D97-AF65-F5344CB8AC3E}">
        <p14:creationId xmlns:p14="http://schemas.microsoft.com/office/powerpoint/2010/main" val="349295823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Goal</a:t>
            </a:r>
            <a:endParaRPr lang="en-US" dirty="0"/>
          </a:p>
        </p:txBody>
      </p:sp>
      <p:sp>
        <p:nvSpPr>
          <p:cNvPr id="3" name="Content Placeholder 2"/>
          <p:cNvSpPr>
            <a:spLocks noGrp="1"/>
          </p:cNvSpPr>
          <p:nvPr>
            <p:ph idx="1"/>
          </p:nvPr>
        </p:nvSpPr>
        <p:spPr/>
        <p:txBody>
          <a:bodyPr/>
          <a:lstStyle/>
          <a:p>
            <a:pPr lvl="0"/>
            <a:r>
              <a:rPr lang="en-US" dirty="0" smtClean="0"/>
              <a:t>To equip you with </a:t>
            </a:r>
            <a:r>
              <a:rPr lang="en-US" dirty="0"/>
              <a:t>the knowledge and skills to be an </a:t>
            </a:r>
            <a:r>
              <a:rPr lang="en-US" dirty="0" smtClean="0"/>
              <a:t>effective trainer.</a:t>
            </a:r>
            <a:endParaRPr lang="en-US" dirty="0"/>
          </a:p>
        </p:txBody>
      </p:sp>
    </p:spTree>
    <p:extLst>
      <p:ext uri="{BB962C8B-B14F-4D97-AF65-F5344CB8AC3E}">
        <p14:creationId xmlns:p14="http://schemas.microsoft.com/office/powerpoint/2010/main" val="2250883321"/>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146"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01700" y="1206500"/>
            <a:ext cx="7339013" cy="4445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3205513583"/>
      </p:ext>
    </p:extLst>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tandardized Framework</a:t>
            </a:r>
            <a:endParaRPr lang="en-US" dirty="0"/>
          </a:p>
        </p:txBody>
      </p:sp>
      <p:sp>
        <p:nvSpPr>
          <p:cNvPr id="3" name="Content Placeholder 2"/>
          <p:cNvSpPr>
            <a:spLocks noGrp="1"/>
          </p:cNvSpPr>
          <p:nvPr>
            <p:ph idx="1"/>
          </p:nvPr>
        </p:nvSpPr>
        <p:spPr/>
        <p:txBody>
          <a:bodyPr/>
          <a:lstStyle/>
          <a:p>
            <a:r>
              <a:rPr lang="en-US" dirty="0" smtClean="0"/>
              <a:t>Foster a </a:t>
            </a:r>
            <a:r>
              <a:rPr lang="en-US" dirty="0"/>
              <a:t>learning climate</a:t>
            </a:r>
          </a:p>
          <a:p>
            <a:r>
              <a:rPr lang="en-US" dirty="0"/>
              <a:t>Set clear goals</a:t>
            </a:r>
          </a:p>
          <a:p>
            <a:r>
              <a:rPr lang="en-US" dirty="0"/>
              <a:t>Promote understanding</a:t>
            </a:r>
          </a:p>
          <a:p>
            <a:r>
              <a:rPr lang="en-US" dirty="0"/>
              <a:t>Ask quality questions</a:t>
            </a:r>
          </a:p>
          <a:p>
            <a:r>
              <a:rPr lang="en-US" dirty="0"/>
              <a:t>Seek out feedback</a:t>
            </a:r>
          </a:p>
        </p:txBody>
      </p:sp>
    </p:spTree>
    <p:extLst>
      <p:ext uri="{BB962C8B-B14F-4D97-AF65-F5344CB8AC3E}">
        <p14:creationId xmlns:p14="http://schemas.microsoft.com/office/powerpoint/2010/main" val="173879919"/>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tandardized Framework</a:t>
            </a:r>
            <a:endParaRPr lang="en-US" dirty="0"/>
          </a:p>
        </p:txBody>
      </p:sp>
      <p:sp>
        <p:nvSpPr>
          <p:cNvPr id="3" name="Content Placeholder 2"/>
          <p:cNvSpPr>
            <a:spLocks noGrp="1"/>
          </p:cNvSpPr>
          <p:nvPr>
            <p:ph idx="1"/>
          </p:nvPr>
        </p:nvSpPr>
        <p:spPr/>
        <p:txBody>
          <a:bodyPr/>
          <a:lstStyle/>
          <a:p>
            <a:r>
              <a:rPr lang="en-US" dirty="0" smtClean="0"/>
              <a:t>Foster </a:t>
            </a:r>
            <a:r>
              <a:rPr lang="en-US" dirty="0"/>
              <a:t>a learning climate</a:t>
            </a:r>
          </a:p>
          <a:p>
            <a:r>
              <a:rPr lang="en-US" dirty="0">
                <a:solidFill>
                  <a:schemeClr val="tx1">
                    <a:lumMod val="50000"/>
                  </a:schemeClr>
                </a:solidFill>
              </a:rPr>
              <a:t>Set clear goals</a:t>
            </a:r>
          </a:p>
          <a:p>
            <a:r>
              <a:rPr lang="en-US" dirty="0">
                <a:solidFill>
                  <a:schemeClr val="tx1">
                    <a:lumMod val="50000"/>
                  </a:schemeClr>
                </a:solidFill>
              </a:rPr>
              <a:t>Promote understanding</a:t>
            </a:r>
          </a:p>
          <a:p>
            <a:r>
              <a:rPr lang="en-US" dirty="0">
                <a:solidFill>
                  <a:schemeClr val="tx1">
                    <a:lumMod val="50000"/>
                  </a:schemeClr>
                </a:solidFill>
              </a:rPr>
              <a:t>Ask quality questions</a:t>
            </a:r>
          </a:p>
          <a:p>
            <a:r>
              <a:rPr lang="en-US" dirty="0">
                <a:solidFill>
                  <a:schemeClr val="tx1">
                    <a:lumMod val="50000"/>
                  </a:schemeClr>
                </a:solidFill>
              </a:rPr>
              <a:t>Seek out feedback</a:t>
            </a:r>
          </a:p>
        </p:txBody>
      </p:sp>
      <p:pic>
        <p:nvPicPr>
          <p:cNvPr id="7171"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752309" y="2209800"/>
            <a:ext cx="4010691" cy="25908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171752720"/>
      </p:ext>
    </p:extLst>
  </p:cSld>
  <p:clrMapOvr>
    <a:masterClrMapping/>
  </p:clrMapOvr>
  <p:timing>
    <p:tnLst>
      <p:par>
        <p:cT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tandardized Framework</a:t>
            </a:r>
            <a:endParaRPr lang="en-US" dirty="0"/>
          </a:p>
        </p:txBody>
      </p:sp>
      <p:sp>
        <p:nvSpPr>
          <p:cNvPr id="3" name="Content Placeholder 2"/>
          <p:cNvSpPr>
            <a:spLocks noGrp="1"/>
          </p:cNvSpPr>
          <p:nvPr>
            <p:ph idx="1"/>
          </p:nvPr>
        </p:nvSpPr>
        <p:spPr/>
        <p:txBody>
          <a:bodyPr/>
          <a:lstStyle/>
          <a:p>
            <a:r>
              <a:rPr lang="en-US" dirty="0" smtClean="0">
                <a:solidFill>
                  <a:schemeClr val="tx1">
                    <a:lumMod val="50000"/>
                  </a:schemeClr>
                </a:solidFill>
              </a:rPr>
              <a:t>Foster a </a:t>
            </a:r>
            <a:r>
              <a:rPr lang="en-US" dirty="0">
                <a:solidFill>
                  <a:schemeClr val="tx1">
                    <a:lumMod val="50000"/>
                  </a:schemeClr>
                </a:solidFill>
              </a:rPr>
              <a:t>learning climate</a:t>
            </a:r>
          </a:p>
          <a:p>
            <a:r>
              <a:rPr lang="en-US" dirty="0"/>
              <a:t>Set clear goals</a:t>
            </a:r>
          </a:p>
          <a:p>
            <a:r>
              <a:rPr lang="en-US" dirty="0">
                <a:solidFill>
                  <a:schemeClr val="tx1">
                    <a:lumMod val="50000"/>
                  </a:schemeClr>
                </a:solidFill>
              </a:rPr>
              <a:t>Promote understanding</a:t>
            </a:r>
          </a:p>
          <a:p>
            <a:r>
              <a:rPr lang="en-US" dirty="0">
                <a:solidFill>
                  <a:schemeClr val="tx1">
                    <a:lumMod val="50000"/>
                  </a:schemeClr>
                </a:solidFill>
              </a:rPr>
              <a:t>Ask quality questions</a:t>
            </a:r>
          </a:p>
          <a:p>
            <a:r>
              <a:rPr lang="en-US" dirty="0">
                <a:solidFill>
                  <a:schemeClr val="tx1">
                    <a:lumMod val="50000"/>
                  </a:schemeClr>
                </a:solidFill>
              </a:rPr>
              <a:t>Seek out feedback</a:t>
            </a:r>
          </a:p>
        </p:txBody>
      </p:sp>
      <p:pic>
        <p:nvPicPr>
          <p:cNvPr id="8194"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800600" y="2514600"/>
            <a:ext cx="4057987" cy="2286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171752720"/>
      </p:ext>
    </p:extLst>
  </p:cSld>
  <p:clrMapOvr>
    <a:masterClrMapping/>
  </p:clrMapOvr>
  <p:timing>
    <p:tnLst>
      <p:par>
        <p:cT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tandardized Framework</a:t>
            </a:r>
            <a:endParaRPr lang="en-US" dirty="0"/>
          </a:p>
        </p:txBody>
      </p:sp>
      <p:sp>
        <p:nvSpPr>
          <p:cNvPr id="3" name="Content Placeholder 2"/>
          <p:cNvSpPr>
            <a:spLocks noGrp="1"/>
          </p:cNvSpPr>
          <p:nvPr>
            <p:ph idx="1"/>
          </p:nvPr>
        </p:nvSpPr>
        <p:spPr/>
        <p:txBody>
          <a:bodyPr/>
          <a:lstStyle/>
          <a:p>
            <a:r>
              <a:rPr lang="en-US" dirty="0" smtClean="0">
                <a:solidFill>
                  <a:schemeClr val="tx1">
                    <a:lumMod val="50000"/>
                  </a:schemeClr>
                </a:solidFill>
              </a:rPr>
              <a:t>Foster a </a:t>
            </a:r>
            <a:r>
              <a:rPr lang="en-US" dirty="0">
                <a:solidFill>
                  <a:schemeClr val="tx1">
                    <a:lumMod val="50000"/>
                  </a:schemeClr>
                </a:solidFill>
              </a:rPr>
              <a:t>learning climate</a:t>
            </a:r>
          </a:p>
          <a:p>
            <a:r>
              <a:rPr lang="en-US" dirty="0">
                <a:solidFill>
                  <a:schemeClr val="tx1">
                    <a:lumMod val="50000"/>
                  </a:schemeClr>
                </a:solidFill>
              </a:rPr>
              <a:t>Set clear goals</a:t>
            </a:r>
          </a:p>
          <a:p>
            <a:r>
              <a:rPr lang="en-US" dirty="0"/>
              <a:t>Promote understanding</a:t>
            </a:r>
          </a:p>
          <a:p>
            <a:r>
              <a:rPr lang="en-US" dirty="0">
                <a:solidFill>
                  <a:schemeClr val="tx1">
                    <a:lumMod val="50000"/>
                  </a:schemeClr>
                </a:solidFill>
              </a:rPr>
              <a:t>Ask quality questions</a:t>
            </a:r>
          </a:p>
          <a:p>
            <a:r>
              <a:rPr lang="en-US" dirty="0">
                <a:solidFill>
                  <a:schemeClr val="tx1">
                    <a:lumMod val="50000"/>
                  </a:schemeClr>
                </a:solidFill>
              </a:rPr>
              <a:t>Seek out feedback</a:t>
            </a:r>
          </a:p>
        </p:txBody>
      </p:sp>
      <p:pic>
        <p:nvPicPr>
          <p:cNvPr id="6" name="Picture 4"/>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724400" y="2264528"/>
            <a:ext cx="4124059" cy="253607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171752720"/>
      </p:ext>
    </p:extLst>
  </p:cSld>
  <p:clrMapOvr>
    <a:masterClrMapping/>
  </p:clrMapOvr>
  <p:timing>
    <p:tnLst>
      <p:par>
        <p:cT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tandardized Framework</a:t>
            </a:r>
            <a:endParaRPr lang="en-US" dirty="0"/>
          </a:p>
        </p:txBody>
      </p:sp>
      <p:sp>
        <p:nvSpPr>
          <p:cNvPr id="3" name="Content Placeholder 2"/>
          <p:cNvSpPr>
            <a:spLocks noGrp="1"/>
          </p:cNvSpPr>
          <p:nvPr>
            <p:ph idx="1"/>
          </p:nvPr>
        </p:nvSpPr>
        <p:spPr/>
        <p:txBody>
          <a:bodyPr/>
          <a:lstStyle/>
          <a:p>
            <a:r>
              <a:rPr lang="en-US" dirty="0" smtClean="0">
                <a:solidFill>
                  <a:schemeClr val="tx1">
                    <a:lumMod val="50000"/>
                  </a:schemeClr>
                </a:solidFill>
              </a:rPr>
              <a:t>Foster a </a:t>
            </a:r>
            <a:r>
              <a:rPr lang="en-US" dirty="0">
                <a:solidFill>
                  <a:schemeClr val="tx1">
                    <a:lumMod val="50000"/>
                  </a:schemeClr>
                </a:solidFill>
              </a:rPr>
              <a:t>learning climate</a:t>
            </a:r>
          </a:p>
          <a:p>
            <a:r>
              <a:rPr lang="en-US" dirty="0">
                <a:solidFill>
                  <a:schemeClr val="tx1">
                    <a:lumMod val="50000"/>
                  </a:schemeClr>
                </a:solidFill>
              </a:rPr>
              <a:t>Set clear goals</a:t>
            </a:r>
          </a:p>
          <a:p>
            <a:r>
              <a:rPr lang="en-US" dirty="0">
                <a:solidFill>
                  <a:schemeClr val="tx1">
                    <a:lumMod val="50000"/>
                  </a:schemeClr>
                </a:solidFill>
              </a:rPr>
              <a:t>Promote understanding</a:t>
            </a:r>
          </a:p>
          <a:p>
            <a:r>
              <a:rPr lang="en-US" dirty="0"/>
              <a:t>Ask quality questions</a:t>
            </a:r>
          </a:p>
          <a:p>
            <a:r>
              <a:rPr lang="en-US" dirty="0">
                <a:solidFill>
                  <a:schemeClr val="tx1">
                    <a:lumMod val="50000"/>
                  </a:schemeClr>
                </a:solidFill>
              </a:rPr>
              <a:t>Seek out feedback</a:t>
            </a:r>
          </a:p>
        </p:txBody>
      </p:sp>
      <p:pic>
        <p:nvPicPr>
          <p:cNvPr id="4"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724400" y="2209800"/>
            <a:ext cx="3999136" cy="266666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171752720"/>
      </p:ext>
    </p:extLst>
  </p:cSld>
  <p:clrMapOvr>
    <a:masterClrMapping/>
  </p:clrMapOvr>
  <p:timing>
    <p:tnLst>
      <p:par>
        <p:cTn id="1" dur="indefinite" restart="never" nodeType="tmRoot"/>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Types of Questions</a:t>
            </a:r>
            <a:endParaRPr lang="en-US" dirty="0"/>
          </a:p>
        </p:txBody>
      </p:sp>
      <p:sp>
        <p:nvSpPr>
          <p:cNvPr id="3" name="Content Placeholder 2"/>
          <p:cNvSpPr>
            <a:spLocks noGrp="1"/>
          </p:cNvSpPr>
          <p:nvPr>
            <p:ph idx="1"/>
          </p:nvPr>
        </p:nvSpPr>
        <p:spPr/>
        <p:txBody>
          <a:bodyPr/>
          <a:lstStyle/>
          <a:p>
            <a:r>
              <a:rPr lang="en-US" dirty="0" smtClean="0"/>
              <a:t>Recall</a:t>
            </a:r>
          </a:p>
          <a:p>
            <a:r>
              <a:rPr lang="en-US" dirty="0" smtClean="0"/>
              <a:t>Synthesis</a:t>
            </a:r>
          </a:p>
          <a:p>
            <a:r>
              <a:rPr lang="en-US" dirty="0" smtClean="0"/>
              <a:t>Application</a:t>
            </a:r>
            <a:endParaRPr lang="en-US" dirty="0"/>
          </a:p>
        </p:txBody>
      </p:sp>
      <p:pic>
        <p:nvPicPr>
          <p:cNvPr id="6"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657600" y="1828800"/>
            <a:ext cx="4724400" cy="328560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1921526543"/>
      </p:ext>
    </p:extLst>
  </p:cSld>
  <p:clrMapOvr>
    <a:masterClrMapping/>
  </p:clrMapOvr>
  <p:timing>
    <p:tnLst>
      <p:par>
        <p:cT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tandardized Framework</a:t>
            </a:r>
            <a:endParaRPr lang="en-US" dirty="0"/>
          </a:p>
        </p:txBody>
      </p:sp>
      <p:sp>
        <p:nvSpPr>
          <p:cNvPr id="3" name="Content Placeholder 2"/>
          <p:cNvSpPr>
            <a:spLocks noGrp="1"/>
          </p:cNvSpPr>
          <p:nvPr>
            <p:ph idx="1"/>
          </p:nvPr>
        </p:nvSpPr>
        <p:spPr/>
        <p:txBody>
          <a:bodyPr/>
          <a:lstStyle/>
          <a:p>
            <a:r>
              <a:rPr lang="en-US" dirty="0">
                <a:solidFill>
                  <a:schemeClr val="tx1">
                    <a:lumMod val="50000"/>
                  </a:schemeClr>
                </a:solidFill>
              </a:rPr>
              <a:t>Foster a learning climate</a:t>
            </a:r>
          </a:p>
          <a:p>
            <a:r>
              <a:rPr lang="en-US" dirty="0">
                <a:solidFill>
                  <a:schemeClr val="tx1">
                    <a:lumMod val="50000"/>
                  </a:schemeClr>
                </a:solidFill>
              </a:rPr>
              <a:t>Set clear goals</a:t>
            </a:r>
          </a:p>
          <a:p>
            <a:r>
              <a:rPr lang="en-US" dirty="0">
                <a:solidFill>
                  <a:schemeClr val="tx1">
                    <a:lumMod val="50000"/>
                  </a:schemeClr>
                </a:solidFill>
              </a:rPr>
              <a:t>Promote understanding</a:t>
            </a:r>
          </a:p>
          <a:p>
            <a:r>
              <a:rPr lang="en-US" dirty="0">
                <a:solidFill>
                  <a:schemeClr val="tx1">
                    <a:lumMod val="50000"/>
                  </a:schemeClr>
                </a:solidFill>
              </a:rPr>
              <a:t>Ask quality questions</a:t>
            </a:r>
          </a:p>
          <a:p>
            <a:r>
              <a:rPr lang="en-US" dirty="0"/>
              <a:t>Seek out feedback</a:t>
            </a:r>
          </a:p>
        </p:txBody>
      </p:sp>
      <p:pic>
        <p:nvPicPr>
          <p:cNvPr id="9218"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724400" y="2173102"/>
            <a:ext cx="4038891" cy="270369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171752720"/>
      </p:ext>
    </p:extLst>
  </p:cSld>
  <p:clrMapOvr>
    <a:masterClrMapping/>
  </p:clrMapOvr>
  <p:timing>
    <p:tnLst>
      <p:par>
        <p:cTn id="1" dur="indefinite" restart="never" nodeType="tmRoot"/>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Part 3 Summary</a:t>
            </a:r>
            <a:endParaRPr lang="en-US" dirty="0"/>
          </a:p>
        </p:txBody>
      </p:sp>
      <p:sp>
        <p:nvSpPr>
          <p:cNvPr id="3" name="Content Placeholder 2"/>
          <p:cNvSpPr>
            <a:spLocks noGrp="1"/>
          </p:cNvSpPr>
          <p:nvPr>
            <p:ph idx="1"/>
          </p:nvPr>
        </p:nvSpPr>
        <p:spPr/>
        <p:txBody>
          <a:bodyPr/>
          <a:lstStyle/>
          <a:p>
            <a:r>
              <a:rPr lang="en-US" dirty="0" smtClean="0"/>
              <a:t>Create a learning climate</a:t>
            </a:r>
          </a:p>
          <a:p>
            <a:r>
              <a:rPr lang="en-US" dirty="0" smtClean="0"/>
              <a:t>Set clear goals</a:t>
            </a:r>
          </a:p>
          <a:p>
            <a:r>
              <a:rPr lang="en-US" dirty="0" smtClean="0"/>
              <a:t>Promote understanding</a:t>
            </a:r>
          </a:p>
          <a:p>
            <a:r>
              <a:rPr lang="en-US" dirty="0" smtClean="0"/>
              <a:t>Ask quality questions</a:t>
            </a:r>
          </a:p>
          <a:p>
            <a:r>
              <a:rPr lang="en-US" dirty="0" smtClean="0"/>
              <a:t>Seek out feedback</a:t>
            </a:r>
            <a:endParaRPr lang="en-US" dirty="0"/>
          </a:p>
        </p:txBody>
      </p:sp>
    </p:spTree>
    <p:extLst>
      <p:ext uri="{BB962C8B-B14F-4D97-AF65-F5344CB8AC3E}">
        <p14:creationId xmlns:p14="http://schemas.microsoft.com/office/powerpoint/2010/main" val="2171752720"/>
      </p:ext>
    </p:extLst>
  </p:cSld>
  <p:clrMapOvr>
    <a:masterClrMapping/>
  </p:clrMapOvr>
  <p:timing>
    <p:tnLst>
      <p:par>
        <p:cT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smtClean="0"/>
              <a:t>Part 3</a:t>
            </a:r>
            <a:br>
              <a:rPr lang="en-US" dirty="0" smtClean="0"/>
            </a:br>
            <a:r>
              <a:rPr lang="en-US" dirty="0" smtClean="0"/>
              <a:t>Questions/Discussion</a:t>
            </a:r>
            <a:endParaRPr lang="en-US" dirty="0">
              <a:solidFill>
                <a:schemeClr val="tx1"/>
              </a:solidFill>
            </a:endParaRPr>
          </a:p>
        </p:txBody>
      </p:sp>
    </p:spTree>
    <p:extLst>
      <p:ext uri="{BB962C8B-B14F-4D97-AF65-F5344CB8AC3E}">
        <p14:creationId xmlns:p14="http://schemas.microsoft.com/office/powerpoint/2010/main" val="24596488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bjectives</a:t>
            </a:r>
            <a:endParaRPr lang="en-US" dirty="0"/>
          </a:p>
        </p:txBody>
      </p:sp>
      <p:sp>
        <p:nvSpPr>
          <p:cNvPr id="3" name="Content Placeholder 2"/>
          <p:cNvSpPr>
            <a:spLocks noGrp="1"/>
          </p:cNvSpPr>
          <p:nvPr>
            <p:ph idx="1"/>
          </p:nvPr>
        </p:nvSpPr>
        <p:spPr/>
        <p:txBody>
          <a:bodyPr/>
          <a:lstStyle/>
          <a:p>
            <a:pPr marL="514350" lvl="0" indent="-514350">
              <a:buFont typeface="+mj-lt"/>
              <a:buAutoNum type="arabicPeriod"/>
            </a:pPr>
            <a:r>
              <a:rPr lang="en-US" dirty="0" smtClean="0"/>
              <a:t>Discuss cognitive load theory as it applies to </a:t>
            </a:r>
            <a:r>
              <a:rPr lang="en-US" dirty="0" smtClean="0"/>
              <a:t>CA-1 orientation.</a:t>
            </a:r>
            <a:endParaRPr lang="en-US" dirty="0" smtClean="0"/>
          </a:p>
          <a:p>
            <a:pPr marL="514350" lvl="0" indent="-514350">
              <a:buFont typeface="+mj-lt"/>
              <a:buAutoNum type="arabicPeriod"/>
            </a:pPr>
            <a:r>
              <a:rPr lang="en-US" dirty="0" smtClean="0"/>
              <a:t>Describe general </a:t>
            </a:r>
            <a:r>
              <a:rPr lang="en-US" dirty="0"/>
              <a:t>principles of effective teaching.</a:t>
            </a:r>
          </a:p>
          <a:p>
            <a:pPr marL="514350" lvl="0" indent="-514350">
              <a:buFont typeface="+mj-lt"/>
              <a:buAutoNum type="arabicPeriod"/>
            </a:pPr>
            <a:r>
              <a:rPr lang="en-US" dirty="0" smtClean="0"/>
              <a:t>Evaluate the quality of teaching using a standardized framework.</a:t>
            </a:r>
            <a:endParaRPr lang="en-US" dirty="0"/>
          </a:p>
          <a:p>
            <a:pPr marL="514350" lvl="0" indent="-514350">
              <a:buFont typeface="+mj-lt"/>
              <a:buAutoNum type="arabicPeriod"/>
            </a:pPr>
            <a:r>
              <a:rPr lang="en-US" dirty="0"/>
              <a:t>Learn how to use </a:t>
            </a:r>
            <a:r>
              <a:rPr lang="en-US" dirty="0" err="1"/>
              <a:t>microskills</a:t>
            </a:r>
            <a:r>
              <a:rPr lang="en-US" dirty="0"/>
              <a:t> for clinical teaching</a:t>
            </a:r>
            <a:r>
              <a:rPr lang="en-US" dirty="0" smtClean="0"/>
              <a:t>.</a:t>
            </a:r>
            <a:endParaRPr lang="en-US" dirty="0"/>
          </a:p>
        </p:txBody>
      </p:sp>
    </p:spTree>
    <p:extLst>
      <p:ext uri="{BB962C8B-B14F-4D97-AF65-F5344CB8AC3E}">
        <p14:creationId xmlns:p14="http://schemas.microsoft.com/office/powerpoint/2010/main" val="4040384951"/>
      </p:ext>
    </p:extLst>
  </p:cSld>
  <p:clrMapOvr>
    <a:masterClrMapping/>
  </p:clrMapOvr>
  <p:timing>
    <p:tnLst>
      <p:par>
        <p:cT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Hour 1 summary</a:t>
            </a:r>
            <a:endParaRPr lang="en-US" dirty="0"/>
          </a:p>
        </p:txBody>
      </p:sp>
      <p:sp>
        <p:nvSpPr>
          <p:cNvPr id="3" name="Content Placeholder 2"/>
          <p:cNvSpPr>
            <a:spLocks noGrp="1"/>
          </p:cNvSpPr>
          <p:nvPr>
            <p:ph idx="1"/>
          </p:nvPr>
        </p:nvSpPr>
        <p:spPr/>
        <p:txBody>
          <a:bodyPr/>
          <a:lstStyle/>
          <a:p>
            <a:r>
              <a:rPr lang="en-US" dirty="0" smtClean="0"/>
              <a:t>Beware of automaticity.</a:t>
            </a:r>
          </a:p>
          <a:p>
            <a:r>
              <a:rPr lang="en-US" dirty="0" smtClean="0"/>
              <a:t>Manage cognitive load.</a:t>
            </a:r>
          </a:p>
          <a:p>
            <a:r>
              <a:rPr lang="en-US" dirty="0" smtClean="0"/>
              <a:t>Provide </a:t>
            </a:r>
            <a:r>
              <a:rPr lang="en-US" dirty="0"/>
              <a:t>appropriate autonomy.</a:t>
            </a:r>
          </a:p>
          <a:p>
            <a:r>
              <a:rPr lang="en-US" dirty="0" smtClean="0"/>
              <a:t>Activate prior knowledge.</a:t>
            </a:r>
          </a:p>
        </p:txBody>
      </p:sp>
    </p:spTree>
    <p:extLst>
      <p:ext uri="{BB962C8B-B14F-4D97-AF65-F5344CB8AC3E}">
        <p14:creationId xmlns:p14="http://schemas.microsoft.com/office/powerpoint/2010/main" val="3544629476"/>
      </p:ext>
    </p:extLst>
  </p:cSld>
  <p:clrMapOvr>
    <a:masterClrMapping/>
  </p:clrMapOvr>
  <p:timing>
    <p:tnLst>
      <p:par>
        <p:cTn id="1" dur="indefinite" restart="never" nodeType="tmRoot"/>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smtClean="0"/>
              <a:t>Hour 1</a:t>
            </a:r>
            <a:br>
              <a:rPr lang="en-US" dirty="0" smtClean="0"/>
            </a:br>
            <a:r>
              <a:rPr lang="en-US" dirty="0" smtClean="0"/>
              <a:t>Questions/Discussion</a:t>
            </a:r>
            <a:endParaRPr lang="en-US" dirty="0">
              <a:solidFill>
                <a:schemeClr val="tx1"/>
              </a:solidFill>
            </a:endParaRPr>
          </a:p>
        </p:txBody>
      </p:sp>
    </p:spTree>
    <p:extLst>
      <p:ext uri="{BB962C8B-B14F-4D97-AF65-F5344CB8AC3E}">
        <p14:creationId xmlns:p14="http://schemas.microsoft.com/office/powerpoint/2010/main" val="2074156291"/>
      </p:ext>
    </p:extLst>
  </p:cSld>
  <p:clrMapOvr>
    <a:masterClrMapping/>
  </p:clrMapOvr>
  <p:timing>
    <p:tnLst>
      <p:par>
        <p:cTn id="1" dur="indefinite" restart="never" nodeType="tmRoot"/>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References</a:t>
            </a:r>
            <a:endParaRPr lang="en-US" dirty="0"/>
          </a:p>
        </p:txBody>
      </p:sp>
      <p:sp>
        <p:nvSpPr>
          <p:cNvPr id="3" name="Content Placeholder 2"/>
          <p:cNvSpPr>
            <a:spLocks noGrp="1"/>
          </p:cNvSpPr>
          <p:nvPr>
            <p:ph idx="1"/>
          </p:nvPr>
        </p:nvSpPr>
        <p:spPr/>
        <p:txBody>
          <a:bodyPr/>
          <a:lstStyle/>
          <a:p>
            <a:r>
              <a:rPr lang="en-US" sz="1800" dirty="0" smtClean="0"/>
              <a:t>Miller </a:t>
            </a:r>
            <a:r>
              <a:rPr lang="en-US" sz="1800" dirty="0"/>
              <a:t>GA. The Magical Number Seven, Plus or Minus Two: Some Limits on our Capacity for Processing Information. Psychological Review. 1956;63: 81-97.</a:t>
            </a:r>
          </a:p>
          <a:p>
            <a:r>
              <a:rPr lang="en-US" sz="1800" dirty="0" smtClean="0"/>
              <a:t>Chase </a:t>
            </a:r>
            <a:r>
              <a:rPr lang="en-US" sz="1800" dirty="0"/>
              <a:t>WG, Simon HA. Perception in chess. Cognitive Psychology. 1973;4(1): 55–81.</a:t>
            </a:r>
          </a:p>
          <a:p>
            <a:r>
              <a:rPr lang="en-US" sz="1800" dirty="0" smtClean="0"/>
              <a:t>Clark </a:t>
            </a:r>
            <a:r>
              <a:rPr lang="en-US" sz="1800" dirty="0"/>
              <a:t>R, Nguyen F, </a:t>
            </a:r>
            <a:r>
              <a:rPr lang="en-US" sz="1800" dirty="0" err="1"/>
              <a:t>Sweller</a:t>
            </a:r>
            <a:r>
              <a:rPr lang="en-US" sz="1800" dirty="0"/>
              <a:t> J. Kilgore D, ed. Efficiency in Learning: Evidence-Based Guidelines to Manage Cognitive Load. San Francisco, CA: Pfeiffer; 2006.</a:t>
            </a:r>
          </a:p>
          <a:p>
            <a:r>
              <a:rPr lang="en-US" sz="1800" dirty="0" smtClean="0"/>
              <a:t>Mayer </a:t>
            </a:r>
            <a:r>
              <a:rPr lang="en-US" sz="1800" dirty="0"/>
              <a:t>RE, Moreno R. Nine ways to reduce cognitive load in multimedia learning. Educational Psychologist. 2003;38(1): 43-52.</a:t>
            </a:r>
          </a:p>
          <a:p>
            <a:r>
              <a:rPr lang="en-US" sz="1800" dirty="0" err="1" smtClean="0"/>
              <a:t>Sweller</a:t>
            </a:r>
            <a:r>
              <a:rPr lang="en-US" sz="1800" dirty="0" smtClean="0"/>
              <a:t> </a:t>
            </a:r>
            <a:r>
              <a:rPr lang="en-US" sz="1800" dirty="0"/>
              <a:t>J. The worked example effect and human cognition. Learning and Instruction. 2006;16: 165-169.</a:t>
            </a:r>
          </a:p>
          <a:p>
            <a:r>
              <a:rPr lang="en-US" sz="1800" dirty="0" smtClean="0"/>
              <a:t>Chandler </a:t>
            </a:r>
            <a:r>
              <a:rPr lang="en-US" sz="1800" dirty="0"/>
              <a:t>P, </a:t>
            </a:r>
            <a:r>
              <a:rPr lang="en-US" sz="1800" dirty="0" err="1"/>
              <a:t>Sweller</a:t>
            </a:r>
            <a:r>
              <a:rPr lang="en-US" sz="1800" dirty="0"/>
              <a:t> J. The Split-Attention Effect as a Factor in the Design of Instruction. Educational Psychology. 1992;62(2): 233-246.</a:t>
            </a:r>
          </a:p>
          <a:p>
            <a:endParaRPr lang="en-US" sz="1800" dirty="0"/>
          </a:p>
        </p:txBody>
      </p:sp>
    </p:spTree>
    <p:extLst>
      <p:ext uri="{BB962C8B-B14F-4D97-AF65-F5344CB8AC3E}">
        <p14:creationId xmlns:p14="http://schemas.microsoft.com/office/powerpoint/2010/main" val="4163875843"/>
      </p:ext>
    </p:extLst>
  </p:cSld>
  <p:clrMapOvr>
    <a:masterClrMapping/>
  </p:clrMapOvr>
  <p:timing>
    <p:tnLst>
      <p:par>
        <p:cTn id="1" dur="indefinite" restart="never" nodeType="tmRoot"/>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smtClean="0"/>
              <a:t>Part 4: </a:t>
            </a:r>
            <a:r>
              <a:rPr lang="en-US" dirty="0" err="1" smtClean="0"/>
              <a:t>Microskills</a:t>
            </a:r>
            <a:endParaRPr lang="en-US" dirty="0"/>
          </a:p>
        </p:txBody>
      </p:sp>
      <p:sp>
        <p:nvSpPr>
          <p:cNvPr id="5" name="Text Placeholder 4"/>
          <p:cNvSpPr>
            <a:spLocks noGrp="1"/>
          </p:cNvSpPr>
          <p:nvPr>
            <p:ph type="body" idx="1"/>
          </p:nvPr>
        </p:nvSpPr>
        <p:spPr/>
        <p:txBody>
          <a:bodyPr/>
          <a:lstStyle/>
          <a:p>
            <a:r>
              <a:rPr lang="en-US" dirty="0" smtClean="0"/>
              <a:t>A framework for teaching clinical pearls</a:t>
            </a:r>
            <a:endParaRPr lang="en-US" dirty="0"/>
          </a:p>
        </p:txBody>
      </p:sp>
    </p:spTree>
    <p:extLst>
      <p:ext uri="{BB962C8B-B14F-4D97-AF65-F5344CB8AC3E}">
        <p14:creationId xmlns:p14="http://schemas.microsoft.com/office/powerpoint/2010/main" val="2142731795"/>
      </p:ext>
    </p:extLst>
  </p:cSld>
  <p:clrMapOvr>
    <a:masterClrMapping/>
  </p:clrMapOvr>
  <p:timing>
    <p:tnLst>
      <p:par>
        <p:cTn id="1" dur="indefinite" restart="never" nodeType="tmRoot"/>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smtClean="0"/>
              <a:t>Goal</a:t>
            </a:r>
            <a:endParaRPr lang="en-US" dirty="0"/>
          </a:p>
        </p:txBody>
      </p:sp>
      <p:sp>
        <p:nvSpPr>
          <p:cNvPr id="5" name="Content Placeholder 4"/>
          <p:cNvSpPr>
            <a:spLocks noGrp="1"/>
          </p:cNvSpPr>
          <p:nvPr>
            <p:ph idx="1"/>
          </p:nvPr>
        </p:nvSpPr>
        <p:spPr/>
        <p:txBody>
          <a:bodyPr/>
          <a:lstStyle/>
          <a:p>
            <a:r>
              <a:rPr lang="en-US" dirty="0" smtClean="0"/>
              <a:t>By the end of this workshop, residents will feel comfortable using </a:t>
            </a:r>
            <a:r>
              <a:rPr lang="en-US" dirty="0" err="1" smtClean="0"/>
              <a:t>microskills</a:t>
            </a:r>
            <a:r>
              <a:rPr lang="en-US" dirty="0" smtClean="0"/>
              <a:t>.</a:t>
            </a:r>
          </a:p>
          <a:p>
            <a:r>
              <a:rPr lang="en-US" dirty="0" smtClean="0"/>
              <a:t>Residents will understand strengths and limitations of </a:t>
            </a:r>
            <a:r>
              <a:rPr lang="en-US" dirty="0" err="1" smtClean="0"/>
              <a:t>microskills</a:t>
            </a:r>
            <a:r>
              <a:rPr lang="en-US" dirty="0" smtClean="0"/>
              <a:t>.</a:t>
            </a:r>
            <a:endParaRPr lang="en-US" dirty="0"/>
          </a:p>
        </p:txBody>
      </p:sp>
    </p:spTree>
    <p:extLst>
      <p:ext uri="{BB962C8B-B14F-4D97-AF65-F5344CB8AC3E}">
        <p14:creationId xmlns:p14="http://schemas.microsoft.com/office/powerpoint/2010/main" val="1050640463"/>
      </p:ext>
    </p:extLst>
  </p:cSld>
  <p:clrMapOvr>
    <a:masterClrMapping/>
  </p:clrMapOvr>
  <p:timing>
    <p:tnLst>
      <p:par>
        <p:cTn id="1" dur="indefinite" restart="never" nodeType="tmRoot"/>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ne-Minute Preceptor (“</a:t>
            </a:r>
            <a:r>
              <a:rPr lang="en-US" dirty="0" err="1"/>
              <a:t>Microskills</a:t>
            </a:r>
            <a:r>
              <a:rPr lang="en-US" dirty="0"/>
              <a:t>”)</a:t>
            </a:r>
          </a:p>
        </p:txBody>
      </p:sp>
      <p:sp>
        <p:nvSpPr>
          <p:cNvPr id="3" name="Content Placeholder 2"/>
          <p:cNvSpPr>
            <a:spLocks noGrp="1"/>
          </p:cNvSpPr>
          <p:nvPr>
            <p:ph idx="1"/>
          </p:nvPr>
        </p:nvSpPr>
        <p:spPr/>
        <p:txBody>
          <a:bodyPr/>
          <a:lstStyle/>
          <a:p>
            <a:r>
              <a:rPr lang="en-US" dirty="0"/>
              <a:t>5 step model for clinical teaching</a:t>
            </a:r>
          </a:p>
          <a:p>
            <a:r>
              <a:rPr lang="en-US" dirty="0"/>
              <a:t>Simple discrete teaching behaviors</a:t>
            </a:r>
          </a:p>
          <a:p>
            <a:r>
              <a:rPr lang="en-US" dirty="0"/>
              <a:t>Easy to learn + Quick to use</a:t>
            </a:r>
          </a:p>
        </p:txBody>
      </p:sp>
      <p:pic>
        <p:nvPicPr>
          <p:cNvPr id="10243"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286000" y="3299306"/>
            <a:ext cx="4191000" cy="279669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Rectangle 3"/>
          <p:cNvSpPr/>
          <p:nvPr/>
        </p:nvSpPr>
        <p:spPr>
          <a:xfrm>
            <a:off x="685800" y="6211669"/>
            <a:ext cx="8001000" cy="646331"/>
          </a:xfrm>
          <a:prstGeom prst="rect">
            <a:avLst/>
          </a:prstGeom>
        </p:spPr>
        <p:txBody>
          <a:bodyPr wrap="square">
            <a:spAutoFit/>
          </a:bodyPr>
          <a:lstStyle/>
          <a:p>
            <a:pPr lvl="0"/>
            <a:r>
              <a:rPr lang="en-US" dirty="0" err="1"/>
              <a:t>Neher</a:t>
            </a:r>
            <a:r>
              <a:rPr lang="en-US" dirty="0"/>
              <a:t> JO, Gordon KC, Meyer B, Stevens N. A five-step “</a:t>
            </a:r>
            <a:r>
              <a:rPr lang="en-US" dirty="0" err="1"/>
              <a:t>microskills</a:t>
            </a:r>
            <a:r>
              <a:rPr lang="en-US" dirty="0"/>
              <a:t>” model of clinical teaching. J Am Board Fam </a:t>
            </a:r>
            <a:r>
              <a:rPr lang="en-US" dirty="0" err="1"/>
              <a:t>Pract</a:t>
            </a:r>
            <a:r>
              <a:rPr lang="en-US" dirty="0"/>
              <a:t> 1992;5:419-24.</a:t>
            </a:r>
            <a:endParaRPr lang="en-US" dirty="0"/>
          </a:p>
        </p:txBody>
      </p:sp>
    </p:spTree>
    <p:extLst>
      <p:ext uri="{BB962C8B-B14F-4D97-AF65-F5344CB8AC3E}">
        <p14:creationId xmlns:p14="http://schemas.microsoft.com/office/powerpoint/2010/main" val="2338474487"/>
      </p:ext>
    </p:extLst>
  </p:cSld>
  <p:clrMapOvr>
    <a:masterClrMapping/>
  </p:clrMapOvr>
  <p:timing>
    <p:tnLst>
      <p:par>
        <p:cTn id="1" dur="indefinite" restart="never" nodeType="tmRoot"/>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uccessfully used </a:t>
            </a:r>
            <a:r>
              <a:rPr lang="en-US" dirty="0" smtClean="0"/>
              <a:t>in multiple disciplines:</a:t>
            </a:r>
            <a:endParaRPr lang="en-US" dirty="0"/>
          </a:p>
        </p:txBody>
      </p:sp>
      <p:sp>
        <p:nvSpPr>
          <p:cNvPr id="3" name="Content Placeholder 2"/>
          <p:cNvSpPr>
            <a:spLocks noGrp="1"/>
          </p:cNvSpPr>
          <p:nvPr>
            <p:ph idx="1"/>
          </p:nvPr>
        </p:nvSpPr>
        <p:spPr/>
        <p:txBody>
          <a:bodyPr/>
          <a:lstStyle/>
          <a:p>
            <a:r>
              <a:rPr lang="en-US" dirty="0"/>
              <a:t>Family Medicine</a:t>
            </a:r>
          </a:p>
          <a:p>
            <a:r>
              <a:rPr lang="en-US" dirty="0"/>
              <a:t>Internal Medicine</a:t>
            </a:r>
          </a:p>
          <a:p>
            <a:r>
              <a:rPr lang="en-US" dirty="0"/>
              <a:t>Emergency Medicine</a:t>
            </a:r>
          </a:p>
          <a:p>
            <a:r>
              <a:rPr lang="en-US" dirty="0"/>
              <a:t>Psychiatry</a:t>
            </a:r>
          </a:p>
          <a:p>
            <a:r>
              <a:rPr lang="en-US" dirty="0"/>
              <a:t>OB/GYN</a:t>
            </a:r>
          </a:p>
          <a:p>
            <a:r>
              <a:rPr lang="en-US" dirty="0"/>
              <a:t>Anatomy lab</a:t>
            </a:r>
          </a:p>
          <a:p>
            <a:r>
              <a:rPr lang="en-US" dirty="0"/>
              <a:t>Nursing</a:t>
            </a:r>
          </a:p>
        </p:txBody>
      </p:sp>
      <p:sp>
        <p:nvSpPr>
          <p:cNvPr id="4" name="Rectangle 3"/>
          <p:cNvSpPr/>
          <p:nvPr/>
        </p:nvSpPr>
        <p:spPr>
          <a:xfrm>
            <a:off x="609600" y="5934670"/>
            <a:ext cx="8534400" cy="923330"/>
          </a:xfrm>
          <a:prstGeom prst="rect">
            <a:avLst/>
          </a:prstGeom>
        </p:spPr>
        <p:txBody>
          <a:bodyPr wrap="square">
            <a:spAutoFit/>
          </a:bodyPr>
          <a:lstStyle/>
          <a:p>
            <a:pPr lvl="0"/>
            <a:r>
              <a:rPr lang="en-US" dirty="0"/>
              <a:t>Farrell SE, Hopson LR, Wolff M, Hemphill RR, Santen SA. What's the Evidence: A Review of the One-Minute Preceptor Model of Clinical Teaching and Implications for Teaching in the Emergency Department. </a:t>
            </a:r>
            <a:r>
              <a:rPr lang="en-US" i="1" dirty="0"/>
              <a:t>J </a:t>
            </a:r>
            <a:r>
              <a:rPr lang="en-US" i="1" dirty="0" err="1"/>
              <a:t>Emerg</a:t>
            </a:r>
            <a:r>
              <a:rPr lang="en-US" i="1" dirty="0"/>
              <a:t> Med</a:t>
            </a:r>
            <a:r>
              <a:rPr lang="en-US" dirty="0"/>
              <a:t>. 2016;51(3): 278-83.</a:t>
            </a:r>
            <a:endParaRPr lang="en-US" b="1" dirty="0"/>
          </a:p>
        </p:txBody>
      </p:sp>
    </p:spTree>
    <p:extLst>
      <p:ext uri="{BB962C8B-B14F-4D97-AF65-F5344CB8AC3E}">
        <p14:creationId xmlns:p14="http://schemas.microsoft.com/office/powerpoint/2010/main" val="3934553140"/>
      </p:ext>
    </p:extLst>
  </p:cSld>
  <p:clrMapOvr>
    <a:masterClrMapping/>
  </p:clrMapOvr>
  <p:timing>
    <p:tnLst>
      <p:par>
        <p:cTn id="1" dur="indefinite" restart="never" nodeType="tmRoot"/>
      </p:par>
    </p:tn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67928CC8-15D3-4853-9A0C-6D1EF836EE20}"/>
              </a:ext>
            </a:extLst>
          </p:cNvPr>
          <p:cNvSpPr>
            <a:spLocks noGrp="1"/>
          </p:cNvSpPr>
          <p:nvPr>
            <p:ph type="title"/>
          </p:nvPr>
        </p:nvSpPr>
        <p:spPr/>
        <p:txBody>
          <a:bodyPr/>
          <a:lstStyle/>
          <a:p>
            <a:r>
              <a:rPr lang="en-US" dirty="0"/>
              <a:t>Supporting Evidence</a:t>
            </a:r>
          </a:p>
        </p:txBody>
      </p:sp>
      <p:sp>
        <p:nvSpPr>
          <p:cNvPr id="3" name="Content Placeholder 2">
            <a:extLst>
              <a:ext uri="{FF2B5EF4-FFF2-40B4-BE49-F238E27FC236}">
                <a16:creationId xmlns="" xmlns:a16="http://schemas.microsoft.com/office/drawing/2014/main" id="{240D10FB-3B9C-487F-92B1-F2C3F9CF01DA}"/>
              </a:ext>
            </a:extLst>
          </p:cNvPr>
          <p:cNvSpPr>
            <a:spLocks noGrp="1"/>
          </p:cNvSpPr>
          <p:nvPr>
            <p:ph idx="1"/>
          </p:nvPr>
        </p:nvSpPr>
        <p:spPr/>
        <p:txBody>
          <a:bodyPr/>
          <a:lstStyle/>
          <a:p>
            <a:r>
              <a:rPr lang="en-US" dirty="0"/>
              <a:t>Students preferred the OMP teaching model due to:</a:t>
            </a:r>
          </a:p>
          <a:p>
            <a:pPr lvl="1"/>
            <a:r>
              <a:rPr lang="en-US" dirty="0"/>
              <a:t>Involvement of the student in the decision-making process</a:t>
            </a:r>
          </a:p>
          <a:p>
            <a:pPr lvl="1"/>
            <a:r>
              <a:rPr lang="en-US" dirty="0"/>
              <a:t>Provision of feedback to the student</a:t>
            </a:r>
          </a:p>
          <a:p>
            <a:pPr lvl="1"/>
            <a:r>
              <a:rPr lang="en-US" dirty="0"/>
              <a:t>Overall effectiveness and satisfaction with the teaching encounter</a:t>
            </a:r>
          </a:p>
        </p:txBody>
      </p:sp>
      <p:sp>
        <p:nvSpPr>
          <p:cNvPr id="4" name="Rectangle 3">
            <a:extLst>
              <a:ext uri="{FF2B5EF4-FFF2-40B4-BE49-F238E27FC236}">
                <a16:creationId xmlns="" xmlns:a16="http://schemas.microsoft.com/office/drawing/2014/main" id="{D8919FD4-566E-4E38-B521-F7D310EA4473}"/>
              </a:ext>
            </a:extLst>
          </p:cNvPr>
          <p:cNvSpPr/>
          <p:nvPr/>
        </p:nvSpPr>
        <p:spPr>
          <a:xfrm>
            <a:off x="810768" y="5629870"/>
            <a:ext cx="8028432" cy="923330"/>
          </a:xfrm>
          <a:prstGeom prst="rect">
            <a:avLst/>
          </a:prstGeom>
        </p:spPr>
        <p:txBody>
          <a:bodyPr wrap="square">
            <a:spAutoFit/>
          </a:bodyPr>
          <a:lstStyle/>
          <a:p>
            <a:pPr lvl="0"/>
            <a:r>
              <a:rPr lang="en-US" dirty="0" err="1"/>
              <a:t>Teherani</a:t>
            </a:r>
            <a:r>
              <a:rPr lang="en-US" dirty="0"/>
              <a:t> A, O’Sullivan P, </a:t>
            </a:r>
            <a:r>
              <a:rPr lang="en-US" dirty="0" err="1"/>
              <a:t>Aagaard</a:t>
            </a:r>
            <a:r>
              <a:rPr lang="en-US" dirty="0"/>
              <a:t> EM, Morrison EH, Irby DM. Student perceptions of the one minute preceptor and traditional preceptor models. </a:t>
            </a:r>
            <a:r>
              <a:rPr lang="en-US" i="1" dirty="0"/>
              <a:t>Med Teach</a:t>
            </a:r>
            <a:r>
              <a:rPr lang="en-US" dirty="0"/>
              <a:t>. 2007;29: 323–327.</a:t>
            </a:r>
            <a:endParaRPr lang="en-US" b="1" dirty="0"/>
          </a:p>
        </p:txBody>
      </p:sp>
    </p:spTree>
    <p:extLst>
      <p:ext uri="{BB962C8B-B14F-4D97-AF65-F5344CB8AC3E}">
        <p14:creationId xmlns:p14="http://schemas.microsoft.com/office/powerpoint/2010/main" val="891683327"/>
      </p:ext>
    </p:extLst>
  </p:cSld>
  <p:clrMapOvr>
    <a:masterClrMapping/>
  </p:clrMapOvr>
  <p:timing>
    <p:tnLst>
      <p:par>
        <p:cTn id="1" dur="indefinite" restart="never" nodeType="tmRoot"/>
      </p:par>
    </p:tn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D9DB2013-37C7-48AD-9E9E-06DCA6BA453A}"/>
              </a:ext>
            </a:extLst>
          </p:cNvPr>
          <p:cNvSpPr>
            <a:spLocks noGrp="1"/>
          </p:cNvSpPr>
          <p:nvPr>
            <p:ph type="title"/>
          </p:nvPr>
        </p:nvSpPr>
        <p:spPr/>
        <p:txBody>
          <a:bodyPr/>
          <a:lstStyle/>
          <a:p>
            <a:r>
              <a:rPr lang="en-US" dirty="0"/>
              <a:t>Supporting Evidence</a:t>
            </a:r>
          </a:p>
        </p:txBody>
      </p:sp>
      <p:sp>
        <p:nvSpPr>
          <p:cNvPr id="3" name="Content Placeholder 2">
            <a:extLst>
              <a:ext uri="{FF2B5EF4-FFF2-40B4-BE49-F238E27FC236}">
                <a16:creationId xmlns="" xmlns:a16="http://schemas.microsoft.com/office/drawing/2014/main" id="{BF0BAB4C-BD4C-421E-A72B-E7A0B8289CBB}"/>
              </a:ext>
            </a:extLst>
          </p:cNvPr>
          <p:cNvSpPr>
            <a:spLocks noGrp="1"/>
          </p:cNvSpPr>
          <p:nvPr>
            <p:ph idx="1"/>
          </p:nvPr>
        </p:nvSpPr>
        <p:spPr/>
        <p:txBody>
          <a:bodyPr/>
          <a:lstStyle/>
          <a:p>
            <a:r>
              <a:rPr lang="en-US" dirty="0"/>
              <a:t>Residents who received training on using the OMP model were more likely to:</a:t>
            </a:r>
          </a:p>
          <a:p>
            <a:pPr lvl="1"/>
            <a:r>
              <a:rPr lang="en-US" dirty="0"/>
              <a:t>Offer students suggestions for improvement</a:t>
            </a:r>
          </a:p>
          <a:p>
            <a:pPr lvl="1"/>
            <a:r>
              <a:rPr lang="en-US" dirty="0"/>
              <a:t>Provide feedback more frequently</a:t>
            </a:r>
          </a:p>
          <a:p>
            <a:pPr lvl="1"/>
            <a:r>
              <a:rPr lang="en-US" dirty="0"/>
              <a:t>Motivate students to do outside reading on their clinical cases</a:t>
            </a:r>
          </a:p>
        </p:txBody>
      </p:sp>
      <p:sp>
        <p:nvSpPr>
          <p:cNvPr id="4" name="Rectangle 3">
            <a:extLst>
              <a:ext uri="{FF2B5EF4-FFF2-40B4-BE49-F238E27FC236}">
                <a16:creationId xmlns="" xmlns:a16="http://schemas.microsoft.com/office/drawing/2014/main" id="{718332F1-4656-4E75-B4D5-6B8898A1674E}"/>
              </a:ext>
            </a:extLst>
          </p:cNvPr>
          <p:cNvSpPr/>
          <p:nvPr/>
        </p:nvSpPr>
        <p:spPr>
          <a:xfrm>
            <a:off x="859536" y="5706070"/>
            <a:ext cx="7827264" cy="923330"/>
          </a:xfrm>
          <a:prstGeom prst="rect">
            <a:avLst/>
          </a:prstGeom>
        </p:spPr>
        <p:txBody>
          <a:bodyPr wrap="square">
            <a:spAutoFit/>
          </a:bodyPr>
          <a:lstStyle/>
          <a:p>
            <a:pPr lvl="0"/>
            <a:r>
              <a:rPr lang="en-US" dirty="0" err="1"/>
              <a:t>Furney</a:t>
            </a:r>
            <a:r>
              <a:rPr lang="en-US" dirty="0"/>
              <a:t> SL, </a:t>
            </a:r>
            <a:r>
              <a:rPr lang="en-US" dirty="0" err="1"/>
              <a:t>Orsini</a:t>
            </a:r>
            <a:r>
              <a:rPr lang="en-US" dirty="0"/>
              <a:t> AN, </a:t>
            </a:r>
            <a:r>
              <a:rPr lang="en-US" dirty="0" err="1"/>
              <a:t>Orsetti</a:t>
            </a:r>
            <a:r>
              <a:rPr lang="en-US" dirty="0"/>
              <a:t> KE, Stern DT, </a:t>
            </a:r>
            <a:r>
              <a:rPr lang="en-US" dirty="0" err="1"/>
              <a:t>Gruppen</a:t>
            </a:r>
            <a:r>
              <a:rPr lang="en-US" dirty="0"/>
              <a:t> LD, Irby DM. Teaching the one-minute preceptor: a randomized controlled trial. </a:t>
            </a:r>
            <a:r>
              <a:rPr lang="en-US" i="1" dirty="0"/>
              <a:t>J Gen Intern Med</a:t>
            </a:r>
            <a:r>
              <a:rPr lang="en-US" dirty="0"/>
              <a:t>. 2001;16: 620–624.</a:t>
            </a:r>
            <a:endParaRPr lang="en-US" b="1" dirty="0"/>
          </a:p>
        </p:txBody>
      </p:sp>
    </p:spTree>
    <p:extLst>
      <p:ext uri="{BB962C8B-B14F-4D97-AF65-F5344CB8AC3E}">
        <p14:creationId xmlns:p14="http://schemas.microsoft.com/office/powerpoint/2010/main" val="2593438513"/>
      </p:ext>
    </p:extLst>
  </p:cSld>
  <p:clrMapOvr>
    <a:masterClrMapping/>
  </p:clrMapOvr>
  <p:timing>
    <p:tnLst>
      <p:par>
        <p:cTn id="1" dur="indefinite" restart="never" nodeType="tmRoot"/>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p:cNvSpPr>
            <a:spLocks noGrp="1"/>
          </p:cNvSpPr>
          <p:nvPr>
            <p:ph type="title"/>
          </p:nvPr>
        </p:nvSpPr>
        <p:spPr/>
        <p:txBody>
          <a:bodyPr/>
          <a:lstStyle/>
          <a:p>
            <a:r>
              <a:rPr lang="en-US" dirty="0" err="1" smtClean="0"/>
              <a:t>Microskills</a:t>
            </a:r>
            <a:endParaRPr lang="en-US" dirty="0"/>
          </a:p>
        </p:txBody>
      </p:sp>
      <p:sp>
        <p:nvSpPr>
          <p:cNvPr id="8" name="Text Placeholder 7"/>
          <p:cNvSpPr>
            <a:spLocks noGrp="1"/>
          </p:cNvSpPr>
          <p:nvPr>
            <p:ph type="body" idx="1"/>
          </p:nvPr>
        </p:nvSpPr>
        <p:spPr/>
        <p:txBody>
          <a:bodyPr/>
          <a:lstStyle/>
          <a:p>
            <a:r>
              <a:rPr lang="en-US" dirty="0" smtClean="0"/>
              <a:t>Strengths</a:t>
            </a:r>
            <a:endParaRPr lang="en-US" dirty="0"/>
          </a:p>
        </p:txBody>
      </p:sp>
      <p:sp>
        <p:nvSpPr>
          <p:cNvPr id="9" name="Content Placeholder 8"/>
          <p:cNvSpPr>
            <a:spLocks noGrp="1"/>
          </p:cNvSpPr>
          <p:nvPr>
            <p:ph sz="half" idx="2"/>
          </p:nvPr>
        </p:nvSpPr>
        <p:spPr/>
        <p:txBody>
          <a:bodyPr/>
          <a:lstStyle/>
          <a:p>
            <a:r>
              <a:rPr lang="en-US" dirty="0"/>
              <a:t>Very quick to use</a:t>
            </a:r>
          </a:p>
          <a:p>
            <a:r>
              <a:rPr lang="en-US" dirty="0" smtClean="0"/>
              <a:t>Ability </a:t>
            </a:r>
            <a:r>
              <a:rPr lang="en-US" dirty="0"/>
              <a:t>to </a:t>
            </a:r>
            <a:r>
              <a:rPr lang="en-US" dirty="0" smtClean="0"/>
              <a:t>assess </a:t>
            </a:r>
            <a:r>
              <a:rPr lang="en-US" dirty="0"/>
              <a:t>the learner’s knowledge base and target </a:t>
            </a:r>
            <a:r>
              <a:rPr lang="en-US" dirty="0" smtClean="0"/>
              <a:t>teaching accordingly</a:t>
            </a:r>
            <a:endParaRPr lang="en-US" dirty="0"/>
          </a:p>
          <a:p>
            <a:r>
              <a:rPr lang="en-US" dirty="0" smtClean="0"/>
              <a:t>Delivers small clinical pearls </a:t>
            </a:r>
            <a:r>
              <a:rPr lang="en-US" dirty="0"/>
              <a:t>to avoid overwhelming the learner with too much </a:t>
            </a:r>
            <a:r>
              <a:rPr lang="en-US" dirty="0" smtClean="0"/>
              <a:t>information</a:t>
            </a:r>
            <a:endParaRPr lang="en-US" dirty="0"/>
          </a:p>
        </p:txBody>
      </p:sp>
      <p:sp>
        <p:nvSpPr>
          <p:cNvPr id="10" name="Text Placeholder 9"/>
          <p:cNvSpPr>
            <a:spLocks noGrp="1"/>
          </p:cNvSpPr>
          <p:nvPr>
            <p:ph type="body" sz="quarter" idx="3"/>
          </p:nvPr>
        </p:nvSpPr>
        <p:spPr/>
        <p:txBody>
          <a:bodyPr/>
          <a:lstStyle/>
          <a:p>
            <a:r>
              <a:rPr lang="en-US" dirty="0" smtClean="0"/>
              <a:t>Limitations</a:t>
            </a:r>
            <a:endParaRPr lang="en-US" dirty="0"/>
          </a:p>
        </p:txBody>
      </p:sp>
      <p:sp>
        <p:nvSpPr>
          <p:cNvPr id="11" name="Content Placeholder 10"/>
          <p:cNvSpPr>
            <a:spLocks noGrp="1"/>
          </p:cNvSpPr>
          <p:nvPr>
            <p:ph sz="quarter" idx="4"/>
          </p:nvPr>
        </p:nvSpPr>
        <p:spPr/>
        <p:txBody>
          <a:bodyPr/>
          <a:lstStyle/>
          <a:p>
            <a:r>
              <a:rPr lang="en-US" dirty="0"/>
              <a:t>Ineffective if learner has little knowledge to draw on and is making a blind guess from the beginning without any reasoning behind it</a:t>
            </a:r>
          </a:p>
          <a:p>
            <a:r>
              <a:rPr lang="en-US" dirty="0"/>
              <a:t>Not designed for teaching procedural </a:t>
            </a:r>
            <a:r>
              <a:rPr lang="en-US" dirty="0" smtClean="0"/>
              <a:t>skills</a:t>
            </a:r>
            <a:endParaRPr lang="en-US" dirty="0"/>
          </a:p>
        </p:txBody>
      </p:sp>
    </p:spTree>
    <p:extLst>
      <p:ext uri="{BB962C8B-B14F-4D97-AF65-F5344CB8AC3E}">
        <p14:creationId xmlns:p14="http://schemas.microsoft.com/office/powerpoint/2010/main" val="3578361834"/>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smtClean="0"/>
              <a:t>Part 1: Cognitive Load Theory</a:t>
            </a:r>
            <a:endParaRPr lang="en-US" dirty="0"/>
          </a:p>
        </p:txBody>
      </p:sp>
      <p:sp>
        <p:nvSpPr>
          <p:cNvPr id="5" name="Text Placeholder 4"/>
          <p:cNvSpPr>
            <a:spLocks noGrp="1"/>
          </p:cNvSpPr>
          <p:nvPr>
            <p:ph type="body" idx="1"/>
          </p:nvPr>
        </p:nvSpPr>
        <p:spPr/>
        <p:txBody>
          <a:bodyPr/>
          <a:lstStyle/>
          <a:p>
            <a:r>
              <a:rPr lang="en-US" dirty="0" smtClean="0"/>
              <a:t>How to not be the fire hose</a:t>
            </a:r>
            <a:endParaRPr lang="en-US" dirty="0"/>
          </a:p>
        </p:txBody>
      </p:sp>
      <p:pic>
        <p:nvPicPr>
          <p:cNvPr id="1028" name="Picture 4"/>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286000" y="457200"/>
            <a:ext cx="4495800" cy="276467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15562154"/>
      </p:ext>
    </p:extLst>
  </p:cSld>
  <p:clrMapOvr>
    <a:masterClrMapping/>
  </p:clrMapOvr>
  <p:timing>
    <p:tnLst>
      <p:par>
        <p:cTn id="1" dur="indefinite" restart="never" nodeType="tmRoot"/>
      </p:par>
    </p:tn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One-Minute Preceptor</a:t>
            </a:r>
          </a:p>
        </p:txBody>
      </p:sp>
      <p:sp>
        <p:nvSpPr>
          <p:cNvPr id="5" name="Content Placeholder 4"/>
          <p:cNvSpPr>
            <a:spLocks noGrp="1"/>
          </p:cNvSpPr>
          <p:nvPr>
            <p:ph idx="1"/>
          </p:nvPr>
        </p:nvSpPr>
        <p:spPr/>
        <p:txBody>
          <a:bodyPr/>
          <a:lstStyle/>
          <a:p>
            <a:pPr marL="514350" indent="-514350">
              <a:buFont typeface="+mj-lt"/>
              <a:buAutoNum type="arabicPeriod"/>
            </a:pPr>
            <a:r>
              <a:rPr lang="en-US" dirty="0"/>
              <a:t>Get a commitment</a:t>
            </a:r>
          </a:p>
          <a:p>
            <a:pPr marL="514350" indent="-514350">
              <a:buFont typeface="+mj-lt"/>
              <a:buAutoNum type="arabicPeriod"/>
            </a:pPr>
            <a:r>
              <a:rPr lang="en-US" dirty="0"/>
              <a:t>Probe for supporting evidence</a:t>
            </a:r>
          </a:p>
          <a:p>
            <a:pPr marL="514350" indent="-514350">
              <a:buFont typeface="+mj-lt"/>
              <a:buAutoNum type="arabicPeriod"/>
            </a:pPr>
            <a:r>
              <a:rPr lang="en-US" dirty="0"/>
              <a:t>Teach general rules</a:t>
            </a:r>
          </a:p>
          <a:p>
            <a:pPr marL="514350" indent="-514350">
              <a:buFont typeface="+mj-lt"/>
              <a:buAutoNum type="arabicPeriod"/>
            </a:pPr>
            <a:r>
              <a:rPr lang="en-US" dirty="0"/>
              <a:t>Reinforce what was done right</a:t>
            </a:r>
          </a:p>
          <a:p>
            <a:pPr marL="514350" indent="-514350">
              <a:buFont typeface="+mj-lt"/>
              <a:buAutoNum type="arabicPeriod"/>
            </a:pPr>
            <a:r>
              <a:rPr lang="en-US" dirty="0"/>
              <a:t>Correct mistakes</a:t>
            </a:r>
          </a:p>
        </p:txBody>
      </p:sp>
    </p:spTree>
    <p:extLst>
      <p:ext uri="{BB962C8B-B14F-4D97-AF65-F5344CB8AC3E}">
        <p14:creationId xmlns:p14="http://schemas.microsoft.com/office/powerpoint/2010/main" val="2958702383"/>
      </p:ext>
    </p:extLst>
  </p:cSld>
  <p:clrMapOvr>
    <a:masterClrMapping/>
  </p:clrMapOvr>
  <p:timing>
    <p:tnLst>
      <p:par>
        <p:cTn id="1" dur="indefinite" restart="never" nodeType="tmRoot"/>
      </p:par>
    </p:tn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cenario</a:t>
            </a:r>
          </a:p>
        </p:txBody>
      </p:sp>
      <p:sp>
        <p:nvSpPr>
          <p:cNvPr id="3" name="Content Placeholder 2"/>
          <p:cNvSpPr>
            <a:spLocks noGrp="1"/>
          </p:cNvSpPr>
          <p:nvPr>
            <p:ph idx="1"/>
          </p:nvPr>
        </p:nvSpPr>
        <p:spPr/>
        <p:txBody>
          <a:bodyPr/>
          <a:lstStyle/>
          <a:p>
            <a:r>
              <a:rPr lang="en-US" dirty="0"/>
              <a:t>30 year old male, previously healthy, undergoing </a:t>
            </a:r>
            <a:r>
              <a:rPr lang="en-US" dirty="0">
                <a:solidFill>
                  <a:srgbClr val="FFFF00"/>
                </a:solidFill>
              </a:rPr>
              <a:t>laparoscopic cholecystectomy</a:t>
            </a:r>
            <a:r>
              <a:rPr lang="en-US" dirty="0"/>
              <a:t>.</a:t>
            </a:r>
          </a:p>
          <a:p>
            <a:r>
              <a:rPr lang="en-US" dirty="0"/>
              <a:t>You have a </a:t>
            </a:r>
            <a:r>
              <a:rPr lang="en-US" dirty="0">
                <a:solidFill>
                  <a:srgbClr val="FFFF00"/>
                </a:solidFill>
              </a:rPr>
              <a:t>visiting 4</a:t>
            </a:r>
            <a:r>
              <a:rPr lang="en-US" baseline="30000" dirty="0">
                <a:solidFill>
                  <a:srgbClr val="FFFF00"/>
                </a:solidFill>
              </a:rPr>
              <a:t>th</a:t>
            </a:r>
            <a:r>
              <a:rPr lang="en-US" dirty="0">
                <a:solidFill>
                  <a:srgbClr val="FFFF00"/>
                </a:solidFill>
              </a:rPr>
              <a:t> year medical student</a:t>
            </a:r>
            <a:r>
              <a:rPr lang="en-US" dirty="0"/>
              <a:t> with you today.</a:t>
            </a:r>
          </a:p>
          <a:p>
            <a:r>
              <a:rPr lang="en-US" dirty="0"/>
              <a:t>Half an hour into the procedure, the end tidal CO2 has risen from 35 to 45.</a:t>
            </a:r>
          </a:p>
          <a:p>
            <a:r>
              <a:rPr lang="en-US" dirty="0"/>
              <a:t>5 minutes before leaving for lecture, the medical student notices the high end tidal CO2 and excitedly asks you, “Is he having malignant hyperthermia?”</a:t>
            </a:r>
          </a:p>
        </p:txBody>
      </p:sp>
    </p:spTree>
    <p:extLst>
      <p:ext uri="{BB962C8B-B14F-4D97-AF65-F5344CB8AC3E}">
        <p14:creationId xmlns:p14="http://schemas.microsoft.com/office/powerpoint/2010/main" val="1448847471"/>
      </p:ext>
    </p:extLst>
  </p:cSld>
  <p:clrMapOvr>
    <a:masterClrMapping/>
  </p:clrMapOvr>
  <p:timing>
    <p:tnLst>
      <p:par>
        <p:cTn id="1" dur="indefinite" restart="never" nodeType="tmRoot"/>
      </p:par>
    </p:tn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One-Minute Preceptor</a:t>
            </a:r>
          </a:p>
        </p:txBody>
      </p:sp>
      <p:sp>
        <p:nvSpPr>
          <p:cNvPr id="5" name="Content Placeholder 4"/>
          <p:cNvSpPr>
            <a:spLocks noGrp="1"/>
          </p:cNvSpPr>
          <p:nvPr>
            <p:ph idx="1"/>
          </p:nvPr>
        </p:nvSpPr>
        <p:spPr/>
        <p:txBody>
          <a:bodyPr/>
          <a:lstStyle/>
          <a:p>
            <a:pPr marL="514350" indent="-514350">
              <a:buFont typeface="+mj-lt"/>
              <a:buAutoNum type="arabicPeriod"/>
            </a:pPr>
            <a:r>
              <a:rPr lang="en-US" dirty="0"/>
              <a:t>Get a commitment</a:t>
            </a:r>
          </a:p>
          <a:p>
            <a:pPr marL="514350" indent="-514350">
              <a:buFont typeface="+mj-lt"/>
              <a:buAutoNum type="arabicPeriod"/>
            </a:pPr>
            <a:r>
              <a:rPr lang="en-US" dirty="0">
                <a:solidFill>
                  <a:schemeClr val="tx1">
                    <a:lumMod val="50000"/>
                  </a:schemeClr>
                </a:solidFill>
              </a:rPr>
              <a:t>Probe for supporting evidence</a:t>
            </a:r>
          </a:p>
          <a:p>
            <a:pPr marL="514350" indent="-514350">
              <a:buFont typeface="+mj-lt"/>
              <a:buAutoNum type="arabicPeriod"/>
            </a:pPr>
            <a:r>
              <a:rPr lang="en-US" dirty="0">
                <a:solidFill>
                  <a:schemeClr val="tx1">
                    <a:lumMod val="50000"/>
                  </a:schemeClr>
                </a:solidFill>
              </a:rPr>
              <a:t>Teach general rules</a:t>
            </a:r>
          </a:p>
          <a:p>
            <a:pPr marL="514350" indent="-514350">
              <a:buFont typeface="+mj-lt"/>
              <a:buAutoNum type="arabicPeriod"/>
            </a:pPr>
            <a:r>
              <a:rPr lang="en-US" dirty="0">
                <a:solidFill>
                  <a:schemeClr val="tx1">
                    <a:lumMod val="50000"/>
                  </a:schemeClr>
                </a:solidFill>
              </a:rPr>
              <a:t>Reinforce what was done right</a:t>
            </a:r>
          </a:p>
          <a:p>
            <a:pPr marL="514350" indent="-514350">
              <a:buFont typeface="+mj-lt"/>
              <a:buAutoNum type="arabicPeriod"/>
            </a:pPr>
            <a:r>
              <a:rPr lang="en-US" dirty="0">
                <a:solidFill>
                  <a:schemeClr val="tx1">
                    <a:lumMod val="50000"/>
                  </a:schemeClr>
                </a:solidFill>
              </a:rPr>
              <a:t>Correct mistakes</a:t>
            </a:r>
          </a:p>
        </p:txBody>
      </p:sp>
      <p:sp>
        <p:nvSpPr>
          <p:cNvPr id="2" name="TextBox 1"/>
          <p:cNvSpPr txBox="1"/>
          <p:nvPr/>
        </p:nvSpPr>
        <p:spPr>
          <a:xfrm>
            <a:off x="2854579" y="5257800"/>
            <a:ext cx="3390672" cy="369332"/>
          </a:xfrm>
          <a:prstGeom prst="rect">
            <a:avLst/>
          </a:prstGeom>
          <a:noFill/>
        </p:spPr>
        <p:txBody>
          <a:bodyPr wrap="none" rtlCol="0">
            <a:spAutoFit/>
          </a:bodyPr>
          <a:lstStyle/>
          <a:p>
            <a:pPr algn="ctr"/>
            <a:r>
              <a:rPr lang="en-US" dirty="0"/>
              <a:t>This is malignant hyperthermia.</a:t>
            </a:r>
          </a:p>
        </p:txBody>
      </p:sp>
    </p:spTree>
    <p:extLst>
      <p:ext uri="{BB962C8B-B14F-4D97-AF65-F5344CB8AC3E}">
        <p14:creationId xmlns:p14="http://schemas.microsoft.com/office/powerpoint/2010/main" val="1468293932"/>
      </p:ext>
    </p:extLst>
  </p:cSld>
  <p:clrMapOvr>
    <a:masterClrMapping/>
  </p:clrMapOvr>
  <p:timing>
    <p:tnLst>
      <p:par>
        <p:cTn id="1" dur="indefinite" restart="never" nodeType="tmRoot"/>
      </p:par>
    </p:tnLst>
  </p:timing>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One-Minute Preceptor</a:t>
            </a:r>
          </a:p>
        </p:txBody>
      </p:sp>
      <p:sp>
        <p:nvSpPr>
          <p:cNvPr id="5" name="Content Placeholder 4"/>
          <p:cNvSpPr>
            <a:spLocks noGrp="1"/>
          </p:cNvSpPr>
          <p:nvPr>
            <p:ph idx="1"/>
          </p:nvPr>
        </p:nvSpPr>
        <p:spPr/>
        <p:txBody>
          <a:bodyPr/>
          <a:lstStyle/>
          <a:p>
            <a:pPr marL="514350" indent="-514350">
              <a:buFont typeface="+mj-lt"/>
              <a:buAutoNum type="arabicPeriod"/>
            </a:pPr>
            <a:r>
              <a:rPr lang="en-US" dirty="0">
                <a:solidFill>
                  <a:schemeClr val="tx1">
                    <a:lumMod val="50000"/>
                  </a:schemeClr>
                </a:solidFill>
              </a:rPr>
              <a:t>Get a commitment</a:t>
            </a:r>
          </a:p>
          <a:p>
            <a:pPr marL="514350" indent="-514350">
              <a:buFont typeface="+mj-lt"/>
              <a:buAutoNum type="arabicPeriod"/>
            </a:pPr>
            <a:r>
              <a:rPr lang="en-US" dirty="0"/>
              <a:t>Probe for supporting evidence</a:t>
            </a:r>
          </a:p>
          <a:p>
            <a:pPr marL="514350" indent="-514350">
              <a:buFont typeface="+mj-lt"/>
              <a:buAutoNum type="arabicPeriod"/>
            </a:pPr>
            <a:r>
              <a:rPr lang="en-US" dirty="0">
                <a:solidFill>
                  <a:schemeClr val="tx1">
                    <a:lumMod val="50000"/>
                  </a:schemeClr>
                </a:solidFill>
              </a:rPr>
              <a:t>Teach general rules</a:t>
            </a:r>
          </a:p>
          <a:p>
            <a:pPr marL="514350" indent="-514350">
              <a:buFont typeface="+mj-lt"/>
              <a:buAutoNum type="arabicPeriod"/>
            </a:pPr>
            <a:r>
              <a:rPr lang="en-US" dirty="0">
                <a:solidFill>
                  <a:schemeClr val="tx1">
                    <a:lumMod val="50000"/>
                  </a:schemeClr>
                </a:solidFill>
              </a:rPr>
              <a:t>Reinforce what was done right</a:t>
            </a:r>
          </a:p>
          <a:p>
            <a:pPr marL="514350" indent="-514350">
              <a:buFont typeface="+mj-lt"/>
              <a:buAutoNum type="arabicPeriod"/>
            </a:pPr>
            <a:r>
              <a:rPr lang="en-US" dirty="0">
                <a:solidFill>
                  <a:schemeClr val="tx1">
                    <a:lumMod val="50000"/>
                  </a:schemeClr>
                </a:solidFill>
              </a:rPr>
              <a:t>Correct mistakes</a:t>
            </a:r>
          </a:p>
        </p:txBody>
      </p:sp>
      <p:sp>
        <p:nvSpPr>
          <p:cNvPr id="6" name="TextBox 5"/>
          <p:cNvSpPr txBox="1"/>
          <p:nvPr/>
        </p:nvSpPr>
        <p:spPr>
          <a:xfrm>
            <a:off x="2841771" y="4800600"/>
            <a:ext cx="3416320" cy="1200329"/>
          </a:xfrm>
          <a:prstGeom prst="rect">
            <a:avLst/>
          </a:prstGeom>
          <a:noFill/>
        </p:spPr>
        <p:txBody>
          <a:bodyPr wrap="none" rtlCol="0">
            <a:spAutoFit/>
          </a:bodyPr>
          <a:lstStyle/>
          <a:p>
            <a:pPr algn="ctr"/>
            <a:r>
              <a:rPr lang="en-US" dirty="0"/>
              <a:t>Temperature is normal</a:t>
            </a:r>
          </a:p>
          <a:p>
            <a:pPr algn="ctr"/>
            <a:r>
              <a:rPr lang="en-US" dirty="0"/>
              <a:t>No muscle rigidity</a:t>
            </a:r>
          </a:p>
          <a:p>
            <a:pPr algn="ctr"/>
            <a:r>
              <a:rPr lang="en-US" dirty="0"/>
              <a:t>Mildly hypertensive</a:t>
            </a:r>
          </a:p>
          <a:p>
            <a:pPr algn="ctr"/>
            <a:r>
              <a:rPr lang="en-US" dirty="0"/>
              <a:t>Minute ventilation is unchanged</a:t>
            </a:r>
          </a:p>
        </p:txBody>
      </p:sp>
    </p:spTree>
    <p:extLst>
      <p:ext uri="{BB962C8B-B14F-4D97-AF65-F5344CB8AC3E}">
        <p14:creationId xmlns:p14="http://schemas.microsoft.com/office/powerpoint/2010/main" val="901198252"/>
      </p:ext>
    </p:extLst>
  </p:cSld>
  <p:clrMapOvr>
    <a:masterClrMapping/>
  </p:clrMapOvr>
  <p:timing>
    <p:tnLst>
      <p:par>
        <p:cTn id="1" dur="indefinite" restart="never" nodeType="tmRoot"/>
      </p:par>
    </p:tnLst>
  </p:timing>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One-Minute Preceptor</a:t>
            </a:r>
          </a:p>
        </p:txBody>
      </p:sp>
      <p:sp>
        <p:nvSpPr>
          <p:cNvPr id="5" name="Content Placeholder 4"/>
          <p:cNvSpPr>
            <a:spLocks noGrp="1"/>
          </p:cNvSpPr>
          <p:nvPr>
            <p:ph idx="1"/>
          </p:nvPr>
        </p:nvSpPr>
        <p:spPr/>
        <p:txBody>
          <a:bodyPr/>
          <a:lstStyle/>
          <a:p>
            <a:pPr marL="514350" indent="-514350">
              <a:buFont typeface="+mj-lt"/>
              <a:buAutoNum type="arabicPeriod"/>
            </a:pPr>
            <a:r>
              <a:rPr lang="en-US" dirty="0">
                <a:solidFill>
                  <a:schemeClr val="tx1">
                    <a:lumMod val="50000"/>
                  </a:schemeClr>
                </a:solidFill>
              </a:rPr>
              <a:t>Get a commitment</a:t>
            </a:r>
          </a:p>
          <a:p>
            <a:pPr marL="514350" indent="-514350">
              <a:buFont typeface="+mj-lt"/>
              <a:buAutoNum type="arabicPeriod"/>
            </a:pPr>
            <a:r>
              <a:rPr lang="en-US" dirty="0">
                <a:solidFill>
                  <a:schemeClr val="tx1">
                    <a:lumMod val="50000"/>
                  </a:schemeClr>
                </a:solidFill>
              </a:rPr>
              <a:t>Probe for supporting evidence</a:t>
            </a:r>
          </a:p>
          <a:p>
            <a:pPr marL="514350" indent="-514350">
              <a:buFont typeface="+mj-lt"/>
              <a:buAutoNum type="arabicPeriod"/>
            </a:pPr>
            <a:r>
              <a:rPr lang="en-US" dirty="0"/>
              <a:t>Teach general rules</a:t>
            </a:r>
          </a:p>
          <a:p>
            <a:pPr marL="514350" indent="-514350">
              <a:buFont typeface="+mj-lt"/>
              <a:buAutoNum type="arabicPeriod"/>
            </a:pPr>
            <a:r>
              <a:rPr lang="en-US" dirty="0">
                <a:solidFill>
                  <a:schemeClr val="tx1">
                    <a:lumMod val="50000"/>
                  </a:schemeClr>
                </a:solidFill>
              </a:rPr>
              <a:t>Reinforce what was done right</a:t>
            </a:r>
          </a:p>
          <a:p>
            <a:pPr marL="514350" indent="-514350">
              <a:buFont typeface="+mj-lt"/>
              <a:buAutoNum type="arabicPeriod"/>
            </a:pPr>
            <a:r>
              <a:rPr lang="en-US" dirty="0">
                <a:solidFill>
                  <a:schemeClr val="tx1">
                    <a:lumMod val="50000"/>
                  </a:schemeClr>
                </a:solidFill>
              </a:rPr>
              <a:t>Correct mistakes</a:t>
            </a:r>
          </a:p>
        </p:txBody>
      </p:sp>
      <p:sp>
        <p:nvSpPr>
          <p:cNvPr id="6" name="TextBox 5"/>
          <p:cNvSpPr txBox="1"/>
          <p:nvPr/>
        </p:nvSpPr>
        <p:spPr>
          <a:xfrm>
            <a:off x="400030" y="5269468"/>
            <a:ext cx="8439170" cy="369332"/>
          </a:xfrm>
          <a:prstGeom prst="rect">
            <a:avLst/>
          </a:prstGeom>
          <a:noFill/>
        </p:spPr>
        <p:txBody>
          <a:bodyPr wrap="none" rtlCol="0">
            <a:spAutoFit/>
          </a:bodyPr>
          <a:lstStyle/>
          <a:p>
            <a:pPr algn="ctr"/>
            <a:r>
              <a:rPr lang="en-US" dirty="0"/>
              <a:t>Laparoscopy is performed with CO2 insufflation, which can result in hypercapnia.</a:t>
            </a:r>
          </a:p>
        </p:txBody>
      </p:sp>
    </p:spTree>
    <p:extLst>
      <p:ext uri="{BB962C8B-B14F-4D97-AF65-F5344CB8AC3E}">
        <p14:creationId xmlns:p14="http://schemas.microsoft.com/office/powerpoint/2010/main" val="1772095472"/>
      </p:ext>
    </p:extLst>
  </p:cSld>
  <p:clrMapOvr>
    <a:masterClrMapping/>
  </p:clrMapOvr>
  <p:timing>
    <p:tnLst>
      <p:par>
        <p:cTn id="1" dur="indefinite" restart="never" nodeType="tmRoot"/>
      </p:par>
    </p:tnLst>
  </p:timing>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One-Minute Preceptor</a:t>
            </a:r>
          </a:p>
        </p:txBody>
      </p:sp>
      <p:sp>
        <p:nvSpPr>
          <p:cNvPr id="5" name="Content Placeholder 4"/>
          <p:cNvSpPr>
            <a:spLocks noGrp="1"/>
          </p:cNvSpPr>
          <p:nvPr>
            <p:ph idx="1"/>
          </p:nvPr>
        </p:nvSpPr>
        <p:spPr/>
        <p:txBody>
          <a:bodyPr/>
          <a:lstStyle/>
          <a:p>
            <a:pPr marL="514350" indent="-514350">
              <a:buFont typeface="+mj-lt"/>
              <a:buAutoNum type="arabicPeriod"/>
            </a:pPr>
            <a:r>
              <a:rPr lang="en-US" dirty="0">
                <a:solidFill>
                  <a:schemeClr val="tx1">
                    <a:lumMod val="50000"/>
                  </a:schemeClr>
                </a:solidFill>
              </a:rPr>
              <a:t>Get a commitment</a:t>
            </a:r>
          </a:p>
          <a:p>
            <a:pPr marL="514350" indent="-514350">
              <a:buFont typeface="+mj-lt"/>
              <a:buAutoNum type="arabicPeriod"/>
            </a:pPr>
            <a:r>
              <a:rPr lang="en-US" dirty="0">
                <a:solidFill>
                  <a:schemeClr val="tx1">
                    <a:lumMod val="50000"/>
                  </a:schemeClr>
                </a:solidFill>
              </a:rPr>
              <a:t>Probe for supporting evidence</a:t>
            </a:r>
          </a:p>
          <a:p>
            <a:pPr marL="514350" indent="-514350">
              <a:buFont typeface="+mj-lt"/>
              <a:buAutoNum type="arabicPeriod"/>
            </a:pPr>
            <a:r>
              <a:rPr lang="en-US" dirty="0">
                <a:solidFill>
                  <a:schemeClr val="tx1">
                    <a:lumMod val="50000"/>
                  </a:schemeClr>
                </a:solidFill>
              </a:rPr>
              <a:t>Teach general rules</a:t>
            </a:r>
          </a:p>
          <a:p>
            <a:pPr marL="514350" indent="-514350">
              <a:buFont typeface="+mj-lt"/>
              <a:buAutoNum type="arabicPeriod"/>
            </a:pPr>
            <a:r>
              <a:rPr lang="en-US" dirty="0"/>
              <a:t>Reinforce what was done right</a:t>
            </a:r>
          </a:p>
          <a:p>
            <a:pPr marL="514350" indent="-514350">
              <a:buFont typeface="+mj-lt"/>
              <a:buAutoNum type="arabicPeriod"/>
            </a:pPr>
            <a:r>
              <a:rPr lang="en-US" dirty="0">
                <a:solidFill>
                  <a:schemeClr val="tx1">
                    <a:lumMod val="50000"/>
                  </a:schemeClr>
                </a:solidFill>
              </a:rPr>
              <a:t>Correct mistakes</a:t>
            </a:r>
          </a:p>
        </p:txBody>
      </p:sp>
      <p:sp>
        <p:nvSpPr>
          <p:cNvPr id="7" name="TextBox 6"/>
          <p:cNvSpPr txBox="1"/>
          <p:nvPr/>
        </p:nvSpPr>
        <p:spPr>
          <a:xfrm>
            <a:off x="240578" y="5257800"/>
            <a:ext cx="8618705" cy="646331"/>
          </a:xfrm>
          <a:prstGeom prst="rect">
            <a:avLst/>
          </a:prstGeom>
          <a:noFill/>
        </p:spPr>
        <p:txBody>
          <a:bodyPr wrap="none" rtlCol="0">
            <a:spAutoFit/>
          </a:bodyPr>
          <a:lstStyle/>
          <a:p>
            <a:pPr algn="ctr"/>
            <a:r>
              <a:rPr lang="en-US" dirty="0"/>
              <a:t>Good job examining their masseter muscle.</a:t>
            </a:r>
          </a:p>
          <a:p>
            <a:pPr algn="ctr"/>
            <a:r>
              <a:rPr lang="en-US" dirty="0"/>
              <a:t>I like that you considered a potentially life-threatening diagnosis on your differential.</a:t>
            </a:r>
          </a:p>
        </p:txBody>
      </p:sp>
    </p:spTree>
    <p:extLst>
      <p:ext uri="{BB962C8B-B14F-4D97-AF65-F5344CB8AC3E}">
        <p14:creationId xmlns:p14="http://schemas.microsoft.com/office/powerpoint/2010/main" val="2223415048"/>
      </p:ext>
    </p:extLst>
  </p:cSld>
  <p:clrMapOvr>
    <a:masterClrMapping/>
  </p:clrMapOvr>
  <p:timing>
    <p:tnLst>
      <p:par>
        <p:cTn id="1" dur="indefinite" restart="never" nodeType="tmRoot"/>
      </p:par>
    </p:tnLst>
  </p:timing>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One-Minute Preceptor</a:t>
            </a:r>
          </a:p>
        </p:txBody>
      </p:sp>
      <p:sp>
        <p:nvSpPr>
          <p:cNvPr id="5" name="Content Placeholder 4"/>
          <p:cNvSpPr>
            <a:spLocks noGrp="1"/>
          </p:cNvSpPr>
          <p:nvPr>
            <p:ph idx="1"/>
          </p:nvPr>
        </p:nvSpPr>
        <p:spPr/>
        <p:txBody>
          <a:bodyPr/>
          <a:lstStyle/>
          <a:p>
            <a:pPr marL="514350" indent="-514350">
              <a:buFont typeface="+mj-lt"/>
              <a:buAutoNum type="arabicPeriod"/>
            </a:pPr>
            <a:r>
              <a:rPr lang="en-US" dirty="0">
                <a:solidFill>
                  <a:schemeClr val="tx1">
                    <a:lumMod val="50000"/>
                  </a:schemeClr>
                </a:solidFill>
              </a:rPr>
              <a:t>Get a commitment</a:t>
            </a:r>
          </a:p>
          <a:p>
            <a:pPr marL="514350" indent="-514350">
              <a:buFont typeface="+mj-lt"/>
              <a:buAutoNum type="arabicPeriod"/>
            </a:pPr>
            <a:r>
              <a:rPr lang="en-US" dirty="0">
                <a:solidFill>
                  <a:schemeClr val="tx1">
                    <a:lumMod val="50000"/>
                  </a:schemeClr>
                </a:solidFill>
              </a:rPr>
              <a:t>Probe for supporting evidence</a:t>
            </a:r>
          </a:p>
          <a:p>
            <a:pPr marL="514350" indent="-514350">
              <a:buFont typeface="+mj-lt"/>
              <a:buAutoNum type="arabicPeriod"/>
            </a:pPr>
            <a:r>
              <a:rPr lang="en-US" dirty="0">
                <a:solidFill>
                  <a:schemeClr val="tx1">
                    <a:lumMod val="50000"/>
                  </a:schemeClr>
                </a:solidFill>
              </a:rPr>
              <a:t>Teach general rules</a:t>
            </a:r>
          </a:p>
          <a:p>
            <a:pPr marL="514350" indent="-514350">
              <a:buFont typeface="+mj-lt"/>
              <a:buAutoNum type="arabicPeriod"/>
            </a:pPr>
            <a:r>
              <a:rPr lang="en-US" dirty="0">
                <a:solidFill>
                  <a:schemeClr val="tx1">
                    <a:lumMod val="50000"/>
                  </a:schemeClr>
                </a:solidFill>
              </a:rPr>
              <a:t>Reinforce what was done right</a:t>
            </a:r>
          </a:p>
          <a:p>
            <a:pPr marL="514350" indent="-514350">
              <a:buFont typeface="+mj-lt"/>
              <a:buAutoNum type="arabicPeriod"/>
            </a:pPr>
            <a:r>
              <a:rPr lang="en-US" dirty="0"/>
              <a:t>Correct mistakes</a:t>
            </a:r>
          </a:p>
        </p:txBody>
      </p:sp>
      <p:sp>
        <p:nvSpPr>
          <p:cNvPr id="6" name="TextBox 5"/>
          <p:cNvSpPr txBox="1"/>
          <p:nvPr/>
        </p:nvSpPr>
        <p:spPr>
          <a:xfrm>
            <a:off x="1296474" y="5257800"/>
            <a:ext cx="6506909" cy="369332"/>
          </a:xfrm>
          <a:prstGeom prst="rect">
            <a:avLst/>
          </a:prstGeom>
          <a:noFill/>
        </p:spPr>
        <p:txBody>
          <a:bodyPr wrap="none" rtlCol="0">
            <a:spAutoFit/>
          </a:bodyPr>
          <a:lstStyle/>
          <a:p>
            <a:pPr algn="ctr"/>
            <a:r>
              <a:rPr lang="en-US" dirty="0"/>
              <a:t>It is important to keep an eye on what the surgeons are doing.</a:t>
            </a:r>
          </a:p>
        </p:txBody>
      </p:sp>
    </p:spTree>
    <p:extLst>
      <p:ext uri="{BB962C8B-B14F-4D97-AF65-F5344CB8AC3E}">
        <p14:creationId xmlns:p14="http://schemas.microsoft.com/office/powerpoint/2010/main" val="711596316"/>
      </p:ext>
    </p:extLst>
  </p:cSld>
  <p:clrMapOvr>
    <a:masterClrMapping/>
  </p:clrMapOvr>
  <p:timing>
    <p:tnLst>
      <p:par>
        <p:cTn id="1" dur="indefinite" restart="never" nodeType="tmRoot"/>
      </p:par>
    </p:tnLst>
  </p:timing>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Practice</a:t>
            </a:r>
            <a:endParaRPr lang="en-US" dirty="0"/>
          </a:p>
        </p:txBody>
      </p:sp>
      <p:pic>
        <p:nvPicPr>
          <p:cNvPr id="11267"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90600" y="1600200"/>
            <a:ext cx="7313613" cy="48768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3839227033"/>
      </p:ext>
    </p:extLst>
  </p:cSld>
  <p:clrMapOvr>
    <a:masterClrMapping/>
  </p:clrMapOvr>
  <p:timing>
    <p:tnLst>
      <p:par>
        <p:cTn id="1" dur="indefinite" restart="never" nodeType="tmRoot"/>
      </p:par>
    </p:tnLst>
  </p:timing>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ummary</a:t>
            </a:r>
            <a:endParaRPr lang="en-US" dirty="0"/>
          </a:p>
        </p:txBody>
      </p:sp>
      <p:sp>
        <p:nvSpPr>
          <p:cNvPr id="3" name="Content Placeholder 2"/>
          <p:cNvSpPr>
            <a:spLocks noGrp="1"/>
          </p:cNvSpPr>
          <p:nvPr>
            <p:ph idx="1"/>
          </p:nvPr>
        </p:nvSpPr>
        <p:spPr/>
        <p:txBody>
          <a:bodyPr/>
          <a:lstStyle/>
          <a:p>
            <a:pPr marL="514350" indent="-514350">
              <a:buFont typeface="+mj-lt"/>
              <a:buAutoNum type="arabicPeriod"/>
            </a:pPr>
            <a:r>
              <a:rPr lang="en-US" dirty="0"/>
              <a:t>Get a commitment</a:t>
            </a:r>
          </a:p>
          <a:p>
            <a:pPr marL="514350" indent="-514350">
              <a:buFont typeface="+mj-lt"/>
              <a:buAutoNum type="arabicPeriod"/>
            </a:pPr>
            <a:r>
              <a:rPr lang="en-US" dirty="0"/>
              <a:t>Probe for supporting evidence</a:t>
            </a:r>
          </a:p>
          <a:p>
            <a:pPr marL="514350" indent="-514350">
              <a:buFont typeface="+mj-lt"/>
              <a:buAutoNum type="arabicPeriod"/>
            </a:pPr>
            <a:r>
              <a:rPr lang="en-US" dirty="0"/>
              <a:t>Teach general rules</a:t>
            </a:r>
          </a:p>
          <a:p>
            <a:pPr marL="514350" indent="-514350">
              <a:buFont typeface="+mj-lt"/>
              <a:buAutoNum type="arabicPeriod"/>
            </a:pPr>
            <a:r>
              <a:rPr lang="en-US" dirty="0"/>
              <a:t>Reinforce what was done right</a:t>
            </a:r>
          </a:p>
          <a:p>
            <a:pPr marL="514350" indent="-514350">
              <a:buFont typeface="+mj-lt"/>
              <a:buAutoNum type="arabicPeriod"/>
            </a:pPr>
            <a:r>
              <a:rPr lang="en-US" dirty="0"/>
              <a:t>Correct </a:t>
            </a:r>
            <a:r>
              <a:rPr lang="en-US" dirty="0" smtClean="0"/>
              <a:t>mistakes</a:t>
            </a:r>
            <a:endParaRPr lang="en-US" dirty="0"/>
          </a:p>
        </p:txBody>
      </p:sp>
    </p:spTree>
    <p:extLst>
      <p:ext uri="{BB962C8B-B14F-4D97-AF65-F5344CB8AC3E}">
        <p14:creationId xmlns:p14="http://schemas.microsoft.com/office/powerpoint/2010/main" val="3469352399"/>
      </p:ext>
    </p:extLst>
  </p:cSld>
  <p:clrMapOvr>
    <a:masterClrMapping/>
  </p:clrMapOvr>
  <p:timing>
    <p:tnLst>
      <p:par>
        <p:cTn id="1" dur="indefinite" restart="never" nodeType="tmRoot"/>
      </p:par>
    </p:tnLst>
  </p:timing>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Hour 1 refresher</a:t>
            </a:r>
            <a:endParaRPr lang="en-US" dirty="0"/>
          </a:p>
        </p:txBody>
      </p:sp>
      <p:sp>
        <p:nvSpPr>
          <p:cNvPr id="3" name="Content Placeholder 2"/>
          <p:cNvSpPr>
            <a:spLocks noGrp="1"/>
          </p:cNvSpPr>
          <p:nvPr>
            <p:ph idx="1"/>
          </p:nvPr>
        </p:nvSpPr>
        <p:spPr/>
        <p:txBody>
          <a:bodyPr/>
          <a:lstStyle/>
          <a:p>
            <a:r>
              <a:rPr lang="en-US" dirty="0" smtClean="0"/>
              <a:t>Beware of automaticity.</a:t>
            </a:r>
          </a:p>
          <a:p>
            <a:r>
              <a:rPr lang="en-US" dirty="0" smtClean="0"/>
              <a:t>Manage cognitive load.</a:t>
            </a:r>
          </a:p>
          <a:p>
            <a:r>
              <a:rPr lang="en-US" dirty="0" smtClean="0"/>
              <a:t>Provide </a:t>
            </a:r>
            <a:r>
              <a:rPr lang="en-US" dirty="0"/>
              <a:t>appropriate autonomy.</a:t>
            </a:r>
          </a:p>
          <a:p>
            <a:r>
              <a:rPr lang="en-US" dirty="0" smtClean="0"/>
              <a:t>Activate prior knowledge.</a:t>
            </a:r>
          </a:p>
        </p:txBody>
      </p:sp>
    </p:spTree>
    <p:extLst>
      <p:ext uri="{BB962C8B-B14F-4D97-AF65-F5344CB8AC3E}">
        <p14:creationId xmlns:p14="http://schemas.microsoft.com/office/powerpoint/2010/main" val="1209879393"/>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smtClean="0"/>
              <a:t>A Theory of Mastery</a:t>
            </a:r>
            <a:endParaRPr lang="en-US" dirty="0"/>
          </a:p>
        </p:txBody>
      </p:sp>
      <p:sp>
        <p:nvSpPr>
          <p:cNvPr id="5" name="Content Placeholder 4"/>
          <p:cNvSpPr>
            <a:spLocks noGrp="1"/>
          </p:cNvSpPr>
          <p:nvPr>
            <p:ph idx="1"/>
          </p:nvPr>
        </p:nvSpPr>
        <p:spPr/>
        <p:txBody>
          <a:bodyPr/>
          <a:lstStyle/>
          <a:p>
            <a:r>
              <a:rPr lang="en-US" dirty="0" smtClean="0"/>
              <a:t>Schema construction, aka “chunking”</a:t>
            </a:r>
            <a:endParaRPr lang="en-US" dirty="0"/>
          </a:p>
        </p:txBody>
      </p:sp>
      <p:pic>
        <p:nvPicPr>
          <p:cNvPr id="2050"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075442" y="2362200"/>
            <a:ext cx="3020558" cy="402907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4043441526"/>
      </p:ext>
    </p:extLst>
  </p:cSld>
  <p:clrMapOvr>
    <a:masterClrMapping/>
  </p:clrMapOvr>
  <p:timing>
    <p:tnLst>
      <p:par>
        <p:cTn id="1" dur="indefinite" restart="never" nodeType="tmRoot"/>
      </p:par>
    </p:tnLst>
  </p:timing>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smtClean="0"/>
              <a:t>End of Workshop</a:t>
            </a:r>
            <a:br>
              <a:rPr lang="en-US" dirty="0" smtClean="0"/>
            </a:br>
            <a:r>
              <a:rPr lang="en-US" dirty="0" smtClean="0"/>
              <a:t>Questions/Discussion</a:t>
            </a:r>
            <a:endParaRPr lang="en-US" dirty="0">
              <a:solidFill>
                <a:schemeClr val="tx1"/>
              </a:solidFill>
            </a:endParaRPr>
          </a:p>
        </p:txBody>
      </p:sp>
    </p:spTree>
    <p:extLst>
      <p:ext uri="{BB962C8B-B14F-4D97-AF65-F5344CB8AC3E}">
        <p14:creationId xmlns:p14="http://schemas.microsoft.com/office/powerpoint/2010/main" val="1811037084"/>
      </p:ext>
    </p:extLst>
  </p:cSld>
  <p:clrMapOvr>
    <a:masterClrMapping/>
  </p:clrMapOvr>
  <p:timing>
    <p:tnLst>
      <p:par>
        <p:cTn id="1" dur="indefinite" restart="never" nodeType="tmRoot"/>
      </p:par>
    </p:tnLst>
  </p:timing>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References</a:t>
            </a:r>
            <a:endParaRPr lang="en-US" dirty="0"/>
          </a:p>
        </p:txBody>
      </p:sp>
      <p:sp>
        <p:nvSpPr>
          <p:cNvPr id="3" name="Content Placeholder 2"/>
          <p:cNvSpPr>
            <a:spLocks noGrp="1"/>
          </p:cNvSpPr>
          <p:nvPr>
            <p:ph idx="1"/>
          </p:nvPr>
        </p:nvSpPr>
        <p:spPr/>
        <p:txBody>
          <a:bodyPr/>
          <a:lstStyle/>
          <a:p>
            <a:r>
              <a:rPr lang="en-US" sz="2000" dirty="0"/>
              <a:t>Farrell SE, Hopson LR, Wolff M, Hemphill RR, Santen SA. What's the Evidence: A Review of the One-Minute Preceptor Model of Clinical Teaching and Implications for Teaching in the Emergency Department. </a:t>
            </a:r>
            <a:r>
              <a:rPr lang="en-US" sz="2000" i="1" dirty="0"/>
              <a:t>J </a:t>
            </a:r>
            <a:r>
              <a:rPr lang="en-US" sz="2000" i="1" dirty="0" err="1"/>
              <a:t>Emerg</a:t>
            </a:r>
            <a:r>
              <a:rPr lang="en-US" sz="2000" i="1" dirty="0"/>
              <a:t> Med</a:t>
            </a:r>
            <a:r>
              <a:rPr lang="en-US" sz="2000" dirty="0"/>
              <a:t>. 2016;51(3): 278-83.</a:t>
            </a:r>
            <a:endParaRPr lang="en-US" sz="2000" b="1" dirty="0"/>
          </a:p>
          <a:p>
            <a:r>
              <a:rPr lang="en-US" sz="2000" dirty="0" err="1"/>
              <a:t>Teherani</a:t>
            </a:r>
            <a:r>
              <a:rPr lang="en-US" sz="2000" dirty="0"/>
              <a:t> A, O’Sullivan P, </a:t>
            </a:r>
            <a:r>
              <a:rPr lang="en-US" sz="2000" dirty="0" err="1"/>
              <a:t>Aagaard</a:t>
            </a:r>
            <a:r>
              <a:rPr lang="en-US" sz="2000" dirty="0"/>
              <a:t> EM, Morrison EH, Irby DM. Student perceptions of the one minute preceptor and traditional preceptor models. </a:t>
            </a:r>
            <a:r>
              <a:rPr lang="en-US" sz="2000" i="1" dirty="0"/>
              <a:t>Med Teach</a:t>
            </a:r>
            <a:r>
              <a:rPr lang="en-US" sz="2000" dirty="0"/>
              <a:t>. 2007;29: 323–327.</a:t>
            </a:r>
            <a:endParaRPr lang="en-US" sz="2000" b="1" dirty="0"/>
          </a:p>
          <a:p>
            <a:r>
              <a:rPr lang="en-US" sz="2000" dirty="0" err="1"/>
              <a:t>Furney</a:t>
            </a:r>
            <a:r>
              <a:rPr lang="en-US" sz="2000" dirty="0"/>
              <a:t> SL, </a:t>
            </a:r>
            <a:r>
              <a:rPr lang="en-US" sz="2000" dirty="0" err="1"/>
              <a:t>Orsini</a:t>
            </a:r>
            <a:r>
              <a:rPr lang="en-US" sz="2000" dirty="0"/>
              <a:t> AN, </a:t>
            </a:r>
            <a:r>
              <a:rPr lang="en-US" sz="2000" dirty="0" err="1"/>
              <a:t>Orsetti</a:t>
            </a:r>
            <a:r>
              <a:rPr lang="en-US" sz="2000" dirty="0"/>
              <a:t> KE, Stern DT, </a:t>
            </a:r>
            <a:r>
              <a:rPr lang="en-US" sz="2000" dirty="0" err="1"/>
              <a:t>Gruppen</a:t>
            </a:r>
            <a:r>
              <a:rPr lang="en-US" sz="2000" dirty="0"/>
              <a:t> LD, Irby DM. Teaching the one-minute preceptor: a randomized controlled trial. </a:t>
            </a:r>
            <a:r>
              <a:rPr lang="en-US" sz="2000" i="1" dirty="0"/>
              <a:t>J Gen Intern Med</a:t>
            </a:r>
            <a:r>
              <a:rPr lang="en-US" sz="2000" dirty="0"/>
              <a:t>. 2001;16: 620–624.</a:t>
            </a:r>
            <a:endParaRPr lang="en-US" sz="2000" b="1" dirty="0"/>
          </a:p>
          <a:p>
            <a:pPr lvl="0"/>
            <a:r>
              <a:rPr lang="en-US" sz="2000" dirty="0" err="1" smtClean="0"/>
              <a:t>Neher</a:t>
            </a:r>
            <a:r>
              <a:rPr lang="en-US" sz="2000" dirty="0" smtClean="0"/>
              <a:t> </a:t>
            </a:r>
            <a:r>
              <a:rPr lang="en-US" sz="2000" dirty="0"/>
              <a:t>JO, Gordon KC, Meyer B, Stevens N. A five-step “</a:t>
            </a:r>
            <a:r>
              <a:rPr lang="en-US" sz="2000" dirty="0" err="1"/>
              <a:t>microskills</a:t>
            </a:r>
            <a:r>
              <a:rPr lang="en-US" sz="2000" dirty="0"/>
              <a:t>” model of clinical teaching. J Am Board Fam </a:t>
            </a:r>
            <a:r>
              <a:rPr lang="en-US" sz="2000" dirty="0" err="1"/>
              <a:t>Pract</a:t>
            </a:r>
            <a:r>
              <a:rPr lang="en-US" sz="2000" dirty="0"/>
              <a:t> 1992;5:419-24.</a:t>
            </a:r>
          </a:p>
          <a:p>
            <a:pPr lvl="0"/>
            <a:r>
              <a:rPr lang="en-US" sz="2000" dirty="0" err="1"/>
              <a:t>Neher</a:t>
            </a:r>
            <a:r>
              <a:rPr lang="en-US" sz="2000" dirty="0"/>
              <a:t> JO, Stevens NG. The One-minute Preceptor: Shaping the Teaching Conversation. Fam Med 2003;35(6):391-3</a:t>
            </a:r>
            <a:r>
              <a:rPr lang="en-US" sz="2000" dirty="0" smtClean="0"/>
              <a:t>.</a:t>
            </a:r>
            <a:endParaRPr lang="en-US" sz="2000" dirty="0"/>
          </a:p>
        </p:txBody>
      </p:sp>
    </p:spTree>
    <p:extLst>
      <p:ext uri="{BB962C8B-B14F-4D97-AF65-F5344CB8AC3E}">
        <p14:creationId xmlns:p14="http://schemas.microsoft.com/office/powerpoint/2010/main" val="2561694883"/>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Automaticity</a:t>
            </a:r>
            <a:endParaRPr lang="en-US" dirty="0"/>
          </a:p>
        </p:txBody>
      </p:sp>
      <p:pic>
        <p:nvPicPr>
          <p:cNvPr id="3074"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676400" y="1905000"/>
            <a:ext cx="5826013" cy="38862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286604319"/>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Types of Cognitive Load</a:t>
            </a:r>
            <a:endParaRPr lang="en-US" dirty="0"/>
          </a:p>
        </p:txBody>
      </p:sp>
      <p:sp>
        <p:nvSpPr>
          <p:cNvPr id="3" name="Content Placeholder 2"/>
          <p:cNvSpPr>
            <a:spLocks noGrp="1"/>
          </p:cNvSpPr>
          <p:nvPr>
            <p:ph idx="1"/>
          </p:nvPr>
        </p:nvSpPr>
        <p:spPr/>
        <p:txBody>
          <a:bodyPr/>
          <a:lstStyle/>
          <a:p>
            <a:r>
              <a:rPr lang="en-US" dirty="0" smtClean="0"/>
              <a:t>Intrinsic load</a:t>
            </a:r>
          </a:p>
          <a:p>
            <a:r>
              <a:rPr lang="en-US" dirty="0" smtClean="0"/>
              <a:t>Extraneous load</a:t>
            </a:r>
          </a:p>
          <a:p>
            <a:r>
              <a:rPr lang="en-US" dirty="0" smtClean="0"/>
              <a:t>Germane load</a:t>
            </a:r>
            <a:endParaRPr lang="en-US" dirty="0"/>
          </a:p>
        </p:txBody>
      </p:sp>
    </p:spTree>
    <p:extLst>
      <p:ext uri="{BB962C8B-B14F-4D97-AF65-F5344CB8AC3E}">
        <p14:creationId xmlns:p14="http://schemas.microsoft.com/office/powerpoint/2010/main" val="1683237378"/>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How to Decrease Cognitive Load</a:t>
            </a:r>
            <a:endParaRPr lang="en-US" dirty="0"/>
          </a:p>
        </p:txBody>
      </p:sp>
      <p:sp>
        <p:nvSpPr>
          <p:cNvPr id="3" name="Content Placeholder 2"/>
          <p:cNvSpPr>
            <a:spLocks noGrp="1"/>
          </p:cNvSpPr>
          <p:nvPr>
            <p:ph idx="1"/>
          </p:nvPr>
        </p:nvSpPr>
        <p:spPr/>
        <p:txBody>
          <a:bodyPr/>
          <a:lstStyle/>
          <a:p>
            <a:r>
              <a:rPr lang="en-US" dirty="0" smtClean="0"/>
              <a:t>Minimize distractions</a:t>
            </a:r>
          </a:p>
          <a:p>
            <a:r>
              <a:rPr lang="en-US" dirty="0" smtClean="0"/>
              <a:t>Scaffolding</a:t>
            </a:r>
          </a:p>
          <a:p>
            <a:r>
              <a:rPr lang="en-US" dirty="0" smtClean="0"/>
              <a:t>Worked examples</a:t>
            </a:r>
          </a:p>
          <a:p>
            <a:r>
              <a:rPr lang="en-US" dirty="0" smtClean="0"/>
              <a:t>Integration</a:t>
            </a:r>
          </a:p>
          <a:p>
            <a:r>
              <a:rPr lang="en-US" dirty="0" smtClean="0"/>
              <a:t>Split-attention effect</a:t>
            </a:r>
            <a:endParaRPr lang="en-US" dirty="0"/>
          </a:p>
        </p:txBody>
      </p:sp>
    </p:spTree>
    <p:extLst>
      <p:ext uri="{BB962C8B-B14F-4D97-AF65-F5344CB8AC3E}">
        <p14:creationId xmlns:p14="http://schemas.microsoft.com/office/powerpoint/2010/main" val="2340804457"/>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Part 1 Summary</a:t>
            </a:r>
            <a:endParaRPr lang="en-US" dirty="0"/>
          </a:p>
        </p:txBody>
      </p:sp>
      <p:sp>
        <p:nvSpPr>
          <p:cNvPr id="3" name="Content Placeholder 2"/>
          <p:cNvSpPr>
            <a:spLocks noGrp="1"/>
          </p:cNvSpPr>
          <p:nvPr>
            <p:ph idx="1"/>
          </p:nvPr>
        </p:nvSpPr>
        <p:spPr/>
        <p:txBody>
          <a:bodyPr/>
          <a:lstStyle/>
          <a:p>
            <a:r>
              <a:rPr lang="en-US" dirty="0" smtClean="0"/>
              <a:t>Be mindful of automaticity</a:t>
            </a:r>
          </a:p>
          <a:p>
            <a:r>
              <a:rPr lang="en-US" dirty="0" smtClean="0"/>
              <a:t>Cognitive load can be both good and bad</a:t>
            </a:r>
          </a:p>
          <a:p>
            <a:pPr lvl="1"/>
            <a:r>
              <a:rPr lang="en-US" dirty="0" smtClean="0"/>
              <a:t>Intrinsic</a:t>
            </a:r>
          </a:p>
          <a:p>
            <a:pPr lvl="1"/>
            <a:r>
              <a:rPr lang="en-US" dirty="0" smtClean="0"/>
              <a:t>Extraneous</a:t>
            </a:r>
          </a:p>
          <a:p>
            <a:pPr lvl="1"/>
            <a:r>
              <a:rPr lang="en-US" dirty="0" smtClean="0"/>
              <a:t>Germane</a:t>
            </a:r>
          </a:p>
          <a:p>
            <a:endParaRPr lang="en-US" dirty="0"/>
          </a:p>
        </p:txBody>
      </p:sp>
    </p:spTree>
    <p:extLst>
      <p:ext uri="{BB962C8B-B14F-4D97-AF65-F5344CB8AC3E}">
        <p14:creationId xmlns:p14="http://schemas.microsoft.com/office/powerpoint/2010/main" val="3075700287"/>
      </p:ext>
    </p:extLst>
  </p:cSld>
  <p:clrMapOvr>
    <a:masterClrMapping/>
  </p:clrMapOvr>
  <p:timing>
    <p:tnLst>
      <p:par>
        <p:cTn id="1" dur="indefinite" restart="never" nodeType="tmRoot"/>
      </p:par>
    </p:tnLst>
  </p:timing>
</p:sld>
</file>

<file path=ppt/theme/theme1.xml><?xml version="1.0" encoding="utf-8"?>
<a:theme xmlns:a="http://schemas.openxmlformats.org/drawingml/2006/main" name="MayoBlueTexture">
  <a:themeElements>
    <a:clrScheme name="mc-bluetexture">
      <a:dk1>
        <a:sysClr val="windowText" lastClr="000000"/>
      </a:dk1>
      <a:lt1>
        <a:sysClr val="window" lastClr="FFFFFF"/>
      </a:lt1>
      <a:dk2>
        <a:srgbClr val="0046AD"/>
      </a:dk2>
      <a:lt2>
        <a:srgbClr val="FFFF00"/>
      </a:lt2>
      <a:accent1>
        <a:srgbClr val="FFB600"/>
      </a:accent1>
      <a:accent2>
        <a:srgbClr val="F36925"/>
      </a:accent2>
      <a:accent3>
        <a:srgbClr val="3CBE18"/>
      </a:accent3>
      <a:accent4>
        <a:srgbClr val="A43EBD"/>
      </a:accent4>
      <a:accent5>
        <a:srgbClr val="C18253"/>
      </a:accent5>
      <a:accent6>
        <a:srgbClr val="56A7FD"/>
      </a:accent6>
      <a:hlink>
        <a:srgbClr val="CC99FF"/>
      </a:hlink>
      <a:folHlink>
        <a:srgbClr val="969696"/>
      </a:folHlink>
    </a:clrScheme>
    <a:fontScheme name="mc-bluetexture">
      <a:majorFont>
        <a:latin typeface="Arial"/>
        <a:ea typeface=""/>
        <a:cs typeface=""/>
      </a:majorFont>
      <a:minorFont>
        <a:latin typeface="Arial"/>
        <a:ea typeface=""/>
        <a:cs typeface=""/>
      </a:minorFont>
    </a:fontScheme>
    <a:fmtScheme name="mc-bluetextur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1905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MayoBlueTexture</Template>
  <TotalTime>505</TotalTime>
  <Words>4084</Words>
  <Application>Microsoft Office PowerPoint</Application>
  <PresentationFormat>On-screen Show (4:3)</PresentationFormat>
  <Paragraphs>409</Paragraphs>
  <Slides>51</Slides>
  <Notes>44</Notes>
  <HiddenSlides>0</HiddenSlides>
  <MMClips>0</MMClips>
  <ScaleCrop>false</ScaleCrop>
  <HeadingPairs>
    <vt:vector size="4" baseType="variant">
      <vt:variant>
        <vt:lpstr>Theme</vt:lpstr>
      </vt:variant>
      <vt:variant>
        <vt:i4>1</vt:i4>
      </vt:variant>
      <vt:variant>
        <vt:lpstr>Slide Titles</vt:lpstr>
      </vt:variant>
      <vt:variant>
        <vt:i4>51</vt:i4>
      </vt:variant>
    </vt:vector>
  </HeadingPairs>
  <TitlesOfParts>
    <vt:vector size="52" baseType="lpstr">
      <vt:lpstr>MayoBlueTexture</vt:lpstr>
      <vt:lpstr>Training the Trainer</vt:lpstr>
      <vt:lpstr>Goal</vt:lpstr>
      <vt:lpstr>Objectives</vt:lpstr>
      <vt:lpstr>Part 1: Cognitive Load Theory</vt:lpstr>
      <vt:lpstr>A Theory of Mastery</vt:lpstr>
      <vt:lpstr>Automaticity</vt:lpstr>
      <vt:lpstr>Types of Cognitive Load</vt:lpstr>
      <vt:lpstr>How to Decrease Cognitive Load</vt:lpstr>
      <vt:lpstr>Part 1 Summary</vt:lpstr>
      <vt:lpstr>Part 1 Questions/Discussion</vt:lpstr>
      <vt:lpstr>Part 2: General Principles of Effective Teaching</vt:lpstr>
      <vt:lpstr>General Principles</vt:lpstr>
      <vt:lpstr>General Principles</vt:lpstr>
      <vt:lpstr>General Principles</vt:lpstr>
      <vt:lpstr>General Principles</vt:lpstr>
      <vt:lpstr>Self-determination theory</vt:lpstr>
      <vt:lpstr>Part 2 Summary</vt:lpstr>
      <vt:lpstr>Part 2 Questions/Discussion</vt:lpstr>
      <vt:lpstr>Part 3: A Standardized Framework for Evaluating the Quality of Teaching</vt:lpstr>
      <vt:lpstr>PowerPoint Presentation</vt:lpstr>
      <vt:lpstr>Standardized Framework</vt:lpstr>
      <vt:lpstr>Standardized Framework</vt:lpstr>
      <vt:lpstr>Standardized Framework</vt:lpstr>
      <vt:lpstr>Standardized Framework</vt:lpstr>
      <vt:lpstr>Standardized Framework</vt:lpstr>
      <vt:lpstr>Types of Questions</vt:lpstr>
      <vt:lpstr>Standardized Framework</vt:lpstr>
      <vt:lpstr>Part 3 Summary</vt:lpstr>
      <vt:lpstr>Part 3 Questions/Discussion</vt:lpstr>
      <vt:lpstr>Hour 1 summary</vt:lpstr>
      <vt:lpstr>Hour 1 Questions/Discussion</vt:lpstr>
      <vt:lpstr>References</vt:lpstr>
      <vt:lpstr>Part 4: Microskills</vt:lpstr>
      <vt:lpstr>Goal</vt:lpstr>
      <vt:lpstr>One-Minute Preceptor (“Microskills”)</vt:lpstr>
      <vt:lpstr>Successfully used in multiple disciplines:</vt:lpstr>
      <vt:lpstr>Supporting Evidence</vt:lpstr>
      <vt:lpstr>Supporting Evidence</vt:lpstr>
      <vt:lpstr>Microskills</vt:lpstr>
      <vt:lpstr>One-Minute Preceptor</vt:lpstr>
      <vt:lpstr>Scenario</vt:lpstr>
      <vt:lpstr>One-Minute Preceptor</vt:lpstr>
      <vt:lpstr>One-Minute Preceptor</vt:lpstr>
      <vt:lpstr>One-Minute Preceptor</vt:lpstr>
      <vt:lpstr>One-Minute Preceptor</vt:lpstr>
      <vt:lpstr>One-Minute Preceptor</vt:lpstr>
      <vt:lpstr>Practice</vt:lpstr>
      <vt:lpstr>Summary</vt:lpstr>
      <vt:lpstr>Hour 1 refresher</vt:lpstr>
      <vt:lpstr>End of Workshop Questions/Discussion</vt:lpstr>
      <vt:lpstr>References</vt:lpstr>
    </vt:vector>
  </TitlesOfParts>
  <Company>Mayo Clinic</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raining the Trainer: How to Teach Effectively</dc:title>
  <dc:creator>Jeffrey  Huang</dc:creator>
  <dc:description>v2.16</dc:description>
  <cp:lastModifiedBy>Huang, Jeffrey, M.D.</cp:lastModifiedBy>
  <cp:revision>85</cp:revision>
  <dcterms:created xsi:type="dcterms:W3CDTF">2019-02-08T13:44:04Z</dcterms:created>
  <dcterms:modified xsi:type="dcterms:W3CDTF">2020-10-28T21:06:47Z</dcterms:modified>
</cp:coreProperties>
</file>